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5"/>
  </p:notesMasterIdLst>
  <p:sldIdLst>
    <p:sldId id="272" r:id="rId2"/>
    <p:sldId id="268" r:id="rId3"/>
    <p:sldId id="260" r:id="rId4"/>
    <p:sldId id="274" r:id="rId5"/>
    <p:sldId id="270" r:id="rId6"/>
    <p:sldId id="257" r:id="rId7"/>
    <p:sldId id="259" r:id="rId8"/>
    <p:sldId id="258" r:id="rId9"/>
    <p:sldId id="281" r:id="rId10"/>
    <p:sldId id="280" r:id="rId11"/>
    <p:sldId id="261" r:id="rId12"/>
    <p:sldId id="262" r:id="rId13"/>
    <p:sldId id="263" r:id="rId14"/>
  </p:sldIdLst>
  <p:sldSz cx="14400213" cy="20520025"/>
  <p:notesSz cx="6797675" cy="9928225"/>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33FF"/>
    <a:srgbClr val="0000FF"/>
    <a:srgbClr val="EE3A3E"/>
    <a:srgbClr val="E14747"/>
    <a:srgbClr val="F94040"/>
    <a:srgbClr val="81B2DF"/>
    <a:srgbClr val="0081E2"/>
    <a:srgbClr val="ED7E7B"/>
    <a:srgbClr val="E85956"/>
    <a:srgbClr val="FDA74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381" autoAdjust="0"/>
    <p:restoredTop sz="96238" autoAdjust="0"/>
  </p:normalViewPr>
  <p:slideViewPr>
    <p:cSldViewPr snapToGrid="0">
      <p:cViewPr>
        <p:scale>
          <a:sx n="50" d="100"/>
          <a:sy n="50" d="100"/>
        </p:scale>
        <p:origin x="3114" y="-756"/>
      </p:cViewPr>
      <p:guideLst/>
    </p:cSldViewPr>
  </p:slideViewPr>
  <p:notesTextViewPr>
    <p:cViewPr>
      <p:scale>
        <a:sx n="150" d="100"/>
        <a:sy n="15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____.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Dongyoon%20Shin\Desktop\&#50976;&#48169;&#50516;&#50896;&#51204;&#51060;&#50672;&#44396;\2019_FFPE_TMT_1st_search_new_tN.txt"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Dongyoon%20Shin\Downloads\6_1st%20raw_SDY.xlsx_190717\1st%20raw_SDY.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19050" cap="rnd">
              <a:noFill/>
              <a:round/>
            </a:ln>
            <a:effectLst/>
          </c:spPr>
          <c:marker>
            <c:symbol val="circle"/>
            <c:size val="5"/>
            <c:spPr>
              <a:solidFill>
                <a:schemeClr val="accent1"/>
              </a:solidFill>
              <a:ln w="9525">
                <a:solidFill>
                  <a:schemeClr val="accent1"/>
                </a:solidFill>
              </a:ln>
              <a:effectLst/>
            </c:spPr>
          </c:marker>
          <c:yVal>
            <c:numRef>
              <c:f>Sheet1!$B$6:$S$6</c:f>
              <c:numCache>
                <c:formatCode>General</c:formatCode>
                <c:ptCount val="18"/>
                <c:pt idx="0">
                  <c:v>16.779089628648297</c:v>
                </c:pt>
                <c:pt idx="1">
                  <c:v>16.851792953949076</c:v>
                </c:pt>
                <c:pt idx="2">
                  <c:v>16.864603306866002</c:v>
                </c:pt>
                <c:pt idx="3">
                  <c:v>16.828277830434875</c:v>
                </c:pt>
                <c:pt idx="4">
                  <c:v>16.91275487235751</c:v>
                </c:pt>
                <c:pt idx="5">
                  <c:v>16.940185107133146</c:v>
                </c:pt>
                <c:pt idx="6">
                  <c:v>17.096848959895283</c:v>
                </c:pt>
                <c:pt idx="7">
                  <c:v>17.115749823852873</c:v>
                </c:pt>
                <c:pt idx="8">
                  <c:v>17.068757288903484</c:v>
                </c:pt>
                <c:pt idx="9">
                  <c:v>16.925301760678703</c:v>
                </c:pt>
                <c:pt idx="10">
                  <c:v>16.965104479906707</c:v>
                </c:pt>
                <c:pt idx="11">
                  <c:v>16.983644965876174</c:v>
                </c:pt>
                <c:pt idx="12">
                  <c:v>16.995731824905622</c:v>
                </c:pt>
                <c:pt idx="13">
                  <c:v>17.004888673038817</c:v>
                </c:pt>
                <c:pt idx="14">
                  <c:v>17.099667309945531</c:v>
                </c:pt>
                <c:pt idx="15">
                  <c:v>17.048275060526588</c:v>
                </c:pt>
                <c:pt idx="16">
                  <c:v>17.012243694971776</c:v>
                </c:pt>
                <c:pt idx="17">
                  <c:v>17.009076288764458</c:v>
                </c:pt>
              </c:numCache>
            </c:numRef>
          </c:yVal>
          <c:smooth val="0"/>
          <c:extLst>
            <c:ext xmlns:c16="http://schemas.microsoft.com/office/drawing/2014/chart" uri="{C3380CC4-5D6E-409C-BE32-E72D297353CC}">
              <c16:uniqueId val="{00000000-BC84-4A5B-BEDB-F054064ED054}"/>
            </c:ext>
          </c:extLst>
        </c:ser>
        <c:dLbls>
          <c:showLegendKey val="0"/>
          <c:showVal val="0"/>
          <c:showCatName val="0"/>
          <c:showSerName val="0"/>
          <c:showPercent val="0"/>
          <c:showBubbleSize val="0"/>
        </c:dLbls>
        <c:axId val="1618490688"/>
        <c:axId val="1618491104"/>
      </c:scatterChart>
      <c:valAx>
        <c:axId val="1618490688"/>
        <c:scaling>
          <c:orientation val="minMax"/>
        </c:scaling>
        <c:delete val="0"/>
        <c:axPos val="b"/>
        <c:majorTickMark val="out"/>
        <c:minorTickMark val="none"/>
        <c:tickLblPos val="nextTo"/>
        <c:spPr>
          <a:noFill/>
          <a:ln w="31750"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ln w="12700">
                  <a:solidFill>
                    <a:schemeClr val="tx1"/>
                  </a:solidFill>
                </a:ln>
                <a:solidFill>
                  <a:schemeClr val="tx1"/>
                </a:solidFill>
                <a:latin typeface="+mn-lt"/>
                <a:ea typeface="+mn-ea"/>
                <a:cs typeface="+mn-cs"/>
              </a:defRPr>
            </a:pPr>
            <a:endParaRPr lang="ko-KR"/>
          </a:p>
        </c:txPr>
        <c:crossAx val="1618491104"/>
        <c:crosses val="autoZero"/>
        <c:crossBetween val="midCat"/>
      </c:valAx>
      <c:valAx>
        <c:axId val="1618491104"/>
        <c:scaling>
          <c:orientation val="minMax"/>
          <c:max val="20"/>
          <c:min val="10"/>
        </c:scaling>
        <c:delete val="0"/>
        <c:axPos val="l"/>
        <c:numFmt formatCode="General" sourceLinked="1"/>
        <c:majorTickMark val="out"/>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ln w="12700">
                  <a:solidFill>
                    <a:schemeClr val="tx1"/>
                  </a:solidFill>
                </a:ln>
                <a:solidFill>
                  <a:schemeClr val="tx1">
                    <a:lumMod val="65000"/>
                    <a:lumOff val="35000"/>
                  </a:schemeClr>
                </a:solidFill>
                <a:latin typeface="+mn-lt"/>
                <a:ea typeface="+mn-ea"/>
                <a:cs typeface="+mn-cs"/>
              </a:defRPr>
            </a:pPr>
            <a:endParaRPr lang="ko-KR"/>
          </a:p>
        </c:txPr>
        <c:crossAx val="1618490688"/>
        <c:crosses val="autoZero"/>
        <c:crossBetween val="midCat"/>
        <c:majorUnit val="2"/>
      </c:valAx>
      <c:spPr>
        <a:noFill/>
        <a:ln>
          <a:noFill/>
        </a:ln>
        <a:effectLst/>
      </c:spPr>
    </c:plotArea>
    <c:plotVisOnly val="1"/>
    <c:dispBlanksAs val="gap"/>
    <c:showDLblsOverMax val="0"/>
  </c:chart>
  <c:spPr>
    <a:noFill/>
    <a:ln>
      <a:noFill/>
    </a:ln>
    <a:effectLst/>
  </c:spPr>
  <c:txPr>
    <a:bodyPr/>
    <a:lstStyle/>
    <a:p>
      <a:pPr>
        <a:defRPr>
          <a:ln w="12700">
            <a:solidFill>
              <a:schemeClr val="tx1"/>
            </a:solidFill>
          </a:ln>
        </a:defRPr>
      </a:pPr>
      <a:endParaRPr lang="ko-K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724291711676787"/>
          <c:y val="0.16021185561167262"/>
          <c:w val="0.89047461654007387"/>
          <c:h val="0.83978814400246704"/>
        </c:manualLayout>
      </c:layout>
      <c:scatterChart>
        <c:scatterStyle val="lineMarker"/>
        <c:varyColors val="0"/>
        <c:ser>
          <c:idx val="0"/>
          <c:order val="0"/>
          <c:spPr>
            <a:ln w="19050" cap="rnd">
              <a:noFill/>
              <a:round/>
            </a:ln>
            <a:effectLst/>
          </c:spPr>
          <c:marker>
            <c:symbol val="circle"/>
            <c:size val="5"/>
            <c:spPr>
              <a:solidFill>
                <a:schemeClr val="accent4"/>
              </a:solidFill>
              <a:ln w="9525">
                <a:noFill/>
              </a:ln>
              <a:effectLst/>
            </c:spPr>
          </c:marker>
          <c:yVal>
            <c:numRef>
              <c:f>Sheet1!$B$5:$S$5</c:f>
              <c:numCache>
                <c:formatCode>General</c:formatCode>
                <c:ptCount val="18"/>
                <c:pt idx="0">
                  <c:v>15.848290393758374</c:v>
                </c:pt>
                <c:pt idx="1">
                  <c:v>15.781428875158944</c:v>
                </c:pt>
                <c:pt idx="2">
                  <c:v>15.903881845736182</c:v>
                </c:pt>
                <c:pt idx="3">
                  <c:v>15.831492814550735</c:v>
                </c:pt>
                <c:pt idx="4">
                  <c:v>15.797370221990983</c:v>
                </c:pt>
                <c:pt idx="5">
                  <c:v>15.826138798271968</c:v>
                </c:pt>
                <c:pt idx="6">
                  <c:v>15.731414500332129</c:v>
                </c:pt>
                <c:pt idx="7">
                  <c:v>15.688818531627959</c:v>
                </c:pt>
                <c:pt idx="8">
                  <c:v>15.762646757683328</c:v>
                </c:pt>
                <c:pt idx="9">
                  <c:v>15.739548578754919</c:v>
                </c:pt>
                <c:pt idx="10">
                  <c:v>15.708518129009349</c:v>
                </c:pt>
                <c:pt idx="11">
                  <c:v>15.699857082039479</c:v>
                </c:pt>
                <c:pt idx="12">
                  <c:v>15.748114212178853</c:v>
                </c:pt>
                <c:pt idx="13">
                  <c:v>15.70294643263769</c:v>
                </c:pt>
                <c:pt idx="14">
                  <c:v>15.780670477594949</c:v>
                </c:pt>
                <c:pt idx="15">
                  <c:v>15.771419829722552</c:v>
                </c:pt>
                <c:pt idx="16">
                  <c:v>15.710421713943362</c:v>
                </c:pt>
                <c:pt idx="17">
                  <c:v>15.718912764283106</c:v>
                </c:pt>
              </c:numCache>
            </c:numRef>
          </c:yVal>
          <c:smooth val="0"/>
          <c:extLst>
            <c:ext xmlns:c16="http://schemas.microsoft.com/office/drawing/2014/chart" uri="{C3380CC4-5D6E-409C-BE32-E72D297353CC}">
              <c16:uniqueId val="{00000000-F962-45A5-AE33-E978B73FCE2D}"/>
            </c:ext>
          </c:extLst>
        </c:ser>
        <c:dLbls>
          <c:showLegendKey val="0"/>
          <c:showVal val="0"/>
          <c:showCatName val="0"/>
          <c:showSerName val="0"/>
          <c:showPercent val="0"/>
          <c:showBubbleSize val="0"/>
        </c:dLbls>
        <c:axId val="1547992560"/>
        <c:axId val="1547993392"/>
      </c:scatterChart>
      <c:valAx>
        <c:axId val="1547992560"/>
        <c:scaling>
          <c:orientation val="minMax"/>
        </c:scaling>
        <c:delete val="1"/>
        <c:axPos val="b"/>
        <c:majorTickMark val="out"/>
        <c:minorTickMark val="none"/>
        <c:tickLblPos val="nextTo"/>
        <c:crossAx val="1547993392"/>
        <c:crosses val="autoZero"/>
        <c:crossBetween val="midCat"/>
      </c:valAx>
      <c:valAx>
        <c:axId val="1547993392"/>
        <c:scaling>
          <c:orientation val="minMax"/>
          <c:max val="20"/>
          <c:min val="10"/>
        </c:scaling>
        <c:delete val="1"/>
        <c:axPos val="l"/>
        <c:majorGridlines>
          <c:spPr>
            <a:ln w="9525" cap="flat" cmpd="sng" algn="ctr">
              <a:solidFill>
                <a:schemeClr val="tx1">
                  <a:lumMod val="15000"/>
                  <a:lumOff val="85000"/>
                </a:schemeClr>
              </a:solidFill>
              <a:round/>
            </a:ln>
            <a:effectLst/>
          </c:spPr>
        </c:majorGridlines>
        <c:numFmt formatCode="General" sourceLinked="1"/>
        <c:majorTickMark val="out"/>
        <c:minorTickMark val="none"/>
        <c:tickLblPos val="nextTo"/>
        <c:crossAx val="1547992560"/>
        <c:crosses val="autoZero"/>
        <c:crossBetween val="midCat"/>
        <c:majorUnit val="2"/>
      </c:valAx>
      <c:spPr>
        <a:noFill/>
        <a:ln>
          <a:noFill/>
        </a:ln>
        <a:effectLst/>
      </c:spPr>
    </c:plotArea>
    <c:plotVisOnly val="1"/>
    <c:dispBlanksAs val="gap"/>
    <c:showDLblsOverMax val="0"/>
  </c:chart>
  <c:spPr>
    <a:noFill/>
    <a:ln>
      <a:noFill/>
    </a:ln>
    <a:effectLst/>
  </c:spPr>
  <c:txPr>
    <a:bodyPr/>
    <a:lstStyle/>
    <a:p>
      <a:pPr>
        <a:defRPr b="0"/>
      </a:pPr>
      <a:endParaRPr lang="ko-KR"/>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ko-K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3.6171134520068073E-2"/>
          <c:y val="9.190853877479413E-2"/>
          <c:w val="0.9391785505770115"/>
          <c:h val="0.90368984406992792"/>
        </c:manualLayout>
      </c:layout>
      <c:scatterChart>
        <c:scatterStyle val="lineMarker"/>
        <c:varyColors val="0"/>
        <c:ser>
          <c:idx val="0"/>
          <c:order val="0"/>
          <c:tx>
            <c:strRef>
              <c:f>'[2nd raw_SDY.xlsx]Proteins'!$I$1</c:f>
              <c:strCache>
                <c:ptCount val="1"/>
              </c:strCache>
            </c:strRef>
          </c:tx>
          <c:spPr>
            <a:ln w="19050" cap="rnd">
              <a:noFill/>
              <a:round/>
            </a:ln>
            <a:effectLst/>
          </c:spPr>
          <c:marker>
            <c:symbol val="circle"/>
            <c:size val="5"/>
            <c:spPr>
              <a:solidFill>
                <a:schemeClr val="accent1">
                  <a:lumMod val="50000"/>
                </a:schemeClr>
              </a:solidFill>
              <a:ln w="9525">
                <a:solidFill>
                  <a:schemeClr val="accent1"/>
                </a:solidFill>
              </a:ln>
              <a:effectLst/>
            </c:spPr>
          </c:marker>
          <c:yVal>
            <c:numRef>
              <c:f>[1]Proteins!$I$2:$I$8747</c:f>
              <c:numCache>
                <c:formatCode>General</c:formatCode>
                <c:ptCount val="8746"/>
                <c:pt idx="0">
                  <c:v>5.90051304650967</c:v>
                </c:pt>
                <c:pt idx="1">
                  <c:v>5.8898967948422412</c:v>
                </c:pt>
                <c:pt idx="2">
                  <c:v>5.7674579853887238</c:v>
                </c:pt>
                <c:pt idx="3">
                  <c:v>5.6450650249659136</c:v>
                </c:pt>
                <c:pt idx="4">
                  <c:v>5.6300647941436832</c:v>
                </c:pt>
                <c:pt idx="5">
                  <c:v>5.6241875929783518</c:v>
                </c:pt>
                <c:pt idx="6">
                  <c:v>5.6008448923816658</c:v>
                </c:pt>
                <c:pt idx="7">
                  <c:v>5.5587491254523798</c:v>
                </c:pt>
                <c:pt idx="8">
                  <c:v>5.542878462677491</c:v>
                </c:pt>
                <c:pt idx="9">
                  <c:v>5.5383868942160479</c:v>
                </c:pt>
                <c:pt idx="10">
                  <c:v>5.516123932374299</c:v>
                </c:pt>
                <c:pt idx="11">
                  <c:v>5.5024997087745753</c:v>
                </c:pt>
                <c:pt idx="12">
                  <c:v>5.4979975805086685</c:v>
                </c:pt>
                <c:pt idx="13">
                  <c:v>5.4692304902758622</c:v>
                </c:pt>
                <c:pt idx="14">
                  <c:v>5.453149491389869</c:v>
                </c:pt>
                <c:pt idx="15">
                  <c:v>5.4359663482427321</c:v>
                </c:pt>
                <c:pt idx="16">
                  <c:v>5.4294917148560167</c:v>
                </c:pt>
                <c:pt idx="17">
                  <c:v>5.4047285879139597</c:v>
                </c:pt>
                <c:pt idx="18">
                  <c:v>5.393328574870166</c:v>
                </c:pt>
                <c:pt idx="19">
                  <c:v>5.3819025170957531</c:v>
                </c:pt>
                <c:pt idx="20">
                  <c:v>5.3708808700539157</c:v>
                </c:pt>
                <c:pt idx="21">
                  <c:v>5.3707334397320565</c:v>
                </c:pt>
                <c:pt idx="22">
                  <c:v>5.3693545063700618</c:v>
                </c:pt>
                <c:pt idx="23">
                  <c:v>5.3654467062338727</c:v>
                </c:pt>
                <c:pt idx="24">
                  <c:v>5.3514769083312803</c:v>
                </c:pt>
                <c:pt idx="25">
                  <c:v>5.3474571945529776</c:v>
                </c:pt>
                <c:pt idx="26">
                  <c:v>5.3448135685568046</c:v>
                </c:pt>
                <c:pt idx="27">
                  <c:v>5.3404669196593666</c:v>
                </c:pt>
                <c:pt idx="28">
                  <c:v>5.3352880390533866</c:v>
                </c:pt>
                <c:pt idx="29">
                  <c:v>5.3312295749787593</c:v>
                </c:pt>
                <c:pt idx="30">
                  <c:v>5.3311758143483718</c:v>
                </c:pt>
                <c:pt idx="31">
                  <c:v>5.3255090613253326</c:v>
                </c:pt>
                <c:pt idx="32">
                  <c:v>5.3235053819407545</c:v>
                </c:pt>
                <c:pt idx="33">
                  <c:v>5.3206766279995978</c:v>
                </c:pt>
                <c:pt idx="34">
                  <c:v>5.313917767993324</c:v>
                </c:pt>
                <c:pt idx="35">
                  <c:v>5.2970563421473003</c:v>
                </c:pt>
                <c:pt idx="36">
                  <c:v>5.2830447860581229</c:v>
                </c:pt>
                <c:pt idx="37">
                  <c:v>5.2828407279994432</c:v>
                </c:pt>
                <c:pt idx="38">
                  <c:v>5.2807879682860035</c:v>
                </c:pt>
                <c:pt idx="39">
                  <c:v>5.2807165375935758</c:v>
                </c:pt>
                <c:pt idx="40">
                  <c:v>5.2745339722259335</c:v>
                </c:pt>
                <c:pt idx="41">
                  <c:v>5.2617363683472078</c:v>
                </c:pt>
                <c:pt idx="42">
                  <c:v>5.2598782059446059</c:v>
                </c:pt>
                <c:pt idx="43">
                  <c:v>5.2523158694248826</c:v>
                </c:pt>
                <c:pt idx="44">
                  <c:v>5.2522988914820532</c:v>
                </c:pt>
                <c:pt idx="45">
                  <c:v>5.2515022202426511</c:v>
                </c:pt>
                <c:pt idx="46">
                  <c:v>5.2487009107724178</c:v>
                </c:pt>
                <c:pt idx="47">
                  <c:v>5.2335710499147776</c:v>
                </c:pt>
                <c:pt idx="48">
                  <c:v>5.2333957511099118</c:v>
                </c:pt>
                <c:pt idx="49">
                  <c:v>5.2295575047749718</c:v>
                </c:pt>
                <c:pt idx="50">
                  <c:v>5.2247435550661416</c:v>
                </c:pt>
                <c:pt idx="51">
                  <c:v>5.2211656610089872</c:v>
                </c:pt>
                <c:pt idx="52">
                  <c:v>5.2148601190740926</c:v>
                </c:pt>
                <c:pt idx="53">
                  <c:v>5.2058953878486429</c:v>
                </c:pt>
                <c:pt idx="54">
                  <c:v>5.2031902615240169</c:v>
                </c:pt>
                <c:pt idx="55">
                  <c:v>5.2006645339335789</c:v>
                </c:pt>
                <c:pt idx="56">
                  <c:v>5.1884328773712944</c:v>
                </c:pt>
                <c:pt idx="57">
                  <c:v>5.18589526703028</c:v>
                </c:pt>
                <c:pt idx="58">
                  <c:v>5.1823831048579292</c:v>
                </c:pt>
                <c:pt idx="59">
                  <c:v>5.1814662736160697</c:v>
                </c:pt>
                <c:pt idx="60">
                  <c:v>5.1713774806171777</c:v>
                </c:pt>
                <c:pt idx="61">
                  <c:v>5.1675023710829144</c:v>
                </c:pt>
                <c:pt idx="62">
                  <c:v>5.165602264557025</c:v>
                </c:pt>
                <c:pt idx="63">
                  <c:v>5.1631942010169629</c:v>
                </c:pt>
                <c:pt idx="64">
                  <c:v>5.1610499356395962</c:v>
                </c:pt>
                <c:pt idx="65">
                  <c:v>5.1574198449855642</c:v>
                </c:pt>
                <c:pt idx="66">
                  <c:v>5.1421822994103161</c:v>
                </c:pt>
                <c:pt idx="67">
                  <c:v>5.1416271655380612</c:v>
                </c:pt>
                <c:pt idx="68">
                  <c:v>5.1415771338354732</c:v>
                </c:pt>
                <c:pt idx="69">
                  <c:v>5.135065884736556</c:v>
                </c:pt>
                <c:pt idx="70">
                  <c:v>5.1337089205384725</c:v>
                </c:pt>
                <c:pt idx="71">
                  <c:v>5.1276245242918881</c:v>
                </c:pt>
                <c:pt idx="72">
                  <c:v>5.1228588135050872</c:v>
                </c:pt>
                <c:pt idx="73">
                  <c:v>5.120498745691223</c:v>
                </c:pt>
                <c:pt idx="74">
                  <c:v>5.1125865704363003</c:v>
                </c:pt>
                <c:pt idx="75">
                  <c:v>5.1091656152983678</c:v>
                </c:pt>
                <c:pt idx="76">
                  <c:v>5.1061007641539753</c:v>
                </c:pt>
                <c:pt idx="77">
                  <c:v>5.0964206252801247</c:v>
                </c:pt>
                <c:pt idx="78">
                  <c:v>5.0934192918661569</c:v>
                </c:pt>
                <c:pt idx="79">
                  <c:v>5.0875655967907889</c:v>
                </c:pt>
                <c:pt idx="80">
                  <c:v>5.0868866764547462</c:v>
                </c:pt>
                <c:pt idx="81">
                  <c:v>5.0828395640149857</c:v>
                </c:pt>
                <c:pt idx="82">
                  <c:v>5.0823920341093789</c:v>
                </c:pt>
                <c:pt idx="83">
                  <c:v>5.0796382211227664</c:v>
                </c:pt>
                <c:pt idx="84">
                  <c:v>5.0719598420960743</c:v>
                </c:pt>
                <c:pt idx="85">
                  <c:v>5.0696045881063441</c:v>
                </c:pt>
                <c:pt idx="86">
                  <c:v>5.0686671133405472</c:v>
                </c:pt>
                <c:pt idx="87">
                  <c:v>5.0661888016913919</c:v>
                </c:pt>
                <c:pt idx="88">
                  <c:v>5.0637563116572695</c:v>
                </c:pt>
                <c:pt idx="89">
                  <c:v>5.0550057249824594</c:v>
                </c:pt>
                <c:pt idx="90">
                  <c:v>5.0546517121090018</c:v>
                </c:pt>
                <c:pt idx="91">
                  <c:v>5.0501634145381082</c:v>
                </c:pt>
                <c:pt idx="92">
                  <c:v>5.049529349315474</c:v>
                </c:pt>
                <c:pt idx="93">
                  <c:v>5.048815984989159</c:v>
                </c:pt>
                <c:pt idx="94">
                  <c:v>5.0414884825866624</c:v>
                </c:pt>
                <c:pt idx="95">
                  <c:v>5.0391154528176241</c:v>
                </c:pt>
                <c:pt idx="96">
                  <c:v>5.0388230237265406</c:v>
                </c:pt>
                <c:pt idx="97">
                  <c:v>5.0354327624469084</c:v>
                </c:pt>
                <c:pt idx="98">
                  <c:v>5.0324586574339207</c:v>
                </c:pt>
                <c:pt idx="99">
                  <c:v>5.0300659813791473</c:v>
                </c:pt>
                <c:pt idx="100">
                  <c:v>5.0293609123582383</c:v>
                </c:pt>
                <c:pt idx="101">
                  <c:v>5.0252928908647485</c:v>
                </c:pt>
                <c:pt idx="102">
                  <c:v>5.0225847706046371</c:v>
                </c:pt>
                <c:pt idx="103">
                  <c:v>5.0205075193074222</c:v>
                </c:pt>
                <c:pt idx="104">
                  <c:v>5.0203324116032499</c:v>
                </c:pt>
                <c:pt idx="105">
                  <c:v>5.0175307530290363</c:v>
                </c:pt>
                <c:pt idx="106">
                  <c:v>5.0127931136997441</c:v>
                </c:pt>
                <c:pt idx="107">
                  <c:v>5.0109278299697317</c:v>
                </c:pt>
                <c:pt idx="108">
                  <c:v>5.0092183410444218</c:v>
                </c:pt>
                <c:pt idx="109">
                  <c:v>5.0070741752783006</c:v>
                </c:pt>
                <c:pt idx="110">
                  <c:v>5.0067507006413239</c:v>
                </c:pt>
                <c:pt idx="111">
                  <c:v>5.0020826999454577</c:v>
                </c:pt>
                <c:pt idx="112">
                  <c:v>4.9995896150270163</c:v>
                </c:pt>
                <c:pt idx="113">
                  <c:v>4.9983071546950892</c:v>
                </c:pt>
                <c:pt idx="114">
                  <c:v>4.9982499392669375</c:v>
                </c:pt>
                <c:pt idx="115">
                  <c:v>4.9941922438774018</c:v>
                </c:pt>
                <c:pt idx="116">
                  <c:v>4.9828809282995898</c:v>
                </c:pt>
                <c:pt idx="117">
                  <c:v>4.9826589090570232</c:v>
                </c:pt>
                <c:pt idx="118">
                  <c:v>4.9824184108054688</c:v>
                </c:pt>
                <c:pt idx="119">
                  <c:v>4.980862822863946</c:v>
                </c:pt>
                <c:pt idx="120">
                  <c:v>4.9796801958990402</c:v>
                </c:pt>
                <c:pt idx="121">
                  <c:v>4.9760554067782836</c:v>
                </c:pt>
                <c:pt idx="122">
                  <c:v>4.9724282868246394</c:v>
                </c:pt>
                <c:pt idx="123">
                  <c:v>4.9718066379373376</c:v>
                </c:pt>
                <c:pt idx="124">
                  <c:v>4.9708984610841664</c:v>
                </c:pt>
                <c:pt idx="125">
                  <c:v>4.9688147690643625</c:v>
                </c:pt>
                <c:pt idx="126">
                  <c:v>4.9681067083990929</c:v>
                </c:pt>
                <c:pt idx="127">
                  <c:v>4.9667467150654652</c:v>
                </c:pt>
                <c:pt idx="128">
                  <c:v>4.9597790925638341</c:v>
                </c:pt>
                <c:pt idx="129">
                  <c:v>4.955575996086151</c:v>
                </c:pt>
                <c:pt idx="130">
                  <c:v>4.9526243520572812</c:v>
                </c:pt>
                <c:pt idx="131">
                  <c:v>4.9520652938117689</c:v>
                </c:pt>
                <c:pt idx="132">
                  <c:v>4.9478641267157846</c:v>
                </c:pt>
                <c:pt idx="133">
                  <c:v>4.9459440080302572</c:v>
                </c:pt>
                <c:pt idx="134">
                  <c:v>4.9459025259707099</c:v>
                </c:pt>
                <c:pt idx="135">
                  <c:v>4.9432819332911269</c:v>
                </c:pt>
                <c:pt idx="136">
                  <c:v>4.9423392313651089</c:v>
                </c:pt>
                <c:pt idx="137">
                  <c:v>4.9418912051954536</c:v>
                </c:pt>
                <c:pt idx="138">
                  <c:v>4.9417868511912335</c:v>
                </c:pt>
                <c:pt idx="139">
                  <c:v>4.9409823489470348</c:v>
                </c:pt>
                <c:pt idx="140">
                  <c:v>4.939500061148518</c:v>
                </c:pt>
                <c:pt idx="141">
                  <c:v>4.9375428824550012</c:v>
                </c:pt>
                <c:pt idx="142">
                  <c:v>4.9367514056349817</c:v>
                </c:pt>
                <c:pt idx="143">
                  <c:v>4.9345441507583878</c:v>
                </c:pt>
                <c:pt idx="144">
                  <c:v>4.934395560641339</c:v>
                </c:pt>
                <c:pt idx="145">
                  <c:v>4.9321170333490452</c:v>
                </c:pt>
                <c:pt idx="146">
                  <c:v>4.9284962769342817</c:v>
                </c:pt>
                <c:pt idx="147">
                  <c:v>4.9246925021491847</c:v>
                </c:pt>
                <c:pt idx="148">
                  <c:v>4.9231161933235041</c:v>
                </c:pt>
                <c:pt idx="149">
                  <c:v>4.9224717716181905</c:v>
                </c:pt>
                <c:pt idx="150">
                  <c:v>4.9222533754030797</c:v>
                </c:pt>
                <c:pt idx="151">
                  <c:v>4.9191798809336928</c:v>
                </c:pt>
                <c:pt idx="152">
                  <c:v>4.9158944744040234</c:v>
                </c:pt>
                <c:pt idx="153">
                  <c:v>4.9101445842062326</c:v>
                </c:pt>
                <c:pt idx="154">
                  <c:v>4.9085954550376991</c:v>
                </c:pt>
                <c:pt idx="155">
                  <c:v>4.907783743569162</c:v>
                </c:pt>
                <c:pt idx="156">
                  <c:v>4.9077103429252968</c:v>
                </c:pt>
                <c:pt idx="157">
                  <c:v>4.9038548475791197</c:v>
                </c:pt>
                <c:pt idx="158">
                  <c:v>4.9012542646460346</c:v>
                </c:pt>
                <c:pt idx="159">
                  <c:v>4.8988228990393416</c:v>
                </c:pt>
                <c:pt idx="160">
                  <c:v>4.8974787889181393</c:v>
                </c:pt>
                <c:pt idx="161">
                  <c:v>4.8973502701531757</c:v>
                </c:pt>
                <c:pt idx="162">
                  <c:v>4.8931914802871441</c:v>
                </c:pt>
                <c:pt idx="163">
                  <c:v>4.8893106062302243</c:v>
                </c:pt>
                <c:pt idx="164">
                  <c:v>4.8890765270517687</c:v>
                </c:pt>
                <c:pt idx="165">
                  <c:v>4.8876588026036476</c:v>
                </c:pt>
                <c:pt idx="166">
                  <c:v>4.8868997907745451</c:v>
                </c:pt>
                <c:pt idx="167">
                  <c:v>4.8861704010593634</c:v>
                </c:pt>
                <c:pt idx="168">
                  <c:v>4.885475025207934</c:v>
                </c:pt>
                <c:pt idx="169">
                  <c:v>4.8835332094673092</c:v>
                </c:pt>
                <c:pt idx="170">
                  <c:v>4.882900864600618</c:v>
                </c:pt>
                <c:pt idx="171">
                  <c:v>4.8807222157446537</c:v>
                </c:pt>
                <c:pt idx="172">
                  <c:v>4.8798380014627831</c:v>
                </c:pt>
                <c:pt idx="173">
                  <c:v>4.8794510805407629</c:v>
                </c:pt>
                <c:pt idx="174">
                  <c:v>4.8778268728987397</c:v>
                </c:pt>
                <c:pt idx="175">
                  <c:v>4.8767140631327708</c:v>
                </c:pt>
                <c:pt idx="176">
                  <c:v>4.87591177589991</c:v>
                </c:pt>
                <c:pt idx="177">
                  <c:v>4.871353235680119</c:v>
                </c:pt>
                <c:pt idx="178">
                  <c:v>4.8710543718867676</c:v>
                </c:pt>
                <c:pt idx="179">
                  <c:v>4.8710157330792203</c:v>
                </c:pt>
                <c:pt idx="180">
                  <c:v>4.8695798308812739</c:v>
                </c:pt>
                <c:pt idx="181">
                  <c:v>4.8691295572192903</c:v>
                </c:pt>
                <c:pt idx="182">
                  <c:v>4.8687388158515619</c:v>
                </c:pt>
                <c:pt idx="183">
                  <c:v>4.8639677743735907</c:v>
                </c:pt>
                <c:pt idx="184">
                  <c:v>4.8638853928531747</c:v>
                </c:pt>
                <c:pt idx="185">
                  <c:v>4.8637064826881229</c:v>
                </c:pt>
                <c:pt idx="186">
                  <c:v>4.8635069500605157</c:v>
                </c:pt>
                <c:pt idx="187">
                  <c:v>4.8632710655972478</c:v>
                </c:pt>
                <c:pt idx="188">
                  <c:v>4.8631839892808655</c:v>
                </c:pt>
                <c:pt idx="189">
                  <c:v>4.8617347852585668</c:v>
                </c:pt>
                <c:pt idx="190">
                  <c:v>4.8596339123461405</c:v>
                </c:pt>
                <c:pt idx="191">
                  <c:v>4.8571058401289351</c:v>
                </c:pt>
                <c:pt idx="192">
                  <c:v>4.8569163327942322</c:v>
                </c:pt>
                <c:pt idx="193">
                  <c:v>4.8559735373226625</c:v>
                </c:pt>
                <c:pt idx="194">
                  <c:v>4.855737358553041</c:v>
                </c:pt>
                <c:pt idx="195">
                  <c:v>4.8555562706798021</c:v>
                </c:pt>
                <c:pt idx="196">
                  <c:v>4.8549853649983366</c:v>
                </c:pt>
                <c:pt idx="197">
                  <c:v>4.8545808392927228</c:v>
                </c:pt>
                <c:pt idx="198">
                  <c:v>4.8533275922426364</c:v>
                </c:pt>
                <c:pt idx="199">
                  <c:v>4.8499570518154602</c:v>
                </c:pt>
                <c:pt idx="200">
                  <c:v>4.8440956284640766</c:v>
                </c:pt>
                <c:pt idx="201">
                  <c:v>4.8432656968290493</c:v>
                </c:pt>
                <c:pt idx="202">
                  <c:v>4.8401407850276605</c:v>
                </c:pt>
                <c:pt idx="203">
                  <c:v>4.8373036196594486</c:v>
                </c:pt>
                <c:pt idx="204">
                  <c:v>4.8363484535234562</c:v>
                </c:pt>
                <c:pt idx="205">
                  <c:v>4.8332021303994424</c:v>
                </c:pt>
                <c:pt idx="206">
                  <c:v>4.8328074939451442</c:v>
                </c:pt>
                <c:pt idx="207">
                  <c:v>4.8320209088968769</c:v>
                </c:pt>
                <c:pt idx="208">
                  <c:v>4.8304889755050908</c:v>
                </c:pt>
                <c:pt idx="209">
                  <c:v>4.8241977762936763</c:v>
                </c:pt>
                <c:pt idx="210">
                  <c:v>4.8229234041427489</c:v>
                </c:pt>
                <c:pt idx="211">
                  <c:v>4.8209089019799398</c:v>
                </c:pt>
                <c:pt idx="212">
                  <c:v>4.8201173154479937</c:v>
                </c:pt>
                <c:pt idx="213">
                  <c:v>4.8200412980107794</c:v>
                </c:pt>
                <c:pt idx="214">
                  <c:v>4.8166668032113336</c:v>
                </c:pt>
                <c:pt idx="215">
                  <c:v>4.8165810144948651</c:v>
                </c:pt>
                <c:pt idx="216">
                  <c:v>4.8156915088382952</c:v>
                </c:pt>
                <c:pt idx="217">
                  <c:v>4.8136999047825686</c:v>
                </c:pt>
                <c:pt idx="218">
                  <c:v>4.813100322853602</c:v>
                </c:pt>
                <c:pt idx="219">
                  <c:v>4.8128917527389872</c:v>
                </c:pt>
                <c:pt idx="220">
                  <c:v>4.8124636476587259</c:v>
                </c:pt>
                <c:pt idx="221">
                  <c:v>4.809783462662871</c:v>
                </c:pt>
                <c:pt idx="222">
                  <c:v>4.8088300783657347</c:v>
                </c:pt>
                <c:pt idx="223">
                  <c:v>4.8084960937876806</c:v>
                </c:pt>
                <c:pt idx="224">
                  <c:v>4.8034429272496126</c:v>
                </c:pt>
                <c:pt idx="225">
                  <c:v>4.80342365456442</c:v>
                </c:pt>
                <c:pt idx="226">
                  <c:v>4.8003194802364799</c:v>
                </c:pt>
                <c:pt idx="227">
                  <c:v>4.7997997243177259</c:v>
                </c:pt>
                <c:pt idx="228">
                  <c:v>4.7936608062720731</c:v>
                </c:pt>
                <c:pt idx="229">
                  <c:v>4.7922729816839649</c:v>
                </c:pt>
                <c:pt idx="230">
                  <c:v>4.7903347847980315</c:v>
                </c:pt>
                <c:pt idx="231">
                  <c:v>4.7901288352482618</c:v>
                </c:pt>
                <c:pt idx="232">
                  <c:v>4.790082046918239</c:v>
                </c:pt>
                <c:pt idx="233">
                  <c:v>4.7874728332756202</c:v>
                </c:pt>
                <c:pt idx="234">
                  <c:v>4.7858731146755948</c:v>
                </c:pt>
                <c:pt idx="235">
                  <c:v>4.785091026059562</c:v>
                </c:pt>
                <c:pt idx="236">
                  <c:v>4.7850497869652786</c:v>
                </c:pt>
                <c:pt idx="237">
                  <c:v>4.7818736828458182</c:v>
                </c:pt>
                <c:pt idx="238">
                  <c:v>4.7805582399250754</c:v>
                </c:pt>
                <c:pt idx="239">
                  <c:v>4.7791294417763845</c:v>
                </c:pt>
                <c:pt idx="240">
                  <c:v>4.7788478948402187</c:v>
                </c:pt>
                <c:pt idx="241">
                  <c:v>4.7753889365294455</c:v>
                </c:pt>
                <c:pt idx="242">
                  <c:v>4.773347867258372</c:v>
                </c:pt>
                <c:pt idx="243">
                  <c:v>4.7727601407012656</c:v>
                </c:pt>
                <c:pt idx="244">
                  <c:v>4.7724292073850574</c:v>
                </c:pt>
                <c:pt idx="245">
                  <c:v>4.7712586349262658</c:v>
                </c:pt>
                <c:pt idx="246">
                  <c:v>4.7672596224350938</c:v>
                </c:pt>
                <c:pt idx="247">
                  <c:v>4.7668378031872072</c:v>
                </c:pt>
                <c:pt idx="248">
                  <c:v>4.7644753594256297</c:v>
                </c:pt>
                <c:pt idx="249">
                  <c:v>4.7632998494675469</c:v>
                </c:pt>
                <c:pt idx="250">
                  <c:v>4.7619260017233342</c:v>
                </c:pt>
                <c:pt idx="251">
                  <c:v>4.7615747993924469</c:v>
                </c:pt>
                <c:pt idx="252">
                  <c:v>4.7605304571888301</c:v>
                </c:pt>
                <c:pt idx="253">
                  <c:v>4.7585079267242332</c:v>
                </c:pt>
                <c:pt idx="254">
                  <c:v>4.7583471358819915</c:v>
                </c:pt>
                <c:pt idx="255">
                  <c:v>4.7583323204355956</c:v>
                </c:pt>
                <c:pt idx="256">
                  <c:v>4.7562978539186025</c:v>
                </c:pt>
                <c:pt idx="257">
                  <c:v>4.7546822114002909</c:v>
                </c:pt>
                <c:pt idx="258">
                  <c:v>4.7520176148059887</c:v>
                </c:pt>
                <c:pt idx="259">
                  <c:v>4.751211935438695</c:v>
                </c:pt>
                <c:pt idx="260">
                  <c:v>4.7484105028498726</c:v>
                </c:pt>
                <c:pt idx="261">
                  <c:v>4.7481342107942144</c:v>
                </c:pt>
                <c:pt idx="262">
                  <c:v>4.7476059496261147</c:v>
                </c:pt>
                <c:pt idx="263">
                  <c:v>4.7454652120264686</c:v>
                </c:pt>
                <c:pt idx="264">
                  <c:v>4.74543937123721</c:v>
                </c:pt>
                <c:pt idx="265">
                  <c:v>4.7439844331667524</c:v>
                </c:pt>
                <c:pt idx="266">
                  <c:v>4.7434101077101198</c:v>
                </c:pt>
                <c:pt idx="267">
                  <c:v>4.741984270677059</c:v>
                </c:pt>
                <c:pt idx="268">
                  <c:v>4.7418486777226141</c:v>
                </c:pt>
                <c:pt idx="269">
                  <c:v>4.7395915493167546</c:v>
                </c:pt>
                <c:pt idx="270">
                  <c:v>4.737326560453285</c:v>
                </c:pt>
                <c:pt idx="271">
                  <c:v>4.737241690288581</c:v>
                </c:pt>
                <c:pt idx="272">
                  <c:v>4.7353352359254952</c:v>
                </c:pt>
                <c:pt idx="273">
                  <c:v>4.7348000073234049</c:v>
                </c:pt>
                <c:pt idx="274">
                  <c:v>4.7340227456415587</c:v>
                </c:pt>
                <c:pt idx="275">
                  <c:v>4.7322988033755458</c:v>
                </c:pt>
                <c:pt idx="276">
                  <c:v>4.7322025298585038</c:v>
                </c:pt>
                <c:pt idx="277">
                  <c:v>4.7319053060747898</c:v>
                </c:pt>
                <c:pt idx="278">
                  <c:v>4.7309667802308013</c:v>
                </c:pt>
                <c:pt idx="279">
                  <c:v>4.7290109047897877</c:v>
                </c:pt>
                <c:pt idx="280">
                  <c:v>4.7288907033763525</c:v>
                </c:pt>
                <c:pt idx="281">
                  <c:v>4.7252681496363733</c:v>
                </c:pt>
                <c:pt idx="282">
                  <c:v>4.7246560522438736</c:v>
                </c:pt>
                <c:pt idx="283">
                  <c:v>4.7241797132600531</c:v>
                </c:pt>
                <c:pt idx="284">
                  <c:v>4.7239092960402367</c:v>
                </c:pt>
                <c:pt idx="285">
                  <c:v>4.7232976516830369</c:v>
                </c:pt>
                <c:pt idx="286">
                  <c:v>4.7231869484507518</c:v>
                </c:pt>
                <c:pt idx="287">
                  <c:v>4.7215444905510973</c:v>
                </c:pt>
                <c:pt idx="288">
                  <c:v>4.7214770060868698</c:v>
                </c:pt>
                <c:pt idx="289">
                  <c:v>4.7165269188212706</c:v>
                </c:pt>
                <c:pt idx="290">
                  <c:v>4.7159845516400791</c:v>
                </c:pt>
                <c:pt idx="291">
                  <c:v>4.7143667412056791</c:v>
                </c:pt>
                <c:pt idx="292">
                  <c:v>4.7139000502943791</c:v>
                </c:pt>
                <c:pt idx="293">
                  <c:v>4.7128987603665005</c:v>
                </c:pt>
                <c:pt idx="294">
                  <c:v>4.7106230420154445</c:v>
                </c:pt>
                <c:pt idx="295">
                  <c:v>4.7087739808587425</c:v>
                </c:pt>
                <c:pt idx="296">
                  <c:v>4.7081057121775958</c:v>
                </c:pt>
                <c:pt idx="297">
                  <c:v>4.7073807104723047</c:v>
                </c:pt>
                <c:pt idx="298">
                  <c:v>4.7064977352561126</c:v>
                </c:pt>
                <c:pt idx="299">
                  <c:v>4.7057218214765149</c:v>
                </c:pt>
                <c:pt idx="300">
                  <c:v>4.7050377964236638</c:v>
                </c:pt>
                <c:pt idx="301">
                  <c:v>4.7046239391412792</c:v>
                </c:pt>
                <c:pt idx="302">
                  <c:v>4.704567492976377</c:v>
                </c:pt>
                <c:pt idx="303">
                  <c:v>4.7028814955190574</c:v>
                </c:pt>
                <c:pt idx="304">
                  <c:v>4.70265121800613</c:v>
                </c:pt>
                <c:pt idx="305">
                  <c:v>4.7005179151020124</c:v>
                </c:pt>
                <c:pt idx="306">
                  <c:v>4.7000179943415201</c:v>
                </c:pt>
                <c:pt idx="307">
                  <c:v>4.6981659604733093</c:v>
                </c:pt>
                <c:pt idx="308">
                  <c:v>4.6980830903285034</c:v>
                </c:pt>
                <c:pt idx="309">
                  <c:v>4.6980433902173342</c:v>
                </c:pt>
                <c:pt idx="310">
                  <c:v>4.6980230310181463</c:v>
                </c:pt>
                <c:pt idx="311">
                  <c:v>4.6973556786895188</c:v>
                </c:pt>
                <c:pt idx="312">
                  <c:v>4.6967734916782167</c:v>
                </c:pt>
                <c:pt idx="313">
                  <c:v>4.6963615346021399</c:v>
                </c:pt>
                <c:pt idx="314">
                  <c:v>4.6939717688546372</c:v>
                </c:pt>
                <c:pt idx="315">
                  <c:v>4.6935656458751689</c:v>
                </c:pt>
                <c:pt idx="316">
                  <c:v>4.6914772283369839</c:v>
                </c:pt>
                <c:pt idx="317">
                  <c:v>4.6909091258622464</c:v>
                </c:pt>
                <c:pt idx="318">
                  <c:v>4.6897371202093767</c:v>
                </c:pt>
                <c:pt idx="319">
                  <c:v>4.6871742862759893</c:v>
                </c:pt>
                <c:pt idx="320">
                  <c:v>4.6868320746502681</c:v>
                </c:pt>
                <c:pt idx="321">
                  <c:v>4.6860512061586137</c:v>
                </c:pt>
                <c:pt idx="322">
                  <c:v>4.6830058894402615</c:v>
                </c:pt>
                <c:pt idx="323">
                  <c:v>4.6828034426583862</c:v>
                </c:pt>
                <c:pt idx="324">
                  <c:v>4.6811298848749416</c:v>
                </c:pt>
                <c:pt idx="325">
                  <c:v>4.6798250610891561</c:v>
                </c:pt>
                <c:pt idx="326">
                  <c:v>4.6786050168510487</c:v>
                </c:pt>
                <c:pt idx="327">
                  <c:v>4.6768779551694069</c:v>
                </c:pt>
                <c:pt idx="328">
                  <c:v>4.6755806448467592</c:v>
                </c:pt>
                <c:pt idx="329">
                  <c:v>4.6741078433289891</c:v>
                </c:pt>
                <c:pt idx="330">
                  <c:v>4.6735390056308637</c:v>
                </c:pt>
                <c:pt idx="331">
                  <c:v>4.6727341514847209</c:v>
                </c:pt>
                <c:pt idx="332">
                  <c:v>4.6723793394196012</c:v>
                </c:pt>
                <c:pt idx="333">
                  <c:v>4.6723280859132696</c:v>
                </c:pt>
                <c:pt idx="334">
                  <c:v>4.6719092120144223</c:v>
                </c:pt>
                <c:pt idx="335">
                  <c:v>4.6716942283090539</c:v>
                </c:pt>
                <c:pt idx="336">
                  <c:v>4.6694610531472787</c:v>
                </c:pt>
                <c:pt idx="337">
                  <c:v>4.6692243906893589</c:v>
                </c:pt>
                <c:pt idx="338">
                  <c:v>4.6687629388879026</c:v>
                </c:pt>
                <c:pt idx="339">
                  <c:v>4.6659436895922468</c:v>
                </c:pt>
                <c:pt idx="340">
                  <c:v>4.6649775937041023</c:v>
                </c:pt>
                <c:pt idx="341">
                  <c:v>4.6645644160449091</c:v>
                </c:pt>
                <c:pt idx="342">
                  <c:v>4.664148021629571</c:v>
                </c:pt>
                <c:pt idx="343">
                  <c:v>4.6629504940042787</c:v>
                </c:pt>
                <c:pt idx="344">
                  <c:v>4.6626311964478218</c:v>
                </c:pt>
                <c:pt idx="345">
                  <c:v>4.6621743943710108</c:v>
                </c:pt>
                <c:pt idx="346">
                  <c:v>4.6618583623780427</c:v>
                </c:pt>
                <c:pt idx="347">
                  <c:v>4.661760117059087</c:v>
                </c:pt>
                <c:pt idx="348">
                  <c:v>4.6595741099454155</c:v>
                </c:pt>
                <c:pt idx="349">
                  <c:v>4.6594401476318383</c:v>
                </c:pt>
                <c:pt idx="350">
                  <c:v>4.6587144479812697</c:v>
                </c:pt>
                <c:pt idx="351">
                  <c:v>4.6583012007891114</c:v>
                </c:pt>
                <c:pt idx="352">
                  <c:v>4.6582372876910885</c:v>
                </c:pt>
                <c:pt idx="353">
                  <c:v>4.6581716689382038</c:v>
                </c:pt>
                <c:pt idx="354">
                  <c:v>4.6547600238473317</c:v>
                </c:pt>
                <c:pt idx="355">
                  <c:v>4.6539537202252141</c:v>
                </c:pt>
                <c:pt idx="356">
                  <c:v>4.6532303141226468</c:v>
                </c:pt>
                <c:pt idx="357">
                  <c:v>4.6521287506821132</c:v>
                </c:pt>
                <c:pt idx="358">
                  <c:v>4.6512675658157328</c:v>
                </c:pt>
                <c:pt idx="359">
                  <c:v>4.6511508953244531</c:v>
                </c:pt>
                <c:pt idx="360">
                  <c:v>4.6485043722791701</c:v>
                </c:pt>
                <c:pt idx="361">
                  <c:v>4.6466126536286341</c:v>
                </c:pt>
                <c:pt idx="362">
                  <c:v>4.6462299518832371</c:v>
                </c:pt>
                <c:pt idx="363">
                  <c:v>4.6444319694082736</c:v>
                </c:pt>
                <c:pt idx="364">
                  <c:v>4.6444304921911286</c:v>
                </c:pt>
                <c:pt idx="365">
                  <c:v>4.6426510146755779</c:v>
                </c:pt>
                <c:pt idx="366">
                  <c:v>4.6417932140091036</c:v>
                </c:pt>
                <c:pt idx="367">
                  <c:v>4.6409178310143853</c:v>
                </c:pt>
                <c:pt idx="368">
                  <c:v>4.6407900705714216</c:v>
                </c:pt>
                <c:pt idx="369">
                  <c:v>4.6407878084978629</c:v>
                </c:pt>
                <c:pt idx="370">
                  <c:v>4.6404296453972265</c:v>
                </c:pt>
                <c:pt idx="371">
                  <c:v>4.6403686250114928</c:v>
                </c:pt>
                <c:pt idx="372">
                  <c:v>4.6397413024192415</c:v>
                </c:pt>
                <c:pt idx="373">
                  <c:v>4.6389491547455082</c:v>
                </c:pt>
                <c:pt idx="374">
                  <c:v>4.6389120306384797</c:v>
                </c:pt>
                <c:pt idx="375">
                  <c:v>4.6374485885576977</c:v>
                </c:pt>
                <c:pt idx="376">
                  <c:v>4.6365195450931127</c:v>
                </c:pt>
                <c:pt idx="377">
                  <c:v>4.6338558933405594</c:v>
                </c:pt>
                <c:pt idx="378">
                  <c:v>4.631974249263564</c:v>
                </c:pt>
                <c:pt idx="379">
                  <c:v>4.6310114579655659</c:v>
                </c:pt>
                <c:pt idx="380">
                  <c:v>4.6303884895215184</c:v>
                </c:pt>
                <c:pt idx="381">
                  <c:v>4.6284871319473382</c:v>
                </c:pt>
                <c:pt idx="382">
                  <c:v>4.6279035548215788</c:v>
                </c:pt>
                <c:pt idx="383">
                  <c:v>4.6273446307279</c:v>
                </c:pt>
                <c:pt idx="384">
                  <c:v>4.6252253660731411</c:v>
                </c:pt>
                <c:pt idx="385">
                  <c:v>4.6244824623557657</c:v>
                </c:pt>
                <c:pt idx="386">
                  <c:v>4.6235742577382011</c:v>
                </c:pt>
                <c:pt idx="387">
                  <c:v>4.6216330781025308</c:v>
                </c:pt>
                <c:pt idx="388">
                  <c:v>4.6209736907582126</c:v>
                </c:pt>
                <c:pt idx="389">
                  <c:v>4.6202273478947342</c:v>
                </c:pt>
                <c:pt idx="390">
                  <c:v>4.6190281351622096</c:v>
                </c:pt>
                <c:pt idx="391">
                  <c:v>4.6177175117754494</c:v>
                </c:pt>
                <c:pt idx="392">
                  <c:v>4.6176753272281283</c:v>
                </c:pt>
                <c:pt idx="393">
                  <c:v>4.6163728068250256</c:v>
                </c:pt>
                <c:pt idx="394">
                  <c:v>4.6157994771465365</c:v>
                </c:pt>
                <c:pt idx="395">
                  <c:v>4.6144746040461753</c:v>
                </c:pt>
                <c:pt idx="396">
                  <c:v>4.6136196279390189</c:v>
                </c:pt>
                <c:pt idx="397">
                  <c:v>4.613254675583641</c:v>
                </c:pt>
                <c:pt idx="398">
                  <c:v>4.6124457640139447</c:v>
                </c:pt>
                <c:pt idx="399">
                  <c:v>4.6087823271765389</c:v>
                </c:pt>
                <c:pt idx="400">
                  <c:v>4.6076512752060355</c:v>
                </c:pt>
                <c:pt idx="401">
                  <c:v>4.6072856808870064</c:v>
                </c:pt>
                <c:pt idx="402">
                  <c:v>4.6067569104183796</c:v>
                </c:pt>
                <c:pt idx="403">
                  <c:v>4.6037225054390554</c:v>
                </c:pt>
                <c:pt idx="404">
                  <c:v>4.6030657255870384</c:v>
                </c:pt>
                <c:pt idx="405">
                  <c:v>4.602222580045642</c:v>
                </c:pt>
                <c:pt idx="406">
                  <c:v>4.602221977084219</c:v>
                </c:pt>
                <c:pt idx="407">
                  <c:v>4.6018674114159497</c:v>
                </c:pt>
                <c:pt idx="408">
                  <c:v>4.6014018383330368</c:v>
                </c:pt>
                <c:pt idx="409">
                  <c:v>4.601365590725921</c:v>
                </c:pt>
                <c:pt idx="410">
                  <c:v>4.6012365246829487</c:v>
                </c:pt>
                <c:pt idx="411">
                  <c:v>4.6006424231784253</c:v>
                </c:pt>
                <c:pt idx="412">
                  <c:v>4.5983840999984524</c:v>
                </c:pt>
                <c:pt idx="413">
                  <c:v>4.5980128699320684</c:v>
                </c:pt>
                <c:pt idx="414">
                  <c:v>4.5975263826816137</c:v>
                </c:pt>
                <c:pt idx="415">
                  <c:v>4.5966744798862491</c:v>
                </c:pt>
                <c:pt idx="416">
                  <c:v>4.5964752195268126</c:v>
                </c:pt>
                <c:pt idx="417">
                  <c:v>4.5962314869405159</c:v>
                </c:pt>
                <c:pt idx="418">
                  <c:v>4.5959397203160304</c:v>
                </c:pt>
                <c:pt idx="419">
                  <c:v>4.5952114978375969</c:v>
                </c:pt>
                <c:pt idx="420">
                  <c:v>4.594951236041493</c:v>
                </c:pt>
                <c:pt idx="421">
                  <c:v>4.5949018140407691</c:v>
                </c:pt>
                <c:pt idx="422">
                  <c:v>4.5948635479837119</c:v>
                </c:pt>
                <c:pt idx="423">
                  <c:v>4.593064308496519</c:v>
                </c:pt>
                <c:pt idx="424">
                  <c:v>4.589773168247822</c:v>
                </c:pt>
                <c:pt idx="425">
                  <c:v>4.5889185882402099</c:v>
                </c:pt>
                <c:pt idx="426">
                  <c:v>4.5878642440435344</c:v>
                </c:pt>
                <c:pt idx="427">
                  <c:v>4.5874895218792409</c:v>
                </c:pt>
                <c:pt idx="428">
                  <c:v>4.5874126046167838</c:v>
                </c:pt>
                <c:pt idx="429">
                  <c:v>4.5872089233026543</c:v>
                </c:pt>
                <c:pt idx="430">
                  <c:v>4.5870180101642424</c:v>
                </c:pt>
                <c:pt idx="431">
                  <c:v>4.5833078693515663</c:v>
                </c:pt>
                <c:pt idx="432">
                  <c:v>4.5808099591666176</c:v>
                </c:pt>
                <c:pt idx="433">
                  <c:v>4.5804687839510017</c:v>
                </c:pt>
                <c:pt idx="434">
                  <c:v>4.5801438988386405</c:v>
                </c:pt>
                <c:pt idx="435">
                  <c:v>4.5795883106801902</c:v>
                </c:pt>
                <c:pt idx="436">
                  <c:v>4.578795342023132</c:v>
                </c:pt>
                <c:pt idx="437">
                  <c:v>4.5785642109831182</c:v>
                </c:pt>
                <c:pt idx="438">
                  <c:v>4.5781827763789007</c:v>
                </c:pt>
                <c:pt idx="439">
                  <c:v>4.5755365906663874</c:v>
                </c:pt>
                <c:pt idx="440">
                  <c:v>4.574611611947498</c:v>
                </c:pt>
                <c:pt idx="441">
                  <c:v>4.5742884225924305</c:v>
                </c:pt>
                <c:pt idx="442">
                  <c:v>4.5735076756334374</c:v>
                </c:pt>
                <c:pt idx="443">
                  <c:v>4.5731969431231168</c:v>
                </c:pt>
                <c:pt idx="444">
                  <c:v>4.5728632800785336</c:v>
                </c:pt>
                <c:pt idx="445">
                  <c:v>4.5715813838385149</c:v>
                </c:pt>
                <c:pt idx="446">
                  <c:v>4.5709669741751542</c:v>
                </c:pt>
                <c:pt idx="447">
                  <c:v>4.570540864395543</c:v>
                </c:pt>
                <c:pt idx="448">
                  <c:v>4.5685143557088086</c:v>
                </c:pt>
                <c:pt idx="449">
                  <c:v>4.5680704377399053</c:v>
                </c:pt>
                <c:pt idx="450">
                  <c:v>4.5680259492169473</c:v>
                </c:pt>
                <c:pt idx="451">
                  <c:v>4.5674107316796828</c:v>
                </c:pt>
                <c:pt idx="452">
                  <c:v>4.5672598625309675</c:v>
                </c:pt>
                <c:pt idx="453">
                  <c:v>4.5672152908920101</c:v>
                </c:pt>
                <c:pt idx="454">
                  <c:v>4.5664272125266523</c:v>
                </c:pt>
                <c:pt idx="455">
                  <c:v>4.5642936052118932</c:v>
                </c:pt>
                <c:pt idx="456">
                  <c:v>4.5631888865042241</c:v>
                </c:pt>
                <c:pt idx="457">
                  <c:v>4.5615918752372648</c:v>
                </c:pt>
                <c:pt idx="458">
                  <c:v>4.5611200091271629</c:v>
                </c:pt>
                <c:pt idx="459">
                  <c:v>4.5601161445066598</c:v>
                </c:pt>
                <c:pt idx="460">
                  <c:v>4.5600766804397708</c:v>
                </c:pt>
                <c:pt idx="461">
                  <c:v>4.558265385437819</c:v>
                </c:pt>
                <c:pt idx="462">
                  <c:v>4.5570360931944442</c:v>
                </c:pt>
                <c:pt idx="463">
                  <c:v>4.5561929080089909</c:v>
                </c:pt>
                <c:pt idx="464">
                  <c:v>4.5553854936668916</c:v>
                </c:pt>
                <c:pt idx="465">
                  <c:v>4.5537310239359687</c:v>
                </c:pt>
                <c:pt idx="466">
                  <c:v>4.551683619172433</c:v>
                </c:pt>
                <c:pt idx="467">
                  <c:v>4.550703709833563</c:v>
                </c:pt>
                <c:pt idx="468">
                  <c:v>4.5502379359731471</c:v>
                </c:pt>
                <c:pt idx="469">
                  <c:v>4.5499630057560561</c:v>
                </c:pt>
                <c:pt idx="470">
                  <c:v>4.5492189244202841</c:v>
                </c:pt>
                <c:pt idx="471">
                  <c:v>4.5492176982070474</c:v>
                </c:pt>
                <c:pt idx="472">
                  <c:v>4.5488179044131236</c:v>
                </c:pt>
                <c:pt idx="473">
                  <c:v>4.548181810838952</c:v>
                </c:pt>
                <c:pt idx="474">
                  <c:v>4.5480144102412821</c:v>
                </c:pt>
                <c:pt idx="475">
                  <c:v>4.5474743409739915</c:v>
                </c:pt>
                <c:pt idx="476">
                  <c:v>4.5472988670578047</c:v>
                </c:pt>
                <c:pt idx="477">
                  <c:v>4.5471410510155943</c:v>
                </c:pt>
                <c:pt idx="478">
                  <c:v>4.5466464266252311</c:v>
                </c:pt>
                <c:pt idx="479">
                  <c:v>4.5460548364687661</c:v>
                </c:pt>
                <c:pt idx="480">
                  <c:v>4.5457749098831233</c:v>
                </c:pt>
                <c:pt idx="481">
                  <c:v>4.544402597951076</c:v>
                </c:pt>
                <c:pt idx="482">
                  <c:v>4.5442415206844853</c:v>
                </c:pt>
                <c:pt idx="483">
                  <c:v>4.5439691104503872</c:v>
                </c:pt>
                <c:pt idx="484">
                  <c:v>4.5437145364649005</c:v>
                </c:pt>
                <c:pt idx="485">
                  <c:v>4.5428202419415769</c:v>
                </c:pt>
                <c:pt idx="486">
                  <c:v>4.5418934113973775</c:v>
                </c:pt>
                <c:pt idx="487">
                  <c:v>4.5412080214689281</c:v>
                </c:pt>
                <c:pt idx="488">
                  <c:v>4.5405882638827846</c:v>
                </c:pt>
                <c:pt idx="489">
                  <c:v>4.540461356242834</c:v>
                </c:pt>
                <c:pt idx="490">
                  <c:v>4.5403428246562187</c:v>
                </c:pt>
                <c:pt idx="491">
                  <c:v>4.5401074731368452</c:v>
                </c:pt>
                <c:pt idx="492">
                  <c:v>4.5396578365422391</c:v>
                </c:pt>
                <c:pt idx="493">
                  <c:v>4.5392823884829685</c:v>
                </c:pt>
                <c:pt idx="494">
                  <c:v>4.5373616211493628</c:v>
                </c:pt>
                <c:pt idx="495">
                  <c:v>4.5365900736565781</c:v>
                </c:pt>
                <c:pt idx="496">
                  <c:v>4.5358930950887233</c:v>
                </c:pt>
                <c:pt idx="497">
                  <c:v>4.5354876594214213</c:v>
                </c:pt>
                <c:pt idx="498">
                  <c:v>4.5354790110649477</c:v>
                </c:pt>
                <c:pt idx="499">
                  <c:v>4.5348640442584562</c:v>
                </c:pt>
                <c:pt idx="500">
                  <c:v>4.5339859622969927</c:v>
                </c:pt>
                <c:pt idx="501">
                  <c:v>4.5339835634311516</c:v>
                </c:pt>
                <c:pt idx="502">
                  <c:v>4.5338809642374294</c:v>
                </c:pt>
                <c:pt idx="503">
                  <c:v>4.5337107824266072</c:v>
                </c:pt>
                <c:pt idx="504">
                  <c:v>4.5329499019243267</c:v>
                </c:pt>
                <c:pt idx="505">
                  <c:v>4.5293929209500217</c:v>
                </c:pt>
                <c:pt idx="506">
                  <c:v>4.529177883690874</c:v>
                </c:pt>
                <c:pt idx="507">
                  <c:v>4.5291495607340266</c:v>
                </c:pt>
                <c:pt idx="508">
                  <c:v>4.528733921210053</c:v>
                </c:pt>
                <c:pt idx="509">
                  <c:v>4.5278984417821979</c:v>
                </c:pt>
                <c:pt idx="510">
                  <c:v>4.5271239316819507</c:v>
                </c:pt>
                <c:pt idx="511">
                  <c:v>4.526693935619206</c:v>
                </c:pt>
                <c:pt idx="512">
                  <c:v>4.525966146652693</c:v>
                </c:pt>
                <c:pt idx="513">
                  <c:v>4.525422975494247</c:v>
                </c:pt>
                <c:pt idx="514">
                  <c:v>4.5250318428289633</c:v>
                </c:pt>
                <c:pt idx="515">
                  <c:v>4.5245007700650106</c:v>
                </c:pt>
                <c:pt idx="516">
                  <c:v>4.524447259233872</c:v>
                </c:pt>
                <c:pt idx="517">
                  <c:v>4.5241608425882509</c:v>
                </c:pt>
                <c:pt idx="518">
                  <c:v>4.5240914825968197</c:v>
                </c:pt>
                <c:pt idx="519">
                  <c:v>4.5237923354797216</c:v>
                </c:pt>
                <c:pt idx="520">
                  <c:v>4.5231299119951487</c:v>
                </c:pt>
                <c:pt idx="521">
                  <c:v>4.5230230518355459</c:v>
                </c:pt>
                <c:pt idx="522">
                  <c:v>4.5227443103333069</c:v>
                </c:pt>
                <c:pt idx="523">
                  <c:v>4.5222840062387819</c:v>
                </c:pt>
                <c:pt idx="524">
                  <c:v>4.5221804176725602</c:v>
                </c:pt>
                <c:pt idx="525">
                  <c:v>4.5216590552950073</c:v>
                </c:pt>
                <c:pt idx="526">
                  <c:v>4.5212053011251383</c:v>
                </c:pt>
                <c:pt idx="527">
                  <c:v>4.5197042043946434</c:v>
                </c:pt>
                <c:pt idx="528">
                  <c:v>4.5195753472278204</c:v>
                </c:pt>
                <c:pt idx="529">
                  <c:v>4.5187880291781832</c:v>
                </c:pt>
                <c:pt idx="530">
                  <c:v>4.5184078391586207</c:v>
                </c:pt>
                <c:pt idx="531">
                  <c:v>4.5181086286297898</c:v>
                </c:pt>
                <c:pt idx="532">
                  <c:v>4.5179882278557777</c:v>
                </c:pt>
                <c:pt idx="533">
                  <c:v>4.5149765966551136</c:v>
                </c:pt>
                <c:pt idx="534">
                  <c:v>4.514965539790369</c:v>
                </c:pt>
                <c:pt idx="535">
                  <c:v>4.5133218685530778</c:v>
                </c:pt>
                <c:pt idx="536">
                  <c:v>4.5128608702974082</c:v>
                </c:pt>
                <c:pt idx="537">
                  <c:v>4.5121613689234703</c:v>
                </c:pt>
                <c:pt idx="538">
                  <c:v>4.5118623510111284</c:v>
                </c:pt>
                <c:pt idx="539">
                  <c:v>4.5115712249549649</c:v>
                </c:pt>
                <c:pt idx="540">
                  <c:v>4.5110377055010442</c:v>
                </c:pt>
                <c:pt idx="541">
                  <c:v>4.5100145522220032</c:v>
                </c:pt>
                <c:pt idx="542">
                  <c:v>4.5094538085683373</c:v>
                </c:pt>
                <c:pt idx="543">
                  <c:v>4.508630780742255</c:v>
                </c:pt>
                <c:pt idx="544">
                  <c:v>4.5075730686167885</c:v>
                </c:pt>
                <c:pt idx="545">
                  <c:v>4.5045219085414612</c:v>
                </c:pt>
                <c:pt idx="546">
                  <c:v>4.5041391435843829</c:v>
                </c:pt>
                <c:pt idx="547">
                  <c:v>4.5033342904216189</c:v>
                </c:pt>
                <c:pt idx="548">
                  <c:v>4.5019447580197829</c:v>
                </c:pt>
                <c:pt idx="549">
                  <c:v>4.5014159282921149</c:v>
                </c:pt>
                <c:pt idx="550">
                  <c:v>4.5011922854385729</c:v>
                </c:pt>
                <c:pt idx="551">
                  <c:v>4.5009450032320411</c:v>
                </c:pt>
                <c:pt idx="552">
                  <c:v>4.5007302581239212</c:v>
                </c:pt>
                <c:pt idx="553">
                  <c:v>4.4996806689394564</c:v>
                </c:pt>
                <c:pt idx="554">
                  <c:v>4.4991197930528015</c:v>
                </c:pt>
                <c:pt idx="555">
                  <c:v>4.4990648201855041</c:v>
                </c:pt>
                <c:pt idx="556">
                  <c:v>4.4984121070798642</c:v>
                </c:pt>
                <c:pt idx="557">
                  <c:v>4.4982506522539945</c:v>
                </c:pt>
                <c:pt idx="558">
                  <c:v>4.4974633516134279</c:v>
                </c:pt>
                <c:pt idx="559">
                  <c:v>4.4960511810783865</c:v>
                </c:pt>
                <c:pt idx="560">
                  <c:v>4.4925599528835818</c:v>
                </c:pt>
                <c:pt idx="561">
                  <c:v>4.4918651990137937</c:v>
                </c:pt>
                <c:pt idx="562">
                  <c:v>4.4913591254184517</c:v>
                </c:pt>
                <c:pt idx="563">
                  <c:v>4.4907894959867987</c:v>
                </c:pt>
                <c:pt idx="564">
                  <c:v>4.4907577760305726</c:v>
                </c:pt>
                <c:pt idx="565">
                  <c:v>4.490368140832274</c:v>
                </c:pt>
                <c:pt idx="566">
                  <c:v>4.4894276631248804</c:v>
                </c:pt>
                <c:pt idx="567">
                  <c:v>4.486341044500274</c:v>
                </c:pt>
                <c:pt idx="568">
                  <c:v>4.4862253666004737</c:v>
                </c:pt>
                <c:pt idx="569">
                  <c:v>4.4861569218037518</c:v>
                </c:pt>
                <c:pt idx="570">
                  <c:v>4.4857653425665465</c:v>
                </c:pt>
                <c:pt idx="571">
                  <c:v>4.485534437754704</c:v>
                </c:pt>
                <c:pt idx="572">
                  <c:v>4.4851532709524955</c:v>
                </c:pt>
                <c:pt idx="573">
                  <c:v>4.48379690578279</c:v>
                </c:pt>
                <c:pt idx="574">
                  <c:v>4.4818180743603291</c:v>
                </c:pt>
                <c:pt idx="575">
                  <c:v>4.4803040406271322</c:v>
                </c:pt>
                <c:pt idx="576">
                  <c:v>4.4788655411921114</c:v>
                </c:pt>
                <c:pt idx="577">
                  <c:v>4.4785551932094263</c:v>
                </c:pt>
                <c:pt idx="578">
                  <c:v>4.4780392188434899</c:v>
                </c:pt>
                <c:pt idx="579">
                  <c:v>4.4767101693879603</c:v>
                </c:pt>
                <c:pt idx="580">
                  <c:v>4.4760950277977338</c:v>
                </c:pt>
                <c:pt idx="581">
                  <c:v>4.4743533965720106</c:v>
                </c:pt>
                <c:pt idx="582">
                  <c:v>4.473983833291209</c:v>
                </c:pt>
                <c:pt idx="583">
                  <c:v>4.4739630947450584</c:v>
                </c:pt>
                <c:pt idx="584">
                  <c:v>4.4735108130286756</c:v>
                </c:pt>
                <c:pt idx="585">
                  <c:v>4.4731307106164655</c:v>
                </c:pt>
                <c:pt idx="586">
                  <c:v>4.4730722662286544</c:v>
                </c:pt>
                <c:pt idx="587">
                  <c:v>4.473062524732649</c:v>
                </c:pt>
                <c:pt idx="588">
                  <c:v>4.472191889639876</c:v>
                </c:pt>
                <c:pt idx="589">
                  <c:v>4.4717354786354697</c:v>
                </c:pt>
                <c:pt idx="590">
                  <c:v>4.4707866969338079</c:v>
                </c:pt>
                <c:pt idx="591">
                  <c:v>4.4700841493023686</c:v>
                </c:pt>
                <c:pt idx="592">
                  <c:v>4.4699695365411269</c:v>
                </c:pt>
                <c:pt idx="593">
                  <c:v>4.4694111639630503</c:v>
                </c:pt>
                <c:pt idx="594">
                  <c:v>4.4691760646397407</c:v>
                </c:pt>
                <c:pt idx="595">
                  <c:v>4.4683681747340005</c:v>
                </c:pt>
                <c:pt idx="596">
                  <c:v>4.4682641072828817</c:v>
                </c:pt>
                <c:pt idx="597">
                  <c:v>4.4681469605329873</c:v>
                </c:pt>
                <c:pt idx="598">
                  <c:v>4.4663047480538633</c:v>
                </c:pt>
                <c:pt idx="599">
                  <c:v>4.4660100431120311</c:v>
                </c:pt>
                <c:pt idx="600">
                  <c:v>4.4657335496862425</c:v>
                </c:pt>
                <c:pt idx="601">
                  <c:v>4.4657101015504468</c:v>
                </c:pt>
                <c:pt idx="602">
                  <c:v>4.4656338037840611</c:v>
                </c:pt>
                <c:pt idx="603">
                  <c:v>4.4652325245091449</c:v>
                </c:pt>
                <c:pt idx="604">
                  <c:v>4.4652180593051396</c:v>
                </c:pt>
                <c:pt idx="605">
                  <c:v>4.4646933494155601</c:v>
                </c:pt>
                <c:pt idx="606">
                  <c:v>4.4637741594445144</c:v>
                </c:pt>
                <c:pt idx="607">
                  <c:v>4.4635981357892618</c:v>
                </c:pt>
                <c:pt idx="608">
                  <c:v>4.4630760326667902</c:v>
                </c:pt>
                <c:pt idx="609">
                  <c:v>4.4625523031009351</c:v>
                </c:pt>
                <c:pt idx="610">
                  <c:v>4.4609323211305068</c:v>
                </c:pt>
                <c:pt idx="611">
                  <c:v>4.4600124059570341</c:v>
                </c:pt>
                <c:pt idx="612">
                  <c:v>4.4594954361888117</c:v>
                </c:pt>
                <c:pt idx="613">
                  <c:v>4.4591927199763779</c:v>
                </c:pt>
                <c:pt idx="614">
                  <c:v>4.4590796395141883</c:v>
                </c:pt>
                <c:pt idx="615">
                  <c:v>4.4590765375595565</c:v>
                </c:pt>
                <c:pt idx="616">
                  <c:v>4.4574639625867789</c:v>
                </c:pt>
                <c:pt idx="617">
                  <c:v>4.4573795531542348</c:v>
                </c:pt>
                <c:pt idx="618">
                  <c:v>4.4573491684756119</c:v>
                </c:pt>
                <c:pt idx="619">
                  <c:v>4.4571356582705484</c:v>
                </c:pt>
                <c:pt idx="620">
                  <c:v>4.4571247947324943</c:v>
                </c:pt>
                <c:pt idx="621">
                  <c:v>4.4565976288350768</c:v>
                </c:pt>
                <c:pt idx="622">
                  <c:v>4.4561509416777891</c:v>
                </c:pt>
                <c:pt idx="623">
                  <c:v>4.4559042443649552</c:v>
                </c:pt>
                <c:pt idx="624">
                  <c:v>4.4557842221466073</c:v>
                </c:pt>
                <c:pt idx="625">
                  <c:v>4.4557677492325798</c:v>
                </c:pt>
                <c:pt idx="626">
                  <c:v>4.4556224226151615</c:v>
                </c:pt>
                <c:pt idx="627">
                  <c:v>4.455346421674415</c:v>
                </c:pt>
                <c:pt idx="628">
                  <c:v>4.4550766758257447</c:v>
                </c:pt>
                <c:pt idx="629">
                  <c:v>4.4541031326480107</c:v>
                </c:pt>
                <c:pt idx="630">
                  <c:v>4.4540151835471713</c:v>
                </c:pt>
                <c:pt idx="631">
                  <c:v>4.4526272690755633</c:v>
                </c:pt>
                <c:pt idx="632">
                  <c:v>4.4523309656286312</c:v>
                </c:pt>
                <c:pt idx="633">
                  <c:v>4.4512961922249872</c:v>
                </c:pt>
                <c:pt idx="634">
                  <c:v>4.4510362164435131</c:v>
                </c:pt>
                <c:pt idx="635">
                  <c:v>4.4492002656803598</c:v>
                </c:pt>
                <c:pt idx="636">
                  <c:v>4.4480987586525726</c:v>
                </c:pt>
                <c:pt idx="637">
                  <c:v>4.447382617253294</c:v>
                </c:pt>
                <c:pt idx="638">
                  <c:v>4.4472148133569629</c:v>
                </c:pt>
                <c:pt idx="639">
                  <c:v>4.446963158297768</c:v>
                </c:pt>
                <c:pt idx="640">
                  <c:v>4.4458346934911344</c:v>
                </c:pt>
                <c:pt idx="641">
                  <c:v>4.445716697090182</c:v>
                </c:pt>
                <c:pt idx="642">
                  <c:v>4.4456852259680604</c:v>
                </c:pt>
                <c:pt idx="643">
                  <c:v>4.4450121146952508</c:v>
                </c:pt>
                <c:pt idx="644">
                  <c:v>4.4449779943848524</c:v>
                </c:pt>
                <c:pt idx="645">
                  <c:v>4.4441938746288328</c:v>
                </c:pt>
                <c:pt idx="646">
                  <c:v>4.4439833446296158</c:v>
                </c:pt>
                <c:pt idx="647">
                  <c:v>4.443834714610106</c:v>
                </c:pt>
                <c:pt idx="648">
                  <c:v>4.4436300046257582</c:v>
                </c:pt>
                <c:pt idx="649">
                  <c:v>4.4435896939631165</c:v>
                </c:pt>
                <c:pt idx="650">
                  <c:v>4.4431390719570523</c:v>
                </c:pt>
                <c:pt idx="651">
                  <c:v>4.4429623986284899</c:v>
                </c:pt>
                <c:pt idx="652">
                  <c:v>4.4426613404081774</c:v>
                </c:pt>
                <c:pt idx="653">
                  <c:v>4.4420847525527929</c:v>
                </c:pt>
                <c:pt idx="654">
                  <c:v>4.4413991351355939</c:v>
                </c:pt>
                <c:pt idx="655">
                  <c:v>4.4413990478157972</c:v>
                </c:pt>
                <c:pt idx="656">
                  <c:v>4.4412278672658845</c:v>
                </c:pt>
                <c:pt idx="657">
                  <c:v>4.4398417920400757</c:v>
                </c:pt>
                <c:pt idx="658">
                  <c:v>4.4396205488144567</c:v>
                </c:pt>
                <c:pt idx="659">
                  <c:v>4.4396074845772304</c:v>
                </c:pt>
                <c:pt idx="660">
                  <c:v>4.4393533990938039</c:v>
                </c:pt>
                <c:pt idx="661">
                  <c:v>4.4388723610082454</c:v>
                </c:pt>
                <c:pt idx="662">
                  <c:v>4.4384209473469065</c:v>
                </c:pt>
                <c:pt idx="663">
                  <c:v>4.4382975771626088</c:v>
                </c:pt>
                <c:pt idx="664">
                  <c:v>4.4376031312774256</c:v>
                </c:pt>
                <c:pt idx="665">
                  <c:v>4.4373720192665127</c:v>
                </c:pt>
                <c:pt idx="666">
                  <c:v>4.4372464112222056</c:v>
                </c:pt>
                <c:pt idx="667">
                  <c:v>4.4370301039640712</c:v>
                </c:pt>
                <c:pt idx="668">
                  <c:v>4.4369720627328979</c:v>
                </c:pt>
                <c:pt idx="669">
                  <c:v>4.4368257785366882</c:v>
                </c:pt>
                <c:pt idx="670">
                  <c:v>4.4361219907907037</c:v>
                </c:pt>
                <c:pt idx="671">
                  <c:v>4.4356562052467412</c:v>
                </c:pt>
                <c:pt idx="672">
                  <c:v>4.4356062984543154</c:v>
                </c:pt>
                <c:pt idx="673">
                  <c:v>4.4350121087958723</c:v>
                </c:pt>
                <c:pt idx="674">
                  <c:v>4.4341555244160267</c:v>
                </c:pt>
                <c:pt idx="675">
                  <c:v>4.4336819352733512</c:v>
                </c:pt>
                <c:pt idx="676">
                  <c:v>4.4336040647825889</c:v>
                </c:pt>
                <c:pt idx="677">
                  <c:v>4.4327983172067666</c:v>
                </c:pt>
                <c:pt idx="678">
                  <c:v>4.4326347606566046</c:v>
                </c:pt>
                <c:pt idx="679">
                  <c:v>4.4324864731683098</c:v>
                </c:pt>
                <c:pt idx="680">
                  <c:v>4.4324672205983395</c:v>
                </c:pt>
                <c:pt idx="681">
                  <c:v>4.4322819601307915</c:v>
                </c:pt>
                <c:pt idx="682">
                  <c:v>4.4314337281896758</c:v>
                </c:pt>
                <c:pt idx="683">
                  <c:v>4.4305394313045277</c:v>
                </c:pt>
                <c:pt idx="684">
                  <c:v>4.4300757725638649</c:v>
                </c:pt>
                <c:pt idx="685">
                  <c:v>4.4294349192210385</c:v>
                </c:pt>
                <c:pt idx="686">
                  <c:v>4.4294061057004406</c:v>
                </c:pt>
                <c:pt idx="687">
                  <c:v>4.4292411765891764</c:v>
                </c:pt>
                <c:pt idx="688">
                  <c:v>4.4288766200121321</c:v>
                </c:pt>
                <c:pt idx="689">
                  <c:v>4.4276850520464528</c:v>
                </c:pt>
                <c:pt idx="690">
                  <c:v>4.4246763231926778</c:v>
                </c:pt>
                <c:pt idx="691">
                  <c:v>4.4241396730349578</c:v>
                </c:pt>
                <c:pt idx="692">
                  <c:v>4.423527755187239</c:v>
                </c:pt>
                <c:pt idx="693">
                  <c:v>4.4234076344355628</c:v>
                </c:pt>
                <c:pt idx="694">
                  <c:v>4.4228310475677093</c:v>
                </c:pt>
                <c:pt idx="695">
                  <c:v>4.4227532120987352</c:v>
                </c:pt>
                <c:pt idx="696">
                  <c:v>4.4226953277353509</c:v>
                </c:pt>
                <c:pt idx="697">
                  <c:v>4.4222025882055069</c:v>
                </c:pt>
                <c:pt idx="698">
                  <c:v>4.4201187388755718</c:v>
                </c:pt>
                <c:pt idx="699">
                  <c:v>4.419898040551721</c:v>
                </c:pt>
                <c:pt idx="700">
                  <c:v>4.4191177264013728</c:v>
                </c:pt>
                <c:pt idx="701">
                  <c:v>4.4186534832272315</c:v>
                </c:pt>
                <c:pt idx="702">
                  <c:v>4.4183492673433982</c:v>
                </c:pt>
                <c:pt idx="703">
                  <c:v>4.41756865359201</c:v>
                </c:pt>
                <c:pt idx="704">
                  <c:v>4.4173632675141112</c:v>
                </c:pt>
                <c:pt idx="705">
                  <c:v>4.4172845381155108</c:v>
                </c:pt>
                <c:pt idx="706">
                  <c:v>4.4168527032832241</c:v>
                </c:pt>
                <c:pt idx="707">
                  <c:v>4.4168242439940206</c:v>
                </c:pt>
                <c:pt idx="708">
                  <c:v>4.4158655185773927</c:v>
                </c:pt>
                <c:pt idx="709">
                  <c:v>4.4147810280082771</c:v>
                </c:pt>
                <c:pt idx="710">
                  <c:v>4.414342513448652</c:v>
                </c:pt>
                <c:pt idx="711">
                  <c:v>4.4137799053997648</c:v>
                </c:pt>
                <c:pt idx="712">
                  <c:v>4.4132139586903216</c:v>
                </c:pt>
                <c:pt idx="713">
                  <c:v>4.411873531325849</c:v>
                </c:pt>
                <c:pt idx="714">
                  <c:v>4.4117697753473193</c:v>
                </c:pt>
                <c:pt idx="715">
                  <c:v>4.4108865662504195</c:v>
                </c:pt>
                <c:pt idx="716">
                  <c:v>4.4104442872310115</c:v>
                </c:pt>
                <c:pt idx="717">
                  <c:v>4.4098163193990008</c:v>
                </c:pt>
                <c:pt idx="718">
                  <c:v>4.4086055875978243</c:v>
                </c:pt>
                <c:pt idx="719">
                  <c:v>4.4072255219007292</c:v>
                </c:pt>
                <c:pt idx="720">
                  <c:v>4.4071957633540801</c:v>
                </c:pt>
                <c:pt idx="721">
                  <c:v>4.4071448384440686</c:v>
                </c:pt>
                <c:pt idx="722">
                  <c:v>4.4068486186597697</c:v>
                </c:pt>
                <c:pt idx="723">
                  <c:v>4.4059401748375926</c:v>
                </c:pt>
                <c:pt idx="724">
                  <c:v>4.4051382429000432</c:v>
                </c:pt>
                <c:pt idx="725">
                  <c:v>4.4047441317692941</c:v>
                </c:pt>
                <c:pt idx="726">
                  <c:v>4.404401011459619</c:v>
                </c:pt>
                <c:pt idx="727">
                  <c:v>4.4032663105506726</c:v>
                </c:pt>
                <c:pt idx="728">
                  <c:v>4.4027872816715332</c:v>
                </c:pt>
                <c:pt idx="729">
                  <c:v>4.4026430498452047</c:v>
                </c:pt>
                <c:pt idx="730">
                  <c:v>4.4015870099267813</c:v>
                </c:pt>
                <c:pt idx="731">
                  <c:v>4.401156133504041</c:v>
                </c:pt>
                <c:pt idx="732">
                  <c:v>4.4008259845216706</c:v>
                </c:pt>
                <c:pt idx="733">
                  <c:v>4.4007897438914245</c:v>
                </c:pt>
                <c:pt idx="734">
                  <c:v>4.4005393324697781</c:v>
                </c:pt>
                <c:pt idx="735">
                  <c:v>4.4000498893991988</c:v>
                </c:pt>
                <c:pt idx="736">
                  <c:v>4.39988091837402</c:v>
                </c:pt>
                <c:pt idx="737">
                  <c:v>4.39979837821123</c:v>
                </c:pt>
                <c:pt idx="738">
                  <c:v>4.3994495953901254</c:v>
                </c:pt>
                <c:pt idx="739">
                  <c:v>4.3989458271819215</c:v>
                </c:pt>
                <c:pt idx="740">
                  <c:v>4.3989231029431419</c:v>
                </c:pt>
                <c:pt idx="741">
                  <c:v>4.3982617499297811</c:v>
                </c:pt>
                <c:pt idx="742">
                  <c:v>4.3978198372408963</c:v>
                </c:pt>
                <c:pt idx="743">
                  <c:v>4.3977078403528695</c:v>
                </c:pt>
                <c:pt idx="744">
                  <c:v>4.3966597535602983</c:v>
                </c:pt>
                <c:pt idx="745">
                  <c:v>4.3953398887087527</c:v>
                </c:pt>
                <c:pt idx="746">
                  <c:v>4.3949374608395084</c:v>
                </c:pt>
                <c:pt idx="747">
                  <c:v>4.394704945412335</c:v>
                </c:pt>
                <c:pt idx="748">
                  <c:v>4.3946340578842458</c:v>
                </c:pt>
                <c:pt idx="749">
                  <c:v>4.3945321307078329</c:v>
                </c:pt>
                <c:pt idx="750">
                  <c:v>4.3935904106215542</c:v>
                </c:pt>
                <c:pt idx="751">
                  <c:v>4.3933012822904347</c:v>
                </c:pt>
                <c:pt idx="752">
                  <c:v>4.3926463509996871</c:v>
                </c:pt>
                <c:pt idx="753">
                  <c:v>4.3925341844333605</c:v>
                </c:pt>
                <c:pt idx="754">
                  <c:v>4.3918133020304611</c:v>
                </c:pt>
                <c:pt idx="755">
                  <c:v>4.3912982404213077</c:v>
                </c:pt>
                <c:pt idx="756">
                  <c:v>4.3910984762381791</c:v>
                </c:pt>
                <c:pt idx="757">
                  <c:v>4.3906548045310902</c:v>
                </c:pt>
                <c:pt idx="758">
                  <c:v>4.3905629334588472</c:v>
                </c:pt>
                <c:pt idx="759">
                  <c:v>4.3905192486212057</c:v>
                </c:pt>
                <c:pt idx="760">
                  <c:v>4.3897371850885474</c:v>
                </c:pt>
                <c:pt idx="761">
                  <c:v>4.3890613880646274</c:v>
                </c:pt>
                <c:pt idx="762">
                  <c:v>4.3889922333000522</c:v>
                </c:pt>
                <c:pt idx="763">
                  <c:v>4.3883444812767465</c:v>
                </c:pt>
                <c:pt idx="764">
                  <c:v>4.3880106647564423</c:v>
                </c:pt>
                <c:pt idx="765">
                  <c:v>4.3876607803166632</c:v>
                </c:pt>
                <c:pt idx="766">
                  <c:v>4.3874364966441632</c:v>
                </c:pt>
                <c:pt idx="767">
                  <c:v>4.3873119983825655</c:v>
                </c:pt>
                <c:pt idx="768">
                  <c:v>4.3868148363030892</c:v>
                </c:pt>
                <c:pt idx="769">
                  <c:v>4.3862991619702356</c:v>
                </c:pt>
                <c:pt idx="770">
                  <c:v>4.385972003228753</c:v>
                </c:pt>
                <c:pt idx="771">
                  <c:v>4.3854734032481559</c:v>
                </c:pt>
                <c:pt idx="772">
                  <c:v>4.3834086975401849</c:v>
                </c:pt>
                <c:pt idx="773">
                  <c:v>4.3821250521362405</c:v>
                </c:pt>
                <c:pt idx="774">
                  <c:v>4.3820058296634121</c:v>
                </c:pt>
                <c:pt idx="775">
                  <c:v>4.3811556089575081</c:v>
                </c:pt>
                <c:pt idx="776">
                  <c:v>4.3810774582831886</c:v>
                </c:pt>
                <c:pt idx="777">
                  <c:v>4.3795359520305848</c:v>
                </c:pt>
                <c:pt idx="778">
                  <c:v>4.3772402598499189</c:v>
                </c:pt>
                <c:pt idx="779">
                  <c:v>4.3771446965096494</c:v>
                </c:pt>
                <c:pt idx="780">
                  <c:v>4.3768698347157207</c:v>
                </c:pt>
                <c:pt idx="781">
                  <c:v>4.3764089446466681</c:v>
                </c:pt>
                <c:pt idx="782">
                  <c:v>4.3763184729049946</c:v>
                </c:pt>
                <c:pt idx="783">
                  <c:v>4.3760890648860347</c:v>
                </c:pt>
                <c:pt idx="784">
                  <c:v>4.3760646051360439</c:v>
                </c:pt>
                <c:pt idx="785">
                  <c:v>4.3751724565815984</c:v>
                </c:pt>
                <c:pt idx="786">
                  <c:v>4.3748700861421144</c:v>
                </c:pt>
                <c:pt idx="787">
                  <c:v>4.3741788902833285</c:v>
                </c:pt>
                <c:pt idx="788">
                  <c:v>4.3739741520320763</c:v>
                </c:pt>
                <c:pt idx="789">
                  <c:v>4.3729094470863972</c:v>
                </c:pt>
                <c:pt idx="790">
                  <c:v>4.3721841955737428</c:v>
                </c:pt>
                <c:pt idx="791">
                  <c:v>4.3713033236172985</c:v>
                </c:pt>
                <c:pt idx="792">
                  <c:v>4.3711903304202213</c:v>
                </c:pt>
                <c:pt idx="793">
                  <c:v>4.3709242030577071</c:v>
                </c:pt>
                <c:pt idx="794">
                  <c:v>4.370246443920168</c:v>
                </c:pt>
                <c:pt idx="795">
                  <c:v>4.3702186696271168</c:v>
                </c:pt>
                <c:pt idx="796">
                  <c:v>4.3701583830126776</c:v>
                </c:pt>
                <c:pt idx="797">
                  <c:v>4.3698868866875697</c:v>
                </c:pt>
                <c:pt idx="798">
                  <c:v>4.3695816366437938</c:v>
                </c:pt>
                <c:pt idx="799">
                  <c:v>4.3672612647513533</c:v>
                </c:pt>
                <c:pt idx="800">
                  <c:v>4.3670949967372819</c:v>
                </c:pt>
                <c:pt idx="801">
                  <c:v>4.366992096232031</c:v>
                </c:pt>
                <c:pt idx="802">
                  <c:v>4.3661862878720159</c:v>
                </c:pt>
                <c:pt idx="803">
                  <c:v>4.3643166403181981</c:v>
                </c:pt>
                <c:pt idx="804">
                  <c:v>4.3641418342195379</c:v>
                </c:pt>
                <c:pt idx="805">
                  <c:v>4.3641284809806598</c:v>
                </c:pt>
                <c:pt idx="806">
                  <c:v>4.362893096844199</c:v>
                </c:pt>
                <c:pt idx="807">
                  <c:v>4.3627968348915944</c:v>
                </c:pt>
                <c:pt idx="808">
                  <c:v>4.3627211705773759</c:v>
                </c:pt>
                <c:pt idx="809">
                  <c:v>4.3621257569400989</c:v>
                </c:pt>
                <c:pt idx="810">
                  <c:v>4.362064021832242</c:v>
                </c:pt>
                <c:pt idx="811">
                  <c:v>4.3613014097116078</c:v>
                </c:pt>
                <c:pt idx="812">
                  <c:v>4.3608896996328657</c:v>
                </c:pt>
                <c:pt idx="813">
                  <c:v>4.3606087690513995</c:v>
                </c:pt>
                <c:pt idx="814">
                  <c:v>4.3605509202119395</c:v>
                </c:pt>
                <c:pt idx="815">
                  <c:v>4.3604814914316936</c:v>
                </c:pt>
                <c:pt idx="816">
                  <c:v>4.3596538034692172</c:v>
                </c:pt>
                <c:pt idx="817">
                  <c:v>4.3593111045759567</c:v>
                </c:pt>
                <c:pt idx="818">
                  <c:v>4.3591918874213107</c:v>
                </c:pt>
                <c:pt idx="819">
                  <c:v>4.3589230539910924</c:v>
                </c:pt>
                <c:pt idx="820">
                  <c:v>4.3585661467284789</c:v>
                </c:pt>
                <c:pt idx="821">
                  <c:v>4.3581243332929622</c:v>
                </c:pt>
                <c:pt idx="822">
                  <c:v>4.3570694175729434</c:v>
                </c:pt>
                <c:pt idx="823">
                  <c:v>4.3564635448535016</c:v>
                </c:pt>
                <c:pt idx="824">
                  <c:v>4.3563557574038603</c:v>
                </c:pt>
                <c:pt idx="825">
                  <c:v>4.3561906792513732</c:v>
                </c:pt>
                <c:pt idx="826">
                  <c:v>4.3547378592807195</c:v>
                </c:pt>
                <c:pt idx="827">
                  <c:v>4.3544871606745881</c:v>
                </c:pt>
                <c:pt idx="828">
                  <c:v>4.3544003261427919</c:v>
                </c:pt>
                <c:pt idx="829">
                  <c:v>4.3540057251112678</c:v>
                </c:pt>
                <c:pt idx="830">
                  <c:v>4.3539088612451122</c:v>
                </c:pt>
                <c:pt idx="831">
                  <c:v>4.3537058790087402</c:v>
                </c:pt>
                <c:pt idx="832">
                  <c:v>4.3535305969710647</c:v>
                </c:pt>
                <c:pt idx="833">
                  <c:v>4.3527935318259763</c:v>
                </c:pt>
                <c:pt idx="834">
                  <c:v>4.3527604420902568</c:v>
                </c:pt>
                <c:pt idx="835">
                  <c:v>4.351541219223332</c:v>
                </c:pt>
                <c:pt idx="836">
                  <c:v>4.3515317686537429</c:v>
                </c:pt>
                <c:pt idx="837">
                  <c:v>4.3514964345888423</c:v>
                </c:pt>
                <c:pt idx="838">
                  <c:v>4.3512764180504151</c:v>
                </c:pt>
                <c:pt idx="839">
                  <c:v>4.3492966347093969</c:v>
                </c:pt>
                <c:pt idx="840">
                  <c:v>4.3491047684852573</c:v>
                </c:pt>
                <c:pt idx="841">
                  <c:v>4.3485772124884505</c:v>
                </c:pt>
                <c:pt idx="842">
                  <c:v>4.3484361918444909</c:v>
                </c:pt>
                <c:pt idx="843">
                  <c:v>4.3456584829536471</c:v>
                </c:pt>
                <c:pt idx="844">
                  <c:v>4.3453704627177352</c:v>
                </c:pt>
                <c:pt idx="845">
                  <c:v>4.3447445447004522</c:v>
                </c:pt>
                <c:pt idx="846">
                  <c:v>4.3447443265292796</c:v>
                </c:pt>
                <c:pt idx="847">
                  <c:v>4.344244536031967</c:v>
                </c:pt>
                <c:pt idx="848">
                  <c:v>4.3435171265063186</c:v>
                </c:pt>
                <c:pt idx="849">
                  <c:v>4.3420290053268511</c:v>
                </c:pt>
                <c:pt idx="850">
                  <c:v>4.3418166586642792</c:v>
                </c:pt>
                <c:pt idx="851">
                  <c:v>4.3416184919263827</c:v>
                </c:pt>
                <c:pt idx="852">
                  <c:v>4.3405249729009325</c:v>
                </c:pt>
                <c:pt idx="853">
                  <c:v>4.340291501053037</c:v>
                </c:pt>
                <c:pt idx="854">
                  <c:v>4.3392942806468167</c:v>
                </c:pt>
                <c:pt idx="855">
                  <c:v>4.3388374962052998</c:v>
                </c:pt>
                <c:pt idx="856">
                  <c:v>4.338398495259951</c:v>
                </c:pt>
                <c:pt idx="857">
                  <c:v>4.3380814705151014</c:v>
                </c:pt>
                <c:pt idx="858">
                  <c:v>4.3369120273159902</c:v>
                </c:pt>
                <c:pt idx="859">
                  <c:v>4.3364399421999762</c:v>
                </c:pt>
                <c:pt idx="860">
                  <c:v>4.3361928042261724</c:v>
                </c:pt>
                <c:pt idx="861">
                  <c:v>4.3347035550030899</c:v>
                </c:pt>
                <c:pt idx="862">
                  <c:v>4.3346948472279099</c:v>
                </c:pt>
                <c:pt idx="863">
                  <c:v>4.334245601838596</c:v>
                </c:pt>
                <c:pt idx="864">
                  <c:v>4.3340744715205819</c:v>
                </c:pt>
                <c:pt idx="865">
                  <c:v>4.332947979988667</c:v>
                </c:pt>
                <c:pt idx="866">
                  <c:v>4.3322130620761561</c:v>
                </c:pt>
                <c:pt idx="867">
                  <c:v>4.3314716123186727</c:v>
                </c:pt>
                <c:pt idx="868">
                  <c:v>4.3310332044629387</c:v>
                </c:pt>
                <c:pt idx="869">
                  <c:v>4.3296763578179442</c:v>
                </c:pt>
                <c:pt idx="870">
                  <c:v>4.3294132483447676</c:v>
                </c:pt>
                <c:pt idx="871">
                  <c:v>4.3289436838511559</c:v>
                </c:pt>
                <c:pt idx="872">
                  <c:v>4.3288793095428701</c:v>
                </c:pt>
                <c:pt idx="873">
                  <c:v>4.3282581561817306</c:v>
                </c:pt>
                <c:pt idx="874">
                  <c:v>4.3278604960522351</c:v>
                </c:pt>
                <c:pt idx="875">
                  <c:v>4.32688134534631</c:v>
                </c:pt>
                <c:pt idx="876">
                  <c:v>4.3263243660851547</c:v>
                </c:pt>
                <c:pt idx="877">
                  <c:v>4.3259354107210042</c:v>
                </c:pt>
                <c:pt idx="878">
                  <c:v>4.3254853319290181</c:v>
                </c:pt>
                <c:pt idx="879">
                  <c:v>4.3254131437182144</c:v>
                </c:pt>
                <c:pt idx="880">
                  <c:v>4.3243698085405455</c:v>
                </c:pt>
                <c:pt idx="881">
                  <c:v>4.3236388843828424</c:v>
                </c:pt>
                <c:pt idx="882">
                  <c:v>4.3226785078551648</c:v>
                </c:pt>
                <c:pt idx="883">
                  <c:v>4.3221586271405164</c:v>
                </c:pt>
                <c:pt idx="884">
                  <c:v>4.3215404378215272</c:v>
                </c:pt>
                <c:pt idx="885">
                  <c:v>4.3202772935257245</c:v>
                </c:pt>
                <c:pt idx="886">
                  <c:v>4.3202725617872249</c:v>
                </c:pt>
                <c:pt idx="887">
                  <c:v>4.3202502873012527</c:v>
                </c:pt>
                <c:pt idx="888">
                  <c:v>4.3200066937621129</c:v>
                </c:pt>
                <c:pt idx="889">
                  <c:v>4.3198784925326121</c:v>
                </c:pt>
                <c:pt idx="890">
                  <c:v>4.3196165441016499</c:v>
                </c:pt>
                <c:pt idx="891">
                  <c:v>4.3195533154089718</c:v>
                </c:pt>
                <c:pt idx="892">
                  <c:v>4.3192273161926389</c:v>
                </c:pt>
                <c:pt idx="893">
                  <c:v>4.3191882122324472</c:v>
                </c:pt>
                <c:pt idx="894">
                  <c:v>4.319070300578173</c:v>
                </c:pt>
                <c:pt idx="895">
                  <c:v>4.3181215617830899</c:v>
                </c:pt>
                <c:pt idx="896">
                  <c:v>4.3179933828624106</c:v>
                </c:pt>
                <c:pt idx="897">
                  <c:v>4.3172518711065857</c:v>
                </c:pt>
                <c:pt idx="898">
                  <c:v>4.3171600520269742</c:v>
                </c:pt>
                <c:pt idx="899">
                  <c:v>4.3164030256373014</c:v>
                </c:pt>
                <c:pt idx="900">
                  <c:v>4.316095860102819</c:v>
                </c:pt>
                <c:pt idx="901">
                  <c:v>4.3157025295569964</c:v>
                </c:pt>
                <c:pt idx="902">
                  <c:v>4.3155748012198076</c:v>
                </c:pt>
                <c:pt idx="903">
                  <c:v>4.3146595413912054</c:v>
                </c:pt>
                <c:pt idx="904">
                  <c:v>4.3126287475916234</c:v>
                </c:pt>
                <c:pt idx="905">
                  <c:v>4.3122246211359272</c:v>
                </c:pt>
                <c:pt idx="906">
                  <c:v>4.3116651099718375</c:v>
                </c:pt>
                <c:pt idx="907">
                  <c:v>4.311560445137939</c:v>
                </c:pt>
                <c:pt idx="908">
                  <c:v>4.310794293831572</c:v>
                </c:pt>
                <c:pt idx="909">
                  <c:v>4.310695436027566</c:v>
                </c:pt>
                <c:pt idx="910">
                  <c:v>4.3102288019186208</c:v>
                </c:pt>
                <c:pt idx="911">
                  <c:v>4.3101149299122072</c:v>
                </c:pt>
                <c:pt idx="912">
                  <c:v>4.3094985108275985</c:v>
                </c:pt>
                <c:pt idx="913">
                  <c:v>4.308900052864737</c:v>
                </c:pt>
                <c:pt idx="914">
                  <c:v>4.3086170521264693</c:v>
                </c:pt>
                <c:pt idx="915">
                  <c:v>4.3077618341620463</c:v>
                </c:pt>
                <c:pt idx="916">
                  <c:v>4.3075017428935665</c:v>
                </c:pt>
                <c:pt idx="917">
                  <c:v>4.3072630205180298</c:v>
                </c:pt>
                <c:pt idx="918">
                  <c:v>4.3071295736564901</c:v>
                </c:pt>
                <c:pt idx="919">
                  <c:v>4.3063611595234308</c:v>
                </c:pt>
                <c:pt idx="920">
                  <c:v>4.3063285069409103</c:v>
                </c:pt>
                <c:pt idx="921">
                  <c:v>4.3041552946561836</c:v>
                </c:pt>
                <c:pt idx="922">
                  <c:v>4.3021584178874903</c:v>
                </c:pt>
                <c:pt idx="923">
                  <c:v>4.3017771835108309</c:v>
                </c:pt>
                <c:pt idx="924">
                  <c:v>4.3013398025041027</c:v>
                </c:pt>
                <c:pt idx="925">
                  <c:v>4.3012017492922334</c:v>
                </c:pt>
                <c:pt idx="926">
                  <c:v>4.3010518304765339</c:v>
                </c:pt>
                <c:pt idx="927">
                  <c:v>4.3004115303290513</c:v>
                </c:pt>
                <c:pt idx="928">
                  <c:v>4.3003919587856094</c:v>
                </c:pt>
                <c:pt idx="929">
                  <c:v>4.3001265685918471</c:v>
                </c:pt>
                <c:pt idx="930">
                  <c:v>4.2996491591027626</c:v>
                </c:pt>
                <c:pt idx="931">
                  <c:v>4.2987412754452254</c:v>
                </c:pt>
                <c:pt idx="932">
                  <c:v>4.2978729293483822</c:v>
                </c:pt>
                <c:pt idx="933">
                  <c:v>4.2973700418649647</c:v>
                </c:pt>
                <c:pt idx="934">
                  <c:v>4.2966266820851384</c:v>
                </c:pt>
                <c:pt idx="935">
                  <c:v>4.2958175869196387</c:v>
                </c:pt>
                <c:pt idx="936">
                  <c:v>4.2957884054801827</c:v>
                </c:pt>
                <c:pt idx="937">
                  <c:v>4.2957443243578908</c:v>
                </c:pt>
                <c:pt idx="938">
                  <c:v>4.2944036371959644</c:v>
                </c:pt>
                <c:pt idx="939">
                  <c:v>4.294372155578821</c:v>
                </c:pt>
                <c:pt idx="940">
                  <c:v>4.2938512139957981</c:v>
                </c:pt>
                <c:pt idx="941">
                  <c:v>4.2935027538205635</c:v>
                </c:pt>
                <c:pt idx="942">
                  <c:v>4.2929768350782416</c:v>
                </c:pt>
                <c:pt idx="943">
                  <c:v>4.2923594624965675</c:v>
                </c:pt>
                <c:pt idx="944">
                  <c:v>4.2921474841620357</c:v>
                </c:pt>
                <c:pt idx="945">
                  <c:v>4.289704248713786</c:v>
                </c:pt>
                <c:pt idx="946">
                  <c:v>4.2894845279860832</c:v>
                </c:pt>
                <c:pt idx="947">
                  <c:v>4.2890086634930142</c:v>
                </c:pt>
                <c:pt idx="948">
                  <c:v>4.2881221091175217</c:v>
                </c:pt>
                <c:pt idx="949">
                  <c:v>4.2875037654005919</c:v>
                </c:pt>
                <c:pt idx="950">
                  <c:v>4.2874141494441087</c:v>
                </c:pt>
                <c:pt idx="951">
                  <c:v>4.2859433019774826</c:v>
                </c:pt>
                <c:pt idx="952">
                  <c:v>4.2858152588157177</c:v>
                </c:pt>
                <c:pt idx="953">
                  <c:v>4.2857721528682573</c:v>
                </c:pt>
                <c:pt idx="954">
                  <c:v>4.2857060487712619</c:v>
                </c:pt>
                <c:pt idx="955">
                  <c:v>4.2851410669890253</c:v>
                </c:pt>
                <c:pt idx="956">
                  <c:v>4.2843843564885979</c:v>
                </c:pt>
                <c:pt idx="957">
                  <c:v>4.2839796606419238</c:v>
                </c:pt>
                <c:pt idx="958">
                  <c:v>4.2839633495267844</c:v>
                </c:pt>
                <c:pt idx="959">
                  <c:v>4.2838283201569274</c:v>
                </c:pt>
                <c:pt idx="960">
                  <c:v>4.2834612950270339</c:v>
                </c:pt>
                <c:pt idx="961">
                  <c:v>4.2834150652877172</c:v>
                </c:pt>
                <c:pt idx="962">
                  <c:v>4.2833081401637463</c:v>
                </c:pt>
                <c:pt idx="963">
                  <c:v>4.2827693447849855</c:v>
                </c:pt>
                <c:pt idx="964">
                  <c:v>4.2814679495093255</c:v>
                </c:pt>
                <c:pt idx="965">
                  <c:v>4.2800033817854732</c:v>
                </c:pt>
                <c:pt idx="966">
                  <c:v>4.2792927056714261</c:v>
                </c:pt>
                <c:pt idx="967">
                  <c:v>4.2791855218096693</c:v>
                </c:pt>
                <c:pt idx="968">
                  <c:v>4.2789383272956014</c:v>
                </c:pt>
                <c:pt idx="969">
                  <c:v>4.2786081768470607</c:v>
                </c:pt>
                <c:pt idx="970">
                  <c:v>4.2785851839497022</c:v>
                </c:pt>
                <c:pt idx="971">
                  <c:v>4.278301292881574</c:v>
                </c:pt>
                <c:pt idx="972">
                  <c:v>4.2781932282766109</c:v>
                </c:pt>
                <c:pt idx="973">
                  <c:v>4.2781296482988225</c:v>
                </c:pt>
                <c:pt idx="974">
                  <c:v>4.2774109290841809</c:v>
                </c:pt>
                <c:pt idx="975">
                  <c:v>4.2774064707650696</c:v>
                </c:pt>
                <c:pt idx="976">
                  <c:v>4.276968058227121</c:v>
                </c:pt>
                <c:pt idx="977">
                  <c:v>4.2768189736220155</c:v>
                </c:pt>
                <c:pt idx="978">
                  <c:v>4.2761217162568803</c:v>
                </c:pt>
                <c:pt idx="979">
                  <c:v>4.2760892643641011</c:v>
                </c:pt>
                <c:pt idx="980">
                  <c:v>4.2758613940163004</c:v>
                </c:pt>
                <c:pt idx="981">
                  <c:v>4.2753772680949709</c:v>
                </c:pt>
                <c:pt idx="982">
                  <c:v>4.2752885704434975</c:v>
                </c:pt>
                <c:pt idx="983">
                  <c:v>4.2751143221705989</c:v>
                </c:pt>
                <c:pt idx="984">
                  <c:v>4.2746417973374795</c:v>
                </c:pt>
                <c:pt idx="985">
                  <c:v>4.2744866540647832</c:v>
                </c:pt>
                <c:pt idx="986">
                  <c:v>4.2742397209431156</c:v>
                </c:pt>
                <c:pt idx="987">
                  <c:v>4.2733234955132797</c:v>
                </c:pt>
                <c:pt idx="988">
                  <c:v>4.2729609934040207</c:v>
                </c:pt>
                <c:pt idx="989">
                  <c:v>4.2726244627337433</c:v>
                </c:pt>
                <c:pt idx="990">
                  <c:v>4.2720065967735099</c:v>
                </c:pt>
                <c:pt idx="991">
                  <c:v>4.2711982040301164</c:v>
                </c:pt>
                <c:pt idx="992">
                  <c:v>4.2711162738660606</c:v>
                </c:pt>
                <c:pt idx="993">
                  <c:v>4.270872330282943</c:v>
                </c:pt>
                <c:pt idx="994">
                  <c:v>4.270554493950371</c:v>
                </c:pt>
                <c:pt idx="995">
                  <c:v>4.2705473765145383</c:v>
                </c:pt>
                <c:pt idx="996">
                  <c:v>4.2697190165656496</c:v>
                </c:pt>
                <c:pt idx="997">
                  <c:v>4.2685861616261338</c:v>
                </c:pt>
                <c:pt idx="998">
                  <c:v>4.2684802030212348</c:v>
                </c:pt>
                <c:pt idx="999">
                  <c:v>4.2680790162995592</c:v>
                </c:pt>
                <c:pt idx="1000">
                  <c:v>4.2678402618396039</c:v>
                </c:pt>
                <c:pt idx="1001">
                  <c:v>4.2674137181966287</c:v>
                </c:pt>
                <c:pt idx="1002">
                  <c:v>4.2670728597273584</c:v>
                </c:pt>
                <c:pt idx="1003">
                  <c:v>4.2663942587544748</c:v>
                </c:pt>
                <c:pt idx="1004">
                  <c:v>4.266374791103579</c:v>
                </c:pt>
                <c:pt idx="1005">
                  <c:v>4.2663485279904743</c:v>
                </c:pt>
                <c:pt idx="1006">
                  <c:v>4.2663278822393407</c:v>
                </c:pt>
                <c:pt idx="1007">
                  <c:v>4.2656971914433965</c:v>
                </c:pt>
                <c:pt idx="1008">
                  <c:v>4.2655414373565907</c:v>
                </c:pt>
                <c:pt idx="1009">
                  <c:v>4.2651241600540573</c:v>
                </c:pt>
                <c:pt idx="1010">
                  <c:v>4.2644900115475117</c:v>
                </c:pt>
                <c:pt idx="1011">
                  <c:v>4.2644423736880999</c:v>
                </c:pt>
                <c:pt idx="1012">
                  <c:v>4.2643506265595121</c:v>
                </c:pt>
                <c:pt idx="1013">
                  <c:v>4.2639680724009743</c:v>
                </c:pt>
                <c:pt idx="1014">
                  <c:v>4.2636966788774844</c:v>
                </c:pt>
                <c:pt idx="1015">
                  <c:v>4.2620128826104198</c:v>
                </c:pt>
                <c:pt idx="1016">
                  <c:v>4.2619635203309283</c:v>
                </c:pt>
                <c:pt idx="1017">
                  <c:v>4.2612623399708847</c:v>
                </c:pt>
                <c:pt idx="1018">
                  <c:v>4.261088454955277</c:v>
                </c:pt>
                <c:pt idx="1019">
                  <c:v>4.2605745916001965</c:v>
                </c:pt>
                <c:pt idx="1020">
                  <c:v>4.2604461300442189</c:v>
                </c:pt>
                <c:pt idx="1021">
                  <c:v>4.260208044629775</c:v>
                </c:pt>
                <c:pt idx="1022">
                  <c:v>4.2601237493950812</c:v>
                </c:pt>
                <c:pt idx="1023">
                  <c:v>4.2597282977316073</c:v>
                </c:pt>
                <c:pt idx="1024">
                  <c:v>4.2594465409529061</c:v>
                </c:pt>
                <c:pt idx="1025">
                  <c:v>4.2593250491145032</c:v>
                </c:pt>
                <c:pt idx="1026">
                  <c:v>4.2587938037635533</c:v>
                </c:pt>
                <c:pt idx="1027">
                  <c:v>4.2587715990295045</c:v>
                </c:pt>
                <c:pt idx="1028">
                  <c:v>4.2577586813493458</c:v>
                </c:pt>
                <c:pt idx="1029">
                  <c:v>4.257258073479111</c:v>
                </c:pt>
                <c:pt idx="1030">
                  <c:v>4.256944399551057</c:v>
                </c:pt>
                <c:pt idx="1031">
                  <c:v>4.2565805210169714</c:v>
                </c:pt>
                <c:pt idx="1032">
                  <c:v>4.2560691868525327</c:v>
                </c:pt>
                <c:pt idx="1033">
                  <c:v>4.2555676981975266</c:v>
                </c:pt>
                <c:pt idx="1034">
                  <c:v>4.254229079937752</c:v>
                </c:pt>
                <c:pt idx="1035">
                  <c:v>4.2541129739759533</c:v>
                </c:pt>
                <c:pt idx="1036">
                  <c:v>4.2538766347182113</c:v>
                </c:pt>
                <c:pt idx="1037">
                  <c:v>4.2536121802522775</c:v>
                </c:pt>
                <c:pt idx="1038">
                  <c:v>4.2534544532320391</c:v>
                </c:pt>
                <c:pt idx="1039">
                  <c:v>4.2532868391477558</c:v>
                </c:pt>
                <c:pt idx="1040">
                  <c:v>4.2525843107099375</c:v>
                </c:pt>
                <c:pt idx="1041">
                  <c:v>4.2524297178586732</c:v>
                </c:pt>
                <c:pt idx="1042">
                  <c:v>4.2522201337587271</c:v>
                </c:pt>
                <c:pt idx="1043">
                  <c:v>4.2502121581247394</c:v>
                </c:pt>
                <c:pt idx="1044">
                  <c:v>4.250094837487147</c:v>
                </c:pt>
                <c:pt idx="1045">
                  <c:v>4.2488832946809874</c:v>
                </c:pt>
                <c:pt idx="1046">
                  <c:v>4.2477139208606456</c:v>
                </c:pt>
                <c:pt idx="1047">
                  <c:v>4.2473897257885511</c:v>
                </c:pt>
                <c:pt idx="1048">
                  <c:v>4.2471943551050639</c:v>
                </c:pt>
                <c:pt idx="1049">
                  <c:v>4.2470979343869608</c:v>
                </c:pt>
                <c:pt idx="1050">
                  <c:v>4.2466946748050685</c:v>
                </c:pt>
                <c:pt idx="1051">
                  <c:v>4.2466682879498734</c:v>
                </c:pt>
                <c:pt idx="1052">
                  <c:v>4.2464407202504422</c:v>
                </c:pt>
                <c:pt idx="1053">
                  <c:v>4.246085865177526</c:v>
                </c:pt>
                <c:pt idx="1054">
                  <c:v>4.2458353898932844</c:v>
                </c:pt>
                <c:pt idx="1055">
                  <c:v>4.2455954610162703</c:v>
                </c:pt>
                <c:pt idx="1056">
                  <c:v>4.2453083587863105</c:v>
                </c:pt>
                <c:pt idx="1057">
                  <c:v>4.2450545526764163</c:v>
                </c:pt>
                <c:pt idx="1058">
                  <c:v>4.2447279535754801</c:v>
                </c:pt>
                <c:pt idx="1059">
                  <c:v>4.2442626853227461</c:v>
                </c:pt>
                <c:pt idx="1060">
                  <c:v>4.2441499345966349</c:v>
                </c:pt>
                <c:pt idx="1061">
                  <c:v>4.2433672982984527</c:v>
                </c:pt>
                <c:pt idx="1062">
                  <c:v>4.2420760212443014</c:v>
                </c:pt>
                <c:pt idx="1063">
                  <c:v>4.2419696119130732</c:v>
                </c:pt>
                <c:pt idx="1064">
                  <c:v>4.2416727717576261</c:v>
                </c:pt>
                <c:pt idx="1065">
                  <c:v>4.2414070058460398</c:v>
                </c:pt>
                <c:pt idx="1066">
                  <c:v>4.2413045851484679</c:v>
                </c:pt>
                <c:pt idx="1067">
                  <c:v>4.2408316142790978</c:v>
                </c:pt>
                <c:pt idx="1068">
                  <c:v>4.2398088470557775</c:v>
                </c:pt>
                <c:pt idx="1069">
                  <c:v>4.2387434266197932</c:v>
                </c:pt>
                <c:pt idx="1070">
                  <c:v>4.2386846627737658</c:v>
                </c:pt>
                <c:pt idx="1071">
                  <c:v>4.2379887791684885</c:v>
                </c:pt>
                <c:pt idx="1072">
                  <c:v>4.2370343610669519</c:v>
                </c:pt>
                <c:pt idx="1073">
                  <c:v>4.2364483838089972</c:v>
                </c:pt>
                <c:pt idx="1074">
                  <c:v>4.2356982879235545</c:v>
                </c:pt>
                <c:pt idx="1075">
                  <c:v>4.235684826484726</c:v>
                </c:pt>
                <c:pt idx="1076">
                  <c:v>4.2356521527154838</c:v>
                </c:pt>
                <c:pt idx="1077">
                  <c:v>4.2352673147891355</c:v>
                </c:pt>
                <c:pt idx="1078">
                  <c:v>4.2351684898485109</c:v>
                </c:pt>
                <c:pt idx="1079">
                  <c:v>4.2350459100654243</c:v>
                </c:pt>
                <c:pt idx="1080">
                  <c:v>4.2349643114429458</c:v>
                </c:pt>
                <c:pt idx="1081">
                  <c:v>4.2345802690797241</c:v>
                </c:pt>
                <c:pt idx="1082">
                  <c:v>4.2338703093509773</c:v>
                </c:pt>
                <c:pt idx="1083">
                  <c:v>4.2335991604814778</c:v>
                </c:pt>
                <c:pt idx="1084">
                  <c:v>4.2332418306602841</c:v>
                </c:pt>
                <c:pt idx="1085">
                  <c:v>4.2332172930936176</c:v>
                </c:pt>
                <c:pt idx="1086">
                  <c:v>4.2329050937271999</c:v>
                </c:pt>
                <c:pt idx="1087">
                  <c:v>4.2320375737237059</c:v>
                </c:pt>
                <c:pt idx="1088">
                  <c:v>4.2316757011273856</c:v>
                </c:pt>
                <c:pt idx="1089">
                  <c:v>4.2307394892183545</c:v>
                </c:pt>
                <c:pt idx="1090">
                  <c:v>4.2305784807642413</c:v>
                </c:pt>
                <c:pt idx="1091">
                  <c:v>4.2304560176353618</c:v>
                </c:pt>
                <c:pt idx="1092">
                  <c:v>4.229794432066269</c:v>
                </c:pt>
                <c:pt idx="1093">
                  <c:v>4.2292925288717189</c:v>
                </c:pt>
                <c:pt idx="1094">
                  <c:v>4.2288270854476506</c:v>
                </c:pt>
                <c:pt idx="1095">
                  <c:v>4.2286136319593703</c:v>
                </c:pt>
                <c:pt idx="1096">
                  <c:v>4.2280180295699248</c:v>
                </c:pt>
                <c:pt idx="1097">
                  <c:v>4.2276767877202666</c:v>
                </c:pt>
                <c:pt idx="1098">
                  <c:v>4.227402171805303</c:v>
                </c:pt>
                <c:pt idx="1099">
                  <c:v>4.2266490165113018</c:v>
                </c:pt>
                <c:pt idx="1100">
                  <c:v>4.2266243899627085</c:v>
                </c:pt>
                <c:pt idx="1101">
                  <c:v>4.2263683056550603</c:v>
                </c:pt>
                <c:pt idx="1102">
                  <c:v>4.2259764393434365</c:v>
                </c:pt>
                <c:pt idx="1103">
                  <c:v>4.2253560979858458</c:v>
                </c:pt>
                <c:pt idx="1104">
                  <c:v>4.2253362806758377</c:v>
                </c:pt>
                <c:pt idx="1105">
                  <c:v>4.2252551351562468</c:v>
                </c:pt>
                <c:pt idx="1106">
                  <c:v>4.2243305863624157</c:v>
                </c:pt>
                <c:pt idx="1107">
                  <c:v>4.2239678502929658</c:v>
                </c:pt>
                <c:pt idx="1108">
                  <c:v>4.22318908343951</c:v>
                </c:pt>
                <c:pt idx="1109">
                  <c:v>4.2231411669752106</c:v>
                </c:pt>
                <c:pt idx="1110">
                  <c:v>4.2229890115908093</c:v>
                </c:pt>
                <c:pt idx="1111">
                  <c:v>4.2229558017162292</c:v>
                </c:pt>
                <c:pt idx="1112">
                  <c:v>4.2227501327220214</c:v>
                </c:pt>
                <c:pt idx="1113">
                  <c:v>4.2224566258040301</c:v>
                </c:pt>
                <c:pt idx="1114">
                  <c:v>4.2211183763146325</c:v>
                </c:pt>
                <c:pt idx="1115">
                  <c:v>4.2209356271727474</c:v>
                </c:pt>
                <c:pt idx="1116">
                  <c:v>4.2201654959994022</c:v>
                </c:pt>
                <c:pt idx="1117">
                  <c:v>4.2198204980323197</c:v>
                </c:pt>
                <c:pt idx="1118">
                  <c:v>4.2197445704144929</c:v>
                </c:pt>
                <c:pt idx="1119">
                  <c:v>4.2197397699465276</c:v>
                </c:pt>
                <c:pt idx="1120">
                  <c:v>4.2196021339635674</c:v>
                </c:pt>
                <c:pt idx="1121">
                  <c:v>4.2182030782675914</c:v>
                </c:pt>
                <c:pt idx="1122">
                  <c:v>4.2178302181265943</c:v>
                </c:pt>
                <c:pt idx="1123">
                  <c:v>4.2174639106393839</c:v>
                </c:pt>
                <c:pt idx="1124">
                  <c:v>4.2174447535833428</c:v>
                </c:pt>
                <c:pt idx="1125">
                  <c:v>4.2173536363221737</c:v>
                </c:pt>
                <c:pt idx="1126">
                  <c:v>4.2172655722644778</c:v>
                </c:pt>
                <c:pt idx="1127">
                  <c:v>4.2160484024748479</c:v>
                </c:pt>
                <c:pt idx="1128">
                  <c:v>4.2156886642629283</c:v>
                </c:pt>
                <c:pt idx="1129">
                  <c:v>4.2148520866182624</c:v>
                </c:pt>
                <c:pt idx="1130">
                  <c:v>4.2145729179805436</c:v>
                </c:pt>
                <c:pt idx="1131">
                  <c:v>4.214559374400233</c:v>
                </c:pt>
                <c:pt idx="1132">
                  <c:v>4.2144102198687392</c:v>
                </c:pt>
                <c:pt idx="1133">
                  <c:v>4.2142903290474525</c:v>
                </c:pt>
                <c:pt idx="1134">
                  <c:v>4.2139587632172271</c:v>
                </c:pt>
                <c:pt idx="1135">
                  <c:v>4.2138214945691415</c:v>
                </c:pt>
                <c:pt idx="1136">
                  <c:v>4.2127263636491357</c:v>
                </c:pt>
                <c:pt idx="1137">
                  <c:v>4.2126793486892602</c:v>
                </c:pt>
                <c:pt idx="1138">
                  <c:v>4.2124649077623388</c:v>
                </c:pt>
                <c:pt idx="1139">
                  <c:v>4.2122607207689287</c:v>
                </c:pt>
                <c:pt idx="1140">
                  <c:v>4.2115405656239497</c:v>
                </c:pt>
                <c:pt idx="1141">
                  <c:v>4.2107800116079064</c:v>
                </c:pt>
                <c:pt idx="1142">
                  <c:v>4.2103894247202929</c:v>
                </c:pt>
                <c:pt idx="1143">
                  <c:v>4.2103813983322089</c:v>
                </c:pt>
                <c:pt idx="1144">
                  <c:v>4.2091697949594895</c:v>
                </c:pt>
                <c:pt idx="1145">
                  <c:v>4.208845333495888</c:v>
                </c:pt>
                <c:pt idx="1146">
                  <c:v>4.2086030222070354</c:v>
                </c:pt>
                <c:pt idx="1147">
                  <c:v>4.2078831994511576</c:v>
                </c:pt>
                <c:pt idx="1148">
                  <c:v>4.2072563604476816</c:v>
                </c:pt>
                <c:pt idx="1149">
                  <c:v>4.206812238551394</c:v>
                </c:pt>
                <c:pt idx="1150">
                  <c:v>4.2063955645197533</c:v>
                </c:pt>
                <c:pt idx="1151">
                  <c:v>4.2057359259037375</c:v>
                </c:pt>
                <c:pt idx="1152">
                  <c:v>4.2056172227324371</c:v>
                </c:pt>
                <c:pt idx="1153">
                  <c:v>4.2054359499819256</c:v>
                </c:pt>
                <c:pt idx="1154">
                  <c:v>4.2045566211105267</c:v>
                </c:pt>
                <c:pt idx="1155">
                  <c:v>4.2039803224627379</c:v>
                </c:pt>
                <c:pt idx="1156">
                  <c:v>4.2038763776845087</c:v>
                </c:pt>
                <c:pt idx="1157">
                  <c:v>4.2036196527224865</c:v>
                </c:pt>
                <c:pt idx="1158">
                  <c:v>4.2034901006945073</c:v>
                </c:pt>
                <c:pt idx="1159">
                  <c:v>4.2034532513339169</c:v>
                </c:pt>
                <c:pt idx="1160">
                  <c:v>4.203067958113154</c:v>
                </c:pt>
                <c:pt idx="1161">
                  <c:v>4.2025804881441511</c:v>
                </c:pt>
                <c:pt idx="1162">
                  <c:v>4.2023852257293521</c:v>
                </c:pt>
                <c:pt idx="1163">
                  <c:v>4.2022733265330583</c:v>
                </c:pt>
                <c:pt idx="1164">
                  <c:v>4.2017826891676169</c:v>
                </c:pt>
                <c:pt idx="1165">
                  <c:v>4.2005614192186016</c:v>
                </c:pt>
                <c:pt idx="1166">
                  <c:v>4.2005351159547359</c:v>
                </c:pt>
                <c:pt idx="1167">
                  <c:v>4.1999861850835609</c:v>
                </c:pt>
                <c:pt idx="1168">
                  <c:v>4.1993063633359915</c:v>
                </c:pt>
                <c:pt idx="1169">
                  <c:v>4.1988091550199984</c:v>
                </c:pt>
                <c:pt idx="1170">
                  <c:v>4.1985391822943354</c:v>
                </c:pt>
                <c:pt idx="1171">
                  <c:v>4.1984814400986075</c:v>
                </c:pt>
                <c:pt idx="1172">
                  <c:v>4.1981542421123681</c:v>
                </c:pt>
                <c:pt idx="1173">
                  <c:v>4.1981060814780893</c:v>
                </c:pt>
                <c:pt idx="1174">
                  <c:v>4.1976526510930361</c:v>
                </c:pt>
                <c:pt idx="1175">
                  <c:v>4.1975966278491672</c:v>
                </c:pt>
                <c:pt idx="1176">
                  <c:v>4.1975502424819267</c:v>
                </c:pt>
                <c:pt idx="1177">
                  <c:v>4.1973931383981897</c:v>
                </c:pt>
                <c:pt idx="1178">
                  <c:v>4.1972246400687734</c:v>
                </c:pt>
                <c:pt idx="1179">
                  <c:v>4.1966518699046294</c:v>
                </c:pt>
                <c:pt idx="1180">
                  <c:v>4.196118281392347</c:v>
                </c:pt>
                <c:pt idx="1181">
                  <c:v>4.1948210301678985</c:v>
                </c:pt>
                <c:pt idx="1182">
                  <c:v>4.1947993071204817</c:v>
                </c:pt>
                <c:pt idx="1183">
                  <c:v>4.1943400957979193</c:v>
                </c:pt>
                <c:pt idx="1184">
                  <c:v>4.1938987709428401</c:v>
                </c:pt>
                <c:pt idx="1185">
                  <c:v>4.1935558946670461</c:v>
                </c:pt>
                <c:pt idx="1186">
                  <c:v>4.1934831144731541</c:v>
                </c:pt>
                <c:pt idx="1187">
                  <c:v>4.1926713531869044</c:v>
                </c:pt>
                <c:pt idx="1188">
                  <c:v>4.1925268776448625</c:v>
                </c:pt>
                <c:pt idx="1189">
                  <c:v>4.1918745136320688</c:v>
                </c:pt>
                <c:pt idx="1190">
                  <c:v>4.1914202718111788</c:v>
                </c:pt>
                <c:pt idx="1191">
                  <c:v>4.1912572062070792</c:v>
                </c:pt>
                <c:pt idx="1192">
                  <c:v>4.1912234983466004</c:v>
                </c:pt>
                <c:pt idx="1193">
                  <c:v>4.1903271839747962</c:v>
                </c:pt>
                <c:pt idx="1194">
                  <c:v>4.1900361528545327</c:v>
                </c:pt>
                <c:pt idx="1195">
                  <c:v>4.1899144817301766</c:v>
                </c:pt>
                <c:pt idx="1196">
                  <c:v>4.1880601203915679</c:v>
                </c:pt>
                <c:pt idx="1197">
                  <c:v>4.187290038558487</c:v>
                </c:pt>
                <c:pt idx="1198">
                  <c:v>4.1866674313666943</c:v>
                </c:pt>
                <c:pt idx="1199">
                  <c:v>4.1866261436594154</c:v>
                </c:pt>
                <c:pt idx="1200">
                  <c:v>4.1860539913585768</c:v>
                </c:pt>
                <c:pt idx="1201">
                  <c:v>4.1858302354109354</c:v>
                </c:pt>
                <c:pt idx="1202">
                  <c:v>4.1857095826513167</c:v>
                </c:pt>
                <c:pt idx="1203">
                  <c:v>4.1854133929668595</c:v>
                </c:pt>
                <c:pt idx="1204">
                  <c:v>4.1849291711367211</c:v>
                </c:pt>
                <c:pt idx="1205">
                  <c:v>4.1847910831863784</c:v>
                </c:pt>
                <c:pt idx="1206">
                  <c:v>4.1844096945930787</c:v>
                </c:pt>
                <c:pt idx="1207">
                  <c:v>4.1842455534252903</c:v>
                </c:pt>
                <c:pt idx="1208">
                  <c:v>4.1838992330582156</c:v>
                </c:pt>
                <c:pt idx="1209">
                  <c:v>4.1837661903170629</c:v>
                </c:pt>
                <c:pt idx="1210">
                  <c:v>4.1836105006862256</c:v>
                </c:pt>
                <c:pt idx="1211">
                  <c:v>4.1832538638832943</c:v>
                </c:pt>
                <c:pt idx="1212">
                  <c:v>4.1831285365536992</c:v>
                </c:pt>
                <c:pt idx="1213">
                  <c:v>4.1831036883301191</c:v>
                </c:pt>
                <c:pt idx="1214">
                  <c:v>4.182566651094592</c:v>
                </c:pt>
                <c:pt idx="1215">
                  <c:v>4.1822955840055327</c:v>
                </c:pt>
                <c:pt idx="1216">
                  <c:v>4.182210265909287</c:v>
                </c:pt>
                <c:pt idx="1217">
                  <c:v>4.1821653799595726</c:v>
                </c:pt>
                <c:pt idx="1218">
                  <c:v>4.181852000731543</c:v>
                </c:pt>
                <c:pt idx="1219">
                  <c:v>4.1817989815790133</c:v>
                </c:pt>
                <c:pt idx="1220">
                  <c:v>4.1816249570816293</c:v>
                </c:pt>
                <c:pt idx="1221">
                  <c:v>4.1813811102333833</c:v>
                </c:pt>
                <c:pt idx="1222">
                  <c:v>4.1809147989827951</c:v>
                </c:pt>
                <c:pt idx="1223">
                  <c:v>4.1808912555116171</c:v>
                </c:pt>
                <c:pt idx="1224">
                  <c:v>4.180575363241867</c:v>
                </c:pt>
                <c:pt idx="1225">
                  <c:v>4.1803497216738181</c:v>
                </c:pt>
                <c:pt idx="1226">
                  <c:v>4.1798564691219076</c:v>
                </c:pt>
                <c:pt idx="1227">
                  <c:v>4.1798172398670781</c:v>
                </c:pt>
                <c:pt idx="1228">
                  <c:v>4.17825700071295</c:v>
                </c:pt>
                <c:pt idx="1229">
                  <c:v>4.1781425501135958</c:v>
                </c:pt>
                <c:pt idx="1230">
                  <c:v>4.1770263974292341</c:v>
                </c:pt>
                <c:pt idx="1231">
                  <c:v>4.1768199404342772</c:v>
                </c:pt>
                <c:pt idx="1232">
                  <c:v>4.1767635731429733</c:v>
                </c:pt>
                <c:pt idx="1233">
                  <c:v>4.1764920726135086</c:v>
                </c:pt>
                <c:pt idx="1234">
                  <c:v>4.1763188019147099</c:v>
                </c:pt>
                <c:pt idx="1235">
                  <c:v>4.1755243762174903</c:v>
                </c:pt>
                <c:pt idx="1236">
                  <c:v>4.1746873471092982</c:v>
                </c:pt>
                <c:pt idx="1237">
                  <c:v>4.1738242869046944</c:v>
                </c:pt>
                <c:pt idx="1238">
                  <c:v>4.17371286708536</c:v>
                </c:pt>
                <c:pt idx="1239">
                  <c:v>4.1731595492497586</c:v>
                </c:pt>
                <c:pt idx="1240">
                  <c:v>4.1728963181300278</c:v>
                </c:pt>
                <c:pt idx="1241">
                  <c:v>4.1719774043205788</c:v>
                </c:pt>
                <c:pt idx="1242">
                  <c:v>4.1718708695174724</c:v>
                </c:pt>
                <c:pt idx="1243">
                  <c:v>4.1715663867237582</c:v>
                </c:pt>
                <c:pt idx="1244">
                  <c:v>4.1713548779116429</c:v>
                </c:pt>
                <c:pt idx="1245">
                  <c:v>4.1710985231949378</c:v>
                </c:pt>
                <c:pt idx="1246">
                  <c:v>4.1710309934445924</c:v>
                </c:pt>
                <c:pt idx="1247">
                  <c:v>4.1710121157810764</c:v>
                </c:pt>
                <c:pt idx="1248">
                  <c:v>4.1709512460017697</c:v>
                </c:pt>
                <c:pt idx="1249">
                  <c:v>4.1707441597771826</c:v>
                </c:pt>
                <c:pt idx="1250">
                  <c:v>4.1706840667532354</c:v>
                </c:pt>
                <c:pt idx="1251">
                  <c:v>4.1706511667789297</c:v>
                </c:pt>
                <c:pt idx="1252">
                  <c:v>4.1702703555520815</c:v>
                </c:pt>
                <c:pt idx="1253">
                  <c:v>4.1699887283541175</c:v>
                </c:pt>
                <c:pt idx="1254">
                  <c:v>4.1693600755096156</c:v>
                </c:pt>
                <c:pt idx="1255">
                  <c:v>4.1692504455978279</c:v>
                </c:pt>
                <c:pt idx="1256">
                  <c:v>4.168954911534227</c:v>
                </c:pt>
                <c:pt idx="1257">
                  <c:v>4.1689280942897469</c:v>
                </c:pt>
                <c:pt idx="1258">
                  <c:v>4.1681188740784867</c:v>
                </c:pt>
                <c:pt idx="1259">
                  <c:v>4.1674136698152884</c:v>
                </c:pt>
                <c:pt idx="1260">
                  <c:v>4.1669882886833518</c:v>
                </c:pt>
                <c:pt idx="1261">
                  <c:v>4.1665077358523757</c:v>
                </c:pt>
                <c:pt idx="1262">
                  <c:v>4.1659787433495596</c:v>
                </c:pt>
                <c:pt idx="1263">
                  <c:v>4.1659008620582627</c:v>
                </c:pt>
                <c:pt idx="1264">
                  <c:v>4.1652990753771553</c:v>
                </c:pt>
                <c:pt idx="1265">
                  <c:v>4.1647707539894476</c:v>
                </c:pt>
                <c:pt idx="1266">
                  <c:v>4.1645818411265303</c:v>
                </c:pt>
                <c:pt idx="1267">
                  <c:v>4.1640418967234183</c:v>
                </c:pt>
                <c:pt idx="1268">
                  <c:v>4.163891213942863</c:v>
                </c:pt>
                <c:pt idx="1269">
                  <c:v>4.1635526072687963</c:v>
                </c:pt>
                <c:pt idx="1270">
                  <c:v>4.1630195034870869</c:v>
                </c:pt>
                <c:pt idx="1271">
                  <c:v>4.1619558153645499</c:v>
                </c:pt>
                <c:pt idx="1272">
                  <c:v>4.1615491700708995</c:v>
                </c:pt>
                <c:pt idx="1273">
                  <c:v>4.1612603304483642</c:v>
                </c:pt>
                <c:pt idx="1274">
                  <c:v>4.1595979362916156</c:v>
                </c:pt>
                <c:pt idx="1275">
                  <c:v>4.1594888220076207</c:v>
                </c:pt>
                <c:pt idx="1276">
                  <c:v>4.1592895717640772</c:v>
                </c:pt>
                <c:pt idx="1277">
                  <c:v>4.1589373171287622</c:v>
                </c:pt>
                <c:pt idx="1278">
                  <c:v>4.1581565219961414</c:v>
                </c:pt>
                <c:pt idx="1279">
                  <c:v>4.1581327176897966</c:v>
                </c:pt>
                <c:pt idx="1280">
                  <c:v>4.1577348921407857</c:v>
                </c:pt>
                <c:pt idx="1281">
                  <c:v>4.1572066905481337</c:v>
                </c:pt>
                <c:pt idx="1282">
                  <c:v>4.1571549439617943</c:v>
                </c:pt>
                <c:pt idx="1283">
                  <c:v>4.1570433654075876</c:v>
                </c:pt>
                <c:pt idx="1284">
                  <c:v>4.157041684788541</c:v>
                </c:pt>
                <c:pt idx="1285">
                  <c:v>4.1566248585544789</c:v>
                </c:pt>
                <c:pt idx="1286">
                  <c:v>4.156327337324722</c:v>
                </c:pt>
                <c:pt idx="1287">
                  <c:v>4.1563234655129069</c:v>
                </c:pt>
                <c:pt idx="1288">
                  <c:v>4.1560823351397316</c:v>
                </c:pt>
                <c:pt idx="1289">
                  <c:v>4.1554993311827291</c:v>
                </c:pt>
                <c:pt idx="1290">
                  <c:v>4.1550752812766962</c:v>
                </c:pt>
                <c:pt idx="1291">
                  <c:v>4.1531357167226863</c:v>
                </c:pt>
                <c:pt idx="1292">
                  <c:v>4.1528755021887411</c:v>
                </c:pt>
                <c:pt idx="1293">
                  <c:v>4.1528744840943066</c:v>
                </c:pt>
                <c:pt idx="1294">
                  <c:v>4.1527337944292873</c:v>
                </c:pt>
                <c:pt idx="1295">
                  <c:v>4.1524383505660003</c:v>
                </c:pt>
                <c:pt idx="1296">
                  <c:v>4.151935974374493</c:v>
                </c:pt>
                <c:pt idx="1297">
                  <c:v>4.1517565348919812</c:v>
                </c:pt>
                <c:pt idx="1298">
                  <c:v>4.1515669798956267</c:v>
                </c:pt>
                <c:pt idx="1299">
                  <c:v>4.1514331866259546</c:v>
                </c:pt>
                <c:pt idx="1300">
                  <c:v>4.1513674664399511</c:v>
                </c:pt>
                <c:pt idx="1301">
                  <c:v>4.1507924164367536</c:v>
                </c:pt>
                <c:pt idx="1302">
                  <c:v>4.1507545642224537</c:v>
                </c:pt>
                <c:pt idx="1303">
                  <c:v>4.1496354114001868</c:v>
                </c:pt>
                <c:pt idx="1304">
                  <c:v>4.149538983277461</c:v>
                </c:pt>
                <c:pt idx="1305">
                  <c:v>4.1486218466886831</c:v>
                </c:pt>
                <c:pt idx="1306">
                  <c:v>4.1475894223056438</c:v>
                </c:pt>
                <c:pt idx="1307">
                  <c:v>4.1472407810798275</c:v>
                </c:pt>
                <c:pt idx="1308">
                  <c:v>4.1471737356538521</c:v>
                </c:pt>
                <c:pt idx="1309">
                  <c:v>4.1470714284561963</c:v>
                </c:pt>
                <c:pt idx="1310">
                  <c:v>4.1469594647291119</c:v>
                </c:pt>
                <c:pt idx="1311">
                  <c:v>4.1468908275296172</c:v>
                </c:pt>
                <c:pt idx="1312">
                  <c:v>4.1465368038838584</c:v>
                </c:pt>
                <c:pt idx="1313">
                  <c:v>4.1459298005004257</c:v>
                </c:pt>
                <c:pt idx="1314">
                  <c:v>4.1457842555230995</c:v>
                </c:pt>
                <c:pt idx="1315">
                  <c:v>4.1445034625236499</c:v>
                </c:pt>
                <c:pt idx="1316">
                  <c:v>4.1441564891124578</c:v>
                </c:pt>
                <c:pt idx="1317">
                  <c:v>4.1435452805044877</c:v>
                </c:pt>
                <c:pt idx="1318">
                  <c:v>4.1424869732652567</c:v>
                </c:pt>
                <c:pt idx="1319">
                  <c:v>4.1424374402849793</c:v>
                </c:pt>
                <c:pt idx="1320">
                  <c:v>4.1421369929756304</c:v>
                </c:pt>
                <c:pt idx="1321">
                  <c:v>4.1420133110456714</c:v>
                </c:pt>
                <c:pt idx="1322">
                  <c:v>4.1414163246432887</c:v>
                </c:pt>
                <c:pt idx="1323">
                  <c:v>4.1412715245294196</c:v>
                </c:pt>
                <c:pt idx="1324">
                  <c:v>4.1411711293265316</c:v>
                </c:pt>
                <c:pt idx="1325">
                  <c:v>4.1406452441740411</c:v>
                </c:pt>
                <c:pt idx="1326">
                  <c:v>4.1406410554678557</c:v>
                </c:pt>
                <c:pt idx="1327">
                  <c:v>4.1399203459137901</c:v>
                </c:pt>
                <c:pt idx="1328">
                  <c:v>4.1395257724926706</c:v>
                </c:pt>
                <c:pt idx="1329">
                  <c:v>4.1394291733192805</c:v>
                </c:pt>
                <c:pt idx="1330">
                  <c:v>4.1386664757706271</c:v>
                </c:pt>
                <c:pt idx="1331">
                  <c:v>4.1385286479818886</c:v>
                </c:pt>
                <c:pt idx="1332">
                  <c:v>4.138065218932601</c:v>
                </c:pt>
                <c:pt idx="1333">
                  <c:v>4.1375095404387814</c:v>
                </c:pt>
                <c:pt idx="1334">
                  <c:v>4.1371085466974939</c:v>
                </c:pt>
                <c:pt idx="1335">
                  <c:v>4.1365933950042084</c:v>
                </c:pt>
                <c:pt idx="1336">
                  <c:v>4.1364822209723204</c:v>
                </c:pt>
                <c:pt idx="1337">
                  <c:v>4.1364755249555936</c:v>
                </c:pt>
                <c:pt idx="1338">
                  <c:v>4.1363851186236991</c:v>
                </c:pt>
                <c:pt idx="1339">
                  <c:v>4.1361873221981895</c:v>
                </c:pt>
                <c:pt idx="1340">
                  <c:v>4.1359088089468763</c:v>
                </c:pt>
                <c:pt idx="1341">
                  <c:v>4.1358680488359694</c:v>
                </c:pt>
                <c:pt idx="1342">
                  <c:v>4.1357648080641081</c:v>
                </c:pt>
                <c:pt idx="1343">
                  <c:v>4.1349160687930588</c:v>
                </c:pt>
                <c:pt idx="1344">
                  <c:v>4.1346949547616942</c:v>
                </c:pt>
                <c:pt idx="1345">
                  <c:v>4.1342066901792949</c:v>
                </c:pt>
                <c:pt idx="1346">
                  <c:v>4.1332553180126039</c:v>
                </c:pt>
                <c:pt idx="1347">
                  <c:v>4.1332178588837793</c:v>
                </c:pt>
                <c:pt idx="1348">
                  <c:v>4.1327700520909554</c:v>
                </c:pt>
                <c:pt idx="1349">
                  <c:v>4.1325377069957066</c:v>
                </c:pt>
                <c:pt idx="1350">
                  <c:v>4.1321927822448723</c:v>
                </c:pt>
                <c:pt idx="1351">
                  <c:v>4.1321618163414406</c:v>
                </c:pt>
                <c:pt idx="1352">
                  <c:v>4.1319619085614976</c:v>
                </c:pt>
                <c:pt idx="1353">
                  <c:v>4.1319412538937081</c:v>
                </c:pt>
                <c:pt idx="1354">
                  <c:v>4.1317961093443598</c:v>
                </c:pt>
                <c:pt idx="1355">
                  <c:v>4.131738216084555</c:v>
                </c:pt>
                <c:pt idx="1356">
                  <c:v>4.1317366127767707</c:v>
                </c:pt>
                <c:pt idx="1357">
                  <c:v>4.131688867121281</c:v>
                </c:pt>
                <c:pt idx="1358">
                  <c:v>4.1308096231358116</c:v>
                </c:pt>
                <c:pt idx="1359">
                  <c:v>4.1303970314782648</c:v>
                </c:pt>
                <c:pt idx="1360">
                  <c:v>4.1303305514869288</c:v>
                </c:pt>
                <c:pt idx="1361">
                  <c:v>4.1303150022786141</c:v>
                </c:pt>
                <c:pt idx="1362">
                  <c:v>4.129901224626539</c:v>
                </c:pt>
                <c:pt idx="1363">
                  <c:v>4.1293634759422133</c:v>
                </c:pt>
                <c:pt idx="1364">
                  <c:v>4.1290282097669166</c:v>
                </c:pt>
                <c:pt idx="1365">
                  <c:v>4.1288252399293084</c:v>
                </c:pt>
                <c:pt idx="1366">
                  <c:v>4.1287473977087483</c:v>
                </c:pt>
                <c:pt idx="1367">
                  <c:v>4.1287204904706911</c:v>
                </c:pt>
                <c:pt idx="1368">
                  <c:v>4.1279624567831412</c:v>
                </c:pt>
                <c:pt idx="1369">
                  <c:v>4.1275705328450991</c:v>
                </c:pt>
                <c:pt idx="1370">
                  <c:v>4.1272970553503043</c:v>
                </c:pt>
                <c:pt idx="1371">
                  <c:v>4.1272716779837859</c:v>
                </c:pt>
                <c:pt idx="1372">
                  <c:v>4.1270406937850179</c:v>
                </c:pt>
                <c:pt idx="1373">
                  <c:v>4.1269155185247328</c:v>
                </c:pt>
                <c:pt idx="1374">
                  <c:v>4.1269020082460903</c:v>
                </c:pt>
                <c:pt idx="1375">
                  <c:v>4.1267928297745087</c:v>
                </c:pt>
                <c:pt idx="1376">
                  <c:v>4.1264562937566636</c:v>
                </c:pt>
                <c:pt idx="1377">
                  <c:v>4.1263681059655548</c:v>
                </c:pt>
                <c:pt idx="1378">
                  <c:v>4.125790565502431</c:v>
                </c:pt>
                <c:pt idx="1379">
                  <c:v>4.1257846056135792</c:v>
                </c:pt>
                <c:pt idx="1380">
                  <c:v>4.1253760680300884</c:v>
                </c:pt>
                <c:pt idx="1381">
                  <c:v>4.125270483236168</c:v>
                </c:pt>
                <c:pt idx="1382">
                  <c:v>4.124959727000995</c:v>
                </c:pt>
                <c:pt idx="1383">
                  <c:v>4.1249260695011811</c:v>
                </c:pt>
                <c:pt idx="1384">
                  <c:v>4.1244542280972585</c:v>
                </c:pt>
                <c:pt idx="1385">
                  <c:v>4.1239171248803768</c:v>
                </c:pt>
                <c:pt idx="1386">
                  <c:v>4.1238113661777991</c:v>
                </c:pt>
                <c:pt idx="1387">
                  <c:v>4.1233016218630771</c:v>
                </c:pt>
                <c:pt idx="1388">
                  <c:v>4.1231528336671053</c:v>
                </c:pt>
                <c:pt idx="1389">
                  <c:v>4.1214856134994564</c:v>
                </c:pt>
                <c:pt idx="1390">
                  <c:v>4.1210127562922798</c:v>
                </c:pt>
                <c:pt idx="1391">
                  <c:v>4.1208903975425892</c:v>
                </c:pt>
                <c:pt idx="1392">
                  <c:v>4.1201258796746361</c:v>
                </c:pt>
                <c:pt idx="1393">
                  <c:v>4.1195487669371458</c:v>
                </c:pt>
                <c:pt idx="1394">
                  <c:v>4.1191315673402986</c:v>
                </c:pt>
                <c:pt idx="1395">
                  <c:v>4.1186919378179736</c:v>
                </c:pt>
                <c:pt idx="1396">
                  <c:v>4.1186693571767687</c:v>
                </c:pt>
                <c:pt idx="1397">
                  <c:v>4.1185632307970197</c:v>
                </c:pt>
                <c:pt idx="1398">
                  <c:v>4.1183060697500276</c:v>
                </c:pt>
                <c:pt idx="1399">
                  <c:v>4.1178871223317213</c:v>
                </c:pt>
                <c:pt idx="1400">
                  <c:v>4.1178792137775506</c:v>
                </c:pt>
                <c:pt idx="1401">
                  <c:v>4.1176908372730479</c:v>
                </c:pt>
                <c:pt idx="1402">
                  <c:v>4.1173714775682848</c:v>
                </c:pt>
                <c:pt idx="1403">
                  <c:v>4.117183433304727</c:v>
                </c:pt>
                <c:pt idx="1404">
                  <c:v>4.117103660262404</c:v>
                </c:pt>
                <c:pt idx="1405">
                  <c:v>4.1170297696164218</c:v>
                </c:pt>
                <c:pt idx="1406">
                  <c:v>4.1163734155801883</c:v>
                </c:pt>
                <c:pt idx="1407">
                  <c:v>4.1162929398145618</c:v>
                </c:pt>
                <c:pt idx="1408">
                  <c:v>4.1161843846552824</c:v>
                </c:pt>
                <c:pt idx="1409">
                  <c:v>4.1154118999517841</c:v>
                </c:pt>
                <c:pt idx="1410">
                  <c:v>4.1142967687190373</c:v>
                </c:pt>
                <c:pt idx="1411">
                  <c:v>4.1142928743573917</c:v>
                </c:pt>
                <c:pt idx="1412">
                  <c:v>4.1142682092559868</c:v>
                </c:pt>
                <c:pt idx="1413">
                  <c:v>4.1138813588409775</c:v>
                </c:pt>
                <c:pt idx="1414">
                  <c:v>4.1137525177668648</c:v>
                </c:pt>
                <c:pt idx="1415">
                  <c:v>4.1135851901057618</c:v>
                </c:pt>
                <c:pt idx="1416">
                  <c:v>4.1133016445041868</c:v>
                </c:pt>
                <c:pt idx="1417">
                  <c:v>4.1120481863148495</c:v>
                </c:pt>
                <c:pt idx="1418">
                  <c:v>4.111874046706645</c:v>
                </c:pt>
                <c:pt idx="1419">
                  <c:v>4.1116106537568813</c:v>
                </c:pt>
                <c:pt idx="1420">
                  <c:v>4.1114303650930486</c:v>
                </c:pt>
                <c:pt idx="1421">
                  <c:v>4.1109565173562794</c:v>
                </c:pt>
                <c:pt idx="1422">
                  <c:v>4.1107839958474317</c:v>
                </c:pt>
                <c:pt idx="1423">
                  <c:v>4.110415171893032</c:v>
                </c:pt>
                <c:pt idx="1424">
                  <c:v>4.1091071774768428</c:v>
                </c:pt>
                <c:pt idx="1425">
                  <c:v>4.1083219898538283</c:v>
                </c:pt>
                <c:pt idx="1426">
                  <c:v>4.1080355503376023</c:v>
                </c:pt>
                <c:pt idx="1427">
                  <c:v>4.1079405303119945</c:v>
                </c:pt>
                <c:pt idx="1428">
                  <c:v>4.1079219001862795</c:v>
                </c:pt>
                <c:pt idx="1429">
                  <c:v>4.1074306422370395</c:v>
                </c:pt>
                <c:pt idx="1430">
                  <c:v>4.1073809017583107</c:v>
                </c:pt>
                <c:pt idx="1431">
                  <c:v>4.1072753727893874</c:v>
                </c:pt>
                <c:pt idx="1432">
                  <c:v>4.1071051532971499</c:v>
                </c:pt>
                <c:pt idx="1433">
                  <c:v>4.1068541322061041</c:v>
                </c:pt>
                <c:pt idx="1434">
                  <c:v>4.106610138743731</c:v>
                </c:pt>
                <c:pt idx="1435">
                  <c:v>4.1061733256094062</c:v>
                </c:pt>
                <c:pt idx="1436">
                  <c:v>4.1061321333541372</c:v>
                </c:pt>
                <c:pt idx="1437">
                  <c:v>4.1057466642105584</c:v>
                </c:pt>
                <c:pt idx="1438">
                  <c:v>4.1055014798695906</c:v>
                </c:pt>
                <c:pt idx="1439">
                  <c:v>4.1050805980048448</c:v>
                </c:pt>
                <c:pt idx="1440">
                  <c:v>4.1049868238209184</c:v>
                </c:pt>
                <c:pt idx="1441">
                  <c:v>4.1048208222925204</c:v>
                </c:pt>
                <c:pt idx="1442">
                  <c:v>4.1041402352642509</c:v>
                </c:pt>
                <c:pt idx="1443">
                  <c:v>4.103472079107636</c:v>
                </c:pt>
                <c:pt idx="1444">
                  <c:v>4.1031774752438128</c:v>
                </c:pt>
                <c:pt idx="1445">
                  <c:v>4.1031358075677211</c:v>
                </c:pt>
                <c:pt idx="1446">
                  <c:v>4.1027474781278865</c:v>
                </c:pt>
                <c:pt idx="1447">
                  <c:v>4.1026853893699329</c:v>
                </c:pt>
                <c:pt idx="1448">
                  <c:v>4.1022928439675646</c:v>
                </c:pt>
                <c:pt idx="1449">
                  <c:v>4.1020979639570472</c:v>
                </c:pt>
                <c:pt idx="1450">
                  <c:v>4.1020254813710233</c:v>
                </c:pt>
                <c:pt idx="1451">
                  <c:v>4.1016697598984893</c:v>
                </c:pt>
                <c:pt idx="1452">
                  <c:v>4.1016275654400598</c:v>
                </c:pt>
                <c:pt idx="1453">
                  <c:v>4.1014711619852857</c:v>
                </c:pt>
                <c:pt idx="1454">
                  <c:v>4.1014123290147557</c:v>
                </c:pt>
                <c:pt idx="1455">
                  <c:v>4.1013364838487938</c:v>
                </c:pt>
                <c:pt idx="1456">
                  <c:v>4.1012084531432365</c:v>
                </c:pt>
                <c:pt idx="1457">
                  <c:v>4.1011721390578071</c:v>
                </c:pt>
                <c:pt idx="1458">
                  <c:v>4.097938169441214</c:v>
                </c:pt>
                <c:pt idx="1459">
                  <c:v>4.0975729157750367</c:v>
                </c:pt>
                <c:pt idx="1460">
                  <c:v>4.0964022673393199</c:v>
                </c:pt>
                <c:pt idx="1461">
                  <c:v>4.0962921033954336</c:v>
                </c:pt>
                <c:pt idx="1462">
                  <c:v>4.0962578889050008</c:v>
                </c:pt>
                <c:pt idx="1463">
                  <c:v>4.0962317912951365</c:v>
                </c:pt>
                <c:pt idx="1464">
                  <c:v>4.0940975065538794</c:v>
                </c:pt>
                <c:pt idx="1465">
                  <c:v>4.0937583663397739</c:v>
                </c:pt>
                <c:pt idx="1466">
                  <c:v>4.0937503948171621</c:v>
                </c:pt>
                <c:pt idx="1467">
                  <c:v>4.0935024268542639</c:v>
                </c:pt>
                <c:pt idx="1468">
                  <c:v>4.0932965545245574</c:v>
                </c:pt>
                <c:pt idx="1469">
                  <c:v>4.0927225935869327</c:v>
                </c:pt>
                <c:pt idx="1470">
                  <c:v>4.0924268450129269</c:v>
                </c:pt>
                <c:pt idx="1471">
                  <c:v>4.0922528499961848</c:v>
                </c:pt>
                <c:pt idx="1472">
                  <c:v>4.0922159743874706</c:v>
                </c:pt>
                <c:pt idx="1473">
                  <c:v>4.0921710950840762</c:v>
                </c:pt>
                <c:pt idx="1474">
                  <c:v>4.0921219176527739</c:v>
                </c:pt>
                <c:pt idx="1475">
                  <c:v>4.0919634191498053</c:v>
                </c:pt>
                <c:pt idx="1476">
                  <c:v>4.0919368669460887</c:v>
                </c:pt>
                <c:pt idx="1477">
                  <c:v>4.0901818026449304</c:v>
                </c:pt>
                <c:pt idx="1478">
                  <c:v>4.0900441654121469</c:v>
                </c:pt>
                <c:pt idx="1479">
                  <c:v>4.0900104356753362</c:v>
                </c:pt>
                <c:pt idx="1480">
                  <c:v>4.0899637588118027</c:v>
                </c:pt>
                <c:pt idx="1481">
                  <c:v>4.0898733326317274</c:v>
                </c:pt>
                <c:pt idx="1482">
                  <c:v>4.0898138882486936</c:v>
                </c:pt>
                <c:pt idx="1483">
                  <c:v>4.0897734692688754</c:v>
                </c:pt>
                <c:pt idx="1484">
                  <c:v>4.0897334389988806</c:v>
                </c:pt>
                <c:pt idx="1485">
                  <c:v>4.0885436024723187</c:v>
                </c:pt>
                <c:pt idx="1486">
                  <c:v>4.0883505240476508</c:v>
                </c:pt>
                <c:pt idx="1487">
                  <c:v>4.0882575953727844</c:v>
                </c:pt>
                <c:pt idx="1488">
                  <c:v>4.0882339662678273</c:v>
                </c:pt>
                <c:pt idx="1489">
                  <c:v>4.0880133659376643</c:v>
                </c:pt>
                <c:pt idx="1490">
                  <c:v>4.0877863457781549</c:v>
                </c:pt>
                <c:pt idx="1491">
                  <c:v>4.087570053891219</c:v>
                </c:pt>
                <c:pt idx="1492">
                  <c:v>4.0870615311171887</c:v>
                </c:pt>
                <c:pt idx="1493">
                  <c:v>4.0868731259329003</c:v>
                </c:pt>
                <c:pt idx="1494">
                  <c:v>4.086094941024057</c:v>
                </c:pt>
                <c:pt idx="1495">
                  <c:v>4.0860581325161034</c:v>
                </c:pt>
                <c:pt idx="1496">
                  <c:v>4.0856274787554065</c:v>
                </c:pt>
                <c:pt idx="1497">
                  <c:v>4.0852069071232755</c:v>
                </c:pt>
                <c:pt idx="1498">
                  <c:v>4.0848674971476511</c:v>
                </c:pt>
                <c:pt idx="1499">
                  <c:v>4.0844624766798203</c:v>
                </c:pt>
                <c:pt idx="1500">
                  <c:v>4.0844191727335817</c:v>
                </c:pt>
                <c:pt idx="1501">
                  <c:v>4.0837314917886332</c:v>
                </c:pt>
                <c:pt idx="1502">
                  <c:v>4.0832182525858007</c:v>
                </c:pt>
                <c:pt idx="1503">
                  <c:v>4.0827588492284042</c:v>
                </c:pt>
                <c:pt idx="1504">
                  <c:v>4.0824265004262452</c:v>
                </c:pt>
                <c:pt idx="1505">
                  <c:v>4.0821709815265805</c:v>
                </c:pt>
                <c:pt idx="1506">
                  <c:v>4.0818006115907632</c:v>
                </c:pt>
                <c:pt idx="1507">
                  <c:v>4.0812928875441417</c:v>
                </c:pt>
                <c:pt idx="1508">
                  <c:v>4.081268276143188</c:v>
                </c:pt>
                <c:pt idx="1509">
                  <c:v>4.0808240307467569</c:v>
                </c:pt>
                <c:pt idx="1510">
                  <c:v>4.0802225046145377</c:v>
                </c:pt>
                <c:pt idx="1511">
                  <c:v>4.0794471699868948</c:v>
                </c:pt>
                <c:pt idx="1512">
                  <c:v>4.0793330215299992</c:v>
                </c:pt>
                <c:pt idx="1513">
                  <c:v>4.0792912131804302</c:v>
                </c:pt>
                <c:pt idx="1514">
                  <c:v>4.0791179068170829</c:v>
                </c:pt>
                <c:pt idx="1515">
                  <c:v>4.0786772928065709</c:v>
                </c:pt>
                <c:pt idx="1516">
                  <c:v>4.0785871029655212</c:v>
                </c:pt>
                <c:pt idx="1517">
                  <c:v>4.0785544850632913</c:v>
                </c:pt>
                <c:pt idx="1518">
                  <c:v>4.0781173298980145</c:v>
                </c:pt>
                <c:pt idx="1519">
                  <c:v>4.0779963798067715</c:v>
                </c:pt>
                <c:pt idx="1520">
                  <c:v>4.0778037980760882</c:v>
                </c:pt>
                <c:pt idx="1521">
                  <c:v>4.0774654137394553</c:v>
                </c:pt>
                <c:pt idx="1522">
                  <c:v>4.0774337208459581</c:v>
                </c:pt>
                <c:pt idx="1523">
                  <c:v>4.0772156433383344</c:v>
                </c:pt>
                <c:pt idx="1524">
                  <c:v>4.0763618671023742</c:v>
                </c:pt>
                <c:pt idx="1525">
                  <c:v>4.0758884639713315</c:v>
                </c:pt>
                <c:pt idx="1526">
                  <c:v>4.0758473357484784</c:v>
                </c:pt>
                <c:pt idx="1527">
                  <c:v>4.0758033667889606</c:v>
                </c:pt>
                <c:pt idx="1528">
                  <c:v>4.0757806713906186</c:v>
                </c:pt>
                <c:pt idx="1529">
                  <c:v>4.075769931190476</c:v>
                </c:pt>
                <c:pt idx="1530">
                  <c:v>4.0748702570065589</c:v>
                </c:pt>
                <c:pt idx="1531">
                  <c:v>4.0748495435738574</c:v>
                </c:pt>
                <c:pt idx="1532">
                  <c:v>4.0744287658564335</c:v>
                </c:pt>
                <c:pt idx="1533">
                  <c:v>4.0735727466842482</c:v>
                </c:pt>
                <c:pt idx="1534">
                  <c:v>4.0727797249111903</c:v>
                </c:pt>
                <c:pt idx="1535">
                  <c:v>4.0726431954230549</c:v>
                </c:pt>
                <c:pt idx="1536">
                  <c:v>4.0725362275450241</c:v>
                </c:pt>
                <c:pt idx="1537">
                  <c:v>4.0721078880096249</c:v>
                </c:pt>
                <c:pt idx="1538">
                  <c:v>4.0717304685304798</c:v>
                </c:pt>
                <c:pt idx="1539">
                  <c:v>4.0717126730594444</c:v>
                </c:pt>
                <c:pt idx="1540">
                  <c:v>4.0716731931468999</c:v>
                </c:pt>
                <c:pt idx="1541">
                  <c:v>4.0714481095559831</c:v>
                </c:pt>
                <c:pt idx="1542">
                  <c:v>4.0714073774243165</c:v>
                </c:pt>
                <c:pt idx="1543">
                  <c:v>4.0710195144526935</c:v>
                </c:pt>
                <c:pt idx="1544">
                  <c:v>4.0708100801088234</c:v>
                </c:pt>
                <c:pt idx="1545">
                  <c:v>4.0707791277216296</c:v>
                </c:pt>
                <c:pt idx="1546">
                  <c:v>4.0706460688295287</c:v>
                </c:pt>
                <c:pt idx="1547">
                  <c:v>4.0704867135592089</c:v>
                </c:pt>
                <c:pt idx="1548">
                  <c:v>4.0704056804124455</c:v>
                </c:pt>
                <c:pt idx="1549">
                  <c:v>4.0698074137925504</c:v>
                </c:pt>
                <c:pt idx="1550">
                  <c:v>4.0695135220611407</c:v>
                </c:pt>
                <c:pt idx="1551">
                  <c:v>4.0688046924088308</c:v>
                </c:pt>
                <c:pt idx="1552">
                  <c:v>4.0682701965976236</c:v>
                </c:pt>
                <c:pt idx="1553">
                  <c:v>4.0682541144422606</c:v>
                </c:pt>
                <c:pt idx="1554">
                  <c:v>4.0677612582172049</c:v>
                </c:pt>
                <c:pt idx="1555">
                  <c:v>4.0675944392932335</c:v>
                </c:pt>
                <c:pt idx="1556">
                  <c:v>4.0675665610710867</c:v>
                </c:pt>
                <c:pt idx="1557">
                  <c:v>4.067375908674526</c:v>
                </c:pt>
                <c:pt idx="1558">
                  <c:v>4.0669786367249072</c:v>
                </c:pt>
                <c:pt idx="1559">
                  <c:v>4.0667595890494361</c:v>
                </c:pt>
                <c:pt idx="1560">
                  <c:v>4.0658188490025369</c:v>
                </c:pt>
                <c:pt idx="1561">
                  <c:v>4.0653165771297388</c:v>
                </c:pt>
                <c:pt idx="1562">
                  <c:v>4.0650914970572005</c:v>
                </c:pt>
                <c:pt idx="1563">
                  <c:v>4.0648064497541201</c:v>
                </c:pt>
                <c:pt idx="1564">
                  <c:v>4.0647779762996352</c:v>
                </c:pt>
                <c:pt idx="1565">
                  <c:v>4.0647043939108674</c:v>
                </c:pt>
                <c:pt idx="1566">
                  <c:v>4.0646382838454533</c:v>
                </c:pt>
                <c:pt idx="1567">
                  <c:v>4.064491475202014</c:v>
                </c:pt>
                <c:pt idx="1568">
                  <c:v>4.0644831559461423</c:v>
                </c:pt>
                <c:pt idx="1569">
                  <c:v>4.0641542096634549</c:v>
                </c:pt>
                <c:pt idx="1570">
                  <c:v>4.0634857711110142</c:v>
                </c:pt>
                <c:pt idx="1571">
                  <c:v>4.062961590940942</c:v>
                </c:pt>
                <c:pt idx="1572">
                  <c:v>4.0628346746852104</c:v>
                </c:pt>
                <c:pt idx="1573">
                  <c:v>4.0625968155805943</c:v>
                </c:pt>
                <c:pt idx="1574">
                  <c:v>4.062441792484913</c:v>
                </c:pt>
                <c:pt idx="1575">
                  <c:v>4.062359871146187</c:v>
                </c:pt>
                <c:pt idx="1576">
                  <c:v>4.0622990470960163</c:v>
                </c:pt>
                <c:pt idx="1577">
                  <c:v>4.0616084837557684</c:v>
                </c:pt>
                <c:pt idx="1578">
                  <c:v>4.061508395928402</c:v>
                </c:pt>
                <c:pt idx="1579">
                  <c:v>4.0610025787669644</c:v>
                </c:pt>
                <c:pt idx="1580">
                  <c:v>4.0601209156645792</c:v>
                </c:pt>
                <c:pt idx="1581">
                  <c:v>4.0600759555774975</c:v>
                </c:pt>
                <c:pt idx="1582">
                  <c:v>4.0599713108106465</c:v>
                </c:pt>
                <c:pt idx="1583">
                  <c:v>4.0594161459428104</c:v>
                </c:pt>
                <c:pt idx="1584">
                  <c:v>4.0591629318409588</c:v>
                </c:pt>
                <c:pt idx="1585">
                  <c:v>4.0585799574356241</c:v>
                </c:pt>
                <c:pt idx="1586">
                  <c:v>4.0583737169988821</c:v>
                </c:pt>
                <c:pt idx="1587">
                  <c:v>4.0577370861151385</c:v>
                </c:pt>
                <c:pt idx="1588">
                  <c:v>4.0566143779855457</c:v>
                </c:pt>
                <c:pt idx="1589">
                  <c:v>4.0565542265711692</c:v>
                </c:pt>
                <c:pt idx="1590">
                  <c:v>4.0564059304589435</c:v>
                </c:pt>
                <c:pt idx="1591">
                  <c:v>4.0556172040953413</c:v>
                </c:pt>
                <c:pt idx="1592">
                  <c:v>4.0555983113941814</c:v>
                </c:pt>
                <c:pt idx="1593">
                  <c:v>4.0551257265593197</c:v>
                </c:pt>
                <c:pt idx="1594">
                  <c:v>4.0550290222499799</c:v>
                </c:pt>
                <c:pt idx="1595">
                  <c:v>4.0549654619772539</c:v>
                </c:pt>
                <c:pt idx="1596">
                  <c:v>4.054935060297324</c:v>
                </c:pt>
                <c:pt idx="1597">
                  <c:v>4.0548706357187578</c:v>
                </c:pt>
                <c:pt idx="1598">
                  <c:v>4.0546232671230404</c:v>
                </c:pt>
                <c:pt idx="1599">
                  <c:v>4.0545028286645994</c:v>
                </c:pt>
                <c:pt idx="1600">
                  <c:v>4.0540727227823066</c:v>
                </c:pt>
                <c:pt idx="1601">
                  <c:v>4.054049075900231</c:v>
                </c:pt>
                <c:pt idx="1602">
                  <c:v>4.0527601859077613</c:v>
                </c:pt>
                <c:pt idx="1603">
                  <c:v>4.0526659454625538</c:v>
                </c:pt>
                <c:pt idx="1604">
                  <c:v>4.0523955050439833</c:v>
                </c:pt>
                <c:pt idx="1605">
                  <c:v>4.0523298470658142</c:v>
                </c:pt>
                <c:pt idx="1606">
                  <c:v>4.0521499318436511</c:v>
                </c:pt>
                <c:pt idx="1607">
                  <c:v>4.051871247742409</c:v>
                </c:pt>
                <c:pt idx="1608">
                  <c:v>4.0513855848887248</c:v>
                </c:pt>
                <c:pt idx="1609">
                  <c:v>4.0513602906929496</c:v>
                </c:pt>
                <c:pt idx="1610">
                  <c:v>4.0512099956423997</c:v>
                </c:pt>
                <c:pt idx="1611">
                  <c:v>4.051055572809231</c:v>
                </c:pt>
                <c:pt idx="1612">
                  <c:v>4.0508495902481503</c:v>
                </c:pt>
                <c:pt idx="1613">
                  <c:v>4.0498556398207102</c:v>
                </c:pt>
                <c:pt idx="1614">
                  <c:v>4.0498048714117365</c:v>
                </c:pt>
                <c:pt idx="1615">
                  <c:v>4.0495735418906911</c:v>
                </c:pt>
                <c:pt idx="1616">
                  <c:v>4.0493278749393395</c:v>
                </c:pt>
                <c:pt idx="1617">
                  <c:v>4.0492865220521903</c:v>
                </c:pt>
                <c:pt idx="1618">
                  <c:v>4.048869111336975</c:v>
                </c:pt>
                <c:pt idx="1619">
                  <c:v>4.0486126908306383</c:v>
                </c:pt>
                <c:pt idx="1620">
                  <c:v>4.048578605049971</c:v>
                </c:pt>
                <c:pt idx="1621">
                  <c:v>4.0482216223372021</c:v>
                </c:pt>
                <c:pt idx="1622">
                  <c:v>4.0480428048752977</c:v>
                </c:pt>
                <c:pt idx="1623">
                  <c:v>4.0479676277294674</c:v>
                </c:pt>
                <c:pt idx="1624">
                  <c:v>4.0479481832460324</c:v>
                </c:pt>
                <c:pt idx="1625">
                  <c:v>4.0473696358094626</c:v>
                </c:pt>
                <c:pt idx="1626">
                  <c:v>4.0470298449381108</c:v>
                </c:pt>
                <c:pt idx="1627">
                  <c:v>4.0467136223282001</c:v>
                </c:pt>
                <c:pt idx="1628">
                  <c:v>4.046598772201861</c:v>
                </c:pt>
                <c:pt idx="1629">
                  <c:v>4.0465810002236413</c:v>
                </c:pt>
                <c:pt idx="1630">
                  <c:v>4.046471968392531</c:v>
                </c:pt>
                <c:pt idx="1631">
                  <c:v>4.0462833198686736</c:v>
                </c:pt>
                <c:pt idx="1632">
                  <c:v>4.0457798561505838</c:v>
                </c:pt>
                <c:pt idx="1633">
                  <c:v>4.0456936445790408</c:v>
                </c:pt>
                <c:pt idx="1634">
                  <c:v>4.0455967718675785</c:v>
                </c:pt>
                <c:pt idx="1635">
                  <c:v>4.0453060240164724</c:v>
                </c:pt>
                <c:pt idx="1636">
                  <c:v>4.0447999020323842</c:v>
                </c:pt>
                <c:pt idx="1637">
                  <c:v>4.0445354052313656</c:v>
                </c:pt>
                <c:pt idx="1638">
                  <c:v>4.0438615714813215</c:v>
                </c:pt>
                <c:pt idx="1639">
                  <c:v>4.0433013546126499</c:v>
                </c:pt>
                <c:pt idx="1640">
                  <c:v>4.0429015374483921</c:v>
                </c:pt>
                <c:pt idx="1641">
                  <c:v>4.0428477634583322</c:v>
                </c:pt>
                <c:pt idx="1642">
                  <c:v>4.0423251970974752</c:v>
                </c:pt>
                <c:pt idx="1643">
                  <c:v>4.0421456864498593</c:v>
                </c:pt>
                <c:pt idx="1644">
                  <c:v>4.0421417451398565</c:v>
                </c:pt>
                <c:pt idx="1645">
                  <c:v>4.0420296217853497</c:v>
                </c:pt>
                <c:pt idx="1646">
                  <c:v>4.0419790254034158</c:v>
                </c:pt>
                <c:pt idx="1647">
                  <c:v>4.0419174694760818</c:v>
                </c:pt>
                <c:pt idx="1648">
                  <c:v>4.0416371811448917</c:v>
                </c:pt>
                <c:pt idx="1649">
                  <c:v>4.0412823427962676</c:v>
                </c:pt>
                <c:pt idx="1650">
                  <c:v>4.0405150945017736</c:v>
                </c:pt>
                <c:pt idx="1651">
                  <c:v>4.0398638250419907</c:v>
                </c:pt>
                <c:pt idx="1652">
                  <c:v>4.0396333043481532</c:v>
                </c:pt>
                <c:pt idx="1653">
                  <c:v>4.0394700824897924</c:v>
                </c:pt>
                <c:pt idx="1654">
                  <c:v>4.0393885587284348</c:v>
                </c:pt>
                <c:pt idx="1655">
                  <c:v>4.0385342835023259</c:v>
                </c:pt>
                <c:pt idx="1656">
                  <c:v>4.038119664608848</c:v>
                </c:pt>
                <c:pt idx="1657">
                  <c:v>4.038018434842721</c:v>
                </c:pt>
                <c:pt idx="1658">
                  <c:v>4.0376247849079956</c:v>
                </c:pt>
                <c:pt idx="1659">
                  <c:v>4.0373286489159304</c:v>
                </c:pt>
                <c:pt idx="1660">
                  <c:v>4.0371408587259729</c:v>
                </c:pt>
                <c:pt idx="1661">
                  <c:v>4.0367876463934298</c:v>
                </c:pt>
                <c:pt idx="1662">
                  <c:v>4.036261949600342</c:v>
                </c:pt>
                <c:pt idx="1663">
                  <c:v>4.0361627278258645</c:v>
                </c:pt>
                <c:pt idx="1664">
                  <c:v>4.0353394453582645</c:v>
                </c:pt>
                <c:pt idx="1665">
                  <c:v>4.0352386777511491</c:v>
                </c:pt>
                <c:pt idx="1666">
                  <c:v>4.034861203180351</c:v>
                </c:pt>
                <c:pt idx="1667">
                  <c:v>4.0346563036909897</c:v>
                </c:pt>
                <c:pt idx="1668">
                  <c:v>4.0343494418652481</c:v>
                </c:pt>
                <c:pt idx="1669">
                  <c:v>4.0340903235895009</c:v>
                </c:pt>
                <c:pt idx="1670">
                  <c:v>4.0340370090035726</c:v>
                </c:pt>
                <c:pt idx="1671">
                  <c:v>4.0328199257252821</c:v>
                </c:pt>
                <c:pt idx="1672">
                  <c:v>4.0324750465690196</c:v>
                </c:pt>
                <c:pt idx="1673">
                  <c:v>4.0321435613200833</c:v>
                </c:pt>
                <c:pt idx="1674">
                  <c:v>4.0315967299356386</c:v>
                </c:pt>
                <c:pt idx="1675">
                  <c:v>4.0314046487277873</c:v>
                </c:pt>
                <c:pt idx="1676">
                  <c:v>4.031057744908261</c:v>
                </c:pt>
                <c:pt idx="1677">
                  <c:v>4.031047636759399</c:v>
                </c:pt>
                <c:pt idx="1678">
                  <c:v>4.0309669877677328</c:v>
                </c:pt>
                <c:pt idx="1679">
                  <c:v>4.0306235564652084</c:v>
                </c:pt>
                <c:pt idx="1680">
                  <c:v>4.0293896403956531</c:v>
                </c:pt>
                <c:pt idx="1681">
                  <c:v>4.0291916173711328</c:v>
                </c:pt>
                <c:pt idx="1682">
                  <c:v>4.0285771263817658</c:v>
                </c:pt>
                <c:pt idx="1683">
                  <c:v>4.0285140930302523</c:v>
                </c:pt>
                <c:pt idx="1684">
                  <c:v>4.0275407730730812</c:v>
                </c:pt>
                <c:pt idx="1685">
                  <c:v>4.0272972717965372</c:v>
                </c:pt>
                <c:pt idx="1686">
                  <c:v>4.0267300075117802</c:v>
                </c:pt>
                <c:pt idx="1687">
                  <c:v>4.0264917260624324</c:v>
                </c:pt>
                <c:pt idx="1688">
                  <c:v>4.0261052052515671</c:v>
                </c:pt>
                <c:pt idx="1689">
                  <c:v>4.0260274962085028</c:v>
                </c:pt>
                <c:pt idx="1690">
                  <c:v>4.0258574876013125</c:v>
                </c:pt>
                <c:pt idx="1691">
                  <c:v>4.0257012846789317</c:v>
                </c:pt>
                <c:pt idx="1692">
                  <c:v>4.0250219332575217</c:v>
                </c:pt>
                <c:pt idx="1693">
                  <c:v>4.0248649737699367</c:v>
                </c:pt>
                <c:pt idx="1694">
                  <c:v>4.0241350165069862</c:v>
                </c:pt>
                <c:pt idx="1695">
                  <c:v>4.0239978273288148</c:v>
                </c:pt>
                <c:pt idx="1696">
                  <c:v>4.0232808170626821</c:v>
                </c:pt>
                <c:pt idx="1697">
                  <c:v>4.0229724449769266</c:v>
                </c:pt>
                <c:pt idx="1698">
                  <c:v>4.0229655796053345</c:v>
                </c:pt>
                <c:pt idx="1699">
                  <c:v>4.0228158875267921</c:v>
                </c:pt>
                <c:pt idx="1700">
                  <c:v>4.0225422342559565</c:v>
                </c:pt>
                <c:pt idx="1701">
                  <c:v>4.0218758146416373</c:v>
                </c:pt>
                <c:pt idx="1702">
                  <c:v>4.0215439429494335</c:v>
                </c:pt>
                <c:pt idx="1703">
                  <c:v>4.0211757415173546</c:v>
                </c:pt>
                <c:pt idx="1704">
                  <c:v>4.0205012362637929</c:v>
                </c:pt>
                <c:pt idx="1705">
                  <c:v>4.0204812127710712</c:v>
                </c:pt>
                <c:pt idx="1706">
                  <c:v>4.0204722364229175</c:v>
                </c:pt>
                <c:pt idx="1707">
                  <c:v>4.0203628942124521</c:v>
                </c:pt>
                <c:pt idx="1708">
                  <c:v>4.0199022037380585</c:v>
                </c:pt>
                <c:pt idx="1709">
                  <c:v>4.0196589924868169</c:v>
                </c:pt>
                <c:pt idx="1710">
                  <c:v>4.019265878092293</c:v>
                </c:pt>
                <c:pt idx="1711">
                  <c:v>4.0189828184715726</c:v>
                </c:pt>
                <c:pt idx="1712">
                  <c:v>4.0189003594015071</c:v>
                </c:pt>
                <c:pt idx="1713">
                  <c:v>4.0187998628982164</c:v>
                </c:pt>
                <c:pt idx="1714">
                  <c:v>4.0182551601677261</c:v>
                </c:pt>
                <c:pt idx="1715">
                  <c:v>4.0176991181117749</c:v>
                </c:pt>
                <c:pt idx="1716">
                  <c:v>4.0174354322853159</c:v>
                </c:pt>
                <c:pt idx="1717">
                  <c:v>4.0173786424181435</c:v>
                </c:pt>
                <c:pt idx="1718">
                  <c:v>4.016511733613882</c:v>
                </c:pt>
                <c:pt idx="1719">
                  <c:v>4.0163595676738337</c:v>
                </c:pt>
                <c:pt idx="1720">
                  <c:v>4.0162291968879344</c:v>
                </c:pt>
                <c:pt idx="1721">
                  <c:v>4.0160408919202704</c:v>
                </c:pt>
                <c:pt idx="1722">
                  <c:v>4.0158008591030185</c:v>
                </c:pt>
                <c:pt idx="1723">
                  <c:v>4.0153755916845997</c:v>
                </c:pt>
                <c:pt idx="1724">
                  <c:v>4.0151906438769682</c:v>
                </c:pt>
                <c:pt idx="1725">
                  <c:v>4.0149109762259609</c:v>
                </c:pt>
                <c:pt idx="1726">
                  <c:v>4.0147393575880397</c:v>
                </c:pt>
                <c:pt idx="1727">
                  <c:v>4.0146948096004849</c:v>
                </c:pt>
                <c:pt idx="1728">
                  <c:v>4.0142883022667109</c:v>
                </c:pt>
                <c:pt idx="1729">
                  <c:v>4.0142196578599529</c:v>
                </c:pt>
                <c:pt idx="1730">
                  <c:v>4.0141645476956143</c:v>
                </c:pt>
                <c:pt idx="1731">
                  <c:v>4.0136242847380386</c:v>
                </c:pt>
                <c:pt idx="1732">
                  <c:v>4.0131753461398381</c:v>
                </c:pt>
                <c:pt idx="1733">
                  <c:v>4.0130587661289567</c:v>
                </c:pt>
                <c:pt idx="1734">
                  <c:v>4.0126495520793339</c:v>
                </c:pt>
                <c:pt idx="1735">
                  <c:v>4.0125007152547942</c:v>
                </c:pt>
                <c:pt idx="1736">
                  <c:v>4.012245581719573</c:v>
                </c:pt>
                <c:pt idx="1737">
                  <c:v>4.0119696437222983</c:v>
                </c:pt>
                <c:pt idx="1738">
                  <c:v>4.0119654188189324</c:v>
                </c:pt>
                <c:pt idx="1739">
                  <c:v>4.0115359072847756</c:v>
                </c:pt>
                <c:pt idx="1740">
                  <c:v>4.01148163038705</c:v>
                </c:pt>
                <c:pt idx="1741">
                  <c:v>4.0107419900407226</c:v>
                </c:pt>
                <c:pt idx="1742">
                  <c:v>4.0104483717740864</c:v>
                </c:pt>
                <c:pt idx="1743">
                  <c:v>4.0099178488387315</c:v>
                </c:pt>
                <c:pt idx="1744">
                  <c:v>4.0096229647062458</c:v>
                </c:pt>
                <c:pt idx="1745">
                  <c:v>4.0093505498108959</c:v>
                </c:pt>
                <c:pt idx="1746">
                  <c:v>4.0092929289300736</c:v>
                </c:pt>
                <c:pt idx="1747">
                  <c:v>4.008907569932525</c:v>
                </c:pt>
                <c:pt idx="1748">
                  <c:v>4.0083723202879789</c:v>
                </c:pt>
                <c:pt idx="1749">
                  <c:v>4.0080735425595053</c:v>
                </c:pt>
                <c:pt idx="1750">
                  <c:v>4.0075372633882269</c:v>
                </c:pt>
                <c:pt idx="1751">
                  <c:v>4.0073781243862694</c:v>
                </c:pt>
                <c:pt idx="1752">
                  <c:v>4.0073159708204651</c:v>
                </c:pt>
                <c:pt idx="1753">
                  <c:v>4.0072400459996658</c:v>
                </c:pt>
                <c:pt idx="1754">
                  <c:v>4.0068101086633554</c:v>
                </c:pt>
                <c:pt idx="1755">
                  <c:v>4.0061145660476987</c:v>
                </c:pt>
                <c:pt idx="1756">
                  <c:v>4.0059896497798633</c:v>
                </c:pt>
                <c:pt idx="1757">
                  <c:v>4.0056387403145717</c:v>
                </c:pt>
                <c:pt idx="1758">
                  <c:v>4.0052241400281199</c:v>
                </c:pt>
                <c:pt idx="1759">
                  <c:v>4.0044236048946642</c:v>
                </c:pt>
                <c:pt idx="1760">
                  <c:v>4.004243490011171</c:v>
                </c:pt>
                <c:pt idx="1761">
                  <c:v>4.004056846597754</c:v>
                </c:pt>
                <c:pt idx="1762">
                  <c:v>4.0033013286434285</c:v>
                </c:pt>
                <c:pt idx="1763">
                  <c:v>4.0030991878385347</c:v>
                </c:pt>
                <c:pt idx="1764">
                  <c:v>4.0023731965084934</c:v>
                </c:pt>
                <c:pt idx="1765">
                  <c:v>4.002337441016711</c:v>
                </c:pt>
                <c:pt idx="1766">
                  <c:v>4.0020604161981872</c:v>
                </c:pt>
                <c:pt idx="1767">
                  <c:v>4.0017469298480872</c:v>
                </c:pt>
                <c:pt idx="1768">
                  <c:v>4.0016570460491314</c:v>
                </c:pt>
                <c:pt idx="1769">
                  <c:v>4.0007974042461765</c:v>
                </c:pt>
                <c:pt idx="1770">
                  <c:v>4.0007405641473097</c:v>
                </c:pt>
                <c:pt idx="1771">
                  <c:v>4.0006899798375013</c:v>
                </c:pt>
                <c:pt idx="1772">
                  <c:v>4.0006198746964499</c:v>
                </c:pt>
                <c:pt idx="1773">
                  <c:v>4.0005259016028205</c:v>
                </c:pt>
                <c:pt idx="1774">
                  <c:v>4.0002351791557587</c:v>
                </c:pt>
                <c:pt idx="1775">
                  <c:v>4.0001300276028084</c:v>
                </c:pt>
                <c:pt idx="1776">
                  <c:v>3.99928113055278</c:v>
                </c:pt>
                <c:pt idx="1777">
                  <c:v>3.9990882315364824</c:v>
                </c:pt>
                <c:pt idx="1778">
                  <c:v>3.9989054060323235</c:v>
                </c:pt>
                <c:pt idx="1779">
                  <c:v>3.9988454147595132</c:v>
                </c:pt>
                <c:pt idx="1780">
                  <c:v>3.9987222615459186</c:v>
                </c:pt>
                <c:pt idx="1781">
                  <c:v>3.9986545002885383</c:v>
                </c:pt>
                <c:pt idx="1782">
                  <c:v>3.998521851225338</c:v>
                </c:pt>
                <c:pt idx="1783">
                  <c:v>3.9982028919765562</c:v>
                </c:pt>
                <c:pt idx="1784">
                  <c:v>3.9981151795067067</c:v>
                </c:pt>
                <c:pt idx="1785">
                  <c:v>3.99793097412326</c:v>
                </c:pt>
                <c:pt idx="1786">
                  <c:v>3.9977847660862929</c:v>
                </c:pt>
                <c:pt idx="1787">
                  <c:v>3.9977185562076785</c:v>
                </c:pt>
                <c:pt idx="1788">
                  <c:v>3.9976149769215246</c:v>
                </c:pt>
                <c:pt idx="1789">
                  <c:v>3.9974706039220198</c:v>
                </c:pt>
                <c:pt idx="1790">
                  <c:v>3.997095495144332</c:v>
                </c:pt>
                <c:pt idx="1791">
                  <c:v>3.9964197250816151</c:v>
                </c:pt>
                <c:pt idx="1792">
                  <c:v>3.9963822595814711</c:v>
                </c:pt>
                <c:pt idx="1793">
                  <c:v>3.9960585593368112</c:v>
                </c:pt>
                <c:pt idx="1794">
                  <c:v>3.9960040176537039</c:v>
                </c:pt>
                <c:pt idx="1795">
                  <c:v>3.9956339760366881</c:v>
                </c:pt>
                <c:pt idx="1796">
                  <c:v>3.9953775147633013</c:v>
                </c:pt>
                <c:pt idx="1797">
                  <c:v>3.9948573013181434</c:v>
                </c:pt>
                <c:pt idx="1798">
                  <c:v>3.9947364308685196</c:v>
                </c:pt>
                <c:pt idx="1799">
                  <c:v>3.9944171222745553</c:v>
                </c:pt>
                <c:pt idx="1800">
                  <c:v>3.9942582355978105</c:v>
                </c:pt>
                <c:pt idx="1801">
                  <c:v>3.9939060333268444</c:v>
                </c:pt>
                <c:pt idx="1802">
                  <c:v>3.9938492629022142</c:v>
                </c:pt>
                <c:pt idx="1803">
                  <c:v>3.993546688424364</c:v>
                </c:pt>
                <c:pt idx="1804">
                  <c:v>3.9933534298610436</c:v>
                </c:pt>
                <c:pt idx="1805">
                  <c:v>3.9931904771855651</c:v>
                </c:pt>
                <c:pt idx="1806">
                  <c:v>3.9928871979620983</c:v>
                </c:pt>
                <c:pt idx="1807">
                  <c:v>3.9927964427221965</c:v>
                </c:pt>
                <c:pt idx="1808">
                  <c:v>3.9925127716662145</c:v>
                </c:pt>
                <c:pt idx="1809">
                  <c:v>3.9920734030413589</c:v>
                </c:pt>
                <c:pt idx="1810">
                  <c:v>3.9918524456322126</c:v>
                </c:pt>
                <c:pt idx="1811">
                  <c:v>3.9907898387991336</c:v>
                </c:pt>
                <c:pt idx="1812">
                  <c:v>3.9907242791858066</c:v>
                </c:pt>
                <c:pt idx="1813">
                  <c:v>3.9905603368415434</c:v>
                </c:pt>
                <c:pt idx="1814">
                  <c:v>3.9905228556147074</c:v>
                </c:pt>
                <c:pt idx="1815">
                  <c:v>3.9903985526070458</c:v>
                </c:pt>
                <c:pt idx="1816">
                  <c:v>3.990351189720414</c:v>
                </c:pt>
                <c:pt idx="1817">
                  <c:v>3.9896188748227854</c:v>
                </c:pt>
                <c:pt idx="1818">
                  <c:v>3.9895348487896989</c:v>
                </c:pt>
                <c:pt idx="1819">
                  <c:v>3.9894569866307319</c:v>
                </c:pt>
                <c:pt idx="1820">
                  <c:v>3.9888850754677394</c:v>
                </c:pt>
                <c:pt idx="1821">
                  <c:v>3.9888080870111269</c:v>
                </c:pt>
                <c:pt idx="1822">
                  <c:v>3.9887011221954034</c:v>
                </c:pt>
                <c:pt idx="1823">
                  <c:v>3.9886449055859003</c:v>
                </c:pt>
                <c:pt idx="1824">
                  <c:v>3.9886330174412152</c:v>
                </c:pt>
                <c:pt idx="1825">
                  <c:v>3.9885507821964428</c:v>
                </c:pt>
                <c:pt idx="1826">
                  <c:v>3.9885237798799666</c:v>
                </c:pt>
                <c:pt idx="1827">
                  <c:v>3.9881440833518447</c:v>
                </c:pt>
                <c:pt idx="1828">
                  <c:v>3.9879836287310981</c:v>
                </c:pt>
                <c:pt idx="1829">
                  <c:v>3.9875726740128097</c:v>
                </c:pt>
                <c:pt idx="1830">
                  <c:v>3.9875240086981281</c:v>
                </c:pt>
                <c:pt idx="1831">
                  <c:v>3.9875187942338166</c:v>
                </c:pt>
                <c:pt idx="1832">
                  <c:v>3.9871441822675111</c:v>
                </c:pt>
                <c:pt idx="1833">
                  <c:v>3.9867622821643534</c:v>
                </c:pt>
                <c:pt idx="1834">
                  <c:v>3.9865848927313441</c:v>
                </c:pt>
                <c:pt idx="1835">
                  <c:v>3.9864499984168691</c:v>
                </c:pt>
                <c:pt idx="1836">
                  <c:v>3.9860091843320804</c:v>
                </c:pt>
                <c:pt idx="1837">
                  <c:v>3.985672918536681</c:v>
                </c:pt>
                <c:pt idx="1838">
                  <c:v>3.9854658946356638</c:v>
                </c:pt>
                <c:pt idx="1839">
                  <c:v>3.9853034489728674</c:v>
                </c:pt>
                <c:pt idx="1840">
                  <c:v>3.9845763155984399</c:v>
                </c:pt>
                <c:pt idx="1841">
                  <c:v>3.9845153119487629</c:v>
                </c:pt>
                <c:pt idx="1842">
                  <c:v>3.9842529486048446</c:v>
                </c:pt>
                <c:pt idx="1843">
                  <c:v>3.9841143247624862</c:v>
                </c:pt>
                <c:pt idx="1844">
                  <c:v>3.983858980961533</c:v>
                </c:pt>
                <c:pt idx="1845">
                  <c:v>3.9837452796360573</c:v>
                </c:pt>
                <c:pt idx="1846">
                  <c:v>3.983220465427276</c:v>
                </c:pt>
                <c:pt idx="1847">
                  <c:v>3.9831690526685604</c:v>
                </c:pt>
                <c:pt idx="1848">
                  <c:v>3.9830428775200342</c:v>
                </c:pt>
                <c:pt idx="1849">
                  <c:v>3.9829851709026669</c:v>
                </c:pt>
                <c:pt idx="1850">
                  <c:v>3.9829648463115941</c:v>
                </c:pt>
                <c:pt idx="1851">
                  <c:v>3.9825810097418564</c:v>
                </c:pt>
                <c:pt idx="1852">
                  <c:v>3.9824936012264658</c:v>
                </c:pt>
                <c:pt idx="1853">
                  <c:v>3.9823345630338127</c:v>
                </c:pt>
                <c:pt idx="1854">
                  <c:v>3.9821023078923647</c:v>
                </c:pt>
                <c:pt idx="1855">
                  <c:v>3.9819816068321665</c:v>
                </c:pt>
                <c:pt idx="1856">
                  <c:v>3.9819790918699964</c:v>
                </c:pt>
                <c:pt idx="1857">
                  <c:v>3.981878229883606</c:v>
                </c:pt>
                <c:pt idx="1858">
                  <c:v>3.9818148333057968</c:v>
                </c:pt>
                <c:pt idx="1859">
                  <c:v>3.9814425691119624</c:v>
                </c:pt>
                <c:pt idx="1860">
                  <c:v>3.9811254272815311</c:v>
                </c:pt>
                <c:pt idx="1861">
                  <c:v>3.9802314489247892</c:v>
                </c:pt>
                <c:pt idx="1862">
                  <c:v>3.9798747569093198</c:v>
                </c:pt>
                <c:pt idx="1863">
                  <c:v>3.9797160206803563</c:v>
                </c:pt>
                <c:pt idx="1864">
                  <c:v>3.9790964450582491</c:v>
                </c:pt>
                <c:pt idx="1865">
                  <c:v>3.9786850992815981</c:v>
                </c:pt>
                <c:pt idx="1866">
                  <c:v>3.978362639884276</c:v>
                </c:pt>
                <c:pt idx="1867">
                  <c:v>3.9782198396370472</c:v>
                </c:pt>
                <c:pt idx="1868">
                  <c:v>3.9779302904315896</c:v>
                </c:pt>
                <c:pt idx="1869">
                  <c:v>3.9778137564817087</c:v>
                </c:pt>
                <c:pt idx="1870">
                  <c:v>3.9775938054960105</c:v>
                </c:pt>
                <c:pt idx="1871">
                  <c:v>3.9774525311103042</c:v>
                </c:pt>
                <c:pt idx="1872">
                  <c:v>3.9772318885355058</c:v>
                </c:pt>
                <c:pt idx="1873">
                  <c:v>3.977178744714656</c:v>
                </c:pt>
                <c:pt idx="1874">
                  <c:v>3.9757133320660367</c:v>
                </c:pt>
                <c:pt idx="1875">
                  <c:v>3.9755987538376227</c:v>
                </c:pt>
                <c:pt idx="1876">
                  <c:v>3.975455807658792</c:v>
                </c:pt>
                <c:pt idx="1877">
                  <c:v>3.9753695066547112</c:v>
                </c:pt>
                <c:pt idx="1878">
                  <c:v>3.9753130698013894</c:v>
                </c:pt>
                <c:pt idx="1879">
                  <c:v>3.975036653152106</c:v>
                </c:pt>
                <c:pt idx="1880">
                  <c:v>3.9746020014525256</c:v>
                </c:pt>
                <c:pt idx="1881">
                  <c:v>3.9742813588778305</c:v>
                </c:pt>
                <c:pt idx="1882">
                  <c:v>3.9738064857525379</c:v>
                </c:pt>
                <c:pt idx="1883">
                  <c:v>3.973532954787204</c:v>
                </c:pt>
                <c:pt idx="1884">
                  <c:v>3.9731476171423794</c:v>
                </c:pt>
                <c:pt idx="1885">
                  <c:v>3.9719241770220619</c:v>
                </c:pt>
                <c:pt idx="1886">
                  <c:v>3.9719079613002042</c:v>
                </c:pt>
                <c:pt idx="1887">
                  <c:v>3.9718497856331689</c:v>
                </c:pt>
                <c:pt idx="1888">
                  <c:v>3.9714804715952612</c:v>
                </c:pt>
                <c:pt idx="1889">
                  <c:v>3.9714400185506538</c:v>
                </c:pt>
                <c:pt idx="1890">
                  <c:v>3.9714206925177762</c:v>
                </c:pt>
                <c:pt idx="1891">
                  <c:v>3.9711531318688174</c:v>
                </c:pt>
                <c:pt idx="1892">
                  <c:v>3.9711304409181345</c:v>
                </c:pt>
                <c:pt idx="1893">
                  <c:v>3.9710187738550746</c:v>
                </c:pt>
                <c:pt idx="1894">
                  <c:v>3.9709578993459491</c:v>
                </c:pt>
                <c:pt idx="1895">
                  <c:v>3.9706453962730759</c:v>
                </c:pt>
                <c:pt idx="1896">
                  <c:v>3.9704786015438653</c:v>
                </c:pt>
                <c:pt idx="1897">
                  <c:v>3.9700838226431494</c:v>
                </c:pt>
                <c:pt idx="1898">
                  <c:v>3.9698669032406197</c:v>
                </c:pt>
                <c:pt idx="1899">
                  <c:v>3.9696783357978078</c:v>
                </c:pt>
                <c:pt idx="1900">
                  <c:v>3.9691136960783315</c:v>
                </c:pt>
                <c:pt idx="1901">
                  <c:v>3.9688016773970305</c:v>
                </c:pt>
                <c:pt idx="1902">
                  <c:v>3.9686922622908449</c:v>
                </c:pt>
                <c:pt idx="1903">
                  <c:v>3.9685389829365563</c:v>
                </c:pt>
                <c:pt idx="1904">
                  <c:v>3.9681297136681555</c:v>
                </c:pt>
                <c:pt idx="1905">
                  <c:v>3.9675638355817027</c:v>
                </c:pt>
                <c:pt idx="1906">
                  <c:v>3.9666607499971116</c:v>
                </c:pt>
                <c:pt idx="1907">
                  <c:v>3.9665312492739315</c:v>
                </c:pt>
                <c:pt idx="1908">
                  <c:v>3.9663386204353372</c:v>
                </c:pt>
                <c:pt idx="1909">
                  <c:v>3.9663193267783883</c:v>
                </c:pt>
                <c:pt idx="1910">
                  <c:v>3.9662126747517812</c:v>
                </c:pt>
                <c:pt idx="1911">
                  <c:v>3.9657301970362631</c:v>
                </c:pt>
                <c:pt idx="1912">
                  <c:v>3.9654792220273714</c:v>
                </c:pt>
                <c:pt idx="1913">
                  <c:v>3.9654418637105673</c:v>
                </c:pt>
                <c:pt idx="1914">
                  <c:v>3.9654413411938387</c:v>
                </c:pt>
                <c:pt idx="1915">
                  <c:v>3.9651891535140105</c:v>
                </c:pt>
                <c:pt idx="1916">
                  <c:v>3.9651083702264756</c:v>
                </c:pt>
                <c:pt idx="1917">
                  <c:v>3.9648191003635174</c:v>
                </c:pt>
                <c:pt idx="1918">
                  <c:v>3.964346857570237</c:v>
                </c:pt>
                <c:pt idx="1919">
                  <c:v>3.9639926003122259</c:v>
                </c:pt>
                <c:pt idx="1920">
                  <c:v>3.9637332748541221</c:v>
                </c:pt>
                <c:pt idx="1921">
                  <c:v>3.9636666485748804</c:v>
                </c:pt>
                <c:pt idx="1922">
                  <c:v>3.963472482229252</c:v>
                </c:pt>
                <c:pt idx="1923">
                  <c:v>3.9624816704339461</c:v>
                </c:pt>
                <c:pt idx="1924">
                  <c:v>3.9620874500792165</c:v>
                </c:pt>
                <c:pt idx="1925">
                  <c:v>3.9618446344265292</c:v>
                </c:pt>
                <c:pt idx="1926">
                  <c:v>3.9615787509963867</c:v>
                </c:pt>
                <c:pt idx="1927">
                  <c:v>3.9613285296409586</c:v>
                </c:pt>
                <c:pt idx="1928">
                  <c:v>3.9611765862797346</c:v>
                </c:pt>
                <c:pt idx="1929">
                  <c:v>3.9604810837797797</c:v>
                </c:pt>
                <c:pt idx="1930">
                  <c:v>3.9602297001892</c:v>
                </c:pt>
                <c:pt idx="1931">
                  <c:v>3.9599329279041613</c:v>
                </c:pt>
                <c:pt idx="1932">
                  <c:v>3.9595994122903813</c:v>
                </c:pt>
                <c:pt idx="1933">
                  <c:v>3.9594513657636696</c:v>
                </c:pt>
                <c:pt idx="1934">
                  <c:v>3.9591355057744155</c:v>
                </c:pt>
                <c:pt idx="1935">
                  <c:v>3.958682248302468</c:v>
                </c:pt>
                <c:pt idx="1936">
                  <c:v>3.9582335643001354</c:v>
                </c:pt>
                <c:pt idx="1937">
                  <c:v>3.9578086129983658</c:v>
                </c:pt>
                <c:pt idx="1938">
                  <c:v>3.9561484127536248</c:v>
                </c:pt>
                <c:pt idx="1939">
                  <c:v>3.9548535766951569</c:v>
                </c:pt>
                <c:pt idx="1940">
                  <c:v>3.9538399303037344</c:v>
                </c:pt>
                <c:pt idx="1941">
                  <c:v>3.9538187315872531</c:v>
                </c:pt>
                <c:pt idx="1942">
                  <c:v>3.9535897731880731</c:v>
                </c:pt>
                <c:pt idx="1943">
                  <c:v>3.9535374152152807</c:v>
                </c:pt>
                <c:pt idx="1944">
                  <c:v>3.9528967945959241</c:v>
                </c:pt>
                <c:pt idx="1945">
                  <c:v>3.9523055861370491</c:v>
                </c:pt>
                <c:pt idx="1946">
                  <c:v>3.9520537350960141</c:v>
                </c:pt>
                <c:pt idx="1947">
                  <c:v>3.9518351662772653</c:v>
                </c:pt>
                <c:pt idx="1948">
                  <c:v>3.9518017379196833</c:v>
                </c:pt>
                <c:pt idx="1949">
                  <c:v>3.9515053531077711</c:v>
                </c:pt>
                <c:pt idx="1950">
                  <c:v>3.9505444208459934</c:v>
                </c:pt>
                <c:pt idx="1951">
                  <c:v>3.9500111834473928</c:v>
                </c:pt>
                <c:pt idx="1952">
                  <c:v>3.9491131302239046</c:v>
                </c:pt>
                <c:pt idx="1953">
                  <c:v>3.9484556214875854</c:v>
                </c:pt>
                <c:pt idx="1954">
                  <c:v>3.9483540016267442</c:v>
                </c:pt>
                <c:pt idx="1955">
                  <c:v>3.9479655076714493</c:v>
                </c:pt>
                <c:pt idx="1956">
                  <c:v>3.947629202991612</c:v>
                </c:pt>
                <c:pt idx="1957">
                  <c:v>3.9473217843173112</c:v>
                </c:pt>
                <c:pt idx="1958">
                  <c:v>3.947230524318639</c:v>
                </c:pt>
                <c:pt idx="1959">
                  <c:v>3.9460541430737495</c:v>
                </c:pt>
                <c:pt idx="1960">
                  <c:v>3.9459341980721736</c:v>
                </c:pt>
                <c:pt idx="1961">
                  <c:v>3.9458276132152648</c:v>
                </c:pt>
                <c:pt idx="1962">
                  <c:v>3.9455968630559317</c:v>
                </c:pt>
                <c:pt idx="1963">
                  <c:v>3.9454748768304402</c:v>
                </c:pt>
                <c:pt idx="1964">
                  <c:v>3.9454666702489303</c:v>
                </c:pt>
                <c:pt idx="1965">
                  <c:v>3.9449830288332639</c:v>
                </c:pt>
                <c:pt idx="1966">
                  <c:v>3.9448077229863028</c:v>
                </c:pt>
                <c:pt idx="1967">
                  <c:v>3.9446315241026162</c:v>
                </c:pt>
                <c:pt idx="1968">
                  <c:v>3.9445100888656794</c:v>
                </c:pt>
                <c:pt idx="1969">
                  <c:v>3.9443145698496096</c:v>
                </c:pt>
                <c:pt idx="1970">
                  <c:v>3.9442163658074469</c:v>
                </c:pt>
                <c:pt idx="1971">
                  <c:v>3.944059138247785</c:v>
                </c:pt>
                <c:pt idx="1972">
                  <c:v>3.9439164042675308</c:v>
                </c:pt>
                <c:pt idx="1973">
                  <c:v>3.9434203134714485</c:v>
                </c:pt>
                <c:pt idx="1974">
                  <c:v>3.9433559944380279</c:v>
                </c:pt>
                <c:pt idx="1975">
                  <c:v>3.9431783804630993</c:v>
                </c:pt>
                <c:pt idx="1976">
                  <c:v>3.9430892711717678</c:v>
                </c:pt>
                <c:pt idx="1977">
                  <c:v>3.9429506203668909</c:v>
                </c:pt>
                <c:pt idx="1978">
                  <c:v>3.9427480666238157</c:v>
                </c:pt>
                <c:pt idx="1979">
                  <c:v>3.9425523033504484</c:v>
                </c:pt>
                <c:pt idx="1980">
                  <c:v>3.9423941965878133</c:v>
                </c:pt>
                <c:pt idx="1981">
                  <c:v>3.9418751247825563</c:v>
                </c:pt>
                <c:pt idx="1982">
                  <c:v>3.9414346817224652</c:v>
                </c:pt>
                <c:pt idx="1983">
                  <c:v>3.9409387869830925</c:v>
                </c:pt>
                <c:pt idx="1984">
                  <c:v>3.9404046873059246</c:v>
                </c:pt>
                <c:pt idx="1985">
                  <c:v>3.9397011412040825</c:v>
                </c:pt>
                <c:pt idx="1986">
                  <c:v>3.9394668346041346</c:v>
                </c:pt>
                <c:pt idx="1987">
                  <c:v>3.9393081552815992</c:v>
                </c:pt>
                <c:pt idx="1988">
                  <c:v>3.9392082574412144</c:v>
                </c:pt>
                <c:pt idx="1989">
                  <c:v>3.9387484311764585</c:v>
                </c:pt>
                <c:pt idx="1990">
                  <c:v>3.9384813641386955</c:v>
                </c:pt>
                <c:pt idx="1991">
                  <c:v>3.9384354932323236</c:v>
                </c:pt>
                <c:pt idx="1992">
                  <c:v>3.9384207579130512</c:v>
                </c:pt>
                <c:pt idx="1993">
                  <c:v>3.9382511267279883</c:v>
                </c:pt>
                <c:pt idx="1994">
                  <c:v>3.9376853032822754</c:v>
                </c:pt>
                <c:pt idx="1995">
                  <c:v>3.9371694920420595</c:v>
                </c:pt>
                <c:pt idx="1996">
                  <c:v>3.937072447731417</c:v>
                </c:pt>
                <c:pt idx="1997">
                  <c:v>3.9369059160171052</c:v>
                </c:pt>
                <c:pt idx="1998">
                  <c:v>3.9368425781527052</c:v>
                </c:pt>
                <c:pt idx="1999">
                  <c:v>3.9368263934281007</c:v>
                </c:pt>
                <c:pt idx="2000">
                  <c:v>3.9367421114934609</c:v>
                </c:pt>
                <c:pt idx="2001">
                  <c:v>3.9367019183213081</c:v>
                </c:pt>
                <c:pt idx="2002">
                  <c:v>3.9366832160634018</c:v>
                </c:pt>
                <c:pt idx="2003">
                  <c:v>3.9366620005869195</c:v>
                </c:pt>
                <c:pt idx="2004">
                  <c:v>3.9366198457095583</c:v>
                </c:pt>
                <c:pt idx="2005">
                  <c:v>3.9364556539413558</c:v>
                </c:pt>
                <c:pt idx="2006">
                  <c:v>3.9362629007327929</c:v>
                </c:pt>
                <c:pt idx="2007">
                  <c:v>3.9362506063217442</c:v>
                </c:pt>
                <c:pt idx="2008">
                  <c:v>3.9361614614314986</c:v>
                </c:pt>
                <c:pt idx="2009">
                  <c:v>3.9355386136118473</c:v>
                </c:pt>
                <c:pt idx="2010">
                  <c:v>3.9353902514198764</c:v>
                </c:pt>
                <c:pt idx="2011">
                  <c:v>3.9352135503164214</c:v>
                </c:pt>
                <c:pt idx="2012">
                  <c:v>3.934948223655558</c:v>
                </c:pt>
                <c:pt idx="2013">
                  <c:v>3.9347228348610126</c:v>
                </c:pt>
                <c:pt idx="2014">
                  <c:v>3.9345643759575788</c:v>
                </c:pt>
                <c:pt idx="2015">
                  <c:v>3.9345032206012247</c:v>
                </c:pt>
                <c:pt idx="2016">
                  <c:v>3.9343601170828708</c:v>
                </c:pt>
                <c:pt idx="2017">
                  <c:v>3.9342166856612368</c:v>
                </c:pt>
                <c:pt idx="2018">
                  <c:v>3.9341383537921986</c:v>
                </c:pt>
                <c:pt idx="2019">
                  <c:v>3.9340914602142769</c:v>
                </c:pt>
                <c:pt idx="2020">
                  <c:v>3.9340263062406895</c:v>
                </c:pt>
                <c:pt idx="2021">
                  <c:v>3.9336121253502383</c:v>
                </c:pt>
                <c:pt idx="2022">
                  <c:v>3.9328690385060607</c:v>
                </c:pt>
                <c:pt idx="2023">
                  <c:v>3.9326760951593727</c:v>
                </c:pt>
                <c:pt idx="2024">
                  <c:v>3.9323886337135434</c:v>
                </c:pt>
                <c:pt idx="2025">
                  <c:v>3.9321069060348242</c:v>
                </c:pt>
                <c:pt idx="2026">
                  <c:v>3.9314875345995324</c:v>
                </c:pt>
                <c:pt idx="2027">
                  <c:v>3.9314166203600434</c:v>
                </c:pt>
                <c:pt idx="2028">
                  <c:v>3.9312710827691699</c:v>
                </c:pt>
                <c:pt idx="2029">
                  <c:v>3.930802770872126</c:v>
                </c:pt>
                <c:pt idx="2030">
                  <c:v>3.9306230607196797</c:v>
                </c:pt>
                <c:pt idx="2031">
                  <c:v>3.9304214704664764</c:v>
                </c:pt>
                <c:pt idx="2032">
                  <c:v>3.9303682259598696</c:v>
                </c:pt>
                <c:pt idx="2033">
                  <c:v>3.9303033607997091</c:v>
                </c:pt>
                <c:pt idx="2034">
                  <c:v>3.9301038893075417</c:v>
                </c:pt>
                <c:pt idx="2035">
                  <c:v>3.9298382573535342</c:v>
                </c:pt>
                <c:pt idx="2036">
                  <c:v>3.9297350224517538</c:v>
                </c:pt>
                <c:pt idx="2037">
                  <c:v>3.9296283584287921</c:v>
                </c:pt>
                <c:pt idx="2038">
                  <c:v>3.9291662233925067</c:v>
                </c:pt>
                <c:pt idx="2039">
                  <c:v>3.9291653713382244</c:v>
                </c:pt>
                <c:pt idx="2040">
                  <c:v>3.9274867068895167</c:v>
                </c:pt>
                <c:pt idx="2041">
                  <c:v>3.9273746409383827</c:v>
                </c:pt>
                <c:pt idx="2042">
                  <c:v>3.9271858028609059</c:v>
                </c:pt>
                <c:pt idx="2043">
                  <c:v>3.9271170362804568</c:v>
                </c:pt>
                <c:pt idx="2044">
                  <c:v>3.9268595642623434</c:v>
                </c:pt>
                <c:pt idx="2045">
                  <c:v>3.926133424989394</c:v>
                </c:pt>
                <c:pt idx="2046">
                  <c:v>3.9260170040767193</c:v>
                </c:pt>
                <c:pt idx="2047">
                  <c:v>3.9258639217258318</c:v>
                </c:pt>
                <c:pt idx="2048">
                  <c:v>3.9251192008300562</c:v>
                </c:pt>
                <c:pt idx="2049">
                  <c:v>3.9239065865425453</c:v>
                </c:pt>
                <c:pt idx="2050">
                  <c:v>3.9238677752243314</c:v>
                </c:pt>
                <c:pt idx="2051">
                  <c:v>3.9236696397144408</c:v>
                </c:pt>
                <c:pt idx="2052">
                  <c:v>3.9234380315600785</c:v>
                </c:pt>
                <c:pt idx="2053">
                  <c:v>3.9233807578274713</c:v>
                </c:pt>
                <c:pt idx="2054">
                  <c:v>3.9233712594431607</c:v>
                </c:pt>
                <c:pt idx="2055">
                  <c:v>3.9231844156557321</c:v>
                </c:pt>
                <c:pt idx="2056">
                  <c:v>3.9230522233521832</c:v>
                </c:pt>
                <c:pt idx="2057">
                  <c:v>3.9228540035094506</c:v>
                </c:pt>
                <c:pt idx="2058">
                  <c:v>3.9221927127397729</c:v>
                </c:pt>
                <c:pt idx="2059">
                  <c:v>3.922167313865693</c:v>
                </c:pt>
                <c:pt idx="2060">
                  <c:v>3.9217006338886149</c:v>
                </c:pt>
                <c:pt idx="2061">
                  <c:v>3.9214699966778848</c:v>
                </c:pt>
                <c:pt idx="2062">
                  <c:v>3.920944681093574</c:v>
                </c:pt>
                <c:pt idx="2063">
                  <c:v>3.9207272529430761</c:v>
                </c:pt>
                <c:pt idx="2064">
                  <c:v>3.9207194339248241</c:v>
                </c:pt>
                <c:pt idx="2065">
                  <c:v>3.9204416226434065</c:v>
                </c:pt>
                <c:pt idx="2066">
                  <c:v>3.9203358396290309</c:v>
                </c:pt>
                <c:pt idx="2067">
                  <c:v>3.9195243665690604</c:v>
                </c:pt>
                <c:pt idx="2068">
                  <c:v>3.919279204961009</c:v>
                </c:pt>
                <c:pt idx="2069">
                  <c:v>3.9192710692652315</c:v>
                </c:pt>
                <c:pt idx="2070">
                  <c:v>3.917957773472764</c:v>
                </c:pt>
                <c:pt idx="2071">
                  <c:v>3.9179391207028536</c:v>
                </c:pt>
                <c:pt idx="2072">
                  <c:v>3.9177980331863069</c:v>
                </c:pt>
                <c:pt idx="2073">
                  <c:v>3.9172195034053887</c:v>
                </c:pt>
                <c:pt idx="2074">
                  <c:v>3.91704196813469</c:v>
                </c:pt>
                <c:pt idx="2075">
                  <c:v>3.9162705410465901</c:v>
                </c:pt>
                <c:pt idx="2076">
                  <c:v>3.9162088027576116</c:v>
                </c:pt>
                <c:pt idx="2077">
                  <c:v>3.9160888122601021</c:v>
                </c:pt>
                <c:pt idx="2078">
                  <c:v>3.9154968619546633</c:v>
                </c:pt>
                <c:pt idx="2079">
                  <c:v>3.9150414398655973</c:v>
                </c:pt>
                <c:pt idx="2080">
                  <c:v>3.9147907980361003</c:v>
                </c:pt>
                <c:pt idx="2081">
                  <c:v>3.9146751135635149</c:v>
                </c:pt>
                <c:pt idx="2082">
                  <c:v>3.9146225462228483</c:v>
                </c:pt>
                <c:pt idx="2083">
                  <c:v>3.9132019961497777</c:v>
                </c:pt>
                <c:pt idx="2084">
                  <c:v>3.9128565263047248</c:v>
                </c:pt>
                <c:pt idx="2085">
                  <c:v>3.9125810146947275</c:v>
                </c:pt>
                <c:pt idx="2086">
                  <c:v>3.9122684189656214</c:v>
                </c:pt>
                <c:pt idx="2087">
                  <c:v>3.9122320972244418</c:v>
                </c:pt>
                <c:pt idx="2088">
                  <c:v>3.9117489950473114</c:v>
                </c:pt>
                <c:pt idx="2089">
                  <c:v>3.9111232664415576</c:v>
                </c:pt>
                <c:pt idx="2090">
                  <c:v>3.9106673816733335</c:v>
                </c:pt>
                <c:pt idx="2091">
                  <c:v>3.9105891311094001</c:v>
                </c:pt>
                <c:pt idx="2092">
                  <c:v>3.9105182784751125</c:v>
                </c:pt>
                <c:pt idx="2093">
                  <c:v>3.9099985368806309</c:v>
                </c:pt>
                <c:pt idx="2094">
                  <c:v>3.9099317441523622</c:v>
                </c:pt>
                <c:pt idx="2095">
                  <c:v>3.909569697297965</c:v>
                </c:pt>
                <c:pt idx="2096">
                  <c:v>3.9094769837803436</c:v>
                </c:pt>
                <c:pt idx="2097">
                  <c:v>3.9093670093977426</c:v>
                </c:pt>
                <c:pt idx="2098">
                  <c:v>3.9087024095719323</c:v>
                </c:pt>
                <c:pt idx="2099">
                  <c:v>3.9086559626200605</c:v>
                </c:pt>
                <c:pt idx="2100">
                  <c:v>3.9084242491441055</c:v>
                </c:pt>
                <c:pt idx="2101">
                  <c:v>3.9081998636791462</c:v>
                </c:pt>
                <c:pt idx="2102">
                  <c:v>3.9080707820678162</c:v>
                </c:pt>
                <c:pt idx="2103">
                  <c:v>3.9078468104731741</c:v>
                </c:pt>
                <c:pt idx="2104">
                  <c:v>3.9078307015388836</c:v>
                </c:pt>
                <c:pt idx="2105">
                  <c:v>3.9078020619580487</c:v>
                </c:pt>
                <c:pt idx="2106">
                  <c:v>3.9074934700243507</c:v>
                </c:pt>
                <c:pt idx="2107">
                  <c:v>3.9074806321473421</c:v>
                </c:pt>
                <c:pt idx="2108">
                  <c:v>3.9073695537380035</c:v>
                </c:pt>
                <c:pt idx="2109">
                  <c:v>3.907190335126185</c:v>
                </c:pt>
                <c:pt idx="2110">
                  <c:v>3.9069844411522774</c:v>
                </c:pt>
                <c:pt idx="2111">
                  <c:v>3.9058144626189604</c:v>
                </c:pt>
                <c:pt idx="2112">
                  <c:v>3.9056804727816181</c:v>
                </c:pt>
                <c:pt idx="2113">
                  <c:v>3.905543142764365</c:v>
                </c:pt>
                <c:pt idx="2114">
                  <c:v>3.9054597640588931</c:v>
                </c:pt>
                <c:pt idx="2115">
                  <c:v>3.9053832695132673</c:v>
                </c:pt>
                <c:pt idx="2116">
                  <c:v>3.9052809557470467</c:v>
                </c:pt>
                <c:pt idx="2117">
                  <c:v>3.9046668669549738</c:v>
                </c:pt>
                <c:pt idx="2118">
                  <c:v>3.9046037573025334</c:v>
                </c:pt>
                <c:pt idx="2119">
                  <c:v>3.9044904374350975</c:v>
                </c:pt>
                <c:pt idx="2120">
                  <c:v>3.9043238606717909</c:v>
                </c:pt>
                <c:pt idx="2121">
                  <c:v>3.9042447594404552</c:v>
                </c:pt>
                <c:pt idx="2122">
                  <c:v>3.9033167260224535</c:v>
                </c:pt>
                <c:pt idx="2123">
                  <c:v>3.9032470887298159</c:v>
                </c:pt>
                <c:pt idx="2124">
                  <c:v>3.9020766583058051</c:v>
                </c:pt>
                <c:pt idx="2125">
                  <c:v>3.9014789064545838</c:v>
                </c:pt>
                <c:pt idx="2126">
                  <c:v>3.9011842655412123</c:v>
                </c:pt>
                <c:pt idx="2127">
                  <c:v>3.9008494101962086</c:v>
                </c:pt>
                <c:pt idx="2128">
                  <c:v>3.9006086396942834</c:v>
                </c:pt>
                <c:pt idx="2129">
                  <c:v>3.9004454220714138</c:v>
                </c:pt>
                <c:pt idx="2130">
                  <c:v>3.9001042265814094</c:v>
                </c:pt>
                <c:pt idx="2131">
                  <c:v>3.8999882076260568</c:v>
                </c:pt>
                <c:pt idx="2132">
                  <c:v>3.8982124749468956</c:v>
                </c:pt>
                <c:pt idx="2133">
                  <c:v>3.8981719080997665</c:v>
                </c:pt>
                <c:pt idx="2134">
                  <c:v>3.8980535410547223</c:v>
                </c:pt>
                <c:pt idx="2135">
                  <c:v>3.8977819070842901</c:v>
                </c:pt>
                <c:pt idx="2136">
                  <c:v>3.8976222046865008</c:v>
                </c:pt>
                <c:pt idx="2137">
                  <c:v>3.8975959382482626</c:v>
                </c:pt>
                <c:pt idx="2138">
                  <c:v>3.8973515231349856</c:v>
                </c:pt>
                <c:pt idx="2139">
                  <c:v>3.896771709411087</c:v>
                </c:pt>
                <c:pt idx="2140">
                  <c:v>3.8960038560301236</c:v>
                </c:pt>
                <c:pt idx="2141">
                  <c:v>3.8959544979219989</c:v>
                </c:pt>
                <c:pt idx="2142">
                  <c:v>3.89591923869571</c:v>
                </c:pt>
                <c:pt idx="2143">
                  <c:v>3.8959082004365242</c:v>
                </c:pt>
                <c:pt idx="2144">
                  <c:v>3.8955450079197318</c:v>
                </c:pt>
                <c:pt idx="2145">
                  <c:v>3.8955247534507786</c:v>
                </c:pt>
                <c:pt idx="2146">
                  <c:v>3.8952297290450262</c:v>
                </c:pt>
                <c:pt idx="2147">
                  <c:v>3.8948982399425018</c:v>
                </c:pt>
                <c:pt idx="2148">
                  <c:v>3.8948748817712819</c:v>
                </c:pt>
                <c:pt idx="2149">
                  <c:v>3.8938597399686454</c:v>
                </c:pt>
                <c:pt idx="2150">
                  <c:v>3.8935469343812694</c:v>
                </c:pt>
                <c:pt idx="2151">
                  <c:v>3.8934081799821816</c:v>
                </c:pt>
                <c:pt idx="2152">
                  <c:v>3.8930857903241964</c:v>
                </c:pt>
                <c:pt idx="2153">
                  <c:v>3.8922282112077324</c:v>
                </c:pt>
                <c:pt idx="2154">
                  <c:v>3.8920355172995786</c:v>
                </c:pt>
                <c:pt idx="2155">
                  <c:v>3.8917381122276948</c:v>
                </c:pt>
                <c:pt idx="2156">
                  <c:v>3.8913890747053874</c:v>
                </c:pt>
                <c:pt idx="2157">
                  <c:v>3.8913735829553233</c:v>
                </c:pt>
                <c:pt idx="2158">
                  <c:v>3.891207166711856</c:v>
                </c:pt>
                <c:pt idx="2159">
                  <c:v>3.8910930867159537</c:v>
                </c:pt>
                <c:pt idx="2160">
                  <c:v>3.8903281631363171</c:v>
                </c:pt>
                <c:pt idx="2161">
                  <c:v>3.8898265857615981</c:v>
                </c:pt>
                <c:pt idx="2162">
                  <c:v>3.8895472662915704</c:v>
                </c:pt>
                <c:pt idx="2163">
                  <c:v>3.8892204398074646</c:v>
                </c:pt>
                <c:pt idx="2164">
                  <c:v>3.8891531764178806</c:v>
                </c:pt>
                <c:pt idx="2165">
                  <c:v>3.8887752490170699</c:v>
                </c:pt>
                <c:pt idx="2166">
                  <c:v>3.888707604887514</c:v>
                </c:pt>
                <c:pt idx="2167">
                  <c:v>3.8882241258859698</c:v>
                </c:pt>
                <c:pt idx="2168">
                  <c:v>3.8882107055667556</c:v>
                </c:pt>
                <c:pt idx="2169">
                  <c:v>3.8881133178043319</c:v>
                </c:pt>
                <c:pt idx="2170">
                  <c:v>3.8881123812775287</c:v>
                </c:pt>
                <c:pt idx="2171">
                  <c:v>3.887651677496279</c:v>
                </c:pt>
                <c:pt idx="2172">
                  <c:v>3.8875982354646372</c:v>
                </c:pt>
                <c:pt idx="2173">
                  <c:v>3.8861487324875967</c:v>
                </c:pt>
                <c:pt idx="2174">
                  <c:v>3.8860122991367878</c:v>
                </c:pt>
                <c:pt idx="2175">
                  <c:v>3.885754056196792</c:v>
                </c:pt>
                <c:pt idx="2176">
                  <c:v>3.8855371138848911</c:v>
                </c:pt>
                <c:pt idx="2177">
                  <c:v>3.8854055143018069</c:v>
                </c:pt>
                <c:pt idx="2178">
                  <c:v>3.8853769277365213</c:v>
                </c:pt>
                <c:pt idx="2179">
                  <c:v>3.8853766135879888</c:v>
                </c:pt>
                <c:pt idx="2180">
                  <c:v>3.8852952414658839</c:v>
                </c:pt>
                <c:pt idx="2181">
                  <c:v>3.8847906453826924</c:v>
                </c:pt>
                <c:pt idx="2182">
                  <c:v>3.8845946222997174</c:v>
                </c:pt>
                <c:pt idx="2183">
                  <c:v>3.8843591517966236</c:v>
                </c:pt>
                <c:pt idx="2184">
                  <c:v>3.8842350691877554</c:v>
                </c:pt>
                <c:pt idx="2185">
                  <c:v>3.8829761792632072</c:v>
                </c:pt>
                <c:pt idx="2186">
                  <c:v>3.8828450651991839</c:v>
                </c:pt>
                <c:pt idx="2187">
                  <c:v>3.8827448863377034</c:v>
                </c:pt>
                <c:pt idx="2188">
                  <c:v>3.8824252339949026</c:v>
                </c:pt>
                <c:pt idx="2189">
                  <c:v>3.8823983484439544</c:v>
                </c:pt>
                <c:pt idx="2190">
                  <c:v>3.8822727550606984</c:v>
                </c:pt>
                <c:pt idx="2191">
                  <c:v>3.8822271908003012</c:v>
                </c:pt>
                <c:pt idx="2192">
                  <c:v>3.8814284074055263</c:v>
                </c:pt>
                <c:pt idx="2193">
                  <c:v>3.8813304379121889</c:v>
                </c:pt>
                <c:pt idx="2194">
                  <c:v>3.8810751061113491</c:v>
                </c:pt>
                <c:pt idx="2195">
                  <c:v>3.8808193066442747</c:v>
                </c:pt>
                <c:pt idx="2196">
                  <c:v>3.8804216615437261</c:v>
                </c:pt>
                <c:pt idx="2197">
                  <c:v>3.8801476717419443</c:v>
                </c:pt>
                <c:pt idx="2198">
                  <c:v>3.8799504955802115</c:v>
                </c:pt>
                <c:pt idx="2199">
                  <c:v>3.8790531682698699</c:v>
                </c:pt>
                <c:pt idx="2200">
                  <c:v>3.8788510298059444</c:v>
                </c:pt>
                <c:pt idx="2201">
                  <c:v>3.8781424839283281</c:v>
                </c:pt>
                <c:pt idx="2202">
                  <c:v>3.8777270323781532</c:v>
                </c:pt>
                <c:pt idx="2203">
                  <c:v>3.877492286377779</c:v>
                </c:pt>
                <c:pt idx="2204">
                  <c:v>3.8771729048882171</c:v>
                </c:pt>
                <c:pt idx="2205">
                  <c:v>3.8771652214786378</c:v>
                </c:pt>
                <c:pt idx="2206">
                  <c:v>3.8771008675864369</c:v>
                </c:pt>
                <c:pt idx="2207">
                  <c:v>3.8768741122225601</c:v>
                </c:pt>
                <c:pt idx="2208">
                  <c:v>3.8768238128583192</c:v>
                </c:pt>
                <c:pt idx="2209">
                  <c:v>3.8759886975129252</c:v>
                </c:pt>
                <c:pt idx="2210">
                  <c:v>3.8758467864242894</c:v>
                </c:pt>
                <c:pt idx="2211">
                  <c:v>3.8755155872280724</c:v>
                </c:pt>
                <c:pt idx="2212">
                  <c:v>3.8748575797784057</c:v>
                </c:pt>
                <c:pt idx="2213">
                  <c:v>3.8747188400421404</c:v>
                </c:pt>
                <c:pt idx="2214">
                  <c:v>3.8745768353953292</c:v>
                </c:pt>
                <c:pt idx="2215">
                  <c:v>3.8742256495122702</c:v>
                </c:pt>
                <c:pt idx="2216">
                  <c:v>3.8734094154187524</c:v>
                </c:pt>
                <c:pt idx="2217">
                  <c:v>3.8732579369276037</c:v>
                </c:pt>
                <c:pt idx="2218">
                  <c:v>3.8730194692844528</c:v>
                </c:pt>
                <c:pt idx="2219">
                  <c:v>3.8724635059312678</c:v>
                </c:pt>
                <c:pt idx="2220">
                  <c:v>3.8719891295131079</c:v>
                </c:pt>
                <c:pt idx="2221">
                  <c:v>3.8714688247042206</c:v>
                </c:pt>
                <c:pt idx="2222">
                  <c:v>3.8709180167558364</c:v>
                </c:pt>
                <c:pt idx="2223">
                  <c:v>3.8705128229253991</c:v>
                </c:pt>
                <c:pt idx="2224">
                  <c:v>3.8693415836417215</c:v>
                </c:pt>
                <c:pt idx="2225">
                  <c:v>3.8692004180997759</c:v>
                </c:pt>
                <c:pt idx="2226">
                  <c:v>3.8690402880115959</c:v>
                </c:pt>
                <c:pt idx="2227">
                  <c:v>3.8688318021469548</c:v>
                </c:pt>
                <c:pt idx="2228">
                  <c:v>3.8687799098285414</c:v>
                </c:pt>
                <c:pt idx="2229">
                  <c:v>3.8687319283947383</c:v>
                </c:pt>
                <c:pt idx="2230">
                  <c:v>3.868719524168561</c:v>
                </c:pt>
                <c:pt idx="2231">
                  <c:v>3.8687028758344795</c:v>
                </c:pt>
                <c:pt idx="2232">
                  <c:v>3.8683080253806699</c:v>
                </c:pt>
                <c:pt idx="2233">
                  <c:v>3.8680684580832421</c:v>
                </c:pt>
                <c:pt idx="2234">
                  <c:v>3.8678591779717788</c:v>
                </c:pt>
                <c:pt idx="2235">
                  <c:v>3.8674822194437244</c:v>
                </c:pt>
                <c:pt idx="2236">
                  <c:v>3.8672795344600397</c:v>
                </c:pt>
                <c:pt idx="2237">
                  <c:v>3.8672209051724544</c:v>
                </c:pt>
                <c:pt idx="2238">
                  <c:v>3.8671773375033403</c:v>
                </c:pt>
                <c:pt idx="2239">
                  <c:v>3.8663126147470845</c:v>
                </c:pt>
                <c:pt idx="2240">
                  <c:v>3.8660867228926543</c:v>
                </c:pt>
                <c:pt idx="2241">
                  <c:v>3.8660473111139941</c:v>
                </c:pt>
                <c:pt idx="2242">
                  <c:v>3.8660436981886575</c:v>
                </c:pt>
                <c:pt idx="2243">
                  <c:v>3.8659208408403645</c:v>
                </c:pt>
                <c:pt idx="2244">
                  <c:v>3.8651075953925202</c:v>
                </c:pt>
                <c:pt idx="2245">
                  <c:v>3.8647288988102049</c:v>
                </c:pt>
                <c:pt idx="2246">
                  <c:v>3.8645041591877178</c:v>
                </c:pt>
                <c:pt idx="2247">
                  <c:v>3.8644708667445613</c:v>
                </c:pt>
                <c:pt idx="2248">
                  <c:v>3.8639715036159683</c:v>
                </c:pt>
                <c:pt idx="2249">
                  <c:v>3.8637361355649529</c:v>
                </c:pt>
                <c:pt idx="2250">
                  <c:v>3.8636984912547083</c:v>
                </c:pt>
                <c:pt idx="2251">
                  <c:v>3.8636773561766367</c:v>
                </c:pt>
                <c:pt idx="2252">
                  <c:v>3.8636605134248883</c:v>
                </c:pt>
                <c:pt idx="2253">
                  <c:v>3.8636004025933448</c:v>
                </c:pt>
                <c:pt idx="2254">
                  <c:v>3.8635472206907431</c:v>
                </c:pt>
                <c:pt idx="2255">
                  <c:v>3.8632643553251076</c:v>
                </c:pt>
                <c:pt idx="2256">
                  <c:v>3.8626166403237914</c:v>
                </c:pt>
                <c:pt idx="2257">
                  <c:v>3.8625663176260687</c:v>
                </c:pt>
                <c:pt idx="2258">
                  <c:v>3.8621804268968809</c:v>
                </c:pt>
                <c:pt idx="2259">
                  <c:v>3.8619725994848033</c:v>
                </c:pt>
                <c:pt idx="2260">
                  <c:v>3.8616472344450594</c:v>
                </c:pt>
                <c:pt idx="2261">
                  <c:v>3.861587839798855</c:v>
                </c:pt>
                <c:pt idx="2262">
                  <c:v>3.861429193047285</c:v>
                </c:pt>
                <c:pt idx="2263">
                  <c:v>3.8611226880514309</c:v>
                </c:pt>
                <c:pt idx="2264">
                  <c:v>3.8607710866684286</c:v>
                </c:pt>
                <c:pt idx="2265">
                  <c:v>3.8602098624756036</c:v>
                </c:pt>
                <c:pt idx="2266">
                  <c:v>3.8594648797869922</c:v>
                </c:pt>
                <c:pt idx="2267">
                  <c:v>3.8594488732948036</c:v>
                </c:pt>
                <c:pt idx="2268">
                  <c:v>3.8589470374681185</c:v>
                </c:pt>
                <c:pt idx="2269">
                  <c:v>3.8579422920813746</c:v>
                </c:pt>
                <c:pt idx="2270">
                  <c:v>3.8579081581152814</c:v>
                </c:pt>
                <c:pt idx="2271">
                  <c:v>3.8577789601868768</c:v>
                </c:pt>
                <c:pt idx="2272">
                  <c:v>3.8576895702148044</c:v>
                </c:pt>
                <c:pt idx="2273">
                  <c:v>3.8573207676410513</c:v>
                </c:pt>
                <c:pt idx="2274">
                  <c:v>3.8562944457900081</c:v>
                </c:pt>
                <c:pt idx="2275">
                  <c:v>3.8561718229035611</c:v>
                </c:pt>
                <c:pt idx="2276">
                  <c:v>3.8561432619180165</c:v>
                </c:pt>
                <c:pt idx="2277">
                  <c:v>3.8559281541630273</c:v>
                </c:pt>
                <c:pt idx="2278">
                  <c:v>3.8553411075677948</c:v>
                </c:pt>
                <c:pt idx="2279">
                  <c:v>3.8551747736519402</c:v>
                </c:pt>
                <c:pt idx="2280">
                  <c:v>3.8551330118145071</c:v>
                </c:pt>
                <c:pt idx="2281">
                  <c:v>3.854843599733377</c:v>
                </c:pt>
                <c:pt idx="2282">
                  <c:v>3.8546898869795361</c:v>
                </c:pt>
                <c:pt idx="2283">
                  <c:v>3.8546774122861311</c:v>
                </c:pt>
                <c:pt idx="2284">
                  <c:v>3.8543822981617595</c:v>
                </c:pt>
                <c:pt idx="2285">
                  <c:v>3.854214921512205</c:v>
                </c:pt>
                <c:pt idx="2286">
                  <c:v>3.8539448231729598</c:v>
                </c:pt>
                <c:pt idx="2287">
                  <c:v>3.8536123716731119</c:v>
                </c:pt>
                <c:pt idx="2288">
                  <c:v>3.8535981760054727</c:v>
                </c:pt>
                <c:pt idx="2289">
                  <c:v>3.8532228365105858</c:v>
                </c:pt>
                <c:pt idx="2290">
                  <c:v>3.8531788566030696</c:v>
                </c:pt>
                <c:pt idx="2291">
                  <c:v>3.853071594615129</c:v>
                </c:pt>
                <c:pt idx="2292">
                  <c:v>3.8530641495823374</c:v>
                </c:pt>
                <c:pt idx="2293">
                  <c:v>3.8530079693107315</c:v>
                </c:pt>
                <c:pt idx="2294">
                  <c:v>3.8527435537120915</c:v>
                </c:pt>
                <c:pt idx="2295">
                  <c:v>3.852732377676392</c:v>
                </c:pt>
                <c:pt idx="2296">
                  <c:v>3.8525067634610397</c:v>
                </c:pt>
                <c:pt idx="2297">
                  <c:v>3.8522769636689467</c:v>
                </c:pt>
                <c:pt idx="2298">
                  <c:v>3.8518903003172515</c:v>
                </c:pt>
                <c:pt idx="2299">
                  <c:v>3.8509643018360751</c:v>
                </c:pt>
                <c:pt idx="2300">
                  <c:v>3.8507663454742613</c:v>
                </c:pt>
                <c:pt idx="2301">
                  <c:v>3.8505812324766282</c:v>
                </c:pt>
                <c:pt idx="2302">
                  <c:v>3.8504409840776987</c:v>
                </c:pt>
                <c:pt idx="2303">
                  <c:v>3.8503882089968178</c:v>
                </c:pt>
                <c:pt idx="2304">
                  <c:v>3.8503194215230927</c:v>
                </c:pt>
                <c:pt idx="2305">
                  <c:v>3.8502938788456338</c:v>
                </c:pt>
                <c:pt idx="2306">
                  <c:v>3.8492187033075167</c:v>
                </c:pt>
                <c:pt idx="2307">
                  <c:v>3.8491155812413864</c:v>
                </c:pt>
                <c:pt idx="2308">
                  <c:v>3.8486601172093229</c:v>
                </c:pt>
                <c:pt idx="2309">
                  <c:v>3.8483273573756485</c:v>
                </c:pt>
                <c:pt idx="2310">
                  <c:v>3.8469738578170745</c:v>
                </c:pt>
                <c:pt idx="2311">
                  <c:v>3.8467589660767718</c:v>
                </c:pt>
                <c:pt idx="2312">
                  <c:v>3.846738020460259</c:v>
                </c:pt>
                <c:pt idx="2313">
                  <c:v>3.8466298425899308</c:v>
                </c:pt>
                <c:pt idx="2314">
                  <c:v>3.8465494644393177</c:v>
                </c:pt>
                <c:pt idx="2315">
                  <c:v>3.8463501723879316</c:v>
                </c:pt>
                <c:pt idx="2316">
                  <c:v>3.845957505702696</c:v>
                </c:pt>
                <c:pt idx="2317">
                  <c:v>3.8459299850932145</c:v>
                </c:pt>
                <c:pt idx="2318">
                  <c:v>3.8457730843098905</c:v>
                </c:pt>
                <c:pt idx="2319">
                  <c:v>3.8455025037748749</c:v>
                </c:pt>
                <c:pt idx="2320">
                  <c:v>3.8454918285671673</c:v>
                </c:pt>
                <c:pt idx="2321">
                  <c:v>3.8454119283587773</c:v>
                </c:pt>
                <c:pt idx="2322">
                  <c:v>3.8453227120503142</c:v>
                </c:pt>
                <c:pt idx="2323">
                  <c:v>3.843751019010369</c:v>
                </c:pt>
                <c:pt idx="2324">
                  <c:v>3.8434476913358582</c:v>
                </c:pt>
                <c:pt idx="2325">
                  <c:v>3.8433667220225107</c:v>
                </c:pt>
                <c:pt idx="2326">
                  <c:v>3.8430426937264719</c:v>
                </c:pt>
                <c:pt idx="2327">
                  <c:v>3.8428081763459776</c:v>
                </c:pt>
                <c:pt idx="2328">
                  <c:v>3.8423578390351465</c:v>
                </c:pt>
                <c:pt idx="2329">
                  <c:v>3.8423481268521984</c:v>
                </c:pt>
                <c:pt idx="2330">
                  <c:v>3.8419591141486937</c:v>
                </c:pt>
                <c:pt idx="2331">
                  <c:v>3.8416600906306635</c:v>
                </c:pt>
                <c:pt idx="2332">
                  <c:v>3.8415169310197279</c:v>
                </c:pt>
                <c:pt idx="2333">
                  <c:v>3.8413973635331327</c:v>
                </c:pt>
                <c:pt idx="2334">
                  <c:v>3.8413737242024997</c:v>
                </c:pt>
                <c:pt idx="2335">
                  <c:v>3.8405678272319363</c:v>
                </c:pt>
                <c:pt idx="2336">
                  <c:v>3.8405110518622521</c:v>
                </c:pt>
                <c:pt idx="2337">
                  <c:v>3.8401444456800422</c:v>
                </c:pt>
                <c:pt idx="2338">
                  <c:v>3.839611059803874</c:v>
                </c:pt>
                <c:pt idx="2339">
                  <c:v>3.8395520645671266</c:v>
                </c:pt>
                <c:pt idx="2340">
                  <c:v>3.839002919828749</c:v>
                </c:pt>
                <c:pt idx="2341">
                  <c:v>3.8385871062847698</c:v>
                </c:pt>
                <c:pt idx="2342">
                  <c:v>3.8385346204387938</c:v>
                </c:pt>
                <c:pt idx="2343">
                  <c:v>3.83852132301742</c:v>
                </c:pt>
                <c:pt idx="2344">
                  <c:v>3.8384523798581962</c:v>
                </c:pt>
                <c:pt idx="2345">
                  <c:v>3.838281549653749</c:v>
                </c:pt>
                <c:pt idx="2346">
                  <c:v>3.8370346965628146</c:v>
                </c:pt>
                <c:pt idx="2347">
                  <c:v>3.8362498980473188</c:v>
                </c:pt>
                <c:pt idx="2348">
                  <c:v>3.8357465717930701</c:v>
                </c:pt>
                <c:pt idx="2349">
                  <c:v>3.8357187486469093</c:v>
                </c:pt>
                <c:pt idx="2350">
                  <c:v>3.8354474676228612</c:v>
                </c:pt>
                <c:pt idx="2351">
                  <c:v>3.835234904497026</c:v>
                </c:pt>
                <c:pt idx="2352">
                  <c:v>3.834736753906018</c:v>
                </c:pt>
                <c:pt idx="2353">
                  <c:v>3.8346170703206464</c:v>
                </c:pt>
                <c:pt idx="2354">
                  <c:v>3.8343412135226389</c:v>
                </c:pt>
                <c:pt idx="2355">
                  <c:v>3.8341669908705889</c:v>
                </c:pt>
                <c:pt idx="2356">
                  <c:v>3.8336081588429463</c:v>
                </c:pt>
                <c:pt idx="2357">
                  <c:v>3.8334237279865788</c:v>
                </c:pt>
                <c:pt idx="2358">
                  <c:v>3.833408148664911</c:v>
                </c:pt>
                <c:pt idx="2359">
                  <c:v>3.8334003587944947</c:v>
                </c:pt>
                <c:pt idx="2360">
                  <c:v>3.8321983378987703</c:v>
                </c:pt>
                <c:pt idx="2361">
                  <c:v>3.8321745475852125</c:v>
                </c:pt>
                <c:pt idx="2362">
                  <c:v>3.8318978450997498</c:v>
                </c:pt>
                <c:pt idx="2363">
                  <c:v>3.8318541391134429</c:v>
                </c:pt>
                <c:pt idx="2364">
                  <c:v>3.8316753607167007</c:v>
                </c:pt>
                <c:pt idx="2365">
                  <c:v>3.8306816760072797</c:v>
                </c:pt>
                <c:pt idx="2366">
                  <c:v>3.8303330632468851</c:v>
                </c:pt>
                <c:pt idx="2367">
                  <c:v>3.8295196153726065</c:v>
                </c:pt>
                <c:pt idx="2368">
                  <c:v>3.8294070618685523</c:v>
                </c:pt>
                <c:pt idx="2369">
                  <c:v>3.8293180703563969</c:v>
                </c:pt>
                <c:pt idx="2370">
                  <c:v>3.8287375700229975</c:v>
                </c:pt>
                <c:pt idx="2371">
                  <c:v>3.8278250143293886</c:v>
                </c:pt>
                <c:pt idx="2372">
                  <c:v>3.8277400028364941</c:v>
                </c:pt>
                <c:pt idx="2373">
                  <c:v>3.8273082320067568</c:v>
                </c:pt>
                <c:pt idx="2374">
                  <c:v>3.8272083934513543</c:v>
                </c:pt>
                <c:pt idx="2375">
                  <c:v>3.8271527181023273</c:v>
                </c:pt>
                <c:pt idx="2376">
                  <c:v>3.8270517658801535</c:v>
                </c:pt>
                <c:pt idx="2377">
                  <c:v>3.8269852898606911</c:v>
                </c:pt>
                <c:pt idx="2378">
                  <c:v>3.8268569803391177</c:v>
                </c:pt>
                <c:pt idx="2379">
                  <c:v>3.8267782506919858</c:v>
                </c:pt>
                <c:pt idx="2380">
                  <c:v>3.8266002475152634</c:v>
                </c:pt>
                <c:pt idx="2381">
                  <c:v>3.8260985694102057</c:v>
                </c:pt>
                <c:pt idx="2382">
                  <c:v>3.8260686807619964</c:v>
                </c:pt>
                <c:pt idx="2383">
                  <c:v>3.8260319473166775</c:v>
                </c:pt>
                <c:pt idx="2384">
                  <c:v>3.8256410118701756</c:v>
                </c:pt>
                <c:pt idx="2385">
                  <c:v>3.8256017187118014</c:v>
                </c:pt>
                <c:pt idx="2386">
                  <c:v>3.8255901824305911</c:v>
                </c:pt>
                <c:pt idx="2387">
                  <c:v>3.8252973467025426</c:v>
                </c:pt>
                <c:pt idx="2388">
                  <c:v>3.8252334880640619</c:v>
                </c:pt>
                <c:pt idx="2389">
                  <c:v>3.824083871069818</c:v>
                </c:pt>
                <c:pt idx="2390">
                  <c:v>3.8239796699173212</c:v>
                </c:pt>
                <c:pt idx="2391">
                  <c:v>3.822783184773848</c:v>
                </c:pt>
                <c:pt idx="2392">
                  <c:v>3.8227331084146736</c:v>
                </c:pt>
                <c:pt idx="2393">
                  <c:v>3.8227087938970681</c:v>
                </c:pt>
                <c:pt idx="2394">
                  <c:v>3.8224241765436866</c:v>
                </c:pt>
                <c:pt idx="2395">
                  <c:v>3.8223871335290869</c:v>
                </c:pt>
                <c:pt idx="2396">
                  <c:v>3.8223257513830684</c:v>
                </c:pt>
                <c:pt idx="2397">
                  <c:v>3.8215779363345002</c:v>
                </c:pt>
                <c:pt idx="2398">
                  <c:v>3.8213439115521957</c:v>
                </c:pt>
                <c:pt idx="2399">
                  <c:v>3.8204459504976347</c:v>
                </c:pt>
                <c:pt idx="2400">
                  <c:v>3.8204404783242327</c:v>
                </c:pt>
                <c:pt idx="2401">
                  <c:v>3.8204247910449989</c:v>
                </c:pt>
                <c:pt idx="2402">
                  <c:v>3.8201547350915415</c:v>
                </c:pt>
                <c:pt idx="2403">
                  <c:v>3.8199929860673434</c:v>
                </c:pt>
                <c:pt idx="2404">
                  <c:v>3.8194177963530471</c:v>
                </c:pt>
                <c:pt idx="2405">
                  <c:v>3.8192173607891404</c:v>
                </c:pt>
                <c:pt idx="2406">
                  <c:v>3.8190838076548475</c:v>
                </c:pt>
                <c:pt idx="2407">
                  <c:v>3.8190783182911958</c:v>
                </c:pt>
                <c:pt idx="2408">
                  <c:v>3.8185799610558511</c:v>
                </c:pt>
                <c:pt idx="2409">
                  <c:v>3.8185213362874744</c:v>
                </c:pt>
                <c:pt idx="2410">
                  <c:v>3.8181983918261553</c:v>
                </c:pt>
                <c:pt idx="2411">
                  <c:v>3.8179926232009849</c:v>
                </c:pt>
                <c:pt idx="2412">
                  <c:v>3.817494119736585</c:v>
                </c:pt>
                <c:pt idx="2413">
                  <c:v>3.8174144089168993</c:v>
                </c:pt>
                <c:pt idx="2414">
                  <c:v>3.8174037552105506</c:v>
                </c:pt>
                <c:pt idx="2415">
                  <c:v>3.8173537895144762</c:v>
                </c:pt>
                <c:pt idx="2416">
                  <c:v>3.8172545758737506</c:v>
                </c:pt>
                <c:pt idx="2417">
                  <c:v>3.8169693022751581</c:v>
                </c:pt>
                <c:pt idx="2418">
                  <c:v>3.8164674131395149</c:v>
                </c:pt>
                <c:pt idx="2419">
                  <c:v>3.8164331722954445</c:v>
                </c:pt>
                <c:pt idx="2420">
                  <c:v>3.8159465132966686</c:v>
                </c:pt>
                <c:pt idx="2421">
                  <c:v>3.8159148118125197</c:v>
                </c:pt>
                <c:pt idx="2422">
                  <c:v>3.8155729523172686</c:v>
                </c:pt>
                <c:pt idx="2423">
                  <c:v>3.814987441720795</c:v>
                </c:pt>
                <c:pt idx="2424">
                  <c:v>3.8146884753353993</c:v>
                </c:pt>
                <c:pt idx="2425">
                  <c:v>3.8146308017746207</c:v>
                </c:pt>
                <c:pt idx="2426">
                  <c:v>3.8145775578428531</c:v>
                </c:pt>
                <c:pt idx="2427">
                  <c:v>3.8145509334289063</c:v>
                </c:pt>
                <c:pt idx="2428">
                  <c:v>3.8142653579241848</c:v>
                </c:pt>
                <c:pt idx="2429">
                  <c:v>3.8142520363480918</c:v>
                </c:pt>
                <c:pt idx="2430">
                  <c:v>3.8138573843685006</c:v>
                </c:pt>
                <c:pt idx="2431">
                  <c:v>3.8138440502721296</c:v>
                </c:pt>
                <c:pt idx="2432">
                  <c:v>3.8136702992087241</c:v>
                </c:pt>
                <c:pt idx="2433">
                  <c:v>3.8134879525625651</c:v>
                </c:pt>
                <c:pt idx="2434">
                  <c:v>3.8133500298617236</c:v>
                </c:pt>
                <c:pt idx="2435">
                  <c:v>3.8132554607650948</c:v>
                </c:pt>
                <c:pt idx="2436">
                  <c:v>3.8129775680883395</c:v>
                </c:pt>
                <c:pt idx="2437">
                  <c:v>3.8129218939718341</c:v>
                </c:pt>
                <c:pt idx="2438">
                  <c:v>3.8127975293366876</c:v>
                </c:pt>
                <c:pt idx="2439">
                  <c:v>3.8125576091727997</c:v>
                </c:pt>
                <c:pt idx="2440">
                  <c:v>3.8120717922146232</c:v>
                </c:pt>
                <c:pt idx="2441">
                  <c:v>3.8117101433626615</c:v>
                </c:pt>
                <c:pt idx="2442">
                  <c:v>3.8114066766947778</c:v>
                </c:pt>
                <c:pt idx="2443">
                  <c:v>3.8110139032548562</c:v>
                </c:pt>
                <c:pt idx="2444">
                  <c:v>3.8109654340952579</c:v>
                </c:pt>
                <c:pt idx="2445">
                  <c:v>3.8108621394550029</c:v>
                </c:pt>
                <c:pt idx="2446">
                  <c:v>3.8103826351346766</c:v>
                </c:pt>
                <c:pt idx="2447">
                  <c:v>3.8103258805256806</c:v>
                </c:pt>
                <c:pt idx="2448">
                  <c:v>3.8100337757059086</c:v>
                </c:pt>
                <c:pt idx="2449">
                  <c:v>3.8095129534527836</c:v>
                </c:pt>
                <c:pt idx="2450">
                  <c:v>3.8094542142734675</c:v>
                </c:pt>
                <c:pt idx="2451">
                  <c:v>3.8089690317352707</c:v>
                </c:pt>
                <c:pt idx="2452">
                  <c:v>3.808806808977657</c:v>
                </c:pt>
                <c:pt idx="2453">
                  <c:v>3.808739729207224</c:v>
                </c:pt>
                <c:pt idx="2454">
                  <c:v>3.8086269068985232</c:v>
                </c:pt>
                <c:pt idx="2455">
                  <c:v>3.808547426415116</c:v>
                </c:pt>
                <c:pt idx="2456">
                  <c:v>3.8084649312858265</c:v>
                </c:pt>
                <c:pt idx="2457">
                  <c:v>3.8083872965575765</c:v>
                </c:pt>
                <c:pt idx="2458">
                  <c:v>3.8081284138540612</c:v>
                </c:pt>
                <c:pt idx="2459">
                  <c:v>3.8078122927174127</c:v>
                </c:pt>
                <c:pt idx="2460">
                  <c:v>3.8061309622925092</c:v>
                </c:pt>
                <c:pt idx="2461">
                  <c:v>3.8060860928948155</c:v>
                </c:pt>
                <c:pt idx="2462">
                  <c:v>3.805755273695818</c:v>
                </c:pt>
                <c:pt idx="2463">
                  <c:v>3.8056631879519029</c:v>
                </c:pt>
                <c:pt idx="2464">
                  <c:v>3.8056394085428678</c:v>
                </c:pt>
                <c:pt idx="2465">
                  <c:v>3.8054366645238002</c:v>
                </c:pt>
                <c:pt idx="2466">
                  <c:v>3.8049046251311514</c:v>
                </c:pt>
                <c:pt idx="2467">
                  <c:v>3.8042931846027357</c:v>
                </c:pt>
                <c:pt idx="2468">
                  <c:v>3.8042235105165867</c:v>
                </c:pt>
                <c:pt idx="2469">
                  <c:v>3.8038347966809809</c:v>
                </c:pt>
                <c:pt idx="2470">
                  <c:v>3.8035439810315386</c:v>
                </c:pt>
                <c:pt idx="2471">
                  <c:v>3.8031573156175433</c:v>
                </c:pt>
                <c:pt idx="2472">
                  <c:v>3.8030563236990882</c:v>
                </c:pt>
                <c:pt idx="2473">
                  <c:v>3.8025270611022455</c:v>
                </c:pt>
                <c:pt idx="2474">
                  <c:v>3.8018288771555424</c:v>
                </c:pt>
                <c:pt idx="2475">
                  <c:v>3.8010548078802286</c:v>
                </c:pt>
                <c:pt idx="2476">
                  <c:v>3.8003641852092853</c:v>
                </c:pt>
                <c:pt idx="2477">
                  <c:v>3.7998526689211269</c:v>
                </c:pt>
                <c:pt idx="2478">
                  <c:v>3.7997512881242343</c:v>
                </c:pt>
                <c:pt idx="2479">
                  <c:v>3.7992175968402515</c:v>
                </c:pt>
                <c:pt idx="2480">
                  <c:v>3.7992057210685259</c:v>
                </c:pt>
                <c:pt idx="2481">
                  <c:v>3.7979615647099552</c:v>
                </c:pt>
                <c:pt idx="2482">
                  <c:v>3.7979300596836705</c:v>
                </c:pt>
                <c:pt idx="2483">
                  <c:v>3.7975564356454723</c:v>
                </c:pt>
                <c:pt idx="2484">
                  <c:v>3.7970123380578062</c:v>
                </c:pt>
                <c:pt idx="2485">
                  <c:v>3.7969418710564637</c:v>
                </c:pt>
                <c:pt idx="2486">
                  <c:v>3.7967839526515497</c:v>
                </c:pt>
                <c:pt idx="2487">
                  <c:v>3.7966749169290206</c:v>
                </c:pt>
                <c:pt idx="2488">
                  <c:v>3.7957452686426989</c:v>
                </c:pt>
                <c:pt idx="2489">
                  <c:v>3.7948751529169975</c:v>
                </c:pt>
                <c:pt idx="2490">
                  <c:v>3.7948418753364574</c:v>
                </c:pt>
                <c:pt idx="2491">
                  <c:v>3.7946704166929126</c:v>
                </c:pt>
                <c:pt idx="2492">
                  <c:v>3.7945933737281683</c:v>
                </c:pt>
                <c:pt idx="2493">
                  <c:v>3.7943218722526959</c:v>
                </c:pt>
                <c:pt idx="2494">
                  <c:v>3.7937190049553902</c:v>
                </c:pt>
                <c:pt idx="2495">
                  <c:v>3.7936930105072939</c:v>
                </c:pt>
                <c:pt idx="2496">
                  <c:v>3.7932236789666955</c:v>
                </c:pt>
                <c:pt idx="2497">
                  <c:v>3.7929645335528654</c:v>
                </c:pt>
                <c:pt idx="2498">
                  <c:v>3.7927293428026863</c:v>
                </c:pt>
                <c:pt idx="2499">
                  <c:v>3.7923780689380142</c:v>
                </c:pt>
                <c:pt idx="2500">
                  <c:v>3.7923068459092688</c:v>
                </c:pt>
                <c:pt idx="2501">
                  <c:v>3.7915647313623015</c:v>
                </c:pt>
                <c:pt idx="2502">
                  <c:v>3.7912722120190567</c:v>
                </c:pt>
                <c:pt idx="2503">
                  <c:v>3.7908889085766795</c:v>
                </c:pt>
                <c:pt idx="2504">
                  <c:v>3.7904532808029558</c:v>
                </c:pt>
                <c:pt idx="2505">
                  <c:v>3.7904063710413252</c:v>
                </c:pt>
                <c:pt idx="2506">
                  <c:v>3.7903543734681637</c:v>
                </c:pt>
                <c:pt idx="2507">
                  <c:v>3.7898743726542832</c:v>
                </c:pt>
                <c:pt idx="2508">
                  <c:v>3.7897244348404735</c:v>
                </c:pt>
                <c:pt idx="2509">
                  <c:v>3.7893538703701992</c:v>
                </c:pt>
                <c:pt idx="2510">
                  <c:v>3.7892668633263993</c:v>
                </c:pt>
                <c:pt idx="2511">
                  <c:v>3.78918532739339</c:v>
                </c:pt>
                <c:pt idx="2512">
                  <c:v>3.7881730865822556</c:v>
                </c:pt>
                <c:pt idx="2513">
                  <c:v>3.7878991131331139</c:v>
                </c:pt>
                <c:pt idx="2514">
                  <c:v>3.7874073357274067</c:v>
                </c:pt>
                <c:pt idx="2515">
                  <c:v>3.7873057635034546</c:v>
                </c:pt>
                <c:pt idx="2516">
                  <c:v>3.7872715070480552</c:v>
                </c:pt>
                <c:pt idx="2517">
                  <c:v>3.7871903832863318</c:v>
                </c:pt>
                <c:pt idx="2518">
                  <c:v>3.7866942536227901</c:v>
                </c:pt>
                <c:pt idx="2519">
                  <c:v>3.7853128267881795</c:v>
                </c:pt>
                <c:pt idx="2520">
                  <c:v>3.7848771101556613</c:v>
                </c:pt>
                <c:pt idx="2521">
                  <c:v>3.784071804052501</c:v>
                </c:pt>
                <c:pt idx="2522">
                  <c:v>3.783473993130706</c:v>
                </c:pt>
                <c:pt idx="2523">
                  <c:v>3.7834724042232648</c:v>
                </c:pt>
                <c:pt idx="2524">
                  <c:v>3.7831787537823196</c:v>
                </c:pt>
                <c:pt idx="2525">
                  <c:v>3.7831103790425815</c:v>
                </c:pt>
                <c:pt idx="2526">
                  <c:v>3.7829696204011101</c:v>
                </c:pt>
                <c:pt idx="2527">
                  <c:v>3.7829362133474027</c:v>
                </c:pt>
                <c:pt idx="2528">
                  <c:v>3.7827066692270597</c:v>
                </c:pt>
                <c:pt idx="2529">
                  <c:v>3.7823065667550924</c:v>
                </c:pt>
                <c:pt idx="2530">
                  <c:v>3.7820846595602471</c:v>
                </c:pt>
                <c:pt idx="2531">
                  <c:v>3.7819830304459638</c:v>
                </c:pt>
                <c:pt idx="2532">
                  <c:v>3.7819037033574268</c:v>
                </c:pt>
                <c:pt idx="2533">
                  <c:v>3.7818546647946563</c:v>
                </c:pt>
                <c:pt idx="2534">
                  <c:v>3.7815587211553856</c:v>
                </c:pt>
                <c:pt idx="2535">
                  <c:v>3.7811523676374268</c:v>
                </c:pt>
                <c:pt idx="2536">
                  <c:v>3.7804797320687142</c:v>
                </c:pt>
                <c:pt idx="2537">
                  <c:v>3.7802837004318506</c:v>
                </c:pt>
                <c:pt idx="2538">
                  <c:v>3.7799626575940728</c:v>
                </c:pt>
                <c:pt idx="2539">
                  <c:v>3.7798485141219742</c:v>
                </c:pt>
                <c:pt idx="2540">
                  <c:v>3.7795872730231497</c:v>
                </c:pt>
                <c:pt idx="2541">
                  <c:v>3.7794565935209752</c:v>
                </c:pt>
                <c:pt idx="2542">
                  <c:v>3.7792564895042182</c:v>
                </c:pt>
                <c:pt idx="2543">
                  <c:v>3.7791172846460852</c:v>
                </c:pt>
                <c:pt idx="2544">
                  <c:v>3.7789439182390399</c:v>
                </c:pt>
                <c:pt idx="2545">
                  <c:v>3.778658033603091</c:v>
                </c:pt>
                <c:pt idx="2546">
                  <c:v>3.7785809088897087</c:v>
                </c:pt>
                <c:pt idx="2547">
                  <c:v>3.7784221977734833</c:v>
                </c:pt>
                <c:pt idx="2548">
                  <c:v>3.7783651279555031</c:v>
                </c:pt>
                <c:pt idx="2549">
                  <c:v>3.7782007088833049</c:v>
                </c:pt>
                <c:pt idx="2550">
                  <c:v>3.7777924071021611</c:v>
                </c:pt>
                <c:pt idx="2551">
                  <c:v>3.7774389060966036</c:v>
                </c:pt>
                <c:pt idx="2552">
                  <c:v>3.7771419523176317</c:v>
                </c:pt>
                <c:pt idx="2553">
                  <c:v>3.77677743301457</c:v>
                </c:pt>
                <c:pt idx="2554">
                  <c:v>3.7767758194172223</c:v>
                </c:pt>
                <c:pt idx="2555">
                  <c:v>3.7765373445038706</c:v>
                </c:pt>
                <c:pt idx="2556">
                  <c:v>3.7764118000240878</c:v>
                </c:pt>
                <c:pt idx="2557">
                  <c:v>3.776312469030918</c:v>
                </c:pt>
                <c:pt idx="2558">
                  <c:v>3.7758069827589567</c:v>
                </c:pt>
                <c:pt idx="2559">
                  <c:v>3.7757277325311454</c:v>
                </c:pt>
                <c:pt idx="2560">
                  <c:v>3.7752276374672284</c:v>
                </c:pt>
                <c:pt idx="2561">
                  <c:v>3.775168121806284</c:v>
                </c:pt>
                <c:pt idx="2562">
                  <c:v>3.7750122087919333</c:v>
                </c:pt>
                <c:pt idx="2563">
                  <c:v>3.7749972219952741</c:v>
                </c:pt>
                <c:pt idx="2564">
                  <c:v>3.7747597945560036</c:v>
                </c:pt>
                <c:pt idx="2565">
                  <c:v>3.7742147603377174</c:v>
                </c:pt>
                <c:pt idx="2566">
                  <c:v>3.7740873248427476</c:v>
                </c:pt>
                <c:pt idx="2567">
                  <c:v>3.7738510238146508</c:v>
                </c:pt>
                <c:pt idx="2568">
                  <c:v>3.7738266555716491</c:v>
                </c:pt>
                <c:pt idx="2569">
                  <c:v>3.7737161690511511</c:v>
                </c:pt>
                <c:pt idx="2570">
                  <c:v>3.7736755419392285</c:v>
                </c:pt>
                <c:pt idx="2571">
                  <c:v>3.7735833042871381</c:v>
                </c:pt>
                <c:pt idx="2572">
                  <c:v>3.77326052148628</c:v>
                </c:pt>
                <c:pt idx="2573">
                  <c:v>3.7729175560687298</c:v>
                </c:pt>
                <c:pt idx="2574">
                  <c:v>3.7729114510280559</c:v>
                </c:pt>
                <c:pt idx="2575">
                  <c:v>3.7727657185848225</c:v>
                </c:pt>
                <c:pt idx="2576">
                  <c:v>3.7727066789572397</c:v>
                </c:pt>
                <c:pt idx="2577">
                  <c:v>3.7726219736125257</c:v>
                </c:pt>
                <c:pt idx="2578">
                  <c:v>3.7720987149107192</c:v>
                </c:pt>
                <c:pt idx="2579">
                  <c:v>3.772001247433538</c:v>
                </c:pt>
                <c:pt idx="2580">
                  <c:v>3.7713142768911165</c:v>
                </c:pt>
                <c:pt idx="2581">
                  <c:v>3.7709628202962513</c:v>
                </c:pt>
                <c:pt idx="2582">
                  <c:v>3.7708843167156241</c:v>
                </c:pt>
                <c:pt idx="2583">
                  <c:v>3.7707469012946171</c:v>
                </c:pt>
                <c:pt idx="2584">
                  <c:v>3.7700407349108054</c:v>
                </c:pt>
                <c:pt idx="2585">
                  <c:v>3.7697796744938641</c:v>
                </c:pt>
                <c:pt idx="2586">
                  <c:v>3.7697317075579835</c:v>
                </c:pt>
                <c:pt idx="2587">
                  <c:v>3.7695262507441738</c:v>
                </c:pt>
                <c:pt idx="2588">
                  <c:v>3.7691212039345379</c:v>
                </c:pt>
                <c:pt idx="2589">
                  <c:v>3.7690132097556535</c:v>
                </c:pt>
                <c:pt idx="2590">
                  <c:v>3.7689207979790398</c:v>
                </c:pt>
                <c:pt idx="2591">
                  <c:v>3.7687433122270821</c:v>
                </c:pt>
                <c:pt idx="2592">
                  <c:v>3.7687141351736217</c:v>
                </c:pt>
                <c:pt idx="2593">
                  <c:v>3.7684761251571892</c:v>
                </c:pt>
                <c:pt idx="2594">
                  <c:v>3.7682918758699753</c:v>
                </c:pt>
                <c:pt idx="2595">
                  <c:v>3.7681618672897308</c:v>
                </c:pt>
                <c:pt idx="2596">
                  <c:v>3.7671377185451886</c:v>
                </c:pt>
                <c:pt idx="2597">
                  <c:v>3.7671269946441512</c:v>
                </c:pt>
                <c:pt idx="2598">
                  <c:v>3.7667927711837077</c:v>
                </c:pt>
                <c:pt idx="2599">
                  <c:v>3.7666362992395803</c:v>
                </c:pt>
                <c:pt idx="2600">
                  <c:v>3.7663769023030897</c:v>
                </c:pt>
                <c:pt idx="2601">
                  <c:v>3.7662578913602638</c:v>
                </c:pt>
                <c:pt idx="2602">
                  <c:v>3.7659825535807894</c:v>
                </c:pt>
                <c:pt idx="2603">
                  <c:v>3.7659225845211206</c:v>
                </c:pt>
                <c:pt idx="2604">
                  <c:v>3.7658824626649503</c:v>
                </c:pt>
                <c:pt idx="2605">
                  <c:v>3.7651588060274115</c:v>
                </c:pt>
                <c:pt idx="2606">
                  <c:v>3.7651169560431716</c:v>
                </c:pt>
                <c:pt idx="2607">
                  <c:v>3.7644700475356374</c:v>
                </c:pt>
                <c:pt idx="2608">
                  <c:v>3.7641366794836353</c:v>
                </c:pt>
                <c:pt idx="2609">
                  <c:v>3.7636862471007588</c:v>
                </c:pt>
                <c:pt idx="2610">
                  <c:v>3.7634363133009074</c:v>
                </c:pt>
                <c:pt idx="2611">
                  <c:v>3.7632902787482663</c:v>
                </c:pt>
                <c:pt idx="2612">
                  <c:v>3.7632386764537058</c:v>
                </c:pt>
                <c:pt idx="2613">
                  <c:v>3.7630830001297872</c:v>
                </c:pt>
                <c:pt idx="2614">
                  <c:v>3.7630209638005372</c:v>
                </c:pt>
                <c:pt idx="2615">
                  <c:v>3.762862710213239</c:v>
                </c:pt>
                <c:pt idx="2616">
                  <c:v>3.7628527133135083</c:v>
                </c:pt>
                <c:pt idx="2617">
                  <c:v>3.7625743738936941</c:v>
                </c:pt>
                <c:pt idx="2618">
                  <c:v>3.7625105973835415</c:v>
                </c:pt>
                <c:pt idx="2619">
                  <c:v>3.7624630715412142</c:v>
                </c:pt>
                <c:pt idx="2620">
                  <c:v>3.7624109538934687</c:v>
                </c:pt>
                <c:pt idx="2621">
                  <c:v>3.7616234250709173</c:v>
                </c:pt>
                <c:pt idx="2622">
                  <c:v>3.761394870463961</c:v>
                </c:pt>
                <c:pt idx="2623">
                  <c:v>3.7612899541281939</c:v>
                </c:pt>
                <c:pt idx="2624">
                  <c:v>3.761237695501328</c:v>
                </c:pt>
                <c:pt idx="2625">
                  <c:v>3.7611068123062852</c:v>
                </c:pt>
                <c:pt idx="2626">
                  <c:v>3.7608767302662978</c:v>
                </c:pt>
                <c:pt idx="2627">
                  <c:v>3.7608001486627374</c:v>
                </c:pt>
                <c:pt idx="2628">
                  <c:v>3.7605288658387099</c:v>
                </c:pt>
                <c:pt idx="2629">
                  <c:v>3.7598369138789791</c:v>
                </c:pt>
                <c:pt idx="2630">
                  <c:v>3.7595310308703804</c:v>
                </c:pt>
                <c:pt idx="2631">
                  <c:v>3.7595222162324617</c:v>
                </c:pt>
                <c:pt idx="2632">
                  <c:v>3.7589224007513358</c:v>
                </c:pt>
                <c:pt idx="2633">
                  <c:v>3.7587756811324731</c:v>
                </c:pt>
                <c:pt idx="2634">
                  <c:v>3.7587332114774274</c:v>
                </c:pt>
                <c:pt idx="2635">
                  <c:v>3.7583958296836175</c:v>
                </c:pt>
                <c:pt idx="2636">
                  <c:v>3.7583621612588556</c:v>
                </c:pt>
                <c:pt idx="2637">
                  <c:v>3.7582030426395656</c:v>
                </c:pt>
                <c:pt idx="2638">
                  <c:v>3.757762847611529</c:v>
                </c:pt>
                <c:pt idx="2639">
                  <c:v>3.757674755039496</c:v>
                </c:pt>
                <c:pt idx="2640">
                  <c:v>3.7573719850180414</c:v>
                </c:pt>
                <c:pt idx="2641">
                  <c:v>3.7571378049709141</c:v>
                </c:pt>
                <c:pt idx="2642">
                  <c:v>3.7563055502098135</c:v>
                </c:pt>
                <c:pt idx="2643">
                  <c:v>3.7562188533305805</c:v>
                </c:pt>
                <c:pt idx="2644">
                  <c:v>3.756072063550278</c:v>
                </c:pt>
                <c:pt idx="2645">
                  <c:v>3.7559878591241107</c:v>
                </c:pt>
                <c:pt idx="2646">
                  <c:v>3.7555856530362326</c:v>
                </c:pt>
                <c:pt idx="2647">
                  <c:v>3.7553191451616765</c:v>
                </c:pt>
                <c:pt idx="2648">
                  <c:v>3.7545963360711698</c:v>
                </c:pt>
                <c:pt idx="2649">
                  <c:v>3.7545657683368279</c:v>
                </c:pt>
                <c:pt idx="2650">
                  <c:v>3.7544952845275552</c:v>
                </c:pt>
                <c:pt idx="2651">
                  <c:v>3.7541460936230506</c:v>
                </c:pt>
                <c:pt idx="2652">
                  <c:v>3.7538855043854995</c:v>
                </c:pt>
                <c:pt idx="2653">
                  <c:v>3.7537477072439294</c:v>
                </c:pt>
                <c:pt idx="2654">
                  <c:v>3.7536668799362416</c:v>
                </c:pt>
                <c:pt idx="2655">
                  <c:v>3.7535247575625603</c:v>
                </c:pt>
                <c:pt idx="2656">
                  <c:v>3.7534136654818959</c:v>
                </c:pt>
                <c:pt idx="2657">
                  <c:v>3.7533429944286607</c:v>
                </c:pt>
                <c:pt idx="2658">
                  <c:v>3.7530397446996488</c:v>
                </c:pt>
                <c:pt idx="2659">
                  <c:v>3.7527840326686563</c:v>
                </c:pt>
                <c:pt idx="2660">
                  <c:v>3.7526015327020485</c:v>
                </c:pt>
                <c:pt idx="2661">
                  <c:v>3.7525388339412662</c:v>
                </c:pt>
                <c:pt idx="2662">
                  <c:v>3.7523336134821754</c:v>
                </c:pt>
                <c:pt idx="2663">
                  <c:v>3.7516793328611162</c:v>
                </c:pt>
                <c:pt idx="2664">
                  <c:v>3.7515652026032322</c:v>
                </c:pt>
                <c:pt idx="2665">
                  <c:v>3.7513154647848093</c:v>
                </c:pt>
                <c:pt idx="2666">
                  <c:v>3.7512097961423723</c:v>
                </c:pt>
                <c:pt idx="2667">
                  <c:v>3.7512020945883533</c:v>
                </c:pt>
                <c:pt idx="2668">
                  <c:v>3.7508399674058581</c:v>
                </c:pt>
                <c:pt idx="2669">
                  <c:v>3.7508211251048946</c:v>
                </c:pt>
                <c:pt idx="2670">
                  <c:v>3.7507821532067149</c:v>
                </c:pt>
                <c:pt idx="2671">
                  <c:v>3.7506827804533196</c:v>
                </c:pt>
                <c:pt idx="2672">
                  <c:v>3.7503952424140139</c:v>
                </c:pt>
                <c:pt idx="2673">
                  <c:v>3.7499384756085834</c:v>
                </c:pt>
                <c:pt idx="2674">
                  <c:v>3.7498702410208771</c:v>
                </c:pt>
                <c:pt idx="2675">
                  <c:v>3.7496865122391392</c:v>
                </c:pt>
                <c:pt idx="2676">
                  <c:v>3.7489744732528441</c:v>
                </c:pt>
                <c:pt idx="2677">
                  <c:v>3.7484516257858211</c:v>
                </c:pt>
                <c:pt idx="2678">
                  <c:v>3.748287972171485</c:v>
                </c:pt>
                <c:pt idx="2679">
                  <c:v>3.7480626322244022</c:v>
                </c:pt>
                <c:pt idx="2680">
                  <c:v>3.7480066022349163</c:v>
                </c:pt>
                <c:pt idx="2681">
                  <c:v>3.7474299354828884</c:v>
                </c:pt>
                <c:pt idx="2682">
                  <c:v>3.74707328712396</c:v>
                </c:pt>
                <c:pt idx="2683">
                  <c:v>3.7467539549969526</c:v>
                </c:pt>
                <c:pt idx="2684">
                  <c:v>3.7466354961115131</c:v>
                </c:pt>
                <c:pt idx="2685">
                  <c:v>3.7465606860834444</c:v>
                </c:pt>
                <c:pt idx="2686">
                  <c:v>3.7460189019117398</c:v>
                </c:pt>
                <c:pt idx="2687">
                  <c:v>3.7457464563324643</c:v>
                </c:pt>
                <c:pt idx="2688">
                  <c:v>3.7455878480957616</c:v>
                </c:pt>
                <c:pt idx="2689">
                  <c:v>3.7455119903495935</c:v>
                </c:pt>
                <c:pt idx="2690">
                  <c:v>3.7449289607998213</c:v>
                </c:pt>
                <c:pt idx="2691">
                  <c:v>3.7448490803304604</c:v>
                </c:pt>
                <c:pt idx="2692">
                  <c:v>3.7445115968840867</c:v>
                </c:pt>
                <c:pt idx="2693">
                  <c:v>3.743645188441405</c:v>
                </c:pt>
                <c:pt idx="2694">
                  <c:v>3.7435110712682271</c:v>
                </c:pt>
                <c:pt idx="2695">
                  <c:v>3.7428669061383948</c:v>
                </c:pt>
                <c:pt idx="2696">
                  <c:v>3.7425841830607487</c:v>
                </c:pt>
                <c:pt idx="2697">
                  <c:v>3.7424231056924304</c:v>
                </c:pt>
                <c:pt idx="2698">
                  <c:v>3.7423903590832186</c:v>
                </c:pt>
                <c:pt idx="2699">
                  <c:v>3.742334902527114</c:v>
                </c:pt>
                <c:pt idx="2700">
                  <c:v>3.7422497389105094</c:v>
                </c:pt>
                <c:pt idx="2701">
                  <c:v>3.7421357245434725</c:v>
                </c:pt>
                <c:pt idx="2702">
                  <c:v>3.7421165007819619</c:v>
                </c:pt>
                <c:pt idx="2703">
                  <c:v>3.7420103178606787</c:v>
                </c:pt>
                <c:pt idx="2704">
                  <c:v>3.7418241073507645</c:v>
                </c:pt>
                <c:pt idx="2705">
                  <c:v>3.7416351925869638</c:v>
                </c:pt>
                <c:pt idx="2706">
                  <c:v>3.7413748628750989</c:v>
                </c:pt>
                <c:pt idx="2707">
                  <c:v>3.7411975743578632</c:v>
                </c:pt>
                <c:pt idx="2708">
                  <c:v>3.7406372171988425</c:v>
                </c:pt>
                <c:pt idx="2709">
                  <c:v>3.7404026076574808</c:v>
                </c:pt>
                <c:pt idx="2710">
                  <c:v>3.7403245225445345</c:v>
                </c:pt>
                <c:pt idx="2711">
                  <c:v>3.740213512236231</c:v>
                </c:pt>
                <c:pt idx="2712">
                  <c:v>3.7402047355074495</c:v>
                </c:pt>
                <c:pt idx="2713">
                  <c:v>3.7401476824465614</c:v>
                </c:pt>
                <c:pt idx="2714">
                  <c:v>3.7398284859447721</c:v>
                </c:pt>
                <c:pt idx="2715">
                  <c:v>3.7397691870310323</c:v>
                </c:pt>
                <c:pt idx="2716">
                  <c:v>3.739718227421934</c:v>
                </c:pt>
                <c:pt idx="2717">
                  <c:v>3.7395516883824222</c:v>
                </c:pt>
                <c:pt idx="2718">
                  <c:v>3.7392580022668822</c:v>
                </c:pt>
                <c:pt idx="2719">
                  <c:v>3.7385837076805482</c:v>
                </c:pt>
                <c:pt idx="2720">
                  <c:v>3.7385480271784206</c:v>
                </c:pt>
                <c:pt idx="2721">
                  <c:v>3.7383030300108828</c:v>
                </c:pt>
                <c:pt idx="2722">
                  <c:v>3.737862921919703</c:v>
                </c:pt>
                <c:pt idx="2723">
                  <c:v>3.7378386544940687</c:v>
                </c:pt>
                <c:pt idx="2724">
                  <c:v>3.737462556703778</c:v>
                </c:pt>
                <c:pt idx="2725">
                  <c:v>3.7374139757289746</c:v>
                </c:pt>
                <c:pt idx="2726">
                  <c:v>3.7372222486657658</c:v>
                </c:pt>
                <c:pt idx="2727">
                  <c:v>3.7372213649349586</c:v>
                </c:pt>
                <c:pt idx="2728">
                  <c:v>3.7371374023070612</c:v>
                </c:pt>
                <c:pt idx="2729">
                  <c:v>3.7370830388962757</c:v>
                </c:pt>
                <c:pt idx="2730">
                  <c:v>3.736970312581422</c:v>
                </c:pt>
                <c:pt idx="2731">
                  <c:v>3.7368518078913939</c:v>
                </c:pt>
                <c:pt idx="2732">
                  <c:v>3.7364637883598628</c:v>
                </c:pt>
                <c:pt idx="2733">
                  <c:v>3.7357133127064528</c:v>
                </c:pt>
                <c:pt idx="2734">
                  <c:v>3.7356667529100833</c:v>
                </c:pt>
                <c:pt idx="2735">
                  <c:v>3.7356450232967635</c:v>
                </c:pt>
                <c:pt idx="2736">
                  <c:v>3.7352505971089913</c:v>
                </c:pt>
                <c:pt idx="2737">
                  <c:v>3.7352168612580452</c:v>
                </c:pt>
                <c:pt idx="2738">
                  <c:v>3.7351742438054707</c:v>
                </c:pt>
                <c:pt idx="2739">
                  <c:v>3.7351573732417611</c:v>
                </c:pt>
                <c:pt idx="2740">
                  <c:v>3.7348851338159674</c:v>
                </c:pt>
                <c:pt idx="2741">
                  <c:v>3.7347149530265193</c:v>
                </c:pt>
                <c:pt idx="2742">
                  <c:v>3.734611834571802</c:v>
                </c:pt>
                <c:pt idx="2743">
                  <c:v>3.7344513299940814</c:v>
                </c:pt>
                <c:pt idx="2744">
                  <c:v>3.7344153083520739</c:v>
                </c:pt>
                <c:pt idx="2745">
                  <c:v>3.7338229688589113</c:v>
                </c:pt>
                <c:pt idx="2746">
                  <c:v>3.7331700595272155</c:v>
                </c:pt>
                <c:pt idx="2747">
                  <c:v>3.7331209959777887</c:v>
                </c:pt>
                <c:pt idx="2748">
                  <c:v>3.7330870942874057</c:v>
                </c:pt>
                <c:pt idx="2749">
                  <c:v>3.7326179980441263</c:v>
                </c:pt>
                <c:pt idx="2750">
                  <c:v>3.7321077104255678</c:v>
                </c:pt>
                <c:pt idx="2751">
                  <c:v>3.731326820331569</c:v>
                </c:pt>
                <c:pt idx="2752">
                  <c:v>3.7311314902477108</c:v>
                </c:pt>
                <c:pt idx="2753">
                  <c:v>3.7307096180956583</c:v>
                </c:pt>
                <c:pt idx="2754">
                  <c:v>3.7306705932716682</c:v>
                </c:pt>
                <c:pt idx="2755">
                  <c:v>3.7306575842177008</c:v>
                </c:pt>
                <c:pt idx="2756">
                  <c:v>3.7293911508033872</c:v>
                </c:pt>
                <c:pt idx="2757">
                  <c:v>3.7282667340093685</c:v>
                </c:pt>
                <c:pt idx="2758">
                  <c:v>3.7282599678890822</c:v>
                </c:pt>
                <c:pt idx="2759">
                  <c:v>3.7282292934882655</c:v>
                </c:pt>
                <c:pt idx="2760">
                  <c:v>3.7282184667118603</c:v>
                </c:pt>
                <c:pt idx="2761">
                  <c:v>3.7282085419297113</c:v>
                </c:pt>
                <c:pt idx="2762">
                  <c:v>3.7277178848001289</c:v>
                </c:pt>
                <c:pt idx="2763">
                  <c:v>3.7271434686414526</c:v>
                </c:pt>
                <c:pt idx="2764">
                  <c:v>3.7266244400958595</c:v>
                </c:pt>
                <c:pt idx="2765">
                  <c:v>3.7262394063499769</c:v>
                </c:pt>
                <c:pt idx="2766">
                  <c:v>3.7261301758160443</c:v>
                </c:pt>
                <c:pt idx="2767">
                  <c:v>3.7259043758521053</c:v>
                </c:pt>
                <c:pt idx="2768">
                  <c:v>3.7255409451198527</c:v>
                </c:pt>
                <c:pt idx="2769">
                  <c:v>3.7245744013334288</c:v>
                </c:pt>
                <c:pt idx="2770">
                  <c:v>3.7243323151104435</c:v>
                </c:pt>
                <c:pt idx="2771">
                  <c:v>3.7238240412236587</c:v>
                </c:pt>
                <c:pt idx="2772">
                  <c:v>3.723810369733461</c:v>
                </c:pt>
                <c:pt idx="2773">
                  <c:v>3.7226270680844888</c:v>
                </c:pt>
                <c:pt idx="2774">
                  <c:v>3.7218170247401452</c:v>
                </c:pt>
                <c:pt idx="2775">
                  <c:v>3.7217304881350977</c:v>
                </c:pt>
                <c:pt idx="2776">
                  <c:v>3.721373170404219</c:v>
                </c:pt>
                <c:pt idx="2777">
                  <c:v>3.7212980046419322</c:v>
                </c:pt>
                <c:pt idx="2778">
                  <c:v>3.7212883788180986</c:v>
                </c:pt>
                <c:pt idx="2779">
                  <c:v>3.7206865705753853</c:v>
                </c:pt>
                <c:pt idx="2780">
                  <c:v>3.7204547069936571</c:v>
                </c:pt>
                <c:pt idx="2781">
                  <c:v>3.7203159888081521</c:v>
                </c:pt>
                <c:pt idx="2782">
                  <c:v>3.7197763120379403</c:v>
                </c:pt>
                <c:pt idx="2783">
                  <c:v>3.7195241718242</c:v>
                </c:pt>
                <c:pt idx="2784">
                  <c:v>3.7192833977593804</c:v>
                </c:pt>
                <c:pt idx="2785">
                  <c:v>3.7186063977725312</c:v>
                </c:pt>
                <c:pt idx="2786">
                  <c:v>3.7182007985934726</c:v>
                </c:pt>
                <c:pt idx="2787">
                  <c:v>3.7177462991707668</c:v>
                </c:pt>
                <c:pt idx="2788">
                  <c:v>3.7172408955530836</c:v>
                </c:pt>
                <c:pt idx="2789">
                  <c:v>3.7167288813367265</c:v>
                </c:pt>
                <c:pt idx="2790">
                  <c:v>3.7166779246609956</c:v>
                </c:pt>
                <c:pt idx="2791">
                  <c:v>3.7163386787868919</c:v>
                </c:pt>
                <c:pt idx="2792">
                  <c:v>3.7160863898739649</c:v>
                </c:pt>
                <c:pt idx="2793">
                  <c:v>3.7160594827757878</c:v>
                </c:pt>
                <c:pt idx="2794">
                  <c:v>3.7159824635904717</c:v>
                </c:pt>
                <c:pt idx="2795">
                  <c:v>3.7158098167626803</c:v>
                </c:pt>
                <c:pt idx="2796">
                  <c:v>3.715718824690371</c:v>
                </c:pt>
                <c:pt idx="2797">
                  <c:v>3.7156937520958304</c:v>
                </c:pt>
                <c:pt idx="2798">
                  <c:v>3.7152891403377515</c:v>
                </c:pt>
                <c:pt idx="2799">
                  <c:v>3.7151678227320475</c:v>
                </c:pt>
                <c:pt idx="2800">
                  <c:v>3.7147371272658649</c:v>
                </c:pt>
                <c:pt idx="2801">
                  <c:v>3.7146868671408808</c:v>
                </c:pt>
                <c:pt idx="2802">
                  <c:v>3.7140478705965378</c:v>
                </c:pt>
                <c:pt idx="2803">
                  <c:v>3.7133393117238152</c:v>
                </c:pt>
                <c:pt idx="2804">
                  <c:v>3.7132618085774927</c:v>
                </c:pt>
                <c:pt idx="2805">
                  <c:v>3.7131735502018395</c:v>
                </c:pt>
                <c:pt idx="2806">
                  <c:v>3.7118906130722995</c:v>
                </c:pt>
                <c:pt idx="2807">
                  <c:v>3.7117439776661874</c:v>
                </c:pt>
                <c:pt idx="2808">
                  <c:v>3.7116858719891055</c:v>
                </c:pt>
                <c:pt idx="2809">
                  <c:v>3.711661502778437</c:v>
                </c:pt>
                <c:pt idx="2810">
                  <c:v>3.7115161964101375</c:v>
                </c:pt>
                <c:pt idx="2811">
                  <c:v>3.7112493623365341</c:v>
                </c:pt>
                <c:pt idx="2812">
                  <c:v>3.7109772009486144</c:v>
                </c:pt>
                <c:pt idx="2813">
                  <c:v>3.7109556084334567</c:v>
                </c:pt>
                <c:pt idx="2814">
                  <c:v>3.7107490170681268</c:v>
                </c:pt>
                <c:pt idx="2815">
                  <c:v>3.7106447450213302</c:v>
                </c:pt>
                <c:pt idx="2816">
                  <c:v>3.7105202433491535</c:v>
                </c:pt>
                <c:pt idx="2817">
                  <c:v>3.7105070863704217</c:v>
                </c:pt>
                <c:pt idx="2818">
                  <c:v>3.7103449408760745</c:v>
                </c:pt>
                <c:pt idx="2819">
                  <c:v>3.7099842438469257</c:v>
                </c:pt>
                <c:pt idx="2820">
                  <c:v>3.7097931929337351</c:v>
                </c:pt>
                <c:pt idx="2821">
                  <c:v>3.7093232077944842</c:v>
                </c:pt>
                <c:pt idx="2822">
                  <c:v>3.7092803281248798</c:v>
                </c:pt>
                <c:pt idx="2823">
                  <c:v>3.7090899101032395</c:v>
                </c:pt>
                <c:pt idx="2824">
                  <c:v>3.7088975219837166</c:v>
                </c:pt>
                <c:pt idx="2825">
                  <c:v>3.7086059481560971</c:v>
                </c:pt>
                <c:pt idx="2826">
                  <c:v>3.7082489992003285</c:v>
                </c:pt>
                <c:pt idx="2827">
                  <c:v>3.7079546261610017</c:v>
                </c:pt>
                <c:pt idx="2828">
                  <c:v>3.7078567726413261</c:v>
                </c:pt>
                <c:pt idx="2829">
                  <c:v>3.7078274595663041</c:v>
                </c:pt>
                <c:pt idx="2830">
                  <c:v>3.7078052370457901</c:v>
                </c:pt>
                <c:pt idx="2831">
                  <c:v>3.7074916364432697</c:v>
                </c:pt>
                <c:pt idx="2832">
                  <c:v>3.7072516713307517</c:v>
                </c:pt>
                <c:pt idx="2833">
                  <c:v>3.7072313131592103</c:v>
                </c:pt>
                <c:pt idx="2834">
                  <c:v>3.7072095335935558</c:v>
                </c:pt>
                <c:pt idx="2835">
                  <c:v>3.7071986434011284</c:v>
                </c:pt>
                <c:pt idx="2836">
                  <c:v>3.7068196840608389</c:v>
                </c:pt>
                <c:pt idx="2837">
                  <c:v>3.7067732387985015</c:v>
                </c:pt>
                <c:pt idx="2838">
                  <c:v>3.7066101671193135</c:v>
                </c:pt>
                <c:pt idx="2839">
                  <c:v>3.7062980744485916</c:v>
                </c:pt>
                <c:pt idx="2840">
                  <c:v>3.7059843328879172</c:v>
                </c:pt>
                <c:pt idx="2841">
                  <c:v>3.7058162146645901</c:v>
                </c:pt>
                <c:pt idx="2842">
                  <c:v>3.7054593414499402</c:v>
                </c:pt>
                <c:pt idx="2843">
                  <c:v>3.7054274889742018</c:v>
                </c:pt>
                <c:pt idx="2844">
                  <c:v>3.7049570364383198</c:v>
                </c:pt>
                <c:pt idx="2845">
                  <c:v>3.7049103915381756</c:v>
                </c:pt>
                <c:pt idx="2846">
                  <c:v>3.7046780443585705</c:v>
                </c:pt>
                <c:pt idx="2847">
                  <c:v>3.7046308931822618</c:v>
                </c:pt>
                <c:pt idx="2848">
                  <c:v>3.7043931542418851</c:v>
                </c:pt>
                <c:pt idx="2849">
                  <c:v>3.704303074839753</c:v>
                </c:pt>
                <c:pt idx="2850">
                  <c:v>3.7042525459377802</c:v>
                </c:pt>
                <c:pt idx="2851">
                  <c:v>3.7040737408272415</c:v>
                </c:pt>
                <c:pt idx="2852">
                  <c:v>3.7040565716631759</c:v>
                </c:pt>
                <c:pt idx="2853">
                  <c:v>3.7031470670892808</c:v>
                </c:pt>
                <c:pt idx="2854">
                  <c:v>3.7030180066818277</c:v>
                </c:pt>
                <c:pt idx="2855">
                  <c:v>3.7029319450979257</c:v>
                </c:pt>
                <c:pt idx="2856">
                  <c:v>3.7028329531884405</c:v>
                </c:pt>
                <c:pt idx="2857">
                  <c:v>3.7027344170949452</c:v>
                </c:pt>
                <c:pt idx="2858">
                  <c:v>3.7025119111647586</c:v>
                </c:pt>
                <c:pt idx="2859">
                  <c:v>3.7023194592791873</c:v>
                </c:pt>
                <c:pt idx="2860">
                  <c:v>3.7016025200232949</c:v>
                </c:pt>
                <c:pt idx="2861">
                  <c:v>3.7015866918374765</c:v>
                </c:pt>
                <c:pt idx="2862">
                  <c:v>3.7015627086385194</c:v>
                </c:pt>
                <c:pt idx="2863">
                  <c:v>3.7013362419526623</c:v>
                </c:pt>
                <c:pt idx="2864">
                  <c:v>3.7010510714595055</c:v>
                </c:pt>
                <c:pt idx="2865">
                  <c:v>3.7008565296167846</c:v>
                </c:pt>
                <c:pt idx="2866">
                  <c:v>3.7007647524743121</c:v>
                </c:pt>
                <c:pt idx="2867">
                  <c:v>3.7007527383237724</c:v>
                </c:pt>
                <c:pt idx="2868">
                  <c:v>3.7006840109943586</c:v>
                </c:pt>
                <c:pt idx="2869">
                  <c:v>3.7006364241635046</c:v>
                </c:pt>
                <c:pt idx="2870">
                  <c:v>3.7005748900258988</c:v>
                </c:pt>
                <c:pt idx="2871">
                  <c:v>3.7003339576836747</c:v>
                </c:pt>
                <c:pt idx="2872">
                  <c:v>3.7002675696006371</c:v>
                </c:pt>
                <c:pt idx="2873">
                  <c:v>3.7002593906563961</c:v>
                </c:pt>
                <c:pt idx="2874">
                  <c:v>3.6999287361321715</c:v>
                </c:pt>
                <c:pt idx="2875">
                  <c:v>3.6998449496009456</c:v>
                </c:pt>
                <c:pt idx="2876">
                  <c:v>3.6997409162413959</c:v>
                </c:pt>
                <c:pt idx="2877">
                  <c:v>3.699508195883737</c:v>
                </c:pt>
                <c:pt idx="2878">
                  <c:v>3.6993756389099017</c:v>
                </c:pt>
                <c:pt idx="2879">
                  <c:v>3.6989714519818793</c:v>
                </c:pt>
                <c:pt idx="2880">
                  <c:v>3.6987865968326838</c:v>
                </c:pt>
                <c:pt idx="2881">
                  <c:v>3.6986914840274014</c:v>
                </c:pt>
                <c:pt idx="2882">
                  <c:v>3.6983847602808866</c:v>
                </c:pt>
                <c:pt idx="2883">
                  <c:v>3.6980783032967972</c:v>
                </c:pt>
                <c:pt idx="2884">
                  <c:v>3.6972564732052127</c:v>
                </c:pt>
                <c:pt idx="2885">
                  <c:v>3.696810543805467</c:v>
                </c:pt>
                <c:pt idx="2886">
                  <c:v>3.6967654406670678</c:v>
                </c:pt>
                <c:pt idx="2887">
                  <c:v>3.6963316294555044</c:v>
                </c:pt>
                <c:pt idx="2888">
                  <c:v>3.6963063832482348</c:v>
                </c:pt>
                <c:pt idx="2889">
                  <c:v>3.6962966727777213</c:v>
                </c:pt>
                <c:pt idx="2890">
                  <c:v>3.696185958065227</c:v>
                </c:pt>
                <c:pt idx="2891">
                  <c:v>3.6961058179685926</c:v>
                </c:pt>
                <c:pt idx="2892">
                  <c:v>3.6959445215525353</c:v>
                </c:pt>
                <c:pt idx="2893">
                  <c:v>3.6957131606804339</c:v>
                </c:pt>
                <c:pt idx="2894">
                  <c:v>3.6947046219790733</c:v>
                </c:pt>
                <c:pt idx="2895">
                  <c:v>3.6941540978492475</c:v>
                </c:pt>
                <c:pt idx="2896">
                  <c:v>3.6938905355772604</c:v>
                </c:pt>
                <c:pt idx="2897">
                  <c:v>3.6935383815978011</c:v>
                </c:pt>
                <c:pt idx="2898">
                  <c:v>3.6935290976718571</c:v>
                </c:pt>
                <c:pt idx="2899">
                  <c:v>3.6933712405584362</c:v>
                </c:pt>
                <c:pt idx="2900">
                  <c:v>3.6933101349417949</c:v>
                </c:pt>
                <c:pt idx="2901">
                  <c:v>3.6926187984913801</c:v>
                </c:pt>
                <c:pt idx="2902">
                  <c:v>3.6924841216140125</c:v>
                </c:pt>
                <c:pt idx="2903">
                  <c:v>3.6923626317323786</c:v>
                </c:pt>
                <c:pt idx="2904">
                  <c:v>3.6922259149797227</c:v>
                </c:pt>
                <c:pt idx="2905">
                  <c:v>3.6921072942568713</c:v>
                </c:pt>
                <c:pt idx="2906">
                  <c:v>3.6920219849498426</c:v>
                </c:pt>
                <c:pt idx="2907">
                  <c:v>3.6919597083805376</c:v>
                </c:pt>
                <c:pt idx="2908">
                  <c:v>3.6910981992154848</c:v>
                </c:pt>
                <c:pt idx="2909">
                  <c:v>3.6910770695497179</c:v>
                </c:pt>
                <c:pt idx="2910">
                  <c:v>3.6903865960175701</c:v>
                </c:pt>
                <c:pt idx="2911">
                  <c:v>3.6900719781611446</c:v>
                </c:pt>
                <c:pt idx="2912">
                  <c:v>3.6900498133811874</c:v>
                </c:pt>
                <c:pt idx="2913">
                  <c:v>3.6899448847374199</c:v>
                </c:pt>
                <c:pt idx="2914">
                  <c:v>3.6897408663700912</c:v>
                </c:pt>
                <c:pt idx="2915">
                  <c:v>3.6893300749911324</c:v>
                </c:pt>
                <c:pt idx="2916">
                  <c:v>3.6891879582384668</c:v>
                </c:pt>
                <c:pt idx="2917">
                  <c:v>3.6884964496281984</c:v>
                </c:pt>
                <c:pt idx="2918">
                  <c:v>3.6881077337812767</c:v>
                </c:pt>
                <c:pt idx="2919">
                  <c:v>3.6879305696993279</c:v>
                </c:pt>
                <c:pt idx="2920">
                  <c:v>3.6878919601134159</c:v>
                </c:pt>
                <c:pt idx="2921">
                  <c:v>3.687818691462454</c:v>
                </c:pt>
                <c:pt idx="2922">
                  <c:v>3.6877072796248189</c:v>
                </c:pt>
                <c:pt idx="2923">
                  <c:v>3.6873703944721843</c:v>
                </c:pt>
                <c:pt idx="2924">
                  <c:v>3.6872539101398156</c:v>
                </c:pt>
                <c:pt idx="2925">
                  <c:v>3.6870248157712715</c:v>
                </c:pt>
                <c:pt idx="2926">
                  <c:v>3.6863765482542359</c:v>
                </c:pt>
                <c:pt idx="2927">
                  <c:v>3.686257312606279</c:v>
                </c:pt>
                <c:pt idx="2928">
                  <c:v>3.6858009339302185</c:v>
                </c:pt>
                <c:pt idx="2929">
                  <c:v>3.6856700964902731</c:v>
                </c:pt>
                <c:pt idx="2930">
                  <c:v>3.6856208356818869</c:v>
                </c:pt>
                <c:pt idx="2931">
                  <c:v>3.6854640595626189</c:v>
                </c:pt>
                <c:pt idx="2932">
                  <c:v>3.6849325906412576</c:v>
                </c:pt>
                <c:pt idx="2933">
                  <c:v>3.6847471457495948</c:v>
                </c:pt>
                <c:pt idx="2934">
                  <c:v>3.6845122349313066</c:v>
                </c:pt>
                <c:pt idx="2935">
                  <c:v>3.6844284143318151</c:v>
                </c:pt>
                <c:pt idx="2936">
                  <c:v>3.6844044626173855</c:v>
                </c:pt>
                <c:pt idx="2937">
                  <c:v>3.6843695306658093</c:v>
                </c:pt>
                <c:pt idx="2938">
                  <c:v>3.6840215548754651</c:v>
                </c:pt>
                <c:pt idx="2939">
                  <c:v>3.683600815948215</c:v>
                </c:pt>
                <c:pt idx="2940">
                  <c:v>3.6831281229995771</c:v>
                </c:pt>
                <c:pt idx="2941">
                  <c:v>3.6830195060193374</c:v>
                </c:pt>
                <c:pt idx="2942">
                  <c:v>3.6828247282953468</c:v>
                </c:pt>
                <c:pt idx="2943">
                  <c:v>3.6825546990201334</c:v>
                </c:pt>
                <c:pt idx="2944">
                  <c:v>3.682438419500083</c:v>
                </c:pt>
                <c:pt idx="2945">
                  <c:v>3.6824354118580827</c:v>
                </c:pt>
                <c:pt idx="2946">
                  <c:v>3.6821515972630428</c:v>
                </c:pt>
                <c:pt idx="2947">
                  <c:v>3.6821470828117095</c:v>
                </c:pt>
                <c:pt idx="2948">
                  <c:v>3.6817978230276243</c:v>
                </c:pt>
                <c:pt idx="2949">
                  <c:v>3.6817295440466982</c:v>
                </c:pt>
                <c:pt idx="2950">
                  <c:v>3.6811919743279469</c:v>
                </c:pt>
                <c:pt idx="2951">
                  <c:v>3.6807594260978806</c:v>
                </c:pt>
                <c:pt idx="2952">
                  <c:v>3.6806643083098254</c:v>
                </c:pt>
                <c:pt idx="2953">
                  <c:v>3.6805596043314108</c:v>
                </c:pt>
                <c:pt idx="2954">
                  <c:v>3.68047350666899</c:v>
                </c:pt>
                <c:pt idx="2955">
                  <c:v>3.6802166227540818</c:v>
                </c:pt>
                <c:pt idx="2956">
                  <c:v>3.6800382257154216</c:v>
                </c:pt>
                <c:pt idx="2957">
                  <c:v>3.6799605950844523</c:v>
                </c:pt>
                <c:pt idx="2958">
                  <c:v>3.6798723616110962</c:v>
                </c:pt>
                <c:pt idx="2959">
                  <c:v>3.6798723616110962</c:v>
                </c:pt>
                <c:pt idx="2960">
                  <c:v>3.6792294810809607</c:v>
                </c:pt>
                <c:pt idx="2961">
                  <c:v>3.6787540258230531</c:v>
                </c:pt>
                <c:pt idx="2962">
                  <c:v>3.6786367240937161</c:v>
                </c:pt>
                <c:pt idx="2963">
                  <c:v>3.6783564874276329</c:v>
                </c:pt>
                <c:pt idx="2964">
                  <c:v>3.678276025084835</c:v>
                </c:pt>
                <c:pt idx="2965">
                  <c:v>3.6779874526026908</c:v>
                </c:pt>
                <c:pt idx="2966">
                  <c:v>3.6775486576487606</c:v>
                </c:pt>
                <c:pt idx="2967">
                  <c:v>3.6775339559169087</c:v>
                </c:pt>
                <c:pt idx="2968">
                  <c:v>3.6773072834846765</c:v>
                </c:pt>
                <c:pt idx="2969">
                  <c:v>3.676557966658847</c:v>
                </c:pt>
                <c:pt idx="2970">
                  <c:v>3.676350101799466</c:v>
                </c:pt>
                <c:pt idx="2971">
                  <c:v>3.6759915680227171</c:v>
                </c:pt>
                <c:pt idx="2972">
                  <c:v>3.6757503447607847</c:v>
                </c:pt>
                <c:pt idx="2973">
                  <c:v>3.6755670476550346</c:v>
                </c:pt>
                <c:pt idx="2974">
                  <c:v>3.6755583900452238</c:v>
                </c:pt>
                <c:pt idx="2975">
                  <c:v>3.6755578807686837</c:v>
                </c:pt>
                <c:pt idx="2976">
                  <c:v>3.6753602363888049</c:v>
                </c:pt>
                <c:pt idx="2977">
                  <c:v>3.6752277439292409</c:v>
                </c:pt>
                <c:pt idx="2978">
                  <c:v>3.6747815587002672</c:v>
                </c:pt>
                <c:pt idx="2979">
                  <c:v>3.6747136983935618</c:v>
                </c:pt>
                <c:pt idx="2980">
                  <c:v>3.6746167367008269</c:v>
                </c:pt>
                <c:pt idx="2981">
                  <c:v>3.6742572792873611</c:v>
                </c:pt>
                <c:pt idx="2982">
                  <c:v>3.674036555758541</c:v>
                </c:pt>
                <c:pt idx="2983">
                  <c:v>3.6729753135480525</c:v>
                </c:pt>
                <c:pt idx="2984">
                  <c:v>3.6725319354150363</c:v>
                </c:pt>
                <c:pt idx="2985">
                  <c:v>3.6723878041314495</c:v>
                </c:pt>
                <c:pt idx="2986">
                  <c:v>3.6722585069106835</c:v>
                </c:pt>
                <c:pt idx="2987">
                  <c:v>3.672053707552807</c:v>
                </c:pt>
                <c:pt idx="2988">
                  <c:v>3.6720152006476452</c:v>
                </c:pt>
                <c:pt idx="2989">
                  <c:v>3.6719787442978746</c:v>
                </c:pt>
                <c:pt idx="2990">
                  <c:v>3.6719700148586041</c:v>
                </c:pt>
                <c:pt idx="2991">
                  <c:v>3.6717034257288668</c:v>
                </c:pt>
                <c:pt idx="2992">
                  <c:v>3.6716222350706773</c:v>
                </c:pt>
                <c:pt idx="2993">
                  <c:v>3.6715096735464132</c:v>
                </c:pt>
                <c:pt idx="2994">
                  <c:v>3.6714392435097696</c:v>
                </c:pt>
                <c:pt idx="2995">
                  <c:v>3.6712664616166379</c:v>
                </c:pt>
                <c:pt idx="2996">
                  <c:v>3.6712186259081334</c:v>
                </c:pt>
                <c:pt idx="2997">
                  <c:v>3.671026715749846</c:v>
                </c:pt>
                <c:pt idx="2998">
                  <c:v>3.6703551347061234</c:v>
                </c:pt>
                <c:pt idx="2999">
                  <c:v>3.6696794162477393</c:v>
                </c:pt>
                <c:pt idx="3000">
                  <c:v>3.6694439574312749</c:v>
                </c:pt>
                <c:pt idx="3001">
                  <c:v>3.6694269126940191</c:v>
                </c:pt>
                <c:pt idx="3002">
                  <c:v>3.669025393180398</c:v>
                </c:pt>
                <c:pt idx="3003">
                  <c:v>3.6687895794127114</c:v>
                </c:pt>
                <c:pt idx="3004">
                  <c:v>3.6687823374900352</c:v>
                </c:pt>
                <c:pt idx="3005">
                  <c:v>3.6686648980303964</c:v>
                </c:pt>
                <c:pt idx="3006">
                  <c:v>3.6682844244808002</c:v>
                </c:pt>
                <c:pt idx="3007">
                  <c:v>3.6680108988300799</c:v>
                </c:pt>
                <c:pt idx="3008">
                  <c:v>3.667508987272575</c:v>
                </c:pt>
                <c:pt idx="3009">
                  <c:v>3.6672126494484987</c:v>
                </c:pt>
                <c:pt idx="3010">
                  <c:v>3.6670168829439254</c:v>
                </c:pt>
                <c:pt idx="3011">
                  <c:v>3.6668657136812994</c:v>
                </c:pt>
                <c:pt idx="3012">
                  <c:v>3.6668101158733775</c:v>
                </c:pt>
                <c:pt idx="3013">
                  <c:v>3.6667326827683291</c:v>
                </c:pt>
                <c:pt idx="3014">
                  <c:v>3.6665850539050315</c:v>
                </c:pt>
                <c:pt idx="3015">
                  <c:v>3.666516940576428</c:v>
                </c:pt>
                <c:pt idx="3016">
                  <c:v>3.6663406282333315</c:v>
                </c:pt>
                <c:pt idx="3017">
                  <c:v>3.6661460294700454</c:v>
                </c:pt>
                <c:pt idx="3018">
                  <c:v>3.6657529238377089</c:v>
                </c:pt>
                <c:pt idx="3019">
                  <c:v>3.6657044769308689</c:v>
                </c:pt>
                <c:pt idx="3020">
                  <c:v>3.6655747376326602</c:v>
                </c:pt>
                <c:pt idx="3021">
                  <c:v>3.6654089901047637</c:v>
                </c:pt>
                <c:pt idx="3022">
                  <c:v>3.6653797953090681</c:v>
                </c:pt>
                <c:pt idx="3023">
                  <c:v>3.665171203959618</c:v>
                </c:pt>
                <c:pt idx="3024">
                  <c:v>3.6651315602746601</c:v>
                </c:pt>
                <c:pt idx="3025">
                  <c:v>3.6645641548783749</c:v>
                </c:pt>
                <c:pt idx="3026">
                  <c:v>3.6645526633954031</c:v>
                </c:pt>
                <c:pt idx="3027">
                  <c:v>3.664314407800529</c:v>
                </c:pt>
                <c:pt idx="3028">
                  <c:v>3.6639954841801821</c:v>
                </c:pt>
                <c:pt idx="3029">
                  <c:v>3.6639222555396773</c:v>
                </c:pt>
                <c:pt idx="3030">
                  <c:v>3.6637333732710728</c:v>
                </c:pt>
                <c:pt idx="3031">
                  <c:v>3.663675802784105</c:v>
                </c:pt>
                <c:pt idx="3032">
                  <c:v>3.6635292252802993</c:v>
                </c:pt>
                <c:pt idx="3033">
                  <c:v>3.6634611546192573</c:v>
                </c:pt>
                <c:pt idx="3034">
                  <c:v>3.6633768369320063</c:v>
                </c:pt>
                <c:pt idx="3035">
                  <c:v>3.6632862164470774</c:v>
                </c:pt>
                <c:pt idx="3036">
                  <c:v>3.6623647957140419</c:v>
                </c:pt>
                <c:pt idx="3037">
                  <c:v>3.6620938188618406</c:v>
                </c:pt>
                <c:pt idx="3038">
                  <c:v>3.6620397082721241</c:v>
                </c:pt>
                <c:pt idx="3039">
                  <c:v>3.6617963899895467</c:v>
                </c:pt>
                <c:pt idx="3040">
                  <c:v>3.6617122742134964</c:v>
                </c:pt>
                <c:pt idx="3041">
                  <c:v>3.6613119753816044</c:v>
                </c:pt>
                <c:pt idx="3042">
                  <c:v>3.6612809249695704</c:v>
                </c:pt>
                <c:pt idx="3043">
                  <c:v>3.6609228954824524</c:v>
                </c:pt>
                <c:pt idx="3044">
                  <c:v>3.6608818085179613</c:v>
                </c:pt>
                <c:pt idx="3045">
                  <c:v>3.6608638975989489</c:v>
                </c:pt>
                <c:pt idx="3046">
                  <c:v>3.660577222389807</c:v>
                </c:pt>
                <c:pt idx="3047">
                  <c:v>3.6599452365371623</c:v>
                </c:pt>
                <c:pt idx="3048">
                  <c:v>3.6596003691130301</c:v>
                </c:pt>
                <c:pt idx="3049">
                  <c:v>3.6593884540816042</c:v>
                </c:pt>
                <c:pt idx="3050">
                  <c:v>3.6592467674135061</c:v>
                </c:pt>
                <c:pt idx="3051">
                  <c:v>3.6588727675539712</c:v>
                </c:pt>
                <c:pt idx="3052">
                  <c:v>3.6587483822441969</c:v>
                </c:pt>
                <c:pt idx="3053">
                  <c:v>3.6586011910552392</c:v>
                </c:pt>
                <c:pt idx="3054">
                  <c:v>3.6584216349864831</c:v>
                </c:pt>
                <c:pt idx="3055">
                  <c:v>3.6581402341493239</c:v>
                </c:pt>
                <c:pt idx="3056">
                  <c:v>3.6581216796647906</c:v>
                </c:pt>
                <c:pt idx="3057">
                  <c:v>3.6580829777602446</c:v>
                </c:pt>
                <c:pt idx="3058">
                  <c:v>3.6580135177483033</c:v>
                </c:pt>
                <c:pt idx="3059">
                  <c:v>3.6578496329361365</c:v>
                </c:pt>
                <c:pt idx="3060">
                  <c:v>3.6577615657147384</c:v>
                </c:pt>
                <c:pt idx="3061">
                  <c:v>3.6575519363363234</c:v>
                </c:pt>
                <c:pt idx="3062">
                  <c:v>3.6570516012995151</c:v>
                </c:pt>
                <c:pt idx="3063">
                  <c:v>3.6568650232249076</c:v>
                </c:pt>
                <c:pt idx="3064">
                  <c:v>3.6567602704866213</c:v>
                </c:pt>
                <c:pt idx="3065">
                  <c:v>3.6558403396899246</c:v>
                </c:pt>
                <c:pt idx="3066">
                  <c:v>3.6558227525912641</c:v>
                </c:pt>
                <c:pt idx="3067">
                  <c:v>3.655165657432335</c:v>
                </c:pt>
                <c:pt idx="3068">
                  <c:v>3.6551571171859241</c:v>
                </c:pt>
                <c:pt idx="3069">
                  <c:v>3.6550177806970061</c:v>
                </c:pt>
                <c:pt idx="3070">
                  <c:v>3.6541642372283079</c:v>
                </c:pt>
                <c:pt idx="3071">
                  <c:v>3.6538136757933795</c:v>
                </c:pt>
                <c:pt idx="3072">
                  <c:v>3.6537006865555544</c:v>
                </c:pt>
                <c:pt idx="3073">
                  <c:v>3.6528450846613683</c:v>
                </c:pt>
                <c:pt idx="3074">
                  <c:v>3.6528343521320519</c:v>
                </c:pt>
                <c:pt idx="3075">
                  <c:v>3.6526072969887573</c:v>
                </c:pt>
                <c:pt idx="3076">
                  <c:v>3.6525568241654089</c:v>
                </c:pt>
                <c:pt idx="3077">
                  <c:v>3.6521162803713727</c:v>
                </c:pt>
                <c:pt idx="3078">
                  <c:v>3.6518732528437483</c:v>
                </c:pt>
                <c:pt idx="3079">
                  <c:v>3.6518006408055643</c:v>
                </c:pt>
                <c:pt idx="3080">
                  <c:v>3.6516150215328107</c:v>
                </c:pt>
                <c:pt idx="3081">
                  <c:v>3.6511498178885451</c:v>
                </c:pt>
                <c:pt idx="3082">
                  <c:v>3.651056609565432</c:v>
                </c:pt>
                <c:pt idx="3083">
                  <c:v>3.6507617671666877</c:v>
                </c:pt>
                <c:pt idx="3084">
                  <c:v>3.6504807529693095</c:v>
                </c:pt>
                <c:pt idx="3085">
                  <c:v>3.6502044158821532</c:v>
                </c:pt>
                <c:pt idx="3086">
                  <c:v>3.6498544244763891</c:v>
                </c:pt>
                <c:pt idx="3087">
                  <c:v>3.6492055465114075</c:v>
                </c:pt>
                <c:pt idx="3088">
                  <c:v>3.649130322121946</c:v>
                </c:pt>
                <c:pt idx="3089">
                  <c:v>3.649058873947145</c:v>
                </c:pt>
                <c:pt idx="3090">
                  <c:v>3.6489061952737836</c:v>
                </c:pt>
                <c:pt idx="3091">
                  <c:v>3.6488888666427965</c:v>
                </c:pt>
                <c:pt idx="3092">
                  <c:v>3.6488390429769169</c:v>
                </c:pt>
                <c:pt idx="3093">
                  <c:v>3.648828752594623</c:v>
                </c:pt>
                <c:pt idx="3094">
                  <c:v>3.6485670783284556</c:v>
                </c:pt>
                <c:pt idx="3095">
                  <c:v>3.6484088053725232</c:v>
                </c:pt>
                <c:pt idx="3096">
                  <c:v>3.64812572155865</c:v>
                </c:pt>
                <c:pt idx="3097">
                  <c:v>3.6471758809614365</c:v>
                </c:pt>
                <c:pt idx="3098">
                  <c:v>3.6469164725811583</c:v>
                </c:pt>
                <c:pt idx="3099">
                  <c:v>3.6468141893772223</c:v>
                </c:pt>
                <c:pt idx="3100">
                  <c:v>3.6467445359624411</c:v>
                </c:pt>
                <c:pt idx="3101">
                  <c:v>3.6464429384014991</c:v>
                </c:pt>
                <c:pt idx="3102">
                  <c:v>3.6456891179713193</c:v>
                </c:pt>
                <c:pt idx="3103">
                  <c:v>3.6455538041919655</c:v>
                </c:pt>
                <c:pt idx="3104">
                  <c:v>3.6445890181649556</c:v>
                </c:pt>
                <c:pt idx="3105">
                  <c:v>3.6445376047622209</c:v>
                </c:pt>
                <c:pt idx="3106">
                  <c:v>3.644424911547679</c:v>
                </c:pt>
                <c:pt idx="3107">
                  <c:v>3.6440773478650277</c:v>
                </c:pt>
                <c:pt idx="3108">
                  <c:v>3.6437634806134334</c:v>
                </c:pt>
                <c:pt idx="3109">
                  <c:v>3.6437596448811882</c:v>
                </c:pt>
                <c:pt idx="3110">
                  <c:v>3.6436977205155063</c:v>
                </c:pt>
                <c:pt idx="3111">
                  <c:v>3.6435354696883078</c:v>
                </c:pt>
                <c:pt idx="3112">
                  <c:v>3.6431037847527068</c:v>
                </c:pt>
                <c:pt idx="3113">
                  <c:v>3.6430664652718487</c:v>
                </c:pt>
                <c:pt idx="3114">
                  <c:v>3.642907821691364</c:v>
                </c:pt>
                <c:pt idx="3115">
                  <c:v>3.6426573872599546</c:v>
                </c:pt>
                <c:pt idx="3116">
                  <c:v>3.6422864130952388</c:v>
                </c:pt>
                <c:pt idx="3117">
                  <c:v>3.6419745497203708</c:v>
                </c:pt>
                <c:pt idx="3118">
                  <c:v>3.6414283870901563</c:v>
                </c:pt>
                <c:pt idx="3119">
                  <c:v>3.6409846751285877</c:v>
                </c:pt>
                <c:pt idx="3120">
                  <c:v>3.6405714225628167</c:v>
                </c:pt>
                <c:pt idx="3121">
                  <c:v>3.6399096205851107</c:v>
                </c:pt>
                <c:pt idx="3122">
                  <c:v>3.639784106981689</c:v>
                </c:pt>
                <c:pt idx="3123">
                  <c:v>3.6397691756367321</c:v>
                </c:pt>
                <c:pt idx="3124">
                  <c:v>3.6395451438384887</c:v>
                </c:pt>
                <c:pt idx="3125">
                  <c:v>3.6392811358679187</c:v>
                </c:pt>
                <c:pt idx="3126">
                  <c:v>3.639150456203216</c:v>
                </c:pt>
                <c:pt idx="3127">
                  <c:v>3.6391410413191005</c:v>
                </c:pt>
                <c:pt idx="3128">
                  <c:v>3.6390125354387637</c:v>
                </c:pt>
                <c:pt idx="3129">
                  <c:v>3.6386850058754838</c:v>
                </c:pt>
                <c:pt idx="3130">
                  <c:v>3.6384249122650014</c:v>
                </c:pt>
                <c:pt idx="3131">
                  <c:v>3.6375186370412762</c:v>
                </c:pt>
                <c:pt idx="3132">
                  <c:v>3.6367948141281166</c:v>
                </c:pt>
                <c:pt idx="3133">
                  <c:v>3.6366199365717873</c:v>
                </c:pt>
                <c:pt idx="3134">
                  <c:v>3.6358778733563186</c:v>
                </c:pt>
                <c:pt idx="3135">
                  <c:v>3.6358142567361553</c:v>
                </c:pt>
                <c:pt idx="3136">
                  <c:v>3.6356624320599358</c:v>
                </c:pt>
                <c:pt idx="3137">
                  <c:v>3.6355245158595779</c:v>
                </c:pt>
                <c:pt idx="3138">
                  <c:v>3.6354100177281468</c:v>
                </c:pt>
                <c:pt idx="3139">
                  <c:v>3.6352831967628183</c:v>
                </c:pt>
                <c:pt idx="3140">
                  <c:v>3.635251346032832</c:v>
                </c:pt>
                <c:pt idx="3141">
                  <c:v>3.6351742240641913</c:v>
                </c:pt>
                <c:pt idx="3142">
                  <c:v>3.6346127211479744</c:v>
                </c:pt>
                <c:pt idx="3143">
                  <c:v>3.6345886564966841</c:v>
                </c:pt>
                <c:pt idx="3144">
                  <c:v>3.6343294572506601</c:v>
                </c:pt>
                <c:pt idx="3145">
                  <c:v>3.6339944524546355</c:v>
                </c:pt>
                <c:pt idx="3146">
                  <c:v>3.633987727304838</c:v>
                </c:pt>
                <c:pt idx="3147">
                  <c:v>3.6335172688826702</c:v>
                </c:pt>
                <c:pt idx="3148">
                  <c:v>3.6335099752894782</c:v>
                </c:pt>
                <c:pt idx="3149">
                  <c:v>3.6332664111554247</c:v>
                </c:pt>
                <c:pt idx="3150">
                  <c:v>3.6331215548090121</c:v>
                </c:pt>
                <c:pt idx="3151">
                  <c:v>3.632922719766198</c:v>
                </c:pt>
                <c:pt idx="3152">
                  <c:v>3.6325118427145084</c:v>
                </c:pt>
                <c:pt idx="3153">
                  <c:v>3.6322046957903158</c:v>
                </c:pt>
                <c:pt idx="3154">
                  <c:v>3.6317469477328985</c:v>
                </c:pt>
                <c:pt idx="3155">
                  <c:v>3.6316494802625949</c:v>
                </c:pt>
                <c:pt idx="3156">
                  <c:v>3.6316066552666477</c:v>
                </c:pt>
                <c:pt idx="3157">
                  <c:v>3.6315942577691165</c:v>
                </c:pt>
                <c:pt idx="3158">
                  <c:v>3.6315773515203054</c:v>
                </c:pt>
                <c:pt idx="3159">
                  <c:v>3.6315097199430149</c:v>
                </c:pt>
                <c:pt idx="3160">
                  <c:v>3.6312983033557882</c:v>
                </c:pt>
                <c:pt idx="3161">
                  <c:v>3.6305414344559854</c:v>
                </c:pt>
                <c:pt idx="3162">
                  <c:v>3.6301441291781877</c:v>
                </c:pt>
                <c:pt idx="3163">
                  <c:v>3.6299394005351697</c:v>
                </c:pt>
                <c:pt idx="3164">
                  <c:v>3.6297391029042139</c:v>
                </c:pt>
                <c:pt idx="3165">
                  <c:v>3.6295647574655403</c:v>
                </c:pt>
                <c:pt idx="3166">
                  <c:v>3.6294237581860003</c:v>
                </c:pt>
                <c:pt idx="3167">
                  <c:v>3.6292623172651917</c:v>
                </c:pt>
                <c:pt idx="3168">
                  <c:v>3.6288785835040636</c:v>
                </c:pt>
                <c:pt idx="3169">
                  <c:v>3.6280686262273383</c:v>
                </c:pt>
                <c:pt idx="3170">
                  <c:v>3.6278634850005078</c:v>
                </c:pt>
                <c:pt idx="3171">
                  <c:v>3.6278123266645568</c:v>
                </c:pt>
                <c:pt idx="3172">
                  <c:v>3.6277026001331936</c:v>
                </c:pt>
                <c:pt idx="3173">
                  <c:v>3.6277008943206108</c:v>
                </c:pt>
                <c:pt idx="3174">
                  <c:v>3.62735276838047</c:v>
                </c:pt>
                <c:pt idx="3175">
                  <c:v>3.6269337371898596</c:v>
                </c:pt>
                <c:pt idx="3176">
                  <c:v>3.6267764961999713</c:v>
                </c:pt>
                <c:pt idx="3177">
                  <c:v>3.626558771585271</c:v>
                </c:pt>
                <c:pt idx="3178">
                  <c:v>3.626498906684664</c:v>
                </c:pt>
                <c:pt idx="3179">
                  <c:v>3.6264224956812448</c:v>
                </c:pt>
                <c:pt idx="3180">
                  <c:v>3.625891809749263</c:v>
                </c:pt>
                <c:pt idx="3181">
                  <c:v>3.6258341370595577</c:v>
                </c:pt>
                <c:pt idx="3182">
                  <c:v>3.6251906530460212</c:v>
                </c:pt>
                <c:pt idx="3183">
                  <c:v>3.6244104510598296</c:v>
                </c:pt>
                <c:pt idx="3184">
                  <c:v>3.6239507181755171</c:v>
                </c:pt>
                <c:pt idx="3185">
                  <c:v>3.6237419006831013</c:v>
                </c:pt>
                <c:pt idx="3186">
                  <c:v>3.6234238922296447</c:v>
                </c:pt>
                <c:pt idx="3187">
                  <c:v>3.623074618341775</c:v>
                </c:pt>
                <c:pt idx="3188">
                  <c:v>3.6229556402440357</c:v>
                </c:pt>
                <c:pt idx="3189">
                  <c:v>3.6228964264352093</c:v>
                </c:pt>
                <c:pt idx="3190">
                  <c:v>3.6215484241754119</c:v>
                </c:pt>
                <c:pt idx="3191">
                  <c:v>3.6213586425476239</c:v>
                </c:pt>
                <c:pt idx="3192">
                  <c:v>3.6211341432380064</c:v>
                </c:pt>
                <c:pt idx="3193">
                  <c:v>3.6207096436876811</c:v>
                </c:pt>
                <c:pt idx="3194">
                  <c:v>3.6206252719092462</c:v>
                </c:pt>
                <c:pt idx="3195">
                  <c:v>3.6206102450784701</c:v>
                </c:pt>
                <c:pt idx="3196">
                  <c:v>3.6204564791629239</c:v>
                </c:pt>
                <c:pt idx="3197">
                  <c:v>3.6200978659302425</c:v>
                </c:pt>
                <c:pt idx="3198">
                  <c:v>3.6199832786469788</c:v>
                </c:pt>
                <c:pt idx="3199">
                  <c:v>3.6199300257815734</c:v>
                </c:pt>
                <c:pt idx="3200">
                  <c:v>3.6198310275608945</c:v>
                </c:pt>
                <c:pt idx="3201">
                  <c:v>3.6196978364600323</c:v>
                </c:pt>
                <c:pt idx="3202">
                  <c:v>3.6191455263460415</c:v>
                </c:pt>
                <c:pt idx="3203">
                  <c:v>3.6189610733885424</c:v>
                </c:pt>
                <c:pt idx="3204">
                  <c:v>3.6188943494098926</c:v>
                </c:pt>
                <c:pt idx="3205">
                  <c:v>3.6187057262022688</c:v>
                </c:pt>
                <c:pt idx="3206">
                  <c:v>3.6182067857801261</c:v>
                </c:pt>
                <c:pt idx="3207">
                  <c:v>3.617647337701726</c:v>
                </c:pt>
                <c:pt idx="3208">
                  <c:v>3.6175932156218611</c:v>
                </c:pt>
                <c:pt idx="3209">
                  <c:v>3.6175769194810008</c:v>
                </c:pt>
                <c:pt idx="3210">
                  <c:v>3.6174418707852771</c:v>
                </c:pt>
                <c:pt idx="3211">
                  <c:v>3.6174360487766259</c:v>
                </c:pt>
                <c:pt idx="3212">
                  <c:v>3.6174139244319283</c:v>
                </c:pt>
                <c:pt idx="3213">
                  <c:v>3.6174051908276992</c:v>
                </c:pt>
                <c:pt idx="3214">
                  <c:v>3.6164626768338697</c:v>
                </c:pt>
                <c:pt idx="3215">
                  <c:v>3.6162694916960305</c:v>
                </c:pt>
                <c:pt idx="3216">
                  <c:v>3.6158933805327074</c:v>
                </c:pt>
                <c:pt idx="3217">
                  <c:v>3.6156414843200166</c:v>
                </c:pt>
                <c:pt idx="3218">
                  <c:v>3.6152127496088418</c:v>
                </c:pt>
                <c:pt idx="3219">
                  <c:v>3.6150658413436991</c:v>
                </c:pt>
                <c:pt idx="3220">
                  <c:v>3.6150266183824482</c:v>
                </c:pt>
                <c:pt idx="3221">
                  <c:v>3.6147378986550791</c:v>
                </c:pt>
                <c:pt idx="3222">
                  <c:v>3.6143727711873876</c:v>
                </c:pt>
                <c:pt idx="3223">
                  <c:v>3.6138013140134113</c:v>
                </c:pt>
                <c:pt idx="3224">
                  <c:v>3.6137913332352238</c:v>
                </c:pt>
                <c:pt idx="3225">
                  <c:v>3.6134982658131993</c:v>
                </c:pt>
                <c:pt idx="3226">
                  <c:v>3.6132202857407707</c:v>
                </c:pt>
                <c:pt idx="3227">
                  <c:v>3.613120333987454</c:v>
                </c:pt>
                <c:pt idx="3228">
                  <c:v>3.6122385867969102</c:v>
                </c:pt>
                <c:pt idx="3229">
                  <c:v>3.6120405656809909</c:v>
                </c:pt>
                <c:pt idx="3230">
                  <c:v>3.6113036766848858</c:v>
                </c:pt>
                <c:pt idx="3231">
                  <c:v>3.6111448074361974</c:v>
                </c:pt>
                <c:pt idx="3232">
                  <c:v>3.6108718182387456</c:v>
                </c:pt>
                <c:pt idx="3233">
                  <c:v>3.6108209831183435</c:v>
                </c:pt>
                <c:pt idx="3234">
                  <c:v>3.6100707691784777</c:v>
                </c:pt>
                <c:pt idx="3235">
                  <c:v>3.609982527974454</c:v>
                </c:pt>
                <c:pt idx="3236">
                  <c:v>3.609469900741443</c:v>
                </c:pt>
                <c:pt idx="3237">
                  <c:v>3.6092664600881177</c:v>
                </c:pt>
                <c:pt idx="3238">
                  <c:v>3.6090391819022392</c:v>
                </c:pt>
                <c:pt idx="3239">
                  <c:v>3.6084838381664435</c:v>
                </c:pt>
                <c:pt idx="3240">
                  <c:v>3.6074472785252238</c:v>
                </c:pt>
                <c:pt idx="3241">
                  <c:v>3.6070711970739717</c:v>
                </c:pt>
                <c:pt idx="3242">
                  <c:v>3.6062905789977968</c:v>
                </c:pt>
                <c:pt idx="3243">
                  <c:v>3.6062559319253489</c:v>
                </c:pt>
                <c:pt idx="3244">
                  <c:v>3.6055504423860607</c:v>
                </c:pt>
                <c:pt idx="3245">
                  <c:v>3.6051331862295708</c:v>
                </c:pt>
                <c:pt idx="3246">
                  <c:v>3.605084070903708</c:v>
                </c:pt>
                <c:pt idx="3247">
                  <c:v>3.604828222018801</c:v>
                </c:pt>
                <c:pt idx="3248">
                  <c:v>3.6046693640941103</c:v>
                </c:pt>
                <c:pt idx="3249">
                  <c:v>3.6043154715703118</c:v>
                </c:pt>
                <c:pt idx="3250">
                  <c:v>3.6038615873833546</c:v>
                </c:pt>
                <c:pt idx="3251">
                  <c:v>3.6037672688520113</c:v>
                </c:pt>
                <c:pt idx="3252">
                  <c:v>3.6037173979107719</c:v>
                </c:pt>
                <c:pt idx="3253">
                  <c:v>3.6036885542707089</c:v>
                </c:pt>
                <c:pt idx="3254">
                  <c:v>3.6034673560317714</c:v>
                </c:pt>
                <c:pt idx="3255">
                  <c:v>3.6034463122874594</c:v>
                </c:pt>
                <c:pt idx="3256">
                  <c:v>3.6029848974616119</c:v>
                </c:pt>
                <c:pt idx="3257">
                  <c:v>3.6029108570132746</c:v>
                </c:pt>
                <c:pt idx="3258">
                  <c:v>3.6022041290469491</c:v>
                </c:pt>
                <c:pt idx="3259">
                  <c:v>3.6021872450933303</c:v>
                </c:pt>
                <c:pt idx="3260">
                  <c:v>3.6019194260626564</c:v>
                </c:pt>
                <c:pt idx="3261">
                  <c:v>3.6012304208912083</c:v>
                </c:pt>
                <c:pt idx="3262">
                  <c:v>3.6008567780477683</c:v>
                </c:pt>
                <c:pt idx="3263">
                  <c:v>3.6008023372152707</c:v>
                </c:pt>
                <c:pt idx="3264">
                  <c:v>3.6006547077291704</c:v>
                </c:pt>
                <c:pt idx="3265">
                  <c:v>3.6004337748131521</c:v>
                </c:pt>
                <c:pt idx="3266">
                  <c:v>3.5997842473178623</c:v>
                </c:pt>
                <c:pt idx="3267">
                  <c:v>3.5997599924072969</c:v>
                </c:pt>
                <c:pt idx="3268">
                  <c:v>3.5997114785219497</c:v>
                </c:pt>
                <c:pt idx="3269">
                  <c:v>3.599564084355205</c:v>
                </c:pt>
                <c:pt idx="3270">
                  <c:v>3.5989764368865171</c:v>
                </c:pt>
                <c:pt idx="3271">
                  <c:v>3.5987753128756643</c:v>
                </c:pt>
                <c:pt idx="3272">
                  <c:v>3.5987072377341041</c:v>
                </c:pt>
                <c:pt idx="3273">
                  <c:v>3.5986810989071634</c:v>
                </c:pt>
                <c:pt idx="3274">
                  <c:v>3.5986427996450985</c:v>
                </c:pt>
                <c:pt idx="3275">
                  <c:v>3.5984840952830535</c:v>
                </c:pt>
                <c:pt idx="3276">
                  <c:v>3.5983959011268496</c:v>
                </c:pt>
                <c:pt idx="3277">
                  <c:v>3.598318640494961</c:v>
                </c:pt>
                <c:pt idx="3278">
                  <c:v>3.5978943746610814</c:v>
                </c:pt>
                <c:pt idx="3279">
                  <c:v>3.5966960375281176</c:v>
                </c:pt>
                <c:pt idx="3280">
                  <c:v>3.5966514553872626</c:v>
                </c:pt>
                <c:pt idx="3281">
                  <c:v>3.59657938142557</c:v>
                </c:pt>
                <c:pt idx="3282">
                  <c:v>3.5965738837680332</c:v>
                </c:pt>
                <c:pt idx="3283">
                  <c:v>3.5965097392873608</c:v>
                </c:pt>
                <c:pt idx="3284">
                  <c:v>3.5961662524378855</c:v>
                </c:pt>
                <c:pt idx="3285">
                  <c:v>3.5961528008064216</c:v>
                </c:pt>
                <c:pt idx="3286">
                  <c:v>3.5960506771073075</c:v>
                </c:pt>
                <c:pt idx="3287">
                  <c:v>3.5954270182348216</c:v>
                </c:pt>
                <c:pt idx="3288">
                  <c:v>3.5950348604632212</c:v>
                </c:pt>
                <c:pt idx="3289">
                  <c:v>3.5945607347806643</c:v>
                </c:pt>
                <c:pt idx="3290">
                  <c:v>3.5945300490535539</c:v>
                </c:pt>
                <c:pt idx="3291">
                  <c:v>3.594282028811806</c:v>
                </c:pt>
                <c:pt idx="3292">
                  <c:v>3.5933211489162167</c:v>
                </c:pt>
                <c:pt idx="3293">
                  <c:v>3.5930878318426447</c:v>
                </c:pt>
                <c:pt idx="3294">
                  <c:v>3.5919378852866215</c:v>
                </c:pt>
                <c:pt idx="3295">
                  <c:v>3.5917334743556708</c:v>
                </c:pt>
                <c:pt idx="3296">
                  <c:v>3.5912136768388265</c:v>
                </c:pt>
                <c:pt idx="3297">
                  <c:v>3.5911988340061232</c:v>
                </c:pt>
                <c:pt idx="3298">
                  <c:v>3.5904820639278192</c:v>
                </c:pt>
                <c:pt idx="3299">
                  <c:v>3.5902465963765851</c:v>
                </c:pt>
                <c:pt idx="3300">
                  <c:v>3.5897163271402341</c:v>
                </c:pt>
                <c:pt idx="3301">
                  <c:v>3.5894425665417509</c:v>
                </c:pt>
                <c:pt idx="3302">
                  <c:v>3.5886233585327649</c:v>
                </c:pt>
                <c:pt idx="3303">
                  <c:v>3.5881826595620274</c:v>
                </c:pt>
                <c:pt idx="3304">
                  <c:v>3.5878568275566716</c:v>
                </c:pt>
                <c:pt idx="3305">
                  <c:v>3.5877053539428463</c:v>
                </c:pt>
                <c:pt idx="3306">
                  <c:v>3.5875563221702707</c:v>
                </c:pt>
                <c:pt idx="3307">
                  <c:v>3.5867085501657439</c:v>
                </c:pt>
                <c:pt idx="3308">
                  <c:v>3.5865754282929663</c:v>
                </c:pt>
                <c:pt idx="3309">
                  <c:v>3.5865210428308676</c:v>
                </c:pt>
                <c:pt idx="3310">
                  <c:v>3.5863465883250218</c:v>
                </c:pt>
                <c:pt idx="3311">
                  <c:v>3.585780848844446</c:v>
                </c:pt>
                <c:pt idx="3312">
                  <c:v>3.5854945693185436</c:v>
                </c:pt>
                <c:pt idx="3313">
                  <c:v>3.5848348445380021</c:v>
                </c:pt>
                <c:pt idx="3314">
                  <c:v>3.5846710122929664</c:v>
                </c:pt>
                <c:pt idx="3315">
                  <c:v>3.5846615947684013</c:v>
                </c:pt>
                <c:pt idx="3316">
                  <c:v>3.584306719213235</c:v>
                </c:pt>
                <c:pt idx="3317">
                  <c:v>3.5839968296557534</c:v>
                </c:pt>
                <c:pt idx="3318">
                  <c:v>3.5835929500452441</c:v>
                </c:pt>
                <c:pt idx="3319">
                  <c:v>3.5834720906231814</c:v>
                </c:pt>
                <c:pt idx="3320">
                  <c:v>3.5832321605697355</c:v>
                </c:pt>
                <c:pt idx="3321">
                  <c:v>3.5830229795308077</c:v>
                </c:pt>
                <c:pt idx="3322">
                  <c:v>3.58240177355747</c:v>
                </c:pt>
                <c:pt idx="3323">
                  <c:v>3.5817164709613283</c:v>
                </c:pt>
                <c:pt idx="3324">
                  <c:v>3.5813876472851613</c:v>
                </c:pt>
                <c:pt idx="3325">
                  <c:v>3.5813016061587906</c:v>
                </c:pt>
                <c:pt idx="3326">
                  <c:v>3.5811927650226862</c:v>
                </c:pt>
                <c:pt idx="3327">
                  <c:v>3.5808122395255313</c:v>
                </c:pt>
                <c:pt idx="3328">
                  <c:v>3.5804694178830458</c:v>
                </c:pt>
                <c:pt idx="3329">
                  <c:v>3.5803032960410923</c:v>
                </c:pt>
                <c:pt idx="3330">
                  <c:v>3.5802849046024017</c:v>
                </c:pt>
                <c:pt idx="3331">
                  <c:v>3.5796051436580782</c:v>
                </c:pt>
                <c:pt idx="3332">
                  <c:v>3.5795568662002308</c:v>
                </c:pt>
                <c:pt idx="3333">
                  <c:v>3.5792473818918031</c:v>
                </c:pt>
                <c:pt idx="3334">
                  <c:v>3.5791412040280495</c:v>
                </c:pt>
                <c:pt idx="3335">
                  <c:v>3.5789332236607425</c:v>
                </c:pt>
                <c:pt idx="3336">
                  <c:v>3.5789141379041811</c:v>
                </c:pt>
                <c:pt idx="3337">
                  <c:v>3.5788689649385379</c:v>
                </c:pt>
                <c:pt idx="3338">
                  <c:v>3.5782194820492794</c:v>
                </c:pt>
                <c:pt idx="3339">
                  <c:v>3.5780690710729055</c:v>
                </c:pt>
                <c:pt idx="3340">
                  <c:v>3.577563282757624</c:v>
                </c:pt>
                <c:pt idx="3341">
                  <c:v>3.5773015468898914</c:v>
                </c:pt>
                <c:pt idx="3342">
                  <c:v>3.5765454577612337</c:v>
                </c:pt>
                <c:pt idx="3343">
                  <c:v>3.5762562237289455</c:v>
                </c:pt>
                <c:pt idx="3344">
                  <c:v>3.5759277223568215</c:v>
                </c:pt>
                <c:pt idx="3345">
                  <c:v>3.575923238163103</c:v>
                </c:pt>
                <c:pt idx="3346">
                  <c:v>3.5755624291690267</c:v>
                </c:pt>
                <c:pt idx="3347">
                  <c:v>3.5755271653212337</c:v>
                </c:pt>
                <c:pt idx="3348">
                  <c:v>3.5751936200818411</c:v>
                </c:pt>
                <c:pt idx="3349">
                  <c:v>3.5749818141959264</c:v>
                </c:pt>
                <c:pt idx="3350">
                  <c:v>3.574080806643118</c:v>
                </c:pt>
                <c:pt idx="3351">
                  <c:v>3.5736778978258563</c:v>
                </c:pt>
                <c:pt idx="3352">
                  <c:v>3.5736431245941276</c:v>
                </c:pt>
                <c:pt idx="3353">
                  <c:v>3.5735123780883415</c:v>
                </c:pt>
                <c:pt idx="3354">
                  <c:v>3.5734131648204612</c:v>
                </c:pt>
                <c:pt idx="3355">
                  <c:v>3.5733822365707755</c:v>
                </c:pt>
                <c:pt idx="3356">
                  <c:v>3.5725824924327054</c:v>
                </c:pt>
                <c:pt idx="3357">
                  <c:v>3.5722440928728143</c:v>
                </c:pt>
                <c:pt idx="3358">
                  <c:v>3.5718330090801733</c:v>
                </c:pt>
                <c:pt idx="3359">
                  <c:v>3.5715386771683288</c:v>
                </c:pt>
                <c:pt idx="3360">
                  <c:v>3.5712350799685759</c:v>
                </c:pt>
                <c:pt idx="3361">
                  <c:v>3.5709876434471517</c:v>
                </c:pt>
                <c:pt idx="3362">
                  <c:v>3.5709656134675649</c:v>
                </c:pt>
                <c:pt idx="3363">
                  <c:v>3.5707251548609902</c:v>
                </c:pt>
                <c:pt idx="3364">
                  <c:v>3.5704722380421687</c:v>
                </c:pt>
                <c:pt idx="3365">
                  <c:v>3.5700114212409786</c:v>
                </c:pt>
                <c:pt idx="3366">
                  <c:v>3.5699770026201647</c:v>
                </c:pt>
                <c:pt idx="3367">
                  <c:v>3.5699256943292186</c:v>
                </c:pt>
                <c:pt idx="3368">
                  <c:v>3.5690850643309395</c:v>
                </c:pt>
                <c:pt idx="3369">
                  <c:v>3.568876768362629</c:v>
                </c:pt>
                <c:pt idx="3370">
                  <c:v>3.5687908171627272</c:v>
                </c:pt>
                <c:pt idx="3371">
                  <c:v>3.5681965072851294</c:v>
                </c:pt>
                <c:pt idx="3372">
                  <c:v>3.5681234657584846</c:v>
                </c:pt>
                <c:pt idx="3373">
                  <c:v>3.5677894051090817</c:v>
                </c:pt>
                <c:pt idx="3374">
                  <c:v>3.5676248902246512</c:v>
                </c:pt>
                <c:pt idx="3375">
                  <c:v>3.5671747672503393</c:v>
                </c:pt>
                <c:pt idx="3376">
                  <c:v>3.5670145965014246</c:v>
                </c:pt>
                <c:pt idx="3377">
                  <c:v>3.5662894938871119</c:v>
                </c:pt>
                <c:pt idx="3378">
                  <c:v>3.5661905819483204</c:v>
                </c:pt>
                <c:pt idx="3379">
                  <c:v>3.565466725953693</c:v>
                </c:pt>
                <c:pt idx="3380">
                  <c:v>3.5654601637703318</c:v>
                </c:pt>
                <c:pt idx="3381">
                  <c:v>3.5654581950959878</c:v>
                </c:pt>
                <c:pt idx="3382">
                  <c:v>3.5652901686711194</c:v>
                </c:pt>
                <c:pt idx="3383">
                  <c:v>3.5652711303277846</c:v>
                </c:pt>
                <c:pt idx="3384">
                  <c:v>3.5651050017838348</c:v>
                </c:pt>
                <c:pt idx="3385">
                  <c:v>3.5650971205903246</c:v>
                </c:pt>
                <c:pt idx="3386">
                  <c:v>3.5636900080404015</c:v>
                </c:pt>
                <c:pt idx="3387">
                  <c:v>3.5634955880038128</c:v>
                </c:pt>
                <c:pt idx="3388">
                  <c:v>3.5633485618513689</c:v>
                </c:pt>
                <c:pt idx="3389">
                  <c:v>3.5630418224554852</c:v>
                </c:pt>
                <c:pt idx="3390">
                  <c:v>3.562801556911122</c:v>
                </c:pt>
                <c:pt idx="3391">
                  <c:v>3.5627989158919062</c:v>
                </c:pt>
                <c:pt idx="3392">
                  <c:v>3.562759298676287</c:v>
                </c:pt>
                <c:pt idx="3393">
                  <c:v>3.5627097720740886</c:v>
                </c:pt>
                <c:pt idx="3394">
                  <c:v>3.5625756917316451</c:v>
                </c:pt>
                <c:pt idx="3395">
                  <c:v>3.5624501603006413</c:v>
                </c:pt>
                <c:pt idx="3396">
                  <c:v>3.5624448739705743</c:v>
                </c:pt>
                <c:pt idx="3397">
                  <c:v>3.562440909180796</c:v>
                </c:pt>
                <c:pt idx="3398">
                  <c:v>3.5622320457501413</c:v>
                </c:pt>
                <c:pt idx="3399">
                  <c:v>3.561852397446954</c:v>
                </c:pt>
                <c:pt idx="3400">
                  <c:v>3.5617438655180567</c:v>
                </c:pt>
                <c:pt idx="3401">
                  <c:v>3.5615624772498271</c:v>
                </c:pt>
                <c:pt idx="3402">
                  <c:v>3.5615008939340136</c:v>
                </c:pt>
                <c:pt idx="3403">
                  <c:v>3.5613651149167405</c:v>
                </c:pt>
                <c:pt idx="3404">
                  <c:v>3.5611544078212609</c:v>
                </c:pt>
                <c:pt idx="3405">
                  <c:v>3.5610238241378394</c:v>
                </c:pt>
                <c:pt idx="3406">
                  <c:v>3.5609164111735629</c:v>
                </c:pt>
                <c:pt idx="3407">
                  <c:v>3.5606902266625524</c:v>
                </c:pt>
                <c:pt idx="3408">
                  <c:v>3.5606066213400185</c:v>
                </c:pt>
                <c:pt idx="3409">
                  <c:v>3.5604167907796249</c:v>
                </c:pt>
                <c:pt idx="3410">
                  <c:v>3.5603723079854701</c:v>
                </c:pt>
                <c:pt idx="3411">
                  <c:v>3.5603623485267248</c:v>
                </c:pt>
                <c:pt idx="3412">
                  <c:v>3.5591921836008442</c:v>
                </c:pt>
                <c:pt idx="3413">
                  <c:v>3.5589817515358453</c:v>
                </c:pt>
                <c:pt idx="3414">
                  <c:v>3.558929127584129</c:v>
                </c:pt>
                <c:pt idx="3415">
                  <c:v>3.5588445162185121</c:v>
                </c:pt>
                <c:pt idx="3416">
                  <c:v>3.5583791923245078</c:v>
                </c:pt>
                <c:pt idx="3417">
                  <c:v>3.5575700223562721</c:v>
                </c:pt>
                <c:pt idx="3418">
                  <c:v>3.5575018550647179</c:v>
                </c:pt>
                <c:pt idx="3419">
                  <c:v>3.5574818038248939</c:v>
                </c:pt>
                <c:pt idx="3420">
                  <c:v>3.557401589606719</c:v>
                </c:pt>
                <c:pt idx="3421">
                  <c:v>3.5567385868559485</c:v>
                </c:pt>
                <c:pt idx="3422">
                  <c:v>3.5562059801575101</c:v>
                </c:pt>
                <c:pt idx="3423">
                  <c:v>3.5561965950650785</c:v>
                </c:pt>
                <c:pt idx="3424">
                  <c:v>3.5556948678621989</c:v>
                </c:pt>
                <c:pt idx="3425">
                  <c:v>3.5556821159029779</c:v>
                </c:pt>
                <c:pt idx="3426">
                  <c:v>3.5555572611555655</c:v>
                </c:pt>
                <c:pt idx="3427">
                  <c:v>3.5552711681878639</c:v>
                </c:pt>
                <c:pt idx="3428">
                  <c:v>3.5545766427195509</c:v>
                </c:pt>
                <c:pt idx="3429">
                  <c:v>3.5536652856665918</c:v>
                </c:pt>
                <c:pt idx="3430">
                  <c:v>3.5532449998896407</c:v>
                </c:pt>
                <c:pt idx="3431">
                  <c:v>3.5528513300157187</c:v>
                </c:pt>
                <c:pt idx="3432">
                  <c:v>3.5528378187129039</c:v>
                </c:pt>
                <c:pt idx="3433">
                  <c:v>3.5527364705409417</c:v>
                </c:pt>
                <c:pt idx="3434">
                  <c:v>3.5525742642558691</c:v>
                </c:pt>
                <c:pt idx="3435">
                  <c:v>3.5525614203366676</c:v>
                </c:pt>
                <c:pt idx="3436">
                  <c:v>3.5523768315462174</c:v>
                </c:pt>
                <c:pt idx="3437">
                  <c:v>3.5522577876416421</c:v>
                </c:pt>
                <c:pt idx="3438">
                  <c:v>3.5520913420313849</c:v>
                </c:pt>
                <c:pt idx="3439">
                  <c:v>3.5514303431274126</c:v>
                </c:pt>
                <c:pt idx="3440">
                  <c:v>3.5514133985811456</c:v>
                </c:pt>
                <c:pt idx="3441">
                  <c:v>3.5510852218027908</c:v>
                </c:pt>
                <c:pt idx="3442">
                  <c:v>3.5507914153189768</c:v>
                </c:pt>
                <c:pt idx="3443">
                  <c:v>3.5497162770310191</c:v>
                </c:pt>
                <c:pt idx="3444">
                  <c:v>3.5495645104070808</c:v>
                </c:pt>
                <c:pt idx="3445">
                  <c:v>3.5495447700427487</c:v>
                </c:pt>
                <c:pt idx="3446">
                  <c:v>3.5492996425094736</c:v>
                </c:pt>
                <c:pt idx="3447">
                  <c:v>3.5490080329684668</c:v>
                </c:pt>
                <c:pt idx="3448">
                  <c:v>3.5490025804582697</c:v>
                </c:pt>
                <c:pt idx="3449">
                  <c:v>3.5488941976148922</c:v>
                </c:pt>
                <c:pt idx="3450">
                  <c:v>3.5486480203777386</c:v>
                </c:pt>
                <c:pt idx="3451">
                  <c:v>3.5484719965337908</c:v>
                </c:pt>
                <c:pt idx="3452">
                  <c:v>3.5482324076219416</c:v>
                </c:pt>
                <c:pt idx="3453">
                  <c:v>3.5482208002440498</c:v>
                </c:pt>
                <c:pt idx="3454">
                  <c:v>3.5481716361450863</c:v>
                </c:pt>
                <c:pt idx="3455">
                  <c:v>3.5474321379344671</c:v>
                </c:pt>
                <c:pt idx="3456">
                  <c:v>3.5473466248765173</c:v>
                </c:pt>
                <c:pt idx="3457">
                  <c:v>3.5472446713093553</c:v>
                </c:pt>
                <c:pt idx="3458">
                  <c:v>3.547166650402108</c:v>
                </c:pt>
                <c:pt idx="3459">
                  <c:v>3.546094840662537</c:v>
                </c:pt>
                <c:pt idx="3460">
                  <c:v>3.5457660519777696</c:v>
                </c:pt>
                <c:pt idx="3461">
                  <c:v>3.5456438081678248</c:v>
                </c:pt>
                <c:pt idx="3462">
                  <c:v>3.5452672458798555</c:v>
                </c:pt>
                <c:pt idx="3463">
                  <c:v>3.5446646169923612</c:v>
                </c:pt>
                <c:pt idx="3464">
                  <c:v>3.5440852779163539</c:v>
                </c:pt>
                <c:pt idx="3465">
                  <c:v>3.5436542334738954</c:v>
                </c:pt>
                <c:pt idx="3466">
                  <c:v>3.54337054530051</c:v>
                </c:pt>
                <c:pt idx="3467">
                  <c:v>3.5432607475903621</c:v>
                </c:pt>
                <c:pt idx="3468">
                  <c:v>3.5432324304708458</c:v>
                </c:pt>
                <c:pt idx="3469">
                  <c:v>3.5430942717037719</c:v>
                </c:pt>
                <c:pt idx="3470">
                  <c:v>3.5428558444823031</c:v>
                </c:pt>
                <c:pt idx="3471">
                  <c:v>3.5425757845320196</c:v>
                </c:pt>
                <c:pt idx="3472">
                  <c:v>3.5421723191351218</c:v>
                </c:pt>
                <c:pt idx="3473">
                  <c:v>3.5411581957995879</c:v>
                </c:pt>
                <c:pt idx="3474">
                  <c:v>3.5407152039190648</c:v>
                </c:pt>
                <c:pt idx="3475">
                  <c:v>3.5404031720519007</c:v>
                </c:pt>
                <c:pt idx="3476">
                  <c:v>3.539832735069508</c:v>
                </c:pt>
                <c:pt idx="3477">
                  <c:v>3.5389624198175182</c:v>
                </c:pt>
                <c:pt idx="3478">
                  <c:v>3.5386889104527222</c:v>
                </c:pt>
                <c:pt idx="3479">
                  <c:v>3.5385925829846934</c:v>
                </c:pt>
                <c:pt idx="3480">
                  <c:v>3.5379736232635288</c:v>
                </c:pt>
                <c:pt idx="3481">
                  <c:v>3.5377848257186471</c:v>
                </c:pt>
                <c:pt idx="3482">
                  <c:v>3.5377841263159056</c:v>
                </c:pt>
                <c:pt idx="3483">
                  <c:v>3.5376470216288625</c:v>
                </c:pt>
                <c:pt idx="3484">
                  <c:v>3.5376043424594461</c:v>
                </c:pt>
                <c:pt idx="3485">
                  <c:v>3.5371598100430526</c:v>
                </c:pt>
                <c:pt idx="3486">
                  <c:v>3.537085560294754</c:v>
                </c:pt>
                <c:pt idx="3487">
                  <c:v>3.5368830601514936</c:v>
                </c:pt>
                <c:pt idx="3488">
                  <c:v>3.5368529223012537</c:v>
                </c:pt>
                <c:pt idx="3489">
                  <c:v>3.5368122679341489</c:v>
                </c:pt>
                <c:pt idx="3490">
                  <c:v>3.5367912383198346</c:v>
                </c:pt>
                <c:pt idx="3491">
                  <c:v>3.535902859108027</c:v>
                </c:pt>
                <c:pt idx="3492">
                  <c:v>3.5354896281289125</c:v>
                </c:pt>
                <c:pt idx="3493">
                  <c:v>3.5353321033218266</c:v>
                </c:pt>
                <c:pt idx="3494">
                  <c:v>3.5352019616143289</c:v>
                </c:pt>
                <c:pt idx="3495">
                  <c:v>3.534965496352525</c:v>
                </c:pt>
                <c:pt idx="3496">
                  <c:v>3.534736649950363</c:v>
                </c:pt>
                <c:pt idx="3497">
                  <c:v>3.5346570535555895</c:v>
                </c:pt>
                <c:pt idx="3498">
                  <c:v>3.534279300135216</c:v>
                </c:pt>
                <c:pt idx="3499">
                  <c:v>3.534178463357085</c:v>
                </c:pt>
                <c:pt idx="3500">
                  <c:v>3.5328527173742588</c:v>
                </c:pt>
                <c:pt idx="3501">
                  <c:v>3.5324032920842074</c:v>
                </c:pt>
                <c:pt idx="3502">
                  <c:v>3.5323537206664999</c:v>
                </c:pt>
                <c:pt idx="3503">
                  <c:v>3.5323360152174099</c:v>
                </c:pt>
                <c:pt idx="3504">
                  <c:v>3.5320108148208096</c:v>
                </c:pt>
                <c:pt idx="3505">
                  <c:v>3.5319406416223185</c:v>
                </c:pt>
                <c:pt idx="3506">
                  <c:v>3.5317924609575062</c:v>
                </c:pt>
                <c:pt idx="3507">
                  <c:v>3.5316243671419074</c:v>
                </c:pt>
                <c:pt idx="3508">
                  <c:v>3.5314107870739764</c:v>
                </c:pt>
                <c:pt idx="3509">
                  <c:v>3.5312411253998164</c:v>
                </c:pt>
                <c:pt idx="3510">
                  <c:v>3.5309122615826891</c:v>
                </c:pt>
                <c:pt idx="3511">
                  <c:v>3.530637188535235</c:v>
                </c:pt>
                <c:pt idx="3512">
                  <c:v>3.5297510799423799</c:v>
                </c:pt>
                <c:pt idx="3513">
                  <c:v>3.5289595279964314</c:v>
                </c:pt>
                <c:pt idx="3514">
                  <c:v>3.5288560204454478</c:v>
                </c:pt>
                <c:pt idx="3515">
                  <c:v>3.5278367607730647</c:v>
                </c:pt>
                <c:pt idx="3516">
                  <c:v>3.5275812136307079</c:v>
                </c:pt>
                <c:pt idx="3517">
                  <c:v>3.5275797815704113</c:v>
                </c:pt>
                <c:pt idx="3518">
                  <c:v>3.52751318555107</c:v>
                </c:pt>
                <c:pt idx="3519">
                  <c:v>3.5273541731121187</c:v>
                </c:pt>
                <c:pt idx="3520">
                  <c:v>3.5273047384647098</c:v>
                </c:pt>
                <c:pt idx="3521">
                  <c:v>3.5271635679893127</c:v>
                </c:pt>
                <c:pt idx="3522">
                  <c:v>3.5271578342084329</c:v>
                </c:pt>
                <c:pt idx="3523">
                  <c:v>3.5269427627609637</c:v>
                </c:pt>
                <c:pt idx="3524">
                  <c:v>3.5268832408458128</c:v>
                </c:pt>
                <c:pt idx="3525">
                  <c:v>3.5268653109593733</c:v>
                </c:pt>
                <c:pt idx="3526">
                  <c:v>3.5268208416464701</c:v>
                </c:pt>
                <c:pt idx="3527">
                  <c:v>3.5255378797974402</c:v>
                </c:pt>
                <c:pt idx="3528">
                  <c:v>3.5245317052602019</c:v>
                </c:pt>
                <c:pt idx="3529">
                  <c:v>3.5243550060810986</c:v>
                </c:pt>
                <c:pt idx="3530">
                  <c:v>3.5243124432906416</c:v>
                </c:pt>
                <c:pt idx="3531">
                  <c:v>3.5242143165590214</c:v>
                </c:pt>
                <c:pt idx="3532">
                  <c:v>3.5239241357915274</c:v>
                </c:pt>
                <c:pt idx="3533">
                  <c:v>3.5229359236229634</c:v>
                </c:pt>
                <c:pt idx="3534">
                  <c:v>3.5228070807783394</c:v>
                </c:pt>
                <c:pt idx="3535">
                  <c:v>3.522698475661814</c:v>
                </c:pt>
                <c:pt idx="3536">
                  <c:v>3.5221151637648305</c:v>
                </c:pt>
                <c:pt idx="3537">
                  <c:v>3.521882344947358</c:v>
                </c:pt>
                <c:pt idx="3538">
                  <c:v>3.5217713312933383</c:v>
                </c:pt>
                <c:pt idx="3539">
                  <c:v>3.5214105223817511</c:v>
                </c:pt>
                <c:pt idx="3540">
                  <c:v>3.5201238371967607</c:v>
                </c:pt>
                <c:pt idx="3541">
                  <c:v>3.5196632251067914</c:v>
                </c:pt>
                <c:pt idx="3542">
                  <c:v>3.5195107948855129</c:v>
                </c:pt>
                <c:pt idx="3543">
                  <c:v>3.5194670251274163</c:v>
                </c:pt>
                <c:pt idx="3544">
                  <c:v>3.5186192106290766</c:v>
                </c:pt>
                <c:pt idx="3545">
                  <c:v>3.5184905429119353</c:v>
                </c:pt>
                <c:pt idx="3546">
                  <c:v>3.51817821896026</c:v>
                </c:pt>
                <c:pt idx="3547">
                  <c:v>3.5180157509756502</c:v>
                </c:pt>
                <c:pt idx="3548">
                  <c:v>3.5177316518987483</c:v>
                </c:pt>
                <c:pt idx="3549">
                  <c:v>3.5176562026181633</c:v>
                </c:pt>
                <c:pt idx="3550">
                  <c:v>3.5175587584246122</c:v>
                </c:pt>
                <c:pt idx="3551">
                  <c:v>3.5173879951998459</c:v>
                </c:pt>
                <c:pt idx="3552">
                  <c:v>3.5170800119595298</c:v>
                </c:pt>
                <c:pt idx="3553">
                  <c:v>3.5169009880118938</c:v>
                </c:pt>
                <c:pt idx="3554">
                  <c:v>3.5164898341196524</c:v>
                </c:pt>
                <c:pt idx="3555">
                  <c:v>3.5164435549390518</c:v>
                </c:pt>
                <c:pt idx="3556">
                  <c:v>3.5163289376434639</c:v>
                </c:pt>
                <c:pt idx="3557">
                  <c:v>3.5161959142711963</c:v>
                </c:pt>
                <c:pt idx="3558">
                  <c:v>3.5160797611045926</c:v>
                </c:pt>
                <c:pt idx="3559">
                  <c:v>3.5158113137513998</c:v>
                </c:pt>
                <c:pt idx="3560">
                  <c:v>3.5157561327794222</c:v>
                </c:pt>
                <c:pt idx="3561">
                  <c:v>3.5156700364606639</c:v>
                </c:pt>
                <c:pt idx="3562">
                  <c:v>3.5152584516359533</c:v>
                </c:pt>
                <c:pt idx="3563">
                  <c:v>3.5149238897392201</c:v>
                </c:pt>
                <c:pt idx="3564">
                  <c:v>3.5143942541604214</c:v>
                </c:pt>
                <c:pt idx="3565">
                  <c:v>3.514293860415135</c:v>
                </c:pt>
                <c:pt idx="3566">
                  <c:v>3.5139319550962771</c:v>
                </c:pt>
                <c:pt idx="3567">
                  <c:v>3.5139134824507727</c:v>
                </c:pt>
                <c:pt idx="3568">
                  <c:v>3.5137922824087515</c:v>
                </c:pt>
                <c:pt idx="3569">
                  <c:v>3.5137582812000492</c:v>
                </c:pt>
                <c:pt idx="3570">
                  <c:v>3.5134743411126528</c:v>
                </c:pt>
                <c:pt idx="3571">
                  <c:v>3.5132250010696673</c:v>
                </c:pt>
                <c:pt idx="3572">
                  <c:v>3.5131768923038189</c:v>
                </c:pt>
                <c:pt idx="3573">
                  <c:v>3.5131258171666162</c:v>
                </c:pt>
                <c:pt idx="3574">
                  <c:v>3.513093984694982</c:v>
                </c:pt>
                <c:pt idx="3575">
                  <c:v>3.5128592407221153</c:v>
                </c:pt>
                <c:pt idx="3576">
                  <c:v>3.5125109639183396</c:v>
                </c:pt>
                <c:pt idx="3577">
                  <c:v>3.5121824386181557</c:v>
                </c:pt>
                <c:pt idx="3578">
                  <c:v>3.5119011778229172</c:v>
                </c:pt>
                <c:pt idx="3579">
                  <c:v>3.5118276786296856</c:v>
                </c:pt>
                <c:pt idx="3580">
                  <c:v>3.5118054036908743</c:v>
                </c:pt>
                <c:pt idx="3581">
                  <c:v>3.5117860978197224</c:v>
                </c:pt>
                <c:pt idx="3582">
                  <c:v>3.5109915855486897</c:v>
                </c:pt>
                <c:pt idx="3583">
                  <c:v>3.5109536444968086</c:v>
                </c:pt>
                <c:pt idx="3584">
                  <c:v>3.5102701381506001</c:v>
                </c:pt>
                <c:pt idx="3585">
                  <c:v>3.5098996423485525</c:v>
                </c:pt>
                <c:pt idx="3586">
                  <c:v>3.509721363754267</c:v>
                </c:pt>
                <c:pt idx="3587">
                  <c:v>3.5095863007060295</c:v>
                </c:pt>
                <c:pt idx="3588">
                  <c:v>3.5091450010209448</c:v>
                </c:pt>
                <c:pt idx="3589">
                  <c:v>3.5089723913649435</c:v>
                </c:pt>
                <c:pt idx="3590">
                  <c:v>3.5089507169067558</c:v>
                </c:pt>
                <c:pt idx="3591">
                  <c:v>3.5088453187781239</c:v>
                </c:pt>
                <c:pt idx="3592">
                  <c:v>3.5087698051012048</c:v>
                </c:pt>
                <c:pt idx="3593">
                  <c:v>3.5087346605961738</c:v>
                </c:pt>
                <c:pt idx="3594">
                  <c:v>3.5085267264064068</c:v>
                </c:pt>
                <c:pt idx="3595">
                  <c:v>3.5083359078236152</c:v>
                </c:pt>
                <c:pt idx="3596">
                  <c:v>3.5082558138717541</c:v>
                </c:pt>
                <c:pt idx="3597">
                  <c:v>3.5081772026408764</c:v>
                </c:pt>
                <c:pt idx="3598">
                  <c:v>3.5075245545954337</c:v>
                </c:pt>
                <c:pt idx="3599">
                  <c:v>3.5073520497345667</c:v>
                </c:pt>
                <c:pt idx="3600">
                  <c:v>3.5072845291760943</c:v>
                </c:pt>
                <c:pt idx="3601">
                  <c:v>3.5072230013043613</c:v>
                </c:pt>
                <c:pt idx="3602">
                  <c:v>3.5068160977089162</c:v>
                </c:pt>
                <c:pt idx="3603">
                  <c:v>3.5063516718683481</c:v>
                </c:pt>
                <c:pt idx="3604">
                  <c:v>3.5057437112613345</c:v>
                </c:pt>
                <c:pt idx="3605">
                  <c:v>3.5054574946787302</c:v>
                </c:pt>
                <c:pt idx="3606">
                  <c:v>3.5053866646236269</c:v>
                </c:pt>
                <c:pt idx="3607">
                  <c:v>3.5052758753105087</c:v>
                </c:pt>
                <c:pt idx="3608">
                  <c:v>3.5052208469840767</c:v>
                </c:pt>
                <c:pt idx="3609">
                  <c:v>3.5052140621870316</c:v>
                </c:pt>
                <c:pt idx="3610">
                  <c:v>3.5046890499050067</c:v>
                </c:pt>
                <c:pt idx="3611">
                  <c:v>3.5045259859255027</c:v>
                </c:pt>
                <c:pt idx="3612">
                  <c:v>3.5040659061608008</c:v>
                </c:pt>
                <c:pt idx="3613">
                  <c:v>3.5039056325964877</c:v>
                </c:pt>
                <c:pt idx="3614">
                  <c:v>3.5038670673925632</c:v>
                </c:pt>
                <c:pt idx="3615">
                  <c:v>3.5038269861987139</c:v>
                </c:pt>
                <c:pt idx="3616">
                  <c:v>3.5032851491055812</c:v>
                </c:pt>
                <c:pt idx="3617">
                  <c:v>3.5025022273149755</c:v>
                </c:pt>
                <c:pt idx="3618">
                  <c:v>3.5023322689385834</c:v>
                </c:pt>
                <c:pt idx="3619">
                  <c:v>3.5016190848049034</c:v>
                </c:pt>
                <c:pt idx="3620">
                  <c:v>3.5012586296189561</c:v>
                </c:pt>
                <c:pt idx="3621">
                  <c:v>3.5004369824180341</c:v>
                </c:pt>
                <c:pt idx="3622">
                  <c:v>3.5002868010215114</c:v>
                </c:pt>
                <c:pt idx="3623">
                  <c:v>3.5000000161520011</c:v>
                </c:pt>
                <c:pt idx="3624">
                  <c:v>3.4998389980318994</c:v>
                </c:pt>
                <c:pt idx="3625">
                  <c:v>3.4997893832630962</c:v>
                </c:pt>
                <c:pt idx="3626">
                  <c:v>3.4991492262897008</c:v>
                </c:pt>
                <c:pt idx="3627">
                  <c:v>3.4989672434132721</c:v>
                </c:pt>
                <c:pt idx="3628">
                  <c:v>3.4988593940466286</c:v>
                </c:pt>
                <c:pt idx="3629">
                  <c:v>3.4985594167001079</c:v>
                </c:pt>
                <c:pt idx="3630">
                  <c:v>3.4982454430343308</c:v>
                </c:pt>
                <c:pt idx="3631">
                  <c:v>3.4980554170225724</c:v>
                </c:pt>
                <c:pt idx="3632">
                  <c:v>3.4980538842167155</c:v>
                </c:pt>
                <c:pt idx="3633">
                  <c:v>3.4976881554238175</c:v>
                </c:pt>
                <c:pt idx="3634">
                  <c:v>3.4972814285506701</c:v>
                </c:pt>
                <c:pt idx="3635">
                  <c:v>3.4968220600354583</c:v>
                </c:pt>
                <c:pt idx="3636">
                  <c:v>3.4966775427311405</c:v>
                </c:pt>
                <c:pt idx="3637">
                  <c:v>3.4964314451842</c:v>
                </c:pt>
                <c:pt idx="3638">
                  <c:v>3.4963306587572713</c:v>
                </c:pt>
                <c:pt idx="3639">
                  <c:v>3.4961775109456168</c:v>
                </c:pt>
                <c:pt idx="3640">
                  <c:v>3.4956730497075119</c:v>
                </c:pt>
                <c:pt idx="3641">
                  <c:v>3.4955643790728801</c:v>
                </c:pt>
                <c:pt idx="3642">
                  <c:v>3.4955427958522605</c:v>
                </c:pt>
                <c:pt idx="3643">
                  <c:v>3.4955343164363986</c:v>
                </c:pt>
                <c:pt idx="3644">
                  <c:v>3.495322277215954</c:v>
                </c:pt>
                <c:pt idx="3645">
                  <c:v>3.4949573274143928</c:v>
                </c:pt>
                <c:pt idx="3646">
                  <c:v>3.4945781647744281</c:v>
                </c:pt>
                <c:pt idx="3647">
                  <c:v>3.4943664310354112</c:v>
                </c:pt>
                <c:pt idx="3648">
                  <c:v>3.4934836106459333</c:v>
                </c:pt>
                <c:pt idx="3649">
                  <c:v>3.493025632615216</c:v>
                </c:pt>
                <c:pt idx="3650">
                  <c:v>3.4929535210076241</c:v>
                </c:pt>
                <c:pt idx="3651">
                  <c:v>3.4927557341842936</c:v>
                </c:pt>
                <c:pt idx="3652">
                  <c:v>3.4924647074774775</c:v>
                </c:pt>
                <c:pt idx="3653">
                  <c:v>3.4924476278529402</c:v>
                </c:pt>
                <c:pt idx="3654">
                  <c:v>3.4918175415517987</c:v>
                </c:pt>
                <c:pt idx="3655">
                  <c:v>3.4916316819115889</c:v>
                </c:pt>
                <c:pt idx="3656">
                  <c:v>3.4915274412781176</c:v>
                </c:pt>
                <c:pt idx="3657">
                  <c:v>3.4914970978850088</c:v>
                </c:pt>
                <c:pt idx="3658">
                  <c:v>3.4911662951974884</c:v>
                </c:pt>
                <c:pt idx="3659">
                  <c:v>3.4910635004702351</c:v>
                </c:pt>
                <c:pt idx="3660">
                  <c:v>3.4909123792004344</c:v>
                </c:pt>
                <c:pt idx="3661">
                  <c:v>3.4908804344679187</c:v>
                </c:pt>
                <c:pt idx="3662">
                  <c:v>3.4906848191331479</c:v>
                </c:pt>
                <c:pt idx="3663">
                  <c:v>3.4905476020252211</c:v>
                </c:pt>
                <c:pt idx="3664">
                  <c:v>3.489234833557656</c:v>
                </c:pt>
                <c:pt idx="3665">
                  <c:v>3.4883736411689465</c:v>
                </c:pt>
                <c:pt idx="3666">
                  <c:v>3.4883556161797329</c:v>
                </c:pt>
                <c:pt idx="3667">
                  <c:v>3.4877595866692439</c:v>
                </c:pt>
                <c:pt idx="3668">
                  <c:v>3.4874015759292583</c:v>
                </c:pt>
                <c:pt idx="3669">
                  <c:v>3.4872224598260755</c:v>
                </c:pt>
                <c:pt idx="3670">
                  <c:v>3.4866752269586869</c:v>
                </c:pt>
                <c:pt idx="3671">
                  <c:v>3.486551689688969</c:v>
                </c:pt>
                <c:pt idx="3672">
                  <c:v>3.486549328762008</c:v>
                </c:pt>
                <c:pt idx="3673">
                  <c:v>3.4865178485093877</c:v>
                </c:pt>
                <c:pt idx="3674">
                  <c:v>3.4863667115249535</c:v>
                </c:pt>
                <c:pt idx="3675">
                  <c:v>3.486021733300297</c:v>
                </c:pt>
                <c:pt idx="3676">
                  <c:v>3.4858751527643372</c:v>
                </c:pt>
                <c:pt idx="3677">
                  <c:v>3.4858609649253087</c:v>
                </c:pt>
                <c:pt idx="3678">
                  <c:v>3.4858522943510577</c:v>
                </c:pt>
                <c:pt idx="3679">
                  <c:v>3.485673326571503</c:v>
                </c:pt>
                <c:pt idx="3680">
                  <c:v>3.4853593635328037</c:v>
                </c:pt>
                <c:pt idx="3681">
                  <c:v>3.4848769329338167</c:v>
                </c:pt>
                <c:pt idx="3682">
                  <c:v>3.4847473512823588</c:v>
                </c:pt>
                <c:pt idx="3683">
                  <c:v>3.4847109982650712</c:v>
                </c:pt>
                <c:pt idx="3684">
                  <c:v>3.4841621722839107</c:v>
                </c:pt>
                <c:pt idx="3685">
                  <c:v>3.4837085116801463</c:v>
                </c:pt>
                <c:pt idx="3686">
                  <c:v>3.4834050150956601</c:v>
                </c:pt>
                <c:pt idx="3687">
                  <c:v>3.4834026370004683</c:v>
                </c:pt>
                <c:pt idx="3688">
                  <c:v>3.4829362787616618</c:v>
                </c:pt>
                <c:pt idx="3689">
                  <c:v>3.4828688215817483</c:v>
                </c:pt>
                <c:pt idx="3690">
                  <c:v>3.4823987113264692</c:v>
                </c:pt>
                <c:pt idx="3691">
                  <c:v>3.482226262973815</c:v>
                </c:pt>
                <c:pt idx="3692">
                  <c:v>3.4822087759070746</c:v>
                </c:pt>
                <c:pt idx="3693">
                  <c:v>3.481698161175057</c:v>
                </c:pt>
                <c:pt idx="3694">
                  <c:v>3.4814251098530415</c:v>
                </c:pt>
                <c:pt idx="3695">
                  <c:v>3.4813454707215246</c:v>
                </c:pt>
                <c:pt idx="3696">
                  <c:v>3.4807158076547666</c:v>
                </c:pt>
                <c:pt idx="3697">
                  <c:v>3.4806049243300587</c:v>
                </c:pt>
                <c:pt idx="3698">
                  <c:v>3.4805075789411948</c:v>
                </c:pt>
                <c:pt idx="3699">
                  <c:v>3.4804150007897539</c:v>
                </c:pt>
                <c:pt idx="3700">
                  <c:v>3.48024495674448</c:v>
                </c:pt>
                <c:pt idx="3701">
                  <c:v>3.4794721343872905</c:v>
                </c:pt>
                <c:pt idx="3702">
                  <c:v>3.4788661820119255</c:v>
                </c:pt>
                <c:pt idx="3703">
                  <c:v>3.4787339929071948</c:v>
                </c:pt>
                <c:pt idx="3704">
                  <c:v>3.4785119849290762</c:v>
                </c:pt>
                <c:pt idx="3705">
                  <c:v>3.4782930717437379</c:v>
                </c:pt>
                <c:pt idx="3706">
                  <c:v>3.4781077512829919</c:v>
                </c:pt>
                <c:pt idx="3707">
                  <c:v>3.4775641700106013</c:v>
                </c:pt>
                <c:pt idx="3708">
                  <c:v>3.4775384595137324</c:v>
                </c:pt>
                <c:pt idx="3709">
                  <c:v>3.4774050618781884</c:v>
                </c:pt>
                <c:pt idx="3710">
                  <c:v>3.4771276886643281</c:v>
                </c:pt>
                <c:pt idx="3711">
                  <c:v>3.4769845108571404</c:v>
                </c:pt>
                <c:pt idx="3712">
                  <c:v>3.4768630140151595</c:v>
                </c:pt>
                <c:pt idx="3713">
                  <c:v>3.4765571098911709</c:v>
                </c:pt>
                <c:pt idx="3714">
                  <c:v>3.4764217993498283</c:v>
                </c:pt>
                <c:pt idx="3715">
                  <c:v>3.4761776504879842</c:v>
                </c:pt>
                <c:pt idx="3716">
                  <c:v>3.4758043128270377</c:v>
                </c:pt>
                <c:pt idx="3717">
                  <c:v>3.475053440975798</c:v>
                </c:pt>
                <c:pt idx="3718">
                  <c:v>3.4748829010429279</c:v>
                </c:pt>
                <c:pt idx="3719">
                  <c:v>3.4747939674053274</c:v>
                </c:pt>
                <c:pt idx="3720">
                  <c:v>3.4743886845890737</c:v>
                </c:pt>
                <c:pt idx="3721">
                  <c:v>3.4742259797278012</c:v>
                </c:pt>
                <c:pt idx="3722">
                  <c:v>3.473681568244996</c:v>
                </c:pt>
                <c:pt idx="3723">
                  <c:v>3.4736718404065856</c:v>
                </c:pt>
                <c:pt idx="3724">
                  <c:v>3.4731194282153188</c:v>
                </c:pt>
                <c:pt idx="3725">
                  <c:v>3.4730000927917111</c:v>
                </c:pt>
                <c:pt idx="3726">
                  <c:v>3.4726622038508159</c:v>
                </c:pt>
                <c:pt idx="3727">
                  <c:v>3.472478528923896</c:v>
                </c:pt>
                <c:pt idx="3728">
                  <c:v>3.4723809708311149</c:v>
                </c:pt>
                <c:pt idx="3729">
                  <c:v>3.4714327034579378</c:v>
                </c:pt>
                <c:pt idx="3730">
                  <c:v>3.4709027259713632</c:v>
                </c:pt>
                <c:pt idx="3731">
                  <c:v>3.4706432088876169</c:v>
                </c:pt>
                <c:pt idx="3732">
                  <c:v>3.47036066497142</c:v>
                </c:pt>
                <c:pt idx="3733">
                  <c:v>3.4702258610625014</c:v>
                </c:pt>
                <c:pt idx="3734">
                  <c:v>3.4700624062673664</c:v>
                </c:pt>
                <c:pt idx="3735">
                  <c:v>3.4694087898585724</c:v>
                </c:pt>
                <c:pt idx="3736">
                  <c:v>3.4690271271303512</c:v>
                </c:pt>
                <c:pt idx="3737">
                  <c:v>3.4680016940875573</c:v>
                </c:pt>
                <c:pt idx="3738">
                  <c:v>3.4680000514530986</c:v>
                </c:pt>
                <c:pt idx="3739">
                  <c:v>3.4678028901983589</c:v>
                </c:pt>
                <c:pt idx="3740">
                  <c:v>3.4670857832921738</c:v>
                </c:pt>
                <c:pt idx="3741">
                  <c:v>3.4668643264888925</c:v>
                </c:pt>
                <c:pt idx="3742">
                  <c:v>3.4668140919486627</c:v>
                </c:pt>
                <c:pt idx="3743">
                  <c:v>3.4661893808265858</c:v>
                </c:pt>
                <c:pt idx="3744">
                  <c:v>3.4660772003133045</c:v>
                </c:pt>
                <c:pt idx="3745">
                  <c:v>3.4660301748617948</c:v>
                </c:pt>
                <c:pt idx="3746">
                  <c:v>3.4657206698810383</c:v>
                </c:pt>
                <c:pt idx="3747">
                  <c:v>3.465504298105432</c:v>
                </c:pt>
                <c:pt idx="3748">
                  <c:v>3.465465471915119</c:v>
                </c:pt>
                <c:pt idx="3749">
                  <c:v>3.4651844981762316</c:v>
                </c:pt>
                <c:pt idx="3750">
                  <c:v>3.4651646578654902</c:v>
                </c:pt>
                <c:pt idx="3751">
                  <c:v>3.4644754714676806</c:v>
                </c:pt>
                <c:pt idx="3752">
                  <c:v>3.4644224755024582</c:v>
                </c:pt>
                <c:pt idx="3753">
                  <c:v>3.4640496649158319</c:v>
                </c:pt>
                <c:pt idx="3754">
                  <c:v>3.463951023698705</c:v>
                </c:pt>
                <c:pt idx="3755">
                  <c:v>3.4636740454078181</c:v>
                </c:pt>
                <c:pt idx="3756">
                  <c:v>3.463644180911555</c:v>
                </c:pt>
                <c:pt idx="3757">
                  <c:v>3.4630231979594348</c:v>
                </c:pt>
                <c:pt idx="3758">
                  <c:v>3.4629558991663063</c:v>
                </c:pt>
                <c:pt idx="3759">
                  <c:v>3.4629284781493483</c:v>
                </c:pt>
                <c:pt idx="3760">
                  <c:v>3.4628894209845296</c:v>
                </c:pt>
                <c:pt idx="3761">
                  <c:v>3.4627905158590591</c:v>
                </c:pt>
                <c:pt idx="3762">
                  <c:v>3.4626890939383239</c:v>
                </c:pt>
                <c:pt idx="3763">
                  <c:v>3.4626167539999679</c:v>
                </c:pt>
                <c:pt idx="3764">
                  <c:v>3.462530262856987</c:v>
                </c:pt>
                <c:pt idx="3765">
                  <c:v>3.4622373957264041</c:v>
                </c:pt>
                <c:pt idx="3766">
                  <c:v>3.4621982763585759</c:v>
                </c:pt>
                <c:pt idx="3767">
                  <c:v>3.4621641480746961</c:v>
                </c:pt>
                <c:pt idx="3768">
                  <c:v>3.4612158082170943</c:v>
                </c:pt>
                <c:pt idx="3769">
                  <c:v>3.46106645186252</c:v>
                </c:pt>
                <c:pt idx="3770">
                  <c:v>3.4607884622454876</c:v>
                </c:pt>
                <c:pt idx="3771">
                  <c:v>3.46026121259399</c:v>
                </c:pt>
                <c:pt idx="3772">
                  <c:v>3.4601750872677011</c:v>
                </c:pt>
                <c:pt idx="3773">
                  <c:v>3.4599843801440193</c:v>
                </c:pt>
                <c:pt idx="3774">
                  <c:v>3.4597868933003766</c:v>
                </c:pt>
                <c:pt idx="3775">
                  <c:v>3.4597425300902804</c:v>
                </c:pt>
                <c:pt idx="3776">
                  <c:v>3.4596914649365775</c:v>
                </c:pt>
                <c:pt idx="3777">
                  <c:v>3.4595524703376364</c:v>
                </c:pt>
                <c:pt idx="3778">
                  <c:v>3.4593958387839714</c:v>
                </c:pt>
                <c:pt idx="3779">
                  <c:v>3.4592944588447057</c:v>
                </c:pt>
                <c:pt idx="3780">
                  <c:v>3.4590371324237141</c:v>
                </c:pt>
                <c:pt idx="3781">
                  <c:v>3.4589138634893719</c:v>
                </c:pt>
                <c:pt idx="3782">
                  <c:v>3.4588861860619096</c:v>
                </c:pt>
                <c:pt idx="3783">
                  <c:v>3.4588476024621841</c:v>
                </c:pt>
                <c:pt idx="3784">
                  <c:v>3.4584153997217784</c:v>
                </c:pt>
                <c:pt idx="3785">
                  <c:v>3.4581861157530303</c:v>
                </c:pt>
                <c:pt idx="3786">
                  <c:v>3.4579869688274822</c:v>
                </c:pt>
                <c:pt idx="3787">
                  <c:v>3.4579642754076261</c:v>
                </c:pt>
                <c:pt idx="3788">
                  <c:v>3.45792729099725</c:v>
                </c:pt>
                <c:pt idx="3789">
                  <c:v>3.4576102726737656</c:v>
                </c:pt>
                <c:pt idx="3790">
                  <c:v>3.4570260840902614</c:v>
                </c:pt>
                <c:pt idx="3791">
                  <c:v>3.4568634826720155</c:v>
                </c:pt>
                <c:pt idx="3792">
                  <c:v>3.4563761564255531</c:v>
                </c:pt>
                <c:pt idx="3793">
                  <c:v>3.4560782641151264</c:v>
                </c:pt>
                <c:pt idx="3794">
                  <c:v>3.455776788293536</c:v>
                </c:pt>
                <c:pt idx="3795">
                  <c:v>3.455699908032404</c:v>
                </c:pt>
                <c:pt idx="3796">
                  <c:v>3.4554548141692285</c:v>
                </c:pt>
                <c:pt idx="3797">
                  <c:v>3.4553592746163631</c:v>
                </c:pt>
                <c:pt idx="3798">
                  <c:v>3.4551639026741992</c:v>
                </c:pt>
                <c:pt idx="3799">
                  <c:v>3.4551435992496033</c:v>
                </c:pt>
                <c:pt idx="3800">
                  <c:v>3.4548101489259668</c:v>
                </c:pt>
                <c:pt idx="3801">
                  <c:v>3.4545374434400489</c:v>
                </c:pt>
                <c:pt idx="3802">
                  <c:v>3.4534066851806973</c:v>
                </c:pt>
                <c:pt idx="3803">
                  <c:v>3.4526687915855003</c:v>
                </c:pt>
                <c:pt idx="3804">
                  <c:v>3.4523811156428064</c:v>
                </c:pt>
                <c:pt idx="3805">
                  <c:v>3.452078765477824</c:v>
                </c:pt>
                <c:pt idx="3806">
                  <c:v>3.4518333238381875</c:v>
                </c:pt>
                <c:pt idx="3807">
                  <c:v>3.451762563165222</c:v>
                </c:pt>
                <c:pt idx="3808">
                  <c:v>3.4511294670364556</c:v>
                </c:pt>
                <c:pt idx="3809">
                  <c:v>3.4510201602916535</c:v>
                </c:pt>
                <c:pt idx="3810">
                  <c:v>3.4510158899385663</c:v>
                </c:pt>
                <c:pt idx="3811">
                  <c:v>3.450901428831016</c:v>
                </c:pt>
                <c:pt idx="3812">
                  <c:v>3.4508065911831691</c:v>
                </c:pt>
                <c:pt idx="3813">
                  <c:v>3.4505946268087397</c:v>
                </c:pt>
                <c:pt idx="3814">
                  <c:v>3.4499760911985566</c:v>
                </c:pt>
                <c:pt idx="3815">
                  <c:v>3.4492769330785329</c:v>
                </c:pt>
                <c:pt idx="3816">
                  <c:v>3.4491362800636121</c:v>
                </c:pt>
                <c:pt idx="3817">
                  <c:v>3.4491277021866007</c:v>
                </c:pt>
                <c:pt idx="3818">
                  <c:v>3.4488050510015524</c:v>
                </c:pt>
                <c:pt idx="3819">
                  <c:v>3.4477848929693726</c:v>
                </c:pt>
                <c:pt idx="3820">
                  <c:v>3.4476635522138173</c:v>
                </c:pt>
                <c:pt idx="3821">
                  <c:v>3.4473406723572446</c:v>
                </c:pt>
                <c:pt idx="3822">
                  <c:v>3.4471140826531568</c:v>
                </c:pt>
                <c:pt idx="3823">
                  <c:v>3.4471132208696966</c:v>
                </c:pt>
                <c:pt idx="3824">
                  <c:v>3.4471089119267466</c:v>
                </c:pt>
                <c:pt idx="3825">
                  <c:v>3.446656234835531</c:v>
                </c:pt>
                <c:pt idx="3826">
                  <c:v>3.4466217258003633</c:v>
                </c:pt>
                <c:pt idx="3827">
                  <c:v>3.4456949960934757</c:v>
                </c:pt>
                <c:pt idx="3828">
                  <c:v>3.4454839816711056</c:v>
                </c:pt>
                <c:pt idx="3829">
                  <c:v>3.4452114138043943</c:v>
                </c:pt>
                <c:pt idx="3830">
                  <c:v>3.4445834243427496</c:v>
                </c:pt>
                <c:pt idx="3831">
                  <c:v>3.4445348797702464</c:v>
                </c:pt>
                <c:pt idx="3832">
                  <c:v>3.4444230332289174</c:v>
                </c:pt>
                <c:pt idx="3833">
                  <c:v>3.444114221940429</c:v>
                </c:pt>
                <c:pt idx="3834">
                  <c:v>3.4434194617828173</c:v>
                </c:pt>
                <c:pt idx="3835">
                  <c:v>3.4432908092370278</c:v>
                </c:pt>
                <c:pt idx="3836">
                  <c:v>3.4432342943829317</c:v>
                </c:pt>
                <c:pt idx="3837">
                  <c:v>3.4432125559421931</c:v>
                </c:pt>
                <c:pt idx="3838">
                  <c:v>3.4428628523097622</c:v>
                </c:pt>
                <c:pt idx="3839">
                  <c:v>3.4428088928462808</c:v>
                </c:pt>
                <c:pt idx="3840">
                  <c:v>3.4424222774217057</c:v>
                </c:pt>
                <c:pt idx="3841">
                  <c:v>3.4415101044073095</c:v>
                </c:pt>
                <c:pt idx="3842">
                  <c:v>3.4412009613296672</c:v>
                </c:pt>
                <c:pt idx="3843">
                  <c:v>3.4411817417831898</c:v>
                </c:pt>
                <c:pt idx="3844">
                  <c:v>3.4409213204651339</c:v>
                </c:pt>
                <c:pt idx="3845">
                  <c:v>3.4408540049973348</c:v>
                </c:pt>
                <c:pt idx="3846">
                  <c:v>3.4408172830712225</c:v>
                </c:pt>
                <c:pt idx="3847">
                  <c:v>3.4406458730152658</c:v>
                </c:pt>
                <c:pt idx="3848">
                  <c:v>3.4403825043477689</c:v>
                </c:pt>
                <c:pt idx="3849">
                  <c:v>3.4402582018670507</c:v>
                </c:pt>
                <c:pt idx="3850">
                  <c:v>3.4401732705608126</c:v>
                </c:pt>
                <c:pt idx="3851">
                  <c:v>3.4398868333084969</c:v>
                </c:pt>
                <c:pt idx="3852">
                  <c:v>3.4394405960233212</c:v>
                </c:pt>
                <c:pt idx="3853">
                  <c:v>3.4394081404592174</c:v>
                </c:pt>
                <c:pt idx="3854">
                  <c:v>3.4390211183710049</c:v>
                </c:pt>
                <c:pt idx="3855">
                  <c:v>3.4385063099021491</c:v>
                </c:pt>
                <c:pt idx="3856">
                  <c:v>3.4383366232638441</c:v>
                </c:pt>
                <c:pt idx="3857">
                  <c:v>3.4380384120447052</c:v>
                </c:pt>
                <c:pt idx="3858">
                  <c:v>3.4379794493018676</c:v>
                </c:pt>
                <c:pt idx="3859">
                  <c:v>3.4379037540470669</c:v>
                </c:pt>
                <c:pt idx="3860">
                  <c:v>3.437884388025287</c:v>
                </c:pt>
                <c:pt idx="3861">
                  <c:v>3.4371540110295138</c:v>
                </c:pt>
                <c:pt idx="3862">
                  <c:v>3.4371196204418264</c:v>
                </c:pt>
                <c:pt idx="3863">
                  <c:v>3.4366749430579864</c:v>
                </c:pt>
                <c:pt idx="3864">
                  <c:v>3.4366263891904292</c:v>
                </c:pt>
                <c:pt idx="3865">
                  <c:v>3.4361025451517029</c:v>
                </c:pt>
                <c:pt idx="3866">
                  <c:v>3.4360495071649928</c:v>
                </c:pt>
                <c:pt idx="3867">
                  <c:v>3.4350981439436539</c:v>
                </c:pt>
                <c:pt idx="3868">
                  <c:v>3.4349723195293977</c:v>
                </c:pt>
                <c:pt idx="3869">
                  <c:v>3.4346105928842339</c:v>
                </c:pt>
                <c:pt idx="3870">
                  <c:v>3.4343870228803799</c:v>
                </c:pt>
                <c:pt idx="3871">
                  <c:v>3.4343479750432158</c:v>
                </c:pt>
                <c:pt idx="3872">
                  <c:v>3.4342893967038757</c:v>
                </c:pt>
                <c:pt idx="3873">
                  <c:v>3.4338933419043762</c:v>
                </c:pt>
                <c:pt idx="3874">
                  <c:v>3.4337405067265703</c:v>
                </c:pt>
                <c:pt idx="3875">
                  <c:v>3.4336125103167694</c:v>
                </c:pt>
                <c:pt idx="3876">
                  <c:v>3.4335858396492238</c:v>
                </c:pt>
                <c:pt idx="3877">
                  <c:v>3.433579616257783</c:v>
                </c:pt>
                <c:pt idx="3878">
                  <c:v>3.4326459870944803</c:v>
                </c:pt>
                <c:pt idx="3879">
                  <c:v>3.4323340336172925</c:v>
                </c:pt>
                <c:pt idx="3880">
                  <c:v>3.4315996131589301</c:v>
                </c:pt>
                <c:pt idx="3881">
                  <c:v>3.4312860131256611</c:v>
                </c:pt>
                <c:pt idx="3882">
                  <c:v>3.4310938100420545</c:v>
                </c:pt>
                <c:pt idx="3883">
                  <c:v>3.4307082535410598</c:v>
                </c:pt>
                <c:pt idx="3884">
                  <c:v>3.4296921813992745</c:v>
                </c:pt>
                <c:pt idx="3885">
                  <c:v>3.4295226046855989</c:v>
                </c:pt>
                <c:pt idx="3886">
                  <c:v>3.4289460872364157</c:v>
                </c:pt>
                <c:pt idx="3887">
                  <c:v>3.4287645323832137</c:v>
                </c:pt>
                <c:pt idx="3888">
                  <c:v>3.4282302130960698</c:v>
                </c:pt>
                <c:pt idx="3889">
                  <c:v>3.4282194119897835</c:v>
                </c:pt>
                <c:pt idx="3890">
                  <c:v>3.4282005094073709</c:v>
                </c:pt>
                <c:pt idx="3891">
                  <c:v>3.427999731212616</c:v>
                </c:pt>
                <c:pt idx="3892">
                  <c:v>3.4279321840498849</c:v>
                </c:pt>
                <c:pt idx="3893">
                  <c:v>3.427457256153847</c:v>
                </c:pt>
                <c:pt idx="3894">
                  <c:v>3.4270440882321114</c:v>
                </c:pt>
                <c:pt idx="3895">
                  <c:v>3.4266178790480515</c:v>
                </c:pt>
                <c:pt idx="3896">
                  <c:v>3.4262455067919868</c:v>
                </c:pt>
                <c:pt idx="3897">
                  <c:v>3.4259569699707808</c:v>
                </c:pt>
                <c:pt idx="3898">
                  <c:v>3.4255260692490603</c:v>
                </c:pt>
                <c:pt idx="3899">
                  <c:v>3.425448171817858</c:v>
                </c:pt>
                <c:pt idx="3900">
                  <c:v>3.4245549766067129</c:v>
                </c:pt>
                <c:pt idx="3901">
                  <c:v>3.4240872437227217</c:v>
                </c:pt>
                <c:pt idx="3902">
                  <c:v>3.4238345492750497</c:v>
                </c:pt>
                <c:pt idx="3903">
                  <c:v>3.4232049008265455</c:v>
                </c:pt>
                <c:pt idx="3904">
                  <c:v>3.4230828691105915</c:v>
                </c:pt>
                <c:pt idx="3905">
                  <c:v>3.422911602612877</c:v>
                </c:pt>
                <c:pt idx="3906">
                  <c:v>3.4228104507798398</c:v>
                </c:pt>
                <c:pt idx="3907">
                  <c:v>3.4226026055216496</c:v>
                </c:pt>
                <c:pt idx="3908">
                  <c:v>3.4223891871692085</c:v>
                </c:pt>
                <c:pt idx="3909">
                  <c:v>3.4222331612535255</c:v>
                </c:pt>
                <c:pt idx="3910">
                  <c:v>3.4220889471160101</c:v>
                </c:pt>
                <c:pt idx="3911">
                  <c:v>3.4219675145380699</c:v>
                </c:pt>
                <c:pt idx="3912">
                  <c:v>3.4217565245914519</c:v>
                </c:pt>
                <c:pt idx="3913">
                  <c:v>3.4217528701828868</c:v>
                </c:pt>
                <c:pt idx="3914">
                  <c:v>3.4216916542677462</c:v>
                </c:pt>
                <c:pt idx="3915">
                  <c:v>3.4212693035021613</c:v>
                </c:pt>
                <c:pt idx="3916">
                  <c:v>3.4207851977922172</c:v>
                </c:pt>
                <c:pt idx="3917">
                  <c:v>3.4204783487083752</c:v>
                </c:pt>
                <c:pt idx="3918">
                  <c:v>3.4204508591060683</c:v>
                </c:pt>
                <c:pt idx="3919">
                  <c:v>3.4202088755469289</c:v>
                </c:pt>
                <c:pt idx="3920">
                  <c:v>3.4200878331872184</c:v>
                </c:pt>
                <c:pt idx="3921">
                  <c:v>3.419993360029117</c:v>
                </c:pt>
                <c:pt idx="3922">
                  <c:v>3.4196501486781612</c:v>
                </c:pt>
                <c:pt idx="3923">
                  <c:v>3.4195326236433878</c:v>
                </c:pt>
                <c:pt idx="3924">
                  <c:v>3.4192938029607438</c:v>
                </c:pt>
                <c:pt idx="3925">
                  <c:v>3.4190474964200548</c:v>
                </c:pt>
                <c:pt idx="3926">
                  <c:v>3.4186805347755609</c:v>
                </c:pt>
                <c:pt idx="3927">
                  <c:v>3.4182202449233081</c:v>
                </c:pt>
                <c:pt idx="3928">
                  <c:v>3.4178599580414293</c:v>
                </c:pt>
                <c:pt idx="3929">
                  <c:v>3.4176165261433926</c:v>
                </c:pt>
                <c:pt idx="3930">
                  <c:v>3.4168401370737671</c:v>
                </c:pt>
                <c:pt idx="3931">
                  <c:v>3.4168050236787426</c:v>
                </c:pt>
                <c:pt idx="3932">
                  <c:v>3.4161937807786411</c:v>
                </c:pt>
                <c:pt idx="3933">
                  <c:v>3.4159021896098833</c:v>
                </c:pt>
                <c:pt idx="3934">
                  <c:v>3.415726214517401</c:v>
                </c:pt>
                <c:pt idx="3935">
                  <c:v>3.4156947167147558</c:v>
                </c:pt>
                <c:pt idx="3936">
                  <c:v>3.415650245339259</c:v>
                </c:pt>
                <c:pt idx="3937">
                  <c:v>3.415607622664147</c:v>
                </c:pt>
                <c:pt idx="3938">
                  <c:v>3.4147663591875976</c:v>
                </c:pt>
                <c:pt idx="3939">
                  <c:v>3.4146735070572829</c:v>
                </c:pt>
                <c:pt idx="3940">
                  <c:v>3.4145109680455641</c:v>
                </c:pt>
                <c:pt idx="3941">
                  <c:v>3.4142517085541639</c:v>
                </c:pt>
                <c:pt idx="3942">
                  <c:v>3.4142061595431277</c:v>
                </c:pt>
                <c:pt idx="3943">
                  <c:v>3.4141801293917942</c:v>
                </c:pt>
                <c:pt idx="3944">
                  <c:v>3.4141689731350335</c:v>
                </c:pt>
                <c:pt idx="3945">
                  <c:v>3.413913230349007</c:v>
                </c:pt>
                <c:pt idx="3946">
                  <c:v>3.413334230529578</c:v>
                </c:pt>
                <c:pt idx="3947">
                  <c:v>3.4129913073477849</c:v>
                </c:pt>
                <c:pt idx="3948">
                  <c:v>3.4128766285983345</c:v>
                </c:pt>
                <c:pt idx="3949">
                  <c:v>3.4127320715898266</c:v>
                </c:pt>
                <c:pt idx="3950">
                  <c:v>3.4125604059456238</c:v>
                </c:pt>
                <c:pt idx="3951">
                  <c:v>3.4122430190429935</c:v>
                </c:pt>
                <c:pt idx="3952">
                  <c:v>3.4121309447341819</c:v>
                </c:pt>
                <c:pt idx="3953">
                  <c:v>3.4119833361037721</c:v>
                </c:pt>
                <c:pt idx="3954">
                  <c:v>3.4117833304638507</c:v>
                </c:pt>
                <c:pt idx="3955">
                  <c:v>3.4115851031725528</c:v>
                </c:pt>
                <c:pt idx="3956">
                  <c:v>3.4114831491942286</c:v>
                </c:pt>
                <c:pt idx="3957">
                  <c:v>3.4113755571170059</c:v>
                </c:pt>
                <c:pt idx="3958">
                  <c:v>3.4109149489484727</c:v>
                </c:pt>
                <c:pt idx="3959">
                  <c:v>3.4106516586749756</c:v>
                </c:pt>
                <c:pt idx="3960">
                  <c:v>3.4106497841506509</c:v>
                </c:pt>
                <c:pt idx="3961">
                  <c:v>3.4106375995453186</c:v>
                </c:pt>
                <c:pt idx="3962">
                  <c:v>3.4100729838128272</c:v>
                </c:pt>
                <c:pt idx="3963">
                  <c:v>3.4099472052846331</c:v>
                </c:pt>
                <c:pt idx="3964">
                  <c:v>3.4099331233312946</c:v>
                </c:pt>
                <c:pt idx="3965">
                  <c:v>3.4097772525529884</c:v>
                </c:pt>
                <c:pt idx="3966">
                  <c:v>3.4094766208069709</c:v>
                </c:pt>
                <c:pt idx="3967">
                  <c:v>3.4093713505114422</c:v>
                </c:pt>
                <c:pt idx="3968">
                  <c:v>3.4091061818834318</c:v>
                </c:pt>
                <c:pt idx="3969">
                  <c:v>3.4090798442454178</c:v>
                </c:pt>
                <c:pt idx="3970">
                  <c:v>3.4088897896586849</c:v>
                </c:pt>
                <c:pt idx="3971">
                  <c:v>3.4086845878865786</c:v>
                </c:pt>
                <c:pt idx="3972">
                  <c:v>3.4083587014765246</c:v>
                </c:pt>
                <c:pt idx="3973">
                  <c:v>3.4082324254116436</c:v>
                </c:pt>
                <c:pt idx="3974">
                  <c:v>3.4081843554703619</c:v>
                </c:pt>
                <c:pt idx="3975">
                  <c:v>3.4080269127297744</c:v>
                </c:pt>
                <c:pt idx="3976">
                  <c:v>3.4077892263630805</c:v>
                </c:pt>
                <c:pt idx="3977">
                  <c:v>3.407613707708816</c:v>
                </c:pt>
                <c:pt idx="3978">
                  <c:v>3.4076118200259322</c:v>
                </c:pt>
                <c:pt idx="3979">
                  <c:v>3.4074220660357306</c:v>
                </c:pt>
                <c:pt idx="3980">
                  <c:v>3.4062638093159192</c:v>
                </c:pt>
                <c:pt idx="3981">
                  <c:v>3.4061833257585827</c:v>
                </c:pt>
                <c:pt idx="3982">
                  <c:v>3.4059019895760123</c:v>
                </c:pt>
                <c:pt idx="3983">
                  <c:v>3.4054952930701354</c:v>
                </c:pt>
                <c:pt idx="3984">
                  <c:v>3.4054298447765801</c:v>
                </c:pt>
                <c:pt idx="3985">
                  <c:v>3.4054156155814495</c:v>
                </c:pt>
                <c:pt idx="3986">
                  <c:v>3.4051404261341518</c:v>
                </c:pt>
                <c:pt idx="3987">
                  <c:v>3.4049135009279903</c:v>
                </c:pt>
                <c:pt idx="3988">
                  <c:v>3.4047881190051235</c:v>
                </c:pt>
                <c:pt idx="3989">
                  <c:v>3.4044241164353033</c:v>
                </c:pt>
                <c:pt idx="3990">
                  <c:v>3.4042976420531805</c:v>
                </c:pt>
                <c:pt idx="3991">
                  <c:v>3.4039503613458546</c:v>
                </c:pt>
                <c:pt idx="3992">
                  <c:v>3.4038827758373236</c:v>
                </c:pt>
                <c:pt idx="3993">
                  <c:v>3.4036770988909084</c:v>
                </c:pt>
                <c:pt idx="3994">
                  <c:v>3.4031767831756845</c:v>
                </c:pt>
                <c:pt idx="3995">
                  <c:v>3.4028744084663995</c:v>
                </c:pt>
                <c:pt idx="3996">
                  <c:v>3.4026949826393236</c:v>
                </c:pt>
                <c:pt idx="3997">
                  <c:v>3.4026825727936489</c:v>
                </c:pt>
                <c:pt idx="3998">
                  <c:v>3.4022661601454729</c:v>
                </c:pt>
                <c:pt idx="3999">
                  <c:v>3.4019306385235444</c:v>
                </c:pt>
                <c:pt idx="4000">
                  <c:v>3.4018569993828702</c:v>
                </c:pt>
                <c:pt idx="4001">
                  <c:v>3.4014551113949447</c:v>
                </c:pt>
                <c:pt idx="4002">
                  <c:v>3.401199431964844</c:v>
                </c:pt>
                <c:pt idx="4003">
                  <c:v>3.4009828964800448</c:v>
                </c:pt>
                <c:pt idx="4004">
                  <c:v>3.4009742711498081</c:v>
                </c:pt>
                <c:pt idx="4005">
                  <c:v>3.4009138890411688</c:v>
                </c:pt>
                <c:pt idx="4006">
                  <c:v>3.400859250374622</c:v>
                </c:pt>
                <c:pt idx="4007">
                  <c:v>3.4007432402402262</c:v>
                </c:pt>
                <c:pt idx="4008">
                  <c:v>3.4005907500405352</c:v>
                </c:pt>
                <c:pt idx="4009">
                  <c:v>3.4005312739404827</c:v>
                </c:pt>
                <c:pt idx="4010">
                  <c:v>3.4003806286687506</c:v>
                </c:pt>
                <c:pt idx="4011">
                  <c:v>3.3995650862118842</c:v>
                </c:pt>
                <c:pt idx="4012">
                  <c:v>3.3995237399883274</c:v>
                </c:pt>
                <c:pt idx="4013">
                  <c:v>3.3992928980439108</c:v>
                </c:pt>
                <c:pt idx="4014">
                  <c:v>3.3991735816140314</c:v>
                </c:pt>
                <c:pt idx="4015">
                  <c:v>3.3990397927650084</c:v>
                </c:pt>
                <c:pt idx="4016">
                  <c:v>3.3982998414324981</c:v>
                </c:pt>
                <c:pt idx="4017">
                  <c:v>3.397966065559253</c:v>
                </c:pt>
                <c:pt idx="4018">
                  <c:v>3.3977266694355568</c:v>
                </c:pt>
                <c:pt idx="4019">
                  <c:v>3.3973731258338464</c:v>
                </c:pt>
                <c:pt idx="4020">
                  <c:v>3.3972339477799198</c:v>
                </c:pt>
                <c:pt idx="4021">
                  <c:v>3.3971276011539286</c:v>
                </c:pt>
                <c:pt idx="4022">
                  <c:v>3.3970163927395909</c:v>
                </c:pt>
                <c:pt idx="4023">
                  <c:v>3.3968993513948011</c:v>
                </c:pt>
                <c:pt idx="4024">
                  <c:v>3.3967580859499598</c:v>
                </c:pt>
                <c:pt idx="4025">
                  <c:v>3.3966022536393967</c:v>
                </c:pt>
                <c:pt idx="4026">
                  <c:v>3.3965064035171006</c:v>
                </c:pt>
                <c:pt idx="4027">
                  <c:v>3.3960840237905447</c:v>
                </c:pt>
                <c:pt idx="4028">
                  <c:v>3.3957766684857558</c:v>
                </c:pt>
                <c:pt idx="4029">
                  <c:v>3.3955088885069276</c:v>
                </c:pt>
                <c:pt idx="4030">
                  <c:v>3.3954147382030104</c:v>
                </c:pt>
                <c:pt idx="4031">
                  <c:v>3.3950709648537383</c:v>
                </c:pt>
                <c:pt idx="4032">
                  <c:v>3.3948455193677036</c:v>
                </c:pt>
                <c:pt idx="4033">
                  <c:v>3.394783306908828</c:v>
                </c:pt>
                <c:pt idx="4034">
                  <c:v>3.3942989115010507</c:v>
                </c:pt>
                <c:pt idx="4035">
                  <c:v>3.3940954599980357</c:v>
                </c:pt>
                <c:pt idx="4036">
                  <c:v>3.3940448256751434</c:v>
                </c:pt>
                <c:pt idx="4037">
                  <c:v>3.3939795765929239</c:v>
                </c:pt>
                <c:pt idx="4038">
                  <c:v>3.3937486914365009</c:v>
                </c:pt>
                <c:pt idx="4039">
                  <c:v>3.3936346648854308</c:v>
                </c:pt>
                <c:pt idx="4040">
                  <c:v>3.3935771529598551</c:v>
                </c:pt>
                <c:pt idx="4041">
                  <c:v>3.3934572307219502</c:v>
                </c:pt>
                <c:pt idx="4042">
                  <c:v>3.393434802562989</c:v>
                </c:pt>
                <c:pt idx="4043">
                  <c:v>3.3932641155835341</c:v>
                </c:pt>
                <c:pt idx="4044">
                  <c:v>3.3927321173811298</c:v>
                </c:pt>
                <c:pt idx="4045">
                  <c:v>3.3924233573028761</c:v>
                </c:pt>
                <c:pt idx="4046">
                  <c:v>3.3914448194595224</c:v>
                </c:pt>
                <c:pt idx="4047">
                  <c:v>3.3913889763280785</c:v>
                </c:pt>
                <c:pt idx="4048">
                  <c:v>3.3911361228356895</c:v>
                </c:pt>
                <c:pt idx="4049">
                  <c:v>3.3910420002223751</c:v>
                </c:pt>
                <c:pt idx="4050">
                  <c:v>3.3907330170397771</c:v>
                </c:pt>
                <c:pt idx="4051">
                  <c:v>3.3904159582254154</c:v>
                </c:pt>
                <c:pt idx="4052">
                  <c:v>3.390131095077201</c:v>
                </c:pt>
                <c:pt idx="4053">
                  <c:v>3.3897309889906828</c:v>
                </c:pt>
                <c:pt idx="4054">
                  <c:v>3.3894604382175011</c:v>
                </c:pt>
                <c:pt idx="4055">
                  <c:v>3.3894063078317052</c:v>
                </c:pt>
                <c:pt idx="4056">
                  <c:v>3.3888350672129102</c:v>
                </c:pt>
                <c:pt idx="4057">
                  <c:v>3.3887719877114426</c:v>
                </c:pt>
                <c:pt idx="4058">
                  <c:v>3.3883538544413465</c:v>
                </c:pt>
                <c:pt idx="4059">
                  <c:v>3.3872226817757443</c:v>
                </c:pt>
                <c:pt idx="4060">
                  <c:v>3.3870980232468866</c:v>
                </c:pt>
                <c:pt idx="4061">
                  <c:v>3.3868822596597021</c:v>
                </c:pt>
                <c:pt idx="4062">
                  <c:v>3.3867218521256777</c:v>
                </c:pt>
                <c:pt idx="4063">
                  <c:v>3.3865970497366535</c:v>
                </c:pt>
                <c:pt idx="4064">
                  <c:v>3.3859734913225896</c:v>
                </c:pt>
                <c:pt idx="4065">
                  <c:v>3.3858306110582106</c:v>
                </c:pt>
                <c:pt idx="4066">
                  <c:v>3.3855059791133129</c:v>
                </c:pt>
                <c:pt idx="4067">
                  <c:v>3.3854394343473881</c:v>
                </c:pt>
                <c:pt idx="4068">
                  <c:v>3.3850439282511813</c:v>
                </c:pt>
                <c:pt idx="4069">
                  <c:v>3.3849981932623967</c:v>
                </c:pt>
                <c:pt idx="4070">
                  <c:v>3.3846281593252145</c:v>
                </c:pt>
                <c:pt idx="4071">
                  <c:v>3.3846162174957808</c:v>
                </c:pt>
                <c:pt idx="4072">
                  <c:v>3.3845933280714986</c:v>
                </c:pt>
                <c:pt idx="4073">
                  <c:v>3.384307606369898</c:v>
                </c:pt>
                <c:pt idx="4074">
                  <c:v>3.3842080075945891</c:v>
                </c:pt>
                <c:pt idx="4075">
                  <c:v>3.3840107346070685</c:v>
                </c:pt>
                <c:pt idx="4076">
                  <c:v>3.3834772503987218</c:v>
                </c:pt>
                <c:pt idx="4077">
                  <c:v>3.3833535081196255</c:v>
                </c:pt>
                <c:pt idx="4078">
                  <c:v>3.3829860652490762</c:v>
                </c:pt>
                <c:pt idx="4079">
                  <c:v>3.3825833184059504</c:v>
                </c:pt>
                <c:pt idx="4080">
                  <c:v>3.3822602514544942</c:v>
                </c:pt>
                <c:pt idx="4081">
                  <c:v>3.3821661868053767</c:v>
                </c:pt>
                <c:pt idx="4082">
                  <c:v>3.3812113792732661</c:v>
                </c:pt>
                <c:pt idx="4083">
                  <c:v>3.3809665785774743</c:v>
                </c:pt>
                <c:pt idx="4084">
                  <c:v>3.3808722332811185</c:v>
                </c:pt>
                <c:pt idx="4085">
                  <c:v>3.380190129661147</c:v>
                </c:pt>
                <c:pt idx="4086">
                  <c:v>3.3798059121680537</c:v>
                </c:pt>
                <c:pt idx="4087">
                  <c:v>3.379766666644815</c:v>
                </c:pt>
                <c:pt idx="4088">
                  <c:v>3.3797173531392906</c:v>
                </c:pt>
                <c:pt idx="4089">
                  <c:v>3.3797032625377472</c:v>
                </c:pt>
                <c:pt idx="4090">
                  <c:v>3.379686151906955</c:v>
                </c:pt>
                <c:pt idx="4091">
                  <c:v>3.379272271945744</c:v>
                </c:pt>
                <c:pt idx="4092">
                  <c:v>3.3792148413786265</c:v>
                </c:pt>
                <c:pt idx="4093">
                  <c:v>3.3788872412107915</c:v>
                </c:pt>
                <c:pt idx="4094">
                  <c:v>3.3788176573619038</c:v>
                </c:pt>
                <c:pt idx="4095">
                  <c:v>3.3787450362397666</c:v>
                </c:pt>
                <c:pt idx="4096">
                  <c:v>3.3782817909015455</c:v>
                </c:pt>
                <c:pt idx="4097">
                  <c:v>3.3772394500794434</c:v>
                </c:pt>
                <c:pt idx="4098">
                  <c:v>3.3771534033625548</c:v>
                </c:pt>
                <c:pt idx="4099">
                  <c:v>3.3767107526717175</c:v>
                </c:pt>
                <c:pt idx="4100">
                  <c:v>3.3766560230838389</c:v>
                </c:pt>
                <c:pt idx="4101">
                  <c:v>3.3757164372116044</c:v>
                </c:pt>
                <c:pt idx="4102">
                  <c:v>3.3756839313561269</c:v>
                </c:pt>
                <c:pt idx="4103">
                  <c:v>3.3754176981170354</c:v>
                </c:pt>
                <c:pt idx="4104">
                  <c:v>3.3753668716965111</c:v>
                </c:pt>
                <c:pt idx="4105">
                  <c:v>3.3753058721390499</c:v>
                </c:pt>
                <c:pt idx="4106">
                  <c:v>3.3752011362494962</c:v>
                </c:pt>
                <c:pt idx="4107">
                  <c:v>3.375109598770536</c:v>
                </c:pt>
                <c:pt idx="4108">
                  <c:v>3.3743603006954155</c:v>
                </c:pt>
                <c:pt idx="4109">
                  <c:v>3.3743531680093137</c:v>
                </c:pt>
                <c:pt idx="4110">
                  <c:v>3.3742410675550802</c:v>
                </c:pt>
                <c:pt idx="4111">
                  <c:v>3.3740473713178605</c:v>
                </c:pt>
                <c:pt idx="4112">
                  <c:v>3.373788295019553</c:v>
                </c:pt>
                <c:pt idx="4113">
                  <c:v>3.3737729904040781</c:v>
                </c:pt>
                <c:pt idx="4114">
                  <c:v>3.3731501453270614</c:v>
                </c:pt>
                <c:pt idx="4115">
                  <c:v>3.3731021185402006</c:v>
                </c:pt>
                <c:pt idx="4116">
                  <c:v>3.372592912427324</c:v>
                </c:pt>
                <c:pt idx="4117">
                  <c:v>3.3723933617176329</c:v>
                </c:pt>
                <c:pt idx="4118">
                  <c:v>3.3723749370288032</c:v>
                </c:pt>
                <c:pt idx="4119">
                  <c:v>3.3719991075561415</c:v>
                </c:pt>
                <c:pt idx="4120">
                  <c:v>3.3712628916456318</c:v>
                </c:pt>
                <c:pt idx="4121">
                  <c:v>3.3712495503214424</c:v>
                </c:pt>
                <c:pt idx="4122">
                  <c:v>3.3710678622717363</c:v>
                </c:pt>
                <c:pt idx="4123">
                  <c:v>3.3707833729630878</c:v>
                </c:pt>
                <c:pt idx="4124">
                  <c:v>3.3707371386867999</c:v>
                </c:pt>
                <c:pt idx="4125">
                  <c:v>3.3707145334713373</c:v>
                </c:pt>
                <c:pt idx="4126">
                  <c:v>3.369816566376556</c:v>
                </c:pt>
                <c:pt idx="4127">
                  <c:v>3.3692199817446133</c:v>
                </c:pt>
                <c:pt idx="4128">
                  <c:v>3.368933247225347</c:v>
                </c:pt>
                <c:pt idx="4129">
                  <c:v>3.368523445341447</c:v>
                </c:pt>
                <c:pt idx="4130">
                  <c:v>3.36819904582469</c:v>
                </c:pt>
                <c:pt idx="4131">
                  <c:v>3.3681825094230802</c:v>
                </c:pt>
                <c:pt idx="4132">
                  <c:v>3.3678423400040178</c:v>
                </c:pt>
                <c:pt idx="4133">
                  <c:v>3.3676261060624646</c:v>
                </c:pt>
                <c:pt idx="4134">
                  <c:v>3.3670834954741689</c:v>
                </c:pt>
                <c:pt idx="4135">
                  <c:v>3.366340967972095</c:v>
                </c:pt>
                <c:pt idx="4136">
                  <c:v>3.3659422173049567</c:v>
                </c:pt>
                <c:pt idx="4137">
                  <c:v>3.3658580590568752</c:v>
                </c:pt>
                <c:pt idx="4138">
                  <c:v>3.3652341562901089</c:v>
                </c:pt>
                <c:pt idx="4139">
                  <c:v>3.3651831646212851</c:v>
                </c:pt>
                <c:pt idx="4140">
                  <c:v>3.3651779610531243</c:v>
                </c:pt>
                <c:pt idx="4141">
                  <c:v>3.3651613092160231</c:v>
                </c:pt>
                <c:pt idx="4142">
                  <c:v>3.3647583482983507</c:v>
                </c:pt>
                <c:pt idx="4143">
                  <c:v>3.3646489533032122</c:v>
                </c:pt>
                <c:pt idx="4144">
                  <c:v>3.3645572486492239</c:v>
                </c:pt>
                <c:pt idx="4145">
                  <c:v>3.3643508423501571</c:v>
                </c:pt>
                <c:pt idx="4146">
                  <c:v>3.3637456526652683</c:v>
                </c:pt>
                <c:pt idx="4147">
                  <c:v>3.3636443575426775</c:v>
                </c:pt>
                <c:pt idx="4148">
                  <c:v>3.3635284135109162</c:v>
                </c:pt>
                <c:pt idx="4149">
                  <c:v>3.3633371949311694</c:v>
                </c:pt>
                <c:pt idx="4150">
                  <c:v>3.3628519788596924</c:v>
                </c:pt>
                <c:pt idx="4151">
                  <c:v>3.3625945106209234</c:v>
                </c:pt>
                <c:pt idx="4152">
                  <c:v>3.362546349209298</c:v>
                </c:pt>
                <c:pt idx="4153">
                  <c:v>3.3624510576366888</c:v>
                </c:pt>
                <c:pt idx="4154">
                  <c:v>3.3624238276322922</c:v>
                </c:pt>
                <c:pt idx="4155">
                  <c:v>3.3624217329458506</c:v>
                </c:pt>
                <c:pt idx="4156">
                  <c:v>3.3623725049058319</c:v>
                </c:pt>
                <c:pt idx="4157">
                  <c:v>3.3620623446949898</c:v>
                </c:pt>
                <c:pt idx="4158">
                  <c:v>3.3614959405895113</c:v>
                </c:pt>
                <c:pt idx="4159">
                  <c:v>3.3610927144411287</c:v>
                </c:pt>
                <c:pt idx="4160">
                  <c:v>3.3609886969692706</c:v>
                </c:pt>
                <c:pt idx="4161">
                  <c:v>3.3609739854169498</c:v>
                </c:pt>
                <c:pt idx="4162">
                  <c:v>3.3607669199979391</c:v>
                </c:pt>
                <c:pt idx="4163">
                  <c:v>3.3607196069358602</c:v>
                </c:pt>
                <c:pt idx="4164">
                  <c:v>3.3602009282138656</c:v>
                </c:pt>
                <c:pt idx="4165">
                  <c:v>3.3598628751114239</c:v>
                </c:pt>
                <c:pt idx="4166">
                  <c:v>3.3593526646337919</c:v>
                </c:pt>
                <c:pt idx="4167">
                  <c:v>3.3592651096220294</c:v>
                </c:pt>
                <c:pt idx="4168">
                  <c:v>3.3590266173140573</c:v>
                </c:pt>
                <c:pt idx="4169">
                  <c:v>3.358745746085726</c:v>
                </c:pt>
                <c:pt idx="4170">
                  <c:v>3.3587203953844851</c:v>
                </c:pt>
                <c:pt idx="4171">
                  <c:v>3.3583463005540128</c:v>
                </c:pt>
                <c:pt idx="4172">
                  <c:v>3.3581633629130678</c:v>
                </c:pt>
                <c:pt idx="4173">
                  <c:v>3.3577040932201312</c:v>
                </c:pt>
                <c:pt idx="4174">
                  <c:v>3.3575738431553956</c:v>
                </c:pt>
                <c:pt idx="4175">
                  <c:v>3.3573863415559124</c:v>
                </c:pt>
                <c:pt idx="4176">
                  <c:v>3.3573556132352222</c:v>
                </c:pt>
                <c:pt idx="4177">
                  <c:v>3.3571945188790084</c:v>
                </c:pt>
                <c:pt idx="4178">
                  <c:v>3.3565272489938121</c:v>
                </c:pt>
                <c:pt idx="4179">
                  <c:v>3.3564943363547379</c:v>
                </c:pt>
                <c:pt idx="4180">
                  <c:v>3.3564847806052209</c:v>
                </c:pt>
                <c:pt idx="4181">
                  <c:v>3.356318052029732</c:v>
                </c:pt>
                <c:pt idx="4182">
                  <c:v>3.3562181966346056</c:v>
                </c:pt>
                <c:pt idx="4183">
                  <c:v>3.3561204435855547</c:v>
                </c:pt>
                <c:pt idx="4184">
                  <c:v>3.3558068478364618</c:v>
                </c:pt>
                <c:pt idx="4185">
                  <c:v>3.355586664022046</c:v>
                </c:pt>
                <c:pt idx="4186">
                  <c:v>3.3551843009567812</c:v>
                </c:pt>
                <c:pt idx="4187">
                  <c:v>3.3538489379388481</c:v>
                </c:pt>
                <c:pt idx="4188">
                  <c:v>3.3536448589607164</c:v>
                </c:pt>
                <c:pt idx="4189">
                  <c:v>3.3531882724301556</c:v>
                </c:pt>
                <c:pt idx="4190">
                  <c:v>3.3531272866081356</c:v>
                </c:pt>
                <c:pt idx="4191">
                  <c:v>3.3530202732419889</c:v>
                </c:pt>
                <c:pt idx="4192">
                  <c:v>3.3525448151859072</c:v>
                </c:pt>
                <c:pt idx="4193">
                  <c:v>3.3520388018395195</c:v>
                </c:pt>
                <c:pt idx="4194">
                  <c:v>3.3517748406447936</c:v>
                </c:pt>
                <c:pt idx="4195">
                  <c:v>3.3514398296547601</c:v>
                </c:pt>
                <c:pt idx="4196">
                  <c:v>3.3514065291880297</c:v>
                </c:pt>
                <c:pt idx="4197">
                  <c:v>3.3513743004985583</c:v>
                </c:pt>
                <c:pt idx="4198">
                  <c:v>3.3512550335476345</c:v>
                </c:pt>
                <c:pt idx="4199">
                  <c:v>3.351094884960014</c:v>
                </c:pt>
                <c:pt idx="4200">
                  <c:v>3.3509701646248882</c:v>
                </c:pt>
                <c:pt idx="4201">
                  <c:v>3.3507937747380634</c:v>
                </c:pt>
                <c:pt idx="4202">
                  <c:v>3.3507819411449229</c:v>
                </c:pt>
                <c:pt idx="4203">
                  <c:v>3.3507571971354637</c:v>
                </c:pt>
                <c:pt idx="4204">
                  <c:v>3.3507442866578097</c:v>
                </c:pt>
                <c:pt idx="4205">
                  <c:v>3.3505721102718682</c:v>
                </c:pt>
                <c:pt idx="4206">
                  <c:v>3.3505387432018106</c:v>
                </c:pt>
                <c:pt idx="4207">
                  <c:v>3.350292177978262</c:v>
                </c:pt>
                <c:pt idx="4208">
                  <c:v>3.3496713768819264</c:v>
                </c:pt>
                <c:pt idx="4209">
                  <c:v>3.3495937143122148</c:v>
                </c:pt>
                <c:pt idx="4210">
                  <c:v>3.3491360861504349</c:v>
                </c:pt>
                <c:pt idx="4211">
                  <c:v>3.3488541458294017</c:v>
                </c:pt>
                <c:pt idx="4212">
                  <c:v>3.3483957372880582</c:v>
                </c:pt>
                <c:pt idx="4213">
                  <c:v>3.3482821415167754</c:v>
                </c:pt>
                <c:pt idx="4214">
                  <c:v>3.3475587594000946</c:v>
                </c:pt>
                <c:pt idx="4215">
                  <c:v>3.3473029049525791</c:v>
                </c:pt>
                <c:pt idx="4216">
                  <c:v>3.3472703702812932</c:v>
                </c:pt>
                <c:pt idx="4217">
                  <c:v>3.3472139710767332</c:v>
                </c:pt>
                <c:pt idx="4218">
                  <c:v>3.3470751110537091</c:v>
                </c:pt>
                <c:pt idx="4219">
                  <c:v>3.3468265709692404</c:v>
                </c:pt>
                <c:pt idx="4220">
                  <c:v>3.3465561628177181</c:v>
                </c:pt>
                <c:pt idx="4221">
                  <c:v>3.3457417499932065</c:v>
                </c:pt>
                <c:pt idx="4222">
                  <c:v>3.3451776165427041</c:v>
                </c:pt>
                <c:pt idx="4223">
                  <c:v>3.3449465241806489</c:v>
                </c:pt>
                <c:pt idx="4224">
                  <c:v>3.3446116581611767</c:v>
                </c:pt>
                <c:pt idx="4225">
                  <c:v>3.3443693465235791</c:v>
                </c:pt>
                <c:pt idx="4226">
                  <c:v>3.3442776257718876</c:v>
                </c:pt>
                <c:pt idx="4227">
                  <c:v>3.3442099146943636</c:v>
                </c:pt>
                <c:pt idx="4228">
                  <c:v>3.3441411006873309</c:v>
                </c:pt>
                <c:pt idx="4229">
                  <c:v>3.3439171065978428</c:v>
                </c:pt>
                <c:pt idx="4230">
                  <c:v>3.3436503483241511</c:v>
                </c:pt>
                <c:pt idx="4231">
                  <c:v>3.3435398799239331</c:v>
                </c:pt>
                <c:pt idx="4232">
                  <c:v>3.3432893078378454</c:v>
                </c:pt>
                <c:pt idx="4233">
                  <c:v>3.3432893078378454</c:v>
                </c:pt>
                <c:pt idx="4234">
                  <c:v>3.343283835218529</c:v>
                </c:pt>
                <c:pt idx="4235">
                  <c:v>3.3432301998994762</c:v>
                </c:pt>
                <c:pt idx="4236">
                  <c:v>3.3426967701225019</c:v>
                </c:pt>
                <c:pt idx="4237">
                  <c:v>3.3420057335096089</c:v>
                </c:pt>
                <c:pt idx="4238">
                  <c:v>3.3417883232855941</c:v>
                </c:pt>
                <c:pt idx="4239">
                  <c:v>3.3412399223334384</c:v>
                </c:pt>
                <c:pt idx="4240">
                  <c:v>3.3411629369253912</c:v>
                </c:pt>
                <c:pt idx="4241">
                  <c:v>3.3411222391245605</c:v>
                </c:pt>
                <c:pt idx="4242">
                  <c:v>3.3409131903200762</c:v>
                </c:pt>
                <c:pt idx="4243">
                  <c:v>3.3407866118786331</c:v>
                </c:pt>
                <c:pt idx="4244">
                  <c:v>3.3405002984675294</c:v>
                </c:pt>
                <c:pt idx="4245">
                  <c:v>3.3404573351710702</c:v>
                </c:pt>
                <c:pt idx="4246">
                  <c:v>3.3401189884213163</c:v>
                </c:pt>
                <c:pt idx="4247">
                  <c:v>3.3397549990186204</c:v>
                </c:pt>
                <c:pt idx="4248">
                  <c:v>3.3393023443837988</c:v>
                </c:pt>
                <c:pt idx="4249">
                  <c:v>3.3392736235416471</c:v>
                </c:pt>
                <c:pt idx="4250">
                  <c:v>3.3390504199652105</c:v>
                </c:pt>
                <c:pt idx="4251">
                  <c:v>3.3388801777642496</c:v>
                </c:pt>
                <c:pt idx="4252">
                  <c:v>3.3385948171659563</c:v>
                </c:pt>
                <c:pt idx="4253">
                  <c:v>3.3384221825425064</c:v>
                </c:pt>
                <c:pt idx="4254">
                  <c:v>3.3378628621780857</c:v>
                </c:pt>
                <c:pt idx="4255">
                  <c:v>3.3374570426669461</c:v>
                </c:pt>
                <c:pt idx="4256">
                  <c:v>3.3374171055019328</c:v>
                </c:pt>
                <c:pt idx="4257">
                  <c:v>3.3369753330401819</c:v>
                </c:pt>
                <c:pt idx="4258">
                  <c:v>3.3368109411526934</c:v>
                </c:pt>
                <c:pt idx="4259">
                  <c:v>3.3367253883254917</c:v>
                </c:pt>
                <c:pt idx="4260">
                  <c:v>3.3366964965513164</c:v>
                </c:pt>
                <c:pt idx="4261">
                  <c:v>3.336527552320077</c:v>
                </c:pt>
                <c:pt idx="4262">
                  <c:v>3.3353230333755399</c:v>
                </c:pt>
                <c:pt idx="4263">
                  <c:v>3.3351312490505296</c:v>
                </c:pt>
                <c:pt idx="4264">
                  <c:v>3.3348635014017303</c:v>
                </c:pt>
                <c:pt idx="4265">
                  <c:v>3.3348289052895579</c:v>
                </c:pt>
                <c:pt idx="4266">
                  <c:v>3.3340581485817977</c:v>
                </c:pt>
                <c:pt idx="4267">
                  <c:v>3.3335983947726717</c:v>
                </c:pt>
                <c:pt idx="4268">
                  <c:v>3.3335916794324643</c:v>
                </c:pt>
                <c:pt idx="4269">
                  <c:v>3.3326931264416162</c:v>
                </c:pt>
                <c:pt idx="4270">
                  <c:v>3.3323655102715395</c:v>
                </c:pt>
                <c:pt idx="4271">
                  <c:v>3.332180275354871</c:v>
                </c:pt>
                <c:pt idx="4272">
                  <c:v>3.3321611860551514</c:v>
                </c:pt>
                <c:pt idx="4273">
                  <c:v>3.3321140206582931</c:v>
                </c:pt>
                <c:pt idx="4274">
                  <c:v>3.3317657365892175</c:v>
                </c:pt>
                <c:pt idx="4275">
                  <c:v>3.3315802456261827</c:v>
                </c:pt>
                <c:pt idx="4276">
                  <c:v>3.3314981546414106</c:v>
                </c:pt>
                <c:pt idx="4277">
                  <c:v>3.3313755515419148</c:v>
                </c:pt>
                <c:pt idx="4278">
                  <c:v>3.3305941282030713</c:v>
                </c:pt>
                <c:pt idx="4279">
                  <c:v>3.3304690149800891</c:v>
                </c:pt>
                <c:pt idx="4280">
                  <c:v>3.3302310877192798</c:v>
                </c:pt>
                <c:pt idx="4281">
                  <c:v>3.3297661332881656</c:v>
                </c:pt>
                <c:pt idx="4282">
                  <c:v>3.3293899686426953</c:v>
                </c:pt>
                <c:pt idx="4283">
                  <c:v>3.3290824690943004</c:v>
                </c:pt>
                <c:pt idx="4284">
                  <c:v>3.3290508023655723</c:v>
                </c:pt>
                <c:pt idx="4285">
                  <c:v>3.3286672254378025</c:v>
                </c:pt>
                <c:pt idx="4286">
                  <c:v>3.3283501510667644</c:v>
                </c:pt>
                <c:pt idx="4287">
                  <c:v>3.3283501510667644</c:v>
                </c:pt>
                <c:pt idx="4288">
                  <c:v>3.3282572497312364</c:v>
                </c:pt>
                <c:pt idx="4289">
                  <c:v>3.3277811018029322</c:v>
                </c:pt>
                <c:pt idx="4290">
                  <c:v>3.327266956403915</c:v>
                </c:pt>
                <c:pt idx="4291">
                  <c:v>3.3271374729005756</c:v>
                </c:pt>
                <c:pt idx="4292">
                  <c:v>3.3270204502129963</c:v>
                </c:pt>
                <c:pt idx="4293">
                  <c:v>3.3270159050064874</c:v>
                </c:pt>
                <c:pt idx="4294">
                  <c:v>3.3266441733847287</c:v>
                </c:pt>
                <c:pt idx="4295">
                  <c:v>3.3261115996484261</c:v>
                </c:pt>
                <c:pt idx="4296">
                  <c:v>3.326006828810264</c:v>
                </c:pt>
                <c:pt idx="4297">
                  <c:v>3.3258473464142218</c:v>
                </c:pt>
                <c:pt idx="4298">
                  <c:v>3.3258405101454596</c:v>
                </c:pt>
                <c:pt idx="4299">
                  <c:v>3.325586352468838</c:v>
                </c:pt>
                <c:pt idx="4300">
                  <c:v>3.3254962788563169</c:v>
                </c:pt>
                <c:pt idx="4301">
                  <c:v>3.3252042663238313</c:v>
                </c:pt>
                <c:pt idx="4302">
                  <c:v>3.3249577279344789</c:v>
                </c:pt>
                <c:pt idx="4303">
                  <c:v>3.324779585351588</c:v>
                </c:pt>
                <c:pt idx="4304">
                  <c:v>3.3238156638518528</c:v>
                </c:pt>
                <c:pt idx="4305">
                  <c:v>3.323763003918669</c:v>
                </c:pt>
                <c:pt idx="4306">
                  <c:v>3.3228415672566949</c:v>
                </c:pt>
                <c:pt idx="4307">
                  <c:v>3.3225879438579335</c:v>
                </c:pt>
                <c:pt idx="4308">
                  <c:v>3.3220928943493484</c:v>
                </c:pt>
                <c:pt idx="4309">
                  <c:v>3.3218951763469518</c:v>
                </c:pt>
                <c:pt idx="4310">
                  <c:v>3.3218457327785256</c:v>
                </c:pt>
                <c:pt idx="4311">
                  <c:v>3.3218215838735521</c:v>
                </c:pt>
                <c:pt idx="4312">
                  <c:v>3.3217422280157782</c:v>
                </c:pt>
                <c:pt idx="4313">
                  <c:v>3.3210596292066805</c:v>
                </c:pt>
                <c:pt idx="4314">
                  <c:v>3.3206781499775055</c:v>
                </c:pt>
                <c:pt idx="4315">
                  <c:v>3.3206308739310484</c:v>
                </c:pt>
                <c:pt idx="4316">
                  <c:v>3.3198275480242874</c:v>
                </c:pt>
                <c:pt idx="4317">
                  <c:v>3.3196935157885954</c:v>
                </c:pt>
                <c:pt idx="4318">
                  <c:v>3.3196831150064381</c:v>
                </c:pt>
                <c:pt idx="4319">
                  <c:v>3.3193675061852823</c:v>
                </c:pt>
                <c:pt idx="4320">
                  <c:v>3.3192194494066416</c:v>
                </c:pt>
                <c:pt idx="4321">
                  <c:v>3.3191292025504042</c:v>
                </c:pt>
                <c:pt idx="4322">
                  <c:v>3.3187738179054955</c:v>
                </c:pt>
                <c:pt idx="4323">
                  <c:v>3.3177987801973257</c:v>
                </c:pt>
                <c:pt idx="4324">
                  <c:v>3.3171076250870661</c:v>
                </c:pt>
                <c:pt idx="4325">
                  <c:v>3.3170925119336845</c:v>
                </c:pt>
                <c:pt idx="4326">
                  <c:v>3.3169215804383345</c:v>
                </c:pt>
                <c:pt idx="4327">
                  <c:v>3.316620251635936</c:v>
                </c:pt>
                <c:pt idx="4328">
                  <c:v>3.3160414399149807</c:v>
                </c:pt>
                <c:pt idx="4329">
                  <c:v>3.3157150087589979</c:v>
                </c:pt>
                <c:pt idx="4330">
                  <c:v>3.31551203143133</c:v>
                </c:pt>
                <c:pt idx="4331">
                  <c:v>3.3153217999054547</c:v>
                </c:pt>
                <c:pt idx="4332">
                  <c:v>3.3149831450391236</c:v>
                </c:pt>
                <c:pt idx="4333">
                  <c:v>3.3148674747850304</c:v>
                </c:pt>
                <c:pt idx="4334">
                  <c:v>3.3146699462710418</c:v>
                </c:pt>
                <c:pt idx="4335">
                  <c:v>3.3142921712346523</c:v>
                </c:pt>
                <c:pt idx="4336">
                  <c:v>3.3141575899206632</c:v>
                </c:pt>
                <c:pt idx="4337">
                  <c:v>3.3139480281670735</c:v>
                </c:pt>
                <c:pt idx="4338">
                  <c:v>3.3138777613694308</c:v>
                </c:pt>
                <c:pt idx="4339">
                  <c:v>3.313759453244483</c:v>
                </c:pt>
                <c:pt idx="4340">
                  <c:v>3.3136047841238296</c:v>
                </c:pt>
                <c:pt idx="4341">
                  <c:v>3.3135262567474375</c:v>
                </c:pt>
                <c:pt idx="4342">
                  <c:v>3.3134090252900994</c:v>
                </c:pt>
                <c:pt idx="4343">
                  <c:v>3.3132014480029648</c:v>
                </c:pt>
                <c:pt idx="4344">
                  <c:v>3.3127472466703574</c:v>
                </c:pt>
                <c:pt idx="4345">
                  <c:v>3.3127296324013087</c:v>
                </c:pt>
                <c:pt idx="4346">
                  <c:v>3.3123842484252828</c:v>
                </c:pt>
                <c:pt idx="4347">
                  <c:v>3.3123724958393854</c:v>
                </c:pt>
                <c:pt idx="4348">
                  <c:v>3.3121597190412788</c:v>
                </c:pt>
                <c:pt idx="4349">
                  <c:v>3.3119362499732157</c:v>
                </c:pt>
                <c:pt idx="4350">
                  <c:v>3.3115914116026004</c:v>
                </c:pt>
                <c:pt idx="4351">
                  <c:v>3.3114347904759351</c:v>
                </c:pt>
                <c:pt idx="4352">
                  <c:v>3.3111131279380932</c:v>
                </c:pt>
                <c:pt idx="4353">
                  <c:v>3.3111025196210218</c:v>
                </c:pt>
                <c:pt idx="4354">
                  <c:v>3.3109539759675157</c:v>
                </c:pt>
                <c:pt idx="4355">
                  <c:v>3.3108431245864227</c:v>
                </c:pt>
                <c:pt idx="4356">
                  <c:v>3.3103722806542373</c:v>
                </c:pt>
                <c:pt idx="4357">
                  <c:v>3.3102919856389472</c:v>
                </c:pt>
                <c:pt idx="4358">
                  <c:v>3.3102093134958372</c:v>
                </c:pt>
                <c:pt idx="4359">
                  <c:v>3.3101809651378464</c:v>
                </c:pt>
                <c:pt idx="4360">
                  <c:v>3.3100829127987041</c:v>
                </c:pt>
                <c:pt idx="4361">
                  <c:v>3.3099411112290298</c:v>
                </c:pt>
                <c:pt idx="4362">
                  <c:v>3.3097685235287866</c:v>
                </c:pt>
                <c:pt idx="4363">
                  <c:v>3.3096987597211771</c:v>
                </c:pt>
                <c:pt idx="4364">
                  <c:v>3.3088358368798931</c:v>
                </c:pt>
                <c:pt idx="4365">
                  <c:v>3.3087434060640009</c:v>
                </c:pt>
                <c:pt idx="4366">
                  <c:v>3.3087434060640009</c:v>
                </c:pt>
                <c:pt idx="4367">
                  <c:v>3.308627247147073</c:v>
                </c:pt>
                <c:pt idx="4368">
                  <c:v>3.3076113115153536</c:v>
                </c:pt>
                <c:pt idx="4369">
                  <c:v>3.307450870840138</c:v>
                </c:pt>
                <c:pt idx="4370">
                  <c:v>3.3072297221103537</c:v>
                </c:pt>
                <c:pt idx="4371">
                  <c:v>3.3070013213695648</c:v>
                </c:pt>
                <c:pt idx="4372">
                  <c:v>3.30691325983797</c:v>
                </c:pt>
                <c:pt idx="4373">
                  <c:v>3.3065012755808003</c:v>
                </c:pt>
                <c:pt idx="4374">
                  <c:v>3.3058646705720798</c:v>
                </c:pt>
                <c:pt idx="4375">
                  <c:v>3.3055806393381322</c:v>
                </c:pt>
                <c:pt idx="4376">
                  <c:v>3.3054827367958248</c:v>
                </c:pt>
                <c:pt idx="4377">
                  <c:v>3.3051697782388603</c:v>
                </c:pt>
                <c:pt idx="4378">
                  <c:v>3.3049498556660177</c:v>
                </c:pt>
                <c:pt idx="4379">
                  <c:v>3.3045683127530605</c:v>
                </c:pt>
                <c:pt idx="4380">
                  <c:v>3.3045168565570751</c:v>
                </c:pt>
                <c:pt idx="4381">
                  <c:v>3.3044582129937634</c:v>
                </c:pt>
                <c:pt idx="4382">
                  <c:v>3.3044522285114226</c:v>
                </c:pt>
                <c:pt idx="4383">
                  <c:v>3.3041049873624346</c:v>
                </c:pt>
                <c:pt idx="4384">
                  <c:v>3.3040942064698564</c:v>
                </c:pt>
                <c:pt idx="4385">
                  <c:v>3.3040115440678233</c:v>
                </c:pt>
                <c:pt idx="4386">
                  <c:v>3.3039013030513908</c:v>
                </c:pt>
                <c:pt idx="4387">
                  <c:v>3.3038389805310997</c:v>
                </c:pt>
                <c:pt idx="4388">
                  <c:v>3.3036363705521961</c:v>
                </c:pt>
                <c:pt idx="4389">
                  <c:v>3.303523635322084</c:v>
                </c:pt>
                <c:pt idx="4390">
                  <c:v>3.3033748759852615</c:v>
                </c:pt>
                <c:pt idx="4391">
                  <c:v>3.3033244782037681</c:v>
                </c:pt>
                <c:pt idx="4392">
                  <c:v>3.3030555912178947</c:v>
                </c:pt>
                <c:pt idx="4393">
                  <c:v>3.302829789646395</c:v>
                </c:pt>
                <c:pt idx="4394">
                  <c:v>3.3027324665997009</c:v>
                </c:pt>
                <c:pt idx="4395">
                  <c:v>3.3025870421529988</c:v>
                </c:pt>
                <c:pt idx="4396">
                  <c:v>3.3022924384903338</c:v>
                </c:pt>
                <c:pt idx="4397">
                  <c:v>3.3021793538132012</c:v>
                </c:pt>
                <c:pt idx="4398">
                  <c:v>3.3020253188045663</c:v>
                </c:pt>
                <c:pt idx="4399">
                  <c:v>3.3019880052315207</c:v>
                </c:pt>
                <c:pt idx="4400">
                  <c:v>3.3019181841286325</c:v>
                </c:pt>
                <c:pt idx="4401">
                  <c:v>3.3015363772276927</c:v>
                </c:pt>
                <c:pt idx="4402">
                  <c:v>3.3015026368196545</c:v>
                </c:pt>
                <c:pt idx="4403">
                  <c:v>3.3014447900209318</c:v>
                </c:pt>
                <c:pt idx="4404">
                  <c:v>3.3013929623866765</c:v>
                </c:pt>
                <c:pt idx="4405">
                  <c:v>3.3013399230554148</c:v>
                </c:pt>
                <c:pt idx="4406">
                  <c:v>3.3012374423636799</c:v>
                </c:pt>
                <c:pt idx="4407">
                  <c:v>3.3010541224650152</c:v>
                </c:pt>
                <c:pt idx="4408">
                  <c:v>3.300890033780298</c:v>
                </c:pt>
                <c:pt idx="4409">
                  <c:v>3.2997844401038443</c:v>
                </c:pt>
                <c:pt idx="4410">
                  <c:v>3.2991451751706879</c:v>
                </c:pt>
                <c:pt idx="4411">
                  <c:v>3.2988215519363604</c:v>
                </c:pt>
                <c:pt idx="4412">
                  <c:v>3.2985243819699788</c:v>
                </c:pt>
                <c:pt idx="4413">
                  <c:v>3.2979051302958364</c:v>
                </c:pt>
                <c:pt idx="4414">
                  <c:v>3.2977921126824361</c:v>
                </c:pt>
                <c:pt idx="4415">
                  <c:v>3.2965189385403635</c:v>
                </c:pt>
                <c:pt idx="4416">
                  <c:v>3.2959493063374765</c:v>
                </c:pt>
                <c:pt idx="4417">
                  <c:v>3.2958113600824746</c:v>
                </c:pt>
                <c:pt idx="4418">
                  <c:v>3.2951319767545413</c:v>
                </c:pt>
                <c:pt idx="4419">
                  <c:v>3.2949252627563879</c:v>
                </c:pt>
                <c:pt idx="4420">
                  <c:v>3.2944625519118551</c:v>
                </c:pt>
                <c:pt idx="4421">
                  <c:v>3.2944049846072501</c:v>
                </c:pt>
                <c:pt idx="4422">
                  <c:v>3.2940361278596786</c:v>
                </c:pt>
                <c:pt idx="4423">
                  <c:v>3.2938914406879949</c:v>
                </c:pt>
                <c:pt idx="4424">
                  <c:v>3.2937503856080244</c:v>
                </c:pt>
                <c:pt idx="4425">
                  <c:v>3.2935675591274927</c:v>
                </c:pt>
                <c:pt idx="4426">
                  <c:v>3.2932950170981088</c:v>
                </c:pt>
                <c:pt idx="4427">
                  <c:v>3.292876049308878</c:v>
                </c:pt>
                <c:pt idx="4428">
                  <c:v>3.2926953138124779</c:v>
                </c:pt>
                <c:pt idx="4429">
                  <c:v>3.2926104528383209</c:v>
                </c:pt>
                <c:pt idx="4430">
                  <c:v>3.2924972790727032</c:v>
                </c:pt>
                <c:pt idx="4431">
                  <c:v>3.292242530217651</c:v>
                </c:pt>
                <c:pt idx="4432">
                  <c:v>3.2921452678141212</c:v>
                </c:pt>
                <c:pt idx="4433">
                  <c:v>3.2920245829085024</c:v>
                </c:pt>
                <c:pt idx="4434">
                  <c:v>3.2915501386959614</c:v>
                </c:pt>
                <c:pt idx="4435">
                  <c:v>3.2914477879683908</c:v>
                </c:pt>
                <c:pt idx="4436">
                  <c:v>3.2911924225762155</c:v>
                </c:pt>
                <c:pt idx="4437">
                  <c:v>3.2911183755439675</c:v>
                </c:pt>
                <c:pt idx="4438">
                  <c:v>3.290873930724544</c:v>
                </c:pt>
                <c:pt idx="4439">
                  <c:v>3.2906318194595507</c:v>
                </c:pt>
                <c:pt idx="4440">
                  <c:v>3.2901100804840411</c:v>
                </c:pt>
                <c:pt idx="4441">
                  <c:v>3.2896979336042018</c:v>
                </c:pt>
                <c:pt idx="4442">
                  <c:v>3.2895914296886346</c:v>
                </c:pt>
                <c:pt idx="4443">
                  <c:v>3.2892853952240655</c:v>
                </c:pt>
                <c:pt idx="4444">
                  <c:v>3.2891639128623318</c:v>
                </c:pt>
                <c:pt idx="4445">
                  <c:v>3.289149035135575</c:v>
                </c:pt>
                <c:pt idx="4446">
                  <c:v>3.2890783589724686</c:v>
                </c:pt>
                <c:pt idx="4447">
                  <c:v>3.2886677137756246</c:v>
                </c:pt>
                <c:pt idx="4448">
                  <c:v>3.2886503365349276</c:v>
                </c:pt>
                <c:pt idx="4449">
                  <c:v>3.2886044076228904</c:v>
                </c:pt>
                <c:pt idx="4450">
                  <c:v>3.2885584738531173</c:v>
                </c:pt>
                <c:pt idx="4451">
                  <c:v>3.2880317505605872</c:v>
                </c:pt>
                <c:pt idx="4452">
                  <c:v>3.287977053992178</c:v>
                </c:pt>
                <c:pt idx="4453">
                  <c:v>3.2876810758158501</c:v>
                </c:pt>
                <c:pt idx="4454">
                  <c:v>3.287644997457547</c:v>
                </c:pt>
                <c:pt idx="4455">
                  <c:v>3.2872230314440753</c:v>
                </c:pt>
                <c:pt idx="4456">
                  <c:v>3.2870212391017128</c:v>
                </c:pt>
                <c:pt idx="4457">
                  <c:v>3.2869576924728698</c:v>
                </c:pt>
                <c:pt idx="4458">
                  <c:v>3.2868579927503454</c:v>
                </c:pt>
                <c:pt idx="4459">
                  <c:v>3.286804394690686</c:v>
                </c:pt>
                <c:pt idx="4460">
                  <c:v>3.2866186199926952</c:v>
                </c:pt>
                <c:pt idx="4461">
                  <c:v>3.2862343503970863</c:v>
                </c:pt>
                <c:pt idx="4462">
                  <c:v>3.2861731852368159</c:v>
                </c:pt>
                <c:pt idx="4463">
                  <c:v>3.2859434268792089</c:v>
                </c:pt>
                <c:pt idx="4464">
                  <c:v>3.2857960178489871</c:v>
                </c:pt>
                <c:pt idx="4465">
                  <c:v>3.2857547843352699</c:v>
                </c:pt>
                <c:pt idx="4466">
                  <c:v>3.2854772934423782</c:v>
                </c:pt>
                <c:pt idx="4467">
                  <c:v>3.2851383140613835</c:v>
                </c:pt>
                <c:pt idx="4468">
                  <c:v>3.2850920122089065</c:v>
                </c:pt>
                <c:pt idx="4469">
                  <c:v>3.2849881279304984</c:v>
                </c:pt>
                <c:pt idx="4470">
                  <c:v>3.2848541681478802</c:v>
                </c:pt>
                <c:pt idx="4471">
                  <c:v>3.2845735951094293</c:v>
                </c:pt>
                <c:pt idx="4472">
                  <c:v>3.2844670802022695</c:v>
                </c:pt>
                <c:pt idx="4473">
                  <c:v>3.284413186238226</c:v>
                </c:pt>
                <c:pt idx="4474">
                  <c:v>3.2841799864461549</c:v>
                </c:pt>
                <c:pt idx="4475">
                  <c:v>3.2841335823043059</c:v>
                </c:pt>
                <c:pt idx="4476">
                  <c:v>3.2840595762520479</c:v>
                </c:pt>
                <c:pt idx="4477">
                  <c:v>3.2832333648887535</c:v>
                </c:pt>
                <c:pt idx="4478">
                  <c:v>3.2830435412487859</c:v>
                </c:pt>
                <c:pt idx="4479">
                  <c:v>3.2829932429373985</c:v>
                </c:pt>
                <c:pt idx="4480">
                  <c:v>3.2828410550721179</c:v>
                </c:pt>
                <c:pt idx="4481">
                  <c:v>3.2823678000819005</c:v>
                </c:pt>
                <c:pt idx="4482">
                  <c:v>3.2817427163634618</c:v>
                </c:pt>
                <c:pt idx="4483">
                  <c:v>3.281381875651677</c:v>
                </c:pt>
                <c:pt idx="4484">
                  <c:v>3.280899445452202</c:v>
                </c:pt>
                <c:pt idx="4485">
                  <c:v>3.2806314779065238</c:v>
                </c:pt>
                <c:pt idx="4486">
                  <c:v>3.2806200982664095</c:v>
                </c:pt>
                <c:pt idx="4487">
                  <c:v>3.2802633850827214</c:v>
                </c:pt>
                <c:pt idx="4488">
                  <c:v>3.2798075803772262</c:v>
                </c:pt>
                <c:pt idx="4489">
                  <c:v>3.2797911118101739</c:v>
                </c:pt>
                <c:pt idx="4490">
                  <c:v>3.2794920353532739</c:v>
                </c:pt>
                <c:pt idx="4491">
                  <c:v>3.2787104233317281</c:v>
                </c:pt>
                <c:pt idx="4492">
                  <c:v>3.2786558101920331</c:v>
                </c:pt>
                <c:pt idx="4493">
                  <c:v>3.2783534085499544</c:v>
                </c:pt>
                <c:pt idx="4494">
                  <c:v>3.2778955937947871</c:v>
                </c:pt>
                <c:pt idx="4495">
                  <c:v>3.2778065181880014</c:v>
                </c:pt>
                <c:pt idx="4496">
                  <c:v>3.2776372241853475</c:v>
                </c:pt>
                <c:pt idx="4497">
                  <c:v>3.2775226268844504</c:v>
                </c:pt>
                <c:pt idx="4498">
                  <c:v>3.2772283553277552</c:v>
                </c:pt>
                <c:pt idx="4499">
                  <c:v>3.2771365935481906</c:v>
                </c:pt>
                <c:pt idx="4500">
                  <c:v>3.2767642496658369</c:v>
                </c:pt>
                <c:pt idx="4501">
                  <c:v>3.2758882385759653</c:v>
                </c:pt>
                <c:pt idx="4502">
                  <c:v>3.2757961931766921</c:v>
                </c:pt>
                <c:pt idx="4503">
                  <c:v>3.2755212192264977</c:v>
                </c:pt>
                <c:pt idx="4504">
                  <c:v>3.2755097048916877</c:v>
                </c:pt>
                <c:pt idx="4505">
                  <c:v>3.275462364974365</c:v>
                </c:pt>
                <c:pt idx="4506">
                  <c:v>3.2754482899497228</c:v>
                </c:pt>
                <c:pt idx="4507">
                  <c:v>3.2753958244751691</c:v>
                </c:pt>
                <c:pt idx="4508">
                  <c:v>3.2752627128839245</c:v>
                </c:pt>
                <c:pt idx="4509">
                  <c:v>3.2751884598483656</c:v>
                </c:pt>
                <c:pt idx="4510">
                  <c:v>3.2751513285692933</c:v>
                </c:pt>
                <c:pt idx="4511">
                  <c:v>3.274524739818828</c:v>
                </c:pt>
                <c:pt idx="4512">
                  <c:v>3.2744798572658884</c:v>
                </c:pt>
                <c:pt idx="4513">
                  <c:v>3.2744298398138412</c:v>
                </c:pt>
                <c:pt idx="4514">
                  <c:v>3.2735298244684041</c:v>
                </c:pt>
                <c:pt idx="4515">
                  <c:v>3.2730270072705188</c:v>
                </c:pt>
                <c:pt idx="4516">
                  <c:v>3.2726189246621211</c:v>
                </c:pt>
                <c:pt idx="4517">
                  <c:v>3.2724205378531055</c:v>
                </c:pt>
                <c:pt idx="4518">
                  <c:v>3.2722761995955727</c:v>
                </c:pt>
                <c:pt idx="4519">
                  <c:v>3.2721214982108551</c:v>
                </c:pt>
                <c:pt idx="4520">
                  <c:v>3.2717332129262764</c:v>
                </c:pt>
                <c:pt idx="4521">
                  <c:v>3.2712386465044294</c:v>
                </c:pt>
                <c:pt idx="4522">
                  <c:v>3.271052554079688</c:v>
                </c:pt>
                <c:pt idx="4523">
                  <c:v>3.2708689681529188</c:v>
                </c:pt>
                <c:pt idx="4524">
                  <c:v>3.2695894708516167</c:v>
                </c:pt>
                <c:pt idx="4525">
                  <c:v>3.2695622341038848</c:v>
                </c:pt>
                <c:pt idx="4526">
                  <c:v>3.2690690833279765</c:v>
                </c:pt>
                <c:pt idx="4527">
                  <c:v>3.2689638919034665</c:v>
                </c:pt>
                <c:pt idx="4528">
                  <c:v>3.2682710701934461</c:v>
                </c:pt>
                <c:pt idx="4529">
                  <c:v>3.2682645656923297</c:v>
                </c:pt>
                <c:pt idx="4530">
                  <c:v>3.2682294397027998</c:v>
                </c:pt>
                <c:pt idx="4531">
                  <c:v>3.2681019214951723</c:v>
                </c:pt>
                <c:pt idx="4532">
                  <c:v>3.2679327068913175</c:v>
                </c:pt>
                <c:pt idx="4533">
                  <c:v>3.2674155430383909</c:v>
                </c:pt>
                <c:pt idx="4534">
                  <c:v>3.267395990763327</c:v>
                </c:pt>
                <c:pt idx="4535">
                  <c:v>3.2672108522697041</c:v>
                </c:pt>
                <c:pt idx="4536">
                  <c:v>3.2670895568088794</c:v>
                </c:pt>
                <c:pt idx="4537">
                  <c:v>3.2669225570991745</c:v>
                </c:pt>
                <c:pt idx="4538">
                  <c:v>3.2668560002578033</c:v>
                </c:pt>
                <c:pt idx="4539">
                  <c:v>3.266820760153105</c:v>
                </c:pt>
                <c:pt idx="4540">
                  <c:v>3.2667202448867378</c:v>
                </c:pt>
                <c:pt idx="4541">
                  <c:v>3.2667032724812173</c:v>
                </c:pt>
                <c:pt idx="4542">
                  <c:v>3.2662970424539837</c:v>
                </c:pt>
                <c:pt idx="4543">
                  <c:v>3.2662526084041645</c:v>
                </c:pt>
                <c:pt idx="4544">
                  <c:v>3.2658224086301906</c:v>
                </c:pt>
                <c:pt idx="4545">
                  <c:v>3.2653184416457006</c:v>
                </c:pt>
                <c:pt idx="4546">
                  <c:v>3.2652162679616095</c:v>
                </c:pt>
                <c:pt idx="4547">
                  <c:v>3.2650734465093096</c:v>
                </c:pt>
                <c:pt idx="4548">
                  <c:v>3.2644610095060371</c:v>
                </c:pt>
                <c:pt idx="4549">
                  <c:v>3.2643323798270978</c:v>
                </c:pt>
                <c:pt idx="4550">
                  <c:v>3.2641800750358305</c:v>
                </c:pt>
                <c:pt idx="4551">
                  <c:v>3.2640053839618863</c:v>
                </c:pt>
                <c:pt idx="4552">
                  <c:v>3.2632427508164721</c:v>
                </c:pt>
                <c:pt idx="4553">
                  <c:v>3.2628293175643401</c:v>
                </c:pt>
                <c:pt idx="4554">
                  <c:v>3.2627753051797606</c:v>
                </c:pt>
                <c:pt idx="4555">
                  <c:v>3.2626619890823481</c:v>
                </c:pt>
                <c:pt idx="4556">
                  <c:v>3.2622506404390896</c:v>
                </c:pt>
                <c:pt idx="4557">
                  <c:v>3.2622400879131352</c:v>
                </c:pt>
                <c:pt idx="4558">
                  <c:v>3.2620223848651579</c:v>
                </c:pt>
                <c:pt idx="4559">
                  <c:v>3.2617293030123062</c:v>
                </c:pt>
                <c:pt idx="4560">
                  <c:v>3.2616566620627436</c:v>
                </c:pt>
                <c:pt idx="4561">
                  <c:v>3.2614994518670688</c:v>
                </c:pt>
                <c:pt idx="4562">
                  <c:v>3.2614003405671137</c:v>
                </c:pt>
                <c:pt idx="4563">
                  <c:v>3.2610208656401851</c:v>
                </c:pt>
                <c:pt idx="4564">
                  <c:v>3.2605324815858459</c:v>
                </c:pt>
                <c:pt idx="4565">
                  <c:v>3.26031392064843</c:v>
                </c:pt>
                <c:pt idx="4566">
                  <c:v>3.26014031814662</c:v>
                </c:pt>
                <c:pt idx="4567">
                  <c:v>3.2596827884077682</c:v>
                </c:pt>
                <c:pt idx="4568">
                  <c:v>3.2591424154770627</c:v>
                </c:pt>
                <c:pt idx="4569">
                  <c:v>3.2590161873586569</c:v>
                </c:pt>
                <c:pt idx="4570">
                  <c:v>3.2587689397037933</c:v>
                </c:pt>
                <c:pt idx="4571">
                  <c:v>3.2586838326819869</c:v>
                </c:pt>
                <c:pt idx="4572">
                  <c:v>3.2586465931148245</c:v>
                </c:pt>
                <c:pt idx="4573">
                  <c:v>3.2586386127921179</c:v>
                </c:pt>
                <c:pt idx="4574">
                  <c:v>3.2583951424799378</c:v>
                </c:pt>
                <c:pt idx="4575">
                  <c:v>3.2583352518167095</c:v>
                </c:pt>
                <c:pt idx="4576">
                  <c:v>3.2583259347489721</c:v>
                </c:pt>
                <c:pt idx="4577">
                  <c:v>3.258194143382775</c:v>
                </c:pt>
                <c:pt idx="4578">
                  <c:v>3.258100933425915</c:v>
                </c:pt>
                <c:pt idx="4579">
                  <c:v>3.257927776127707</c:v>
                </c:pt>
                <c:pt idx="4580">
                  <c:v>3.2577692100542071</c:v>
                </c:pt>
                <c:pt idx="4581">
                  <c:v>3.2575425866159096</c:v>
                </c:pt>
                <c:pt idx="4582">
                  <c:v>3.2574692419421933</c:v>
                </c:pt>
                <c:pt idx="4583">
                  <c:v>3.2572638109344711</c:v>
                </c:pt>
                <c:pt idx="4584">
                  <c:v>3.2568646769245242</c:v>
                </c:pt>
                <c:pt idx="4585">
                  <c:v>3.2568339591092692</c:v>
                </c:pt>
                <c:pt idx="4586">
                  <c:v>3.256648270403868</c:v>
                </c:pt>
                <c:pt idx="4587">
                  <c:v>3.2561067818570737</c:v>
                </c:pt>
                <c:pt idx="4588">
                  <c:v>3.2560639687833191</c:v>
                </c:pt>
                <c:pt idx="4589">
                  <c:v>3.2557065825826248</c:v>
                </c:pt>
                <c:pt idx="4590">
                  <c:v>3.2553462216753934</c:v>
                </c:pt>
                <c:pt idx="4591">
                  <c:v>3.2552162040212438</c:v>
                </c:pt>
                <c:pt idx="4592">
                  <c:v>3.2545735867633878</c:v>
                </c:pt>
                <c:pt idx="4593">
                  <c:v>3.2539878296729419</c:v>
                </c:pt>
                <c:pt idx="4594">
                  <c:v>3.2537726746287858</c:v>
                </c:pt>
                <c:pt idx="4595">
                  <c:v>3.2532801063070762</c:v>
                </c:pt>
                <c:pt idx="4596">
                  <c:v>3.253277413141578</c:v>
                </c:pt>
                <c:pt idx="4597">
                  <c:v>3.2527869786895907</c:v>
                </c:pt>
                <c:pt idx="4598">
                  <c:v>3.2527478817850684</c:v>
                </c:pt>
                <c:pt idx="4599">
                  <c:v>3.2522217535986875</c:v>
                </c:pt>
                <c:pt idx="4600">
                  <c:v>3.2515517043714981</c:v>
                </c:pt>
                <c:pt idx="4601">
                  <c:v>3.2514813973663976</c:v>
                </c:pt>
                <c:pt idx="4602">
                  <c:v>3.2512162916903602</c:v>
                </c:pt>
                <c:pt idx="4603">
                  <c:v>3.250788535347823</c:v>
                </c:pt>
                <c:pt idx="4604">
                  <c:v>3.2505772090581431</c:v>
                </c:pt>
                <c:pt idx="4605">
                  <c:v>3.2497539531594679</c:v>
                </c:pt>
                <c:pt idx="4606">
                  <c:v>3.2495108825703074</c:v>
                </c:pt>
                <c:pt idx="4607">
                  <c:v>3.2493016514618658</c:v>
                </c:pt>
                <c:pt idx="4608">
                  <c:v>3.248960415744389</c:v>
                </c:pt>
                <c:pt idx="4609">
                  <c:v>3.2488298323620071</c:v>
                </c:pt>
                <c:pt idx="4610">
                  <c:v>3.2487155396850165</c:v>
                </c:pt>
                <c:pt idx="4611">
                  <c:v>3.2485168165270331</c:v>
                </c:pt>
                <c:pt idx="4612">
                  <c:v>3.2483561381880062</c:v>
                </c:pt>
                <c:pt idx="4613">
                  <c:v>3.2483220885341422</c:v>
                </c:pt>
                <c:pt idx="4614">
                  <c:v>3.2480373289331061</c:v>
                </c:pt>
                <c:pt idx="4615">
                  <c:v>3.2480018912317443</c:v>
                </c:pt>
                <c:pt idx="4616">
                  <c:v>3.2479323704173435</c:v>
                </c:pt>
                <c:pt idx="4617">
                  <c:v>3.2477005539623254</c:v>
                </c:pt>
                <c:pt idx="4618">
                  <c:v>3.2474877193466445</c:v>
                </c:pt>
                <c:pt idx="4619">
                  <c:v>3.2468472222893836</c:v>
                </c:pt>
                <c:pt idx="4620">
                  <c:v>3.2463193658911873</c:v>
                </c:pt>
                <c:pt idx="4621">
                  <c:v>3.2461852483530111</c:v>
                </c:pt>
                <c:pt idx="4622">
                  <c:v>3.2461797732879205</c:v>
                </c:pt>
                <c:pt idx="4623">
                  <c:v>3.2457620961597926</c:v>
                </c:pt>
                <c:pt idx="4624">
                  <c:v>3.2456538454069022</c:v>
                </c:pt>
                <c:pt idx="4625">
                  <c:v>3.2452603527892121</c:v>
                </c:pt>
                <c:pt idx="4626">
                  <c:v>3.2445629819159341</c:v>
                </c:pt>
                <c:pt idx="4627">
                  <c:v>3.2440089550125859</c:v>
                </c:pt>
                <c:pt idx="4628">
                  <c:v>3.2439814414642529</c:v>
                </c:pt>
                <c:pt idx="4629">
                  <c:v>3.2437296115234742</c:v>
                </c:pt>
                <c:pt idx="4630">
                  <c:v>3.2435740370201764</c:v>
                </c:pt>
                <c:pt idx="4631">
                  <c:v>3.243512067052793</c:v>
                </c:pt>
                <c:pt idx="4632">
                  <c:v>3.2430104735580652</c:v>
                </c:pt>
                <c:pt idx="4633">
                  <c:v>3.2425593716992025</c:v>
                </c:pt>
                <c:pt idx="4634">
                  <c:v>3.2424461778359115</c:v>
                </c:pt>
                <c:pt idx="4635">
                  <c:v>3.2423992351411783</c:v>
                </c:pt>
                <c:pt idx="4636">
                  <c:v>3.2423522873718822</c:v>
                </c:pt>
                <c:pt idx="4637">
                  <c:v>3.2422859995269961</c:v>
                </c:pt>
                <c:pt idx="4638">
                  <c:v>3.2421036557667078</c:v>
                </c:pt>
                <c:pt idx="4639">
                  <c:v>3.2420995107004438</c:v>
                </c:pt>
                <c:pt idx="4640">
                  <c:v>3.2418908245721925</c:v>
                </c:pt>
                <c:pt idx="4641">
                  <c:v>3.2413970416496465</c:v>
                </c:pt>
                <c:pt idx="4642">
                  <c:v>3.24067957253664</c:v>
                </c:pt>
                <c:pt idx="4643">
                  <c:v>3.2404618814099666</c:v>
                </c:pt>
                <c:pt idx="4644">
                  <c:v>3.2403273297893178</c:v>
                </c:pt>
                <c:pt idx="4645">
                  <c:v>3.24007892400508</c:v>
                </c:pt>
                <c:pt idx="4646">
                  <c:v>3.2399150927333098</c:v>
                </c:pt>
                <c:pt idx="4647">
                  <c:v>3.2397803715754945</c:v>
                </c:pt>
                <c:pt idx="4648">
                  <c:v>3.2396136483746205</c:v>
                </c:pt>
                <c:pt idx="4649">
                  <c:v>3.2394635427507166</c:v>
                </c:pt>
                <c:pt idx="4650">
                  <c:v>3.2392661026680765</c:v>
                </c:pt>
                <c:pt idx="4651">
                  <c:v>3.2390713555188051</c:v>
                </c:pt>
                <c:pt idx="4652">
                  <c:v>3.2390630072605582</c:v>
                </c:pt>
                <c:pt idx="4653">
                  <c:v>3.2390282211237555</c:v>
                </c:pt>
                <c:pt idx="4654">
                  <c:v>3.2388653849599853</c:v>
                </c:pt>
                <c:pt idx="4655">
                  <c:v>3.238170209379355</c:v>
                </c:pt>
                <c:pt idx="4656">
                  <c:v>3.2379596261257317</c:v>
                </c:pt>
                <c:pt idx="4657">
                  <c:v>3.2379038253711978</c:v>
                </c:pt>
                <c:pt idx="4658">
                  <c:v>3.2376875297027361</c:v>
                </c:pt>
                <c:pt idx="4659">
                  <c:v>3.2370561678267604</c:v>
                </c:pt>
                <c:pt idx="4660">
                  <c:v>3.2369051754964264</c:v>
                </c:pt>
                <c:pt idx="4661">
                  <c:v>3.2368674192099309</c:v>
                </c:pt>
                <c:pt idx="4662">
                  <c:v>3.236692578799516</c:v>
                </c:pt>
                <c:pt idx="4663">
                  <c:v>3.2366855837188147</c:v>
                </c:pt>
                <c:pt idx="4664">
                  <c:v>3.2366072311165022</c:v>
                </c:pt>
                <c:pt idx="4665">
                  <c:v>3.2364742791839061</c:v>
                </c:pt>
                <c:pt idx="4666">
                  <c:v>3.2362250596191928</c:v>
                </c:pt>
                <c:pt idx="4667">
                  <c:v>3.2361214093843564</c:v>
                </c:pt>
                <c:pt idx="4668">
                  <c:v>3.2357121695953452</c:v>
                </c:pt>
                <c:pt idx="4669">
                  <c:v>3.2356771140140563</c:v>
                </c:pt>
                <c:pt idx="4670">
                  <c:v>3.2351930578076429</c:v>
                </c:pt>
                <c:pt idx="4671">
                  <c:v>3.2346930016834738</c:v>
                </c:pt>
                <c:pt idx="4672">
                  <c:v>3.234615694447291</c:v>
                </c:pt>
                <c:pt idx="4673">
                  <c:v>3.2344090057220405</c:v>
                </c:pt>
                <c:pt idx="4674">
                  <c:v>3.2342908536992629</c:v>
                </c:pt>
                <c:pt idx="4675">
                  <c:v>3.2340896399780337</c:v>
                </c:pt>
                <c:pt idx="4676">
                  <c:v>3.2340417852325891</c:v>
                </c:pt>
                <c:pt idx="4677">
                  <c:v>3.2339094534877804</c:v>
                </c:pt>
                <c:pt idx="4678">
                  <c:v>3.2338601707259169</c:v>
                </c:pt>
                <c:pt idx="4679">
                  <c:v>3.2335009417021729</c:v>
                </c:pt>
                <c:pt idx="4680">
                  <c:v>3.2331555199774837</c:v>
                </c:pt>
                <c:pt idx="4681">
                  <c:v>3.2331216679680033</c:v>
                </c:pt>
                <c:pt idx="4682">
                  <c:v>3.2331174362812809</c:v>
                </c:pt>
                <c:pt idx="4683">
                  <c:v>3.2320200387675193</c:v>
                </c:pt>
                <c:pt idx="4684">
                  <c:v>3.2317767389077661</c:v>
                </c:pt>
                <c:pt idx="4685">
                  <c:v>3.2312897299027288</c:v>
                </c:pt>
                <c:pt idx="4686">
                  <c:v>3.2312146479626009</c:v>
                </c:pt>
                <c:pt idx="4687">
                  <c:v>3.2308730738280107</c:v>
                </c:pt>
                <c:pt idx="4688">
                  <c:v>3.2308262813474848</c:v>
                </c:pt>
                <c:pt idx="4689">
                  <c:v>3.2307894109934434</c:v>
                </c:pt>
                <c:pt idx="4690">
                  <c:v>3.2303225885973239</c:v>
                </c:pt>
                <c:pt idx="4691">
                  <c:v>3.2302686375612275</c:v>
                </c:pt>
                <c:pt idx="4692">
                  <c:v>3.2301834380667231</c:v>
                </c:pt>
                <c:pt idx="4693">
                  <c:v>3.2299106873094341</c:v>
                </c:pt>
                <c:pt idx="4694">
                  <c:v>3.2293049092051036</c:v>
                </c:pt>
                <c:pt idx="4695">
                  <c:v>3.2285215495376214</c:v>
                </c:pt>
                <c:pt idx="4696">
                  <c:v>3.2283989327271874</c:v>
                </c:pt>
                <c:pt idx="4697">
                  <c:v>3.228364707902871</c:v>
                </c:pt>
                <c:pt idx="4698">
                  <c:v>3.2275224983820161</c:v>
                </c:pt>
                <c:pt idx="4699">
                  <c:v>3.227448191368917</c:v>
                </c:pt>
                <c:pt idx="4700">
                  <c:v>3.2272008861025729</c:v>
                </c:pt>
                <c:pt idx="4701">
                  <c:v>3.2269162392984456</c:v>
                </c:pt>
                <c:pt idx="4702">
                  <c:v>3.2268604323755223</c:v>
                </c:pt>
                <c:pt idx="4703">
                  <c:v>3.2266414282469245</c:v>
                </c:pt>
                <c:pt idx="4704">
                  <c:v>3.2266342693854022</c:v>
                </c:pt>
                <c:pt idx="4705">
                  <c:v>3.2263048341258043</c:v>
                </c:pt>
                <c:pt idx="4706">
                  <c:v>3.2262862064085094</c:v>
                </c:pt>
                <c:pt idx="4707">
                  <c:v>3.2261185209890639</c:v>
                </c:pt>
                <c:pt idx="4708">
                  <c:v>3.2260611777860251</c:v>
                </c:pt>
                <c:pt idx="4709">
                  <c:v>3.2259679789295634</c:v>
                </c:pt>
                <c:pt idx="4710">
                  <c:v>3.2258589825891582</c:v>
                </c:pt>
                <c:pt idx="4711">
                  <c:v>3.2258016051047842</c:v>
                </c:pt>
                <c:pt idx="4712">
                  <c:v>3.2254701017543264</c:v>
                </c:pt>
                <c:pt idx="4713">
                  <c:v>3.2254270308000104</c:v>
                </c:pt>
                <c:pt idx="4714">
                  <c:v>3.225303537051865</c:v>
                </c:pt>
                <c:pt idx="4715">
                  <c:v>3.2252029929543489</c:v>
                </c:pt>
                <c:pt idx="4716">
                  <c:v>3.2250248291091301</c:v>
                </c:pt>
                <c:pt idx="4717">
                  <c:v>3.2244568033187635</c:v>
                </c:pt>
                <c:pt idx="4718">
                  <c:v>3.2244481693480687</c:v>
                </c:pt>
                <c:pt idx="4719">
                  <c:v>3.2241732315401275</c:v>
                </c:pt>
                <c:pt idx="4720">
                  <c:v>3.2234901722519442</c:v>
                </c:pt>
                <c:pt idx="4721">
                  <c:v>3.2227858140316368</c:v>
                </c:pt>
                <c:pt idx="4722">
                  <c:v>3.2226976888776218</c:v>
                </c:pt>
                <c:pt idx="4723">
                  <c:v>3.222658676952022</c:v>
                </c:pt>
                <c:pt idx="4724">
                  <c:v>3.2224201945654385</c:v>
                </c:pt>
                <c:pt idx="4725">
                  <c:v>3.2223941703809671</c:v>
                </c:pt>
                <c:pt idx="4726">
                  <c:v>3.2223464553255017</c:v>
                </c:pt>
                <c:pt idx="4727">
                  <c:v>3.2221135884826726</c:v>
                </c:pt>
                <c:pt idx="4728">
                  <c:v>3.2216054765836821</c:v>
                </c:pt>
                <c:pt idx="4729">
                  <c:v>3.22043063682352</c:v>
                </c:pt>
                <c:pt idx="4730">
                  <c:v>3.2192191134656665</c:v>
                </c:pt>
                <c:pt idx="4731">
                  <c:v>3.2190821864924892</c:v>
                </c:pt>
                <c:pt idx="4732">
                  <c:v>3.2190821864924892</c:v>
                </c:pt>
                <c:pt idx="4733">
                  <c:v>3.2185252939538889</c:v>
                </c:pt>
                <c:pt idx="4734">
                  <c:v>3.2179633044477383</c:v>
                </c:pt>
                <c:pt idx="4735">
                  <c:v>3.2174166745391251</c:v>
                </c:pt>
                <c:pt idx="4736">
                  <c:v>3.2171635887432886</c:v>
                </c:pt>
                <c:pt idx="4737">
                  <c:v>3.2168224942763568</c:v>
                </c:pt>
                <c:pt idx="4738">
                  <c:v>3.2168151717157056</c:v>
                </c:pt>
                <c:pt idx="4739">
                  <c:v>3.216673089602478</c:v>
                </c:pt>
                <c:pt idx="4740">
                  <c:v>3.2161820358576474</c:v>
                </c:pt>
                <c:pt idx="4741">
                  <c:v>3.2159810567918625</c:v>
                </c:pt>
                <c:pt idx="4742">
                  <c:v>3.2159473066610564</c:v>
                </c:pt>
                <c:pt idx="4743">
                  <c:v>3.2156801478758235</c:v>
                </c:pt>
                <c:pt idx="4744">
                  <c:v>3.215527411893166</c:v>
                </c:pt>
                <c:pt idx="4745">
                  <c:v>3.2154201708885268</c:v>
                </c:pt>
                <c:pt idx="4746">
                  <c:v>3.2147570393235281</c:v>
                </c:pt>
                <c:pt idx="4747">
                  <c:v>3.2141872023572566</c:v>
                </c:pt>
                <c:pt idx="4748">
                  <c:v>3.2140884724405634</c:v>
                </c:pt>
                <c:pt idx="4749">
                  <c:v>3.2138850475323824</c:v>
                </c:pt>
                <c:pt idx="4750">
                  <c:v>3.2138039458247851</c:v>
                </c:pt>
                <c:pt idx="4751">
                  <c:v>3.2134572496426261</c:v>
                </c:pt>
                <c:pt idx="4752">
                  <c:v>3.2132682943763555</c:v>
                </c:pt>
                <c:pt idx="4753">
                  <c:v>3.2132402393203359</c:v>
                </c:pt>
                <c:pt idx="4754">
                  <c:v>3.2131531094349528</c:v>
                </c:pt>
                <c:pt idx="4755">
                  <c:v>3.2129123037705809</c:v>
                </c:pt>
                <c:pt idx="4756">
                  <c:v>3.2127290247210851</c:v>
                </c:pt>
                <c:pt idx="4757">
                  <c:v>3.2126802358110855</c:v>
                </c:pt>
                <c:pt idx="4758">
                  <c:v>3.2125205246823563</c:v>
                </c:pt>
                <c:pt idx="4759">
                  <c:v>3.211667738630974</c:v>
                </c:pt>
                <c:pt idx="4760">
                  <c:v>3.2116632926505591</c:v>
                </c:pt>
                <c:pt idx="4761">
                  <c:v>3.2115061721200893</c:v>
                </c:pt>
                <c:pt idx="4762">
                  <c:v>3.2111160896722795</c:v>
                </c:pt>
                <c:pt idx="4763">
                  <c:v>3.2110418898576603</c:v>
                </c:pt>
                <c:pt idx="4764">
                  <c:v>3.2106796127693054</c:v>
                </c:pt>
                <c:pt idx="4765">
                  <c:v>3.2104047339010759</c:v>
                </c:pt>
                <c:pt idx="4766">
                  <c:v>3.2098827282970541</c:v>
                </c:pt>
                <c:pt idx="4767">
                  <c:v>3.2098604063795966</c:v>
                </c:pt>
                <c:pt idx="4768">
                  <c:v>3.2098008756567222</c:v>
                </c:pt>
                <c:pt idx="4769">
                  <c:v>3.2093466853668153</c:v>
                </c:pt>
                <c:pt idx="4770">
                  <c:v>3.2089844819994995</c:v>
                </c:pt>
                <c:pt idx="4771">
                  <c:v>3.2089472011351212</c:v>
                </c:pt>
                <c:pt idx="4772">
                  <c:v>3.2088427976861689</c:v>
                </c:pt>
                <c:pt idx="4773">
                  <c:v>3.2086682387257537</c:v>
                </c:pt>
                <c:pt idx="4774">
                  <c:v>3.208471216143753</c:v>
                </c:pt>
                <c:pt idx="4775">
                  <c:v>3.2082711169060305</c:v>
                </c:pt>
                <c:pt idx="4776">
                  <c:v>3.2081366701213696</c:v>
                </c:pt>
                <c:pt idx="4777">
                  <c:v>3.2074249029984108</c:v>
                </c:pt>
                <c:pt idx="4778">
                  <c:v>3.207123995225889</c:v>
                </c:pt>
                <c:pt idx="4779">
                  <c:v>3.2064360649610602</c:v>
                </c:pt>
                <c:pt idx="4780">
                  <c:v>3.2062755410330261</c:v>
                </c:pt>
                <c:pt idx="4781">
                  <c:v>3.2059873492580881</c:v>
                </c:pt>
                <c:pt idx="4782">
                  <c:v>3.2058582013188945</c:v>
                </c:pt>
                <c:pt idx="4783">
                  <c:v>3.2057996215705762</c:v>
                </c:pt>
                <c:pt idx="4784">
                  <c:v>3.2052224140502608</c:v>
                </c:pt>
                <c:pt idx="4785">
                  <c:v>3.2049801793367774</c:v>
                </c:pt>
                <c:pt idx="4786">
                  <c:v>3.2045269429998409</c:v>
                </c:pt>
                <c:pt idx="4787">
                  <c:v>3.2040370365531641</c:v>
                </c:pt>
                <c:pt idx="4788">
                  <c:v>3.2039299372446264</c:v>
                </c:pt>
                <c:pt idx="4789">
                  <c:v>3.2037382993436578</c:v>
                </c:pt>
                <c:pt idx="4790">
                  <c:v>3.2033079377273728</c:v>
                </c:pt>
                <c:pt idx="4791">
                  <c:v>3.2032671445034731</c:v>
                </c:pt>
                <c:pt idx="4792">
                  <c:v>3.2031447418365224</c:v>
                </c:pt>
                <c:pt idx="4793">
                  <c:v>3.202737996388628</c:v>
                </c:pt>
                <c:pt idx="4794">
                  <c:v>3.2020067116137527</c:v>
                </c:pt>
                <c:pt idx="4795">
                  <c:v>3.2013591863879616</c:v>
                </c:pt>
                <c:pt idx="4796">
                  <c:v>3.2012468706807153</c:v>
                </c:pt>
                <c:pt idx="4797">
                  <c:v>3.2010175957793852</c:v>
                </c:pt>
                <c:pt idx="4798">
                  <c:v>3.200838343023642</c:v>
                </c:pt>
                <c:pt idx="4799">
                  <c:v>3.2007897193516452</c:v>
                </c:pt>
                <c:pt idx="4800">
                  <c:v>3.2002955765243</c:v>
                </c:pt>
                <c:pt idx="4801">
                  <c:v>3.1993086504907851</c:v>
                </c:pt>
                <c:pt idx="4802">
                  <c:v>3.1990569912260081</c:v>
                </c:pt>
                <c:pt idx="4803">
                  <c:v>3.1989456045183777</c:v>
                </c:pt>
                <c:pt idx="4804">
                  <c:v>3.1988265570054604</c:v>
                </c:pt>
                <c:pt idx="4805">
                  <c:v>3.1987654943380832</c:v>
                </c:pt>
                <c:pt idx="4806">
                  <c:v>3.1979861918174577</c:v>
                </c:pt>
                <c:pt idx="4807">
                  <c:v>3.1971196785231486</c:v>
                </c:pt>
                <c:pt idx="4808">
                  <c:v>3.1970767672288023</c:v>
                </c:pt>
                <c:pt idx="4809">
                  <c:v>3.1969970635744693</c:v>
                </c:pt>
                <c:pt idx="4810">
                  <c:v>3.1963389496948071</c:v>
                </c:pt>
                <c:pt idx="4811">
                  <c:v>3.1960471583907495</c:v>
                </c:pt>
                <c:pt idx="4812">
                  <c:v>3.1957044372772758</c:v>
                </c:pt>
                <c:pt idx="4813">
                  <c:v>3.1950751553199339</c:v>
                </c:pt>
                <c:pt idx="4814">
                  <c:v>3.194700846495846</c:v>
                </c:pt>
                <c:pt idx="4815">
                  <c:v>3.1945729222066106</c:v>
                </c:pt>
                <c:pt idx="4816">
                  <c:v>3.1945451746169877</c:v>
                </c:pt>
                <c:pt idx="4817">
                  <c:v>3.1939651526320341</c:v>
                </c:pt>
                <c:pt idx="4818">
                  <c:v>3.1938153935169322</c:v>
                </c:pt>
                <c:pt idx="4819">
                  <c:v>3.1934492698464152</c:v>
                </c:pt>
                <c:pt idx="4820">
                  <c:v>3.193189552073286</c:v>
                </c:pt>
                <c:pt idx="4821">
                  <c:v>3.1929497936764633</c:v>
                </c:pt>
                <c:pt idx="4822">
                  <c:v>3.1927547957231908</c:v>
                </c:pt>
                <c:pt idx="4823">
                  <c:v>3.1926340388135483</c:v>
                </c:pt>
                <c:pt idx="4824">
                  <c:v>3.1920979683564923</c:v>
                </c:pt>
                <c:pt idx="4825">
                  <c:v>3.1918793219877126</c:v>
                </c:pt>
                <c:pt idx="4826">
                  <c:v>3.1917707332418104</c:v>
                </c:pt>
                <c:pt idx="4827">
                  <c:v>3.1917428060323982</c:v>
                </c:pt>
                <c:pt idx="4828">
                  <c:v>3.1916559098945259</c:v>
                </c:pt>
                <c:pt idx="4829">
                  <c:v>3.1915845179150937</c:v>
                </c:pt>
                <c:pt idx="4830">
                  <c:v>3.1910922146922669</c:v>
                </c:pt>
                <c:pt idx="4831">
                  <c:v>3.1909912002537015</c:v>
                </c:pt>
                <c:pt idx="4832">
                  <c:v>3.190958559797445</c:v>
                </c:pt>
                <c:pt idx="4833">
                  <c:v>3.1909336892317142</c:v>
                </c:pt>
                <c:pt idx="4834">
                  <c:v>3.1908901623142829</c:v>
                </c:pt>
                <c:pt idx="4835">
                  <c:v>3.1907284527021367</c:v>
                </c:pt>
                <c:pt idx="4836">
                  <c:v>3.1900778964233116</c:v>
                </c:pt>
                <c:pt idx="4837">
                  <c:v>3.1900358413202787</c:v>
                </c:pt>
                <c:pt idx="4838">
                  <c:v>3.1898925118634702</c:v>
                </c:pt>
                <c:pt idx="4839">
                  <c:v>3.1896197436746632</c:v>
                </c:pt>
                <c:pt idx="4840">
                  <c:v>3.1894731574339756</c:v>
                </c:pt>
                <c:pt idx="4841">
                  <c:v>3.1894060855292286</c:v>
                </c:pt>
                <c:pt idx="4842">
                  <c:v>3.189231337971731</c:v>
                </c:pt>
                <c:pt idx="4843">
                  <c:v>3.1891080362306963</c:v>
                </c:pt>
                <c:pt idx="4844">
                  <c:v>3.189051836482423</c:v>
                </c:pt>
                <c:pt idx="4845">
                  <c:v>3.1889331686814515</c:v>
                </c:pt>
                <c:pt idx="4846">
                  <c:v>3.1888925643571762</c:v>
                </c:pt>
                <c:pt idx="4847">
                  <c:v>3.188823840697312</c:v>
                </c:pt>
                <c:pt idx="4848">
                  <c:v>3.1885363329615384</c:v>
                </c:pt>
                <c:pt idx="4849">
                  <c:v>3.1884831856912341</c:v>
                </c:pt>
                <c:pt idx="4850">
                  <c:v>3.1884175242000765</c:v>
                </c:pt>
                <c:pt idx="4851">
                  <c:v>3.1884112702069394</c:v>
                </c:pt>
                <c:pt idx="4852">
                  <c:v>3.1878323860418019</c:v>
                </c:pt>
                <c:pt idx="4853">
                  <c:v>3.187384394897018</c:v>
                </c:pt>
                <c:pt idx="4854">
                  <c:v>3.1871508176889281</c:v>
                </c:pt>
                <c:pt idx="4855">
                  <c:v>3.1869971212128587</c:v>
                </c:pt>
                <c:pt idx="4856">
                  <c:v>3.1869124080687672</c:v>
                </c:pt>
                <c:pt idx="4857">
                  <c:v>3.1865812407845802</c:v>
                </c:pt>
                <c:pt idx="4858">
                  <c:v>3.1861571035690321</c:v>
                </c:pt>
                <c:pt idx="4859">
                  <c:v>3.1859165751525547</c:v>
                </c:pt>
                <c:pt idx="4860">
                  <c:v>3.1858725424563898</c:v>
                </c:pt>
                <c:pt idx="4861">
                  <c:v>3.1858458061411503</c:v>
                </c:pt>
                <c:pt idx="4862">
                  <c:v>3.1857246857446078</c:v>
                </c:pt>
                <c:pt idx="4863">
                  <c:v>3.1857168196157248</c:v>
                </c:pt>
                <c:pt idx="4864">
                  <c:v>3.1856302827933756</c:v>
                </c:pt>
                <c:pt idx="4865">
                  <c:v>3.1849657350220197</c:v>
                </c:pt>
                <c:pt idx="4866">
                  <c:v>3.1841675646329168</c:v>
                </c:pt>
                <c:pt idx="4867">
                  <c:v>3.1835497903155243</c:v>
                </c:pt>
                <c:pt idx="4868">
                  <c:v>3.1826270237035703</c:v>
                </c:pt>
                <c:pt idx="4869">
                  <c:v>3.1825921639034114</c:v>
                </c:pt>
                <c:pt idx="4870">
                  <c:v>3.1824431859572413</c:v>
                </c:pt>
                <c:pt idx="4871">
                  <c:v>3.1823670923970644</c:v>
                </c:pt>
                <c:pt idx="4872">
                  <c:v>3.182010226002745</c:v>
                </c:pt>
                <c:pt idx="4873">
                  <c:v>3.181394140041899</c:v>
                </c:pt>
                <c:pt idx="4874">
                  <c:v>3.1810873591140671</c:v>
                </c:pt>
                <c:pt idx="4875">
                  <c:v>3.1803903362529771</c:v>
                </c:pt>
                <c:pt idx="4876">
                  <c:v>3.1803409611685676</c:v>
                </c:pt>
                <c:pt idx="4877">
                  <c:v>3.1800254652293898</c:v>
                </c:pt>
                <c:pt idx="4878">
                  <c:v>3.1800063368951803</c:v>
                </c:pt>
                <c:pt idx="4879">
                  <c:v>3.1797671616044654</c:v>
                </c:pt>
                <c:pt idx="4880">
                  <c:v>3.1796570967239126</c:v>
                </c:pt>
                <c:pt idx="4881">
                  <c:v>3.1788858605325663</c:v>
                </c:pt>
                <c:pt idx="4882">
                  <c:v>3.1788411091607802</c:v>
                </c:pt>
                <c:pt idx="4883">
                  <c:v>3.1787356055354148</c:v>
                </c:pt>
                <c:pt idx="4884">
                  <c:v>3.1786428690651767</c:v>
                </c:pt>
                <c:pt idx="4885">
                  <c:v>3.1783965416124262</c:v>
                </c:pt>
                <c:pt idx="4886">
                  <c:v>3.1778858470074871</c:v>
                </c:pt>
                <c:pt idx="4887">
                  <c:v>3.1778650222609683</c:v>
                </c:pt>
                <c:pt idx="4888">
                  <c:v>3.1778313801762907</c:v>
                </c:pt>
                <c:pt idx="4889">
                  <c:v>3.1775845918940222</c:v>
                </c:pt>
                <c:pt idx="4890">
                  <c:v>3.1770681264210419</c:v>
                </c:pt>
                <c:pt idx="4891">
                  <c:v>3.1767261514988134</c:v>
                </c:pt>
                <c:pt idx="4892">
                  <c:v>3.1758289946955074</c:v>
                </c:pt>
                <c:pt idx="4893">
                  <c:v>3.1754489936415653</c:v>
                </c:pt>
                <c:pt idx="4894">
                  <c:v>3.1750863946286034</c:v>
                </c:pt>
                <c:pt idx="4895">
                  <c:v>3.1749057879797316</c:v>
                </c:pt>
                <c:pt idx="4896">
                  <c:v>3.1746815377282376</c:v>
                </c:pt>
                <c:pt idx="4897">
                  <c:v>3.1744620152820779</c:v>
                </c:pt>
                <c:pt idx="4898">
                  <c:v>3.1742294587427424</c:v>
                </c:pt>
                <c:pt idx="4899">
                  <c:v>3.1741567592784814</c:v>
                </c:pt>
                <c:pt idx="4900">
                  <c:v>3.173982230896006</c:v>
                </c:pt>
                <c:pt idx="4901">
                  <c:v>3.1738448212553041</c:v>
                </c:pt>
                <c:pt idx="4902">
                  <c:v>3.1728833549379334</c:v>
                </c:pt>
                <c:pt idx="4903">
                  <c:v>3.1728396013077163</c:v>
                </c:pt>
                <c:pt idx="4904">
                  <c:v>3.1725332024093404</c:v>
                </c:pt>
                <c:pt idx="4905">
                  <c:v>3.172372621435855</c:v>
                </c:pt>
                <c:pt idx="4906">
                  <c:v>3.1720577753284811</c:v>
                </c:pt>
                <c:pt idx="4907">
                  <c:v>3.1710614238125663</c:v>
                </c:pt>
                <c:pt idx="4908">
                  <c:v>3.1709881920458649</c:v>
                </c:pt>
                <c:pt idx="4909">
                  <c:v>3.170908436742514</c:v>
                </c:pt>
                <c:pt idx="4910">
                  <c:v>3.170737483185126</c:v>
                </c:pt>
                <c:pt idx="4911">
                  <c:v>3.1706609393087319</c:v>
                </c:pt>
                <c:pt idx="4912">
                  <c:v>3.1702405218288012</c:v>
                </c:pt>
                <c:pt idx="4913">
                  <c:v>3.1696483142246796</c:v>
                </c:pt>
                <c:pt idx="4914">
                  <c:v>3.1682993770151735</c:v>
                </c:pt>
                <c:pt idx="4915">
                  <c:v>3.1681421372886849</c:v>
                </c:pt>
                <c:pt idx="4916">
                  <c:v>3.1681126485010198</c:v>
                </c:pt>
                <c:pt idx="4917">
                  <c:v>3.1680389177705974</c:v>
                </c:pt>
                <c:pt idx="4918">
                  <c:v>3.1671203311240661</c:v>
                </c:pt>
                <c:pt idx="4919">
                  <c:v>3.1670447893678717</c:v>
                </c:pt>
                <c:pt idx="4920">
                  <c:v>3.1666323625138357</c:v>
                </c:pt>
                <c:pt idx="4921">
                  <c:v>3.1666257868027605</c:v>
                </c:pt>
                <c:pt idx="4922">
                  <c:v>3.1664597170934838</c:v>
                </c:pt>
                <c:pt idx="4923">
                  <c:v>3.1664070876979706</c:v>
                </c:pt>
                <c:pt idx="4924">
                  <c:v>3.1663988637787694</c:v>
                </c:pt>
                <c:pt idx="4925">
                  <c:v>3.1663264865739169</c:v>
                </c:pt>
                <c:pt idx="4926">
                  <c:v>3.1661438450105335</c:v>
                </c:pt>
                <c:pt idx="4927">
                  <c:v>3.1660483801183692</c:v>
                </c:pt>
                <c:pt idx="4928">
                  <c:v>3.1658540936414927</c:v>
                </c:pt>
                <c:pt idx="4929">
                  <c:v>3.1656383008663735</c:v>
                </c:pt>
                <c:pt idx="4930">
                  <c:v>3.1652327817272745</c:v>
                </c:pt>
                <c:pt idx="4931">
                  <c:v>3.1649770771108856</c:v>
                </c:pt>
                <c:pt idx="4932">
                  <c:v>3.1648681507168606</c:v>
                </c:pt>
                <c:pt idx="4933">
                  <c:v>3.1644222580326544</c:v>
                </c:pt>
                <c:pt idx="4934">
                  <c:v>3.1642074055767742</c:v>
                </c:pt>
                <c:pt idx="4935">
                  <c:v>3.1639874849334451</c:v>
                </c:pt>
                <c:pt idx="4936">
                  <c:v>3.163984177006034</c:v>
                </c:pt>
                <c:pt idx="4937">
                  <c:v>3.1639295925657938</c:v>
                </c:pt>
                <c:pt idx="4938">
                  <c:v>3.163916358940992</c:v>
                </c:pt>
                <c:pt idx="4939">
                  <c:v>3.1637641432651789</c:v>
                </c:pt>
                <c:pt idx="4940">
                  <c:v>3.1632243404608289</c:v>
                </c:pt>
                <c:pt idx="4941">
                  <c:v>3.1629077636412175</c:v>
                </c:pt>
                <c:pt idx="4942">
                  <c:v>3.1628729426806257</c:v>
                </c:pt>
                <c:pt idx="4943">
                  <c:v>3.1624332952467453</c:v>
                </c:pt>
                <c:pt idx="4944">
                  <c:v>3.1623469725468492</c:v>
                </c:pt>
                <c:pt idx="4945">
                  <c:v>3.1616441323791231</c:v>
                </c:pt>
                <c:pt idx="4946">
                  <c:v>3.1615044258152127</c:v>
                </c:pt>
                <c:pt idx="4947">
                  <c:v>3.1614778099449516</c:v>
                </c:pt>
                <c:pt idx="4948">
                  <c:v>3.1610583946849471</c:v>
                </c:pt>
                <c:pt idx="4949">
                  <c:v>3.1607785593170026</c:v>
                </c:pt>
                <c:pt idx="4950">
                  <c:v>3.1606385739875535</c:v>
                </c:pt>
                <c:pt idx="4951">
                  <c:v>3.1604835375799469</c:v>
                </c:pt>
                <c:pt idx="4952">
                  <c:v>3.1600247725298889</c:v>
                </c:pt>
                <c:pt idx="4953">
                  <c:v>3.1599730267901185</c:v>
                </c:pt>
                <c:pt idx="4954">
                  <c:v>3.1593566116222265</c:v>
                </c:pt>
                <c:pt idx="4955">
                  <c:v>3.1589819920106312</c:v>
                </c:pt>
                <c:pt idx="4956">
                  <c:v>3.15859700140579</c:v>
                </c:pt>
                <c:pt idx="4957">
                  <c:v>3.1579417331109254</c:v>
                </c:pt>
                <c:pt idx="4958">
                  <c:v>3.1577437851417041</c:v>
                </c:pt>
                <c:pt idx="4959">
                  <c:v>3.157676663654168</c:v>
                </c:pt>
                <c:pt idx="4960">
                  <c:v>3.1573896022692751</c:v>
                </c:pt>
                <c:pt idx="4961">
                  <c:v>3.1573241055481693</c:v>
                </c:pt>
                <c:pt idx="4962">
                  <c:v>3.1567560531519523</c:v>
                </c:pt>
                <c:pt idx="4963">
                  <c:v>3.1565424211621393</c:v>
                </c:pt>
                <c:pt idx="4964">
                  <c:v>3.1564414560999836</c:v>
                </c:pt>
                <c:pt idx="4965">
                  <c:v>3.1560373609632957</c:v>
                </c:pt>
                <c:pt idx="4966">
                  <c:v>3.1559463877173135</c:v>
                </c:pt>
                <c:pt idx="4967">
                  <c:v>3.1548143684327807</c:v>
                </c:pt>
                <c:pt idx="4968">
                  <c:v>3.1547687559189583</c:v>
                </c:pt>
                <c:pt idx="4969">
                  <c:v>3.1547028627182612</c:v>
                </c:pt>
                <c:pt idx="4970">
                  <c:v>3.1545879480911272</c:v>
                </c:pt>
                <c:pt idx="4971">
                  <c:v>3.1535252381371275</c:v>
                </c:pt>
                <c:pt idx="4972">
                  <c:v>3.1532337232325558</c:v>
                </c:pt>
                <c:pt idx="4973">
                  <c:v>3.153028528576292</c:v>
                </c:pt>
                <c:pt idx="4974">
                  <c:v>3.1530013881396495</c:v>
                </c:pt>
                <c:pt idx="4975">
                  <c:v>3.1522968398884195</c:v>
                </c:pt>
                <c:pt idx="4976">
                  <c:v>3.1519619911970036</c:v>
                </c:pt>
                <c:pt idx="4977">
                  <c:v>3.1517919184021612</c:v>
                </c:pt>
                <c:pt idx="4978">
                  <c:v>3.1515468965124085</c:v>
                </c:pt>
                <c:pt idx="4979">
                  <c:v>3.1508502114263846</c:v>
                </c:pt>
                <c:pt idx="4980">
                  <c:v>3.1508297539023755</c:v>
                </c:pt>
                <c:pt idx="4981">
                  <c:v>3.1506626480429847</c:v>
                </c:pt>
                <c:pt idx="4982">
                  <c:v>3.1505432473363171</c:v>
                </c:pt>
                <c:pt idx="4983">
                  <c:v>3.14992354233725</c:v>
                </c:pt>
                <c:pt idx="4984">
                  <c:v>3.1490051639432823</c:v>
                </c:pt>
                <c:pt idx="4985">
                  <c:v>3.147956147085849</c:v>
                </c:pt>
                <c:pt idx="4986">
                  <c:v>3.1477055166414933</c:v>
                </c:pt>
                <c:pt idx="4987">
                  <c:v>3.1475200256651203</c:v>
                </c:pt>
                <c:pt idx="4988">
                  <c:v>3.147427250459164</c:v>
                </c:pt>
                <c:pt idx="4989">
                  <c:v>3.1472313265825345</c:v>
                </c:pt>
                <c:pt idx="4990">
                  <c:v>3.1470851854482436</c:v>
                </c:pt>
                <c:pt idx="4991">
                  <c:v>3.1470387538534723</c:v>
                </c:pt>
                <c:pt idx="4992">
                  <c:v>3.1470163961298399</c:v>
                </c:pt>
                <c:pt idx="4993">
                  <c:v>3.1469527563082207</c:v>
                </c:pt>
                <c:pt idx="4994">
                  <c:v>3.1468065213885064</c:v>
                </c:pt>
                <c:pt idx="4995">
                  <c:v>3.1467290829624659</c:v>
                </c:pt>
                <c:pt idx="4996">
                  <c:v>3.1466619584889979</c:v>
                </c:pt>
                <c:pt idx="4997">
                  <c:v>3.1466292530636815</c:v>
                </c:pt>
                <c:pt idx="4998">
                  <c:v>3.1465104600120131</c:v>
                </c:pt>
                <c:pt idx="4999">
                  <c:v>3.1462228118300448</c:v>
                </c:pt>
                <c:pt idx="5000">
                  <c:v>3.1461004605500085</c:v>
                </c:pt>
                <c:pt idx="5001">
                  <c:v>3.1460263437160862</c:v>
                </c:pt>
                <c:pt idx="5002">
                  <c:v>3.1447384854792855</c:v>
                </c:pt>
                <c:pt idx="5003">
                  <c:v>3.1446105270153173</c:v>
                </c:pt>
                <c:pt idx="5004">
                  <c:v>3.1445223174749106</c:v>
                </c:pt>
                <c:pt idx="5005">
                  <c:v>3.1441052416162902</c:v>
                </c:pt>
                <c:pt idx="5006">
                  <c:v>3.144101778729516</c:v>
                </c:pt>
                <c:pt idx="5007">
                  <c:v>3.1440602219343736</c:v>
                </c:pt>
                <c:pt idx="5008">
                  <c:v>3.1438852934959125</c:v>
                </c:pt>
                <c:pt idx="5009">
                  <c:v>3.143791738485985</c:v>
                </c:pt>
                <c:pt idx="5010">
                  <c:v>3.1437137605797543</c:v>
                </c:pt>
                <c:pt idx="5011">
                  <c:v>3.1436894979309162</c:v>
                </c:pt>
                <c:pt idx="5012">
                  <c:v>3.1431970198973307</c:v>
                </c:pt>
                <c:pt idx="5013">
                  <c:v>3.1427751952470273</c:v>
                </c:pt>
                <c:pt idx="5014">
                  <c:v>3.1426883492035715</c:v>
                </c:pt>
                <c:pt idx="5015">
                  <c:v>3.1425980108920646</c:v>
                </c:pt>
                <c:pt idx="5016">
                  <c:v>3.1425736858279594</c:v>
                </c:pt>
                <c:pt idx="5017">
                  <c:v>3.1424659441637295</c:v>
                </c:pt>
                <c:pt idx="5018">
                  <c:v>3.1419494558137444</c:v>
                </c:pt>
                <c:pt idx="5019">
                  <c:v>3.1399245415768506</c:v>
                </c:pt>
                <c:pt idx="5020">
                  <c:v>3.1395730142643976</c:v>
                </c:pt>
                <c:pt idx="5021">
                  <c:v>3.1392071938179429</c:v>
                </c:pt>
                <c:pt idx="5022">
                  <c:v>3.1390373063718791</c:v>
                </c:pt>
                <c:pt idx="5023">
                  <c:v>3.139009277314222</c:v>
                </c:pt>
                <c:pt idx="5024">
                  <c:v>3.1387218751262256</c:v>
                </c:pt>
                <c:pt idx="5025">
                  <c:v>3.1385325063522234</c:v>
                </c:pt>
                <c:pt idx="5026">
                  <c:v>3.1385307525517754</c:v>
                </c:pt>
                <c:pt idx="5027">
                  <c:v>3.1382869053525231</c:v>
                </c:pt>
                <c:pt idx="5028">
                  <c:v>3.1378479863833948</c:v>
                </c:pt>
                <c:pt idx="5029">
                  <c:v>3.1376160581019197</c:v>
                </c:pt>
                <c:pt idx="5030">
                  <c:v>3.1375000474979919</c:v>
                </c:pt>
                <c:pt idx="5031">
                  <c:v>3.1373945564143555</c:v>
                </c:pt>
                <c:pt idx="5032">
                  <c:v>3.136981136106721</c:v>
                </c:pt>
                <c:pt idx="5033">
                  <c:v>3.1369547342098678</c:v>
                </c:pt>
                <c:pt idx="5034">
                  <c:v>3.1369248101196567</c:v>
                </c:pt>
                <c:pt idx="5035">
                  <c:v>3.136394635965984</c:v>
                </c:pt>
                <c:pt idx="5036">
                  <c:v>3.134791374321193</c:v>
                </c:pt>
                <c:pt idx="5037">
                  <c:v>3.1346569117988854</c:v>
                </c:pt>
                <c:pt idx="5038">
                  <c:v>3.1342692144390814</c:v>
                </c:pt>
                <c:pt idx="5039">
                  <c:v>3.1336595289742157</c:v>
                </c:pt>
                <c:pt idx="5040">
                  <c:v>3.1328997699444829</c:v>
                </c:pt>
                <c:pt idx="5041">
                  <c:v>3.1323806658984812</c:v>
                </c:pt>
                <c:pt idx="5042">
                  <c:v>3.1321422390564218</c:v>
                </c:pt>
                <c:pt idx="5043">
                  <c:v>3.1321297803246311</c:v>
                </c:pt>
                <c:pt idx="5044">
                  <c:v>3.13199093027103</c:v>
                </c:pt>
                <c:pt idx="5045">
                  <c:v>3.1316133184954227</c:v>
                </c:pt>
                <c:pt idx="5046">
                  <c:v>3.1315705492967023</c:v>
                </c:pt>
                <c:pt idx="5047">
                  <c:v>3.1313602061185484</c:v>
                </c:pt>
                <c:pt idx="5048">
                  <c:v>3.1310605585921341</c:v>
                </c:pt>
                <c:pt idx="5049">
                  <c:v>3.1309945370017078</c:v>
                </c:pt>
                <c:pt idx="5050">
                  <c:v>3.1307249934284975</c:v>
                </c:pt>
                <c:pt idx="5051">
                  <c:v>3.1301979185230198</c:v>
                </c:pt>
                <c:pt idx="5052">
                  <c:v>3.1298241118381305</c:v>
                </c:pt>
                <c:pt idx="5053">
                  <c:v>3.1297292675928023</c:v>
                </c:pt>
                <c:pt idx="5054">
                  <c:v>3.1296039698561771</c:v>
                </c:pt>
                <c:pt idx="5055">
                  <c:v>3.129569954231965</c:v>
                </c:pt>
                <c:pt idx="5056">
                  <c:v>3.1294643097823771</c:v>
                </c:pt>
                <c:pt idx="5057">
                  <c:v>3.1293640133071388</c:v>
                </c:pt>
                <c:pt idx="5058">
                  <c:v>3.1291651428815714</c:v>
                </c:pt>
                <c:pt idx="5059">
                  <c:v>3.1289518382563415</c:v>
                </c:pt>
                <c:pt idx="5060">
                  <c:v>3.1287348412051119</c:v>
                </c:pt>
                <c:pt idx="5061">
                  <c:v>3.1285177356761964</c:v>
                </c:pt>
                <c:pt idx="5062">
                  <c:v>3.1280724195829337</c:v>
                </c:pt>
                <c:pt idx="5063">
                  <c:v>3.1269373142216477</c:v>
                </c:pt>
                <c:pt idx="5064">
                  <c:v>3.1269120959605594</c:v>
                </c:pt>
                <c:pt idx="5065">
                  <c:v>3.1267157036857394</c:v>
                </c:pt>
                <c:pt idx="5066">
                  <c:v>3.1267120993279058</c:v>
                </c:pt>
                <c:pt idx="5067">
                  <c:v>3.1265697032608872</c:v>
                </c:pt>
                <c:pt idx="5068">
                  <c:v>3.1262144108236334</c:v>
                </c:pt>
                <c:pt idx="5069">
                  <c:v>3.1261043374529001</c:v>
                </c:pt>
                <c:pt idx="5070">
                  <c:v>3.12606824174927</c:v>
                </c:pt>
                <c:pt idx="5071">
                  <c:v>3.1259707683616225</c:v>
                </c:pt>
                <c:pt idx="5072">
                  <c:v>3.1254866875703939</c:v>
                </c:pt>
                <c:pt idx="5073">
                  <c:v>3.125101566510315</c:v>
                </c:pt>
                <c:pt idx="5074">
                  <c:v>3.124750501545599</c:v>
                </c:pt>
                <c:pt idx="5075">
                  <c:v>3.1245929729797517</c:v>
                </c:pt>
                <c:pt idx="5076">
                  <c:v>3.124371974565018</c:v>
                </c:pt>
                <c:pt idx="5077">
                  <c:v>3.1242958671142884</c:v>
                </c:pt>
                <c:pt idx="5078">
                  <c:v>3.1242541835721651</c:v>
                </c:pt>
                <c:pt idx="5079">
                  <c:v>3.1234832233417626</c:v>
                </c:pt>
                <c:pt idx="5080">
                  <c:v>3.1230763305167737</c:v>
                </c:pt>
                <c:pt idx="5081">
                  <c:v>3.1230527044927658</c:v>
                </c:pt>
                <c:pt idx="5082">
                  <c:v>3.1228709228644358</c:v>
                </c:pt>
                <c:pt idx="5083">
                  <c:v>3.1226199392001823</c:v>
                </c:pt>
                <c:pt idx="5084">
                  <c:v>3.1225162296916027</c:v>
                </c:pt>
                <c:pt idx="5085">
                  <c:v>3.1223524273957572</c:v>
                </c:pt>
                <c:pt idx="5086">
                  <c:v>3.1222850685274701</c:v>
                </c:pt>
                <c:pt idx="5087">
                  <c:v>3.1210616901411989</c:v>
                </c:pt>
                <c:pt idx="5088">
                  <c:v>3.1208955117328743</c:v>
                </c:pt>
                <c:pt idx="5089">
                  <c:v>3.1208608071165362</c:v>
                </c:pt>
                <c:pt idx="5090">
                  <c:v>3.1205830703033324</c:v>
                </c:pt>
                <c:pt idx="5091">
                  <c:v>3.1203380759777155</c:v>
                </c:pt>
                <c:pt idx="5092">
                  <c:v>3.1202941817998804</c:v>
                </c:pt>
                <c:pt idx="5093">
                  <c:v>3.1202704039344105</c:v>
                </c:pt>
                <c:pt idx="5094">
                  <c:v>3.1201825974595256</c:v>
                </c:pt>
                <c:pt idx="5095">
                  <c:v>3.1198659809108311</c:v>
                </c:pt>
                <c:pt idx="5096">
                  <c:v>3.1197982352596334</c:v>
                </c:pt>
                <c:pt idx="5097">
                  <c:v>3.1193347180855766</c:v>
                </c:pt>
                <c:pt idx="5098">
                  <c:v>3.1186596269450297</c:v>
                </c:pt>
                <c:pt idx="5099">
                  <c:v>3.1184043599848037</c:v>
                </c:pt>
                <c:pt idx="5100">
                  <c:v>3.1179742908052046</c:v>
                </c:pt>
                <c:pt idx="5101">
                  <c:v>3.1176910212743421</c:v>
                </c:pt>
                <c:pt idx="5102">
                  <c:v>3.1170299538980095</c:v>
                </c:pt>
                <c:pt idx="5103">
                  <c:v>3.1163401934476358</c:v>
                </c:pt>
                <c:pt idx="5104">
                  <c:v>3.1161445004342254</c:v>
                </c:pt>
                <c:pt idx="5105">
                  <c:v>3.116103873850919</c:v>
                </c:pt>
                <c:pt idx="5106">
                  <c:v>3.1155014159191197</c:v>
                </c:pt>
                <c:pt idx="5107">
                  <c:v>3.1153404958907638</c:v>
                </c:pt>
                <c:pt idx="5108">
                  <c:v>3.1153293957595971</c:v>
                </c:pt>
                <c:pt idx="5109">
                  <c:v>3.1151647104892342</c:v>
                </c:pt>
                <c:pt idx="5110">
                  <c:v>3.1150518002351717</c:v>
                </c:pt>
                <c:pt idx="5111">
                  <c:v>3.114833300327073</c:v>
                </c:pt>
                <c:pt idx="5112">
                  <c:v>3.1148277438114618</c:v>
                </c:pt>
                <c:pt idx="5113">
                  <c:v>3.1148221872247577</c:v>
                </c:pt>
                <c:pt idx="5114">
                  <c:v>3.114779584364634</c:v>
                </c:pt>
                <c:pt idx="5115">
                  <c:v>3.1142902780968931</c:v>
                </c:pt>
                <c:pt idx="5116">
                  <c:v>3.1138635387223648</c:v>
                </c:pt>
                <c:pt idx="5117">
                  <c:v>3.113859826105617</c:v>
                </c:pt>
                <c:pt idx="5118">
                  <c:v>3.1135664290458482</c:v>
                </c:pt>
                <c:pt idx="5119">
                  <c:v>3.1134177979507736</c:v>
                </c:pt>
                <c:pt idx="5120">
                  <c:v>3.1130683145223275</c:v>
                </c:pt>
                <c:pt idx="5121">
                  <c:v>3.1129604383763754</c:v>
                </c:pt>
                <c:pt idx="5122">
                  <c:v>3.1128785834219297</c:v>
                </c:pt>
                <c:pt idx="5123">
                  <c:v>3.1126813240191122</c:v>
                </c:pt>
                <c:pt idx="5124">
                  <c:v>3.1125454234451877</c:v>
                </c:pt>
                <c:pt idx="5125">
                  <c:v>3.1125063208818089</c:v>
                </c:pt>
                <c:pt idx="5126">
                  <c:v>3.1122492735565945</c:v>
                </c:pt>
                <c:pt idx="5127">
                  <c:v>3.1113502750037818</c:v>
                </c:pt>
                <c:pt idx="5128">
                  <c:v>3.1113260023634988</c:v>
                </c:pt>
                <c:pt idx="5129">
                  <c:v>3.1110178086073996</c:v>
                </c:pt>
                <c:pt idx="5130">
                  <c:v>3.11070004673183</c:v>
                </c:pt>
                <c:pt idx="5131">
                  <c:v>3.1105560427553813</c:v>
                </c:pt>
                <c:pt idx="5132">
                  <c:v>3.110389537087995</c:v>
                </c:pt>
                <c:pt idx="5133">
                  <c:v>3.1101967597944054</c:v>
                </c:pt>
                <c:pt idx="5134">
                  <c:v>3.109627286535424</c:v>
                </c:pt>
                <c:pt idx="5135">
                  <c:v>3.1093891602714234</c:v>
                </c:pt>
                <c:pt idx="5136">
                  <c:v>3.1093572751915133</c:v>
                </c:pt>
                <c:pt idx="5137">
                  <c:v>3.1091546564601047</c:v>
                </c:pt>
                <c:pt idx="5138">
                  <c:v>3.1090927263211694</c:v>
                </c:pt>
                <c:pt idx="5139">
                  <c:v>3.1089951215101306</c:v>
                </c:pt>
                <c:pt idx="5140">
                  <c:v>3.1086533318216181</c:v>
                </c:pt>
                <c:pt idx="5141">
                  <c:v>3.1083996326283088</c:v>
                </c:pt>
                <c:pt idx="5142">
                  <c:v>3.1076658902549839</c:v>
                </c:pt>
                <c:pt idx="5143">
                  <c:v>3.107407845224782</c:v>
                </c:pt>
                <c:pt idx="5144">
                  <c:v>3.107407845224782</c:v>
                </c:pt>
                <c:pt idx="5145">
                  <c:v>3.1071081699485541</c:v>
                </c:pt>
                <c:pt idx="5146">
                  <c:v>3.106413787716094</c:v>
                </c:pt>
                <c:pt idx="5147">
                  <c:v>3.106217347875067</c:v>
                </c:pt>
                <c:pt idx="5148">
                  <c:v>3.1061927866462451</c:v>
                </c:pt>
                <c:pt idx="5149">
                  <c:v>3.1061304326724608</c:v>
                </c:pt>
                <c:pt idx="5150">
                  <c:v>3.1055026153012744</c:v>
                </c:pt>
                <c:pt idx="5151">
                  <c:v>3.1054685510593858</c:v>
                </c:pt>
                <c:pt idx="5152">
                  <c:v>3.1053341604889328</c:v>
                </c:pt>
                <c:pt idx="5153">
                  <c:v>3.1049383185203467</c:v>
                </c:pt>
                <c:pt idx="5154">
                  <c:v>3.1045971125792029</c:v>
                </c:pt>
                <c:pt idx="5155">
                  <c:v>3.1045060790359322</c:v>
                </c:pt>
                <c:pt idx="5156">
                  <c:v>3.1043277497205186</c:v>
                </c:pt>
                <c:pt idx="5157">
                  <c:v>3.1041797187206521</c:v>
                </c:pt>
                <c:pt idx="5158">
                  <c:v>3.1041132781503404</c:v>
                </c:pt>
                <c:pt idx="5159">
                  <c:v>3.1039556784389291</c:v>
                </c:pt>
                <c:pt idx="5160">
                  <c:v>3.1038436149421313</c:v>
                </c:pt>
                <c:pt idx="5161">
                  <c:v>3.1033018836921831</c:v>
                </c:pt>
                <c:pt idx="5162">
                  <c:v>3.103067874976507</c:v>
                </c:pt>
                <c:pt idx="5163">
                  <c:v>3.1029784237058675</c:v>
                </c:pt>
                <c:pt idx="5164">
                  <c:v>3.1024260824007754</c:v>
                </c:pt>
                <c:pt idx="5165">
                  <c:v>3.1019970572656028</c:v>
                </c:pt>
                <c:pt idx="5166">
                  <c:v>3.1019550853862792</c:v>
                </c:pt>
                <c:pt idx="5167">
                  <c:v>3.1014740270238415</c:v>
                </c:pt>
                <c:pt idx="5168">
                  <c:v>3.1012772504527955</c:v>
                </c:pt>
                <c:pt idx="5169">
                  <c:v>3.1012122755019149</c:v>
                </c:pt>
                <c:pt idx="5170">
                  <c:v>3.1008203086323594</c:v>
                </c:pt>
                <c:pt idx="5171">
                  <c:v>3.0998397995500118</c:v>
                </c:pt>
                <c:pt idx="5172">
                  <c:v>3.0993986148770856</c:v>
                </c:pt>
                <c:pt idx="5173">
                  <c:v>3.0993928573323002</c:v>
                </c:pt>
                <c:pt idx="5174">
                  <c:v>3.0991183257931905</c:v>
                </c:pt>
                <c:pt idx="5175">
                  <c:v>3.0990415026835154</c:v>
                </c:pt>
                <c:pt idx="5176">
                  <c:v>3.0989204787223299</c:v>
                </c:pt>
                <c:pt idx="5177">
                  <c:v>3.0982725232444213</c:v>
                </c:pt>
                <c:pt idx="5178">
                  <c:v>3.0980107597579361</c:v>
                </c:pt>
                <c:pt idx="5179">
                  <c:v>3.0979375917507745</c:v>
                </c:pt>
                <c:pt idx="5180">
                  <c:v>3.0973286640579762</c:v>
                </c:pt>
                <c:pt idx="5181">
                  <c:v>3.0970894843057297</c:v>
                </c:pt>
                <c:pt idx="5182">
                  <c:v>3.0968868500180031</c:v>
                </c:pt>
                <c:pt idx="5183">
                  <c:v>3.0962648480027779</c:v>
                </c:pt>
                <c:pt idx="5184">
                  <c:v>3.0959805941157654</c:v>
                </c:pt>
                <c:pt idx="5185">
                  <c:v>3.0957522828351594</c:v>
                </c:pt>
                <c:pt idx="5186">
                  <c:v>3.0957367997589347</c:v>
                </c:pt>
                <c:pt idx="5187">
                  <c:v>3.0956129152735281</c:v>
                </c:pt>
                <c:pt idx="5188">
                  <c:v>3.0955528960194019</c:v>
                </c:pt>
                <c:pt idx="5189">
                  <c:v>3.0952177974669333</c:v>
                </c:pt>
                <c:pt idx="5190">
                  <c:v>3.0952081086922245</c:v>
                </c:pt>
                <c:pt idx="5191">
                  <c:v>3.095091826532959</c:v>
                </c:pt>
                <c:pt idx="5192">
                  <c:v>3.0941876402566382</c:v>
                </c:pt>
                <c:pt idx="5193">
                  <c:v>3.0940885698658045</c:v>
                </c:pt>
                <c:pt idx="5194">
                  <c:v>3.093678450067241</c:v>
                </c:pt>
                <c:pt idx="5195">
                  <c:v>3.0935092357082232</c:v>
                </c:pt>
                <c:pt idx="5196">
                  <c:v>3.0934683809831394</c:v>
                </c:pt>
                <c:pt idx="5197">
                  <c:v>3.0933924977243463</c:v>
                </c:pt>
                <c:pt idx="5198">
                  <c:v>3.0932114918136602</c:v>
                </c:pt>
                <c:pt idx="5199">
                  <c:v>3.0931725559531071</c:v>
                </c:pt>
                <c:pt idx="5200">
                  <c:v>3.0927946968442197</c:v>
                </c:pt>
                <c:pt idx="5201">
                  <c:v>3.0926309856983014</c:v>
                </c:pt>
                <c:pt idx="5202">
                  <c:v>3.092262409828098</c:v>
                </c:pt>
                <c:pt idx="5203">
                  <c:v>3.092240948686892</c:v>
                </c:pt>
                <c:pt idx="5204">
                  <c:v>3.0915321354145902</c:v>
                </c:pt>
                <c:pt idx="5205">
                  <c:v>3.0914832764669371</c:v>
                </c:pt>
                <c:pt idx="5206">
                  <c:v>3.0912447659079607</c:v>
                </c:pt>
                <c:pt idx="5207">
                  <c:v>3.0910746004633278</c:v>
                </c:pt>
                <c:pt idx="5208">
                  <c:v>3.0908965399482748</c:v>
                </c:pt>
                <c:pt idx="5209">
                  <c:v>3.0908495667647915</c:v>
                </c:pt>
                <c:pt idx="5210">
                  <c:v>3.0908104185638288</c:v>
                </c:pt>
                <c:pt idx="5211">
                  <c:v>3.0907673514664991</c:v>
                </c:pt>
                <c:pt idx="5212">
                  <c:v>3.0903227277701757</c:v>
                </c:pt>
                <c:pt idx="5213">
                  <c:v>3.0901247531876908</c:v>
                </c:pt>
                <c:pt idx="5214">
                  <c:v>3.0900090628980119</c:v>
                </c:pt>
                <c:pt idx="5215">
                  <c:v>3.0897167586306762</c:v>
                </c:pt>
                <c:pt idx="5216">
                  <c:v>3.089640216962199</c:v>
                </c:pt>
                <c:pt idx="5217">
                  <c:v>3.0893751608160995</c:v>
                </c:pt>
                <c:pt idx="5218">
                  <c:v>3.0887855673479958</c:v>
                </c:pt>
                <c:pt idx="5219">
                  <c:v>3.0887718006063523</c:v>
                </c:pt>
                <c:pt idx="5220">
                  <c:v>3.0886360765106895</c:v>
                </c:pt>
                <c:pt idx="5221">
                  <c:v>3.0885298280583489</c:v>
                </c:pt>
                <c:pt idx="5222">
                  <c:v>3.0883802491505583</c:v>
                </c:pt>
                <c:pt idx="5223">
                  <c:v>3.0874481574085482</c:v>
                </c:pt>
                <c:pt idx="5224">
                  <c:v>3.0867650621821259</c:v>
                </c:pt>
                <c:pt idx="5225">
                  <c:v>3.0865041759792438</c:v>
                </c:pt>
                <c:pt idx="5226">
                  <c:v>3.0862451111530587</c:v>
                </c:pt>
                <c:pt idx="5227">
                  <c:v>3.0861659765819263</c:v>
                </c:pt>
                <c:pt idx="5228">
                  <c:v>3.0859878710582058</c:v>
                </c:pt>
                <c:pt idx="5229">
                  <c:v>3.0858195931917582</c:v>
                </c:pt>
                <c:pt idx="5230">
                  <c:v>3.085629459750213</c:v>
                </c:pt>
                <c:pt idx="5231">
                  <c:v>3.0848978584613556</c:v>
                </c:pt>
                <c:pt idx="5232">
                  <c:v>3.0845266300941052</c:v>
                </c:pt>
                <c:pt idx="5233">
                  <c:v>3.0840218860066724</c:v>
                </c:pt>
                <c:pt idx="5234">
                  <c:v>3.0839463226402475</c:v>
                </c:pt>
                <c:pt idx="5235">
                  <c:v>3.0838886470139837</c:v>
                </c:pt>
                <c:pt idx="5236">
                  <c:v>3.0834050638171346</c:v>
                </c:pt>
                <c:pt idx="5237">
                  <c:v>3.0829329016906883</c:v>
                </c:pt>
                <c:pt idx="5238">
                  <c:v>3.0829030007319309</c:v>
                </c:pt>
                <c:pt idx="5239">
                  <c:v>3.0828571485964091</c:v>
                </c:pt>
                <c:pt idx="5240">
                  <c:v>3.0827853703164503</c:v>
                </c:pt>
                <c:pt idx="5241">
                  <c:v>3.0825939035517913</c:v>
                </c:pt>
                <c:pt idx="5242">
                  <c:v>3.0823265066366825</c:v>
                </c:pt>
                <c:pt idx="5243">
                  <c:v>3.0810411051001032</c:v>
                </c:pt>
                <c:pt idx="5244">
                  <c:v>3.0806966192565408</c:v>
                </c:pt>
                <c:pt idx="5245">
                  <c:v>3.0806024389425142</c:v>
                </c:pt>
                <c:pt idx="5246">
                  <c:v>3.0803859471859956</c:v>
                </c:pt>
                <c:pt idx="5247">
                  <c:v>3.0797297994355182</c:v>
                </c:pt>
                <c:pt idx="5248">
                  <c:v>3.0794586233694061</c:v>
                </c:pt>
                <c:pt idx="5249">
                  <c:v>3.0793219668289757</c:v>
                </c:pt>
                <c:pt idx="5250">
                  <c:v>3.0786823251700959</c:v>
                </c:pt>
                <c:pt idx="5251">
                  <c:v>3.078446748040379</c:v>
                </c:pt>
                <c:pt idx="5252">
                  <c:v>3.0778017810616052</c:v>
                </c:pt>
                <c:pt idx="5253">
                  <c:v>3.0772851169486248</c:v>
                </c:pt>
                <c:pt idx="5254">
                  <c:v>3.076933595615722</c:v>
                </c:pt>
                <c:pt idx="5255">
                  <c:v>3.076569653199384</c:v>
                </c:pt>
                <c:pt idx="5256">
                  <c:v>3.076448271254193</c:v>
                </c:pt>
                <c:pt idx="5257">
                  <c:v>3.0764280376312905</c:v>
                </c:pt>
                <c:pt idx="5258">
                  <c:v>3.0757760105816692</c:v>
                </c:pt>
                <c:pt idx="5259">
                  <c:v>3.0757172395683656</c:v>
                </c:pt>
                <c:pt idx="5260">
                  <c:v>3.0751108259769677</c:v>
                </c:pt>
                <c:pt idx="5261">
                  <c:v>3.0745177909907362</c:v>
                </c:pt>
                <c:pt idx="5262">
                  <c:v>3.0742657090491265</c:v>
                </c:pt>
                <c:pt idx="5263">
                  <c:v>3.0741863949564161</c:v>
                </c:pt>
                <c:pt idx="5264">
                  <c:v>3.0739198748609677</c:v>
                </c:pt>
                <c:pt idx="5265">
                  <c:v>3.0737020614524928</c:v>
                </c:pt>
                <c:pt idx="5266">
                  <c:v>3.0735228432889001</c:v>
                </c:pt>
                <c:pt idx="5267">
                  <c:v>3.0733129825905436</c:v>
                </c:pt>
                <c:pt idx="5268">
                  <c:v>3.0732131103394646</c:v>
                </c:pt>
                <c:pt idx="5269">
                  <c:v>3.0727419744132218</c:v>
                </c:pt>
                <c:pt idx="5270">
                  <c:v>3.0725154024897443</c:v>
                </c:pt>
                <c:pt idx="5271">
                  <c:v>3.0722212950969729</c:v>
                </c:pt>
                <c:pt idx="5272">
                  <c:v>3.071994451300609</c:v>
                </c:pt>
                <c:pt idx="5273">
                  <c:v>3.0719310773566724</c:v>
                </c:pt>
                <c:pt idx="5274">
                  <c:v>3.0716447572041501</c:v>
                </c:pt>
                <c:pt idx="5275">
                  <c:v>3.0715178979462388</c:v>
                </c:pt>
                <c:pt idx="5276">
                  <c:v>3.0711903479071214</c:v>
                </c:pt>
                <c:pt idx="5277">
                  <c:v>3.071173963918516</c:v>
                </c:pt>
                <c:pt idx="5278">
                  <c:v>3.0711534830635259</c:v>
                </c:pt>
                <c:pt idx="5279">
                  <c:v>3.0710633558254452</c:v>
                </c:pt>
                <c:pt idx="5280">
                  <c:v>3.0707621132182235</c:v>
                </c:pt>
                <c:pt idx="5281">
                  <c:v>3.0707518631956385</c:v>
                </c:pt>
                <c:pt idx="5282">
                  <c:v>3.0705078412364375</c:v>
                </c:pt>
                <c:pt idx="5283">
                  <c:v>3.0704032184093037</c:v>
                </c:pt>
                <c:pt idx="5284">
                  <c:v>3.0703067789727059</c:v>
                </c:pt>
                <c:pt idx="5285">
                  <c:v>3.06995161516766</c:v>
                </c:pt>
                <c:pt idx="5286">
                  <c:v>3.0696105488745733</c:v>
                </c:pt>
                <c:pt idx="5287">
                  <c:v>3.0687731848831956</c:v>
                </c:pt>
                <c:pt idx="5288">
                  <c:v>3.0684827137617545</c:v>
                </c:pt>
                <c:pt idx="5289">
                  <c:v>3.0683528659712165</c:v>
                </c:pt>
                <c:pt idx="5290">
                  <c:v>3.0680291080062516</c:v>
                </c:pt>
                <c:pt idx="5291">
                  <c:v>3.0680022891989478</c:v>
                </c:pt>
                <c:pt idx="5292">
                  <c:v>3.0676369759466606</c:v>
                </c:pt>
                <c:pt idx="5293">
                  <c:v>3.0675172019036752</c:v>
                </c:pt>
                <c:pt idx="5294">
                  <c:v>3.0673436774644065</c:v>
                </c:pt>
                <c:pt idx="5295">
                  <c:v>3.0669778095571933</c:v>
                </c:pt>
                <c:pt idx="5296">
                  <c:v>3.0669054262816697</c:v>
                </c:pt>
                <c:pt idx="5297">
                  <c:v>3.0664501692427031</c:v>
                </c:pt>
                <c:pt idx="5298">
                  <c:v>3.065921887098757</c:v>
                </c:pt>
                <c:pt idx="5299">
                  <c:v>3.0659053031404193</c:v>
                </c:pt>
                <c:pt idx="5300">
                  <c:v>3.0655548189457078</c:v>
                </c:pt>
                <c:pt idx="5301">
                  <c:v>3.0654116404928522</c:v>
                </c:pt>
                <c:pt idx="5302">
                  <c:v>3.0650981431586213</c:v>
                </c:pt>
                <c:pt idx="5303">
                  <c:v>3.0650503720429221</c:v>
                </c:pt>
                <c:pt idx="5304">
                  <c:v>3.0646804873444031</c:v>
                </c:pt>
                <c:pt idx="5305">
                  <c:v>3.0643602203653098</c:v>
                </c:pt>
                <c:pt idx="5306">
                  <c:v>3.0643477376496615</c:v>
                </c:pt>
                <c:pt idx="5307">
                  <c:v>3.0641292320275113</c:v>
                </c:pt>
                <c:pt idx="5308">
                  <c:v>3.0634876472612254</c:v>
                </c:pt>
                <c:pt idx="5309">
                  <c:v>3.0628555516179969</c:v>
                </c:pt>
                <c:pt idx="5310">
                  <c:v>3.0624754342728382</c:v>
                </c:pt>
                <c:pt idx="5311">
                  <c:v>3.0619569360453487</c:v>
                </c:pt>
                <c:pt idx="5312">
                  <c:v>3.0619422920280863</c:v>
                </c:pt>
                <c:pt idx="5313">
                  <c:v>3.0619150946859222</c:v>
                </c:pt>
                <c:pt idx="5314">
                  <c:v>3.0617832680490475</c:v>
                </c:pt>
                <c:pt idx="5315">
                  <c:v>3.0617414099537221</c:v>
                </c:pt>
                <c:pt idx="5316">
                  <c:v>3.0611403015321308</c:v>
                </c:pt>
                <c:pt idx="5317">
                  <c:v>3.0610375900634184</c:v>
                </c:pt>
                <c:pt idx="5318">
                  <c:v>3.0608719428522928</c:v>
                </c:pt>
                <c:pt idx="5319">
                  <c:v>3.060857262203684</c:v>
                </c:pt>
                <c:pt idx="5320">
                  <c:v>3.0604019157787317</c:v>
                </c:pt>
                <c:pt idx="5321">
                  <c:v>3.0600973857322527</c:v>
                </c:pt>
                <c:pt idx="5322">
                  <c:v>3.0599902243822528</c:v>
                </c:pt>
                <c:pt idx="5323">
                  <c:v>3.0599692092518445</c:v>
                </c:pt>
                <c:pt idx="5324">
                  <c:v>3.0598620162659667</c:v>
                </c:pt>
                <c:pt idx="5325">
                  <c:v>3.0590645953012254</c:v>
                </c:pt>
                <c:pt idx="5326">
                  <c:v>3.0588223439705526</c:v>
                </c:pt>
                <c:pt idx="5327">
                  <c:v>3.0575773598354523</c:v>
                </c:pt>
                <c:pt idx="5328">
                  <c:v>3.0560150335589764</c:v>
                </c:pt>
                <c:pt idx="5329">
                  <c:v>3.0559407997178014</c:v>
                </c:pt>
                <c:pt idx="5330">
                  <c:v>3.0557816844606314</c:v>
                </c:pt>
                <c:pt idx="5331">
                  <c:v>3.0555036232299506</c:v>
                </c:pt>
                <c:pt idx="5332">
                  <c:v>3.0554781430688798</c:v>
                </c:pt>
                <c:pt idx="5333">
                  <c:v>3.0554590319669823</c:v>
                </c:pt>
                <c:pt idx="5334">
                  <c:v>3.0551467648647117</c:v>
                </c:pt>
                <c:pt idx="5335">
                  <c:v>3.0550064902410252</c:v>
                </c:pt>
                <c:pt idx="5336">
                  <c:v>3.0549405880337908</c:v>
                </c:pt>
                <c:pt idx="5337">
                  <c:v>3.0548363996283587</c:v>
                </c:pt>
                <c:pt idx="5338">
                  <c:v>3.0547385673531995</c:v>
                </c:pt>
                <c:pt idx="5339">
                  <c:v>3.0545556043971502</c:v>
                </c:pt>
                <c:pt idx="5340">
                  <c:v>3.0543129532364484</c:v>
                </c:pt>
                <c:pt idx="5341">
                  <c:v>3.0542512045498071</c:v>
                </c:pt>
                <c:pt idx="5342">
                  <c:v>3.0539636381466142</c:v>
                </c:pt>
                <c:pt idx="5343">
                  <c:v>3.0539359365136267</c:v>
                </c:pt>
                <c:pt idx="5344">
                  <c:v>3.0538037967190252</c:v>
                </c:pt>
                <c:pt idx="5345">
                  <c:v>3.0537739531357619</c:v>
                </c:pt>
                <c:pt idx="5346">
                  <c:v>3.0537249199393304</c:v>
                </c:pt>
                <c:pt idx="5347">
                  <c:v>3.0534668714776569</c:v>
                </c:pt>
                <c:pt idx="5348">
                  <c:v>3.0529396349640447</c:v>
                </c:pt>
                <c:pt idx="5349">
                  <c:v>3.0527024901034507</c:v>
                </c:pt>
                <c:pt idx="5350">
                  <c:v>3.0525079774039581</c:v>
                </c:pt>
                <c:pt idx="5351">
                  <c:v>3.0524203113380173</c:v>
                </c:pt>
                <c:pt idx="5352">
                  <c:v>3.0522192540254607</c:v>
                </c:pt>
                <c:pt idx="5353">
                  <c:v>3.0521700449741469</c:v>
                </c:pt>
                <c:pt idx="5354">
                  <c:v>3.0519281977412764</c:v>
                </c:pt>
                <c:pt idx="5355">
                  <c:v>3.0515919561976359</c:v>
                </c:pt>
                <c:pt idx="5356">
                  <c:v>3.0514205227532654</c:v>
                </c:pt>
                <c:pt idx="5357">
                  <c:v>3.050669704741285</c:v>
                </c:pt>
                <c:pt idx="5358">
                  <c:v>3.0503238920941516</c:v>
                </c:pt>
                <c:pt idx="5359">
                  <c:v>3.0500573640843016</c:v>
                </c:pt>
                <c:pt idx="5360">
                  <c:v>3.0499627502975666</c:v>
                </c:pt>
                <c:pt idx="5361">
                  <c:v>3.049786369583837</c:v>
                </c:pt>
                <c:pt idx="5362">
                  <c:v>3.0497347324062121</c:v>
                </c:pt>
                <c:pt idx="5363">
                  <c:v>3.0494549242803273</c:v>
                </c:pt>
                <c:pt idx="5364">
                  <c:v>3.0493558720545808</c:v>
                </c:pt>
                <c:pt idx="5365">
                  <c:v>3.0489917687021038</c:v>
                </c:pt>
                <c:pt idx="5366">
                  <c:v>3.0487783355175759</c:v>
                </c:pt>
                <c:pt idx="5367">
                  <c:v>3.0480380526824291</c:v>
                </c:pt>
                <c:pt idx="5368">
                  <c:v>3.0477593104156391</c:v>
                </c:pt>
                <c:pt idx="5369">
                  <c:v>3.0476166288815563</c:v>
                </c:pt>
                <c:pt idx="5370">
                  <c:v>3.0473441066249491</c:v>
                </c:pt>
                <c:pt idx="5371">
                  <c:v>3.0471363557775586</c:v>
                </c:pt>
                <c:pt idx="5372">
                  <c:v>3.0464821574169068</c:v>
                </c:pt>
                <c:pt idx="5373">
                  <c:v>3.046224106367637</c:v>
                </c:pt>
                <c:pt idx="5374">
                  <c:v>3.0460396902689397</c:v>
                </c:pt>
                <c:pt idx="5375">
                  <c:v>3.0456706229772466</c:v>
                </c:pt>
                <c:pt idx="5376">
                  <c:v>3.0454729344727327</c:v>
                </c:pt>
                <c:pt idx="5377">
                  <c:v>3.0454142623269616</c:v>
                </c:pt>
                <c:pt idx="5378">
                  <c:v>3.0453034155315399</c:v>
                </c:pt>
                <c:pt idx="5379">
                  <c:v>3.0452968942506633</c:v>
                </c:pt>
                <c:pt idx="5380">
                  <c:v>3.0452512425424962</c:v>
                </c:pt>
                <c:pt idx="5381">
                  <c:v>3.0442652999153195</c:v>
                </c:pt>
                <c:pt idx="5382">
                  <c:v>3.0439492377362289</c:v>
                </c:pt>
                <c:pt idx="5383">
                  <c:v>3.0437376745592695</c:v>
                </c:pt>
                <c:pt idx="5384">
                  <c:v>3.0436285811079271</c:v>
                </c:pt>
                <c:pt idx="5385">
                  <c:v>3.0434212280221571</c:v>
                </c:pt>
                <c:pt idx="5386">
                  <c:v>3.0432924009900417</c:v>
                </c:pt>
                <c:pt idx="5387">
                  <c:v>3.0428969472457505</c:v>
                </c:pt>
                <c:pt idx="5388">
                  <c:v>3.0425995736216436</c:v>
                </c:pt>
                <c:pt idx="5389">
                  <c:v>3.0425820747127923</c:v>
                </c:pt>
                <c:pt idx="5390">
                  <c:v>3.0422516504875121</c:v>
                </c:pt>
                <c:pt idx="5391">
                  <c:v>3.0420611594047395</c:v>
                </c:pt>
                <c:pt idx="5392">
                  <c:v>3.0411908448667719</c:v>
                </c:pt>
                <c:pt idx="5393">
                  <c:v>3.0411250070934197</c:v>
                </c:pt>
                <c:pt idx="5394">
                  <c:v>3.0410833046740731</c:v>
                </c:pt>
                <c:pt idx="5395">
                  <c:v>3.0410525740130274</c:v>
                </c:pt>
                <c:pt idx="5396">
                  <c:v>3.0410218411773275</c:v>
                </c:pt>
                <c:pt idx="5397">
                  <c:v>3.0409625645661604</c:v>
                </c:pt>
                <c:pt idx="5398">
                  <c:v>3.0404199174614317</c:v>
                </c:pt>
                <c:pt idx="5399">
                  <c:v>3.0402264217672763</c:v>
                </c:pt>
                <c:pt idx="5400">
                  <c:v>3.0401912314678539</c:v>
                </c:pt>
                <c:pt idx="5401">
                  <c:v>3.0395859520962105</c:v>
                </c:pt>
                <c:pt idx="5402">
                  <c:v>3.0394163225925763</c:v>
                </c:pt>
                <c:pt idx="5403">
                  <c:v>3.0388673264412884</c:v>
                </c:pt>
                <c:pt idx="5404">
                  <c:v>3.0384324878230045</c:v>
                </c:pt>
                <c:pt idx="5405">
                  <c:v>3.0376234573945289</c:v>
                </c:pt>
                <c:pt idx="5406">
                  <c:v>3.0375858428266174</c:v>
                </c:pt>
                <c:pt idx="5407">
                  <c:v>3.0375216692791187</c:v>
                </c:pt>
                <c:pt idx="5408">
                  <c:v>3.0372980942513226</c:v>
                </c:pt>
                <c:pt idx="5409">
                  <c:v>3.037229449121944</c:v>
                </c:pt>
                <c:pt idx="5410">
                  <c:v>3.0370544656871536</c:v>
                </c:pt>
                <c:pt idx="5411">
                  <c:v>3.0370145861797502</c:v>
                </c:pt>
                <c:pt idx="5412">
                  <c:v>3.0364159537144024</c:v>
                </c:pt>
                <c:pt idx="5413">
                  <c:v>3.0362362029509447</c:v>
                </c:pt>
                <c:pt idx="5414">
                  <c:v>3.0357853893309699</c:v>
                </c:pt>
                <c:pt idx="5415">
                  <c:v>3.0356787245648258</c:v>
                </c:pt>
                <c:pt idx="5416">
                  <c:v>3.035640941177133</c:v>
                </c:pt>
                <c:pt idx="5417">
                  <c:v>3.0355920401483285</c:v>
                </c:pt>
                <c:pt idx="5418">
                  <c:v>3.0347710147725997</c:v>
                </c:pt>
                <c:pt idx="5419">
                  <c:v>3.0343833254234442</c:v>
                </c:pt>
                <c:pt idx="5420">
                  <c:v>3.0342607079176966</c:v>
                </c:pt>
                <c:pt idx="5421">
                  <c:v>3.0337989096255766</c:v>
                </c:pt>
                <c:pt idx="5422">
                  <c:v>3.0329856656799943</c:v>
                </c:pt>
                <c:pt idx="5423">
                  <c:v>3.0319781720621162</c:v>
                </c:pt>
                <c:pt idx="5424">
                  <c:v>3.0316552798559493</c:v>
                </c:pt>
                <c:pt idx="5425">
                  <c:v>3.0315431083332802</c:v>
                </c:pt>
                <c:pt idx="5426">
                  <c:v>3.0314062198298974</c:v>
                </c:pt>
                <c:pt idx="5427">
                  <c:v>3.0313613289593788</c:v>
                </c:pt>
                <c:pt idx="5428">
                  <c:v>3.0313523502284303</c:v>
                </c:pt>
                <c:pt idx="5429">
                  <c:v>3.0311996833942354</c:v>
                </c:pt>
                <c:pt idx="5430">
                  <c:v>3.0310896401911167</c:v>
                </c:pt>
                <c:pt idx="5431">
                  <c:v>3.030943621473515</c:v>
                </c:pt>
                <c:pt idx="5432">
                  <c:v>3.0308739644830851</c:v>
                </c:pt>
                <c:pt idx="5433">
                  <c:v>3.0301362632934561</c:v>
                </c:pt>
                <c:pt idx="5434">
                  <c:v>3.0294130904460297</c:v>
                </c:pt>
                <c:pt idx="5435">
                  <c:v>3.0288264589904541</c:v>
                </c:pt>
                <c:pt idx="5436">
                  <c:v>3.0284966951179539</c:v>
                </c:pt>
                <c:pt idx="5437">
                  <c:v>3.0284153449813997</c:v>
                </c:pt>
                <c:pt idx="5438">
                  <c:v>3.0282548597583876</c:v>
                </c:pt>
                <c:pt idx="5439">
                  <c:v>3.0281598969133467</c:v>
                </c:pt>
                <c:pt idx="5440">
                  <c:v>3.0276553413191696</c:v>
                </c:pt>
                <c:pt idx="5441">
                  <c:v>3.0268055494738482</c:v>
                </c:pt>
                <c:pt idx="5442">
                  <c:v>3.0265332645232967</c:v>
                </c:pt>
                <c:pt idx="5443">
                  <c:v>3.0263085008540704</c:v>
                </c:pt>
                <c:pt idx="5444">
                  <c:v>3.0262926040693205</c:v>
                </c:pt>
                <c:pt idx="5445">
                  <c:v>3.0254014541586214</c:v>
                </c:pt>
                <c:pt idx="5446">
                  <c:v>3.0251783806697499</c:v>
                </c:pt>
                <c:pt idx="5447">
                  <c:v>3.024854948305018</c:v>
                </c:pt>
                <c:pt idx="5448">
                  <c:v>3.0236730572952761</c:v>
                </c:pt>
                <c:pt idx="5449">
                  <c:v>3.0233805107434097</c:v>
                </c:pt>
                <c:pt idx="5450">
                  <c:v>3.0231289460104955</c:v>
                </c:pt>
                <c:pt idx="5451">
                  <c:v>3.0223069148898087</c:v>
                </c:pt>
                <c:pt idx="5452">
                  <c:v>3.0213914631962662</c:v>
                </c:pt>
                <c:pt idx="5453">
                  <c:v>3.0212421465056556</c:v>
                </c:pt>
                <c:pt idx="5454">
                  <c:v>3.0208996728625364</c:v>
                </c:pt>
                <c:pt idx="5455">
                  <c:v>3.0207570874443852</c:v>
                </c:pt>
                <c:pt idx="5456">
                  <c:v>3.0206834766504378</c:v>
                </c:pt>
                <c:pt idx="5457">
                  <c:v>3.0205615313212535</c:v>
                </c:pt>
                <c:pt idx="5458">
                  <c:v>3.0199236366823174</c:v>
                </c:pt>
                <c:pt idx="5459">
                  <c:v>3.0191001282038963</c:v>
                </c:pt>
                <c:pt idx="5460">
                  <c:v>3.0184138325795646</c:v>
                </c:pt>
                <c:pt idx="5461">
                  <c:v>3.0182704285472761</c:v>
                </c:pt>
                <c:pt idx="5462">
                  <c:v>3.0181825123425581</c:v>
                </c:pt>
                <c:pt idx="5463">
                  <c:v>3.0178931886756986</c:v>
                </c:pt>
                <c:pt idx="5464">
                  <c:v>3.0178121434970655</c:v>
                </c:pt>
                <c:pt idx="5465">
                  <c:v>3.017599038301392</c:v>
                </c:pt>
                <c:pt idx="5466">
                  <c:v>3.0172142576442016</c:v>
                </c:pt>
                <c:pt idx="5467">
                  <c:v>3.0170843751813559</c:v>
                </c:pt>
                <c:pt idx="5468">
                  <c:v>3.0169335700261128</c:v>
                </c:pt>
                <c:pt idx="5469">
                  <c:v>3.0167502132338302</c:v>
                </c:pt>
                <c:pt idx="5470">
                  <c:v>3.0165737462691231</c:v>
                </c:pt>
                <c:pt idx="5471">
                  <c:v>3.015189711950558</c:v>
                </c:pt>
                <c:pt idx="5472">
                  <c:v>3.0145298723021994</c:v>
                </c:pt>
                <c:pt idx="5473">
                  <c:v>3.0144692006785561</c:v>
                </c:pt>
                <c:pt idx="5474">
                  <c:v>3.0143548349589011</c:v>
                </c:pt>
                <c:pt idx="5475">
                  <c:v>3.0142848002637095</c:v>
                </c:pt>
                <c:pt idx="5476">
                  <c:v>3.0139251109302818</c:v>
                </c:pt>
                <c:pt idx="5477">
                  <c:v>3.0137358040649809</c:v>
                </c:pt>
                <c:pt idx="5478">
                  <c:v>3.0135768160429119</c:v>
                </c:pt>
                <c:pt idx="5479">
                  <c:v>3.0132048373272817</c:v>
                </c:pt>
                <c:pt idx="5480">
                  <c:v>3.013003508445836</c:v>
                </c:pt>
                <c:pt idx="5481">
                  <c:v>3.0128583064498868</c:v>
                </c:pt>
                <c:pt idx="5482">
                  <c:v>3.0126966535817883</c:v>
                </c:pt>
                <c:pt idx="5483">
                  <c:v>3.0123802020973476</c:v>
                </c:pt>
                <c:pt idx="5484">
                  <c:v>3.0119485187944486</c:v>
                </c:pt>
                <c:pt idx="5485">
                  <c:v>3.0117982674437247</c:v>
                </c:pt>
                <c:pt idx="5486">
                  <c:v>3.0116784986714094</c:v>
                </c:pt>
                <c:pt idx="5487">
                  <c:v>3.0109121365476006</c:v>
                </c:pt>
                <c:pt idx="5488">
                  <c:v>3.0108744888452685</c:v>
                </c:pt>
                <c:pt idx="5489">
                  <c:v>3.010606154459516</c:v>
                </c:pt>
                <c:pt idx="5490">
                  <c:v>3.010606154459516</c:v>
                </c:pt>
                <c:pt idx="5491">
                  <c:v>3.0099676055347242</c:v>
                </c:pt>
                <c:pt idx="5492">
                  <c:v>3.0099204429305586</c:v>
                </c:pt>
                <c:pt idx="5493">
                  <c:v>3.009413121206872</c:v>
                </c:pt>
                <c:pt idx="5494">
                  <c:v>3.0093895104184036</c:v>
                </c:pt>
                <c:pt idx="5495">
                  <c:v>3.0087515334370241</c:v>
                </c:pt>
                <c:pt idx="5496">
                  <c:v>3.0086593036950067</c:v>
                </c:pt>
                <c:pt idx="5497">
                  <c:v>3.0086498431267357</c:v>
                </c:pt>
                <c:pt idx="5498">
                  <c:v>3.0082168015896906</c:v>
                </c:pt>
                <c:pt idx="5499">
                  <c:v>3.0075936951077371</c:v>
                </c:pt>
                <c:pt idx="5500">
                  <c:v>3.0074632745631806</c:v>
                </c:pt>
                <c:pt idx="5501">
                  <c:v>3.0072023159176351</c:v>
                </c:pt>
                <c:pt idx="5502">
                  <c:v>3.0061688042101817</c:v>
                </c:pt>
                <c:pt idx="5503">
                  <c:v>3.0055498966796668</c:v>
                </c:pt>
                <c:pt idx="5504">
                  <c:v>3.0055213104124792</c:v>
                </c:pt>
                <c:pt idx="5505">
                  <c:v>3.0054569844308245</c:v>
                </c:pt>
                <c:pt idx="5506">
                  <c:v>3.0053259205445046</c:v>
                </c:pt>
                <c:pt idx="5507">
                  <c:v>3.0052448794453652</c:v>
                </c:pt>
                <c:pt idx="5508">
                  <c:v>3.0052258087535018</c:v>
                </c:pt>
                <c:pt idx="5509">
                  <c:v>3.0046413629132038</c:v>
                </c:pt>
                <c:pt idx="5510">
                  <c:v>3.0042162512854369</c:v>
                </c:pt>
                <c:pt idx="5511">
                  <c:v>3.0041708496124273</c:v>
                </c:pt>
                <c:pt idx="5512">
                  <c:v>3.003993976788514</c:v>
                </c:pt>
                <c:pt idx="5513">
                  <c:v>3.0038098569390033</c:v>
                </c:pt>
                <c:pt idx="5514">
                  <c:v>3.0035610516058244</c:v>
                </c:pt>
                <c:pt idx="5515">
                  <c:v>3.0034940411934246</c:v>
                </c:pt>
                <c:pt idx="5516">
                  <c:v>3.0034222328474418</c:v>
                </c:pt>
                <c:pt idx="5517">
                  <c:v>3.0028425442585891</c:v>
                </c:pt>
                <c:pt idx="5518">
                  <c:v>3.0024012709053109</c:v>
                </c:pt>
                <c:pt idx="5519">
                  <c:v>3.0022668812761979</c:v>
                </c:pt>
                <c:pt idx="5520">
                  <c:v>3.0010410579860936</c:v>
                </c:pt>
                <c:pt idx="5521">
                  <c:v>3.0000554896387031</c:v>
                </c:pt>
                <c:pt idx="5522">
                  <c:v>3.0000168889014587</c:v>
                </c:pt>
                <c:pt idx="5523">
                  <c:v>2.9998045234976312</c:v>
                </c:pt>
                <c:pt idx="5524">
                  <c:v>2.9997659004467057</c:v>
                </c:pt>
                <c:pt idx="5525">
                  <c:v>2.9992755720056676</c:v>
                </c:pt>
                <c:pt idx="5526">
                  <c:v>2.9992731552238632</c:v>
                </c:pt>
                <c:pt idx="5527">
                  <c:v>2.9991087825017306</c:v>
                </c:pt>
                <c:pt idx="5528">
                  <c:v>2.9990096453475252</c:v>
                </c:pt>
                <c:pt idx="5529">
                  <c:v>2.9989782068898321</c:v>
                </c:pt>
                <c:pt idx="5530">
                  <c:v>2.9988862968085548</c:v>
                </c:pt>
                <c:pt idx="5531">
                  <c:v>2.9985862443344322</c:v>
                </c:pt>
                <c:pt idx="5532">
                  <c:v>2.9984530901475921</c:v>
                </c:pt>
                <c:pt idx="5533">
                  <c:v>2.9983731780351195</c:v>
                </c:pt>
                <c:pt idx="5534">
                  <c:v>2.9976047874604546</c:v>
                </c:pt>
                <c:pt idx="5535">
                  <c:v>2.9968569079737049</c:v>
                </c:pt>
                <c:pt idx="5536">
                  <c:v>2.9960712198193979</c:v>
                </c:pt>
                <c:pt idx="5537">
                  <c:v>2.9960614810193973</c:v>
                </c:pt>
                <c:pt idx="5538">
                  <c:v>2.9956425058909213</c:v>
                </c:pt>
                <c:pt idx="5539">
                  <c:v>2.9953840988382137</c:v>
                </c:pt>
                <c:pt idx="5540">
                  <c:v>2.9949961997428258</c:v>
                </c:pt>
                <c:pt idx="5541">
                  <c:v>2.9949473828638227</c:v>
                </c:pt>
                <c:pt idx="5542">
                  <c:v>2.9947129854315704</c:v>
                </c:pt>
                <c:pt idx="5543">
                  <c:v>2.9945957392574964</c:v>
                </c:pt>
                <c:pt idx="5544">
                  <c:v>2.9944271424085818</c:v>
                </c:pt>
                <c:pt idx="5545">
                  <c:v>2.9937667857452608</c:v>
                </c:pt>
                <c:pt idx="5546">
                  <c:v>2.9937349654443097</c:v>
                </c:pt>
                <c:pt idx="5547">
                  <c:v>2.9932353258995312</c:v>
                </c:pt>
                <c:pt idx="5548">
                  <c:v>2.9930686515658897</c:v>
                </c:pt>
                <c:pt idx="5549">
                  <c:v>2.992980386309458</c:v>
                </c:pt>
                <c:pt idx="5550">
                  <c:v>2.9929509605704463</c:v>
                </c:pt>
                <c:pt idx="5551">
                  <c:v>2.992825878932114</c:v>
                </c:pt>
                <c:pt idx="5552">
                  <c:v>2.9924283216569751</c:v>
                </c:pt>
                <c:pt idx="5553">
                  <c:v>2.9916960607863863</c:v>
                </c:pt>
                <c:pt idx="5554">
                  <c:v>2.991661628885705</c:v>
                </c:pt>
                <c:pt idx="5555">
                  <c:v>2.9907481874093085</c:v>
                </c:pt>
                <c:pt idx="5556">
                  <c:v>2.9905361716841821</c:v>
                </c:pt>
                <c:pt idx="5557">
                  <c:v>2.9896870722379587</c:v>
                </c:pt>
                <c:pt idx="5558">
                  <c:v>2.9894695938321698</c:v>
                </c:pt>
                <c:pt idx="5559">
                  <c:v>2.9887620359450269</c:v>
                </c:pt>
                <c:pt idx="5560">
                  <c:v>2.9874899893980413</c:v>
                </c:pt>
                <c:pt idx="5561">
                  <c:v>2.9872043208130341</c:v>
                </c:pt>
                <c:pt idx="5562">
                  <c:v>2.9869955397243815</c:v>
                </c:pt>
                <c:pt idx="5563">
                  <c:v>2.9861569193487907</c:v>
                </c:pt>
                <c:pt idx="5564">
                  <c:v>2.9861070986525333</c:v>
                </c:pt>
                <c:pt idx="5565">
                  <c:v>2.9848372344890453</c:v>
                </c:pt>
                <c:pt idx="5566">
                  <c:v>2.9847222895446306</c:v>
                </c:pt>
                <c:pt idx="5567">
                  <c:v>2.9847072944826731</c:v>
                </c:pt>
                <c:pt idx="5568">
                  <c:v>2.9846323114057931</c:v>
                </c:pt>
                <c:pt idx="5569">
                  <c:v>2.9842046604833903</c:v>
                </c:pt>
                <c:pt idx="5570">
                  <c:v>2.9840545076712375</c:v>
                </c:pt>
                <c:pt idx="5571">
                  <c:v>2.9837790926114507</c:v>
                </c:pt>
                <c:pt idx="5572">
                  <c:v>2.983771578844423</c:v>
                </c:pt>
                <c:pt idx="5573">
                  <c:v>2.9833907110637594</c:v>
                </c:pt>
                <c:pt idx="5574">
                  <c:v>2.9833355577828709</c:v>
                </c:pt>
                <c:pt idx="5575">
                  <c:v>2.9832854123578607</c:v>
                </c:pt>
                <c:pt idx="5576">
                  <c:v>2.98310734932303</c:v>
                </c:pt>
                <c:pt idx="5577">
                  <c:v>2.9828137621318627</c:v>
                </c:pt>
                <c:pt idx="5578">
                  <c:v>2.9826304832019925</c:v>
                </c:pt>
                <c:pt idx="5579">
                  <c:v>2.9824169787199044</c:v>
                </c:pt>
                <c:pt idx="5580">
                  <c:v>2.982364214380639</c:v>
                </c:pt>
                <c:pt idx="5581">
                  <c:v>2.9818211230623559</c:v>
                </c:pt>
                <c:pt idx="5582">
                  <c:v>2.9817506725851453</c:v>
                </c:pt>
                <c:pt idx="5583">
                  <c:v>2.9813226920399036</c:v>
                </c:pt>
                <c:pt idx="5584">
                  <c:v>2.9810556199477038</c:v>
                </c:pt>
                <c:pt idx="5585">
                  <c:v>2.9809724413269421</c:v>
                </c:pt>
                <c:pt idx="5586">
                  <c:v>2.9808816828406162</c:v>
                </c:pt>
                <c:pt idx="5587">
                  <c:v>2.9807152430057791</c:v>
                </c:pt>
                <c:pt idx="5588">
                  <c:v>2.9796925086307127</c:v>
                </c:pt>
                <c:pt idx="5589">
                  <c:v>2.9793991330472505</c:v>
                </c:pt>
                <c:pt idx="5590">
                  <c:v>2.9789511001158986</c:v>
                </c:pt>
                <c:pt idx="5591">
                  <c:v>2.9788928472001324</c:v>
                </c:pt>
                <c:pt idx="5592">
                  <c:v>2.9787053717465208</c:v>
                </c:pt>
                <c:pt idx="5593">
                  <c:v>2.9785457004627389</c:v>
                </c:pt>
                <c:pt idx="5594">
                  <c:v>2.9782033499061584</c:v>
                </c:pt>
                <c:pt idx="5595">
                  <c:v>2.97806633408362</c:v>
                </c:pt>
                <c:pt idx="5596">
                  <c:v>2.9775737351376428</c:v>
                </c:pt>
                <c:pt idx="5597">
                  <c:v>2.9774924279943842</c:v>
                </c:pt>
                <c:pt idx="5598">
                  <c:v>2.9773628132642234</c:v>
                </c:pt>
                <c:pt idx="5599">
                  <c:v>2.977141616464523</c:v>
                </c:pt>
                <c:pt idx="5600">
                  <c:v>2.9770932941250923</c:v>
                </c:pt>
                <c:pt idx="5601">
                  <c:v>2.9770195286078187</c:v>
                </c:pt>
                <c:pt idx="5602">
                  <c:v>2.9769050400632699</c:v>
                </c:pt>
                <c:pt idx="5603">
                  <c:v>2.9768337875113517</c:v>
                </c:pt>
                <c:pt idx="5604">
                  <c:v>2.9767447053791676</c:v>
                </c:pt>
                <c:pt idx="5605">
                  <c:v>2.9765792186401101</c:v>
                </c:pt>
                <c:pt idx="5606">
                  <c:v>2.9760186413150431</c:v>
                </c:pt>
                <c:pt idx="5607">
                  <c:v>2.9759880435496959</c:v>
                </c:pt>
                <c:pt idx="5608">
                  <c:v>2.9757967586599445</c:v>
                </c:pt>
                <c:pt idx="5609">
                  <c:v>2.9755696578936619</c:v>
                </c:pt>
                <c:pt idx="5610">
                  <c:v>2.975503291429662</c:v>
                </c:pt>
                <c:pt idx="5611">
                  <c:v>2.9751840802276139</c:v>
                </c:pt>
                <c:pt idx="5612">
                  <c:v>2.9750333309950006</c:v>
                </c:pt>
                <c:pt idx="5613">
                  <c:v>2.9749719942980688</c:v>
                </c:pt>
                <c:pt idx="5614">
                  <c:v>2.9748953112428858</c:v>
                </c:pt>
                <c:pt idx="5615">
                  <c:v>2.974373507081423</c:v>
                </c:pt>
                <c:pt idx="5616">
                  <c:v>2.9742224761766805</c:v>
                </c:pt>
                <c:pt idx="5617">
                  <c:v>2.9739612479457409</c:v>
                </c:pt>
                <c:pt idx="5618">
                  <c:v>2.9738485127297802</c:v>
                </c:pt>
                <c:pt idx="5619">
                  <c:v>2.9734229298435295</c:v>
                </c:pt>
                <c:pt idx="5620">
                  <c:v>2.9732664361085286</c:v>
                </c:pt>
                <c:pt idx="5621">
                  <c:v>2.9732561722538757</c:v>
                </c:pt>
                <c:pt idx="5622">
                  <c:v>2.9730636800522006</c:v>
                </c:pt>
                <c:pt idx="5623">
                  <c:v>2.9723854279712154</c:v>
                </c:pt>
                <c:pt idx="5624">
                  <c:v>2.9722491359625955</c:v>
                </c:pt>
                <c:pt idx="5625">
                  <c:v>2.9715593055554148</c:v>
                </c:pt>
                <c:pt idx="5626">
                  <c:v>2.9713196677892491</c:v>
                </c:pt>
                <c:pt idx="5627">
                  <c:v>2.9710231585538325</c:v>
                </c:pt>
                <c:pt idx="5628">
                  <c:v>2.9710154208202724</c:v>
                </c:pt>
                <c:pt idx="5629">
                  <c:v>2.9700962295355975</c:v>
                </c:pt>
                <c:pt idx="5630">
                  <c:v>2.9699023313319803</c:v>
                </c:pt>
                <c:pt idx="5631">
                  <c:v>2.9692139402085793</c:v>
                </c:pt>
                <c:pt idx="5632">
                  <c:v>2.9690351942107305</c:v>
                </c:pt>
                <c:pt idx="5633">
                  <c:v>2.9689522725387247</c:v>
                </c:pt>
                <c:pt idx="5634">
                  <c:v>2.9685062970919858</c:v>
                </c:pt>
                <c:pt idx="5635">
                  <c:v>2.9684388423346904</c:v>
                </c:pt>
                <c:pt idx="5636">
                  <c:v>2.9682649683125022</c:v>
                </c:pt>
                <c:pt idx="5637">
                  <c:v>2.9682286276329797</c:v>
                </c:pt>
                <c:pt idx="5638">
                  <c:v>2.9681195873454653</c:v>
                </c:pt>
                <c:pt idx="5639">
                  <c:v>2.9681066045350697</c:v>
                </c:pt>
                <c:pt idx="5640">
                  <c:v>2.9678234827728507</c:v>
                </c:pt>
                <c:pt idx="5641">
                  <c:v>2.9676675571332103</c:v>
                </c:pt>
                <c:pt idx="5642">
                  <c:v>2.9674777720833689</c:v>
                </c:pt>
                <c:pt idx="5643">
                  <c:v>2.9672879040619176</c:v>
                </c:pt>
                <c:pt idx="5644">
                  <c:v>2.9669912317054625</c:v>
                </c:pt>
                <c:pt idx="5645">
                  <c:v>2.9666266197512439</c:v>
                </c:pt>
                <c:pt idx="5646">
                  <c:v>2.9662330162793364</c:v>
                </c:pt>
                <c:pt idx="5647">
                  <c:v>2.9660295581169303</c:v>
                </c:pt>
                <c:pt idx="5648">
                  <c:v>2.965449962639477</c:v>
                </c:pt>
                <c:pt idx="5649">
                  <c:v>2.9653872573123934</c:v>
                </c:pt>
                <c:pt idx="5650">
                  <c:v>2.9652409096642183</c:v>
                </c:pt>
                <c:pt idx="5651">
                  <c:v>2.9647361547468694</c:v>
                </c:pt>
                <c:pt idx="5652">
                  <c:v>2.964529375890967</c:v>
                </c:pt>
                <c:pt idx="5653">
                  <c:v>2.9644717743752445</c:v>
                </c:pt>
                <c:pt idx="5654">
                  <c:v>2.9644508264752107</c:v>
                </c:pt>
                <c:pt idx="5655">
                  <c:v>2.9642989239749262</c:v>
                </c:pt>
                <c:pt idx="5656">
                  <c:v>2.9641024195229502</c:v>
                </c:pt>
                <c:pt idx="5657">
                  <c:v>2.9640919367876544</c:v>
                </c:pt>
                <c:pt idx="5658">
                  <c:v>2.9638428974294704</c:v>
                </c:pt>
                <c:pt idx="5659">
                  <c:v>2.9637589783239835</c:v>
                </c:pt>
                <c:pt idx="5660">
                  <c:v>2.9628899873917911</c:v>
                </c:pt>
                <c:pt idx="5661">
                  <c:v>2.9616978784681622</c:v>
                </c:pt>
                <c:pt idx="5662">
                  <c:v>2.9616715256476502</c:v>
                </c:pt>
                <c:pt idx="5663">
                  <c:v>2.9616030008296912</c:v>
                </c:pt>
                <c:pt idx="5664">
                  <c:v>2.9608960372626982</c:v>
                </c:pt>
                <c:pt idx="5665">
                  <c:v>2.9608009842699214</c:v>
                </c:pt>
                <c:pt idx="5666">
                  <c:v>2.9605394812181562</c:v>
                </c:pt>
                <c:pt idx="5667">
                  <c:v>2.9603544849959409</c:v>
                </c:pt>
                <c:pt idx="5668">
                  <c:v>2.9603016144552448</c:v>
                </c:pt>
                <c:pt idx="5669">
                  <c:v>2.9601297407330449</c:v>
                </c:pt>
                <c:pt idx="5670">
                  <c:v>2.9600027749240598</c:v>
                </c:pt>
                <c:pt idx="5671">
                  <c:v>2.9596534274362787</c:v>
                </c:pt>
                <c:pt idx="5672">
                  <c:v>2.9592614003335256</c:v>
                </c:pt>
                <c:pt idx="5673">
                  <c:v>2.958818620076197</c:v>
                </c:pt>
                <c:pt idx="5674">
                  <c:v>2.958699230779684</c:v>
                </c:pt>
                <c:pt idx="5675">
                  <c:v>2.958534685080588</c:v>
                </c:pt>
                <c:pt idx="5676">
                  <c:v>2.9578758781431569</c:v>
                </c:pt>
                <c:pt idx="5677">
                  <c:v>2.9578413163265695</c:v>
                </c:pt>
                <c:pt idx="5678">
                  <c:v>2.9577322956542913</c:v>
                </c:pt>
                <c:pt idx="5679">
                  <c:v>2.9573465150502107</c:v>
                </c:pt>
                <c:pt idx="5680">
                  <c:v>2.9573145730205876</c:v>
                </c:pt>
                <c:pt idx="5681">
                  <c:v>2.9571388498513493</c:v>
                </c:pt>
                <c:pt idx="5682">
                  <c:v>2.9567365489194546</c:v>
                </c:pt>
                <c:pt idx="5683">
                  <c:v>2.9562965220503674</c:v>
                </c:pt>
                <c:pt idx="5684">
                  <c:v>2.9559682117258381</c:v>
                </c:pt>
                <c:pt idx="5685">
                  <c:v>2.9555862053415485</c:v>
                </c:pt>
                <c:pt idx="5686">
                  <c:v>2.9555167135202338</c:v>
                </c:pt>
                <c:pt idx="5687">
                  <c:v>2.9552413096671506</c:v>
                </c:pt>
                <c:pt idx="5688">
                  <c:v>2.9548800787881162</c:v>
                </c:pt>
                <c:pt idx="5689">
                  <c:v>2.9547836997879151</c:v>
                </c:pt>
                <c:pt idx="5690">
                  <c:v>2.9543979697595106</c:v>
                </c:pt>
                <c:pt idx="5691">
                  <c:v>2.954395289880567</c:v>
                </c:pt>
                <c:pt idx="5692">
                  <c:v>2.9543202465555014</c:v>
                </c:pt>
                <c:pt idx="5693">
                  <c:v>2.9542773588328233</c:v>
                </c:pt>
                <c:pt idx="5694">
                  <c:v>2.9541272184418683</c:v>
                </c:pt>
                <c:pt idx="5695">
                  <c:v>2.9540092145679604</c:v>
                </c:pt>
                <c:pt idx="5696">
                  <c:v>2.9539394699320507</c:v>
                </c:pt>
                <c:pt idx="5697">
                  <c:v>2.9537113804275554</c:v>
                </c:pt>
                <c:pt idx="5698">
                  <c:v>2.9536415879413309</c:v>
                </c:pt>
                <c:pt idx="5699">
                  <c:v>2.9536066874918161</c:v>
                </c:pt>
                <c:pt idx="5700">
                  <c:v>2.9535986331436197</c:v>
                </c:pt>
                <c:pt idx="5701">
                  <c:v>2.9534751144292737</c:v>
                </c:pt>
                <c:pt idx="5702">
                  <c:v>2.9533569332123819</c:v>
                </c:pt>
                <c:pt idx="5703">
                  <c:v>2.953279023459797</c:v>
                </c:pt>
                <c:pt idx="5704">
                  <c:v>2.9531822884566528</c:v>
                </c:pt>
                <c:pt idx="5705">
                  <c:v>2.952781683726327</c:v>
                </c:pt>
                <c:pt idx="5706">
                  <c:v>2.9524587801833073</c:v>
                </c:pt>
                <c:pt idx="5707">
                  <c:v>2.9521706552393856</c:v>
                </c:pt>
                <c:pt idx="5708">
                  <c:v>2.9521006146940674</c:v>
                </c:pt>
                <c:pt idx="5709">
                  <c:v>2.9520305628511867</c:v>
                </c:pt>
                <c:pt idx="5710">
                  <c:v>2.9512943354925207</c:v>
                </c:pt>
                <c:pt idx="5711">
                  <c:v>2.9511377600132778</c:v>
                </c:pt>
                <c:pt idx="5712">
                  <c:v>2.9507163456491456</c:v>
                </c:pt>
                <c:pt idx="5713">
                  <c:v>2.9505406355720636</c:v>
                </c:pt>
                <c:pt idx="5714">
                  <c:v>2.9496555986957396</c:v>
                </c:pt>
                <c:pt idx="5715">
                  <c:v>2.949533663329361</c:v>
                </c:pt>
                <c:pt idx="5716">
                  <c:v>2.9493574740045814</c:v>
                </c:pt>
                <c:pt idx="5717">
                  <c:v>2.949240878693864</c:v>
                </c:pt>
                <c:pt idx="5718">
                  <c:v>2.9488067605363004</c:v>
                </c:pt>
                <c:pt idx="5719">
                  <c:v>2.9486710095718593</c:v>
                </c:pt>
                <c:pt idx="5720">
                  <c:v>2.9483504689579401</c:v>
                </c:pt>
                <c:pt idx="5721">
                  <c:v>2.9482471936329042</c:v>
                </c:pt>
                <c:pt idx="5722">
                  <c:v>2.9479698594231256</c:v>
                </c:pt>
                <c:pt idx="5723">
                  <c:v>2.9477549395905642</c:v>
                </c:pt>
                <c:pt idx="5724">
                  <c:v>2.9475562481911228</c:v>
                </c:pt>
                <c:pt idx="5725">
                  <c:v>2.9475480808462131</c:v>
                </c:pt>
                <c:pt idx="5726">
                  <c:v>2.9470468565249432</c:v>
                </c:pt>
                <c:pt idx="5727">
                  <c:v>2.9470032444511571</c:v>
                </c:pt>
                <c:pt idx="5728">
                  <c:v>2.9456518277123989</c:v>
                </c:pt>
                <c:pt idx="5729">
                  <c:v>2.9455889322576025</c:v>
                </c:pt>
                <c:pt idx="5730">
                  <c:v>2.9453919832298832</c:v>
                </c:pt>
                <c:pt idx="5731">
                  <c:v>2.9450909163145611</c:v>
                </c:pt>
                <c:pt idx="5732">
                  <c:v>2.9448992195536237</c:v>
                </c:pt>
                <c:pt idx="5733">
                  <c:v>2.9447266200934905</c:v>
                </c:pt>
                <c:pt idx="5734">
                  <c:v>2.9446772933602583</c:v>
                </c:pt>
                <c:pt idx="5735">
                  <c:v>2.9445128304420392</c:v>
                </c:pt>
                <c:pt idx="5736">
                  <c:v>2.9437362729175294</c:v>
                </c:pt>
                <c:pt idx="5737">
                  <c:v>2.943640135678518</c:v>
                </c:pt>
                <c:pt idx="5738">
                  <c:v>2.9432306274082958</c:v>
                </c:pt>
                <c:pt idx="5739">
                  <c:v>2.942961075740461</c:v>
                </c:pt>
                <c:pt idx="5740">
                  <c:v>2.9429198030646977</c:v>
                </c:pt>
                <c:pt idx="5741">
                  <c:v>2.9429142997448992</c:v>
                </c:pt>
                <c:pt idx="5742">
                  <c:v>2.9424407531641421</c:v>
                </c:pt>
                <c:pt idx="5743">
                  <c:v>2.9422974862099025</c:v>
                </c:pt>
                <c:pt idx="5744">
                  <c:v>2.9421073089893555</c:v>
                </c:pt>
                <c:pt idx="5745">
                  <c:v>2.9420824971241846</c:v>
                </c:pt>
                <c:pt idx="5746">
                  <c:v>2.9411855619400225</c:v>
                </c:pt>
                <c:pt idx="5747">
                  <c:v>2.9407903228540491</c:v>
                </c:pt>
                <c:pt idx="5748">
                  <c:v>2.9407460779163124</c:v>
                </c:pt>
                <c:pt idx="5749">
                  <c:v>2.9403919560480141</c:v>
                </c:pt>
                <c:pt idx="5750">
                  <c:v>2.9403642781127615</c:v>
                </c:pt>
                <c:pt idx="5751">
                  <c:v>2.9402895388755157</c:v>
                </c:pt>
                <c:pt idx="5752">
                  <c:v>2.9401732522682944</c:v>
                </c:pt>
                <c:pt idx="5753">
                  <c:v>2.9401095583103882</c:v>
                </c:pt>
                <c:pt idx="5754">
                  <c:v>2.9400846320446679</c:v>
                </c:pt>
                <c:pt idx="5755">
                  <c:v>2.9397992628591969</c:v>
                </c:pt>
                <c:pt idx="5756">
                  <c:v>2.9394332726590249</c:v>
                </c:pt>
                <c:pt idx="5757">
                  <c:v>2.9394138554734135</c:v>
                </c:pt>
                <c:pt idx="5758">
                  <c:v>2.9393944374196264</c:v>
                </c:pt>
                <c:pt idx="5759">
                  <c:v>2.9393777926824676</c:v>
                </c:pt>
                <c:pt idx="5760">
                  <c:v>2.9392723611971716</c:v>
                </c:pt>
                <c:pt idx="5761">
                  <c:v>2.9392196358548182</c:v>
                </c:pt>
                <c:pt idx="5762">
                  <c:v>2.9391974337955165</c:v>
                </c:pt>
                <c:pt idx="5763">
                  <c:v>2.9389975641695134</c:v>
                </c:pt>
                <c:pt idx="5764">
                  <c:v>2.9388503791187182</c:v>
                </c:pt>
                <c:pt idx="5765">
                  <c:v>2.9381359622345729</c:v>
                </c:pt>
                <c:pt idx="5766">
                  <c:v>2.9379105520352358</c:v>
                </c:pt>
                <c:pt idx="5767">
                  <c:v>2.9378548771812194</c:v>
                </c:pt>
                <c:pt idx="5768">
                  <c:v>2.9377490752912965</c:v>
                </c:pt>
                <c:pt idx="5769">
                  <c:v>2.9371667037150329</c:v>
                </c:pt>
                <c:pt idx="5770">
                  <c:v>2.9368989409340003</c:v>
                </c:pt>
                <c:pt idx="5771">
                  <c:v>2.9365388745342171</c:v>
                </c:pt>
                <c:pt idx="5772">
                  <c:v>2.9358681881751791</c:v>
                </c:pt>
                <c:pt idx="5773">
                  <c:v>2.9355548463980878</c:v>
                </c:pt>
                <c:pt idx="5774">
                  <c:v>2.9347508746635791</c:v>
                </c:pt>
                <c:pt idx="5775">
                  <c:v>2.9346639453822321</c:v>
                </c:pt>
                <c:pt idx="5776">
                  <c:v>2.9346611409221484</c:v>
                </c:pt>
                <c:pt idx="5777">
                  <c:v>2.9346022430766299</c:v>
                </c:pt>
                <c:pt idx="5778">
                  <c:v>2.9343665717863741</c:v>
                </c:pt>
                <c:pt idx="5779">
                  <c:v>2.9341925418601948</c:v>
                </c:pt>
                <c:pt idx="5780">
                  <c:v>2.9340886520549159</c:v>
                </c:pt>
                <c:pt idx="5781">
                  <c:v>2.9335210312527784</c:v>
                </c:pt>
                <c:pt idx="5782">
                  <c:v>2.9333551009334013</c:v>
                </c:pt>
                <c:pt idx="5783">
                  <c:v>2.9332932123802151</c:v>
                </c:pt>
                <c:pt idx="5784">
                  <c:v>2.9331722229190076</c:v>
                </c:pt>
                <c:pt idx="5785">
                  <c:v>2.9328287669008466</c:v>
                </c:pt>
                <c:pt idx="5786">
                  <c:v>2.932527315341972</c:v>
                </c:pt>
                <c:pt idx="5787">
                  <c:v>2.9321833487261899</c:v>
                </c:pt>
                <c:pt idx="5788">
                  <c:v>2.9320027982228143</c:v>
                </c:pt>
                <c:pt idx="5789">
                  <c:v>2.9319266059607121</c:v>
                </c:pt>
                <c:pt idx="5790">
                  <c:v>2.9317403019156481</c:v>
                </c:pt>
                <c:pt idx="5791">
                  <c:v>2.9311243654314385</c:v>
                </c:pt>
                <c:pt idx="5792">
                  <c:v>2.9308415332330608</c:v>
                </c:pt>
                <c:pt idx="5793">
                  <c:v>2.9305556856248214</c:v>
                </c:pt>
                <c:pt idx="5794">
                  <c:v>2.9305075541568559</c:v>
                </c:pt>
                <c:pt idx="5795">
                  <c:v>2.9299522410163825</c:v>
                </c:pt>
                <c:pt idx="5796">
                  <c:v>2.9293451177661884</c:v>
                </c:pt>
                <c:pt idx="5797">
                  <c:v>2.9287229294372801</c:v>
                </c:pt>
                <c:pt idx="5798">
                  <c:v>2.9285864402156885</c:v>
                </c:pt>
                <c:pt idx="5799">
                  <c:v>2.9281937945928092</c:v>
                </c:pt>
                <c:pt idx="5800">
                  <c:v>2.9280571389482231</c:v>
                </c:pt>
                <c:pt idx="5801">
                  <c:v>2.927880561741528</c:v>
                </c:pt>
                <c:pt idx="5802">
                  <c:v>2.9278235860339108</c:v>
                </c:pt>
                <c:pt idx="5803">
                  <c:v>2.9276668642854609</c:v>
                </c:pt>
                <c:pt idx="5804">
                  <c:v>2.9274587643968148</c:v>
                </c:pt>
                <c:pt idx="5805">
                  <c:v>2.9272334480057638</c:v>
                </c:pt>
                <c:pt idx="5806">
                  <c:v>2.9272134776232539</c:v>
                </c:pt>
                <c:pt idx="5807">
                  <c:v>2.9271364404017421</c:v>
                </c:pt>
                <c:pt idx="5808">
                  <c:v>2.926679642892501</c:v>
                </c:pt>
                <c:pt idx="5809">
                  <c:v>2.926611081806981</c:v>
                </c:pt>
                <c:pt idx="5810">
                  <c:v>2.9264853583653707</c:v>
                </c:pt>
                <c:pt idx="5811">
                  <c:v>2.926082226516054</c:v>
                </c:pt>
                <c:pt idx="5812">
                  <c:v>2.926065063665872</c:v>
                </c:pt>
                <c:pt idx="5813">
                  <c:v>2.9254782584395835</c:v>
                </c:pt>
                <c:pt idx="5814">
                  <c:v>2.9253034949283863</c:v>
                </c:pt>
                <c:pt idx="5815">
                  <c:v>2.9252404482058161</c:v>
                </c:pt>
                <c:pt idx="5816">
                  <c:v>2.9247386139544114</c:v>
                </c:pt>
                <c:pt idx="5817">
                  <c:v>2.9245434589561539</c:v>
                </c:pt>
                <c:pt idx="5818">
                  <c:v>2.9241615050540917</c:v>
                </c:pt>
                <c:pt idx="5819">
                  <c:v>2.9240321964368481</c:v>
                </c:pt>
                <c:pt idx="5820">
                  <c:v>2.9238913499200501</c:v>
                </c:pt>
                <c:pt idx="5821">
                  <c:v>2.9234253686715865</c:v>
                </c:pt>
                <c:pt idx="5822">
                  <c:v>2.9230625928302865</c:v>
                </c:pt>
                <c:pt idx="5823">
                  <c:v>2.9230309075362948</c:v>
                </c:pt>
                <c:pt idx="5824">
                  <c:v>2.9228580379546538</c:v>
                </c:pt>
                <c:pt idx="5825">
                  <c:v>2.9226678019053023</c:v>
                </c:pt>
                <c:pt idx="5826">
                  <c:v>2.922532279961723</c:v>
                </c:pt>
                <c:pt idx="5827">
                  <c:v>2.9224428699968441</c:v>
                </c:pt>
                <c:pt idx="5828">
                  <c:v>2.9223822914962332</c:v>
                </c:pt>
                <c:pt idx="5829">
                  <c:v>2.9214032104089247</c:v>
                </c:pt>
                <c:pt idx="5830">
                  <c:v>2.920250904753698</c:v>
                </c:pt>
                <c:pt idx="5831">
                  <c:v>2.9201262262174863</c:v>
                </c:pt>
                <c:pt idx="5832">
                  <c:v>2.9199783052582537</c:v>
                </c:pt>
                <c:pt idx="5833">
                  <c:v>2.9193454470968221</c:v>
                </c:pt>
                <c:pt idx="5834">
                  <c:v>2.9188309334991636</c:v>
                </c:pt>
                <c:pt idx="5835">
                  <c:v>2.9185457991701447</c:v>
                </c:pt>
                <c:pt idx="5836">
                  <c:v>2.9182808638502022</c:v>
                </c:pt>
                <c:pt idx="5837">
                  <c:v>2.9180827846421873</c:v>
                </c:pt>
                <c:pt idx="5838">
                  <c:v>2.9171786300044871</c:v>
                </c:pt>
                <c:pt idx="5839">
                  <c:v>2.9165738382208533</c:v>
                </c:pt>
                <c:pt idx="5840">
                  <c:v>2.9165299799852762</c:v>
                </c:pt>
                <c:pt idx="5841">
                  <c:v>2.9158979297983145</c:v>
                </c:pt>
                <c:pt idx="5842">
                  <c:v>2.9155991416039968</c:v>
                </c:pt>
                <c:pt idx="5843">
                  <c:v>2.9153177412819029</c:v>
                </c:pt>
                <c:pt idx="5844">
                  <c:v>2.9149099736650408</c:v>
                </c:pt>
                <c:pt idx="5845">
                  <c:v>2.914363728166776</c:v>
                </c:pt>
                <c:pt idx="5846">
                  <c:v>2.9139668289142224</c:v>
                </c:pt>
                <c:pt idx="5847">
                  <c:v>2.9137020277558614</c:v>
                </c:pt>
                <c:pt idx="5848">
                  <c:v>2.9136990846136333</c:v>
                </c:pt>
                <c:pt idx="5849">
                  <c:v>2.9134547342535191</c:v>
                </c:pt>
                <c:pt idx="5850">
                  <c:v>2.9132868477176084</c:v>
                </c:pt>
                <c:pt idx="5851">
                  <c:v>2.9130687928925529</c:v>
                </c:pt>
                <c:pt idx="5852">
                  <c:v>2.9119502790578959</c:v>
                </c:pt>
                <c:pt idx="5853">
                  <c:v>2.9118941299058045</c:v>
                </c:pt>
                <c:pt idx="5854">
                  <c:v>2.9118882190464266</c:v>
                </c:pt>
                <c:pt idx="5855">
                  <c:v>2.9115955309112596</c:v>
                </c:pt>
                <c:pt idx="5856">
                  <c:v>2.9112671306878943</c:v>
                </c:pt>
                <c:pt idx="5857">
                  <c:v>2.9112404927560229</c:v>
                </c:pt>
                <c:pt idx="5858">
                  <c:v>2.911024369137182</c:v>
                </c:pt>
                <c:pt idx="5859">
                  <c:v>2.9110095622132648</c:v>
                </c:pt>
                <c:pt idx="5860">
                  <c:v>2.9100757067973841</c:v>
                </c:pt>
                <c:pt idx="5861">
                  <c:v>2.9099183843739258</c:v>
                </c:pt>
                <c:pt idx="5862">
                  <c:v>2.9093806834045406</c:v>
                </c:pt>
                <c:pt idx="5863">
                  <c:v>2.9090773760512048</c:v>
                </c:pt>
                <c:pt idx="5864">
                  <c:v>2.9087292036309091</c:v>
                </c:pt>
                <c:pt idx="5865">
                  <c:v>2.9083867106478554</c:v>
                </c:pt>
                <c:pt idx="5866">
                  <c:v>2.9083479770522072</c:v>
                </c:pt>
                <c:pt idx="5867">
                  <c:v>2.9082883801586696</c:v>
                </c:pt>
                <c:pt idx="5868">
                  <c:v>2.9082734796573391</c:v>
                </c:pt>
                <c:pt idx="5869">
                  <c:v>2.9078142936767568</c:v>
                </c:pt>
                <c:pt idx="5870">
                  <c:v>2.9075546686399032</c:v>
                </c:pt>
                <c:pt idx="5871">
                  <c:v>2.9073934439659901</c:v>
                </c:pt>
                <c:pt idx="5872">
                  <c:v>2.9073516352045403</c:v>
                </c:pt>
                <c:pt idx="5873">
                  <c:v>2.9065594950024498</c:v>
                </c:pt>
                <c:pt idx="5874">
                  <c:v>2.90655051910145</c:v>
                </c:pt>
                <c:pt idx="5875">
                  <c:v>2.9065325667428956</c:v>
                </c:pt>
                <c:pt idx="5876">
                  <c:v>2.9060056338044036</c:v>
                </c:pt>
                <c:pt idx="5877">
                  <c:v>2.9053160631867287</c:v>
                </c:pt>
                <c:pt idx="5878">
                  <c:v>2.9052530478088272</c:v>
                </c:pt>
                <c:pt idx="5879">
                  <c:v>2.9048116839618046</c:v>
                </c:pt>
                <c:pt idx="5880">
                  <c:v>2.9046644629457581</c:v>
                </c:pt>
                <c:pt idx="5881">
                  <c:v>2.9045893309513722</c:v>
                </c:pt>
                <c:pt idx="5882">
                  <c:v>2.904490136812572</c:v>
                </c:pt>
                <c:pt idx="5883">
                  <c:v>2.9043458139726357</c:v>
                </c:pt>
                <c:pt idx="5884">
                  <c:v>2.9042555878365439</c:v>
                </c:pt>
                <c:pt idx="5885">
                  <c:v>2.9040540150945606</c:v>
                </c:pt>
                <c:pt idx="5886">
                  <c:v>2.9039366386135548</c:v>
                </c:pt>
                <c:pt idx="5887">
                  <c:v>2.9038433167244628</c:v>
                </c:pt>
                <c:pt idx="5888">
                  <c:v>2.9033975033507677</c:v>
                </c:pt>
                <c:pt idx="5889">
                  <c:v>2.9033733922884619</c:v>
                </c:pt>
                <c:pt idx="5890">
                  <c:v>2.9033462657432358</c:v>
                </c:pt>
                <c:pt idx="5891">
                  <c:v>2.9022930496925086</c:v>
                </c:pt>
                <c:pt idx="5892">
                  <c:v>2.9015521571310732</c:v>
                </c:pt>
                <c:pt idx="5893">
                  <c:v>2.9008948808207751</c:v>
                </c:pt>
                <c:pt idx="5894">
                  <c:v>2.9008251572496717</c:v>
                </c:pt>
                <c:pt idx="5895">
                  <c:v>2.9005218810857119</c:v>
                </c:pt>
                <c:pt idx="5896">
                  <c:v>2.9004247879674754</c:v>
                </c:pt>
                <c:pt idx="5897">
                  <c:v>2.9001242686015449</c:v>
                </c:pt>
                <c:pt idx="5898">
                  <c:v>2.8999146926666923</c:v>
                </c:pt>
                <c:pt idx="5899">
                  <c:v>2.899343160474491</c:v>
                </c:pt>
                <c:pt idx="5900">
                  <c:v>2.899184944221461</c:v>
                </c:pt>
                <c:pt idx="5901">
                  <c:v>2.8990358030635912</c:v>
                </c:pt>
                <c:pt idx="5902">
                  <c:v>2.8987952430892001</c:v>
                </c:pt>
                <c:pt idx="5903">
                  <c:v>2.8987556444998908</c:v>
                </c:pt>
                <c:pt idx="5904">
                  <c:v>2.8986551087854622</c:v>
                </c:pt>
                <c:pt idx="5905">
                  <c:v>2.8978927176361333</c:v>
                </c:pt>
                <c:pt idx="5906">
                  <c:v>2.8974010283036833</c:v>
                </c:pt>
                <c:pt idx="5907">
                  <c:v>2.8971381585262717</c:v>
                </c:pt>
                <c:pt idx="5908">
                  <c:v>2.8970586549349755</c:v>
                </c:pt>
                <c:pt idx="5909">
                  <c:v>2.8968843076544371</c:v>
                </c:pt>
                <c:pt idx="5910">
                  <c:v>2.8968812483053976</c:v>
                </c:pt>
                <c:pt idx="5911">
                  <c:v>2.8964343519192703</c:v>
                </c:pt>
                <c:pt idx="5912">
                  <c:v>2.896391474668778</c:v>
                </c:pt>
                <c:pt idx="5913">
                  <c:v>2.8958214176817556</c:v>
                </c:pt>
                <c:pt idx="5914">
                  <c:v>2.8956005494194259</c:v>
                </c:pt>
                <c:pt idx="5915">
                  <c:v>2.8955207638228089</c:v>
                </c:pt>
                <c:pt idx="5916">
                  <c:v>2.8949710724891178</c:v>
                </c:pt>
                <c:pt idx="5917">
                  <c:v>2.8943252950370266</c:v>
                </c:pt>
                <c:pt idx="5918">
                  <c:v>2.8943252950370266</c:v>
                </c:pt>
                <c:pt idx="5919">
                  <c:v>2.8941467680953772</c:v>
                </c:pt>
                <c:pt idx="5920">
                  <c:v>2.8939158054327017</c:v>
                </c:pt>
                <c:pt idx="5921">
                  <c:v>2.8931388699585732</c:v>
                </c:pt>
                <c:pt idx="5922">
                  <c:v>2.8925305342710605</c:v>
                </c:pt>
                <c:pt idx="5923">
                  <c:v>2.8922894347104955</c:v>
                </c:pt>
                <c:pt idx="5924">
                  <c:v>2.892023451754997</c:v>
                </c:pt>
                <c:pt idx="5925">
                  <c:v>2.8918161195248606</c:v>
                </c:pt>
                <c:pt idx="5926">
                  <c:v>2.8915374576725643</c:v>
                </c:pt>
                <c:pt idx="5927">
                  <c:v>2.8911284299184601</c:v>
                </c:pt>
                <c:pt idx="5928">
                  <c:v>2.8908152013577268</c:v>
                </c:pt>
                <c:pt idx="5929">
                  <c:v>2.8900295861634167</c:v>
                </c:pt>
                <c:pt idx="5930">
                  <c:v>2.8899860718623032</c:v>
                </c:pt>
                <c:pt idx="5931">
                  <c:v>2.8897435551959796</c:v>
                </c:pt>
                <c:pt idx="5932">
                  <c:v>2.8897404451285436</c:v>
                </c:pt>
                <c:pt idx="5933">
                  <c:v>2.8892923627396048</c:v>
                </c:pt>
                <c:pt idx="5934">
                  <c:v>2.8888936788011716</c:v>
                </c:pt>
                <c:pt idx="5935">
                  <c:v>2.8887253741814858</c:v>
                </c:pt>
                <c:pt idx="5936">
                  <c:v>2.8886256073239918</c:v>
                </c:pt>
                <c:pt idx="5937">
                  <c:v>2.8885944254803348</c:v>
                </c:pt>
                <c:pt idx="5938">
                  <c:v>2.8883636102284078</c:v>
                </c:pt>
                <c:pt idx="5939">
                  <c:v>2.8878391413945157</c:v>
                </c:pt>
                <c:pt idx="5940">
                  <c:v>2.8874485002499539</c:v>
                </c:pt>
                <c:pt idx="5941">
                  <c:v>2.8874234872490163</c:v>
                </c:pt>
                <c:pt idx="5942">
                  <c:v>2.8865063920789935</c:v>
                </c:pt>
                <c:pt idx="5943">
                  <c:v>2.8860925961374306</c:v>
                </c:pt>
                <c:pt idx="5944">
                  <c:v>2.8859388896701494</c:v>
                </c:pt>
                <c:pt idx="5945">
                  <c:v>2.885926339801431</c:v>
                </c:pt>
                <c:pt idx="5946">
                  <c:v>2.8853329447307496</c:v>
                </c:pt>
                <c:pt idx="5947">
                  <c:v>2.8849557647066915</c:v>
                </c:pt>
                <c:pt idx="5948">
                  <c:v>2.8849557647066915</c:v>
                </c:pt>
                <c:pt idx="5949">
                  <c:v>2.8849526201631419</c:v>
                </c:pt>
                <c:pt idx="5950">
                  <c:v>2.8849211734753251</c:v>
                </c:pt>
                <c:pt idx="5951">
                  <c:v>2.8845247499909021</c:v>
                </c:pt>
                <c:pt idx="5952">
                  <c:v>2.8842350691877554</c:v>
                </c:pt>
                <c:pt idx="5953">
                  <c:v>2.8841689193008127</c:v>
                </c:pt>
                <c:pt idx="5954">
                  <c:v>2.8830965166101787</c:v>
                </c:pt>
                <c:pt idx="5955">
                  <c:v>2.8824170103560065</c:v>
                </c:pt>
                <c:pt idx="5956">
                  <c:v>2.8824106843739679</c:v>
                </c:pt>
                <c:pt idx="5957">
                  <c:v>2.8822525048684704</c:v>
                </c:pt>
                <c:pt idx="5958">
                  <c:v>2.8814544020722526</c:v>
                </c:pt>
                <c:pt idx="5959">
                  <c:v>2.8812546469947558</c:v>
                </c:pt>
                <c:pt idx="5960">
                  <c:v>2.8811055635027487</c:v>
                </c:pt>
                <c:pt idx="5961">
                  <c:v>2.8807596195836438</c:v>
                </c:pt>
                <c:pt idx="5962">
                  <c:v>2.8805246014299493</c:v>
                </c:pt>
                <c:pt idx="5963">
                  <c:v>2.8805023633972877</c:v>
                </c:pt>
                <c:pt idx="5964">
                  <c:v>2.880365733352213</c:v>
                </c:pt>
                <c:pt idx="5965">
                  <c:v>2.8802513123406648</c:v>
                </c:pt>
                <c:pt idx="5966">
                  <c:v>2.8799587660565473</c:v>
                </c:pt>
                <c:pt idx="5967">
                  <c:v>2.879869691102249</c:v>
                </c:pt>
                <c:pt idx="5968">
                  <c:v>2.8798156009652702</c:v>
                </c:pt>
                <c:pt idx="5969">
                  <c:v>2.8793794520179472</c:v>
                </c:pt>
                <c:pt idx="5970">
                  <c:v>2.8793412283189954</c:v>
                </c:pt>
                <c:pt idx="5971">
                  <c:v>2.8790066273713051</c:v>
                </c:pt>
                <c:pt idx="5972">
                  <c:v>2.8789109797318049</c:v>
                </c:pt>
                <c:pt idx="5973">
                  <c:v>2.878087539299842</c:v>
                </c:pt>
                <c:pt idx="5974">
                  <c:v>2.8780619812900126</c:v>
                </c:pt>
                <c:pt idx="5975">
                  <c:v>2.8778830330946845</c:v>
                </c:pt>
                <c:pt idx="5976">
                  <c:v>2.8774737315558503</c:v>
                </c:pt>
                <c:pt idx="5977">
                  <c:v>2.8773969445542824</c:v>
                </c:pt>
                <c:pt idx="5978">
                  <c:v>2.8770832566506508</c:v>
                </c:pt>
                <c:pt idx="5979">
                  <c:v>2.8767629332241929</c:v>
                </c:pt>
                <c:pt idx="5980">
                  <c:v>2.8766122995582499</c:v>
                </c:pt>
                <c:pt idx="5981">
                  <c:v>2.8762948363336935</c:v>
                </c:pt>
                <c:pt idx="5982">
                  <c:v>2.8758262343685201</c:v>
                </c:pt>
                <c:pt idx="5983">
                  <c:v>2.8757363076873337</c:v>
                </c:pt>
                <c:pt idx="5984">
                  <c:v>2.8756913373630653</c:v>
                </c:pt>
                <c:pt idx="5985">
                  <c:v>2.8754696298509255</c:v>
                </c:pt>
                <c:pt idx="5986">
                  <c:v>2.875299255886091</c:v>
                </c:pt>
                <c:pt idx="5987">
                  <c:v>2.8751481136033492</c:v>
                </c:pt>
                <c:pt idx="5988">
                  <c:v>2.875128815057225</c:v>
                </c:pt>
                <c:pt idx="5989">
                  <c:v>2.8742949426088518</c:v>
                </c:pt>
                <c:pt idx="5990">
                  <c:v>2.8742820517070431</c:v>
                </c:pt>
                <c:pt idx="5991">
                  <c:v>2.8738661148396529</c:v>
                </c:pt>
                <c:pt idx="5992">
                  <c:v>2.8738274027786654</c:v>
                </c:pt>
                <c:pt idx="5993">
                  <c:v>2.8737467415669022</c:v>
                </c:pt>
                <c:pt idx="5994">
                  <c:v>2.8732301547545918</c:v>
                </c:pt>
                <c:pt idx="5995">
                  <c:v>2.87193275275312</c:v>
                </c:pt>
                <c:pt idx="5996">
                  <c:v>2.8717480189918718</c:v>
                </c:pt>
                <c:pt idx="5997">
                  <c:v>2.8716118490786231</c:v>
                </c:pt>
                <c:pt idx="5998">
                  <c:v>2.871329646938372</c:v>
                </c:pt>
                <c:pt idx="5999">
                  <c:v>2.8712452750649411</c:v>
                </c:pt>
                <c:pt idx="6000">
                  <c:v>2.8710797287652681</c:v>
                </c:pt>
                <c:pt idx="6001">
                  <c:v>2.8710634953387886</c:v>
                </c:pt>
                <c:pt idx="6002">
                  <c:v>2.8708621504223863</c:v>
                </c:pt>
                <c:pt idx="6003">
                  <c:v>2.8707127051407046</c:v>
                </c:pt>
                <c:pt idx="6004">
                  <c:v>2.8705762101739287</c:v>
                </c:pt>
                <c:pt idx="6005">
                  <c:v>2.8693360422109166</c:v>
                </c:pt>
                <c:pt idx="6006">
                  <c:v>2.8687456379167573</c:v>
                </c:pt>
                <c:pt idx="6007">
                  <c:v>2.8684844297490146</c:v>
                </c:pt>
                <c:pt idx="6008">
                  <c:v>2.8683537667272456</c:v>
                </c:pt>
                <c:pt idx="6009">
                  <c:v>2.8677456667345353</c:v>
                </c:pt>
                <c:pt idx="6010">
                  <c:v>2.8674216530663799</c:v>
                </c:pt>
                <c:pt idx="6011">
                  <c:v>2.8672480918039165</c:v>
                </c:pt>
                <c:pt idx="6012">
                  <c:v>2.8672251634319563</c:v>
                </c:pt>
                <c:pt idx="6013">
                  <c:v>2.8669368177316392</c:v>
                </c:pt>
                <c:pt idx="6014">
                  <c:v>2.8668384742874786</c:v>
                </c:pt>
                <c:pt idx="6015">
                  <c:v>2.8659918001262752</c:v>
                </c:pt>
                <c:pt idx="6016">
                  <c:v>2.8652323283020431</c:v>
                </c:pt>
                <c:pt idx="6017">
                  <c:v>2.8644385607461005</c:v>
                </c:pt>
                <c:pt idx="6018">
                  <c:v>2.86443526408052</c:v>
                </c:pt>
                <c:pt idx="6019">
                  <c:v>2.8641153685190299</c:v>
                </c:pt>
                <c:pt idx="6020">
                  <c:v>2.8640130841494691</c:v>
                </c:pt>
                <c:pt idx="6021">
                  <c:v>2.8636565503295475</c:v>
                </c:pt>
                <c:pt idx="6022">
                  <c:v>2.8631311200837692</c:v>
                </c:pt>
                <c:pt idx="6023">
                  <c:v>2.8626249165249216</c:v>
                </c:pt>
                <c:pt idx="6024">
                  <c:v>2.8623434371697423</c:v>
                </c:pt>
                <c:pt idx="6025">
                  <c:v>2.8620882924057245</c:v>
                </c:pt>
                <c:pt idx="6026">
                  <c:v>2.8614447947741368</c:v>
                </c:pt>
                <c:pt idx="6027">
                  <c:v>2.8601982111372655</c:v>
                </c:pt>
                <c:pt idx="6028">
                  <c:v>2.8601649198766492</c:v>
                </c:pt>
                <c:pt idx="6029">
                  <c:v>2.8596119118320287</c:v>
                </c:pt>
                <c:pt idx="6030">
                  <c:v>2.8594452050572543</c:v>
                </c:pt>
                <c:pt idx="6031">
                  <c:v>2.8592150445706648</c:v>
                </c:pt>
                <c:pt idx="6032">
                  <c:v>2.8587677174759034</c:v>
                </c:pt>
                <c:pt idx="6033">
                  <c:v>2.8587109340748023</c:v>
                </c:pt>
                <c:pt idx="6034">
                  <c:v>2.8586040275277464</c:v>
                </c:pt>
                <c:pt idx="6035">
                  <c:v>2.8582028934334311</c:v>
                </c:pt>
                <c:pt idx="6036">
                  <c:v>2.8576373338492722</c:v>
                </c:pt>
                <c:pt idx="6037">
                  <c:v>2.8565778576976868</c:v>
                </c:pt>
                <c:pt idx="6038">
                  <c:v>2.8565677869842427</c:v>
                </c:pt>
                <c:pt idx="6039">
                  <c:v>2.8565409306066507</c:v>
                </c:pt>
                <c:pt idx="6040">
                  <c:v>2.8556032739895305</c:v>
                </c:pt>
                <c:pt idx="6041">
                  <c:v>2.8554350210500701</c:v>
                </c:pt>
                <c:pt idx="6042">
                  <c:v>2.8552667029013454</c:v>
                </c:pt>
                <c:pt idx="6043">
                  <c:v>2.8550242101056709</c:v>
                </c:pt>
                <c:pt idx="6044">
                  <c:v>2.8549130223078554</c:v>
                </c:pt>
                <c:pt idx="6045">
                  <c:v>2.8546737035243965</c:v>
                </c:pt>
                <c:pt idx="6046">
                  <c:v>2.8543262881581342</c:v>
                </c:pt>
                <c:pt idx="6047">
                  <c:v>2.8538941610280371</c:v>
                </c:pt>
                <c:pt idx="6048">
                  <c:v>2.85387389451517</c:v>
                </c:pt>
                <c:pt idx="6049">
                  <c:v>2.8537015909606773</c:v>
                </c:pt>
                <c:pt idx="6050">
                  <c:v>2.8535021740740936</c:v>
                </c:pt>
                <c:pt idx="6051">
                  <c:v>2.8533872142666197</c:v>
                </c:pt>
                <c:pt idx="6052">
                  <c:v>2.8530218458367824</c:v>
                </c:pt>
                <c:pt idx="6053">
                  <c:v>2.8526798803271438</c:v>
                </c:pt>
                <c:pt idx="6054">
                  <c:v>2.8526053570631875</c:v>
                </c:pt>
                <c:pt idx="6055">
                  <c:v>2.8519985329123108</c:v>
                </c:pt>
                <c:pt idx="6056">
                  <c:v>2.8513568863656586</c:v>
                </c:pt>
                <c:pt idx="6057">
                  <c:v>2.8512243650356663</c:v>
                </c:pt>
                <c:pt idx="6058">
                  <c:v>2.8511699856103987</c:v>
                </c:pt>
                <c:pt idx="6059">
                  <c:v>2.8510884037034443</c:v>
                </c:pt>
                <c:pt idx="6060">
                  <c:v>2.8509523997934929</c:v>
                </c:pt>
                <c:pt idx="6061">
                  <c:v>2.850547536145569</c:v>
                </c:pt>
                <c:pt idx="6062">
                  <c:v>2.8504930719009631</c:v>
                </c:pt>
                <c:pt idx="6063">
                  <c:v>2.8502853642859654</c:v>
                </c:pt>
                <c:pt idx="6064">
                  <c:v>2.8501218523604996</c:v>
                </c:pt>
                <c:pt idx="6065">
                  <c:v>2.8494057629621561</c:v>
                </c:pt>
                <c:pt idx="6066">
                  <c:v>2.8487978660203366</c:v>
                </c:pt>
                <c:pt idx="6067">
                  <c:v>2.8486269552636019</c:v>
                </c:pt>
                <c:pt idx="6068">
                  <c:v>2.8483670420294116</c:v>
                </c:pt>
                <c:pt idx="6069">
                  <c:v>2.848360200106435</c:v>
                </c:pt>
                <c:pt idx="6070">
                  <c:v>2.848141201639466</c:v>
                </c:pt>
                <c:pt idx="6071">
                  <c:v>2.8479357902328317</c:v>
                </c:pt>
                <c:pt idx="6072">
                  <c:v>2.8478946962903406</c:v>
                </c:pt>
                <c:pt idx="6073">
                  <c:v>2.8472915379715982</c:v>
                </c:pt>
                <c:pt idx="6074">
                  <c:v>2.8468351858590935</c:v>
                </c:pt>
                <c:pt idx="6075">
                  <c:v>2.8463405490779174</c:v>
                </c:pt>
                <c:pt idx="6076">
                  <c:v>2.8461686683441707</c:v>
                </c:pt>
                <c:pt idx="6077">
                  <c:v>2.8461033358249868</c:v>
                </c:pt>
                <c:pt idx="6078">
                  <c:v>2.8457076922499498</c:v>
                </c:pt>
                <c:pt idx="6079">
                  <c:v>2.8455906502994575</c:v>
                </c:pt>
                <c:pt idx="6080">
                  <c:v>2.8455390041155026</c:v>
                </c:pt>
                <c:pt idx="6081">
                  <c:v>2.8454322492021769</c:v>
                </c:pt>
                <c:pt idx="6082">
                  <c:v>2.8451876470910626</c:v>
                </c:pt>
                <c:pt idx="6083">
                  <c:v>2.8450049669385202</c:v>
                </c:pt>
                <c:pt idx="6084">
                  <c:v>2.8448635955968222</c:v>
                </c:pt>
                <c:pt idx="6085">
                  <c:v>2.8446600779946998</c:v>
                </c:pt>
                <c:pt idx="6086">
                  <c:v>2.8444909823766977</c:v>
                </c:pt>
                <c:pt idx="6087">
                  <c:v>2.8439072693947742</c:v>
                </c:pt>
                <c:pt idx="6088">
                  <c:v>2.8434992408537845</c:v>
                </c:pt>
                <c:pt idx="6089">
                  <c:v>2.8430284946509632</c:v>
                </c:pt>
                <c:pt idx="6090">
                  <c:v>2.8423422300637271</c:v>
                </c:pt>
                <c:pt idx="6091">
                  <c:v>2.8422693807784958</c:v>
                </c:pt>
                <c:pt idx="6092">
                  <c:v>2.8422173380921949</c:v>
                </c:pt>
                <c:pt idx="6093">
                  <c:v>2.8419014787107519</c:v>
                </c:pt>
                <c:pt idx="6094">
                  <c:v>2.8417521465163418</c:v>
                </c:pt>
                <c:pt idx="6095">
                  <c:v>2.8416479308472411</c:v>
                </c:pt>
                <c:pt idx="6096">
                  <c:v>2.841599288308656</c:v>
                </c:pt>
                <c:pt idx="6097">
                  <c:v>2.8415888641986786</c:v>
                </c:pt>
                <c:pt idx="6098">
                  <c:v>2.8414533279955227</c:v>
                </c:pt>
                <c:pt idx="6099">
                  <c:v>2.8411508254919644</c:v>
                </c:pt>
                <c:pt idx="6100">
                  <c:v>2.8409455601528903</c:v>
                </c:pt>
                <c:pt idx="6101">
                  <c:v>2.8408585540418794</c:v>
                </c:pt>
                <c:pt idx="6102">
                  <c:v>2.8405451876368386</c:v>
                </c:pt>
                <c:pt idx="6103">
                  <c:v>2.8399735823487746</c:v>
                </c:pt>
                <c:pt idx="6104">
                  <c:v>2.8397572915451454</c:v>
                </c:pt>
                <c:pt idx="6105">
                  <c:v>2.8391916356384859</c:v>
                </c:pt>
                <c:pt idx="6106">
                  <c:v>2.8388490907372552</c:v>
                </c:pt>
                <c:pt idx="6107">
                  <c:v>2.8381421752527305</c:v>
                </c:pt>
                <c:pt idx="6108">
                  <c:v>2.8377181741514956</c:v>
                </c:pt>
                <c:pt idx="6109">
                  <c:v>2.837458663552197</c:v>
                </c:pt>
                <c:pt idx="6110">
                  <c:v>2.8373569211445195</c:v>
                </c:pt>
                <c:pt idx="6111">
                  <c:v>2.8368794660858501</c:v>
                </c:pt>
                <c:pt idx="6112">
                  <c:v>2.8366792000390886</c:v>
                </c:pt>
                <c:pt idx="6113">
                  <c:v>2.8359441000938479</c:v>
                </c:pt>
                <c:pt idx="6114">
                  <c:v>2.8351054826256301</c:v>
                </c:pt>
                <c:pt idx="6115">
                  <c:v>2.8349855478280102</c:v>
                </c:pt>
                <c:pt idx="6116">
                  <c:v>2.8344948813720841</c:v>
                </c:pt>
                <c:pt idx="6117">
                  <c:v>2.8344560279714299</c:v>
                </c:pt>
                <c:pt idx="6118">
                  <c:v>2.8335791365306657</c:v>
                </c:pt>
                <c:pt idx="6119">
                  <c:v>2.8333490129711483</c:v>
                </c:pt>
                <c:pt idx="6120">
                  <c:v>2.8332817230470071</c:v>
                </c:pt>
                <c:pt idx="6121">
                  <c:v>2.8331789972681025</c:v>
                </c:pt>
                <c:pt idx="6122">
                  <c:v>2.8330408104847908</c:v>
                </c:pt>
                <c:pt idx="6123">
                  <c:v>2.8319763626923518</c:v>
                </c:pt>
                <c:pt idx="6124">
                  <c:v>2.8319372833120595</c:v>
                </c:pt>
                <c:pt idx="6125">
                  <c:v>2.83116919304388</c:v>
                </c:pt>
                <c:pt idx="6126">
                  <c:v>2.8305530284174369</c:v>
                </c:pt>
                <c:pt idx="6127">
                  <c:v>2.8304318296249873</c:v>
                </c:pt>
                <c:pt idx="6128">
                  <c:v>2.830146522505343</c:v>
                </c:pt>
                <c:pt idx="6129">
                  <c:v>2.8299966612029488</c:v>
                </c:pt>
                <c:pt idx="6130">
                  <c:v>2.829853888059692</c:v>
                </c:pt>
                <c:pt idx="6131">
                  <c:v>2.8297289230453133</c:v>
                </c:pt>
                <c:pt idx="6132">
                  <c:v>2.8297217811011617</c:v>
                </c:pt>
                <c:pt idx="6133">
                  <c:v>2.8293681079888202</c:v>
                </c:pt>
                <c:pt idx="6134">
                  <c:v>2.8282301147269613</c:v>
                </c:pt>
                <c:pt idx="6135">
                  <c:v>2.8282050309879576</c:v>
                </c:pt>
                <c:pt idx="6136">
                  <c:v>2.8281799458000974</c:v>
                </c:pt>
                <c:pt idx="6137">
                  <c:v>2.8273333675945924</c:v>
                </c:pt>
                <c:pt idx="6138">
                  <c:v>2.8268699208331363</c:v>
                </c:pt>
                <c:pt idx="6139">
                  <c:v>2.8267153286128122</c:v>
                </c:pt>
                <c:pt idx="6140">
                  <c:v>2.8264563532469613</c:v>
                </c:pt>
                <c:pt idx="6141">
                  <c:v>2.8255090592998489</c:v>
                </c:pt>
                <c:pt idx="6142">
                  <c:v>2.8254910298794309</c:v>
                </c:pt>
                <c:pt idx="6143">
                  <c:v>2.8251627635859755</c:v>
                </c:pt>
                <c:pt idx="6144">
                  <c:v>2.8248992496104575</c:v>
                </c:pt>
                <c:pt idx="6145">
                  <c:v>2.8245922166573685</c:v>
                </c:pt>
                <c:pt idx="6146">
                  <c:v>2.8242234903608168</c:v>
                </c:pt>
                <c:pt idx="6147">
                  <c:v>2.8235321891973326</c:v>
                </c:pt>
                <c:pt idx="6148">
                  <c:v>2.8233908980773581</c:v>
                </c:pt>
                <c:pt idx="6149">
                  <c:v>2.823372780506388</c:v>
                </c:pt>
                <c:pt idx="6150">
                  <c:v>2.8232495609755017</c:v>
                </c:pt>
                <c:pt idx="6151">
                  <c:v>2.8230030169832947</c:v>
                </c:pt>
                <c:pt idx="6152">
                  <c:v>2.8226656050542482</c:v>
                </c:pt>
                <c:pt idx="6153">
                  <c:v>2.8221571782652948</c:v>
                </c:pt>
                <c:pt idx="6154">
                  <c:v>2.8215717506767914</c:v>
                </c:pt>
                <c:pt idx="6155">
                  <c:v>2.82093451999167</c:v>
                </c:pt>
                <c:pt idx="6156">
                  <c:v>2.820340142923758</c:v>
                </c:pt>
                <c:pt idx="6157">
                  <c:v>2.8203328448994096</c:v>
                </c:pt>
                <c:pt idx="6158">
                  <c:v>2.8202489088035914</c:v>
                </c:pt>
                <c:pt idx="6159">
                  <c:v>2.8199568307571203</c:v>
                </c:pt>
                <c:pt idx="6160">
                  <c:v>2.8195804907779412</c:v>
                </c:pt>
                <c:pt idx="6161">
                  <c:v>2.8195549024357698</c:v>
                </c:pt>
                <c:pt idx="6162">
                  <c:v>2.8195183450457328</c:v>
                </c:pt>
                <c:pt idx="6163">
                  <c:v>2.819467159529311</c:v>
                </c:pt>
                <c:pt idx="6164">
                  <c:v>2.8187352784304056</c:v>
                </c:pt>
                <c:pt idx="6165">
                  <c:v>2.8185154733753617</c:v>
                </c:pt>
                <c:pt idx="6166">
                  <c:v>2.8184018638278312</c:v>
                </c:pt>
                <c:pt idx="6167">
                  <c:v>2.8183872023663268</c:v>
                </c:pt>
                <c:pt idx="6168">
                  <c:v>2.8179287821024528</c:v>
                </c:pt>
                <c:pt idx="6169">
                  <c:v>2.8179141046610865</c:v>
                </c:pt>
                <c:pt idx="6170">
                  <c:v>2.8178553899347221</c:v>
                </c:pt>
                <c:pt idx="6171">
                  <c:v>2.8177305947784004</c:v>
                </c:pt>
                <c:pt idx="6172">
                  <c:v>2.8176755266895794</c:v>
                </c:pt>
                <c:pt idx="6173">
                  <c:v>2.8176204516172967</c:v>
                </c:pt>
                <c:pt idx="6174">
                  <c:v>2.8174111026222075</c:v>
                </c:pt>
                <c:pt idx="6175">
                  <c:v>2.8172972037705235</c:v>
                </c:pt>
                <c:pt idx="6176">
                  <c:v>2.8171943017070218</c:v>
                </c:pt>
                <c:pt idx="6177">
                  <c:v>2.8171575450604283</c:v>
                </c:pt>
                <c:pt idx="6178">
                  <c:v>2.8170325491872812</c:v>
                </c:pt>
                <c:pt idx="6179">
                  <c:v>2.8169921016423807</c:v>
                </c:pt>
                <c:pt idx="6180">
                  <c:v>2.8168964833770169</c:v>
                </c:pt>
                <c:pt idx="6181">
                  <c:v>2.81682291653707</c:v>
                </c:pt>
                <c:pt idx="6182">
                  <c:v>2.8167640540913172</c:v>
                </c:pt>
                <c:pt idx="6183">
                  <c:v>2.8166352646706634</c:v>
                </c:pt>
                <c:pt idx="6184">
                  <c:v>2.8163260141470219</c:v>
                </c:pt>
                <c:pt idx="6185">
                  <c:v>2.8158985915536556</c:v>
                </c:pt>
                <c:pt idx="6186">
                  <c:v>2.8151902078086128</c:v>
                </c:pt>
                <c:pt idx="6187">
                  <c:v>2.8146840391795522</c:v>
                </c:pt>
                <c:pt idx="6188">
                  <c:v>2.8137106867868362</c:v>
                </c:pt>
                <c:pt idx="6189">
                  <c:v>2.8129541858287013</c:v>
                </c:pt>
                <c:pt idx="6190">
                  <c:v>2.8126497304215494</c:v>
                </c:pt>
                <c:pt idx="6191">
                  <c:v>2.8126274448144817</c:v>
                </c:pt>
                <c:pt idx="6192">
                  <c:v>2.8125197149228165</c:v>
                </c:pt>
                <c:pt idx="6193">
                  <c:v>2.8117797432391582</c:v>
                </c:pt>
                <c:pt idx="6194">
                  <c:v>2.8114819115138663</c:v>
                </c:pt>
                <c:pt idx="6195">
                  <c:v>2.8114707388499314</c:v>
                </c:pt>
                <c:pt idx="6196">
                  <c:v>2.811001227227786</c:v>
                </c:pt>
                <c:pt idx="6197">
                  <c:v>2.8108930931345508</c:v>
                </c:pt>
                <c:pt idx="6198">
                  <c:v>2.8106655507451279</c:v>
                </c:pt>
                <c:pt idx="6199">
                  <c:v>2.8106468944420708</c:v>
                </c:pt>
                <c:pt idx="6200">
                  <c:v>2.8100756237465672</c:v>
                </c:pt>
                <c:pt idx="6201">
                  <c:v>2.8086947537268574</c:v>
                </c:pt>
                <c:pt idx="6202">
                  <c:v>2.808481056565951</c:v>
                </c:pt>
                <c:pt idx="6203">
                  <c:v>2.8084698064336591</c:v>
                </c:pt>
                <c:pt idx="6204">
                  <c:v>2.8082710060282197</c:v>
                </c:pt>
                <c:pt idx="6205">
                  <c:v>2.8082334863107077</c:v>
                </c:pt>
                <c:pt idx="6206">
                  <c:v>2.8077078696323294</c:v>
                </c:pt>
                <c:pt idx="6207">
                  <c:v>2.8074673756842778</c:v>
                </c:pt>
                <c:pt idx="6208">
                  <c:v>2.8073132392339639</c:v>
                </c:pt>
                <c:pt idx="6209">
                  <c:v>2.8064211817001143</c:v>
                </c:pt>
                <c:pt idx="6210">
                  <c:v>2.8061648940525705</c:v>
                </c:pt>
                <c:pt idx="6211">
                  <c:v>2.8054668744749911</c:v>
                </c:pt>
                <c:pt idx="6212">
                  <c:v>2.8051155539454404</c:v>
                </c:pt>
                <c:pt idx="6213">
                  <c:v>2.8046769489986989</c:v>
                </c:pt>
                <c:pt idx="6214">
                  <c:v>2.8035898723198258</c:v>
                </c:pt>
                <c:pt idx="6215">
                  <c:v>2.8034836702294168</c:v>
                </c:pt>
                <c:pt idx="6216">
                  <c:v>2.803472289893516</c:v>
                </c:pt>
                <c:pt idx="6217">
                  <c:v>2.8028838997671537</c:v>
                </c:pt>
                <c:pt idx="6218">
                  <c:v>2.8028345146656135</c:v>
                </c:pt>
                <c:pt idx="6219">
                  <c:v>2.8024050074434133</c:v>
                </c:pt>
                <c:pt idx="6220">
                  <c:v>2.8015980584732185</c:v>
                </c:pt>
                <c:pt idx="6221">
                  <c:v>2.8014113331641051</c:v>
                </c:pt>
                <c:pt idx="6222">
                  <c:v>2.8012435930180262</c:v>
                </c:pt>
                <c:pt idx="6223">
                  <c:v>2.8006483553639883</c:v>
                </c:pt>
                <c:pt idx="6224">
                  <c:v>2.8006025340427909</c:v>
                </c:pt>
                <c:pt idx="6225">
                  <c:v>2.8004039191000221</c:v>
                </c:pt>
                <c:pt idx="6226">
                  <c:v>2.8000446537267796</c:v>
                </c:pt>
                <c:pt idx="6227">
                  <c:v>2.7998037030382279</c:v>
                </c:pt>
                <c:pt idx="6228">
                  <c:v>2.7994439405936733</c:v>
                </c:pt>
                <c:pt idx="6229">
                  <c:v>2.7990762157702616</c:v>
                </c:pt>
                <c:pt idx="6230">
                  <c:v>2.7989267385772014</c:v>
                </c:pt>
                <c:pt idx="6231">
                  <c:v>2.7983820531874413</c:v>
                </c:pt>
                <c:pt idx="6232">
                  <c:v>2.7982822480257421</c:v>
                </c:pt>
                <c:pt idx="6233">
                  <c:v>2.7977867213849601</c:v>
                </c:pt>
                <c:pt idx="6234">
                  <c:v>2.7976521786044226</c:v>
                </c:pt>
                <c:pt idx="6235">
                  <c:v>2.7971328370888773</c:v>
                </c:pt>
                <c:pt idx="6236">
                  <c:v>2.7964239922749345</c:v>
                </c:pt>
                <c:pt idx="6237">
                  <c:v>2.7959919543837004</c:v>
                </c:pt>
                <c:pt idx="6238">
                  <c:v>2.795926339618334</c:v>
                </c:pt>
                <c:pt idx="6239">
                  <c:v>2.7959108994092166</c:v>
                </c:pt>
                <c:pt idx="6240">
                  <c:v>2.795466758478125</c:v>
                </c:pt>
                <c:pt idx="6241">
                  <c:v>2.7953856054147344</c:v>
                </c:pt>
                <c:pt idx="6242">
                  <c:v>2.7950105586314464</c:v>
                </c:pt>
                <c:pt idx="6243">
                  <c:v>2.7949834808657239</c:v>
                </c:pt>
                <c:pt idx="6244">
                  <c:v>2.7947435754997332</c:v>
                </c:pt>
                <c:pt idx="6245">
                  <c:v>2.7944764281388061</c:v>
                </c:pt>
                <c:pt idx="6246">
                  <c:v>2.7942439924342009</c:v>
                </c:pt>
                <c:pt idx="6247">
                  <c:v>2.7935110057928578</c:v>
                </c:pt>
                <c:pt idx="6248">
                  <c:v>2.7933207701042417</c:v>
                </c:pt>
                <c:pt idx="6249">
                  <c:v>2.7932625180264434</c:v>
                </c:pt>
                <c:pt idx="6250">
                  <c:v>2.793122681152898</c:v>
                </c:pt>
                <c:pt idx="6251">
                  <c:v>2.7927184548571771</c:v>
                </c:pt>
                <c:pt idx="6252">
                  <c:v>2.792337204694058</c:v>
                </c:pt>
                <c:pt idx="6253">
                  <c:v>2.7920257317587533</c:v>
                </c:pt>
                <c:pt idx="6254">
                  <c:v>2.7917179328639601</c:v>
                </c:pt>
                <c:pt idx="6255">
                  <c:v>2.7909962832617361</c:v>
                </c:pt>
                <c:pt idx="6256">
                  <c:v>2.7909181952145783</c:v>
                </c:pt>
                <c:pt idx="6257">
                  <c:v>2.7907619769859182</c:v>
                </c:pt>
                <c:pt idx="6258">
                  <c:v>2.7906721260531673</c:v>
                </c:pt>
                <c:pt idx="6259">
                  <c:v>2.7904063710413252</c:v>
                </c:pt>
                <c:pt idx="6260">
                  <c:v>2.7894553565619091</c:v>
                </c:pt>
                <c:pt idx="6261">
                  <c:v>2.7892006165469012</c:v>
                </c:pt>
                <c:pt idx="6262">
                  <c:v>2.78867106321136</c:v>
                </c:pt>
                <c:pt idx="6263">
                  <c:v>2.7886004072881185</c:v>
                </c:pt>
                <c:pt idx="6264">
                  <c:v>2.7881565823144481</c:v>
                </c:pt>
                <c:pt idx="6265">
                  <c:v>2.7872163760442485</c:v>
                </c:pt>
                <c:pt idx="6266">
                  <c:v>2.7866843962202945</c:v>
                </c:pt>
                <c:pt idx="6267">
                  <c:v>2.7863767328201896</c:v>
                </c:pt>
                <c:pt idx="6268">
                  <c:v>2.7862622895414395</c:v>
                </c:pt>
                <c:pt idx="6269">
                  <c:v>2.7862465018946412</c:v>
                </c:pt>
                <c:pt idx="6270">
                  <c:v>2.7855156954228009</c:v>
                </c:pt>
                <c:pt idx="6271">
                  <c:v>2.785452432722642</c:v>
                </c:pt>
                <c:pt idx="6272">
                  <c:v>2.7850251682881186</c:v>
                </c:pt>
                <c:pt idx="6273">
                  <c:v>2.7844627542414178</c:v>
                </c:pt>
                <c:pt idx="6274">
                  <c:v>2.7835502538523902</c:v>
                </c:pt>
                <c:pt idx="6275">
                  <c:v>2.7834827320177218</c:v>
                </c:pt>
                <c:pt idx="6276">
                  <c:v>2.7824367898099061</c:v>
                </c:pt>
                <c:pt idx="6277">
                  <c:v>2.7820862535529942</c:v>
                </c:pt>
                <c:pt idx="6278">
                  <c:v>2.7820424166205542</c:v>
                </c:pt>
                <c:pt idx="6279">
                  <c:v>2.7812565868614483</c:v>
                </c:pt>
                <c:pt idx="6280">
                  <c:v>2.7811887074481421</c:v>
                </c:pt>
                <c:pt idx="6281">
                  <c:v>2.7811727342795094</c:v>
                </c:pt>
                <c:pt idx="6282">
                  <c:v>2.7810688943609572</c:v>
                </c:pt>
                <c:pt idx="6283">
                  <c:v>2.7805253267440855</c:v>
                </c:pt>
                <c:pt idx="6284">
                  <c:v>2.7799690647593591</c:v>
                </c:pt>
                <c:pt idx="6285">
                  <c:v>2.7799450374021246</c:v>
                </c:pt>
                <c:pt idx="6286">
                  <c:v>2.778601396477594</c:v>
                </c:pt>
                <c:pt idx="6287">
                  <c:v>2.7785451537251293</c:v>
                </c:pt>
                <c:pt idx="6288">
                  <c:v>2.778287951203946</c:v>
                </c:pt>
                <c:pt idx="6289">
                  <c:v>2.77817135614425</c:v>
                </c:pt>
                <c:pt idx="6290">
                  <c:v>2.7781150576687677</c:v>
                </c:pt>
                <c:pt idx="6291">
                  <c:v>2.7778374799381869</c:v>
                </c:pt>
                <c:pt idx="6292">
                  <c:v>2.7775033468578241</c:v>
                </c:pt>
                <c:pt idx="6293">
                  <c:v>2.7771246203856741</c:v>
                </c:pt>
                <c:pt idx="6294">
                  <c:v>2.7769593276809226</c:v>
                </c:pt>
                <c:pt idx="6295">
                  <c:v>2.7768988390184401</c:v>
                </c:pt>
                <c:pt idx="6296">
                  <c:v>2.7765639827163082</c:v>
                </c:pt>
                <c:pt idx="6297">
                  <c:v>2.7762248289256917</c:v>
                </c:pt>
                <c:pt idx="6298">
                  <c:v>2.7760874770582644</c:v>
                </c:pt>
                <c:pt idx="6299">
                  <c:v>2.7759541233969176</c:v>
                </c:pt>
                <c:pt idx="6300">
                  <c:v>2.7758934945573528</c:v>
                </c:pt>
                <c:pt idx="6301">
                  <c:v>2.775545725742214</c:v>
                </c:pt>
                <c:pt idx="6302">
                  <c:v>2.7751814831748387</c:v>
                </c:pt>
                <c:pt idx="6303">
                  <c:v>2.7749708925866008</c:v>
                </c:pt>
                <c:pt idx="6304">
                  <c:v>2.7741031548521695</c:v>
                </c:pt>
                <c:pt idx="6305">
                  <c:v>2.7738636135378396</c:v>
                </c:pt>
                <c:pt idx="6306">
                  <c:v>2.7735873680323428</c:v>
                </c:pt>
                <c:pt idx="6307">
                  <c:v>2.7735142148002048</c:v>
                </c:pt>
                <c:pt idx="6308">
                  <c:v>2.7732743483374538</c:v>
                </c:pt>
                <c:pt idx="6309">
                  <c:v>2.7722279581190206</c:v>
                </c:pt>
                <c:pt idx="6310">
                  <c:v>2.7719547489639491</c:v>
                </c:pt>
                <c:pt idx="6311">
                  <c:v>2.7715629852958177</c:v>
                </c:pt>
                <c:pt idx="6312">
                  <c:v>2.7712730159116279</c:v>
                </c:pt>
                <c:pt idx="6313">
                  <c:v>2.7708029360466457</c:v>
                </c:pt>
                <c:pt idx="6314">
                  <c:v>2.7704633445967661</c:v>
                </c:pt>
                <c:pt idx="6315">
                  <c:v>2.7703732878674874</c:v>
                </c:pt>
                <c:pt idx="6316">
                  <c:v>2.7696562616579112</c:v>
                </c:pt>
                <c:pt idx="6317">
                  <c:v>2.7694552819963678</c:v>
                </c:pt>
                <c:pt idx="6318">
                  <c:v>2.7692049527927076</c:v>
                </c:pt>
                <c:pt idx="6319">
                  <c:v>2.7689380496701181</c:v>
                </c:pt>
                <c:pt idx="6320">
                  <c:v>2.7688312424757711</c:v>
                </c:pt>
                <c:pt idx="6321">
                  <c:v>2.7687819379868026</c:v>
                </c:pt>
                <c:pt idx="6322">
                  <c:v>2.7686381012476144</c:v>
                </c:pt>
                <c:pt idx="6323">
                  <c:v>2.7684901051712449</c:v>
                </c:pt>
                <c:pt idx="6324">
                  <c:v>2.7684325375187311</c:v>
                </c:pt>
                <c:pt idx="6325">
                  <c:v>2.7683996382908762</c:v>
                </c:pt>
                <c:pt idx="6326">
                  <c:v>2.7682021905698506</c:v>
                </c:pt>
                <c:pt idx="6327">
                  <c:v>2.7680952022280061</c:v>
                </c:pt>
                <c:pt idx="6328">
                  <c:v>2.7680087693220896</c:v>
                </c:pt>
                <c:pt idx="6329">
                  <c:v>2.7675351409941324</c:v>
                </c:pt>
                <c:pt idx="6330">
                  <c:v>2.7675062947597286</c:v>
                </c:pt>
                <c:pt idx="6331">
                  <c:v>2.7673579124246466</c:v>
                </c:pt>
                <c:pt idx="6332">
                  <c:v>2.7669495994043998</c:v>
                </c:pt>
                <c:pt idx="6333">
                  <c:v>2.7667225928511576</c:v>
                </c:pt>
                <c:pt idx="6334">
                  <c:v>2.7664830755110588</c:v>
                </c:pt>
                <c:pt idx="6335">
                  <c:v>2.7648566497663163</c:v>
                </c:pt>
                <c:pt idx="6336">
                  <c:v>2.7648566497663163</c:v>
                </c:pt>
                <c:pt idx="6337">
                  <c:v>2.7645995063489313</c:v>
                </c:pt>
                <c:pt idx="6338">
                  <c:v>2.7644999260717618</c:v>
                </c:pt>
                <c:pt idx="6339">
                  <c:v>2.7640432240898702</c:v>
                </c:pt>
                <c:pt idx="6340">
                  <c:v>2.7636151491279555</c:v>
                </c:pt>
                <c:pt idx="6341">
                  <c:v>2.7632740496552652</c:v>
                </c:pt>
                <c:pt idx="6342">
                  <c:v>2.7624159574590519</c:v>
                </c:pt>
                <c:pt idx="6343">
                  <c:v>2.7618902680686821</c:v>
                </c:pt>
                <c:pt idx="6344">
                  <c:v>2.7617065439920281</c:v>
                </c:pt>
                <c:pt idx="6345">
                  <c:v>2.761184176150155</c:v>
                </c:pt>
                <c:pt idx="6346">
                  <c:v>2.7609122963641055</c:v>
                </c:pt>
                <c:pt idx="6347">
                  <c:v>2.7602423277872572</c:v>
                </c:pt>
                <c:pt idx="6348">
                  <c:v>2.76015850899809</c:v>
                </c:pt>
                <c:pt idx="6349">
                  <c:v>2.7599824368670252</c:v>
                </c:pt>
                <c:pt idx="6350">
                  <c:v>2.7595545356968838</c:v>
                </c:pt>
                <c:pt idx="6351">
                  <c:v>2.7593152306966675</c:v>
                </c:pt>
                <c:pt idx="6352">
                  <c:v>2.7590463801227934</c:v>
                </c:pt>
                <c:pt idx="6353">
                  <c:v>2.7590169644914635</c:v>
                </c:pt>
                <c:pt idx="6354">
                  <c:v>2.7583566898932887</c:v>
                </c:pt>
                <c:pt idx="6355">
                  <c:v>2.7581209348372222</c:v>
                </c:pt>
                <c:pt idx="6356">
                  <c:v>2.7571217664019052</c:v>
                </c:pt>
                <c:pt idx="6357">
                  <c:v>2.7571175456274042</c:v>
                </c:pt>
                <c:pt idx="6358">
                  <c:v>2.7564966451288271</c:v>
                </c:pt>
                <c:pt idx="6359">
                  <c:v>2.7553030392871802</c:v>
                </c:pt>
                <c:pt idx="6360">
                  <c:v>2.7549595877217099</c:v>
                </c:pt>
                <c:pt idx="6361">
                  <c:v>2.7546031286088541</c:v>
                </c:pt>
                <c:pt idx="6362">
                  <c:v>2.7544035535255391</c:v>
                </c:pt>
                <c:pt idx="6363">
                  <c:v>2.7543865641765075</c:v>
                </c:pt>
                <c:pt idx="6364">
                  <c:v>2.7543016074607163</c:v>
                </c:pt>
                <c:pt idx="6365">
                  <c:v>2.7534043000997248</c:v>
                </c:pt>
                <c:pt idx="6366">
                  <c:v>2.7532510196927564</c:v>
                </c:pt>
                <c:pt idx="6367">
                  <c:v>2.7528761063456142</c:v>
                </c:pt>
                <c:pt idx="6368">
                  <c:v>2.7528420072597668</c:v>
                </c:pt>
                <c:pt idx="6369">
                  <c:v>2.7519160468237778</c:v>
                </c:pt>
                <c:pt idx="6370">
                  <c:v>2.7514843956354293</c:v>
                </c:pt>
                <c:pt idx="6371">
                  <c:v>2.7513176035606826</c:v>
                </c:pt>
                <c:pt idx="6372">
                  <c:v>2.7511635847694937</c:v>
                </c:pt>
                <c:pt idx="6373">
                  <c:v>2.75101379189321</c:v>
                </c:pt>
                <c:pt idx="6374">
                  <c:v>2.7502211701288641</c:v>
                </c:pt>
                <c:pt idx="6375">
                  <c:v>2.749023068240787</c:v>
                </c:pt>
                <c:pt idx="6376">
                  <c:v>2.7480372041250516</c:v>
                </c:pt>
                <c:pt idx="6377">
                  <c:v>2.7480328941301435</c:v>
                </c:pt>
                <c:pt idx="6378">
                  <c:v>2.7475326442396613</c:v>
                </c:pt>
                <c:pt idx="6379">
                  <c:v>2.747157078312886</c:v>
                </c:pt>
                <c:pt idx="6380">
                  <c:v>2.7457078929927659</c:v>
                </c:pt>
                <c:pt idx="6381">
                  <c:v>2.7456342231625461</c:v>
                </c:pt>
                <c:pt idx="6382">
                  <c:v>2.7453047227861105</c:v>
                </c:pt>
                <c:pt idx="6383">
                  <c:v>2.7450444142070038</c:v>
                </c:pt>
                <c:pt idx="6384">
                  <c:v>2.7450183747656909</c:v>
                </c:pt>
                <c:pt idx="6385">
                  <c:v>2.7447318378197987</c:v>
                </c:pt>
                <c:pt idx="6386">
                  <c:v>2.7446058754142388</c:v>
                </c:pt>
                <c:pt idx="6387">
                  <c:v>2.7445971870049619</c:v>
                </c:pt>
                <c:pt idx="6388">
                  <c:v>2.7440799135506579</c:v>
                </c:pt>
                <c:pt idx="6389">
                  <c:v>2.7439929163284034</c:v>
                </c:pt>
                <c:pt idx="6390">
                  <c:v>2.7437231141365799</c:v>
                </c:pt>
                <c:pt idx="6391">
                  <c:v>2.743653460547248</c:v>
                </c:pt>
                <c:pt idx="6392">
                  <c:v>2.7432309463370839</c:v>
                </c:pt>
                <c:pt idx="6393">
                  <c:v>2.7421794117461955</c:v>
                </c:pt>
                <c:pt idx="6394">
                  <c:v>2.7417860686240942</c:v>
                </c:pt>
                <c:pt idx="6395">
                  <c:v>2.741615509239046</c:v>
                </c:pt>
                <c:pt idx="6396">
                  <c:v>2.7415017657579983</c:v>
                </c:pt>
                <c:pt idx="6397">
                  <c:v>2.7411209458102421</c:v>
                </c:pt>
                <c:pt idx="6398">
                  <c:v>2.7408712619029116</c:v>
                </c:pt>
                <c:pt idx="6399">
                  <c:v>2.7408624984567749</c:v>
                </c:pt>
                <c:pt idx="6400">
                  <c:v>2.7406959593729203</c:v>
                </c:pt>
                <c:pt idx="6401">
                  <c:v>2.7404855028900701</c:v>
                </c:pt>
                <c:pt idx="6402">
                  <c:v>2.739976478279905</c:v>
                </c:pt>
                <c:pt idx="6403">
                  <c:v>2.739928177720226</c:v>
                </c:pt>
                <c:pt idx="6404">
                  <c:v>2.7396822006421893</c:v>
                </c:pt>
                <c:pt idx="6405">
                  <c:v>2.7393877234669382</c:v>
                </c:pt>
                <c:pt idx="6406">
                  <c:v>2.7393393573801639</c:v>
                </c:pt>
                <c:pt idx="6407">
                  <c:v>2.7389918425955191</c:v>
                </c:pt>
                <c:pt idx="6408">
                  <c:v>2.7389566357143922</c:v>
                </c:pt>
                <c:pt idx="6409">
                  <c:v>2.7383400528355843</c:v>
                </c:pt>
                <c:pt idx="6410">
                  <c:v>2.7380623046890542</c:v>
                </c:pt>
                <c:pt idx="6411">
                  <c:v>2.7379123350310057</c:v>
                </c:pt>
                <c:pt idx="6412">
                  <c:v>2.7374974433239885</c:v>
                </c:pt>
                <c:pt idx="6413">
                  <c:v>2.7371440315257853</c:v>
                </c:pt>
                <c:pt idx="6414">
                  <c:v>2.7369716389434653</c:v>
                </c:pt>
                <c:pt idx="6415">
                  <c:v>2.7365248680132757</c:v>
                </c:pt>
                <c:pt idx="6416">
                  <c:v>2.7361750929004969</c:v>
                </c:pt>
                <c:pt idx="6417">
                  <c:v>2.7359624336514416</c:v>
                </c:pt>
                <c:pt idx="6418">
                  <c:v>2.735749670219362</c:v>
                </c:pt>
                <c:pt idx="6419">
                  <c:v>2.7354170185443611</c:v>
                </c:pt>
                <c:pt idx="6420">
                  <c:v>2.7352261832683493</c:v>
                </c:pt>
                <c:pt idx="6421">
                  <c:v>2.7346798421638807</c:v>
                </c:pt>
                <c:pt idx="6422">
                  <c:v>2.7343863999352145</c:v>
                </c:pt>
                <c:pt idx="6423">
                  <c:v>2.7338256408730492</c:v>
                </c:pt>
                <c:pt idx="6424">
                  <c:v>2.733678655677088</c:v>
                </c:pt>
                <c:pt idx="6425">
                  <c:v>2.7330589895641211</c:v>
                </c:pt>
                <c:pt idx="6426">
                  <c:v>2.7330099134644734</c:v>
                </c:pt>
                <c:pt idx="6427">
                  <c:v>2.7328314081569181</c:v>
                </c:pt>
                <c:pt idx="6428">
                  <c:v>2.732541180456713</c:v>
                </c:pt>
                <c:pt idx="6429">
                  <c:v>2.7324741772811936</c:v>
                </c:pt>
                <c:pt idx="6430">
                  <c:v>2.7322060611584025</c:v>
                </c:pt>
                <c:pt idx="6431">
                  <c:v>2.7317767307737038</c:v>
                </c:pt>
                <c:pt idx="6432">
                  <c:v>2.7317498835272636</c:v>
                </c:pt>
                <c:pt idx="6433">
                  <c:v>2.7316380021327586</c:v>
                </c:pt>
                <c:pt idx="6434">
                  <c:v>2.7306163115362532</c:v>
                </c:pt>
                <c:pt idx="6435">
                  <c:v>2.7303919348744272</c:v>
                </c:pt>
                <c:pt idx="6436">
                  <c:v>2.7303335779491302</c:v>
                </c:pt>
                <c:pt idx="6437">
                  <c:v>2.7297855382112015</c:v>
                </c:pt>
                <c:pt idx="6438">
                  <c:v>2.7297675579809306</c:v>
                </c:pt>
                <c:pt idx="6439">
                  <c:v>2.7296686534060917</c:v>
                </c:pt>
                <c:pt idx="6440">
                  <c:v>2.7294437864786705</c:v>
                </c:pt>
                <c:pt idx="6441">
                  <c:v>2.7291917972162949</c:v>
                </c:pt>
                <c:pt idx="6442">
                  <c:v>2.7291287770486181</c:v>
                </c:pt>
                <c:pt idx="6443">
                  <c:v>2.7291242752581213</c:v>
                </c:pt>
                <c:pt idx="6444">
                  <c:v>2.7288135389650194</c:v>
                </c:pt>
                <c:pt idx="6445">
                  <c:v>2.7275502934406188</c:v>
                </c:pt>
                <c:pt idx="6446">
                  <c:v>2.7274599208579091</c:v>
                </c:pt>
                <c:pt idx="6447">
                  <c:v>2.7262607053693335</c:v>
                </c:pt>
                <c:pt idx="6448">
                  <c:v>2.7262199190980789</c:v>
                </c:pt>
                <c:pt idx="6449">
                  <c:v>2.7258889555082688</c:v>
                </c:pt>
                <c:pt idx="6450">
                  <c:v>2.7257982365185605</c:v>
                </c:pt>
                <c:pt idx="6451">
                  <c:v>2.7257256476802323</c:v>
                </c:pt>
                <c:pt idx="6452">
                  <c:v>2.725521426501341</c:v>
                </c:pt>
                <c:pt idx="6453">
                  <c:v>2.7242348964905267</c:v>
                </c:pt>
                <c:pt idx="6454">
                  <c:v>2.7242348964905267</c:v>
                </c:pt>
                <c:pt idx="6455">
                  <c:v>2.7241073998657575</c:v>
                </c:pt>
                <c:pt idx="6456">
                  <c:v>2.7239206408230174</c:v>
                </c:pt>
                <c:pt idx="6457">
                  <c:v>2.7238796341837328</c:v>
                </c:pt>
                <c:pt idx="6458">
                  <c:v>2.723797609287637</c:v>
                </c:pt>
                <c:pt idx="6459">
                  <c:v>2.7237793794289078</c:v>
                </c:pt>
                <c:pt idx="6460">
                  <c:v>2.7236608666914495</c:v>
                </c:pt>
                <c:pt idx="6461">
                  <c:v>2.7234465500221017</c:v>
                </c:pt>
                <c:pt idx="6462">
                  <c:v>2.7234146214673682</c:v>
                </c:pt>
                <c:pt idx="6463">
                  <c:v>2.7226384921065936</c:v>
                </c:pt>
                <c:pt idx="6464">
                  <c:v>2.7225425209798808</c:v>
                </c:pt>
                <c:pt idx="6465">
                  <c:v>2.722249906671828</c:v>
                </c:pt>
                <c:pt idx="6466">
                  <c:v>2.7219937073239864</c:v>
                </c:pt>
                <c:pt idx="6467">
                  <c:v>2.7214075406560281</c:v>
                </c:pt>
                <c:pt idx="6468">
                  <c:v>2.7212792111684725</c:v>
                </c:pt>
                <c:pt idx="6469">
                  <c:v>2.721072887872777</c:v>
                </c:pt>
                <c:pt idx="6470">
                  <c:v>2.7207701029556297</c:v>
                </c:pt>
                <c:pt idx="6471">
                  <c:v>2.7195430413964901</c:v>
                </c:pt>
                <c:pt idx="6472">
                  <c:v>2.7192760297176806</c:v>
                </c:pt>
                <c:pt idx="6473">
                  <c:v>2.719257609066525</c:v>
                </c:pt>
                <c:pt idx="6474">
                  <c:v>2.7188152788820612</c:v>
                </c:pt>
                <c:pt idx="6475">
                  <c:v>2.7177305864178809</c:v>
                </c:pt>
                <c:pt idx="6476">
                  <c:v>2.7173884620638225</c:v>
                </c:pt>
                <c:pt idx="6477">
                  <c:v>2.7171756542474768</c:v>
                </c:pt>
                <c:pt idx="6478">
                  <c:v>2.7164207338465549</c:v>
                </c:pt>
                <c:pt idx="6479">
                  <c:v>2.7156877158846626</c:v>
                </c:pt>
                <c:pt idx="6480">
                  <c:v>2.7154322608296293</c:v>
                </c:pt>
                <c:pt idx="6481">
                  <c:v>2.7151766554257031</c:v>
                </c:pt>
                <c:pt idx="6482">
                  <c:v>2.7149767136368297</c:v>
                </c:pt>
                <c:pt idx="6483">
                  <c:v>2.7148557739307004</c:v>
                </c:pt>
                <c:pt idx="6484">
                  <c:v>2.7136958347460296</c:v>
                </c:pt>
                <c:pt idx="6485">
                  <c:v>2.7135932010501946</c:v>
                </c:pt>
                <c:pt idx="6486">
                  <c:v>2.7128413698534</c:v>
                </c:pt>
                <c:pt idx="6487">
                  <c:v>2.7128366960248917</c:v>
                </c:pt>
                <c:pt idx="6488">
                  <c:v>2.7126543774685552</c:v>
                </c:pt>
                <c:pt idx="6489">
                  <c:v>2.7126403497934941</c:v>
                </c:pt>
                <c:pt idx="6490">
                  <c:v>2.7124766600971584</c:v>
                </c:pt>
                <c:pt idx="6491">
                  <c:v>2.7119290205548245</c:v>
                </c:pt>
                <c:pt idx="6492">
                  <c:v>2.7116947757826906</c:v>
                </c:pt>
                <c:pt idx="6493">
                  <c:v>2.7116572848916185</c:v>
                </c:pt>
                <c:pt idx="6494">
                  <c:v>2.7108645325348677</c:v>
                </c:pt>
                <c:pt idx="6495">
                  <c:v>2.7097362378544441</c:v>
                </c:pt>
                <c:pt idx="6496">
                  <c:v>2.7095949946887972</c:v>
                </c:pt>
                <c:pt idx="6497">
                  <c:v>2.7095667405425439</c:v>
                </c:pt>
                <c:pt idx="6498">
                  <c:v>2.7095102267350009</c:v>
                </c:pt>
                <c:pt idx="6499">
                  <c:v>2.7086710738526278</c:v>
                </c:pt>
                <c:pt idx="6500">
                  <c:v>2.708501160234762</c:v>
                </c:pt>
                <c:pt idx="6501">
                  <c:v>2.7083784034878855</c:v>
                </c:pt>
                <c:pt idx="6502">
                  <c:v>2.7083500700796095</c:v>
                </c:pt>
                <c:pt idx="6503">
                  <c:v>2.7080997113269833</c:v>
                </c:pt>
                <c:pt idx="6504">
                  <c:v>2.7076269429082784</c:v>
                </c:pt>
                <c:pt idx="6505">
                  <c:v>2.7074045638401443</c:v>
                </c:pt>
                <c:pt idx="6506">
                  <c:v>2.7072767626478367</c:v>
                </c:pt>
                <c:pt idx="6507">
                  <c:v>2.7071394527972519</c:v>
                </c:pt>
                <c:pt idx="6508">
                  <c:v>2.7069878880806217</c:v>
                </c:pt>
                <c:pt idx="6509">
                  <c:v>2.7061580816349582</c:v>
                </c:pt>
                <c:pt idx="6510">
                  <c:v>2.7058067145173301</c:v>
                </c:pt>
                <c:pt idx="6511">
                  <c:v>2.7056451802101358</c:v>
                </c:pt>
                <c:pt idx="6512">
                  <c:v>2.7056356763207368</c:v>
                </c:pt>
                <c:pt idx="6513">
                  <c:v>2.7054598168423323</c:v>
                </c:pt>
                <c:pt idx="6514">
                  <c:v>2.7053932568436618</c:v>
                </c:pt>
                <c:pt idx="6515">
                  <c:v>2.7048270846108879</c:v>
                </c:pt>
                <c:pt idx="6516">
                  <c:v>2.7043221408222355</c:v>
                </c:pt>
                <c:pt idx="6517">
                  <c:v>2.7037975210748293</c:v>
                </c:pt>
                <c:pt idx="6518">
                  <c:v>2.7029950585936025</c:v>
                </c:pt>
                <c:pt idx="6519">
                  <c:v>2.7023012628973455</c:v>
                </c:pt>
                <c:pt idx="6520">
                  <c:v>2.7022964742490903</c:v>
                </c:pt>
                <c:pt idx="6521">
                  <c:v>2.7022390063511739</c:v>
                </c:pt>
                <c:pt idx="6522">
                  <c:v>2.702195900436783</c:v>
                </c:pt>
                <c:pt idx="6523">
                  <c:v>2.702104885009216</c:v>
                </c:pt>
                <c:pt idx="6524">
                  <c:v>2.7017070674878645</c:v>
                </c:pt>
                <c:pt idx="6525">
                  <c:v>2.7015152179968855</c:v>
                </c:pt>
                <c:pt idx="6526">
                  <c:v>2.7011696751996905</c:v>
                </c:pt>
                <c:pt idx="6527">
                  <c:v>2.7009823913289872</c:v>
                </c:pt>
                <c:pt idx="6528">
                  <c:v>2.6999388472066461</c:v>
                </c:pt>
                <c:pt idx="6529">
                  <c:v>2.6997895645717263</c:v>
                </c:pt>
                <c:pt idx="6530">
                  <c:v>2.6997654819209917</c:v>
                </c:pt>
                <c:pt idx="6531">
                  <c:v>2.6995197625730043</c:v>
                </c:pt>
                <c:pt idx="6532">
                  <c:v>2.6992787262128211</c:v>
                </c:pt>
                <c:pt idx="6533">
                  <c:v>2.699167804548924</c:v>
                </c:pt>
                <c:pt idx="6534">
                  <c:v>2.6986514048818733</c:v>
                </c:pt>
                <c:pt idx="6535">
                  <c:v>2.6979989952956238</c:v>
                </c:pt>
                <c:pt idx="6536">
                  <c:v>2.6979022586165877</c:v>
                </c:pt>
                <c:pt idx="6537">
                  <c:v>2.6978683956876717</c:v>
                </c:pt>
                <c:pt idx="6538">
                  <c:v>2.6975199379407861</c:v>
                </c:pt>
                <c:pt idx="6539">
                  <c:v>2.6974957291009622</c:v>
                </c:pt>
                <c:pt idx="6540">
                  <c:v>2.6973843510532891</c:v>
                </c:pt>
                <c:pt idx="6541">
                  <c:v>2.6972390323990996</c:v>
                </c:pt>
                <c:pt idx="6542">
                  <c:v>2.6970791256977176</c:v>
                </c:pt>
                <c:pt idx="6543">
                  <c:v>2.6961573036079698</c:v>
                </c:pt>
                <c:pt idx="6544">
                  <c:v>2.6955497728845113</c:v>
                </c:pt>
                <c:pt idx="6545">
                  <c:v>2.69524812204418</c:v>
                </c:pt>
                <c:pt idx="6546">
                  <c:v>2.6949608725235223</c:v>
                </c:pt>
                <c:pt idx="6547">
                  <c:v>2.6947367833859928</c:v>
                </c:pt>
                <c:pt idx="6548">
                  <c:v>2.6943272785402521</c:v>
                </c:pt>
                <c:pt idx="6549">
                  <c:v>2.6939515595912975</c:v>
                </c:pt>
                <c:pt idx="6550">
                  <c:v>2.6924846114237782</c:v>
                </c:pt>
                <c:pt idx="6551">
                  <c:v>2.69177871238815</c:v>
                </c:pt>
                <c:pt idx="6552">
                  <c:v>2.6915578834331084</c:v>
                </c:pt>
                <c:pt idx="6553">
                  <c:v>2.6914646108167477</c:v>
                </c:pt>
                <c:pt idx="6554">
                  <c:v>2.6913123861614427</c:v>
                </c:pt>
                <c:pt idx="6555">
                  <c:v>2.6910962337085471</c:v>
                </c:pt>
                <c:pt idx="6556">
                  <c:v>2.6908209749025858</c:v>
                </c:pt>
                <c:pt idx="6557">
                  <c:v>2.6908062239705695</c:v>
                </c:pt>
                <c:pt idx="6558">
                  <c:v>2.6906931168437156</c:v>
                </c:pt>
                <c:pt idx="6559">
                  <c:v>2.6904028377005469</c:v>
                </c:pt>
                <c:pt idx="6560">
                  <c:v>2.6901419129397821</c:v>
                </c:pt>
                <c:pt idx="6561">
                  <c:v>2.6899005410705943</c:v>
                </c:pt>
                <c:pt idx="6562">
                  <c:v>2.6879498732051861</c:v>
                </c:pt>
                <c:pt idx="6563">
                  <c:v>2.6872762180689302</c:v>
                </c:pt>
                <c:pt idx="6564">
                  <c:v>2.687043167608075</c:v>
                </c:pt>
                <c:pt idx="6565">
                  <c:v>2.6868645762532264</c:v>
                </c:pt>
                <c:pt idx="6566">
                  <c:v>2.6867603640375193</c:v>
                </c:pt>
                <c:pt idx="6567">
                  <c:v>2.6865816563258691</c:v>
                </c:pt>
                <c:pt idx="6568">
                  <c:v>2.6862041428271906</c:v>
                </c:pt>
                <c:pt idx="6569">
                  <c:v>2.6858611158657704</c:v>
                </c:pt>
                <c:pt idx="6570">
                  <c:v>2.6852688813218801</c:v>
                </c:pt>
                <c:pt idx="6571">
                  <c:v>2.6852589208961675</c:v>
                </c:pt>
                <c:pt idx="6572">
                  <c:v>2.6843216194199724</c:v>
                </c:pt>
                <c:pt idx="6573">
                  <c:v>2.6842617229289067</c:v>
                </c:pt>
                <c:pt idx="6574">
                  <c:v>2.683972106711602</c:v>
                </c:pt>
                <c:pt idx="6575">
                  <c:v>2.6839121619941437</c:v>
                </c:pt>
                <c:pt idx="6576">
                  <c:v>2.6838422160313731</c:v>
                </c:pt>
                <c:pt idx="6577">
                  <c:v>2.6837322781815445</c:v>
                </c:pt>
                <c:pt idx="6578">
                  <c:v>2.683011996929265</c:v>
                </c:pt>
                <c:pt idx="6579">
                  <c:v>2.6827215458328064</c:v>
                </c:pt>
                <c:pt idx="6580">
                  <c:v>2.6819895492341512</c:v>
                </c:pt>
                <c:pt idx="6581">
                  <c:v>2.6818992175874854</c:v>
                </c:pt>
                <c:pt idx="6582">
                  <c:v>2.6817938069141221</c:v>
                </c:pt>
                <c:pt idx="6583">
                  <c:v>2.6815778861488582</c:v>
                </c:pt>
                <c:pt idx="6584">
                  <c:v>2.6814523014525933</c:v>
                </c:pt>
                <c:pt idx="6585">
                  <c:v>2.6813116034658337</c:v>
                </c:pt>
                <c:pt idx="6586">
                  <c:v>2.6810049249392987</c:v>
                </c:pt>
                <c:pt idx="6587">
                  <c:v>2.6803657346651861</c:v>
                </c:pt>
                <c:pt idx="6588">
                  <c:v>2.6797356903916945</c:v>
                </c:pt>
                <c:pt idx="6589">
                  <c:v>2.6796650684812242</c:v>
                </c:pt>
                <c:pt idx="6590">
                  <c:v>2.6794379916710311</c:v>
                </c:pt>
                <c:pt idx="6591">
                  <c:v>2.6792915903447754</c:v>
                </c:pt>
                <c:pt idx="6592">
                  <c:v>2.6788369269009218</c:v>
                </c:pt>
                <c:pt idx="6593">
                  <c:v>2.6784121444765412</c:v>
                </c:pt>
                <c:pt idx="6594">
                  <c:v>2.6783514273422067</c:v>
                </c:pt>
                <c:pt idx="6595">
                  <c:v>2.6781287251963821</c:v>
                </c:pt>
                <c:pt idx="6596">
                  <c:v>2.6777741907999935</c:v>
                </c:pt>
                <c:pt idx="6597">
                  <c:v>2.6773585106450444</c:v>
                </c:pt>
                <c:pt idx="6598">
                  <c:v>2.6768764319731373</c:v>
                </c:pt>
                <c:pt idx="6599">
                  <c:v>2.6768459669258164</c:v>
                </c:pt>
                <c:pt idx="6600">
                  <c:v>2.6766224912554066</c:v>
                </c:pt>
                <c:pt idx="6601">
                  <c:v>2.6765767661530075</c:v>
                </c:pt>
                <c:pt idx="6602">
                  <c:v>2.6765462800766278</c:v>
                </c:pt>
                <c:pt idx="6603">
                  <c:v>2.675141602150144</c:v>
                </c:pt>
                <c:pt idx="6604">
                  <c:v>2.674764211961516</c:v>
                </c:pt>
                <c:pt idx="6605">
                  <c:v>2.6746060185534772</c:v>
                </c:pt>
                <c:pt idx="6606">
                  <c:v>2.6742945663990265</c:v>
                </c:pt>
                <c:pt idx="6607">
                  <c:v>2.674023778971756</c:v>
                </c:pt>
                <c:pt idx="6608">
                  <c:v>2.6739573336204741</c:v>
                </c:pt>
                <c:pt idx="6609">
                  <c:v>2.6737272519498605</c:v>
                </c:pt>
                <c:pt idx="6610">
                  <c:v>2.6732257630203846</c:v>
                </c:pt>
                <c:pt idx="6611">
                  <c:v>2.6724467960262972</c:v>
                </c:pt>
                <c:pt idx="6612">
                  <c:v>2.6722826247889206</c:v>
                </c:pt>
                <c:pt idx="6613">
                  <c:v>2.67207218965462</c:v>
                </c:pt>
                <c:pt idx="6614">
                  <c:v>2.6718719249787464</c:v>
                </c:pt>
                <c:pt idx="6615">
                  <c:v>2.6714197061475669</c:v>
                </c:pt>
                <c:pt idx="6616">
                  <c:v>2.6710081891016602</c:v>
                </c:pt>
                <c:pt idx="6617">
                  <c:v>2.6705293098914336</c:v>
                </c:pt>
                <c:pt idx="6618">
                  <c:v>2.6705138533800081</c:v>
                </c:pt>
                <c:pt idx="6619">
                  <c:v>2.6702870946564068</c:v>
                </c:pt>
                <c:pt idx="6620">
                  <c:v>2.6692187063114523</c:v>
                </c:pt>
                <c:pt idx="6621">
                  <c:v>2.6690326310512531</c:v>
                </c:pt>
                <c:pt idx="6622">
                  <c:v>2.6687223283418429</c:v>
                </c:pt>
                <c:pt idx="6623">
                  <c:v>2.6686395434944989</c:v>
                </c:pt>
                <c:pt idx="6624">
                  <c:v>2.6686343689175449</c:v>
                </c:pt>
                <c:pt idx="6625">
                  <c:v>2.6683496721951165</c:v>
                </c:pt>
                <c:pt idx="6626">
                  <c:v>2.6680026074841381</c:v>
                </c:pt>
                <c:pt idx="6627">
                  <c:v>2.6676760098482304</c:v>
                </c:pt>
                <c:pt idx="6628">
                  <c:v>2.6665231804097895</c:v>
                </c:pt>
                <c:pt idx="6629">
                  <c:v>2.6655601460501357</c:v>
                </c:pt>
                <c:pt idx="6630">
                  <c:v>2.6641717053619307</c:v>
                </c:pt>
                <c:pt idx="6631">
                  <c:v>2.664035754669976</c:v>
                </c:pt>
                <c:pt idx="6632">
                  <c:v>2.6635700625562526</c:v>
                </c:pt>
                <c:pt idx="6633">
                  <c:v>2.6631615168945402</c:v>
                </c:pt>
                <c:pt idx="6634">
                  <c:v>2.6631405554715788</c:v>
                </c:pt>
                <c:pt idx="6635">
                  <c:v>2.6628784522855722</c:v>
                </c:pt>
                <c:pt idx="6636">
                  <c:v>2.6624902490410536</c:v>
                </c:pt>
                <c:pt idx="6637">
                  <c:v>2.6624850006742324</c:v>
                </c:pt>
                <c:pt idx="6638">
                  <c:v>2.6623957687327979</c:v>
                </c:pt>
                <c:pt idx="6639">
                  <c:v>2.6620754325244658</c:v>
                </c:pt>
                <c:pt idx="6640">
                  <c:v>2.6617285729176396</c:v>
                </c:pt>
                <c:pt idx="6641">
                  <c:v>2.6612288184424191</c:v>
                </c:pt>
                <c:pt idx="6642">
                  <c:v>2.6600217779193804</c:v>
                </c:pt>
                <c:pt idx="6643">
                  <c:v>2.6597947538045825</c:v>
                </c:pt>
                <c:pt idx="6644">
                  <c:v>2.6596944030071867</c:v>
                </c:pt>
                <c:pt idx="6645">
                  <c:v>2.659551759342706</c:v>
                </c:pt>
                <c:pt idx="6646">
                  <c:v>2.6594143544822364</c:v>
                </c:pt>
                <c:pt idx="6647">
                  <c:v>2.6591711470281978</c:v>
                </c:pt>
                <c:pt idx="6648">
                  <c:v>2.6590865211956971</c:v>
                </c:pt>
                <c:pt idx="6649">
                  <c:v>2.6581015338982881</c:v>
                </c:pt>
                <c:pt idx="6650">
                  <c:v>2.6576506604972003</c:v>
                </c:pt>
                <c:pt idx="6651">
                  <c:v>2.6572630658338845</c:v>
                </c:pt>
                <c:pt idx="6652">
                  <c:v>2.656699640607604</c:v>
                </c:pt>
                <c:pt idx="6653">
                  <c:v>2.6560449372207247</c:v>
                </c:pt>
                <c:pt idx="6654">
                  <c:v>2.655618583541222</c:v>
                </c:pt>
                <c:pt idx="6655">
                  <c:v>2.6551117443106884</c:v>
                </c:pt>
                <c:pt idx="6656">
                  <c:v>2.6546684422129094</c:v>
                </c:pt>
                <c:pt idx="6657">
                  <c:v>2.6546310345903348</c:v>
                </c:pt>
                <c:pt idx="6658">
                  <c:v>2.6540802353065707</c:v>
                </c:pt>
                <c:pt idx="6659">
                  <c:v>2.654010667276347</c:v>
                </c:pt>
                <c:pt idx="6660">
                  <c:v>2.6534751556955261</c:v>
                </c:pt>
                <c:pt idx="6661">
                  <c:v>2.6533411745619175</c:v>
                </c:pt>
                <c:pt idx="6662">
                  <c:v>2.6530355429343562</c:v>
                </c:pt>
                <c:pt idx="6663">
                  <c:v>2.6528531338843031</c:v>
                </c:pt>
                <c:pt idx="6664">
                  <c:v>2.652214098196827</c:v>
                </c:pt>
                <c:pt idx="6665">
                  <c:v>2.6520958540888002</c:v>
                </c:pt>
                <c:pt idx="6666">
                  <c:v>2.651283399561005</c:v>
                </c:pt>
                <c:pt idx="6667">
                  <c:v>2.6510787012079771</c:v>
                </c:pt>
                <c:pt idx="6668">
                  <c:v>2.6505719272131021</c:v>
                </c:pt>
                <c:pt idx="6669">
                  <c:v>2.6505665328201879</c:v>
                </c:pt>
                <c:pt idx="6670">
                  <c:v>2.6503399077918748</c:v>
                </c:pt>
                <c:pt idx="6671">
                  <c:v>2.6491887709778821</c:v>
                </c:pt>
                <c:pt idx="6672">
                  <c:v>2.6491346519366021</c:v>
                </c:pt>
                <c:pt idx="6673">
                  <c:v>2.6488856174475099</c:v>
                </c:pt>
                <c:pt idx="6674">
                  <c:v>2.6478826211755986</c:v>
                </c:pt>
                <c:pt idx="6675">
                  <c:v>2.6476491601624588</c:v>
                </c:pt>
                <c:pt idx="6676">
                  <c:v>2.6474916388207799</c:v>
                </c:pt>
                <c:pt idx="6677">
                  <c:v>2.6473177558368635</c:v>
                </c:pt>
                <c:pt idx="6678">
                  <c:v>2.6468174541069578</c:v>
                </c:pt>
                <c:pt idx="6679">
                  <c:v>2.6464091725706833</c:v>
                </c:pt>
                <c:pt idx="6680">
                  <c:v>2.6463329174880053</c:v>
                </c:pt>
                <c:pt idx="6681">
                  <c:v>2.6461367714867472</c:v>
                </c:pt>
                <c:pt idx="6682">
                  <c:v>2.6448979173603684</c:v>
                </c:pt>
                <c:pt idx="6683">
                  <c:v>2.6446792503793111</c:v>
                </c:pt>
                <c:pt idx="6684">
                  <c:v>2.6446737822938964</c:v>
                </c:pt>
                <c:pt idx="6685">
                  <c:v>2.6437377257612953</c:v>
                </c:pt>
                <c:pt idx="6686">
                  <c:v>2.6429643691296372</c:v>
                </c:pt>
                <c:pt idx="6687">
                  <c:v>2.6425854155700756</c:v>
                </c:pt>
                <c:pt idx="6688">
                  <c:v>2.6423490887538366</c:v>
                </c:pt>
                <c:pt idx="6689">
                  <c:v>2.6423325960363977</c:v>
                </c:pt>
                <c:pt idx="6690">
                  <c:v>2.6422776157877004</c:v>
                </c:pt>
                <c:pt idx="6691">
                  <c:v>2.6420466227063359</c:v>
                </c:pt>
                <c:pt idx="6692">
                  <c:v>2.6413804549701951</c:v>
                </c:pt>
                <c:pt idx="6693">
                  <c:v>2.640768442459084</c:v>
                </c:pt>
                <c:pt idx="6694">
                  <c:v>2.6396082163285599</c:v>
                </c:pt>
                <c:pt idx="6695">
                  <c:v>2.6394975567749106</c:v>
                </c:pt>
                <c:pt idx="6696">
                  <c:v>2.6390767931319745</c:v>
                </c:pt>
                <c:pt idx="6697">
                  <c:v>2.637283985754312</c:v>
                </c:pt>
                <c:pt idx="6698">
                  <c:v>2.6365101844384542</c:v>
                </c:pt>
                <c:pt idx="6699">
                  <c:v>2.6361367080510516</c:v>
                </c:pt>
                <c:pt idx="6700">
                  <c:v>2.6360251602877396</c:v>
                </c:pt>
                <c:pt idx="6701">
                  <c:v>2.6359247427984132</c:v>
                </c:pt>
                <c:pt idx="6702">
                  <c:v>2.6353608580489394</c:v>
                </c:pt>
                <c:pt idx="6703">
                  <c:v>2.6344828681458168</c:v>
                </c:pt>
                <c:pt idx="6704">
                  <c:v>2.6341972788662011</c:v>
                </c:pt>
                <c:pt idx="6705">
                  <c:v>2.6337881671403998</c:v>
                </c:pt>
                <c:pt idx="6706">
                  <c:v>2.6333618327357282</c:v>
                </c:pt>
                <c:pt idx="6707">
                  <c:v>2.6324010473511414</c:v>
                </c:pt>
                <c:pt idx="6708">
                  <c:v>2.6315677710205021</c:v>
                </c:pt>
                <c:pt idx="6709">
                  <c:v>2.6312576995912158</c:v>
                </c:pt>
                <c:pt idx="6710">
                  <c:v>2.6311730962204258</c:v>
                </c:pt>
                <c:pt idx="6711">
                  <c:v>2.6311561735683342</c:v>
                </c:pt>
                <c:pt idx="6712">
                  <c:v>2.6309474066233376</c:v>
                </c:pt>
                <c:pt idx="6713">
                  <c:v>2.6304956752721216</c:v>
                </c:pt>
                <c:pt idx="6714">
                  <c:v>2.6304052725903002</c:v>
                </c:pt>
                <c:pt idx="6715">
                  <c:v>2.6303657154987881</c:v>
                </c:pt>
                <c:pt idx="6716">
                  <c:v>2.6289279154002756</c:v>
                </c:pt>
                <c:pt idx="6717">
                  <c:v>2.6286783632379005</c:v>
                </c:pt>
                <c:pt idx="6718">
                  <c:v>2.6285989301959432</c:v>
                </c:pt>
                <c:pt idx="6719">
                  <c:v>2.6279572596343921</c:v>
                </c:pt>
                <c:pt idx="6720">
                  <c:v>2.6252724272457906</c:v>
                </c:pt>
                <c:pt idx="6721">
                  <c:v>2.6252667092709787</c:v>
                </c:pt>
                <c:pt idx="6722">
                  <c:v>2.6245341862520197</c:v>
                </c:pt>
                <c:pt idx="6723">
                  <c:v>2.6244769058232973</c:v>
                </c:pt>
                <c:pt idx="6724">
                  <c:v>2.6243795117526387</c:v>
                </c:pt>
                <c:pt idx="6725">
                  <c:v>2.6242075865642396</c:v>
                </c:pt>
                <c:pt idx="6726">
                  <c:v>2.6240929319489763</c:v>
                </c:pt>
                <c:pt idx="6727">
                  <c:v>2.6237028796890667</c:v>
                </c:pt>
                <c:pt idx="6728">
                  <c:v>2.6233986252562018</c:v>
                </c:pt>
                <c:pt idx="6729">
                  <c:v>2.6231228900133297</c:v>
                </c:pt>
                <c:pt idx="6730">
                  <c:v>2.6227837254272086</c:v>
                </c:pt>
                <c:pt idx="6731">
                  <c:v>2.6222658449915226</c:v>
                </c:pt>
                <c:pt idx="6732">
                  <c:v>2.6220585197784181</c:v>
                </c:pt>
                <c:pt idx="6733">
                  <c:v>2.6218107515473443</c:v>
                </c:pt>
                <c:pt idx="6734">
                  <c:v>2.6216089753267222</c:v>
                </c:pt>
                <c:pt idx="6735">
                  <c:v>2.6215224710973946</c:v>
                </c:pt>
                <c:pt idx="6736">
                  <c:v>2.6214820965597267</c:v>
                </c:pt>
                <c:pt idx="6737">
                  <c:v>2.620916458565429</c:v>
                </c:pt>
                <c:pt idx="6738">
                  <c:v>2.6205004178372611</c:v>
                </c:pt>
                <c:pt idx="6739">
                  <c:v>2.6204483847117088</c:v>
                </c:pt>
                <c:pt idx="6740">
                  <c:v>2.62027489592184</c:v>
                </c:pt>
                <c:pt idx="6741">
                  <c:v>2.6197192656117267</c:v>
                </c:pt>
                <c:pt idx="6742">
                  <c:v>2.6191397271314503</c:v>
                </c:pt>
                <c:pt idx="6743">
                  <c:v>2.6187800245062149</c:v>
                </c:pt>
                <c:pt idx="6744">
                  <c:v>2.6186929549010989</c:v>
                </c:pt>
                <c:pt idx="6745">
                  <c:v>2.6185942549081287</c:v>
                </c:pt>
                <c:pt idx="6746">
                  <c:v>2.6184548755433732</c:v>
                </c:pt>
                <c:pt idx="6747">
                  <c:v>2.6182863991084204</c:v>
                </c:pt>
                <c:pt idx="6748">
                  <c:v>2.6181585457875198</c:v>
                </c:pt>
                <c:pt idx="6749">
                  <c:v>2.6180480967120925</c:v>
                </c:pt>
                <c:pt idx="6750">
                  <c:v>2.6175303557088565</c:v>
                </c:pt>
                <c:pt idx="6751">
                  <c:v>2.6170994039790587</c:v>
                </c:pt>
                <c:pt idx="6752">
                  <c:v>2.6169420582942795</c:v>
                </c:pt>
                <c:pt idx="6753">
                  <c:v>2.6164054889800128</c:v>
                </c:pt>
                <c:pt idx="6754">
                  <c:v>2.6162537296003423</c:v>
                </c:pt>
                <c:pt idx="6755">
                  <c:v>2.6160435136424298</c:v>
                </c:pt>
                <c:pt idx="6756">
                  <c:v>2.6159149982255006</c:v>
                </c:pt>
                <c:pt idx="6757">
                  <c:v>2.6156227762212421</c:v>
                </c:pt>
                <c:pt idx="6758">
                  <c:v>2.6155058323419502</c:v>
                </c:pt>
                <c:pt idx="6759">
                  <c:v>2.6152777011647763</c:v>
                </c:pt>
                <c:pt idx="6760">
                  <c:v>2.6152074828407055</c:v>
                </c:pt>
                <c:pt idx="6761">
                  <c:v>2.6149382073749075</c:v>
                </c:pt>
                <c:pt idx="6762">
                  <c:v>2.6148152217407294</c:v>
                </c:pt>
                <c:pt idx="6763">
                  <c:v>2.6144870896791046</c:v>
                </c:pt>
                <c:pt idx="6764">
                  <c:v>2.6143522492981028</c:v>
                </c:pt>
                <c:pt idx="6765">
                  <c:v>2.6143346583354292</c:v>
                </c:pt>
                <c:pt idx="6766">
                  <c:v>2.6142115016422132</c:v>
                </c:pt>
                <c:pt idx="6767">
                  <c:v>2.6141000440561006</c:v>
                </c:pt>
                <c:pt idx="6768">
                  <c:v>2.6140061628447748</c:v>
                </c:pt>
                <c:pt idx="6769">
                  <c:v>2.6134777025579541</c:v>
                </c:pt>
                <c:pt idx="6770">
                  <c:v>2.6129956560323477</c:v>
                </c:pt>
                <c:pt idx="6771">
                  <c:v>2.6123010390136394</c:v>
                </c:pt>
                <c:pt idx="6772">
                  <c:v>2.6118648642282505</c:v>
                </c:pt>
                <c:pt idx="6773">
                  <c:v>2.6118471722236896</c:v>
                </c:pt>
                <c:pt idx="6774">
                  <c:v>2.611292457344093</c:v>
                </c:pt>
                <c:pt idx="6775">
                  <c:v>2.6109380131970172</c:v>
                </c:pt>
                <c:pt idx="6776">
                  <c:v>2.6107902427167509</c:v>
                </c:pt>
                <c:pt idx="6777">
                  <c:v>2.6107784189059688</c:v>
                </c:pt>
                <c:pt idx="6778">
                  <c:v>2.6107547703186396</c:v>
                </c:pt>
                <c:pt idx="6779">
                  <c:v>2.6106779035151968</c:v>
                </c:pt>
                <c:pt idx="6780">
                  <c:v>2.6104117210144313</c:v>
                </c:pt>
                <c:pt idx="6781">
                  <c:v>2.6097366609401846</c:v>
                </c:pt>
                <c:pt idx="6782">
                  <c:v>2.6095529103633357</c:v>
                </c:pt>
                <c:pt idx="6783">
                  <c:v>2.6092089100182663</c:v>
                </c:pt>
                <c:pt idx="6784">
                  <c:v>2.6091258346129376</c:v>
                </c:pt>
                <c:pt idx="6785">
                  <c:v>2.6090071278890696</c:v>
                </c:pt>
                <c:pt idx="6786">
                  <c:v>2.6082406889664669</c:v>
                </c:pt>
                <c:pt idx="6787">
                  <c:v>2.6068171131171556</c:v>
                </c:pt>
                <c:pt idx="6788">
                  <c:v>2.6062619057557317</c:v>
                </c:pt>
                <c:pt idx="6789">
                  <c:v>2.6062380099411557</c:v>
                </c:pt>
                <c:pt idx="6790">
                  <c:v>2.6060946074363351</c:v>
                </c:pt>
                <c:pt idx="6791">
                  <c:v>2.6059989794535854</c:v>
                </c:pt>
                <c:pt idx="6792">
                  <c:v>2.605346952878111</c:v>
                </c:pt>
                <c:pt idx="6793">
                  <c:v>2.6047778733439868</c:v>
                </c:pt>
                <c:pt idx="6794">
                  <c:v>2.604556029912704</c:v>
                </c:pt>
                <c:pt idx="6795">
                  <c:v>2.6043820733772716</c:v>
                </c:pt>
                <c:pt idx="6796">
                  <c:v>2.6041720329983375</c:v>
                </c:pt>
                <c:pt idx="6797">
                  <c:v>2.6040879883952517</c:v>
                </c:pt>
                <c:pt idx="6798">
                  <c:v>2.603793704136963</c:v>
                </c:pt>
                <c:pt idx="6799">
                  <c:v>2.6037516472454345</c:v>
                </c:pt>
                <c:pt idx="6800">
                  <c:v>2.6023976446323949</c:v>
                </c:pt>
                <c:pt idx="6801">
                  <c:v>2.6023192842235083</c:v>
                </c:pt>
                <c:pt idx="6802">
                  <c:v>2.6014443045974547</c:v>
                </c:pt>
                <c:pt idx="6803">
                  <c:v>2.601015222520942</c:v>
                </c:pt>
                <c:pt idx="6804">
                  <c:v>2.6009487070720825</c:v>
                </c:pt>
                <c:pt idx="6805">
                  <c:v>2.6003738311612707</c:v>
                </c:pt>
                <c:pt idx="6806">
                  <c:v>2.5998951962618464</c:v>
                </c:pt>
                <c:pt idx="6807">
                  <c:v>2.5973599528082083</c:v>
                </c:pt>
                <c:pt idx="6808">
                  <c:v>2.5967986201413051</c:v>
                </c:pt>
                <c:pt idx="6809">
                  <c:v>2.5966703880883513</c:v>
                </c:pt>
                <c:pt idx="6810">
                  <c:v>2.5966703880883508</c:v>
                </c:pt>
                <c:pt idx="6811">
                  <c:v>2.5957043785374085</c:v>
                </c:pt>
                <c:pt idx="6812">
                  <c:v>2.5948956818866948</c:v>
                </c:pt>
                <c:pt idx="6813">
                  <c:v>2.5945460059022354</c:v>
                </c:pt>
                <c:pt idx="6814">
                  <c:v>2.5942636058164101</c:v>
                </c:pt>
                <c:pt idx="6815">
                  <c:v>2.5942574646442713</c:v>
                </c:pt>
                <c:pt idx="6816">
                  <c:v>2.5942206157876919</c:v>
                </c:pt>
                <c:pt idx="6817">
                  <c:v>2.5942021901868846</c:v>
                </c:pt>
                <c:pt idx="6818">
                  <c:v>2.5939687315546913</c:v>
                </c:pt>
                <c:pt idx="6819">
                  <c:v>2.5936490583424523</c:v>
                </c:pt>
                <c:pt idx="6820">
                  <c:v>2.5935014374597349</c:v>
                </c:pt>
                <c:pt idx="6821">
                  <c:v>2.5932552910942919</c:v>
                </c:pt>
                <c:pt idx="6822">
                  <c:v>2.5931198511039408</c:v>
                </c:pt>
                <c:pt idx="6823">
                  <c:v>2.5923556710915863</c:v>
                </c:pt>
                <c:pt idx="6824">
                  <c:v>2.5913738234738113</c:v>
                </c:pt>
                <c:pt idx="6825">
                  <c:v>2.5912377953600858</c:v>
                </c:pt>
                <c:pt idx="6826">
                  <c:v>2.5911512098263167</c:v>
                </c:pt>
                <c:pt idx="6827">
                  <c:v>2.5910212991496699</c:v>
                </c:pt>
                <c:pt idx="6828">
                  <c:v>2.5909594232616779</c:v>
                </c:pt>
                <c:pt idx="6829">
                  <c:v>2.5909470470261211</c:v>
                </c:pt>
                <c:pt idx="6830">
                  <c:v>2.5904393174627875</c:v>
                </c:pt>
                <c:pt idx="6831">
                  <c:v>2.5895090050385323</c:v>
                </c:pt>
                <c:pt idx="6832">
                  <c:v>2.5893537590344691</c:v>
                </c:pt>
                <c:pt idx="6833">
                  <c:v>2.5892295222621873</c:v>
                </c:pt>
                <c:pt idx="6834">
                  <c:v>2.589055531052344</c:v>
                </c:pt>
                <c:pt idx="6835">
                  <c:v>2.5874116064119157</c:v>
                </c:pt>
                <c:pt idx="6836">
                  <c:v>2.5871307701885393</c:v>
                </c:pt>
                <c:pt idx="6837">
                  <c:v>2.5869059703826816</c:v>
                </c:pt>
                <c:pt idx="6838">
                  <c:v>2.5866248068937812</c:v>
                </c:pt>
                <c:pt idx="6839">
                  <c:v>2.5864747785713966</c:v>
                </c:pt>
                <c:pt idx="6840">
                  <c:v>2.586431010546232</c:v>
                </c:pt>
                <c:pt idx="6841">
                  <c:v>2.5863497153666208</c:v>
                </c:pt>
                <c:pt idx="6842">
                  <c:v>2.5858052709640194</c:v>
                </c:pt>
                <c:pt idx="6843">
                  <c:v>2.5854983291346789</c:v>
                </c:pt>
                <c:pt idx="6844">
                  <c:v>2.5850657367737662</c:v>
                </c:pt>
                <c:pt idx="6845">
                  <c:v>2.5844945567364803</c:v>
                </c:pt>
                <c:pt idx="6846">
                  <c:v>2.584249535142106</c:v>
                </c:pt>
                <c:pt idx="6847">
                  <c:v>2.5838785984986261</c:v>
                </c:pt>
                <c:pt idx="6848">
                  <c:v>2.5835073447624151</c:v>
                </c:pt>
                <c:pt idx="6849">
                  <c:v>2.5834758679892715</c:v>
                </c:pt>
                <c:pt idx="6850">
                  <c:v>2.5821896663826887</c:v>
                </c:pt>
                <c:pt idx="6851">
                  <c:v>2.5813110968253148</c:v>
                </c:pt>
                <c:pt idx="6852">
                  <c:v>2.5810516106034456</c:v>
                </c:pt>
                <c:pt idx="6853">
                  <c:v>2.5809819659626774</c:v>
                </c:pt>
                <c:pt idx="6854">
                  <c:v>2.5802468508771095</c:v>
                </c:pt>
                <c:pt idx="6855">
                  <c:v>2.5798534336812455</c:v>
                </c:pt>
                <c:pt idx="6856">
                  <c:v>2.5797264488462295</c:v>
                </c:pt>
                <c:pt idx="6857">
                  <c:v>2.5796629425024342</c:v>
                </c:pt>
                <c:pt idx="6858">
                  <c:v>2.5786328438340211</c:v>
                </c:pt>
                <c:pt idx="6859">
                  <c:v>2.578186982394338</c:v>
                </c:pt>
                <c:pt idx="6860">
                  <c:v>2.5780850069061239</c:v>
                </c:pt>
                <c:pt idx="6861">
                  <c:v>2.5777342834285366</c:v>
                </c:pt>
                <c:pt idx="6862">
                  <c:v>2.5777279040156333</c:v>
                </c:pt>
                <c:pt idx="6863">
                  <c:v>2.5775747699867835</c:v>
                </c:pt>
                <c:pt idx="6864">
                  <c:v>2.577153372779279</c:v>
                </c:pt>
                <c:pt idx="6865">
                  <c:v>2.5769169559652072</c:v>
                </c:pt>
                <c:pt idx="6866">
                  <c:v>2.576610061167945</c:v>
                </c:pt>
                <c:pt idx="6867">
                  <c:v>2.5763605493606292</c:v>
                </c:pt>
                <c:pt idx="6868">
                  <c:v>2.5760404525848073</c:v>
                </c:pt>
                <c:pt idx="6869">
                  <c:v>2.5759443775281361</c:v>
                </c:pt>
                <c:pt idx="6870">
                  <c:v>2.5756239737525903</c:v>
                </c:pt>
                <c:pt idx="6871">
                  <c:v>2.5749246730995674</c:v>
                </c:pt>
                <c:pt idx="6872">
                  <c:v>2.5747898159876508</c:v>
                </c:pt>
                <c:pt idx="6873">
                  <c:v>2.5747320072609483</c:v>
                </c:pt>
                <c:pt idx="6874">
                  <c:v>2.5745071223685243</c:v>
                </c:pt>
                <c:pt idx="6875">
                  <c:v>2.5737480797571091</c:v>
                </c:pt>
                <c:pt idx="6876">
                  <c:v>2.5730135053162346</c:v>
                </c:pt>
                <c:pt idx="6877">
                  <c:v>2.5727038387186743</c:v>
                </c:pt>
                <c:pt idx="6878">
                  <c:v>2.5723939511608354</c:v>
                </c:pt>
                <c:pt idx="6879">
                  <c:v>2.5723487407451597</c:v>
                </c:pt>
                <c:pt idx="6880">
                  <c:v>2.5717605766534888</c:v>
                </c:pt>
                <c:pt idx="6881">
                  <c:v>2.5715406184717198</c:v>
                </c:pt>
                <c:pt idx="6882">
                  <c:v>2.5714759036819439</c:v>
                </c:pt>
                <c:pt idx="6883">
                  <c:v>2.5713205488307422</c:v>
                </c:pt>
                <c:pt idx="6884">
                  <c:v>2.5709189580568803</c:v>
                </c:pt>
                <c:pt idx="6885">
                  <c:v>2.5706531858368167</c:v>
                </c:pt>
                <c:pt idx="6886">
                  <c:v>2.5704845630444009</c:v>
                </c:pt>
                <c:pt idx="6887">
                  <c:v>2.5704196906871708</c:v>
                </c:pt>
                <c:pt idx="6888">
                  <c:v>2.5699588180965942</c:v>
                </c:pt>
                <c:pt idx="6889">
                  <c:v>2.5698483957125293</c:v>
                </c:pt>
                <c:pt idx="6890">
                  <c:v>2.5697184510705648</c:v>
                </c:pt>
                <c:pt idx="6891">
                  <c:v>2.5695819673383631</c:v>
                </c:pt>
                <c:pt idx="6892">
                  <c:v>2.5695364632277169</c:v>
                </c:pt>
                <c:pt idx="6893">
                  <c:v>2.5694519429423428</c:v>
                </c:pt>
                <c:pt idx="6894">
                  <c:v>2.569191777307112</c:v>
                </c:pt>
                <c:pt idx="6895">
                  <c:v>2.569146232292975</c:v>
                </c:pt>
                <c:pt idx="6896">
                  <c:v>2.5687686754619774</c:v>
                </c:pt>
                <c:pt idx="6897">
                  <c:v>2.5687556504047859</c:v>
                </c:pt>
                <c:pt idx="6898">
                  <c:v>2.5686384073079935</c:v>
                </c:pt>
                <c:pt idx="6899">
                  <c:v>2.568449449051756</c:v>
                </c:pt>
                <c:pt idx="6900">
                  <c:v>2.5682147657475083</c:v>
                </c:pt>
                <c:pt idx="6901">
                  <c:v>2.5681952030798718</c:v>
                </c:pt>
                <c:pt idx="6902">
                  <c:v>2.5680256230379266</c:v>
                </c:pt>
                <c:pt idx="6903">
                  <c:v>2.5680125756762151</c:v>
                </c:pt>
                <c:pt idx="6904">
                  <c:v>2.5677189063608989</c:v>
                </c:pt>
                <c:pt idx="6905">
                  <c:v>2.5674185056727485</c:v>
                </c:pt>
                <c:pt idx="6906">
                  <c:v>2.5667320289862192</c:v>
                </c:pt>
                <c:pt idx="6907">
                  <c:v>2.5666273276776761</c:v>
                </c:pt>
                <c:pt idx="6908">
                  <c:v>2.5661951677679751</c:v>
                </c:pt>
                <c:pt idx="6909">
                  <c:v>2.5660772313018252</c:v>
                </c:pt>
                <c:pt idx="6910">
                  <c:v>2.5657691350095826</c:v>
                </c:pt>
                <c:pt idx="6911">
                  <c:v>2.5652048178576785</c:v>
                </c:pt>
                <c:pt idx="6912">
                  <c:v>2.5645016770735101</c:v>
                </c:pt>
                <c:pt idx="6913">
                  <c:v>2.5641990419923739</c:v>
                </c:pt>
                <c:pt idx="6914">
                  <c:v>2.5638632650902933</c:v>
                </c:pt>
                <c:pt idx="6915">
                  <c:v>2.5636260896998642</c:v>
                </c:pt>
                <c:pt idx="6916">
                  <c:v>2.5632568925590915</c:v>
                </c:pt>
                <c:pt idx="6917">
                  <c:v>2.5627949543329684</c:v>
                </c:pt>
                <c:pt idx="6918">
                  <c:v>2.5614724169752572</c:v>
                </c:pt>
                <c:pt idx="6919">
                  <c:v>2.5607300330647345</c:v>
                </c:pt>
                <c:pt idx="6920">
                  <c:v>2.559733776800643</c:v>
                </c:pt>
                <c:pt idx="6921">
                  <c:v>2.5596140723258896</c:v>
                </c:pt>
                <c:pt idx="6922">
                  <c:v>2.5594743753916762</c:v>
                </c:pt>
                <c:pt idx="6923">
                  <c:v>2.5591881890047756</c:v>
                </c:pt>
                <c:pt idx="6924">
                  <c:v>2.5591548992752728</c:v>
                </c:pt>
                <c:pt idx="6925">
                  <c:v>2.5583151546038465</c:v>
                </c:pt>
                <c:pt idx="6926">
                  <c:v>2.5577944977896432</c:v>
                </c:pt>
                <c:pt idx="6927">
                  <c:v>2.5575005183441979</c:v>
                </c:pt>
                <c:pt idx="6928">
                  <c:v>2.5550944485783189</c:v>
                </c:pt>
                <c:pt idx="6929">
                  <c:v>2.55486588314443</c:v>
                </c:pt>
                <c:pt idx="6930">
                  <c:v>2.5548389851831987</c:v>
                </c:pt>
                <c:pt idx="6931">
                  <c:v>2.5545631849871615</c:v>
                </c:pt>
                <c:pt idx="6932">
                  <c:v>2.554388196506467</c:v>
                </c:pt>
                <c:pt idx="6933">
                  <c:v>2.5537010215499611</c:v>
                </c:pt>
                <c:pt idx="6934">
                  <c:v>2.5526749744549062</c:v>
                </c:pt>
                <c:pt idx="6935">
                  <c:v>2.5526479404530051</c:v>
                </c:pt>
                <c:pt idx="6936">
                  <c:v>2.5525735882695915</c:v>
                </c:pt>
                <c:pt idx="6937">
                  <c:v>2.552573588269591</c:v>
                </c:pt>
                <c:pt idx="6938">
                  <c:v>2.5522963452062797</c:v>
                </c:pt>
                <c:pt idx="6939">
                  <c:v>2.5520866048406328</c:v>
                </c:pt>
                <c:pt idx="6940">
                  <c:v>2.5519850811910927</c:v>
                </c:pt>
                <c:pt idx="6941">
                  <c:v>2.5519512346999247</c:v>
                </c:pt>
                <c:pt idx="6942">
                  <c:v>2.551829365486026</c:v>
                </c:pt>
                <c:pt idx="6943">
                  <c:v>2.5514364430022316</c:v>
                </c:pt>
                <c:pt idx="6944">
                  <c:v>2.5513754403982913</c:v>
                </c:pt>
                <c:pt idx="6945">
                  <c:v>2.5507038456142568</c:v>
                </c:pt>
                <c:pt idx="6946">
                  <c:v>2.5504321993305585</c:v>
                </c:pt>
                <c:pt idx="6947">
                  <c:v>2.5497591431974058</c:v>
                </c:pt>
                <c:pt idx="6948">
                  <c:v>2.54970470924532</c:v>
                </c:pt>
                <c:pt idx="6949">
                  <c:v>2.5495413664409674</c:v>
                </c:pt>
                <c:pt idx="6950">
                  <c:v>2.5492281209092056</c:v>
                </c:pt>
                <c:pt idx="6951">
                  <c:v>2.548914649278343</c:v>
                </c:pt>
                <c:pt idx="6952">
                  <c:v>2.5483416383339916</c:v>
                </c:pt>
                <c:pt idx="6953">
                  <c:v>2.547959210587186</c:v>
                </c:pt>
                <c:pt idx="6954">
                  <c:v>2.5473712543635818</c:v>
                </c:pt>
                <c:pt idx="6955">
                  <c:v>2.5469605804442441</c:v>
                </c:pt>
                <c:pt idx="6956">
                  <c:v>2.5467482466686699</c:v>
                </c:pt>
                <c:pt idx="6957">
                  <c:v>2.5457536918079016</c:v>
                </c:pt>
                <c:pt idx="6958">
                  <c:v>2.5456025946339405</c:v>
                </c:pt>
                <c:pt idx="6959">
                  <c:v>2.5452177462665366</c:v>
                </c:pt>
                <c:pt idx="6960">
                  <c:v>2.5451214808648341</c:v>
                </c:pt>
                <c:pt idx="6961">
                  <c:v>2.5446329489764263</c:v>
                </c:pt>
                <c:pt idx="6962">
                  <c:v>2.5440611507323596</c:v>
                </c:pt>
                <c:pt idx="6963">
                  <c:v>2.5439232553901405</c:v>
                </c:pt>
                <c:pt idx="6964">
                  <c:v>2.5434747929048216</c:v>
                </c:pt>
                <c:pt idx="6965">
                  <c:v>2.5426733073791903</c:v>
                </c:pt>
                <c:pt idx="6966">
                  <c:v>2.5425557239259464</c:v>
                </c:pt>
                <c:pt idx="6967">
                  <c:v>2.5423412250497694</c:v>
                </c:pt>
                <c:pt idx="6968">
                  <c:v>2.5421750886142318</c:v>
                </c:pt>
                <c:pt idx="6969">
                  <c:v>2.5416000429926759</c:v>
                </c:pt>
                <c:pt idx="6970">
                  <c:v>2.5413434517816027</c:v>
                </c:pt>
                <c:pt idx="6971">
                  <c:v>2.5403433808917026</c:v>
                </c:pt>
                <c:pt idx="6972">
                  <c:v>2.5402599376068484</c:v>
                </c:pt>
                <c:pt idx="6973">
                  <c:v>2.5400790888041724</c:v>
                </c:pt>
                <c:pt idx="6974">
                  <c:v>2.5391806850622536</c:v>
                </c:pt>
                <c:pt idx="6975">
                  <c:v>2.5387272958811642</c:v>
                </c:pt>
                <c:pt idx="6976">
                  <c:v>2.5373292760616604</c:v>
                </c:pt>
                <c:pt idx="6977">
                  <c:v>2.5366005233314004</c:v>
                </c:pt>
                <c:pt idx="6978">
                  <c:v>2.5362988544143961</c:v>
                </c:pt>
                <c:pt idx="6979">
                  <c:v>2.5347310152871834</c:v>
                </c:pt>
                <c:pt idx="6980">
                  <c:v>2.5342941063620188</c:v>
                </c:pt>
                <c:pt idx="6981">
                  <c:v>2.5340543244039506</c:v>
                </c:pt>
                <c:pt idx="6982">
                  <c:v>2.5339343837611277</c:v>
                </c:pt>
                <c:pt idx="6983">
                  <c:v>2.533531987941342</c:v>
                </c:pt>
                <c:pt idx="6984">
                  <c:v>2.5334825451957541</c:v>
                </c:pt>
                <c:pt idx="6985">
                  <c:v>2.5333695120644051</c:v>
                </c:pt>
                <c:pt idx="6986">
                  <c:v>2.5331716332675414</c:v>
                </c:pt>
                <c:pt idx="6987">
                  <c:v>2.5329312305981109</c:v>
                </c:pt>
                <c:pt idx="6988">
                  <c:v>2.5308539919163171</c:v>
                </c:pt>
                <c:pt idx="6989">
                  <c:v>2.5305198563317748</c:v>
                </c:pt>
                <c:pt idx="6990">
                  <c:v>2.5300929263569629</c:v>
                </c:pt>
                <c:pt idx="6991">
                  <c:v>2.529950523049874</c:v>
                </c:pt>
                <c:pt idx="6992">
                  <c:v>2.5297867015011319</c:v>
                </c:pt>
                <c:pt idx="6993">
                  <c:v>2.529401833961006</c:v>
                </c:pt>
                <c:pt idx="6994">
                  <c:v>2.5291379313780507</c:v>
                </c:pt>
                <c:pt idx="6995">
                  <c:v>2.5285096261669864</c:v>
                </c:pt>
                <c:pt idx="6996">
                  <c:v>2.5283667026694392</c:v>
                </c:pt>
                <c:pt idx="6997">
                  <c:v>2.5280091880110467</c:v>
                </c:pt>
                <c:pt idx="6998">
                  <c:v>2.5277873810300071</c:v>
                </c:pt>
                <c:pt idx="6999">
                  <c:v>2.5276585378752001</c:v>
                </c:pt>
                <c:pt idx="7000">
                  <c:v>2.5275153339691632</c:v>
                </c:pt>
                <c:pt idx="7001">
                  <c:v>2.5274007368362592</c:v>
                </c:pt>
                <c:pt idx="7002">
                  <c:v>2.5264541549151542</c:v>
                </c:pt>
                <c:pt idx="7003">
                  <c:v>2.5263608192405913</c:v>
                </c:pt>
                <c:pt idx="7004">
                  <c:v>2.5262459170206495</c:v>
                </c:pt>
                <c:pt idx="7005">
                  <c:v>2.5261669041064132</c:v>
                </c:pt>
                <c:pt idx="7006">
                  <c:v>2.5250376047469105</c:v>
                </c:pt>
                <c:pt idx="7007">
                  <c:v>2.5247998621473053</c:v>
                </c:pt>
                <c:pt idx="7008">
                  <c:v>2.5241363765925686</c:v>
                </c:pt>
                <c:pt idx="7009">
                  <c:v>2.523912582295222</c:v>
                </c:pt>
                <c:pt idx="7010">
                  <c:v>2.5236453219215385</c:v>
                </c:pt>
                <c:pt idx="7011">
                  <c:v>2.5233706669901497</c:v>
                </c:pt>
                <c:pt idx="7012">
                  <c:v>2.5222123160149783</c:v>
                </c:pt>
                <c:pt idx="7013">
                  <c:v>2.5221688176944106</c:v>
                </c:pt>
                <c:pt idx="7014">
                  <c:v>2.5220382965862163</c:v>
                </c:pt>
                <c:pt idx="7015">
                  <c:v>2.5213851020017559</c:v>
                </c:pt>
                <c:pt idx="7016">
                  <c:v>2.5209781734342442</c:v>
                </c:pt>
                <c:pt idx="7017">
                  <c:v>2.5209636332168932</c:v>
                </c:pt>
                <c:pt idx="7018">
                  <c:v>2.5187332251549033</c:v>
                </c:pt>
                <c:pt idx="7019">
                  <c:v>2.518711301609029</c:v>
                </c:pt>
                <c:pt idx="7020">
                  <c:v>2.5186820684928617</c:v>
                </c:pt>
                <c:pt idx="7021">
                  <c:v>2.5183750019126143</c:v>
                </c:pt>
                <c:pt idx="7022">
                  <c:v>2.5181043108812289</c:v>
                </c:pt>
                <c:pt idx="7023">
                  <c:v>2.5169024557213082</c:v>
                </c:pt>
                <c:pt idx="7024">
                  <c:v>2.5168364038866016</c:v>
                </c:pt>
                <c:pt idx="7025">
                  <c:v>2.5166528738408913</c:v>
                </c:pt>
                <c:pt idx="7026">
                  <c:v>2.5162047347615171</c:v>
                </c:pt>
                <c:pt idx="7027">
                  <c:v>2.51619003384479</c:v>
                </c:pt>
                <c:pt idx="7028">
                  <c:v>2.5159253322138322</c:v>
                </c:pt>
                <c:pt idx="7029">
                  <c:v>2.5150197157380774</c:v>
                </c:pt>
                <c:pt idx="7030">
                  <c:v>2.5143853968222407</c:v>
                </c:pt>
                <c:pt idx="7031">
                  <c:v>2.5138831856110926</c:v>
                </c:pt>
                <c:pt idx="7032">
                  <c:v>2.5137871084834917</c:v>
                </c:pt>
                <c:pt idx="7033">
                  <c:v>2.5134099851345422</c:v>
                </c:pt>
                <c:pt idx="7034">
                  <c:v>2.5133803929785001</c:v>
                </c:pt>
                <c:pt idx="7035">
                  <c:v>2.5130029161356164</c:v>
                </c:pt>
                <c:pt idx="7036">
                  <c:v>2.5118833609788744</c:v>
                </c:pt>
                <c:pt idx="7037">
                  <c:v>2.5117274324067727</c:v>
                </c:pt>
                <c:pt idx="7038">
                  <c:v>2.5115863059181116</c:v>
                </c:pt>
                <c:pt idx="7039">
                  <c:v>2.5110808455391185</c:v>
                </c:pt>
                <c:pt idx="7040">
                  <c:v>2.5107460259389227</c:v>
                </c:pt>
                <c:pt idx="7041">
                  <c:v>2.5105971343311411</c:v>
                </c:pt>
                <c:pt idx="7042">
                  <c:v>2.5103066487945345</c:v>
                </c:pt>
                <c:pt idx="7043">
                  <c:v>2.5102917468616184</c:v>
                </c:pt>
                <c:pt idx="7044">
                  <c:v>2.5101054295438994</c:v>
                </c:pt>
                <c:pt idx="7045">
                  <c:v>2.5097325549400615</c:v>
                </c:pt>
                <c:pt idx="7046">
                  <c:v>2.5096504795465822</c:v>
                </c:pt>
                <c:pt idx="7047">
                  <c:v>2.5085671242925192</c:v>
                </c:pt>
                <c:pt idx="7048">
                  <c:v>2.5081180476663061</c:v>
                </c:pt>
                <c:pt idx="7049">
                  <c:v>2.5078708574442463</c:v>
                </c:pt>
                <c:pt idx="7050">
                  <c:v>2.5075185555764241</c:v>
                </c:pt>
                <c:pt idx="7051">
                  <c:v>2.5070383653707773</c:v>
                </c:pt>
                <c:pt idx="7052">
                  <c:v>2.5068656672455272</c:v>
                </c:pt>
                <c:pt idx="7053">
                  <c:v>2.5067680248756732</c:v>
                </c:pt>
                <c:pt idx="7054">
                  <c:v>2.5067605130147745</c:v>
                </c:pt>
                <c:pt idx="7055">
                  <c:v>2.5062268385148263</c:v>
                </c:pt>
                <c:pt idx="7056">
                  <c:v>2.5058506174840711</c:v>
                </c:pt>
                <c:pt idx="7057">
                  <c:v>2.5057075679945155</c:v>
                </c:pt>
                <c:pt idx="7058">
                  <c:v>2.5055494058257128</c:v>
                </c:pt>
                <c:pt idx="7059">
                  <c:v>2.5054891384167237</c:v>
                </c:pt>
                <c:pt idx="7060">
                  <c:v>2.5028138977134495</c:v>
                </c:pt>
                <c:pt idx="7061">
                  <c:v>2.5026546780100234</c:v>
                </c:pt>
                <c:pt idx="7062">
                  <c:v>2.5025940075273478</c:v>
                </c:pt>
                <c:pt idx="7063">
                  <c:v>2.5023815940677387</c:v>
                </c:pt>
                <c:pt idx="7064">
                  <c:v>2.502222215766476</c:v>
                </c:pt>
                <c:pt idx="7065">
                  <c:v>2.5019640506357059</c:v>
                </c:pt>
                <c:pt idx="7066">
                  <c:v>2.501523296792969</c:v>
                </c:pt>
                <c:pt idx="7067">
                  <c:v>2.5012418923642206</c:v>
                </c:pt>
                <c:pt idx="7068">
                  <c:v>2.5008156358278533</c:v>
                </c:pt>
                <c:pt idx="7069">
                  <c:v>2.4995496259051491</c:v>
                </c:pt>
                <c:pt idx="7070">
                  <c:v>2.4994656031581308</c:v>
                </c:pt>
                <c:pt idx="7071">
                  <c:v>2.4987392749319217</c:v>
                </c:pt>
                <c:pt idx="7072">
                  <c:v>2.4977050301950605</c:v>
                </c:pt>
                <c:pt idx="7073">
                  <c:v>2.4976820189807967</c:v>
                </c:pt>
                <c:pt idx="7074">
                  <c:v>2.497221538466281</c:v>
                </c:pt>
                <c:pt idx="7075">
                  <c:v>2.4967451951157158</c:v>
                </c:pt>
                <c:pt idx="7076">
                  <c:v>2.4959603948817053</c:v>
                </c:pt>
                <c:pt idx="7077">
                  <c:v>2.4938915868254536</c:v>
                </c:pt>
                <c:pt idx="7078">
                  <c:v>2.4922635911096158</c:v>
                </c:pt>
                <c:pt idx="7079">
                  <c:v>2.4922247548283782</c:v>
                </c:pt>
                <c:pt idx="7080">
                  <c:v>2.4917662242446874</c:v>
                </c:pt>
                <c:pt idx="7081">
                  <c:v>2.4916651269621801</c:v>
                </c:pt>
                <c:pt idx="7082">
                  <c:v>2.4911670738525693</c:v>
                </c:pt>
                <c:pt idx="7083">
                  <c:v>2.4911203520765182</c:v>
                </c:pt>
                <c:pt idx="7084">
                  <c:v>2.4890439527623234</c:v>
                </c:pt>
                <c:pt idx="7085">
                  <c:v>2.4890048274857768</c:v>
                </c:pt>
                <c:pt idx="7086">
                  <c:v>2.4889265663567914</c:v>
                </c:pt>
                <c:pt idx="7087">
                  <c:v>2.4888952579559631</c:v>
                </c:pt>
                <c:pt idx="7088">
                  <c:v>2.4886133807357314</c:v>
                </c:pt>
                <c:pt idx="7089">
                  <c:v>2.4881039719140072</c:v>
                </c:pt>
                <c:pt idx="7090">
                  <c:v>2.4879627991480322</c:v>
                </c:pt>
                <c:pt idx="7091">
                  <c:v>2.4878137336489008</c:v>
                </c:pt>
                <c:pt idx="7092">
                  <c:v>2.4877509539181126</c:v>
                </c:pt>
                <c:pt idx="7093">
                  <c:v>2.4866429690235119</c:v>
                </c:pt>
                <c:pt idx="7094">
                  <c:v>2.4865013204632529</c:v>
                </c:pt>
                <c:pt idx="7095">
                  <c:v>2.486391117411356</c:v>
                </c:pt>
                <c:pt idx="7096">
                  <c:v>2.4862493866704822</c:v>
                </c:pt>
                <c:pt idx="7097">
                  <c:v>2.4852165062306599</c:v>
                </c:pt>
                <c:pt idx="7098">
                  <c:v>2.4851454547169611</c:v>
                </c:pt>
                <c:pt idx="7099">
                  <c:v>2.4849085323504307</c:v>
                </c:pt>
                <c:pt idx="7100">
                  <c:v>2.4846951916562032</c:v>
                </c:pt>
                <c:pt idx="7101">
                  <c:v>2.4846003399198251</c:v>
                </c:pt>
                <c:pt idx="7102">
                  <c:v>2.4837615819824856</c:v>
                </c:pt>
                <c:pt idx="7103">
                  <c:v>2.4834842774848975</c:v>
                </c:pt>
                <c:pt idx="7104">
                  <c:v>2.4834287953314038</c:v>
                </c:pt>
                <c:pt idx="7105">
                  <c:v>2.4834129419855877</c:v>
                </c:pt>
                <c:pt idx="7106">
                  <c:v>2.4833336665747652</c:v>
                </c:pt>
                <c:pt idx="7107">
                  <c:v>2.4832781651758031</c:v>
                </c:pt>
                <c:pt idx="7108">
                  <c:v>2.4825321727166165</c:v>
                </c:pt>
                <c:pt idx="7109">
                  <c:v>2.4822938200258231</c:v>
                </c:pt>
                <c:pt idx="7110">
                  <c:v>2.4821427956334312</c:v>
                </c:pt>
                <c:pt idx="7111">
                  <c:v>2.4815540942617424</c:v>
                </c:pt>
                <c:pt idx="7112">
                  <c:v>2.4809964791567398</c:v>
                </c:pt>
                <c:pt idx="7113">
                  <c:v>2.4808689236871682</c:v>
                </c:pt>
                <c:pt idx="7114">
                  <c:v>2.4804940126875796</c:v>
                </c:pt>
                <c:pt idx="7115">
                  <c:v>2.4797192354395712</c:v>
                </c:pt>
                <c:pt idx="7116">
                  <c:v>2.4795993010316111</c:v>
                </c:pt>
                <c:pt idx="7117">
                  <c:v>2.4792793139244251</c:v>
                </c:pt>
                <c:pt idx="7118">
                  <c:v>2.4792713112252183</c:v>
                </c:pt>
                <c:pt idx="7119">
                  <c:v>2.4792312955170601</c:v>
                </c:pt>
                <c:pt idx="7120">
                  <c:v>2.4791992802956599</c:v>
                </c:pt>
                <c:pt idx="7121">
                  <c:v>2.4787668436538173</c:v>
                </c:pt>
                <c:pt idx="7122">
                  <c:v>2.4782457463311816</c:v>
                </c:pt>
                <c:pt idx="7123">
                  <c:v>2.4778525053730975</c:v>
                </c:pt>
                <c:pt idx="7124">
                  <c:v>2.4774347986349139</c:v>
                </c:pt>
                <c:pt idx="7125">
                  <c:v>2.4760583463459716</c:v>
                </c:pt>
                <c:pt idx="7126">
                  <c:v>2.4759454609041698</c:v>
                </c:pt>
                <c:pt idx="7127">
                  <c:v>2.4746451649625003</c:v>
                </c:pt>
                <c:pt idx="7128">
                  <c:v>2.4744752737645066</c:v>
                </c:pt>
                <c:pt idx="7129">
                  <c:v>2.4744590901837293</c:v>
                </c:pt>
                <c:pt idx="7130">
                  <c:v>2.4741109972506261</c:v>
                </c:pt>
                <c:pt idx="7131">
                  <c:v>2.4740543045435546</c:v>
                </c:pt>
                <c:pt idx="7132">
                  <c:v>2.4739084893051206</c:v>
                </c:pt>
                <c:pt idx="7133">
                  <c:v>2.4738274596797378</c:v>
                </c:pt>
                <c:pt idx="7134">
                  <c:v>2.4736572482404031</c:v>
                </c:pt>
                <c:pt idx="7135">
                  <c:v>2.4734139732609841</c:v>
                </c:pt>
                <c:pt idx="7136">
                  <c:v>2.4732273701124874</c:v>
                </c:pt>
                <c:pt idx="7137">
                  <c:v>2.472910772721078</c:v>
                </c:pt>
                <c:pt idx="7138">
                  <c:v>2.4727808198164696</c:v>
                </c:pt>
                <c:pt idx="7139">
                  <c:v>2.4725451810186705</c:v>
                </c:pt>
                <c:pt idx="7140">
                  <c:v>2.4718130730446055</c:v>
                </c:pt>
                <c:pt idx="7141">
                  <c:v>2.4715606164910153</c:v>
                </c:pt>
                <c:pt idx="7142">
                  <c:v>2.471087883917682</c:v>
                </c:pt>
                <c:pt idx="7143">
                  <c:v>2.4708921198220799</c:v>
                </c:pt>
                <c:pt idx="7144">
                  <c:v>2.4708594838918829</c:v>
                </c:pt>
                <c:pt idx="7145">
                  <c:v>2.4706799424243178</c:v>
                </c:pt>
                <c:pt idx="7146">
                  <c:v>2.4701326993685906</c:v>
                </c:pt>
                <c:pt idx="7147">
                  <c:v>2.470100006318146</c:v>
                </c:pt>
                <c:pt idx="7148">
                  <c:v>2.4698383732777227</c:v>
                </c:pt>
                <c:pt idx="7149">
                  <c:v>2.4692655009061677</c:v>
                </c:pt>
                <c:pt idx="7150">
                  <c:v>2.4682570481772665</c:v>
                </c:pt>
                <c:pt idx="7151">
                  <c:v>2.4677067416235539</c:v>
                </c:pt>
                <c:pt idx="7152">
                  <c:v>2.4672133372511196</c:v>
                </c:pt>
                <c:pt idx="7153">
                  <c:v>2.4668511507781994</c:v>
                </c:pt>
                <c:pt idx="7154">
                  <c:v>2.466727609046707</c:v>
                </c:pt>
                <c:pt idx="7155">
                  <c:v>2.4655315569735499</c:v>
                </c:pt>
                <c:pt idx="7156">
                  <c:v>2.4655315569735499</c:v>
                </c:pt>
                <c:pt idx="7157">
                  <c:v>2.4652175633467452</c:v>
                </c:pt>
                <c:pt idx="7158">
                  <c:v>2.463743721247059</c:v>
                </c:pt>
                <c:pt idx="7159">
                  <c:v>2.4633620260015729</c:v>
                </c:pt>
                <c:pt idx="7160">
                  <c:v>2.463328819251402</c:v>
                </c:pt>
                <c:pt idx="7161">
                  <c:v>2.4631295254129966</c:v>
                </c:pt>
                <c:pt idx="7162">
                  <c:v>2.4624811881074096</c:v>
                </c:pt>
                <c:pt idx="7163">
                  <c:v>2.4617985575251091</c:v>
                </c:pt>
                <c:pt idx="7164">
                  <c:v>2.4611231966396132</c:v>
                </c:pt>
                <c:pt idx="7165">
                  <c:v>2.4606974299786937</c:v>
                </c:pt>
                <c:pt idx="7166">
                  <c:v>2.4598446423882079</c:v>
                </c:pt>
                <c:pt idx="7167">
                  <c:v>2.4597609455578109</c:v>
                </c:pt>
                <c:pt idx="7168">
                  <c:v>2.459752574987554</c:v>
                </c:pt>
                <c:pt idx="7169">
                  <c:v>2.4594511269594768</c:v>
                </c:pt>
                <c:pt idx="7170">
                  <c:v>2.4592332842931528</c:v>
                </c:pt>
                <c:pt idx="7171">
                  <c:v>2.459107556108914</c:v>
                </c:pt>
                <c:pt idx="7172">
                  <c:v>2.4585287371894875</c:v>
                </c:pt>
                <c:pt idx="7173">
                  <c:v>2.4583356259919475</c:v>
                </c:pt>
                <c:pt idx="7174">
                  <c:v>2.4581424288883547</c:v>
                </c:pt>
                <c:pt idx="7175">
                  <c:v>2.4579071163549107</c:v>
                </c:pt>
                <c:pt idx="7176">
                  <c:v>2.4573519461106943</c:v>
                </c:pt>
                <c:pt idx="7177">
                  <c:v>2.4554877831191213</c:v>
                </c:pt>
                <c:pt idx="7178">
                  <c:v>2.4554370606210312</c:v>
                </c:pt>
                <c:pt idx="7179">
                  <c:v>2.4551918183332555</c:v>
                </c:pt>
                <c:pt idx="7180">
                  <c:v>2.4550649145126529</c:v>
                </c:pt>
                <c:pt idx="7181">
                  <c:v>2.4540992317153298</c:v>
                </c:pt>
                <c:pt idx="7182">
                  <c:v>2.4540059381037902</c:v>
                </c:pt>
                <c:pt idx="7183">
                  <c:v>2.4539295920577286</c:v>
                </c:pt>
                <c:pt idx="7184">
                  <c:v>2.4537344244987582</c:v>
                </c:pt>
                <c:pt idx="7185">
                  <c:v>2.4536070940398154</c:v>
                </c:pt>
                <c:pt idx="7186">
                  <c:v>2.4534457551812663</c:v>
                </c:pt>
                <c:pt idx="7187">
                  <c:v>2.4532588668558359</c:v>
                </c:pt>
                <c:pt idx="7188">
                  <c:v>2.452952876015337</c:v>
                </c:pt>
                <c:pt idx="7189">
                  <c:v>2.4529443731914959</c:v>
                </c:pt>
                <c:pt idx="7190">
                  <c:v>2.4528083053649254</c:v>
                </c:pt>
                <c:pt idx="7191">
                  <c:v>2.4525956140036524</c:v>
                </c:pt>
                <c:pt idx="7192">
                  <c:v>2.4520336078116283</c:v>
                </c:pt>
                <c:pt idx="7193">
                  <c:v>2.4518546350347794</c:v>
                </c:pt>
                <c:pt idx="7194">
                  <c:v>2.4518120115957855</c:v>
                </c:pt>
                <c:pt idx="7195">
                  <c:v>2.4517608579465038</c:v>
                </c:pt>
                <c:pt idx="7196">
                  <c:v>2.4505313593293216</c:v>
                </c:pt>
                <c:pt idx="7197">
                  <c:v>2.4499666737532015</c:v>
                </c:pt>
                <c:pt idx="7198">
                  <c:v>2.4496069457272713</c:v>
                </c:pt>
                <c:pt idx="7199">
                  <c:v>2.4493498145877868</c:v>
                </c:pt>
                <c:pt idx="7200">
                  <c:v>2.4488179273160653</c:v>
                </c:pt>
                <c:pt idx="7201">
                  <c:v>2.4480618703404637</c:v>
                </c:pt>
                <c:pt idx="7202">
                  <c:v>2.4473820143779395</c:v>
                </c:pt>
                <c:pt idx="7203">
                  <c:v>2.4467442204658392</c:v>
                </c:pt>
                <c:pt idx="7204">
                  <c:v>2.446442234601689</c:v>
                </c:pt>
                <c:pt idx="7205">
                  <c:v>2.4459586200239531</c:v>
                </c:pt>
                <c:pt idx="7206">
                  <c:v>2.4458981303183722</c:v>
                </c:pt>
                <c:pt idx="7207">
                  <c:v>2.4458722035794818</c:v>
                </c:pt>
                <c:pt idx="7208">
                  <c:v>2.4450417296443141</c:v>
                </c:pt>
                <c:pt idx="7209">
                  <c:v>2.4450330705113963</c:v>
                </c:pt>
                <c:pt idx="7210">
                  <c:v>2.4446432307300632</c:v>
                </c:pt>
                <c:pt idx="7211">
                  <c:v>2.4443050862956031</c:v>
                </c:pt>
                <c:pt idx="7212">
                  <c:v>2.4443050862956031</c:v>
                </c:pt>
                <c:pt idx="7213">
                  <c:v>2.4440274376782249</c:v>
                </c:pt>
                <c:pt idx="7214">
                  <c:v>2.4434802976868486</c:v>
                </c:pt>
                <c:pt idx="7215">
                  <c:v>2.4429933716745897</c:v>
                </c:pt>
                <c:pt idx="7216">
                  <c:v>2.4426713529259474</c:v>
                </c:pt>
                <c:pt idx="7217">
                  <c:v>2.4426016958454175</c:v>
                </c:pt>
                <c:pt idx="7218">
                  <c:v>2.4424710586986826</c:v>
                </c:pt>
                <c:pt idx="7219">
                  <c:v>2.4423142422341049</c:v>
                </c:pt>
                <c:pt idx="7220">
                  <c:v>2.4414420070352012</c:v>
                </c:pt>
                <c:pt idx="7221">
                  <c:v>2.4404542684525592</c:v>
                </c:pt>
                <c:pt idx="7222">
                  <c:v>2.4400690537919019</c:v>
                </c:pt>
                <c:pt idx="7223">
                  <c:v>2.439736093212447</c:v>
                </c:pt>
                <c:pt idx="7224">
                  <c:v>2.4380586511407136</c:v>
                </c:pt>
                <c:pt idx="7225">
                  <c:v>2.4378386103588352</c:v>
                </c:pt>
                <c:pt idx="7226">
                  <c:v>2.4377945888209229</c:v>
                </c:pt>
                <c:pt idx="7227">
                  <c:v>2.4371866354801193</c:v>
                </c:pt>
                <c:pt idx="7228">
                  <c:v>2.4371337297303244</c:v>
                </c:pt>
                <c:pt idx="7229">
                  <c:v>2.4368602806370303</c:v>
                </c:pt>
                <c:pt idx="7230">
                  <c:v>2.4354107749458023</c:v>
                </c:pt>
                <c:pt idx="7231">
                  <c:v>2.4352956678926243</c:v>
                </c:pt>
                <c:pt idx="7232">
                  <c:v>2.4352691003933917</c:v>
                </c:pt>
                <c:pt idx="7233">
                  <c:v>2.4351450972365156</c:v>
                </c:pt>
                <c:pt idx="7234">
                  <c:v>2.4348881208673161</c:v>
                </c:pt>
                <c:pt idx="7235">
                  <c:v>2.4341251577179763</c:v>
                </c:pt>
                <c:pt idx="7236">
                  <c:v>2.4338586921311918</c:v>
                </c:pt>
                <c:pt idx="7237">
                  <c:v>2.4336187332368633</c:v>
                </c:pt>
                <c:pt idx="7238">
                  <c:v>2.4334409003895887</c:v>
                </c:pt>
                <c:pt idx="7239">
                  <c:v>2.4333252699778636</c:v>
                </c:pt>
                <c:pt idx="7240">
                  <c:v>2.4328535348122373</c:v>
                </c:pt>
                <c:pt idx="7241">
                  <c:v>2.432746655670933</c:v>
                </c:pt>
                <c:pt idx="7242">
                  <c:v>2.4323010425783766</c:v>
                </c:pt>
                <c:pt idx="7243">
                  <c:v>2.4320869857780831</c:v>
                </c:pt>
                <c:pt idx="7244">
                  <c:v>2.4320156100593033</c:v>
                </c:pt>
                <c:pt idx="7245">
                  <c:v>2.4319709942774348</c:v>
                </c:pt>
                <c:pt idx="7246">
                  <c:v>2.4319263739116437</c:v>
                </c:pt>
                <c:pt idx="7247">
                  <c:v>2.4311492447760616</c:v>
                </c:pt>
                <c:pt idx="7248">
                  <c:v>2.4308809464528913</c:v>
                </c:pt>
                <c:pt idx="7249">
                  <c:v>2.4306930389570942</c:v>
                </c:pt>
                <c:pt idx="7250">
                  <c:v>2.430245312647437</c:v>
                </c:pt>
                <c:pt idx="7251">
                  <c:v>2.4296536062719865</c:v>
                </c:pt>
                <c:pt idx="7252">
                  <c:v>2.4294023355656633</c:v>
                </c:pt>
                <c:pt idx="7253">
                  <c:v>2.4292137870854282</c:v>
                </c:pt>
                <c:pt idx="7254">
                  <c:v>2.4287735220331226</c:v>
                </c:pt>
                <c:pt idx="7255">
                  <c:v>2.4287105905757165</c:v>
                </c:pt>
                <c:pt idx="7256">
                  <c:v>2.4278285913247597</c:v>
                </c:pt>
                <c:pt idx="7257">
                  <c:v>2.4276303450592178</c:v>
                </c:pt>
                <c:pt idx="7258">
                  <c:v>2.4274139731464621</c:v>
                </c:pt>
                <c:pt idx="7259">
                  <c:v>2.4273869190761292</c:v>
                </c:pt>
                <c:pt idx="7260">
                  <c:v>2.4262943310494238</c:v>
                </c:pt>
                <c:pt idx="7261">
                  <c:v>2.4262852899343752</c:v>
                </c:pt>
                <c:pt idx="7262">
                  <c:v>2.4262762486311056</c:v>
                </c:pt>
                <c:pt idx="7263">
                  <c:v>2.4260863377694375</c:v>
                </c:pt>
                <c:pt idx="7264">
                  <c:v>2.4238827361800479</c:v>
                </c:pt>
                <c:pt idx="7265">
                  <c:v>2.4237918130180067</c:v>
                </c:pt>
                <c:pt idx="7266">
                  <c:v>2.423109281867148</c:v>
                </c:pt>
                <c:pt idx="7267">
                  <c:v>2.422826855380328</c:v>
                </c:pt>
                <c:pt idx="7268">
                  <c:v>2.4221793147411304</c:v>
                </c:pt>
                <c:pt idx="7269">
                  <c:v>2.4215673685565888</c:v>
                </c:pt>
                <c:pt idx="7270">
                  <c:v>2.4200107886624318</c:v>
                </c:pt>
                <c:pt idx="7271">
                  <c:v>2.4198731751494762</c:v>
                </c:pt>
                <c:pt idx="7272">
                  <c:v>2.4195335419309956</c:v>
                </c:pt>
                <c:pt idx="7273">
                  <c:v>2.4195243589675455</c:v>
                </c:pt>
                <c:pt idx="7274">
                  <c:v>2.4182460340536993</c:v>
                </c:pt>
                <c:pt idx="7275">
                  <c:v>2.4176377396522297</c:v>
                </c:pt>
                <c:pt idx="7276">
                  <c:v>2.4170378279349505</c:v>
                </c:pt>
                <c:pt idx="7277">
                  <c:v>2.4170193559651505</c:v>
                </c:pt>
                <c:pt idx="7278">
                  <c:v>2.4167236975467343</c:v>
                </c:pt>
                <c:pt idx="7279">
                  <c:v>2.4165942836692569</c:v>
                </c:pt>
                <c:pt idx="7280">
                  <c:v>2.4165388087715529</c:v>
                </c:pt>
                <c:pt idx="7281">
                  <c:v>2.4164370863845339</c:v>
                </c:pt>
                <c:pt idx="7282">
                  <c:v>2.4163445908073511</c:v>
                </c:pt>
                <c:pt idx="7283">
                  <c:v>2.4163075870598827</c:v>
                </c:pt>
                <c:pt idx="7284">
                  <c:v>2.4161873031014096</c:v>
                </c:pt>
                <c:pt idx="7285">
                  <c:v>2.4157892032702564</c:v>
                </c:pt>
                <c:pt idx="7286">
                  <c:v>2.4152980194627718</c:v>
                </c:pt>
                <c:pt idx="7287">
                  <c:v>2.4148155627689425</c:v>
                </c:pt>
                <c:pt idx="7288">
                  <c:v>2.4142117372297247</c:v>
                </c:pt>
                <c:pt idx="7289">
                  <c:v>2.4140722735698508</c:v>
                </c:pt>
                <c:pt idx="7290">
                  <c:v>2.4136629216146979</c:v>
                </c:pt>
                <c:pt idx="7291">
                  <c:v>2.4136443055367707</c:v>
                </c:pt>
                <c:pt idx="7292">
                  <c:v>2.4136163799235812</c:v>
                </c:pt>
                <c:pt idx="7293">
                  <c:v>2.4135139706430455</c:v>
                </c:pt>
                <c:pt idx="7294">
                  <c:v>2.4120963826545525</c:v>
                </c:pt>
                <c:pt idx="7295">
                  <c:v>2.4117973525529939</c:v>
                </c:pt>
                <c:pt idx="7296">
                  <c:v>2.4116851631613114</c:v>
                </c:pt>
                <c:pt idx="7297">
                  <c:v>2.4116384090265566</c:v>
                </c:pt>
                <c:pt idx="7298">
                  <c:v>2.410955224841131</c:v>
                </c:pt>
                <c:pt idx="7299">
                  <c:v>2.4099800614001761</c:v>
                </c:pt>
                <c:pt idx="7300">
                  <c:v>2.4097265355395145</c:v>
                </c:pt>
                <c:pt idx="7301">
                  <c:v>2.4094352676625359</c:v>
                </c:pt>
                <c:pt idx="7302">
                  <c:v>2.4090309272511341</c:v>
                </c:pt>
                <c:pt idx="7303">
                  <c:v>2.4086356263496049</c:v>
                </c:pt>
                <c:pt idx="7304">
                  <c:v>2.4077401637749136</c:v>
                </c:pt>
                <c:pt idx="7305">
                  <c:v>2.4071925511985448</c:v>
                </c:pt>
                <c:pt idx="7306">
                  <c:v>2.4068333957849894</c:v>
                </c:pt>
                <c:pt idx="7307">
                  <c:v>2.4061710151935132</c:v>
                </c:pt>
                <c:pt idx="7308">
                  <c:v>2.40589630413825</c:v>
                </c:pt>
                <c:pt idx="7309">
                  <c:v>2.403492287455705</c:v>
                </c:pt>
                <c:pt idx="7310">
                  <c:v>2.403396993102862</c:v>
                </c:pt>
                <c:pt idx="7311">
                  <c:v>2.4030919105837656</c:v>
                </c:pt>
                <c:pt idx="7312">
                  <c:v>2.4026147896864369</c:v>
                </c:pt>
                <c:pt idx="7313">
                  <c:v>2.4020893505720968</c:v>
                </c:pt>
                <c:pt idx="7314">
                  <c:v>2.4019172505175748</c:v>
                </c:pt>
                <c:pt idx="7315">
                  <c:v>2.4018216098992702</c:v>
                </c:pt>
                <c:pt idx="7316">
                  <c:v>2.4012856328613332</c:v>
                </c:pt>
                <c:pt idx="7317">
                  <c:v>2.4010940520730557</c:v>
                </c:pt>
                <c:pt idx="7318">
                  <c:v>2.4007585822013393</c:v>
                </c:pt>
                <c:pt idx="7319">
                  <c:v>2.400461235186488</c:v>
                </c:pt>
                <c:pt idx="7320">
                  <c:v>2.4001828874234885</c:v>
                </c:pt>
                <c:pt idx="7321">
                  <c:v>2.3985957805417479</c:v>
                </c:pt>
                <c:pt idx="7322">
                  <c:v>2.398499405581429</c:v>
                </c:pt>
                <c:pt idx="7323">
                  <c:v>2.3981715706513458</c:v>
                </c:pt>
                <c:pt idx="7324">
                  <c:v>2.3981522785347842</c:v>
                </c:pt>
                <c:pt idx="7325">
                  <c:v>2.3965286736138411</c:v>
                </c:pt>
                <c:pt idx="7326">
                  <c:v>2.3962962337624858</c:v>
                </c:pt>
                <c:pt idx="7327">
                  <c:v>2.396189657240162</c:v>
                </c:pt>
                <c:pt idx="7328">
                  <c:v>2.3961218221969403</c:v>
                </c:pt>
                <c:pt idx="7329">
                  <c:v>2.3958018856285133</c:v>
                </c:pt>
                <c:pt idx="7330">
                  <c:v>2.3954525949024061</c:v>
                </c:pt>
                <c:pt idx="7331">
                  <c:v>2.3951127371558782</c:v>
                </c:pt>
                <c:pt idx="7332">
                  <c:v>2.3947823347684425</c:v>
                </c:pt>
                <c:pt idx="7333">
                  <c:v>2.3944127638064399</c:v>
                </c:pt>
                <c:pt idx="7334">
                  <c:v>2.3940331399929922</c:v>
                </c:pt>
                <c:pt idx="7335">
                  <c:v>2.3935557058854946</c:v>
                </c:pt>
                <c:pt idx="7336">
                  <c:v>2.3933509304874834</c:v>
                </c:pt>
                <c:pt idx="7337">
                  <c:v>2.3933314230319751</c:v>
                </c:pt>
                <c:pt idx="7338">
                  <c:v>2.3928043902462126</c:v>
                </c:pt>
                <c:pt idx="7339">
                  <c:v>2.3927457915483763</c:v>
                </c:pt>
                <c:pt idx="7340">
                  <c:v>2.3906800264145116</c:v>
                </c:pt>
                <c:pt idx="7341">
                  <c:v>2.3902087142468136</c:v>
                </c:pt>
                <c:pt idx="7342">
                  <c:v>2.3896090160519861</c:v>
                </c:pt>
                <c:pt idx="7343">
                  <c:v>2.3884663166402582</c:v>
                </c:pt>
                <c:pt idx="7344">
                  <c:v>2.3883972643551115</c:v>
                </c:pt>
                <c:pt idx="7345">
                  <c:v>2.3880715841884408</c:v>
                </c:pt>
                <c:pt idx="7346">
                  <c:v>2.3874788119925401</c:v>
                </c:pt>
                <c:pt idx="7347">
                  <c:v>2.3871821222133396</c:v>
                </c:pt>
                <c:pt idx="7348">
                  <c:v>2.38693472580804</c:v>
                </c:pt>
                <c:pt idx="7349">
                  <c:v>2.3858445042581002</c:v>
                </c:pt>
                <c:pt idx="7350">
                  <c:v>2.3847515390055607</c:v>
                </c:pt>
                <c:pt idx="7351">
                  <c:v>2.3847415903306111</c:v>
                </c:pt>
                <c:pt idx="7352">
                  <c:v>2.3841542147569368</c:v>
                </c:pt>
                <c:pt idx="7353">
                  <c:v>2.3834862303209468</c:v>
                </c:pt>
                <c:pt idx="7354">
                  <c:v>2.3830969299490943</c:v>
                </c:pt>
                <c:pt idx="7355">
                  <c:v>2.3829471060672813</c:v>
                </c:pt>
                <c:pt idx="7356">
                  <c:v>2.3828272097363654</c:v>
                </c:pt>
                <c:pt idx="7357">
                  <c:v>2.3818267843281768</c:v>
                </c:pt>
                <c:pt idx="7358">
                  <c:v>2.3800805315744937</c:v>
                </c:pt>
                <c:pt idx="7359">
                  <c:v>2.3799196035356331</c:v>
                </c:pt>
                <c:pt idx="7360">
                  <c:v>2.3791946885024324</c:v>
                </c:pt>
                <c:pt idx="7361">
                  <c:v>2.3785896669526285</c:v>
                </c:pt>
                <c:pt idx="7362">
                  <c:v>2.3783979009481375</c:v>
                </c:pt>
                <c:pt idx="7363">
                  <c:v>2.3755620127247448</c:v>
                </c:pt>
                <c:pt idx="7364">
                  <c:v>2.3755315277183393</c:v>
                </c:pt>
                <c:pt idx="7365">
                  <c:v>2.3749519056491262</c:v>
                </c:pt>
                <c:pt idx="7366">
                  <c:v>2.3745752452682756</c:v>
                </c:pt>
                <c:pt idx="7367">
                  <c:v>2.3745446909152097</c:v>
                </c:pt>
                <c:pt idx="7368">
                  <c:v>2.374228836663959</c:v>
                </c:pt>
                <c:pt idx="7369">
                  <c:v>2.374106508804013</c:v>
                </c:pt>
                <c:pt idx="7370">
                  <c:v>2.3737801326250838</c:v>
                </c:pt>
                <c:pt idx="7371">
                  <c:v>2.3736474722092176</c:v>
                </c:pt>
                <c:pt idx="7372">
                  <c:v>2.3735964381803334</c:v>
                </c:pt>
                <c:pt idx="7373">
                  <c:v>2.3730755482485986</c:v>
                </c:pt>
                <c:pt idx="7374">
                  <c:v>2.3728302072297947</c:v>
                </c:pt>
                <c:pt idx="7375">
                  <c:v>2.3717244542620999</c:v>
                </c:pt>
                <c:pt idx="7376">
                  <c:v>2.3714783485800872</c:v>
                </c:pt>
                <c:pt idx="7377">
                  <c:v>2.3714065414779353</c:v>
                </c:pt>
                <c:pt idx="7378">
                  <c:v>2.370872745276313</c:v>
                </c:pt>
                <c:pt idx="7379">
                  <c:v>2.3703897104835856</c:v>
                </c:pt>
                <c:pt idx="7380">
                  <c:v>2.3698649578562292</c:v>
                </c:pt>
                <c:pt idx="7381">
                  <c:v>2.3696486988175565</c:v>
                </c:pt>
                <c:pt idx="7382">
                  <c:v>2.369628097101184</c:v>
                </c:pt>
                <c:pt idx="7383">
                  <c:v>2.3694426376626643</c:v>
                </c:pt>
                <c:pt idx="7384">
                  <c:v>2.3684728384403617</c:v>
                </c:pt>
                <c:pt idx="7385">
                  <c:v>2.3684728384403617</c:v>
                </c:pt>
                <c:pt idx="7386">
                  <c:v>2.3684625097767809</c:v>
                </c:pt>
                <c:pt idx="7387">
                  <c:v>2.3677595837487302</c:v>
                </c:pt>
                <c:pt idx="7388">
                  <c:v>2.3676768117209579</c:v>
                </c:pt>
                <c:pt idx="7389">
                  <c:v>2.3674076936292754</c:v>
                </c:pt>
                <c:pt idx="7390">
                  <c:v>2.36726271478424</c:v>
                </c:pt>
                <c:pt idx="7391">
                  <c:v>2.3666823149415954</c:v>
                </c:pt>
                <c:pt idx="7392">
                  <c:v>2.3666615720232222</c:v>
                </c:pt>
                <c:pt idx="7393">
                  <c:v>2.3665785904410064</c:v>
                </c:pt>
                <c:pt idx="7394">
                  <c:v>2.3657894736096394</c:v>
                </c:pt>
                <c:pt idx="7395">
                  <c:v>2.3656959305409839</c:v>
                </c:pt>
                <c:pt idx="7396">
                  <c:v>2.3654359829173113</c:v>
                </c:pt>
                <c:pt idx="7397">
                  <c:v>2.3651654722351556</c:v>
                </c:pt>
                <c:pt idx="7398">
                  <c:v>2.3650926136383634</c:v>
                </c:pt>
                <c:pt idx="7399">
                  <c:v>2.3649989203357378</c:v>
                </c:pt>
                <c:pt idx="7400">
                  <c:v>2.3638938977741004</c:v>
                </c:pt>
                <c:pt idx="7401">
                  <c:v>2.3636328689752344</c:v>
                </c:pt>
                <c:pt idx="7402">
                  <c:v>2.3635597527882508</c:v>
                </c:pt>
                <c:pt idx="7403">
                  <c:v>2.3635284135109162</c:v>
                </c:pt>
                <c:pt idx="7404">
                  <c:v>2.3634657281709766</c:v>
                </c:pt>
                <c:pt idx="7405">
                  <c:v>2.3634134834752185</c:v>
                </c:pt>
                <c:pt idx="7406">
                  <c:v>2.3631103402384466</c:v>
                </c:pt>
                <c:pt idx="7407">
                  <c:v>2.3629011525835648</c:v>
                </c:pt>
                <c:pt idx="7408">
                  <c:v>2.3627232638200728</c:v>
                </c:pt>
                <c:pt idx="7409">
                  <c:v>2.3620633929065318</c:v>
                </c:pt>
                <c:pt idx="7410">
                  <c:v>2.3614655016804691</c:v>
                </c:pt>
                <c:pt idx="7411">
                  <c:v>2.3612660215508625</c:v>
                </c:pt>
                <c:pt idx="7412">
                  <c:v>2.3610139156138858</c:v>
                </c:pt>
                <c:pt idx="7413">
                  <c:v>2.3599302961121023</c:v>
                </c:pt>
                <c:pt idx="7414">
                  <c:v>2.3596984925595597</c:v>
                </c:pt>
                <c:pt idx="7415">
                  <c:v>2.3594032908029146</c:v>
                </c:pt>
                <c:pt idx="7416">
                  <c:v>2.358960111595402</c:v>
                </c:pt>
                <c:pt idx="7417">
                  <c:v>2.3589178804557647</c:v>
                </c:pt>
                <c:pt idx="7418">
                  <c:v>2.3588017236426979</c:v>
                </c:pt>
                <c:pt idx="7419">
                  <c:v>2.3583156400821959</c:v>
                </c:pt>
                <c:pt idx="7420">
                  <c:v>2.358231048246731</c:v>
                </c:pt>
                <c:pt idx="7421">
                  <c:v>2.3579771738346476</c:v>
                </c:pt>
                <c:pt idx="7422">
                  <c:v>2.3574795728087587</c:v>
                </c:pt>
                <c:pt idx="7423">
                  <c:v>2.3567692395419635</c:v>
                </c:pt>
                <c:pt idx="7424">
                  <c:v>2.355887660262324</c:v>
                </c:pt>
                <c:pt idx="7425">
                  <c:v>2.3550682063488506</c:v>
                </c:pt>
                <c:pt idx="7426">
                  <c:v>2.3541404655831593</c:v>
                </c:pt>
                <c:pt idx="7427">
                  <c:v>2.3538735064262899</c:v>
                </c:pt>
                <c:pt idx="7428">
                  <c:v>2.3538628246460052</c:v>
                </c:pt>
                <c:pt idx="7429">
                  <c:v>2.3529432072874776</c:v>
                </c:pt>
                <c:pt idx="7430">
                  <c:v>2.3526969327192151</c:v>
                </c:pt>
                <c:pt idx="7431">
                  <c:v>2.352611239253684</c:v>
                </c:pt>
                <c:pt idx="7432">
                  <c:v>2.3525040986383869</c:v>
                </c:pt>
                <c:pt idx="7433">
                  <c:v>2.3521610709407166</c:v>
                </c:pt>
                <c:pt idx="7434">
                  <c:v>2.3520645455637248</c:v>
                </c:pt>
                <c:pt idx="7435">
                  <c:v>2.3510981100108403</c:v>
                </c:pt>
                <c:pt idx="7436">
                  <c:v>2.3508185166636535</c:v>
                </c:pt>
                <c:pt idx="7437">
                  <c:v>2.3502049314268501</c:v>
                </c:pt>
                <c:pt idx="7438">
                  <c:v>2.3499894327463489</c:v>
                </c:pt>
                <c:pt idx="7439">
                  <c:v>2.3499463201755186</c:v>
                </c:pt>
                <c:pt idx="7440">
                  <c:v>2.3495689025086759</c:v>
                </c:pt>
                <c:pt idx="7441">
                  <c:v>2.3495473258750317</c:v>
                </c:pt>
                <c:pt idx="7442">
                  <c:v>2.3495365371562067</c:v>
                </c:pt>
                <c:pt idx="7443">
                  <c:v>2.349428635224696</c:v>
                </c:pt>
                <c:pt idx="7444">
                  <c:v>2.3487482358972178</c:v>
                </c:pt>
                <c:pt idx="7445">
                  <c:v>2.3484454936962638</c:v>
                </c:pt>
                <c:pt idx="7446">
                  <c:v>2.3483805929018362</c:v>
                </c:pt>
                <c:pt idx="7447">
                  <c:v>2.3476985483558797</c:v>
                </c:pt>
                <c:pt idx="7448">
                  <c:v>2.3475685135781519</c:v>
                </c:pt>
                <c:pt idx="7449">
                  <c:v>2.3475685135781519</c:v>
                </c:pt>
                <c:pt idx="7450">
                  <c:v>2.3475359987992914</c:v>
                </c:pt>
                <c:pt idx="7451">
                  <c:v>2.3468960462756909</c:v>
                </c:pt>
                <c:pt idx="7452">
                  <c:v>2.3466463175768895</c:v>
                </c:pt>
                <c:pt idx="7453">
                  <c:v>2.3454281909619317</c:v>
                </c:pt>
                <c:pt idx="7454">
                  <c:v>2.3453083690596945</c:v>
                </c:pt>
                <c:pt idx="7455">
                  <c:v>2.3452212050891252</c:v>
                </c:pt>
                <c:pt idx="7456">
                  <c:v>2.3451122255191819</c:v>
                </c:pt>
                <c:pt idx="7457">
                  <c:v>2.34499231639828</c:v>
                </c:pt>
                <c:pt idx="7458">
                  <c:v>2.3442066380841209</c:v>
                </c:pt>
                <c:pt idx="7459">
                  <c:v>2.3436820617821037</c:v>
                </c:pt>
                <c:pt idx="7460">
                  <c:v>2.3431787475524466</c:v>
                </c:pt>
                <c:pt idx="7461">
                  <c:v>2.3429378256994311</c:v>
                </c:pt>
                <c:pt idx="7462">
                  <c:v>2.3427734841384558</c:v>
                </c:pt>
                <c:pt idx="7463">
                  <c:v>2.3421813390644517</c:v>
                </c:pt>
                <c:pt idx="7464">
                  <c:v>2.3411156391217958</c:v>
                </c:pt>
                <c:pt idx="7465">
                  <c:v>2.3401906473555067</c:v>
                </c:pt>
                <c:pt idx="7466">
                  <c:v>2.3397163761823725</c:v>
                </c:pt>
                <c:pt idx="7467">
                  <c:v>2.3395176901787988</c:v>
                </c:pt>
                <c:pt idx="7468">
                  <c:v>2.3395176901787988</c:v>
                </c:pt>
                <c:pt idx="7469">
                  <c:v>2.3392305387167833</c:v>
                </c:pt>
                <c:pt idx="7470">
                  <c:v>2.3391752955084275</c:v>
                </c:pt>
                <c:pt idx="7471">
                  <c:v>2.3391642460234592</c:v>
                </c:pt>
                <c:pt idx="7472">
                  <c:v>2.3386446028650298</c:v>
                </c:pt>
                <c:pt idx="7473">
                  <c:v>2.336926466275937</c:v>
                </c:pt>
                <c:pt idx="7474">
                  <c:v>2.3367376111898306</c:v>
                </c:pt>
                <c:pt idx="7475">
                  <c:v>2.3363151673354929</c:v>
                </c:pt>
                <c:pt idx="7476">
                  <c:v>2.3356807300846798</c:v>
                </c:pt>
                <c:pt idx="7477">
                  <c:v>2.3353687369089751</c:v>
                </c:pt>
                <c:pt idx="7478">
                  <c:v>2.3353464431032718</c:v>
                </c:pt>
                <c:pt idx="7479">
                  <c:v>2.335279554818841</c:v>
                </c:pt>
                <c:pt idx="7480">
                  <c:v>2.3349561161368517</c:v>
                </c:pt>
                <c:pt idx="7481">
                  <c:v>2.3349561161368517</c:v>
                </c:pt>
                <c:pt idx="7482">
                  <c:v>2.3344984293549622</c:v>
                </c:pt>
                <c:pt idx="7483">
                  <c:v>2.3344314103251897</c:v>
                </c:pt>
                <c:pt idx="7484">
                  <c:v>2.3343308623849581</c:v>
                </c:pt>
                <c:pt idx="7485">
                  <c:v>2.3340849804852954</c:v>
                </c:pt>
                <c:pt idx="7486">
                  <c:v>2.3333017015516164</c:v>
                </c:pt>
                <c:pt idx="7487">
                  <c:v>2.3326067584962442</c:v>
                </c:pt>
                <c:pt idx="7488">
                  <c:v>2.3313147995684491</c:v>
                </c:pt>
                <c:pt idx="7489">
                  <c:v>2.3306504737383822</c:v>
                </c:pt>
                <c:pt idx="7490">
                  <c:v>2.3302333435659959</c:v>
                </c:pt>
                <c:pt idx="7491">
                  <c:v>2.3291152643436486</c:v>
                </c:pt>
                <c:pt idx="7492">
                  <c:v>2.3283342912698926</c:v>
                </c:pt>
                <c:pt idx="7493">
                  <c:v>2.3280849897992013</c:v>
                </c:pt>
                <c:pt idx="7494">
                  <c:v>2.3279942992257778</c:v>
                </c:pt>
                <c:pt idx="7495">
                  <c:v>2.3265861682004068</c:v>
                </c:pt>
                <c:pt idx="7496">
                  <c:v>2.3262561874424033</c:v>
                </c:pt>
                <c:pt idx="7497">
                  <c:v>2.3257094608593714</c:v>
                </c:pt>
                <c:pt idx="7498">
                  <c:v>2.3247967176217301</c:v>
                </c:pt>
                <c:pt idx="7499">
                  <c:v>2.3236988875544817</c:v>
                </c:pt>
                <c:pt idx="7500">
                  <c:v>2.3233323266322139</c:v>
                </c:pt>
                <c:pt idx="7501">
                  <c:v>2.3230113318311978</c:v>
                </c:pt>
                <c:pt idx="7502">
                  <c:v>2.3223915996288209</c:v>
                </c:pt>
                <c:pt idx="7503">
                  <c:v>2.3212185760061947</c:v>
                </c:pt>
                <c:pt idx="7504">
                  <c:v>2.3211840273023143</c:v>
                </c:pt>
                <c:pt idx="7505">
                  <c:v>2.3195918085612339</c:v>
                </c:pt>
                <c:pt idx="7506">
                  <c:v>2.3190944872269634</c:v>
                </c:pt>
                <c:pt idx="7507">
                  <c:v>2.3190597691283314</c:v>
                </c:pt>
                <c:pt idx="7508">
                  <c:v>2.3187471812838103</c:v>
                </c:pt>
                <c:pt idx="7509">
                  <c:v>2.3182257010486285</c:v>
                </c:pt>
                <c:pt idx="7510">
                  <c:v>2.318109731467469</c:v>
                </c:pt>
                <c:pt idx="7511">
                  <c:v>2.317761636804117</c:v>
                </c:pt>
                <c:pt idx="7512">
                  <c:v>2.3175758721723363</c:v>
                </c:pt>
                <c:pt idx="7513">
                  <c:v>2.3169366995410834</c:v>
                </c:pt>
                <c:pt idx="7514">
                  <c:v>2.3160402745258883</c:v>
                </c:pt>
                <c:pt idx="7515">
                  <c:v>2.3151770280717248</c:v>
                </c:pt>
                <c:pt idx="7516">
                  <c:v>2.3146512406903303</c:v>
                </c:pt>
                <c:pt idx="7517">
                  <c:v>2.3126944017198481</c:v>
                </c:pt>
                <c:pt idx="7518">
                  <c:v>2.3126121856804067</c:v>
                </c:pt>
                <c:pt idx="7519">
                  <c:v>2.3125417023994457</c:v>
                </c:pt>
                <c:pt idx="7520">
                  <c:v>2.3116361501234972</c:v>
                </c:pt>
                <c:pt idx="7521">
                  <c:v>2.3115772826910921</c:v>
                </c:pt>
                <c:pt idx="7522">
                  <c:v>2.3115419584011949</c:v>
                </c:pt>
                <c:pt idx="7523">
                  <c:v>2.3111296292496153</c:v>
                </c:pt>
                <c:pt idx="7524">
                  <c:v>2.3093225515215323</c:v>
                </c:pt>
                <c:pt idx="7525">
                  <c:v>2.3091686618227572</c:v>
                </c:pt>
                <c:pt idx="7526">
                  <c:v>2.3091094589542407</c:v>
                </c:pt>
                <c:pt idx="7527">
                  <c:v>2.3089554937154491</c:v>
                </c:pt>
                <c:pt idx="7528">
                  <c:v>2.3089436479743801</c:v>
                </c:pt>
                <c:pt idx="7529">
                  <c:v>2.3087185174828466</c:v>
                </c:pt>
                <c:pt idx="7530">
                  <c:v>2.3080780350087013</c:v>
                </c:pt>
                <c:pt idx="7531">
                  <c:v>2.3079593234176761</c:v>
                </c:pt>
                <c:pt idx="7532">
                  <c:v>2.3071155367547993</c:v>
                </c:pt>
                <c:pt idx="7533">
                  <c:v>2.3067585138958719</c:v>
                </c:pt>
                <c:pt idx="7534">
                  <c:v>2.3059720289558476</c:v>
                </c:pt>
                <c:pt idx="7535">
                  <c:v>2.3049331178667529</c:v>
                </c:pt>
                <c:pt idx="7536">
                  <c:v>2.3043947732847516</c:v>
                </c:pt>
                <c:pt idx="7537">
                  <c:v>2.3042989976791359</c:v>
                </c:pt>
                <c:pt idx="7538">
                  <c:v>2.3042151766944592</c:v>
                </c:pt>
                <c:pt idx="7539">
                  <c:v>2.3037958289312308</c:v>
                </c:pt>
                <c:pt idx="7540">
                  <c:v>2.3033040774389297</c:v>
                </c:pt>
                <c:pt idx="7541">
                  <c:v>2.3028598232198392</c:v>
                </c:pt>
                <c:pt idx="7542">
                  <c:v>2.3018856773720255</c:v>
                </c:pt>
                <c:pt idx="7543">
                  <c:v>2.3015604759143735</c:v>
                </c:pt>
                <c:pt idx="7544">
                  <c:v>2.3013073729857623</c:v>
                </c:pt>
                <c:pt idx="7545">
                  <c:v>2.3008972742943796</c:v>
                </c:pt>
                <c:pt idx="7546">
                  <c:v>2.3006075595334989</c:v>
                </c:pt>
                <c:pt idx="7547">
                  <c:v>2.3003780648707024</c:v>
                </c:pt>
                <c:pt idx="7548">
                  <c:v>2.2998945214461433</c:v>
                </c:pt>
                <c:pt idx="7549">
                  <c:v>2.2998824259598827</c:v>
                </c:pt>
                <c:pt idx="7550">
                  <c:v>2.2997735514217119</c:v>
                </c:pt>
                <c:pt idx="7551">
                  <c:v>2.2987681976140957</c:v>
                </c:pt>
                <c:pt idx="7552">
                  <c:v>2.2973227142053028</c:v>
                </c:pt>
                <c:pt idx="7553">
                  <c:v>2.2973105468784243</c:v>
                </c:pt>
                <c:pt idx="7554">
                  <c:v>2.295872403653016</c:v>
                </c:pt>
                <c:pt idx="7555">
                  <c:v>2.2955670999624789</c:v>
                </c:pt>
                <c:pt idx="7556">
                  <c:v>2.2951026269140042</c:v>
                </c:pt>
                <c:pt idx="7557">
                  <c:v>2.2950047797846271</c:v>
                </c:pt>
                <c:pt idx="7558">
                  <c:v>2.2948946754068733</c:v>
                </c:pt>
                <c:pt idx="7559">
                  <c:v>2.2948457311663342</c:v>
                </c:pt>
                <c:pt idx="7560">
                  <c:v>2.2945152131879718</c:v>
                </c:pt>
                <c:pt idx="7561">
                  <c:v>2.2935589680708466</c:v>
                </c:pt>
                <c:pt idx="7562">
                  <c:v>2.2932151863754866</c:v>
                </c:pt>
                <c:pt idx="7563">
                  <c:v>2.2926252124597912</c:v>
                </c:pt>
                <c:pt idx="7564">
                  <c:v>2.292576011770727</c:v>
                </c:pt>
                <c:pt idx="7565">
                  <c:v>2.2924529856567903</c:v>
                </c:pt>
                <c:pt idx="7566">
                  <c:v>2.2921945173230793</c:v>
                </c:pt>
                <c:pt idx="7567">
                  <c:v>2.2916894448992773</c:v>
                </c:pt>
                <c:pt idx="7568">
                  <c:v>2.2915784966780879</c:v>
                </c:pt>
                <c:pt idx="7569">
                  <c:v>2.29034382780983</c:v>
                </c:pt>
                <c:pt idx="7570">
                  <c:v>2.2902325352496868</c:v>
                </c:pt>
                <c:pt idx="7571">
                  <c:v>2.2902077996961046</c:v>
                </c:pt>
                <c:pt idx="7572">
                  <c:v>2.2899851162935825</c:v>
                </c:pt>
                <c:pt idx="7573">
                  <c:v>2.2898861092301415</c:v>
                </c:pt>
                <c:pt idx="7574">
                  <c:v>2.2896880273649503</c:v>
                </c:pt>
                <c:pt idx="7575">
                  <c:v>2.2896261082496734</c:v>
                </c:pt>
                <c:pt idx="7576">
                  <c:v>2.2891552342503294</c:v>
                </c:pt>
                <c:pt idx="7577">
                  <c:v>2.2886962605902559</c:v>
                </c:pt>
                <c:pt idx="7578">
                  <c:v>2.2884479646130487</c:v>
                </c:pt>
                <c:pt idx="7579">
                  <c:v>2.2875778090787056</c:v>
                </c:pt>
                <c:pt idx="7580">
                  <c:v>2.2857197952533124</c:v>
                </c:pt>
                <c:pt idx="7581">
                  <c:v>2.2849693510118039</c:v>
                </c:pt>
                <c:pt idx="7582">
                  <c:v>2.2849067554189681</c:v>
                </c:pt>
                <c:pt idx="7583">
                  <c:v>2.2839416422465253</c:v>
                </c:pt>
                <c:pt idx="7584">
                  <c:v>2.2831001198868495</c:v>
                </c:pt>
                <c:pt idx="7585">
                  <c:v>2.2826472842625369</c:v>
                </c:pt>
                <c:pt idx="7586">
                  <c:v>2.2823451313176704</c:v>
                </c:pt>
                <c:pt idx="7587">
                  <c:v>2.2816392891903172</c:v>
                </c:pt>
                <c:pt idx="7588">
                  <c:v>2.2811344129629121</c:v>
                </c:pt>
                <c:pt idx="7589">
                  <c:v>2.279350028666463</c:v>
                </c:pt>
                <c:pt idx="7590">
                  <c:v>2.2791851412281208</c:v>
                </c:pt>
                <c:pt idx="7591">
                  <c:v>2.2787916952892338</c:v>
                </c:pt>
                <c:pt idx="7592">
                  <c:v>2.2787536009528289</c:v>
                </c:pt>
                <c:pt idx="7593">
                  <c:v>2.277685600634761</c:v>
                </c:pt>
                <c:pt idx="7594">
                  <c:v>2.2771761044689782</c:v>
                </c:pt>
                <c:pt idx="7595">
                  <c:v>2.2765256287720663</c:v>
                </c:pt>
                <c:pt idx="7596">
                  <c:v>2.2761297649730938</c:v>
                </c:pt>
                <c:pt idx="7597">
                  <c:v>2.2754777190264752</c:v>
                </c:pt>
                <c:pt idx="7598">
                  <c:v>2.2749271930997761</c:v>
                </c:pt>
                <c:pt idx="7599">
                  <c:v>2.2742605072199322</c:v>
                </c:pt>
                <c:pt idx="7600">
                  <c:v>2.273939620502091</c:v>
                </c:pt>
                <c:pt idx="7601">
                  <c:v>2.2738497297176563</c:v>
                </c:pt>
                <c:pt idx="7602">
                  <c:v>2.2732842754978768</c:v>
                </c:pt>
                <c:pt idx="7603">
                  <c:v>2.2704459080179626</c:v>
                </c:pt>
                <c:pt idx="7604">
                  <c:v>2.2704329639027385</c:v>
                </c:pt>
                <c:pt idx="7605">
                  <c:v>2.2700055915232684</c:v>
                </c:pt>
                <c:pt idx="7606">
                  <c:v>2.269927842249857</c:v>
                </c:pt>
                <c:pt idx="7607">
                  <c:v>2.269629674357553</c:v>
                </c:pt>
                <c:pt idx="7608">
                  <c:v>2.2694480805807404</c:v>
                </c:pt>
                <c:pt idx="7609">
                  <c:v>2.2690067507446652</c:v>
                </c:pt>
                <c:pt idx="7610">
                  <c:v>2.2688898530322632</c:v>
                </c:pt>
                <c:pt idx="7611">
                  <c:v>2.2683699266180728</c:v>
                </c:pt>
                <c:pt idx="7612">
                  <c:v>2.2679925903655827</c:v>
                </c:pt>
                <c:pt idx="7613">
                  <c:v>2.2674846206945762</c:v>
                </c:pt>
                <c:pt idx="7614">
                  <c:v>2.2674455214839351</c:v>
                </c:pt>
                <c:pt idx="7615">
                  <c:v>2.2672760508829541</c:v>
                </c:pt>
                <c:pt idx="7616">
                  <c:v>2.2669499598929499</c:v>
                </c:pt>
                <c:pt idx="7617">
                  <c:v>2.2658263333502942</c:v>
                </c:pt>
                <c:pt idx="7618">
                  <c:v>2.2655515172526552</c:v>
                </c:pt>
                <c:pt idx="7619">
                  <c:v>2.2655122436103516</c:v>
                </c:pt>
                <c:pt idx="7620">
                  <c:v>2.2654467796464797</c:v>
                </c:pt>
                <c:pt idx="7621">
                  <c:v>2.2653682098621126</c:v>
                </c:pt>
                <c:pt idx="7622">
                  <c:v>2.2646342056134317</c:v>
                </c:pt>
                <c:pt idx="7623">
                  <c:v>2.2644898803209164</c:v>
                </c:pt>
                <c:pt idx="7624">
                  <c:v>2.2642142169611503</c:v>
                </c:pt>
                <c:pt idx="7625">
                  <c:v>2.2637938217616203</c:v>
                </c:pt>
                <c:pt idx="7626">
                  <c:v>2.263057149537171</c:v>
                </c:pt>
                <c:pt idx="7627">
                  <c:v>2.262727874132143</c:v>
                </c:pt>
                <c:pt idx="7628">
                  <c:v>2.2625301889897145</c:v>
                </c:pt>
                <c:pt idx="7629">
                  <c:v>2.2624379051197967</c:v>
                </c:pt>
                <c:pt idx="7630">
                  <c:v>2.2620817692473425</c:v>
                </c:pt>
                <c:pt idx="7631">
                  <c:v>2.2617385473525378</c:v>
                </c:pt>
                <c:pt idx="7632">
                  <c:v>2.2617121344298048</c:v>
                </c:pt>
                <c:pt idx="7633">
                  <c:v>2.2615271989783183</c:v>
                </c:pt>
                <c:pt idx="7634">
                  <c:v>2.2614743458101985</c:v>
                </c:pt>
                <c:pt idx="7635">
                  <c:v>2.2613818372857462</c:v>
                </c:pt>
                <c:pt idx="7636">
                  <c:v>2.2613421847422899</c:v>
                </c:pt>
                <c:pt idx="7637">
                  <c:v>2.2599918395862986</c:v>
                </c:pt>
                <c:pt idx="7638">
                  <c:v>2.2598061699726166</c:v>
                </c:pt>
                <c:pt idx="7639">
                  <c:v>2.2590494088417565</c:v>
                </c:pt>
                <c:pt idx="7640">
                  <c:v>2.2586638833109776</c:v>
                </c:pt>
                <c:pt idx="7641">
                  <c:v>2.2581981376481943</c:v>
                </c:pt>
                <c:pt idx="7642">
                  <c:v>2.2581581933407944</c:v>
                </c:pt>
                <c:pt idx="7643">
                  <c:v>2.2580116994401722</c:v>
                </c:pt>
                <c:pt idx="7644">
                  <c:v>2.2578784802728999</c:v>
                </c:pt>
                <c:pt idx="7645">
                  <c:v>2.2572918299763534</c:v>
                </c:pt>
                <c:pt idx="7646">
                  <c:v>2.2565039394590007</c:v>
                </c:pt>
                <c:pt idx="7647">
                  <c:v>2.2561429021054686</c:v>
                </c:pt>
                <c:pt idx="7648">
                  <c:v>2.2555940856303307</c:v>
                </c:pt>
                <c:pt idx="7649">
                  <c:v>2.2542928981194863</c:v>
                </c:pt>
                <c:pt idx="7650">
                  <c:v>2.2541450943558292</c:v>
                </c:pt>
                <c:pt idx="7651">
                  <c:v>2.2528799882116393</c:v>
                </c:pt>
                <c:pt idx="7652">
                  <c:v>2.252731702726023</c:v>
                </c:pt>
                <c:pt idx="7653">
                  <c:v>2.2527182197163853</c:v>
                </c:pt>
                <c:pt idx="7654">
                  <c:v>2.2523945018442109</c:v>
                </c:pt>
                <c:pt idx="7655">
                  <c:v>2.2521380539584581</c:v>
                </c:pt>
                <c:pt idx="7656">
                  <c:v>2.2512325273015659</c:v>
                </c:pt>
                <c:pt idx="7657">
                  <c:v>2.2509347779489493</c:v>
                </c:pt>
                <c:pt idx="7658">
                  <c:v>2.250745194747827</c:v>
                </c:pt>
                <c:pt idx="7659">
                  <c:v>2.2505148752592712</c:v>
                </c:pt>
                <c:pt idx="7660">
                  <c:v>2.2503386661382465</c:v>
                </c:pt>
                <c:pt idx="7661">
                  <c:v>2.2495380480473854</c:v>
                </c:pt>
                <c:pt idx="7662">
                  <c:v>2.2490624066991582</c:v>
                </c:pt>
                <c:pt idx="7663">
                  <c:v>2.2487903775753857</c:v>
                </c:pt>
                <c:pt idx="7664">
                  <c:v>2.2487359512977405</c:v>
                </c:pt>
                <c:pt idx="7665">
                  <c:v>2.2485454055945162</c:v>
                </c:pt>
                <c:pt idx="7666">
                  <c:v>2.2483820141396529</c:v>
                </c:pt>
                <c:pt idx="7667">
                  <c:v>2.2467173689525204</c:v>
                </c:pt>
                <c:pt idx="7668">
                  <c:v>2.2464165068123942</c:v>
                </c:pt>
                <c:pt idx="7669">
                  <c:v>2.2463070507014495</c:v>
                </c:pt>
                <c:pt idx="7670">
                  <c:v>2.2462933667477056</c:v>
                </c:pt>
                <c:pt idx="7671">
                  <c:v>2.2460332896725261</c:v>
                </c:pt>
                <c:pt idx="7672">
                  <c:v>2.2458004570397443</c:v>
                </c:pt>
                <c:pt idx="7673">
                  <c:v>2.2456086187471493</c:v>
                </c:pt>
                <c:pt idx="7674">
                  <c:v>2.2452932717590151</c:v>
                </c:pt>
                <c:pt idx="7675">
                  <c:v>2.2442908684310967</c:v>
                </c:pt>
                <c:pt idx="7676">
                  <c:v>2.2441121152976149</c:v>
                </c:pt>
                <c:pt idx="7677">
                  <c:v>2.2440708541240624</c:v>
                </c:pt>
                <c:pt idx="7678">
                  <c:v>2.2438369667317066</c:v>
                </c:pt>
                <c:pt idx="7679">
                  <c:v>2.2437130929819284</c:v>
                </c:pt>
                <c:pt idx="7680">
                  <c:v>2.2436717938790931</c:v>
                </c:pt>
                <c:pt idx="7681">
                  <c:v>2.2434790127875406</c:v>
                </c:pt>
                <c:pt idx="7682">
                  <c:v>2.2432723666122971</c:v>
                </c:pt>
                <c:pt idx="7683">
                  <c:v>2.2429966853373511</c:v>
                </c:pt>
                <c:pt idx="7684">
                  <c:v>2.2428725716479416</c:v>
                </c:pt>
                <c:pt idx="7685">
                  <c:v>2.2428449860105641</c:v>
                </c:pt>
                <c:pt idx="7686">
                  <c:v>2.2415326458170082</c:v>
                </c:pt>
                <c:pt idx="7687">
                  <c:v>2.2411450929502506</c:v>
                </c:pt>
                <c:pt idx="7688">
                  <c:v>2.2411035489090949</c:v>
                </c:pt>
                <c:pt idx="7689">
                  <c:v>2.2405908453787382</c:v>
                </c:pt>
                <c:pt idx="7690">
                  <c:v>2.2400636542102341</c:v>
                </c:pt>
                <c:pt idx="7691">
                  <c:v>2.2394385201019564</c:v>
                </c:pt>
                <c:pt idx="7692">
                  <c:v>2.2393133852277214</c:v>
                </c:pt>
                <c:pt idx="7693">
                  <c:v>2.2391603936230928</c:v>
                </c:pt>
                <c:pt idx="7694">
                  <c:v>2.2389377641260202</c:v>
                </c:pt>
                <c:pt idx="7695">
                  <c:v>2.2379066155792091</c:v>
                </c:pt>
                <c:pt idx="7696">
                  <c:v>2.2377252147616011</c:v>
                </c:pt>
                <c:pt idx="7697">
                  <c:v>2.2372643951848272</c:v>
                </c:pt>
                <c:pt idx="7698">
                  <c:v>2.2372085050255706</c:v>
                </c:pt>
                <c:pt idx="7699">
                  <c:v>2.2370128328069403</c:v>
                </c:pt>
                <c:pt idx="7700">
                  <c:v>2.2363272849425626</c:v>
                </c:pt>
                <c:pt idx="7701">
                  <c:v>2.2362012502673654</c:v>
                </c:pt>
                <c:pt idx="7702">
                  <c:v>2.2361732375939654</c:v>
                </c:pt>
                <c:pt idx="7703">
                  <c:v>2.2359630849299443</c:v>
                </c:pt>
                <c:pt idx="7704">
                  <c:v>2.2349810256623597</c:v>
                </c:pt>
                <c:pt idx="7705">
                  <c:v>2.2349529341693422</c:v>
                </c:pt>
                <c:pt idx="7706">
                  <c:v>2.2330243287399694</c:v>
                </c:pt>
                <c:pt idx="7707">
                  <c:v>2.2329678902107277</c:v>
                </c:pt>
                <c:pt idx="7708">
                  <c:v>2.2319648838865578</c:v>
                </c:pt>
                <c:pt idx="7709">
                  <c:v>2.2306333863889618</c:v>
                </c:pt>
                <c:pt idx="7710">
                  <c:v>2.2299376859079336</c:v>
                </c:pt>
                <c:pt idx="7711">
                  <c:v>2.2290700496327807</c:v>
                </c:pt>
                <c:pt idx="7712">
                  <c:v>2.2287709536426044</c:v>
                </c:pt>
                <c:pt idx="7713">
                  <c:v>2.2284431358004935</c:v>
                </c:pt>
                <c:pt idx="7714">
                  <c:v>2.2280151751017878</c:v>
                </c:pt>
                <c:pt idx="7715">
                  <c:v>2.2271436856438926</c:v>
                </c:pt>
                <c:pt idx="7716">
                  <c:v>2.2264280435185682</c:v>
                </c:pt>
                <c:pt idx="7717">
                  <c:v>2.2260697797491766</c:v>
                </c:pt>
                <c:pt idx="7718">
                  <c:v>2.2257686096183926</c:v>
                </c:pt>
                <c:pt idx="7719">
                  <c:v>2.225409801222181</c:v>
                </c:pt>
                <c:pt idx="7720">
                  <c:v>2.2250794354744521</c:v>
                </c:pt>
                <c:pt idx="7721">
                  <c:v>2.2248925957838153</c:v>
                </c:pt>
                <c:pt idx="7722">
                  <c:v>2.2244611202397437</c:v>
                </c:pt>
                <c:pt idx="7723">
                  <c:v>2.2242308245491169</c:v>
                </c:pt>
                <c:pt idx="7724">
                  <c:v>2.2241732315401275</c:v>
                </c:pt>
                <c:pt idx="7725">
                  <c:v>2.2238995603984191</c:v>
                </c:pt>
                <c:pt idx="7726">
                  <c:v>2.223726626570051</c:v>
                </c:pt>
                <c:pt idx="7727">
                  <c:v>2.2211098207294566</c:v>
                </c:pt>
                <c:pt idx="7728">
                  <c:v>2.220631019448092</c:v>
                </c:pt>
                <c:pt idx="7729">
                  <c:v>2.2200790178247156</c:v>
                </c:pt>
                <c:pt idx="7730">
                  <c:v>2.2198754718149418</c:v>
                </c:pt>
                <c:pt idx="7731">
                  <c:v>2.2197009278450515</c:v>
                </c:pt>
                <c:pt idx="7732">
                  <c:v>2.2196718303620817</c:v>
                </c:pt>
                <c:pt idx="7733">
                  <c:v>2.2196281804819602</c:v>
                </c:pt>
                <c:pt idx="7734">
                  <c:v>2.2194535370768107</c:v>
                </c:pt>
                <c:pt idx="7735">
                  <c:v>2.2192496976354046</c:v>
                </c:pt>
                <c:pt idx="7736">
                  <c:v>2.2191331749846999</c:v>
                </c:pt>
                <c:pt idx="7737">
                  <c:v>2.2190603324488616</c:v>
                </c:pt>
                <c:pt idx="7738">
                  <c:v>2.2183750147539172</c:v>
                </c:pt>
                <c:pt idx="7739">
                  <c:v>2.2180392520156755</c:v>
                </c:pt>
                <c:pt idx="7740">
                  <c:v>2.2178931872102416</c:v>
                </c:pt>
                <c:pt idx="7741">
                  <c:v>2.2168254232660476</c:v>
                </c:pt>
                <c:pt idx="7742">
                  <c:v>2.2149174011822463</c:v>
                </c:pt>
                <c:pt idx="7743">
                  <c:v>2.214726137115441</c:v>
                </c:pt>
                <c:pt idx="7744">
                  <c:v>2.2140781560795406</c:v>
                </c:pt>
                <c:pt idx="7745">
                  <c:v>2.2133111117575002</c:v>
                </c:pt>
                <c:pt idx="7746">
                  <c:v>2.2128088492985558</c:v>
                </c:pt>
                <c:pt idx="7747">
                  <c:v>2.2120691712202669</c:v>
                </c:pt>
                <c:pt idx="7748">
                  <c:v>2.2120099425148352</c:v>
                </c:pt>
                <c:pt idx="7749">
                  <c:v>2.2118618354022916</c:v>
                </c:pt>
                <c:pt idx="7750">
                  <c:v>2.211372723260673</c:v>
                </c:pt>
                <c:pt idx="7751">
                  <c:v>2.2111057024613654</c:v>
                </c:pt>
                <c:pt idx="7752">
                  <c:v>2.2099169530089915</c:v>
                </c:pt>
                <c:pt idx="7753">
                  <c:v>2.2092170423306654</c:v>
                </c:pt>
                <c:pt idx="7754">
                  <c:v>2.208948692431143</c:v>
                </c:pt>
                <c:pt idx="7755">
                  <c:v>2.2088293725644941</c:v>
                </c:pt>
                <c:pt idx="7756">
                  <c:v>2.2087697003355049</c:v>
                </c:pt>
                <c:pt idx="7757">
                  <c:v>2.2084861452265101</c:v>
                </c:pt>
                <c:pt idx="7758">
                  <c:v>2.2067059714253721</c:v>
                </c:pt>
                <c:pt idx="7759">
                  <c:v>2.2064060649968371</c:v>
                </c:pt>
                <c:pt idx="7760">
                  <c:v>2.2056253376532418</c:v>
                </c:pt>
                <c:pt idx="7761">
                  <c:v>2.2054750367408911</c:v>
                </c:pt>
                <c:pt idx="7762">
                  <c:v>2.2053697951440134</c:v>
                </c:pt>
                <c:pt idx="7763">
                  <c:v>2.2049485735413756</c:v>
                </c:pt>
                <c:pt idx="7764">
                  <c:v>2.2046625117482188</c:v>
                </c:pt>
                <c:pt idx="7765">
                  <c:v>2.2027153041984353</c:v>
                </c:pt>
                <c:pt idx="7766">
                  <c:v>2.2022763553077023</c:v>
                </c:pt>
                <c:pt idx="7767">
                  <c:v>2.2022157758011316</c:v>
                </c:pt>
                <c:pt idx="7768">
                  <c:v>2.2018066429570218</c:v>
                </c:pt>
                <c:pt idx="7769">
                  <c:v>2.2006681363491984</c:v>
                </c:pt>
                <c:pt idx="7770">
                  <c:v>2.1996485402368449</c:v>
                </c:pt>
                <c:pt idx="7771">
                  <c:v>2.1983362869215464</c:v>
                </c:pt>
                <c:pt idx="7772">
                  <c:v>2.1981987286196296</c:v>
                </c:pt>
                <c:pt idx="7773">
                  <c:v>2.1979387773349166</c:v>
                </c:pt>
                <c:pt idx="7774">
                  <c:v>2.1972192776850061</c:v>
                </c:pt>
                <c:pt idx="7775">
                  <c:v>2.1967133838456032</c:v>
                </c:pt>
                <c:pt idx="7776">
                  <c:v>2.1959918495185713</c:v>
                </c:pt>
                <c:pt idx="7777">
                  <c:v>2.1958381767941684</c:v>
                </c:pt>
                <c:pt idx="7778">
                  <c:v>2.194914996792531</c:v>
                </c:pt>
                <c:pt idx="7779">
                  <c:v>2.1947763503788842</c:v>
                </c:pt>
                <c:pt idx="7780">
                  <c:v>2.1945605901634231</c:v>
                </c:pt>
                <c:pt idx="7781">
                  <c:v>2.194252175221723</c:v>
                </c:pt>
                <c:pt idx="7782">
                  <c:v>2.1934029030624176</c:v>
                </c:pt>
                <c:pt idx="7783">
                  <c:v>2.1932173864077797</c:v>
                </c:pt>
                <c:pt idx="7784">
                  <c:v>2.1911093071191359</c:v>
                </c:pt>
                <c:pt idx="7785">
                  <c:v>2.1892094895823062</c:v>
                </c:pt>
                <c:pt idx="7786">
                  <c:v>2.1884441026662258</c:v>
                </c:pt>
                <c:pt idx="7787">
                  <c:v>2.1879591807241887</c:v>
                </c:pt>
                <c:pt idx="7788">
                  <c:v>2.1870190811827652</c:v>
                </c:pt>
                <c:pt idx="7789">
                  <c:v>2.1870033956032819</c:v>
                </c:pt>
                <c:pt idx="7790">
                  <c:v>2.1869877094572554</c:v>
                </c:pt>
                <c:pt idx="7791">
                  <c:v>2.1866424708265413</c:v>
                </c:pt>
                <c:pt idx="7792">
                  <c:v>2.1866424708265413</c:v>
                </c:pt>
                <c:pt idx="7793">
                  <c:v>2.1858725424563898</c:v>
                </c:pt>
                <c:pt idx="7794">
                  <c:v>2.1852587652965849</c:v>
                </c:pt>
                <c:pt idx="7795">
                  <c:v>2.1848175692099763</c:v>
                </c:pt>
                <c:pt idx="7796">
                  <c:v>2.1838390370564214</c:v>
                </c:pt>
                <c:pt idx="7797">
                  <c:v>2.1826523745281263</c:v>
                </c:pt>
                <c:pt idx="7798">
                  <c:v>2.1823670923970644</c:v>
                </c:pt>
                <c:pt idx="7799">
                  <c:v>2.1816371855329786</c:v>
                </c:pt>
                <c:pt idx="7800">
                  <c:v>2.181414796254284</c:v>
                </c:pt>
                <c:pt idx="7801">
                  <c:v>2.1808424146466825</c:v>
                </c:pt>
                <c:pt idx="7802">
                  <c:v>2.1804922541570733</c:v>
                </c:pt>
                <c:pt idx="7803">
                  <c:v>2.1803807802231123</c:v>
                </c:pt>
                <c:pt idx="7804">
                  <c:v>2.1792005881097731</c:v>
                </c:pt>
                <c:pt idx="7805">
                  <c:v>2.1787212166914021</c:v>
                </c:pt>
                <c:pt idx="7806">
                  <c:v>2.1786892397755899</c:v>
                </c:pt>
                <c:pt idx="7807">
                  <c:v>2.176589607426664</c:v>
                </c:pt>
                <c:pt idx="7808">
                  <c:v>2.1763967662104391</c:v>
                </c:pt>
                <c:pt idx="7809">
                  <c:v>2.1763003134823475</c:v>
                </c:pt>
                <c:pt idx="7810">
                  <c:v>2.1752862644194515</c:v>
                </c:pt>
                <c:pt idx="7811">
                  <c:v>2.1747864173673368</c:v>
                </c:pt>
                <c:pt idx="7812">
                  <c:v>2.1745120632513641</c:v>
                </c:pt>
                <c:pt idx="7813">
                  <c:v>2.1739951613298625</c:v>
                </c:pt>
                <c:pt idx="7814">
                  <c:v>2.1738658396637827</c:v>
                </c:pt>
                <c:pt idx="7815">
                  <c:v>2.1730405075510624</c:v>
                </c:pt>
                <c:pt idx="7816">
                  <c:v>2.1730405075510624</c:v>
                </c:pt>
                <c:pt idx="7817">
                  <c:v>2.1722136039924793</c:v>
                </c:pt>
                <c:pt idx="7818">
                  <c:v>2.1719376192274824</c:v>
                </c:pt>
                <c:pt idx="7819">
                  <c:v>2.1716127065710955</c:v>
                </c:pt>
                <c:pt idx="7820">
                  <c:v>2.1710272505248041</c:v>
                </c:pt>
                <c:pt idx="7821">
                  <c:v>2.170620218983732</c:v>
                </c:pt>
                <c:pt idx="7822">
                  <c:v>2.1700171113434883</c:v>
                </c:pt>
                <c:pt idx="7823">
                  <c:v>2.1700171113434878</c:v>
                </c:pt>
                <c:pt idx="7824">
                  <c:v>2.1693314861732751</c:v>
                </c:pt>
                <c:pt idx="7825">
                  <c:v>2.1690373151424498</c:v>
                </c:pt>
                <c:pt idx="7826">
                  <c:v>2.1675142490484904</c:v>
                </c:pt>
                <c:pt idx="7827">
                  <c:v>2.1669560931453651</c:v>
                </c:pt>
                <c:pt idx="7828">
                  <c:v>2.1665945508154123</c:v>
                </c:pt>
                <c:pt idx="7829">
                  <c:v>2.1663149709063969</c:v>
                </c:pt>
                <c:pt idx="7830">
                  <c:v>2.1657223245406514</c:v>
                </c:pt>
                <c:pt idx="7831">
                  <c:v>2.1649968789749194</c:v>
                </c:pt>
                <c:pt idx="7832">
                  <c:v>2.1645015613095686</c:v>
                </c:pt>
                <c:pt idx="7833">
                  <c:v>2.1638898904815793</c:v>
                </c:pt>
                <c:pt idx="7834">
                  <c:v>2.1634429917622895</c:v>
                </c:pt>
                <c:pt idx="7835">
                  <c:v>2.1627800731341988</c:v>
                </c:pt>
                <c:pt idx="7836">
                  <c:v>2.162531217536575</c:v>
                </c:pt>
                <c:pt idx="7837">
                  <c:v>2.1620663052160913</c:v>
                </c:pt>
                <c:pt idx="7838">
                  <c:v>2.1619499993304632</c:v>
                </c:pt>
                <c:pt idx="7839">
                  <c:v>2.1618669046240195</c:v>
                </c:pt>
                <c:pt idx="7840">
                  <c:v>2.1612681529456736</c:v>
                </c:pt>
                <c:pt idx="7841">
                  <c:v>2.1609351560869245</c:v>
                </c:pt>
                <c:pt idx="7842">
                  <c:v>2.16070190627326</c:v>
                </c:pt>
                <c:pt idx="7843">
                  <c:v>2.1604018294629546</c:v>
                </c:pt>
                <c:pt idx="7844">
                  <c:v>2.1595504841371098</c:v>
                </c:pt>
                <c:pt idx="7845">
                  <c:v>2.1594502160555722</c:v>
                </c:pt>
                <c:pt idx="7846">
                  <c:v>2.1590489120742333</c:v>
                </c:pt>
                <c:pt idx="7847">
                  <c:v>2.1572384410829044</c:v>
                </c:pt>
                <c:pt idx="7848">
                  <c:v>2.1561114732246773</c:v>
                </c:pt>
                <c:pt idx="7849">
                  <c:v>2.155285417442637</c:v>
                </c:pt>
                <c:pt idx="7850">
                  <c:v>2.1547788924471458</c:v>
                </c:pt>
                <c:pt idx="7851">
                  <c:v>2.1546606182279886</c:v>
                </c:pt>
                <c:pt idx="7852">
                  <c:v>2.1544746936381385</c:v>
                </c:pt>
                <c:pt idx="7853">
                  <c:v>2.1499542923566328</c:v>
                </c:pt>
                <c:pt idx="7854">
                  <c:v>2.1499372092813269</c:v>
                </c:pt>
                <c:pt idx="7855">
                  <c:v>2.1496125031115074</c:v>
                </c:pt>
                <c:pt idx="7856">
                  <c:v>2.1481397365012196</c:v>
                </c:pt>
                <c:pt idx="7857">
                  <c:v>2.1472811752499448</c:v>
                </c:pt>
                <c:pt idx="7858">
                  <c:v>2.14630034057314</c:v>
                </c:pt>
                <c:pt idx="7859">
                  <c:v>2.1435005495055526</c:v>
                </c:pt>
                <c:pt idx="7860">
                  <c:v>2.1433618194350861</c:v>
                </c:pt>
                <c:pt idx="7861">
                  <c:v>2.1426501314420103</c:v>
                </c:pt>
                <c:pt idx="7862">
                  <c:v>2.1422677687391514</c:v>
                </c:pt>
                <c:pt idx="7863">
                  <c:v>2.1419198739138805</c:v>
                </c:pt>
                <c:pt idx="7864">
                  <c:v>2.141258104986719</c:v>
                </c:pt>
                <c:pt idx="7865">
                  <c:v>2.1411709550091214</c:v>
                </c:pt>
                <c:pt idx="7866">
                  <c:v>2.1407174929973407</c:v>
                </c:pt>
                <c:pt idx="7867">
                  <c:v>2.1403334242099241</c:v>
                </c:pt>
                <c:pt idx="7868">
                  <c:v>2.1398091460706397</c:v>
                </c:pt>
                <c:pt idx="7869">
                  <c:v>2.1395992574728031</c:v>
                </c:pt>
                <c:pt idx="7870">
                  <c:v>2.1382676022446572</c:v>
                </c:pt>
                <c:pt idx="7871">
                  <c:v>2.138162297459683</c:v>
                </c:pt>
                <c:pt idx="7872">
                  <c:v>2.1365620365899805</c:v>
                </c:pt>
                <c:pt idx="7873">
                  <c:v>2.1343719259761729</c:v>
                </c:pt>
                <c:pt idx="7874">
                  <c:v>2.1322418960461746</c:v>
                </c:pt>
                <c:pt idx="7875">
                  <c:v>2.132135119824877</c:v>
                </c:pt>
                <c:pt idx="7876">
                  <c:v>2.1314760857260775</c:v>
                </c:pt>
                <c:pt idx="7877">
                  <c:v>2.1313691210323213</c:v>
                </c:pt>
                <c:pt idx="7878">
                  <c:v>2.1311372737786072</c:v>
                </c:pt>
                <c:pt idx="7879">
                  <c:v>2.130940998613454</c:v>
                </c:pt>
                <c:pt idx="7880">
                  <c:v>2.1287043453276269</c:v>
                </c:pt>
                <c:pt idx="7881">
                  <c:v>2.1287043453276264</c:v>
                </c:pt>
                <c:pt idx="7882">
                  <c:v>2.1283813163592522</c:v>
                </c:pt>
                <c:pt idx="7883">
                  <c:v>2.1282556290664547</c:v>
                </c:pt>
                <c:pt idx="7884">
                  <c:v>2.1277165568611536</c:v>
                </c:pt>
                <c:pt idx="7885">
                  <c:v>2.127554704633059</c:v>
                </c:pt>
                <c:pt idx="7886">
                  <c:v>2.1275367173282085</c:v>
                </c:pt>
                <c:pt idx="7887">
                  <c:v>2.1261494528640439</c:v>
                </c:pt>
                <c:pt idx="7888">
                  <c:v>2.1249749263072419</c:v>
                </c:pt>
                <c:pt idx="7889">
                  <c:v>2.1238334996323891</c:v>
                </c:pt>
                <c:pt idx="7890">
                  <c:v>2.1225071311846753</c:v>
                </c:pt>
                <c:pt idx="7891">
                  <c:v>2.1221612466000828</c:v>
                </c:pt>
                <c:pt idx="7892">
                  <c:v>2.1219790913747372</c:v>
                </c:pt>
                <c:pt idx="7893">
                  <c:v>2.121286203902534</c:v>
                </c:pt>
                <c:pt idx="7894">
                  <c:v>2.1209393451793668</c:v>
                </c:pt>
                <c:pt idx="7895">
                  <c:v>2.1203728223891498</c:v>
                </c:pt>
                <c:pt idx="7896">
                  <c:v>2.1202996688147309</c:v>
                </c:pt>
                <c:pt idx="7897">
                  <c:v>2.1201533246890372</c:v>
                </c:pt>
                <c:pt idx="7898">
                  <c:v>2.1198787964669732</c:v>
                </c:pt>
                <c:pt idx="7899">
                  <c:v>2.1198604884138579</c:v>
                </c:pt>
                <c:pt idx="7900">
                  <c:v>2.1194941651818962</c:v>
                </c:pt>
                <c:pt idx="7901">
                  <c:v>2.1189441003250677</c:v>
                </c:pt>
                <c:pt idx="7902">
                  <c:v>2.1181176945241638</c:v>
                </c:pt>
                <c:pt idx="7903">
                  <c:v>2.1174002019417539</c:v>
                </c:pt>
                <c:pt idx="7904">
                  <c:v>2.1172897131821937</c:v>
                </c:pt>
                <c:pt idx="7905">
                  <c:v>2.1171976177385625</c:v>
                </c:pt>
                <c:pt idx="7906">
                  <c:v>2.1169396465507555</c:v>
                </c:pt>
                <c:pt idx="7907">
                  <c:v>2.1168290405443249</c:v>
                </c:pt>
                <c:pt idx="7908">
                  <c:v>2.1162755875805446</c:v>
                </c:pt>
                <c:pt idx="7909">
                  <c:v>2.1131073665204956</c:v>
                </c:pt>
                <c:pt idx="7910">
                  <c:v>2.1129957800651273</c:v>
                </c:pt>
                <c:pt idx="7911">
                  <c:v>2.1120647762745675</c:v>
                </c:pt>
                <c:pt idx="7912">
                  <c:v>2.1117477797944511</c:v>
                </c:pt>
                <c:pt idx="7913">
                  <c:v>2.1113185335858637</c:v>
                </c:pt>
                <c:pt idx="7914">
                  <c:v>2.1098034534251577</c:v>
                </c:pt>
                <c:pt idx="7915">
                  <c:v>2.1088467952874557</c:v>
                </c:pt>
                <c:pt idx="7916">
                  <c:v>2.1071345647545625</c:v>
                </c:pt>
                <c:pt idx="7917">
                  <c:v>2.106870544478654</c:v>
                </c:pt>
                <c:pt idx="7918">
                  <c:v>2.1066063635994823</c:v>
                </c:pt>
                <c:pt idx="7919">
                  <c:v>2.1063420219215399</c:v>
                </c:pt>
                <c:pt idx="7920">
                  <c:v>2.1053398398052865</c:v>
                </c:pt>
                <c:pt idx="7921">
                  <c:v>2.1053209084619429</c:v>
                </c:pt>
                <c:pt idx="7922">
                  <c:v>2.1051504892259425</c:v>
                </c:pt>
                <c:pt idx="7923">
                  <c:v>2.1046577910087962</c:v>
                </c:pt>
                <c:pt idx="7924">
                  <c:v>2.1039366866609921</c:v>
                </c:pt>
                <c:pt idx="7925">
                  <c:v>2.1034806346582147</c:v>
                </c:pt>
                <c:pt idx="7926">
                  <c:v>2.1028146991980976</c:v>
                </c:pt>
                <c:pt idx="7927">
                  <c:v>2.1019951495409024</c:v>
                </c:pt>
                <c:pt idx="7928">
                  <c:v>2.1006576819755618</c:v>
                </c:pt>
                <c:pt idx="7929">
                  <c:v>2.0996422809553672</c:v>
                </c:pt>
                <c:pt idx="7930">
                  <c:v>2.0993928573323002</c:v>
                </c:pt>
                <c:pt idx="7931">
                  <c:v>2.0979895808130093</c:v>
                </c:pt>
                <c:pt idx="7932">
                  <c:v>2.0979318148041139</c:v>
                </c:pt>
                <c:pt idx="7933">
                  <c:v>2.0975850573036903</c:v>
                </c:pt>
                <c:pt idx="7934">
                  <c:v>2.0952662380985045</c:v>
                </c:pt>
                <c:pt idx="7935">
                  <c:v>2.0938689804163273</c:v>
                </c:pt>
                <c:pt idx="7936">
                  <c:v>2.0937134517045513</c:v>
                </c:pt>
                <c:pt idx="7937">
                  <c:v>2.0933243860732422</c:v>
                </c:pt>
                <c:pt idx="7938">
                  <c:v>2.0926816647907098</c:v>
                </c:pt>
                <c:pt idx="7939">
                  <c:v>2.0924672128167461</c:v>
                </c:pt>
                <c:pt idx="7940">
                  <c:v>2.0923892040183141</c:v>
                </c:pt>
                <c:pt idx="7941">
                  <c:v>2.0907086167229991</c:v>
                </c:pt>
                <c:pt idx="7942">
                  <c:v>2.0902972509530859</c:v>
                </c:pt>
                <c:pt idx="7943">
                  <c:v>2.0895715142338145</c:v>
                </c:pt>
                <c:pt idx="7944">
                  <c:v>2.0887068943742912</c:v>
                </c:pt>
                <c:pt idx="7945">
                  <c:v>2.0882148651349959</c:v>
                </c:pt>
                <c:pt idx="7946">
                  <c:v>2.0876236932819676</c:v>
                </c:pt>
                <c:pt idx="7947">
                  <c:v>2.0875250863560617</c:v>
                </c:pt>
                <c:pt idx="7948">
                  <c:v>2.0862807170062712</c:v>
                </c:pt>
                <c:pt idx="7949">
                  <c:v>2.0834428942602217</c:v>
                </c:pt>
                <c:pt idx="7950">
                  <c:v>2.083104294128765</c:v>
                </c:pt>
                <c:pt idx="7951">
                  <c:v>2.0822466547436691</c:v>
                </c:pt>
                <c:pt idx="7952">
                  <c:v>2.0808668935052506</c:v>
                </c:pt>
                <c:pt idx="7953">
                  <c:v>2.0797840143357855</c:v>
                </c:pt>
                <c:pt idx="7954">
                  <c:v>2.0795831845139854</c:v>
                </c:pt>
                <c:pt idx="7955">
                  <c:v>2.0793822617799353</c:v>
                </c:pt>
                <c:pt idx="7956">
                  <c:v>2.0792817655439428</c:v>
                </c:pt>
                <c:pt idx="7957">
                  <c:v>2.0789600212262935</c:v>
                </c:pt>
                <c:pt idx="7958">
                  <c:v>2.078799059637459</c:v>
                </c:pt>
                <c:pt idx="7959">
                  <c:v>2.0785776399992391</c:v>
                </c:pt>
                <c:pt idx="7960">
                  <c:v>2.0777110057129202</c:v>
                </c:pt>
                <c:pt idx="7961">
                  <c:v>2.0776101219563041</c:v>
                </c:pt>
                <c:pt idx="7962">
                  <c:v>2.0771457545991789</c:v>
                </c:pt>
                <c:pt idx="7963">
                  <c:v>2.0770245335855795</c:v>
                </c:pt>
                <c:pt idx="7964">
                  <c:v>2.0770043267933502</c:v>
                </c:pt>
                <c:pt idx="7965">
                  <c:v>2.075263015987252</c:v>
                </c:pt>
                <c:pt idx="7966">
                  <c:v>2.0719024538343138</c:v>
                </c:pt>
                <c:pt idx="7967">
                  <c:v>2.0711452904510828</c:v>
                </c:pt>
                <c:pt idx="7968">
                  <c:v>2.0706329452510359</c:v>
                </c:pt>
                <c:pt idx="7969">
                  <c:v>2.068556895072363</c:v>
                </c:pt>
                <c:pt idx="7970">
                  <c:v>2.0681033668305555</c:v>
                </c:pt>
                <c:pt idx="7971">
                  <c:v>2.0678557880218156</c:v>
                </c:pt>
                <c:pt idx="7972">
                  <c:v>2.0664915759721909</c:v>
                </c:pt>
                <c:pt idx="7973">
                  <c:v>2.0664915759721905</c:v>
                </c:pt>
                <c:pt idx="7974">
                  <c:v>2.066408758565017</c:v>
                </c:pt>
                <c:pt idx="7975">
                  <c:v>2.0660358846726026</c:v>
                </c:pt>
                <c:pt idx="7976">
                  <c:v>2.0640209790019721</c:v>
                </c:pt>
                <c:pt idx="7977">
                  <c:v>2.0624148353828771</c:v>
                </c:pt>
                <c:pt idx="7978">
                  <c:v>2.061996681603314</c:v>
                </c:pt>
                <c:pt idx="7979">
                  <c:v>2.0619757633420135</c:v>
                </c:pt>
                <c:pt idx="7980">
                  <c:v>2.0617874536366987</c:v>
                </c:pt>
                <c:pt idx="7981">
                  <c:v>2.0610333972425505</c:v>
                </c:pt>
                <c:pt idx="7982">
                  <c:v>2.0597316675815911</c:v>
                </c:pt>
                <c:pt idx="7983">
                  <c:v>2.0590372171415408</c:v>
                </c:pt>
                <c:pt idx="7984">
                  <c:v>2.0586368777319648</c:v>
                </c:pt>
                <c:pt idx="7985">
                  <c:v>2.0585314638908438</c:v>
                </c:pt>
                <c:pt idx="7986">
                  <c:v>2.0573067898028334</c:v>
                </c:pt>
                <c:pt idx="7987">
                  <c:v>2.0572222020863653</c:v>
                </c:pt>
                <c:pt idx="7988">
                  <c:v>2.0560998567002429</c:v>
                </c:pt>
                <c:pt idx="7989">
                  <c:v>2.0541234207664503</c:v>
                </c:pt>
                <c:pt idx="7990">
                  <c:v>2.0539103642070833</c:v>
                </c:pt>
                <c:pt idx="7991">
                  <c:v>2.0534199370979511</c:v>
                </c:pt>
                <c:pt idx="7992">
                  <c:v>2.0528221469390067</c:v>
                </c:pt>
                <c:pt idx="7993">
                  <c:v>2.0511310752767353</c:v>
                </c:pt>
                <c:pt idx="7994">
                  <c:v>2.0506374978013096</c:v>
                </c:pt>
                <c:pt idx="7995">
                  <c:v>2.0496056125949731</c:v>
                </c:pt>
                <c:pt idx="7996">
                  <c:v>2.0493687931913636</c:v>
                </c:pt>
                <c:pt idx="7997">
                  <c:v>2.0488516476296033</c:v>
                </c:pt>
                <c:pt idx="7998">
                  <c:v>2.0485281186618689</c:v>
                </c:pt>
                <c:pt idx="7999">
                  <c:v>2.0482043485005774</c:v>
                </c:pt>
                <c:pt idx="8000">
                  <c:v>2.0461264840702582</c:v>
                </c:pt>
                <c:pt idx="8001">
                  <c:v>2.0460613903454874</c:v>
                </c:pt>
                <c:pt idx="8002">
                  <c:v>2.0449750560907787</c:v>
                </c:pt>
                <c:pt idx="8003">
                  <c:v>2.0444090865590487</c:v>
                </c:pt>
                <c:pt idx="8004">
                  <c:v>2.0435369214262789</c:v>
                </c:pt>
                <c:pt idx="8005">
                  <c:v>2.0433404426566408</c:v>
                </c:pt>
                <c:pt idx="8006">
                  <c:v>2.0432312493636555</c:v>
                </c:pt>
                <c:pt idx="8007">
                  <c:v>2.0431001811622975</c:v>
                </c:pt>
                <c:pt idx="8008">
                  <c:v>2.0403165838965136</c:v>
                </c:pt>
                <c:pt idx="8009">
                  <c:v>2.0401626372498418</c:v>
                </c:pt>
                <c:pt idx="8010">
                  <c:v>2.0399426187629923</c:v>
                </c:pt>
                <c:pt idx="8011">
                  <c:v>2.0396564279902614</c:v>
                </c:pt>
                <c:pt idx="8012">
                  <c:v>2.0390614284801498</c:v>
                </c:pt>
                <c:pt idx="8013">
                  <c:v>2.0385539332828717</c:v>
                </c:pt>
                <c:pt idx="8014">
                  <c:v>2.038288917572495</c:v>
                </c:pt>
                <c:pt idx="8015">
                  <c:v>2.0370500348116094</c:v>
                </c:pt>
                <c:pt idx="8016">
                  <c:v>2.0369170875201927</c:v>
                </c:pt>
                <c:pt idx="8017">
                  <c:v>2.0353852613058261</c:v>
                </c:pt>
                <c:pt idx="8018">
                  <c:v>2.0350292822023683</c:v>
                </c:pt>
                <c:pt idx="8019">
                  <c:v>2.0347843772000593</c:v>
                </c:pt>
                <c:pt idx="8020">
                  <c:v>2.0346507344206985</c:v>
                </c:pt>
                <c:pt idx="8021">
                  <c:v>2.0342941524891125</c:v>
                </c:pt>
                <c:pt idx="8022">
                  <c:v>2.0338926475465828</c:v>
                </c:pt>
                <c:pt idx="8023">
                  <c:v>2.0336247712192601</c:v>
                </c:pt>
                <c:pt idx="8024">
                  <c:v>2.0335131072991985</c:v>
                </c:pt>
                <c:pt idx="8025">
                  <c:v>2.0333790726861589</c:v>
                </c:pt>
                <c:pt idx="8026">
                  <c:v>2.0331779431723302</c:v>
                </c:pt>
                <c:pt idx="8027">
                  <c:v>2.0322605059474155</c:v>
                </c:pt>
                <c:pt idx="8028">
                  <c:v>2.0321484906565255</c:v>
                </c:pt>
                <c:pt idx="8029">
                  <c:v>2.0310492091535632</c:v>
                </c:pt>
                <c:pt idx="8030">
                  <c:v>2.0301047481465391</c:v>
                </c:pt>
                <c:pt idx="8031">
                  <c:v>2.0300146922660911</c:v>
                </c:pt>
                <c:pt idx="8032">
                  <c:v>2.029541592277925</c:v>
                </c:pt>
                <c:pt idx="8033">
                  <c:v>2.0277798377510847</c:v>
                </c:pt>
                <c:pt idx="8034">
                  <c:v>2.0271003323210746</c:v>
                </c:pt>
                <c:pt idx="8035">
                  <c:v>2.0245540766907086</c:v>
                </c:pt>
                <c:pt idx="8036">
                  <c:v>2.0239608404668337</c:v>
                </c:pt>
                <c:pt idx="8037">
                  <c:v>2.0238695013883321</c:v>
                </c:pt>
                <c:pt idx="8038">
                  <c:v>2.0233896558066746</c:v>
                </c:pt>
                <c:pt idx="8039">
                  <c:v>2.0221762541611787</c:v>
                </c:pt>
                <c:pt idx="8040">
                  <c:v>2.0220157398177201</c:v>
                </c:pt>
                <c:pt idx="8041">
                  <c:v>2.0215797587409683</c:v>
                </c:pt>
                <c:pt idx="8042">
                  <c:v>2.0213960567419713</c:v>
                </c:pt>
                <c:pt idx="8043">
                  <c:v>2.0203152354142548</c:v>
                </c:pt>
                <c:pt idx="8044">
                  <c:v>2.0197161766673788</c:v>
                </c:pt>
                <c:pt idx="8045">
                  <c:v>2.0195547503347981</c:v>
                </c:pt>
                <c:pt idx="8046">
                  <c:v>2.019139378322568</c:v>
                </c:pt>
                <c:pt idx="8047">
                  <c:v>2.0183768296202986</c:v>
                </c:pt>
                <c:pt idx="8048">
                  <c:v>2.0182843084265309</c:v>
                </c:pt>
                <c:pt idx="8049">
                  <c:v>2.018099206886423</c:v>
                </c:pt>
                <c:pt idx="8050">
                  <c:v>2.0177287669604316</c:v>
                </c:pt>
                <c:pt idx="8051">
                  <c:v>2.0175897704856003</c:v>
                </c:pt>
                <c:pt idx="8052">
                  <c:v>2.0157787563890408</c:v>
                </c:pt>
                <c:pt idx="8053">
                  <c:v>2.0148704094623398</c:v>
                </c:pt>
                <c:pt idx="8054">
                  <c:v>2.0135861698908304</c:v>
                </c:pt>
                <c:pt idx="8055">
                  <c:v>2.0132820666619691</c:v>
                </c:pt>
                <c:pt idx="8056">
                  <c:v>2.0128372247051725</c:v>
                </c:pt>
                <c:pt idx="8057">
                  <c:v>2.0123215746579857</c:v>
                </c:pt>
                <c:pt idx="8058">
                  <c:v>2.0118992232997077</c:v>
                </c:pt>
                <c:pt idx="8059">
                  <c:v>2.011758348189459</c:v>
                </c:pt>
                <c:pt idx="8060">
                  <c:v>2.0117113796627382</c:v>
                </c:pt>
                <c:pt idx="8061">
                  <c:v>2.0110062415277961</c:v>
                </c:pt>
                <c:pt idx="8062">
                  <c:v>2.0105119627372137</c:v>
                </c:pt>
                <c:pt idx="8063">
                  <c:v>2.0082215366185765</c:v>
                </c:pt>
                <c:pt idx="8064">
                  <c:v>2.0074395575284201</c:v>
                </c:pt>
                <c:pt idx="8065">
                  <c:v>2.0071785846271233</c:v>
                </c:pt>
                <c:pt idx="8066">
                  <c:v>2.0069886876053382</c:v>
                </c:pt>
                <c:pt idx="8067">
                  <c:v>2.0067987075139873</c:v>
                </c:pt>
                <c:pt idx="8068">
                  <c:v>2.0062996140111715</c:v>
                </c:pt>
                <c:pt idx="8069">
                  <c:v>2.0060379549973173</c:v>
                </c:pt>
                <c:pt idx="8070">
                  <c:v>2.005871362597361</c:v>
                </c:pt>
                <c:pt idx="8071">
                  <c:v>2.0035323341237072</c:v>
                </c:pt>
                <c:pt idx="8072">
                  <c:v>2.0034605321095067</c:v>
                </c:pt>
                <c:pt idx="8073">
                  <c:v>2.0024300632733514</c:v>
                </c:pt>
                <c:pt idx="8074">
                  <c:v>2.0018058008632624</c:v>
                </c:pt>
                <c:pt idx="8075">
                  <c:v>2.00021709297223</c:v>
                </c:pt>
                <c:pt idx="8076">
                  <c:v>1.9999276115538114</c:v>
                </c:pt>
                <c:pt idx="8077">
                  <c:v>1.9994930273128413</c:v>
                </c:pt>
                <c:pt idx="8078">
                  <c:v>1.9986467554716052</c:v>
                </c:pt>
                <c:pt idx="8079">
                  <c:v>1.9974591976227172</c:v>
                </c:pt>
                <c:pt idx="8080">
                  <c:v>1.9967062049600754</c:v>
                </c:pt>
                <c:pt idx="8081">
                  <c:v>1.9958301203108326</c:v>
                </c:pt>
                <c:pt idx="8082">
                  <c:v>1.9949522647986573</c:v>
                </c:pt>
                <c:pt idx="8083">
                  <c:v>1.9933627395960227</c:v>
                </c:pt>
                <c:pt idx="8084">
                  <c:v>1.9927252969768146</c:v>
                </c:pt>
                <c:pt idx="8085">
                  <c:v>1.9926516856630019</c:v>
                </c:pt>
                <c:pt idx="8086">
                  <c:v>1.9914722046205353</c:v>
                </c:pt>
                <c:pt idx="8087">
                  <c:v>1.9912999290183939</c:v>
                </c:pt>
                <c:pt idx="8088">
                  <c:v>1.9900673975920182</c:v>
                </c:pt>
                <c:pt idx="8089">
                  <c:v>1.9897957706150933</c:v>
                </c:pt>
                <c:pt idx="8090">
                  <c:v>1.9869955397243817</c:v>
                </c:pt>
                <c:pt idx="8091">
                  <c:v>1.9851019918549271</c:v>
                </c:pt>
                <c:pt idx="8092">
                  <c:v>1.9849271701858526</c:v>
                </c:pt>
                <c:pt idx="8093">
                  <c:v>1.9838266767840609</c:v>
                </c:pt>
                <c:pt idx="8094">
                  <c:v>1.9836513408891094</c:v>
                </c:pt>
                <c:pt idx="8095">
                  <c:v>1.9826229495362975</c:v>
                </c:pt>
                <c:pt idx="8096">
                  <c:v>1.9824973691977126</c:v>
                </c:pt>
                <c:pt idx="8097">
                  <c:v>1.98214555094293</c:v>
                </c:pt>
                <c:pt idx="8098">
                  <c:v>1.9820198324641527</c:v>
                </c:pt>
                <c:pt idx="8099">
                  <c:v>1.9817682862758847</c:v>
                </c:pt>
                <c:pt idx="8100">
                  <c:v>1.9806597488829891</c:v>
                </c:pt>
                <c:pt idx="8101">
                  <c:v>1.9805588323072119</c:v>
                </c:pt>
                <c:pt idx="8102">
                  <c:v>1.9805083652242543</c:v>
                </c:pt>
                <c:pt idx="8103">
                  <c:v>1.9797253745827248</c:v>
                </c:pt>
                <c:pt idx="8104">
                  <c:v>1.9797000933019362</c:v>
                </c:pt>
                <c:pt idx="8105">
                  <c:v>1.9796748105493804</c:v>
                </c:pt>
                <c:pt idx="8106">
                  <c:v>1.9788649843476569</c:v>
                </c:pt>
                <c:pt idx="8107">
                  <c:v>1.9772407875827516</c:v>
                </c:pt>
                <c:pt idx="8108">
                  <c:v>1.9757125666102482</c:v>
                </c:pt>
                <c:pt idx="8109">
                  <c:v>1.9756360142174585</c:v>
                </c:pt>
                <c:pt idx="8110">
                  <c:v>1.9755849717913665</c:v>
                </c:pt>
                <c:pt idx="8111">
                  <c:v>1.9742557586843659</c:v>
                </c:pt>
                <c:pt idx="8112">
                  <c:v>1.9732818314357039</c:v>
                </c:pt>
                <c:pt idx="8113">
                  <c:v>1.9716108232876108</c:v>
                </c:pt>
                <c:pt idx="8114">
                  <c:v>1.971378945351504</c:v>
                </c:pt>
                <c:pt idx="8115">
                  <c:v>1.9712500707602432</c:v>
                </c:pt>
                <c:pt idx="8116">
                  <c:v>1.9705793057148508</c:v>
                </c:pt>
                <c:pt idx="8117">
                  <c:v>1.9703468762300935</c:v>
                </c:pt>
                <c:pt idx="8118">
                  <c:v>1.9696229657461766</c:v>
                </c:pt>
                <c:pt idx="8119">
                  <c:v>1.9690274209765206</c:v>
                </c:pt>
                <c:pt idx="8120">
                  <c:v>1.9686904471158868</c:v>
                </c:pt>
                <c:pt idx="8121">
                  <c:v>1.9686385817689687</c:v>
                </c:pt>
                <c:pt idx="8122">
                  <c:v>1.9676779539177052</c:v>
                </c:pt>
                <c:pt idx="8123">
                  <c:v>1.9672879040619176</c:v>
                </c:pt>
                <c:pt idx="8124">
                  <c:v>1.9650709799937409</c:v>
                </c:pt>
                <c:pt idx="8125">
                  <c:v>1.9646524080855219</c:v>
                </c:pt>
                <c:pt idx="8126">
                  <c:v>1.9628163977575388</c:v>
                </c:pt>
                <c:pt idx="8127">
                  <c:v>1.9600741977588614</c:v>
                </c:pt>
                <c:pt idx="8128">
                  <c:v>1.9593594402898327</c:v>
                </c:pt>
                <c:pt idx="8129">
                  <c:v>1.9589088035605147</c:v>
                </c:pt>
                <c:pt idx="8130">
                  <c:v>1.9585904252835129</c:v>
                </c:pt>
                <c:pt idx="8131">
                  <c:v>1.9581124198130817</c:v>
                </c:pt>
                <c:pt idx="8132">
                  <c:v>1.9577668661476535</c:v>
                </c:pt>
                <c:pt idx="8133">
                  <c:v>1.9576870839334302</c:v>
                </c:pt>
                <c:pt idx="8134">
                  <c:v>1.9566485792052033</c:v>
                </c:pt>
                <c:pt idx="8135">
                  <c:v>1.9565152577975857</c:v>
                </c:pt>
                <c:pt idx="8136">
                  <c:v>1.9564619177727209</c:v>
                </c:pt>
                <c:pt idx="8137">
                  <c:v>1.9540548107747588</c:v>
                </c:pt>
                <c:pt idx="8138">
                  <c:v>1.9538938616134713</c:v>
                </c:pt>
                <c:pt idx="8139">
                  <c:v>1.9537328527824491</c:v>
                </c:pt>
                <c:pt idx="8140">
                  <c:v>1.9531419758451756</c:v>
                </c:pt>
                <c:pt idx="8141">
                  <c:v>1.952980687969379</c:v>
                </c:pt>
                <c:pt idx="8142">
                  <c:v>1.9524426287022607</c:v>
                </c:pt>
                <c:pt idx="8143">
                  <c:v>1.9523887860934754</c:v>
                </c:pt>
                <c:pt idx="8144">
                  <c:v>1.9520925323657659</c:v>
                </c:pt>
                <c:pt idx="8145">
                  <c:v>1.9511755592632172</c:v>
                </c:pt>
                <c:pt idx="8146">
                  <c:v>1.9505000769951135</c:v>
                </c:pt>
                <c:pt idx="8147">
                  <c:v>1.9504189484761996</c:v>
                </c:pt>
                <c:pt idx="8148">
                  <c:v>1.9499589337166969</c:v>
                </c:pt>
                <c:pt idx="8149">
                  <c:v>1.9495255330875489</c:v>
                </c:pt>
                <c:pt idx="8150">
                  <c:v>1.9491730763297614</c:v>
                </c:pt>
                <c:pt idx="8151">
                  <c:v>1.9490645705248488</c:v>
                </c:pt>
                <c:pt idx="8152">
                  <c:v>1.9487388903581779</c:v>
                </c:pt>
                <c:pt idx="8153">
                  <c:v>1.946233861949932</c:v>
                </c:pt>
                <c:pt idx="8154">
                  <c:v>1.9453591497067975</c:v>
                </c:pt>
                <c:pt idx="8155">
                  <c:v>1.9441260972563106</c:v>
                </c:pt>
                <c:pt idx="8156">
                  <c:v>1.9434120679738374</c:v>
                </c:pt>
                <c:pt idx="8157">
                  <c:v>1.9433021130439752</c:v>
                </c:pt>
                <c:pt idx="8158">
                  <c:v>1.9428620147283697</c:v>
                </c:pt>
                <c:pt idx="8159">
                  <c:v>1.94272439249383</c:v>
                </c:pt>
                <c:pt idx="8160">
                  <c:v>1.9411524088458891</c:v>
                </c:pt>
                <c:pt idx="8161">
                  <c:v>1.9411247793340369</c:v>
                </c:pt>
                <c:pt idx="8162">
                  <c:v>1.9401566373537564</c:v>
                </c:pt>
                <c:pt idx="8163">
                  <c:v>1.9396024428270719</c:v>
                </c:pt>
                <c:pt idx="8164">
                  <c:v>1.9395747145281381</c:v>
                </c:pt>
                <c:pt idx="8165">
                  <c:v>1.9395747145281381</c:v>
                </c:pt>
                <c:pt idx="8166">
                  <c:v>1.9387142579823888</c:v>
                </c:pt>
                <c:pt idx="8167">
                  <c:v>1.9386586860716408</c:v>
                </c:pt>
                <c:pt idx="8168">
                  <c:v>1.9385475209128067</c:v>
                </c:pt>
                <c:pt idx="8169">
                  <c:v>1.9370161074648142</c:v>
                </c:pt>
                <c:pt idx="8170">
                  <c:v>1.9361505615845018</c:v>
                </c:pt>
                <c:pt idx="8171">
                  <c:v>1.935591228025439</c:v>
                </c:pt>
                <c:pt idx="8172">
                  <c:v>1.9344984512435679</c:v>
                </c:pt>
                <c:pt idx="8173">
                  <c:v>1.9344423372203741</c:v>
                </c:pt>
                <c:pt idx="8174">
                  <c:v>1.9337684028057038</c:v>
                </c:pt>
                <c:pt idx="8175">
                  <c:v>1.9326710239592211</c:v>
                </c:pt>
                <c:pt idx="8176">
                  <c:v>1.9325301336151133</c:v>
                </c:pt>
                <c:pt idx="8177">
                  <c:v>1.9325019500606788</c:v>
                </c:pt>
                <c:pt idx="8178">
                  <c:v>1.9311752556716113</c:v>
                </c:pt>
                <c:pt idx="8179">
                  <c:v>1.9307509880141402</c:v>
                </c:pt>
                <c:pt idx="8180">
                  <c:v>1.9307226887614077</c:v>
                </c:pt>
                <c:pt idx="8181">
                  <c:v>1.9300146074718965</c:v>
                </c:pt>
                <c:pt idx="8182">
                  <c:v>1.9282820285155555</c:v>
                </c:pt>
                <c:pt idx="8183">
                  <c:v>1.9275699534553863</c:v>
                </c:pt>
                <c:pt idx="8184">
                  <c:v>1.9257130756834244</c:v>
                </c:pt>
                <c:pt idx="8185">
                  <c:v>1.925283435600335</c:v>
                </c:pt>
                <c:pt idx="8186">
                  <c:v>1.9249680958524342</c:v>
                </c:pt>
                <c:pt idx="8187">
                  <c:v>1.9241356464105299</c:v>
                </c:pt>
                <c:pt idx="8188">
                  <c:v>1.9235030669421045</c:v>
                </c:pt>
                <c:pt idx="8189">
                  <c:v>1.9231288364304493</c:v>
                </c:pt>
                <c:pt idx="8190">
                  <c:v>1.9225813034189942</c:v>
                </c:pt>
                <c:pt idx="8191">
                  <c:v>1.9212817545099838</c:v>
                </c:pt>
                <c:pt idx="8192">
                  <c:v>1.9212239064270606</c:v>
                </c:pt>
                <c:pt idx="8193">
                  <c:v>1.9210503159316832</c:v>
                </c:pt>
                <c:pt idx="8194">
                  <c:v>1.9207608441607162</c:v>
                </c:pt>
                <c:pt idx="8195">
                  <c:v>1.9194848712073547</c:v>
                </c:pt>
                <c:pt idx="8196">
                  <c:v>1.9181177463618893</c:v>
                </c:pt>
                <c:pt idx="8197">
                  <c:v>1.9172136645836289</c:v>
                </c:pt>
                <c:pt idx="8198">
                  <c:v>1.9155170853430854</c:v>
                </c:pt>
                <c:pt idx="8199">
                  <c:v>1.9154291507127637</c:v>
                </c:pt>
                <c:pt idx="8200">
                  <c:v>1.9146369367977629</c:v>
                </c:pt>
                <c:pt idx="8201">
                  <c:v>1.9126943082923145</c:v>
                </c:pt>
                <c:pt idx="8202">
                  <c:v>1.9121334521289861</c:v>
                </c:pt>
                <c:pt idx="8203">
                  <c:v>1.9116605897678478</c:v>
                </c:pt>
                <c:pt idx="8204">
                  <c:v>1.9112168132226397</c:v>
                </c:pt>
                <c:pt idx="8205">
                  <c:v>1.907560638774854</c:v>
                </c:pt>
                <c:pt idx="8206">
                  <c:v>1.9065744544252128</c:v>
                </c:pt>
                <c:pt idx="8207">
                  <c:v>1.9065146136422173</c:v>
                </c:pt>
                <c:pt idx="8208">
                  <c:v>1.9061853418684447</c:v>
                </c:pt>
                <c:pt idx="8209">
                  <c:v>1.9026071692858475</c:v>
                </c:pt>
                <c:pt idx="8210">
                  <c:v>1.9022447034293057</c:v>
                </c:pt>
                <c:pt idx="8211">
                  <c:v>1.9014583213961123</c:v>
                </c:pt>
                <c:pt idx="8212">
                  <c:v>1.9007918072365593</c:v>
                </c:pt>
                <c:pt idx="8213">
                  <c:v>1.9007311642870921</c:v>
                </c:pt>
                <c:pt idx="8214">
                  <c:v>1.9003671286564703</c:v>
                </c:pt>
                <c:pt idx="8215">
                  <c:v>1.8985423592412229</c:v>
                </c:pt>
                <c:pt idx="8216">
                  <c:v>1.89835945989891</c:v>
                </c:pt>
                <c:pt idx="8217">
                  <c:v>1.8973521343443129</c:v>
                </c:pt>
                <c:pt idx="8218">
                  <c:v>1.8960360430787122</c:v>
                </c:pt>
                <c:pt idx="8219">
                  <c:v>1.8955146258620581</c:v>
                </c:pt>
                <c:pt idx="8220">
                  <c:v>1.8946544540102843</c:v>
                </c:pt>
                <c:pt idx="8221">
                  <c:v>1.8939158054327019</c:v>
                </c:pt>
                <c:pt idx="8222">
                  <c:v>1.8936693097996053</c:v>
                </c:pt>
                <c:pt idx="8223">
                  <c:v>1.8923110773183343</c:v>
                </c:pt>
                <c:pt idx="8224">
                  <c:v>1.8917542101189249</c:v>
                </c:pt>
                <c:pt idx="8225">
                  <c:v>1.8890214220952248</c:v>
                </c:pt>
                <c:pt idx="8226">
                  <c:v>1.8883667301712372</c:v>
                </c:pt>
                <c:pt idx="8227">
                  <c:v>1.8883355297342899</c:v>
                </c:pt>
                <c:pt idx="8228">
                  <c:v>1.8874922695354186</c:v>
                </c:pt>
                <c:pt idx="8229">
                  <c:v>1.8874610062102133</c:v>
                </c:pt>
                <c:pt idx="8230">
                  <c:v>1.884795363948981</c:v>
                </c:pt>
                <c:pt idx="8231">
                  <c:v>1.8838821533035981</c:v>
                </c:pt>
                <c:pt idx="8232">
                  <c:v>1.8834721588455865</c:v>
                </c:pt>
                <c:pt idx="8233">
                  <c:v>1.8831249378872401</c:v>
                </c:pt>
                <c:pt idx="8234">
                  <c:v>1.8830301930629754</c:v>
                </c:pt>
                <c:pt idx="8235">
                  <c:v>1.8830301930629754</c:v>
                </c:pt>
                <c:pt idx="8236">
                  <c:v>1.8824929149540361</c:v>
                </c:pt>
                <c:pt idx="8237">
                  <c:v>1.8819866335334616</c:v>
                </c:pt>
                <c:pt idx="8238">
                  <c:v>1.8814480620531007</c:v>
                </c:pt>
                <c:pt idx="8239">
                  <c:v>1.8802735632317729</c:v>
                </c:pt>
                <c:pt idx="8240">
                  <c:v>1.8801146032790803</c:v>
                </c:pt>
                <c:pt idx="8241">
                  <c:v>1.8799873934123525</c:v>
                </c:pt>
                <c:pt idx="8242">
                  <c:v>1.8791596197925338</c:v>
                </c:pt>
                <c:pt idx="8243">
                  <c:v>1.8758647686753009</c:v>
                </c:pt>
                <c:pt idx="8244">
                  <c:v>1.875704186502311</c:v>
                </c:pt>
                <c:pt idx="8245">
                  <c:v>1.8750612633917001</c:v>
                </c:pt>
                <c:pt idx="8246">
                  <c:v>1.8743851682093817</c:v>
                </c:pt>
                <c:pt idx="8247">
                  <c:v>1.8743207232646273</c:v>
                </c:pt>
                <c:pt idx="8248">
                  <c:v>1.873740288022729</c:v>
                </c:pt>
                <c:pt idx="8249">
                  <c:v>1.872609438381319</c:v>
                </c:pt>
                <c:pt idx="8250">
                  <c:v>1.8717674683517755</c:v>
                </c:pt>
                <c:pt idx="8251">
                  <c:v>1.870143692879449</c:v>
                </c:pt>
                <c:pt idx="8252">
                  <c:v>1.8693947125953039</c:v>
                </c:pt>
                <c:pt idx="8253">
                  <c:v>1.8683504996479683</c:v>
                </c:pt>
                <c:pt idx="8254">
                  <c:v>1.8682851529006432</c:v>
                </c:pt>
                <c:pt idx="8255">
                  <c:v>1.866287339084195</c:v>
                </c:pt>
                <c:pt idx="8256">
                  <c:v>1.8659589500463154</c:v>
                </c:pt>
                <c:pt idx="8257">
                  <c:v>1.8646099528816769</c:v>
                </c:pt>
                <c:pt idx="8258">
                  <c:v>1.8643792169365641</c:v>
                </c:pt>
                <c:pt idx="8259">
                  <c:v>1.8643462446492687</c:v>
                </c:pt>
                <c:pt idx="8260">
                  <c:v>1.8629260629417308</c:v>
                </c:pt>
                <c:pt idx="8261">
                  <c:v>1.8622970583605214</c:v>
                </c:pt>
                <c:pt idx="8262">
                  <c:v>1.8618661613005789</c:v>
                </c:pt>
                <c:pt idx="8263">
                  <c:v>1.8616671414474497</c:v>
                </c:pt>
                <c:pt idx="8264">
                  <c:v>1.8602714429289133</c:v>
                </c:pt>
                <c:pt idx="8265">
                  <c:v>1.85907154950651</c:v>
                </c:pt>
                <c:pt idx="8266">
                  <c:v>1.8578683317637747</c:v>
                </c:pt>
                <c:pt idx="8267">
                  <c:v>1.857533512163579</c:v>
                </c:pt>
                <c:pt idx="8268">
                  <c:v>1.8553845324547247</c:v>
                </c:pt>
                <c:pt idx="8269">
                  <c:v>1.854002233126989</c:v>
                </c:pt>
                <c:pt idx="8270">
                  <c:v>1.8539684634848972</c:v>
                </c:pt>
                <c:pt idx="8271">
                  <c:v>1.8537657904710751</c:v>
                </c:pt>
                <c:pt idx="8272">
                  <c:v>1.852920300031736</c:v>
                </c:pt>
                <c:pt idx="8273">
                  <c:v>1.8527848686805479</c:v>
                </c:pt>
                <c:pt idx="8274">
                  <c:v>1.8525816424335528</c:v>
                </c:pt>
                <c:pt idx="8275">
                  <c:v>1.8525816424335528</c:v>
                </c:pt>
                <c:pt idx="8276">
                  <c:v>1.8521070777011424</c:v>
                </c:pt>
                <c:pt idx="8277">
                  <c:v>1.8520731603687886</c:v>
                </c:pt>
                <c:pt idx="8278">
                  <c:v>1.8519374645445623</c:v>
                </c:pt>
                <c:pt idx="8279">
                  <c:v>1.8516659456348723</c:v>
                </c:pt>
                <c:pt idx="8280">
                  <c:v>1.850237679666668</c:v>
                </c:pt>
                <c:pt idx="8281">
                  <c:v>1.8499310106070359</c:v>
                </c:pt>
                <c:pt idx="8282">
                  <c:v>1.848770524818703</c:v>
                </c:pt>
                <c:pt idx="8283">
                  <c:v>1.8474012654456207</c:v>
                </c:pt>
                <c:pt idx="8284">
                  <c:v>1.8460276753643787</c:v>
                </c:pt>
                <c:pt idx="8285">
                  <c:v>1.845373695042174</c:v>
                </c:pt>
                <c:pt idx="8286">
                  <c:v>1.8450980400142567</c:v>
                </c:pt>
                <c:pt idx="8287">
                  <c:v>1.844649727093616</c:v>
                </c:pt>
                <c:pt idx="8288">
                  <c:v>1.8425745723200306</c:v>
                </c:pt>
                <c:pt idx="8289">
                  <c:v>1.8400014829948759</c:v>
                </c:pt>
                <c:pt idx="8290">
                  <c:v>1.8396874973333597</c:v>
                </c:pt>
                <c:pt idx="8291">
                  <c:v>1.8391986235383386</c:v>
                </c:pt>
                <c:pt idx="8292">
                  <c:v>1.8382542385963692</c:v>
                </c:pt>
                <c:pt idx="8293">
                  <c:v>1.8378688996478436</c:v>
                </c:pt>
                <c:pt idx="8294">
                  <c:v>1.8367459656494909</c:v>
                </c:pt>
                <c:pt idx="8295">
                  <c:v>1.8337489956916999</c:v>
                </c:pt>
                <c:pt idx="8296">
                  <c:v>1.8315854105565408</c:v>
                </c:pt>
                <c:pt idx="8297">
                  <c:v>1.8315498519957558</c:v>
                </c:pt>
                <c:pt idx="8298">
                  <c:v>1.8308024488922192</c:v>
                </c:pt>
                <c:pt idx="8299">
                  <c:v>1.8307668261647332</c:v>
                </c:pt>
                <c:pt idx="8300">
                  <c:v>1.8293037728310249</c:v>
                </c:pt>
                <c:pt idx="8301">
                  <c:v>1.8292680269581785</c:v>
                </c:pt>
                <c:pt idx="8302">
                  <c:v>1.8277281644732273</c:v>
                </c:pt>
                <c:pt idx="8303">
                  <c:v>1.8266865611971725</c:v>
                </c:pt>
                <c:pt idx="8304">
                  <c:v>1.8266146343202436</c:v>
                </c:pt>
                <c:pt idx="8305">
                  <c:v>1.8258586820285867</c:v>
                </c:pt>
                <c:pt idx="8306">
                  <c:v>1.8257866178980133</c:v>
                </c:pt>
                <c:pt idx="8307">
                  <c:v>1.8256424537533193</c:v>
                </c:pt>
                <c:pt idx="8308">
                  <c:v>1.8250292216906057</c:v>
                </c:pt>
                <c:pt idx="8309">
                  <c:v>1.8238725482294427</c:v>
                </c:pt>
                <c:pt idx="8310">
                  <c:v>1.8220954001808503</c:v>
                </c:pt>
                <c:pt idx="8311">
                  <c:v>1.8219500053077471</c:v>
                </c:pt>
                <c:pt idx="8312">
                  <c:v>1.821877289613663</c:v>
                </c:pt>
                <c:pt idx="8313">
                  <c:v>1.8218409272004543</c:v>
                </c:pt>
                <c:pt idx="8314">
                  <c:v>1.8192147998823842</c:v>
                </c:pt>
                <c:pt idx="8315">
                  <c:v>1.8164990743134495</c:v>
                </c:pt>
                <c:pt idx="8316">
                  <c:v>1.8152086699627128</c:v>
                </c:pt>
                <c:pt idx="8317">
                  <c:v>1.8132843899690572</c:v>
                </c:pt>
                <c:pt idx="8318">
                  <c:v>1.8124305389367594</c:v>
                </c:pt>
                <c:pt idx="8319">
                  <c:v>1.8112397727532894</c:v>
                </c:pt>
                <c:pt idx="8320">
                  <c:v>1.8109415703679379</c:v>
                </c:pt>
                <c:pt idx="8321">
                  <c:v>1.8093352150273205</c:v>
                </c:pt>
                <c:pt idx="8322">
                  <c:v>1.8085860437497656</c:v>
                </c:pt>
                <c:pt idx="8323">
                  <c:v>1.808286013007675</c:v>
                </c:pt>
                <c:pt idx="8324">
                  <c:v>1.8080233159702142</c:v>
                </c:pt>
                <c:pt idx="8325">
                  <c:v>1.8071966607109473</c:v>
                </c:pt>
                <c:pt idx="8326">
                  <c:v>1.8064437880565911</c:v>
                </c:pt>
                <c:pt idx="8327">
                  <c:v>1.8060291511027382</c:v>
                </c:pt>
                <c:pt idx="8328">
                  <c:v>1.8057650849601123</c:v>
                </c:pt>
                <c:pt idx="8329">
                  <c:v>1.8051231122166038</c:v>
                </c:pt>
                <c:pt idx="8330">
                  <c:v>1.8046315507810993</c:v>
                </c:pt>
                <c:pt idx="8331">
                  <c:v>1.804063672285982</c:v>
                </c:pt>
                <c:pt idx="8332">
                  <c:v>1.8035709095654551</c:v>
                </c:pt>
                <c:pt idx="8333">
                  <c:v>1.8018227845093613</c:v>
                </c:pt>
                <c:pt idx="8334">
                  <c:v>1.8013274711894751</c:v>
                </c:pt>
                <c:pt idx="8335">
                  <c:v>1.8009079182388343</c:v>
                </c:pt>
                <c:pt idx="8336">
                  <c:v>1.7992256415333707</c:v>
                </c:pt>
                <c:pt idx="8337">
                  <c:v>1.7988040521872044</c:v>
                </c:pt>
                <c:pt idx="8338">
                  <c:v>1.7979596437371961</c:v>
                </c:pt>
                <c:pt idx="8339">
                  <c:v>1.7956097055607234</c:v>
                </c:pt>
                <c:pt idx="8340">
                  <c:v>1.7930916001765802</c:v>
                </c:pt>
                <c:pt idx="8341">
                  <c:v>1.7918075677129504</c:v>
                </c:pt>
                <c:pt idx="8342">
                  <c:v>1.7906369619317033</c:v>
                </c:pt>
                <c:pt idx="8343">
                  <c:v>1.7904415538375615</c:v>
                </c:pt>
                <c:pt idx="8344">
                  <c:v>1.7875785374474833</c:v>
                </c:pt>
                <c:pt idx="8345">
                  <c:v>1.787421113075337</c:v>
                </c:pt>
                <c:pt idx="8346">
                  <c:v>1.7872636316188375</c:v>
                </c:pt>
                <c:pt idx="8347">
                  <c:v>1.7854880191253926</c:v>
                </c:pt>
                <c:pt idx="8348">
                  <c:v>1.785132023810853</c:v>
                </c:pt>
                <c:pt idx="8349">
                  <c:v>1.7842605825660838</c:v>
                </c:pt>
                <c:pt idx="8350">
                  <c:v>1.7842209300226275</c:v>
                </c:pt>
                <c:pt idx="8351">
                  <c:v>1.7836654139353139</c:v>
                </c:pt>
                <c:pt idx="8352">
                  <c:v>1.7829103608873542</c:v>
                </c:pt>
                <c:pt idx="8353">
                  <c:v>1.780797195594396</c:v>
                </c:pt>
                <c:pt idx="8354">
                  <c:v>1.7805973085922466</c:v>
                </c:pt>
                <c:pt idx="8355">
                  <c:v>1.780477332216355</c:v>
                </c:pt>
                <c:pt idx="8356">
                  <c:v>1.7754890858477106</c:v>
                </c:pt>
                <c:pt idx="8357">
                  <c:v>1.7740300884556923</c:v>
                </c:pt>
                <c:pt idx="8358">
                  <c:v>1.773827061720237</c:v>
                </c:pt>
                <c:pt idx="8359">
                  <c:v>1.7736239400281644</c:v>
                </c:pt>
                <c:pt idx="8360">
                  <c:v>1.773542664743581</c:v>
                </c:pt>
                <c:pt idx="8361">
                  <c:v>1.7733394099629238</c:v>
                </c:pt>
                <c:pt idx="8362">
                  <c:v>1.7730140043229714</c:v>
                </c:pt>
                <c:pt idx="8363">
                  <c:v>1.7722401873455047</c:v>
                </c:pt>
                <c:pt idx="8364">
                  <c:v>1.7681445847377988</c:v>
                </c:pt>
                <c:pt idx="8365">
                  <c:v>1.7675681057732218</c:v>
                </c:pt>
                <c:pt idx="8366">
                  <c:v>1.7668257923578341</c:v>
                </c:pt>
                <c:pt idx="8367">
                  <c:v>1.766784515497859</c:v>
                </c:pt>
                <c:pt idx="8368">
                  <c:v>1.7655029830902518</c:v>
                </c:pt>
                <c:pt idx="8369">
                  <c:v>1.7628868684376042</c:v>
                </c:pt>
                <c:pt idx="8370">
                  <c:v>1.7622199413739692</c:v>
                </c:pt>
                <c:pt idx="8371">
                  <c:v>1.7585754907685252</c:v>
                </c:pt>
                <c:pt idx="8372">
                  <c:v>1.7574803823879097</c:v>
                </c:pt>
                <c:pt idx="8373">
                  <c:v>1.7573960287930241</c:v>
                </c:pt>
                <c:pt idx="8374">
                  <c:v>1.7570162347313005</c:v>
                </c:pt>
                <c:pt idx="8375">
                  <c:v>1.7551970646930861</c:v>
                </c:pt>
                <c:pt idx="8376">
                  <c:v>1.7544757508452475</c:v>
                </c:pt>
                <c:pt idx="8377">
                  <c:v>1.7516212028445943</c:v>
                </c:pt>
                <c:pt idx="8378">
                  <c:v>1.7514929473486867</c:v>
                </c:pt>
                <c:pt idx="8379">
                  <c:v>1.7511935371459257</c:v>
                </c:pt>
                <c:pt idx="8380">
                  <c:v>1.7500367317452106</c:v>
                </c:pt>
                <c:pt idx="8381">
                  <c:v>1.7499080074004743</c:v>
                </c:pt>
                <c:pt idx="8382">
                  <c:v>1.7495645558350037</c:v>
                </c:pt>
                <c:pt idx="8383">
                  <c:v>1.7493497605974766</c:v>
                </c:pt>
                <c:pt idx="8384">
                  <c:v>1.749091866004445</c:v>
                </c:pt>
                <c:pt idx="8385">
                  <c:v>1.7483172620858338</c:v>
                </c:pt>
                <c:pt idx="8386">
                  <c:v>1.7468935566532016</c:v>
                </c:pt>
                <c:pt idx="8387">
                  <c:v>1.7463314190464916</c:v>
                </c:pt>
                <c:pt idx="8388">
                  <c:v>1.7459418201828729</c:v>
                </c:pt>
                <c:pt idx="8389">
                  <c:v>1.7456818933031517</c:v>
                </c:pt>
                <c:pt idx="8390">
                  <c:v>1.7455518715022995</c:v>
                </c:pt>
                <c:pt idx="8391">
                  <c:v>1.7439885660097945</c:v>
                </c:pt>
                <c:pt idx="8392">
                  <c:v>1.7433790908950675</c:v>
                </c:pt>
                <c:pt idx="8393">
                  <c:v>1.7432919531576356</c:v>
                </c:pt>
                <c:pt idx="8394">
                  <c:v>1.7411078081301041</c:v>
                </c:pt>
                <c:pt idx="8395">
                  <c:v>1.7396602316267358</c:v>
                </c:pt>
                <c:pt idx="8396">
                  <c:v>1.7395723444500919</c:v>
                </c:pt>
                <c:pt idx="8397">
                  <c:v>1.7392645991951918</c:v>
                </c:pt>
                <c:pt idx="8398">
                  <c:v>1.7381196323456964</c:v>
                </c:pt>
                <c:pt idx="8399">
                  <c:v>1.7371926427047373</c:v>
                </c:pt>
                <c:pt idx="8400">
                  <c:v>1.736927424692279</c:v>
                </c:pt>
                <c:pt idx="8401">
                  <c:v>1.7368389826836435</c:v>
                </c:pt>
                <c:pt idx="8402">
                  <c:v>1.7323043896236814</c:v>
                </c:pt>
                <c:pt idx="8403">
                  <c:v>1.7320808836324877</c:v>
                </c:pt>
                <c:pt idx="8404">
                  <c:v>1.7287594751678745</c:v>
                </c:pt>
                <c:pt idx="8405">
                  <c:v>1.7260023276032828</c:v>
                </c:pt>
                <c:pt idx="8406">
                  <c:v>1.7257301848380937</c:v>
                </c:pt>
                <c:pt idx="8407">
                  <c:v>1.7249127318440289</c:v>
                </c:pt>
                <c:pt idx="8408">
                  <c:v>1.7218106152125467</c:v>
                </c:pt>
                <c:pt idx="8409">
                  <c:v>1.7210774738999672</c:v>
                </c:pt>
                <c:pt idx="8410">
                  <c:v>1.720343092863589</c:v>
                </c:pt>
                <c:pt idx="8411">
                  <c:v>1.719377329335416</c:v>
                </c:pt>
                <c:pt idx="8412">
                  <c:v>1.7149348537035487</c:v>
                </c:pt>
                <c:pt idx="8413">
                  <c:v>1.7131170367437623</c:v>
                </c:pt>
                <c:pt idx="8414">
                  <c:v>1.7129768890046113</c:v>
                </c:pt>
                <c:pt idx="8415">
                  <c:v>1.7126029404447269</c:v>
                </c:pt>
                <c:pt idx="8416">
                  <c:v>1.7114322715545685</c:v>
                </c:pt>
                <c:pt idx="8417">
                  <c:v>1.7111977586259783</c:v>
                </c:pt>
                <c:pt idx="8418">
                  <c:v>1.7087984654546493</c:v>
                </c:pt>
                <c:pt idx="8419">
                  <c:v>1.707428226601035</c:v>
                </c:pt>
                <c:pt idx="8420">
                  <c:v>1.7058162146645901</c:v>
                </c:pt>
                <c:pt idx="8421">
                  <c:v>1.7049127715013048</c:v>
                </c:pt>
                <c:pt idx="8422">
                  <c:v>1.7045794496962992</c:v>
                </c:pt>
                <c:pt idx="8423">
                  <c:v>1.7035301982961963</c:v>
                </c:pt>
                <c:pt idx="8424">
                  <c:v>1.702813343417779</c:v>
                </c:pt>
                <c:pt idx="8425">
                  <c:v>1.7013760741018973</c:v>
                </c:pt>
                <c:pt idx="8426">
                  <c:v>1.7011840783065939</c:v>
                </c:pt>
                <c:pt idx="8427">
                  <c:v>1.7007998318918769</c:v>
                </c:pt>
                <c:pt idx="8428">
                  <c:v>1.7007037171450194</c:v>
                </c:pt>
                <c:pt idx="8429">
                  <c:v>1.6995486779484872</c:v>
                </c:pt>
                <c:pt idx="8430">
                  <c:v>1.6984388753242492</c:v>
                </c:pt>
                <c:pt idx="8431">
                  <c:v>1.6971324344737184</c:v>
                </c:pt>
                <c:pt idx="8432">
                  <c:v>1.6941662959331982</c:v>
                </c:pt>
                <c:pt idx="8433">
                  <c:v>1.6937269489236471</c:v>
                </c:pt>
                <c:pt idx="8434">
                  <c:v>1.6930915508850632</c:v>
                </c:pt>
                <c:pt idx="8435">
                  <c:v>1.6926021497943922</c:v>
                </c:pt>
                <c:pt idx="8436">
                  <c:v>1.6915726088573169</c:v>
                </c:pt>
                <c:pt idx="8437">
                  <c:v>1.6901960800285136</c:v>
                </c:pt>
                <c:pt idx="8438">
                  <c:v>1.6893088591236203</c:v>
                </c:pt>
                <c:pt idx="8439">
                  <c:v>1.6888645680547918</c:v>
                </c:pt>
                <c:pt idx="8440">
                  <c:v>1.6877766059051009</c:v>
                </c:pt>
                <c:pt idx="8441">
                  <c:v>1.6857914831165959</c:v>
                </c:pt>
                <c:pt idx="8442">
                  <c:v>1.6838472125451809</c:v>
                </c:pt>
                <c:pt idx="8443">
                  <c:v>1.6835973164096807</c:v>
                </c:pt>
                <c:pt idx="8444">
                  <c:v>1.6804362427393573</c:v>
                </c:pt>
                <c:pt idx="8445">
                  <c:v>1.6767951870974154</c:v>
                </c:pt>
                <c:pt idx="8446">
                  <c:v>1.6752690247611284</c:v>
                </c:pt>
                <c:pt idx="8447">
                  <c:v>1.6752690247611284</c:v>
                </c:pt>
                <c:pt idx="8448">
                  <c:v>1.6729184429354509</c:v>
                </c:pt>
                <c:pt idx="8449">
                  <c:v>1.6719951757075755</c:v>
                </c:pt>
                <c:pt idx="8450">
                  <c:v>1.670967015942556</c:v>
                </c:pt>
                <c:pt idx="8451">
                  <c:v>1.6690067809585756</c:v>
                </c:pt>
                <c:pt idx="8452">
                  <c:v>1.6680751513945196</c:v>
                </c:pt>
                <c:pt idx="8453">
                  <c:v>1.6677641635674798</c:v>
                </c:pt>
                <c:pt idx="8454">
                  <c:v>1.6647464109256087</c:v>
                </c:pt>
                <c:pt idx="8455">
                  <c:v>1.664328518680805</c:v>
                </c:pt>
                <c:pt idx="8456">
                  <c:v>1.6629675851181089</c:v>
                </c:pt>
                <c:pt idx="8457">
                  <c:v>1.661391959438091</c:v>
                </c:pt>
                <c:pt idx="8458">
                  <c:v>1.6612867141978078</c:v>
                </c:pt>
                <c:pt idx="8459">
                  <c:v>1.6565772913961141</c:v>
                </c:pt>
                <c:pt idx="8460">
                  <c:v>1.6542300363021094</c:v>
                </c:pt>
                <c:pt idx="8461">
                  <c:v>1.6469480231760085</c:v>
                </c:pt>
                <c:pt idx="8462">
                  <c:v>1.644876055616038</c:v>
                </c:pt>
                <c:pt idx="8463">
                  <c:v>1.6438911363739128</c:v>
                </c:pt>
                <c:pt idx="8464">
                  <c:v>1.6433978378622238</c:v>
                </c:pt>
                <c:pt idx="8465">
                  <c:v>1.6409229053509047</c:v>
                </c:pt>
                <c:pt idx="8466">
                  <c:v>1.6393204428196495</c:v>
                </c:pt>
                <c:pt idx="8467">
                  <c:v>1.638045306512806</c:v>
                </c:pt>
                <c:pt idx="8468">
                  <c:v>1.6376009017854596</c:v>
                </c:pt>
                <c:pt idx="8469">
                  <c:v>1.6281049846450328</c:v>
                </c:pt>
                <c:pt idx="8470">
                  <c:v>1.625255273095499</c:v>
                </c:pt>
                <c:pt idx="8471">
                  <c:v>1.6232492903979006</c:v>
                </c:pt>
                <c:pt idx="8472">
                  <c:v>1.622098840766468</c:v>
                </c:pt>
                <c:pt idx="8473">
                  <c:v>1.6219260101684838</c:v>
                </c:pt>
                <c:pt idx="8474">
                  <c:v>1.6210030835745728</c:v>
                </c:pt>
                <c:pt idx="8475">
                  <c:v>1.6208298162744876</c:v>
                </c:pt>
                <c:pt idx="8476">
                  <c:v>1.6201939107630796</c:v>
                </c:pt>
                <c:pt idx="8477">
                  <c:v>1.6201360549737576</c:v>
                </c:pt>
                <c:pt idx="8478">
                  <c:v>1.6194411836544731</c:v>
                </c:pt>
                <c:pt idx="8479">
                  <c:v>1.619267291967704</c:v>
                </c:pt>
                <c:pt idx="8480">
                  <c:v>1.6182805884103126</c:v>
                </c:pt>
                <c:pt idx="8481">
                  <c:v>1.6182224771528628</c:v>
                </c:pt>
                <c:pt idx="8482">
                  <c:v>1.6153069554493786</c:v>
                </c:pt>
                <c:pt idx="8483">
                  <c:v>1.6135482010942113</c:v>
                </c:pt>
                <c:pt idx="8484">
                  <c:v>1.6117233080073419</c:v>
                </c:pt>
                <c:pt idx="8485">
                  <c:v>1.609712955556488</c:v>
                </c:pt>
                <c:pt idx="8486">
                  <c:v>1.609060549930087</c:v>
                </c:pt>
                <c:pt idx="8487">
                  <c:v>1.608526033577194</c:v>
                </c:pt>
                <c:pt idx="8488">
                  <c:v>1.6080503550171499</c:v>
                </c:pt>
                <c:pt idx="8489">
                  <c:v>1.6061424135326907</c:v>
                </c:pt>
                <c:pt idx="8490">
                  <c:v>1.6061424135326905</c:v>
                </c:pt>
                <c:pt idx="8491">
                  <c:v>1.6060826550899541</c:v>
                </c:pt>
                <c:pt idx="8492">
                  <c:v>1.6030842001944672</c:v>
                </c:pt>
                <c:pt idx="8493">
                  <c:v>1.6026025204202565</c:v>
                </c:pt>
                <c:pt idx="8494">
                  <c:v>1.6026025204202563</c:v>
                </c:pt>
                <c:pt idx="8495">
                  <c:v>1.60067044112901</c:v>
                </c:pt>
                <c:pt idx="8496">
                  <c:v>1.5975733129116907</c:v>
                </c:pt>
                <c:pt idx="8497">
                  <c:v>1.5946380531981901</c:v>
                </c:pt>
                <c:pt idx="8498">
                  <c:v>1.5941469086935933</c:v>
                </c:pt>
                <c:pt idx="8499">
                  <c:v>1.5934091489206443</c:v>
                </c:pt>
                <c:pt idx="8500">
                  <c:v>1.5864622738714373</c:v>
                </c:pt>
                <c:pt idx="8501">
                  <c:v>1.5837024498521619</c:v>
                </c:pt>
                <c:pt idx="8502">
                  <c:v>1.5835765856339494</c:v>
                </c:pt>
                <c:pt idx="8503">
                  <c:v>1.5823159331322052</c:v>
                </c:pt>
                <c:pt idx="8504">
                  <c:v>1.5802912465657908</c:v>
                </c:pt>
                <c:pt idx="8505">
                  <c:v>1.5796565913572698</c:v>
                </c:pt>
                <c:pt idx="8506">
                  <c:v>1.5784481853413272</c:v>
                </c:pt>
                <c:pt idx="8507">
                  <c:v>1.5755726872053055</c:v>
                </c:pt>
                <c:pt idx="8508">
                  <c:v>1.5755726872053055</c:v>
                </c:pt>
                <c:pt idx="8509">
                  <c:v>1.5754444443335915</c:v>
                </c:pt>
                <c:pt idx="8510">
                  <c:v>1.5750594883486557</c:v>
                </c:pt>
                <c:pt idx="8511">
                  <c:v>1.5749310938223982</c:v>
                </c:pt>
                <c:pt idx="8512">
                  <c:v>1.5733229512683964</c:v>
                </c:pt>
                <c:pt idx="8513">
                  <c:v>1.5732585015417953</c:v>
                </c:pt>
                <c:pt idx="8514">
                  <c:v>1.5725489225794962</c:v>
                </c:pt>
                <c:pt idx="8515">
                  <c:v>1.5719674944023394</c:v>
                </c:pt>
                <c:pt idx="8516">
                  <c:v>1.5687230860526618</c:v>
                </c:pt>
                <c:pt idx="8517">
                  <c:v>1.5675491401997985</c:v>
                </c:pt>
                <c:pt idx="8518">
                  <c:v>1.5634810853944106</c:v>
                </c:pt>
                <c:pt idx="8519">
                  <c:v>1.5633492212725828</c:v>
                </c:pt>
                <c:pt idx="8520">
                  <c:v>1.5626892994286878</c:v>
                </c:pt>
                <c:pt idx="8521">
                  <c:v>1.5616975326539935</c:v>
                </c:pt>
                <c:pt idx="8522">
                  <c:v>1.560105979862612</c:v>
                </c:pt>
                <c:pt idx="8523">
                  <c:v>1.5575740318637652</c:v>
                </c:pt>
                <c:pt idx="8524">
                  <c:v>1.5552288426632237</c:v>
                </c:pt>
                <c:pt idx="8525">
                  <c:v>1.5497523393264991</c:v>
                </c:pt>
                <c:pt idx="8526">
                  <c:v>1.54927580328475</c:v>
                </c:pt>
                <c:pt idx="8527">
                  <c:v>1.5492076840026867</c:v>
                </c:pt>
                <c:pt idx="8528">
                  <c:v>1.5491395540344077</c:v>
                </c:pt>
                <c:pt idx="8529">
                  <c:v>1.5483211596680386</c:v>
                </c:pt>
                <c:pt idx="8530">
                  <c:v>1.5470906692062412</c:v>
                </c:pt>
                <c:pt idx="8531">
                  <c:v>1.5396336014134979</c:v>
                </c:pt>
                <c:pt idx="8532">
                  <c:v>1.5396336014134979</c:v>
                </c:pt>
                <c:pt idx="8533">
                  <c:v>1.5386575016693786</c:v>
                </c:pt>
                <c:pt idx="8534">
                  <c:v>1.5383083622648497</c:v>
                </c:pt>
                <c:pt idx="8535">
                  <c:v>1.5381686278743576</c:v>
                </c:pt>
                <c:pt idx="8536">
                  <c:v>1.5372592567980015</c:v>
                </c:pt>
                <c:pt idx="8537">
                  <c:v>1.5271284473932238</c:v>
                </c:pt>
                <c:pt idx="8538">
                  <c:v>1.5259082158339554</c:v>
                </c:pt>
                <c:pt idx="8539">
                  <c:v>1.5254047693300619</c:v>
                </c:pt>
                <c:pt idx="8540">
                  <c:v>1.5207745660784737</c:v>
                </c:pt>
                <c:pt idx="8541">
                  <c:v>1.5182213871676646</c:v>
                </c:pt>
                <c:pt idx="8542">
                  <c:v>1.5111403420090934</c:v>
                </c:pt>
                <c:pt idx="8543">
                  <c:v>1.5109171882068539</c:v>
                </c:pt>
                <c:pt idx="8544">
                  <c:v>1.5086793209300182</c:v>
                </c:pt>
                <c:pt idx="8545">
                  <c:v>1.5056021329488829</c:v>
                </c:pt>
                <c:pt idx="8546">
                  <c:v>1.5055268065274117</c:v>
                </c:pt>
                <c:pt idx="8547">
                  <c:v>1.50454637227152</c:v>
                </c:pt>
                <c:pt idx="8548">
                  <c:v>1.5019716459186641</c:v>
                </c:pt>
                <c:pt idx="8549">
                  <c:v>1.501591718957243</c:v>
                </c:pt>
                <c:pt idx="8550">
                  <c:v>1.4974671888320221</c:v>
                </c:pt>
                <c:pt idx="8551">
                  <c:v>1.4970064803568126</c:v>
                </c:pt>
                <c:pt idx="8552">
                  <c:v>1.4966221829404414</c:v>
                </c:pt>
                <c:pt idx="8553">
                  <c:v>1.4963144999790043</c:v>
                </c:pt>
                <c:pt idx="8554">
                  <c:v>1.4942319187728361</c:v>
                </c:pt>
                <c:pt idx="8555">
                  <c:v>1.4939225371163662</c:v>
                </c:pt>
                <c:pt idx="8556">
                  <c:v>1.4890987222285545</c:v>
                </c:pt>
                <c:pt idx="8557">
                  <c:v>1.4871383754771865</c:v>
                </c:pt>
                <c:pt idx="8558">
                  <c:v>1.485011214578573</c:v>
                </c:pt>
                <c:pt idx="8559">
                  <c:v>1.4848532318624246</c:v>
                </c:pt>
                <c:pt idx="8560">
                  <c:v>1.4827148212301247</c:v>
                </c:pt>
                <c:pt idx="8561">
                  <c:v>1.4819996714322372</c:v>
                </c:pt>
                <c:pt idx="8562">
                  <c:v>1.4794473365523737</c:v>
                </c:pt>
                <c:pt idx="8563">
                  <c:v>1.4766384370135663</c:v>
                </c:pt>
                <c:pt idx="8564">
                  <c:v>1.4751867549424629</c:v>
                </c:pt>
                <c:pt idx="8565">
                  <c:v>1.4730812769179222</c:v>
                </c:pt>
                <c:pt idx="8566">
                  <c:v>1.470557485217274</c:v>
                </c:pt>
                <c:pt idx="8567">
                  <c:v>1.4699037963158312</c:v>
                </c:pt>
                <c:pt idx="8568">
                  <c:v>1.469822015978163</c:v>
                </c:pt>
                <c:pt idx="8569">
                  <c:v>1.4688394488579062</c:v>
                </c:pt>
                <c:pt idx="8570">
                  <c:v>1.4675258917675993</c:v>
                </c:pt>
                <c:pt idx="8571">
                  <c:v>1.4674436623851888</c:v>
                </c:pt>
                <c:pt idx="8572">
                  <c:v>1.467196880780725</c:v>
                </c:pt>
                <c:pt idx="8573">
                  <c:v>1.4630630738052006</c:v>
                </c:pt>
                <c:pt idx="8574">
                  <c:v>1.4629799949944444</c:v>
                </c:pt>
                <c:pt idx="8575">
                  <c:v>1.4609813207927305</c:v>
                </c:pt>
                <c:pt idx="8576">
                  <c:v>1.458973405914588</c:v>
                </c:pt>
                <c:pt idx="8577">
                  <c:v>1.454675511407455</c:v>
                </c:pt>
                <c:pt idx="8578">
                  <c:v>1.4533183400470377</c:v>
                </c:pt>
                <c:pt idx="8579">
                  <c:v>1.4527232413196229</c:v>
                </c:pt>
                <c:pt idx="8580">
                  <c:v>1.4509330367786646</c:v>
                </c:pt>
                <c:pt idx="8581">
                  <c:v>1.4499067397703702</c:v>
                </c:pt>
                <c:pt idx="8582">
                  <c:v>1.4481908367799872</c:v>
                </c:pt>
                <c:pt idx="8583">
                  <c:v>1.4443918150990673</c:v>
                </c:pt>
                <c:pt idx="8584">
                  <c:v>1.4440447959180762</c:v>
                </c:pt>
                <c:pt idx="8585">
                  <c:v>1.4416951356407171</c:v>
                </c:pt>
                <c:pt idx="8586">
                  <c:v>1.4389816069219725</c:v>
                </c:pt>
                <c:pt idx="8587">
                  <c:v>1.4373981940530629</c:v>
                </c:pt>
                <c:pt idx="8588">
                  <c:v>1.4372219023997783</c:v>
                </c:pt>
                <c:pt idx="8589">
                  <c:v>1.436162647040756</c:v>
                </c:pt>
                <c:pt idx="8590">
                  <c:v>1.4358974290282978</c:v>
                </c:pt>
                <c:pt idx="8591">
                  <c:v>1.4344801910358504</c:v>
                </c:pt>
                <c:pt idx="8592">
                  <c:v>1.4342139432609418</c:v>
                </c:pt>
                <c:pt idx="8593">
                  <c:v>1.4304692334989575</c:v>
                </c:pt>
                <c:pt idx="8594">
                  <c:v>1.4269628517992581</c:v>
                </c:pt>
                <c:pt idx="8595">
                  <c:v>1.4196804429452592</c:v>
                </c:pt>
                <c:pt idx="8596">
                  <c:v>1.415529779157638</c:v>
                </c:pt>
                <c:pt idx="8597">
                  <c:v>1.4086167935193552</c:v>
                </c:pt>
                <c:pt idx="8598">
                  <c:v>1.4078628098544481</c:v>
                </c:pt>
                <c:pt idx="8599">
                  <c:v>1.4060668349027339</c:v>
                </c:pt>
                <c:pt idx="8600">
                  <c:v>1.4030251452048839</c:v>
                </c:pt>
                <c:pt idx="8601">
                  <c:v>1.4029297482837086</c:v>
                </c:pt>
                <c:pt idx="8602">
                  <c:v>1.3983258767399838</c:v>
                </c:pt>
                <c:pt idx="8603">
                  <c:v>1.396973835900017</c:v>
                </c:pt>
                <c:pt idx="8604">
                  <c:v>1.3966835644297682</c:v>
                </c:pt>
                <c:pt idx="8605">
                  <c:v>1.3961024388097372</c:v>
                </c:pt>
                <c:pt idx="8606">
                  <c:v>1.3941597181383105</c:v>
                </c:pt>
                <c:pt idx="8607">
                  <c:v>1.3933801900279168</c:v>
                </c:pt>
                <c:pt idx="8608">
                  <c:v>1.390837016875542</c:v>
                </c:pt>
                <c:pt idx="8609">
                  <c:v>1.3897565596178365</c:v>
                </c:pt>
                <c:pt idx="8610">
                  <c:v>1.3886734076447607</c:v>
                </c:pt>
                <c:pt idx="8611">
                  <c:v>1.3876863743064847</c:v>
                </c:pt>
                <c:pt idx="8612">
                  <c:v>1.3784988409792494</c:v>
                </c:pt>
                <c:pt idx="8613">
                  <c:v>1.3757651914334343</c:v>
                </c:pt>
                <c:pt idx="8614">
                  <c:v>1.3693189540235418</c:v>
                </c:pt>
                <c:pt idx="8615">
                  <c:v>1.368286884902131</c:v>
                </c:pt>
                <c:pt idx="8616">
                  <c:v>1.3639252106896413</c:v>
                </c:pt>
                <c:pt idx="8617">
                  <c:v>1.3610979671879633</c:v>
                </c:pt>
                <c:pt idx="8618">
                  <c:v>1.360887807744277</c:v>
                </c:pt>
                <c:pt idx="8619">
                  <c:v>1.36078268987328</c:v>
                </c:pt>
                <c:pt idx="8620">
                  <c:v>1.3594138371787066</c:v>
                </c:pt>
                <c:pt idx="8621">
                  <c:v>1.3590973344449826</c:v>
                </c:pt>
                <c:pt idx="8622">
                  <c:v>1.3521825181113625</c:v>
                </c:pt>
                <c:pt idx="8623">
                  <c:v>1.3515386418156574</c:v>
                </c:pt>
                <c:pt idx="8624">
                  <c:v>1.350140293049745</c:v>
                </c:pt>
                <c:pt idx="8625">
                  <c:v>1.3471130850017992</c:v>
                </c:pt>
                <c:pt idx="8626">
                  <c:v>1.3428611407099316</c:v>
                </c:pt>
                <c:pt idx="8627">
                  <c:v>1.3411046388942931</c:v>
                </c:pt>
                <c:pt idx="8628">
                  <c:v>1.3405542719699171</c:v>
                </c:pt>
                <c:pt idx="8629">
                  <c:v>1.333783025949038</c:v>
                </c:pt>
                <c:pt idx="8630">
                  <c:v>1.3238248214493376</c:v>
                </c:pt>
                <c:pt idx="8631">
                  <c:v>1.323252100171687</c:v>
                </c:pt>
                <c:pt idx="8632">
                  <c:v>1.3188745590474167</c:v>
                </c:pt>
                <c:pt idx="8633">
                  <c:v>1.3117538610557542</c:v>
                </c:pt>
                <c:pt idx="8634">
                  <c:v>1.3101029976107677</c:v>
                </c:pt>
                <c:pt idx="8635">
                  <c:v>1.3071393278464214</c:v>
                </c:pt>
                <c:pt idx="8636">
                  <c:v>1.3070203593531686</c:v>
                </c:pt>
                <c:pt idx="8637">
                  <c:v>1.3063058631976545</c:v>
                </c:pt>
                <c:pt idx="8638">
                  <c:v>1.305470795951406</c:v>
                </c:pt>
                <c:pt idx="8639">
                  <c:v>1.2966651902615312</c:v>
                </c:pt>
                <c:pt idx="8640">
                  <c:v>1.2915168465279521</c:v>
                </c:pt>
                <c:pt idx="8641">
                  <c:v>1.2855573090077737</c:v>
                </c:pt>
                <c:pt idx="8642">
                  <c:v>1.281412167517624</c:v>
                </c:pt>
                <c:pt idx="8643">
                  <c:v>1.2802747740733618</c:v>
                </c:pt>
                <c:pt idx="8644">
                  <c:v>1.2740294926846745</c:v>
                </c:pt>
                <c:pt idx="8645">
                  <c:v>1.2692534315230697</c:v>
                </c:pt>
                <c:pt idx="8646">
                  <c:v>1.2671717284030137</c:v>
                </c:pt>
                <c:pt idx="8647">
                  <c:v>1.2502844335605157</c:v>
                </c:pt>
                <c:pt idx="8648">
                  <c:v>1.2445519907362737</c:v>
                </c:pt>
                <c:pt idx="8649">
                  <c:v>1.2404105625136093</c:v>
                </c:pt>
                <c:pt idx="8650">
                  <c:v>1.2390212635620266</c:v>
                </c:pt>
                <c:pt idx="8651">
                  <c:v>1.2324313580604203</c:v>
                </c:pt>
                <c:pt idx="8652">
                  <c:v>1.2231496826367745</c:v>
                </c:pt>
                <c:pt idx="8653">
                  <c:v>1.2206890840891176</c:v>
                </c:pt>
                <c:pt idx="8654">
                  <c:v>1.2078736316230434</c:v>
                </c:pt>
                <c:pt idx="8655">
                  <c:v>1.1929699075311331</c:v>
                </c:pt>
                <c:pt idx="8656">
                  <c:v>1.1879904823553891</c:v>
                </c:pt>
                <c:pt idx="8657">
                  <c:v>1.1879904823553891</c:v>
                </c:pt>
                <c:pt idx="8658">
                  <c:v>1.1784973288215597</c:v>
                </c:pt>
                <c:pt idx="8659">
                  <c:v>1.1723758660836265</c:v>
                </c:pt>
                <c:pt idx="8660">
                  <c:v>1.166331421766525</c:v>
                </c:pt>
                <c:pt idx="8661">
                  <c:v>1.1658376246901283</c:v>
                </c:pt>
                <c:pt idx="8662">
                  <c:v>1.1636913256003165</c:v>
                </c:pt>
                <c:pt idx="8663">
                  <c:v>1.159700842867512</c:v>
                </c:pt>
                <c:pt idx="8664">
                  <c:v>1.1306910654973912</c:v>
                </c:pt>
                <c:pt idx="8665">
                  <c:v>1.1289016337037274</c:v>
                </c:pt>
                <c:pt idx="8666">
                  <c:v>1.109840926524271</c:v>
                </c:pt>
                <c:pt idx="8667">
                  <c:v>1.1070214328609251</c:v>
                </c:pt>
                <c:pt idx="8668">
                  <c:v>1.0885298280583491</c:v>
                </c:pt>
                <c:pt idx="8669">
                  <c:v>1.0765595393329426</c:v>
                </c:pt>
                <c:pt idx="8670">
                  <c:v>1.0609075937901464</c:v>
                </c:pt>
                <c:pt idx="8671">
                  <c:v>1.0545704996127645</c:v>
                </c:pt>
                <c:pt idx="8672">
                  <c:v>1.0459745835329053</c:v>
                </c:pt>
                <c:pt idx="8673">
                  <c:v>1.0347621062592121</c:v>
                </c:pt>
                <c:pt idx="8674">
                  <c:v>1.0268962732013356</c:v>
                </c:pt>
                <c:pt idx="8675">
                  <c:v>1.0243944389451494</c:v>
                </c:pt>
                <c:pt idx="8676">
                  <c:v>1.0142404391146103</c:v>
                </c:pt>
                <c:pt idx="8677">
                  <c:v>0.99927557200566774</c:v>
                </c:pt>
                <c:pt idx="8678">
                  <c:v>0.99490344298061906</c:v>
                </c:pt>
                <c:pt idx="8679">
                  <c:v>0.94448267215016868</c:v>
                </c:pt>
                <c:pt idx="8680">
                  <c:v>0.93253013361511317</c:v>
                </c:pt>
                <c:pt idx="8681">
                  <c:v>0.92856653195311512</c:v>
                </c:pt>
                <c:pt idx="8682">
                  <c:v>0.90729190141971294</c:v>
                </c:pt>
                <c:pt idx="8683">
                  <c:v>0.90248638094355771</c:v>
                </c:pt>
                <c:pt idx="8684">
                  <c:v>0.83814918005892902</c:v>
                </c:pt>
                <c:pt idx="8685">
                  <c:v>0.8235466779955426</c:v>
                </c:pt>
                <c:pt idx="8686">
                  <c:v>0.79161268573440402</c:v>
                </c:pt>
                <c:pt idx="8687">
                  <c:v>0.69655053021260593</c:v>
                </c:pt>
                <c:pt idx="8688">
                  <c:v>0.68274659237290425</c:v>
                </c:pt>
                <c:pt idx="8689">
                  <c:v>0.664328518680805</c:v>
                </c:pt>
              </c:numCache>
            </c:numRef>
          </c:yVal>
          <c:smooth val="0"/>
          <c:extLst>
            <c:ext xmlns:c16="http://schemas.microsoft.com/office/drawing/2014/chart" uri="{C3380CC4-5D6E-409C-BE32-E72D297353CC}">
              <c16:uniqueId val="{00000000-6ADE-4F27-9622-74455B836F38}"/>
            </c:ext>
          </c:extLst>
        </c:ser>
        <c:dLbls>
          <c:showLegendKey val="0"/>
          <c:showVal val="0"/>
          <c:showCatName val="0"/>
          <c:showSerName val="0"/>
          <c:showPercent val="0"/>
          <c:showBubbleSize val="0"/>
        </c:dLbls>
        <c:axId val="386209136"/>
        <c:axId val="386223696"/>
      </c:scatterChart>
      <c:valAx>
        <c:axId val="386209136"/>
        <c:scaling>
          <c:orientation val="minMax"/>
        </c:scaling>
        <c:delete val="1"/>
        <c:axPos val="b"/>
        <c:majorTickMark val="out"/>
        <c:minorTickMark val="none"/>
        <c:tickLblPos val="nextTo"/>
        <c:crossAx val="386223696"/>
        <c:crosses val="autoZero"/>
        <c:crossBetween val="midCat"/>
      </c:valAx>
      <c:valAx>
        <c:axId val="386223696"/>
        <c:scaling>
          <c:orientation val="minMax"/>
        </c:scaling>
        <c:delete val="1"/>
        <c:axPos val="l"/>
        <c:numFmt formatCode="General" sourceLinked="1"/>
        <c:majorTickMark val="out"/>
        <c:minorTickMark val="none"/>
        <c:tickLblPos val="nextTo"/>
        <c:crossAx val="386209136"/>
        <c:crosses val="autoZero"/>
        <c:crossBetween val="midCat"/>
      </c:valAx>
      <c:spPr>
        <a:noFill/>
        <a:ln w="25400">
          <a:noFill/>
        </a:ln>
        <a:effectLst/>
      </c:spPr>
    </c:plotArea>
    <c:plotVisOnly val="1"/>
    <c:dispBlanksAs val="gap"/>
    <c:showDLblsOverMax val="0"/>
  </c:chart>
  <c:spPr>
    <a:noFill/>
    <a:ln>
      <a:noFill/>
    </a:ln>
    <a:effectLst/>
  </c:spPr>
  <c:txPr>
    <a:bodyPr/>
    <a:lstStyle/>
    <a:p>
      <a:pPr>
        <a:defRPr/>
      </a:pPr>
      <a:endParaRPr lang="ko-K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image" Target="../media/image1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6400" cy="498475"/>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9688" y="0"/>
            <a:ext cx="2946400" cy="498475"/>
          </a:xfrm>
          <a:prstGeom prst="rect">
            <a:avLst/>
          </a:prstGeom>
        </p:spPr>
        <p:txBody>
          <a:bodyPr vert="horz" lIns="91440" tIns="45720" rIns="91440" bIns="45720" rtlCol="0"/>
          <a:lstStyle>
            <a:lvl1pPr algn="r">
              <a:defRPr sz="1200"/>
            </a:lvl1pPr>
          </a:lstStyle>
          <a:p>
            <a:fld id="{8A914B18-6D69-4180-80C8-E7B6BDB6E7F8}" type="datetimeFigureOut">
              <a:rPr lang="ko-KR" altLang="en-US" smtClean="0"/>
              <a:t>2020-04-06</a:t>
            </a:fld>
            <a:endParaRPr lang="ko-KR" altLang="en-US"/>
          </a:p>
        </p:txBody>
      </p:sp>
      <p:sp>
        <p:nvSpPr>
          <p:cNvPr id="4" name="슬라이드 이미지 개체 틀 3"/>
          <p:cNvSpPr>
            <a:spLocks noGrp="1" noRot="1" noChangeAspect="1"/>
          </p:cNvSpPr>
          <p:nvPr>
            <p:ph type="sldImg" idx="2"/>
          </p:nvPr>
        </p:nvSpPr>
        <p:spPr>
          <a:xfrm>
            <a:off x="2224088" y="1241425"/>
            <a:ext cx="2349500" cy="3349625"/>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450" y="4778375"/>
            <a:ext cx="5438775" cy="3908425"/>
          </a:xfrm>
          <a:prstGeom prst="rect">
            <a:avLst/>
          </a:prstGeom>
        </p:spPr>
        <p:txBody>
          <a:bodyPr vert="horz" lIns="91440" tIns="45720" rIns="91440" bIns="45720" rtlCol="0"/>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9429750"/>
            <a:ext cx="2946400" cy="498475"/>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9688" y="9429750"/>
            <a:ext cx="2946400" cy="498475"/>
          </a:xfrm>
          <a:prstGeom prst="rect">
            <a:avLst/>
          </a:prstGeom>
        </p:spPr>
        <p:txBody>
          <a:bodyPr vert="horz" lIns="91440" tIns="45720" rIns="91440" bIns="45720" rtlCol="0" anchor="b"/>
          <a:lstStyle>
            <a:lvl1pPr algn="r">
              <a:defRPr sz="1200"/>
            </a:lvl1pPr>
          </a:lstStyle>
          <a:p>
            <a:fld id="{856220E8-1C50-4220-9EA3-25AD4D705C75}" type="slidenum">
              <a:rPr lang="ko-KR" altLang="en-US" smtClean="0"/>
              <a:t>‹#›</a:t>
            </a:fld>
            <a:endParaRPr lang="ko-KR" altLang="en-US"/>
          </a:p>
        </p:txBody>
      </p:sp>
    </p:spTree>
    <p:extLst>
      <p:ext uri="{BB962C8B-B14F-4D97-AF65-F5344CB8AC3E}">
        <p14:creationId xmlns:p14="http://schemas.microsoft.com/office/powerpoint/2010/main" val="1815937778"/>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856220E8-1C50-4220-9EA3-25AD4D705C75}" type="slidenum">
              <a:rPr lang="ko-KR" altLang="en-US" smtClean="0"/>
              <a:t>3</a:t>
            </a:fld>
            <a:endParaRPr lang="ko-KR" altLang="en-US"/>
          </a:p>
        </p:txBody>
      </p:sp>
    </p:spTree>
    <p:extLst>
      <p:ext uri="{BB962C8B-B14F-4D97-AF65-F5344CB8AC3E}">
        <p14:creationId xmlns:p14="http://schemas.microsoft.com/office/powerpoint/2010/main" val="74534430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856220E8-1C50-4220-9EA3-25AD4D705C75}" type="slidenum">
              <a:rPr lang="ko-KR" altLang="en-US" smtClean="0"/>
              <a:t>8</a:t>
            </a:fld>
            <a:endParaRPr lang="ko-KR" altLang="en-US"/>
          </a:p>
        </p:txBody>
      </p:sp>
    </p:spTree>
    <p:extLst>
      <p:ext uri="{BB962C8B-B14F-4D97-AF65-F5344CB8AC3E}">
        <p14:creationId xmlns:p14="http://schemas.microsoft.com/office/powerpoint/2010/main" val="7079309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a:p>
        </p:txBody>
      </p:sp>
      <p:sp>
        <p:nvSpPr>
          <p:cNvPr id="4" name="슬라이드 번호 개체 틀 3"/>
          <p:cNvSpPr>
            <a:spLocks noGrp="1"/>
          </p:cNvSpPr>
          <p:nvPr>
            <p:ph type="sldNum" sz="quarter" idx="10"/>
          </p:nvPr>
        </p:nvSpPr>
        <p:spPr/>
        <p:txBody>
          <a:bodyPr/>
          <a:lstStyle/>
          <a:p>
            <a:fld id="{856220E8-1C50-4220-9EA3-25AD4D705C75}" type="slidenum">
              <a:rPr lang="ko-KR" altLang="en-US" smtClean="0"/>
              <a:t>12</a:t>
            </a:fld>
            <a:endParaRPr lang="ko-KR" altLang="en-US"/>
          </a:p>
        </p:txBody>
      </p:sp>
    </p:spTree>
    <p:extLst>
      <p:ext uri="{BB962C8B-B14F-4D97-AF65-F5344CB8AC3E}">
        <p14:creationId xmlns:p14="http://schemas.microsoft.com/office/powerpoint/2010/main" val="39694393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1080016" y="3358255"/>
            <a:ext cx="12240181" cy="7144009"/>
          </a:xfrm>
        </p:spPr>
        <p:txBody>
          <a:bodyPr anchor="b"/>
          <a:lstStyle>
            <a:lvl1pPr algn="ctr">
              <a:defRPr sz="9449"/>
            </a:lvl1pPr>
          </a:lstStyle>
          <a:p>
            <a:r>
              <a:rPr lang="ko-KR" altLang="en-US" smtClean="0"/>
              <a:t>마스터 제목 스타일 편집</a:t>
            </a:r>
            <a:endParaRPr lang="en-US" dirty="0"/>
          </a:p>
        </p:txBody>
      </p:sp>
      <p:sp>
        <p:nvSpPr>
          <p:cNvPr id="3" name="Subtitle 2"/>
          <p:cNvSpPr>
            <a:spLocks noGrp="1"/>
          </p:cNvSpPr>
          <p:nvPr>
            <p:ph type="subTitle" idx="1"/>
          </p:nvPr>
        </p:nvSpPr>
        <p:spPr>
          <a:xfrm>
            <a:off x="1800027" y="10777764"/>
            <a:ext cx="10800160" cy="4954255"/>
          </a:xfrm>
        </p:spPr>
        <p:txBody>
          <a:bodyPr/>
          <a:lstStyle>
            <a:lvl1pPr marL="0" indent="0" algn="ctr">
              <a:buNone/>
              <a:defRPr sz="3780"/>
            </a:lvl1pPr>
            <a:lvl2pPr marL="719999" indent="0" algn="ctr">
              <a:buNone/>
              <a:defRPr sz="3150"/>
            </a:lvl2pPr>
            <a:lvl3pPr marL="1439997" indent="0" algn="ctr">
              <a:buNone/>
              <a:defRPr sz="2835"/>
            </a:lvl3pPr>
            <a:lvl4pPr marL="2159996" indent="0" algn="ctr">
              <a:buNone/>
              <a:defRPr sz="2520"/>
            </a:lvl4pPr>
            <a:lvl5pPr marL="2879994" indent="0" algn="ctr">
              <a:buNone/>
              <a:defRPr sz="2520"/>
            </a:lvl5pPr>
            <a:lvl6pPr marL="3599993" indent="0" algn="ctr">
              <a:buNone/>
              <a:defRPr sz="2520"/>
            </a:lvl6pPr>
            <a:lvl7pPr marL="4319991" indent="0" algn="ctr">
              <a:buNone/>
              <a:defRPr sz="2520"/>
            </a:lvl7pPr>
            <a:lvl8pPr marL="5039990" indent="0" algn="ctr">
              <a:buNone/>
              <a:defRPr sz="2520"/>
            </a:lvl8pPr>
            <a:lvl9pPr marL="5759988" indent="0" algn="ctr">
              <a:buNone/>
              <a:defRPr sz="2520"/>
            </a:lvl9pPr>
          </a:lstStyle>
          <a:p>
            <a:r>
              <a:rPr lang="ko-KR" altLang="en-US" smtClean="0"/>
              <a:t>클릭하여 마스터 부제목 스타일 편집</a:t>
            </a:r>
            <a:endParaRPr lang="en-US" dirty="0"/>
          </a:p>
        </p:txBody>
      </p:sp>
      <p:sp>
        <p:nvSpPr>
          <p:cNvPr id="4" name="Date Placeholder 3"/>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38714913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34993860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305153" y="1092501"/>
            <a:ext cx="3105046" cy="17389773"/>
          </a:xfrm>
        </p:spPr>
        <p:txBody>
          <a:bodyPr vert="eaVert"/>
          <a:lstStyle/>
          <a:p>
            <a:r>
              <a:rPr lang="ko-KR" altLang="en-US" smtClean="0"/>
              <a:t>마스터 제목 스타일 편집</a:t>
            </a:r>
            <a:endParaRPr lang="en-US" dirty="0"/>
          </a:p>
        </p:txBody>
      </p:sp>
      <p:sp>
        <p:nvSpPr>
          <p:cNvPr id="3" name="Vertical Text Placeholder 2"/>
          <p:cNvSpPr>
            <a:spLocks noGrp="1"/>
          </p:cNvSpPr>
          <p:nvPr>
            <p:ph type="body" orient="vert" idx="1"/>
          </p:nvPr>
        </p:nvSpPr>
        <p:spPr>
          <a:xfrm>
            <a:off x="990015" y="1092501"/>
            <a:ext cx="9135135" cy="17389773"/>
          </a:xfrm>
        </p:spPr>
        <p:txBody>
          <a:bodyPr vert="eaVert"/>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26106541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idx="1"/>
          </p:nvPr>
        </p:nvSpPr>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4938797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982515" y="5115762"/>
            <a:ext cx="12420184" cy="8535759"/>
          </a:xfrm>
        </p:spPr>
        <p:txBody>
          <a:bodyPr anchor="b"/>
          <a:lstStyle>
            <a:lvl1pPr>
              <a:defRPr sz="9449"/>
            </a:lvl1pPr>
          </a:lstStyle>
          <a:p>
            <a:r>
              <a:rPr lang="ko-KR" altLang="en-US" smtClean="0"/>
              <a:t>마스터 제목 스타일 편집</a:t>
            </a:r>
            <a:endParaRPr lang="en-US" dirty="0"/>
          </a:p>
        </p:txBody>
      </p:sp>
      <p:sp>
        <p:nvSpPr>
          <p:cNvPr id="3" name="Text Placeholder 2"/>
          <p:cNvSpPr>
            <a:spLocks noGrp="1"/>
          </p:cNvSpPr>
          <p:nvPr>
            <p:ph type="body" idx="1"/>
          </p:nvPr>
        </p:nvSpPr>
        <p:spPr>
          <a:xfrm>
            <a:off x="982515" y="13732273"/>
            <a:ext cx="12420184" cy="4488754"/>
          </a:xfrm>
        </p:spPr>
        <p:txBody>
          <a:bodyPr/>
          <a:lstStyle>
            <a:lvl1pPr marL="0" indent="0">
              <a:buNone/>
              <a:defRPr sz="3780">
                <a:solidFill>
                  <a:schemeClr val="tx1"/>
                </a:solidFill>
              </a:defRPr>
            </a:lvl1pPr>
            <a:lvl2pPr marL="719999" indent="0">
              <a:buNone/>
              <a:defRPr sz="3150">
                <a:solidFill>
                  <a:schemeClr val="tx1">
                    <a:tint val="75000"/>
                  </a:schemeClr>
                </a:solidFill>
              </a:defRPr>
            </a:lvl2pPr>
            <a:lvl3pPr marL="1439997" indent="0">
              <a:buNone/>
              <a:defRPr sz="2835">
                <a:solidFill>
                  <a:schemeClr val="tx1">
                    <a:tint val="75000"/>
                  </a:schemeClr>
                </a:solidFill>
              </a:defRPr>
            </a:lvl3pPr>
            <a:lvl4pPr marL="2159996" indent="0">
              <a:buNone/>
              <a:defRPr sz="2520">
                <a:solidFill>
                  <a:schemeClr val="tx1">
                    <a:tint val="75000"/>
                  </a:schemeClr>
                </a:solidFill>
              </a:defRPr>
            </a:lvl4pPr>
            <a:lvl5pPr marL="2879994" indent="0">
              <a:buNone/>
              <a:defRPr sz="2520">
                <a:solidFill>
                  <a:schemeClr val="tx1">
                    <a:tint val="75000"/>
                  </a:schemeClr>
                </a:solidFill>
              </a:defRPr>
            </a:lvl5pPr>
            <a:lvl6pPr marL="3599993" indent="0">
              <a:buNone/>
              <a:defRPr sz="2520">
                <a:solidFill>
                  <a:schemeClr val="tx1">
                    <a:tint val="75000"/>
                  </a:schemeClr>
                </a:solidFill>
              </a:defRPr>
            </a:lvl6pPr>
            <a:lvl7pPr marL="4319991" indent="0">
              <a:buNone/>
              <a:defRPr sz="2520">
                <a:solidFill>
                  <a:schemeClr val="tx1">
                    <a:tint val="75000"/>
                  </a:schemeClr>
                </a:solidFill>
              </a:defRPr>
            </a:lvl7pPr>
            <a:lvl8pPr marL="5039990" indent="0">
              <a:buNone/>
              <a:defRPr sz="2520">
                <a:solidFill>
                  <a:schemeClr val="tx1">
                    <a:tint val="75000"/>
                  </a:schemeClr>
                </a:solidFill>
              </a:defRPr>
            </a:lvl8pPr>
            <a:lvl9pPr marL="5759988" indent="0">
              <a:buNone/>
              <a:defRPr sz="2520">
                <a:solidFill>
                  <a:schemeClr val="tx1">
                    <a:tint val="75000"/>
                  </a:schemeClr>
                </a:solidFill>
              </a:defRPr>
            </a:lvl9pPr>
          </a:lstStyle>
          <a:p>
            <a:pPr lvl="0"/>
            <a:r>
              <a:rPr lang="ko-KR" altLang="en-US" smtClean="0"/>
              <a:t>마스터 텍스트 스타일 편집</a:t>
            </a:r>
          </a:p>
        </p:txBody>
      </p:sp>
      <p:sp>
        <p:nvSpPr>
          <p:cNvPr id="4" name="Date Placeholder 3"/>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4088829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Content Placeholder 2"/>
          <p:cNvSpPr>
            <a:spLocks noGrp="1"/>
          </p:cNvSpPr>
          <p:nvPr>
            <p:ph sz="half" idx="1"/>
          </p:nvPr>
        </p:nvSpPr>
        <p:spPr>
          <a:xfrm>
            <a:off x="990014" y="5462507"/>
            <a:ext cx="6120091" cy="13019767"/>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Content Placeholder 3"/>
          <p:cNvSpPr>
            <a:spLocks noGrp="1"/>
          </p:cNvSpPr>
          <p:nvPr>
            <p:ph sz="half" idx="2"/>
          </p:nvPr>
        </p:nvSpPr>
        <p:spPr>
          <a:xfrm>
            <a:off x="7290108" y="5462507"/>
            <a:ext cx="6120091" cy="13019767"/>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Date Placeholder 4"/>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8360757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991890" y="1092506"/>
            <a:ext cx="12420184" cy="3966256"/>
          </a:xfrm>
        </p:spPr>
        <p:txBody>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991892" y="5030257"/>
            <a:ext cx="6091964" cy="2465252"/>
          </a:xfrm>
        </p:spPr>
        <p:txBody>
          <a:bodyPr anchor="b"/>
          <a:lstStyle>
            <a:lvl1pPr marL="0" indent="0">
              <a:buNone/>
              <a:defRPr sz="3780" b="1"/>
            </a:lvl1pPr>
            <a:lvl2pPr marL="719999" indent="0">
              <a:buNone/>
              <a:defRPr sz="3150" b="1"/>
            </a:lvl2pPr>
            <a:lvl3pPr marL="1439997" indent="0">
              <a:buNone/>
              <a:defRPr sz="2835" b="1"/>
            </a:lvl3pPr>
            <a:lvl4pPr marL="2159996" indent="0">
              <a:buNone/>
              <a:defRPr sz="2520" b="1"/>
            </a:lvl4pPr>
            <a:lvl5pPr marL="2879994" indent="0">
              <a:buNone/>
              <a:defRPr sz="2520" b="1"/>
            </a:lvl5pPr>
            <a:lvl6pPr marL="3599993" indent="0">
              <a:buNone/>
              <a:defRPr sz="2520" b="1"/>
            </a:lvl6pPr>
            <a:lvl7pPr marL="4319991" indent="0">
              <a:buNone/>
              <a:defRPr sz="2520" b="1"/>
            </a:lvl7pPr>
            <a:lvl8pPr marL="5039990" indent="0">
              <a:buNone/>
              <a:defRPr sz="2520" b="1"/>
            </a:lvl8pPr>
            <a:lvl9pPr marL="5759988" indent="0">
              <a:buNone/>
              <a:defRPr sz="2520" b="1"/>
            </a:lvl9pPr>
          </a:lstStyle>
          <a:p>
            <a:pPr lvl="0"/>
            <a:r>
              <a:rPr lang="ko-KR" altLang="en-US" smtClean="0"/>
              <a:t>마스터 텍스트 스타일 편집</a:t>
            </a:r>
          </a:p>
        </p:txBody>
      </p:sp>
      <p:sp>
        <p:nvSpPr>
          <p:cNvPr id="4" name="Content Placeholder 3"/>
          <p:cNvSpPr>
            <a:spLocks noGrp="1"/>
          </p:cNvSpPr>
          <p:nvPr>
            <p:ph sz="half" idx="2"/>
          </p:nvPr>
        </p:nvSpPr>
        <p:spPr>
          <a:xfrm>
            <a:off x="991892" y="7495509"/>
            <a:ext cx="6091964" cy="11024765"/>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5" name="Text Placeholder 4"/>
          <p:cNvSpPr>
            <a:spLocks noGrp="1"/>
          </p:cNvSpPr>
          <p:nvPr>
            <p:ph type="body" sz="quarter" idx="3"/>
          </p:nvPr>
        </p:nvSpPr>
        <p:spPr>
          <a:xfrm>
            <a:off x="7290109" y="5030257"/>
            <a:ext cx="6121966" cy="2465252"/>
          </a:xfrm>
        </p:spPr>
        <p:txBody>
          <a:bodyPr anchor="b"/>
          <a:lstStyle>
            <a:lvl1pPr marL="0" indent="0">
              <a:buNone/>
              <a:defRPr sz="3780" b="1"/>
            </a:lvl1pPr>
            <a:lvl2pPr marL="719999" indent="0">
              <a:buNone/>
              <a:defRPr sz="3150" b="1"/>
            </a:lvl2pPr>
            <a:lvl3pPr marL="1439997" indent="0">
              <a:buNone/>
              <a:defRPr sz="2835" b="1"/>
            </a:lvl3pPr>
            <a:lvl4pPr marL="2159996" indent="0">
              <a:buNone/>
              <a:defRPr sz="2520" b="1"/>
            </a:lvl4pPr>
            <a:lvl5pPr marL="2879994" indent="0">
              <a:buNone/>
              <a:defRPr sz="2520" b="1"/>
            </a:lvl5pPr>
            <a:lvl6pPr marL="3599993" indent="0">
              <a:buNone/>
              <a:defRPr sz="2520" b="1"/>
            </a:lvl6pPr>
            <a:lvl7pPr marL="4319991" indent="0">
              <a:buNone/>
              <a:defRPr sz="2520" b="1"/>
            </a:lvl7pPr>
            <a:lvl8pPr marL="5039990" indent="0">
              <a:buNone/>
              <a:defRPr sz="2520" b="1"/>
            </a:lvl8pPr>
            <a:lvl9pPr marL="5759988" indent="0">
              <a:buNone/>
              <a:defRPr sz="2520" b="1"/>
            </a:lvl9pPr>
          </a:lstStyle>
          <a:p>
            <a:pPr lvl="0"/>
            <a:r>
              <a:rPr lang="ko-KR" altLang="en-US" smtClean="0"/>
              <a:t>마스터 텍스트 스타일 편집</a:t>
            </a:r>
          </a:p>
        </p:txBody>
      </p:sp>
      <p:sp>
        <p:nvSpPr>
          <p:cNvPr id="6" name="Content Placeholder 5"/>
          <p:cNvSpPr>
            <a:spLocks noGrp="1"/>
          </p:cNvSpPr>
          <p:nvPr>
            <p:ph sz="quarter" idx="4"/>
          </p:nvPr>
        </p:nvSpPr>
        <p:spPr>
          <a:xfrm>
            <a:off x="7290109" y="7495509"/>
            <a:ext cx="6121966" cy="11024765"/>
          </a:xfrm>
        </p:spPr>
        <p:txBody>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7" name="Date Placeholder 6"/>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5684391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smtClean="0"/>
              <a:t>마스터 제목 스타일 편집</a:t>
            </a:r>
            <a:endParaRPr lang="en-US" dirty="0"/>
          </a:p>
        </p:txBody>
      </p:sp>
      <p:sp>
        <p:nvSpPr>
          <p:cNvPr id="3" name="Date Placeholder 2"/>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12392092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31992228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991890" y="1368002"/>
            <a:ext cx="4644444" cy="4788006"/>
          </a:xfrm>
        </p:spPr>
        <p:txBody>
          <a:bodyPr anchor="b"/>
          <a:lstStyle>
            <a:lvl1pPr>
              <a:defRPr sz="5039"/>
            </a:lvl1pPr>
          </a:lstStyle>
          <a:p>
            <a:r>
              <a:rPr lang="ko-KR" altLang="en-US" smtClean="0"/>
              <a:t>마스터 제목 스타일 편집</a:t>
            </a:r>
            <a:endParaRPr lang="en-US" dirty="0"/>
          </a:p>
        </p:txBody>
      </p:sp>
      <p:sp>
        <p:nvSpPr>
          <p:cNvPr id="3" name="Content Placeholder 2"/>
          <p:cNvSpPr>
            <a:spLocks noGrp="1"/>
          </p:cNvSpPr>
          <p:nvPr>
            <p:ph idx="1"/>
          </p:nvPr>
        </p:nvSpPr>
        <p:spPr>
          <a:xfrm>
            <a:off x="6121966" y="2954508"/>
            <a:ext cx="7290108" cy="14582518"/>
          </a:xfrm>
        </p:spPr>
        <p:txBody>
          <a:bodyPr/>
          <a:lstStyle>
            <a:lvl1pPr>
              <a:defRPr sz="5039"/>
            </a:lvl1pPr>
            <a:lvl2pPr>
              <a:defRPr sz="4409"/>
            </a:lvl2pPr>
            <a:lvl3pPr>
              <a:defRPr sz="3780"/>
            </a:lvl3pPr>
            <a:lvl4pPr>
              <a:defRPr sz="3150"/>
            </a:lvl4pPr>
            <a:lvl5pPr>
              <a:defRPr sz="3150"/>
            </a:lvl5pPr>
            <a:lvl6pPr>
              <a:defRPr sz="3150"/>
            </a:lvl6pPr>
            <a:lvl7pPr>
              <a:defRPr sz="3150"/>
            </a:lvl7pPr>
            <a:lvl8pPr>
              <a:defRPr sz="3150"/>
            </a:lvl8pPr>
            <a:lvl9pPr>
              <a:defRPr sz="3150"/>
            </a:lvl9p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Text Placeholder 3"/>
          <p:cNvSpPr>
            <a:spLocks noGrp="1"/>
          </p:cNvSpPr>
          <p:nvPr>
            <p:ph type="body" sz="half" idx="2"/>
          </p:nvPr>
        </p:nvSpPr>
        <p:spPr>
          <a:xfrm>
            <a:off x="991890" y="6156008"/>
            <a:ext cx="4644444" cy="11404765"/>
          </a:xfrm>
        </p:spPr>
        <p:txBody>
          <a:bodyPr/>
          <a:lstStyle>
            <a:lvl1pPr marL="0" indent="0">
              <a:buNone/>
              <a:defRPr sz="2520"/>
            </a:lvl1pPr>
            <a:lvl2pPr marL="719999" indent="0">
              <a:buNone/>
              <a:defRPr sz="2205"/>
            </a:lvl2pPr>
            <a:lvl3pPr marL="1439997" indent="0">
              <a:buNone/>
              <a:defRPr sz="1890"/>
            </a:lvl3pPr>
            <a:lvl4pPr marL="2159996" indent="0">
              <a:buNone/>
              <a:defRPr sz="1575"/>
            </a:lvl4pPr>
            <a:lvl5pPr marL="2879994" indent="0">
              <a:buNone/>
              <a:defRPr sz="1575"/>
            </a:lvl5pPr>
            <a:lvl6pPr marL="3599993" indent="0">
              <a:buNone/>
              <a:defRPr sz="1575"/>
            </a:lvl6pPr>
            <a:lvl7pPr marL="4319991" indent="0">
              <a:buNone/>
              <a:defRPr sz="1575"/>
            </a:lvl7pPr>
            <a:lvl8pPr marL="5039990" indent="0">
              <a:buNone/>
              <a:defRPr sz="1575"/>
            </a:lvl8pPr>
            <a:lvl9pPr marL="5759988" indent="0">
              <a:buNone/>
              <a:defRPr sz="1575"/>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8856629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991890" y="1368002"/>
            <a:ext cx="4644444" cy="4788006"/>
          </a:xfrm>
        </p:spPr>
        <p:txBody>
          <a:bodyPr anchor="b"/>
          <a:lstStyle>
            <a:lvl1pPr>
              <a:defRPr sz="5039"/>
            </a:lvl1pPr>
          </a:lstStyle>
          <a:p>
            <a:r>
              <a:rPr lang="ko-KR" altLang="en-US" smtClean="0"/>
              <a:t>마스터 제목 스타일 편집</a:t>
            </a:r>
            <a:endParaRPr lang="en-US" dirty="0"/>
          </a:p>
        </p:txBody>
      </p:sp>
      <p:sp>
        <p:nvSpPr>
          <p:cNvPr id="3" name="Picture Placeholder 2"/>
          <p:cNvSpPr>
            <a:spLocks noGrp="1" noChangeAspect="1"/>
          </p:cNvSpPr>
          <p:nvPr>
            <p:ph type="pic" idx="1"/>
          </p:nvPr>
        </p:nvSpPr>
        <p:spPr>
          <a:xfrm>
            <a:off x="6121966" y="2954508"/>
            <a:ext cx="7290108" cy="14582518"/>
          </a:xfrm>
        </p:spPr>
        <p:txBody>
          <a:bodyPr anchor="t"/>
          <a:lstStyle>
            <a:lvl1pPr marL="0" indent="0">
              <a:buNone/>
              <a:defRPr sz="5039"/>
            </a:lvl1pPr>
            <a:lvl2pPr marL="719999" indent="0">
              <a:buNone/>
              <a:defRPr sz="4409"/>
            </a:lvl2pPr>
            <a:lvl3pPr marL="1439997" indent="0">
              <a:buNone/>
              <a:defRPr sz="3780"/>
            </a:lvl3pPr>
            <a:lvl4pPr marL="2159996" indent="0">
              <a:buNone/>
              <a:defRPr sz="3150"/>
            </a:lvl4pPr>
            <a:lvl5pPr marL="2879994" indent="0">
              <a:buNone/>
              <a:defRPr sz="3150"/>
            </a:lvl5pPr>
            <a:lvl6pPr marL="3599993" indent="0">
              <a:buNone/>
              <a:defRPr sz="3150"/>
            </a:lvl6pPr>
            <a:lvl7pPr marL="4319991" indent="0">
              <a:buNone/>
              <a:defRPr sz="3150"/>
            </a:lvl7pPr>
            <a:lvl8pPr marL="5039990" indent="0">
              <a:buNone/>
              <a:defRPr sz="3150"/>
            </a:lvl8pPr>
            <a:lvl9pPr marL="5759988" indent="0">
              <a:buNone/>
              <a:defRPr sz="3150"/>
            </a:lvl9pPr>
          </a:lstStyle>
          <a:p>
            <a:r>
              <a:rPr lang="ko-KR" altLang="en-US" smtClean="0"/>
              <a:t>그림을 추가하려면 아이콘을 클릭하십시오</a:t>
            </a:r>
            <a:endParaRPr lang="en-US"/>
          </a:p>
        </p:txBody>
      </p:sp>
      <p:sp>
        <p:nvSpPr>
          <p:cNvPr id="4" name="Text Placeholder 3"/>
          <p:cNvSpPr>
            <a:spLocks noGrp="1"/>
          </p:cNvSpPr>
          <p:nvPr>
            <p:ph type="body" sz="half" idx="2"/>
          </p:nvPr>
        </p:nvSpPr>
        <p:spPr>
          <a:xfrm>
            <a:off x="991890" y="6156008"/>
            <a:ext cx="4644444" cy="11404765"/>
          </a:xfrm>
        </p:spPr>
        <p:txBody>
          <a:bodyPr/>
          <a:lstStyle>
            <a:lvl1pPr marL="0" indent="0">
              <a:buNone/>
              <a:defRPr sz="2520"/>
            </a:lvl1pPr>
            <a:lvl2pPr marL="719999" indent="0">
              <a:buNone/>
              <a:defRPr sz="2205"/>
            </a:lvl2pPr>
            <a:lvl3pPr marL="1439997" indent="0">
              <a:buNone/>
              <a:defRPr sz="1890"/>
            </a:lvl3pPr>
            <a:lvl4pPr marL="2159996" indent="0">
              <a:buNone/>
              <a:defRPr sz="1575"/>
            </a:lvl4pPr>
            <a:lvl5pPr marL="2879994" indent="0">
              <a:buNone/>
              <a:defRPr sz="1575"/>
            </a:lvl5pPr>
            <a:lvl6pPr marL="3599993" indent="0">
              <a:buNone/>
              <a:defRPr sz="1575"/>
            </a:lvl6pPr>
            <a:lvl7pPr marL="4319991" indent="0">
              <a:buNone/>
              <a:defRPr sz="1575"/>
            </a:lvl7pPr>
            <a:lvl8pPr marL="5039990" indent="0">
              <a:buNone/>
              <a:defRPr sz="1575"/>
            </a:lvl8pPr>
            <a:lvl9pPr marL="5759988" indent="0">
              <a:buNone/>
              <a:defRPr sz="1575"/>
            </a:lvl9pPr>
          </a:lstStyle>
          <a:p>
            <a:pPr lvl="0"/>
            <a:r>
              <a:rPr lang="ko-KR" altLang="en-US" smtClean="0"/>
              <a:t>마스터 텍스트 스타일 편집</a:t>
            </a:r>
          </a:p>
        </p:txBody>
      </p:sp>
      <p:sp>
        <p:nvSpPr>
          <p:cNvPr id="5" name="Date Placeholder 4"/>
          <p:cNvSpPr>
            <a:spLocks noGrp="1"/>
          </p:cNvSpPr>
          <p:nvPr>
            <p:ph type="dt" sz="half" idx="10"/>
          </p:nvPr>
        </p:nvSpPr>
        <p:spPr/>
        <p:txBody>
          <a:bodyPr/>
          <a:lstStyle/>
          <a:p>
            <a:fld id="{D93D439F-1DC1-45AE-96B4-CAB3A1316EB4}" type="datetimeFigureOut">
              <a:rPr lang="ko-KR" altLang="en-US" smtClean="0"/>
              <a:t>2020-04-06</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12551318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90015" y="1092506"/>
            <a:ext cx="12420184" cy="3966256"/>
          </a:xfrm>
          <a:prstGeom prst="rect">
            <a:avLst/>
          </a:prstGeom>
        </p:spPr>
        <p:txBody>
          <a:bodyPr vert="horz" lIns="91440" tIns="45720" rIns="91440" bIns="45720" rtlCol="0" anchor="ctr">
            <a:normAutofit/>
          </a:bodyPr>
          <a:lstStyle/>
          <a:p>
            <a:r>
              <a:rPr lang="ko-KR" altLang="en-US" smtClean="0"/>
              <a:t>마스터 제목 스타일 편집</a:t>
            </a:r>
            <a:endParaRPr lang="en-US" dirty="0"/>
          </a:p>
        </p:txBody>
      </p:sp>
      <p:sp>
        <p:nvSpPr>
          <p:cNvPr id="3" name="Text Placeholder 2"/>
          <p:cNvSpPr>
            <a:spLocks noGrp="1"/>
          </p:cNvSpPr>
          <p:nvPr>
            <p:ph type="body" idx="1"/>
          </p:nvPr>
        </p:nvSpPr>
        <p:spPr>
          <a:xfrm>
            <a:off x="990015" y="5462507"/>
            <a:ext cx="12420184" cy="13019767"/>
          </a:xfrm>
          <a:prstGeom prst="rect">
            <a:avLst/>
          </a:prstGeom>
        </p:spPr>
        <p:txBody>
          <a:bodyPr vert="horz" lIns="91440" tIns="45720" rIns="91440" bIns="45720" rtlCol="0">
            <a:normAutofit/>
          </a:bodyPr>
          <a:lstStyle/>
          <a:p>
            <a:pPr lvl="0"/>
            <a:r>
              <a:rPr lang="ko-KR" altLang="en-US" smtClean="0"/>
              <a:t>마스터 텍스트 스타일 편집</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en-US" dirty="0"/>
          </a:p>
        </p:txBody>
      </p:sp>
      <p:sp>
        <p:nvSpPr>
          <p:cNvPr id="4" name="Date Placeholder 3"/>
          <p:cNvSpPr>
            <a:spLocks noGrp="1"/>
          </p:cNvSpPr>
          <p:nvPr>
            <p:ph type="dt" sz="half" idx="2"/>
          </p:nvPr>
        </p:nvSpPr>
        <p:spPr>
          <a:xfrm>
            <a:off x="990015" y="19019028"/>
            <a:ext cx="3240048" cy="1092501"/>
          </a:xfrm>
          <a:prstGeom prst="rect">
            <a:avLst/>
          </a:prstGeom>
        </p:spPr>
        <p:txBody>
          <a:bodyPr vert="horz" lIns="91440" tIns="45720" rIns="91440" bIns="45720" rtlCol="0" anchor="ctr"/>
          <a:lstStyle>
            <a:lvl1pPr algn="l">
              <a:defRPr sz="1890">
                <a:solidFill>
                  <a:schemeClr val="tx1">
                    <a:tint val="75000"/>
                  </a:schemeClr>
                </a:solidFill>
              </a:defRPr>
            </a:lvl1pPr>
          </a:lstStyle>
          <a:p>
            <a:fld id="{D93D439F-1DC1-45AE-96B4-CAB3A1316EB4}" type="datetimeFigureOut">
              <a:rPr lang="ko-KR" altLang="en-US" smtClean="0"/>
              <a:t>2020-04-06</a:t>
            </a:fld>
            <a:endParaRPr lang="ko-KR" altLang="en-US"/>
          </a:p>
        </p:txBody>
      </p:sp>
      <p:sp>
        <p:nvSpPr>
          <p:cNvPr id="5" name="Footer Placeholder 4"/>
          <p:cNvSpPr>
            <a:spLocks noGrp="1"/>
          </p:cNvSpPr>
          <p:nvPr>
            <p:ph type="ftr" sz="quarter" idx="3"/>
          </p:nvPr>
        </p:nvSpPr>
        <p:spPr>
          <a:xfrm>
            <a:off x="4770071" y="19019028"/>
            <a:ext cx="4860072" cy="1092501"/>
          </a:xfrm>
          <a:prstGeom prst="rect">
            <a:avLst/>
          </a:prstGeom>
        </p:spPr>
        <p:txBody>
          <a:bodyPr vert="horz" lIns="91440" tIns="45720" rIns="91440" bIns="45720" rtlCol="0" anchor="ctr"/>
          <a:lstStyle>
            <a:lvl1pPr algn="ctr">
              <a:defRPr sz="1890">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10170150" y="19019028"/>
            <a:ext cx="3240048" cy="1092501"/>
          </a:xfrm>
          <a:prstGeom prst="rect">
            <a:avLst/>
          </a:prstGeom>
        </p:spPr>
        <p:txBody>
          <a:bodyPr vert="horz" lIns="91440" tIns="45720" rIns="91440" bIns="45720" rtlCol="0" anchor="ctr"/>
          <a:lstStyle>
            <a:lvl1pPr algn="r">
              <a:defRPr sz="1890">
                <a:solidFill>
                  <a:schemeClr val="tx1">
                    <a:tint val="75000"/>
                  </a:schemeClr>
                </a:solidFill>
              </a:defRPr>
            </a:lvl1pPr>
          </a:lstStyle>
          <a:p>
            <a:fld id="{A7F23EDD-A7C7-44DA-B386-F999A20325FB}" type="slidenum">
              <a:rPr lang="ko-KR" altLang="en-US" smtClean="0"/>
              <a:t>‹#›</a:t>
            </a:fld>
            <a:endParaRPr lang="ko-KR" altLang="en-US"/>
          </a:p>
        </p:txBody>
      </p:sp>
    </p:spTree>
    <p:extLst>
      <p:ext uri="{BB962C8B-B14F-4D97-AF65-F5344CB8AC3E}">
        <p14:creationId xmlns:p14="http://schemas.microsoft.com/office/powerpoint/2010/main" val="293137927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439997" rtl="0" eaLnBrk="1" latinLnBrk="1" hangingPunct="1">
        <a:lnSpc>
          <a:spcPct val="90000"/>
        </a:lnSpc>
        <a:spcBef>
          <a:spcPct val="0"/>
        </a:spcBef>
        <a:buNone/>
        <a:defRPr sz="6929" kern="1200">
          <a:solidFill>
            <a:schemeClr val="tx1"/>
          </a:solidFill>
          <a:latin typeface="+mj-lt"/>
          <a:ea typeface="+mj-ea"/>
          <a:cs typeface="+mj-cs"/>
        </a:defRPr>
      </a:lvl1pPr>
    </p:titleStyle>
    <p:bodyStyle>
      <a:lvl1pPr marL="359999" indent="-359999" algn="l" defTabSz="1439997" rtl="0" eaLnBrk="1" latinLnBrk="1" hangingPunct="1">
        <a:lnSpc>
          <a:spcPct val="90000"/>
        </a:lnSpc>
        <a:spcBef>
          <a:spcPts val="1575"/>
        </a:spcBef>
        <a:buFont typeface="Arial" panose="020B0604020202020204" pitchFamily="34" charset="0"/>
        <a:buChar char="•"/>
        <a:defRPr sz="4409" kern="1200">
          <a:solidFill>
            <a:schemeClr val="tx1"/>
          </a:solidFill>
          <a:latin typeface="+mn-lt"/>
          <a:ea typeface="+mn-ea"/>
          <a:cs typeface="+mn-cs"/>
        </a:defRPr>
      </a:lvl1pPr>
      <a:lvl2pPr marL="1079998" indent="-359999" algn="l" defTabSz="1439997" rtl="0" eaLnBrk="1" latinLnBrk="1" hangingPunct="1">
        <a:lnSpc>
          <a:spcPct val="90000"/>
        </a:lnSpc>
        <a:spcBef>
          <a:spcPts val="787"/>
        </a:spcBef>
        <a:buFont typeface="Arial" panose="020B0604020202020204" pitchFamily="34" charset="0"/>
        <a:buChar char="•"/>
        <a:defRPr sz="3780" kern="1200">
          <a:solidFill>
            <a:schemeClr val="tx1"/>
          </a:solidFill>
          <a:latin typeface="+mn-lt"/>
          <a:ea typeface="+mn-ea"/>
          <a:cs typeface="+mn-cs"/>
        </a:defRPr>
      </a:lvl2pPr>
      <a:lvl3pPr marL="1799996" indent="-359999" algn="l" defTabSz="1439997" rtl="0" eaLnBrk="1" latinLnBrk="1" hangingPunct="1">
        <a:lnSpc>
          <a:spcPct val="90000"/>
        </a:lnSpc>
        <a:spcBef>
          <a:spcPts val="787"/>
        </a:spcBef>
        <a:buFont typeface="Arial" panose="020B0604020202020204" pitchFamily="34" charset="0"/>
        <a:buChar char="•"/>
        <a:defRPr sz="3150" kern="1200">
          <a:solidFill>
            <a:schemeClr val="tx1"/>
          </a:solidFill>
          <a:latin typeface="+mn-lt"/>
          <a:ea typeface="+mn-ea"/>
          <a:cs typeface="+mn-cs"/>
        </a:defRPr>
      </a:lvl3pPr>
      <a:lvl4pPr marL="2519995"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4pPr>
      <a:lvl5pPr marL="3239994"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5pPr>
      <a:lvl6pPr marL="3959992"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6pPr>
      <a:lvl7pPr marL="4679991"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7pPr>
      <a:lvl8pPr marL="5399989"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8pPr>
      <a:lvl9pPr marL="6119988" indent="-359999" algn="l" defTabSz="1439997" rtl="0" eaLnBrk="1" latinLnBrk="1" hangingPunct="1">
        <a:lnSpc>
          <a:spcPct val="90000"/>
        </a:lnSpc>
        <a:spcBef>
          <a:spcPts val="787"/>
        </a:spcBef>
        <a:buFont typeface="Arial" panose="020B0604020202020204" pitchFamily="34" charset="0"/>
        <a:buChar char="•"/>
        <a:defRPr sz="2835" kern="1200">
          <a:solidFill>
            <a:schemeClr val="tx1"/>
          </a:solidFill>
          <a:latin typeface="+mn-lt"/>
          <a:ea typeface="+mn-ea"/>
          <a:cs typeface="+mn-cs"/>
        </a:defRPr>
      </a:lvl9pPr>
    </p:bodyStyle>
    <p:otherStyle>
      <a:defPPr>
        <a:defRPr lang="en-US"/>
      </a:defPPr>
      <a:lvl1pPr marL="0" algn="l" defTabSz="1439997" rtl="0" eaLnBrk="1" latinLnBrk="1" hangingPunct="1">
        <a:defRPr sz="2835" kern="1200">
          <a:solidFill>
            <a:schemeClr val="tx1"/>
          </a:solidFill>
          <a:latin typeface="+mn-lt"/>
          <a:ea typeface="+mn-ea"/>
          <a:cs typeface="+mn-cs"/>
        </a:defRPr>
      </a:lvl1pPr>
      <a:lvl2pPr marL="719999" algn="l" defTabSz="1439997" rtl="0" eaLnBrk="1" latinLnBrk="1" hangingPunct="1">
        <a:defRPr sz="2835" kern="1200">
          <a:solidFill>
            <a:schemeClr val="tx1"/>
          </a:solidFill>
          <a:latin typeface="+mn-lt"/>
          <a:ea typeface="+mn-ea"/>
          <a:cs typeface="+mn-cs"/>
        </a:defRPr>
      </a:lvl2pPr>
      <a:lvl3pPr marL="1439997" algn="l" defTabSz="1439997" rtl="0" eaLnBrk="1" latinLnBrk="1" hangingPunct="1">
        <a:defRPr sz="2835" kern="1200">
          <a:solidFill>
            <a:schemeClr val="tx1"/>
          </a:solidFill>
          <a:latin typeface="+mn-lt"/>
          <a:ea typeface="+mn-ea"/>
          <a:cs typeface="+mn-cs"/>
        </a:defRPr>
      </a:lvl3pPr>
      <a:lvl4pPr marL="2159996" algn="l" defTabSz="1439997" rtl="0" eaLnBrk="1" latinLnBrk="1" hangingPunct="1">
        <a:defRPr sz="2835" kern="1200">
          <a:solidFill>
            <a:schemeClr val="tx1"/>
          </a:solidFill>
          <a:latin typeface="+mn-lt"/>
          <a:ea typeface="+mn-ea"/>
          <a:cs typeface="+mn-cs"/>
        </a:defRPr>
      </a:lvl4pPr>
      <a:lvl5pPr marL="2879994" algn="l" defTabSz="1439997" rtl="0" eaLnBrk="1" latinLnBrk="1" hangingPunct="1">
        <a:defRPr sz="2835" kern="1200">
          <a:solidFill>
            <a:schemeClr val="tx1"/>
          </a:solidFill>
          <a:latin typeface="+mn-lt"/>
          <a:ea typeface="+mn-ea"/>
          <a:cs typeface="+mn-cs"/>
        </a:defRPr>
      </a:lvl5pPr>
      <a:lvl6pPr marL="3599993" algn="l" defTabSz="1439997" rtl="0" eaLnBrk="1" latinLnBrk="1" hangingPunct="1">
        <a:defRPr sz="2835" kern="1200">
          <a:solidFill>
            <a:schemeClr val="tx1"/>
          </a:solidFill>
          <a:latin typeface="+mn-lt"/>
          <a:ea typeface="+mn-ea"/>
          <a:cs typeface="+mn-cs"/>
        </a:defRPr>
      </a:lvl6pPr>
      <a:lvl7pPr marL="4319991" algn="l" defTabSz="1439997" rtl="0" eaLnBrk="1" latinLnBrk="1" hangingPunct="1">
        <a:defRPr sz="2835" kern="1200">
          <a:solidFill>
            <a:schemeClr val="tx1"/>
          </a:solidFill>
          <a:latin typeface="+mn-lt"/>
          <a:ea typeface="+mn-ea"/>
          <a:cs typeface="+mn-cs"/>
        </a:defRPr>
      </a:lvl7pPr>
      <a:lvl8pPr marL="5039990" algn="l" defTabSz="1439997" rtl="0" eaLnBrk="1" latinLnBrk="1" hangingPunct="1">
        <a:defRPr sz="2835" kern="1200">
          <a:solidFill>
            <a:schemeClr val="tx1"/>
          </a:solidFill>
          <a:latin typeface="+mn-lt"/>
          <a:ea typeface="+mn-ea"/>
          <a:cs typeface="+mn-cs"/>
        </a:defRPr>
      </a:lvl8pPr>
      <a:lvl9pPr marL="5759988" algn="l" defTabSz="1439997" rtl="0" eaLnBrk="1" latinLnBrk="1" hangingPunct="1">
        <a:defRPr sz="283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emf"/><Relationship Id="rId1" Type="http://schemas.openxmlformats.org/officeDocument/2006/relationships/slideLayout" Target="../slideLayouts/slideLayout2.xml"/><Relationship Id="rId4" Type="http://schemas.openxmlformats.org/officeDocument/2006/relationships/image" Target="../media/image27.emf"/></Relationships>
</file>

<file path=ppt/slides/_rels/slide11.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s>
</file>

<file path=ppt/slides/_rels/slide13.xml.rels><?xml version="1.0" encoding="UTF-8" standalone="yes"?>
<Relationships xmlns="http://schemas.openxmlformats.org/package/2006/relationships"><Relationship Id="rId3" Type="http://schemas.openxmlformats.org/officeDocument/2006/relationships/image" Target="../media/image35.emf"/><Relationship Id="rId2" Type="http://schemas.openxmlformats.org/officeDocument/2006/relationships/image" Target="../media/image34.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2.png"/><Relationship Id="rId7" Type="http://schemas.openxmlformats.org/officeDocument/2006/relationships/image" Target="../media/image5.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microsoft.com/office/2007/relationships/hdphoto" Target="../media/hdphoto1.wdp"/><Relationship Id="rId9"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11.emf"/></Relationships>
</file>

<file path=ppt/slides/_rels/slide4.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2.bin"/><Relationship Id="rId13" Type="http://schemas.openxmlformats.org/officeDocument/2006/relationships/chart" Target="../charts/chart3.xml"/><Relationship Id="rId3" Type="http://schemas.openxmlformats.org/officeDocument/2006/relationships/chart" Target="../charts/chart1.xml"/><Relationship Id="rId7" Type="http://schemas.openxmlformats.org/officeDocument/2006/relationships/image" Target="../media/image13.emf"/><Relationship Id="rId12" Type="http://schemas.openxmlformats.org/officeDocument/2006/relationships/image" Target="../media/image17.png"/><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1.bin"/><Relationship Id="rId11" Type="http://schemas.openxmlformats.org/officeDocument/2006/relationships/image" Target="../media/image15.emf"/><Relationship Id="rId5" Type="http://schemas.openxmlformats.org/officeDocument/2006/relationships/image" Target="../media/image16.emf"/><Relationship Id="rId10" Type="http://schemas.openxmlformats.org/officeDocument/2006/relationships/oleObject" Target="../embeddings/oleObject3.bin"/><Relationship Id="rId4" Type="http://schemas.openxmlformats.org/officeDocument/2006/relationships/chart" Target="../charts/chart2.xml"/><Relationship Id="rId9" Type="http://schemas.openxmlformats.org/officeDocument/2006/relationships/image" Target="../media/image14.emf"/></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 Id="rId4" Type="http://schemas.openxmlformats.org/officeDocument/2006/relationships/image" Target="../media/image20.png"/></Relationships>
</file>

<file path=ppt/slides/_rels/slide8.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2.emf"/></Relationships>
</file>

<file path=ppt/slides/_rels/slide9.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직사각형 4"/>
          <p:cNvSpPr/>
          <p:nvPr/>
        </p:nvSpPr>
        <p:spPr>
          <a:xfrm>
            <a:off x="623734" y="1348319"/>
            <a:ext cx="12952566" cy="6760825"/>
          </a:xfrm>
          <a:prstGeom prst="rect">
            <a:avLst/>
          </a:prstGeom>
        </p:spPr>
        <p:txBody>
          <a:bodyPr wrap="square">
            <a:spAutoFit/>
          </a:bodyPr>
          <a:lstStyle/>
          <a:p>
            <a:pPr algn="ctr" fontAlgn="base" latinLnBrk="1"/>
            <a:r>
              <a:rPr lang="en-US" altLang="ko-KR" sz="2800" b="1" dirty="0">
                <a:latin typeface="Times New Roman" panose="02020603050405020304" pitchFamily="18" charset="0"/>
                <a:cs typeface="Times New Roman" panose="02020603050405020304" pitchFamily="18" charset="0"/>
              </a:rPr>
              <a:t>Identification of TUBB2A by quantitative proteomic analysis as a novel biomarker for the prediction of distant metastatic breast cancer </a:t>
            </a:r>
            <a:endParaRPr lang="en-US" altLang="ko-KR" sz="2800" b="1" dirty="0" smtClean="0">
              <a:latin typeface="Times New Roman" panose="02020603050405020304" pitchFamily="18" charset="0"/>
              <a:cs typeface="Times New Roman" panose="02020603050405020304" pitchFamily="18" charset="0"/>
            </a:endParaRPr>
          </a:p>
          <a:p>
            <a:pPr algn="ctr" fontAlgn="base" latinLnBrk="1"/>
            <a:endParaRPr lang="en-US" altLang="ko-KR" sz="2800" b="1" dirty="0" smtClean="0">
              <a:latin typeface="Times New Roman" panose="02020603050405020304" pitchFamily="18" charset="0"/>
              <a:cs typeface="Times New Roman" panose="02020603050405020304" pitchFamily="18" charset="0"/>
            </a:endParaRPr>
          </a:p>
          <a:p>
            <a:pPr algn="ctr" fontAlgn="base" latinLnBrk="1"/>
            <a:endParaRPr lang="en-US" altLang="ko-KR" sz="2800" b="1" dirty="0">
              <a:latin typeface="Times New Roman" panose="02020603050405020304" pitchFamily="18" charset="0"/>
              <a:cs typeface="Times New Roman" panose="02020603050405020304" pitchFamily="18" charset="0"/>
            </a:endParaRPr>
          </a:p>
          <a:p>
            <a:pPr algn="just" latinLnBrk="1">
              <a:lnSpc>
                <a:spcPct val="150000"/>
              </a:lnSpc>
              <a:spcAft>
                <a:spcPts val="800"/>
              </a:spcAft>
            </a:pPr>
            <a:r>
              <a:rPr lang="en-US" altLang="ko-KR" sz="2400" dirty="0" err="1" smtClean="0">
                <a:solidFill>
                  <a:srgbClr val="000000"/>
                </a:solidFill>
                <a:latin typeface="Times New Roman" panose="02020603050405020304" pitchFamily="18" charset="0"/>
                <a:ea typeface="Arial Unicode MS"/>
                <a:cs typeface="굴림" panose="020B0600000101010101" pitchFamily="50" charset="-127"/>
              </a:rPr>
              <a:t>Dongyoon</a:t>
            </a:r>
            <a:r>
              <a:rPr lang="en-US" altLang="ko-KR" sz="2400" dirty="0" smtClean="0">
                <a:solidFill>
                  <a:srgbClr val="000000"/>
                </a:solidFill>
                <a:latin typeface="Times New Roman" panose="02020603050405020304" pitchFamily="18" charset="0"/>
                <a:ea typeface="Arial Unicode MS"/>
                <a:cs typeface="굴림" panose="020B0600000101010101" pitchFamily="50" charset="-127"/>
              </a:rPr>
              <a:t> </a:t>
            </a:r>
            <a:r>
              <a:rPr lang="en-US" altLang="ko-KR" sz="2400" dirty="0">
                <a:solidFill>
                  <a:srgbClr val="000000"/>
                </a:solidFill>
                <a:latin typeface="Times New Roman" panose="02020603050405020304" pitchFamily="18" charset="0"/>
                <a:ea typeface="Arial Unicode MS"/>
                <a:cs typeface="굴림" panose="020B0600000101010101" pitchFamily="50" charset="-127"/>
              </a:rPr>
              <a:t>Shin</a:t>
            </a:r>
            <a:r>
              <a:rPr lang="en-US" altLang="ko-KR" sz="2400" baseline="30000" dirty="0">
                <a:solidFill>
                  <a:srgbClr val="000000"/>
                </a:solidFill>
                <a:latin typeface="Times New Roman" panose="02020603050405020304" pitchFamily="18" charset="0"/>
                <a:ea typeface="Arial Unicode MS"/>
                <a:cs typeface="굴림" panose="020B0600000101010101" pitchFamily="50" charset="-127"/>
              </a:rPr>
              <a:t>1,#</a:t>
            </a:r>
            <a:r>
              <a:rPr lang="en-US" altLang="ko-KR" sz="2400" dirty="0">
                <a:solidFill>
                  <a:srgbClr val="000000"/>
                </a:solidFill>
                <a:latin typeface="Times New Roman" panose="02020603050405020304" pitchFamily="18" charset="0"/>
                <a:ea typeface="Arial Unicode MS"/>
                <a:cs typeface="굴림" panose="020B0600000101010101" pitchFamily="50" charset="-127"/>
              </a:rPr>
              <a:t>, </a:t>
            </a:r>
            <a:r>
              <a:rPr lang="en-US" altLang="ko-KR" sz="2400" dirty="0" err="1">
                <a:solidFill>
                  <a:srgbClr val="000000"/>
                </a:solidFill>
                <a:latin typeface="Times New Roman" panose="02020603050405020304" pitchFamily="18" charset="0"/>
                <a:ea typeface="Arial Unicode MS"/>
                <a:cs typeface="굴림" panose="020B0600000101010101" pitchFamily="50" charset="-127"/>
              </a:rPr>
              <a:t>Joonho</a:t>
            </a:r>
            <a:r>
              <a:rPr lang="en-US" altLang="ko-KR" sz="2400" dirty="0">
                <a:solidFill>
                  <a:srgbClr val="000000"/>
                </a:solidFill>
                <a:latin typeface="Times New Roman" panose="02020603050405020304" pitchFamily="18" charset="0"/>
                <a:ea typeface="Arial Unicode MS"/>
                <a:cs typeface="굴림" panose="020B0600000101010101" pitchFamily="50" charset="-127"/>
              </a:rPr>
              <a:t> Park</a:t>
            </a:r>
            <a:r>
              <a:rPr lang="en-US" altLang="ko-KR" sz="2400" baseline="30000" dirty="0">
                <a:solidFill>
                  <a:srgbClr val="000000"/>
                </a:solidFill>
                <a:latin typeface="Times New Roman" panose="02020603050405020304" pitchFamily="18" charset="0"/>
                <a:ea typeface="Arial Unicode MS"/>
                <a:cs typeface="굴림" panose="020B0600000101010101" pitchFamily="50" charset="-127"/>
              </a:rPr>
              <a:t>2,#</a:t>
            </a:r>
            <a:r>
              <a:rPr lang="en-US" altLang="ko-KR" sz="2400" dirty="0">
                <a:solidFill>
                  <a:srgbClr val="000000"/>
                </a:solidFill>
                <a:latin typeface="Times New Roman" panose="02020603050405020304" pitchFamily="18" charset="0"/>
                <a:ea typeface="Arial Unicode MS"/>
                <a:cs typeface="굴림" panose="020B0600000101010101" pitchFamily="50" charset="-127"/>
              </a:rPr>
              <a:t>, </a:t>
            </a:r>
            <a:r>
              <a:rPr lang="en-US" altLang="ko-KR" sz="2400" dirty="0" err="1" smtClean="0">
                <a:solidFill>
                  <a:srgbClr val="000000"/>
                </a:solidFill>
                <a:latin typeface="Times New Roman" panose="02020603050405020304" pitchFamily="18" charset="0"/>
                <a:ea typeface="Arial Unicode MS"/>
                <a:cs typeface="굴림" panose="020B0600000101010101" pitchFamily="50" charset="-127"/>
              </a:rPr>
              <a:t>Dohyun</a:t>
            </a:r>
            <a:r>
              <a:rPr lang="en-US" altLang="ko-KR" sz="2400" dirty="0" smtClean="0">
                <a:solidFill>
                  <a:srgbClr val="000000"/>
                </a:solidFill>
                <a:latin typeface="Times New Roman" panose="02020603050405020304" pitchFamily="18" charset="0"/>
                <a:ea typeface="Arial Unicode MS"/>
                <a:cs typeface="굴림" panose="020B0600000101010101" pitchFamily="50" charset="-127"/>
              </a:rPr>
              <a:t> Han</a:t>
            </a:r>
            <a:r>
              <a:rPr lang="en-US" altLang="ko-KR" sz="2400" baseline="30000" dirty="0" smtClean="0">
                <a:solidFill>
                  <a:srgbClr val="000000"/>
                </a:solidFill>
                <a:latin typeface="Times New Roman" panose="02020603050405020304" pitchFamily="18" charset="0"/>
                <a:ea typeface="Arial Unicode MS"/>
                <a:cs typeface="굴림" panose="020B0600000101010101" pitchFamily="50" charset="-127"/>
              </a:rPr>
              <a:t>3</a:t>
            </a:r>
            <a:r>
              <a:rPr lang="en-US" altLang="ko-KR" sz="2400" dirty="0" smtClean="0">
                <a:solidFill>
                  <a:srgbClr val="000000"/>
                </a:solidFill>
                <a:latin typeface="Times New Roman" panose="02020603050405020304" pitchFamily="18" charset="0"/>
                <a:ea typeface="Arial Unicode MS"/>
                <a:cs typeface="굴림" panose="020B0600000101010101" pitchFamily="50" charset="-127"/>
              </a:rPr>
              <a:t>, </a:t>
            </a:r>
            <a:r>
              <a:rPr lang="en-US" altLang="ko-KR" sz="2400" dirty="0" err="1" smtClean="0">
                <a:solidFill>
                  <a:srgbClr val="000000"/>
                </a:solidFill>
                <a:latin typeface="Times New Roman" panose="02020603050405020304" pitchFamily="18" charset="0"/>
                <a:ea typeface="Arial Unicode MS"/>
                <a:cs typeface="굴림" panose="020B0600000101010101" pitchFamily="50" charset="-127"/>
              </a:rPr>
              <a:t>Jihye</a:t>
            </a:r>
            <a:r>
              <a:rPr lang="en-US" altLang="ko-KR" sz="2400" dirty="0" smtClean="0">
                <a:solidFill>
                  <a:srgbClr val="000000"/>
                </a:solidFill>
                <a:latin typeface="Times New Roman" panose="02020603050405020304" pitchFamily="18" charset="0"/>
                <a:ea typeface="Arial Unicode MS"/>
                <a:cs typeface="굴림" panose="020B0600000101010101" pitchFamily="50" charset="-127"/>
              </a:rPr>
              <a:t> Moon</a:t>
            </a:r>
            <a:r>
              <a:rPr lang="en-US" altLang="ko-KR" sz="2400" baseline="30000" dirty="0" smtClean="0">
                <a:solidFill>
                  <a:srgbClr val="000000"/>
                </a:solidFill>
                <a:latin typeface="Times New Roman" panose="02020603050405020304" pitchFamily="18" charset="0"/>
                <a:ea typeface="Arial Unicode MS"/>
                <a:cs typeface="굴림" panose="020B0600000101010101" pitchFamily="50" charset="-127"/>
              </a:rPr>
              <a:t>4</a:t>
            </a:r>
            <a:r>
              <a:rPr lang="en-US" altLang="ko-KR" sz="2400" dirty="0" smtClean="0">
                <a:solidFill>
                  <a:srgbClr val="000000"/>
                </a:solidFill>
                <a:latin typeface="Times New Roman" panose="02020603050405020304" pitchFamily="18" charset="0"/>
                <a:ea typeface="Arial Unicode MS"/>
                <a:cs typeface="굴림" panose="020B0600000101010101" pitchFamily="50" charset="-127"/>
              </a:rPr>
              <a:t>, </a:t>
            </a:r>
            <a:r>
              <a:rPr lang="en-US" altLang="ko-KR" sz="2400" dirty="0" err="1" smtClean="0">
                <a:solidFill>
                  <a:srgbClr val="000000"/>
                </a:solidFill>
                <a:latin typeface="Times New Roman" panose="02020603050405020304" pitchFamily="18" charset="0"/>
                <a:ea typeface="Arial Unicode MS"/>
                <a:cs typeface="굴림" panose="020B0600000101010101" pitchFamily="50" charset="-127"/>
              </a:rPr>
              <a:t>Hansuk</a:t>
            </a:r>
            <a:r>
              <a:rPr lang="en-US" altLang="ko-KR" sz="2400" dirty="0" smtClean="0">
                <a:solidFill>
                  <a:srgbClr val="000000"/>
                </a:solidFill>
                <a:latin typeface="Times New Roman" panose="02020603050405020304" pitchFamily="18" charset="0"/>
                <a:ea typeface="Arial Unicode MS"/>
                <a:cs typeface="굴림" panose="020B0600000101010101" pitchFamily="50" charset="-127"/>
              </a:rPr>
              <a:t> </a:t>
            </a:r>
            <a:r>
              <a:rPr lang="en-US" altLang="ko-KR" sz="2400" dirty="0">
                <a:solidFill>
                  <a:srgbClr val="000000"/>
                </a:solidFill>
                <a:latin typeface="Times New Roman" panose="02020603050405020304" pitchFamily="18" charset="0"/>
                <a:ea typeface="Arial Unicode MS"/>
                <a:cs typeface="굴림" panose="020B0600000101010101" pitchFamily="50" charset="-127"/>
              </a:rPr>
              <a:t>Ryu</a:t>
            </a:r>
            <a:r>
              <a:rPr lang="en-US" altLang="ko-KR" sz="2400" baseline="30000" dirty="0">
                <a:solidFill>
                  <a:srgbClr val="000000"/>
                </a:solidFill>
                <a:latin typeface="Times New Roman" panose="02020603050405020304" pitchFamily="18" charset="0"/>
                <a:ea typeface="Arial Unicode MS"/>
                <a:cs typeface="굴림" panose="020B0600000101010101" pitchFamily="50" charset="-127"/>
              </a:rPr>
              <a:t>4,*</a:t>
            </a:r>
            <a:r>
              <a:rPr lang="en-US" altLang="ko-KR" sz="2400" dirty="0">
                <a:solidFill>
                  <a:srgbClr val="000000"/>
                </a:solidFill>
                <a:latin typeface="Times New Roman" panose="02020603050405020304" pitchFamily="18" charset="0"/>
                <a:ea typeface="Arial Unicode MS"/>
                <a:cs typeface="굴림" panose="020B0600000101010101" pitchFamily="50" charset="-127"/>
              </a:rPr>
              <a:t> and </a:t>
            </a:r>
            <a:r>
              <a:rPr lang="en-US" altLang="ko-KR" sz="2400" dirty="0" err="1">
                <a:solidFill>
                  <a:srgbClr val="000000"/>
                </a:solidFill>
                <a:latin typeface="Times New Roman" panose="02020603050405020304" pitchFamily="18" charset="0"/>
                <a:ea typeface="Arial Unicode MS"/>
                <a:cs typeface="굴림" panose="020B0600000101010101" pitchFamily="50" charset="-127"/>
              </a:rPr>
              <a:t>Youngsoo</a:t>
            </a:r>
            <a:r>
              <a:rPr lang="en-US" altLang="ko-KR" sz="2400" dirty="0">
                <a:solidFill>
                  <a:srgbClr val="000000"/>
                </a:solidFill>
                <a:latin typeface="Times New Roman" panose="02020603050405020304" pitchFamily="18" charset="0"/>
                <a:ea typeface="Arial Unicode MS"/>
                <a:cs typeface="굴림" panose="020B0600000101010101" pitchFamily="50" charset="-127"/>
              </a:rPr>
              <a:t> Kim</a:t>
            </a:r>
            <a:r>
              <a:rPr lang="en-US" altLang="ko-KR" sz="2400" baseline="30000" dirty="0">
                <a:solidFill>
                  <a:srgbClr val="000000"/>
                </a:solidFill>
                <a:latin typeface="Times New Roman" panose="02020603050405020304" pitchFamily="18" charset="0"/>
                <a:ea typeface="Arial Unicode MS"/>
                <a:cs typeface="굴림" panose="020B0600000101010101" pitchFamily="50" charset="-127"/>
              </a:rPr>
              <a:t>1,2,*</a:t>
            </a:r>
            <a:endParaRPr lang="ko-KR" altLang="ko-KR" sz="2400" dirty="0">
              <a:solidFill>
                <a:srgbClr val="000000"/>
              </a:solidFill>
              <a:latin typeface="맑은 고딕" panose="020B0503020000020004" pitchFamily="50" charset="-127"/>
              <a:cs typeface="굴림" panose="020B0600000101010101" pitchFamily="50" charset="-127"/>
            </a:endParaRPr>
          </a:p>
          <a:p>
            <a:pPr algn="just" latinLnBrk="1">
              <a:lnSpc>
                <a:spcPct val="150000"/>
              </a:lnSpc>
              <a:spcAft>
                <a:spcPts val="800"/>
              </a:spcAft>
            </a:pPr>
            <a:r>
              <a:rPr lang="en-US" altLang="ko-KR" sz="2400" dirty="0">
                <a:solidFill>
                  <a:srgbClr val="000000"/>
                </a:solidFill>
                <a:latin typeface="Times New Roman" panose="02020603050405020304" pitchFamily="18" charset="0"/>
                <a:ea typeface="Arial Unicode MS"/>
                <a:cs typeface="굴림" panose="020B0600000101010101" pitchFamily="50" charset="-127"/>
              </a:rPr>
              <a:t> </a:t>
            </a:r>
            <a:endParaRPr lang="ko-KR" altLang="ko-KR" sz="2400" dirty="0">
              <a:solidFill>
                <a:srgbClr val="000000"/>
              </a:solidFill>
              <a:latin typeface="맑은 고딕" panose="020B0503020000020004" pitchFamily="50" charset="-127"/>
              <a:cs typeface="굴림" panose="020B0600000101010101" pitchFamily="50" charset="-127"/>
            </a:endParaRPr>
          </a:p>
          <a:p>
            <a:pPr algn="just" latinLnBrk="1">
              <a:lnSpc>
                <a:spcPct val="150000"/>
              </a:lnSpc>
              <a:spcAft>
                <a:spcPts val="800"/>
              </a:spcAft>
            </a:pPr>
            <a:r>
              <a:rPr lang="en-US" altLang="ko-KR" sz="2400" kern="100" baseline="30000" dirty="0">
                <a:solidFill>
                  <a:srgbClr val="000000"/>
                </a:solidFill>
                <a:latin typeface="Times New Roman" panose="02020603050405020304" pitchFamily="18" charset="0"/>
              </a:rPr>
              <a:t>1</a:t>
            </a:r>
            <a:r>
              <a:rPr lang="en-US" altLang="ko-KR" sz="2400" kern="100" dirty="0">
                <a:solidFill>
                  <a:srgbClr val="000000"/>
                </a:solidFill>
                <a:latin typeface="Times New Roman" panose="02020603050405020304" pitchFamily="18" charset="0"/>
              </a:rPr>
              <a:t>Deparment of Biomedical Sciences, Seoul National University College of Medicine, 103 </a:t>
            </a:r>
            <a:r>
              <a:rPr lang="en-US" altLang="ko-KR" sz="2400" kern="100" dirty="0" err="1">
                <a:solidFill>
                  <a:srgbClr val="000000"/>
                </a:solidFill>
                <a:latin typeface="Times New Roman" panose="02020603050405020304" pitchFamily="18" charset="0"/>
              </a:rPr>
              <a:t>Daehakro</a:t>
            </a:r>
            <a:r>
              <a:rPr lang="en-US" altLang="ko-KR" sz="2400" kern="100" dirty="0">
                <a:solidFill>
                  <a:srgbClr val="000000"/>
                </a:solidFill>
                <a:latin typeface="Times New Roman" panose="02020603050405020304" pitchFamily="18" charset="0"/>
              </a:rPr>
              <a:t>, Seoul, Korea.</a:t>
            </a:r>
            <a:endParaRPr lang="ko-KR" altLang="ko-KR" sz="2400" kern="100" dirty="0">
              <a:latin typeface="Times New Roman" panose="02020603050405020304" pitchFamily="18" charset="0"/>
            </a:endParaRPr>
          </a:p>
          <a:p>
            <a:pPr algn="just" latinLnBrk="1">
              <a:lnSpc>
                <a:spcPct val="150000"/>
              </a:lnSpc>
              <a:spcAft>
                <a:spcPts val="800"/>
              </a:spcAft>
            </a:pPr>
            <a:r>
              <a:rPr lang="en-US" altLang="ko-KR" sz="2400" kern="100" baseline="30000" dirty="0">
                <a:solidFill>
                  <a:srgbClr val="000000"/>
                </a:solidFill>
                <a:latin typeface="Times New Roman" panose="02020603050405020304" pitchFamily="18" charset="0"/>
              </a:rPr>
              <a:t>2</a:t>
            </a:r>
            <a:r>
              <a:rPr lang="en-US" altLang="ko-KR" sz="2400" kern="100" dirty="0">
                <a:solidFill>
                  <a:srgbClr val="000000"/>
                </a:solidFill>
                <a:latin typeface="Times New Roman" panose="02020603050405020304" pitchFamily="18" charset="0"/>
              </a:rPr>
              <a:t>Interdisciplinary Program for Bioengineering, Seoul National University College of Engineering, Seoul, Korea.</a:t>
            </a:r>
            <a:endParaRPr lang="ko-KR" altLang="ko-KR" sz="2400" kern="100" dirty="0">
              <a:latin typeface="Times New Roman" panose="02020603050405020304" pitchFamily="18" charset="0"/>
            </a:endParaRPr>
          </a:p>
          <a:p>
            <a:pPr algn="just" latinLnBrk="1">
              <a:lnSpc>
                <a:spcPct val="150000"/>
              </a:lnSpc>
              <a:spcAft>
                <a:spcPts val="800"/>
              </a:spcAft>
            </a:pPr>
            <a:r>
              <a:rPr lang="en-US" altLang="ko-KR" sz="2400" kern="100" baseline="30000" dirty="0">
                <a:solidFill>
                  <a:srgbClr val="000000"/>
                </a:solidFill>
                <a:latin typeface="Times New Roman" panose="02020603050405020304" pitchFamily="18" charset="0"/>
              </a:rPr>
              <a:t>3</a:t>
            </a:r>
            <a:r>
              <a:rPr lang="en-US" altLang="ko-KR" sz="2400" kern="100" dirty="0">
                <a:solidFill>
                  <a:srgbClr val="000000"/>
                </a:solidFill>
                <a:latin typeface="Times New Roman" panose="02020603050405020304" pitchFamily="18" charset="0"/>
              </a:rPr>
              <a:t>Biomedical Research Institute, Seoul National University Hospital, 101 </a:t>
            </a:r>
            <a:r>
              <a:rPr lang="en-US" altLang="ko-KR" sz="2400" kern="100" dirty="0" err="1">
                <a:solidFill>
                  <a:srgbClr val="000000"/>
                </a:solidFill>
                <a:latin typeface="Times New Roman" panose="02020603050405020304" pitchFamily="18" charset="0"/>
              </a:rPr>
              <a:t>Daehakro</a:t>
            </a:r>
            <a:r>
              <a:rPr lang="en-US" altLang="ko-KR" sz="2400" kern="100" dirty="0">
                <a:solidFill>
                  <a:srgbClr val="000000"/>
                </a:solidFill>
                <a:latin typeface="Times New Roman" panose="02020603050405020304" pitchFamily="18" charset="0"/>
              </a:rPr>
              <a:t>, Seoul, Korea.</a:t>
            </a:r>
            <a:endParaRPr lang="ko-KR" altLang="ko-KR" sz="2400" kern="100" dirty="0">
              <a:latin typeface="Times New Roman" panose="02020603050405020304" pitchFamily="18" charset="0"/>
            </a:endParaRPr>
          </a:p>
          <a:p>
            <a:pPr algn="just" latinLnBrk="1">
              <a:lnSpc>
                <a:spcPct val="150000"/>
              </a:lnSpc>
              <a:spcAft>
                <a:spcPts val="800"/>
              </a:spcAft>
            </a:pPr>
            <a:r>
              <a:rPr lang="en-US" altLang="ko-KR" sz="2400" kern="100" baseline="30000" dirty="0">
                <a:solidFill>
                  <a:srgbClr val="000000"/>
                </a:solidFill>
                <a:latin typeface="Times New Roman" panose="02020603050405020304" pitchFamily="18" charset="0"/>
              </a:rPr>
              <a:t>4</a:t>
            </a:r>
            <a:r>
              <a:rPr lang="en-US" altLang="ko-KR" sz="2400" kern="100" dirty="0">
                <a:solidFill>
                  <a:srgbClr val="000000"/>
                </a:solidFill>
                <a:latin typeface="Times New Roman" panose="02020603050405020304" pitchFamily="18" charset="0"/>
              </a:rPr>
              <a:t>Deparment of Pathology, Seoul National University Hospital, 101 </a:t>
            </a:r>
            <a:r>
              <a:rPr lang="en-US" altLang="ko-KR" sz="2400" kern="100" dirty="0" err="1">
                <a:solidFill>
                  <a:srgbClr val="000000"/>
                </a:solidFill>
                <a:latin typeface="Times New Roman" panose="02020603050405020304" pitchFamily="18" charset="0"/>
              </a:rPr>
              <a:t>Daehakro</a:t>
            </a:r>
            <a:r>
              <a:rPr lang="en-US" altLang="ko-KR" sz="2400" kern="100" dirty="0">
                <a:solidFill>
                  <a:srgbClr val="000000"/>
                </a:solidFill>
                <a:latin typeface="Times New Roman" panose="02020603050405020304" pitchFamily="18" charset="0"/>
              </a:rPr>
              <a:t>, Seoul, Korea.</a:t>
            </a:r>
            <a:endParaRPr lang="ko-KR" altLang="ko-KR" sz="2400" kern="100" dirty="0">
              <a:latin typeface="Times New Roman" panose="02020603050405020304" pitchFamily="18" charset="0"/>
            </a:endParaRPr>
          </a:p>
        </p:txBody>
      </p:sp>
      <p:sp>
        <p:nvSpPr>
          <p:cNvPr id="6" name="TextBox 5"/>
          <p:cNvSpPr txBox="1"/>
          <p:nvPr/>
        </p:nvSpPr>
        <p:spPr>
          <a:xfrm>
            <a:off x="4827869" y="9744075"/>
            <a:ext cx="4544296" cy="523220"/>
          </a:xfrm>
          <a:prstGeom prst="rect">
            <a:avLst/>
          </a:prstGeom>
          <a:noFill/>
        </p:spPr>
        <p:txBody>
          <a:bodyPr wrap="square" rtlCol="0">
            <a:spAutoFit/>
          </a:bodyPr>
          <a:lstStyle/>
          <a:p>
            <a:r>
              <a:rPr lang="en-US" altLang="ko-KR" sz="2800" b="1" smtClean="0">
                <a:latin typeface="Arial" panose="020B0604020202020204" pitchFamily="34" charset="0"/>
                <a:cs typeface="Arial" panose="020B0604020202020204" pitchFamily="34" charset="0"/>
              </a:rPr>
              <a:t>Supplementary Figures</a:t>
            </a:r>
            <a:endParaRPr lang="ko-KR" altLang="en-US" sz="28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150903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그림 19"/>
          <p:cNvPicPr>
            <a:picLocks noChangeAspect="1"/>
          </p:cNvPicPr>
          <p:nvPr/>
        </p:nvPicPr>
        <p:blipFill rotWithShape="1">
          <a:blip r:embed="rId2"/>
          <a:srcRect l="3156" t="3715" r="6091" b="2927"/>
          <a:stretch/>
        </p:blipFill>
        <p:spPr>
          <a:xfrm>
            <a:off x="868046" y="7373121"/>
            <a:ext cx="5988957" cy="5746630"/>
          </a:xfrm>
          <a:prstGeom prst="rect">
            <a:avLst/>
          </a:prstGeom>
        </p:spPr>
      </p:pic>
      <p:sp>
        <p:nvSpPr>
          <p:cNvPr id="22" name="TextBox 21"/>
          <p:cNvSpPr txBox="1"/>
          <p:nvPr/>
        </p:nvSpPr>
        <p:spPr>
          <a:xfrm>
            <a:off x="5331469" y="11313413"/>
            <a:ext cx="1177267" cy="338554"/>
          </a:xfrm>
          <a:prstGeom prst="rect">
            <a:avLst/>
          </a:prstGeom>
          <a:noFill/>
        </p:spPr>
        <p:txBody>
          <a:bodyPr wrap="square" rtlCol="0">
            <a:spAutoFit/>
          </a:bodyPr>
          <a:lstStyle/>
          <a:p>
            <a:pPr algn="ctr"/>
            <a:r>
              <a:rPr lang="en-US" altLang="ko-KR" sz="1600" b="1" dirty="0" smtClean="0">
                <a:latin typeface="Arial" panose="020B0604020202020204" pitchFamily="34" charset="0"/>
                <a:cs typeface="Arial" panose="020B0604020202020204" pitchFamily="34" charset="0"/>
              </a:rPr>
              <a:t>TUBB2A</a:t>
            </a:r>
            <a:endParaRPr lang="ko-KR" altLang="en-US" sz="1600" b="1" dirty="0">
              <a:latin typeface="Arial" panose="020B0604020202020204" pitchFamily="34" charset="0"/>
              <a:cs typeface="Arial" panose="020B0604020202020204" pitchFamily="34" charset="0"/>
            </a:endParaRPr>
          </a:p>
        </p:txBody>
      </p:sp>
      <p:pic>
        <p:nvPicPr>
          <p:cNvPr id="23" name="그림 22"/>
          <p:cNvPicPr>
            <a:picLocks noChangeAspect="1"/>
          </p:cNvPicPr>
          <p:nvPr/>
        </p:nvPicPr>
        <p:blipFill>
          <a:blip r:embed="rId3"/>
          <a:stretch>
            <a:fillRect/>
          </a:stretch>
        </p:blipFill>
        <p:spPr>
          <a:xfrm>
            <a:off x="7909590" y="7547944"/>
            <a:ext cx="4735906" cy="4748207"/>
          </a:xfrm>
          <a:prstGeom prst="rect">
            <a:avLst/>
          </a:prstGeom>
        </p:spPr>
      </p:pic>
      <p:sp>
        <p:nvSpPr>
          <p:cNvPr id="24" name="TextBox 23"/>
          <p:cNvSpPr txBox="1"/>
          <p:nvPr/>
        </p:nvSpPr>
        <p:spPr>
          <a:xfrm rot="16200000">
            <a:off x="5847843" y="9532946"/>
            <a:ext cx="2569739" cy="400110"/>
          </a:xfrm>
          <a:prstGeom prst="rect">
            <a:avLst/>
          </a:prstGeom>
          <a:noFill/>
        </p:spPr>
        <p:txBody>
          <a:bodyPr wrap="square" rtlCol="0">
            <a:spAutoFit/>
          </a:bodyPr>
          <a:lstStyle/>
          <a:p>
            <a:r>
              <a:rPr lang="en-US" altLang="ko-KR" sz="2000" b="1" dirty="0" err="1" smtClean="0">
                <a:latin typeface="Arial" panose="020B0604020202020204" pitchFamily="34" charset="0"/>
                <a:cs typeface="Arial" panose="020B0604020202020204" pitchFamily="34" charset="0"/>
              </a:rPr>
              <a:t>Reprot</a:t>
            </a:r>
            <a:r>
              <a:rPr lang="en-US" altLang="ko-KR" sz="2000" b="1" dirty="0" smtClean="0">
                <a:latin typeface="Arial" panose="020B0604020202020204" pitchFamily="34" charset="0"/>
                <a:cs typeface="Arial" panose="020B0604020202020204" pitchFamily="34" charset="0"/>
              </a:rPr>
              <a:t> ion intensity</a:t>
            </a:r>
            <a:endParaRPr lang="ko-KR" altLang="en-US" sz="2000" b="1" dirty="0">
              <a:latin typeface="Arial" panose="020B0604020202020204" pitchFamily="34" charset="0"/>
              <a:cs typeface="Arial" panose="020B0604020202020204" pitchFamily="34" charset="0"/>
            </a:endParaRPr>
          </a:p>
        </p:txBody>
      </p:sp>
      <p:sp>
        <p:nvSpPr>
          <p:cNvPr id="25" name="TextBox 24"/>
          <p:cNvSpPr txBox="1"/>
          <p:nvPr/>
        </p:nvSpPr>
        <p:spPr>
          <a:xfrm>
            <a:off x="7341736" y="7544799"/>
            <a:ext cx="781994" cy="369332"/>
          </a:xfrm>
          <a:prstGeom prst="rect">
            <a:avLst/>
          </a:prstGeom>
          <a:noFill/>
        </p:spPr>
        <p:txBody>
          <a:bodyPr wrap="square" rtlCol="0">
            <a:spAutoFit/>
          </a:bodyPr>
          <a:lstStyle/>
          <a:p>
            <a:r>
              <a:rPr lang="en-US" altLang="ko-KR" b="1" dirty="0" smtClean="0"/>
              <a:t>22000</a:t>
            </a:r>
            <a:endParaRPr lang="ko-KR" altLang="en-US" b="1" dirty="0"/>
          </a:p>
        </p:txBody>
      </p:sp>
      <p:sp>
        <p:nvSpPr>
          <p:cNvPr id="26" name="TextBox 25"/>
          <p:cNvSpPr txBox="1"/>
          <p:nvPr/>
        </p:nvSpPr>
        <p:spPr>
          <a:xfrm>
            <a:off x="7335386" y="8099455"/>
            <a:ext cx="794694" cy="369332"/>
          </a:xfrm>
          <a:prstGeom prst="rect">
            <a:avLst/>
          </a:prstGeom>
          <a:noFill/>
        </p:spPr>
        <p:txBody>
          <a:bodyPr wrap="square" rtlCol="0">
            <a:spAutoFit/>
          </a:bodyPr>
          <a:lstStyle/>
          <a:p>
            <a:r>
              <a:rPr lang="en-US" altLang="ko-KR" b="1" dirty="0" smtClean="0"/>
              <a:t>20000</a:t>
            </a:r>
            <a:endParaRPr lang="ko-KR" altLang="en-US" b="1" dirty="0"/>
          </a:p>
        </p:txBody>
      </p:sp>
      <p:sp>
        <p:nvSpPr>
          <p:cNvPr id="27" name="TextBox 26"/>
          <p:cNvSpPr txBox="1"/>
          <p:nvPr/>
        </p:nvSpPr>
        <p:spPr>
          <a:xfrm>
            <a:off x="7335386" y="8701774"/>
            <a:ext cx="794694" cy="369332"/>
          </a:xfrm>
          <a:prstGeom prst="rect">
            <a:avLst/>
          </a:prstGeom>
          <a:noFill/>
        </p:spPr>
        <p:txBody>
          <a:bodyPr wrap="square" rtlCol="0">
            <a:spAutoFit/>
          </a:bodyPr>
          <a:lstStyle/>
          <a:p>
            <a:r>
              <a:rPr lang="en-US" altLang="ko-KR" b="1" dirty="0" smtClean="0"/>
              <a:t>18000</a:t>
            </a:r>
            <a:endParaRPr lang="ko-KR" altLang="en-US" b="1" dirty="0"/>
          </a:p>
        </p:txBody>
      </p:sp>
      <p:sp>
        <p:nvSpPr>
          <p:cNvPr id="28" name="TextBox 27"/>
          <p:cNvSpPr txBox="1"/>
          <p:nvPr/>
        </p:nvSpPr>
        <p:spPr>
          <a:xfrm>
            <a:off x="7329036" y="9332705"/>
            <a:ext cx="794694" cy="369332"/>
          </a:xfrm>
          <a:prstGeom prst="rect">
            <a:avLst/>
          </a:prstGeom>
          <a:noFill/>
        </p:spPr>
        <p:txBody>
          <a:bodyPr wrap="square" rtlCol="0">
            <a:spAutoFit/>
          </a:bodyPr>
          <a:lstStyle/>
          <a:p>
            <a:r>
              <a:rPr lang="en-US" altLang="ko-KR" b="1" dirty="0" smtClean="0"/>
              <a:t>16000</a:t>
            </a:r>
            <a:endParaRPr lang="ko-KR" altLang="en-US" b="1" dirty="0"/>
          </a:p>
        </p:txBody>
      </p:sp>
      <p:sp>
        <p:nvSpPr>
          <p:cNvPr id="29" name="TextBox 28"/>
          <p:cNvSpPr txBox="1"/>
          <p:nvPr/>
        </p:nvSpPr>
        <p:spPr>
          <a:xfrm>
            <a:off x="7341736" y="9960840"/>
            <a:ext cx="794694" cy="369332"/>
          </a:xfrm>
          <a:prstGeom prst="rect">
            <a:avLst/>
          </a:prstGeom>
          <a:noFill/>
        </p:spPr>
        <p:txBody>
          <a:bodyPr wrap="square" rtlCol="0">
            <a:spAutoFit/>
          </a:bodyPr>
          <a:lstStyle/>
          <a:p>
            <a:r>
              <a:rPr lang="en-US" altLang="ko-KR" b="1" dirty="0" smtClean="0"/>
              <a:t>14000</a:t>
            </a:r>
            <a:endParaRPr lang="ko-KR" altLang="en-US" b="1" dirty="0"/>
          </a:p>
        </p:txBody>
      </p:sp>
      <p:sp>
        <p:nvSpPr>
          <p:cNvPr id="30" name="TextBox 29"/>
          <p:cNvSpPr txBox="1"/>
          <p:nvPr/>
        </p:nvSpPr>
        <p:spPr>
          <a:xfrm>
            <a:off x="7341736" y="10553161"/>
            <a:ext cx="794694" cy="369332"/>
          </a:xfrm>
          <a:prstGeom prst="rect">
            <a:avLst/>
          </a:prstGeom>
          <a:noFill/>
        </p:spPr>
        <p:txBody>
          <a:bodyPr wrap="square" rtlCol="0">
            <a:spAutoFit/>
          </a:bodyPr>
          <a:lstStyle/>
          <a:p>
            <a:r>
              <a:rPr lang="en-US" altLang="ko-KR" b="1" dirty="0" smtClean="0"/>
              <a:t>12000</a:t>
            </a:r>
            <a:endParaRPr lang="ko-KR" altLang="en-US" b="1" dirty="0"/>
          </a:p>
        </p:txBody>
      </p:sp>
      <p:sp>
        <p:nvSpPr>
          <p:cNvPr id="31" name="TextBox 30"/>
          <p:cNvSpPr txBox="1"/>
          <p:nvPr/>
        </p:nvSpPr>
        <p:spPr>
          <a:xfrm>
            <a:off x="7335386" y="11181881"/>
            <a:ext cx="794694" cy="369332"/>
          </a:xfrm>
          <a:prstGeom prst="rect">
            <a:avLst/>
          </a:prstGeom>
          <a:noFill/>
        </p:spPr>
        <p:txBody>
          <a:bodyPr wrap="square" rtlCol="0">
            <a:spAutoFit/>
          </a:bodyPr>
          <a:lstStyle/>
          <a:p>
            <a:r>
              <a:rPr lang="en-US" altLang="ko-KR" b="1" dirty="0" smtClean="0"/>
              <a:t>10000</a:t>
            </a:r>
            <a:endParaRPr lang="ko-KR" altLang="en-US" b="1" dirty="0"/>
          </a:p>
        </p:txBody>
      </p:sp>
      <p:sp>
        <p:nvSpPr>
          <p:cNvPr id="32" name="TextBox 31"/>
          <p:cNvSpPr txBox="1"/>
          <p:nvPr/>
        </p:nvSpPr>
        <p:spPr>
          <a:xfrm>
            <a:off x="7428297" y="11761410"/>
            <a:ext cx="794694" cy="369332"/>
          </a:xfrm>
          <a:prstGeom prst="rect">
            <a:avLst/>
          </a:prstGeom>
          <a:noFill/>
        </p:spPr>
        <p:txBody>
          <a:bodyPr wrap="square" rtlCol="0">
            <a:spAutoFit/>
          </a:bodyPr>
          <a:lstStyle/>
          <a:p>
            <a:r>
              <a:rPr lang="en-US" altLang="ko-KR" b="1" dirty="0"/>
              <a:t>8</a:t>
            </a:r>
            <a:r>
              <a:rPr lang="en-US" altLang="ko-KR" b="1" dirty="0" smtClean="0"/>
              <a:t>000</a:t>
            </a:r>
            <a:endParaRPr lang="ko-KR" altLang="en-US" b="1" dirty="0"/>
          </a:p>
        </p:txBody>
      </p:sp>
      <p:sp>
        <p:nvSpPr>
          <p:cNvPr id="33" name="타원 32"/>
          <p:cNvSpPr/>
          <p:nvPr/>
        </p:nvSpPr>
        <p:spPr>
          <a:xfrm>
            <a:off x="9315359" y="10737827"/>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34" name="직선 연결선 33"/>
          <p:cNvCxnSpPr/>
          <p:nvPr/>
        </p:nvCxnSpPr>
        <p:spPr>
          <a:xfrm>
            <a:off x="8595087" y="10386892"/>
            <a:ext cx="3404725" cy="21252"/>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5" name="타원 34"/>
          <p:cNvSpPr/>
          <p:nvPr/>
        </p:nvSpPr>
        <p:spPr>
          <a:xfrm>
            <a:off x="9216935" y="10517259"/>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6" name="타원 35"/>
          <p:cNvSpPr/>
          <p:nvPr/>
        </p:nvSpPr>
        <p:spPr>
          <a:xfrm>
            <a:off x="9315360" y="10611631"/>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7" name="타원 36"/>
          <p:cNvSpPr/>
          <p:nvPr/>
        </p:nvSpPr>
        <p:spPr>
          <a:xfrm>
            <a:off x="9327029" y="10482485"/>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8" name="타원 37"/>
          <p:cNvSpPr/>
          <p:nvPr/>
        </p:nvSpPr>
        <p:spPr>
          <a:xfrm>
            <a:off x="9428520" y="10441421"/>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9" name="타원 38"/>
          <p:cNvSpPr/>
          <p:nvPr/>
        </p:nvSpPr>
        <p:spPr>
          <a:xfrm>
            <a:off x="9324199" y="11517776"/>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0" name="타원 39"/>
          <p:cNvSpPr/>
          <p:nvPr/>
        </p:nvSpPr>
        <p:spPr>
          <a:xfrm>
            <a:off x="9350284" y="11426286"/>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1" name="타원 40"/>
          <p:cNvSpPr/>
          <p:nvPr/>
        </p:nvSpPr>
        <p:spPr>
          <a:xfrm>
            <a:off x="9324199" y="11790635"/>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2" name="타원 41"/>
          <p:cNvSpPr/>
          <p:nvPr/>
        </p:nvSpPr>
        <p:spPr>
          <a:xfrm>
            <a:off x="10892547" y="10227031"/>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3" name="타원 42"/>
          <p:cNvSpPr/>
          <p:nvPr/>
        </p:nvSpPr>
        <p:spPr>
          <a:xfrm>
            <a:off x="10826538" y="10063594"/>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4" name="타원 43"/>
          <p:cNvSpPr/>
          <p:nvPr/>
        </p:nvSpPr>
        <p:spPr>
          <a:xfrm>
            <a:off x="10872006" y="10825184"/>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5" name="타원 44"/>
          <p:cNvSpPr/>
          <p:nvPr/>
        </p:nvSpPr>
        <p:spPr>
          <a:xfrm>
            <a:off x="10875569" y="8437750"/>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6" name="타원 45"/>
          <p:cNvSpPr/>
          <p:nvPr/>
        </p:nvSpPr>
        <p:spPr>
          <a:xfrm>
            <a:off x="10875569" y="7868789"/>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7" name="타원 46"/>
          <p:cNvSpPr/>
          <p:nvPr/>
        </p:nvSpPr>
        <p:spPr>
          <a:xfrm>
            <a:off x="10938015" y="10011932"/>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8" name="타원 47"/>
          <p:cNvSpPr/>
          <p:nvPr/>
        </p:nvSpPr>
        <p:spPr>
          <a:xfrm>
            <a:off x="10872007" y="8856877"/>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9" name="타원 48"/>
          <p:cNvSpPr/>
          <p:nvPr/>
        </p:nvSpPr>
        <p:spPr>
          <a:xfrm>
            <a:off x="10872006" y="9320364"/>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0" name="타원 49"/>
          <p:cNvSpPr/>
          <p:nvPr/>
        </p:nvSpPr>
        <p:spPr>
          <a:xfrm>
            <a:off x="10872006" y="11136539"/>
            <a:ext cx="90935" cy="90684"/>
          </a:xfrm>
          <a:prstGeom prst="ellipse">
            <a:avLst/>
          </a:prstGeom>
          <a:solidFill>
            <a:schemeClr val="tx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1" name="TextBox 50"/>
          <p:cNvSpPr txBox="1"/>
          <p:nvPr/>
        </p:nvSpPr>
        <p:spPr>
          <a:xfrm>
            <a:off x="8484073" y="9536664"/>
            <a:ext cx="2120063" cy="784830"/>
          </a:xfrm>
          <a:prstGeom prst="rect">
            <a:avLst/>
          </a:prstGeom>
          <a:noFill/>
        </p:spPr>
        <p:txBody>
          <a:bodyPr wrap="square" rtlCol="0">
            <a:spAutoFit/>
          </a:bodyPr>
          <a:lstStyle/>
          <a:p>
            <a:r>
              <a:rPr lang="en-US" altLang="ko-KR" sz="1500" b="1" dirty="0" smtClean="0">
                <a:latin typeface="Arial" panose="020B0604020202020204" pitchFamily="34" charset="0"/>
                <a:cs typeface="Arial" panose="020B0604020202020204" pitchFamily="34" charset="0"/>
              </a:rPr>
              <a:t>Threshold: 13178</a:t>
            </a:r>
          </a:p>
          <a:p>
            <a:r>
              <a:rPr lang="en-US" altLang="ko-KR" sz="1500" b="1" dirty="0" smtClean="0">
                <a:latin typeface="Arial" panose="020B0604020202020204" pitchFamily="34" charset="0"/>
                <a:cs typeface="Arial" panose="020B0604020202020204" pitchFamily="34" charset="0"/>
              </a:rPr>
              <a:t>Sensitivity (%): 78</a:t>
            </a:r>
          </a:p>
          <a:p>
            <a:r>
              <a:rPr lang="en-US" altLang="ko-KR" sz="1500" b="1" dirty="0" smtClean="0">
                <a:latin typeface="Arial" panose="020B0604020202020204" pitchFamily="34" charset="0"/>
                <a:cs typeface="Arial" panose="020B0604020202020204" pitchFamily="34" charset="0"/>
              </a:rPr>
              <a:t>Specificity (%): 100</a:t>
            </a:r>
            <a:endParaRPr lang="ko-KR" altLang="en-US" sz="1500" b="1" dirty="0">
              <a:latin typeface="Arial" panose="020B0604020202020204" pitchFamily="34" charset="0"/>
              <a:cs typeface="Arial" panose="020B0604020202020204" pitchFamily="34" charset="0"/>
            </a:endParaRPr>
          </a:p>
        </p:txBody>
      </p:sp>
      <p:cxnSp>
        <p:nvCxnSpPr>
          <p:cNvPr id="52" name="직선 연결선 51"/>
          <p:cNvCxnSpPr/>
          <p:nvPr/>
        </p:nvCxnSpPr>
        <p:spPr>
          <a:xfrm>
            <a:off x="10977357" y="11978160"/>
            <a:ext cx="0" cy="192187"/>
          </a:xfrm>
          <a:prstGeom prst="line">
            <a:avLst/>
          </a:prstGeom>
          <a:ln w="44450">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8704285" y="12296151"/>
            <a:ext cx="1607754" cy="369332"/>
          </a:xfrm>
          <a:prstGeom prst="rect">
            <a:avLst/>
          </a:prstGeom>
          <a:noFill/>
        </p:spPr>
        <p:txBody>
          <a:bodyPr wrap="square" rtlCol="0">
            <a:spAutoFit/>
          </a:bodyPr>
          <a:lstStyle/>
          <a:p>
            <a:r>
              <a:rPr lang="en-US" altLang="ko-KR" b="1" dirty="0" err="1" smtClean="0">
                <a:latin typeface="Arial" panose="020B0604020202020204" pitchFamily="34" charset="0"/>
                <a:cs typeface="Arial" panose="020B0604020202020204" pitchFamily="34" charset="0"/>
              </a:rPr>
              <a:t>Nondis</a:t>
            </a:r>
            <a:r>
              <a:rPr lang="en-US" altLang="ko-KR" b="1" dirty="0" smtClean="0">
                <a:latin typeface="Arial" panose="020B0604020202020204" pitchFamily="34" charset="0"/>
                <a:cs typeface="Arial" panose="020B0604020202020204" pitchFamily="34" charset="0"/>
              </a:rPr>
              <a:t>-meta</a:t>
            </a:r>
            <a:endParaRPr lang="ko-KR" altLang="en-US" b="1" dirty="0">
              <a:latin typeface="Arial" panose="020B0604020202020204" pitchFamily="34" charset="0"/>
              <a:cs typeface="Arial" panose="020B0604020202020204" pitchFamily="34" charset="0"/>
            </a:endParaRPr>
          </a:p>
        </p:txBody>
      </p:sp>
      <p:sp>
        <p:nvSpPr>
          <p:cNvPr id="54" name="TextBox 53"/>
          <p:cNvSpPr txBox="1"/>
          <p:nvPr/>
        </p:nvSpPr>
        <p:spPr>
          <a:xfrm>
            <a:off x="10499803" y="12301218"/>
            <a:ext cx="1607754"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D</a:t>
            </a:r>
            <a:r>
              <a:rPr lang="en-US" altLang="ko-KR" b="1" dirty="0" smtClean="0">
                <a:latin typeface="Arial" panose="020B0604020202020204" pitchFamily="34" charset="0"/>
                <a:cs typeface="Arial" panose="020B0604020202020204" pitchFamily="34" charset="0"/>
              </a:rPr>
              <a:t>is-meta</a:t>
            </a:r>
            <a:endParaRPr lang="ko-KR" altLang="en-US" b="1" dirty="0">
              <a:latin typeface="Arial" panose="020B0604020202020204" pitchFamily="34" charset="0"/>
              <a:cs typeface="Arial" panose="020B0604020202020204" pitchFamily="34" charset="0"/>
            </a:endParaRPr>
          </a:p>
        </p:txBody>
      </p:sp>
      <p:cxnSp>
        <p:nvCxnSpPr>
          <p:cNvPr id="55" name="직선 연결선 54"/>
          <p:cNvCxnSpPr/>
          <p:nvPr/>
        </p:nvCxnSpPr>
        <p:spPr>
          <a:xfrm>
            <a:off x="9367293" y="11971810"/>
            <a:ext cx="0" cy="182660"/>
          </a:xfrm>
          <a:prstGeom prst="line">
            <a:avLst/>
          </a:prstGeom>
          <a:ln w="44450">
            <a:solidFill>
              <a:schemeClr val="tx1"/>
            </a:solidFill>
          </a:ln>
        </p:spPr>
        <p:style>
          <a:lnRef idx="1">
            <a:schemeClr val="accent1"/>
          </a:lnRef>
          <a:fillRef idx="0">
            <a:schemeClr val="accent1"/>
          </a:fillRef>
          <a:effectRef idx="0">
            <a:schemeClr val="accent1"/>
          </a:effectRef>
          <a:fontRef idx="minor">
            <a:schemeClr val="tx1"/>
          </a:fontRef>
        </p:style>
      </p:cxnSp>
      <p:sp>
        <p:nvSpPr>
          <p:cNvPr id="56" name="TextBox 55"/>
          <p:cNvSpPr txBox="1"/>
          <p:nvPr/>
        </p:nvSpPr>
        <p:spPr>
          <a:xfrm>
            <a:off x="3259000" y="6764359"/>
            <a:ext cx="2818051" cy="461665"/>
          </a:xfrm>
          <a:prstGeom prst="rect">
            <a:avLst/>
          </a:prstGeom>
          <a:noFill/>
        </p:spPr>
        <p:txBody>
          <a:bodyPr wrap="square" rtlCol="0">
            <a:spAutoFit/>
          </a:bodyPr>
          <a:lstStyle/>
          <a:p>
            <a:r>
              <a:rPr lang="en-US" altLang="ko-KR" sz="2400" b="1" dirty="0" smtClean="0">
                <a:latin typeface="Arial" panose="020B0604020202020204" pitchFamily="34" charset="0"/>
                <a:cs typeface="Arial" panose="020B0604020202020204" pitchFamily="34" charset="0"/>
              </a:rPr>
              <a:t>ROC curve</a:t>
            </a:r>
            <a:endParaRPr lang="ko-KR" altLang="en-US" sz="2400" b="1" dirty="0">
              <a:latin typeface="Arial" panose="020B0604020202020204" pitchFamily="34" charset="0"/>
              <a:cs typeface="Arial" panose="020B0604020202020204" pitchFamily="34" charset="0"/>
            </a:endParaRPr>
          </a:p>
        </p:txBody>
      </p:sp>
      <p:sp>
        <p:nvSpPr>
          <p:cNvPr id="57" name="TextBox 56"/>
          <p:cNvSpPr txBox="1"/>
          <p:nvPr/>
        </p:nvSpPr>
        <p:spPr>
          <a:xfrm>
            <a:off x="8484073" y="6764359"/>
            <a:ext cx="3733134" cy="461665"/>
          </a:xfrm>
          <a:prstGeom prst="rect">
            <a:avLst/>
          </a:prstGeom>
          <a:noFill/>
        </p:spPr>
        <p:txBody>
          <a:bodyPr wrap="square" rtlCol="0">
            <a:spAutoFit/>
          </a:bodyPr>
          <a:lstStyle/>
          <a:p>
            <a:r>
              <a:rPr lang="en-US" altLang="ko-KR" sz="2400" b="1" dirty="0" smtClean="0">
                <a:latin typeface="Arial" panose="020B0604020202020204" pitchFamily="34" charset="0"/>
                <a:cs typeface="Arial" panose="020B0604020202020204" pitchFamily="34" charset="0"/>
              </a:rPr>
              <a:t>Interactive dot diagram</a:t>
            </a:r>
            <a:endParaRPr lang="ko-KR" altLang="en-US" sz="2400" b="1" dirty="0">
              <a:latin typeface="Arial" panose="020B0604020202020204" pitchFamily="34" charset="0"/>
              <a:cs typeface="Arial" panose="020B0604020202020204" pitchFamily="34" charset="0"/>
            </a:endParaRPr>
          </a:p>
        </p:txBody>
      </p:sp>
      <p:sp>
        <p:nvSpPr>
          <p:cNvPr id="58" name="직사각형 57"/>
          <p:cNvSpPr/>
          <p:nvPr/>
        </p:nvSpPr>
        <p:spPr>
          <a:xfrm>
            <a:off x="4907548" y="11443698"/>
            <a:ext cx="559438" cy="77984"/>
          </a:xfrm>
          <a:prstGeom prst="rect">
            <a:avLst/>
          </a:prstGeom>
          <a:solidFill>
            <a:srgbClr val="F94040"/>
          </a:solidFill>
          <a:ln>
            <a:solidFill>
              <a:srgbClr val="F9404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2400"/>
          </a:p>
        </p:txBody>
      </p:sp>
      <p:sp>
        <p:nvSpPr>
          <p:cNvPr id="59" name="TextBox 58"/>
          <p:cNvSpPr txBox="1"/>
          <p:nvPr/>
        </p:nvSpPr>
        <p:spPr>
          <a:xfrm>
            <a:off x="9661257" y="7231039"/>
            <a:ext cx="1316100" cy="369332"/>
          </a:xfrm>
          <a:prstGeom prst="rect">
            <a:avLst/>
          </a:prstGeom>
          <a:noFill/>
        </p:spPr>
        <p:txBody>
          <a:bodyPr wrap="square" rtlCol="0">
            <a:spAutoFit/>
          </a:bodyPr>
          <a:lstStyle/>
          <a:p>
            <a:r>
              <a:rPr lang="en-US" altLang="ko-KR" b="1" dirty="0" smtClean="0">
                <a:latin typeface="Arial" panose="020B0604020202020204" pitchFamily="34" charset="0"/>
                <a:cs typeface="Arial" panose="020B0604020202020204" pitchFamily="34" charset="0"/>
              </a:rPr>
              <a:t>TUBB2A</a:t>
            </a:r>
            <a:endParaRPr lang="ko-KR" altLang="en-US" b="1" dirty="0">
              <a:latin typeface="Arial" panose="020B0604020202020204" pitchFamily="34" charset="0"/>
              <a:cs typeface="Arial" panose="020B0604020202020204" pitchFamily="34" charset="0"/>
            </a:endParaRPr>
          </a:p>
        </p:txBody>
      </p:sp>
      <p:sp>
        <p:nvSpPr>
          <p:cNvPr id="65" name="직사각형 64"/>
          <p:cNvSpPr/>
          <p:nvPr/>
        </p:nvSpPr>
        <p:spPr>
          <a:xfrm>
            <a:off x="1127663" y="14027161"/>
            <a:ext cx="12207289" cy="1569660"/>
          </a:xfrm>
          <a:prstGeom prst="rect">
            <a:avLst/>
          </a:prstGeom>
        </p:spPr>
        <p:txBody>
          <a:bodyPr wrap="square">
            <a:spAutoFit/>
          </a:bodyPr>
          <a:lstStyle/>
          <a:p>
            <a:pPr algn="just"/>
            <a:r>
              <a:rPr lang="en-US" altLang="ko-KR" sz="2400" b="1" dirty="0">
                <a:latin typeface="Arial" panose="020B0604020202020204" pitchFamily="34" charset="0"/>
                <a:cs typeface="Arial" panose="020B0604020202020204" pitchFamily="34" charset="0"/>
              </a:rPr>
              <a:t>Additional File 1: Figure </a:t>
            </a:r>
            <a:r>
              <a:rPr lang="en-US" altLang="ko-KR" sz="2400" b="1" dirty="0" smtClean="0">
                <a:latin typeface="Arial" panose="020B0604020202020204" pitchFamily="34" charset="0"/>
                <a:cs typeface="Arial" panose="020B0604020202020204" pitchFamily="34" charset="0"/>
              </a:rPr>
              <a:t>S7. Performance of the novel biomarker TUBB2A in the individual sample set. </a:t>
            </a:r>
            <a:r>
              <a:rPr lang="en-US" altLang="ko-KR" sz="2400" dirty="0" smtClean="0">
                <a:latin typeface="Arial" panose="020B0604020202020204" pitchFamily="34" charset="0"/>
                <a:cs typeface="Arial" panose="020B0604020202020204" pitchFamily="34" charset="0"/>
              </a:rPr>
              <a:t>Table of summary </a:t>
            </a:r>
            <a:r>
              <a:rPr lang="en-US" altLang="ko-KR" sz="2400" dirty="0">
                <a:latin typeface="Arial" panose="020B0604020202020204" pitchFamily="34" charset="0"/>
                <a:cs typeface="Arial" panose="020B0604020202020204" pitchFamily="34" charset="0"/>
              </a:rPr>
              <a:t>s</a:t>
            </a:r>
            <a:r>
              <a:rPr lang="en-US" altLang="ko-KR" sz="2400" dirty="0" smtClean="0">
                <a:latin typeface="Arial" panose="020B0604020202020204" pitchFamily="34" charset="0"/>
                <a:cs typeface="Arial" panose="020B0604020202020204" pitchFamily="34" charset="0"/>
              </a:rPr>
              <a:t>tatistics in ROC analysis, ROC curve with AUC = 0.852, and interactive dot diagram with sensitivity = 78%, specificity = 100%, and reporter ion intensity threshold = 13,178.</a:t>
            </a:r>
            <a:endParaRPr lang="ko-KR" altLang="en-US" sz="2400" dirty="0">
              <a:latin typeface="Arial" panose="020B0604020202020204" pitchFamily="34" charset="0"/>
              <a:cs typeface="Arial" panose="020B0604020202020204" pitchFamily="34" charset="0"/>
            </a:endParaRPr>
          </a:p>
        </p:txBody>
      </p:sp>
      <p:sp>
        <p:nvSpPr>
          <p:cNvPr id="66" name="TextBox 65"/>
          <p:cNvSpPr txBox="1"/>
          <p:nvPr/>
        </p:nvSpPr>
        <p:spPr>
          <a:xfrm>
            <a:off x="2732530" y="8702717"/>
            <a:ext cx="2259987" cy="369332"/>
          </a:xfrm>
          <a:prstGeom prst="rect">
            <a:avLst/>
          </a:prstGeom>
          <a:noFill/>
        </p:spPr>
        <p:txBody>
          <a:bodyPr wrap="square" rtlCol="0">
            <a:spAutoFit/>
          </a:bodyPr>
          <a:lstStyle/>
          <a:p>
            <a:r>
              <a:rPr lang="en-US" altLang="ko-KR" b="1" dirty="0" smtClean="0">
                <a:latin typeface="Arial" panose="020B0604020202020204" pitchFamily="34" charset="0"/>
                <a:cs typeface="Arial" panose="020B0604020202020204" pitchFamily="34" charset="0"/>
              </a:rPr>
              <a:t>AUC = 0.852</a:t>
            </a:r>
            <a:endParaRPr lang="ko-KR" altLang="en-US" b="1" dirty="0">
              <a:latin typeface="Arial" panose="020B0604020202020204" pitchFamily="34" charset="0"/>
              <a:cs typeface="Arial" panose="020B0604020202020204" pitchFamily="34" charset="0"/>
            </a:endParaRPr>
          </a:p>
        </p:txBody>
      </p:sp>
      <p:sp>
        <p:nvSpPr>
          <p:cNvPr id="68" name="TextBox 67"/>
          <p:cNvSpPr txBox="1"/>
          <p:nvPr/>
        </p:nvSpPr>
        <p:spPr>
          <a:xfrm>
            <a:off x="6738167" y="19991959"/>
            <a:ext cx="895350" cy="461665"/>
          </a:xfrm>
          <a:prstGeom prst="rect">
            <a:avLst/>
          </a:prstGeom>
          <a:noFill/>
        </p:spPr>
        <p:txBody>
          <a:bodyPr wrap="square" rtlCol="0">
            <a:spAutoFit/>
          </a:bodyPr>
          <a:lstStyle/>
          <a:p>
            <a:r>
              <a:rPr lang="en-US" altLang="ko-KR" sz="2400" b="1" dirty="0" smtClean="0"/>
              <a:t>S-7</a:t>
            </a:r>
            <a:endParaRPr lang="ko-KR" altLang="en-US" sz="2400" b="1" dirty="0"/>
          </a:p>
        </p:txBody>
      </p:sp>
      <p:pic>
        <p:nvPicPr>
          <p:cNvPr id="70" name="그림 69"/>
          <p:cNvPicPr>
            <a:picLocks noChangeAspect="1"/>
          </p:cNvPicPr>
          <p:nvPr/>
        </p:nvPicPr>
        <p:blipFill rotWithShape="1">
          <a:blip r:embed="rId4"/>
          <a:srcRect r="3063"/>
          <a:stretch/>
        </p:blipFill>
        <p:spPr>
          <a:xfrm>
            <a:off x="3936056" y="1199309"/>
            <a:ext cx="6081561" cy="4863366"/>
          </a:xfrm>
          <a:prstGeom prst="rect">
            <a:avLst/>
          </a:prstGeom>
        </p:spPr>
      </p:pic>
    </p:spTree>
    <p:extLst>
      <p:ext uri="{BB962C8B-B14F-4D97-AF65-F5344CB8AC3E}">
        <p14:creationId xmlns:p14="http://schemas.microsoft.com/office/powerpoint/2010/main" val="87188583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 name="TextBox 40"/>
          <p:cNvSpPr txBox="1"/>
          <p:nvPr/>
        </p:nvSpPr>
        <p:spPr>
          <a:xfrm>
            <a:off x="846104" y="550290"/>
            <a:ext cx="431250" cy="523220"/>
          </a:xfrm>
          <a:prstGeom prst="rect">
            <a:avLst/>
          </a:prstGeom>
          <a:noFill/>
        </p:spPr>
        <p:txBody>
          <a:bodyPr wrap="square" rtlCol="0">
            <a:spAutoFit/>
          </a:bodyPr>
          <a:lstStyle/>
          <a:p>
            <a:pPr algn="just"/>
            <a:r>
              <a:rPr lang="en-US" altLang="ko-KR" sz="2800" b="1">
                <a:latin typeface="Arial" panose="020B0604020202020204" pitchFamily="34" charset="0"/>
                <a:cs typeface="Arial" panose="020B0604020202020204" pitchFamily="34" charset="0"/>
              </a:rPr>
              <a:t>a</a:t>
            </a:r>
          </a:p>
        </p:txBody>
      </p:sp>
      <p:sp>
        <p:nvSpPr>
          <p:cNvPr id="44" name="TextBox 43"/>
          <p:cNvSpPr txBox="1"/>
          <p:nvPr/>
        </p:nvSpPr>
        <p:spPr>
          <a:xfrm>
            <a:off x="794557" y="9558153"/>
            <a:ext cx="482797" cy="523220"/>
          </a:xfrm>
          <a:prstGeom prst="rect">
            <a:avLst/>
          </a:prstGeom>
          <a:noFill/>
        </p:spPr>
        <p:txBody>
          <a:bodyPr wrap="square" rtlCol="0">
            <a:spAutoFit/>
          </a:bodyPr>
          <a:lstStyle/>
          <a:p>
            <a:pPr algn="just"/>
            <a:r>
              <a:rPr lang="en-US" altLang="ko-KR" sz="2800" b="1" dirty="0">
                <a:latin typeface="Arial" panose="020B0604020202020204" pitchFamily="34" charset="0"/>
                <a:cs typeface="Arial" panose="020B0604020202020204" pitchFamily="34" charset="0"/>
              </a:rPr>
              <a:t>b</a:t>
            </a:r>
          </a:p>
        </p:txBody>
      </p:sp>
      <p:sp>
        <p:nvSpPr>
          <p:cNvPr id="7" name="직사각형 6"/>
          <p:cNvSpPr/>
          <p:nvPr/>
        </p:nvSpPr>
        <p:spPr>
          <a:xfrm>
            <a:off x="350193" y="17922101"/>
            <a:ext cx="13545784" cy="1569660"/>
          </a:xfrm>
          <a:prstGeom prst="rect">
            <a:avLst/>
          </a:prstGeom>
        </p:spPr>
        <p:txBody>
          <a:bodyPr wrap="square">
            <a:spAutoFit/>
          </a:bodyPr>
          <a:lstStyle/>
          <a:p>
            <a:pPr algn="just"/>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8. </a:t>
            </a:r>
            <a:r>
              <a:rPr lang="en-US" altLang="ko-KR" sz="2400" b="1" dirty="0">
                <a:latin typeface="Arial" panose="020B0604020202020204" pitchFamily="34" charset="0"/>
                <a:cs typeface="Arial" panose="020B0604020202020204" pitchFamily="34" charset="0"/>
              </a:rPr>
              <a:t>Gene ontology analysis of all 259 DEPs in the two sample sets using The Database for Annotation, Visualization and Integrated Discovery (DAVID).</a:t>
            </a:r>
            <a:r>
              <a:rPr lang="en-US" altLang="ko-KR" sz="2400" dirty="0">
                <a:latin typeface="Arial" panose="020B0604020202020204" pitchFamily="34" charset="0"/>
                <a:cs typeface="Arial" panose="020B0604020202020204" pitchFamily="34" charset="0"/>
              </a:rPr>
              <a:t> (a) Biological process terms of 177 upregulated DEPs. (b) Biological process terms of 82 downregulated DEPs (Fisher’s exact test p-value &lt; 0.05).</a:t>
            </a:r>
          </a:p>
        </p:txBody>
      </p:sp>
      <p:sp>
        <p:nvSpPr>
          <p:cNvPr id="8" name="TextBox 7"/>
          <p:cNvSpPr txBox="1"/>
          <p:nvPr/>
        </p:nvSpPr>
        <p:spPr>
          <a:xfrm>
            <a:off x="6738167" y="19991959"/>
            <a:ext cx="895350" cy="461665"/>
          </a:xfrm>
          <a:prstGeom prst="rect">
            <a:avLst/>
          </a:prstGeom>
          <a:noFill/>
        </p:spPr>
        <p:txBody>
          <a:bodyPr wrap="square" rtlCol="0">
            <a:spAutoFit/>
          </a:bodyPr>
          <a:lstStyle/>
          <a:p>
            <a:r>
              <a:rPr lang="en-US" altLang="ko-KR" sz="2400" b="1" dirty="0" smtClean="0"/>
              <a:t>S-8</a:t>
            </a:r>
            <a:endParaRPr lang="ko-KR" altLang="en-US" sz="2400" b="1" dirty="0"/>
          </a:p>
        </p:txBody>
      </p:sp>
      <p:cxnSp>
        <p:nvCxnSpPr>
          <p:cNvPr id="10" name="직선 연결선 9"/>
          <p:cNvCxnSpPr/>
          <p:nvPr/>
        </p:nvCxnSpPr>
        <p:spPr>
          <a:xfrm>
            <a:off x="2991907" y="8474040"/>
            <a:ext cx="7407802"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직선 연결선 10"/>
          <p:cNvCxnSpPr/>
          <p:nvPr/>
        </p:nvCxnSpPr>
        <p:spPr>
          <a:xfrm flipV="1">
            <a:off x="2998829" y="1356492"/>
            <a:ext cx="0" cy="713139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5519251" y="8932667"/>
            <a:ext cx="3165571" cy="360740"/>
          </a:xfrm>
          <a:prstGeom prst="rect">
            <a:avLst/>
          </a:prstGeom>
          <a:noFill/>
        </p:spPr>
        <p:txBody>
          <a:bodyPr wrap="square" rtlCol="0">
            <a:spAutoFit/>
          </a:bodyPr>
          <a:lstStyle/>
          <a:p>
            <a:r>
              <a:rPr lang="en-US" altLang="ko-KR" sz="1744" b="1" dirty="0">
                <a:latin typeface="Arial" panose="020B0604020202020204" pitchFamily="34" charset="0"/>
                <a:cs typeface="Arial" panose="020B0604020202020204" pitchFamily="34" charset="0"/>
              </a:rPr>
              <a:t>Log</a:t>
            </a:r>
            <a:r>
              <a:rPr lang="en-US" altLang="ko-KR" sz="1744" b="1" baseline="-25000" dirty="0">
                <a:latin typeface="Arial" panose="020B0604020202020204" pitchFamily="34" charset="0"/>
                <a:cs typeface="Arial" panose="020B0604020202020204" pitchFamily="34" charset="0"/>
              </a:rPr>
              <a:t>2</a:t>
            </a:r>
            <a:r>
              <a:rPr lang="en-US" altLang="ko-KR" sz="1744" b="1" dirty="0">
                <a:latin typeface="Arial" panose="020B0604020202020204" pitchFamily="34" charset="0"/>
                <a:cs typeface="Arial" panose="020B0604020202020204" pitchFamily="34" charset="0"/>
              </a:rPr>
              <a:t>(Fold enrichment)</a:t>
            </a:r>
            <a:endParaRPr lang="ko-KR" altLang="en-US" sz="1744" b="1" dirty="0">
              <a:latin typeface="Arial" panose="020B0604020202020204" pitchFamily="34" charset="0"/>
              <a:cs typeface="Arial" panose="020B0604020202020204" pitchFamily="34" charset="0"/>
            </a:endParaRPr>
          </a:p>
        </p:txBody>
      </p:sp>
      <p:sp>
        <p:nvSpPr>
          <p:cNvPr id="13" name="TextBox 12"/>
          <p:cNvSpPr txBox="1"/>
          <p:nvPr/>
        </p:nvSpPr>
        <p:spPr>
          <a:xfrm rot="16200000">
            <a:off x="-356018" y="4407742"/>
            <a:ext cx="4335883" cy="405496"/>
          </a:xfrm>
          <a:prstGeom prst="rect">
            <a:avLst/>
          </a:prstGeom>
          <a:noFill/>
        </p:spPr>
        <p:txBody>
          <a:bodyPr wrap="square" rtlCol="0">
            <a:spAutoFit/>
          </a:bodyPr>
          <a:lstStyle/>
          <a:p>
            <a:r>
              <a:rPr lang="en-US" altLang="ko-KR" sz="1744" b="1" dirty="0">
                <a:latin typeface="Arial" panose="020B0604020202020204" pitchFamily="34" charset="0"/>
                <a:cs typeface="Arial" panose="020B0604020202020204" pitchFamily="34" charset="0"/>
              </a:rPr>
              <a:t>-</a:t>
            </a:r>
            <a:r>
              <a:rPr lang="en-US" altLang="ko-KR" sz="2035" b="1" dirty="0">
                <a:latin typeface="Arial" panose="020B0604020202020204" pitchFamily="34" charset="0"/>
                <a:cs typeface="Arial" panose="020B0604020202020204" pitchFamily="34" charset="0"/>
              </a:rPr>
              <a:t>Log</a:t>
            </a:r>
            <a:r>
              <a:rPr lang="en-US" altLang="ko-KR" sz="2035" b="1" baseline="-25000" dirty="0">
                <a:latin typeface="Arial" panose="020B0604020202020204" pitchFamily="34" charset="0"/>
                <a:cs typeface="Arial" panose="020B0604020202020204" pitchFamily="34" charset="0"/>
              </a:rPr>
              <a:t>10</a:t>
            </a:r>
            <a:r>
              <a:rPr lang="en-US" altLang="ko-KR" sz="2035" b="1" dirty="0">
                <a:latin typeface="Arial" panose="020B0604020202020204" pitchFamily="34" charset="0"/>
                <a:cs typeface="Arial" panose="020B0604020202020204" pitchFamily="34" charset="0"/>
              </a:rPr>
              <a:t>(Fisher’s exact test p-value)</a:t>
            </a:r>
            <a:endParaRPr lang="ko-KR" altLang="en-US" sz="2035" b="1" dirty="0">
              <a:latin typeface="Arial" panose="020B0604020202020204" pitchFamily="34" charset="0"/>
              <a:cs typeface="Arial" panose="020B0604020202020204" pitchFamily="34" charset="0"/>
            </a:endParaRPr>
          </a:p>
        </p:txBody>
      </p:sp>
      <p:sp>
        <p:nvSpPr>
          <p:cNvPr id="14" name="TextBox 13"/>
          <p:cNvSpPr txBox="1"/>
          <p:nvPr/>
        </p:nvSpPr>
        <p:spPr>
          <a:xfrm>
            <a:off x="2791926" y="8506595"/>
            <a:ext cx="7845700" cy="405496"/>
          </a:xfrm>
          <a:prstGeom prst="rect">
            <a:avLst/>
          </a:prstGeom>
          <a:noFill/>
        </p:spPr>
        <p:txBody>
          <a:bodyPr wrap="square" rtlCol="0">
            <a:spAutoFit/>
          </a:bodyPr>
          <a:lstStyle/>
          <a:p>
            <a:r>
              <a:rPr lang="en-US" altLang="ko-KR" sz="2035" b="1" dirty="0">
                <a:latin typeface="Arial" panose="020B0604020202020204" pitchFamily="34" charset="0"/>
                <a:cs typeface="Arial" panose="020B0604020202020204" pitchFamily="34" charset="0"/>
              </a:rPr>
              <a:t> </a:t>
            </a:r>
            <a:r>
              <a:rPr lang="en-US" altLang="ko-KR" sz="1744" b="1" dirty="0">
                <a:latin typeface="Arial" panose="020B0604020202020204" pitchFamily="34" charset="0"/>
                <a:cs typeface="Arial" panose="020B0604020202020204" pitchFamily="34" charset="0"/>
              </a:rPr>
              <a:t>0                  1                  2                 3                 4                  5                 6                 </a:t>
            </a:r>
            <a:endParaRPr lang="ko-KR" altLang="en-US" sz="2035" b="1" dirty="0">
              <a:latin typeface="Arial" panose="020B0604020202020204" pitchFamily="34" charset="0"/>
              <a:cs typeface="Arial" panose="020B0604020202020204" pitchFamily="34" charset="0"/>
            </a:endParaRPr>
          </a:p>
        </p:txBody>
      </p:sp>
      <p:pic>
        <p:nvPicPr>
          <p:cNvPr id="15" name="그림 14"/>
          <p:cNvPicPr>
            <a:picLocks noChangeAspect="1"/>
          </p:cNvPicPr>
          <p:nvPr/>
        </p:nvPicPr>
        <p:blipFill rotWithShape="1">
          <a:blip r:embed="rId2">
            <a:extLst>
              <a:ext uri="{28A0092B-C50C-407E-A947-70E740481C1C}">
                <a14:useLocalDpi xmlns:a14="http://schemas.microsoft.com/office/drawing/2010/main" val="0"/>
              </a:ext>
            </a:extLst>
          </a:blip>
          <a:srcRect l="18782" t="5239" r="2176" b="17443"/>
          <a:stretch/>
        </p:blipFill>
        <p:spPr>
          <a:xfrm>
            <a:off x="4051962" y="550290"/>
            <a:ext cx="6546948" cy="7010214"/>
          </a:xfrm>
          <a:prstGeom prst="rect">
            <a:avLst/>
          </a:prstGeom>
          <a:ln w="38100">
            <a:noFill/>
          </a:ln>
        </p:spPr>
      </p:pic>
      <p:sp>
        <p:nvSpPr>
          <p:cNvPr id="16" name="TextBox 15"/>
          <p:cNvSpPr txBox="1"/>
          <p:nvPr/>
        </p:nvSpPr>
        <p:spPr>
          <a:xfrm>
            <a:off x="9891274" y="4830639"/>
            <a:ext cx="2871233"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de novo’ IMP </a:t>
            </a:r>
          </a:p>
          <a:p>
            <a:r>
              <a:rPr lang="en-US" altLang="ko-KR" sz="1400" b="1" dirty="0">
                <a:latin typeface="Arial" panose="020B0604020202020204" pitchFamily="34" charset="0"/>
                <a:cs typeface="Arial" panose="020B0604020202020204" pitchFamily="34" charset="0"/>
              </a:rPr>
              <a:t>biosynthetic process</a:t>
            </a:r>
            <a:endParaRPr lang="ko-KR" altLang="en-US" sz="1400" b="1" dirty="0">
              <a:latin typeface="Arial" panose="020B0604020202020204" pitchFamily="34" charset="0"/>
              <a:cs typeface="Arial" panose="020B0604020202020204" pitchFamily="34" charset="0"/>
            </a:endParaRPr>
          </a:p>
        </p:txBody>
      </p:sp>
      <p:sp>
        <p:nvSpPr>
          <p:cNvPr id="17" name="TextBox 16"/>
          <p:cNvSpPr txBox="1"/>
          <p:nvPr/>
        </p:nvSpPr>
        <p:spPr>
          <a:xfrm>
            <a:off x="9406083" y="5476534"/>
            <a:ext cx="2994177"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U4 snRNA 3</a:t>
            </a:r>
            <a:r>
              <a:rPr lang="en-US" altLang="ko-KR" sz="1400" b="1" baseline="30000" dirty="0">
                <a:latin typeface="Arial" panose="020B0604020202020204" pitchFamily="34" charset="0"/>
                <a:cs typeface="Arial" panose="020B0604020202020204" pitchFamily="34" charset="0"/>
              </a:rPr>
              <a:t>’</a:t>
            </a:r>
            <a:r>
              <a:rPr lang="en-US" altLang="ko-KR" sz="1400" b="1" dirty="0">
                <a:latin typeface="Arial" panose="020B0604020202020204" pitchFamily="34" charset="0"/>
                <a:cs typeface="Arial" panose="020B0604020202020204" pitchFamily="34" charset="0"/>
              </a:rPr>
              <a:t>-end processing</a:t>
            </a:r>
            <a:endParaRPr lang="ko-KR" altLang="en-US" sz="1400" b="1" dirty="0">
              <a:latin typeface="Arial" panose="020B0604020202020204" pitchFamily="34" charset="0"/>
              <a:cs typeface="Arial" panose="020B0604020202020204" pitchFamily="34" charset="0"/>
            </a:endParaRPr>
          </a:p>
        </p:txBody>
      </p:sp>
      <p:sp>
        <p:nvSpPr>
          <p:cNvPr id="18" name="TextBox 17"/>
          <p:cNvSpPr txBox="1"/>
          <p:nvPr/>
        </p:nvSpPr>
        <p:spPr>
          <a:xfrm>
            <a:off x="7607239" y="2108550"/>
            <a:ext cx="2508899"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Canonical glycolysis</a:t>
            </a:r>
            <a:endParaRPr lang="ko-KR" altLang="en-US" sz="1400" b="1" dirty="0">
              <a:latin typeface="Arial" panose="020B0604020202020204" pitchFamily="34" charset="0"/>
              <a:cs typeface="Arial" panose="020B0604020202020204" pitchFamily="34" charset="0"/>
            </a:endParaRPr>
          </a:p>
        </p:txBody>
      </p:sp>
      <p:sp>
        <p:nvSpPr>
          <p:cNvPr id="19" name="TextBox 18"/>
          <p:cNvSpPr txBox="1"/>
          <p:nvPr/>
        </p:nvSpPr>
        <p:spPr>
          <a:xfrm>
            <a:off x="9131219" y="5800792"/>
            <a:ext cx="3483091"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Nuclear-transcribed mRNA catabolic process, </a:t>
            </a:r>
            <a:r>
              <a:rPr lang="en-US" altLang="ko-KR" sz="1400" b="1" dirty="0" err="1">
                <a:latin typeface="Arial" panose="020B0604020202020204" pitchFamily="34" charset="0"/>
                <a:cs typeface="Arial" panose="020B0604020202020204" pitchFamily="34" charset="0"/>
              </a:rPr>
              <a:t>exonucleolytic</a:t>
            </a:r>
            <a:r>
              <a:rPr lang="en-US" altLang="ko-KR" sz="1400" b="1" dirty="0">
                <a:latin typeface="Arial" panose="020B0604020202020204" pitchFamily="34" charset="0"/>
                <a:cs typeface="Arial" panose="020B0604020202020204" pitchFamily="34" charset="0"/>
              </a:rPr>
              <a:t>, 3</a:t>
            </a:r>
            <a:r>
              <a:rPr lang="en-US" altLang="ko-KR" sz="1400" b="1" baseline="30000" dirty="0">
                <a:latin typeface="Arial" panose="020B0604020202020204" pitchFamily="34" charset="0"/>
                <a:cs typeface="Arial" panose="020B0604020202020204" pitchFamily="34" charset="0"/>
              </a:rPr>
              <a:t>’</a:t>
            </a:r>
            <a:r>
              <a:rPr lang="en-US" altLang="ko-KR" sz="1400" b="1" dirty="0">
                <a:latin typeface="Arial" panose="020B0604020202020204" pitchFamily="34" charset="0"/>
                <a:cs typeface="Arial" panose="020B0604020202020204" pitchFamily="34" charset="0"/>
              </a:rPr>
              <a:t>-5</a:t>
            </a:r>
            <a:r>
              <a:rPr lang="en-US" altLang="ko-KR" sz="1400" b="1" baseline="30000" dirty="0">
                <a:latin typeface="Arial" panose="020B0604020202020204" pitchFamily="34" charset="0"/>
                <a:cs typeface="Arial" panose="020B0604020202020204" pitchFamily="34" charset="0"/>
              </a:rPr>
              <a:t>’</a:t>
            </a:r>
            <a:endParaRPr lang="ko-KR" altLang="en-US" sz="1400" b="1" dirty="0">
              <a:latin typeface="Arial" panose="020B0604020202020204" pitchFamily="34" charset="0"/>
              <a:cs typeface="Arial" panose="020B0604020202020204" pitchFamily="34" charset="0"/>
            </a:endParaRPr>
          </a:p>
        </p:txBody>
      </p:sp>
      <p:sp>
        <p:nvSpPr>
          <p:cNvPr id="20" name="TextBox 19"/>
          <p:cNvSpPr txBox="1"/>
          <p:nvPr/>
        </p:nvSpPr>
        <p:spPr>
          <a:xfrm>
            <a:off x="7551384" y="3260215"/>
            <a:ext cx="5113974" cy="307777"/>
          </a:xfrm>
          <a:prstGeom prst="rect">
            <a:avLst/>
          </a:prstGeom>
          <a:noFill/>
        </p:spPr>
        <p:txBody>
          <a:bodyPr wrap="square" rtlCol="0">
            <a:spAutoFit/>
          </a:bodyPr>
          <a:lstStyle/>
          <a:p>
            <a:r>
              <a:rPr lang="en-US" altLang="ko-KR" sz="1400" b="1" dirty="0" err="1">
                <a:latin typeface="Arial" panose="020B0604020202020204" pitchFamily="34" charset="0"/>
                <a:cs typeface="Arial" panose="020B0604020202020204" pitchFamily="34" charset="0"/>
              </a:rPr>
              <a:t>tRNA</a:t>
            </a:r>
            <a:r>
              <a:rPr lang="en-US" altLang="ko-KR" sz="1400" b="1" dirty="0">
                <a:latin typeface="Arial" panose="020B0604020202020204" pitchFamily="34" charset="0"/>
                <a:cs typeface="Arial" panose="020B0604020202020204" pitchFamily="34" charset="0"/>
              </a:rPr>
              <a:t> </a:t>
            </a:r>
            <a:r>
              <a:rPr lang="en-US" altLang="ko-KR" sz="1400" b="1" dirty="0" err="1">
                <a:latin typeface="Arial" panose="020B0604020202020204" pitchFamily="34" charset="0"/>
                <a:cs typeface="Arial" panose="020B0604020202020204" pitchFamily="34" charset="0"/>
              </a:rPr>
              <a:t>aminoacylation</a:t>
            </a:r>
            <a:r>
              <a:rPr lang="en-US" altLang="ko-KR" sz="1400" b="1" dirty="0">
                <a:latin typeface="Arial" panose="020B0604020202020204" pitchFamily="34" charset="0"/>
                <a:cs typeface="Arial" panose="020B0604020202020204" pitchFamily="34" charset="0"/>
              </a:rPr>
              <a:t> for protein translation</a:t>
            </a:r>
            <a:endParaRPr lang="ko-KR" altLang="en-US" sz="1400" b="1" dirty="0">
              <a:latin typeface="Arial" panose="020B0604020202020204" pitchFamily="34" charset="0"/>
              <a:cs typeface="Arial" panose="020B0604020202020204" pitchFamily="34" charset="0"/>
            </a:endParaRPr>
          </a:p>
        </p:txBody>
      </p:sp>
      <p:sp>
        <p:nvSpPr>
          <p:cNvPr id="21" name="TextBox 20"/>
          <p:cNvSpPr txBox="1"/>
          <p:nvPr/>
        </p:nvSpPr>
        <p:spPr>
          <a:xfrm>
            <a:off x="5185415" y="6002406"/>
            <a:ext cx="2696388"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Microtubule-base process</a:t>
            </a:r>
            <a:endParaRPr lang="ko-KR" altLang="en-US" sz="1400" b="1" dirty="0">
              <a:latin typeface="Arial" panose="020B0604020202020204" pitchFamily="34" charset="0"/>
              <a:cs typeface="Arial" panose="020B0604020202020204" pitchFamily="34" charset="0"/>
            </a:endParaRPr>
          </a:p>
        </p:txBody>
      </p:sp>
      <p:sp>
        <p:nvSpPr>
          <p:cNvPr id="22" name="TextBox 21"/>
          <p:cNvSpPr txBox="1"/>
          <p:nvPr/>
        </p:nvSpPr>
        <p:spPr>
          <a:xfrm>
            <a:off x="7222484" y="4747461"/>
            <a:ext cx="2816410"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Proteolysis involved in cellular protein catabolic process</a:t>
            </a:r>
            <a:endParaRPr lang="ko-KR" altLang="en-US" sz="1400" b="1" dirty="0">
              <a:latin typeface="Arial" panose="020B0604020202020204" pitchFamily="34" charset="0"/>
              <a:cs typeface="Arial" panose="020B0604020202020204" pitchFamily="34" charset="0"/>
            </a:endParaRPr>
          </a:p>
        </p:txBody>
      </p:sp>
      <p:sp>
        <p:nvSpPr>
          <p:cNvPr id="23" name="TextBox 22"/>
          <p:cNvSpPr txBox="1"/>
          <p:nvPr/>
        </p:nvSpPr>
        <p:spPr>
          <a:xfrm>
            <a:off x="4788215" y="4449012"/>
            <a:ext cx="2594864"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NIK/NF-</a:t>
            </a:r>
            <a:r>
              <a:rPr lang="en-US" altLang="ko-KR" sz="1400" b="1" dirty="0" err="1">
                <a:latin typeface="Arial" panose="020B0604020202020204" pitchFamily="34" charset="0"/>
                <a:cs typeface="Arial" panose="020B0604020202020204" pitchFamily="34" charset="0"/>
              </a:rPr>
              <a:t>kappaB</a:t>
            </a:r>
            <a:r>
              <a:rPr lang="en-US" altLang="ko-KR" sz="1400" b="1" dirty="0">
                <a:latin typeface="Arial" panose="020B0604020202020204" pitchFamily="34" charset="0"/>
                <a:cs typeface="Arial" panose="020B0604020202020204" pitchFamily="34" charset="0"/>
              </a:rPr>
              <a:t> signaling</a:t>
            </a:r>
            <a:endParaRPr lang="ko-KR" altLang="en-US" sz="1400" b="1" dirty="0">
              <a:latin typeface="Arial" panose="020B0604020202020204" pitchFamily="34" charset="0"/>
              <a:cs typeface="Arial" panose="020B0604020202020204" pitchFamily="34" charset="0"/>
            </a:endParaRPr>
          </a:p>
        </p:txBody>
      </p:sp>
      <p:sp>
        <p:nvSpPr>
          <p:cNvPr id="24" name="TextBox 23"/>
          <p:cNvSpPr txBox="1"/>
          <p:nvPr/>
        </p:nvSpPr>
        <p:spPr>
          <a:xfrm>
            <a:off x="3940501" y="3627690"/>
            <a:ext cx="2434263"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Cell-cell adhesion</a:t>
            </a:r>
            <a:endParaRPr lang="ko-KR" altLang="en-US" sz="1400" b="1" dirty="0">
              <a:latin typeface="Arial" panose="020B0604020202020204" pitchFamily="34" charset="0"/>
              <a:cs typeface="Arial" panose="020B0604020202020204" pitchFamily="34" charset="0"/>
            </a:endParaRPr>
          </a:p>
        </p:txBody>
      </p:sp>
      <p:sp>
        <p:nvSpPr>
          <p:cNvPr id="25" name="TextBox 24"/>
          <p:cNvSpPr txBox="1"/>
          <p:nvPr/>
        </p:nvSpPr>
        <p:spPr>
          <a:xfrm>
            <a:off x="5693332" y="1215336"/>
            <a:ext cx="3592370"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Regulation of mRNA stability</a:t>
            </a:r>
            <a:endParaRPr lang="ko-KR" altLang="en-US" sz="1400" b="1" dirty="0">
              <a:latin typeface="Arial" panose="020B0604020202020204" pitchFamily="34" charset="0"/>
              <a:cs typeface="Arial" panose="020B0604020202020204" pitchFamily="34" charset="0"/>
            </a:endParaRPr>
          </a:p>
        </p:txBody>
      </p:sp>
      <p:sp>
        <p:nvSpPr>
          <p:cNvPr id="26" name="타원 25"/>
          <p:cNvSpPr/>
          <p:nvPr/>
        </p:nvSpPr>
        <p:spPr>
          <a:xfrm>
            <a:off x="6922818" y="1475628"/>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27" name="타원 26"/>
          <p:cNvSpPr/>
          <p:nvPr/>
        </p:nvSpPr>
        <p:spPr>
          <a:xfrm>
            <a:off x="8436118" y="2387932"/>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28" name="타원 27"/>
          <p:cNvSpPr/>
          <p:nvPr/>
        </p:nvSpPr>
        <p:spPr>
          <a:xfrm>
            <a:off x="7687568" y="3492705"/>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29" name="타원 28"/>
          <p:cNvSpPr/>
          <p:nvPr/>
        </p:nvSpPr>
        <p:spPr>
          <a:xfrm>
            <a:off x="5517933" y="3797855"/>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30" name="타원 29"/>
          <p:cNvSpPr/>
          <p:nvPr/>
        </p:nvSpPr>
        <p:spPr>
          <a:xfrm>
            <a:off x="7030220" y="5208067"/>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31" name="타원 30"/>
          <p:cNvSpPr/>
          <p:nvPr/>
        </p:nvSpPr>
        <p:spPr>
          <a:xfrm>
            <a:off x="6801193" y="4708780"/>
            <a:ext cx="171263"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32" name="타원 31"/>
          <p:cNvSpPr/>
          <p:nvPr/>
        </p:nvSpPr>
        <p:spPr>
          <a:xfrm>
            <a:off x="9315281" y="5578132"/>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p>
        </p:txBody>
      </p:sp>
      <p:sp>
        <p:nvSpPr>
          <p:cNvPr id="33" name="타원 32"/>
          <p:cNvSpPr/>
          <p:nvPr/>
        </p:nvSpPr>
        <p:spPr>
          <a:xfrm>
            <a:off x="7157710" y="5932129"/>
            <a:ext cx="173566"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p>
        </p:txBody>
      </p:sp>
      <p:sp>
        <p:nvSpPr>
          <p:cNvPr id="34" name="타원 33"/>
          <p:cNvSpPr/>
          <p:nvPr/>
        </p:nvSpPr>
        <p:spPr>
          <a:xfrm>
            <a:off x="9099972" y="5723059"/>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p>
        </p:txBody>
      </p:sp>
      <p:sp>
        <p:nvSpPr>
          <p:cNvPr id="35" name="타원 34"/>
          <p:cNvSpPr/>
          <p:nvPr/>
        </p:nvSpPr>
        <p:spPr>
          <a:xfrm>
            <a:off x="9811063" y="5266805"/>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p>
        </p:txBody>
      </p:sp>
      <p:sp>
        <p:nvSpPr>
          <p:cNvPr id="36" name="타원 35"/>
          <p:cNvSpPr/>
          <p:nvPr/>
        </p:nvSpPr>
        <p:spPr>
          <a:xfrm>
            <a:off x="8191699" y="6225836"/>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p>
        </p:txBody>
      </p:sp>
      <p:sp>
        <p:nvSpPr>
          <p:cNvPr id="37" name="TextBox 36"/>
          <p:cNvSpPr txBox="1"/>
          <p:nvPr/>
        </p:nvSpPr>
        <p:spPr>
          <a:xfrm>
            <a:off x="7951193" y="6371686"/>
            <a:ext cx="348309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Regulation of translational fidelity</a:t>
            </a:r>
            <a:endParaRPr lang="ko-KR" altLang="en-US" sz="1400" b="1" dirty="0">
              <a:latin typeface="Arial" panose="020B0604020202020204" pitchFamily="34" charset="0"/>
              <a:cs typeface="Arial" panose="020B0604020202020204" pitchFamily="34" charset="0"/>
            </a:endParaRPr>
          </a:p>
        </p:txBody>
      </p:sp>
      <p:sp>
        <p:nvSpPr>
          <p:cNvPr id="38" name="타원 37"/>
          <p:cNvSpPr/>
          <p:nvPr/>
        </p:nvSpPr>
        <p:spPr>
          <a:xfrm>
            <a:off x="6410341" y="5221012"/>
            <a:ext cx="171263"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p>
        </p:txBody>
      </p:sp>
      <p:sp>
        <p:nvSpPr>
          <p:cNvPr id="39" name="TextBox 38"/>
          <p:cNvSpPr txBox="1"/>
          <p:nvPr/>
        </p:nvSpPr>
        <p:spPr>
          <a:xfrm>
            <a:off x="3860617" y="5132248"/>
            <a:ext cx="2729635"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Retrograde vesicle-mediated </a:t>
            </a:r>
          </a:p>
          <a:p>
            <a:r>
              <a:rPr lang="en-US" altLang="ko-KR" sz="1400" b="1" dirty="0">
                <a:latin typeface="Arial" panose="020B0604020202020204" pitchFamily="34" charset="0"/>
                <a:cs typeface="Arial" panose="020B0604020202020204" pitchFamily="34" charset="0"/>
              </a:rPr>
              <a:t>Transport, Golgi to ER</a:t>
            </a:r>
            <a:endParaRPr lang="ko-KR" altLang="en-US" sz="1400" b="1" dirty="0">
              <a:latin typeface="Arial" panose="020B0604020202020204" pitchFamily="34" charset="0"/>
              <a:cs typeface="Arial" panose="020B0604020202020204" pitchFamily="34" charset="0"/>
            </a:endParaRPr>
          </a:p>
        </p:txBody>
      </p:sp>
      <p:sp>
        <p:nvSpPr>
          <p:cNvPr id="40" name="타원 39"/>
          <p:cNvSpPr/>
          <p:nvPr/>
        </p:nvSpPr>
        <p:spPr>
          <a:xfrm>
            <a:off x="7655141" y="4530715"/>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42" name="TextBox 41"/>
          <p:cNvSpPr txBox="1"/>
          <p:nvPr/>
        </p:nvSpPr>
        <p:spPr>
          <a:xfrm>
            <a:off x="7650208" y="4295123"/>
            <a:ext cx="1785366"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Glycolytic process</a:t>
            </a:r>
            <a:endParaRPr lang="ko-KR" altLang="en-US" sz="1400" b="1" dirty="0">
              <a:latin typeface="Arial" panose="020B0604020202020204" pitchFamily="34" charset="0"/>
              <a:cs typeface="Arial" panose="020B0604020202020204" pitchFamily="34" charset="0"/>
            </a:endParaRPr>
          </a:p>
        </p:txBody>
      </p:sp>
      <p:sp>
        <p:nvSpPr>
          <p:cNvPr id="43" name="타원 42"/>
          <p:cNvSpPr/>
          <p:nvPr/>
        </p:nvSpPr>
        <p:spPr>
          <a:xfrm>
            <a:off x="8095885" y="5143281"/>
            <a:ext cx="185730" cy="178065"/>
          </a:xfrm>
          <a:prstGeom prst="ellipse">
            <a:avLst/>
          </a:prstGeom>
          <a:no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400">
              <a:ln w="38100">
                <a:solidFill>
                  <a:schemeClr val="tx1"/>
                </a:solidFill>
              </a:ln>
            </a:endParaRPr>
          </a:p>
        </p:txBody>
      </p:sp>
      <p:sp>
        <p:nvSpPr>
          <p:cNvPr id="45" name="TextBox 44"/>
          <p:cNvSpPr txBox="1"/>
          <p:nvPr/>
        </p:nvSpPr>
        <p:spPr>
          <a:xfrm>
            <a:off x="6596614" y="5277191"/>
            <a:ext cx="2820303"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Negative regulation of mRNA splicing, via spliceosome</a:t>
            </a:r>
            <a:endParaRPr lang="ko-KR" altLang="en-US" sz="1400" b="1" dirty="0">
              <a:latin typeface="Arial" panose="020B0604020202020204" pitchFamily="34" charset="0"/>
              <a:cs typeface="Arial" panose="020B0604020202020204" pitchFamily="34" charset="0"/>
            </a:endParaRPr>
          </a:p>
        </p:txBody>
      </p:sp>
      <p:cxnSp>
        <p:nvCxnSpPr>
          <p:cNvPr id="47" name="직선 연결선 46"/>
          <p:cNvCxnSpPr/>
          <p:nvPr/>
        </p:nvCxnSpPr>
        <p:spPr>
          <a:xfrm>
            <a:off x="3048241" y="16744922"/>
            <a:ext cx="751873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직선 연결선 47"/>
          <p:cNvCxnSpPr/>
          <p:nvPr/>
        </p:nvCxnSpPr>
        <p:spPr>
          <a:xfrm flipV="1">
            <a:off x="3055164" y="9472131"/>
            <a:ext cx="0" cy="728664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a:off x="5607336" y="17222599"/>
            <a:ext cx="3165571" cy="360740"/>
          </a:xfrm>
          <a:prstGeom prst="rect">
            <a:avLst/>
          </a:prstGeom>
          <a:noFill/>
        </p:spPr>
        <p:txBody>
          <a:bodyPr wrap="square" rtlCol="0">
            <a:spAutoFit/>
          </a:bodyPr>
          <a:lstStyle/>
          <a:p>
            <a:r>
              <a:rPr lang="en-US" altLang="ko-KR" sz="1744" b="1" dirty="0">
                <a:latin typeface="Arial" panose="020B0604020202020204" pitchFamily="34" charset="0"/>
                <a:cs typeface="Arial" panose="020B0604020202020204" pitchFamily="34" charset="0"/>
              </a:rPr>
              <a:t>Log</a:t>
            </a:r>
            <a:r>
              <a:rPr lang="en-US" altLang="ko-KR" sz="1744" b="1" baseline="-25000" dirty="0">
                <a:latin typeface="Arial" panose="020B0604020202020204" pitchFamily="34" charset="0"/>
                <a:cs typeface="Arial" panose="020B0604020202020204" pitchFamily="34" charset="0"/>
              </a:rPr>
              <a:t>2</a:t>
            </a:r>
            <a:r>
              <a:rPr lang="en-US" altLang="ko-KR" sz="1744" b="1" dirty="0">
                <a:latin typeface="Arial" panose="020B0604020202020204" pitchFamily="34" charset="0"/>
                <a:cs typeface="Arial" panose="020B0604020202020204" pitchFamily="34" charset="0"/>
              </a:rPr>
              <a:t>(Fold enrichment)</a:t>
            </a:r>
            <a:endParaRPr lang="ko-KR" altLang="en-US" sz="1744" b="1" dirty="0">
              <a:latin typeface="Arial" panose="020B0604020202020204" pitchFamily="34" charset="0"/>
              <a:cs typeface="Arial" panose="020B0604020202020204" pitchFamily="34" charset="0"/>
            </a:endParaRPr>
          </a:p>
        </p:txBody>
      </p:sp>
      <p:sp>
        <p:nvSpPr>
          <p:cNvPr id="50" name="TextBox 49"/>
          <p:cNvSpPr txBox="1"/>
          <p:nvPr/>
        </p:nvSpPr>
        <p:spPr>
          <a:xfrm rot="16200000">
            <a:off x="-185383" y="12714912"/>
            <a:ext cx="4335883" cy="405496"/>
          </a:xfrm>
          <a:prstGeom prst="rect">
            <a:avLst/>
          </a:prstGeom>
          <a:noFill/>
        </p:spPr>
        <p:txBody>
          <a:bodyPr wrap="square" rtlCol="0">
            <a:spAutoFit/>
          </a:bodyPr>
          <a:lstStyle/>
          <a:p>
            <a:r>
              <a:rPr lang="en-US" altLang="ko-KR" sz="1744" b="1" dirty="0">
                <a:latin typeface="Arial" panose="020B0604020202020204" pitchFamily="34" charset="0"/>
                <a:cs typeface="Arial" panose="020B0604020202020204" pitchFamily="34" charset="0"/>
              </a:rPr>
              <a:t>-</a:t>
            </a:r>
            <a:r>
              <a:rPr lang="en-US" altLang="ko-KR" sz="2035" b="1" dirty="0">
                <a:latin typeface="Arial" panose="020B0604020202020204" pitchFamily="34" charset="0"/>
                <a:cs typeface="Arial" panose="020B0604020202020204" pitchFamily="34" charset="0"/>
              </a:rPr>
              <a:t>Log</a:t>
            </a:r>
            <a:r>
              <a:rPr lang="en-US" altLang="ko-KR" sz="2035" b="1" baseline="-25000" dirty="0">
                <a:latin typeface="Arial" panose="020B0604020202020204" pitchFamily="34" charset="0"/>
                <a:cs typeface="Arial" panose="020B0604020202020204" pitchFamily="34" charset="0"/>
              </a:rPr>
              <a:t>10</a:t>
            </a:r>
            <a:r>
              <a:rPr lang="en-US" altLang="ko-KR" sz="2035" b="1" dirty="0">
                <a:latin typeface="Arial" panose="020B0604020202020204" pitchFamily="34" charset="0"/>
                <a:cs typeface="Arial" panose="020B0604020202020204" pitchFamily="34" charset="0"/>
              </a:rPr>
              <a:t>(Fisher’s exact test p-value)</a:t>
            </a:r>
            <a:endParaRPr lang="ko-KR" altLang="en-US" sz="2035" b="1" dirty="0">
              <a:latin typeface="Arial" panose="020B0604020202020204" pitchFamily="34" charset="0"/>
              <a:cs typeface="Arial" panose="020B0604020202020204" pitchFamily="34" charset="0"/>
            </a:endParaRPr>
          </a:p>
        </p:txBody>
      </p:sp>
      <p:sp>
        <p:nvSpPr>
          <p:cNvPr id="51" name="TextBox 50"/>
          <p:cNvSpPr txBox="1"/>
          <p:nvPr/>
        </p:nvSpPr>
        <p:spPr>
          <a:xfrm>
            <a:off x="2879180" y="16769537"/>
            <a:ext cx="9496590" cy="405496"/>
          </a:xfrm>
          <a:prstGeom prst="rect">
            <a:avLst/>
          </a:prstGeom>
          <a:noFill/>
        </p:spPr>
        <p:txBody>
          <a:bodyPr wrap="square" rtlCol="0">
            <a:spAutoFit/>
          </a:bodyPr>
          <a:lstStyle/>
          <a:p>
            <a:r>
              <a:rPr lang="en-US" altLang="ko-KR" sz="2035" b="1" dirty="0">
                <a:latin typeface="Arial" panose="020B0604020202020204" pitchFamily="34" charset="0"/>
                <a:cs typeface="Arial" panose="020B0604020202020204" pitchFamily="34" charset="0"/>
              </a:rPr>
              <a:t> </a:t>
            </a:r>
            <a:r>
              <a:rPr lang="en-US" altLang="ko-KR" sz="1744" b="1" dirty="0">
                <a:latin typeface="Arial" panose="020B0604020202020204" pitchFamily="34" charset="0"/>
                <a:cs typeface="Arial" panose="020B0604020202020204" pitchFamily="34" charset="0"/>
              </a:rPr>
              <a:t>0           1            2            3            4             5              6               7             8               </a:t>
            </a:r>
            <a:endParaRPr lang="ko-KR" altLang="en-US" sz="2035" b="1" dirty="0">
              <a:latin typeface="Arial" panose="020B0604020202020204" pitchFamily="34" charset="0"/>
              <a:cs typeface="Arial" panose="020B0604020202020204" pitchFamily="34" charset="0"/>
            </a:endParaRPr>
          </a:p>
        </p:txBody>
      </p:sp>
      <p:sp>
        <p:nvSpPr>
          <p:cNvPr id="52" name="TextBox 51"/>
          <p:cNvSpPr txBox="1"/>
          <p:nvPr/>
        </p:nvSpPr>
        <p:spPr>
          <a:xfrm rot="16200000">
            <a:off x="-1788183" y="13524266"/>
            <a:ext cx="9209132" cy="360740"/>
          </a:xfrm>
          <a:prstGeom prst="rect">
            <a:avLst/>
          </a:prstGeom>
          <a:noFill/>
        </p:spPr>
        <p:txBody>
          <a:bodyPr wrap="square" rtlCol="0">
            <a:spAutoFit/>
          </a:bodyPr>
          <a:lstStyle/>
          <a:p>
            <a:r>
              <a:rPr lang="en-US" altLang="ko-KR" sz="1744" b="1" dirty="0">
                <a:latin typeface="Arial" panose="020B0604020202020204" pitchFamily="34" charset="0"/>
                <a:cs typeface="Arial" panose="020B0604020202020204" pitchFamily="34" charset="0"/>
              </a:rPr>
              <a:t>                                       1                                2                               3                            4</a:t>
            </a:r>
            <a:endParaRPr lang="ko-KR" altLang="en-US" sz="1744" b="1" dirty="0">
              <a:latin typeface="Arial" panose="020B0604020202020204" pitchFamily="34" charset="0"/>
              <a:cs typeface="Arial" panose="020B0604020202020204" pitchFamily="34" charset="0"/>
            </a:endParaRPr>
          </a:p>
        </p:txBody>
      </p:sp>
      <p:pic>
        <p:nvPicPr>
          <p:cNvPr id="53" name="그림 52"/>
          <p:cNvPicPr>
            <a:picLocks noChangeAspect="1"/>
          </p:cNvPicPr>
          <p:nvPr/>
        </p:nvPicPr>
        <p:blipFill rotWithShape="1">
          <a:blip r:embed="rId3"/>
          <a:srcRect l="17404" t="6671" r="3699" b="28865"/>
          <a:stretch/>
        </p:blipFill>
        <p:spPr>
          <a:xfrm>
            <a:off x="3840679" y="9658105"/>
            <a:ext cx="7478711" cy="5838911"/>
          </a:xfrm>
          <a:prstGeom prst="rect">
            <a:avLst/>
          </a:prstGeom>
        </p:spPr>
      </p:pic>
      <p:sp>
        <p:nvSpPr>
          <p:cNvPr id="54" name="TextBox 53"/>
          <p:cNvSpPr txBox="1"/>
          <p:nvPr/>
        </p:nvSpPr>
        <p:spPr>
          <a:xfrm>
            <a:off x="9302706" y="13324866"/>
            <a:ext cx="2528538"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Medium-chain fatty acid metabolic process</a:t>
            </a:r>
            <a:endParaRPr lang="ko-KR" altLang="en-US" sz="1400" b="1" dirty="0">
              <a:latin typeface="Arial" panose="020B0604020202020204" pitchFamily="34" charset="0"/>
              <a:cs typeface="Arial" panose="020B0604020202020204" pitchFamily="34" charset="0"/>
            </a:endParaRPr>
          </a:p>
        </p:txBody>
      </p:sp>
      <p:sp>
        <p:nvSpPr>
          <p:cNvPr id="55" name="TextBox 54"/>
          <p:cNvSpPr txBox="1"/>
          <p:nvPr/>
        </p:nvSpPr>
        <p:spPr>
          <a:xfrm>
            <a:off x="9937821" y="14066786"/>
            <a:ext cx="2528538"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Adenine transport</a:t>
            </a:r>
            <a:endParaRPr lang="ko-KR" altLang="en-US" sz="1400" b="1" dirty="0">
              <a:latin typeface="Arial" panose="020B0604020202020204" pitchFamily="34" charset="0"/>
              <a:cs typeface="Arial" panose="020B0604020202020204" pitchFamily="34" charset="0"/>
            </a:endParaRPr>
          </a:p>
        </p:txBody>
      </p:sp>
      <p:sp>
        <p:nvSpPr>
          <p:cNvPr id="56" name="TextBox 55"/>
          <p:cNvSpPr txBox="1"/>
          <p:nvPr/>
        </p:nvSpPr>
        <p:spPr>
          <a:xfrm>
            <a:off x="8366983" y="14499485"/>
            <a:ext cx="346797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Thrombin receptor signaling pathway</a:t>
            </a:r>
            <a:endParaRPr lang="ko-KR" altLang="en-US" sz="1400" b="1" dirty="0">
              <a:latin typeface="Arial" panose="020B0604020202020204" pitchFamily="34" charset="0"/>
              <a:cs typeface="Arial" panose="020B0604020202020204" pitchFamily="34" charset="0"/>
            </a:endParaRPr>
          </a:p>
        </p:txBody>
      </p:sp>
      <p:sp>
        <p:nvSpPr>
          <p:cNvPr id="59" name="TextBox 58"/>
          <p:cNvSpPr txBox="1"/>
          <p:nvPr/>
        </p:nvSpPr>
        <p:spPr>
          <a:xfrm>
            <a:off x="8503848" y="14849869"/>
            <a:ext cx="328019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Sequestering of actin monomers</a:t>
            </a:r>
            <a:endParaRPr lang="ko-KR" altLang="en-US" sz="1400" b="1" dirty="0">
              <a:latin typeface="Arial" panose="020B0604020202020204" pitchFamily="34" charset="0"/>
              <a:cs typeface="Arial" panose="020B0604020202020204" pitchFamily="34" charset="0"/>
            </a:endParaRPr>
          </a:p>
        </p:txBody>
      </p:sp>
      <p:sp>
        <p:nvSpPr>
          <p:cNvPr id="60" name="TextBox 59"/>
          <p:cNvSpPr txBox="1"/>
          <p:nvPr/>
        </p:nvSpPr>
        <p:spPr>
          <a:xfrm>
            <a:off x="4961649" y="15017831"/>
            <a:ext cx="3630211"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Positive regulation of toll-like receptor 4 signaling pathway</a:t>
            </a:r>
            <a:endParaRPr lang="ko-KR" altLang="en-US" sz="1400" b="1" dirty="0">
              <a:latin typeface="Arial" panose="020B0604020202020204" pitchFamily="34" charset="0"/>
              <a:cs typeface="Arial" panose="020B0604020202020204" pitchFamily="34" charset="0"/>
            </a:endParaRPr>
          </a:p>
        </p:txBody>
      </p:sp>
      <p:sp>
        <p:nvSpPr>
          <p:cNvPr id="61" name="TextBox 60"/>
          <p:cNvSpPr txBox="1"/>
          <p:nvPr/>
        </p:nvSpPr>
        <p:spPr>
          <a:xfrm>
            <a:off x="4050391" y="10112511"/>
            <a:ext cx="2528538" cy="523220"/>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Oxidation-reduction process</a:t>
            </a:r>
            <a:endParaRPr lang="ko-KR" altLang="en-US" sz="1400" b="1" dirty="0">
              <a:latin typeface="Arial" panose="020B0604020202020204" pitchFamily="34" charset="0"/>
              <a:cs typeface="Arial" panose="020B0604020202020204" pitchFamily="34" charset="0"/>
            </a:endParaRPr>
          </a:p>
        </p:txBody>
      </p:sp>
      <p:sp>
        <p:nvSpPr>
          <p:cNvPr id="62" name="TextBox 61"/>
          <p:cNvSpPr txBox="1"/>
          <p:nvPr/>
        </p:nvSpPr>
        <p:spPr>
          <a:xfrm>
            <a:off x="4737170" y="12113183"/>
            <a:ext cx="3501611"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Actin cytoskeleton organization</a:t>
            </a:r>
            <a:endParaRPr lang="ko-KR" altLang="en-US" sz="1400" b="1" dirty="0">
              <a:latin typeface="Arial" panose="020B0604020202020204" pitchFamily="34" charset="0"/>
              <a:cs typeface="Arial" panose="020B0604020202020204" pitchFamily="34" charset="0"/>
            </a:endParaRPr>
          </a:p>
        </p:txBody>
      </p:sp>
      <p:sp>
        <p:nvSpPr>
          <p:cNvPr id="63" name="TextBox 62"/>
          <p:cNvSpPr txBox="1"/>
          <p:nvPr/>
        </p:nvSpPr>
        <p:spPr>
          <a:xfrm>
            <a:off x="4050390" y="12953243"/>
            <a:ext cx="1758268"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Cell-cell adhesion</a:t>
            </a:r>
            <a:endParaRPr lang="ko-KR" altLang="en-US" sz="1400" b="1" dirty="0">
              <a:latin typeface="Arial" panose="020B0604020202020204" pitchFamily="34" charset="0"/>
              <a:cs typeface="Arial" panose="020B0604020202020204" pitchFamily="34" charset="0"/>
            </a:endParaRPr>
          </a:p>
        </p:txBody>
      </p:sp>
      <p:sp>
        <p:nvSpPr>
          <p:cNvPr id="64" name="TextBox 63"/>
          <p:cNvSpPr txBox="1"/>
          <p:nvPr/>
        </p:nvSpPr>
        <p:spPr>
          <a:xfrm>
            <a:off x="6396015" y="13345033"/>
            <a:ext cx="2738429"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Lysosome organization</a:t>
            </a:r>
            <a:endParaRPr lang="ko-KR" altLang="en-US" sz="1400" b="1" dirty="0">
              <a:latin typeface="Arial" panose="020B0604020202020204" pitchFamily="34" charset="0"/>
              <a:cs typeface="Arial" panose="020B0604020202020204" pitchFamily="34" charset="0"/>
            </a:endParaRPr>
          </a:p>
        </p:txBody>
      </p:sp>
      <p:sp>
        <p:nvSpPr>
          <p:cNvPr id="65" name="TextBox 64"/>
          <p:cNvSpPr txBox="1"/>
          <p:nvPr/>
        </p:nvSpPr>
        <p:spPr>
          <a:xfrm>
            <a:off x="6563745" y="14042369"/>
            <a:ext cx="2896513"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Response to hydrogen peroxide</a:t>
            </a:r>
            <a:endParaRPr lang="ko-KR" altLang="en-US" sz="1400" b="1" dirty="0">
              <a:latin typeface="Arial" panose="020B0604020202020204" pitchFamily="34" charset="0"/>
              <a:cs typeface="Arial" panose="020B0604020202020204" pitchFamily="34" charset="0"/>
            </a:endParaRPr>
          </a:p>
        </p:txBody>
      </p:sp>
      <p:sp>
        <p:nvSpPr>
          <p:cNvPr id="66" name="TextBox 65"/>
          <p:cNvSpPr txBox="1"/>
          <p:nvPr/>
        </p:nvSpPr>
        <p:spPr>
          <a:xfrm>
            <a:off x="6523845" y="12645466"/>
            <a:ext cx="2131060"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Liver development</a:t>
            </a:r>
            <a:endParaRPr lang="ko-KR" altLang="en-US" sz="1400" b="1" dirty="0">
              <a:latin typeface="Arial" panose="020B0604020202020204" pitchFamily="34" charset="0"/>
              <a:cs typeface="Arial" panose="020B0604020202020204" pitchFamily="34" charset="0"/>
            </a:endParaRPr>
          </a:p>
        </p:txBody>
      </p:sp>
      <p:sp>
        <p:nvSpPr>
          <p:cNvPr id="67" name="타원 66"/>
          <p:cNvSpPr/>
          <p:nvPr/>
        </p:nvSpPr>
        <p:spPr>
          <a:xfrm>
            <a:off x="5864260" y="12358221"/>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68" name="타원 67"/>
          <p:cNvSpPr/>
          <p:nvPr/>
        </p:nvSpPr>
        <p:spPr>
          <a:xfrm>
            <a:off x="6393199" y="12795752"/>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69" name="타원 68"/>
          <p:cNvSpPr/>
          <p:nvPr/>
        </p:nvSpPr>
        <p:spPr>
          <a:xfrm>
            <a:off x="4733291" y="10354315"/>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0" name="타원 69"/>
          <p:cNvSpPr/>
          <p:nvPr/>
        </p:nvSpPr>
        <p:spPr>
          <a:xfrm>
            <a:off x="7068710" y="13602771"/>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1" name="타원 70"/>
          <p:cNvSpPr/>
          <p:nvPr/>
        </p:nvSpPr>
        <p:spPr>
          <a:xfrm>
            <a:off x="5010567" y="13210981"/>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2" name="타원 71"/>
          <p:cNvSpPr/>
          <p:nvPr/>
        </p:nvSpPr>
        <p:spPr>
          <a:xfrm>
            <a:off x="10281414" y="13783940"/>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3" name="타원 72"/>
          <p:cNvSpPr/>
          <p:nvPr/>
        </p:nvSpPr>
        <p:spPr>
          <a:xfrm>
            <a:off x="9844956" y="14014566"/>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4" name="타원 73"/>
          <p:cNvSpPr/>
          <p:nvPr/>
        </p:nvSpPr>
        <p:spPr>
          <a:xfrm>
            <a:off x="8591860" y="14736305"/>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5" name="타원 74"/>
          <p:cNvSpPr/>
          <p:nvPr/>
        </p:nvSpPr>
        <p:spPr>
          <a:xfrm>
            <a:off x="8417934" y="14811188"/>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6" name="타원 75"/>
          <p:cNvSpPr/>
          <p:nvPr/>
        </p:nvSpPr>
        <p:spPr>
          <a:xfrm>
            <a:off x="8274119" y="14899818"/>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
        <p:nvSpPr>
          <p:cNvPr id="77" name="타원 76"/>
          <p:cNvSpPr/>
          <p:nvPr/>
        </p:nvSpPr>
        <p:spPr>
          <a:xfrm>
            <a:off x="6519776" y="14198683"/>
            <a:ext cx="185730" cy="178065"/>
          </a:xfrm>
          <a:prstGeom prst="ellipse">
            <a:avLst/>
          </a:prstGeom>
          <a:no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132925" tIns="66463" rIns="132925" bIns="66463" numCol="1" spcCol="0" rtlCol="0" fromWordArt="0" anchor="ctr" anchorCtr="0" forceAA="0" compatLnSpc="1">
            <a:prstTxWarp prst="textNoShape">
              <a:avLst/>
            </a:prstTxWarp>
            <a:noAutofit/>
          </a:bodyPr>
          <a:lstStyle/>
          <a:p>
            <a:pPr algn="ctr"/>
            <a:endParaRPr lang="ko-KR" altLang="en-US" sz="1308"/>
          </a:p>
        </p:txBody>
      </p:sp>
    </p:spTree>
    <p:extLst>
      <p:ext uri="{BB962C8B-B14F-4D97-AF65-F5344CB8AC3E}">
        <p14:creationId xmlns:p14="http://schemas.microsoft.com/office/powerpoint/2010/main" val="168742497"/>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직사각형 22"/>
          <p:cNvSpPr/>
          <p:nvPr/>
        </p:nvSpPr>
        <p:spPr>
          <a:xfrm>
            <a:off x="7028337" y="1871061"/>
            <a:ext cx="3430747"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Acute Phase Response Signaling</a:t>
            </a:r>
          </a:p>
        </p:txBody>
      </p:sp>
      <p:sp>
        <p:nvSpPr>
          <p:cNvPr id="24" name="직사각형 23"/>
          <p:cNvSpPr/>
          <p:nvPr/>
        </p:nvSpPr>
        <p:spPr>
          <a:xfrm>
            <a:off x="7054784" y="2452362"/>
            <a:ext cx="1495922" cy="338554"/>
          </a:xfrm>
          <a:prstGeom prst="rect">
            <a:avLst/>
          </a:prstGeom>
        </p:spPr>
        <p:txBody>
          <a:bodyPr wrap="none">
            <a:spAutoFit/>
          </a:bodyPr>
          <a:lstStyle/>
          <a:p>
            <a:r>
              <a:rPr lang="en-US" altLang="ko-KR" sz="1600" b="1" smtClean="0">
                <a:latin typeface="Arial" panose="020B0604020202020204" pitchFamily="34" charset="0"/>
                <a:cs typeface="Arial" panose="020B0604020202020204" pitchFamily="34" charset="0"/>
              </a:rPr>
              <a:t>ILK </a:t>
            </a:r>
            <a:r>
              <a:rPr lang="en-US" altLang="ko-KR" sz="1600" b="1">
                <a:latin typeface="Arial" panose="020B0604020202020204" pitchFamily="34" charset="0"/>
                <a:cs typeface="Arial" panose="020B0604020202020204" pitchFamily="34" charset="0"/>
              </a:rPr>
              <a:t>Signaling</a:t>
            </a:r>
          </a:p>
        </p:txBody>
      </p:sp>
      <p:sp>
        <p:nvSpPr>
          <p:cNvPr id="25" name="직사각형 24"/>
          <p:cNvSpPr/>
          <p:nvPr/>
        </p:nvSpPr>
        <p:spPr>
          <a:xfrm>
            <a:off x="7025289" y="3017687"/>
            <a:ext cx="3023585"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Actin Cytoskeleton Signaling</a:t>
            </a:r>
          </a:p>
        </p:txBody>
      </p:sp>
      <p:sp>
        <p:nvSpPr>
          <p:cNvPr id="26" name="직사각형 25"/>
          <p:cNvSpPr/>
          <p:nvPr/>
        </p:nvSpPr>
        <p:spPr>
          <a:xfrm>
            <a:off x="7054784" y="3588354"/>
            <a:ext cx="3581430"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Leukocyte Extravasation Signaling</a:t>
            </a:r>
          </a:p>
        </p:txBody>
      </p:sp>
      <p:sp>
        <p:nvSpPr>
          <p:cNvPr id="27" name="직사각형 26"/>
          <p:cNvSpPr/>
          <p:nvPr/>
        </p:nvSpPr>
        <p:spPr>
          <a:xfrm>
            <a:off x="7037681" y="4164440"/>
            <a:ext cx="1645387" cy="338554"/>
          </a:xfrm>
          <a:prstGeom prst="rect">
            <a:avLst/>
          </a:prstGeom>
        </p:spPr>
        <p:txBody>
          <a:bodyPr wrap="none">
            <a:spAutoFit/>
          </a:bodyPr>
          <a:lstStyle/>
          <a:p>
            <a:r>
              <a:rPr lang="en-US" altLang="ko-KR" sz="1600" b="1" err="1">
                <a:latin typeface="Arial" panose="020B0604020202020204" pitchFamily="34" charset="0"/>
                <a:cs typeface="Arial" panose="020B0604020202020204" pitchFamily="34" charset="0"/>
              </a:rPr>
              <a:t>tRNA</a:t>
            </a:r>
            <a:r>
              <a:rPr lang="en-US" altLang="ko-KR" sz="1600" b="1">
                <a:latin typeface="Arial" panose="020B0604020202020204" pitchFamily="34" charset="0"/>
                <a:cs typeface="Arial" panose="020B0604020202020204" pitchFamily="34" charset="0"/>
              </a:rPr>
              <a:t> Charging</a:t>
            </a:r>
          </a:p>
        </p:txBody>
      </p:sp>
      <p:sp>
        <p:nvSpPr>
          <p:cNvPr id="28" name="직사각형 27"/>
          <p:cNvSpPr/>
          <p:nvPr/>
        </p:nvSpPr>
        <p:spPr>
          <a:xfrm>
            <a:off x="7031235" y="4707034"/>
            <a:ext cx="1327608"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Glycolysis I</a:t>
            </a:r>
          </a:p>
        </p:txBody>
      </p:sp>
      <p:sp>
        <p:nvSpPr>
          <p:cNvPr id="116" name="TextBox 115"/>
          <p:cNvSpPr txBox="1"/>
          <p:nvPr/>
        </p:nvSpPr>
        <p:spPr>
          <a:xfrm>
            <a:off x="319350" y="516443"/>
            <a:ext cx="431250" cy="523220"/>
          </a:xfrm>
          <a:prstGeom prst="rect">
            <a:avLst/>
          </a:prstGeom>
          <a:noFill/>
        </p:spPr>
        <p:txBody>
          <a:bodyPr wrap="square" rtlCol="0">
            <a:spAutoFit/>
          </a:bodyPr>
          <a:lstStyle/>
          <a:p>
            <a:pPr algn="just"/>
            <a:r>
              <a:rPr lang="en-US" altLang="ko-KR" sz="2800" b="1">
                <a:latin typeface="Arial" panose="020B0604020202020204" pitchFamily="34" charset="0"/>
                <a:cs typeface="Arial" panose="020B0604020202020204" pitchFamily="34" charset="0"/>
              </a:rPr>
              <a:t>a</a:t>
            </a:r>
          </a:p>
        </p:txBody>
      </p:sp>
      <p:sp>
        <p:nvSpPr>
          <p:cNvPr id="118" name="직사각형 117"/>
          <p:cNvSpPr/>
          <p:nvPr/>
        </p:nvSpPr>
        <p:spPr>
          <a:xfrm>
            <a:off x="5645457" y="6217365"/>
            <a:ext cx="1434528" cy="258656"/>
          </a:xfrm>
          <a:prstGeom prst="rect">
            <a:avLst/>
          </a:prstGeom>
          <a:gradFill flip="none" rotWithShape="1">
            <a:gsLst>
              <a:gs pos="0">
                <a:schemeClr val="bg1">
                  <a:alpha val="55000"/>
                </a:schemeClr>
              </a:gs>
              <a:gs pos="52000">
                <a:srgbClr val="B871FF"/>
              </a:gs>
              <a:gs pos="100000">
                <a:srgbClr val="7030A0"/>
              </a:gs>
            </a:gsLst>
            <a:lin ang="0" scaled="1"/>
            <a:tileRect/>
          </a:gra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latin typeface="Arial" panose="020B0604020202020204" pitchFamily="34" charset="0"/>
              <a:cs typeface="Arial" panose="020B0604020202020204" pitchFamily="34" charset="0"/>
            </a:endParaRPr>
          </a:p>
        </p:txBody>
      </p:sp>
      <p:sp>
        <p:nvSpPr>
          <p:cNvPr id="120" name="TextBox 119"/>
          <p:cNvSpPr txBox="1"/>
          <p:nvPr/>
        </p:nvSpPr>
        <p:spPr>
          <a:xfrm>
            <a:off x="5581612" y="6460573"/>
            <a:ext cx="1634282" cy="307777"/>
          </a:xfrm>
          <a:prstGeom prst="rect">
            <a:avLst/>
          </a:prstGeom>
          <a:noFill/>
          <a:ln>
            <a:noFill/>
          </a:ln>
        </p:spPr>
        <p:txBody>
          <a:bodyPr wrap="square" rtlCol="0">
            <a:spAutoFit/>
          </a:bodyPr>
          <a:lstStyle/>
          <a:p>
            <a:r>
              <a:rPr lang="en-US" altLang="ko-KR" sz="1400" b="1" smtClean="0">
                <a:latin typeface="Arial" panose="020B0604020202020204" pitchFamily="34" charset="0"/>
                <a:cs typeface="Arial" panose="020B0604020202020204" pitchFamily="34" charset="0"/>
              </a:rPr>
              <a:t>1.3                     5</a:t>
            </a:r>
            <a:endParaRPr lang="ko-KR" altLang="en-US" sz="1400" b="1">
              <a:latin typeface="Arial" panose="020B0604020202020204" pitchFamily="34" charset="0"/>
              <a:cs typeface="Arial" panose="020B0604020202020204" pitchFamily="34" charset="0"/>
            </a:endParaRPr>
          </a:p>
        </p:txBody>
      </p:sp>
      <p:sp>
        <p:nvSpPr>
          <p:cNvPr id="121" name="TextBox 120"/>
          <p:cNvSpPr txBox="1"/>
          <p:nvPr/>
        </p:nvSpPr>
        <p:spPr>
          <a:xfrm rot="18701126">
            <a:off x="5834173" y="952243"/>
            <a:ext cx="1034695"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Z-score</a:t>
            </a:r>
            <a:endParaRPr lang="ko-KR" altLang="en-US" b="1">
              <a:latin typeface="Arial" panose="020B0604020202020204" pitchFamily="34" charset="0"/>
              <a:cs typeface="Arial" panose="020B0604020202020204" pitchFamily="34" charset="0"/>
            </a:endParaRPr>
          </a:p>
        </p:txBody>
      </p:sp>
      <p:sp>
        <p:nvSpPr>
          <p:cNvPr id="122" name="TextBox 121"/>
          <p:cNvSpPr txBox="1"/>
          <p:nvPr/>
        </p:nvSpPr>
        <p:spPr>
          <a:xfrm rot="18701126">
            <a:off x="6264887" y="710901"/>
            <a:ext cx="1713769"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log(p-value)</a:t>
            </a:r>
            <a:endParaRPr lang="ko-KR" altLang="en-US" b="1">
              <a:latin typeface="Arial" panose="020B0604020202020204" pitchFamily="34" charset="0"/>
              <a:cs typeface="Arial" panose="020B0604020202020204" pitchFamily="34" charset="0"/>
            </a:endParaRPr>
          </a:p>
        </p:txBody>
      </p:sp>
      <p:sp>
        <p:nvSpPr>
          <p:cNvPr id="123" name="직사각형 122"/>
          <p:cNvSpPr/>
          <p:nvPr/>
        </p:nvSpPr>
        <p:spPr>
          <a:xfrm>
            <a:off x="5645457" y="5435970"/>
            <a:ext cx="1440875" cy="251384"/>
          </a:xfrm>
          <a:prstGeom prst="rect">
            <a:avLst/>
          </a:prstGeom>
          <a:gradFill flip="none" rotWithShape="1">
            <a:gsLst>
              <a:gs pos="35000">
                <a:schemeClr val="bg1">
                  <a:alpha val="55000"/>
                </a:schemeClr>
              </a:gs>
              <a:gs pos="18000">
                <a:srgbClr val="4EA7FF"/>
              </a:gs>
              <a:gs pos="6000">
                <a:srgbClr val="0080FF"/>
              </a:gs>
              <a:gs pos="70000">
                <a:srgbClr val="FFA142"/>
              </a:gs>
              <a:gs pos="85000">
                <a:srgbClr val="FF8000"/>
              </a:gs>
            </a:gsLst>
            <a:lin ang="0" scaled="1"/>
            <a:tileRect/>
          </a:gra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latin typeface="Arial" panose="020B0604020202020204" pitchFamily="34" charset="0"/>
              <a:cs typeface="Arial" panose="020B0604020202020204" pitchFamily="34" charset="0"/>
            </a:endParaRPr>
          </a:p>
        </p:txBody>
      </p:sp>
      <p:sp>
        <p:nvSpPr>
          <p:cNvPr id="125" name="TextBox 124"/>
          <p:cNvSpPr txBox="1"/>
          <p:nvPr/>
        </p:nvSpPr>
        <p:spPr>
          <a:xfrm>
            <a:off x="5581612" y="5679345"/>
            <a:ext cx="1634282" cy="307777"/>
          </a:xfrm>
          <a:prstGeom prst="rect">
            <a:avLst/>
          </a:prstGeom>
          <a:noFill/>
          <a:ln>
            <a:noFill/>
          </a:ln>
        </p:spPr>
        <p:txBody>
          <a:bodyPr wrap="square" rtlCol="0">
            <a:spAutoFit/>
          </a:bodyPr>
          <a:lstStyle/>
          <a:p>
            <a:r>
              <a:rPr lang="en-US" altLang="ko-KR" sz="1400" b="1" smtClean="0">
                <a:latin typeface="Arial" panose="020B0604020202020204" pitchFamily="34" charset="0"/>
                <a:cs typeface="Arial" panose="020B0604020202020204" pitchFamily="34" charset="0"/>
              </a:rPr>
              <a:t>-1                       2</a:t>
            </a:r>
            <a:endParaRPr lang="ko-KR" altLang="en-US" sz="1400" b="1">
              <a:latin typeface="Arial" panose="020B0604020202020204" pitchFamily="34" charset="0"/>
              <a:cs typeface="Arial" panose="020B0604020202020204" pitchFamily="34" charset="0"/>
            </a:endParaRPr>
          </a:p>
        </p:txBody>
      </p:sp>
      <p:sp>
        <p:nvSpPr>
          <p:cNvPr id="126" name="TextBox 125"/>
          <p:cNvSpPr txBox="1"/>
          <p:nvPr/>
        </p:nvSpPr>
        <p:spPr>
          <a:xfrm>
            <a:off x="5591283" y="5879299"/>
            <a:ext cx="1895091" cy="276999"/>
          </a:xfrm>
          <a:prstGeom prst="rect">
            <a:avLst/>
          </a:prstGeom>
          <a:noFill/>
          <a:ln>
            <a:noFill/>
          </a:ln>
        </p:spPr>
        <p:txBody>
          <a:bodyPr wrap="square" rtlCol="0">
            <a:spAutoFit/>
          </a:bodyPr>
          <a:lstStyle/>
          <a:p>
            <a:r>
              <a:rPr lang="en-US" altLang="ko-KR" sz="1200" b="1" smtClean="0">
                <a:latin typeface="Arial" panose="020B0604020202020204" pitchFamily="34" charset="0"/>
                <a:cs typeface="Arial" panose="020B0604020202020204" pitchFamily="34" charset="0"/>
              </a:rPr>
              <a:t>Activation Z-score</a:t>
            </a:r>
            <a:endParaRPr lang="ko-KR" altLang="en-US" sz="1200" b="1">
              <a:latin typeface="Arial" panose="020B0604020202020204" pitchFamily="34" charset="0"/>
              <a:cs typeface="Arial" panose="020B0604020202020204" pitchFamily="34" charset="0"/>
            </a:endParaRPr>
          </a:p>
        </p:txBody>
      </p:sp>
      <p:sp>
        <p:nvSpPr>
          <p:cNvPr id="127" name="TextBox 126"/>
          <p:cNvSpPr txBox="1"/>
          <p:nvPr/>
        </p:nvSpPr>
        <p:spPr>
          <a:xfrm>
            <a:off x="5814159" y="6671942"/>
            <a:ext cx="1175401" cy="276999"/>
          </a:xfrm>
          <a:prstGeom prst="rect">
            <a:avLst/>
          </a:prstGeom>
          <a:noFill/>
          <a:ln>
            <a:noFill/>
          </a:ln>
        </p:spPr>
        <p:txBody>
          <a:bodyPr wrap="square" rtlCol="0">
            <a:spAutoFit/>
          </a:bodyPr>
          <a:lstStyle/>
          <a:p>
            <a:r>
              <a:rPr lang="en-US" altLang="ko-KR" sz="1200" b="1" smtClean="0">
                <a:latin typeface="Arial" panose="020B0604020202020204" pitchFamily="34" charset="0"/>
                <a:cs typeface="Arial" panose="020B0604020202020204" pitchFamily="34" charset="0"/>
              </a:rPr>
              <a:t>-log(p-value)</a:t>
            </a:r>
            <a:endParaRPr lang="ko-KR" altLang="en-US" sz="1200" b="1">
              <a:latin typeface="Arial" panose="020B0604020202020204" pitchFamily="34" charset="0"/>
              <a:cs typeface="Arial" panose="020B0604020202020204" pitchFamily="34" charset="0"/>
            </a:endParaRPr>
          </a:p>
        </p:txBody>
      </p:sp>
      <p:pic>
        <p:nvPicPr>
          <p:cNvPr id="69" name="그림 68"/>
          <p:cNvPicPr>
            <a:picLocks noChangeAspect="1"/>
          </p:cNvPicPr>
          <p:nvPr/>
        </p:nvPicPr>
        <p:blipFill rotWithShape="1">
          <a:blip r:embed="rId3"/>
          <a:srcRect l="2" t="58072" r="76377" b="2049"/>
          <a:stretch/>
        </p:blipFill>
        <p:spPr>
          <a:xfrm>
            <a:off x="4372613" y="8882196"/>
            <a:ext cx="1323974" cy="5728329"/>
          </a:xfrm>
          <a:prstGeom prst="rect">
            <a:avLst/>
          </a:prstGeom>
        </p:spPr>
      </p:pic>
      <p:grpSp>
        <p:nvGrpSpPr>
          <p:cNvPr id="3" name="그룹 2"/>
          <p:cNvGrpSpPr/>
          <p:nvPr/>
        </p:nvGrpSpPr>
        <p:grpSpPr>
          <a:xfrm>
            <a:off x="5696587" y="8794516"/>
            <a:ext cx="1383398" cy="5867084"/>
            <a:chOff x="5872369" y="8702026"/>
            <a:chExt cx="1306203" cy="5750855"/>
          </a:xfrm>
        </p:grpSpPr>
        <p:pic>
          <p:nvPicPr>
            <p:cNvPr id="68" name="그림 67"/>
            <p:cNvPicPr>
              <a:picLocks noChangeAspect="1"/>
            </p:cNvPicPr>
            <p:nvPr/>
          </p:nvPicPr>
          <p:blipFill rotWithShape="1">
            <a:blip r:embed="rId3"/>
            <a:srcRect l="82701" t="58072" r="5214" b="2049"/>
            <a:stretch/>
          </p:blipFill>
          <p:spPr>
            <a:xfrm>
              <a:off x="5872369" y="8724552"/>
              <a:ext cx="677379" cy="5728329"/>
            </a:xfrm>
            <a:prstGeom prst="rect">
              <a:avLst/>
            </a:prstGeom>
          </p:spPr>
        </p:pic>
        <p:pic>
          <p:nvPicPr>
            <p:cNvPr id="76" name="그림 75"/>
            <p:cNvPicPr>
              <a:picLocks noChangeAspect="1"/>
            </p:cNvPicPr>
            <p:nvPr/>
          </p:nvPicPr>
          <p:blipFill rotWithShape="1">
            <a:blip r:embed="rId4">
              <a:extLst>
                <a:ext uri="{28A0092B-C50C-407E-A947-70E740481C1C}">
                  <a14:useLocalDpi xmlns:a14="http://schemas.microsoft.com/office/drawing/2010/main" val="0"/>
                </a:ext>
              </a:extLst>
            </a:blip>
            <a:srcRect l="83111" t="57917" r="5325" b="2049"/>
            <a:stretch/>
          </p:blipFill>
          <p:spPr>
            <a:xfrm>
              <a:off x="6530698" y="8702026"/>
              <a:ext cx="647874" cy="5748337"/>
            </a:xfrm>
            <a:prstGeom prst="rect">
              <a:avLst/>
            </a:prstGeom>
          </p:spPr>
        </p:pic>
      </p:grpSp>
      <p:sp>
        <p:nvSpPr>
          <p:cNvPr id="80" name="직사각형 79"/>
          <p:cNvSpPr/>
          <p:nvPr/>
        </p:nvSpPr>
        <p:spPr>
          <a:xfrm>
            <a:off x="7009287" y="9000476"/>
            <a:ext cx="3166251"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Polarization of tumor cell lines</a:t>
            </a:r>
          </a:p>
        </p:txBody>
      </p:sp>
      <p:sp>
        <p:nvSpPr>
          <p:cNvPr id="81" name="직사각형 80"/>
          <p:cNvSpPr/>
          <p:nvPr/>
        </p:nvSpPr>
        <p:spPr>
          <a:xfrm>
            <a:off x="7014259" y="9523902"/>
            <a:ext cx="878767"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ancer</a:t>
            </a:r>
          </a:p>
        </p:txBody>
      </p:sp>
      <p:sp>
        <p:nvSpPr>
          <p:cNvPr id="82" name="직사각형 81"/>
          <p:cNvSpPr/>
          <p:nvPr/>
        </p:nvSpPr>
        <p:spPr>
          <a:xfrm>
            <a:off x="7032030" y="10028821"/>
            <a:ext cx="2319866"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Malignant solid tumor</a:t>
            </a:r>
          </a:p>
        </p:txBody>
      </p:sp>
      <p:sp>
        <p:nvSpPr>
          <p:cNvPr id="83" name="직사각형 82"/>
          <p:cNvSpPr/>
          <p:nvPr/>
        </p:nvSpPr>
        <p:spPr>
          <a:xfrm>
            <a:off x="7023801" y="10538782"/>
            <a:ext cx="2114681"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Polarization of cells</a:t>
            </a:r>
          </a:p>
        </p:txBody>
      </p:sp>
      <p:sp>
        <p:nvSpPr>
          <p:cNvPr id="84" name="직사각형 83"/>
          <p:cNvSpPr/>
          <p:nvPr/>
        </p:nvSpPr>
        <p:spPr>
          <a:xfrm>
            <a:off x="7031967" y="11089590"/>
            <a:ext cx="2047355"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Orientation of cells</a:t>
            </a:r>
          </a:p>
        </p:txBody>
      </p:sp>
      <p:sp>
        <p:nvSpPr>
          <p:cNvPr id="85" name="직사각형 84"/>
          <p:cNvSpPr/>
          <p:nvPr/>
        </p:nvSpPr>
        <p:spPr>
          <a:xfrm>
            <a:off x="7043764" y="11599031"/>
            <a:ext cx="3687228"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Adhesion of breast cancer cell lines</a:t>
            </a:r>
          </a:p>
        </p:txBody>
      </p:sp>
      <p:sp>
        <p:nvSpPr>
          <p:cNvPr id="86" name="직사각형 85"/>
          <p:cNvSpPr/>
          <p:nvPr/>
        </p:nvSpPr>
        <p:spPr>
          <a:xfrm>
            <a:off x="7043764" y="12149839"/>
            <a:ext cx="3058851"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Binding of </a:t>
            </a:r>
            <a:r>
              <a:rPr lang="en-US" altLang="ko-KR" sz="1600" b="1" err="1" smtClean="0">
                <a:latin typeface="Arial" panose="020B0604020202020204" pitchFamily="34" charset="0"/>
                <a:cs typeface="Arial" panose="020B0604020202020204" pitchFamily="34" charset="0"/>
              </a:rPr>
              <a:t>NFkB</a:t>
            </a:r>
            <a:r>
              <a:rPr lang="en-US" altLang="ko-KR" sz="1600" b="1" smtClean="0">
                <a:latin typeface="Arial" panose="020B0604020202020204" pitchFamily="34" charset="0"/>
                <a:cs typeface="Arial" panose="020B0604020202020204" pitchFamily="34" charset="0"/>
              </a:rPr>
              <a:t> </a:t>
            </a:r>
            <a:r>
              <a:rPr lang="en-US" altLang="ko-KR" sz="1600" b="1">
                <a:latin typeface="Arial" panose="020B0604020202020204" pitchFamily="34" charset="0"/>
                <a:cs typeface="Arial" panose="020B0604020202020204" pitchFamily="34" charset="0"/>
              </a:rPr>
              <a:t>binding site</a:t>
            </a:r>
          </a:p>
        </p:txBody>
      </p:sp>
      <p:sp>
        <p:nvSpPr>
          <p:cNvPr id="87" name="직사각형 86"/>
          <p:cNvSpPr/>
          <p:nvPr/>
        </p:nvSpPr>
        <p:spPr>
          <a:xfrm>
            <a:off x="7043764" y="12627376"/>
            <a:ext cx="1451423"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DNA damage</a:t>
            </a:r>
          </a:p>
        </p:txBody>
      </p:sp>
      <p:sp>
        <p:nvSpPr>
          <p:cNvPr id="88" name="직사각형 87"/>
          <p:cNvSpPr/>
          <p:nvPr/>
        </p:nvSpPr>
        <p:spPr>
          <a:xfrm>
            <a:off x="7033002" y="13133212"/>
            <a:ext cx="3029997"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Glycolysis of tumor cell lines</a:t>
            </a:r>
          </a:p>
        </p:txBody>
      </p:sp>
      <p:sp>
        <p:nvSpPr>
          <p:cNvPr id="89" name="직사각형 88"/>
          <p:cNvSpPr/>
          <p:nvPr/>
        </p:nvSpPr>
        <p:spPr>
          <a:xfrm>
            <a:off x="7043764" y="13684020"/>
            <a:ext cx="4079963"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ell proliferation of carcinoma cell lines</a:t>
            </a:r>
          </a:p>
        </p:txBody>
      </p:sp>
      <p:sp>
        <p:nvSpPr>
          <p:cNvPr id="91" name="직사각형 90"/>
          <p:cNvSpPr/>
          <p:nvPr/>
        </p:nvSpPr>
        <p:spPr>
          <a:xfrm>
            <a:off x="7045496" y="14197426"/>
            <a:ext cx="3635932"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ell proliferation of tumor cell lines</a:t>
            </a:r>
          </a:p>
        </p:txBody>
      </p:sp>
      <p:sp>
        <p:nvSpPr>
          <p:cNvPr id="135" name="직사각형 134"/>
          <p:cNvSpPr/>
          <p:nvPr/>
        </p:nvSpPr>
        <p:spPr>
          <a:xfrm>
            <a:off x="5686284" y="15619492"/>
            <a:ext cx="1431152" cy="230962"/>
          </a:xfrm>
          <a:prstGeom prst="rect">
            <a:avLst/>
          </a:prstGeom>
          <a:gradFill flip="none" rotWithShape="1">
            <a:gsLst>
              <a:gs pos="0">
                <a:schemeClr val="bg1">
                  <a:alpha val="55000"/>
                </a:schemeClr>
              </a:gs>
              <a:gs pos="52000">
                <a:srgbClr val="B871FF"/>
              </a:gs>
              <a:gs pos="100000">
                <a:srgbClr val="7030A0"/>
              </a:gs>
            </a:gsLst>
            <a:lin ang="0" scaled="1"/>
            <a:tileRect/>
          </a:gra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600">
              <a:latin typeface="Arial" panose="020B0604020202020204" pitchFamily="34" charset="0"/>
              <a:cs typeface="Arial" panose="020B0604020202020204" pitchFamily="34" charset="0"/>
            </a:endParaRPr>
          </a:p>
        </p:txBody>
      </p:sp>
      <p:sp>
        <p:nvSpPr>
          <p:cNvPr id="136" name="TextBox 135"/>
          <p:cNvSpPr txBox="1"/>
          <p:nvPr/>
        </p:nvSpPr>
        <p:spPr>
          <a:xfrm>
            <a:off x="5635374" y="15850454"/>
            <a:ext cx="1634282" cy="307777"/>
          </a:xfrm>
          <a:prstGeom prst="rect">
            <a:avLst/>
          </a:prstGeom>
          <a:noFill/>
          <a:ln>
            <a:noFill/>
          </a:ln>
        </p:spPr>
        <p:txBody>
          <a:bodyPr wrap="square" rtlCol="0">
            <a:spAutoFit/>
          </a:bodyPr>
          <a:lstStyle/>
          <a:p>
            <a:r>
              <a:rPr lang="en-US" altLang="ko-KR" sz="1400" b="1" smtClean="0">
                <a:latin typeface="Arial" panose="020B0604020202020204" pitchFamily="34" charset="0"/>
                <a:cs typeface="Arial" panose="020B0604020202020204" pitchFamily="34" charset="0"/>
              </a:rPr>
              <a:t>1.3                    8</a:t>
            </a:r>
            <a:endParaRPr lang="ko-KR" altLang="en-US" sz="1400" b="1">
              <a:latin typeface="Arial" panose="020B0604020202020204" pitchFamily="34" charset="0"/>
              <a:cs typeface="Arial" panose="020B0604020202020204" pitchFamily="34" charset="0"/>
            </a:endParaRPr>
          </a:p>
        </p:txBody>
      </p:sp>
      <p:sp>
        <p:nvSpPr>
          <p:cNvPr id="137" name="직사각형 136"/>
          <p:cNvSpPr/>
          <p:nvPr/>
        </p:nvSpPr>
        <p:spPr>
          <a:xfrm>
            <a:off x="5686284" y="14797791"/>
            <a:ext cx="1431152" cy="260990"/>
          </a:xfrm>
          <a:prstGeom prst="rect">
            <a:avLst/>
          </a:prstGeom>
          <a:gradFill flip="none" rotWithShape="1">
            <a:gsLst>
              <a:gs pos="50000">
                <a:schemeClr val="bg1">
                  <a:alpha val="55000"/>
                </a:schemeClr>
              </a:gs>
              <a:gs pos="28000">
                <a:srgbClr val="4EA7FF"/>
              </a:gs>
              <a:gs pos="13000">
                <a:srgbClr val="0080FF"/>
              </a:gs>
              <a:gs pos="70000">
                <a:srgbClr val="FFA142"/>
              </a:gs>
              <a:gs pos="85000">
                <a:srgbClr val="FF8000"/>
              </a:gs>
            </a:gsLst>
            <a:lin ang="0" scaled="1"/>
            <a:tileRect/>
          </a:gra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900">
              <a:latin typeface="Arial" panose="020B0604020202020204" pitchFamily="34" charset="0"/>
              <a:cs typeface="Arial" panose="020B0604020202020204" pitchFamily="34" charset="0"/>
            </a:endParaRPr>
          </a:p>
        </p:txBody>
      </p:sp>
      <p:sp>
        <p:nvSpPr>
          <p:cNvPr id="138" name="TextBox 137"/>
          <p:cNvSpPr txBox="1"/>
          <p:nvPr/>
        </p:nvSpPr>
        <p:spPr>
          <a:xfrm>
            <a:off x="5553024" y="15041083"/>
            <a:ext cx="1822627" cy="307777"/>
          </a:xfrm>
          <a:prstGeom prst="rect">
            <a:avLst/>
          </a:prstGeom>
          <a:noFill/>
          <a:ln>
            <a:noFill/>
          </a:ln>
        </p:spPr>
        <p:txBody>
          <a:bodyPr wrap="square" rtlCol="0">
            <a:spAutoFit/>
          </a:bodyPr>
          <a:lstStyle/>
          <a:p>
            <a:r>
              <a:rPr lang="en-US" altLang="ko-KR" sz="1400" b="1" smtClean="0">
                <a:latin typeface="Arial" panose="020B0604020202020204" pitchFamily="34" charset="0"/>
                <a:cs typeface="Arial" panose="020B0604020202020204" pitchFamily="34" charset="0"/>
              </a:rPr>
              <a:t>-2                        2</a:t>
            </a:r>
            <a:endParaRPr lang="ko-KR" altLang="en-US" sz="1400" b="1">
              <a:latin typeface="Arial" panose="020B0604020202020204" pitchFamily="34" charset="0"/>
              <a:cs typeface="Arial" panose="020B0604020202020204" pitchFamily="34" charset="0"/>
            </a:endParaRPr>
          </a:p>
        </p:txBody>
      </p:sp>
      <p:sp>
        <p:nvSpPr>
          <p:cNvPr id="139" name="TextBox 138"/>
          <p:cNvSpPr txBox="1"/>
          <p:nvPr/>
        </p:nvSpPr>
        <p:spPr>
          <a:xfrm>
            <a:off x="5614839" y="15284538"/>
            <a:ext cx="1895091" cy="276999"/>
          </a:xfrm>
          <a:prstGeom prst="rect">
            <a:avLst/>
          </a:prstGeom>
          <a:noFill/>
          <a:ln>
            <a:noFill/>
          </a:ln>
        </p:spPr>
        <p:txBody>
          <a:bodyPr wrap="square" rtlCol="0">
            <a:spAutoFit/>
          </a:bodyPr>
          <a:lstStyle/>
          <a:p>
            <a:r>
              <a:rPr lang="en-US" altLang="ko-KR" sz="1200" b="1" smtClean="0">
                <a:latin typeface="Arial" panose="020B0604020202020204" pitchFamily="34" charset="0"/>
                <a:cs typeface="Arial" panose="020B0604020202020204" pitchFamily="34" charset="0"/>
              </a:rPr>
              <a:t>Activation Z-score</a:t>
            </a:r>
            <a:endParaRPr lang="ko-KR" altLang="en-US" sz="1200" b="1">
              <a:latin typeface="Arial" panose="020B0604020202020204" pitchFamily="34" charset="0"/>
              <a:cs typeface="Arial" panose="020B0604020202020204" pitchFamily="34" charset="0"/>
            </a:endParaRPr>
          </a:p>
        </p:txBody>
      </p:sp>
      <p:sp>
        <p:nvSpPr>
          <p:cNvPr id="140" name="TextBox 139"/>
          <p:cNvSpPr txBox="1"/>
          <p:nvPr/>
        </p:nvSpPr>
        <p:spPr>
          <a:xfrm>
            <a:off x="5864814" y="16041237"/>
            <a:ext cx="1175401" cy="276999"/>
          </a:xfrm>
          <a:prstGeom prst="rect">
            <a:avLst/>
          </a:prstGeom>
          <a:noFill/>
          <a:ln>
            <a:noFill/>
          </a:ln>
        </p:spPr>
        <p:txBody>
          <a:bodyPr wrap="square" rtlCol="0">
            <a:spAutoFit/>
          </a:bodyPr>
          <a:lstStyle/>
          <a:p>
            <a:r>
              <a:rPr lang="en-US" altLang="ko-KR" sz="1200" b="1" smtClean="0">
                <a:latin typeface="Arial" panose="020B0604020202020204" pitchFamily="34" charset="0"/>
                <a:cs typeface="Arial" panose="020B0604020202020204" pitchFamily="34" charset="0"/>
              </a:rPr>
              <a:t>-log(p-value)</a:t>
            </a:r>
            <a:endParaRPr lang="ko-KR" altLang="en-US" sz="1200" b="1">
              <a:latin typeface="Arial" panose="020B0604020202020204" pitchFamily="34" charset="0"/>
              <a:cs typeface="Arial" panose="020B0604020202020204" pitchFamily="34" charset="0"/>
            </a:endParaRPr>
          </a:p>
        </p:txBody>
      </p:sp>
      <p:sp>
        <p:nvSpPr>
          <p:cNvPr id="146" name="TextBox 145"/>
          <p:cNvSpPr txBox="1"/>
          <p:nvPr/>
        </p:nvSpPr>
        <p:spPr>
          <a:xfrm rot="18701126">
            <a:off x="5848548" y="8117873"/>
            <a:ext cx="1034695"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Z-score</a:t>
            </a:r>
            <a:endParaRPr lang="ko-KR" altLang="en-US" b="1">
              <a:latin typeface="Arial" panose="020B0604020202020204" pitchFamily="34" charset="0"/>
              <a:cs typeface="Arial" panose="020B0604020202020204" pitchFamily="34" charset="0"/>
            </a:endParaRPr>
          </a:p>
        </p:txBody>
      </p:sp>
      <p:sp>
        <p:nvSpPr>
          <p:cNvPr id="147" name="TextBox 146"/>
          <p:cNvSpPr txBox="1"/>
          <p:nvPr/>
        </p:nvSpPr>
        <p:spPr>
          <a:xfrm rot="18701126">
            <a:off x="6254516" y="7930514"/>
            <a:ext cx="1713769"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log(p-value)</a:t>
            </a:r>
            <a:endParaRPr lang="ko-KR" altLang="en-US" b="1">
              <a:latin typeface="Arial" panose="020B0604020202020204" pitchFamily="34" charset="0"/>
              <a:cs typeface="Arial" panose="020B0604020202020204" pitchFamily="34" charset="0"/>
            </a:endParaRPr>
          </a:p>
        </p:txBody>
      </p:sp>
      <p:pic>
        <p:nvPicPr>
          <p:cNvPr id="152" name="그림 151"/>
          <p:cNvPicPr>
            <a:picLocks noChangeAspect="1"/>
          </p:cNvPicPr>
          <p:nvPr/>
        </p:nvPicPr>
        <p:blipFill rotWithShape="1">
          <a:blip r:embed="rId5"/>
          <a:srcRect l="-596" t="57989" r="84034" b="2002"/>
          <a:stretch/>
        </p:blipFill>
        <p:spPr>
          <a:xfrm>
            <a:off x="4939333" y="1645405"/>
            <a:ext cx="711882" cy="3757271"/>
          </a:xfrm>
          <a:prstGeom prst="rect">
            <a:avLst/>
          </a:prstGeom>
        </p:spPr>
      </p:pic>
      <p:pic>
        <p:nvPicPr>
          <p:cNvPr id="153" name="그림 152"/>
          <p:cNvPicPr>
            <a:picLocks noChangeAspect="1"/>
          </p:cNvPicPr>
          <p:nvPr/>
        </p:nvPicPr>
        <p:blipFill>
          <a:blip r:embed="rId6"/>
          <a:stretch>
            <a:fillRect/>
          </a:stretch>
        </p:blipFill>
        <p:spPr>
          <a:xfrm>
            <a:off x="6340190" y="1660874"/>
            <a:ext cx="705306" cy="3644275"/>
          </a:xfrm>
          <a:prstGeom prst="rect">
            <a:avLst/>
          </a:prstGeom>
        </p:spPr>
      </p:pic>
      <p:pic>
        <p:nvPicPr>
          <p:cNvPr id="154" name="그림 153"/>
          <p:cNvPicPr>
            <a:picLocks noChangeAspect="1"/>
          </p:cNvPicPr>
          <p:nvPr/>
        </p:nvPicPr>
        <p:blipFill rotWithShape="1">
          <a:blip r:embed="rId5"/>
          <a:srcRect l="77943" t="57989" r="4974" b="2002"/>
          <a:stretch/>
        </p:blipFill>
        <p:spPr>
          <a:xfrm>
            <a:off x="5659906" y="1650396"/>
            <a:ext cx="710870" cy="3654752"/>
          </a:xfrm>
          <a:prstGeom prst="rect">
            <a:avLst/>
          </a:prstGeom>
        </p:spPr>
      </p:pic>
      <p:sp>
        <p:nvSpPr>
          <p:cNvPr id="2" name="직사각형 1"/>
          <p:cNvSpPr/>
          <p:nvPr/>
        </p:nvSpPr>
        <p:spPr>
          <a:xfrm>
            <a:off x="5686556" y="1670301"/>
            <a:ext cx="1335879" cy="3616261"/>
          </a:xfrm>
          <a:prstGeom prst="rect">
            <a:avLst/>
          </a:pr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70" name="TextBox 69"/>
          <p:cNvSpPr txBox="1"/>
          <p:nvPr/>
        </p:nvSpPr>
        <p:spPr>
          <a:xfrm>
            <a:off x="267803" y="7540521"/>
            <a:ext cx="1332697" cy="523220"/>
          </a:xfrm>
          <a:prstGeom prst="rect">
            <a:avLst/>
          </a:prstGeom>
          <a:noFill/>
        </p:spPr>
        <p:txBody>
          <a:bodyPr wrap="square" rtlCol="0">
            <a:spAutoFit/>
          </a:bodyPr>
          <a:lstStyle/>
          <a:p>
            <a:pPr algn="just"/>
            <a:r>
              <a:rPr lang="en-US" altLang="ko-KR" sz="2800" b="1">
                <a:latin typeface="Arial" panose="020B0604020202020204" pitchFamily="34" charset="0"/>
                <a:cs typeface="Arial" panose="020B0604020202020204" pitchFamily="34" charset="0"/>
              </a:rPr>
              <a:t>b</a:t>
            </a:r>
          </a:p>
        </p:txBody>
      </p:sp>
      <p:sp>
        <p:nvSpPr>
          <p:cNvPr id="71" name="직사각형 70"/>
          <p:cNvSpPr/>
          <p:nvPr/>
        </p:nvSpPr>
        <p:spPr>
          <a:xfrm>
            <a:off x="312488" y="16846521"/>
            <a:ext cx="13746707" cy="2677656"/>
          </a:xfrm>
          <a:prstGeom prst="rect">
            <a:avLst/>
          </a:prstGeom>
        </p:spPr>
        <p:txBody>
          <a:bodyPr wrap="square">
            <a:spAutoFit/>
          </a:bodyPr>
          <a:lstStyle/>
          <a:p>
            <a:pPr algn="just"/>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9. IPA analysis of total 259 proteins </a:t>
            </a:r>
            <a:r>
              <a:rPr lang="en-US" altLang="ko-KR" sz="2400" b="1" dirty="0">
                <a:latin typeface="Arial" panose="020B0604020202020204" pitchFamily="34" charset="0"/>
                <a:cs typeface="Arial" panose="020B0604020202020204" pitchFamily="34" charset="0"/>
              </a:rPr>
              <a:t>that were sum of DEPs in the two sample sets </a:t>
            </a:r>
            <a:r>
              <a:rPr lang="en-US" altLang="ko-KR" sz="2400" b="1" dirty="0" smtClean="0">
                <a:latin typeface="Arial" panose="020B0604020202020204" pitchFamily="34" charset="0"/>
                <a:cs typeface="Arial" panose="020B0604020202020204" pitchFamily="34" charset="0"/>
              </a:rPr>
              <a:t>on canonical pathway and downstream biological functions. </a:t>
            </a:r>
            <a:r>
              <a:rPr lang="en-US" altLang="ko-KR" sz="2400" dirty="0">
                <a:latin typeface="Arial" panose="020B0604020202020204" pitchFamily="34" charset="0"/>
                <a:cs typeface="Arial" panose="020B0604020202020204" pitchFamily="34" charset="0"/>
              </a:rPr>
              <a:t>(a) Canonical pathway enrichment of all 259 DEPs in the two sample sets. (b) Hierarchical clustering of downstream biological functions assessed by IPA using the 259 DEPs. The significant pathways, and downstream biological functions (Fisher’s exact test p-value &lt;0.05) were deduced using Ingenuity Pathway Analysis (IPA), and their activation and inhibition states are expressed as Z-scores.</a:t>
            </a:r>
            <a:endParaRPr lang="en-US" altLang="ko-KR" sz="2400" b="1" dirty="0">
              <a:latin typeface="Arial" panose="020B0604020202020204" pitchFamily="34" charset="0"/>
              <a:cs typeface="Arial" panose="020B0604020202020204" pitchFamily="34" charset="0"/>
            </a:endParaRPr>
          </a:p>
        </p:txBody>
      </p:sp>
      <p:sp>
        <p:nvSpPr>
          <p:cNvPr id="72" name="TextBox 71"/>
          <p:cNvSpPr txBox="1"/>
          <p:nvPr/>
        </p:nvSpPr>
        <p:spPr>
          <a:xfrm>
            <a:off x="6738167" y="19991959"/>
            <a:ext cx="895350" cy="461665"/>
          </a:xfrm>
          <a:prstGeom prst="rect">
            <a:avLst/>
          </a:prstGeom>
          <a:noFill/>
        </p:spPr>
        <p:txBody>
          <a:bodyPr wrap="square" rtlCol="0">
            <a:spAutoFit/>
          </a:bodyPr>
          <a:lstStyle/>
          <a:p>
            <a:r>
              <a:rPr lang="en-US" altLang="ko-KR" sz="2400" b="1" dirty="0" smtClean="0"/>
              <a:t>S-9</a:t>
            </a:r>
            <a:endParaRPr lang="ko-KR" altLang="en-US" sz="2400" b="1" dirty="0"/>
          </a:p>
        </p:txBody>
      </p:sp>
    </p:spTree>
    <p:extLst>
      <p:ext uri="{BB962C8B-B14F-4D97-AF65-F5344CB8AC3E}">
        <p14:creationId xmlns:p14="http://schemas.microsoft.com/office/powerpoint/2010/main" val="1214178697"/>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p:cNvPicPr>
            <a:picLocks noChangeAspect="1"/>
          </p:cNvPicPr>
          <p:nvPr/>
        </p:nvPicPr>
        <p:blipFill rotWithShape="1">
          <a:blip r:embed="rId2"/>
          <a:srcRect l="48851" t="18669" r="16363" b="23542"/>
          <a:stretch/>
        </p:blipFill>
        <p:spPr>
          <a:xfrm rot="10800000">
            <a:off x="1516391" y="1726638"/>
            <a:ext cx="4262430" cy="3458439"/>
          </a:xfrm>
          <a:prstGeom prst="rect">
            <a:avLst/>
          </a:prstGeom>
        </p:spPr>
      </p:pic>
      <p:sp>
        <p:nvSpPr>
          <p:cNvPr id="11" name="직사각형 10"/>
          <p:cNvSpPr/>
          <p:nvPr/>
        </p:nvSpPr>
        <p:spPr>
          <a:xfrm>
            <a:off x="5740721" y="1781066"/>
            <a:ext cx="3635932"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ell proliferation of tumor cell lines</a:t>
            </a:r>
            <a:endParaRPr lang="ko-KR" altLang="en-US" sz="1600" b="1">
              <a:latin typeface="Arial" panose="020B0604020202020204" pitchFamily="34" charset="0"/>
              <a:cs typeface="Arial" panose="020B0604020202020204" pitchFamily="34" charset="0"/>
            </a:endParaRPr>
          </a:p>
        </p:txBody>
      </p:sp>
      <p:sp>
        <p:nvSpPr>
          <p:cNvPr id="13" name="직사각형 12"/>
          <p:cNvSpPr/>
          <p:nvPr/>
        </p:nvSpPr>
        <p:spPr>
          <a:xfrm>
            <a:off x="5740721" y="2398912"/>
            <a:ext cx="4079963"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Cell proliferation of carcinoma cell lines</a:t>
            </a:r>
          </a:p>
        </p:txBody>
      </p:sp>
      <p:sp>
        <p:nvSpPr>
          <p:cNvPr id="14" name="직사각형 13"/>
          <p:cNvSpPr/>
          <p:nvPr/>
        </p:nvSpPr>
        <p:spPr>
          <a:xfrm>
            <a:off x="5740721" y="2989544"/>
            <a:ext cx="2852063" cy="338554"/>
          </a:xfrm>
          <a:prstGeom prst="rect">
            <a:avLst/>
          </a:prstGeom>
        </p:spPr>
        <p:txBody>
          <a:bodyPr wrap="none">
            <a:spAutoFit/>
          </a:bodyPr>
          <a:lstStyle/>
          <a:p>
            <a:r>
              <a:rPr lang="en-US" altLang="ko-KR" sz="1600" b="1" smtClean="0">
                <a:latin typeface="Arial" panose="020B0604020202020204" pitchFamily="34" charset="0"/>
                <a:cs typeface="Arial" panose="020B0604020202020204" pitchFamily="34" charset="0"/>
              </a:rPr>
              <a:t>Microtubule-based </a:t>
            </a:r>
            <a:r>
              <a:rPr lang="en-US" altLang="ko-KR" sz="1600" b="1">
                <a:latin typeface="Arial" panose="020B0604020202020204" pitchFamily="34" charset="0"/>
                <a:cs typeface="Arial" panose="020B0604020202020204" pitchFamily="34" charset="0"/>
              </a:rPr>
              <a:t>process</a:t>
            </a:r>
            <a:endParaRPr lang="ko-KR" altLang="en-US" sz="1600" b="1">
              <a:latin typeface="Arial" panose="020B0604020202020204" pitchFamily="34" charset="0"/>
              <a:cs typeface="Arial" panose="020B0604020202020204" pitchFamily="34" charset="0"/>
            </a:endParaRPr>
          </a:p>
        </p:txBody>
      </p:sp>
      <p:sp>
        <p:nvSpPr>
          <p:cNvPr id="15" name="직사각형 14"/>
          <p:cNvSpPr/>
          <p:nvPr/>
        </p:nvSpPr>
        <p:spPr>
          <a:xfrm>
            <a:off x="5771839" y="3600132"/>
            <a:ext cx="3985771"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Epithelial </a:t>
            </a:r>
            <a:r>
              <a:rPr lang="en-US" altLang="ko-KR" sz="1600" b="1" err="1">
                <a:latin typeface="Arial" panose="020B0604020202020204" pitchFamily="34" charset="0"/>
                <a:cs typeface="Arial" panose="020B0604020202020204" pitchFamily="34" charset="0"/>
              </a:rPr>
              <a:t>Adherens</a:t>
            </a:r>
            <a:r>
              <a:rPr lang="en-US" altLang="ko-KR" sz="1600" b="1">
                <a:latin typeface="Arial" panose="020B0604020202020204" pitchFamily="34" charset="0"/>
                <a:cs typeface="Arial" panose="020B0604020202020204" pitchFamily="34" charset="0"/>
              </a:rPr>
              <a:t> Junction Signaling</a:t>
            </a:r>
          </a:p>
        </p:txBody>
      </p:sp>
      <p:sp>
        <p:nvSpPr>
          <p:cNvPr id="16" name="직사각형 15"/>
          <p:cNvSpPr/>
          <p:nvPr/>
        </p:nvSpPr>
        <p:spPr>
          <a:xfrm>
            <a:off x="5759596" y="4199154"/>
            <a:ext cx="2728632"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14-3-3-mediated Signaling</a:t>
            </a:r>
          </a:p>
        </p:txBody>
      </p:sp>
      <p:sp>
        <p:nvSpPr>
          <p:cNvPr id="17" name="직사각형 16"/>
          <p:cNvSpPr/>
          <p:nvPr/>
        </p:nvSpPr>
        <p:spPr>
          <a:xfrm>
            <a:off x="5759596" y="4799990"/>
            <a:ext cx="2452916"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Phagosome Maturation</a:t>
            </a:r>
          </a:p>
        </p:txBody>
      </p:sp>
      <p:sp>
        <p:nvSpPr>
          <p:cNvPr id="18" name="직사각형 17"/>
          <p:cNvSpPr/>
          <p:nvPr/>
        </p:nvSpPr>
        <p:spPr>
          <a:xfrm>
            <a:off x="9301580" y="9413904"/>
            <a:ext cx="609600" cy="193658"/>
          </a:xfrm>
          <a:prstGeom prst="rect">
            <a:avLst/>
          </a:prstGeom>
          <a:solidFill>
            <a:srgbClr val="FDA749"/>
          </a:solidFill>
          <a:ln w="12700" cap="flat" cmpd="sng" algn="ctr">
            <a:no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1"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19" name="직사각형 18"/>
          <p:cNvSpPr/>
          <p:nvPr/>
        </p:nvSpPr>
        <p:spPr>
          <a:xfrm>
            <a:off x="9301580" y="10088346"/>
            <a:ext cx="609600" cy="193658"/>
          </a:xfrm>
          <a:prstGeom prst="rect">
            <a:avLst/>
          </a:prstGeom>
          <a:solidFill>
            <a:srgbClr val="ED7E7B"/>
          </a:solidFill>
          <a:ln w="12700" cap="flat" cmpd="sng" algn="ctr">
            <a:no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1"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20" name="TextBox 19"/>
          <p:cNvSpPr txBox="1"/>
          <p:nvPr/>
        </p:nvSpPr>
        <p:spPr>
          <a:xfrm>
            <a:off x="9892305" y="9441377"/>
            <a:ext cx="2135195" cy="307777"/>
          </a:xfrm>
          <a:prstGeom prst="rect">
            <a:avLst/>
          </a:prstGeom>
          <a:noFill/>
        </p:spPr>
        <p:txBody>
          <a:bodyPr wrap="square" rtlCol="0">
            <a:spAutoFit/>
          </a:bodyPr>
          <a:lstStyle/>
          <a:p>
            <a:r>
              <a:rPr lang="en-US" altLang="ko-KR" sz="1400" b="1" dirty="0" smtClean="0">
                <a:latin typeface="Arial" panose="020B0604020202020204" pitchFamily="34" charset="0"/>
                <a:cs typeface="Arial" panose="020B0604020202020204" pitchFamily="34" charset="0"/>
              </a:rPr>
              <a:t>Biological process</a:t>
            </a:r>
            <a:endParaRPr lang="ko-KR" altLang="en-US" sz="1400" b="1" dirty="0">
              <a:latin typeface="Arial" panose="020B0604020202020204" pitchFamily="34" charset="0"/>
              <a:cs typeface="Arial" panose="020B0604020202020204" pitchFamily="34" charset="0"/>
            </a:endParaRPr>
          </a:p>
        </p:txBody>
      </p:sp>
      <p:sp>
        <p:nvSpPr>
          <p:cNvPr id="21" name="TextBox 20"/>
          <p:cNvSpPr txBox="1"/>
          <p:nvPr/>
        </p:nvSpPr>
        <p:spPr>
          <a:xfrm>
            <a:off x="9886863" y="9984460"/>
            <a:ext cx="2135195" cy="307777"/>
          </a:xfrm>
          <a:prstGeom prst="rect">
            <a:avLst/>
          </a:prstGeom>
          <a:noFill/>
        </p:spPr>
        <p:txBody>
          <a:bodyPr wrap="square" rtlCol="0">
            <a:spAutoFit/>
          </a:bodyPr>
          <a:lstStyle/>
          <a:p>
            <a:r>
              <a:rPr lang="en-US" altLang="ko-KR" sz="1400" b="1" smtClean="0">
                <a:latin typeface="Arial" panose="020B0604020202020204" pitchFamily="34" charset="0"/>
                <a:cs typeface="Arial" panose="020B0604020202020204" pitchFamily="34" charset="0"/>
              </a:rPr>
              <a:t>Canonical pathway</a:t>
            </a:r>
            <a:endParaRPr lang="ko-KR" altLang="en-US" sz="1400" b="1">
              <a:latin typeface="Arial" panose="020B0604020202020204" pitchFamily="34" charset="0"/>
              <a:cs typeface="Arial" panose="020B0604020202020204" pitchFamily="34" charset="0"/>
            </a:endParaRPr>
          </a:p>
        </p:txBody>
      </p:sp>
      <p:sp>
        <p:nvSpPr>
          <p:cNvPr id="22" name="직사각형 21"/>
          <p:cNvSpPr/>
          <p:nvPr/>
        </p:nvSpPr>
        <p:spPr>
          <a:xfrm>
            <a:off x="9301580" y="9662172"/>
            <a:ext cx="609600" cy="193658"/>
          </a:xfrm>
          <a:prstGeom prst="rect">
            <a:avLst/>
          </a:prstGeom>
          <a:solidFill>
            <a:srgbClr val="0081E2"/>
          </a:solidFill>
          <a:ln w="12700" cap="flat" cmpd="sng" algn="ctr">
            <a:no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1"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23" name="직사각형 22"/>
          <p:cNvSpPr/>
          <p:nvPr/>
        </p:nvSpPr>
        <p:spPr>
          <a:xfrm>
            <a:off x="854200" y="1008286"/>
            <a:ext cx="4924621" cy="357265"/>
          </a:xfrm>
          <a:prstGeom prst="rect">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400" b="1" smtClean="0">
                <a:latin typeface="Arial" panose="020B0604020202020204" pitchFamily="34" charset="0"/>
                <a:cs typeface="Arial" panose="020B0604020202020204" pitchFamily="34" charset="0"/>
              </a:rPr>
              <a:t>Biological process &amp; pathways related to TUBB2A </a:t>
            </a:r>
            <a:endParaRPr lang="ko-KR" altLang="en-US" sz="1400" b="1">
              <a:latin typeface="Arial" panose="020B0604020202020204" pitchFamily="34" charset="0"/>
              <a:cs typeface="Arial" panose="020B0604020202020204" pitchFamily="34" charset="0"/>
            </a:endParaRPr>
          </a:p>
        </p:txBody>
      </p:sp>
      <p:cxnSp>
        <p:nvCxnSpPr>
          <p:cNvPr id="25" name="직선 연결선 24"/>
          <p:cNvCxnSpPr/>
          <p:nvPr/>
        </p:nvCxnSpPr>
        <p:spPr>
          <a:xfrm flipH="1">
            <a:off x="1029710" y="1720977"/>
            <a:ext cx="4749111"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직선 연결선 27"/>
          <p:cNvCxnSpPr/>
          <p:nvPr/>
        </p:nvCxnSpPr>
        <p:spPr>
          <a:xfrm>
            <a:off x="3460126" y="1606890"/>
            <a:ext cx="0" cy="11408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직선 연결선 28"/>
          <p:cNvCxnSpPr/>
          <p:nvPr/>
        </p:nvCxnSpPr>
        <p:spPr>
          <a:xfrm>
            <a:off x="1044949" y="1606890"/>
            <a:ext cx="0" cy="11408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4584478" y="1353602"/>
            <a:ext cx="1339487" cy="307777"/>
          </a:xfrm>
          <a:prstGeom prst="rect">
            <a:avLst/>
          </a:prstGeom>
          <a:noFill/>
        </p:spPr>
        <p:txBody>
          <a:bodyPr wrap="square" rtlCol="0">
            <a:spAutoFit/>
          </a:bodyPr>
          <a:lstStyle/>
          <a:p>
            <a:r>
              <a:rPr lang="en-US" altLang="ko-KR" sz="1400" b="1" smtClean="0">
                <a:latin typeface="Arial" panose="020B0604020202020204" pitchFamily="34" charset="0"/>
                <a:cs typeface="Arial" panose="020B0604020202020204" pitchFamily="34" charset="0"/>
              </a:rPr>
              <a:t>-Log(p-value)</a:t>
            </a:r>
            <a:endParaRPr lang="ko-KR" altLang="en-US" sz="1400" b="1">
              <a:latin typeface="Arial" panose="020B0604020202020204" pitchFamily="34" charset="0"/>
              <a:cs typeface="Arial" panose="020B0604020202020204" pitchFamily="34" charset="0"/>
            </a:endParaRPr>
          </a:p>
        </p:txBody>
      </p:sp>
      <p:sp>
        <p:nvSpPr>
          <p:cNvPr id="31" name="TextBox 30"/>
          <p:cNvSpPr txBox="1"/>
          <p:nvPr/>
        </p:nvSpPr>
        <p:spPr>
          <a:xfrm>
            <a:off x="3323783" y="1353601"/>
            <a:ext cx="434490" cy="338554"/>
          </a:xfrm>
          <a:prstGeom prst="rect">
            <a:avLst/>
          </a:prstGeom>
          <a:noFill/>
        </p:spPr>
        <p:txBody>
          <a:bodyPr wrap="square" rtlCol="0">
            <a:spAutoFit/>
          </a:bodyPr>
          <a:lstStyle/>
          <a:p>
            <a:r>
              <a:rPr lang="en-US" altLang="ko-KR" sz="1600" b="1">
                <a:latin typeface="Arial" panose="020B0604020202020204" pitchFamily="34" charset="0"/>
                <a:cs typeface="Arial" panose="020B0604020202020204" pitchFamily="34" charset="0"/>
              </a:rPr>
              <a:t>5</a:t>
            </a:r>
            <a:endParaRPr lang="ko-KR" altLang="en-US" sz="1600" b="1">
              <a:latin typeface="Arial" panose="020B0604020202020204" pitchFamily="34" charset="0"/>
              <a:cs typeface="Arial" panose="020B0604020202020204" pitchFamily="34" charset="0"/>
            </a:endParaRPr>
          </a:p>
        </p:txBody>
      </p:sp>
      <p:sp>
        <p:nvSpPr>
          <p:cNvPr id="32" name="TextBox 31"/>
          <p:cNvSpPr txBox="1"/>
          <p:nvPr/>
        </p:nvSpPr>
        <p:spPr>
          <a:xfrm>
            <a:off x="854200" y="1353601"/>
            <a:ext cx="458990" cy="338554"/>
          </a:xfrm>
          <a:prstGeom prst="rect">
            <a:avLst/>
          </a:prstGeom>
          <a:noFill/>
        </p:spPr>
        <p:txBody>
          <a:bodyPr wrap="square" rtlCol="0">
            <a:spAutoFit/>
          </a:bodyPr>
          <a:lstStyle/>
          <a:p>
            <a:r>
              <a:rPr lang="en-US" altLang="ko-KR" sz="1600" b="1" smtClean="0">
                <a:latin typeface="Arial" panose="020B0604020202020204" pitchFamily="34" charset="0"/>
                <a:cs typeface="Arial" panose="020B0604020202020204" pitchFamily="34" charset="0"/>
              </a:rPr>
              <a:t>10</a:t>
            </a:r>
            <a:endParaRPr lang="ko-KR" altLang="en-US" sz="1600" b="1">
              <a:latin typeface="Arial" panose="020B0604020202020204" pitchFamily="34" charset="0"/>
              <a:cs typeface="Arial" panose="020B0604020202020204" pitchFamily="34" charset="0"/>
            </a:endParaRPr>
          </a:p>
        </p:txBody>
      </p:sp>
      <p:pic>
        <p:nvPicPr>
          <p:cNvPr id="41" name="그림 40"/>
          <p:cNvPicPr>
            <a:picLocks noChangeAspect="1"/>
          </p:cNvPicPr>
          <p:nvPr/>
        </p:nvPicPr>
        <p:blipFill rotWithShape="1">
          <a:blip r:embed="rId3"/>
          <a:srcRect l="57901" t="19030" b="22524"/>
          <a:stretch/>
        </p:blipFill>
        <p:spPr>
          <a:xfrm rot="10800000">
            <a:off x="438150" y="5963759"/>
            <a:ext cx="5340671" cy="2909300"/>
          </a:xfrm>
          <a:prstGeom prst="rect">
            <a:avLst/>
          </a:prstGeom>
        </p:spPr>
      </p:pic>
      <p:sp>
        <p:nvSpPr>
          <p:cNvPr id="42" name="직사각형 41"/>
          <p:cNvSpPr/>
          <p:nvPr/>
        </p:nvSpPr>
        <p:spPr>
          <a:xfrm>
            <a:off x="847218" y="5251068"/>
            <a:ext cx="4924621" cy="357265"/>
          </a:xfrm>
          <a:prstGeom prst="rect">
            <a:avLst/>
          </a:prstGeom>
          <a:solidFill>
            <a:schemeClr val="tx1">
              <a:lumMod val="50000"/>
              <a:lumOff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400" b="1" dirty="0" smtClean="0">
                <a:latin typeface="Arial" panose="020B0604020202020204" pitchFamily="34" charset="0"/>
                <a:cs typeface="Arial" panose="020B0604020202020204" pitchFamily="34" charset="0"/>
              </a:rPr>
              <a:t>Biological process &amp; pathways related to LTF</a:t>
            </a:r>
            <a:endParaRPr lang="ko-KR" altLang="en-US" sz="1400" b="1" dirty="0">
              <a:latin typeface="Arial" panose="020B0604020202020204" pitchFamily="34" charset="0"/>
              <a:cs typeface="Arial" panose="020B0604020202020204" pitchFamily="34" charset="0"/>
            </a:endParaRPr>
          </a:p>
        </p:txBody>
      </p:sp>
      <p:cxnSp>
        <p:nvCxnSpPr>
          <p:cNvPr id="43" name="직선 연결선 42"/>
          <p:cNvCxnSpPr/>
          <p:nvPr/>
        </p:nvCxnSpPr>
        <p:spPr>
          <a:xfrm flipH="1">
            <a:off x="1022728" y="5963759"/>
            <a:ext cx="4749111"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직선 연결선 43"/>
          <p:cNvCxnSpPr/>
          <p:nvPr/>
        </p:nvCxnSpPr>
        <p:spPr>
          <a:xfrm>
            <a:off x="3453144" y="5849672"/>
            <a:ext cx="0" cy="11408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직선 연결선 44"/>
          <p:cNvCxnSpPr/>
          <p:nvPr/>
        </p:nvCxnSpPr>
        <p:spPr>
          <a:xfrm>
            <a:off x="1037967" y="5849672"/>
            <a:ext cx="0" cy="114087"/>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4577496" y="5596384"/>
            <a:ext cx="1339487" cy="307777"/>
          </a:xfrm>
          <a:prstGeom prst="rect">
            <a:avLst/>
          </a:prstGeom>
          <a:noFill/>
        </p:spPr>
        <p:txBody>
          <a:bodyPr wrap="square" rtlCol="0">
            <a:spAutoFit/>
          </a:bodyPr>
          <a:lstStyle/>
          <a:p>
            <a:r>
              <a:rPr lang="en-US" altLang="ko-KR" sz="1400" b="1" smtClean="0">
                <a:latin typeface="Arial" panose="020B0604020202020204" pitchFamily="34" charset="0"/>
                <a:cs typeface="Arial" panose="020B0604020202020204" pitchFamily="34" charset="0"/>
              </a:rPr>
              <a:t>-Log(p-value)</a:t>
            </a:r>
            <a:endParaRPr lang="ko-KR" altLang="en-US" sz="1400" b="1">
              <a:latin typeface="Arial" panose="020B0604020202020204" pitchFamily="34" charset="0"/>
              <a:cs typeface="Arial" panose="020B0604020202020204" pitchFamily="34" charset="0"/>
            </a:endParaRPr>
          </a:p>
        </p:txBody>
      </p:sp>
      <p:sp>
        <p:nvSpPr>
          <p:cNvPr id="47" name="TextBox 46"/>
          <p:cNvSpPr txBox="1"/>
          <p:nvPr/>
        </p:nvSpPr>
        <p:spPr>
          <a:xfrm>
            <a:off x="3305263" y="5580692"/>
            <a:ext cx="361134" cy="338554"/>
          </a:xfrm>
          <a:prstGeom prst="rect">
            <a:avLst/>
          </a:prstGeom>
          <a:noFill/>
        </p:spPr>
        <p:txBody>
          <a:bodyPr wrap="square" rtlCol="0">
            <a:spAutoFit/>
          </a:bodyPr>
          <a:lstStyle/>
          <a:p>
            <a:r>
              <a:rPr lang="en-US" altLang="ko-KR" sz="1600" b="1" smtClean="0">
                <a:latin typeface="Arial" panose="020B0604020202020204" pitchFamily="34" charset="0"/>
                <a:cs typeface="Arial" panose="020B0604020202020204" pitchFamily="34" charset="0"/>
              </a:rPr>
              <a:t>2</a:t>
            </a:r>
            <a:endParaRPr lang="ko-KR" altLang="en-US" sz="1600" b="1">
              <a:latin typeface="Arial" panose="020B0604020202020204" pitchFamily="34" charset="0"/>
              <a:cs typeface="Arial" panose="020B0604020202020204" pitchFamily="34" charset="0"/>
            </a:endParaRPr>
          </a:p>
        </p:txBody>
      </p:sp>
      <p:sp>
        <p:nvSpPr>
          <p:cNvPr id="48" name="TextBox 47"/>
          <p:cNvSpPr txBox="1"/>
          <p:nvPr/>
        </p:nvSpPr>
        <p:spPr>
          <a:xfrm>
            <a:off x="892946" y="5567564"/>
            <a:ext cx="381498" cy="338554"/>
          </a:xfrm>
          <a:prstGeom prst="rect">
            <a:avLst/>
          </a:prstGeom>
          <a:noFill/>
        </p:spPr>
        <p:txBody>
          <a:bodyPr wrap="square" rtlCol="0">
            <a:spAutoFit/>
          </a:bodyPr>
          <a:lstStyle/>
          <a:p>
            <a:r>
              <a:rPr lang="en-US" altLang="ko-KR" sz="1600" b="1">
                <a:latin typeface="Arial" panose="020B0604020202020204" pitchFamily="34" charset="0"/>
                <a:cs typeface="Arial" panose="020B0604020202020204" pitchFamily="34" charset="0"/>
              </a:rPr>
              <a:t>4</a:t>
            </a:r>
            <a:endParaRPr lang="ko-KR" altLang="en-US" sz="1600" b="1">
              <a:latin typeface="Arial" panose="020B0604020202020204" pitchFamily="34" charset="0"/>
              <a:cs typeface="Arial" panose="020B0604020202020204" pitchFamily="34" charset="0"/>
            </a:endParaRPr>
          </a:p>
        </p:txBody>
      </p:sp>
      <p:sp>
        <p:nvSpPr>
          <p:cNvPr id="50" name="직사각형 49"/>
          <p:cNvSpPr/>
          <p:nvPr/>
        </p:nvSpPr>
        <p:spPr>
          <a:xfrm>
            <a:off x="5740721" y="6006887"/>
            <a:ext cx="3001143" cy="338554"/>
          </a:xfrm>
          <a:prstGeom prst="rect">
            <a:avLst/>
          </a:prstGeom>
        </p:spPr>
        <p:txBody>
          <a:bodyPr wrap="none">
            <a:spAutoFit/>
          </a:bodyPr>
          <a:lstStyle/>
          <a:p>
            <a:r>
              <a:rPr lang="en-US" altLang="ko-KR" sz="1600" b="1">
                <a:latin typeface="Arial" panose="020B0604020202020204" pitchFamily="34" charset="0"/>
                <a:cs typeface="Arial" panose="020B0604020202020204" pitchFamily="34" charset="0"/>
              </a:rPr>
              <a:t>Binding of </a:t>
            </a:r>
            <a:r>
              <a:rPr lang="en-US" altLang="ko-KR" sz="1600" b="1" err="1">
                <a:latin typeface="Arial" panose="020B0604020202020204" pitchFamily="34" charset="0"/>
                <a:cs typeface="Arial" panose="020B0604020202020204" pitchFamily="34" charset="0"/>
              </a:rPr>
              <a:t>NFkB</a:t>
            </a:r>
            <a:r>
              <a:rPr lang="en-US" altLang="ko-KR" sz="1600" b="1">
                <a:latin typeface="Arial" panose="020B0604020202020204" pitchFamily="34" charset="0"/>
                <a:cs typeface="Arial" panose="020B0604020202020204" pitchFamily="34" charset="0"/>
              </a:rPr>
              <a:t> binding site</a:t>
            </a:r>
          </a:p>
        </p:txBody>
      </p:sp>
      <p:sp>
        <p:nvSpPr>
          <p:cNvPr id="51" name="직사각형 50"/>
          <p:cNvSpPr/>
          <p:nvPr/>
        </p:nvSpPr>
        <p:spPr>
          <a:xfrm>
            <a:off x="5746257" y="6603271"/>
            <a:ext cx="4164923" cy="338554"/>
          </a:xfrm>
          <a:prstGeom prst="rect">
            <a:avLst/>
          </a:prstGeom>
        </p:spPr>
        <p:txBody>
          <a:bodyPr wrap="none">
            <a:spAutoFit/>
          </a:bodyPr>
          <a:lstStyle/>
          <a:p>
            <a:r>
              <a:rPr lang="en-US" altLang="ko-KR" sz="1600" b="1" smtClean="0">
                <a:latin typeface="Arial" panose="020B0604020202020204" pitchFamily="34" charset="0"/>
                <a:cs typeface="Arial" panose="020B0604020202020204" pitchFamily="34" charset="0"/>
              </a:rPr>
              <a:t>Negative </a:t>
            </a:r>
            <a:r>
              <a:rPr lang="en-US" altLang="ko-KR" sz="1600" b="1">
                <a:latin typeface="Arial" panose="020B0604020202020204" pitchFamily="34" charset="0"/>
                <a:cs typeface="Arial" panose="020B0604020202020204" pitchFamily="34" charset="0"/>
              </a:rPr>
              <a:t>regulation of apoptotic process</a:t>
            </a:r>
          </a:p>
        </p:txBody>
      </p:sp>
      <p:sp>
        <p:nvSpPr>
          <p:cNvPr id="52" name="직사각형 51"/>
          <p:cNvSpPr/>
          <p:nvPr/>
        </p:nvSpPr>
        <p:spPr>
          <a:xfrm>
            <a:off x="5740721" y="7228976"/>
            <a:ext cx="5989140" cy="338554"/>
          </a:xfrm>
          <a:prstGeom prst="rect">
            <a:avLst/>
          </a:prstGeom>
        </p:spPr>
        <p:txBody>
          <a:bodyPr wrap="none">
            <a:spAutoFit/>
          </a:bodyPr>
          <a:lstStyle/>
          <a:p>
            <a:r>
              <a:rPr lang="en-US" altLang="ko-KR" sz="1600" b="1" smtClean="0">
                <a:latin typeface="Arial" panose="020B0604020202020204" pitchFamily="34" charset="0"/>
                <a:cs typeface="Arial" panose="020B0604020202020204" pitchFamily="34" charset="0"/>
              </a:rPr>
              <a:t>Positive </a:t>
            </a:r>
            <a:r>
              <a:rPr lang="en-US" altLang="ko-KR" sz="1600" b="1">
                <a:latin typeface="Arial" panose="020B0604020202020204" pitchFamily="34" charset="0"/>
                <a:cs typeface="Arial" panose="020B0604020202020204" pitchFamily="34" charset="0"/>
              </a:rPr>
              <a:t>regulation of I-</a:t>
            </a:r>
            <a:r>
              <a:rPr lang="en-US" altLang="ko-KR" sz="1600" b="1" err="1">
                <a:latin typeface="Arial" panose="020B0604020202020204" pitchFamily="34" charset="0"/>
                <a:cs typeface="Arial" panose="020B0604020202020204" pitchFamily="34" charset="0"/>
              </a:rPr>
              <a:t>kappaB</a:t>
            </a:r>
            <a:r>
              <a:rPr lang="en-US" altLang="ko-KR" sz="1600" b="1">
                <a:latin typeface="Arial" panose="020B0604020202020204" pitchFamily="34" charset="0"/>
                <a:cs typeface="Arial" panose="020B0604020202020204" pitchFamily="34" charset="0"/>
              </a:rPr>
              <a:t> kinase/NF-</a:t>
            </a:r>
            <a:r>
              <a:rPr lang="en-US" altLang="ko-KR" sz="1600" b="1" err="1">
                <a:latin typeface="Arial" panose="020B0604020202020204" pitchFamily="34" charset="0"/>
                <a:cs typeface="Arial" panose="020B0604020202020204" pitchFamily="34" charset="0"/>
              </a:rPr>
              <a:t>kappaB</a:t>
            </a:r>
            <a:r>
              <a:rPr lang="en-US" altLang="ko-KR" sz="1600" b="1">
                <a:latin typeface="Arial" panose="020B0604020202020204" pitchFamily="34" charset="0"/>
                <a:cs typeface="Arial" panose="020B0604020202020204" pitchFamily="34" charset="0"/>
              </a:rPr>
              <a:t> signaling</a:t>
            </a:r>
          </a:p>
        </p:txBody>
      </p:sp>
      <p:sp>
        <p:nvSpPr>
          <p:cNvPr id="53" name="직사각형 52"/>
          <p:cNvSpPr/>
          <p:nvPr/>
        </p:nvSpPr>
        <p:spPr>
          <a:xfrm>
            <a:off x="5740721" y="7853525"/>
            <a:ext cx="3891963" cy="338554"/>
          </a:xfrm>
          <a:prstGeom prst="rect">
            <a:avLst/>
          </a:prstGeom>
        </p:spPr>
        <p:txBody>
          <a:bodyPr wrap="none">
            <a:spAutoFit/>
          </a:bodyPr>
          <a:lstStyle/>
          <a:p>
            <a:r>
              <a:rPr lang="en-US" altLang="ko-KR" sz="1600" b="1" smtClean="0">
                <a:latin typeface="Arial" panose="020B0604020202020204" pitchFamily="34" charset="0"/>
                <a:cs typeface="Arial" panose="020B0604020202020204" pitchFamily="34" charset="0"/>
              </a:rPr>
              <a:t>Negative </a:t>
            </a:r>
            <a:r>
              <a:rPr lang="en-US" altLang="ko-KR" sz="1600" b="1">
                <a:latin typeface="Arial" panose="020B0604020202020204" pitchFamily="34" charset="0"/>
                <a:cs typeface="Arial" panose="020B0604020202020204" pitchFamily="34" charset="0"/>
              </a:rPr>
              <a:t>regulation of ATPase activity</a:t>
            </a:r>
          </a:p>
        </p:txBody>
      </p:sp>
      <p:sp>
        <p:nvSpPr>
          <p:cNvPr id="54" name="직사각형 53"/>
          <p:cNvSpPr/>
          <p:nvPr/>
        </p:nvSpPr>
        <p:spPr>
          <a:xfrm>
            <a:off x="5740721" y="8463601"/>
            <a:ext cx="5939446" cy="338554"/>
          </a:xfrm>
          <a:prstGeom prst="rect">
            <a:avLst/>
          </a:prstGeom>
        </p:spPr>
        <p:txBody>
          <a:bodyPr wrap="none">
            <a:spAutoFit/>
          </a:bodyPr>
          <a:lstStyle/>
          <a:p>
            <a:r>
              <a:rPr lang="en-US" altLang="ko-KR" sz="1600" b="1" smtClean="0">
                <a:latin typeface="Arial" panose="020B0604020202020204" pitchFamily="34" charset="0"/>
                <a:cs typeface="Arial" panose="020B0604020202020204" pitchFamily="34" charset="0"/>
              </a:rPr>
              <a:t>Positive </a:t>
            </a:r>
            <a:r>
              <a:rPr lang="en-US" altLang="ko-KR" sz="1600" b="1">
                <a:latin typeface="Arial" panose="020B0604020202020204" pitchFamily="34" charset="0"/>
                <a:cs typeface="Arial" panose="020B0604020202020204" pitchFamily="34" charset="0"/>
              </a:rPr>
              <a:t>regulation of toll-like receptor 4 signaling pathway</a:t>
            </a:r>
          </a:p>
        </p:txBody>
      </p:sp>
      <p:sp>
        <p:nvSpPr>
          <p:cNvPr id="35" name="직사각형 34"/>
          <p:cNvSpPr/>
          <p:nvPr/>
        </p:nvSpPr>
        <p:spPr>
          <a:xfrm>
            <a:off x="289980" y="11537644"/>
            <a:ext cx="13753543" cy="1200329"/>
          </a:xfrm>
          <a:prstGeom prst="rect">
            <a:avLst/>
          </a:prstGeom>
        </p:spPr>
        <p:txBody>
          <a:bodyPr wrap="square">
            <a:spAutoFit/>
          </a:bodyPr>
          <a:lstStyle/>
          <a:p>
            <a:pPr algn="just"/>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10. </a:t>
            </a:r>
            <a:r>
              <a:rPr lang="en-US" altLang="ko-KR" sz="2400" b="1" dirty="0">
                <a:latin typeface="Arial" panose="020B0604020202020204" pitchFamily="34" charset="0"/>
                <a:cs typeface="Arial" panose="020B0604020202020204" pitchFamily="34" charset="0"/>
              </a:rPr>
              <a:t>Biological functions and canonical pathways related to </a:t>
            </a:r>
            <a:r>
              <a:rPr lang="en-US" altLang="ko-KR" sz="2400" b="1" dirty="0" smtClean="0">
                <a:latin typeface="Arial" panose="020B0604020202020204" pitchFamily="34" charset="0"/>
                <a:cs typeface="Arial" panose="020B0604020202020204" pitchFamily="34" charset="0"/>
              </a:rPr>
              <a:t>the two protein targets by </a:t>
            </a:r>
            <a:r>
              <a:rPr lang="en-US" altLang="ko-KR" sz="2400" b="1" dirty="0">
                <a:latin typeface="Arial" panose="020B0604020202020204" pitchFamily="34" charset="0"/>
                <a:cs typeface="Arial" panose="020B0604020202020204" pitchFamily="34" charset="0"/>
              </a:rPr>
              <a:t>IPA and DAVID analysis.</a:t>
            </a:r>
            <a:r>
              <a:rPr lang="en-US" altLang="ko-KR" sz="2400" dirty="0">
                <a:latin typeface="Arial" panose="020B0604020202020204" pitchFamily="34" charset="0"/>
                <a:cs typeface="Arial" panose="020B0604020202020204" pitchFamily="34" charset="0"/>
              </a:rPr>
              <a:t> Biological functions and pathways of TUBB2A (upper panel) and LTF (lower panel) (Fisher’s exact test p-value &lt; 0.05 for DAVID and IPA analysis).</a:t>
            </a:r>
          </a:p>
        </p:txBody>
      </p:sp>
      <p:sp>
        <p:nvSpPr>
          <p:cNvPr id="36" name="TextBox 35"/>
          <p:cNvSpPr txBox="1"/>
          <p:nvPr/>
        </p:nvSpPr>
        <p:spPr>
          <a:xfrm>
            <a:off x="6738167" y="19991959"/>
            <a:ext cx="895350" cy="461665"/>
          </a:xfrm>
          <a:prstGeom prst="rect">
            <a:avLst/>
          </a:prstGeom>
          <a:noFill/>
        </p:spPr>
        <p:txBody>
          <a:bodyPr wrap="square" rtlCol="0">
            <a:spAutoFit/>
          </a:bodyPr>
          <a:lstStyle/>
          <a:p>
            <a:r>
              <a:rPr lang="en-US" altLang="ko-KR" sz="2400" b="1" dirty="0" smtClean="0"/>
              <a:t>S-10</a:t>
            </a:r>
            <a:endParaRPr lang="ko-KR" altLang="en-US" sz="2400" b="1" dirty="0"/>
          </a:p>
        </p:txBody>
      </p:sp>
    </p:spTree>
    <p:extLst>
      <p:ext uri="{BB962C8B-B14F-4D97-AF65-F5344CB8AC3E}">
        <p14:creationId xmlns:p14="http://schemas.microsoft.com/office/powerpoint/2010/main" val="146170003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직사각형 4"/>
          <p:cNvSpPr/>
          <p:nvPr/>
        </p:nvSpPr>
        <p:spPr>
          <a:xfrm>
            <a:off x="169931" y="18725538"/>
            <a:ext cx="13870264" cy="1200329"/>
          </a:xfrm>
          <a:prstGeom prst="rect">
            <a:avLst/>
          </a:prstGeom>
        </p:spPr>
        <p:txBody>
          <a:bodyPr wrap="square">
            <a:spAutoFit/>
          </a:bodyPr>
          <a:lstStyle/>
          <a:p>
            <a:pPr algn="just"/>
            <a:r>
              <a:rPr lang="en-US" altLang="ko-KR" sz="2200" b="1" dirty="0" smtClean="0">
                <a:latin typeface="Arial" panose="020B0604020202020204" pitchFamily="34" charset="0"/>
                <a:cs typeface="Arial" panose="020B0604020202020204" pitchFamily="34" charset="0"/>
              </a:rPr>
              <a:t>Additional File 1: Figure S1. </a:t>
            </a:r>
            <a:r>
              <a:rPr lang="en-US" altLang="ko-KR" sz="2400" b="1" dirty="0">
                <a:latin typeface="Arial" panose="020B0604020202020204" pitchFamily="34" charset="0"/>
                <a:cs typeface="Arial" panose="020B0604020202020204" pitchFamily="34" charset="0"/>
              </a:rPr>
              <a:t>Detailed experimental workflow of TMT-based proteomic study. </a:t>
            </a:r>
            <a:r>
              <a:rPr lang="en-US" altLang="ko-KR" sz="2400" dirty="0">
                <a:latin typeface="Arial" panose="020B0604020202020204" pitchFamily="34" charset="0"/>
                <a:cs typeface="Arial" panose="020B0604020202020204" pitchFamily="34" charset="0"/>
              </a:rPr>
              <a:t>Graphical representation of the workflow for our TMT experiments. Three sample sets were analyzed using our TMT-based proteomic techniques.</a:t>
            </a:r>
            <a:endParaRPr lang="ko-KR" altLang="ko-KR" sz="2800" dirty="0">
              <a:latin typeface="Arial" panose="020B0604020202020204" pitchFamily="34" charset="0"/>
              <a:cs typeface="Arial" panose="020B0604020202020204" pitchFamily="34" charset="0"/>
            </a:endParaRPr>
          </a:p>
        </p:txBody>
      </p:sp>
      <p:sp>
        <p:nvSpPr>
          <p:cNvPr id="6" name="TextBox 5"/>
          <p:cNvSpPr txBox="1"/>
          <p:nvPr/>
        </p:nvSpPr>
        <p:spPr>
          <a:xfrm>
            <a:off x="6830357" y="19470112"/>
            <a:ext cx="895350" cy="461665"/>
          </a:xfrm>
          <a:prstGeom prst="rect">
            <a:avLst/>
          </a:prstGeom>
          <a:noFill/>
        </p:spPr>
        <p:txBody>
          <a:bodyPr wrap="square" rtlCol="0">
            <a:spAutoFit/>
          </a:bodyPr>
          <a:lstStyle/>
          <a:p>
            <a:r>
              <a:rPr lang="en-US" altLang="ko-KR" sz="2400" b="1" smtClean="0"/>
              <a:t>S-1</a:t>
            </a:r>
            <a:endParaRPr lang="ko-KR" altLang="en-US" sz="2400" b="1"/>
          </a:p>
        </p:txBody>
      </p:sp>
      <p:pic>
        <p:nvPicPr>
          <p:cNvPr id="316" name="그림 315"/>
          <p:cNvPicPr>
            <a:picLocks noChangeAspect="1"/>
          </p:cNvPicPr>
          <p:nvPr/>
        </p:nvPicPr>
        <p:blipFill>
          <a:blip r:embed="rId2"/>
          <a:stretch>
            <a:fillRect/>
          </a:stretch>
        </p:blipFill>
        <p:spPr>
          <a:xfrm>
            <a:off x="10030861" y="12135400"/>
            <a:ext cx="1899886" cy="1117268"/>
          </a:xfrm>
          <a:prstGeom prst="rect">
            <a:avLst/>
          </a:prstGeom>
        </p:spPr>
      </p:pic>
      <p:pic>
        <p:nvPicPr>
          <p:cNvPr id="317" name="그림 316">
            <a:extLst>
              <a:ext uri="{FF2B5EF4-FFF2-40B4-BE49-F238E27FC236}">
                <a16:creationId xmlns:a16="http://schemas.microsoft.com/office/drawing/2014/main" id="{052464BF-3F33-4751-B08A-B45598019C83}"/>
              </a:ext>
            </a:extLst>
          </p:cNvPr>
          <p:cNvPicPr>
            <a:picLocks noChangeAspect="1"/>
          </p:cNvPicPr>
          <p:nvPr/>
        </p:nvPicPr>
        <p:blipFill rotWithShape="1">
          <a:blip r:embed="rId3">
            <a:extLst>
              <a:ext uri="{BEBA8EAE-BF5A-486C-A8C5-ECC9F3942E4B}">
                <a14:imgProps xmlns:a14="http://schemas.microsoft.com/office/drawing/2010/main">
                  <a14:imgLayer r:embed="rId4">
                    <a14:imgEffect>
                      <a14:backgroundRemoval t="27725" b="83174" l="15399" r="93156"/>
                    </a14:imgEffect>
                  </a14:imgLayer>
                </a14:imgProps>
              </a:ext>
            </a:extLst>
          </a:blip>
          <a:srcRect t="14640" b="10978"/>
          <a:stretch/>
        </p:blipFill>
        <p:spPr>
          <a:xfrm>
            <a:off x="11732673" y="12004672"/>
            <a:ext cx="1782238" cy="1247996"/>
          </a:xfrm>
          <a:prstGeom prst="rect">
            <a:avLst/>
          </a:prstGeom>
        </p:spPr>
      </p:pic>
      <p:sp>
        <p:nvSpPr>
          <p:cNvPr id="318" name="TextBox 317"/>
          <p:cNvSpPr txBox="1"/>
          <p:nvPr/>
        </p:nvSpPr>
        <p:spPr>
          <a:xfrm>
            <a:off x="11511647" y="13405625"/>
            <a:ext cx="2003264" cy="646331"/>
          </a:xfrm>
          <a:prstGeom prst="rect">
            <a:avLst/>
          </a:prstGeom>
          <a:noFill/>
        </p:spPr>
        <p:txBody>
          <a:bodyPr wrap="square" rtlCol="0">
            <a:spAutoFit/>
          </a:bodyPr>
          <a:lstStyle/>
          <a:p>
            <a:pPr algn="ctr"/>
            <a:r>
              <a:rPr lang="en-US" altLang="ko-KR" b="1" dirty="0" smtClean="0">
                <a:latin typeface="Arial" panose="020B0604020202020204" pitchFamily="34" charset="0"/>
                <a:cs typeface="Arial" panose="020B0604020202020204" pitchFamily="34" charset="0"/>
              </a:rPr>
              <a:t>High-resolution</a:t>
            </a:r>
          </a:p>
          <a:p>
            <a:pPr algn="ctr"/>
            <a:r>
              <a:rPr lang="en-US" altLang="ko-KR" b="1" dirty="0" smtClean="0">
                <a:latin typeface="Arial" panose="020B0604020202020204" pitchFamily="34" charset="0"/>
                <a:cs typeface="Arial" panose="020B0604020202020204" pitchFamily="34" charset="0"/>
              </a:rPr>
              <a:t>LC-MS/MS</a:t>
            </a:r>
          </a:p>
        </p:txBody>
      </p:sp>
      <p:pic>
        <p:nvPicPr>
          <p:cNvPr id="319" name="그림 318"/>
          <p:cNvPicPr>
            <a:picLocks noChangeAspect="1"/>
          </p:cNvPicPr>
          <p:nvPr/>
        </p:nvPicPr>
        <p:blipFill>
          <a:blip r:embed="rId5"/>
          <a:stretch>
            <a:fillRect/>
          </a:stretch>
        </p:blipFill>
        <p:spPr>
          <a:xfrm>
            <a:off x="11802646" y="16012071"/>
            <a:ext cx="1900677" cy="1676668"/>
          </a:xfrm>
          <a:prstGeom prst="rect">
            <a:avLst/>
          </a:prstGeom>
          <a:ln w="28575">
            <a:solidFill>
              <a:schemeClr val="tx1"/>
            </a:solidFill>
          </a:ln>
        </p:spPr>
      </p:pic>
      <p:pic>
        <p:nvPicPr>
          <p:cNvPr id="320" name="그림 319"/>
          <p:cNvPicPr>
            <a:picLocks noChangeAspect="1"/>
          </p:cNvPicPr>
          <p:nvPr/>
        </p:nvPicPr>
        <p:blipFill>
          <a:blip r:embed="rId5"/>
          <a:stretch>
            <a:fillRect/>
          </a:stretch>
        </p:blipFill>
        <p:spPr>
          <a:xfrm>
            <a:off x="11678209" y="15849536"/>
            <a:ext cx="1900677" cy="1676668"/>
          </a:xfrm>
          <a:prstGeom prst="rect">
            <a:avLst/>
          </a:prstGeom>
          <a:ln w="28575">
            <a:solidFill>
              <a:schemeClr val="tx1"/>
            </a:solidFill>
          </a:ln>
        </p:spPr>
      </p:pic>
      <p:pic>
        <p:nvPicPr>
          <p:cNvPr id="321" name="그림 320"/>
          <p:cNvPicPr>
            <a:picLocks noChangeAspect="1"/>
          </p:cNvPicPr>
          <p:nvPr/>
        </p:nvPicPr>
        <p:blipFill>
          <a:blip r:embed="rId5"/>
          <a:stretch>
            <a:fillRect/>
          </a:stretch>
        </p:blipFill>
        <p:spPr>
          <a:xfrm>
            <a:off x="11553772" y="15696579"/>
            <a:ext cx="1900677" cy="1676668"/>
          </a:xfrm>
          <a:prstGeom prst="rect">
            <a:avLst/>
          </a:prstGeom>
          <a:ln w="28575">
            <a:solidFill>
              <a:schemeClr val="tx1"/>
            </a:solidFill>
          </a:ln>
        </p:spPr>
      </p:pic>
      <p:pic>
        <p:nvPicPr>
          <p:cNvPr id="322" name="그림 321"/>
          <p:cNvPicPr>
            <a:picLocks noChangeAspect="1"/>
          </p:cNvPicPr>
          <p:nvPr/>
        </p:nvPicPr>
        <p:blipFill>
          <a:blip r:embed="rId5"/>
          <a:stretch>
            <a:fillRect/>
          </a:stretch>
        </p:blipFill>
        <p:spPr>
          <a:xfrm>
            <a:off x="11427873" y="15543622"/>
            <a:ext cx="1900677" cy="1676668"/>
          </a:xfrm>
          <a:prstGeom prst="rect">
            <a:avLst/>
          </a:prstGeom>
          <a:ln w="28575">
            <a:solidFill>
              <a:schemeClr val="tx1"/>
            </a:solidFill>
          </a:ln>
        </p:spPr>
      </p:pic>
      <p:cxnSp>
        <p:nvCxnSpPr>
          <p:cNvPr id="323" name="직선 화살표 연결선 322"/>
          <p:cNvCxnSpPr/>
          <p:nvPr/>
        </p:nvCxnSpPr>
        <p:spPr>
          <a:xfrm flipH="1">
            <a:off x="12483824" y="14356059"/>
            <a:ext cx="8878" cy="883460"/>
          </a:xfrm>
          <a:prstGeom prst="straightConnector1">
            <a:avLst/>
          </a:prstGeom>
          <a:ln w="762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4" name="TextBox 323"/>
          <p:cNvSpPr txBox="1"/>
          <p:nvPr/>
        </p:nvSpPr>
        <p:spPr>
          <a:xfrm>
            <a:off x="10887583" y="17921603"/>
            <a:ext cx="3404184" cy="369332"/>
          </a:xfrm>
          <a:prstGeom prst="rect">
            <a:avLst/>
          </a:prstGeom>
          <a:noFill/>
        </p:spPr>
        <p:txBody>
          <a:bodyPr wrap="square" rtlCol="0">
            <a:spAutoFit/>
          </a:bodyPr>
          <a:lstStyle/>
          <a:p>
            <a:pPr algn="ctr"/>
            <a:r>
              <a:rPr lang="en-US" altLang="ko-KR" b="1" dirty="0" smtClean="0">
                <a:latin typeface="Arial" panose="020B0604020202020204" pitchFamily="34" charset="0"/>
                <a:cs typeface="Arial" panose="020B0604020202020204" pitchFamily="34" charset="0"/>
              </a:rPr>
              <a:t>Reporter ion quantification</a:t>
            </a:r>
          </a:p>
        </p:txBody>
      </p:sp>
      <p:pic>
        <p:nvPicPr>
          <p:cNvPr id="325" name="그림 324"/>
          <p:cNvPicPr>
            <a:picLocks noChangeAspect="1"/>
          </p:cNvPicPr>
          <p:nvPr/>
        </p:nvPicPr>
        <p:blipFill>
          <a:blip r:embed="rId6"/>
          <a:stretch>
            <a:fillRect/>
          </a:stretch>
        </p:blipFill>
        <p:spPr>
          <a:xfrm>
            <a:off x="2580986" y="12223357"/>
            <a:ext cx="563360" cy="584398"/>
          </a:xfrm>
          <a:prstGeom prst="rect">
            <a:avLst/>
          </a:prstGeom>
        </p:spPr>
      </p:pic>
      <p:pic>
        <p:nvPicPr>
          <p:cNvPr id="326" name="그림 325"/>
          <p:cNvPicPr>
            <a:picLocks noChangeAspect="1"/>
          </p:cNvPicPr>
          <p:nvPr/>
        </p:nvPicPr>
        <p:blipFill>
          <a:blip r:embed="rId6"/>
          <a:stretch>
            <a:fillRect/>
          </a:stretch>
        </p:blipFill>
        <p:spPr>
          <a:xfrm>
            <a:off x="2579644" y="12883160"/>
            <a:ext cx="563360" cy="584398"/>
          </a:xfrm>
          <a:prstGeom prst="rect">
            <a:avLst/>
          </a:prstGeom>
        </p:spPr>
      </p:pic>
      <p:pic>
        <p:nvPicPr>
          <p:cNvPr id="327" name="그림 326"/>
          <p:cNvPicPr>
            <a:picLocks noChangeAspect="1"/>
          </p:cNvPicPr>
          <p:nvPr/>
        </p:nvPicPr>
        <p:blipFill>
          <a:blip r:embed="rId6"/>
          <a:stretch>
            <a:fillRect/>
          </a:stretch>
        </p:blipFill>
        <p:spPr>
          <a:xfrm>
            <a:off x="2549823" y="13467558"/>
            <a:ext cx="563360" cy="584398"/>
          </a:xfrm>
          <a:prstGeom prst="rect">
            <a:avLst/>
          </a:prstGeom>
        </p:spPr>
      </p:pic>
      <p:pic>
        <p:nvPicPr>
          <p:cNvPr id="328" name="그림 327"/>
          <p:cNvPicPr>
            <a:picLocks noChangeAspect="1"/>
          </p:cNvPicPr>
          <p:nvPr/>
        </p:nvPicPr>
        <p:blipFill>
          <a:blip r:embed="rId6"/>
          <a:stretch>
            <a:fillRect/>
          </a:stretch>
        </p:blipFill>
        <p:spPr>
          <a:xfrm>
            <a:off x="7023255" y="12247057"/>
            <a:ext cx="563360" cy="584398"/>
          </a:xfrm>
          <a:prstGeom prst="rect">
            <a:avLst/>
          </a:prstGeom>
        </p:spPr>
      </p:pic>
      <p:pic>
        <p:nvPicPr>
          <p:cNvPr id="329" name="그림 328"/>
          <p:cNvPicPr>
            <a:picLocks noChangeAspect="1"/>
          </p:cNvPicPr>
          <p:nvPr/>
        </p:nvPicPr>
        <p:blipFill>
          <a:blip r:embed="rId6"/>
          <a:stretch>
            <a:fillRect/>
          </a:stretch>
        </p:blipFill>
        <p:spPr>
          <a:xfrm>
            <a:off x="7021913" y="12906860"/>
            <a:ext cx="563360" cy="584398"/>
          </a:xfrm>
          <a:prstGeom prst="rect">
            <a:avLst/>
          </a:prstGeom>
        </p:spPr>
      </p:pic>
      <p:pic>
        <p:nvPicPr>
          <p:cNvPr id="330" name="그림 329"/>
          <p:cNvPicPr>
            <a:picLocks noChangeAspect="1"/>
          </p:cNvPicPr>
          <p:nvPr/>
        </p:nvPicPr>
        <p:blipFill>
          <a:blip r:embed="rId6"/>
          <a:stretch>
            <a:fillRect/>
          </a:stretch>
        </p:blipFill>
        <p:spPr>
          <a:xfrm>
            <a:off x="6992092" y="13491258"/>
            <a:ext cx="563360" cy="584398"/>
          </a:xfrm>
          <a:prstGeom prst="rect">
            <a:avLst/>
          </a:prstGeom>
        </p:spPr>
      </p:pic>
      <p:sp>
        <p:nvSpPr>
          <p:cNvPr id="331" name="TextBox 330"/>
          <p:cNvSpPr txBox="1"/>
          <p:nvPr/>
        </p:nvSpPr>
        <p:spPr>
          <a:xfrm>
            <a:off x="2985239" y="12214705"/>
            <a:ext cx="650579" cy="338554"/>
          </a:xfrm>
          <a:prstGeom prst="rect">
            <a:avLst/>
          </a:prstGeom>
          <a:noFill/>
        </p:spPr>
        <p:txBody>
          <a:bodyPr wrap="square" rtlCol="0">
            <a:spAutoFit/>
          </a:bodyPr>
          <a:lstStyle/>
          <a:p>
            <a:r>
              <a:rPr lang="en-US" altLang="ko-KR" sz="1600" b="1" dirty="0" smtClean="0"/>
              <a:t>Set1</a:t>
            </a:r>
            <a:endParaRPr lang="ko-KR" altLang="en-US" sz="1600" b="1" dirty="0"/>
          </a:p>
        </p:txBody>
      </p:sp>
      <p:sp>
        <p:nvSpPr>
          <p:cNvPr id="332" name="TextBox 331"/>
          <p:cNvSpPr txBox="1"/>
          <p:nvPr/>
        </p:nvSpPr>
        <p:spPr>
          <a:xfrm>
            <a:off x="2985238" y="12901004"/>
            <a:ext cx="650579" cy="338554"/>
          </a:xfrm>
          <a:prstGeom prst="rect">
            <a:avLst/>
          </a:prstGeom>
          <a:noFill/>
        </p:spPr>
        <p:txBody>
          <a:bodyPr wrap="square" rtlCol="0">
            <a:spAutoFit/>
          </a:bodyPr>
          <a:lstStyle/>
          <a:p>
            <a:r>
              <a:rPr lang="en-US" altLang="ko-KR" sz="1600" b="1" dirty="0" smtClean="0"/>
              <a:t>Set2</a:t>
            </a:r>
            <a:endParaRPr lang="ko-KR" altLang="en-US" sz="1600" b="1" dirty="0"/>
          </a:p>
        </p:txBody>
      </p:sp>
      <p:sp>
        <p:nvSpPr>
          <p:cNvPr id="333" name="TextBox 332"/>
          <p:cNvSpPr txBox="1"/>
          <p:nvPr/>
        </p:nvSpPr>
        <p:spPr>
          <a:xfrm>
            <a:off x="2983171" y="13491258"/>
            <a:ext cx="650579" cy="338554"/>
          </a:xfrm>
          <a:prstGeom prst="rect">
            <a:avLst/>
          </a:prstGeom>
          <a:noFill/>
        </p:spPr>
        <p:txBody>
          <a:bodyPr wrap="square" rtlCol="0">
            <a:spAutoFit/>
          </a:bodyPr>
          <a:lstStyle/>
          <a:p>
            <a:r>
              <a:rPr lang="en-US" altLang="ko-KR" sz="1600" b="1" dirty="0" smtClean="0"/>
              <a:t>Set3</a:t>
            </a:r>
            <a:endParaRPr lang="ko-KR" altLang="en-US" sz="1600" b="1" dirty="0"/>
          </a:p>
        </p:txBody>
      </p:sp>
      <p:sp>
        <p:nvSpPr>
          <p:cNvPr id="334" name="TextBox 333"/>
          <p:cNvSpPr txBox="1"/>
          <p:nvPr/>
        </p:nvSpPr>
        <p:spPr>
          <a:xfrm>
            <a:off x="7450935" y="12228344"/>
            <a:ext cx="650579" cy="338554"/>
          </a:xfrm>
          <a:prstGeom prst="rect">
            <a:avLst/>
          </a:prstGeom>
          <a:noFill/>
        </p:spPr>
        <p:txBody>
          <a:bodyPr wrap="square" rtlCol="0">
            <a:spAutoFit/>
          </a:bodyPr>
          <a:lstStyle/>
          <a:p>
            <a:r>
              <a:rPr lang="en-US" altLang="ko-KR" sz="1600" b="1" dirty="0" smtClean="0"/>
              <a:t>Set1</a:t>
            </a:r>
            <a:endParaRPr lang="ko-KR" altLang="en-US" sz="1600" b="1" dirty="0"/>
          </a:p>
        </p:txBody>
      </p:sp>
      <p:sp>
        <p:nvSpPr>
          <p:cNvPr id="335" name="TextBox 334"/>
          <p:cNvSpPr txBox="1"/>
          <p:nvPr/>
        </p:nvSpPr>
        <p:spPr>
          <a:xfrm>
            <a:off x="7450934" y="12914643"/>
            <a:ext cx="650579" cy="338554"/>
          </a:xfrm>
          <a:prstGeom prst="rect">
            <a:avLst/>
          </a:prstGeom>
          <a:noFill/>
        </p:spPr>
        <p:txBody>
          <a:bodyPr wrap="square" rtlCol="0">
            <a:spAutoFit/>
          </a:bodyPr>
          <a:lstStyle/>
          <a:p>
            <a:r>
              <a:rPr lang="en-US" altLang="ko-KR" sz="1600" b="1" dirty="0" smtClean="0"/>
              <a:t>Set2</a:t>
            </a:r>
            <a:endParaRPr lang="ko-KR" altLang="en-US" sz="1600" b="1" dirty="0"/>
          </a:p>
        </p:txBody>
      </p:sp>
      <p:sp>
        <p:nvSpPr>
          <p:cNvPr id="336" name="TextBox 335"/>
          <p:cNvSpPr txBox="1"/>
          <p:nvPr/>
        </p:nvSpPr>
        <p:spPr>
          <a:xfrm>
            <a:off x="7448867" y="13504897"/>
            <a:ext cx="650579" cy="338554"/>
          </a:xfrm>
          <a:prstGeom prst="rect">
            <a:avLst/>
          </a:prstGeom>
          <a:noFill/>
        </p:spPr>
        <p:txBody>
          <a:bodyPr wrap="square" rtlCol="0">
            <a:spAutoFit/>
          </a:bodyPr>
          <a:lstStyle/>
          <a:p>
            <a:r>
              <a:rPr lang="en-US" altLang="ko-KR" sz="1600" b="1" dirty="0" smtClean="0"/>
              <a:t>Set3</a:t>
            </a:r>
            <a:endParaRPr lang="ko-KR" altLang="en-US" sz="1600" b="1" dirty="0"/>
          </a:p>
        </p:txBody>
      </p:sp>
      <p:sp>
        <p:nvSpPr>
          <p:cNvPr id="337" name="TextBox 336"/>
          <p:cNvSpPr txBox="1"/>
          <p:nvPr/>
        </p:nvSpPr>
        <p:spPr>
          <a:xfrm>
            <a:off x="2271854" y="14018884"/>
            <a:ext cx="1682658" cy="338554"/>
          </a:xfrm>
          <a:prstGeom prst="rect">
            <a:avLst/>
          </a:prstGeom>
          <a:noFill/>
        </p:spPr>
        <p:txBody>
          <a:bodyPr wrap="square" rtlCol="0">
            <a:spAutoFit/>
          </a:bodyPr>
          <a:lstStyle/>
          <a:p>
            <a:r>
              <a:rPr lang="en-US" altLang="ko-KR" sz="1600" b="1" dirty="0" smtClean="0"/>
              <a:t>&lt;1st FFPE TMT&gt;</a:t>
            </a:r>
            <a:endParaRPr lang="ko-KR" altLang="en-US" sz="1600" b="1" dirty="0"/>
          </a:p>
        </p:txBody>
      </p:sp>
      <p:sp>
        <p:nvSpPr>
          <p:cNvPr id="338" name="TextBox 337"/>
          <p:cNvSpPr txBox="1"/>
          <p:nvPr/>
        </p:nvSpPr>
        <p:spPr>
          <a:xfrm>
            <a:off x="6685070" y="14018884"/>
            <a:ext cx="1740764" cy="338554"/>
          </a:xfrm>
          <a:prstGeom prst="rect">
            <a:avLst/>
          </a:prstGeom>
          <a:noFill/>
        </p:spPr>
        <p:txBody>
          <a:bodyPr wrap="square" rtlCol="0">
            <a:spAutoFit/>
          </a:bodyPr>
          <a:lstStyle/>
          <a:p>
            <a:r>
              <a:rPr lang="en-US" altLang="ko-KR" sz="1600" b="1" dirty="0" smtClean="0"/>
              <a:t>&lt;2nd FFPE TMT&gt;</a:t>
            </a:r>
            <a:endParaRPr lang="ko-KR" altLang="en-US" sz="1600" b="1" dirty="0"/>
          </a:p>
        </p:txBody>
      </p:sp>
      <p:cxnSp>
        <p:nvCxnSpPr>
          <p:cNvPr id="339" name="꺾인 연결선 338"/>
          <p:cNvCxnSpPr/>
          <p:nvPr/>
        </p:nvCxnSpPr>
        <p:spPr>
          <a:xfrm flipV="1">
            <a:off x="1394009" y="12694034"/>
            <a:ext cx="8636852" cy="1818418"/>
          </a:xfrm>
          <a:prstGeom prst="bentConnector3">
            <a:avLst>
              <a:gd name="adj1" fmla="val 83835"/>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340" name="그림 339"/>
          <p:cNvPicPr>
            <a:picLocks noChangeAspect="1"/>
          </p:cNvPicPr>
          <p:nvPr/>
        </p:nvPicPr>
        <p:blipFill>
          <a:blip r:embed="rId6"/>
          <a:stretch>
            <a:fillRect/>
          </a:stretch>
        </p:blipFill>
        <p:spPr>
          <a:xfrm>
            <a:off x="10855685" y="6374553"/>
            <a:ext cx="563360" cy="584398"/>
          </a:xfrm>
          <a:prstGeom prst="rect">
            <a:avLst/>
          </a:prstGeom>
        </p:spPr>
      </p:pic>
      <p:sp>
        <p:nvSpPr>
          <p:cNvPr id="341" name="TextBox 340"/>
          <p:cNvSpPr txBox="1"/>
          <p:nvPr/>
        </p:nvSpPr>
        <p:spPr>
          <a:xfrm>
            <a:off x="11182500" y="6337592"/>
            <a:ext cx="650579" cy="338554"/>
          </a:xfrm>
          <a:prstGeom prst="rect">
            <a:avLst/>
          </a:prstGeom>
          <a:noFill/>
        </p:spPr>
        <p:txBody>
          <a:bodyPr wrap="square" rtlCol="0">
            <a:spAutoFit/>
          </a:bodyPr>
          <a:lstStyle/>
          <a:p>
            <a:r>
              <a:rPr lang="en-US" altLang="ko-KR" sz="1600" b="1" dirty="0" smtClean="0"/>
              <a:t>Set1</a:t>
            </a:r>
            <a:endParaRPr lang="ko-KR" altLang="en-US" sz="1600" b="1" dirty="0"/>
          </a:p>
        </p:txBody>
      </p:sp>
      <p:sp>
        <p:nvSpPr>
          <p:cNvPr id="342" name="TextBox 341"/>
          <p:cNvSpPr txBox="1"/>
          <p:nvPr/>
        </p:nvSpPr>
        <p:spPr>
          <a:xfrm>
            <a:off x="10641265" y="7058765"/>
            <a:ext cx="1740764" cy="338554"/>
          </a:xfrm>
          <a:prstGeom prst="rect">
            <a:avLst/>
          </a:prstGeom>
          <a:noFill/>
        </p:spPr>
        <p:txBody>
          <a:bodyPr wrap="square" rtlCol="0">
            <a:spAutoFit/>
          </a:bodyPr>
          <a:lstStyle/>
          <a:p>
            <a:r>
              <a:rPr lang="en-US" altLang="ko-KR" sz="1600" b="1" dirty="0" smtClean="0"/>
              <a:t>&lt;Cell lines TMT&gt;</a:t>
            </a:r>
            <a:endParaRPr lang="ko-KR" altLang="en-US" sz="1600" b="1" dirty="0"/>
          </a:p>
        </p:txBody>
      </p:sp>
      <p:sp>
        <p:nvSpPr>
          <p:cNvPr id="343" name="아래쪽 화살표 342"/>
          <p:cNvSpPr/>
          <p:nvPr/>
        </p:nvSpPr>
        <p:spPr>
          <a:xfrm>
            <a:off x="2801896" y="11269306"/>
            <a:ext cx="304800" cy="537029"/>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44" name="아래쪽 화살표 343"/>
          <p:cNvSpPr/>
          <p:nvPr/>
        </p:nvSpPr>
        <p:spPr>
          <a:xfrm>
            <a:off x="7088645" y="11301191"/>
            <a:ext cx="304800" cy="537029"/>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345" name="아래쪽 화살표 344"/>
          <p:cNvSpPr/>
          <p:nvPr/>
        </p:nvSpPr>
        <p:spPr>
          <a:xfrm>
            <a:off x="11011466" y="5567602"/>
            <a:ext cx="304800" cy="537029"/>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346" name="직선 연결선 345"/>
          <p:cNvCxnSpPr>
            <a:stCxn id="342" idx="2"/>
          </p:cNvCxnSpPr>
          <p:nvPr/>
        </p:nvCxnSpPr>
        <p:spPr>
          <a:xfrm flipH="1">
            <a:off x="8627891" y="7397319"/>
            <a:ext cx="2883756" cy="529473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7" name="직선 연결선 346"/>
          <p:cNvCxnSpPr/>
          <p:nvPr/>
        </p:nvCxnSpPr>
        <p:spPr>
          <a:xfrm>
            <a:off x="10758283" y="7409514"/>
            <a:ext cx="139071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48" name="직사각형 347"/>
          <p:cNvSpPr/>
          <p:nvPr/>
        </p:nvSpPr>
        <p:spPr>
          <a:xfrm>
            <a:off x="1438995" y="4069963"/>
            <a:ext cx="443534" cy="180653"/>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349" name="TextBox 348"/>
          <p:cNvSpPr txBox="1"/>
          <p:nvPr/>
        </p:nvSpPr>
        <p:spPr>
          <a:xfrm>
            <a:off x="750370" y="4042695"/>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TR1)</a:t>
            </a:r>
            <a:endParaRPr lang="ko-KR" altLang="en-US" sz="800" b="1" dirty="0">
              <a:latin typeface="Arial" panose="020B0604020202020204" pitchFamily="34" charset="0"/>
              <a:cs typeface="Arial" panose="020B0604020202020204" pitchFamily="34" charset="0"/>
            </a:endParaRPr>
          </a:p>
        </p:txBody>
      </p:sp>
      <p:sp>
        <p:nvSpPr>
          <p:cNvPr id="350" name="TextBox 349"/>
          <p:cNvSpPr txBox="1"/>
          <p:nvPr/>
        </p:nvSpPr>
        <p:spPr>
          <a:xfrm>
            <a:off x="744325" y="4351712"/>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TR2)</a:t>
            </a:r>
            <a:endParaRPr lang="ko-KR" altLang="en-US" sz="800" b="1" dirty="0">
              <a:latin typeface="Arial" panose="020B0604020202020204" pitchFamily="34" charset="0"/>
              <a:cs typeface="Arial" panose="020B0604020202020204" pitchFamily="34" charset="0"/>
            </a:endParaRPr>
          </a:p>
        </p:txBody>
      </p:sp>
      <p:sp>
        <p:nvSpPr>
          <p:cNvPr id="351" name="TextBox 350"/>
          <p:cNvSpPr txBox="1"/>
          <p:nvPr/>
        </p:nvSpPr>
        <p:spPr>
          <a:xfrm>
            <a:off x="735443" y="4656958"/>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TR3)</a:t>
            </a:r>
            <a:endParaRPr lang="ko-KR" altLang="en-US" sz="800" b="1" dirty="0">
              <a:latin typeface="Arial" panose="020B0604020202020204" pitchFamily="34" charset="0"/>
              <a:cs typeface="Arial" panose="020B0604020202020204" pitchFamily="34" charset="0"/>
            </a:endParaRPr>
          </a:p>
        </p:txBody>
      </p:sp>
      <p:sp>
        <p:nvSpPr>
          <p:cNvPr id="352" name="TextBox 351"/>
          <p:cNvSpPr txBox="1"/>
          <p:nvPr/>
        </p:nvSpPr>
        <p:spPr>
          <a:xfrm>
            <a:off x="1482295" y="3838668"/>
            <a:ext cx="391342"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6</a:t>
            </a:r>
            <a:endParaRPr lang="ko-KR" altLang="en-US" sz="800" b="1" dirty="0">
              <a:latin typeface="Arial" panose="020B0604020202020204" pitchFamily="34" charset="0"/>
              <a:cs typeface="Arial" panose="020B0604020202020204" pitchFamily="34" charset="0"/>
            </a:endParaRPr>
          </a:p>
        </p:txBody>
      </p:sp>
      <p:sp>
        <p:nvSpPr>
          <p:cNvPr id="353" name="직사각형 352"/>
          <p:cNvSpPr/>
          <p:nvPr/>
        </p:nvSpPr>
        <p:spPr>
          <a:xfrm>
            <a:off x="1438995" y="4378581"/>
            <a:ext cx="443534" cy="176940"/>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354" name="직사각형 353"/>
          <p:cNvSpPr/>
          <p:nvPr/>
        </p:nvSpPr>
        <p:spPr>
          <a:xfrm>
            <a:off x="1438995" y="4686263"/>
            <a:ext cx="443534" cy="187386"/>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355" name="TextBox 354"/>
          <p:cNvSpPr txBox="1"/>
          <p:nvPr/>
        </p:nvSpPr>
        <p:spPr>
          <a:xfrm>
            <a:off x="1438687" y="635274"/>
            <a:ext cx="659392"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HER2</a:t>
            </a:r>
            <a:endParaRPr lang="ko-KR" altLang="en-US" sz="1050" b="1" dirty="0">
              <a:latin typeface="Arial" panose="020B0604020202020204" pitchFamily="34" charset="0"/>
              <a:cs typeface="Arial" panose="020B0604020202020204" pitchFamily="34" charset="0"/>
            </a:endParaRPr>
          </a:p>
        </p:txBody>
      </p:sp>
      <p:sp>
        <p:nvSpPr>
          <p:cNvPr id="356" name="TextBox 355"/>
          <p:cNvSpPr txBox="1"/>
          <p:nvPr/>
        </p:nvSpPr>
        <p:spPr>
          <a:xfrm>
            <a:off x="2691092" y="641607"/>
            <a:ext cx="665940"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TNBC</a:t>
            </a:r>
            <a:endParaRPr lang="ko-KR" altLang="en-US" sz="1050" b="1" dirty="0">
              <a:latin typeface="Arial" panose="020B0604020202020204" pitchFamily="34" charset="0"/>
              <a:cs typeface="Arial" panose="020B0604020202020204" pitchFamily="34" charset="0"/>
            </a:endParaRPr>
          </a:p>
        </p:txBody>
      </p:sp>
      <p:sp>
        <p:nvSpPr>
          <p:cNvPr id="357" name="TextBox 356"/>
          <p:cNvSpPr txBox="1"/>
          <p:nvPr/>
        </p:nvSpPr>
        <p:spPr>
          <a:xfrm>
            <a:off x="3889950" y="641607"/>
            <a:ext cx="810945"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Luminal</a:t>
            </a:r>
            <a:endParaRPr lang="ko-KR" altLang="en-US" sz="1050" b="1" dirty="0">
              <a:latin typeface="Arial" panose="020B0604020202020204" pitchFamily="34" charset="0"/>
              <a:cs typeface="Arial" panose="020B0604020202020204" pitchFamily="34" charset="0"/>
            </a:endParaRPr>
          </a:p>
        </p:txBody>
      </p:sp>
      <p:sp>
        <p:nvSpPr>
          <p:cNvPr id="358" name="TextBox 357"/>
          <p:cNvSpPr txBox="1"/>
          <p:nvPr/>
        </p:nvSpPr>
        <p:spPr>
          <a:xfrm>
            <a:off x="1387124" y="5895716"/>
            <a:ext cx="659392"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HER2</a:t>
            </a:r>
            <a:endParaRPr lang="ko-KR" altLang="en-US" sz="1100" b="1" dirty="0">
              <a:latin typeface="Arial" panose="020B0604020202020204" pitchFamily="34" charset="0"/>
              <a:cs typeface="Arial" panose="020B0604020202020204" pitchFamily="34" charset="0"/>
            </a:endParaRPr>
          </a:p>
        </p:txBody>
      </p:sp>
      <p:sp>
        <p:nvSpPr>
          <p:cNvPr id="359" name="TextBox 358"/>
          <p:cNvSpPr txBox="1"/>
          <p:nvPr/>
        </p:nvSpPr>
        <p:spPr>
          <a:xfrm>
            <a:off x="2639530" y="5895716"/>
            <a:ext cx="665940"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TNBC</a:t>
            </a:r>
            <a:endParaRPr lang="ko-KR" altLang="en-US" sz="1100" b="1" dirty="0">
              <a:latin typeface="Arial" panose="020B0604020202020204" pitchFamily="34" charset="0"/>
              <a:cs typeface="Arial" panose="020B0604020202020204" pitchFamily="34" charset="0"/>
            </a:endParaRPr>
          </a:p>
        </p:txBody>
      </p:sp>
      <p:sp>
        <p:nvSpPr>
          <p:cNvPr id="360" name="TextBox 359"/>
          <p:cNvSpPr txBox="1"/>
          <p:nvPr/>
        </p:nvSpPr>
        <p:spPr>
          <a:xfrm>
            <a:off x="3838387" y="5895716"/>
            <a:ext cx="810945"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Luminal</a:t>
            </a:r>
            <a:endParaRPr lang="ko-KR" altLang="en-US" sz="1100" b="1" dirty="0">
              <a:latin typeface="Arial" panose="020B0604020202020204" pitchFamily="34" charset="0"/>
              <a:cs typeface="Arial" panose="020B0604020202020204" pitchFamily="34" charset="0"/>
            </a:endParaRPr>
          </a:p>
        </p:txBody>
      </p:sp>
      <p:pic>
        <p:nvPicPr>
          <p:cNvPr id="361" name="그림 360"/>
          <p:cNvPicPr>
            <a:picLocks noChangeAspect="1"/>
          </p:cNvPicPr>
          <p:nvPr/>
        </p:nvPicPr>
        <p:blipFill>
          <a:blip r:embed="rId7"/>
          <a:stretch>
            <a:fillRect/>
          </a:stretch>
        </p:blipFill>
        <p:spPr>
          <a:xfrm>
            <a:off x="1272144" y="2268635"/>
            <a:ext cx="225421" cy="583778"/>
          </a:xfrm>
          <a:prstGeom prst="rect">
            <a:avLst/>
          </a:prstGeom>
        </p:spPr>
      </p:pic>
      <p:sp>
        <p:nvSpPr>
          <p:cNvPr id="362" name="TextBox 361"/>
          <p:cNvSpPr txBox="1"/>
          <p:nvPr/>
        </p:nvSpPr>
        <p:spPr>
          <a:xfrm>
            <a:off x="750370" y="1923725"/>
            <a:ext cx="932740" cy="21544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Pooled sample</a:t>
            </a:r>
            <a:endParaRPr lang="ko-KR" altLang="en-US" sz="800" b="1" dirty="0">
              <a:latin typeface="Arial" panose="020B0604020202020204" pitchFamily="34" charset="0"/>
              <a:cs typeface="Arial" panose="020B0604020202020204" pitchFamily="34" charset="0"/>
            </a:endParaRPr>
          </a:p>
        </p:txBody>
      </p:sp>
      <p:sp>
        <p:nvSpPr>
          <p:cNvPr id="363" name="TextBox 362"/>
          <p:cNvSpPr txBox="1"/>
          <p:nvPr/>
        </p:nvSpPr>
        <p:spPr>
          <a:xfrm>
            <a:off x="5738209" y="635274"/>
            <a:ext cx="659392"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HER2</a:t>
            </a:r>
            <a:endParaRPr lang="ko-KR" altLang="en-US" sz="1050" b="1" dirty="0">
              <a:latin typeface="Arial" panose="020B0604020202020204" pitchFamily="34" charset="0"/>
              <a:cs typeface="Arial" panose="020B0604020202020204" pitchFamily="34" charset="0"/>
            </a:endParaRPr>
          </a:p>
        </p:txBody>
      </p:sp>
      <p:sp>
        <p:nvSpPr>
          <p:cNvPr id="364" name="TextBox 363"/>
          <p:cNvSpPr txBox="1"/>
          <p:nvPr/>
        </p:nvSpPr>
        <p:spPr>
          <a:xfrm>
            <a:off x="6990615" y="641607"/>
            <a:ext cx="665940"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TNBC</a:t>
            </a:r>
            <a:endParaRPr lang="ko-KR" altLang="en-US" sz="1050" b="1" dirty="0">
              <a:latin typeface="Arial" panose="020B0604020202020204" pitchFamily="34" charset="0"/>
              <a:cs typeface="Arial" panose="020B0604020202020204" pitchFamily="34" charset="0"/>
            </a:endParaRPr>
          </a:p>
        </p:txBody>
      </p:sp>
      <p:sp>
        <p:nvSpPr>
          <p:cNvPr id="365" name="TextBox 364"/>
          <p:cNvSpPr txBox="1"/>
          <p:nvPr/>
        </p:nvSpPr>
        <p:spPr>
          <a:xfrm>
            <a:off x="8189473" y="641607"/>
            <a:ext cx="810945"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Luminal</a:t>
            </a:r>
            <a:endParaRPr lang="ko-KR" altLang="en-US" sz="1050" b="1" dirty="0">
              <a:latin typeface="Arial" panose="020B0604020202020204" pitchFamily="34" charset="0"/>
              <a:cs typeface="Arial" panose="020B0604020202020204" pitchFamily="34" charset="0"/>
            </a:endParaRPr>
          </a:p>
        </p:txBody>
      </p:sp>
      <p:sp>
        <p:nvSpPr>
          <p:cNvPr id="366" name="직사각형 365"/>
          <p:cNvSpPr/>
          <p:nvPr/>
        </p:nvSpPr>
        <p:spPr>
          <a:xfrm>
            <a:off x="845332" y="266700"/>
            <a:ext cx="3912225" cy="319378"/>
          </a:xfrm>
          <a:prstGeom prst="rect">
            <a:avLst/>
          </a:prstGeom>
          <a:solidFill>
            <a:schemeClr val="accent1">
              <a:lumMod val="75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200" b="1" dirty="0" smtClean="0">
                <a:latin typeface="Arial" panose="020B0604020202020204" pitchFamily="34" charset="0"/>
                <a:cs typeface="Arial" panose="020B0604020202020204" pitchFamily="34" charset="0"/>
              </a:rPr>
              <a:t>1</a:t>
            </a:r>
            <a:r>
              <a:rPr lang="en-US" altLang="ko-KR" sz="1200" b="1" baseline="30000" dirty="0" smtClean="0">
                <a:latin typeface="Arial" panose="020B0604020202020204" pitchFamily="34" charset="0"/>
                <a:cs typeface="Arial" panose="020B0604020202020204" pitchFamily="34" charset="0"/>
              </a:rPr>
              <a:t>st</a:t>
            </a:r>
            <a:r>
              <a:rPr lang="en-US" altLang="ko-KR" sz="1200" b="1" dirty="0" smtClean="0">
                <a:latin typeface="Arial" panose="020B0604020202020204" pitchFamily="34" charset="0"/>
                <a:cs typeface="Arial" panose="020B0604020202020204" pitchFamily="34" charset="0"/>
              </a:rPr>
              <a:t> FFPE TMT-pooled sample set</a:t>
            </a:r>
            <a:endParaRPr lang="ko-KR" altLang="en-US" sz="1200" b="1" dirty="0">
              <a:latin typeface="Arial" panose="020B0604020202020204" pitchFamily="34" charset="0"/>
              <a:cs typeface="Arial" panose="020B0604020202020204" pitchFamily="34" charset="0"/>
            </a:endParaRPr>
          </a:p>
        </p:txBody>
      </p:sp>
      <p:sp>
        <p:nvSpPr>
          <p:cNvPr id="367" name="직사각형 366"/>
          <p:cNvSpPr/>
          <p:nvPr/>
        </p:nvSpPr>
        <p:spPr>
          <a:xfrm>
            <a:off x="5144854" y="279019"/>
            <a:ext cx="3912225" cy="319378"/>
          </a:xfrm>
          <a:prstGeom prst="rect">
            <a:avLst/>
          </a:prstGeom>
          <a:solidFill>
            <a:srgbClr val="7030A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200" b="1" dirty="0" smtClean="0">
                <a:latin typeface="Arial" panose="020B0604020202020204" pitchFamily="34" charset="0"/>
                <a:cs typeface="Arial" panose="020B0604020202020204" pitchFamily="34" charset="0"/>
              </a:rPr>
              <a:t>2</a:t>
            </a:r>
            <a:r>
              <a:rPr lang="en-US" altLang="ko-KR" sz="1200" b="1" baseline="30000" dirty="0" smtClean="0">
                <a:latin typeface="Arial" panose="020B0604020202020204" pitchFamily="34" charset="0"/>
                <a:cs typeface="Arial" panose="020B0604020202020204" pitchFamily="34" charset="0"/>
              </a:rPr>
              <a:t>nd</a:t>
            </a:r>
            <a:r>
              <a:rPr lang="en-US" altLang="ko-KR" sz="1200" b="1" dirty="0" smtClean="0">
                <a:latin typeface="Arial" panose="020B0604020202020204" pitchFamily="34" charset="0"/>
                <a:cs typeface="Arial" panose="020B0604020202020204" pitchFamily="34" charset="0"/>
              </a:rPr>
              <a:t> FFPE TMT- individual sample set</a:t>
            </a:r>
            <a:endParaRPr lang="ko-KR" altLang="en-US" sz="1200" b="1" dirty="0">
              <a:latin typeface="Arial" panose="020B0604020202020204" pitchFamily="34" charset="0"/>
              <a:cs typeface="Arial" panose="020B0604020202020204" pitchFamily="34" charset="0"/>
            </a:endParaRPr>
          </a:p>
        </p:txBody>
      </p:sp>
      <p:pic>
        <p:nvPicPr>
          <p:cNvPr id="368" name="그림 367"/>
          <p:cNvPicPr>
            <a:picLocks noChangeAspect="1"/>
          </p:cNvPicPr>
          <p:nvPr/>
        </p:nvPicPr>
        <p:blipFill>
          <a:blip r:embed="rId8"/>
          <a:stretch>
            <a:fillRect/>
          </a:stretch>
        </p:blipFill>
        <p:spPr>
          <a:xfrm>
            <a:off x="1177424" y="964110"/>
            <a:ext cx="447221" cy="570842"/>
          </a:xfrm>
          <a:prstGeom prst="rect">
            <a:avLst/>
          </a:prstGeom>
        </p:spPr>
      </p:pic>
      <p:pic>
        <p:nvPicPr>
          <p:cNvPr id="369" name="그림 368"/>
          <p:cNvPicPr>
            <a:picLocks noChangeAspect="1"/>
          </p:cNvPicPr>
          <p:nvPr/>
        </p:nvPicPr>
        <p:blipFill>
          <a:blip r:embed="rId8"/>
          <a:stretch>
            <a:fillRect/>
          </a:stretch>
        </p:blipFill>
        <p:spPr>
          <a:xfrm>
            <a:off x="1430095" y="896095"/>
            <a:ext cx="447221" cy="570842"/>
          </a:xfrm>
          <a:prstGeom prst="rect">
            <a:avLst/>
          </a:prstGeom>
        </p:spPr>
      </p:pic>
      <p:pic>
        <p:nvPicPr>
          <p:cNvPr id="370" name="그림 369"/>
          <p:cNvPicPr>
            <a:picLocks noChangeAspect="1"/>
          </p:cNvPicPr>
          <p:nvPr/>
        </p:nvPicPr>
        <p:blipFill>
          <a:blip r:embed="rId8"/>
          <a:stretch>
            <a:fillRect/>
          </a:stretch>
        </p:blipFill>
        <p:spPr>
          <a:xfrm>
            <a:off x="1674071" y="966693"/>
            <a:ext cx="447221" cy="570842"/>
          </a:xfrm>
          <a:prstGeom prst="rect">
            <a:avLst/>
          </a:prstGeom>
        </p:spPr>
      </p:pic>
      <p:pic>
        <p:nvPicPr>
          <p:cNvPr id="371" name="그림 370"/>
          <p:cNvPicPr>
            <a:picLocks noChangeAspect="1"/>
          </p:cNvPicPr>
          <p:nvPr/>
        </p:nvPicPr>
        <p:blipFill>
          <a:blip r:embed="rId8"/>
          <a:stretch>
            <a:fillRect/>
          </a:stretch>
        </p:blipFill>
        <p:spPr>
          <a:xfrm>
            <a:off x="2406686" y="957179"/>
            <a:ext cx="447221" cy="570842"/>
          </a:xfrm>
          <a:prstGeom prst="rect">
            <a:avLst/>
          </a:prstGeom>
        </p:spPr>
      </p:pic>
      <p:pic>
        <p:nvPicPr>
          <p:cNvPr id="372" name="그림 371"/>
          <p:cNvPicPr>
            <a:picLocks noChangeAspect="1"/>
          </p:cNvPicPr>
          <p:nvPr/>
        </p:nvPicPr>
        <p:blipFill>
          <a:blip r:embed="rId8"/>
          <a:stretch>
            <a:fillRect/>
          </a:stretch>
        </p:blipFill>
        <p:spPr>
          <a:xfrm>
            <a:off x="2659358" y="889164"/>
            <a:ext cx="447221" cy="570842"/>
          </a:xfrm>
          <a:prstGeom prst="rect">
            <a:avLst/>
          </a:prstGeom>
        </p:spPr>
      </p:pic>
      <p:pic>
        <p:nvPicPr>
          <p:cNvPr id="373" name="그림 372"/>
          <p:cNvPicPr>
            <a:picLocks noChangeAspect="1"/>
          </p:cNvPicPr>
          <p:nvPr/>
        </p:nvPicPr>
        <p:blipFill>
          <a:blip r:embed="rId8"/>
          <a:stretch>
            <a:fillRect/>
          </a:stretch>
        </p:blipFill>
        <p:spPr>
          <a:xfrm>
            <a:off x="2903333" y="959762"/>
            <a:ext cx="447221" cy="570842"/>
          </a:xfrm>
          <a:prstGeom prst="rect">
            <a:avLst/>
          </a:prstGeom>
        </p:spPr>
      </p:pic>
      <p:pic>
        <p:nvPicPr>
          <p:cNvPr id="374" name="그림 373"/>
          <p:cNvPicPr>
            <a:picLocks noChangeAspect="1"/>
          </p:cNvPicPr>
          <p:nvPr/>
        </p:nvPicPr>
        <p:blipFill>
          <a:blip r:embed="rId8"/>
          <a:stretch>
            <a:fillRect/>
          </a:stretch>
        </p:blipFill>
        <p:spPr>
          <a:xfrm>
            <a:off x="3684601" y="957230"/>
            <a:ext cx="447221" cy="570842"/>
          </a:xfrm>
          <a:prstGeom prst="rect">
            <a:avLst/>
          </a:prstGeom>
        </p:spPr>
      </p:pic>
      <p:pic>
        <p:nvPicPr>
          <p:cNvPr id="375" name="그림 374"/>
          <p:cNvPicPr>
            <a:picLocks noChangeAspect="1"/>
          </p:cNvPicPr>
          <p:nvPr/>
        </p:nvPicPr>
        <p:blipFill>
          <a:blip r:embed="rId8"/>
          <a:stretch>
            <a:fillRect/>
          </a:stretch>
        </p:blipFill>
        <p:spPr>
          <a:xfrm>
            <a:off x="3937273" y="889215"/>
            <a:ext cx="447221" cy="570842"/>
          </a:xfrm>
          <a:prstGeom prst="rect">
            <a:avLst/>
          </a:prstGeom>
        </p:spPr>
      </p:pic>
      <p:pic>
        <p:nvPicPr>
          <p:cNvPr id="376" name="그림 375"/>
          <p:cNvPicPr>
            <a:picLocks noChangeAspect="1"/>
          </p:cNvPicPr>
          <p:nvPr/>
        </p:nvPicPr>
        <p:blipFill>
          <a:blip r:embed="rId8"/>
          <a:stretch>
            <a:fillRect/>
          </a:stretch>
        </p:blipFill>
        <p:spPr>
          <a:xfrm>
            <a:off x="4181249" y="959813"/>
            <a:ext cx="447221" cy="570842"/>
          </a:xfrm>
          <a:prstGeom prst="rect">
            <a:avLst/>
          </a:prstGeom>
        </p:spPr>
      </p:pic>
      <p:pic>
        <p:nvPicPr>
          <p:cNvPr id="377" name="그림 376"/>
          <p:cNvPicPr>
            <a:picLocks noChangeAspect="1"/>
          </p:cNvPicPr>
          <p:nvPr/>
        </p:nvPicPr>
        <p:blipFill rotWithShape="1">
          <a:blip r:embed="rId9"/>
          <a:srcRect l="18260" r="5212" b="28670"/>
          <a:stretch/>
        </p:blipFill>
        <p:spPr>
          <a:xfrm>
            <a:off x="1407416" y="1432733"/>
            <a:ext cx="537439" cy="494713"/>
          </a:xfrm>
          <a:prstGeom prst="rect">
            <a:avLst/>
          </a:prstGeom>
        </p:spPr>
      </p:pic>
      <p:pic>
        <p:nvPicPr>
          <p:cNvPr id="378" name="그림 377"/>
          <p:cNvPicPr>
            <a:picLocks noChangeAspect="1"/>
          </p:cNvPicPr>
          <p:nvPr/>
        </p:nvPicPr>
        <p:blipFill rotWithShape="1">
          <a:blip r:embed="rId9"/>
          <a:srcRect l="18260" r="5212" b="28670"/>
          <a:stretch/>
        </p:blipFill>
        <p:spPr>
          <a:xfrm>
            <a:off x="2640348" y="1402120"/>
            <a:ext cx="537439" cy="494713"/>
          </a:xfrm>
          <a:prstGeom prst="rect">
            <a:avLst/>
          </a:prstGeom>
        </p:spPr>
      </p:pic>
      <p:pic>
        <p:nvPicPr>
          <p:cNvPr id="379" name="그림 378"/>
          <p:cNvPicPr>
            <a:picLocks noChangeAspect="1"/>
          </p:cNvPicPr>
          <p:nvPr/>
        </p:nvPicPr>
        <p:blipFill rotWithShape="1">
          <a:blip r:embed="rId9"/>
          <a:srcRect l="18260" r="5212" b="28670"/>
          <a:stretch/>
        </p:blipFill>
        <p:spPr>
          <a:xfrm>
            <a:off x="3925103" y="1401729"/>
            <a:ext cx="537439" cy="494713"/>
          </a:xfrm>
          <a:prstGeom prst="rect">
            <a:avLst/>
          </a:prstGeom>
        </p:spPr>
      </p:pic>
      <p:sp>
        <p:nvSpPr>
          <p:cNvPr id="380" name="아래쪽 화살표 379"/>
          <p:cNvSpPr/>
          <p:nvPr/>
        </p:nvSpPr>
        <p:spPr>
          <a:xfrm>
            <a:off x="1570103" y="1944026"/>
            <a:ext cx="151481" cy="254835"/>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381" name="아래쪽 화살표 380"/>
          <p:cNvSpPr/>
          <p:nvPr/>
        </p:nvSpPr>
        <p:spPr>
          <a:xfrm>
            <a:off x="2777401" y="1944025"/>
            <a:ext cx="151481" cy="263786"/>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382" name="아래쪽 화살표 381"/>
          <p:cNvSpPr/>
          <p:nvPr/>
        </p:nvSpPr>
        <p:spPr>
          <a:xfrm>
            <a:off x="4096655" y="1942321"/>
            <a:ext cx="151481" cy="26714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pic>
        <p:nvPicPr>
          <p:cNvPr id="383" name="그림 382"/>
          <p:cNvPicPr>
            <a:picLocks noChangeAspect="1"/>
          </p:cNvPicPr>
          <p:nvPr/>
        </p:nvPicPr>
        <p:blipFill>
          <a:blip r:embed="rId10"/>
          <a:stretch>
            <a:fillRect/>
          </a:stretch>
        </p:blipFill>
        <p:spPr>
          <a:xfrm>
            <a:off x="1201305" y="6311557"/>
            <a:ext cx="431423" cy="549184"/>
          </a:xfrm>
          <a:prstGeom prst="rect">
            <a:avLst/>
          </a:prstGeom>
        </p:spPr>
      </p:pic>
      <p:pic>
        <p:nvPicPr>
          <p:cNvPr id="384" name="그림 383"/>
          <p:cNvPicPr>
            <a:picLocks noChangeAspect="1"/>
          </p:cNvPicPr>
          <p:nvPr/>
        </p:nvPicPr>
        <p:blipFill>
          <a:blip r:embed="rId10"/>
          <a:stretch>
            <a:fillRect/>
          </a:stretch>
        </p:blipFill>
        <p:spPr>
          <a:xfrm>
            <a:off x="1441860" y="6225751"/>
            <a:ext cx="431423" cy="549184"/>
          </a:xfrm>
          <a:prstGeom prst="rect">
            <a:avLst/>
          </a:prstGeom>
        </p:spPr>
      </p:pic>
      <p:pic>
        <p:nvPicPr>
          <p:cNvPr id="385" name="그림 384"/>
          <p:cNvPicPr>
            <a:picLocks noChangeAspect="1"/>
          </p:cNvPicPr>
          <p:nvPr/>
        </p:nvPicPr>
        <p:blipFill>
          <a:blip r:embed="rId10"/>
          <a:stretch>
            <a:fillRect/>
          </a:stretch>
        </p:blipFill>
        <p:spPr>
          <a:xfrm>
            <a:off x="1679203" y="6312299"/>
            <a:ext cx="431423" cy="549184"/>
          </a:xfrm>
          <a:prstGeom prst="rect">
            <a:avLst/>
          </a:prstGeom>
        </p:spPr>
      </p:pic>
      <p:pic>
        <p:nvPicPr>
          <p:cNvPr id="386" name="그림 385"/>
          <p:cNvPicPr>
            <a:picLocks noChangeAspect="1"/>
          </p:cNvPicPr>
          <p:nvPr/>
        </p:nvPicPr>
        <p:blipFill>
          <a:blip r:embed="rId10"/>
          <a:stretch>
            <a:fillRect/>
          </a:stretch>
        </p:blipFill>
        <p:spPr>
          <a:xfrm>
            <a:off x="2502991" y="6340822"/>
            <a:ext cx="431423" cy="549184"/>
          </a:xfrm>
          <a:prstGeom prst="rect">
            <a:avLst/>
          </a:prstGeom>
        </p:spPr>
      </p:pic>
      <p:pic>
        <p:nvPicPr>
          <p:cNvPr id="387" name="그림 386"/>
          <p:cNvPicPr>
            <a:picLocks noChangeAspect="1"/>
          </p:cNvPicPr>
          <p:nvPr/>
        </p:nvPicPr>
        <p:blipFill>
          <a:blip r:embed="rId10"/>
          <a:stretch>
            <a:fillRect/>
          </a:stretch>
        </p:blipFill>
        <p:spPr>
          <a:xfrm>
            <a:off x="2743547" y="6255015"/>
            <a:ext cx="431423" cy="549184"/>
          </a:xfrm>
          <a:prstGeom prst="rect">
            <a:avLst/>
          </a:prstGeom>
        </p:spPr>
      </p:pic>
      <p:pic>
        <p:nvPicPr>
          <p:cNvPr id="388" name="그림 387"/>
          <p:cNvPicPr>
            <a:picLocks noChangeAspect="1"/>
          </p:cNvPicPr>
          <p:nvPr/>
        </p:nvPicPr>
        <p:blipFill>
          <a:blip r:embed="rId10"/>
          <a:stretch>
            <a:fillRect/>
          </a:stretch>
        </p:blipFill>
        <p:spPr>
          <a:xfrm>
            <a:off x="2980890" y="6341564"/>
            <a:ext cx="431423" cy="549184"/>
          </a:xfrm>
          <a:prstGeom prst="rect">
            <a:avLst/>
          </a:prstGeom>
        </p:spPr>
      </p:pic>
      <p:pic>
        <p:nvPicPr>
          <p:cNvPr id="389" name="그림 388"/>
          <p:cNvPicPr>
            <a:picLocks noChangeAspect="1"/>
          </p:cNvPicPr>
          <p:nvPr/>
        </p:nvPicPr>
        <p:blipFill>
          <a:blip r:embed="rId10"/>
          <a:stretch>
            <a:fillRect/>
          </a:stretch>
        </p:blipFill>
        <p:spPr>
          <a:xfrm>
            <a:off x="3777113" y="6367912"/>
            <a:ext cx="431423" cy="549184"/>
          </a:xfrm>
          <a:prstGeom prst="rect">
            <a:avLst/>
          </a:prstGeom>
        </p:spPr>
      </p:pic>
      <p:pic>
        <p:nvPicPr>
          <p:cNvPr id="390" name="그림 389"/>
          <p:cNvPicPr>
            <a:picLocks noChangeAspect="1"/>
          </p:cNvPicPr>
          <p:nvPr/>
        </p:nvPicPr>
        <p:blipFill>
          <a:blip r:embed="rId10"/>
          <a:stretch>
            <a:fillRect/>
          </a:stretch>
        </p:blipFill>
        <p:spPr>
          <a:xfrm>
            <a:off x="4017668" y="6282106"/>
            <a:ext cx="431423" cy="549184"/>
          </a:xfrm>
          <a:prstGeom prst="rect">
            <a:avLst/>
          </a:prstGeom>
        </p:spPr>
      </p:pic>
      <p:pic>
        <p:nvPicPr>
          <p:cNvPr id="391" name="그림 390"/>
          <p:cNvPicPr>
            <a:picLocks noChangeAspect="1"/>
          </p:cNvPicPr>
          <p:nvPr/>
        </p:nvPicPr>
        <p:blipFill>
          <a:blip r:embed="rId10"/>
          <a:stretch>
            <a:fillRect/>
          </a:stretch>
        </p:blipFill>
        <p:spPr>
          <a:xfrm>
            <a:off x="4255011" y="6368654"/>
            <a:ext cx="431423" cy="549184"/>
          </a:xfrm>
          <a:prstGeom prst="rect">
            <a:avLst/>
          </a:prstGeom>
        </p:spPr>
      </p:pic>
      <p:pic>
        <p:nvPicPr>
          <p:cNvPr id="392" name="그림 391"/>
          <p:cNvPicPr>
            <a:picLocks noChangeAspect="1"/>
          </p:cNvPicPr>
          <p:nvPr/>
        </p:nvPicPr>
        <p:blipFill rotWithShape="1">
          <a:blip r:embed="rId9"/>
          <a:srcRect l="18260" r="5212" b="28670"/>
          <a:stretch/>
        </p:blipFill>
        <p:spPr>
          <a:xfrm>
            <a:off x="1463959" y="6844771"/>
            <a:ext cx="537439" cy="494713"/>
          </a:xfrm>
          <a:prstGeom prst="rect">
            <a:avLst/>
          </a:prstGeom>
        </p:spPr>
      </p:pic>
      <p:pic>
        <p:nvPicPr>
          <p:cNvPr id="393" name="그림 392"/>
          <p:cNvPicPr>
            <a:picLocks noChangeAspect="1"/>
          </p:cNvPicPr>
          <p:nvPr/>
        </p:nvPicPr>
        <p:blipFill rotWithShape="1">
          <a:blip r:embed="rId9"/>
          <a:srcRect l="18260" r="5212" b="28670"/>
          <a:stretch/>
        </p:blipFill>
        <p:spPr>
          <a:xfrm>
            <a:off x="2696891" y="6814158"/>
            <a:ext cx="537439" cy="494713"/>
          </a:xfrm>
          <a:prstGeom prst="rect">
            <a:avLst/>
          </a:prstGeom>
        </p:spPr>
      </p:pic>
      <p:pic>
        <p:nvPicPr>
          <p:cNvPr id="394" name="그림 393"/>
          <p:cNvPicPr>
            <a:picLocks noChangeAspect="1"/>
          </p:cNvPicPr>
          <p:nvPr/>
        </p:nvPicPr>
        <p:blipFill rotWithShape="1">
          <a:blip r:embed="rId9"/>
          <a:srcRect l="18260" r="5212" b="28670"/>
          <a:stretch/>
        </p:blipFill>
        <p:spPr>
          <a:xfrm>
            <a:off x="3981646" y="6813767"/>
            <a:ext cx="537439" cy="494713"/>
          </a:xfrm>
          <a:prstGeom prst="rect">
            <a:avLst/>
          </a:prstGeom>
        </p:spPr>
      </p:pic>
      <p:sp>
        <p:nvSpPr>
          <p:cNvPr id="395" name="TextBox 394"/>
          <p:cNvSpPr txBox="1"/>
          <p:nvPr/>
        </p:nvSpPr>
        <p:spPr>
          <a:xfrm>
            <a:off x="5706652" y="5883887"/>
            <a:ext cx="659392"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HER2</a:t>
            </a:r>
            <a:endParaRPr lang="ko-KR" altLang="en-US" sz="1100" b="1" dirty="0">
              <a:latin typeface="Arial" panose="020B0604020202020204" pitchFamily="34" charset="0"/>
              <a:cs typeface="Arial" panose="020B0604020202020204" pitchFamily="34" charset="0"/>
            </a:endParaRPr>
          </a:p>
        </p:txBody>
      </p:sp>
      <p:sp>
        <p:nvSpPr>
          <p:cNvPr id="396" name="TextBox 395"/>
          <p:cNvSpPr txBox="1"/>
          <p:nvPr/>
        </p:nvSpPr>
        <p:spPr>
          <a:xfrm>
            <a:off x="6959058" y="5883887"/>
            <a:ext cx="665940"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TNBC</a:t>
            </a:r>
            <a:endParaRPr lang="ko-KR" altLang="en-US" sz="1100" b="1" dirty="0">
              <a:latin typeface="Arial" panose="020B0604020202020204" pitchFamily="34" charset="0"/>
              <a:cs typeface="Arial" panose="020B0604020202020204" pitchFamily="34" charset="0"/>
            </a:endParaRPr>
          </a:p>
        </p:txBody>
      </p:sp>
      <p:sp>
        <p:nvSpPr>
          <p:cNvPr id="397" name="TextBox 396"/>
          <p:cNvSpPr txBox="1"/>
          <p:nvPr/>
        </p:nvSpPr>
        <p:spPr>
          <a:xfrm>
            <a:off x="8157916" y="5883887"/>
            <a:ext cx="810945" cy="261610"/>
          </a:xfrm>
          <a:prstGeom prst="rect">
            <a:avLst/>
          </a:prstGeom>
          <a:noFill/>
        </p:spPr>
        <p:txBody>
          <a:bodyPr wrap="square" rtlCol="0">
            <a:spAutoFit/>
          </a:bodyPr>
          <a:lstStyle/>
          <a:p>
            <a:r>
              <a:rPr lang="en-US" altLang="ko-KR" sz="1100" b="1" dirty="0" smtClean="0">
                <a:latin typeface="Arial" panose="020B0604020202020204" pitchFamily="34" charset="0"/>
                <a:cs typeface="Arial" panose="020B0604020202020204" pitchFamily="34" charset="0"/>
              </a:rPr>
              <a:t>Luminal</a:t>
            </a:r>
            <a:endParaRPr lang="ko-KR" altLang="en-US" sz="1100" b="1" dirty="0">
              <a:latin typeface="Arial" panose="020B0604020202020204" pitchFamily="34" charset="0"/>
              <a:cs typeface="Arial" panose="020B0604020202020204" pitchFamily="34" charset="0"/>
            </a:endParaRPr>
          </a:p>
        </p:txBody>
      </p:sp>
      <p:pic>
        <p:nvPicPr>
          <p:cNvPr id="398" name="그림 397"/>
          <p:cNvPicPr>
            <a:picLocks noChangeAspect="1"/>
          </p:cNvPicPr>
          <p:nvPr/>
        </p:nvPicPr>
        <p:blipFill>
          <a:blip r:embed="rId7"/>
          <a:stretch>
            <a:fillRect/>
          </a:stretch>
        </p:blipFill>
        <p:spPr>
          <a:xfrm>
            <a:off x="5607799" y="2289711"/>
            <a:ext cx="225421" cy="583778"/>
          </a:xfrm>
          <a:prstGeom prst="rect">
            <a:avLst/>
          </a:prstGeom>
        </p:spPr>
      </p:pic>
      <p:sp>
        <p:nvSpPr>
          <p:cNvPr id="399" name="TextBox 398"/>
          <p:cNvSpPr txBox="1"/>
          <p:nvPr/>
        </p:nvSpPr>
        <p:spPr>
          <a:xfrm>
            <a:off x="5099536" y="1902684"/>
            <a:ext cx="880540"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Individual</a:t>
            </a:r>
          </a:p>
          <a:p>
            <a:pPr algn="ctr"/>
            <a:r>
              <a:rPr lang="en-US" altLang="ko-KR" sz="800" b="1" dirty="0" smtClean="0">
                <a:latin typeface="Arial" panose="020B0604020202020204" pitchFamily="34" charset="0"/>
                <a:cs typeface="Arial" panose="020B0604020202020204" pitchFamily="34" charset="0"/>
              </a:rPr>
              <a:t>patients</a:t>
            </a:r>
            <a:endParaRPr lang="ko-KR" altLang="en-US" sz="800" b="1" dirty="0">
              <a:latin typeface="Arial" panose="020B0604020202020204" pitchFamily="34" charset="0"/>
              <a:cs typeface="Arial" panose="020B0604020202020204" pitchFamily="34" charset="0"/>
            </a:endParaRPr>
          </a:p>
        </p:txBody>
      </p:sp>
      <p:pic>
        <p:nvPicPr>
          <p:cNvPr id="400" name="그림 399"/>
          <p:cNvPicPr>
            <a:picLocks noChangeAspect="1"/>
          </p:cNvPicPr>
          <p:nvPr/>
        </p:nvPicPr>
        <p:blipFill>
          <a:blip r:embed="rId8"/>
          <a:stretch>
            <a:fillRect/>
          </a:stretch>
        </p:blipFill>
        <p:spPr>
          <a:xfrm>
            <a:off x="5483873" y="991668"/>
            <a:ext cx="447221" cy="570842"/>
          </a:xfrm>
          <a:prstGeom prst="rect">
            <a:avLst/>
          </a:prstGeom>
        </p:spPr>
      </p:pic>
      <p:pic>
        <p:nvPicPr>
          <p:cNvPr id="401" name="그림 400"/>
          <p:cNvPicPr>
            <a:picLocks noChangeAspect="1"/>
          </p:cNvPicPr>
          <p:nvPr/>
        </p:nvPicPr>
        <p:blipFill>
          <a:blip r:embed="rId8"/>
          <a:stretch>
            <a:fillRect/>
          </a:stretch>
        </p:blipFill>
        <p:spPr>
          <a:xfrm>
            <a:off x="5736545" y="923653"/>
            <a:ext cx="447221" cy="570842"/>
          </a:xfrm>
          <a:prstGeom prst="rect">
            <a:avLst/>
          </a:prstGeom>
        </p:spPr>
      </p:pic>
      <p:pic>
        <p:nvPicPr>
          <p:cNvPr id="402" name="그림 401"/>
          <p:cNvPicPr>
            <a:picLocks noChangeAspect="1"/>
          </p:cNvPicPr>
          <p:nvPr/>
        </p:nvPicPr>
        <p:blipFill>
          <a:blip r:embed="rId8"/>
          <a:stretch>
            <a:fillRect/>
          </a:stretch>
        </p:blipFill>
        <p:spPr>
          <a:xfrm>
            <a:off x="5980521" y="994251"/>
            <a:ext cx="447221" cy="570842"/>
          </a:xfrm>
          <a:prstGeom prst="rect">
            <a:avLst/>
          </a:prstGeom>
        </p:spPr>
      </p:pic>
      <p:pic>
        <p:nvPicPr>
          <p:cNvPr id="403" name="그림 402"/>
          <p:cNvPicPr>
            <a:picLocks noChangeAspect="1"/>
          </p:cNvPicPr>
          <p:nvPr/>
        </p:nvPicPr>
        <p:blipFill>
          <a:blip r:embed="rId8"/>
          <a:stretch>
            <a:fillRect/>
          </a:stretch>
        </p:blipFill>
        <p:spPr>
          <a:xfrm>
            <a:off x="6713135" y="984737"/>
            <a:ext cx="447221" cy="570842"/>
          </a:xfrm>
          <a:prstGeom prst="rect">
            <a:avLst/>
          </a:prstGeom>
        </p:spPr>
      </p:pic>
      <p:pic>
        <p:nvPicPr>
          <p:cNvPr id="404" name="그림 403"/>
          <p:cNvPicPr>
            <a:picLocks noChangeAspect="1"/>
          </p:cNvPicPr>
          <p:nvPr/>
        </p:nvPicPr>
        <p:blipFill>
          <a:blip r:embed="rId8"/>
          <a:stretch>
            <a:fillRect/>
          </a:stretch>
        </p:blipFill>
        <p:spPr>
          <a:xfrm>
            <a:off x="6965807" y="916721"/>
            <a:ext cx="447221" cy="570842"/>
          </a:xfrm>
          <a:prstGeom prst="rect">
            <a:avLst/>
          </a:prstGeom>
        </p:spPr>
      </p:pic>
      <p:pic>
        <p:nvPicPr>
          <p:cNvPr id="405" name="그림 404"/>
          <p:cNvPicPr>
            <a:picLocks noChangeAspect="1"/>
          </p:cNvPicPr>
          <p:nvPr/>
        </p:nvPicPr>
        <p:blipFill>
          <a:blip r:embed="rId8"/>
          <a:stretch>
            <a:fillRect/>
          </a:stretch>
        </p:blipFill>
        <p:spPr>
          <a:xfrm>
            <a:off x="7209783" y="987320"/>
            <a:ext cx="447221" cy="570842"/>
          </a:xfrm>
          <a:prstGeom prst="rect">
            <a:avLst/>
          </a:prstGeom>
        </p:spPr>
      </p:pic>
      <p:pic>
        <p:nvPicPr>
          <p:cNvPr id="406" name="그림 405"/>
          <p:cNvPicPr>
            <a:picLocks noChangeAspect="1"/>
          </p:cNvPicPr>
          <p:nvPr/>
        </p:nvPicPr>
        <p:blipFill>
          <a:blip r:embed="rId8"/>
          <a:stretch>
            <a:fillRect/>
          </a:stretch>
        </p:blipFill>
        <p:spPr>
          <a:xfrm>
            <a:off x="7991050" y="984788"/>
            <a:ext cx="447221" cy="570842"/>
          </a:xfrm>
          <a:prstGeom prst="rect">
            <a:avLst/>
          </a:prstGeom>
        </p:spPr>
      </p:pic>
      <p:pic>
        <p:nvPicPr>
          <p:cNvPr id="407" name="그림 406"/>
          <p:cNvPicPr>
            <a:picLocks noChangeAspect="1"/>
          </p:cNvPicPr>
          <p:nvPr/>
        </p:nvPicPr>
        <p:blipFill>
          <a:blip r:embed="rId8"/>
          <a:stretch>
            <a:fillRect/>
          </a:stretch>
        </p:blipFill>
        <p:spPr>
          <a:xfrm>
            <a:off x="8243722" y="916773"/>
            <a:ext cx="447221" cy="570842"/>
          </a:xfrm>
          <a:prstGeom prst="rect">
            <a:avLst/>
          </a:prstGeom>
        </p:spPr>
      </p:pic>
      <p:pic>
        <p:nvPicPr>
          <p:cNvPr id="408" name="그림 407"/>
          <p:cNvPicPr>
            <a:picLocks noChangeAspect="1"/>
          </p:cNvPicPr>
          <p:nvPr/>
        </p:nvPicPr>
        <p:blipFill>
          <a:blip r:embed="rId8"/>
          <a:stretch>
            <a:fillRect/>
          </a:stretch>
        </p:blipFill>
        <p:spPr>
          <a:xfrm>
            <a:off x="8487698" y="987371"/>
            <a:ext cx="447221" cy="570842"/>
          </a:xfrm>
          <a:prstGeom prst="rect">
            <a:avLst/>
          </a:prstGeom>
        </p:spPr>
      </p:pic>
      <p:pic>
        <p:nvPicPr>
          <p:cNvPr id="409" name="그림 408"/>
          <p:cNvPicPr>
            <a:picLocks noChangeAspect="1"/>
          </p:cNvPicPr>
          <p:nvPr/>
        </p:nvPicPr>
        <p:blipFill rotWithShape="1">
          <a:blip r:embed="rId9"/>
          <a:srcRect l="18260" r="5212" b="28670"/>
          <a:stretch/>
        </p:blipFill>
        <p:spPr>
          <a:xfrm>
            <a:off x="5713865" y="1460291"/>
            <a:ext cx="537439" cy="494713"/>
          </a:xfrm>
          <a:prstGeom prst="rect">
            <a:avLst/>
          </a:prstGeom>
        </p:spPr>
      </p:pic>
      <p:pic>
        <p:nvPicPr>
          <p:cNvPr id="410" name="그림 409"/>
          <p:cNvPicPr>
            <a:picLocks noChangeAspect="1"/>
          </p:cNvPicPr>
          <p:nvPr/>
        </p:nvPicPr>
        <p:blipFill rotWithShape="1">
          <a:blip r:embed="rId9"/>
          <a:srcRect l="18260" r="5212" b="28670"/>
          <a:stretch/>
        </p:blipFill>
        <p:spPr>
          <a:xfrm>
            <a:off x="6946797" y="1429678"/>
            <a:ext cx="537439" cy="494713"/>
          </a:xfrm>
          <a:prstGeom prst="rect">
            <a:avLst/>
          </a:prstGeom>
        </p:spPr>
      </p:pic>
      <p:pic>
        <p:nvPicPr>
          <p:cNvPr id="411" name="그림 410"/>
          <p:cNvPicPr>
            <a:picLocks noChangeAspect="1"/>
          </p:cNvPicPr>
          <p:nvPr/>
        </p:nvPicPr>
        <p:blipFill rotWithShape="1">
          <a:blip r:embed="rId9"/>
          <a:srcRect l="18260" r="5212" b="28670"/>
          <a:stretch/>
        </p:blipFill>
        <p:spPr>
          <a:xfrm>
            <a:off x="8231552" y="1429287"/>
            <a:ext cx="537439" cy="494713"/>
          </a:xfrm>
          <a:prstGeom prst="rect">
            <a:avLst/>
          </a:prstGeom>
        </p:spPr>
      </p:pic>
      <p:sp>
        <p:nvSpPr>
          <p:cNvPr id="412" name="아래쪽 화살표 411"/>
          <p:cNvSpPr/>
          <p:nvPr/>
        </p:nvSpPr>
        <p:spPr>
          <a:xfrm>
            <a:off x="5876553" y="1971584"/>
            <a:ext cx="151481" cy="254835"/>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13" name="아래쪽 화살표 412"/>
          <p:cNvSpPr/>
          <p:nvPr/>
        </p:nvSpPr>
        <p:spPr>
          <a:xfrm>
            <a:off x="7083850" y="1971583"/>
            <a:ext cx="151481" cy="263786"/>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14" name="아래쪽 화살표 413"/>
          <p:cNvSpPr/>
          <p:nvPr/>
        </p:nvSpPr>
        <p:spPr>
          <a:xfrm>
            <a:off x="8403104" y="1969879"/>
            <a:ext cx="151481" cy="26714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pic>
        <p:nvPicPr>
          <p:cNvPr id="415" name="그림 414"/>
          <p:cNvPicPr>
            <a:picLocks noChangeAspect="1"/>
          </p:cNvPicPr>
          <p:nvPr/>
        </p:nvPicPr>
        <p:blipFill>
          <a:blip r:embed="rId10"/>
          <a:stretch>
            <a:fillRect/>
          </a:stretch>
        </p:blipFill>
        <p:spPr>
          <a:xfrm>
            <a:off x="5520833" y="6299728"/>
            <a:ext cx="431423" cy="549184"/>
          </a:xfrm>
          <a:prstGeom prst="rect">
            <a:avLst/>
          </a:prstGeom>
        </p:spPr>
      </p:pic>
      <p:pic>
        <p:nvPicPr>
          <p:cNvPr id="416" name="그림 415"/>
          <p:cNvPicPr>
            <a:picLocks noChangeAspect="1"/>
          </p:cNvPicPr>
          <p:nvPr/>
        </p:nvPicPr>
        <p:blipFill>
          <a:blip r:embed="rId10"/>
          <a:stretch>
            <a:fillRect/>
          </a:stretch>
        </p:blipFill>
        <p:spPr>
          <a:xfrm>
            <a:off x="5761389" y="6213922"/>
            <a:ext cx="431423" cy="549184"/>
          </a:xfrm>
          <a:prstGeom prst="rect">
            <a:avLst/>
          </a:prstGeom>
        </p:spPr>
      </p:pic>
      <p:pic>
        <p:nvPicPr>
          <p:cNvPr id="417" name="그림 416"/>
          <p:cNvPicPr>
            <a:picLocks noChangeAspect="1"/>
          </p:cNvPicPr>
          <p:nvPr/>
        </p:nvPicPr>
        <p:blipFill>
          <a:blip r:embed="rId10"/>
          <a:stretch>
            <a:fillRect/>
          </a:stretch>
        </p:blipFill>
        <p:spPr>
          <a:xfrm>
            <a:off x="5998732" y="6300470"/>
            <a:ext cx="431423" cy="549184"/>
          </a:xfrm>
          <a:prstGeom prst="rect">
            <a:avLst/>
          </a:prstGeom>
        </p:spPr>
      </p:pic>
      <p:pic>
        <p:nvPicPr>
          <p:cNvPr id="418" name="그림 417"/>
          <p:cNvPicPr>
            <a:picLocks noChangeAspect="1"/>
          </p:cNvPicPr>
          <p:nvPr/>
        </p:nvPicPr>
        <p:blipFill>
          <a:blip r:embed="rId10"/>
          <a:stretch>
            <a:fillRect/>
          </a:stretch>
        </p:blipFill>
        <p:spPr>
          <a:xfrm>
            <a:off x="6822519" y="6328993"/>
            <a:ext cx="431423" cy="549184"/>
          </a:xfrm>
          <a:prstGeom prst="rect">
            <a:avLst/>
          </a:prstGeom>
        </p:spPr>
      </p:pic>
      <p:pic>
        <p:nvPicPr>
          <p:cNvPr id="419" name="그림 418"/>
          <p:cNvPicPr>
            <a:picLocks noChangeAspect="1"/>
          </p:cNvPicPr>
          <p:nvPr/>
        </p:nvPicPr>
        <p:blipFill>
          <a:blip r:embed="rId10"/>
          <a:stretch>
            <a:fillRect/>
          </a:stretch>
        </p:blipFill>
        <p:spPr>
          <a:xfrm>
            <a:off x="7063075" y="6243187"/>
            <a:ext cx="431423" cy="549184"/>
          </a:xfrm>
          <a:prstGeom prst="rect">
            <a:avLst/>
          </a:prstGeom>
        </p:spPr>
      </p:pic>
      <p:pic>
        <p:nvPicPr>
          <p:cNvPr id="420" name="그림 419"/>
          <p:cNvPicPr>
            <a:picLocks noChangeAspect="1"/>
          </p:cNvPicPr>
          <p:nvPr/>
        </p:nvPicPr>
        <p:blipFill>
          <a:blip r:embed="rId10"/>
          <a:stretch>
            <a:fillRect/>
          </a:stretch>
        </p:blipFill>
        <p:spPr>
          <a:xfrm>
            <a:off x="7300418" y="6329735"/>
            <a:ext cx="431423" cy="549184"/>
          </a:xfrm>
          <a:prstGeom prst="rect">
            <a:avLst/>
          </a:prstGeom>
        </p:spPr>
      </p:pic>
      <p:pic>
        <p:nvPicPr>
          <p:cNvPr id="421" name="그림 420"/>
          <p:cNvPicPr>
            <a:picLocks noChangeAspect="1"/>
          </p:cNvPicPr>
          <p:nvPr/>
        </p:nvPicPr>
        <p:blipFill>
          <a:blip r:embed="rId10"/>
          <a:stretch>
            <a:fillRect/>
          </a:stretch>
        </p:blipFill>
        <p:spPr>
          <a:xfrm>
            <a:off x="8096641" y="6356083"/>
            <a:ext cx="431423" cy="549184"/>
          </a:xfrm>
          <a:prstGeom prst="rect">
            <a:avLst/>
          </a:prstGeom>
        </p:spPr>
      </p:pic>
      <p:pic>
        <p:nvPicPr>
          <p:cNvPr id="422" name="그림 421"/>
          <p:cNvPicPr>
            <a:picLocks noChangeAspect="1"/>
          </p:cNvPicPr>
          <p:nvPr/>
        </p:nvPicPr>
        <p:blipFill>
          <a:blip r:embed="rId10"/>
          <a:stretch>
            <a:fillRect/>
          </a:stretch>
        </p:blipFill>
        <p:spPr>
          <a:xfrm>
            <a:off x="8337197" y="6270277"/>
            <a:ext cx="431423" cy="549184"/>
          </a:xfrm>
          <a:prstGeom prst="rect">
            <a:avLst/>
          </a:prstGeom>
        </p:spPr>
      </p:pic>
      <p:pic>
        <p:nvPicPr>
          <p:cNvPr id="423" name="그림 422"/>
          <p:cNvPicPr>
            <a:picLocks noChangeAspect="1"/>
          </p:cNvPicPr>
          <p:nvPr/>
        </p:nvPicPr>
        <p:blipFill>
          <a:blip r:embed="rId10"/>
          <a:stretch>
            <a:fillRect/>
          </a:stretch>
        </p:blipFill>
        <p:spPr>
          <a:xfrm>
            <a:off x="8574540" y="6356825"/>
            <a:ext cx="431423" cy="549184"/>
          </a:xfrm>
          <a:prstGeom prst="rect">
            <a:avLst/>
          </a:prstGeom>
        </p:spPr>
      </p:pic>
      <p:pic>
        <p:nvPicPr>
          <p:cNvPr id="424" name="그림 423"/>
          <p:cNvPicPr>
            <a:picLocks noChangeAspect="1"/>
          </p:cNvPicPr>
          <p:nvPr/>
        </p:nvPicPr>
        <p:blipFill rotWithShape="1">
          <a:blip r:embed="rId9"/>
          <a:srcRect l="18260" r="5212" b="28670"/>
          <a:stretch/>
        </p:blipFill>
        <p:spPr>
          <a:xfrm>
            <a:off x="5783487" y="6832943"/>
            <a:ext cx="537439" cy="494713"/>
          </a:xfrm>
          <a:prstGeom prst="rect">
            <a:avLst/>
          </a:prstGeom>
        </p:spPr>
      </p:pic>
      <p:pic>
        <p:nvPicPr>
          <p:cNvPr id="425" name="그림 424"/>
          <p:cNvPicPr>
            <a:picLocks noChangeAspect="1"/>
          </p:cNvPicPr>
          <p:nvPr/>
        </p:nvPicPr>
        <p:blipFill rotWithShape="1">
          <a:blip r:embed="rId9"/>
          <a:srcRect l="18260" r="5212" b="28670"/>
          <a:stretch/>
        </p:blipFill>
        <p:spPr>
          <a:xfrm>
            <a:off x="7016419" y="6802329"/>
            <a:ext cx="537439" cy="494713"/>
          </a:xfrm>
          <a:prstGeom prst="rect">
            <a:avLst/>
          </a:prstGeom>
        </p:spPr>
      </p:pic>
      <p:pic>
        <p:nvPicPr>
          <p:cNvPr id="426" name="그림 425"/>
          <p:cNvPicPr>
            <a:picLocks noChangeAspect="1"/>
          </p:cNvPicPr>
          <p:nvPr/>
        </p:nvPicPr>
        <p:blipFill rotWithShape="1">
          <a:blip r:embed="rId9"/>
          <a:srcRect l="18260" r="5212" b="28670"/>
          <a:stretch/>
        </p:blipFill>
        <p:spPr>
          <a:xfrm>
            <a:off x="8301175" y="6801939"/>
            <a:ext cx="537439" cy="494713"/>
          </a:xfrm>
          <a:prstGeom prst="rect">
            <a:avLst/>
          </a:prstGeom>
        </p:spPr>
      </p:pic>
      <p:pic>
        <p:nvPicPr>
          <p:cNvPr id="427" name="그림 426"/>
          <p:cNvPicPr>
            <a:picLocks noChangeAspect="1"/>
          </p:cNvPicPr>
          <p:nvPr/>
        </p:nvPicPr>
        <p:blipFill>
          <a:blip r:embed="rId7"/>
          <a:stretch>
            <a:fillRect/>
          </a:stretch>
        </p:blipFill>
        <p:spPr>
          <a:xfrm>
            <a:off x="5853594" y="2290756"/>
            <a:ext cx="225421" cy="583778"/>
          </a:xfrm>
          <a:prstGeom prst="rect">
            <a:avLst/>
          </a:prstGeom>
        </p:spPr>
      </p:pic>
      <p:pic>
        <p:nvPicPr>
          <p:cNvPr id="428" name="그림 427"/>
          <p:cNvPicPr>
            <a:picLocks noChangeAspect="1"/>
          </p:cNvPicPr>
          <p:nvPr/>
        </p:nvPicPr>
        <p:blipFill>
          <a:blip r:embed="rId7"/>
          <a:stretch>
            <a:fillRect/>
          </a:stretch>
        </p:blipFill>
        <p:spPr>
          <a:xfrm>
            <a:off x="6099155" y="2281144"/>
            <a:ext cx="225421" cy="583778"/>
          </a:xfrm>
          <a:prstGeom prst="rect">
            <a:avLst/>
          </a:prstGeom>
        </p:spPr>
      </p:pic>
      <p:pic>
        <p:nvPicPr>
          <p:cNvPr id="429" name="그림 428"/>
          <p:cNvPicPr>
            <a:picLocks noChangeAspect="1"/>
          </p:cNvPicPr>
          <p:nvPr/>
        </p:nvPicPr>
        <p:blipFill>
          <a:blip r:embed="rId7"/>
          <a:stretch>
            <a:fillRect/>
          </a:stretch>
        </p:blipFill>
        <p:spPr>
          <a:xfrm>
            <a:off x="6828722" y="2262148"/>
            <a:ext cx="225421" cy="583778"/>
          </a:xfrm>
          <a:prstGeom prst="rect">
            <a:avLst/>
          </a:prstGeom>
        </p:spPr>
      </p:pic>
      <p:pic>
        <p:nvPicPr>
          <p:cNvPr id="430" name="그림 429"/>
          <p:cNvPicPr>
            <a:picLocks noChangeAspect="1"/>
          </p:cNvPicPr>
          <p:nvPr/>
        </p:nvPicPr>
        <p:blipFill>
          <a:blip r:embed="rId7"/>
          <a:stretch>
            <a:fillRect/>
          </a:stretch>
        </p:blipFill>
        <p:spPr>
          <a:xfrm>
            <a:off x="7074516" y="2263193"/>
            <a:ext cx="225421" cy="583778"/>
          </a:xfrm>
          <a:prstGeom prst="rect">
            <a:avLst/>
          </a:prstGeom>
        </p:spPr>
      </p:pic>
      <p:pic>
        <p:nvPicPr>
          <p:cNvPr id="431" name="그림 430"/>
          <p:cNvPicPr>
            <a:picLocks noChangeAspect="1"/>
          </p:cNvPicPr>
          <p:nvPr/>
        </p:nvPicPr>
        <p:blipFill>
          <a:blip r:embed="rId7"/>
          <a:stretch>
            <a:fillRect/>
          </a:stretch>
        </p:blipFill>
        <p:spPr>
          <a:xfrm>
            <a:off x="7320078" y="2253580"/>
            <a:ext cx="225421" cy="583778"/>
          </a:xfrm>
          <a:prstGeom prst="rect">
            <a:avLst/>
          </a:prstGeom>
        </p:spPr>
      </p:pic>
      <p:pic>
        <p:nvPicPr>
          <p:cNvPr id="432" name="그림 431"/>
          <p:cNvPicPr>
            <a:picLocks noChangeAspect="1"/>
          </p:cNvPicPr>
          <p:nvPr/>
        </p:nvPicPr>
        <p:blipFill>
          <a:blip r:embed="rId7"/>
          <a:stretch>
            <a:fillRect/>
          </a:stretch>
        </p:blipFill>
        <p:spPr>
          <a:xfrm>
            <a:off x="8131482" y="2270891"/>
            <a:ext cx="225421" cy="583778"/>
          </a:xfrm>
          <a:prstGeom prst="rect">
            <a:avLst/>
          </a:prstGeom>
        </p:spPr>
      </p:pic>
      <p:pic>
        <p:nvPicPr>
          <p:cNvPr id="433" name="그림 432"/>
          <p:cNvPicPr>
            <a:picLocks noChangeAspect="1"/>
          </p:cNvPicPr>
          <p:nvPr/>
        </p:nvPicPr>
        <p:blipFill>
          <a:blip r:embed="rId7"/>
          <a:stretch>
            <a:fillRect/>
          </a:stretch>
        </p:blipFill>
        <p:spPr>
          <a:xfrm>
            <a:off x="8377276" y="2271936"/>
            <a:ext cx="225421" cy="583778"/>
          </a:xfrm>
          <a:prstGeom prst="rect">
            <a:avLst/>
          </a:prstGeom>
        </p:spPr>
      </p:pic>
      <p:pic>
        <p:nvPicPr>
          <p:cNvPr id="434" name="그림 433"/>
          <p:cNvPicPr>
            <a:picLocks noChangeAspect="1"/>
          </p:cNvPicPr>
          <p:nvPr/>
        </p:nvPicPr>
        <p:blipFill>
          <a:blip r:embed="rId7"/>
          <a:stretch>
            <a:fillRect/>
          </a:stretch>
        </p:blipFill>
        <p:spPr>
          <a:xfrm>
            <a:off x="8622838" y="2262323"/>
            <a:ext cx="225421" cy="583778"/>
          </a:xfrm>
          <a:prstGeom prst="rect">
            <a:avLst/>
          </a:prstGeom>
        </p:spPr>
      </p:pic>
      <p:sp>
        <p:nvSpPr>
          <p:cNvPr id="435" name="아래쪽 화살표 434"/>
          <p:cNvSpPr/>
          <p:nvPr/>
        </p:nvSpPr>
        <p:spPr>
          <a:xfrm>
            <a:off x="1615582" y="7364523"/>
            <a:ext cx="151481" cy="254835"/>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36" name="아래쪽 화살표 435"/>
          <p:cNvSpPr/>
          <p:nvPr/>
        </p:nvSpPr>
        <p:spPr>
          <a:xfrm>
            <a:off x="2822880" y="7364522"/>
            <a:ext cx="151481" cy="263786"/>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37" name="아래쪽 화살표 436"/>
          <p:cNvSpPr/>
          <p:nvPr/>
        </p:nvSpPr>
        <p:spPr>
          <a:xfrm>
            <a:off x="4142133" y="7362818"/>
            <a:ext cx="151481" cy="26714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pic>
        <p:nvPicPr>
          <p:cNvPr id="438" name="그림 437"/>
          <p:cNvPicPr>
            <a:picLocks noChangeAspect="1"/>
          </p:cNvPicPr>
          <p:nvPr/>
        </p:nvPicPr>
        <p:blipFill>
          <a:blip r:embed="rId7"/>
          <a:stretch>
            <a:fillRect/>
          </a:stretch>
        </p:blipFill>
        <p:spPr>
          <a:xfrm>
            <a:off x="5686877" y="7690502"/>
            <a:ext cx="225421" cy="583778"/>
          </a:xfrm>
          <a:prstGeom prst="rect">
            <a:avLst/>
          </a:prstGeom>
        </p:spPr>
      </p:pic>
      <p:sp>
        <p:nvSpPr>
          <p:cNvPr id="439" name="아래쪽 화살표 438"/>
          <p:cNvSpPr/>
          <p:nvPr/>
        </p:nvSpPr>
        <p:spPr>
          <a:xfrm>
            <a:off x="5955630" y="7372375"/>
            <a:ext cx="151481" cy="254835"/>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40" name="아래쪽 화살표 439"/>
          <p:cNvSpPr/>
          <p:nvPr/>
        </p:nvSpPr>
        <p:spPr>
          <a:xfrm>
            <a:off x="7162928" y="7372374"/>
            <a:ext cx="151481" cy="263786"/>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41" name="아래쪽 화살표 440"/>
          <p:cNvSpPr/>
          <p:nvPr/>
        </p:nvSpPr>
        <p:spPr>
          <a:xfrm>
            <a:off x="8482181" y="7370670"/>
            <a:ext cx="151481" cy="26714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pic>
        <p:nvPicPr>
          <p:cNvPr id="442" name="그림 441"/>
          <p:cNvPicPr>
            <a:picLocks noChangeAspect="1"/>
          </p:cNvPicPr>
          <p:nvPr/>
        </p:nvPicPr>
        <p:blipFill>
          <a:blip r:embed="rId7"/>
          <a:stretch>
            <a:fillRect/>
          </a:stretch>
        </p:blipFill>
        <p:spPr>
          <a:xfrm>
            <a:off x="5932671" y="7691547"/>
            <a:ext cx="225421" cy="583778"/>
          </a:xfrm>
          <a:prstGeom prst="rect">
            <a:avLst/>
          </a:prstGeom>
        </p:spPr>
      </p:pic>
      <p:pic>
        <p:nvPicPr>
          <p:cNvPr id="443" name="그림 442"/>
          <p:cNvPicPr>
            <a:picLocks noChangeAspect="1"/>
          </p:cNvPicPr>
          <p:nvPr/>
        </p:nvPicPr>
        <p:blipFill>
          <a:blip r:embed="rId7"/>
          <a:stretch>
            <a:fillRect/>
          </a:stretch>
        </p:blipFill>
        <p:spPr>
          <a:xfrm>
            <a:off x="6168259" y="7690502"/>
            <a:ext cx="225421" cy="583778"/>
          </a:xfrm>
          <a:prstGeom prst="rect">
            <a:avLst/>
          </a:prstGeom>
        </p:spPr>
      </p:pic>
      <p:pic>
        <p:nvPicPr>
          <p:cNvPr id="444" name="그림 443"/>
          <p:cNvPicPr>
            <a:picLocks noChangeAspect="1"/>
          </p:cNvPicPr>
          <p:nvPr/>
        </p:nvPicPr>
        <p:blipFill>
          <a:blip r:embed="rId7"/>
          <a:stretch>
            <a:fillRect/>
          </a:stretch>
        </p:blipFill>
        <p:spPr>
          <a:xfrm>
            <a:off x="6907799" y="7662939"/>
            <a:ext cx="225421" cy="583778"/>
          </a:xfrm>
          <a:prstGeom prst="rect">
            <a:avLst/>
          </a:prstGeom>
        </p:spPr>
      </p:pic>
      <p:pic>
        <p:nvPicPr>
          <p:cNvPr id="445" name="그림 444"/>
          <p:cNvPicPr>
            <a:picLocks noChangeAspect="1"/>
          </p:cNvPicPr>
          <p:nvPr/>
        </p:nvPicPr>
        <p:blipFill>
          <a:blip r:embed="rId7"/>
          <a:stretch>
            <a:fillRect/>
          </a:stretch>
        </p:blipFill>
        <p:spPr>
          <a:xfrm>
            <a:off x="7153594" y="7663984"/>
            <a:ext cx="225421" cy="583778"/>
          </a:xfrm>
          <a:prstGeom prst="rect">
            <a:avLst/>
          </a:prstGeom>
        </p:spPr>
      </p:pic>
      <p:pic>
        <p:nvPicPr>
          <p:cNvPr id="446" name="그림 445"/>
          <p:cNvPicPr>
            <a:picLocks noChangeAspect="1"/>
          </p:cNvPicPr>
          <p:nvPr/>
        </p:nvPicPr>
        <p:blipFill>
          <a:blip r:embed="rId7"/>
          <a:stretch>
            <a:fillRect/>
          </a:stretch>
        </p:blipFill>
        <p:spPr>
          <a:xfrm>
            <a:off x="7399156" y="7654371"/>
            <a:ext cx="225421" cy="583778"/>
          </a:xfrm>
          <a:prstGeom prst="rect">
            <a:avLst/>
          </a:prstGeom>
        </p:spPr>
      </p:pic>
      <p:pic>
        <p:nvPicPr>
          <p:cNvPr id="447" name="그림 446"/>
          <p:cNvPicPr>
            <a:picLocks noChangeAspect="1"/>
          </p:cNvPicPr>
          <p:nvPr/>
        </p:nvPicPr>
        <p:blipFill>
          <a:blip r:embed="rId7"/>
          <a:stretch>
            <a:fillRect/>
          </a:stretch>
        </p:blipFill>
        <p:spPr>
          <a:xfrm>
            <a:off x="8210559" y="7671682"/>
            <a:ext cx="225421" cy="583778"/>
          </a:xfrm>
          <a:prstGeom prst="rect">
            <a:avLst/>
          </a:prstGeom>
        </p:spPr>
      </p:pic>
      <p:pic>
        <p:nvPicPr>
          <p:cNvPr id="448" name="그림 447"/>
          <p:cNvPicPr>
            <a:picLocks noChangeAspect="1"/>
          </p:cNvPicPr>
          <p:nvPr/>
        </p:nvPicPr>
        <p:blipFill>
          <a:blip r:embed="rId7"/>
          <a:stretch>
            <a:fillRect/>
          </a:stretch>
        </p:blipFill>
        <p:spPr>
          <a:xfrm>
            <a:off x="8456354" y="7672727"/>
            <a:ext cx="225421" cy="583778"/>
          </a:xfrm>
          <a:prstGeom prst="rect">
            <a:avLst/>
          </a:prstGeom>
        </p:spPr>
      </p:pic>
      <p:pic>
        <p:nvPicPr>
          <p:cNvPr id="449" name="그림 448"/>
          <p:cNvPicPr>
            <a:picLocks noChangeAspect="1"/>
          </p:cNvPicPr>
          <p:nvPr/>
        </p:nvPicPr>
        <p:blipFill>
          <a:blip r:embed="rId7"/>
          <a:stretch>
            <a:fillRect/>
          </a:stretch>
        </p:blipFill>
        <p:spPr>
          <a:xfrm>
            <a:off x="8701915" y="7663114"/>
            <a:ext cx="225421" cy="583778"/>
          </a:xfrm>
          <a:prstGeom prst="rect">
            <a:avLst/>
          </a:prstGeom>
        </p:spPr>
      </p:pic>
      <p:sp>
        <p:nvSpPr>
          <p:cNvPr id="450" name="TextBox 449"/>
          <p:cNvSpPr txBox="1"/>
          <p:nvPr/>
        </p:nvSpPr>
        <p:spPr>
          <a:xfrm>
            <a:off x="2672085" y="3841441"/>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7</a:t>
            </a:r>
            <a:endParaRPr lang="ko-KR" altLang="en-US" sz="800" b="1" dirty="0">
              <a:latin typeface="Arial" panose="020B0604020202020204" pitchFamily="34" charset="0"/>
              <a:cs typeface="Arial" panose="020B0604020202020204" pitchFamily="34" charset="0"/>
            </a:endParaRPr>
          </a:p>
        </p:txBody>
      </p:sp>
      <p:sp>
        <p:nvSpPr>
          <p:cNvPr id="451" name="직사각형 450"/>
          <p:cNvSpPr/>
          <p:nvPr/>
        </p:nvSpPr>
        <p:spPr>
          <a:xfrm>
            <a:off x="2594315" y="4066022"/>
            <a:ext cx="466409" cy="190934"/>
          </a:xfrm>
          <a:prstGeom prst="rect">
            <a:avLst/>
          </a:prstGeom>
          <a:solidFill>
            <a:srgbClr val="FA2EA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452" name="직사각형 451"/>
          <p:cNvSpPr/>
          <p:nvPr/>
        </p:nvSpPr>
        <p:spPr>
          <a:xfrm>
            <a:off x="2594315" y="4374641"/>
            <a:ext cx="466409" cy="190934"/>
          </a:xfrm>
          <a:prstGeom prst="rect">
            <a:avLst/>
          </a:prstGeom>
          <a:solidFill>
            <a:srgbClr val="FA2EA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453" name="직사각형 452"/>
          <p:cNvSpPr/>
          <p:nvPr/>
        </p:nvSpPr>
        <p:spPr>
          <a:xfrm>
            <a:off x="2594315" y="4682323"/>
            <a:ext cx="466409" cy="190934"/>
          </a:xfrm>
          <a:prstGeom prst="rect">
            <a:avLst/>
          </a:prstGeom>
          <a:solidFill>
            <a:srgbClr val="FA2EA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454" name="TextBox 453"/>
          <p:cNvSpPr txBox="1"/>
          <p:nvPr/>
        </p:nvSpPr>
        <p:spPr>
          <a:xfrm>
            <a:off x="1913973" y="4026937"/>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TR1)</a:t>
            </a:r>
            <a:endParaRPr lang="ko-KR" altLang="en-US" sz="800" b="1" dirty="0">
              <a:latin typeface="Arial" panose="020B0604020202020204" pitchFamily="34" charset="0"/>
              <a:cs typeface="Arial" panose="020B0604020202020204" pitchFamily="34" charset="0"/>
            </a:endParaRPr>
          </a:p>
        </p:txBody>
      </p:sp>
      <p:sp>
        <p:nvSpPr>
          <p:cNvPr id="455" name="TextBox 454"/>
          <p:cNvSpPr txBox="1"/>
          <p:nvPr/>
        </p:nvSpPr>
        <p:spPr>
          <a:xfrm>
            <a:off x="1919127" y="4345332"/>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TR2)</a:t>
            </a:r>
            <a:endParaRPr lang="ko-KR" altLang="en-US" sz="800" b="1" dirty="0">
              <a:latin typeface="Arial" panose="020B0604020202020204" pitchFamily="34" charset="0"/>
              <a:cs typeface="Arial" panose="020B0604020202020204" pitchFamily="34" charset="0"/>
            </a:endParaRPr>
          </a:p>
        </p:txBody>
      </p:sp>
      <p:sp>
        <p:nvSpPr>
          <p:cNvPr id="456" name="TextBox 455"/>
          <p:cNvSpPr txBox="1"/>
          <p:nvPr/>
        </p:nvSpPr>
        <p:spPr>
          <a:xfrm>
            <a:off x="1919127" y="4679395"/>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TR3)</a:t>
            </a:r>
            <a:endParaRPr lang="ko-KR" altLang="en-US" sz="800" b="1" dirty="0">
              <a:latin typeface="Arial" panose="020B0604020202020204" pitchFamily="34" charset="0"/>
              <a:cs typeface="Arial" panose="020B0604020202020204" pitchFamily="34" charset="0"/>
            </a:endParaRPr>
          </a:p>
        </p:txBody>
      </p:sp>
      <p:sp>
        <p:nvSpPr>
          <p:cNvPr id="457" name="직사각형 456"/>
          <p:cNvSpPr/>
          <p:nvPr/>
        </p:nvSpPr>
        <p:spPr>
          <a:xfrm>
            <a:off x="3951623" y="4071334"/>
            <a:ext cx="457674" cy="196034"/>
          </a:xfrm>
          <a:prstGeom prst="rect">
            <a:avLst/>
          </a:prstGeom>
          <a:solidFill>
            <a:srgbClr val="92D05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458" name="직사각형 457"/>
          <p:cNvSpPr/>
          <p:nvPr/>
        </p:nvSpPr>
        <p:spPr>
          <a:xfrm>
            <a:off x="3950392" y="4363460"/>
            <a:ext cx="458906" cy="186461"/>
          </a:xfrm>
          <a:prstGeom prst="rect">
            <a:avLst/>
          </a:prstGeom>
          <a:solidFill>
            <a:srgbClr val="92D05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459" name="직사각형 458"/>
          <p:cNvSpPr/>
          <p:nvPr/>
        </p:nvSpPr>
        <p:spPr>
          <a:xfrm>
            <a:off x="3953248" y="4689958"/>
            <a:ext cx="463261" cy="190750"/>
          </a:xfrm>
          <a:prstGeom prst="rect">
            <a:avLst/>
          </a:prstGeom>
          <a:solidFill>
            <a:srgbClr val="92D05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460" name="TextBox 459"/>
          <p:cNvSpPr txBox="1"/>
          <p:nvPr/>
        </p:nvSpPr>
        <p:spPr>
          <a:xfrm>
            <a:off x="3997455" y="3834948"/>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8</a:t>
            </a:r>
            <a:endParaRPr lang="ko-KR" altLang="en-US" sz="800" b="1" dirty="0">
              <a:latin typeface="Arial" panose="020B0604020202020204" pitchFamily="34" charset="0"/>
              <a:cs typeface="Arial" panose="020B0604020202020204" pitchFamily="34" charset="0"/>
            </a:endParaRPr>
          </a:p>
        </p:txBody>
      </p:sp>
      <p:sp>
        <p:nvSpPr>
          <p:cNvPr id="461" name="TextBox 460"/>
          <p:cNvSpPr txBox="1"/>
          <p:nvPr/>
        </p:nvSpPr>
        <p:spPr>
          <a:xfrm>
            <a:off x="3271082" y="4033316"/>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TR1)</a:t>
            </a:r>
            <a:endParaRPr lang="ko-KR" altLang="en-US" sz="800" b="1" dirty="0">
              <a:latin typeface="Arial" panose="020B0604020202020204" pitchFamily="34" charset="0"/>
              <a:cs typeface="Arial" panose="020B0604020202020204" pitchFamily="34" charset="0"/>
            </a:endParaRPr>
          </a:p>
        </p:txBody>
      </p:sp>
      <p:sp>
        <p:nvSpPr>
          <p:cNvPr id="462" name="TextBox 461"/>
          <p:cNvSpPr txBox="1"/>
          <p:nvPr/>
        </p:nvSpPr>
        <p:spPr>
          <a:xfrm>
            <a:off x="3276235" y="4351713"/>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TR2)</a:t>
            </a:r>
            <a:endParaRPr lang="ko-KR" altLang="en-US" sz="800" b="1" dirty="0">
              <a:latin typeface="Arial" panose="020B0604020202020204" pitchFamily="34" charset="0"/>
              <a:cs typeface="Arial" panose="020B0604020202020204" pitchFamily="34" charset="0"/>
            </a:endParaRPr>
          </a:p>
        </p:txBody>
      </p:sp>
      <p:sp>
        <p:nvSpPr>
          <p:cNvPr id="463" name="TextBox 462"/>
          <p:cNvSpPr txBox="1"/>
          <p:nvPr/>
        </p:nvSpPr>
        <p:spPr>
          <a:xfrm>
            <a:off x="3276235" y="4685773"/>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TR3)</a:t>
            </a:r>
            <a:endParaRPr lang="ko-KR" altLang="en-US" sz="800" b="1" dirty="0">
              <a:latin typeface="Arial" panose="020B0604020202020204" pitchFamily="34" charset="0"/>
              <a:cs typeface="Arial" panose="020B0604020202020204" pitchFamily="34" charset="0"/>
            </a:endParaRPr>
          </a:p>
        </p:txBody>
      </p:sp>
      <p:sp>
        <p:nvSpPr>
          <p:cNvPr id="464" name="오른쪽 중괄호 463"/>
          <p:cNvSpPr/>
          <p:nvPr/>
        </p:nvSpPr>
        <p:spPr>
          <a:xfrm rot="5400000">
            <a:off x="2806613" y="3646031"/>
            <a:ext cx="215291" cy="2969663"/>
          </a:xfrm>
          <a:prstGeom prst="rightBrace">
            <a:avLst/>
          </a:prstGeom>
          <a:solidFill>
            <a:schemeClr val="tx1"/>
          </a:solid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700"/>
          </a:p>
        </p:txBody>
      </p:sp>
      <p:sp>
        <p:nvSpPr>
          <p:cNvPr id="465" name="TextBox 464"/>
          <p:cNvSpPr txBox="1"/>
          <p:nvPr/>
        </p:nvSpPr>
        <p:spPr>
          <a:xfrm>
            <a:off x="2353008" y="5241777"/>
            <a:ext cx="1256539"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on dis-meta</a:t>
            </a:r>
            <a:endParaRPr lang="ko-KR" altLang="en-US" sz="1200" b="1" dirty="0">
              <a:latin typeface="Arial" panose="020B0604020202020204" pitchFamily="34" charset="0"/>
              <a:cs typeface="Arial" panose="020B0604020202020204" pitchFamily="34" charset="0"/>
            </a:endParaRPr>
          </a:p>
        </p:txBody>
      </p:sp>
      <p:sp>
        <p:nvSpPr>
          <p:cNvPr id="466" name="TextBox 465"/>
          <p:cNvSpPr txBox="1"/>
          <p:nvPr/>
        </p:nvSpPr>
        <p:spPr>
          <a:xfrm>
            <a:off x="753671" y="3672158"/>
            <a:ext cx="804388" cy="253916"/>
          </a:xfrm>
          <a:prstGeom prst="rect">
            <a:avLst/>
          </a:prstGeom>
          <a:noFill/>
        </p:spPr>
        <p:txBody>
          <a:bodyPr wrap="square" rtlCol="0">
            <a:spAutoFit/>
          </a:bodyPr>
          <a:lstStyle/>
          <a:p>
            <a:r>
              <a:rPr lang="en-US" altLang="ko-KR" sz="1050" b="1" dirty="0" smtClean="0"/>
              <a:t>Channels</a:t>
            </a:r>
            <a:endParaRPr lang="ko-KR" altLang="en-US" sz="900" b="1" dirty="0"/>
          </a:p>
        </p:txBody>
      </p:sp>
      <p:sp>
        <p:nvSpPr>
          <p:cNvPr id="467" name="아래쪽 화살표 466"/>
          <p:cNvSpPr/>
          <p:nvPr/>
        </p:nvSpPr>
        <p:spPr>
          <a:xfrm>
            <a:off x="1583453" y="2917342"/>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68" name="아래쪽 화살표 467"/>
          <p:cNvSpPr/>
          <p:nvPr/>
        </p:nvSpPr>
        <p:spPr>
          <a:xfrm>
            <a:off x="2779294" y="2917342"/>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69" name="아래쪽 화살표 468"/>
          <p:cNvSpPr/>
          <p:nvPr/>
        </p:nvSpPr>
        <p:spPr>
          <a:xfrm>
            <a:off x="4096597" y="2917342"/>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70" name="직사각형 469"/>
          <p:cNvSpPr/>
          <p:nvPr/>
        </p:nvSpPr>
        <p:spPr>
          <a:xfrm>
            <a:off x="1594692" y="9677883"/>
            <a:ext cx="472549" cy="173993"/>
          </a:xfrm>
          <a:prstGeom prst="rect">
            <a:avLst/>
          </a:prstGeom>
          <a:solidFill>
            <a:srgbClr val="F8AF2C"/>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471" name="직사각형 470"/>
          <p:cNvSpPr/>
          <p:nvPr/>
        </p:nvSpPr>
        <p:spPr>
          <a:xfrm>
            <a:off x="2772748" y="9670545"/>
            <a:ext cx="467333" cy="174332"/>
          </a:xfrm>
          <a:prstGeom prst="rect">
            <a:avLst/>
          </a:prstGeom>
          <a:solidFill>
            <a:srgbClr val="7030A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472" name="직사각형 471"/>
          <p:cNvSpPr/>
          <p:nvPr/>
        </p:nvSpPr>
        <p:spPr>
          <a:xfrm>
            <a:off x="4120028" y="9670545"/>
            <a:ext cx="464462" cy="174332"/>
          </a:xfrm>
          <a:prstGeom prst="rect">
            <a:avLst/>
          </a:prstGeom>
          <a:solidFill>
            <a:srgbClr val="A56A1B"/>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473" name="직사각형 472"/>
          <p:cNvSpPr/>
          <p:nvPr/>
        </p:nvSpPr>
        <p:spPr>
          <a:xfrm>
            <a:off x="1594692" y="9986503"/>
            <a:ext cx="472549" cy="173993"/>
          </a:xfrm>
          <a:prstGeom prst="rect">
            <a:avLst/>
          </a:prstGeom>
          <a:solidFill>
            <a:srgbClr val="F8AF2C"/>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474" name="직사각형 473"/>
          <p:cNvSpPr/>
          <p:nvPr/>
        </p:nvSpPr>
        <p:spPr>
          <a:xfrm>
            <a:off x="2772748" y="9979165"/>
            <a:ext cx="467333" cy="174332"/>
          </a:xfrm>
          <a:prstGeom prst="rect">
            <a:avLst/>
          </a:prstGeom>
          <a:solidFill>
            <a:srgbClr val="7030A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475" name="직사각형 474"/>
          <p:cNvSpPr/>
          <p:nvPr/>
        </p:nvSpPr>
        <p:spPr>
          <a:xfrm>
            <a:off x="4120028" y="9979165"/>
            <a:ext cx="464462" cy="174332"/>
          </a:xfrm>
          <a:prstGeom prst="rect">
            <a:avLst/>
          </a:prstGeom>
          <a:solidFill>
            <a:srgbClr val="A56A1B"/>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476" name="직사각형 475"/>
          <p:cNvSpPr/>
          <p:nvPr/>
        </p:nvSpPr>
        <p:spPr>
          <a:xfrm>
            <a:off x="1594692" y="10294184"/>
            <a:ext cx="472549" cy="173993"/>
          </a:xfrm>
          <a:prstGeom prst="rect">
            <a:avLst/>
          </a:prstGeom>
          <a:solidFill>
            <a:srgbClr val="F8AF2C"/>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477" name="직사각형 476"/>
          <p:cNvSpPr/>
          <p:nvPr/>
        </p:nvSpPr>
        <p:spPr>
          <a:xfrm>
            <a:off x="2772748" y="10286846"/>
            <a:ext cx="467333" cy="174332"/>
          </a:xfrm>
          <a:prstGeom prst="rect">
            <a:avLst/>
          </a:prstGeom>
          <a:solidFill>
            <a:srgbClr val="7030A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478" name="직사각형 477"/>
          <p:cNvSpPr/>
          <p:nvPr/>
        </p:nvSpPr>
        <p:spPr>
          <a:xfrm>
            <a:off x="4120028" y="10286846"/>
            <a:ext cx="464462" cy="174332"/>
          </a:xfrm>
          <a:prstGeom prst="rect">
            <a:avLst/>
          </a:prstGeom>
          <a:solidFill>
            <a:srgbClr val="A56A1B"/>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479" name="오른쪽 중괄호 478"/>
          <p:cNvSpPr/>
          <p:nvPr/>
        </p:nvSpPr>
        <p:spPr>
          <a:xfrm rot="5400000">
            <a:off x="2924695" y="9337477"/>
            <a:ext cx="224612" cy="2863205"/>
          </a:xfrm>
          <a:prstGeom prst="rightBrace">
            <a:avLst/>
          </a:prstGeom>
          <a:solidFill>
            <a:schemeClr val="tx1"/>
          </a:solid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700"/>
          </a:p>
        </p:txBody>
      </p:sp>
      <p:sp>
        <p:nvSpPr>
          <p:cNvPr id="480" name="TextBox 479"/>
          <p:cNvSpPr txBox="1"/>
          <p:nvPr/>
        </p:nvSpPr>
        <p:spPr>
          <a:xfrm>
            <a:off x="2461870" y="10938153"/>
            <a:ext cx="1168171" cy="276999"/>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D</a:t>
            </a:r>
            <a:r>
              <a:rPr lang="en-US" altLang="ko-KR" sz="1200" b="1" dirty="0" smtClean="0">
                <a:latin typeface="Arial" panose="020B0604020202020204" pitchFamily="34" charset="0"/>
                <a:cs typeface="Arial" panose="020B0604020202020204" pitchFamily="34" charset="0"/>
              </a:rPr>
              <a:t>is-meta</a:t>
            </a:r>
            <a:endParaRPr lang="ko-KR" altLang="en-US" sz="1200" b="1" dirty="0">
              <a:latin typeface="Arial" panose="020B0604020202020204" pitchFamily="34" charset="0"/>
              <a:cs typeface="Arial" panose="020B0604020202020204" pitchFamily="34" charset="0"/>
            </a:endParaRPr>
          </a:p>
        </p:txBody>
      </p:sp>
      <p:sp>
        <p:nvSpPr>
          <p:cNvPr id="481" name="TextBox 480"/>
          <p:cNvSpPr txBox="1"/>
          <p:nvPr/>
        </p:nvSpPr>
        <p:spPr>
          <a:xfrm>
            <a:off x="970413" y="9661760"/>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TR1)</a:t>
            </a:r>
            <a:endParaRPr lang="ko-KR" altLang="en-US" sz="800" b="1" dirty="0">
              <a:latin typeface="Arial" panose="020B0604020202020204" pitchFamily="34" charset="0"/>
              <a:cs typeface="Arial" panose="020B0604020202020204" pitchFamily="34" charset="0"/>
            </a:endParaRPr>
          </a:p>
        </p:txBody>
      </p:sp>
      <p:sp>
        <p:nvSpPr>
          <p:cNvPr id="482" name="TextBox 481"/>
          <p:cNvSpPr txBox="1"/>
          <p:nvPr/>
        </p:nvSpPr>
        <p:spPr>
          <a:xfrm>
            <a:off x="964368" y="9970776"/>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TR2)</a:t>
            </a:r>
            <a:endParaRPr lang="ko-KR" altLang="en-US" sz="800" b="1" dirty="0">
              <a:latin typeface="Arial" panose="020B0604020202020204" pitchFamily="34" charset="0"/>
              <a:cs typeface="Arial" panose="020B0604020202020204" pitchFamily="34" charset="0"/>
            </a:endParaRPr>
          </a:p>
        </p:txBody>
      </p:sp>
      <p:sp>
        <p:nvSpPr>
          <p:cNvPr id="483" name="TextBox 482"/>
          <p:cNvSpPr txBox="1"/>
          <p:nvPr/>
        </p:nvSpPr>
        <p:spPr>
          <a:xfrm>
            <a:off x="962315" y="10276022"/>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TR3)</a:t>
            </a:r>
            <a:endParaRPr lang="ko-KR" altLang="en-US" sz="800" b="1" dirty="0">
              <a:latin typeface="Arial" panose="020B0604020202020204" pitchFamily="34" charset="0"/>
              <a:cs typeface="Arial" panose="020B0604020202020204" pitchFamily="34" charset="0"/>
            </a:endParaRPr>
          </a:p>
        </p:txBody>
      </p:sp>
      <p:sp>
        <p:nvSpPr>
          <p:cNvPr id="484" name="TextBox 483"/>
          <p:cNvSpPr txBox="1"/>
          <p:nvPr/>
        </p:nvSpPr>
        <p:spPr>
          <a:xfrm>
            <a:off x="2162370" y="9632185"/>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TR1)</a:t>
            </a:r>
            <a:endParaRPr lang="ko-KR" altLang="en-US" sz="800" b="1" dirty="0">
              <a:latin typeface="Arial" panose="020B0604020202020204" pitchFamily="34" charset="0"/>
              <a:cs typeface="Arial" panose="020B0604020202020204" pitchFamily="34" charset="0"/>
            </a:endParaRPr>
          </a:p>
        </p:txBody>
      </p:sp>
      <p:sp>
        <p:nvSpPr>
          <p:cNvPr id="485" name="TextBox 484"/>
          <p:cNvSpPr txBox="1"/>
          <p:nvPr/>
        </p:nvSpPr>
        <p:spPr>
          <a:xfrm>
            <a:off x="2167524" y="9950581"/>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TR2)</a:t>
            </a:r>
            <a:endParaRPr lang="ko-KR" altLang="en-US" sz="800" b="1" dirty="0">
              <a:latin typeface="Arial" panose="020B0604020202020204" pitchFamily="34" charset="0"/>
              <a:cs typeface="Arial" panose="020B0604020202020204" pitchFamily="34" charset="0"/>
            </a:endParaRPr>
          </a:p>
        </p:txBody>
      </p:sp>
      <p:sp>
        <p:nvSpPr>
          <p:cNvPr id="486" name="TextBox 485"/>
          <p:cNvSpPr txBox="1"/>
          <p:nvPr/>
        </p:nvSpPr>
        <p:spPr>
          <a:xfrm>
            <a:off x="2167524" y="10284642"/>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TR3)</a:t>
            </a:r>
            <a:endParaRPr lang="ko-KR" altLang="en-US" sz="800" b="1" dirty="0">
              <a:latin typeface="Arial" panose="020B0604020202020204" pitchFamily="34" charset="0"/>
              <a:cs typeface="Arial" panose="020B0604020202020204" pitchFamily="34" charset="0"/>
            </a:endParaRPr>
          </a:p>
        </p:txBody>
      </p:sp>
      <p:sp>
        <p:nvSpPr>
          <p:cNvPr id="487" name="TextBox 486"/>
          <p:cNvSpPr txBox="1"/>
          <p:nvPr/>
        </p:nvSpPr>
        <p:spPr>
          <a:xfrm>
            <a:off x="3514248" y="9630148"/>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TR1)</a:t>
            </a:r>
            <a:endParaRPr lang="ko-KR" altLang="en-US" sz="800" b="1" dirty="0">
              <a:latin typeface="Arial" panose="020B0604020202020204" pitchFamily="34" charset="0"/>
              <a:cs typeface="Arial" panose="020B0604020202020204" pitchFamily="34" charset="0"/>
            </a:endParaRPr>
          </a:p>
        </p:txBody>
      </p:sp>
      <p:sp>
        <p:nvSpPr>
          <p:cNvPr id="488" name="TextBox 487"/>
          <p:cNvSpPr txBox="1"/>
          <p:nvPr/>
        </p:nvSpPr>
        <p:spPr>
          <a:xfrm>
            <a:off x="3519402" y="9948543"/>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TR2)</a:t>
            </a:r>
            <a:endParaRPr lang="ko-KR" altLang="en-US" sz="800" b="1" dirty="0">
              <a:latin typeface="Arial" panose="020B0604020202020204" pitchFamily="34" charset="0"/>
              <a:cs typeface="Arial" panose="020B0604020202020204" pitchFamily="34" charset="0"/>
            </a:endParaRPr>
          </a:p>
        </p:txBody>
      </p:sp>
      <p:sp>
        <p:nvSpPr>
          <p:cNvPr id="489" name="TextBox 488"/>
          <p:cNvSpPr txBox="1"/>
          <p:nvPr/>
        </p:nvSpPr>
        <p:spPr>
          <a:xfrm>
            <a:off x="3519402" y="10282605"/>
            <a:ext cx="64641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TR3)</a:t>
            </a:r>
            <a:endParaRPr lang="ko-KR" altLang="en-US" sz="800" b="1" dirty="0">
              <a:latin typeface="Arial" panose="020B0604020202020204" pitchFamily="34" charset="0"/>
              <a:cs typeface="Arial" panose="020B0604020202020204" pitchFamily="34" charset="0"/>
            </a:endParaRPr>
          </a:p>
        </p:txBody>
      </p:sp>
      <p:sp>
        <p:nvSpPr>
          <p:cNvPr id="490" name="TextBox 489"/>
          <p:cNvSpPr txBox="1"/>
          <p:nvPr/>
        </p:nvSpPr>
        <p:spPr>
          <a:xfrm>
            <a:off x="1660199" y="9433567"/>
            <a:ext cx="391342" cy="200055"/>
          </a:xfrm>
          <a:prstGeom prst="rect">
            <a:avLst/>
          </a:prstGeom>
          <a:noFill/>
        </p:spPr>
        <p:txBody>
          <a:bodyPr wrap="square" rtlCol="0">
            <a:spAutoFit/>
          </a:bodyPr>
          <a:lstStyle/>
          <a:p>
            <a:r>
              <a:rPr lang="en-US" altLang="ko-KR" sz="700" b="1" dirty="0" smtClean="0">
                <a:latin typeface="Arial" panose="020B0604020202020204" pitchFamily="34" charset="0"/>
                <a:cs typeface="Arial" panose="020B0604020202020204" pitchFamily="34" charset="0"/>
              </a:rPr>
              <a:t>129</a:t>
            </a:r>
            <a:endParaRPr lang="ko-KR" altLang="en-US" sz="700" b="1" dirty="0">
              <a:latin typeface="Arial" panose="020B0604020202020204" pitchFamily="34" charset="0"/>
              <a:cs typeface="Arial" panose="020B0604020202020204" pitchFamily="34" charset="0"/>
            </a:endParaRPr>
          </a:p>
        </p:txBody>
      </p:sp>
      <p:sp>
        <p:nvSpPr>
          <p:cNvPr id="491" name="TextBox 490"/>
          <p:cNvSpPr txBox="1"/>
          <p:nvPr/>
        </p:nvSpPr>
        <p:spPr>
          <a:xfrm>
            <a:off x="2849989" y="9436338"/>
            <a:ext cx="359585" cy="200055"/>
          </a:xfrm>
          <a:prstGeom prst="rect">
            <a:avLst/>
          </a:prstGeom>
          <a:noFill/>
        </p:spPr>
        <p:txBody>
          <a:bodyPr wrap="square" rtlCol="0">
            <a:spAutoFit/>
          </a:bodyPr>
          <a:lstStyle/>
          <a:p>
            <a:r>
              <a:rPr lang="en-US" altLang="ko-KR" sz="700" b="1" dirty="0" smtClean="0">
                <a:latin typeface="Arial" panose="020B0604020202020204" pitchFamily="34" charset="0"/>
                <a:cs typeface="Arial" panose="020B0604020202020204" pitchFamily="34" charset="0"/>
              </a:rPr>
              <a:t>130</a:t>
            </a:r>
            <a:endParaRPr lang="ko-KR" altLang="en-US" sz="700" b="1" dirty="0">
              <a:latin typeface="Arial" panose="020B0604020202020204" pitchFamily="34" charset="0"/>
              <a:cs typeface="Arial" panose="020B0604020202020204" pitchFamily="34" charset="0"/>
            </a:endParaRPr>
          </a:p>
        </p:txBody>
      </p:sp>
      <p:sp>
        <p:nvSpPr>
          <p:cNvPr id="492" name="TextBox 491"/>
          <p:cNvSpPr txBox="1"/>
          <p:nvPr/>
        </p:nvSpPr>
        <p:spPr>
          <a:xfrm>
            <a:off x="4175359" y="9429847"/>
            <a:ext cx="359585" cy="200055"/>
          </a:xfrm>
          <a:prstGeom prst="rect">
            <a:avLst/>
          </a:prstGeom>
          <a:noFill/>
        </p:spPr>
        <p:txBody>
          <a:bodyPr wrap="square" rtlCol="0">
            <a:spAutoFit/>
          </a:bodyPr>
          <a:lstStyle/>
          <a:p>
            <a:r>
              <a:rPr lang="en-US" altLang="ko-KR" sz="700" b="1" dirty="0" smtClean="0">
                <a:latin typeface="Arial" panose="020B0604020202020204" pitchFamily="34" charset="0"/>
                <a:cs typeface="Arial" panose="020B0604020202020204" pitchFamily="34" charset="0"/>
              </a:rPr>
              <a:t>131</a:t>
            </a:r>
            <a:endParaRPr lang="ko-KR" altLang="en-US" sz="700" b="1" dirty="0">
              <a:latin typeface="Arial" panose="020B0604020202020204" pitchFamily="34" charset="0"/>
              <a:cs typeface="Arial" panose="020B0604020202020204" pitchFamily="34" charset="0"/>
            </a:endParaRPr>
          </a:p>
        </p:txBody>
      </p:sp>
      <p:sp>
        <p:nvSpPr>
          <p:cNvPr id="493" name="TextBox 492"/>
          <p:cNvSpPr txBox="1"/>
          <p:nvPr/>
        </p:nvSpPr>
        <p:spPr>
          <a:xfrm>
            <a:off x="905865" y="9271345"/>
            <a:ext cx="804388" cy="230832"/>
          </a:xfrm>
          <a:prstGeom prst="rect">
            <a:avLst/>
          </a:prstGeom>
          <a:noFill/>
        </p:spPr>
        <p:txBody>
          <a:bodyPr wrap="square" rtlCol="0">
            <a:spAutoFit/>
          </a:bodyPr>
          <a:lstStyle/>
          <a:p>
            <a:r>
              <a:rPr lang="en-US" altLang="ko-KR" sz="900" b="1" dirty="0" smtClean="0"/>
              <a:t>Channels</a:t>
            </a:r>
            <a:endParaRPr lang="ko-KR" altLang="en-US" sz="900" b="1" dirty="0"/>
          </a:p>
        </p:txBody>
      </p:sp>
      <p:sp>
        <p:nvSpPr>
          <p:cNvPr id="494" name="아래쪽 화살표 493"/>
          <p:cNvSpPr/>
          <p:nvPr/>
        </p:nvSpPr>
        <p:spPr>
          <a:xfrm>
            <a:off x="1629428" y="8409592"/>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95" name="아래쪽 화살표 494"/>
          <p:cNvSpPr/>
          <p:nvPr/>
        </p:nvSpPr>
        <p:spPr>
          <a:xfrm>
            <a:off x="2825269" y="8409592"/>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96" name="아래쪽 화살표 495"/>
          <p:cNvSpPr/>
          <p:nvPr/>
        </p:nvSpPr>
        <p:spPr>
          <a:xfrm>
            <a:off x="4142571" y="8409592"/>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497" name="TextBox 496"/>
          <p:cNvSpPr txBox="1"/>
          <p:nvPr/>
        </p:nvSpPr>
        <p:spPr>
          <a:xfrm>
            <a:off x="1892544" y="3476897"/>
            <a:ext cx="2295137"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Isobaric chemical tag(TMT) labeling</a:t>
            </a:r>
            <a:endParaRPr lang="ko-KR" altLang="en-US" sz="800" b="1" dirty="0">
              <a:latin typeface="Arial" panose="020B0604020202020204" pitchFamily="34" charset="0"/>
              <a:cs typeface="Arial" panose="020B0604020202020204" pitchFamily="34" charset="0"/>
            </a:endParaRPr>
          </a:p>
        </p:txBody>
      </p:sp>
      <p:sp>
        <p:nvSpPr>
          <p:cNvPr id="498" name="TextBox 497"/>
          <p:cNvSpPr txBox="1"/>
          <p:nvPr/>
        </p:nvSpPr>
        <p:spPr>
          <a:xfrm>
            <a:off x="1882529" y="8967955"/>
            <a:ext cx="2295137"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Isobaric chemical tag(TMT) labeling</a:t>
            </a:r>
            <a:endParaRPr lang="ko-KR" altLang="en-US" sz="800" b="1" dirty="0">
              <a:latin typeface="Arial" panose="020B0604020202020204" pitchFamily="34" charset="0"/>
              <a:cs typeface="Arial" panose="020B0604020202020204" pitchFamily="34" charset="0"/>
            </a:endParaRPr>
          </a:p>
        </p:txBody>
      </p:sp>
      <p:sp>
        <p:nvSpPr>
          <p:cNvPr id="499" name="아래쪽 화살표 498"/>
          <p:cNvSpPr/>
          <p:nvPr/>
        </p:nvSpPr>
        <p:spPr>
          <a:xfrm>
            <a:off x="5899097" y="2943670"/>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00" name="아래쪽 화살표 499"/>
          <p:cNvSpPr/>
          <p:nvPr/>
        </p:nvSpPr>
        <p:spPr>
          <a:xfrm>
            <a:off x="7094937" y="2943670"/>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01" name="아래쪽 화살표 500"/>
          <p:cNvSpPr/>
          <p:nvPr/>
        </p:nvSpPr>
        <p:spPr>
          <a:xfrm>
            <a:off x="8412240" y="2943670"/>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02" name="TextBox 501"/>
          <p:cNvSpPr txBox="1"/>
          <p:nvPr/>
        </p:nvSpPr>
        <p:spPr>
          <a:xfrm>
            <a:off x="6219095" y="3478132"/>
            <a:ext cx="2295137"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Isobaric chemical tag(TMT) labeling</a:t>
            </a:r>
            <a:endParaRPr lang="ko-KR" altLang="en-US" sz="800" b="1" dirty="0">
              <a:latin typeface="Arial" panose="020B0604020202020204" pitchFamily="34" charset="0"/>
              <a:cs typeface="Arial" panose="020B0604020202020204" pitchFamily="34" charset="0"/>
            </a:endParaRPr>
          </a:p>
        </p:txBody>
      </p:sp>
      <p:sp>
        <p:nvSpPr>
          <p:cNvPr id="503" name="직사각형 502"/>
          <p:cNvSpPr/>
          <p:nvPr/>
        </p:nvSpPr>
        <p:spPr>
          <a:xfrm>
            <a:off x="5778376" y="4049160"/>
            <a:ext cx="482011" cy="198382"/>
          </a:xfrm>
          <a:prstGeom prst="rect">
            <a:avLst/>
          </a:prstGeom>
          <a:solidFill>
            <a:schemeClr val="accent2"/>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504" name="TextBox 503"/>
          <p:cNvSpPr txBox="1"/>
          <p:nvPr/>
        </p:nvSpPr>
        <p:spPr>
          <a:xfrm>
            <a:off x="4947942" y="4012385"/>
            <a:ext cx="917766"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sample1)</a:t>
            </a:r>
            <a:endParaRPr lang="ko-KR" altLang="en-US" sz="800" b="1" dirty="0">
              <a:latin typeface="Arial" panose="020B0604020202020204" pitchFamily="34" charset="0"/>
              <a:cs typeface="Arial" panose="020B0604020202020204" pitchFamily="34" charset="0"/>
            </a:endParaRPr>
          </a:p>
        </p:txBody>
      </p:sp>
      <p:sp>
        <p:nvSpPr>
          <p:cNvPr id="505" name="TextBox 504"/>
          <p:cNvSpPr txBox="1"/>
          <p:nvPr/>
        </p:nvSpPr>
        <p:spPr>
          <a:xfrm>
            <a:off x="4954025" y="4372522"/>
            <a:ext cx="897973"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sample2)</a:t>
            </a:r>
            <a:endParaRPr lang="ko-KR" altLang="en-US" sz="800" b="1" dirty="0">
              <a:latin typeface="Arial" panose="020B0604020202020204" pitchFamily="34" charset="0"/>
              <a:cs typeface="Arial" panose="020B0604020202020204" pitchFamily="34" charset="0"/>
            </a:endParaRPr>
          </a:p>
        </p:txBody>
      </p:sp>
      <p:sp>
        <p:nvSpPr>
          <p:cNvPr id="506" name="TextBox 505"/>
          <p:cNvSpPr txBox="1"/>
          <p:nvPr/>
        </p:nvSpPr>
        <p:spPr>
          <a:xfrm>
            <a:off x="4931955" y="4694128"/>
            <a:ext cx="933754"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sample3)</a:t>
            </a:r>
            <a:endParaRPr lang="ko-KR" altLang="en-US" sz="800" b="1" dirty="0">
              <a:latin typeface="Arial" panose="020B0604020202020204" pitchFamily="34" charset="0"/>
              <a:cs typeface="Arial" panose="020B0604020202020204" pitchFamily="34" charset="0"/>
            </a:endParaRPr>
          </a:p>
        </p:txBody>
      </p:sp>
      <p:sp>
        <p:nvSpPr>
          <p:cNvPr id="507" name="직사각형 506"/>
          <p:cNvSpPr/>
          <p:nvPr/>
        </p:nvSpPr>
        <p:spPr>
          <a:xfrm>
            <a:off x="7021913" y="4046041"/>
            <a:ext cx="492035" cy="201384"/>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508" name="직사각형 507"/>
          <p:cNvSpPr/>
          <p:nvPr/>
        </p:nvSpPr>
        <p:spPr>
          <a:xfrm>
            <a:off x="8281335" y="4053870"/>
            <a:ext cx="478957" cy="192487"/>
          </a:xfrm>
          <a:prstGeom prst="rect">
            <a:avLst/>
          </a:prstGeom>
          <a:solidFill>
            <a:schemeClr val="accent6"/>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509" name="직사각형 508"/>
          <p:cNvSpPr/>
          <p:nvPr/>
        </p:nvSpPr>
        <p:spPr>
          <a:xfrm>
            <a:off x="5778376" y="4393569"/>
            <a:ext cx="482011" cy="198382"/>
          </a:xfrm>
          <a:prstGeom prst="rect">
            <a:avLst/>
          </a:prstGeom>
          <a:solidFill>
            <a:srgbClr val="FA2EA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510" name="직사각형 509"/>
          <p:cNvSpPr/>
          <p:nvPr/>
        </p:nvSpPr>
        <p:spPr>
          <a:xfrm>
            <a:off x="7021913" y="4383293"/>
            <a:ext cx="492035" cy="201384"/>
          </a:xfrm>
          <a:prstGeom prst="rect">
            <a:avLst/>
          </a:prstGeom>
          <a:solidFill>
            <a:schemeClr val="accent4">
              <a:lumMod val="75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511" name="직사각형 510"/>
          <p:cNvSpPr/>
          <p:nvPr/>
        </p:nvSpPr>
        <p:spPr>
          <a:xfrm>
            <a:off x="8281335" y="4398280"/>
            <a:ext cx="478957" cy="192487"/>
          </a:xfrm>
          <a:prstGeom prst="rect">
            <a:avLst/>
          </a:prstGeom>
          <a:solidFill>
            <a:srgbClr val="7030A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512" name="직사각형 511"/>
          <p:cNvSpPr/>
          <p:nvPr/>
        </p:nvSpPr>
        <p:spPr>
          <a:xfrm>
            <a:off x="5778376" y="4715567"/>
            <a:ext cx="482011" cy="198382"/>
          </a:xfrm>
          <a:prstGeom prst="rect">
            <a:avLst/>
          </a:prstGeom>
          <a:solidFill>
            <a:schemeClr val="accent3">
              <a:lumMod val="60000"/>
              <a:lumOff val="40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513" name="직사각형 512"/>
          <p:cNvSpPr/>
          <p:nvPr/>
        </p:nvSpPr>
        <p:spPr>
          <a:xfrm>
            <a:off x="7021913" y="4705290"/>
            <a:ext cx="492035" cy="201384"/>
          </a:xfrm>
          <a:prstGeom prst="rect">
            <a:avLst/>
          </a:prstGeom>
          <a:solidFill>
            <a:srgbClr val="FF000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514" name="직사각형 513"/>
          <p:cNvSpPr/>
          <p:nvPr/>
        </p:nvSpPr>
        <p:spPr>
          <a:xfrm>
            <a:off x="8281335" y="4727435"/>
            <a:ext cx="478957" cy="192487"/>
          </a:xfrm>
          <a:prstGeom prst="rect">
            <a:avLst/>
          </a:prstGeom>
          <a:solidFill>
            <a:srgbClr val="19D2F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515" name="TextBox 514"/>
          <p:cNvSpPr txBox="1"/>
          <p:nvPr/>
        </p:nvSpPr>
        <p:spPr>
          <a:xfrm>
            <a:off x="5846672" y="3816654"/>
            <a:ext cx="391342"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6</a:t>
            </a:r>
            <a:endParaRPr lang="ko-KR" altLang="en-US" sz="800" b="1" dirty="0">
              <a:latin typeface="Arial" panose="020B0604020202020204" pitchFamily="34" charset="0"/>
              <a:cs typeface="Arial" panose="020B0604020202020204" pitchFamily="34" charset="0"/>
            </a:endParaRPr>
          </a:p>
        </p:txBody>
      </p:sp>
      <p:sp>
        <p:nvSpPr>
          <p:cNvPr id="516" name="TextBox 515"/>
          <p:cNvSpPr txBox="1"/>
          <p:nvPr/>
        </p:nvSpPr>
        <p:spPr>
          <a:xfrm>
            <a:off x="7063075" y="3806478"/>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7</a:t>
            </a:r>
            <a:endParaRPr lang="ko-KR" altLang="en-US" sz="800" b="1" dirty="0">
              <a:latin typeface="Arial" panose="020B0604020202020204" pitchFamily="34" charset="0"/>
              <a:cs typeface="Arial" panose="020B0604020202020204" pitchFamily="34" charset="0"/>
            </a:endParaRPr>
          </a:p>
        </p:txBody>
      </p:sp>
      <p:sp>
        <p:nvSpPr>
          <p:cNvPr id="517" name="TextBox 516"/>
          <p:cNvSpPr txBox="1"/>
          <p:nvPr/>
        </p:nvSpPr>
        <p:spPr>
          <a:xfrm>
            <a:off x="8361831" y="3812933"/>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8</a:t>
            </a:r>
            <a:endParaRPr lang="ko-KR" altLang="en-US" sz="800" b="1" dirty="0">
              <a:latin typeface="Arial" panose="020B0604020202020204" pitchFamily="34" charset="0"/>
              <a:cs typeface="Arial" panose="020B0604020202020204" pitchFamily="34" charset="0"/>
            </a:endParaRPr>
          </a:p>
        </p:txBody>
      </p:sp>
      <p:sp>
        <p:nvSpPr>
          <p:cNvPr id="518" name="TextBox 517"/>
          <p:cNvSpPr txBox="1"/>
          <p:nvPr/>
        </p:nvSpPr>
        <p:spPr>
          <a:xfrm>
            <a:off x="6204384" y="4025552"/>
            <a:ext cx="917766"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sample1)</a:t>
            </a:r>
            <a:endParaRPr lang="ko-KR" altLang="en-US" sz="800" b="1" dirty="0">
              <a:latin typeface="Arial" panose="020B0604020202020204" pitchFamily="34" charset="0"/>
              <a:cs typeface="Arial" panose="020B0604020202020204" pitchFamily="34" charset="0"/>
            </a:endParaRPr>
          </a:p>
        </p:txBody>
      </p:sp>
      <p:sp>
        <p:nvSpPr>
          <p:cNvPr id="519" name="TextBox 518"/>
          <p:cNvSpPr txBox="1"/>
          <p:nvPr/>
        </p:nvSpPr>
        <p:spPr>
          <a:xfrm>
            <a:off x="6210468" y="4385687"/>
            <a:ext cx="897973"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sample2)</a:t>
            </a:r>
            <a:endParaRPr lang="ko-KR" altLang="en-US" sz="800" b="1" dirty="0">
              <a:latin typeface="Arial" panose="020B0604020202020204" pitchFamily="34" charset="0"/>
              <a:cs typeface="Arial" panose="020B0604020202020204" pitchFamily="34" charset="0"/>
            </a:endParaRPr>
          </a:p>
        </p:txBody>
      </p:sp>
      <p:sp>
        <p:nvSpPr>
          <p:cNvPr id="520" name="TextBox 519"/>
          <p:cNvSpPr txBox="1"/>
          <p:nvPr/>
        </p:nvSpPr>
        <p:spPr>
          <a:xfrm>
            <a:off x="6188397" y="4707292"/>
            <a:ext cx="933754"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sample3)</a:t>
            </a:r>
            <a:endParaRPr lang="ko-KR" altLang="en-US" sz="800" b="1" dirty="0">
              <a:latin typeface="Arial" panose="020B0604020202020204" pitchFamily="34" charset="0"/>
              <a:cs typeface="Arial" panose="020B0604020202020204" pitchFamily="34" charset="0"/>
            </a:endParaRPr>
          </a:p>
        </p:txBody>
      </p:sp>
      <p:sp>
        <p:nvSpPr>
          <p:cNvPr id="521" name="TextBox 520"/>
          <p:cNvSpPr txBox="1"/>
          <p:nvPr/>
        </p:nvSpPr>
        <p:spPr>
          <a:xfrm>
            <a:off x="7452349" y="4039418"/>
            <a:ext cx="917766"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sample1)</a:t>
            </a:r>
            <a:endParaRPr lang="ko-KR" altLang="en-US" sz="800" b="1" dirty="0">
              <a:latin typeface="Arial" panose="020B0604020202020204" pitchFamily="34" charset="0"/>
              <a:cs typeface="Arial" panose="020B0604020202020204" pitchFamily="34" charset="0"/>
            </a:endParaRPr>
          </a:p>
        </p:txBody>
      </p:sp>
      <p:sp>
        <p:nvSpPr>
          <p:cNvPr id="522" name="TextBox 521"/>
          <p:cNvSpPr txBox="1"/>
          <p:nvPr/>
        </p:nvSpPr>
        <p:spPr>
          <a:xfrm>
            <a:off x="7458432" y="4399554"/>
            <a:ext cx="897973"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sample2)</a:t>
            </a:r>
            <a:endParaRPr lang="ko-KR" altLang="en-US" sz="800" b="1" dirty="0">
              <a:latin typeface="Arial" panose="020B0604020202020204" pitchFamily="34" charset="0"/>
              <a:cs typeface="Arial" panose="020B0604020202020204" pitchFamily="34" charset="0"/>
            </a:endParaRPr>
          </a:p>
        </p:txBody>
      </p:sp>
      <p:sp>
        <p:nvSpPr>
          <p:cNvPr id="523" name="TextBox 522"/>
          <p:cNvSpPr txBox="1"/>
          <p:nvPr/>
        </p:nvSpPr>
        <p:spPr>
          <a:xfrm>
            <a:off x="7436362" y="4721161"/>
            <a:ext cx="933754"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sample3)</a:t>
            </a:r>
            <a:endParaRPr lang="ko-KR" altLang="en-US" sz="800" b="1" dirty="0">
              <a:latin typeface="Arial" panose="020B0604020202020204" pitchFamily="34" charset="0"/>
              <a:cs typeface="Arial" panose="020B0604020202020204" pitchFamily="34" charset="0"/>
            </a:endParaRPr>
          </a:p>
        </p:txBody>
      </p:sp>
      <p:sp>
        <p:nvSpPr>
          <p:cNvPr id="524" name="TextBox 523"/>
          <p:cNvSpPr txBox="1"/>
          <p:nvPr/>
        </p:nvSpPr>
        <p:spPr>
          <a:xfrm>
            <a:off x="6324239" y="1911247"/>
            <a:ext cx="907173"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Individual</a:t>
            </a:r>
          </a:p>
          <a:p>
            <a:pPr algn="ctr"/>
            <a:r>
              <a:rPr lang="en-US" altLang="ko-KR" sz="800" b="1" dirty="0" smtClean="0">
                <a:latin typeface="Arial" panose="020B0604020202020204" pitchFamily="34" charset="0"/>
                <a:cs typeface="Arial" panose="020B0604020202020204" pitchFamily="34" charset="0"/>
              </a:rPr>
              <a:t>patients</a:t>
            </a:r>
            <a:endParaRPr lang="ko-KR" altLang="en-US" sz="800" b="1" dirty="0">
              <a:latin typeface="Arial" panose="020B0604020202020204" pitchFamily="34" charset="0"/>
              <a:cs typeface="Arial" panose="020B0604020202020204" pitchFamily="34" charset="0"/>
            </a:endParaRPr>
          </a:p>
        </p:txBody>
      </p:sp>
      <p:sp>
        <p:nvSpPr>
          <p:cNvPr id="525" name="TextBox 524"/>
          <p:cNvSpPr txBox="1"/>
          <p:nvPr/>
        </p:nvSpPr>
        <p:spPr>
          <a:xfrm>
            <a:off x="7682785" y="1905997"/>
            <a:ext cx="879154"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Individual</a:t>
            </a:r>
          </a:p>
          <a:p>
            <a:pPr algn="ctr"/>
            <a:r>
              <a:rPr lang="en-US" altLang="ko-KR" sz="800" b="1" dirty="0" smtClean="0">
                <a:latin typeface="Arial" panose="020B0604020202020204" pitchFamily="34" charset="0"/>
                <a:cs typeface="Arial" panose="020B0604020202020204" pitchFamily="34" charset="0"/>
              </a:rPr>
              <a:t>patients</a:t>
            </a:r>
            <a:endParaRPr lang="ko-KR" altLang="en-US" sz="800" b="1" dirty="0">
              <a:latin typeface="Arial" panose="020B0604020202020204" pitchFamily="34" charset="0"/>
              <a:cs typeface="Arial" panose="020B0604020202020204" pitchFamily="34" charset="0"/>
            </a:endParaRPr>
          </a:p>
        </p:txBody>
      </p:sp>
      <p:sp>
        <p:nvSpPr>
          <p:cNvPr id="526" name="오른쪽 중괄호 525"/>
          <p:cNvSpPr/>
          <p:nvPr/>
        </p:nvSpPr>
        <p:spPr>
          <a:xfrm rot="5400000">
            <a:off x="7139304" y="3662239"/>
            <a:ext cx="215291" cy="2969663"/>
          </a:xfrm>
          <a:prstGeom prst="rightBrace">
            <a:avLst/>
          </a:prstGeom>
          <a:solidFill>
            <a:schemeClr val="tx1"/>
          </a:solid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700"/>
          </a:p>
        </p:txBody>
      </p:sp>
      <p:sp>
        <p:nvSpPr>
          <p:cNvPr id="527" name="TextBox 526"/>
          <p:cNvSpPr txBox="1"/>
          <p:nvPr/>
        </p:nvSpPr>
        <p:spPr>
          <a:xfrm>
            <a:off x="6712803" y="5247928"/>
            <a:ext cx="1256539"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on dis-meta</a:t>
            </a:r>
            <a:endParaRPr lang="ko-KR" altLang="en-US" sz="1200" b="1" dirty="0">
              <a:latin typeface="Arial" panose="020B0604020202020204" pitchFamily="34" charset="0"/>
              <a:cs typeface="Arial" panose="020B0604020202020204" pitchFamily="34" charset="0"/>
            </a:endParaRPr>
          </a:p>
        </p:txBody>
      </p:sp>
      <p:sp>
        <p:nvSpPr>
          <p:cNvPr id="528" name="직사각형 527"/>
          <p:cNvSpPr/>
          <p:nvPr/>
        </p:nvSpPr>
        <p:spPr>
          <a:xfrm>
            <a:off x="5776448" y="9643821"/>
            <a:ext cx="515517" cy="175351"/>
          </a:xfrm>
          <a:prstGeom prst="rect">
            <a:avLst/>
          </a:prstGeom>
          <a:solidFill>
            <a:schemeClr val="accent2">
              <a:lumMod val="60000"/>
              <a:lumOff val="40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529" name="직사각형 528"/>
          <p:cNvSpPr/>
          <p:nvPr/>
        </p:nvSpPr>
        <p:spPr>
          <a:xfrm>
            <a:off x="7043756" y="9666303"/>
            <a:ext cx="535679" cy="175351"/>
          </a:xfrm>
          <a:prstGeom prst="rect">
            <a:avLst/>
          </a:prstGeom>
          <a:solidFill>
            <a:srgbClr val="C0000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530" name="직사각형 529"/>
          <p:cNvSpPr/>
          <p:nvPr/>
        </p:nvSpPr>
        <p:spPr>
          <a:xfrm>
            <a:off x="8389940" y="9662227"/>
            <a:ext cx="535679" cy="175351"/>
          </a:xfrm>
          <a:prstGeom prst="rect">
            <a:avLst/>
          </a:prstGeom>
          <a:solidFill>
            <a:schemeClr val="accent4">
              <a:lumMod val="60000"/>
              <a:lumOff val="40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531" name="직사각형 530"/>
          <p:cNvSpPr/>
          <p:nvPr/>
        </p:nvSpPr>
        <p:spPr>
          <a:xfrm>
            <a:off x="5776448" y="9952441"/>
            <a:ext cx="515517" cy="175351"/>
          </a:xfrm>
          <a:prstGeom prst="rect">
            <a:avLst/>
          </a:prstGeom>
          <a:solidFill>
            <a:schemeClr val="tx2">
              <a:lumMod val="75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532" name="직사각형 531"/>
          <p:cNvSpPr/>
          <p:nvPr/>
        </p:nvSpPr>
        <p:spPr>
          <a:xfrm>
            <a:off x="7043756" y="9974923"/>
            <a:ext cx="535679" cy="175351"/>
          </a:xfrm>
          <a:prstGeom prst="rect">
            <a:avLst/>
          </a:prstGeom>
          <a:solidFill>
            <a:schemeClr val="accent2"/>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533" name="직사각형 532"/>
          <p:cNvSpPr/>
          <p:nvPr/>
        </p:nvSpPr>
        <p:spPr>
          <a:xfrm>
            <a:off x="8389940" y="9970847"/>
            <a:ext cx="535679" cy="175351"/>
          </a:xfrm>
          <a:prstGeom prst="rect">
            <a:avLst/>
          </a:prstGeom>
          <a:solidFill>
            <a:srgbClr val="1F0BB5"/>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534" name="직사각형 533"/>
          <p:cNvSpPr/>
          <p:nvPr/>
        </p:nvSpPr>
        <p:spPr>
          <a:xfrm>
            <a:off x="5776448" y="10260122"/>
            <a:ext cx="515517" cy="175351"/>
          </a:xfrm>
          <a:prstGeom prst="rect">
            <a:avLst/>
          </a:prstGeom>
          <a:solidFill>
            <a:srgbClr val="84EC84"/>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HER2</a:t>
            </a:r>
            <a:endParaRPr lang="ko-KR" altLang="en-US" sz="700" b="1" dirty="0">
              <a:latin typeface="Arial" panose="020B0604020202020204" pitchFamily="34" charset="0"/>
              <a:cs typeface="Arial" panose="020B0604020202020204" pitchFamily="34" charset="0"/>
            </a:endParaRPr>
          </a:p>
        </p:txBody>
      </p:sp>
      <p:sp>
        <p:nvSpPr>
          <p:cNvPr id="535" name="직사각형 534"/>
          <p:cNvSpPr/>
          <p:nvPr/>
        </p:nvSpPr>
        <p:spPr>
          <a:xfrm>
            <a:off x="7043756" y="10282604"/>
            <a:ext cx="535679" cy="175351"/>
          </a:xfrm>
          <a:prstGeom prst="rect">
            <a:avLst/>
          </a:prstGeom>
          <a:solidFill>
            <a:srgbClr val="D9EE1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TNBC</a:t>
            </a:r>
            <a:endParaRPr lang="ko-KR" altLang="en-US" sz="700" b="1" dirty="0">
              <a:latin typeface="Arial" panose="020B0604020202020204" pitchFamily="34" charset="0"/>
              <a:cs typeface="Arial" panose="020B0604020202020204" pitchFamily="34" charset="0"/>
            </a:endParaRPr>
          </a:p>
        </p:txBody>
      </p:sp>
      <p:sp>
        <p:nvSpPr>
          <p:cNvPr id="536" name="직사각형 535"/>
          <p:cNvSpPr/>
          <p:nvPr/>
        </p:nvSpPr>
        <p:spPr>
          <a:xfrm>
            <a:off x="8389940" y="10278528"/>
            <a:ext cx="535679" cy="175351"/>
          </a:xfrm>
          <a:prstGeom prst="rect">
            <a:avLst/>
          </a:prstGeom>
          <a:solidFill>
            <a:srgbClr val="F8AF2C"/>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Lu</a:t>
            </a:r>
            <a:endParaRPr lang="ko-KR" altLang="en-US" sz="700" b="1" dirty="0">
              <a:latin typeface="Arial" panose="020B0604020202020204" pitchFamily="34" charset="0"/>
              <a:cs typeface="Arial" panose="020B0604020202020204" pitchFamily="34" charset="0"/>
            </a:endParaRPr>
          </a:p>
        </p:txBody>
      </p:sp>
      <p:sp>
        <p:nvSpPr>
          <p:cNvPr id="537" name="아래쪽 화살표 536"/>
          <p:cNvSpPr/>
          <p:nvPr/>
        </p:nvSpPr>
        <p:spPr>
          <a:xfrm>
            <a:off x="5969038" y="8343904"/>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38" name="아래쪽 화살표 537"/>
          <p:cNvSpPr/>
          <p:nvPr/>
        </p:nvSpPr>
        <p:spPr>
          <a:xfrm>
            <a:off x="7164879" y="8343904"/>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39" name="아래쪽 화살표 538"/>
          <p:cNvSpPr/>
          <p:nvPr/>
        </p:nvSpPr>
        <p:spPr>
          <a:xfrm>
            <a:off x="8482181" y="8343904"/>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40" name="TextBox 539"/>
          <p:cNvSpPr txBox="1"/>
          <p:nvPr/>
        </p:nvSpPr>
        <p:spPr>
          <a:xfrm>
            <a:off x="6219095" y="8919316"/>
            <a:ext cx="2295137"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Isobaric chemical tag(TMT) labeling</a:t>
            </a:r>
            <a:endParaRPr lang="ko-KR" altLang="en-US" sz="800" b="1" dirty="0">
              <a:latin typeface="Arial" panose="020B0604020202020204" pitchFamily="34" charset="0"/>
              <a:cs typeface="Arial" panose="020B0604020202020204" pitchFamily="34" charset="0"/>
            </a:endParaRPr>
          </a:p>
        </p:txBody>
      </p:sp>
      <p:sp>
        <p:nvSpPr>
          <p:cNvPr id="541" name="TextBox 540"/>
          <p:cNvSpPr txBox="1"/>
          <p:nvPr/>
        </p:nvSpPr>
        <p:spPr>
          <a:xfrm>
            <a:off x="4955326" y="9599102"/>
            <a:ext cx="898054"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sample1)</a:t>
            </a:r>
            <a:endParaRPr lang="ko-KR" altLang="en-US" sz="800" b="1" dirty="0">
              <a:latin typeface="Arial" panose="020B0604020202020204" pitchFamily="34" charset="0"/>
              <a:cs typeface="Arial" panose="020B0604020202020204" pitchFamily="34" charset="0"/>
            </a:endParaRPr>
          </a:p>
        </p:txBody>
      </p:sp>
      <p:sp>
        <p:nvSpPr>
          <p:cNvPr id="542" name="TextBox 541"/>
          <p:cNvSpPr txBox="1"/>
          <p:nvPr/>
        </p:nvSpPr>
        <p:spPr>
          <a:xfrm>
            <a:off x="4960985" y="9926516"/>
            <a:ext cx="878686"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sample2)</a:t>
            </a:r>
            <a:endParaRPr lang="ko-KR" altLang="en-US" sz="800" b="1" dirty="0">
              <a:latin typeface="Arial" panose="020B0604020202020204" pitchFamily="34" charset="0"/>
              <a:cs typeface="Arial" panose="020B0604020202020204" pitchFamily="34" charset="0"/>
            </a:endParaRPr>
          </a:p>
        </p:txBody>
      </p:sp>
      <p:sp>
        <p:nvSpPr>
          <p:cNvPr id="543" name="TextBox 542"/>
          <p:cNvSpPr txBox="1"/>
          <p:nvPr/>
        </p:nvSpPr>
        <p:spPr>
          <a:xfrm>
            <a:off x="4939683" y="10237214"/>
            <a:ext cx="91369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sample3)</a:t>
            </a:r>
            <a:endParaRPr lang="ko-KR" altLang="en-US" sz="800" b="1" dirty="0">
              <a:latin typeface="Arial" panose="020B0604020202020204" pitchFamily="34" charset="0"/>
              <a:cs typeface="Arial" panose="020B0604020202020204" pitchFamily="34" charset="0"/>
            </a:endParaRPr>
          </a:p>
        </p:txBody>
      </p:sp>
      <p:sp>
        <p:nvSpPr>
          <p:cNvPr id="544" name="TextBox 543"/>
          <p:cNvSpPr txBox="1"/>
          <p:nvPr/>
        </p:nvSpPr>
        <p:spPr>
          <a:xfrm>
            <a:off x="6239653" y="9629684"/>
            <a:ext cx="898054"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sample1)</a:t>
            </a:r>
            <a:endParaRPr lang="ko-KR" altLang="en-US" sz="800" b="1" dirty="0">
              <a:latin typeface="Arial" panose="020B0604020202020204" pitchFamily="34" charset="0"/>
              <a:cs typeface="Arial" panose="020B0604020202020204" pitchFamily="34" charset="0"/>
            </a:endParaRPr>
          </a:p>
        </p:txBody>
      </p:sp>
      <p:sp>
        <p:nvSpPr>
          <p:cNvPr id="545" name="TextBox 544"/>
          <p:cNvSpPr txBox="1"/>
          <p:nvPr/>
        </p:nvSpPr>
        <p:spPr>
          <a:xfrm>
            <a:off x="6245312" y="9957099"/>
            <a:ext cx="878686"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sample2)</a:t>
            </a:r>
            <a:endParaRPr lang="ko-KR" altLang="en-US" sz="800" b="1" dirty="0">
              <a:latin typeface="Arial" panose="020B0604020202020204" pitchFamily="34" charset="0"/>
              <a:cs typeface="Arial" panose="020B0604020202020204" pitchFamily="34" charset="0"/>
            </a:endParaRPr>
          </a:p>
        </p:txBody>
      </p:sp>
      <p:sp>
        <p:nvSpPr>
          <p:cNvPr id="546" name="TextBox 545"/>
          <p:cNvSpPr txBox="1"/>
          <p:nvPr/>
        </p:nvSpPr>
        <p:spPr>
          <a:xfrm>
            <a:off x="6234417" y="10267797"/>
            <a:ext cx="91369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sample3)</a:t>
            </a:r>
            <a:endParaRPr lang="ko-KR" altLang="en-US" sz="800" b="1" dirty="0">
              <a:latin typeface="Arial" panose="020B0604020202020204" pitchFamily="34" charset="0"/>
              <a:cs typeface="Arial" panose="020B0604020202020204" pitchFamily="34" charset="0"/>
            </a:endParaRPr>
          </a:p>
        </p:txBody>
      </p:sp>
      <p:sp>
        <p:nvSpPr>
          <p:cNvPr id="547" name="TextBox 546"/>
          <p:cNvSpPr txBox="1"/>
          <p:nvPr/>
        </p:nvSpPr>
        <p:spPr>
          <a:xfrm>
            <a:off x="7567447" y="9629593"/>
            <a:ext cx="898054"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1(sample1)</a:t>
            </a:r>
            <a:endParaRPr lang="ko-KR" altLang="en-US" sz="800" b="1" dirty="0">
              <a:latin typeface="Arial" panose="020B0604020202020204" pitchFamily="34" charset="0"/>
              <a:cs typeface="Arial" panose="020B0604020202020204" pitchFamily="34" charset="0"/>
            </a:endParaRPr>
          </a:p>
        </p:txBody>
      </p:sp>
      <p:sp>
        <p:nvSpPr>
          <p:cNvPr id="548" name="TextBox 547"/>
          <p:cNvSpPr txBox="1"/>
          <p:nvPr/>
        </p:nvSpPr>
        <p:spPr>
          <a:xfrm>
            <a:off x="7562700" y="9935193"/>
            <a:ext cx="878686"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2(sample2)</a:t>
            </a:r>
            <a:endParaRPr lang="ko-KR" altLang="en-US" sz="800" b="1" dirty="0">
              <a:latin typeface="Arial" panose="020B0604020202020204" pitchFamily="34" charset="0"/>
              <a:cs typeface="Arial" panose="020B0604020202020204" pitchFamily="34" charset="0"/>
            </a:endParaRPr>
          </a:p>
        </p:txBody>
      </p:sp>
      <p:sp>
        <p:nvSpPr>
          <p:cNvPr id="549" name="TextBox 548"/>
          <p:cNvSpPr txBox="1"/>
          <p:nvPr/>
        </p:nvSpPr>
        <p:spPr>
          <a:xfrm>
            <a:off x="7562211" y="10256799"/>
            <a:ext cx="913698"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Set3(sample3)</a:t>
            </a:r>
            <a:endParaRPr lang="ko-KR" altLang="en-US" sz="800" b="1" dirty="0">
              <a:latin typeface="Arial" panose="020B0604020202020204" pitchFamily="34" charset="0"/>
              <a:cs typeface="Arial" panose="020B0604020202020204" pitchFamily="34" charset="0"/>
            </a:endParaRPr>
          </a:p>
        </p:txBody>
      </p:sp>
      <p:sp>
        <p:nvSpPr>
          <p:cNvPr id="550" name="오른쪽 중괄호 549"/>
          <p:cNvSpPr/>
          <p:nvPr/>
        </p:nvSpPr>
        <p:spPr>
          <a:xfrm rot="5400000">
            <a:off x="7152696" y="9265464"/>
            <a:ext cx="224614" cy="3007231"/>
          </a:xfrm>
          <a:prstGeom prst="rightBrace">
            <a:avLst/>
          </a:prstGeom>
          <a:solidFill>
            <a:schemeClr val="tx1"/>
          </a:solid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700"/>
          </a:p>
        </p:txBody>
      </p:sp>
      <p:sp>
        <p:nvSpPr>
          <p:cNvPr id="551" name="TextBox 550"/>
          <p:cNvSpPr txBox="1"/>
          <p:nvPr/>
        </p:nvSpPr>
        <p:spPr>
          <a:xfrm>
            <a:off x="6670364" y="10931796"/>
            <a:ext cx="1168171" cy="276999"/>
          </a:xfrm>
          <a:prstGeom prst="rect">
            <a:avLst/>
          </a:prstGeom>
          <a:noFill/>
        </p:spPr>
        <p:txBody>
          <a:bodyPr wrap="square" rtlCol="0">
            <a:spAutoFit/>
          </a:bodyPr>
          <a:lstStyle/>
          <a:p>
            <a:pPr algn="ctr"/>
            <a:r>
              <a:rPr lang="en-US" altLang="ko-KR" sz="1200" b="1" dirty="0">
                <a:latin typeface="Arial" panose="020B0604020202020204" pitchFamily="34" charset="0"/>
                <a:cs typeface="Arial" panose="020B0604020202020204" pitchFamily="34" charset="0"/>
              </a:rPr>
              <a:t>D</a:t>
            </a:r>
            <a:r>
              <a:rPr lang="en-US" altLang="ko-KR" sz="1200" b="1" dirty="0" smtClean="0">
                <a:latin typeface="Arial" panose="020B0604020202020204" pitchFamily="34" charset="0"/>
                <a:cs typeface="Arial" panose="020B0604020202020204" pitchFamily="34" charset="0"/>
              </a:rPr>
              <a:t>is-meta</a:t>
            </a:r>
            <a:endParaRPr lang="ko-KR" altLang="en-US" sz="1200" b="1" dirty="0">
              <a:latin typeface="Arial" panose="020B0604020202020204" pitchFamily="34" charset="0"/>
              <a:cs typeface="Arial" panose="020B0604020202020204" pitchFamily="34" charset="0"/>
            </a:endParaRPr>
          </a:p>
        </p:txBody>
      </p:sp>
      <p:sp>
        <p:nvSpPr>
          <p:cNvPr id="552" name="TextBox 551"/>
          <p:cNvSpPr txBox="1"/>
          <p:nvPr/>
        </p:nvSpPr>
        <p:spPr>
          <a:xfrm>
            <a:off x="5859077" y="9361550"/>
            <a:ext cx="391342" cy="200055"/>
          </a:xfrm>
          <a:prstGeom prst="rect">
            <a:avLst/>
          </a:prstGeom>
          <a:noFill/>
        </p:spPr>
        <p:txBody>
          <a:bodyPr wrap="square" rtlCol="0">
            <a:spAutoFit/>
          </a:bodyPr>
          <a:lstStyle/>
          <a:p>
            <a:r>
              <a:rPr lang="en-US" altLang="ko-KR" sz="700" b="1" dirty="0" smtClean="0">
                <a:latin typeface="Arial" panose="020B0604020202020204" pitchFamily="34" charset="0"/>
                <a:cs typeface="Arial" panose="020B0604020202020204" pitchFamily="34" charset="0"/>
              </a:rPr>
              <a:t>129</a:t>
            </a:r>
            <a:endParaRPr lang="ko-KR" altLang="en-US" sz="700" b="1" dirty="0">
              <a:latin typeface="Arial" panose="020B0604020202020204" pitchFamily="34" charset="0"/>
              <a:cs typeface="Arial" panose="020B0604020202020204" pitchFamily="34" charset="0"/>
            </a:endParaRPr>
          </a:p>
        </p:txBody>
      </p:sp>
      <p:sp>
        <p:nvSpPr>
          <p:cNvPr id="553" name="TextBox 552"/>
          <p:cNvSpPr txBox="1"/>
          <p:nvPr/>
        </p:nvSpPr>
        <p:spPr>
          <a:xfrm>
            <a:off x="7122594" y="9386915"/>
            <a:ext cx="359585" cy="200055"/>
          </a:xfrm>
          <a:prstGeom prst="rect">
            <a:avLst/>
          </a:prstGeom>
          <a:noFill/>
        </p:spPr>
        <p:txBody>
          <a:bodyPr wrap="square" rtlCol="0">
            <a:spAutoFit/>
          </a:bodyPr>
          <a:lstStyle/>
          <a:p>
            <a:r>
              <a:rPr lang="en-US" altLang="ko-KR" sz="700" b="1" dirty="0" smtClean="0">
                <a:latin typeface="Arial" panose="020B0604020202020204" pitchFamily="34" charset="0"/>
                <a:cs typeface="Arial" panose="020B0604020202020204" pitchFamily="34" charset="0"/>
              </a:rPr>
              <a:t>130</a:t>
            </a:r>
            <a:endParaRPr lang="ko-KR" altLang="en-US" sz="700" b="1" dirty="0">
              <a:latin typeface="Arial" panose="020B0604020202020204" pitchFamily="34" charset="0"/>
              <a:cs typeface="Arial" panose="020B0604020202020204" pitchFamily="34" charset="0"/>
            </a:endParaRPr>
          </a:p>
        </p:txBody>
      </p:sp>
      <p:sp>
        <p:nvSpPr>
          <p:cNvPr id="554" name="TextBox 553"/>
          <p:cNvSpPr txBox="1"/>
          <p:nvPr/>
        </p:nvSpPr>
        <p:spPr>
          <a:xfrm>
            <a:off x="8489890" y="9370098"/>
            <a:ext cx="359585" cy="200055"/>
          </a:xfrm>
          <a:prstGeom prst="rect">
            <a:avLst/>
          </a:prstGeom>
          <a:noFill/>
        </p:spPr>
        <p:txBody>
          <a:bodyPr wrap="square" rtlCol="0">
            <a:spAutoFit/>
          </a:bodyPr>
          <a:lstStyle/>
          <a:p>
            <a:r>
              <a:rPr lang="en-US" altLang="ko-KR" sz="700" b="1" dirty="0" smtClean="0">
                <a:latin typeface="Arial" panose="020B0604020202020204" pitchFamily="34" charset="0"/>
                <a:cs typeface="Arial" panose="020B0604020202020204" pitchFamily="34" charset="0"/>
              </a:rPr>
              <a:t>131</a:t>
            </a:r>
            <a:endParaRPr lang="ko-KR" altLang="en-US" sz="700" b="1" dirty="0">
              <a:latin typeface="Arial" panose="020B0604020202020204" pitchFamily="34" charset="0"/>
              <a:cs typeface="Arial" panose="020B0604020202020204" pitchFamily="34" charset="0"/>
            </a:endParaRPr>
          </a:p>
        </p:txBody>
      </p:sp>
      <p:sp>
        <p:nvSpPr>
          <p:cNvPr id="555" name="TextBox 554"/>
          <p:cNvSpPr txBox="1"/>
          <p:nvPr/>
        </p:nvSpPr>
        <p:spPr>
          <a:xfrm>
            <a:off x="5046850" y="9278680"/>
            <a:ext cx="804388" cy="230832"/>
          </a:xfrm>
          <a:prstGeom prst="rect">
            <a:avLst/>
          </a:prstGeom>
          <a:noFill/>
        </p:spPr>
        <p:txBody>
          <a:bodyPr wrap="square" rtlCol="0">
            <a:spAutoFit/>
          </a:bodyPr>
          <a:lstStyle/>
          <a:p>
            <a:r>
              <a:rPr lang="en-US" altLang="ko-KR" sz="900" b="1" dirty="0" smtClean="0"/>
              <a:t>Channels</a:t>
            </a:r>
            <a:endParaRPr lang="ko-KR" altLang="en-US" sz="900" b="1" dirty="0"/>
          </a:p>
        </p:txBody>
      </p:sp>
      <p:sp>
        <p:nvSpPr>
          <p:cNvPr id="556" name="직사각형 555"/>
          <p:cNvSpPr/>
          <p:nvPr/>
        </p:nvSpPr>
        <p:spPr>
          <a:xfrm>
            <a:off x="9392041" y="279019"/>
            <a:ext cx="3912225" cy="322987"/>
          </a:xfrm>
          <a:prstGeom prst="rect">
            <a:avLst/>
          </a:prstGeom>
          <a:solidFill>
            <a:srgbClr val="92D05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200" b="1" dirty="0" smtClean="0">
                <a:latin typeface="Arial" panose="020B0604020202020204" pitchFamily="34" charset="0"/>
                <a:cs typeface="Arial" panose="020B0604020202020204" pitchFamily="34" charset="0"/>
              </a:rPr>
              <a:t>BC cell lines TMT</a:t>
            </a:r>
            <a:endParaRPr lang="ko-KR" altLang="en-US" sz="1200" b="1" dirty="0">
              <a:latin typeface="Arial" panose="020B0604020202020204" pitchFamily="34" charset="0"/>
              <a:cs typeface="Arial" panose="020B0604020202020204" pitchFamily="34" charset="0"/>
            </a:endParaRPr>
          </a:p>
        </p:txBody>
      </p:sp>
      <p:sp>
        <p:nvSpPr>
          <p:cNvPr id="557" name="TextBox 556"/>
          <p:cNvSpPr txBox="1"/>
          <p:nvPr/>
        </p:nvSpPr>
        <p:spPr>
          <a:xfrm>
            <a:off x="1930493" y="1940094"/>
            <a:ext cx="932740" cy="21544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Pooled sample</a:t>
            </a:r>
            <a:endParaRPr lang="ko-KR" altLang="en-US" sz="800" b="1" dirty="0">
              <a:latin typeface="Arial" panose="020B0604020202020204" pitchFamily="34" charset="0"/>
              <a:cs typeface="Arial" panose="020B0604020202020204" pitchFamily="34" charset="0"/>
            </a:endParaRPr>
          </a:p>
        </p:txBody>
      </p:sp>
      <p:sp>
        <p:nvSpPr>
          <p:cNvPr id="558" name="TextBox 557"/>
          <p:cNvSpPr txBox="1"/>
          <p:nvPr/>
        </p:nvSpPr>
        <p:spPr>
          <a:xfrm>
            <a:off x="3276769" y="1938703"/>
            <a:ext cx="932740" cy="21544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Pooled sample</a:t>
            </a:r>
            <a:endParaRPr lang="ko-KR" altLang="en-US" sz="800" b="1" dirty="0">
              <a:latin typeface="Arial" panose="020B0604020202020204" pitchFamily="34" charset="0"/>
              <a:cs typeface="Arial" panose="020B0604020202020204" pitchFamily="34" charset="0"/>
            </a:endParaRPr>
          </a:p>
        </p:txBody>
      </p:sp>
      <p:pic>
        <p:nvPicPr>
          <p:cNvPr id="559" name="그림 558"/>
          <p:cNvPicPr>
            <a:picLocks noChangeAspect="1"/>
          </p:cNvPicPr>
          <p:nvPr/>
        </p:nvPicPr>
        <p:blipFill>
          <a:blip r:embed="rId7"/>
          <a:stretch>
            <a:fillRect/>
          </a:stretch>
        </p:blipFill>
        <p:spPr>
          <a:xfrm>
            <a:off x="1526482" y="2274228"/>
            <a:ext cx="225421" cy="583778"/>
          </a:xfrm>
          <a:prstGeom prst="rect">
            <a:avLst/>
          </a:prstGeom>
        </p:spPr>
      </p:pic>
      <p:pic>
        <p:nvPicPr>
          <p:cNvPr id="560" name="그림 559"/>
          <p:cNvPicPr>
            <a:picLocks noChangeAspect="1"/>
          </p:cNvPicPr>
          <p:nvPr/>
        </p:nvPicPr>
        <p:blipFill>
          <a:blip r:embed="rId7"/>
          <a:stretch>
            <a:fillRect/>
          </a:stretch>
        </p:blipFill>
        <p:spPr>
          <a:xfrm>
            <a:off x="1781176" y="2268635"/>
            <a:ext cx="225421" cy="583778"/>
          </a:xfrm>
          <a:prstGeom prst="rect">
            <a:avLst/>
          </a:prstGeom>
        </p:spPr>
      </p:pic>
      <p:pic>
        <p:nvPicPr>
          <p:cNvPr id="561" name="그림 560"/>
          <p:cNvPicPr>
            <a:picLocks noChangeAspect="1"/>
          </p:cNvPicPr>
          <p:nvPr/>
        </p:nvPicPr>
        <p:blipFill>
          <a:blip r:embed="rId7"/>
          <a:stretch>
            <a:fillRect/>
          </a:stretch>
        </p:blipFill>
        <p:spPr>
          <a:xfrm>
            <a:off x="2462193" y="2295312"/>
            <a:ext cx="225421" cy="583778"/>
          </a:xfrm>
          <a:prstGeom prst="rect">
            <a:avLst/>
          </a:prstGeom>
        </p:spPr>
      </p:pic>
      <p:pic>
        <p:nvPicPr>
          <p:cNvPr id="562" name="그림 561"/>
          <p:cNvPicPr>
            <a:picLocks noChangeAspect="1"/>
          </p:cNvPicPr>
          <p:nvPr/>
        </p:nvPicPr>
        <p:blipFill>
          <a:blip r:embed="rId7"/>
          <a:stretch>
            <a:fillRect/>
          </a:stretch>
        </p:blipFill>
        <p:spPr>
          <a:xfrm>
            <a:off x="2716530" y="2300905"/>
            <a:ext cx="225421" cy="583778"/>
          </a:xfrm>
          <a:prstGeom prst="rect">
            <a:avLst/>
          </a:prstGeom>
        </p:spPr>
      </p:pic>
      <p:pic>
        <p:nvPicPr>
          <p:cNvPr id="563" name="그림 562"/>
          <p:cNvPicPr>
            <a:picLocks noChangeAspect="1"/>
          </p:cNvPicPr>
          <p:nvPr/>
        </p:nvPicPr>
        <p:blipFill>
          <a:blip r:embed="rId7"/>
          <a:stretch>
            <a:fillRect/>
          </a:stretch>
        </p:blipFill>
        <p:spPr>
          <a:xfrm>
            <a:off x="2971225" y="2295312"/>
            <a:ext cx="225421" cy="583778"/>
          </a:xfrm>
          <a:prstGeom prst="rect">
            <a:avLst/>
          </a:prstGeom>
        </p:spPr>
      </p:pic>
      <p:pic>
        <p:nvPicPr>
          <p:cNvPr id="564" name="그림 563"/>
          <p:cNvPicPr>
            <a:picLocks noChangeAspect="1"/>
          </p:cNvPicPr>
          <p:nvPr/>
        </p:nvPicPr>
        <p:blipFill>
          <a:blip r:embed="rId7"/>
          <a:stretch>
            <a:fillRect/>
          </a:stretch>
        </p:blipFill>
        <p:spPr>
          <a:xfrm>
            <a:off x="3784852" y="2286635"/>
            <a:ext cx="225421" cy="583778"/>
          </a:xfrm>
          <a:prstGeom prst="rect">
            <a:avLst/>
          </a:prstGeom>
        </p:spPr>
      </p:pic>
      <p:pic>
        <p:nvPicPr>
          <p:cNvPr id="565" name="그림 564"/>
          <p:cNvPicPr>
            <a:picLocks noChangeAspect="1"/>
          </p:cNvPicPr>
          <p:nvPr/>
        </p:nvPicPr>
        <p:blipFill>
          <a:blip r:embed="rId7"/>
          <a:stretch>
            <a:fillRect/>
          </a:stretch>
        </p:blipFill>
        <p:spPr>
          <a:xfrm>
            <a:off x="4039189" y="2292229"/>
            <a:ext cx="225421" cy="583778"/>
          </a:xfrm>
          <a:prstGeom prst="rect">
            <a:avLst/>
          </a:prstGeom>
        </p:spPr>
      </p:pic>
      <p:pic>
        <p:nvPicPr>
          <p:cNvPr id="566" name="그림 565"/>
          <p:cNvPicPr>
            <a:picLocks noChangeAspect="1"/>
          </p:cNvPicPr>
          <p:nvPr/>
        </p:nvPicPr>
        <p:blipFill>
          <a:blip r:embed="rId7"/>
          <a:stretch>
            <a:fillRect/>
          </a:stretch>
        </p:blipFill>
        <p:spPr>
          <a:xfrm>
            <a:off x="4293884" y="2286635"/>
            <a:ext cx="225421" cy="583778"/>
          </a:xfrm>
          <a:prstGeom prst="rect">
            <a:avLst/>
          </a:prstGeom>
        </p:spPr>
      </p:pic>
      <p:sp>
        <p:nvSpPr>
          <p:cNvPr id="567" name="TextBox 566"/>
          <p:cNvSpPr txBox="1"/>
          <p:nvPr/>
        </p:nvSpPr>
        <p:spPr>
          <a:xfrm>
            <a:off x="5183045" y="7278599"/>
            <a:ext cx="880540"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Individual</a:t>
            </a:r>
          </a:p>
          <a:p>
            <a:pPr algn="ctr"/>
            <a:r>
              <a:rPr lang="en-US" altLang="ko-KR" sz="800" b="1" dirty="0" smtClean="0">
                <a:latin typeface="Arial" panose="020B0604020202020204" pitchFamily="34" charset="0"/>
                <a:cs typeface="Arial" panose="020B0604020202020204" pitchFamily="34" charset="0"/>
              </a:rPr>
              <a:t>patients</a:t>
            </a:r>
            <a:endParaRPr lang="ko-KR" altLang="en-US" sz="800" b="1" dirty="0">
              <a:latin typeface="Arial" panose="020B0604020202020204" pitchFamily="34" charset="0"/>
              <a:cs typeface="Arial" panose="020B0604020202020204" pitchFamily="34" charset="0"/>
            </a:endParaRPr>
          </a:p>
        </p:txBody>
      </p:sp>
      <p:sp>
        <p:nvSpPr>
          <p:cNvPr id="568" name="TextBox 567"/>
          <p:cNvSpPr txBox="1"/>
          <p:nvPr/>
        </p:nvSpPr>
        <p:spPr>
          <a:xfrm>
            <a:off x="6410045" y="7284816"/>
            <a:ext cx="907173"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Individual</a:t>
            </a:r>
          </a:p>
          <a:p>
            <a:pPr algn="ctr"/>
            <a:r>
              <a:rPr lang="en-US" altLang="ko-KR" sz="800" b="1" dirty="0" smtClean="0">
                <a:latin typeface="Arial" panose="020B0604020202020204" pitchFamily="34" charset="0"/>
                <a:cs typeface="Arial" panose="020B0604020202020204" pitchFamily="34" charset="0"/>
              </a:rPr>
              <a:t>patients</a:t>
            </a:r>
            <a:endParaRPr lang="ko-KR" altLang="en-US" sz="800" b="1" dirty="0">
              <a:latin typeface="Arial" panose="020B0604020202020204" pitchFamily="34" charset="0"/>
              <a:cs typeface="Arial" panose="020B0604020202020204" pitchFamily="34" charset="0"/>
            </a:endParaRPr>
          </a:p>
        </p:txBody>
      </p:sp>
      <p:sp>
        <p:nvSpPr>
          <p:cNvPr id="569" name="TextBox 568"/>
          <p:cNvSpPr txBox="1"/>
          <p:nvPr/>
        </p:nvSpPr>
        <p:spPr>
          <a:xfrm>
            <a:off x="7700732" y="7319451"/>
            <a:ext cx="879154"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Individual</a:t>
            </a:r>
          </a:p>
          <a:p>
            <a:pPr algn="ctr"/>
            <a:r>
              <a:rPr lang="en-US" altLang="ko-KR" sz="800" b="1" dirty="0" smtClean="0">
                <a:latin typeface="Arial" panose="020B0604020202020204" pitchFamily="34" charset="0"/>
                <a:cs typeface="Arial" panose="020B0604020202020204" pitchFamily="34" charset="0"/>
              </a:rPr>
              <a:t>patients</a:t>
            </a:r>
            <a:endParaRPr lang="ko-KR" altLang="en-US" sz="800" b="1" dirty="0">
              <a:latin typeface="Arial" panose="020B0604020202020204" pitchFamily="34" charset="0"/>
              <a:cs typeface="Arial" panose="020B0604020202020204" pitchFamily="34" charset="0"/>
            </a:endParaRPr>
          </a:p>
        </p:txBody>
      </p:sp>
      <p:sp>
        <p:nvSpPr>
          <p:cNvPr id="570" name="TextBox 569"/>
          <p:cNvSpPr txBox="1"/>
          <p:nvPr/>
        </p:nvSpPr>
        <p:spPr>
          <a:xfrm>
            <a:off x="750370" y="7378066"/>
            <a:ext cx="971086" cy="21544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Pooled samples</a:t>
            </a:r>
            <a:endParaRPr lang="ko-KR" altLang="en-US" sz="800" b="1" dirty="0">
              <a:latin typeface="Arial" panose="020B0604020202020204" pitchFamily="34" charset="0"/>
              <a:cs typeface="Arial" panose="020B0604020202020204" pitchFamily="34" charset="0"/>
            </a:endParaRPr>
          </a:p>
        </p:txBody>
      </p:sp>
      <p:sp>
        <p:nvSpPr>
          <p:cNvPr id="571" name="TextBox 570"/>
          <p:cNvSpPr txBox="1"/>
          <p:nvPr/>
        </p:nvSpPr>
        <p:spPr>
          <a:xfrm>
            <a:off x="1824553" y="7356335"/>
            <a:ext cx="1191326" cy="21544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Pooled samples</a:t>
            </a:r>
            <a:endParaRPr lang="ko-KR" altLang="en-US" sz="800" b="1" dirty="0">
              <a:latin typeface="Arial" panose="020B0604020202020204" pitchFamily="34" charset="0"/>
              <a:cs typeface="Arial" panose="020B0604020202020204" pitchFamily="34" charset="0"/>
            </a:endParaRPr>
          </a:p>
        </p:txBody>
      </p:sp>
      <p:sp>
        <p:nvSpPr>
          <p:cNvPr id="572" name="TextBox 571"/>
          <p:cNvSpPr txBox="1"/>
          <p:nvPr/>
        </p:nvSpPr>
        <p:spPr>
          <a:xfrm>
            <a:off x="3200370" y="7373724"/>
            <a:ext cx="1083326" cy="21544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Pooled samples</a:t>
            </a:r>
            <a:endParaRPr lang="ko-KR" altLang="en-US" sz="800" b="1" dirty="0">
              <a:latin typeface="Arial" panose="020B0604020202020204" pitchFamily="34" charset="0"/>
              <a:cs typeface="Arial" panose="020B0604020202020204" pitchFamily="34" charset="0"/>
            </a:endParaRPr>
          </a:p>
        </p:txBody>
      </p:sp>
      <p:pic>
        <p:nvPicPr>
          <p:cNvPr id="573" name="그림 572"/>
          <p:cNvPicPr>
            <a:picLocks noChangeAspect="1"/>
          </p:cNvPicPr>
          <p:nvPr/>
        </p:nvPicPr>
        <p:blipFill>
          <a:blip r:embed="rId7"/>
          <a:stretch>
            <a:fillRect/>
          </a:stretch>
        </p:blipFill>
        <p:spPr>
          <a:xfrm>
            <a:off x="1308059" y="7706530"/>
            <a:ext cx="225421" cy="583778"/>
          </a:xfrm>
          <a:prstGeom prst="rect">
            <a:avLst/>
          </a:prstGeom>
        </p:spPr>
      </p:pic>
      <p:pic>
        <p:nvPicPr>
          <p:cNvPr id="574" name="그림 573"/>
          <p:cNvPicPr>
            <a:picLocks noChangeAspect="1"/>
          </p:cNvPicPr>
          <p:nvPr/>
        </p:nvPicPr>
        <p:blipFill>
          <a:blip r:embed="rId7"/>
          <a:stretch>
            <a:fillRect/>
          </a:stretch>
        </p:blipFill>
        <p:spPr>
          <a:xfrm>
            <a:off x="1562396" y="7712124"/>
            <a:ext cx="225421" cy="583778"/>
          </a:xfrm>
          <a:prstGeom prst="rect">
            <a:avLst/>
          </a:prstGeom>
        </p:spPr>
      </p:pic>
      <p:pic>
        <p:nvPicPr>
          <p:cNvPr id="575" name="그림 574"/>
          <p:cNvPicPr>
            <a:picLocks noChangeAspect="1"/>
          </p:cNvPicPr>
          <p:nvPr/>
        </p:nvPicPr>
        <p:blipFill>
          <a:blip r:embed="rId7"/>
          <a:stretch>
            <a:fillRect/>
          </a:stretch>
        </p:blipFill>
        <p:spPr>
          <a:xfrm>
            <a:off x="1817091" y="7706530"/>
            <a:ext cx="225421" cy="583778"/>
          </a:xfrm>
          <a:prstGeom prst="rect">
            <a:avLst/>
          </a:prstGeom>
        </p:spPr>
      </p:pic>
      <p:pic>
        <p:nvPicPr>
          <p:cNvPr id="576" name="그림 575"/>
          <p:cNvPicPr>
            <a:picLocks noChangeAspect="1"/>
          </p:cNvPicPr>
          <p:nvPr/>
        </p:nvPicPr>
        <p:blipFill>
          <a:blip r:embed="rId7"/>
          <a:stretch>
            <a:fillRect/>
          </a:stretch>
        </p:blipFill>
        <p:spPr>
          <a:xfrm>
            <a:off x="2498108" y="7733208"/>
            <a:ext cx="225421" cy="583778"/>
          </a:xfrm>
          <a:prstGeom prst="rect">
            <a:avLst/>
          </a:prstGeom>
        </p:spPr>
      </p:pic>
      <p:pic>
        <p:nvPicPr>
          <p:cNvPr id="577" name="그림 576"/>
          <p:cNvPicPr>
            <a:picLocks noChangeAspect="1"/>
          </p:cNvPicPr>
          <p:nvPr/>
        </p:nvPicPr>
        <p:blipFill>
          <a:blip r:embed="rId7"/>
          <a:stretch>
            <a:fillRect/>
          </a:stretch>
        </p:blipFill>
        <p:spPr>
          <a:xfrm>
            <a:off x="2752445" y="7738801"/>
            <a:ext cx="225421" cy="583778"/>
          </a:xfrm>
          <a:prstGeom prst="rect">
            <a:avLst/>
          </a:prstGeom>
        </p:spPr>
      </p:pic>
      <p:pic>
        <p:nvPicPr>
          <p:cNvPr id="578" name="그림 577"/>
          <p:cNvPicPr>
            <a:picLocks noChangeAspect="1"/>
          </p:cNvPicPr>
          <p:nvPr/>
        </p:nvPicPr>
        <p:blipFill>
          <a:blip r:embed="rId7"/>
          <a:stretch>
            <a:fillRect/>
          </a:stretch>
        </p:blipFill>
        <p:spPr>
          <a:xfrm>
            <a:off x="3007139" y="7733208"/>
            <a:ext cx="225421" cy="583778"/>
          </a:xfrm>
          <a:prstGeom prst="rect">
            <a:avLst/>
          </a:prstGeom>
        </p:spPr>
      </p:pic>
      <p:pic>
        <p:nvPicPr>
          <p:cNvPr id="579" name="그림 578"/>
          <p:cNvPicPr>
            <a:picLocks noChangeAspect="1"/>
          </p:cNvPicPr>
          <p:nvPr/>
        </p:nvPicPr>
        <p:blipFill>
          <a:blip r:embed="rId7"/>
          <a:stretch>
            <a:fillRect/>
          </a:stretch>
        </p:blipFill>
        <p:spPr>
          <a:xfrm>
            <a:off x="3820766" y="7724531"/>
            <a:ext cx="225421" cy="583778"/>
          </a:xfrm>
          <a:prstGeom prst="rect">
            <a:avLst/>
          </a:prstGeom>
        </p:spPr>
      </p:pic>
      <p:pic>
        <p:nvPicPr>
          <p:cNvPr id="580" name="그림 579"/>
          <p:cNvPicPr>
            <a:picLocks noChangeAspect="1"/>
          </p:cNvPicPr>
          <p:nvPr/>
        </p:nvPicPr>
        <p:blipFill>
          <a:blip r:embed="rId7"/>
          <a:stretch>
            <a:fillRect/>
          </a:stretch>
        </p:blipFill>
        <p:spPr>
          <a:xfrm>
            <a:off x="4075104" y="7730124"/>
            <a:ext cx="225421" cy="583778"/>
          </a:xfrm>
          <a:prstGeom prst="rect">
            <a:avLst/>
          </a:prstGeom>
        </p:spPr>
      </p:pic>
      <p:pic>
        <p:nvPicPr>
          <p:cNvPr id="581" name="그림 580"/>
          <p:cNvPicPr>
            <a:picLocks noChangeAspect="1"/>
          </p:cNvPicPr>
          <p:nvPr/>
        </p:nvPicPr>
        <p:blipFill>
          <a:blip r:embed="rId7"/>
          <a:stretch>
            <a:fillRect/>
          </a:stretch>
        </p:blipFill>
        <p:spPr>
          <a:xfrm>
            <a:off x="4329798" y="7724531"/>
            <a:ext cx="225421" cy="583778"/>
          </a:xfrm>
          <a:prstGeom prst="rect">
            <a:avLst/>
          </a:prstGeom>
        </p:spPr>
      </p:pic>
      <p:sp>
        <p:nvSpPr>
          <p:cNvPr id="582" name="TextBox 581"/>
          <p:cNvSpPr txBox="1"/>
          <p:nvPr/>
        </p:nvSpPr>
        <p:spPr>
          <a:xfrm>
            <a:off x="17531" y="2339423"/>
            <a:ext cx="1371135"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equa</a:t>
            </a:r>
            <a:r>
              <a:rPr lang="en-US" altLang="ko-KR" sz="800" b="1" dirty="0">
                <a:latin typeface="Arial" panose="020B0604020202020204" pitchFamily="34" charset="0"/>
                <a:cs typeface="Arial" panose="020B0604020202020204" pitchFamily="34" charset="0"/>
              </a:rPr>
              <a:t>l</a:t>
            </a:r>
            <a:r>
              <a:rPr lang="en-US" altLang="ko-KR" sz="800" b="1" dirty="0" smtClean="0">
                <a:latin typeface="Arial" panose="020B0604020202020204" pitchFamily="34" charset="0"/>
                <a:cs typeface="Arial" panose="020B0604020202020204" pitchFamily="34" charset="0"/>
              </a:rPr>
              <a:t> samples divided by pooled sample</a:t>
            </a:r>
            <a:endParaRPr lang="ko-KR" altLang="en-US" sz="800" b="1" dirty="0">
              <a:latin typeface="Arial" panose="020B0604020202020204" pitchFamily="34" charset="0"/>
              <a:cs typeface="Arial" panose="020B0604020202020204" pitchFamily="34" charset="0"/>
            </a:endParaRPr>
          </a:p>
        </p:txBody>
      </p:sp>
      <p:sp>
        <p:nvSpPr>
          <p:cNvPr id="583" name="TextBox 582"/>
          <p:cNvSpPr txBox="1"/>
          <p:nvPr/>
        </p:nvSpPr>
        <p:spPr>
          <a:xfrm>
            <a:off x="4570902" y="2385992"/>
            <a:ext cx="1115974"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different individual samples</a:t>
            </a:r>
            <a:endParaRPr lang="ko-KR" altLang="en-US" sz="800" b="1" dirty="0">
              <a:latin typeface="Arial" panose="020B0604020202020204" pitchFamily="34" charset="0"/>
              <a:cs typeface="Arial" panose="020B0604020202020204" pitchFamily="34" charset="0"/>
            </a:endParaRPr>
          </a:p>
        </p:txBody>
      </p:sp>
      <p:sp>
        <p:nvSpPr>
          <p:cNvPr id="584" name="TextBox 583"/>
          <p:cNvSpPr txBox="1"/>
          <p:nvPr/>
        </p:nvSpPr>
        <p:spPr>
          <a:xfrm>
            <a:off x="28309" y="7784710"/>
            <a:ext cx="1371135"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equa</a:t>
            </a:r>
            <a:r>
              <a:rPr lang="en-US" altLang="ko-KR" sz="800" b="1" dirty="0">
                <a:latin typeface="Arial" panose="020B0604020202020204" pitchFamily="34" charset="0"/>
                <a:cs typeface="Arial" panose="020B0604020202020204" pitchFamily="34" charset="0"/>
              </a:rPr>
              <a:t>l</a:t>
            </a:r>
            <a:r>
              <a:rPr lang="en-US" altLang="ko-KR" sz="800" b="1" dirty="0" smtClean="0">
                <a:latin typeface="Arial" panose="020B0604020202020204" pitchFamily="34" charset="0"/>
                <a:cs typeface="Arial" panose="020B0604020202020204" pitchFamily="34" charset="0"/>
              </a:rPr>
              <a:t> samples divided by pooled sample</a:t>
            </a:r>
            <a:endParaRPr lang="ko-KR" altLang="en-US" sz="800" b="1" dirty="0">
              <a:latin typeface="Arial" panose="020B0604020202020204" pitchFamily="34" charset="0"/>
              <a:cs typeface="Arial" panose="020B0604020202020204" pitchFamily="34" charset="0"/>
            </a:endParaRPr>
          </a:p>
        </p:txBody>
      </p:sp>
      <p:sp>
        <p:nvSpPr>
          <p:cNvPr id="585" name="TextBox 584"/>
          <p:cNvSpPr txBox="1"/>
          <p:nvPr/>
        </p:nvSpPr>
        <p:spPr>
          <a:xfrm>
            <a:off x="4618301" y="7784710"/>
            <a:ext cx="1115974"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different individual samples</a:t>
            </a:r>
            <a:endParaRPr lang="ko-KR" altLang="en-US" sz="800" b="1" dirty="0">
              <a:latin typeface="Arial" panose="020B0604020202020204" pitchFamily="34" charset="0"/>
              <a:cs typeface="Arial" panose="020B0604020202020204" pitchFamily="34" charset="0"/>
            </a:endParaRPr>
          </a:p>
        </p:txBody>
      </p:sp>
      <p:pic>
        <p:nvPicPr>
          <p:cNvPr id="586" name="그림 585"/>
          <p:cNvPicPr>
            <a:picLocks noChangeAspect="1"/>
          </p:cNvPicPr>
          <p:nvPr/>
        </p:nvPicPr>
        <p:blipFill rotWithShape="1">
          <a:blip r:embed="rId11"/>
          <a:srcRect t="15679"/>
          <a:stretch/>
        </p:blipFill>
        <p:spPr>
          <a:xfrm>
            <a:off x="9977253" y="951351"/>
            <a:ext cx="572952" cy="551455"/>
          </a:xfrm>
          <a:prstGeom prst="rect">
            <a:avLst/>
          </a:prstGeom>
        </p:spPr>
      </p:pic>
      <p:pic>
        <p:nvPicPr>
          <p:cNvPr id="587" name="그림 586"/>
          <p:cNvPicPr>
            <a:picLocks noChangeAspect="1"/>
          </p:cNvPicPr>
          <p:nvPr/>
        </p:nvPicPr>
        <p:blipFill rotWithShape="1">
          <a:blip r:embed="rId11"/>
          <a:srcRect t="15679"/>
          <a:stretch/>
        </p:blipFill>
        <p:spPr>
          <a:xfrm>
            <a:off x="12074341" y="966863"/>
            <a:ext cx="572952" cy="551455"/>
          </a:xfrm>
          <a:prstGeom prst="rect">
            <a:avLst/>
          </a:prstGeom>
        </p:spPr>
      </p:pic>
      <p:sp>
        <p:nvSpPr>
          <p:cNvPr id="588" name="TextBox 587"/>
          <p:cNvSpPr txBox="1"/>
          <p:nvPr/>
        </p:nvSpPr>
        <p:spPr>
          <a:xfrm>
            <a:off x="9712765" y="684817"/>
            <a:ext cx="1428193"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High invasive</a:t>
            </a:r>
            <a:endParaRPr lang="ko-KR" altLang="en-US" sz="1050" b="1" dirty="0">
              <a:latin typeface="Arial" panose="020B0604020202020204" pitchFamily="34" charset="0"/>
              <a:cs typeface="Arial" panose="020B0604020202020204" pitchFamily="34" charset="0"/>
            </a:endParaRPr>
          </a:p>
        </p:txBody>
      </p:sp>
      <p:sp>
        <p:nvSpPr>
          <p:cNvPr id="589" name="TextBox 588"/>
          <p:cNvSpPr txBox="1"/>
          <p:nvPr/>
        </p:nvSpPr>
        <p:spPr>
          <a:xfrm>
            <a:off x="11838475" y="689310"/>
            <a:ext cx="1428193" cy="253916"/>
          </a:xfrm>
          <a:prstGeom prst="rect">
            <a:avLst/>
          </a:prstGeom>
          <a:noFill/>
        </p:spPr>
        <p:txBody>
          <a:bodyPr wrap="square" rtlCol="0">
            <a:spAutoFit/>
          </a:bodyPr>
          <a:lstStyle/>
          <a:p>
            <a:r>
              <a:rPr lang="en-US" altLang="ko-KR" sz="1050" b="1" dirty="0" smtClean="0">
                <a:latin typeface="Arial" panose="020B0604020202020204" pitchFamily="34" charset="0"/>
                <a:cs typeface="Arial" panose="020B0604020202020204" pitchFamily="34" charset="0"/>
              </a:rPr>
              <a:t>Low invasive</a:t>
            </a:r>
            <a:endParaRPr lang="ko-KR" altLang="en-US" sz="1050" b="1" dirty="0">
              <a:latin typeface="Arial" panose="020B0604020202020204" pitchFamily="34" charset="0"/>
              <a:cs typeface="Arial" panose="020B0604020202020204" pitchFamily="34" charset="0"/>
            </a:endParaRPr>
          </a:p>
        </p:txBody>
      </p:sp>
      <p:sp>
        <p:nvSpPr>
          <p:cNvPr id="590" name="TextBox 589"/>
          <p:cNvSpPr txBox="1"/>
          <p:nvPr/>
        </p:nvSpPr>
        <p:spPr>
          <a:xfrm>
            <a:off x="9791113" y="1492427"/>
            <a:ext cx="1428193" cy="246221"/>
          </a:xfrm>
          <a:prstGeom prst="rect">
            <a:avLst/>
          </a:prstGeom>
          <a:noFill/>
        </p:spPr>
        <p:txBody>
          <a:bodyPr wrap="square" rtlCol="0">
            <a:spAutoFit/>
          </a:bodyPr>
          <a:lstStyle/>
          <a:p>
            <a:r>
              <a:rPr lang="en-US" altLang="ko-KR" sz="1000" b="1" dirty="0" smtClean="0">
                <a:latin typeface="Arial" panose="020B0604020202020204" pitchFamily="34" charset="0"/>
                <a:cs typeface="Arial" panose="020B0604020202020204" pitchFamily="34" charset="0"/>
              </a:rPr>
              <a:t>MDA-MB-213</a:t>
            </a:r>
            <a:endParaRPr lang="ko-KR" altLang="en-US" sz="1000" b="1" dirty="0">
              <a:latin typeface="Arial" panose="020B0604020202020204" pitchFamily="34" charset="0"/>
              <a:cs typeface="Arial" panose="020B0604020202020204" pitchFamily="34" charset="0"/>
            </a:endParaRPr>
          </a:p>
        </p:txBody>
      </p:sp>
      <p:sp>
        <p:nvSpPr>
          <p:cNvPr id="591" name="TextBox 590"/>
          <p:cNvSpPr txBox="1"/>
          <p:nvPr/>
        </p:nvSpPr>
        <p:spPr>
          <a:xfrm>
            <a:off x="12085328" y="1520619"/>
            <a:ext cx="557522" cy="246221"/>
          </a:xfrm>
          <a:prstGeom prst="rect">
            <a:avLst/>
          </a:prstGeom>
          <a:noFill/>
        </p:spPr>
        <p:txBody>
          <a:bodyPr wrap="square" rtlCol="0">
            <a:spAutoFit/>
          </a:bodyPr>
          <a:lstStyle/>
          <a:p>
            <a:r>
              <a:rPr lang="en-US" altLang="ko-KR" sz="1000" b="1" dirty="0" smtClean="0">
                <a:latin typeface="Arial" panose="020B0604020202020204" pitchFamily="34" charset="0"/>
                <a:cs typeface="Arial" panose="020B0604020202020204" pitchFamily="34" charset="0"/>
              </a:rPr>
              <a:t>T47D</a:t>
            </a:r>
            <a:endParaRPr lang="ko-KR" altLang="en-US" sz="1000" b="1" dirty="0">
              <a:latin typeface="Arial" panose="020B0604020202020204" pitchFamily="34" charset="0"/>
              <a:cs typeface="Arial" panose="020B0604020202020204" pitchFamily="34" charset="0"/>
            </a:endParaRPr>
          </a:p>
        </p:txBody>
      </p:sp>
      <p:sp>
        <p:nvSpPr>
          <p:cNvPr id="592" name="아래쪽 화살표 591"/>
          <p:cNvSpPr/>
          <p:nvPr/>
        </p:nvSpPr>
        <p:spPr>
          <a:xfrm>
            <a:off x="10130639" y="1968915"/>
            <a:ext cx="151481" cy="254835"/>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93" name="아래쪽 화살표 592"/>
          <p:cNvSpPr/>
          <p:nvPr/>
        </p:nvSpPr>
        <p:spPr>
          <a:xfrm>
            <a:off x="12282550" y="1956303"/>
            <a:ext cx="151481" cy="267148"/>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594" name="TextBox 593"/>
          <p:cNvSpPr txBox="1"/>
          <p:nvPr/>
        </p:nvSpPr>
        <p:spPr>
          <a:xfrm>
            <a:off x="9414704" y="1918455"/>
            <a:ext cx="879154"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biological replicates</a:t>
            </a:r>
            <a:endParaRPr lang="ko-KR" altLang="en-US" sz="800" b="1" dirty="0">
              <a:latin typeface="Arial" panose="020B0604020202020204" pitchFamily="34" charset="0"/>
              <a:cs typeface="Arial" panose="020B0604020202020204" pitchFamily="34" charset="0"/>
            </a:endParaRPr>
          </a:p>
        </p:txBody>
      </p:sp>
      <p:sp>
        <p:nvSpPr>
          <p:cNvPr id="595" name="TextBox 594"/>
          <p:cNvSpPr txBox="1"/>
          <p:nvPr/>
        </p:nvSpPr>
        <p:spPr>
          <a:xfrm>
            <a:off x="11553635" y="1936938"/>
            <a:ext cx="879154" cy="338554"/>
          </a:xfrm>
          <a:prstGeom prst="rect">
            <a:avLst/>
          </a:prstGeom>
          <a:noFill/>
        </p:spPr>
        <p:txBody>
          <a:bodyPr wrap="square" rtlCol="0">
            <a:spAutoFit/>
          </a:bodyPr>
          <a:lstStyle/>
          <a:p>
            <a:pPr algn="ctr"/>
            <a:r>
              <a:rPr lang="en-US" altLang="ko-KR" sz="800" b="1" dirty="0" smtClean="0">
                <a:latin typeface="Arial" panose="020B0604020202020204" pitchFamily="34" charset="0"/>
                <a:cs typeface="Arial" panose="020B0604020202020204" pitchFamily="34" charset="0"/>
              </a:rPr>
              <a:t>3 biological replicates</a:t>
            </a:r>
            <a:endParaRPr lang="ko-KR" altLang="en-US" sz="800" b="1" dirty="0">
              <a:latin typeface="Arial" panose="020B0604020202020204" pitchFamily="34" charset="0"/>
              <a:cs typeface="Arial" panose="020B0604020202020204" pitchFamily="34" charset="0"/>
            </a:endParaRPr>
          </a:p>
        </p:txBody>
      </p:sp>
      <p:pic>
        <p:nvPicPr>
          <p:cNvPr id="596" name="그림 595"/>
          <p:cNvPicPr>
            <a:picLocks noChangeAspect="1"/>
          </p:cNvPicPr>
          <p:nvPr/>
        </p:nvPicPr>
        <p:blipFill>
          <a:blip r:embed="rId7"/>
          <a:stretch>
            <a:fillRect/>
          </a:stretch>
        </p:blipFill>
        <p:spPr>
          <a:xfrm>
            <a:off x="9751305" y="2319540"/>
            <a:ext cx="225421" cy="583778"/>
          </a:xfrm>
          <a:prstGeom prst="rect">
            <a:avLst/>
          </a:prstGeom>
        </p:spPr>
      </p:pic>
      <p:pic>
        <p:nvPicPr>
          <p:cNvPr id="597" name="그림 596"/>
          <p:cNvPicPr>
            <a:picLocks noChangeAspect="1"/>
          </p:cNvPicPr>
          <p:nvPr/>
        </p:nvPicPr>
        <p:blipFill>
          <a:blip r:embed="rId7"/>
          <a:stretch>
            <a:fillRect/>
          </a:stretch>
        </p:blipFill>
        <p:spPr>
          <a:xfrm>
            <a:off x="9997099" y="2320586"/>
            <a:ext cx="225421" cy="583778"/>
          </a:xfrm>
          <a:prstGeom prst="rect">
            <a:avLst/>
          </a:prstGeom>
        </p:spPr>
      </p:pic>
      <p:pic>
        <p:nvPicPr>
          <p:cNvPr id="598" name="그림 597"/>
          <p:cNvPicPr>
            <a:picLocks noChangeAspect="1"/>
          </p:cNvPicPr>
          <p:nvPr/>
        </p:nvPicPr>
        <p:blipFill>
          <a:blip r:embed="rId7"/>
          <a:stretch>
            <a:fillRect/>
          </a:stretch>
        </p:blipFill>
        <p:spPr>
          <a:xfrm>
            <a:off x="10242661" y="2310973"/>
            <a:ext cx="225421" cy="583778"/>
          </a:xfrm>
          <a:prstGeom prst="rect">
            <a:avLst/>
          </a:prstGeom>
        </p:spPr>
      </p:pic>
      <p:pic>
        <p:nvPicPr>
          <p:cNvPr id="599" name="그림 598"/>
          <p:cNvPicPr>
            <a:picLocks noChangeAspect="1"/>
          </p:cNvPicPr>
          <p:nvPr/>
        </p:nvPicPr>
        <p:blipFill>
          <a:blip r:embed="rId7"/>
          <a:stretch>
            <a:fillRect/>
          </a:stretch>
        </p:blipFill>
        <p:spPr>
          <a:xfrm>
            <a:off x="12036284" y="2328854"/>
            <a:ext cx="225421" cy="583778"/>
          </a:xfrm>
          <a:prstGeom prst="rect">
            <a:avLst/>
          </a:prstGeom>
        </p:spPr>
      </p:pic>
      <p:pic>
        <p:nvPicPr>
          <p:cNvPr id="600" name="그림 599"/>
          <p:cNvPicPr>
            <a:picLocks noChangeAspect="1"/>
          </p:cNvPicPr>
          <p:nvPr/>
        </p:nvPicPr>
        <p:blipFill>
          <a:blip r:embed="rId7"/>
          <a:stretch>
            <a:fillRect/>
          </a:stretch>
        </p:blipFill>
        <p:spPr>
          <a:xfrm>
            <a:off x="12282078" y="2329899"/>
            <a:ext cx="225421" cy="583778"/>
          </a:xfrm>
          <a:prstGeom prst="rect">
            <a:avLst/>
          </a:prstGeom>
        </p:spPr>
      </p:pic>
      <p:pic>
        <p:nvPicPr>
          <p:cNvPr id="601" name="그림 600"/>
          <p:cNvPicPr>
            <a:picLocks noChangeAspect="1"/>
          </p:cNvPicPr>
          <p:nvPr/>
        </p:nvPicPr>
        <p:blipFill>
          <a:blip r:embed="rId7"/>
          <a:stretch>
            <a:fillRect/>
          </a:stretch>
        </p:blipFill>
        <p:spPr>
          <a:xfrm>
            <a:off x="12527640" y="2320287"/>
            <a:ext cx="225421" cy="583778"/>
          </a:xfrm>
          <a:prstGeom prst="rect">
            <a:avLst/>
          </a:prstGeom>
        </p:spPr>
      </p:pic>
      <p:sp>
        <p:nvSpPr>
          <p:cNvPr id="602" name="직사각형 601"/>
          <p:cNvSpPr/>
          <p:nvPr/>
        </p:nvSpPr>
        <p:spPr>
          <a:xfrm>
            <a:off x="9365687" y="4067584"/>
            <a:ext cx="443534" cy="180653"/>
          </a:xfrm>
          <a:prstGeom prst="rect">
            <a:avLst/>
          </a:prstGeom>
          <a:solidFill>
            <a:srgbClr val="E1474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BR1</a:t>
            </a:r>
            <a:endParaRPr lang="ko-KR" altLang="en-US" sz="700" b="1" dirty="0">
              <a:latin typeface="Arial" panose="020B0604020202020204" pitchFamily="34" charset="0"/>
              <a:cs typeface="Arial" panose="020B0604020202020204" pitchFamily="34" charset="0"/>
            </a:endParaRPr>
          </a:p>
        </p:txBody>
      </p:sp>
      <p:sp>
        <p:nvSpPr>
          <p:cNvPr id="603" name="TextBox 602"/>
          <p:cNvSpPr txBox="1"/>
          <p:nvPr/>
        </p:nvSpPr>
        <p:spPr>
          <a:xfrm>
            <a:off x="9399771" y="3830563"/>
            <a:ext cx="391342"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6</a:t>
            </a:r>
            <a:endParaRPr lang="ko-KR" altLang="en-US" sz="800" b="1" dirty="0">
              <a:latin typeface="Arial" panose="020B0604020202020204" pitchFamily="34" charset="0"/>
              <a:cs typeface="Arial" panose="020B0604020202020204" pitchFamily="34" charset="0"/>
            </a:endParaRPr>
          </a:p>
        </p:txBody>
      </p:sp>
      <p:sp>
        <p:nvSpPr>
          <p:cNvPr id="604" name="TextBox 603"/>
          <p:cNvSpPr txBox="1"/>
          <p:nvPr/>
        </p:nvSpPr>
        <p:spPr>
          <a:xfrm>
            <a:off x="9963831" y="3823353"/>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7</a:t>
            </a:r>
            <a:endParaRPr lang="ko-KR" altLang="en-US" sz="800" b="1" dirty="0">
              <a:latin typeface="Arial" panose="020B0604020202020204" pitchFamily="34" charset="0"/>
              <a:cs typeface="Arial" panose="020B0604020202020204" pitchFamily="34" charset="0"/>
            </a:endParaRPr>
          </a:p>
        </p:txBody>
      </p:sp>
      <p:sp>
        <p:nvSpPr>
          <p:cNvPr id="605" name="직사각형 604"/>
          <p:cNvSpPr/>
          <p:nvPr/>
        </p:nvSpPr>
        <p:spPr>
          <a:xfrm>
            <a:off x="9913270" y="4068996"/>
            <a:ext cx="466409" cy="183753"/>
          </a:xfrm>
          <a:prstGeom prst="rect">
            <a:avLst/>
          </a:prstGeom>
          <a:solidFill>
            <a:srgbClr val="E1474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BR2</a:t>
            </a:r>
            <a:endParaRPr lang="ko-KR" altLang="en-US" sz="700" b="1" dirty="0">
              <a:latin typeface="Arial" panose="020B0604020202020204" pitchFamily="34" charset="0"/>
              <a:cs typeface="Arial" panose="020B0604020202020204" pitchFamily="34" charset="0"/>
            </a:endParaRPr>
          </a:p>
        </p:txBody>
      </p:sp>
      <p:sp>
        <p:nvSpPr>
          <p:cNvPr id="606" name="직사각형 605"/>
          <p:cNvSpPr/>
          <p:nvPr/>
        </p:nvSpPr>
        <p:spPr>
          <a:xfrm>
            <a:off x="10473939" y="4068996"/>
            <a:ext cx="457674" cy="183753"/>
          </a:xfrm>
          <a:prstGeom prst="rect">
            <a:avLst/>
          </a:prstGeom>
          <a:solidFill>
            <a:srgbClr val="E14747"/>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BR3</a:t>
            </a:r>
            <a:endParaRPr lang="ko-KR" altLang="en-US" sz="700" b="1" dirty="0">
              <a:latin typeface="Arial" panose="020B0604020202020204" pitchFamily="34" charset="0"/>
              <a:cs typeface="Arial" panose="020B0604020202020204" pitchFamily="34" charset="0"/>
            </a:endParaRPr>
          </a:p>
        </p:txBody>
      </p:sp>
      <p:sp>
        <p:nvSpPr>
          <p:cNvPr id="607" name="TextBox 606"/>
          <p:cNvSpPr txBox="1"/>
          <p:nvPr/>
        </p:nvSpPr>
        <p:spPr>
          <a:xfrm>
            <a:off x="10514644" y="3821291"/>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8</a:t>
            </a:r>
            <a:endParaRPr lang="ko-KR" altLang="en-US" sz="800" b="1" dirty="0">
              <a:latin typeface="Arial" panose="020B0604020202020204" pitchFamily="34" charset="0"/>
              <a:cs typeface="Arial" panose="020B0604020202020204" pitchFamily="34" charset="0"/>
            </a:endParaRPr>
          </a:p>
        </p:txBody>
      </p:sp>
      <p:sp>
        <p:nvSpPr>
          <p:cNvPr id="608" name="TextBox 607"/>
          <p:cNvSpPr txBox="1"/>
          <p:nvPr/>
        </p:nvSpPr>
        <p:spPr>
          <a:xfrm>
            <a:off x="5095397" y="3672158"/>
            <a:ext cx="804388" cy="253916"/>
          </a:xfrm>
          <a:prstGeom prst="rect">
            <a:avLst/>
          </a:prstGeom>
          <a:noFill/>
        </p:spPr>
        <p:txBody>
          <a:bodyPr wrap="square" rtlCol="0">
            <a:spAutoFit/>
          </a:bodyPr>
          <a:lstStyle/>
          <a:p>
            <a:r>
              <a:rPr lang="en-US" altLang="ko-KR" sz="1050" b="1" dirty="0" smtClean="0"/>
              <a:t>Channels</a:t>
            </a:r>
            <a:endParaRPr lang="ko-KR" altLang="en-US" sz="900" b="1" dirty="0"/>
          </a:p>
        </p:txBody>
      </p:sp>
      <p:sp>
        <p:nvSpPr>
          <p:cNvPr id="609" name="아래쪽 화살표 608"/>
          <p:cNvSpPr/>
          <p:nvPr/>
        </p:nvSpPr>
        <p:spPr>
          <a:xfrm>
            <a:off x="10084812" y="2987176"/>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610" name="아래쪽 화살표 609"/>
          <p:cNvSpPr/>
          <p:nvPr/>
        </p:nvSpPr>
        <p:spPr>
          <a:xfrm>
            <a:off x="12288991" y="2978143"/>
            <a:ext cx="161980" cy="471590"/>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700"/>
          </a:p>
        </p:txBody>
      </p:sp>
      <p:sp>
        <p:nvSpPr>
          <p:cNvPr id="611" name="직사각형 610"/>
          <p:cNvSpPr/>
          <p:nvPr/>
        </p:nvSpPr>
        <p:spPr>
          <a:xfrm>
            <a:off x="11576246" y="4069067"/>
            <a:ext cx="443534" cy="164975"/>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BR1</a:t>
            </a:r>
            <a:endParaRPr lang="ko-KR" altLang="en-US" sz="700" b="1" dirty="0">
              <a:latin typeface="Arial" panose="020B0604020202020204" pitchFamily="34" charset="0"/>
              <a:cs typeface="Arial" panose="020B0604020202020204" pitchFamily="34" charset="0"/>
            </a:endParaRPr>
          </a:p>
        </p:txBody>
      </p:sp>
      <p:sp>
        <p:nvSpPr>
          <p:cNvPr id="612" name="TextBox 611"/>
          <p:cNvSpPr txBox="1"/>
          <p:nvPr/>
        </p:nvSpPr>
        <p:spPr>
          <a:xfrm>
            <a:off x="11621020" y="3821291"/>
            <a:ext cx="391342"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29</a:t>
            </a:r>
            <a:endParaRPr lang="ko-KR" altLang="en-US" sz="800" b="1" dirty="0">
              <a:latin typeface="Arial" panose="020B0604020202020204" pitchFamily="34" charset="0"/>
              <a:cs typeface="Arial" panose="020B0604020202020204" pitchFamily="34" charset="0"/>
            </a:endParaRPr>
          </a:p>
        </p:txBody>
      </p:sp>
      <p:sp>
        <p:nvSpPr>
          <p:cNvPr id="613" name="TextBox 612"/>
          <p:cNvSpPr txBox="1"/>
          <p:nvPr/>
        </p:nvSpPr>
        <p:spPr>
          <a:xfrm>
            <a:off x="12163353" y="3827815"/>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30</a:t>
            </a:r>
            <a:endParaRPr lang="ko-KR" altLang="en-US" sz="800" b="1" dirty="0">
              <a:latin typeface="Arial" panose="020B0604020202020204" pitchFamily="34" charset="0"/>
              <a:cs typeface="Arial" panose="020B0604020202020204" pitchFamily="34" charset="0"/>
            </a:endParaRPr>
          </a:p>
        </p:txBody>
      </p:sp>
      <p:sp>
        <p:nvSpPr>
          <p:cNvPr id="614" name="직사각형 613"/>
          <p:cNvSpPr/>
          <p:nvPr/>
        </p:nvSpPr>
        <p:spPr>
          <a:xfrm>
            <a:off x="12112762" y="4061857"/>
            <a:ext cx="466409" cy="172185"/>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BR2</a:t>
            </a:r>
            <a:endParaRPr lang="ko-KR" altLang="en-US" sz="700" b="1" dirty="0">
              <a:latin typeface="Arial" panose="020B0604020202020204" pitchFamily="34" charset="0"/>
              <a:cs typeface="Arial" panose="020B0604020202020204" pitchFamily="34" charset="0"/>
            </a:endParaRPr>
          </a:p>
        </p:txBody>
      </p:sp>
      <p:sp>
        <p:nvSpPr>
          <p:cNvPr id="615" name="직사각형 614"/>
          <p:cNvSpPr/>
          <p:nvPr/>
        </p:nvSpPr>
        <p:spPr>
          <a:xfrm>
            <a:off x="12683219" y="4067584"/>
            <a:ext cx="457674" cy="168507"/>
          </a:xfrm>
          <a:prstGeom prst="rect">
            <a:avLst/>
          </a:prstGeom>
          <a:solidFill>
            <a:srgbClr val="0070C0"/>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700" b="1" dirty="0" smtClean="0">
                <a:latin typeface="Arial" panose="020B0604020202020204" pitchFamily="34" charset="0"/>
                <a:cs typeface="Arial" panose="020B0604020202020204" pitchFamily="34" charset="0"/>
              </a:rPr>
              <a:t>BR3</a:t>
            </a:r>
            <a:endParaRPr lang="ko-KR" altLang="en-US" sz="700" b="1" dirty="0">
              <a:latin typeface="Arial" panose="020B0604020202020204" pitchFamily="34" charset="0"/>
              <a:cs typeface="Arial" panose="020B0604020202020204" pitchFamily="34" charset="0"/>
            </a:endParaRPr>
          </a:p>
        </p:txBody>
      </p:sp>
      <p:sp>
        <p:nvSpPr>
          <p:cNvPr id="616" name="TextBox 615"/>
          <p:cNvSpPr txBox="1"/>
          <p:nvPr/>
        </p:nvSpPr>
        <p:spPr>
          <a:xfrm>
            <a:off x="12732264" y="3839641"/>
            <a:ext cx="359585"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131</a:t>
            </a:r>
            <a:endParaRPr lang="ko-KR" altLang="en-US" sz="800" b="1" dirty="0">
              <a:latin typeface="Arial" panose="020B0604020202020204" pitchFamily="34" charset="0"/>
              <a:cs typeface="Arial" panose="020B0604020202020204" pitchFamily="34" charset="0"/>
            </a:endParaRPr>
          </a:p>
        </p:txBody>
      </p:sp>
      <p:sp>
        <p:nvSpPr>
          <p:cNvPr id="617" name="TextBox 616"/>
          <p:cNvSpPr txBox="1"/>
          <p:nvPr/>
        </p:nvSpPr>
        <p:spPr>
          <a:xfrm>
            <a:off x="10450503" y="3514992"/>
            <a:ext cx="2295137" cy="215444"/>
          </a:xfrm>
          <a:prstGeom prst="rect">
            <a:avLst/>
          </a:prstGeom>
          <a:noFill/>
        </p:spPr>
        <p:txBody>
          <a:bodyPr wrap="square" rtlCol="0">
            <a:spAutoFit/>
          </a:bodyPr>
          <a:lstStyle/>
          <a:p>
            <a:r>
              <a:rPr lang="en-US" altLang="ko-KR" sz="800" b="1" dirty="0" smtClean="0">
                <a:latin typeface="Arial" panose="020B0604020202020204" pitchFamily="34" charset="0"/>
                <a:cs typeface="Arial" panose="020B0604020202020204" pitchFamily="34" charset="0"/>
              </a:rPr>
              <a:t>Isobaric chemical tag(TMT) labeling</a:t>
            </a:r>
            <a:endParaRPr lang="ko-KR" altLang="en-US" sz="800" b="1" dirty="0">
              <a:latin typeface="Arial" panose="020B0604020202020204" pitchFamily="34" charset="0"/>
              <a:cs typeface="Arial" panose="020B0604020202020204" pitchFamily="34" charset="0"/>
            </a:endParaRPr>
          </a:p>
        </p:txBody>
      </p:sp>
      <p:sp>
        <p:nvSpPr>
          <p:cNvPr id="618" name="오른쪽 중괄호 617"/>
          <p:cNvSpPr/>
          <p:nvPr/>
        </p:nvSpPr>
        <p:spPr>
          <a:xfrm rot="5400000">
            <a:off x="10041004" y="3691778"/>
            <a:ext cx="215291" cy="1565926"/>
          </a:xfrm>
          <a:prstGeom prst="rightBrace">
            <a:avLst/>
          </a:prstGeom>
          <a:solidFill>
            <a:schemeClr val="tx1"/>
          </a:solid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700"/>
          </a:p>
        </p:txBody>
      </p:sp>
      <p:sp>
        <p:nvSpPr>
          <p:cNvPr id="619" name="TextBox 618"/>
          <p:cNvSpPr txBox="1"/>
          <p:nvPr/>
        </p:nvSpPr>
        <p:spPr>
          <a:xfrm>
            <a:off x="11833333" y="4592565"/>
            <a:ext cx="1433335"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Lower invasive</a:t>
            </a:r>
            <a:endParaRPr lang="ko-KR" altLang="en-US" sz="1200" b="1" dirty="0">
              <a:latin typeface="Arial" panose="020B0604020202020204" pitchFamily="34" charset="0"/>
              <a:cs typeface="Arial" panose="020B0604020202020204" pitchFamily="34" charset="0"/>
            </a:endParaRPr>
          </a:p>
        </p:txBody>
      </p:sp>
      <p:sp>
        <p:nvSpPr>
          <p:cNvPr id="620" name="오른쪽 중괄호 619"/>
          <p:cNvSpPr/>
          <p:nvPr/>
        </p:nvSpPr>
        <p:spPr>
          <a:xfrm rot="5400000">
            <a:off x="12250464" y="3684918"/>
            <a:ext cx="215291" cy="1565567"/>
          </a:xfrm>
          <a:prstGeom prst="rightBrace">
            <a:avLst/>
          </a:prstGeom>
          <a:solidFill>
            <a:schemeClr val="tx1"/>
          </a:solidFill>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700"/>
          </a:p>
        </p:txBody>
      </p:sp>
      <p:sp>
        <p:nvSpPr>
          <p:cNvPr id="621" name="TextBox 620"/>
          <p:cNvSpPr txBox="1"/>
          <p:nvPr/>
        </p:nvSpPr>
        <p:spPr>
          <a:xfrm>
            <a:off x="9594208" y="4609132"/>
            <a:ext cx="137719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Higher invasive</a:t>
            </a:r>
            <a:endParaRPr lang="ko-KR" altLang="en-US" sz="1200" b="1" dirty="0">
              <a:latin typeface="Arial" panose="020B0604020202020204" pitchFamily="34" charset="0"/>
              <a:cs typeface="Arial" panose="020B0604020202020204" pitchFamily="34" charset="0"/>
            </a:endParaRPr>
          </a:p>
        </p:txBody>
      </p:sp>
      <p:sp>
        <p:nvSpPr>
          <p:cNvPr id="622" name="TextBox 621"/>
          <p:cNvSpPr txBox="1"/>
          <p:nvPr/>
        </p:nvSpPr>
        <p:spPr>
          <a:xfrm>
            <a:off x="9019514" y="3620358"/>
            <a:ext cx="804388" cy="253916"/>
          </a:xfrm>
          <a:prstGeom prst="rect">
            <a:avLst/>
          </a:prstGeom>
          <a:noFill/>
        </p:spPr>
        <p:txBody>
          <a:bodyPr wrap="square" rtlCol="0">
            <a:spAutoFit/>
          </a:bodyPr>
          <a:lstStyle/>
          <a:p>
            <a:r>
              <a:rPr lang="en-US" altLang="ko-KR" sz="1050" b="1" dirty="0" smtClean="0"/>
              <a:t>Channels</a:t>
            </a:r>
            <a:endParaRPr lang="ko-KR" altLang="en-US" sz="900" b="1" dirty="0"/>
          </a:p>
        </p:txBody>
      </p:sp>
    </p:spTree>
    <p:extLst>
      <p:ext uri="{BB962C8B-B14F-4D97-AF65-F5344CB8AC3E}">
        <p14:creationId xmlns:p14="http://schemas.microsoft.com/office/powerpoint/2010/main" val="2372717892"/>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92" name="그룹 291"/>
          <p:cNvGrpSpPr/>
          <p:nvPr/>
        </p:nvGrpSpPr>
        <p:grpSpPr>
          <a:xfrm>
            <a:off x="759737" y="917490"/>
            <a:ext cx="5537646" cy="3757844"/>
            <a:chOff x="324674" y="417430"/>
            <a:chExt cx="7497558" cy="5197365"/>
          </a:xfrm>
        </p:grpSpPr>
        <p:sp>
          <p:nvSpPr>
            <p:cNvPr id="293" name="타원 292"/>
            <p:cNvSpPr/>
            <p:nvPr/>
          </p:nvSpPr>
          <p:spPr>
            <a:xfrm>
              <a:off x="778264" y="1169575"/>
              <a:ext cx="4545680" cy="4445220"/>
            </a:xfrm>
            <a:prstGeom prst="ellipse">
              <a:avLst/>
            </a:prstGeom>
            <a:solidFill>
              <a:schemeClr val="accent2">
                <a:lumMod val="40000"/>
                <a:lumOff val="60000"/>
                <a:alpha val="56000"/>
              </a:schemeClr>
            </a:solidFill>
            <a:ln w="1270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294" name="타원 293"/>
            <p:cNvSpPr/>
            <p:nvPr/>
          </p:nvSpPr>
          <p:spPr>
            <a:xfrm>
              <a:off x="1097585" y="1808203"/>
              <a:ext cx="3793968" cy="3782335"/>
            </a:xfrm>
            <a:prstGeom prst="ellipse">
              <a:avLst/>
            </a:prstGeom>
            <a:solidFill>
              <a:srgbClr val="FF0000">
                <a:alpha val="29000"/>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295" name="TextBox 294"/>
            <p:cNvSpPr txBox="1"/>
            <p:nvPr/>
          </p:nvSpPr>
          <p:spPr>
            <a:xfrm>
              <a:off x="324674" y="417430"/>
              <a:ext cx="3373164" cy="434351"/>
            </a:xfrm>
            <a:prstGeom prst="rect">
              <a:avLst/>
            </a:prstGeom>
            <a:noFill/>
          </p:spPr>
          <p:txBody>
            <a:bodyPr wrap="square" rtlCol="0">
              <a:spAutoFit/>
            </a:bodyPr>
            <a:lstStyle/>
            <a:p>
              <a:r>
                <a:rPr lang="en-US" altLang="ko-KR" sz="2000" b="1" smtClean="0">
                  <a:latin typeface="Arial" panose="020B0604020202020204" pitchFamily="34" charset="0"/>
                  <a:cs typeface="Arial" panose="020B0604020202020204" pitchFamily="34" charset="0"/>
                </a:rPr>
                <a:t>Pooled sample set</a:t>
              </a:r>
              <a:endParaRPr lang="ko-KR" altLang="en-US" sz="2000" b="1">
                <a:latin typeface="Arial" panose="020B0604020202020204" pitchFamily="34" charset="0"/>
                <a:cs typeface="Arial" panose="020B0604020202020204" pitchFamily="34" charset="0"/>
              </a:endParaRPr>
            </a:p>
          </p:txBody>
        </p:sp>
        <p:sp>
          <p:nvSpPr>
            <p:cNvPr id="296" name="TextBox 295"/>
            <p:cNvSpPr txBox="1"/>
            <p:nvPr/>
          </p:nvSpPr>
          <p:spPr>
            <a:xfrm>
              <a:off x="3591247" y="477436"/>
              <a:ext cx="4230985" cy="893922"/>
            </a:xfrm>
            <a:prstGeom prst="rect">
              <a:avLst/>
            </a:prstGeom>
            <a:noFill/>
          </p:spPr>
          <p:txBody>
            <a:bodyPr wrap="square" rtlCol="0">
              <a:spAutoFit/>
            </a:bodyPr>
            <a:lstStyle/>
            <a:p>
              <a:pPr algn="ctr"/>
              <a:r>
                <a:rPr lang="en-US" altLang="ko-KR" b="1" dirty="0" smtClean="0">
                  <a:solidFill>
                    <a:schemeClr val="accent2">
                      <a:lumMod val="75000"/>
                    </a:schemeClr>
                  </a:solidFill>
                  <a:latin typeface="Arial" panose="020B0604020202020204" pitchFamily="34" charset="0"/>
                  <a:cs typeface="Arial" panose="020B0604020202020204" pitchFamily="34" charset="0"/>
                </a:rPr>
                <a:t>Total Identified proteins</a:t>
              </a:r>
            </a:p>
            <a:p>
              <a:pPr algn="ctr"/>
              <a:r>
                <a:rPr lang="en-US" altLang="ko-KR" b="1" dirty="0" smtClean="0">
                  <a:solidFill>
                    <a:schemeClr val="accent2">
                      <a:lumMod val="75000"/>
                    </a:schemeClr>
                  </a:solidFill>
                  <a:latin typeface="Arial" panose="020B0604020202020204" pitchFamily="34" charset="0"/>
                  <a:cs typeface="Arial" panose="020B0604020202020204" pitchFamily="34" charset="0"/>
                </a:rPr>
                <a:t>9,441</a:t>
              </a:r>
              <a:endParaRPr lang="ko-KR" altLang="en-US" b="1" dirty="0">
                <a:solidFill>
                  <a:schemeClr val="accent2">
                    <a:lumMod val="75000"/>
                  </a:schemeClr>
                </a:solidFill>
                <a:latin typeface="Arial" panose="020B0604020202020204" pitchFamily="34" charset="0"/>
                <a:cs typeface="Arial" panose="020B0604020202020204" pitchFamily="34" charset="0"/>
              </a:endParaRPr>
            </a:p>
          </p:txBody>
        </p:sp>
        <p:sp>
          <p:nvSpPr>
            <p:cNvPr id="297" name="TextBox 296"/>
            <p:cNvSpPr txBox="1"/>
            <p:nvPr/>
          </p:nvSpPr>
          <p:spPr>
            <a:xfrm>
              <a:off x="1903654" y="3031628"/>
              <a:ext cx="2166202" cy="1370003"/>
            </a:xfrm>
            <a:prstGeom prst="rect">
              <a:avLst/>
            </a:prstGeom>
            <a:noFill/>
          </p:spPr>
          <p:txBody>
            <a:bodyPr wrap="square" rtlCol="0">
              <a:spAutoFit/>
            </a:bodyPr>
            <a:lstStyle/>
            <a:p>
              <a:pPr algn="ctr"/>
              <a:r>
                <a:rPr lang="en-US" altLang="ko-KR" b="1" dirty="0" smtClean="0">
                  <a:solidFill>
                    <a:srgbClr val="C00000"/>
                  </a:solidFill>
                  <a:latin typeface="Arial" panose="020B0604020202020204" pitchFamily="34" charset="0"/>
                  <a:cs typeface="Arial" panose="020B0604020202020204" pitchFamily="34" charset="0"/>
                </a:rPr>
                <a:t>Quantified</a:t>
              </a:r>
            </a:p>
            <a:p>
              <a:pPr algn="ctr"/>
              <a:r>
                <a:rPr lang="en-US" altLang="ko-KR" b="1" dirty="0" smtClean="0">
                  <a:solidFill>
                    <a:srgbClr val="C00000"/>
                  </a:solidFill>
                  <a:latin typeface="Arial" panose="020B0604020202020204" pitchFamily="34" charset="0"/>
                  <a:cs typeface="Arial" panose="020B0604020202020204" pitchFamily="34" charset="0"/>
                </a:rPr>
                <a:t>Proteins</a:t>
              </a:r>
            </a:p>
            <a:p>
              <a:pPr algn="ctr"/>
              <a:r>
                <a:rPr lang="en-US" altLang="ko-KR" b="1" dirty="0" smtClean="0">
                  <a:solidFill>
                    <a:srgbClr val="C00000"/>
                  </a:solidFill>
                  <a:latin typeface="Arial" panose="020B0604020202020204" pitchFamily="34" charset="0"/>
                  <a:cs typeface="Arial" panose="020B0604020202020204" pitchFamily="34" charset="0"/>
                </a:rPr>
                <a:t>7,179</a:t>
              </a:r>
              <a:endParaRPr lang="ko-KR" altLang="en-US" b="1" dirty="0">
                <a:solidFill>
                  <a:srgbClr val="C00000"/>
                </a:solidFill>
                <a:latin typeface="Arial" panose="020B0604020202020204" pitchFamily="34" charset="0"/>
                <a:cs typeface="Arial" panose="020B0604020202020204" pitchFamily="34" charset="0"/>
              </a:endParaRPr>
            </a:p>
          </p:txBody>
        </p:sp>
      </p:grpSp>
      <p:grpSp>
        <p:nvGrpSpPr>
          <p:cNvPr id="298" name="그룹 297"/>
          <p:cNvGrpSpPr/>
          <p:nvPr/>
        </p:nvGrpSpPr>
        <p:grpSpPr>
          <a:xfrm>
            <a:off x="7814932" y="898458"/>
            <a:ext cx="5719769" cy="3821170"/>
            <a:chOff x="7130716" y="507582"/>
            <a:chExt cx="7723159" cy="5112096"/>
          </a:xfrm>
        </p:grpSpPr>
        <p:sp>
          <p:nvSpPr>
            <p:cNvPr id="299" name="TextBox 298"/>
            <p:cNvSpPr txBox="1"/>
            <p:nvPr/>
          </p:nvSpPr>
          <p:spPr>
            <a:xfrm>
              <a:off x="7130716" y="507582"/>
              <a:ext cx="3806711" cy="535281"/>
            </a:xfrm>
            <a:prstGeom prst="rect">
              <a:avLst/>
            </a:prstGeom>
            <a:noFill/>
          </p:spPr>
          <p:txBody>
            <a:bodyPr wrap="square" rtlCol="0">
              <a:spAutoFit/>
            </a:bodyPr>
            <a:lstStyle/>
            <a:p>
              <a:r>
                <a:rPr lang="en-US" altLang="ko-KR" sz="2000" b="1" dirty="0" smtClean="0">
                  <a:latin typeface="Arial" panose="020B0604020202020204" pitchFamily="34" charset="0"/>
                  <a:cs typeface="Arial" panose="020B0604020202020204" pitchFamily="34" charset="0"/>
                </a:rPr>
                <a:t>Individual sample set</a:t>
              </a:r>
              <a:endParaRPr lang="ko-KR" altLang="en-US" sz="2000" b="1" dirty="0">
                <a:latin typeface="Arial" panose="020B0604020202020204" pitchFamily="34" charset="0"/>
                <a:cs typeface="Arial" panose="020B0604020202020204" pitchFamily="34" charset="0"/>
              </a:endParaRPr>
            </a:p>
          </p:txBody>
        </p:sp>
        <p:sp>
          <p:nvSpPr>
            <p:cNvPr id="300" name="타원 299"/>
            <p:cNvSpPr/>
            <p:nvPr/>
          </p:nvSpPr>
          <p:spPr>
            <a:xfrm>
              <a:off x="8362519" y="1280488"/>
              <a:ext cx="4584897" cy="4339190"/>
            </a:xfrm>
            <a:prstGeom prst="ellipse">
              <a:avLst/>
            </a:prstGeom>
            <a:solidFill>
              <a:schemeClr val="accent5">
                <a:lumMod val="60000"/>
                <a:lumOff val="40000"/>
                <a:alpha val="56000"/>
              </a:schemeClr>
            </a:solidFill>
            <a:ln w="1270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01" name="타원 300"/>
            <p:cNvSpPr/>
            <p:nvPr/>
          </p:nvSpPr>
          <p:spPr>
            <a:xfrm>
              <a:off x="8647831" y="1744857"/>
              <a:ext cx="3826700" cy="3850637"/>
            </a:xfrm>
            <a:prstGeom prst="ellipse">
              <a:avLst/>
            </a:prstGeom>
            <a:solidFill>
              <a:schemeClr val="accent6">
                <a:lumMod val="60000"/>
                <a:lumOff val="40000"/>
                <a:alpha val="29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02" name="TextBox 301"/>
            <p:cNvSpPr txBox="1"/>
            <p:nvPr/>
          </p:nvSpPr>
          <p:spPr>
            <a:xfrm>
              <a:off x="12390456" y="896893"/>
              <a:ext cx="1397848" cy="494105"/>
            </a:xfrm>
            <a:prstGeom prst="rect">
              <a:avLst/>
            </a:prstGeom>
            <a:noFill/>
          </p:spPr>
          <p:txBody>
            <a:bodyPr wrap="square" rtlCol="0">
              <a:spAutoFit/>
            </a:bodyPr>
            <a:lstStyle/>
            <a:p>
              <a:r>
                <a:rPr lang="en-US" altLang="ko-KR" b="1" dirty="0" smtClean="0">
                  <a:solidFill>
                    <a:schemeClr val="accent5">
                      <a:lumMod val="75000"/>
                    </a:schemeClr>
                  </a:solidFill>
                  <a:latin typeface="Arial" panose="020B0604020202020204" pitchFamily="34" charset="0"/>
                  <a:cs typeface="Arial" panose="020B0604020202020204" pitchFamily="34" charset="0"/>
                </a:rPr>
                <a:t>8,746</a:t>
              </a:r>
              <a:endParaRPr lang="ko-KR" altLang="en-US" b="1" dirty="0">
                <a:solidFill>
                  <a:schemeClr val="accent5">
                    <a:lumMod val="75000"/>
                  </a:schemeClr>
                </a:solidFill>
                <a:latin typeface="Arial" panose="020B0604020202020204" pitchFamily="34" charset="0"/>
                <a:cs typeface="Arial" panose="020B0604020202020204" pitchFamily="34" charset="0"/>
              </a:endParaRPr>
            </a:p>
          </p:txBody>
        </p:sp>
        <p:sp>
          <p:nvSpPr>
            <p:cNvPr id="303" name="TextBox 302"/>
            <p:cNvSpPr txBox="1"/>
            <p:nvPr/>
          </p:nvSpPr>
          <p:spPr>
            <a:xfrm>
              <a:off x="10913487" y="552346"/>
              <a:ext cx="3940388" cy="490516"/>
            </a:xfrm>
            <a:prstGeom prst="rect">
              <a:avLst/>
            </a:prstGeom>
            <a:noFill/>
          </p:spPr>
          <p:txBody>
            <a:bodyPr wrap="square" rtlCol="0">
              <a:spAutoFit/>
            </a:bodyPr>
            <a:lstStyle/>
            <a:p>
              <a:pPr algn="ctr"/>
              <a:r>
                <a:rPr lang="en-US" altLang="ko-KR" b="1" dirty="0" smtClean="0">
                  <a:solidFill>
                    <a:schemeClr val="accent5">
                      <a:lumMod val="75000"/>
                    </a:schemeClr>
                  </a:solidFill>
                  <a:latin typeface="Arial" panose="020B0604020202020204" pitchFamily="34" charset="0"/>
                  <a:cs typeface="Arial" panose="020B0604020202020204" pitchFamily="34" charset="0"/>
                </a:rPr>
                <a:t>Total Identified proteins</a:t>
              </a:r>
              <a:endParaRPr lang="ko-KR" altLang="en-US" b="1" dirty="0">
                <a:solidFill>
                  <a:schemeClr val="accent5">
                    <a:lumMod val="75000"/>
                  </a:schemeClr>
                </a:solidFill>
                <a:latin typeface="Arial" panose="020B0604020202020204" pitchFamily="34" charset="0"/>
                <a:cs typeface="Arial" panose="020B0604020202020204" pitchFamily="34" charset="0"/>
              </a:endParaRPr>
            </a:p>
          </p:txBody>
        </p:sp>
        <p:sp>
          <p:nvSpPr>
            <p:cNvPr id="304" name="TextBox 303"/>
            <p:cNvSpPr txBox="1"/>
            <p:nvPr/>
          </p:nvSpPr>
          <p:spPr>
            <a:xfrm>
              <a:off x="9483469" y="3044246"/>
              <a:ext cx="2155423" cy="1365901"/>
            </a:xfrm>
            <a:prstGeom prst="rect">
              <a:avLst/>
            </a:prstGeom>
            <a:noFill/>
          </p:spPr>
          <p:txBody>
            <a:bodyPr wrap="square" rtlCol="0">
              <a:spAutoFit/>
            </a:bodyPr>
            <a:lstStyle/>
            <a:p>
              <a:pPr algn="ctr"/>
              <a:r>
                <a:rPr lang="en-US" altLang="ko-KR" b="1" smtClean="0">
                  <a:solidFill>
                    <a:schemeClr val="accent6">
                      <a:lumMod val="50000"/>
                    </a:schemeClr>
                  </a:solidFill>
                  <a:latin typeface="Arial" panose="020B0604020202020204" pitchFamily="34" charset="0"/>
                  <a:cs typeface="Arial" panose="020B0604020202020204" pitchFamily="34" charset="0"/>
                </a:rPr>
                <a:t>Quantified</a:t>
              </a:r>
            </a:p>
            <a:p>
              <a:pPr algn="ctr"/>
              <a:r>
                <a:rPr lang="en-US" altLang="ko-KR" b="1" smtClean="0">
                  <a:solidFill>
                    <a:schemeClr val="accent6">
                      <a:lumMod val="50000"/>
                    </a:schemeClr>
                  </a:solidFill>
                  <a:latin typeface="Arial" panose="020B0604020202020204" pitchFamily="34" charset="0"/>
                  <a:cs typeface="Arial" panose="020B0604020202020204" pitchFamily="34" charset="0"/>
                </a:rPr>
                <a:t>Proteins</a:t>
              </a:r>
            </a:p>
            <a:p>
              <a:pPr algn="ctr"/>
              <a:r>
                <a:rPr lang="en-US" altLang="ko-KR" b="1" smtClean="0">
                  <a:solidFill>
                    <a:schemeClr val="accent6">
                      <a:lumMod val="50000"/>
                    </a:schemeClr>
                  </a:solidFill>
                  <a:latin typeface="Arial" panose="020B0604020202020204" pitchFamily="34" charset="0"/>
                  <a:cs typeface="Arial" panose="020B0604020202020204" pitchFamily="34" charset="0"/>
                </a:rPr>
                <a:t>6,642</a:t>
              </a:r>
              <a:endParaRPr lang="ko-KR" altLang="en-US" b="1">
                <a:solidFill>
                  <a:schemeClr val="accent6">
                    <a:lumMod val="50000"/>
                  </a:schemeClr>
                </a:solidFill>
                <a:latin typeface="Arial" panose="020B0604020202020204" pitchFamily="34" charset="0"/>
                <a:cs typeface="Arial" panose="020B0604020202020204" pitchFamily="34" charset="0"/>
              </a:endParaRPr>
            </a:p>
          </p:txBody>
        </p:sp>
      </p:grpSp>
      <p:grpSp>
        <p:nvGrpSpPr>
          <p:cNvPr id="305" name="그룹 304"/>
          <p:cNvGrpSpPr/>
          <p:nvPr/>
        </p:nvGrpSpPr>
        <p:grpSpPr>
          <a:xfrm>
            <a:off x="4067582" y="4550818"/>
            <a:ext cx="5628809" cy="3912384"/>
            <a:chOff x="4286123" y="6674791"/>
            <a:chExt cx="7320561" cy="5280686"/>
          </a:xfrm>
        </p:grpSpPr>
        <p:sp>
          <p:nvSpPr>
            <p:cNvPr id="306" name="타원 305"/>
            <p:cNvSpPr/>
            <p:nvPr/>
          </p:nvSpPr>
          <p:spPr>
            <a:xfrm>
              <a:off x="4859693" y="7379384"/>
              <a:ext cx="4666395" cy="4576093"/>
            </a:xfrm>
            <a:prstGeom prst="ellipse">
              <a:avLst/>
            </a:prstGeom>
            <a:solidFill>
              <a:schemeClr val="accent6">
                <a:alpha val="56000"/>
              </a:schemeClr>
            </a:solidFill>
            <a:ln w="1270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07" name="타원 306"/>
            <p:cNvSpPr/>
            <p:nvPr/>
          </p:nvSpPr>
          <p:spPr>
            <a:xfrm>
              <a:off x="5128803" y="7801220"/>
              <a:ext cx="4062207" cy="4154257"/>
            </a:xfrm>
            <a:prstGeom prst="ellipse">
              <a:avLst/>
            </a:prstGeom>
            <a:solidFill>
              <a:schemeClr val="accent1">
                <a:lumMod val="75000"/>
                <a:alpha val="29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308" name="TextBox 307"/>
            <p:cNvSpPr txBox="1"/>
            <p:nvPr/>
          </p:nvSpPr>
          <p:spPr>
            <a:xfrm>
              <a:off x="4286123" y="6674791"/>
              <a:ext cx="2492404" cy="400110"/>
            </a:xfrm>
            <a:prstGeom prst="rect">
              <a:avLst/>
            </a:prstGeom>
            <a:noFill/>
          </p:spPr>
          <p:txBody>
            <a:bodyPr wrap="square" rtlCol="0">
              <a:spAutoFit/>
            </a:bodyPr>
            <a:lstStyle/>
            <a:p>
              <a:r>
                <a:rPr lang="en-US" altLang="ko-KR" sz="2000" b="1" dirty="0" smtClean="0">
                  <a:latin typeface="Arial" panose="020B0604020202020204" pitchFamily="34" charset="0"/>
                  <a:cs typeface="Arial" panose="020B0604020202020204" pitchFamily="34" charset="0"/>
                </a:rPr>
                <a:t>Cell lines set</a:t>
              </a:r>
              <a:endParaRPr lang="ko-KR" altLang="en-US" sz="2000" b="1" dirty="0">
                <a:latin typeface="Arial" panose="020B0604020202020204" pitchFamily="34" charset="0"/>
                <a:cs typeface="Arial" panose="020B0604020202020204" pitchFamily="34" charset="0"/>
              </a:endParaRPr>
            </a:p>
          </p:txBody>
        </p:sp>
        <p:sp>
          <p:nvSpPr>
            <p:cNvPr id="309" name="TextBox 308"/>
            <p:cNvSpPr txBox="1"/>
            <p:nvPr/>
          </p:nvSpPr>
          <p:spPr>
            <a:xfrm>
              <a:off x="7037414" y="6740215"/>
              <a:ext cx="4569270" cy="872376"/>
            </a:xfrm>
            <a:prstGeom prst="rect">
              <a:avLst/>
            </a:prstGeom>
            <a:noFill/>
          </p:spPr>
          <p:txBody>
            <a:bodyPr wrap="square" rtlCol="0">
              <a:spAutoFit/>
            </a:bodyPr>
            <a:lstStyle/>
            <a:p>
              <a:pPr algn="ctr"/>
              <a:r>
                <a:rPr lang="en-US" altLang="ko-KR" b="1" dirty="0" smtClean="0">
                  <a:solidFill>
                    <a:schemeClr val="accent6">
                      <a:lumMod val="50000"/>
                    </a:schemeClr>
                  </a:solidFill>
                  <a:latin typeface="Arial" panose="020B0604020202020204" pitchFamily="34" charset="0"/>
                  <a:cs typeface="Arial" panose="020B0604020202020204" pitchFamily="34" charset="0"/>
                </a:rPr>
                <a:t>Total Identified proteins</a:t>
              </a:r>
            </a:p>
            <a:p>
              <a:pPr algn="ctr"/>
              <a:r>
                <a:rPr lang="en-US" altLang="ko-KR" b="1" dirty="0" smtClean="0">
                  <a:solidFill>
                    <a:schemeClr val="accent6">
                      <a:lumMod val="50000"/>
                    </a:schemeClr>
                  </a:solidFill>
                  <a:latin typeface="Arial" panose="020B0604020202020204" pitchFamily="34" charset="0"/>
                  <a:cs typeface="Arial" panose="020B0604020202020204" pitchFamily="34" charset="0"/>
                </a:rPr>
                <a:t>7,823</a:t>
              </a:r>
              <a:endParaRPr lang="ko-KR" altLang="en-US" b="1" dirty="0">
                <a:solidFill>
                  <a:schemeClr val="accent6">
                    <a:lumMod val="50000"/>
                  </a:schemeClr>
                </a:solidFill>
                <a:latin typeface="Arial" panose="020B0604020202020204" pitchFamily="34" charset="0"/>
                <a:cs typeface="Arial" panose="020B0604020202020204" pitchFamily="34" charset="0"/>
              </a:endParaRPr>
            </a:p>
          </p:txBody>
        </p:sp>
        <p:sp>
          <p:nvSpPr>
            <p:cNvPr id="310" name="TextBox 309"/>
            <p:cNvSpPr txBox="1"/>
            <p:nvPr/>
          </p:nvSpPr>
          <p:spPr>
            <a:xfrm>
              <a:off x="6171706" y="9376641"/>
              <a:ext cx="2033012" cy="1297789"/>
            </a:xfrm>
            <a:prstGeom prst="rect">
              <a:avLst/>
            </a:prstGeom>
            <a:noFill/>
          </p:spPr>
          <p:txBody>
            <a:bodyPr wrap="square" rtlCol="0">
              <a:spAutoFit/>
            </a:bodyPr>
            <a:lstStyle/>
            <a:p>
              <a:pPr algn="ctr"/>
              <a:r>
                <a:rPr lang="en-US" altLang="ko-KR" b="1" dirty="0" smtClean="0">
                  <a:solidFill>
                    <a:srgbClr val="002060"/>
                  </a:solidFill>
                  <a:latin typeface="Arial" panose="020B0604020202020204" pitchFamily="34" charset="0"/>
                  <a:cs typeface="Arial" panose="020B0604020202020204" pitchFamily="34" charset="0"/>
                </a:rPr>
                <a:t>Quantified</a:t>
              </a:r>
            </a:p>
            <a:p>
              <a:pPr algn="ctr"/>
              <a:r>
                <a:rPr lang="en-US" altLang="ko-KR" b="1" dirty="0" smtClean="0">
                  <a:solidFill>
                    <a:srgbClr val="002060"/>
                  </a:solidFill>
                  <a:latin typeface="Arial" panose="020B0604020202020204" pitchFamily="34" charset="0"/>
                  <a:cs typeface="Arial" panose="020B0604020202020204" pitchFamily="34" charset="0"/>
                </a:rPr>
                <a:t>Proteins</a:t>
              </a:r>
            </a:p>
            <a:p>
              <a:pPr algn="ctr"/>
              <a:r>
                <a:rPr lang="en-US" altLang="ko-KR" b="1" dirty="0" smtClean="0">
                  <a:solidFill>
                    <a:srgbClr val="002060"/>
                  </a:solidFill>
                  <a:latin typeface="Arial" panose="020B0604020202020204" pitchFamily="34" charset="0"/>
                  <a:cs typeface="Arial" panose="020B0604020202020204" pitchFamily="34" charset="0"/>
                </a:rPr>
                <a:t>7592</a:t>
              </a:r>
            </a:p>
          </p:txBody>
        </p:sp>
      </p:grpSp>
      <p:pic>
        <p:nvPicPr>
          <p:cNvPr id="312" name="그림 311"/>
          <p:cNvPicPr>
            <a:picLocks noChangeAspect="1"/>
          </p:cNvPicPr>
          <p:nvPr/>
        </p:nvPicPr>
        <p:blipFill rotWithShape="1">
          <a:blip r:embed="rId3"/>
          <a:srcRect l="11163" t="2475" r="2002" b="39144"/>
          <a:stretch/>
        </p:blipFill>
        <p:spPr>
          <a:xfrm>
            <a:off x="7851100" y="10816042"/>
            <a:ext cx="6258790" cy="4962063"/>
          </a:xfrm>
          <a:prstGeom prst="rect">
            <a:avLst/>
          </a:prstGeom>
        </p:spPr>
      </p:pic>
      <p:pic>
        <p:nvPicPr>
          <p:cNvPr id="313" name="그림 312"/>
          <p:cNvPicPr>
            <a:picLocks noChangeAspect="1"/>
          </p:cNvPicPr>
          <p:nvPr/>
        </p:nvPicPr>
        <p:blipFill rotWithShape="1">
          <a:blip r:embed="rId4"/>
          <a:srcRect l="11736" t="4058" b="31410"/>
          <a:stretch/>
        </p:blipFill>
        <p:spPr>
          <a:xfrm>
            <a:off x="484446" y="10875293"/>
            <a:ext cx="6374716" cy="4790167"/>
          </a:xfrm>
          <a:prstGeom prst="rect">
            <a:avLst/>
          </a:prstGeom>
        </p:spPr>
      </p:pic>
      <p:sp>
        <p:nvSpPr>
          <p:cNvPr id="314" name="TextBox 313"/>
          <p:cNvSpPr txBox="1"/>
          <p:nvPr/>
        </p:nvSpPr>
        <p:spPr>
          <a:xfrm rot="16200000">
            <a:off x="-1613320" y="13033719"/>
            <a:ext cx="3752347" cy="338553"/>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Number of Identified proteins</a:t>
            </a:r>
            <a:endParaRPr lang="ko-KR" altLang="en-US" sz="1600" b="1" dirty="0">
              <a:latin typeface="Arial" panose="020B0604020202020204" pitchFamily="34" charset="0"/>
              <a:cs typeface="Arial" panose="020B0604020202020204" pitchFamily="34" charset="0"/>
            </a:endParaRPr>
          </a:p>
        </p:txBody>
      </p:sp>
      <p:sp>
        <p:nvSpPr>
          <p:cNvPr id="315" name="왼쪽 대괄호 314"/>
          <p:cNvSpPr/>
          <p:nvPr/>
        </p:nvSpPr>
        <p:spPr>
          <a:xfrm rot="16200000">
            <a:off x="1317724" y="15856587"/>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16" name="TextBox 315"/>
          <p:cNvSpPr txBox="1"/>
          <p:nvPr/>
        </p:nvSpPr>
        <p:spPr>
          <a:xfrm rot="18993510">
            <a:off x="1030217" y="15615763"/>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17" name="TextBox 316"/>
          <p:cNvSpPr txBox="1"/>
          <p:nvPr/>
        </p:nvSpPr>
        <p:spPr>
          <a:xfrm rot="18993510">
            <a:off x="1289104"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18" name="TextBox 317"/>
          <p:cNvSpPr txBox="1"/>
          <p:nvPr/>
        </p:nvSpPr>
        <p:spPr>
          <a:xfrm rot="18993510">
            <a:off x="1632491" y="15625658"/>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19" name="TextBox 318"/>
          <p:cNvSpPr txBox="1"/>
          <p:nvPr/>
        </p:nvSpPr>
        <p:spPr>
          <a:xfrm rot="18993510">
            <a:off x="1883253"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20" name="TextBox 319"/>
          <p:cNvSpPr txBox="1"/>
          <p:nvPr/>
        </p:nvSpPr>
        <p:spPr>
          <a:xfrm rot="18993510">
            <a:off x="2218291" y="15625658"/>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21" name="TextBox 320"/>
          <p:cNvSpPr txBox="1"/>
          <p:nvPr/>
        </p:nvSpPr>
        <p:spPr>
          <a:xfrm rot="18993510">
            <a:off x="2460926" y="15645447"/>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22" name="TextBox 321"/>
          <p:cNvSpPr txBox="1"/>
          <p:nvPr/>
        </p:nvSpPr>
        <p:spPr>
          <a:xfrm rot="18993510">
            <a:off x="2820566" y="1563555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23" name="TextBox 322"/>
          <p:cNvSpPr txBox="1"/>
          <p:nvPr/>
        </p:nvSpPr>
        <p:spPr>
          <a:xfrm rot="18993510">
            <a:off x="3038822" y="15665236"/>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000" b="1" dirty="0">
              <a:latin typeface="Arial" panose="020B0604020202020204" pitchFamily="34" charset="0"/>
              <a:cs typeface="Arial" panose="020B0604020202020204" pitchFamily="34" charset="0"/>
            </a:endParaRPr>
          </a:p>
        </p:txBody>
      </p:sp>
      <p:sp>
        <p:nvSpPr>
          <p:cNvPr id="324" name="TextBox 323"/>
          <p:cNvSpPr txBox="1"/>
          <p:nvPr/>
        </p:nvSpPr>
        <p:spPr>
          <a:xfrm rot="18993510">
            <a:off x="3395513" y="1563555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25" name="TextBox 324"/>
          <p:cNvSpPr txBox="1"/>
          <p:nvPr/>
        </p:nvSpPr>
        <p:spPr>
          <a:xfrm rot="18993510">
            <a:off x="3646275"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26" name="TextBox 325"/>
          <p:cNvSpPr txBox="1"/>
          <p:nvPr/>
        </p:nvSpPr>
        <p:spPr>
          <a:xfrm rot="18993510">
            <a:off x="3981535" y="1563555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27" name="TextBox 326"/>
          <p:cNvSpPr txBox="1"/>
          <p:nvPr/>
        </p:nvSpPr>
        <p:spPr>
          <a:xfrm rot="18993510">
            <a:off x="4232297"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28" name="TextBox 327"/>
          <p:cNvSpPr txBox="1"/>
          <p:nvPr/>
        </p:nvSpPr>
        <p:spPr>
          <a:xfrm rot="18993510">
            <a:off x="4567335" y="1563555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29" name="TextBox 328"/>
          <p:cNvSpPr txBox="1"/>
          <p:nvPr/>
        </p:nvSpPr>
        <p:spPr>
          <a:xfrm rot="18993510">
            <a:off x="4818096"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30" name="TextBox 329"/>
          <p:cNvSpPr txBox="1"/>
          <p:nvPr/>
        </p:nvSpPr>
        <p:spPr>
          <a:xfrm rot="18993510">
            <a:off x="5153357" y="1563555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31" name="TextBox 330"/>
          <p:cNvSpPr txBox="1"/>
          <p:nvPr/>
        </p:nvSpPr>
        <p:spPr>
          <a:xfrm rot="18993510">
            <a:off x="5395992"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32" name="TextBox 331"/>
          <p:cNvSpPr txBox="1"/>
          <p:nvPr/>
        </p:nvSpPr>
        <p:spPr>
          <a:xfrm rot="18993510">
            <a:off x="5704563" y="1563555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33" name="TextBox 332"/>
          <p:cNvSpPr txBox="1"/>
          <p:nvPr/>
        </p:nvSpPr>
        <p:spPr>
          <a:xfrm rot="18993510">
            <a:off x="5947198" y="15635552"/>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34" name="TextBox 333"/>
          <p:cNvSpPr txBox="1"/>
          <p:nvPr/>
        </p:nvSpPr>
        <p:spPr>
          <a:xfrm rot="18993510">
            <a:off x="6226161" y="15657551"/>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Total</a:t>
            </a:r>
            <a:endParaRPr lang="ko-KR" altLang="en-US" sz="1200" b="1" dirty="0">
              <a:latin typeface="Arial" panose="020B0604020202020204" pitchFamily="34" charset="0"/>
              <a:cs typeface="Arial" panose="020B0604020202020204" pitchFamily="34" charset="0"/>
            </a:endParaRPr>
          </a:p>
        </p:txBody>
      </p:sp>
      <p:sp>
        <p:nvSpPr>
          <p:cNvPr id="335" name="왼쪽 대괄호 334"/>
          <p:cNvSpPr/>
          <p:nvPr/>
        </p:nvSpPr>
        <p:spPr>
          <a:xfrm rot="16200000">
            <a:off x="1923900" y="15864678"/>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36" name="왼쪽 대괄호 335"/>
          <p:cNvSpPr/>
          <p:nvPr/>
        </p:nvSpPr>
        <p:spPr>
          <a:xfrm rot="16200000">
            <a:off x="2526176" y="15871687"/>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37" name="왼쪽 대괄호 336"/>
          <p:cNvSpPr/>
          <p:nvPr/>
        </p:nvSpPr>
        <p:spPr>
          <a:xfrm rot="16200000">
            <a:off x="3078604" y="15866684"/>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38" name="왼쪽 대괄호 337"/>
          <p:cNvSpPr/>
          <p:nvPr/>
        </p:nvSpPr>
        <p:spPr>
          <a:xfrm rot="16200000">
            <a:off x="3684779" y="15864881"/>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39" name="왼쪽 대괄호 338"/>
          <p:cNvSpPr/>
          <p:nvPr/>
        </p:nvSpPr>
        <p:spPr>
          <a:xfrm rot="16200000">
            <a:off x="4239430" y="15861995"/>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40" name="왼쪽 대괄호 339"/>
          <p:cNvSpPr/>
          <p:nvPr/>
        </p:nvSpPr>
        <p:spPr>
          <a:xfrm rot="16200000">
            <a:off x="4821902" y="15865987"/>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41" name="왼쪽 대괄호 340"/>
          <p:cNvSpPr/>
          <p:nvPr/>
        </p:nvSpPr>
        <p:spPr>
          <a:xfrm rot="16200000">
            <a:off x="5405098" y="15864184"/>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42" name="왼쪽 대괄호 341"/>
          <p:cNvSpPr/>
          <p:nvPr/>
        </p:nvSpPr>
        <p:spPr>
          <a:xfrm rot="16200000">
            <a:off x="5917758" y="15857341"/>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43" name="TextBox 342"/>
          <p:cNvSpPr txBox="1"/>
          <p:nvPr/>
        </p:nvSpPr>
        <p:spPr>
          <a:xfrm>
            <a:off x="1156955" y="16096224"/>
            <a:ext cx="551206"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S</a:t>
            </a:r>
            <a:r>
              <a:rPr lang="en-US" altLang="ko-KR" sz="1200" b="1" dirty="0" smtClean="0">
                <a:latin typeface="Arial" panose="020B0604020202020204" pitchFamily="34" charset="0"/>
                <a:cs typeface="Arial" panose="020B0604020202020204" pitchFamily="34" charset="0"/>
              </a:rPr>
              <a:t>et1</a:t>
            </a:r>
            <a:endParaRPr lang="ko-KR" altLang="en-US" sz="1200" b="1" dirty="0">
              <a:latin typeface="Arial" panose="020B0604020202020204" pitchFamily="34" charset="0"/>
              <a:cs typeface="Arial" panose="020B0604020202020204" pitchFamily="34" charset="0"/>
            </a:endParaRPr>
          </a:p>
        </p:txBody>
      </p:sp>
      <p:sp>
        <p:nvSpPr>
          <p:cNvPr id="344" name="TextBox 343"/>
          <p:cNvSpPr txBox="1"/>
          <p:nvPr/>
        </p:nvSpPr>
        <p:spPr>
          <a:xfrm>
            <a:off x="1751104" y="1610117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2</a:t>
            </a:r>
            <a:endParaRPr lang="ko-KR" altLang="en-US" sz="1200" b="1" dirty="0">
              <a:latin typeface="Arial" panose="020B0604020202020204" pitchFamily="34" charset="0"/>
              <a:cs typeface="Arial" panose="020B0604020202020204" pitchFamily="34" charset="0"/>
            </a:endParaRPr>
          </a:p>
        </p:txBody>
      </p:sp>
      <p:sp>
        <p:nvSpPr>
          <p:cNvPr id="345" name="TextBox 344"/>
          <p:cNvSpPr txBox="1"/>
          <p:nvPr/>
        </p:nvSpPr>
        <p:spPr>
          <a:xfrm>
            <a:off x="2344358" y="16106119"/>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3</a:t>
            </a:r>
            <a:endParaRPr lang="ko-KR" altLang="en-US" sz="1200" b="1" dirty="0">
              <a:latin typeface="Arial" panose="020B0604020202020204" pitchFamily="34" charset="0"/>
              <a:cs typeface="Arial" panose="020B0604020202020204" pitchFamily="34" charset="0"/>
            </a:endParaRPr>
          </a:p>
        </p:txBody>
      </p:sp>
      <p:sp>
        <p:nvSpPr>
          <p:cNvPr id="346" name="TextBox 345"/>
          <p:cNvSpPr txBox="1"/>
          <p:nvPr/>
        </p:nvSpPr>
        <p:spPr>
          <a:xfrm>
            <a:off x="2912681" y="16109072"/>
            <a:ext cx="551206"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S</a:t>
            </a:r>
            <a:r>
              <a:rPr lang="en-US" altLang="ko-KR" sz="1200" b="1" dirty="0" smtClean="0">
                <a:latin typeface="Arial" panose="020B0604020202020204" pitchFamily="34" charset="0"/>
                <a:cs typeface="Arial" panose="020B0604020202020204" pitchFamily="34" charset="0"/>
              </a:rPr>
              <a:t>et1</a:t>
            </a:r>
            <a:endParaRPr lang="ko-KR" altLang="en-US" sz="1200" b="1" dirty="0">
              <a:latin typeface="Arial" panose="020B0604020202020204" pitchFamily="34" charset="0"/>
              <a:cs typeface="Arial" panose="020B0604020202020204" pitchFamily="34" charset="0"/>
            </a:endParaRPr>
          </a:p>
        </p:txBody>
      </p:sp>
      <p:sp>
        <p:nvSpPr>
          <p:cNvPr id="347" name="TextBox 346"/>
          <p:cNvSpPr txBox="1"/>
          <p:nvPr/>
        </p:nvSpPr>
        <p:spPr>
          <a:xfrm>
            <a:off x="3506830" y="1610907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2</a:t>
            </a:r>
            <a:endParaRPr lang="ko-KR" altLang="en-US" sz="1200" b="1" dirty="0">
              <a:latin typeface="Arial" panose="020B0604020202020204" pitchFamily="34" charset="0"/>
              <a:cs typeface="Arial" panose="020B0604020202020204" pitchFamily="34" charset="0"/>
            </a:endParaRPr>
          </a:p>
        </p:txBody>
      </p:sp>
      <p:sp>
        <p:nvSpPr>
          <p:cNvPr id="348" name="TextBox 347"/>
          <p:cNvSpPr txBox="1"/>
          <p:nvPr/>
        </p:nvSpPr>
        <p:spPr>
          <a:xfrm>
            <a:off x="4090559" y="16109072"/>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3</a:t>
            </a:r>
            <a:endParaRPr lang="ko-KR" altLang="en-US" sz="1200" b="1" dirty="0">
              <a:latin typeface="Arial" panose="020B0604020202020204" pitchFamily="34" charset="0"/>
              <a:cs typeface="Arial" panose="020B0604020202020204" pitchFamily="34" charset="0"/>
            </a:endParaRPr>
          </a:p>
        </p:txBody>
      </p:sp>
      <p:sp>
        <p:nvSpPr>
          <p:cNvPr id="349" name="TextBox 348"/>
          <p:cNvSpPr txBox="1"/>
          <p:nvPr/>
        </p:nvSpPr>
        <p:spPr>
          <a:xfrm>
            <a:off x="4666161" y="16109753"/>
            <a:ext cx="551206"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S</a:t>
            </a:r>
            <a:r>
              <a:rPr lang="en-US" altLang="ko-KR" sz="1200" b="1" dirty="0" smtClean="0">
                <a:latin typeface="Arial" panose="020B0604020202020204" pitchFamily="34" charset="0"/>
                <a:cs typeface="Arial" panose="020B0604020202020204" pitchFamily="34" charset="0"/>
              </a:rPr>
              <a:t>et1</a:t>
            </a:r>
            <a:endParaRPr lang="ko-KR" altLang="en-US" sz="1200" b="1" dirty="0">
              <a:latin typeface="Arial" panose="020B0604020202020204" pitchFamily="34" charset="0"/>
              <a:cs typeface="Arial" panose="020B0604020202020204" pitchFamily="34" charset="0"/>
            </a:endParaRPr>
          </a:p>
        </p:txBody>
      </p:sp>
      <p:sp>
        <p:nvSpPr>
          <p:cNvPr id="350" name="TextBox 349"/>
          <p:cNvSpPr txBox="1"/>
          <p:nvPr/>
        </p:nvSpPr>
        <p:spPr>
          <a:xfrm>
            <a:off x="5246722" y="16114700"/>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2</a:t>
            </a:r>
            <a:endParaRPr lang="ko-KR" altLang="en-US" sz="1200" b="1" dirty="0">
              <a:latin typeface="Arial" panose="020B0604020202020204" pitchFamily="34" charset="0"/>
              <a:cs typeface="Arial" panose="020B0604020202020204" pitchFamily="34" charset="0"/>
            </a:endParaRPr>
          </a:p>
        </p:txBody>
      </p:sp>
      <p:sp>
        <p:nvSpPr>
          <p:cNvPr id="351" name="TextBox 350"/>
          <p:cNvSpPr txBox="1"/>
          <p:nvPr/>
        </p:nvSpPr>
        <p:spPr>
          <a:xfrm>
            <a:off x="5747109" y="16105425"/>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3</a:t>
            </a:r>
            <a:endParaRPr lang="ko-KR" altLang="en-US" sz="1200" b="1" dirty="0">
              <a:latin typeface="Arial" panose="020B0604020202020204" pitchFamily="34" charset="0"/>
              <a:cs typeface="Arial" panose="020B0604020202020204" pitchFamily="34" charset="0"/>
            </a:endParaRPr>
          </a:p>
        </p:txBody>
      </p:sp>
      <p:sp>
        <p:nvSpPr>
          <p:cNvPr id="352" name="직사각형 351"/>
          <p:cNvSpPr/>
          <p:nvPr/>
        </p:nvSpPr>
        <p:spPr>
          <a:xfrm>
            <a:off x="5452729" y="16662783"/>
            <a:ext cx="483154" cy="144813"/>
          </a:xfrm>
          <a:prstGeom prst="rect">
            <a:avLst/>
          </a:prstGeom>
          <a:solidFill>
            <a:srgbClr val="FFA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200">
              <a:solidFill>
                <a:schemeClr val="tx1"/>
              </a:solidFill>
              <a:latin typeface="Arial" panose="020B0604020202020204" pitchFamily="34" charset="0"/>
              <a:cs typeface="Arial" panose="020B0604020202020204" pitchFamily="34" charset="0"/>
            </a:endParaRPr>
          </a:p>
        </p:txBody>
      </p:sp>
      <p:sp>
        <p:nvSpPr>
          <p:cNvPr id="353" name="직사각형 352"/>
          <p:cNvSpPr/>
          <p:nvPr/>
        </p:nvSpPr>
        <p:spPr>
          <a:xfrm>
            <a:off x="5452727" y="16896296"/>
            <a:ext cx="483155" cy="144813"/>
          </a:xfrm>
          <a:prstGeom prst="rect">
            <a:avLst/>
          </a:prstGeom>
          <a:solidFill>
            <a:srgbClr val="90BF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200">
              <a:solidFill>
                <a:schemeClr val="tx1"/>
              </a:solidFill>
              <a:latin typeface="Arial" panose="020B0604020202020204" pitchFamily="34" charset="0"/>
              <a:cs typeface="Arial" panose="020B0604020202020204" pitchFamily="34" charset="0"/>
            </a:endParaRPr>
          </a:p>
        </p:txBody>
      </p:sp>
      <p:sp>
        <p:nvSpPr>
          <p:cNvPr id="354" name="직사각형 353"/>
          <p:cNvSpPr/>
          <p:nvPr/>
        </p:nvSpPr>
        <p:spPr>
          <a:xfrm>
            <a:off x="5452846" y="17129810"/>
            <a:ext cx="483155" cy="144813"/>
          </a:xfrm>
          <a:prstGeom prst="rect">
            <a:avLst/>
          </a:prstGeom>
          <a:solidFill>
            <a:srgbClr val="FFC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200">
              <a:solidFill>
                <a:schemeClr val="tx1"/>
              </a:solidFill>
              <a:latin typeface="Arial" panose="020B0604020202020204" pitchFamily="34" charset="0"/>
              <a:cs typeface="Arial" panose="020B0604020202020204" pitchFamily="34" charset="0"/>
            </a:endParaRPr>
          </a:p>
        </p:txBody>
      </p:sp>
      <p:sp>
        <p:nvSpPr>
          <p:cNvPr id="355" name="TextBox 354"/>
          <p:cNvSpPr txBox="1"/>
          <p:nvPr/>
        </p:nvSpPr>
        <p:spPr>
          <a:xfrm>
            <a:off x="5870433" y="16568179"/>
            <a:ext cx="1038716"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HER2</a:t>
            </a:r>
            <a:endParaRPr lang="ko-KR" altLang="en-US" sz="1600" b="1" dirty="0">
              <a:latin typeface="Arial" panose="020B0604020202020204" pitchFamily="34" charset="0"/>
              <a:cs typeface="Arial" panose="020B0604020202020204" pitchFamily="34" charset="0"/>
            </a:endParaRPr>
          </a:p>
        </p:txBody>
      </p:sp>
      <p:sp>
        <p:nvSpPr>
          <p:cNvPr id="356" name="TextBox 355"/>
          <p:cNvSpPr txBox="1"/>
          <p:nvPr/>
        </p:nvSpPr>
        <p:spPr>
          <a:xfrm>
            <a:off x="5852809" y="16794224"/>
            <a:ext cx="775842"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TNBC</a:t>
            </a:r>
            <a:endParaRPr lang="ko-KR" altLang="en-US" sz="1600" b="1" dirty="0">
              <a:latin typeface="Arial" panose="020B0604020202020204" pitchFamily="34" charset="0"/>
              <a:cs typeface="Arial" panose="020B0604020202020204" pitchFamily="34" charset="0"/>
            </a:endParaRPr>
          </a:p>
        </p:txBody>
      </p:sp>
      <p:sp>
        <p:nvSpPr>
          <p:cNvPr id="357" name="TextBox 356"/>
          <p:cNvSpPr txBox="1"/>
          <p:nvPr/>
        </p:nvSpPr>
        <p:spPr>
          <a:xfrm>
            <a:off x="5870433" y="17030705"/>
            <a:ext cx="991818"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Luminal</a:t>
            </a:r>
            <a:endParaRPr lang="ko-KR" altLang="en-US" sz="1600" b="1" dirty="0">
              <a:latin typeface="Arial" panose="020B0604020202020204" pitchFamily="34" charset="0"/>
              <a:cs typeface="Arial" panose="020B0604020202020204" pitchFamily="34" charset="0"/>
            </a:endParaRPr>
          </a:p>
        </p:txBody>
      </p:sp>
      <p:cxnSp>
        <p:nvCxnSpPr>
          <p:cNvPr id="358" name="직선 연결선 357"/>
          <p:cNvCxnSpPr/>
          <p:nvPr/>
        </p:nvCxnSpPr>
        <p:spPr>
          <a:xfrm>
            <a:off x="1171960" y="12191569"/>
            <a:ext cx="5267767" cy="0"/>
          </a:xfrm>
          <a:prstGeom prst="line">
            <a:avLst/>
          </a:prstGeom>
          <a:ln w="19050">
            <a:solidFill>
              <a:srgbClr val="C00000"/>
            </a:solidFill>
            <a:prstDash val="sysDash"/>
          </a:ln>
        </p:spPr>
        <p:style>
          <a:lnRef idx="1">
            <a:schemeClr val="accent1"/>
          </a:lnRef>
          <a:fillRef idx="0">
            <a:schemeClr val="accent1"/>
          </a:fillRef>
          <a:effectRef idx="0">
            <a:schemeClr val="accent1"/>
          </a:effectRef>
          <a:fontRef idx="minor">
            <a:schemeClr val="tx1"/>
          </a:fontRef>
        </p:style>
      </p:cxnSp>
      <p:sp>
        <p:nvSpPr>
          <p:cNvPr id="359" name="TextBox 358"/>
          <p:cNvSpPr txBox="1"/>
          <p:nvPr/>
        </p:nvSpPr>
        <p:spPr>
          <a:xfrm>
            <a:off x="589079" y="11987746"/>
            <a:ext cx="827789" cy="338553"/>
          </a:xfrm>
          <a:prstGeom prst="rect">
            <a:avLst/>
          </a:prstGeom>
          <a:noFill/>
        </p:spPr>
        <p:txBody>
          <a:bodyPr wrap="square" rtlCol="0">
            <a:spAutoFit/>
          </a:bodyPr>
          <a:lstStyle/>
          <a:p>
            <a:r>
              <a:rPr lang="en-US" altLang="ko-KR" sz="1600" b="1" dirty="0" smtClean="0"/>
              <a:t>7515</a:t>
            </a:r>
            <a:endParaRPr lang="ko-KR" altLang="en-US" sz="1600" b="1" dirty="0"/>
          </a:p>
        </p:txBody>
      </p:sp>
      <p:sp>
        <p:nvSpPr>
          <p:cNvPr id="360" name="TextBox 359"/>
          <p:cNvSpPr txBox="1"/>
          <p:nvPr/>
        </p:nvSpPr>
        <p:spPr>
          <a:xfrm>
            <a:off x="6262284" y="11326822"/>
            <a:ext cx="818321" cy="369332"/>
          </a:xfrm>
          <a:prstGeom prst="rect">
            <a:avLst/>
          </a:prstGeom>
          <a:noFill/>
        </p:spPr>
        <p:txBody>
          <a:bodyPr wrap="square" rtlCol="0">
            <a:spAutoFit/>
          </a:bodyPr>
          <a:lstStyle/>
          <a:p>
            <a:r>
              <a:rPr lang="en-US" altLang="ko-KR" b="1" dirty="0" smtClean="0"/>
              <a:t>8746</a:t>
            </a:r>
            <a:endParaRPr lang="ko-KR" altLang="en-US" b="1" dirty="0"/>
          </a:p>
        </p:txBody>
      </p:sp>
      <p:cxnSp>
        <p:nvCxnSpPr>
          <p:cNvPr id="361" name="직선 연결선 360"/>
          <p:cNvCxnSpPr/>
          <p:nvPr/>
        </p:nvCxnSpPr>
        <p:spPr>
          <a:xfrm>
            <a:off x="8606684" y="11863844"/>
            <a:ext cx="5238497" cy="0"/>
          </a:xfrm>
          <a:prstGeom prst="line">
            <a:avLst/>
          </a:prstGeom>
          <a:ln w="19050">
            <a:solidFill>
              <a:srgbClr val="C00000"/>
            </a:solidFill>
            <a:prstDash val="sysDash"/>
          </a:ln>
        </p:spPr>
        <p:style>
          <a:lnRef idx="1">
            <a:schemeClr val="accent1"/>
          </a:lnRef>
          <a:fillRef idx="0">
            <a:schemeClr val="accent1"/>
          </a:fillRef>
          <a:effectRef idx="0">
            <a:schemeClr val="accent1"/>
          </a:effectRef>
          <a:fontRef idx="minor">
            <a:schemeClr val="tx1"/>
          </a:fontRef>
        </p:style>
      </p:cxnSp>
      <p:sp>
        <p:nvSpPr>
          <p:cNvPr id="362" name="TextBox 361"/>
          <p:cNvSpPr txBox="1"/>
          <p:nvPr/>
        </p:nvSpPr>
        <p:spPr>
          <a:xfrm>
            <a:off x="8078042" y="11598050"/>
            <a:ext cx="827789" cy="338553"/>
          </a:xfrm>
          <a:prstGeom prst="rect">
            <a:avLst/>
          </a:prstGeom>
          <a:noFill/>
        </p:spPr>
        <p:txBody>
          <a:bodyPr wrap="square" rtlCol="0">
            <a:spAutoFit/>
          </a:bodyPr>
          <a:lstStyle/>
          <a:p>
            <a:r>
              <a:rPr lang="en-US" altLang="ko-KR" sz="1600" b="1" dirty="0" smtClean="0"/>
              <a:t>8287</a:t>
            </a:r>
            <a:endParaRPr lang="ko-KR" altLang="en-US" sz="1050" b="1" dirty="0"/>
          </a:p>
        </p:txBody>
      </p:sp>
      <p:sp>
        <p:nvSpPr>
          <p:cNvPr id="363" name="TextBox 362"/>
          <p:cNvSpPr txBox="1"/>
          <p:nvPr/>
        </p:nvSpPr>
        <p:spPr>
          <a:xfrm>
            <a:off x="13591950" y="11017673"/>
            <a:ext cx="808263" cy="369332"/>
          </a:xfrm>
          <a:prstGeom prst="rect">
            <a:avLst/>
          </a:prstGeom>
          <a:noFill/>
        </p:spPr>
        <p:txBody>
          <a:bodyPr wrap="square" rtlCol="0">
            <a:spAutoFit/>
          </a:bodyPr>
          <a:lstStyle/>
          <a:p>
            <a:r>
              <a:rPr lang="en-US" altLang="ko-KR" b="1" dirty="0"/>
              <a:t>9</a:t>
            </a:r>
            <a:r>
              <a:rPr lang="en-US" altLang="ko-KR" b="1" dirty="0" smtClean="0"/>
              <a:t>442</a:t>
            </a:r>
            <a:endParaRPr lang="ko-KR" altLang="en-US" b="1" dirty="0"/>
          </a:p>
        </p:txBody>
      </p:sp>
      <p:sp>
        <p:nvSpPr>
          <p:cNvPr id="364" name="TextBox 363"/>
          <p:cNvSpPr txBox="1"/>
          <p:nvPr/>
        </p:nvSpPr>
        <p:spPr>
          <a:xfrm rot="16200000">
            <a:off x="5999593" y="13385866"/>
            <a:ext cx="3056874" cy="338553"/>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Number of Identified proteins</a:t>
            </a:r>
            <a:endParaRPr lang="ko-KR" altLang="en-US" sz="1600" b="1" dirty="0">
              <a:latin typeface="Arial" panose="020B0604020202020204" pitchFamily="34" charset="0"/>
              <a:cs typeface="Arial" panose="020B0604020202020204" pitchFamily="34" charset="0"/>
            </a:endParaRPr>
          </a:p>
        </p:txBody>
      </p:sp>
      <p:sp>
        <p:nvSpPr>
          <p:cNvPr id="365" name="왼쪽 대괄호 364"/>
          <p:cNvSpPr/>
          <p:nvPr/>
        </p:nvSpPr>
        <p:spPr>
          <a:xfrm rot="16200000">
            <a:off x="8736728" y="15915849"/>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66" name="TextBox 365"/>
          <p:cNvSpPr txBox="1"/>
          <p:nvPr/>
        </p:nvSpPr>
        <p:spPr>
          <a:xfrm rot="18993510">
            <a:off x="8479701" y="1567502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67" name="TextBox 366"/>
          <p:cNvSpPr txBox="1"/>
          <p:nvPr/>
        </p:nvSpPr>
        <p:spPr>
          <a:xfrm rot="18993510">
            <a:off x="8738588"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68" name="TextBox 367"/>
          <p:cNvSpPr txBox="1"/>
          <p:nvPr/>
        </p:nvSpPr>
        <p:spPr>
          <a:xfrm rot="18993510">
            <a:off x="9081975" y="15684919"/>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69" name="TextBox 368"/>
          <p:cNvSpPr txBox="1"/>
          <p:nvPr/>
        </p:nvSpPr>
        <p:spPr>
          <a:xfrm rot="18993510">
            <a:off x="9332737"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70" name="TextBox 369"/>
          <p:cNvSpPr txBox="1"/>
          <p:nvPr/>
        </p:nvSpPr>
        <p:spPr>
          <a:xfrm rot="18993510">
            <a:off x="9667775" y="15684919"/>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71" name="TextBox 370"/>
          <p:cNvSpPr txBox="1"/>
          <p:nvPr/>
        </p:nvSpPr>
        <p:spPr>
          <a:xfrm rot="18993510">
            <a:off x="9910410" y="15704708"/>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72" name="TextBox 371"/>
          <p:cNvSpPr txBox="1"/>
          <p:nvPr/>
        </p:nvSpPr>
        <p:spPr>
          <a:xfrm rot="18993510">
            <a:off x="10270050" y="1569481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73" name="TextBox 372"/>
          <p:cNvSpPr txBox="1"/>
          <p:nvPr/>
        </p:nvSpPr>
        <p:spPr>
          <a:xfrm rot="18993510">
            <a:off x="10488306" y="15713209"/>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74" name="TextBox 373"/>
          <p:cNvSpPr txBox="1"/>
          <p:nvPr/>
        </p:nvSpPr>
        <p:spPr>
          <a:xfrm rot="18993510">
            <a:off x="10844997" y="1569481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75" name="TextBox 374"/>
          <p:cNvSpPr txBox="1"/>
          <p:nvPr/>
        </p:nvSpPr>
        <p:spPr>
          <a:xfrm rot="18993510">
            <a:off x="11095759"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76" name="TextBox 375"/>
          <p:cNvSpPr txBox="1"/>
          <p:nvPr/>
        </p:nvSpPr>
        <p:spPr>
          <a:xfrm rot="18993510">
            <a:off x="11431019" y="1569481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77" name="TextBox 376"/>
          <p:cNvSpPr txBox="1"/>
          <p:nvPr/>
        </p:nvSpPr>
        <p:spPr>
          <a:xfrm rot="18993510">
            <a:off x="11681781"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78" name="TextBox 377"/>
          <p:cNvSpPr txBox="1"/>
          <p:nvPr/>
        </p:nvSpPr>
        <p:spPr>
          <a:xfrm rot="18993510">
            <a:off x="12016819" y="1569481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79" name="TextBox 378"/>
          <p:cNvSpPr txBox="1"/>
          <p:nvPr/>
        </p:nvSpPr>
        <p:spPr>
          <a:xfrm rot="18993510">
            <a:off x="12267580"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80" name="TextBox 379"/>
          <p:cNvSpPr txBox="1"/>
          <p:nvPr/>
        </p:nvSpPr>
        <p:spPr>
          <a:xfrm rot="18993510">
            <a:off x="12602841" y="1569481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81" name="TextBox 380"/>
          <p:cNvSpPr txBox="1"/>
          <p:nvPr/>
        </p:nvSpPr>
        <p:spPr>
          <a:xfrm rot="18993510">
            <a:off x="12845476"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82" name="TextBox 381"/>
          <p:cNvSpPr txBox="1"/>
          <p:nvPr/>
        </p:nvSpPr>
        <p:spPr>
          <a:xfrm rot="18993510">
            <a:off x="13154047" y="1569481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DM</a:t>
            </a:r>
            <a:endParaRPr lang="ko-KR" altLang="en-US" sz="1200" b="1" dirty="0">
              <a:latin typeface="Arial" panose="020B0604020202020204" pitchFamily="34" charset="0"/>
              <a:cs typeface="Arial" panose="020B0604020202020204" pitchFamily="34" charset="0"/>
            </a:endParaRPr>
          </a:p>
        </p:txBody>
      </p:sp>
      <p:sp>
        <p:nvSpPr>
          <p:cNvPr id="383" name="TextBox 382"/>
          <p:cNvSpPr txBox="1"/>
          <p:nvPr/>
        </p:nvSpPr>
        <p:spPr>
          <a:xfrm rot="18993510">
            <a:off x="13396682" y="15694814"/>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NDM</a:t>
            </a:r>
            <a:endParaRPr lang="ko-KR" altLang="en-US" sz="1200" b="1" dirty="0">
              <a:latin typeface="Arial" panose="020B0604020202020204" pitchFamily="34" charset="0"/>
              <a:cs typeface="Arial" panose="020B0604020202020204" pitchFamily="34" charset="0"/>
            </a:endParaRPr>
          </a:p>
        </p:txBody>
      </p:sp>
      <p:sp>
        <p:nvSpPr>
          <p:cNvPr id="384" name="TextBox 383"/>
          <p:cNvSpPr txBox="1"/>
          <p:nvPr/>
        </p:nvSpPr>
        <p:spPr>
          <a:xfrm rot="18993510">
            <a:off x="13675645" y="15716813"/>
            <a:ext cx="651032"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Total</a:t>
            </a:r>
            <a:endParaRPr lang="ko-KR" altLang="en-US" sz="1200" b="1" dirty="0">
              <a:latin typeface="Arial" panose="020B0604020202020204" pitchFamily="34" charset="0"/>
              <a:cs typeface="Arial" panose="020B0604020202020204" pitchFamily="34" charset="0"/>
            </a:endParaRPr>
          </a:p>
        </p:txBody>
      </p:sp>
      <p:sp>
        <p:nvSpPr>
          <p:cNvPr id="385" name="왼쪽 대괄호 384"/>
          <p:cNvSpPr/>
          <p:nvPr/>
        </p:nvSpPr>
        <p:spPr>
          <a:xfrm rot="16200000">
            <a:off x="9342904" y="15923941"/>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86" name="왼쪽 대괄호 385"/>
          <p:cNvSpPr/>
          <p:nvPr/>
        </p:nvSpPr>
        <p:spPr>
          <a:xfrm rot="16200000">
            <a:off x="9945180" y="15930949"/>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87" name="왼쪽 대괄호 386"/>
          <p:cNvSpPr/>
          <p:nvPr/>
        </p:nvSpPr>
        <p:spPr>
          <a:xfrm rot="16200000">
            <a:off x="10497608" y="15925946"/>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88" name="왼쪽 대괄호 387"/>
          <p:cNvSpPr/>
          <p:nvPr/>
        </p:nvSpPr>
        <p:spPr>
          <a:xfrm rot="16200000">
            <a:off x="11103783" y="15924143"/>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89" name="왼쪽 대괄호 388"/>
          <p:cNvSpPr/>
          <p:nvPr/>
        </p:nvSpPr>
        <p:spPr>
          <a:xfrm rot="16200000">
            <a:off x="11706059" y="15921257"/>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90" name="왼쪽 대괄호 389"/>
          <p:cNvSpPr/>
          <p:nvPr/>
        </p:nvSpPr>
        <p:spPr>
          <a:xfrm rot="16200000">
            <a:off x="12288531" y="15925249"/>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91" name="왼쪽 대괄호 390"/>
          <p:cNvSpPr/>
          <p:nvPr/>
        </p:nvSpPr>
        <p:spPr>
          <a:xfrm rot="16200000">
            <a:off x="12832947" y="15923447"/>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92" name="왼쪽 대괄호 391"/>
          <p:cNvSpPr/>
          <p:nvPr/>
        </p:nvSpPr>
        <p:spPr>
          <a:xfrm rot="16200000">
            <a:off x="13375089" y="15940350"/>
            <a:ext cx="150116" cy="390063"/>
          </a:xfrm>
          <a:prstGeom prst="leftBracket">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ko-KR" altLang="en-US" sz="1200">
              <a:latin typeface="Arial" panose="020B0604020202020204" pitchFamily="34" charset="0"/>
              <a:cs typeface="Arial" panose="020B0604020202020204" pitchFamily="34" charset="0"/>
            </a:endParaRPr>
          </a:p>
        </p:txBody>
      </p:sp>
      <p:sp>
        <p:nvSpPr>
          <p:cNvPr id="393" name="TextBox 392"/>
          <p:cNvSpPr txBox="1"/>
          <p:nvPr/>
        </p:nvSpPr>
        <p:spPr>
          <a:xfrm>
            <a:off x="8575959" y="16155486"/>
            <a:ext cx="551206"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S</a:t>
            </a:r>
            <a:r>
              <a:rPr lang="en-US" altLang="ko-KR" sz="1200" b="1" dirty="0" smtClean="0">
                <a:latin typeface="Arial" panose="020B0604020202020204" pitchFamily="34" charset="0"/>
                <a:cs typeface="Arial" panose="020B0604020202020204" pitchFamily="34" charset="0"/>
              </a:rPr>
              <a:t>et1</a:t>
            </a:r>
            <a:endParaRPr lang="ko-KR" altLang="en-US" sz="1200" b="1" dirty="0">
              <a:latin typeface="Arial" panose="020B0604020202020204" pitchFamily="34" charset="0"/>
              <a:cs typeface="Arial" panose="020B0604020202020204" pitchFamily="34" charset="0"/>
            </a:endParaRPr>
          </a:p>
        </p:txBody>
      </p:sp>
      <p:sp>
        <p:nvSpPr>
          <p:cNvPr id="394" name="TextBox 393"/>
          <p:cNvSpPr txBox="1"/>
          <p:nvPr/>
        </p:nvSpPr>
        <p:spPr>
          <a:xfrm>
            <a:off x="9170108" y="1616043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2</a:t>
            </a:r>
            <a:endParaRPr lang="ko-KR" altLang="en-US" sz="1200" b="1" dirty="0">
              <a:latin typeface="Arial" panose="020B0604020202020204" pitchFamily="34" charset="0"/>
              <a:cs typeface="Arial" panose="020B0604020202020204" pitchFamily="34" charset="0"/>
            </a:endParaRPr>
          </a:p>
        </p:txBody>
      </p:sp>
      <p:sp>
        <p:nvSpPr>
          <p:cNvPr id="395" name="TextBox 394"/>
          <p:cNvSpPr txBox="1"/>
          <p:nvPr/>
        </p:nvSpPr>
        <p:spPr>
          <a:xfrm>
            <a:off x="9763362" y="16165381"/>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3</a:t>
            </a:r>
            <a:endParaRPr lang="ko-KR" altLang="en-US" sz="1200" b="1" dirty="0">
              <a:latin typeface="Arial" panose="020B0604020202020204" pitchFamily="34" charset="0"/>
              <a:cs typeface="Arial" panose="020B0604020202020204" pitchFamily="34" charset="0"/>
            </a:endParaRPr>
          </a:p>
        </p:txBody>
      </p:sp>
      <p:sp>
        <p:nvSpPr>
          <p:cNvPr id="396" name="TextBox 395"/>
          <p:cNvSpPr txBox="1"/>
          <p:nvPr/>
        </p:nvSpPr>
        <p:spPr>
          <a:xfrm>
            <a:off x="10331685" y="16168334"/>
            <a:ext cx="551206"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S</a:t>
            </a:r>
            <a:r>
              <a:rPr lang="en-US" altLang="ko-KR" sz="1200" b="1" dirty="0" smtClean="0">
                <a:latin typeface="Arial" panose="020B0604020202020204" pitchFamily="34" charset="0"/>
                <a:cs typeface="Arial" panose="020B0604020202020204" pitchFamily="34" charset="0"/>
              </a:rPr>
              <a:t>et1</a:t>
            </a:r>
            <a:endParaRPr lang="ko-KR" altLang="en-US" sz="1200" b="1" dirty="0">
              <a:latin typeface="Arial" panose="020B0604020202020204" pitchFamily="34" charset="0"/>
              <a:cs typeface="Arial" panose="020B0604020202020204" pitchFamily="34" charset="0"/>
            </a:endParaRPr>
          </a:p>
        </p:txBody>
      </p:sp>
      <p:sp>
        <p:nvSpPr>
          <p:cNvPr id="397" name="TextBox 396"/>
          <p:cNvSpPr txBox="1"/>
          <p:nvPr/>
        </p:nvSpPr>
        <p:spPr>
          <a:xfrm>
            <a:off x="10925834" y="1616833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2</a:t>
            </a:r>
            <a:endParaRPr lang="ko-KR" altLang="en-US" sz="1200" b="1" dirty="0">
              <a:latin typeface="Arial" panose="020B0604020202020204" pitchFamily="34" charset="0"/>
              <a:cs typeface="Arial" panose="020B0604020202020204" pitchFamily="34" charset="0"/>
            </a:endParaRPr>
          </a:p>
        </p:txBody>
      </p:sp>
      <p:sp>
        <p:nvSpPr>
          <p:cNvPr id="398" name="TextBox 397"/>
          <p:cNvSpPr txBox="1"/>
          <p:nvPr/>
        </p:nvSpPr>
        <p:spPr>
          <a:xfrm>
            <a:off x="11519088" y="16168334"/>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3</a:t>
            </a:r>
            <a:endParaRPr lang="ko-KR" altLang="en-US" sz="1200" b="1" dirty="0">
              <a:latin typeface="Arial" panose="020B0604020202020204" pitchFamily="34" charset="0"/>
              <a:cs typeface="Arial" panose="020B0604020202020204" pitchFamily="34" charset="0"/>
            </a:endParaRPr>
          </a:p>
        </p:txBody>
      </p:sp>
      <p:sp>
        <p:nvSpPr>
          <p:cNvPr id="399" name="TextBox 398"/>
          <p:cNvSpPr txBox="1"/>
          <p:nvPr/>
        </p:nvSpPr>
        <p:spPr>
          <a:xfrm>
            <a:off x="12104215" y="16169015"/>
            <a:ext cx="551206"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S</a:t>
            </a:r>
            <a:r>
              <a:rPr lang="en-US" altLang="ko-KR" sz="1200" b="1" dirty="0" smtClean="0">
                <a:latin typeface="Arial" panose="020B0604020202020204" pitchFamily="34" charset="0"/>
                <a:cs typeface="Arial" panose="020B0604020202020204" pitchFamily="34" charset="0"/>
              </a:rPr>
              <a:t>et1</a:t>
            </a:r>
            <a:endParaRPr lang="ko-KR" altLang="en-US" sz="1200" b="1" dirty="0">
              <a:latin typeface="Arial" panose="020B0604020202020204" pitchFamily="34" charset="0"/>
              <a:cs typeface="Arial" panose="020B0604020202020204" pitchFamily="34" charset="0"/>
            </a:endParaRPr>
          </a:p>
        </p:txBody>
      </p:sp>
      <p:sp>
        <p:nvSpPr>
          <p:cNvPr id="400" name="TextBox 399"/>
          <p:cNvSpPr txBox="1"/>
          <p:nvPr/>
        </p:nvSpPr>
        <p:spPr>
          <a:xfrm>
            <a:off x="12655295" y="16162089"/>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2</a:t>
            </a:r>
            <a:endParaRPr lang="ko-KR" altLang="en-US" sz="1200" b="1" dirty="0">
              <a:latin typeface="Arial" panose="020B0604020202020204" pitchFamily="34" charset="0"/>
              <a:cs typeface="Arial" panose="020B0604020202020204" pitchFamily="34" charset="0"/>
            </a:endParaRPr>
          </a:p>
        </p:txBody>
      </p:sp>
      <p:sp>
        <p:nvSpPr>
          <p:cNvPr id="401" name="TextBox 400"/>
          <p:cNvSpPr txBox="1"/>
          <p:nvPr/>
        </p:nvSpPr>
        <p:spPr>
          <a:xfrm>
            <a:off x="13194915" y="16167036"/>
            <a:ext cx="551206" cy="276999"/>
          </a:xfrm>
          <a:prstGeom prst="rect">
            <a:avLst/>
          </a:prstGeom>
          <a:noFill/>
        </p:spPr>
        <p:txBody>
          <a:bodyPr wrap="square" rtlCol="0">
            <a:spAutoFit/>
          </a:bodyPr>
          <a:lstStyle/>
          <a:p>
            <a:r>
              <a:rPr lang="en-US" altLang="ko-KR" sz="1200" b="1" dirty="0" smtClean="0">
                <a:latin typeface="Arial" panose="020B0604020202020204" pitchFamily="34" charset="0"/>
                <a:cs typeface="Arial" panose="020B0604020202020204" pitchFamily="34" charset="0"/>
              </a:rPr>
              <a:t>Set3</a:t>
            </a:r>
            <a:endParaRPr lang="ko-KR" altLang="en-US" sz="1200" b="1" dirty="0">
              <a:latin typeface="Arial" panose="020B0604020202020204" pitchFamily="34" charset="0"/>
              <a:cs typeface="Arial" panose="020B0604020202020204" pitchFamily="34" charset="0"/>
            </a:endParaRPr>
          </a:p>
        </p:txBody>
      </p:sp>
      <p:sp>
        <p:nvSpPr>
          <p:cNvPr id="402" name="TextBox 401"/>
          <p:cNvSpPr txBox="1"/>
          <p:nvPr/>
        </p:nvSpPr>
        <p:spPr>
          <a:xfrm>
            <a:off x="1925962" y="10064391"/>
            <a:ext cx="3779070" cy="461665"/>
          </a:xfrm>
          <a:prstGeom prst="rect">
            <a:avLst/>
          </a:prstGeom>
          <a:noFill/>
        </p:spPr>
        <p:txBody>
          <a:bodyPr wrap="square" rtlCol="0">
            <a:spAutoFit/>
          </a:bodyPr>
          <a:lstStyle/>
          <a:p>
            <a:r>
              <a:rPr lang="en-US" altLang="ko-KR" sz="2400" b="1" dirty="0" smtClean="0">
                <a:latin typeface="Arial" panose="020B0604020202020204" pitchFamily="34" charset="0"/>
                <a:cs typeface="Arial" panose="020B0604020202020204" pitchFamily="34" charset="0"/>
              </a:rPr>
              <a:t>Individual sample set</a:t>
            </a:r>
            <a:endParaRPr lang="ko-KR" altLang="en-US" sz="2400" b="1" dirty="0">
              <a:latin typeface="Arial" panose="020B0604020202020204" pitchFamily="34" charset="0"/>
              <a:cs typeface="Arial" panose="020B0604020202020204" pitchFamily="34" charset="0"/>
            </a:endParaRPr>
          </a:p>
        </p:txBody>
      </p:sp>
      <p:sp>
        <p:nvSpPr>
          <p:cNvPr id="403" name="TextBox 402"/>
          <p:cNvSpPr txBox="1"/>
          <p:nvPr/>
        </p:nvSpPr>
        <p:spPr>
          <a:xfrm>
            <a:off x="9763362" y="10059216"/>
            <a:ext cx="3237195" cy="461665"/>
          </a:xfrm>
          <a:prstGeom prst="rect">
            <a:avLst/>
          </a:prstGeom>
          <a:noFill/>
        </p:spPr>
        <p:txBody>
          <a:bodyPr wrap="square" rtlCol="0">
            <a:spAutoFit/>
          </a:bodyPr>
          <a:lstStyle/>
          <a:p>
            <a:r>
              <a:rPr lang="en-US" altLang="ko-KR" sz="2400" b="1" dirty="0" smtClean="0">
                <a:latin typeface="Arial" panose="020B0604020202020204" pitchFamily="34" charset="0"/>
                <a:cs typeface="Arial" panose="020B0604020202020204" pitchFamily="34" charset="0"/>
              </a:rPr>
              <a:t>Pooled sample set</a:t>
            </a:r>
            <a:endParaRPr lang="ko-KR" altLang="en-US" sz="2400" b="1" dirty="0">
              <a:latin typeface="Arial" panose="020B0604020202020204" pitchFamily="34" charset="0"/>
              <a:cs typeface="Arial" panose="020B0604020202020204" pitchFamily="34" charset="0"/>
            </a:endParaRPr>
          </a:p>
        </p:txBody>
      </p:sp>
      <p:sp>
        <p:nvSpPr>
          <p:cNvPr id="404" name="TextBox 403"/>
          <p:cNvSpPr txBox="1"/>
          <p:nvPr/>
        </p:nvSpPr>
        <p:spPr>
          <a:xfrm>
            <a:off x="317218" y="164496"/>
            <a:ext cx="661580" cy="523220"/>
          </a:xfrm>
          <a:prstGeom prst="rect">
            <a:avLst/>
          </a:prstGeom>
          <a:noFill/>
        </p:spPr>
        <p:txBody>
          <a:bodyPr wrap="square" rtlCol="0">
            <a:spAutoFit/>
          </a:bodyPr>
          <a:lstStyle/>
          <a:p>
            <a:r>
              <a:rPr lang="en-US" altLang="ko-KR" sz="2800" b="1" dirty="0">
                <a:latin typeface="Arial" panose="020B0604020202020204" pitchFamily="34" charset="0"/>
                <a:cs typeface="Arial" panose="020B0604020202020204" pitchFamily="34" charset="0"/>
              </a:rPr>
              <a:t>a</a:t>
            </a:r>
            <a:endParaRPr lang="ko-KR" altLang="en-US" sz="2800" b="1" dirty="0">
              <a:latin typeface="Arial" panose="020B0604020202020204" pitchFamily="34" charset="0"/>
              <a:cs typeface="Arial" panose="020B0604020202020204" pitchFamily="34" charset="0"/>
            </a:endParaRPr>
          </a:p>
        </p:txBody>
      </p:sp>
      <p:sp>
        <p:nvSpPr>
          <p:cNvPr id="405" name="TextBox 404"/>
          <p:cNvSpPr txBox="1"/>
          <p:nvPr/>
        </p:nvSpPr>
        <p:spPr>
          <a:xfrm>
            <a:off x="311033" y="8884418"/>
            <a:ext cx="661580" cy="523220"/>
          </a:xfrm>
          <a:prstGeom prst="rect">
            <a:avLst/>
          </a:prstGeom>
          <a:noFill/>
        </p:spPr>
        <p:txBody>
          <a:bodyPr wrap="square" rtlCol="0">
            <a:spAutoFit/>
          </a:bodyPr>
          <a:lstStyle/>
          <a:p>
            <a:r>
              <a:rPr lang="en-US" altLang="ko-KR" sz="2800" b="1" dirty="0">
                <a:latin typeface="Arial" panose="020B0604020202020204" pitchFamily="34" charset="0"/>
                <a:cs typeface="Arial" panose="020B0604020202020204" pitchFamily="34" charset="0"/>
              </a:rPr>
              <a:t>b</a:t>
            </a:r>
            <a:endParaRPr lang="ko-KR" altLang="en-US" sz="2800" b="1" dirty="0">
              <a:latin typeface="Arial" panose="020B0604020202020204" pitchFamily="34" charset="0"/>
              <a:cs typeface="Arial" panose="020B0604020202020204" pitchFamily="34" charset="0"/>
            </a:endParaRPr>
          </a:p>
        </p:txBody>
      </p:sp>
      <p:sp>
        <p:nvSpPr>
          <p:cNvPr id="406" name="TextBox 405"/>
          <p:cNvSpPr txBox="1"/>
          <p:nvPr/>
        </p:nvSpPr>
        <p:spPr>
          <a:xfrm>
            <a:off x="7480804" y="8884417"/>
            <a:ext cx="661580" cy="523220"/>
          </a:xfrm>
          <a:prstGeom prst="rect">
            <a:avLst/>
          </a:prstGeom>
          <a:noFill/>
        </p:spPr>
        <p:txBody>
          <a:bodyPr wrap="square" rtlCol="0">
            <a:spAutoFit/>
          </a:bodyPr>
          <a:lstStyle/>
          <a:p>
            <a:r>
              <a:rPr lang="en-US" altLang="ko-KR" sz="2800" b="1" dirty="0">
                <a:latin typeface="Arial" panose="020B0604020202020204" pitchFamily="34" charset="0"/>
                <a:cs typeface="Arial" panose="020B0604020202020204" pitchFamily="34" charset="0"/>
              </a:rPr>
              <a:t>c</a:t>
            </a:r>
            <a:endParaRPr lang="ko-KR" altLang="en-US" sz="2800" b="1" dirty="0">
              <a:latin typeface="Arial" panose="020B0604020202020204" pitchFamily="34" charset="0"/>
              <a:cs typeface="Arial" panose="020B0604020202020204" pitchFamily="34" charset="0"/>
            </a:endParaRPr>
          </a:p>
        </p:txBody>
      </p:sp>
      <p:sp>
        <p:nvSpPr>
          <p:cNvPr id="407" name="TextBox 406"/>
          <p:cNvSpPr txBox="1"/>
          <p:nvPr/>
        </p:nvSpPr>
        <p:spPr>
          <a:xfrm>
            <a:off x="2284864" y="16909501"/>
            <a:ext cx="3034996"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DM: Distant metastasis</a:t>
            </a:r>
            <a:endParaRPr lang="ko-KR" altLang="en-US" sz="1600" b="1" dirty="0">
              <a:latin typeface="Arial" panose="020B0604020202020204" pitchFamily="34" charset="0"/>
              <a:cs typeface="Arial" panose="020B0604020202020204" pitchFamily="34" charset="0"/>
            </a:endParaRPr>
          </a:p>
        </p:txBody>
      </p:sp>
      <p:sp>
        <p:nvSpPr>
          <p:cNvPr id="408" name="TextBox 407"/>
          <p:cNvSpPr txBox="1"/>
          <p:nvPr/>
        </p:nvSpPr>
        <p:spPr>
          <a:xfrm>
            <a:off x="2264694" y="16620361"/>
            <a:ext cx="3177099"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NDM: Non distant metastasis</a:t>
            </a:r>
            <a:endParaRPr lang="ko-KR" altLang="en-US" sz="1600" b="1" dirty="0">
              <a:latin typeface="Arial" panose="020B0604020202020204" pitchFamily="34" charset="0"/>
              <a:cs typeface="Arial" panose="020B0604020202020204" pitchFamily="34" charset="0"/>
            </a:endParaRPr>
          </a:p>
        </p:txBody>
      </p:sp>
      <p:sp>
        <p:nvSpPr>
          <p:cNvPr id="419" name="직사각형 418"/>
          <p:cNvSpPr/>
          <p:nvPr/>
        </p:nvSpPr>
        <p:spPr>
          <a:xfrm>
            <a:off x="235875" y="18037564"/>
            <a:ext cx="14148526" cy="1938992"/>
          </a:xfrm>
          <a:prstGeom prst="rect">
            <a:avLst/>
          </a:prstGeom>
        </p:spPr>
        <p:txBody>
          <a:bodyPr wrap="square">
            <a:spAutoFit/>
          </a:bodyPr>
          <a:lstStyle/>
          <a:p>
            <a:pPr algn="just" latinLnBrk="1"/>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2. </a:t>
            </a:r>
            <a:r>
              <a:rPr lang="en-US" altLang="ko-KR" sz="2400" b="1" dirty="0">
                <a:latin typeface="Arial" panose="020B0604020202020204" pitchFamily="34" charset="0"/>
                <a:cs typeface="Arial" panose="020B0604020202020204" pitchFamily="34" charset="0"/>
              </a:rPr>
              <a:t>Identified and quantified proteins in TMT experiments.</a:t>
            </a:r>
            <a:endParaRPr lang="ko-KR" altLang="ko-KR" sz="2400" dirty="0">
              <a:latin typeface="Arial" panose="020B0604020202020204" pitchFamily="34" charset="0"/>
              <a:cs typeface="Arial" panose="020B0604020202020204" pitchFamily="34" charset="0"/>
            </a:endParaRPr>
          </a:p>
          <a:p>
            <a:pPr algn="just"/>
            <a:r>
              <a:rPr lang="en-US" altLang="ko-KR" sz="2400" dirty="0" smtClean="0">
                <a:latin typeface="Arial" panose="020B0604020202020204" pitchFamily="34" charset="0"/>
                <a:cs typeface="Arial" panose="020B0604020202020204" pitchFamily="34" charset="0"/>
              </a:rPr>
              <a:t>(a) The number of identified and quantified proteins in the pooled sample set, individual sample set, and cell line set. (B) The number of identified proteins in each sample of the individual sample set. (C) The number of identified proteins in each sample of the pooled sample set. </a:t>
            </a:r>
            <a:endParaRPr lang="ko-KR" altLang="ko-KR" sz="2400" dirty="0" smtClean="0">
              <a:latin typeface="Arial" panose="020B0604020202020204" pitchFamily="34" charset="0"/>
              <a:cs typeface="Arial" panose="020B0604020202020204" pitchFamily="34" charset="0"/>
            </a:endParaRPr>
          </a:p>
          <a:p>
            <a:pPr algn="just"/>
            <a:endParaRPr lang="ko-KR" altLang="ko-KR" sz="2400" dirty="0">
              <a:latin typeface="Arial" panose="020B0604020202020204" pitchFamily="34" charset="0"/>
              <a:cs typeface="Arial" panose="020B0604020202020204" pitchFamily="34" charset="0"/>
            </a:endParaRPr>
          </a:p>
        </p:txBody>
      </p:sp>
      <p:sp>
        <p:nvSpPr>
          <p:cNvPr id="420" name="TextBox 419"/>
          <p:cNvSpPr txBox="1"/>
          <p:nvPr/>
        </p:nvSpPr>
        <p:spPr>
          <a:xfrm>
            <a:off x="6738167" y="19991959"/>
            <a:ext cx="895350" cy="461665"/>
          </a:xfrm>
          <a:prstGeom prst="rect">
            <a:avLst/>
          </a:prstGeom>
          <a:noFill/>
        </p:spPr>
        <p:txBody>
          <a:bodyPr wrap="square" rtlCol="0">
            <a:spAutoFit/>
          </a:bodyPr>
          <a:lstStyle/>
          <a:p>
            <a:r>
              <a:rPr lang="en-US" altLang="ko-KR" sz="2400" b="1" dirty="0" smtClean="0"/>
              <a:t>S-2</a:t>
            </a:r>
            <a:endParaRPr lang="ko-KR" altLang="en-US" sz="2400" b="1" dirty="0"/>
          </a:p>
        </p:txBody>
      </p:sp>
      <p:sp>
        <p:nvSpPr>
          <p:cNvPr id="128" name="직사각형 127"/>
          <p:cNvSpPr/>
          <p:nvPr/>
        </p:nvSpPr>
        <p:spPr>
          <a:xfrm>
            <a:off x="12837411" y="16659656"/>
            <a:ext cx="483154" cy="144813"/>
          </a:xfrm>
          <a:prstGeom prst="rect">
            <a:avLst/>
          </a:prstGeom>
          <a:solidFill>
            <a:srgbClr val="FFA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200">
              <a:solidFill>
                <a:schemeClr val="tx1"/>
              </a:solidFill>
              <a:latin typeface="Arial" panose="020B0604020202020204" pitchFamily="34" charset="0"/>
              <a:cs typeface="Arial" panose="020B0604020202020204" pitchFamily="34" charset="0"/>
            </a:endParaRPr>
          </a:p>
        </p:txBody>
      </p:sp>
      <p:sp>
        <p:nvSpPr>
          <p:cNvPr id="137" name="직사각형 136"/>
          <p:cNvSpPr/>
          <p:nvPr/>
        </p:nvSpPr>
        <p:spPr>
          <a:xfrm>
            <a:off x="12837409" y="16893169"/>
            <a:ext cx="483155" cy="144813"/>
          </a:xfrm>
          <a:prstGeom prst="rect">
            <a:avLst/>
          </a:prstGeom>
          <a:solidFill>
            <a:srgbClr val="90BFF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200">
              <a:solidFill>
                <a:schemeClr val="tx1"/>
              </a:solidFill>
              <a:latin typeface="Arial" panose="020B0604020202020204" pitchFamily="34" charset="0"/>
              <a:cs typeface="Arial" panose="020B0604020202020204" pitchFamily="34" charset="0"/>
            </a:endParaRPr>
          </a:p>
        </p:txBody>
      </p:sp>
      <p:sp>
        <p:nvSpPr>
          <p:cNvPr id="138" name="직사각형 137"/>
          <p:cNvSpPr/>
          <p:nvPr/>
        </p:nvSpPr>
        <p:spPr>
          <a:xfrm>
            <a:off x="12837528" y="17126683"/>
            <a:ext cx="483155" cy="144813"/>
          </a:xfrm>
          <a:prstGeom prst="rect">
            <a:avLst/>
          </a:prstGeom>
          <a:solidFill>
            <a:srgbClr val="FFC08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200">
              <a:solidFill>
                <a:schemeClr val="tx1"/>
              </a:solidFill>
              <a:latin typeface="Arial" panose="020B0604020202020204" pitchFamily="34" charset="0"/>
              <a:cs typeface="Arial" panose="020B0604020202020204" pitchFamily="34" charset="0"/>
            </a:endParaRPr>
          </a:p>
        </p:txBody>
      </p:sp>
      <p:sp>
        <p:nvSpPr>
          <p:cNvPr id="139" name="TextBox 138"/>
          <p:cNvSpPr txBox="1"/>
          <p:nvPr/>
        </p:nvSpPr>
        <p:spPr>
          <a:xfrm>
            <a:off x="13255115" y="16565052"/>
            <a:ext cx="1038716"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HER2</a:t>
            </a:r>
            <a:endParaRPr lang="ko-KR" altLang="en-US" sz="1600" b="1" dirty="0">
              <a:latin typeface="Arial" panose="020B0604020202020204" pitchFamily="34" charset="0"/>
              <a:cs typeface="Arial" panose="020B0604020202020204" pitchFamily="34" charset="0"/>
            </a:endParaRPr>
          </a:p>
        </p:txBody>
      </p:sp>
      <p:sp>
        <p:nvSpPr>
          <p:cNvPr id="140" name="TextBox 139"/>
          <p:cNvSpPr txBox="1"/>
          <p:nvPr/>
        </p:nvSpPr>
        <p:spPr>
          <a:xfrm>
            <a:off x="13237491" y="16791097"/>
            <a:ext cx="775842"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TNBC</a:t>
            </a:r>
            <a:endParaRPr lang="ko-KR" altLang="en-US" sz="1600" b="1" dirty="0">
              <a:latin typeface="Arial" panose="020B0604020202020204" pitchFamily="34" charset="0"/>
              <a:cs typeface="Arial" panose="020B0604020202020204" pitchFamily="34" charset="0"/>
            </a:endParaRPr>
          </a:p>
        </p:txBody>
      </p:sp>
      <p:sp>
        <p:nvSpPr>
          <p:cNvPr id="141" name="TextBox 140"/>
          <p:cNvSpPr txBox="1"/>
          <p:nvPr/>
        </p:nvSpPr>
        <p:spPr>
          <a:xfrm>
            <a:off x="13255115" y="17027578"/>
            <a:ext cx="991818"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Luminal</a:t>
            </a:r>
            <a:endParaRPr lang="ko-KR" altLang="en-US" sz="1600" b="1" dirty="0">
              <a:latin typeface="Arial" panose="020B0604020202020204" pitchFamily="34" charset="0"/>
              <a:cs typeface="Arial" panose="020B0604020202020204" pitchFamily="34" charset="0"/>
            </a:endParaRPr>
          </a:p>
        </p:txBody>
      </p:sp>
      <p:sp>
        <p:nvSpPr>
          <p:cNvPr id="142" name="TextBox 141"/>
          <p:cNvSpPr txBox="1"/>
          <p:nvPr/>
        </p:nvSpPr>
        <p:spPr>
          <a:xfrm>
            <a:off x="9786989" y="16907064"/>
            <a:ext cx="3105685"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DM: Distant metastasis</a:t>
            </a:r>
            <a:endParaRPr lang="ko-KR" altLang="en-US" sz="1600" b="1" dirty="0">
              <a:latin typeface="Arial" panose="020B0604020202020204" pitchFamily="34" charset="0"/>
              <a:cs typeface="Arial" panose="020B0604020202020204" pitchFamily="34" charset="0"/>
            </a:endParaRPr>
          </a:p>
        </p:txBody>
      </p:sp>
      <p:sp>
        <p:nvSpPr>
          <p:cNvPr id="143" name="TextBox 142"/>
          <p:cNvSpPr txBox="1"/>
          <p:nvPr/>
        </p:nvSpPr>
        <p:spPr>
          <a:xfrm>
            <a:off x="9763511" y="16617924"/>
            <a:ext cx="3251097" cy="338554"/>
          </a:xfrm>
          <a:prstGeom prst="rect">
            <a:avLst/>
          </a:prstGeom>
          <a:noFill/>
        </p:spPr>
        <p:txBody>
          <a:bodyPr wrap="square" rtlCol="0">
            <a:spAutoFit/>
          </a:bodyPr>
          <a:lstStyle/>
          <a:p>
            <a:r>
              <a:rPr lang="en-US" altLang="ko-KR" sz="1600" b="1" dirty="0" smtClean="0">
                <a:latin typeface="Arial" panose="020B0604020202020204" pitchFamily="34" charset="0"/>
                <a:cs typeface="Arial" panose="020B0604020202020204" pitchFamily="34" charset="0"/>
              </a:rPr>
              <a:t>NDM: Non distant metastasis</a:t>
            </a:r>
            <a:endParaRPr lang="ko-KR"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0291501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직사각형 28"/>
          <p:cNvSpPr/>
          <p:nvPr/>
        </p:nvSpPr>
        <p:spPr>
          <a:xfrm>
            <a:off x="10190725" y="1694864"/>
            <a:ext cx="609600" cy="106466"/>
          </a:xfrm>
          <a:prstGeom prst="rect">
            <a:avLst/>
          </a:prstGeom>
          <a:solidFill>
            <a:srgbClr val="5B9BD5"/>
          </a:solidFill>
          <a:ln w="12700" cap="flat" cmpd="sng" algn="ctr">
            <a:no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0"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30" name="직사각형 29"/>
          <p:cNvSpPr/>
          <p:nvPr/>
        </p:nvSpPr>
        <p:spPr>
          <a:xfrm>
            <a:off x="10190725" y="1327570"/>
            <a:ext cx="609600" cy="106466"/>
          </a:xfrm>
          <a:prstGeom prst="rect">
            <a:avLst/>
          </a:prstGeom>
          <a:solidFill>
            <a:srgbClr val="FFC000">
              <a:lumMod val="60000"/>
              <a:lumOff val="40000"/>
            </a:srgbClr>
          </a:solidFill>
          <a:ln w="12700" cap="flat" cmpd="sng" algn="ctr">
            <a:no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0"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31" name="TextBox 30"/>
          <p:cNvSpPr txBox="1"/>
          <p:nvPr/>
        </p:nvSpPr>
        <p:spPr>
          <a:xfrm>
            <a:off x="10753754" y="1204457"/>
            <a:ext cx="3054736" cy="369332"/>
          </a:xfrm>
          <a:prstGeom prst="rect">
            <a:avLst/>
          </a:prstGeom>
          <a:noFill/>
        </p:spPr>
        <p:txBody>
          <a:bodyPr wrap="square" rtlCol="0">
            <a:spAutoFit/>
          </a:bodyPr>
          <a:lstStyle/>
          <a:p>
            <a:pPr defTabSz="914400" latinLnBrk="1"/>
            <a:r>
              <a:rPr lang="en-US" altLang="ko-KR" b="1">
                <a:solidFill>
                  <a:prstClr val="black"/>
                </a:solidFill>
                <a:latin typeface="Arial" panose="020B0604020202020204" pitchFamily="34" charset="0"/>
                <a:cs typeface="Arial" panose="020B0604020202020204" pitchFamily="34" charset="0"/>
              </a:rPr>
              <a:t>P</a:t>
            </a:r>
            <a:r>
              <a:rPr lang="en-US" altLang="ko-KR" b="1" smtClean="0">
                <a:solidFill>
                  <a:prstClr val="black"/>
                </a:solidFill>
                <a:latin typeface="Arial" panose="020B0604020202020204" pitchFamily="34" charset="0"/>
                <a:cs typeface="Arial" panose="020B0604020202020204" pitchFamily="34" charset="0"/>
              </a:rPr>
              <a:t>ooled sample set </a:t>
            </a:r>
            <a:endParaRPr lang="ko-KR" altLang="en-US" b="1">
              <a:solidFill>
                <a:prstClr val="black"/>
              </a:solidFill>
              <a:latin typeface="Arial" panose="020B0604020202020204" pitchFamily="34" charset="0"/>
              <a:cs typeface="Arial" panose="020B0604020202020204" pitchFamily="34" charset="0"/>
            </a:endParaRPr>
          </a:p>
        </p:txBody>
      </p:sp>
      <p:sp>
        <p:nvSpPr>
          <p:cNvPr id="32" name="TextBox 31"/>
          <p:cNvSpPr txBox="1"/>
          <p:nvPr/>
        </p:nvSpPr>
        <p:spPr>
          <a:xfrm>
            <a:off x="10753754" y="1581616"/>
            <a:ext cx="3033659" cy="369332"/>
          </a:xfrm>
          <a:prstGeom prst="rect">
            <a:avLst/>
          </a:prstGeom>
          <a:noFill/>
        </p:spPr>
        <p:txBody>
          <a:bodyPr wrap="square" rtlCol="0">
            <a:spAutoFit/>
          </a:bodyPr>
          <a:lstStyle/>
          <a:p>
            <a:pPr defTabSz="914400" latinLnBrk="1"/>
            <a:r>
              <a:rPr lang="en-US" altLang="ko-KR" b="1">
                <a:solidFill>
                  <a:prstClr val="black"/>
                </a:solidFill>
                <a:latin typeface="Arial" panose="020B0604020202020204" pitchFamily="34" charset="0"/>
                <a:cs typeface="Arial" panose="020B0604020202020204" pitchFamily="34" charset="0"/>
              </a:rPr>
              <a:t>I</a:t>
            </a:r>
            <a:r>
              <a:rPr lang="en-US" altLang="ko-KR" b="1" smtClean="0">
                <a:solidFill>
                  <a:prstClr val="black"/>
                </a:solidFill>
                <a:latin typeface="Arial" panose="020B0604020202020204" pitchFamily="34" charset="0"/>
                <a:cs typeface="Arial" panose="020B0604020202020204" pitchFamily="34" charset="0"/>
              </a:rPr>
              <a:t>ndividual sample set </a:t>
            </a:r>
            <a:endParaRPr lang="ko-KR" altLang="en-US" b="1">
              <a:solidFill>
                <a:prstClr val="black"/>
              </a:solidFill>
              <a:latin typeface="Arial" panose="020B0604020202020204" pitchFamily="34" charset="0"/>
              <a:cs typeface="Arial" panose="020B0604020202020204" pitchFamily="34" charset="0"/>
            </a:endParaRPr>
          </a:p>
        </p:txBody>
      </p:sp>
      <p:sp>
        <p:nvSpPr>
          <p:cNvPr id="33" name="타원 32"/>
          <p:cNvSpPr/>
          <p:nvPr/>
        </p:nvSpPr>
        <p:spPr>
          <a:xfrm>
            <a:off x="10169707" y="2115434"/>
            <a:ext cx="344861" cy="336133"/>
          </a:xfrm>
          <a:prstGeom prst="ellipse">
            <a:avLst/>
          </a:prstGeom>
          <a:noFill/>
          <a:ln w="28575" cap="flat" cmpd="sng" algn="ctr">
            <a:solidFill>
              <a:srgbClr val="C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0"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34" name="TextBox 33"/>
          <p:cNvSpPr txBox="1"/>
          <p:nvPr/>
        </p:nvSpPr>
        <p:spPr>
          <a:xfrm>
            <a:off x="10496912" y="2113891"/>
            <a:ext cx="3024729" cy="369332"/>
          </a:xfrm>
          <a:prstGeom prst="rect">
            <a:avLst/>
          </a:prstGeom>
          <a:noFill/>
        </p:spPr>
        <p:txBody>
          <a:bodyPr wrap="square" rtlCol="0">
            <a:spAutoFit/>
          </a:bodyPr>
          <a:lstStyle/>
          <a:p>
            <a:pPr defTabSz="914400" latinLnBrk="1"/>
            <a:r>
              <a:rPr lang="en-US" altLang="ko-KR" b="1" smtClean="0">
                <a:solidFill>
                  <a:srgbClr val="C00000"/>
                </a:solidFill>
                <a:latin typeface="Arial" panose="020B0604020202020204" pitchFamily="34" charset="0"/>
                <a:cs typeface="Arial" panose="020B0604020202020204" pitchFamily="34" charset="0"/>
              </a:rPr>
              <a:t>Metastatic markers</a:t>
            </a:r>
            <a:endParaRPr lang="ko-KR" altLang="en-US" b="1">
              <a:solidFill>
                <a:srgbClr val="C00000"/>
              </a:solidFill>
              <a:latin typeface="Arial" panose="020B0604020202020204" pitchFamily="34" charset="0"/>
              <a:cs typeface="Arial" panose="020B0604020202020204" pitchFamily="34" charset="0"/>
            </a:endParaRPr>
          </a:p>
        </p:txBody>
      </p:sp>
      <p:sp>
        <p:nvSpPr>
          <p:cNvPr id="35" name="타원 34"/>
          <p:cNvSpPr/>
          <p:nvPr/>
        </p:nvSpPr>
        <p:spPr>
          <a:xfrm>
            <a:off x="10161472" y="2554773"/>
            <a:ext cx="347833" cy="340054"/>
          </a:xfrm>
          <a:prstGeom prst="ellipse">
            <a:avLst/>
          </a:prstGeom>
          <a:noFill/>
          <a:ln w="28575" cap="flat" cmpd="sng" algn="ctr">
            <a:solidFill>
              <a:sysClr val="windowText" lastClr="0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b="0"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36" name="TextBox 35"/>
          <p:cNvSpPr txBox="1"/>
          <p:nvPr/>
        </p:nvSpPr>
        <p:spPr>
          <a:xfrm>
            <a:off x="10496912" y="2525495"/>
            <a:ext cx="3177893" cy="369332"/>
          </a:xfrm>
          <a:prstGeom prst="rect">
            <a:avLst/>
          </a:prstGeom>
          <a:noFill/>
        </p:spPr>
        <p:txBody>
          <a:bodyPr wrap="square" rtlCol="0">
            <a:spAutoFit/>
          </a:bodyPr>
          <a:lstStyle/>
          <a:p>
            <a:pPr defTabSz="914400" latinLnBrk="1"/>
            <a:r>
              <a:rPr lang="en-US" altLang="ko-KR" b="1" dirty="0" smtClean="0">
                <a:solidFill>
                  <a:prstClr val="black"/>
                </a:solidFill>
                <a:latin typeface="Arial" panose="020B0604020202020204" pitchFamily="34" charset="0"/>
                <a:cs typeface="Arial" panose="020B0604020202020204" pitchFamily="34" charset="0"/>
              </a:rPr>
              <a:t>Breast cancer markers</a:t>
            </a:r>
            <a:endParaRPr lang="ko-KR" altLang="en-US" b="1" dirty="0">
              <a:solidFill>
                <a:prstClr val="black"/>
              </a:solidFill>
              <a:latin typeface="Arial" panose="020B0604020202020204" pitchFamily="34" charset="0"/>
              <a:cs typeface="Arial" panose="020B0604020202020204" pitchFamily="34" charset="0"/>
            </a:endParaRPr>
          </a:p>
        </p:txBody>
      </p:sp>
      <p:pic>
        <p:nvPicPr>
          <p:cNvPr id="37" name="그림 36"/>
          <p:cNvPicPr>
            <a:picLocks noChangeAspect="1"/>
          </p:cNvPicPr>
          <p:nvPr/>
        </p:nvPicPr>
        <p:blipFill>
          <a:blip r:embed="rId2"/>
          <a:stretch>
            <a:fillRect/>
          </a:stretch>
        </p:blipFill>
        <p:spPr>
          <a:xfrm>
            <a:off x="743320" y="367130"/>
            <a:ext cx="10010434" cy="6925987"/>
          </a:xfrm>
          <a:prstGeom prst="rect">
            <a:avLst/>
          </a:prstGeom>
        </p:spPr>
      </p:pic>
      <p:sp>
        <p:nvSpPr>
          <p:cNvPr id="38" name="타원 37"/>
          <p:cNvSpPr/>
          <p:nvPr/>
        </p:nvSpPr>
        <p:spPr>
          <a:xfrm>
            <a:off x="7034399" y="3977530"/>
            <a:ext cx="188709" cy="188916"/>
          </a:xfrm>
          <a:prstGeom prst="ellipse">
            <a:avLst/>
          </a:prstGeom>
          <a:noFill/>
          <a:ln w="28575" cap="flat" cmpd="sng" algn="ctr">
            <a:solidFill>
              <a:sysClr val="windowText" lastClr="0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sz="1800" b="0"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cxnSp>
        <p:nvCxnSpPr>
          <p:cNvPr id="39" name="직선 연결선 38"/>
          <p:cNvCxnSpPr>
            <a:stCxn id="38" idx="7"/>
            <a:endCxn id="40" idx="1"/>
          </p:cNvCxnSpPr>
          <p:nvPr/>
        </p:nvCxnSpPr>
        <p:spPr>
          <a:xfrm flipV="1">
            <a:off x="7195472" y="3723486"/>
            <a:ext cx="244538" cy="281710"/>
          </a:xfrm>
          <a:prstGeom prst="line">
            <a:avLst/>
          </a:prstGeom>
          <a:noFill/>
          <a:ln w="28575" cap="flat" cmpd="sng" algn="ctr">
            <a:solidFill>
              <a:sysClr val="windowText" lastClr="000000"/>
            </a:solidFill>
            <a:prstDash val="solid"/>
            <a:miter lim="800000"/>
          </a:ln>
          <a:effectLst/>
        </p:spPr>
      </p:cxnSp>
      <p:sp>
        <p:nvSpPr>
          <p:cNvPr id="40" name="직사각형 39"/>
          <p:cNvSpPr/>
          <p:nvPr/>
        </p:nvSpPr>
        <p:spPr>
          <a:xfrm>
            <a:off x="7440010" y="3598463"/>
            <a:ext cx="887944" cy="250045"/>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r>
              <a:rPr kumimoji="0" lang="en-US" altLang="ko-KR" sz="1600" b="1" i="0" u="none" strike="noStrike" kern="0" cap="none" spc="0" normalizeH="0" baseline="0" noProof="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ER, PR</a:t>
            </a:r>
            <a:endParaRPr kumimoji="0" lang="ko-KR" altLang="en-US" sz="1600" b="1" i="0" u="none" strike="noStrike" kern="0" cap="none" spc="0" normalizeH="0" baseline="0" noProof="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41" name="타원 40"/>
          <p:cNvSpPr/>
          <p:nvPr/>
        </p:nvSpPr>
        <p:spPr>
          <a:xfrm>
            <a:off x="3634588" y="3051703"/>
            <a:ext cx="251980" cy="241094"/>
          </a:xfrm>
          <a:prstGeom prst="ellipse">
            <a:avLst/>
          </a:prstGeom>
          <a:noFill/>
          <a:ln w="28575" cap="flat" cmpd="sng" algn="ctr">
            <a:solidFill>
              <a:sysClr val="windowText" lastClr="0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sz="1800" b="0"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cxnSp>
        <p:nvCxnSpPr>
          <p:cNvPr id="42" name="직선 연결선 41"/>
          <p:cNvCxnSpPr>
            <a:stCxn id="41" idx="7"/>
            <a:endCxn id="43" idx="1"/>
          </p:cNvCxnSpPr>
          <p:nvPr/>
        </p:nvCxnSpPr>
        <p:spPr>
          <a:xfrm flipV="1">
            <a:off x="3849666" y="2663814"/>
            <a:ext cx="677090" cy="423196"/>
          </a:xfrm>
          <a:prstGeom prst="line">
            <a:avLst/>
          </a:prstGeom>
          <a:noFill/>
          <a:ln w="28575" cap="flat" cmpd="sng" algn="ctr">
            <a:solidFill>
              <a:sysClr val="windowText" lastClr="000000"/>
            </a:solidFill>
            <a:prstDash val="solid"/>
            <a:miter lim="800000"/>
          </a:ln>
          <a:effectLst/>
        </p:spPr>
      </p:cxnSp>
      <p:sp>
        <p:nvSpPr>
          <p:cNvPr id="43" name="직사각형 42"/>
          <p:cNvSpPr/>
          <p:nvPr/>
        </p:nvSpPr>
        <p:spPr>
          <a:xfrm>
            <a:off x="4526756" y="2553965"/>
            <a:ext cx="955995" cy="219697"/>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r>
              <a:rPr kumimoji="0" lang="en-US" altLang="ko-KR" sz="1600" b="1" i="0" u="none" strike="noStrike" kern="0" cap="none" spc="0" normalizeH="0" baseline="0" noProof="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ERBB2</a:t>
            </a:r>
            <a:endParaRPr kumimoji="0" lang="ko-KR" altLang="en-US" sz="1600" b="1" i="0" u="none" strike="noStrike" kern="0" cap="none" spc="0" normalizeH="0" baseline="0" noProof="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44" name="타원 43"/>
          <p:cNvSpPr/>
          <p:nvPr/>
        </p:nvSpPr>
        <p:spPr>
          <a:xfrm>
            <a:off x="7844816" y="4233407"/>
            <a:ext cx="315280" cy="301337"/>
          </a:xfrm>
          <a:prstGeom prst="ellipse">
            <a:avLst/>
          </a:prstGeom>
          <a:noFill/>
          <a:ln w="28575" cap="flat" cmpd="sng" algn="ctr">
            <a:solidFill>
              <a:sysClr val="windowText" lastClr="0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sz="1800" b="0" i="0" u="none" strike="noStrike" kern="0" cap="none" spc="0" normalizeH="0" baseline="0" noProof="0" smtClean="0">
              <a:ln>
                <a:noFill/>
              </a:ln>
              <a:solidFill>
                <a:prstClr val="white"/>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cxnSp>
        <p:nvCxnSpPr>
          <p:cNvPr id="45" name="직선 연결선 44"/>
          <p:cNvCxnSpPr>
            <a:stCxn id="44" idx="7"/>
            <a:endCxn id="46" idx="1"/>
          </p:cNvCxnSpPr>
          <p:nvPr/>
        </p:nvCxnSpPr>
        <p:spPr>
          <a:xfrm flipV="1">
            <a:off x="8113924" y="4142525"/>
            <a:ext cx="241014" cy="135012"/>
          </a:xfrm>
          <a:prstGeom prst="line">
            <a:avLst/>
          </a:prstGeom>
          <a:noFill/>
          <a:ln w="28575" cap="flat" cmpd="sng" algn="ctr">
            <a:solidFill>
              <a:sysClr val="windowText" lastClr="000000"/>
            </a:solidFill>
            <a:prstDash val="solid"/>
            <a:miter lim="800000"/>
          </a:ln>
          <a:effectLst/>
        </p:spPr>
      </p:cxnSp>
      <p:sp>
        <p:nvSpPr>
          <p:cNvPr id="46" name="직사각형 45"/>
          <p:cNvSpPr/>
          <p:nvPr/>
        </p:nvSpPr>
        <p:spPr>
          <a:xfrm>
            <a:off x="8354938" y="4035694"/>
            <a:ext cx="559033" cy="213662"/>
          </a:xfrm>
          <a:prstGeom prst="rect">
            <a:avLst/>
          </a:prstGeom>
          <a:solidFill>
            <a:sysClr val="window" lastClr="FFFFFF"/>
          </a:solidFill>
          <a:ln w="19050" cap="flat" cmpd="sng" algn="ctr">
            <a:solidFill>
              <a:sysClr val="windowText" lastClr="000000"/>
            </a:solid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r>
              <a:rPr kumimoji="0" lang="en-US" altLang="ko-KR" sz="1600" b="1" i="0" u="none" strike="noStrike" kern="0" cap="none" spc="0" normalizeH="0" baseline="0" noProof="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rPr>
              <a:t>AR</a:t>
            </a:r>
            <a:endParaRPr kumimoji="0" lang="ko-KR" altLang="en-US" sz="1600" b="1" i="0" u="none" strike="noStrike" kern="0" cap="none" spc="0" normalizeH="0" baseline="0" noProof="0" smtClean="0">
              <a:ln>
                <a:noFill/>
              </a:ln>
              <a:solidFill>
                <a:prstClr val="black"/>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47" name="타원 46"/>
          <p:cNvSpPr/>
          <p:nvPr/>
        </p:nvSpPr>
        <p:spPr>
          <a:xfrm>
            <a:off x="4528543" y="3290568"/>
            <a:ext cx="253542" cy="236637"/>
          </a:xfrm>
          <a:prstGeom prst="ellipse">
            <a:avLst/>
          </a:prstGeom>
          <a:noFill/>
          <a:ln w="28575" cap="flat" cmpd="sng" algn="ctr">
            <a:solidFill>
              <a:srgbClr val="C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sz="1200" b="0"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48" name="직사각형 47"/>
          <p:cNvSpPr/>
          <p:nvPr/>
        </p:nvSpPr>
        <p:spPr>
          <a:xfrm>
            <a:off x="5380603" y="3048134"/>
            <a:ext cx="974798" cy="242433"/>
          </a:xfrm>
          <a:prstGeom prst="rect">
            <a:avLst/>
          </a:prstGeom>
          <a:solidFill>
            <a:sysClr val="window" lastClr="FFFFFF"/>
          </a:solidFill>
          <a:ln w="19050" cap="flat" cmpd="sng" algn="ctr">
            <a:solidFill>
              <a:srgbClr val="C00000"/>
            </a:solid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r>
              <a:rPr kumimoji="0" lang="en-US" altLang="ko-KR" sz="1600" b="1"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rPr>
              <a:t>EGFR</a:t>
            </a:r>
            <a:endParaRPr kumimoji="0" lang="ko-KR" altLang="en-US" sz="1600" b="1"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sp>
        <p:nvSpPr>
          <p:cNvPr id="49" name="타원 48"/>
          <p:cNvSpPr/>
          <p:nvPr/>
        </p:nvSpPr>
        <p:spPr>
          <a:xfrm>
            <a:off x="2398658" y="2513474"/>
            <a:ext cx="344861" cy="305634"/>
          </a:xfrm>
          <a:prstGeom prst="ellipse">
            <a:avLst/>
          </a:prstGeom>
          <a:noFill/>
          <a:ln w="28575" cap="flat" cmpd="sng" algn="ctr">
            <a:solidFill>
              <a:srgbClr val="C00000"/>
            </a:solidFill>
            <a:prstDash val="solid"/>
            <a:miter lim="800000"/>
          </a:ln>
          <a:effectLst>
            <a:glow>
              <a:srgbClr val="E7E6E6">
                <a:lumMod val="50000"/>
                <a:alpha val="90000"/>
              </a:srgbClr>
            </a:glow>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endParaRPr kumimoji="0" lang="ko-KR" altLang="en-US" sz="1800" b="0"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cxnSp>
        <p:nvCxnSpPr>
          <p:cNvPr id="50" name="직선 연결선 49"/>
          <p:cNvCxnSpPr>
            <a:stCxn id="49" idx="7"/>
            <a:endCxn id="51" idx="1"/>
          </p:cNvCxnSpPr>
          <p:nvPr/>
        </p:nvCxnSpPr>
        <p:spPr>
          <a:xfrm flipV="1">
            <a:off x="2693015" y="2196630"/>
            <a:ext cx="283734" cy="361603"/>
          </a:xfrm>
          <a:prstGeom prst="line">
            <a:avLst/>
          </a:prstGeom>
          <a:noFill/>
          <a:ln w="28575" cap="flat" cmpd="sng" algn="ctr">
            <a:solidFill>
              <a:srgbClr val="C00000"/>
            </a:solidFill>
            <a:prstDash val="solid"/>
            <a:miter lim="800000"/>
          </a:ln>
          <a:effectLst/>
        </p:spPr>
      </p:cxnSp>
      <p:sp>
        <p:nvSpPr>
          <p:cNvPr id="51" name="직사각형 50"/>
          <p:cNvSpPr/>
          <p:nvPr/>
        </p:nvSpPr>
        <p:spPr>
          <a:xfrm>
            <a:off x="2976749" y="2072714"/>
            <a:ext cx="2403854" cy="247831"/>
          </a:xfrm>
          <a:prstGeom prst="rect">
            <a:avLst/>
          </a:prstGeom>
          <a:solidFill>
            <a:sysClr val="window" lastClr="FFFFFF"/>
          </a:solidFill>
          <a:ln w="19050" cap="flat" cmpd="sng" algn="ctr">
            <a:solidFill>
              <a:srgbClr val="C00000"/>
            </a:solidFill>
            <a:prstDash val="solid"/>
            <a:miter lim="800000"/>
          </a:ln>
          <a:effectLst/>
        </p:spPr>
        <p:txBody>
          <a:bodyPr rtlCol="0" anchor="ctr"/>
          <a:lstStyle/>
          <a:p>
            <a:pPr marL="0" marR="0" lvl="0" indent="0" algn="ctr" defTabSz="914400" eaLnBrk="1" fontAlgn="auto" latinLnBrk="1" hangingPunct="1">
              <a:lnSpc>
                <a:spcPct val="100000"/>
              </a:lnSpc>
              <a:spcBef>
                <a:spcPts val="0"/>
              </a:spcBef>
              <a:spcAft>
                <a:spcPts val="0"/>
              </a:spcAft>
              <a:buClrTx/>
              <a:buSzTx/>
              <a:buFontTx/>
              <a:buNone/>
              <a:tabLst/>
              <a:defRPr/>
            </a:pPr>
            <a:r>
              <a:rPr kumimoji="0" lang="en-US" altLang="ko-KR" sz="1600" b="1"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rPr>
              <a:t>HSPD1 PRDX6 TPM4</a:t>
            </a:r>
            <a:endParaRPr kumimoji="0" lang="ko-KR" altLang="en-US" sz="1600" b="1" i="0" u="none" strike="noStrike" kern="0" cap="none" spc="0" normalizeH="0" baseline="0" noProof="0" smtClean="0">
              <a:ln>
                <a:noFill/>
              </a:ln>
              <a:solidFill>
                <a:srgbClr val="C00000"/>
              </a:solidFill>
              <a:effectLst/>
              <a:uLnTx/>
              <a:uFillTx/>
              <a:latin typeface="Arial" panose="020B0604020202020204" pitchFamily="34" charset="0"/>
              <a:ea typeface="맑은 고딕" panose="020B0503020000020004" pitchFamily="50" charset="-127"/>
              <a:cs typeface="Arial" panose="020B0604020202020204" pitchFamily="34" charset="0"/>
            </a:endParaRPr>
          </a:p>
        </p:txBody>
      </p:sp>
      <p:cxnSp>
        <p:nvCxnSpPr>
          <p:cNvPr id="52" name="직선 연결선 51"/>
          <p:cNvCxnSpPr>
            <a:stCxn id="47" idx="7"/>
            <a:endCxn id="48" idx="1"/>
          </p:cNvCxnSpPr>
          <p:nvPr/>
        </p:nvCxnSpPr>
        <p:spPr>
          <a:xfrm flipV="1">
            <a:off x="4744955" y="3169351"/>
            <a:ext cx="635648" cy="155872"/>
          </a:xfrm>
          <a:prstGeom prst="line">
            <a:avLst/>
          </a:prstGeom>
          <a:noFill/>
          <a:ln w="28575" cap="flat" cmpd="sng" algn="ctr">
            <a:solidFill>
              <a:srgbClr val="C00000"/>
            </a:solidFill>
            <a:prstDash val="solid"/>
            <a:miter lim="800000"/>
          </a:ln>
          <a:effectLst/>
        </p:spPr>
      </p:cxnSp>
      <p:sp>
        <p:nvSpPr>
          <p:cNvPr id="27" name="직사각형 26"/>
          <p:cNvSpPr/>
          <p:nvPr/>
        </p:nvSpPr>
        <p:spPr>
          <a:xfrm>
            <a:off x="423494" y="8045712"/>
            <a:ext cx="13599228" cy="1569660"/>
          </a:xfrm>
          <a:prstGeom prst="rect">
            <a:avLst/>
          </a:prstGeom>
        </p:spPr>
        <p:txBody>
          <a:bodyPr wrap="square">
            <a:spAutoFit/>
          </a:bodyPr>
          <a:lstStyle/>
          <a:p>
            <a:pPr algn="just" latinLnBrk="1"/>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3. Dynamic </a:t>
            </a:r>
            <a:r>
              <a:rPr lang="en-US" altLang="ko-KR" sz="2400" b="1" dirty="0">
                <a:latin typeface="Arial" panose="020B0604020202020204" pitchFamily="34" charset="0"/>
                <a:cs typeface="Arial" panose="020B0604020202020204" pitchFamily="34" charset="0"/>
              </a:rPr>
              <a:t>ranges of protein abundance in pooled sample set and individual sample set.</a:t>
            </a:r>
            <a:r>
              <a:rPr lang="en-US" altLang="ko-KR" sz="2400" dirty="0">
                <a:latin typeface="Arial" panose="020B0604020202020204" pitchFamily="34" charset="0"/>
                <a:cs typeface="Arial" panose="020B0604020202020204" pitchFamily="34" charset="0"/>
              </a:rPr>
              <a:t> The dynamic range of the pooled sample set is marked in yellow, and that of the individual sample set is marked in blue. Known metastatic biomarkers are indicated in red, and breast cancer markers are marked in black.</a:t>
            </a:r>
            <a:endParaRPr lang="ko-KR" altLang="ko-KR" sz="2400" dirty="0">
              <a:latin typeface="Arial" panose="020B0604020202020204" pitchFamily="34" charset="0"/>
              <a:cs typeface="Arial" panose="020B0604020202020204" pitchFamily="34" charset="0"/>
            </a:endParaRPr>
          </a:p>
        </p:txBody>
      </p:sp>
      <p:sp>
        <p:nvSpPr>
          <p:cNvPr id="53" name="TextBox 52"/>
          <p:cNvSpPr txBox="1"/>
          <p:nvPr/>
        </p:nvSpPr>
        <p:spPr>
          <a:xfrm>
            <a:off x="6738167" y="19991959"/>
            <a:ext cx="895350" cy="461665"/>
          </a:xfrm>
          <a:prstGeom prst="rect">
            <a:avLst/>
          </a:prstGeom>
          <a:noFill/>
        </p:spPr>
        <p:txBody>
          <a:bodyPr wrap="square" rtlCol="0">
            <a:spAutoFit/>
          </a:bodyPr>
          <a:lstStyle/>
          <a:p>
            <a:r>
              <a:rPr lang="en-US" altLang="ko-KR" sz="2400" b="1" smtClean="0"/>
              <a:t>S-3</a:t>
            </a:r>
            <a:endParaRPr lang="ko-KR" altLang="en-US" sz="2400" b="1"/>
          </a:p>
        </p:txBody>
      </p:sp>
    </p:spTree>
    <p:extLst>
      <p:ext uri="{BB962C8B-B14F-4D97-AF65-F5344CB8AC3E}">
        <p14:creationId xmlns:p14="http://schemas.microsoft.com/office/powerpoint/2010/main" val="255975250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타원 3"/>
          <p:cNvSpPr/>
          <p:nvPr/>
        </p:nvSpPr>
        <p:spPr>
          <a:xfrm>
            <a:off x="1645589" y="2185538"/>
            <a:ext cx="3957463" cy="3752409"/>
          </a:xfrm>
          <a:prstGeom prst="ellipse">
            <a:avLst/>
          </a:prstGeom>
          <a:solidFill>
            <a:schemeClr val="accent2">
              <a:lumMod val="40000"/>
              <a:lumOff val="60000"/>
              <a:alpha val="56000"/>
            </a:schemeClr>
          </a:solidFill>
          <a:ln w="1270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 name="타원 4"/>
          <p:cNvSpPr/>
          <p:nvPr/>
        </p:nvSpPr>
        <p:spPr>
          <a:xfrm>
            <a:off x="2468108" y="3267233"/>
            <a:ext cx="3230474" cy="2902060"/>
          </a:xfrm>
          <a:prstGeom prst="ellipse">
            <a:avLst/>
          </a:prstGeom>
          <a:solidFill>
            <a:srgbClr val="FA2EA7">
              <a:alpha val="29000"/>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 name="TextBox 5"/>
          <p:cNvSpPr txBox="1"/>
          <p:nvPr/>
        </p:nvSpPr>
        <p:spPr>
          <a:xfrm>
            <a:off x="461206" y="1406408"/>
            <a:ext cx="6143006" cy="795252"/>
          </a:xfrm>
          <a:prstGeom prst="rect">
            <a:avLst/>
          </a:prstGeom>
          <a:noFill/>
        </p:spPr>
        <p:txBody>
          <a:bodyPr wrap="square" rtlCol="0">
            <a:spAutoFit/>
          </a:bodyPr>
          <a:lstStyle/>
          <a:p>
            <a:pPr algn="ctr"/>
            <a:r>
              <a:rPr lang="en-US" altLang="ko-KR" b="1" i="1" smtClean="0">
                <a:solidFill>
                  <a:srgbClr val="A56A1B"/>
                </a:solidFill>
              </a:rPr>
              <a:t>Our study</a:t>
            </a:r>
          </a:p>
          <a:p>
            <a:pPr algn="ctr"/>
            <a:r>
              <a:rPr lang="en-US" altLang="ko-KR" b="1" i="1" smtClean="0">
                <a:solidFill>
                  <a:srgbClr val="A56A1B"/>
                </a:solidFill>
              </a:rPr>
              <a:t>(Pooled sample proteome)</a:t>
            </a:r>
            <a:endParaRPr lang="ko-KR" altLang="en-US" b="1" i="1">
              <a:solidFill>
                <a:srgbClr val="A56A1B"/>
              </a:solidFill>
            </a:endParaRPr>
          </a:p>
        </p:txBody>
      </p:sp>
      <p:sp>
        <p:nvSpPr>
          <p:cNvPr id="7" name="TextBox 6"/>
          <p:cNvSpPr txBox="1"/>
          <p:nvPr/>
        </p:nvSpPr>
        <p:spPr>
          <a:xfrm>
            <a:off x="4481522" y="6186811"/>
            <a:ext cx="2034774" cy="454430"/>
          </a:xfrm>
          <a:prstGeom prst="rect">
            <a:avLst/>
          </a:prstGeom>
          <a:noFill/>
        </p:spPr>
        <p:txBody>
          <a:bodyPr wrap="square" rtlCol="0">
            <a:spAutoFit/>
          </a:bodyPr>
          <a:lstStyle/>
          <a:p>
            <a:r>
              <a:rPr lang="en-US" altLang="ko-KR" b="1" i="1" smtClean="0">
                <a:solidFill>
                  <a:srgbClr val="EE64DA"/>
                </a:solidFill>
              </a:rPr>
              <a:t>MS </a:t>
            </a:r>
            <a:r>
              <a:rPr lang="en-US" altLang="ko-KR" b="1" i="1" err="1">
                <a:solidFill>
                  <a:srgbClr val="EE64DA"/>
                </a:solidFill>
              </a:rPr>
              <a:t>J</a:t>
            </a:r>
            <a:r>
              <a:rPr lang="en-US" altLang="ko-KR" b="1" i="1" err="1" smtClean="0">
                <a:solidFill>
                  <a:srgbClr val="EE64DA"/>
                </a:solidFill>
              </a:rPr>
              <a:t>in</a:t>
            </a:r>
            <a:r>
              <a:rPr lang="en-US" altLang="ko-KR" b="1" i="1" smtClean="0">
                <a:solidFill>
                  <a:srgbClr val="EE64DA"/>
                </a:solidFill>
              </a:rPr>
              <a:t> et </a:t>
            </a:r>
            <a:r>
              <a:rPr lang="en-US" altLang="ko-KR" b="1" i="1" smtClean="0">
                <a:solidFill>
                  <a:srgbClr val="EE64DA"/>
                </a:solidFill>
                <a:latin typeface="Arial" panose="020B0604020202020204" pitchFamily="34" charset="0"/>
                <a:cs typeface="Arial" panose="020B0604020202020204" pitchFamily="34" charset="0"/>
              </a:rPr>
              <a:t>al</a:t>
            </a:r>
            <a:r>
              <a:rPr lang="en-US" altLang="ko-KR" b="1" i="1" smtClean="0">
                <a:solidFill>
                  <a:srgbClr val="EE64DA"/>
                </a:solidFill>
              </a:rPr>
              <a:t>.</a:t>
            </a:r>
            <a:endParaRPr lang="ko-KR" altLang="en-US" b="1" i="1">
              <a:solidFill>
                <a:srgbClr val="EE64DA"/>
              </a:solidFill>
            </a:endParaRPr>
          </a:p>
        </p:txBody>
      </p:sp>
      <p:sp>
        <p:nvSpPr>
          <p:cNvPr id="8" name="TextBox 7"/>
          <p:cNvSpPr txBox="1"/>
          <p:nvPr/>
        </p:nvSpPr>
        <p:spPr>
          <a:xfrm>
            <a:off x="2350619" y="4208440"/>
            <a:ext cx="3230474" cy="584774"/>
          </a:xfrm>
          <a:prstGeom prst="rect">
            <a:avLst/>
          </a:prstGeom>
          <a:noFill/>
        </p:spPr>
        <p:txBody>
          <a:bodyPr wrap="square" rtlCol="0">
            <a:spAutoFit/>
          </a:bodyPr>
          <a:lstStyle/>
          <a:p>
            <a:pPr algn="ctr"/>
            <a:r>
              <a:rPr lang="en-US" altLang="ko-KR" sz="1600" b="1" smtClean="0"/>
              <a:t>5684</a:t>
            </a:r>
          </a:p>
          <a:p>
            <a:pPr algn="ctr"/>
            <a:r>
              <a:rPr lang="en-US" altLang="ko-KR" sz="1600" b="1" smtClean="0"/>
              <a:t>(92% of MS </a:t>
            </a:r>
            <a:r>
              <a:rPr lang="en-US" altLang="ko-KR" sz="1600" b="1" err="1" smtClean="0"/>
              <a:t>Jin</a:t>
            </a:r>
            <a:r>
              <a:rPr lang="en-US" altLang="ko-KR" sz="1600" b="1" smtClean="0"/>
              <a:t> et al.)</a:t>
            </a:r>
            <a:endParaRPr lang="ko-KR" altLang="en-US" sz="1600" b="1"/>
          </a:p>
        </p:txBody>
      </p:sp>
      <p:sp>
        <p:nvSpPr>
          <p:cNvPr id="9" name="TextBox 8"/>
          <p:cNvSpPr txBox="1"/>
          <p:nvPr/>
        </p:nvSpPr>
        <p:spPr>
          <a:xfrm>
            <a:off x="4432766" y="5654762"/>
            <a:ext cx="631625" cy="338553"/>
          </a:xfrm>
          <a:prstGeom prst="rect">
            <a:avLst/>
          </a:prstGeom>
          <a:noFill/>
        </p:spPr>
        <p:txBody>
          <a:bodyPr wrap="square" rtlCol="0">
            <a:spAutoFit/>
          </a:bodyPr>
          <a:lstStyle/>
          <a:p>
            <a:r>
              <a:rPr lang="en-US" altLang="ko-KR" sz="1600" b="1" smtClean="0"/>
              <a:t>471</a:t>
            </a:r>
            <a:endParaRPr lang="ko-KR" altLang="en-US" sz="1600" b="1"/>
          </a:p>
        </p:txBody>
      </p:sp>
      <p:sp>
        <p:nvSpPr>
          <p:cNvPr id="10" name="TextBox 9"/>
          <p:cNvSpPr txBox="1"/>
          <p:nvPr/>
        </p:nvSpPr>
        <p:spPr>
          <a:xfrm>
            <a:off x="2583505" y="2774817"/>
            <a:ext cx="754804" cy="338553"/>
          </a:xfrm>
          <a:prstGeom prst="rect">
            <a:avLst/>
          </a:prstGeom>
          <a:noFill/>
        </p:spPr>
        <p:txBody>
          <a:bodyPr wrap="square" rtlCol="0">
            <a:spAutoFit/>
          </a:bodyPr>
          <a:lstStyle/>
          <a:p>
            <a:r>
              <a:rPr lang="en-US" altLang="ko-KR" sz="1600" b="1" smtClean="0"/>
              <a:t>3757</a:t>
            </a:r>
            <a:endParaRPr lang="ko-KR" altLang="en-US" sz="1600" b="1"/>
          </a:p>
        </p:txBody>
      </p:sp>
      <p:sp>
        <p:nvSpPr>
          <p:cNvPr id="11" name="타원 10"/>
          <p:cNvSpPr/>
          <p:nvPr/>
        </p:nvSpPr>
        <p:spPr>
          <a:xfrm>
            <a:off x="8846709" y="2240285"/>
            <a:ext cx="3768555" cy="3666837"/>
          </a:xfrm>
          <a:prstGeom prst="ellipse">
            <a:avLst/>
          </a:prstGeom>
          <a:solidFill>
            <a:schemeClr val="accent5">
              <a:lumMod val="60000"/>
              <a:lumOff val="40000"/>
              <a:alpha val="56000"/>
            </a:schemeClr>
          </a:solidFill>
          <a:ln w="12700">
            <a:solidFill>
              <a:schemeClr val="tx1">
                <a:lumMod val="95000"/>
                <a:lumOff val="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2" name="타원 11"/>
          <p:cNvSpPr/>
          <p:nvPr/>
        </p:nvSpPr>
        <p:spPr>
          <a:xfrm>
            <a:off x="9629966" y="3297312"/>
            <a:ext cx="3076269" cy="2835879"/>
          </a:xfrm>
          <a:prstGeom prst="ellipse">
            <a:avLst/>
          </a:prstGeom>
          <a:solidFill>
            <a:srgbClr val="FA2EA7">
              <a:alpha val="29000"/>
            </a:srgb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3" name="TextBox 12"/>
          <p:cNvSpPr txBox="1"/>
          <p:nvPr/>
        </p:nvSpPr>
        <p:spPr>
          <a:xfrm>
            <a:off x="7788595" y="1406408"/>
            <a:ext cx="5849772" cy="777117"/>
          </a:xfrm>
          <a:prstGeom prst="rect">
            <a:avLst/>
          </a:prstGeom>
          <a:noFill/>
        </p:spPr>
        <p:txBody>
          <a:bodyPr wrap="square" rtlCol="0">
            <a:spAutoFit/>
          </a:bodyPr>
          <a:lstStyle/>
          <a:p>
            <a:pPr algn="ctr"/>
            <a:r>
              <a:rPr lang="en-US" altLang="ko-KR" b="1" i="1" smtClean="0">
                <a:solidFill>
                  <a:schemeClr val="accent5">
                    <a:lumMod val="75000"/>
                  </a:schemeClr>
                </a:solidFill>
              </a:rPr>
              <a:t>Our study</a:t>
            </a:r>
          </a:p>
          <a:p>
            <a:pPr algn="ctr"/>
            <a:r>
              <a:rPr lang="en-US" altLang="ko-KR" b="1" i="1" smtClean="0">
                <a:solidFill>
                  <a:schemeClr val="accent5">
                    <a:lumMod val="75000"/>
                  </a:schemeClr>
                </a:solidFill>
              </a:rPr>
              <a:t>(Individual sample proteome)</a:t>
            </a:r>
            <a:endParaRPr lang="ko-KR" altLang="en-US" b="1" i="1">
              <a:solidFill>
                <a:schemeClr val="accent5">
                  <a:lumMod val="75000"/>
                </a:schemeClr>
              </a:solidFill>
            </a:endParaRPr>
          </a:p>
        </p:txBody>
      </p:sp>
      <p:sp>
        <p:nvSpPr>
          <p:cNvPr id="14" name="TextBox 13"/>
          <p:cNvSpPr txBox="1"/>
          <p:nvPr/>
        </p:nvSpPr>
        <p:spPr>
          <a:xfrm>
            <a:off x="11582340" y="6014021"/>
            <a:ext cx="1937645" cy="444067"/>
          </a:xfrm>
          <a:prstGeom prst="rect">
            <a:avLst/>
          </a:prstGeom>
          <a:noFill/>
        </p:spPr>
        <p:txBody>
          <a:bodyPr wrap="square" rtlCol="0">
            <a:spAutoFit/>
          </a:bodyPr>
          <a:lstStyle/>
          <a:p>
            <a:r>
              <a:rPr lang="en-US" altLang="ko-KR" b="1" i="1" smtClean="0">
                <a:solidFill>
                  <a:srgbClr val="EE64DA"/>
                </a:solidFill>
              </a:rPr>
              <a:t>MS </a:t>
            </a:r>
            <a:r>
              <a:rPr lang="en-US" altLang="ko-KR" b="1" i="1" err="1">
                <a:solidFill>
                  <a:srgbClr val="EE64DA"/>
                </a:solidFill>
              </a:rPr>
              <a:t>J</a:t>
            </a:r>
            <a:r>
              <a:rPr lang="en-US" altLang="ko-KR" b="1" i="1" err="1" smtClean="0">
                <a:solidFill>
                  <a:srgbClr val="EE64DA"/>
                </a:solidFill>
              </a:rPr>
              <a:t>in</a:t>
            </a:r>
            <a:r>
              <a:rPr lang="en-US" altLang="ko-KR" b="1" i="1" smtClean="0">
                <a:solidFill>
                  <a:srgbClr val="EE64DA"/>
                </a:solidFill>
              </a:rPr>
              <a:t> et </a:t>
            </a:r>
            <a:r>
              <a:rPr lang="en-US" altLang="ko-KR" b="1" i="1" smtClean="0">
                <a:solidFill>
                  <a:srgbClr val="EE64DA"/>
                </a:solidFill>
                <a:latin typeface="Arial" panose="020B0604020202020204" pitchFamily="34" charset="0"/>
                <a:cs typeface="Arial" panose="020B0604020202020204" pitchFamily="34" charset="0"/>
              </a:rPr>
              <a:t>al</a:t>
            </a:r>
            <a:r>
              <a:rPr lang="en-US" altLang="ko-KR" b="1" i="1" smtClean="0">
                <a:solidFill>
                  <a:srgbClr val="EE64DA"/>
                </a:solidFill>
              </a:rPr>
              <a:t>.</a:t>
            </a:r>
            <a:endParaRPr lang="ko-KR" altLang="en-US" b="1" i="1">
              <a:solidFill>
                <a:srgbClr val="EE64DA"/>
              </a:solidFill>
            </a:endParaRPr>
          </a:p>
        </p:txBody>
      </p:sp>
      <p:sp>
        <p:nvSpPr>
          <p:cNvPr id="15" name="TextBox 14"/>
          <p:cNvSpPr txBox="1"/>
          <p:nvPr/>
        </p:nvSpPr>
        <p:spPr>
          <a:xfrm>
            <a:off x="9538996" y="4209993"/>
            <a:ext cx="3076269" cy="703105"/>
          </a:xfrm>
          <a:prstGeom prst="rect">
            <a:avLst/>
          </a:prstGeom>
          <a:noFill/>
        </p:spPr>
        <p:txBody>
          <a:bodyPr wrap="square" rtlCol="0">
            <a:spAutoFit/>
          </a:bodyPr>
          <a:lstStyle/>
          <a:p>
            <a:pPr algn="ctr"/>
            <a:r>
              <a:rPr lang="en-US" altLang="ko-KR" sz="1600" b="1" smtClean="0"/>
              <a:t>5620</a:t>
            </a:r>
          </a:p>
          <a:p>
            <a:pPr algn="ctr"/>
            <a:r>
              <a:rPr lang="en-US" altLang="ko-KR" sz="1600" b="1" smtClean="0"/>
              <a:t>(91% of MS </a:t>
            </a:r>
            <a:r>
              <a:rPr lang="en-US" altLang="ko-KR" sz="1600" b="1" err="1" smtClean="0"/>
              <a:t>Jin</a:t>
            </a:r>
            <a:r>
              <a:rPr lang="en-US" altLang="ko-KR" sz="1600" b="1" smtClean="0"/>
              <a:t> et al.)</a:t>
            </a:r>
            <a:endParaRPr lang="ko-KR" altLang="en-US" sz="1600" b="1"/>
          </a:p>
        </p:txBody>
      </p:sp>
      <p:sp>
        <p:nvSpPr>
          <p:cNvPr id="16" name="TextBox 15"/>
          <p:cNvSpPr txBox="1"/>
          <p:nvPr/>
        </p:nvSpPr>
        <p:spPr>
          <a:xfrm>
            <a:off x="11500842" y="5630395"/>
            <a:ext cx="601475" cy="407061"/>
          </a:xfrm>
          <a:prstGeom prst="rect">
            <a:avLst/>
          </a:prstGeom>
          <a:noFill/>
        </p:spPr>
        <p:txBody>
          <a:bodyPr wrap="square" rtlCol="0">
            <a:spAutoFit/>
          </a:bodyPr>
          <a:lstStyle/>
          <a:p>
            <a:r>
              <a:rPr lang="en-US" altLang="ko-KR" sz="1600" b="1" smtClean="0"/>
              <a:t>524</a:t>
            </a:r>
            <a:endParaRPr lang="ko-KR" altLang="en-US" sz="1600" b="1"/>
          </a:p>
        </p:txBody>
      </p:sp>
      <p:sp>
        <p:nvSpPr>
          <p:cNvPr id="17" name="TextBox 16"/>
          <p:cNvSpPr txBox="1"/>
          <p:nvPr/>
        </p:nvSpPr>
        <p:spPr>
          <a:xfrm>
            <a:off x="9739855" y="2816126"/>
            <a:ext cx="718774" cy="407061"/>
          </a:xfrm>
          <a:prstGeom prst="rect">
            <a:avLst/>
          </a:prstGeom>
          <a:noFill/>
        </p:spPr>
        <p:txBody>
          <a:bodyPr wrap="square" rtlCol="0">
            <a:spAutoFit/>
          </a:bodyPr>
          <a:lstStyle/>
          <a:p>
            <a:r>
              <a:rPr lang="en-US" altLang="ko-KR" sz="1600" b="1" smtClean="0"/>
              <a:t>3126</a:t>
            </a:r>
            <a:endParaRPr lang="ko-KR" altLang="en-US" sz="1600" b="1"/>
          </a:p>
        </p:txBody>
      </p:sp>
      <p:sp>
        <p:nvSpPr>
          <p:cNvPr id="60" name="TextBox 59"/>
          <p:cNvSpPr txBox="1"/>
          <p:nvPr/>
        </p:nvSpPr>
        <p:spPr>
          <a:xfrm>
            <a:off x="886034" y="838599"/>
            <a:ext cx="597237" cy="523220"/>
          </a:xfrm>
          <a:prstGeom prst="rect">
            <a:avLst/>
          </a:prstGeom>
          <a:noFill/>
        </p:spPr>
        <p:txBody>
          <a:bodyPr wrap="square" rtlCol="0">
            <a:spAutoFit/>
          </a:bodyPr>
          <a:lstStyle/>
          <a:p>
            <a:r>
              <a:rPr lang="en-US" altLang="ko-KR" sz="2800" b="1">
                <a:latin typeface="Arial" panose="020B0604020202020204" pitchFamily="34" charset="0"/>
                <a:cs typeface="Arial" panose="020B0604020202020204" pitchFamily="34" charset="0"/>
              </a:rPr>
              <a:t>a</a:t>
            </a:r>
            <a:endParaRPr lang="ko-KR" altLang="en-US" sz="2800" b="1">
              <a:latin typeface="Arial" panose="020B0604020202020204" pitchFamily="34" charset="0"/>
              <a:cs typeface="Arial" panose="020B0604020202020204" pitchFamily="34" charset="0"/>
            </a:endParaRPr>
          </a:p>
        </p:txBody>
      </p:sp>
      <p:sp>
        <p:nvSpPr>
          <p:cNvPr id="61" name="TextBox 60"/>
          <p:cNvSpPr txBox="1"/>
          <p:nvPr/>
        </p:nvSpPr>
        <p:spPr>
          <a:xfrm>
            <a:off x="7567710" y="883188"/>
            <a:ext cx="597237" cy="523220"/>
          </a:xfrm>
          <a:prstGeom prst="rect">
            <a:avLst/>
          </a:prstGeom>
          <a:noFill/>
        </p:spPr>
        <p:txBody>
          <a:bodyPr wrap="square" rtlCol="0">
            <a:spAutoFit/>
          </a:bodyPr>
          <a:lstStyle/>
          <a:p>
            <a:r>
              <a:rPr lang="en-US" altLang="ko-KR" sz="2800" b="1">
                <a:latin typeface="Arial" panose="020B0604020202020204" pitchFamily="34" charset="0"/>
                <a:cs typeface="Arial" panose="020B0604020202020204" pitchFamily="34" charset="0"/>
              </a:rPr>
              <a:t>b</a:t>
            </a:r>
            <a:endParaRPr lang="ko-KR" altLang="en-US" sz="2800" b="1">
              <a:latin typeface="Arial" panose="020B0604020202020204" pitchFamily="34" charset="0"/>
              <a:cs typeface="Arial" panose="020B0604020202020204" pitchFamily="34" charset="0"/>
            </a:endParaRPr>
          </a:p>
        </p:txBody>
      </p:sp>
      <p:sp>
        <p:nvSpPr>
          <p:cNvPr id="21" name="직사각형 20"/>
          <p:cNvSpPr/>
          <p:nvPr/>
        </p:nvSpPr>
        <p:spPr>
          <a:xfrm>
            <a:off x="288231" y="7307615"/>
            <a:ext cx="13795221" cy="1569660"/>
          </a:xfrm>
          <a:prstGeom prst="rect">
            <a:avLst/>
          </a:prstGeom>
        </p:spPr>
        <p:txBody>
          <a:bodyPr wrap="square">
            <a:spAutoFit/>
          </a:bodyPr>
          <a:lstStyle/>
          <a:p>
            <a:pPr algn="just"/>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4. </a:t>
            </a:r>
            <a:r>
              <a:rPr lang="en-US" altLang="ko-KR" sz="2400" b="1" dirty="0">
                <a:latin typeface="Arial" panose="020B0604020202020204" pitchFamily="34" charset="0"/>
                <a:cs typeface="Arial" panose="020B0604020202020204" pitchFamily="34" charset="0"/>
              </a:rPr>
              <a:t>Comparative analysis between our FFPE tissue proteome and those of our previous studies.</a:t>
            </a:r>
            <a:r>
              <a:rPr lang="en-US" altLang="ko-KR" sz="2400" dirty="0">
                <a:latin typeface="Arial" panose="020B0604020202020204" pitchFamily="34" charset="0"/>
                <a:cs typeface="Arial" panose="020B0604020202020204" pitchFamily="34" charset="0"/>
              </a:rPr>
              <a:t> (a) Comparison of identified proteins between our pooled sample proteome data and those of </a:t>
            </a:r>
            <a:r>
              <a:rPr lang="en-US" altLang="ko-KR" sz="2400" i="1" dirty="0">
                <a:latin typeface="Arial" panose="020B0604020202020204" pitchFamily="34" charset="0"/>
                <a:cs typeface="Arial" panose="020B0604020202020204" pitchFamily="34" charset="0"/>
              </a:rPr>
              <a:t>MS </a:t>
            </a:r>
            <a:r>
              <a:rPr lang="en-US" altLang="ko-KR" sz="2400" i="1" dirty="0" err="1">
                <a:latin typeface="Arial" panose="020B0604020202020204" pitchFamily="34" charset="0"/>
                <a:cs typeface="Arial" panose="020B0604020202020204" pitchFamily="34" charset="0"/>
              </a:rPr>
              <a:t>Jin</a:t>
            </a:r>
            <a:r>
              <a:rPr lang="en-US" altLang="ko-KR" sz="2400" i="1" dirty="0">
                <a:latin typeface="Arial" panose="020B0604020202020204" pitchFamily="34" charset="0"/>
                <a:cs typeface="Arial" panose="020B0604020202020204" pitchFamily="34" charset="0"/>
              </a:rPr>
              <a:t> et al. </a:t>
            </a:r>
            <a:r>
              <a:rPr lang="en-US" altLang="ko-KR" sz="2400" dirty="0">
                <a:latin typeface="Arial" panose="020B0604020202020204" pitchFamily="34" charset="0"/>
                <a:cs typeface="Arial" panose="020B0604020202020204" pitchFamily="34" charset="0"/>
              </a:rPr>
              <a:t>(b) Comparison of identified proteins between our individual sample proteome data and those of </a:t>
            </a:r>
            <a:r>
              <a:rPr lang="en-US" altLang="ko-KR" sz="2400" i="1" dirty="0">
                <a:latin typeface="Arial" panose="020B0604020202020204" pitchFamily="34" charset="0"/>
                <a:cs typeface="Arial" panose="020B0604020202020204" pitchFamily="34" charset="0"/>
              </a:rPr>
              <a:t>MS </a:t>
            </a:r>
            <a:r>
              <a:rPr lang="en-US" altLang="ko-KR" sz="2400" i="1" dirty="0" err="1">
                <a:latin typeface="Arial" panose="020B0604020202020204" pitchFamily="34" charset="0"/>
                <a:cs typeface="Arial" panose="020B0604020202020204" pitchFamily="34" charset="0"/>
              </a:rPr>
              <a:t>Jin</a:t>
            </a:r>
            <a:r>
              <a:rPr lang="en-US" altLang="ko-KR" sz="2400" i="1" dirty="0">
                <a:latin typeface="Arial" panose="020B0604020202020204" pitchFamily="34" charset="0"/>
                <a:cs typeface="Arial" panose="020B0604020202020204" pitchFamily="34" charset="0"/>
              </a:rPr>
              <a:t> et al.</a:t>
            </a:r>
            <a:endParaRPr lang="en-US" altLang="ko-KR" sz="2400" dirty="0">
              <a:latin typeface="Arial" panose="020B0604020202020204" pitchFamily="34" charset="0"/>
              <a:cs typeface="Arial" panose="020B0604020202020204" pitchFamily="34" charset="0"/>
            </a:endParaRPr>
          </a:p>
        </p:txBody>
      </p:sp>
      <p:sp>
        <p:nvSpPr>
          <p:cNvPr id="22" name="TextBox 21"/>
          <p:cNvSpPr txBox="1"/>
          <p:nvPr/>
        </p:nvSpPr>
        <p:spPr>
          <a:xfrm>
            <a:off x="6738167" y="19991959"/>
            <a:ext cx="895350" cy="461665"/>
          </a:xfrm>
          <a:prstGeom prst="rect">
            <a:avLst/>
          </a:prstGeom>
          <a:noFill/>
        </p:spPr>
        <p:txBody>
          <a:bodyPr wrap="square" rtlCol="0">
            <a:spAutoFit/>
          </a:bodyPr>
          <a:lstStyle/>
          <a:p>
            <a:r>
              <a:rPr lang="en-US" altLang="ko-KR" sz="2400" b="1" smtClean="0"/>
              <a:t>S-4</a:t>
            </a:r>
            <a:endParaRPr lang="ko-KR" altLang="en-US" sz="2400" b="1"/>
          </a:p>
        </p:txBody>
      </p:sp>
    </p:spTree>
    <p:extLst>
      <p:ext uri="{BB962C8B-B14F-4D97-AF65-F5344CB8AC3E}">
        <p14:creationId xmlns:p14="http://schemas.microsoft.com/office/powerpoint/2010/main" val="15065719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9" name="차트 68"/>
          <p:cNvGraphicFramePr>
            <a:graphicFrameLocks/>
          </p:cNvGraphicFramePr>
          <p:nvPr>
            <p:extLst>
              <p:ext uri="{D42A27DB-BD31-4B8C-83A1-F6EECF244321}">
                <p14:modId xmlns:p14="http://schemas.microsoft.com/office/powerpoint/2010/main" val="701445689"/>
              </p:ext>
            </p:extLst>
          </p:nvPr>
        </p:nvGraphicFramePr>
        <p:xfrm>
          <a:off x="8044257" y="1926229"/>
          <a:ext cx="5293255" cy="329054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70" name="차트 69"/>
          <p:cNvGraphicFramePr>
            <a:graphicFrameLocks/>
          </p:cNvGraphicFramePr>
          <p:nvPr>
            <p:extLst>
              <p:ext uri="{D42A27DB-BD31-4B8C-83A1-F6EECF244321}">
                <p14:modId xmlns:p14="http://schemas.microsoft.com/office/powerpoint/2010/main" val="2237385317"/>
              </p:ext>
            </p:extLst>
          </p:nvPr>
        </p:nvGraphicFramePr>
        <p:xfrm>
          <a:off x="7806133" y="1568384"/>
          <a:ext cx="5293254" cy="3290543"/>
        </p:xfrm>
        <a:graphic>
          <a:graphicData uri="http://schemas.openxmlformats.org/drawingml/2006/chart">
            <c:chart xmlns:c="http://schemas.openxmlformats.org/drawingml/2006/chart" xmlns:r="http://schemas.openxmlformats.org/officeDocument/2006/relationships" r:id="rId4"/>
          </a:graphicData>
        </a:graphic>
      </p:graphicFrame>
      <p:cxnSp>
        <p:nvCxnSpPr>
          <p:cNvPr id="73" name="직선 연결선 72"/>
          <p:cNvCxnSpPr/>
          <p:nvPr/>
        </p:nvCxnSpPr>
        <p:spPr>
          <a:xfrm>
            <a:off x="8357984" y="1788085"/>
            <a:ext cx="0" cy="313913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직선 연결선 73"/>
          <p:cNvCxnSpPr/>
          <p:nvPr/>
        </p:nvCxnSpPr>
        <p:spPr>
          <a:xfrm flipH="1" flipV="1">
            <a:off x="8357985" y="4913370"/>
            <a:ext cx="4866624" cy="448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3" name="TextBox 82"/>
          <p:cNvSpPr txBox="1"/>
          <p:nvPr/>
        </p:nvSpPr>
        <p:spPr>
          <a:xfrm rot="16200000">
            <a:off x="6460217" y="3154510"/>
            <a:ext cx="2795116" cy="338554"/>
          </a:xfrm>
          <a:prstGeom prst="rect">
            <a:avLst/>
          </a:prstGeom>
          <a:noFill/>
        </p:spPr>
        <p:txBody>
          <a:bodyPr wrap="square" rtlCol="0">
            <a:spAutoFit/>
          </a:bodyPr>
          <a:lstStyle/>
          <a:p>
            <a:pPr algn="ctr"/>
            <a:r>
              <a:rPr lang="en-US" altLang="ko-KR" sz="1600" b="1">
                <a:latin typeface="Arial" panose="020B0604020202020204" pitchFamily="34" charset="0"/>
                <a:cs typeface="Arial" panose="020B0604020202020204" pitchFamily="34" charset="0"/>
              </a:rPr>
              <a:t>Log2 (Reporter intensity)</a:t>
            </a:r>
          </a:p>
        </p:txBody>
      </p:sp>
      <p:sp>
        <p:nvSpPr>
          <p:cNvPr id="85" name="TextBox 84"/>
          <p:cNvSpPr txBox="1"/>
          <p:nvPr/>
        </p:nvSpPr>
        <p:spPr>
          <a:xfrm>
            <a:off x="9416522" y="5197979"/>
            <a:ext cx="2749550" cy="338554"/>
          </a:xfrm>
          <a:prstGeom prst="rect">
            <a:avLst/>
          </a:prstGeom>
          <a:noFill/>
        </p:spPr>
        <p:txBody>
          <a:bodyPr wrap="square" rtlCol="0">
            <a:spAutoFit/>
          </a:bodyPr>
          <a:lstStyle/>
          <a:p>
            <a:pPr algn="ctr"/>
            <a:r>
              <a:rPr lang="en-US" altLang="ko-KR" sz="1600" b="1">
                <a:latin typeface="Arial" panose="020B0604020202020204" pitchFamily="34" charset="0"/>
                <a:cs typeface="Arial" panose="020B0604020202020204" pitchFamily="34" charset="0"/>
              </a:rPr>
              <a:t>TMT channels</a:t>
            </a:r>
          </a:p>
        </p:txBody>
      </p:sp>
      <p:sp>
        <p:nvSpPr>
          <p:cNvPr id="86" name="TextBox 85"/>
          <p:cNvSpPr txBox="1"/>
          <p:nvPr/>
        </p:nvSpPr>
        <p:spPr>
          <a:xfrm>
            <a:off x="12166072" y="3329919"/>
            <a:ext cx="1400086" cy="307777"/>
          </a:xfrm>
          <a:prstGeom prst="rect">
            <a:avLst/>
          </a:prstGeom>
          <a:noFill/>
        </p:spPr>
        <p:txBody>
          <a:bodyPr wrap="square" rtlCol="0">
            <a:spAutoFit/>
          </a:bodyPr>
          <a:lstStyle/>
          <a:p>
            <a:r>
              <a:rPr lang="en-US" altLang="ko-KR" sz="1400" b="1">
                <a:latin typeface="Arial" panose="020B0604020202020204" pitchFamily="34" charset="0"/>
                <a:cs typeface="Arial" panose="020B0604020202020204" pitchFamily="34" charset="0"/>
              </a:rPr>
              <a:t>CV = 4.2%</a:t>
            </a:r>
            <a:endParaRPr lang="ko-KR" altLang="en-US" sz="1400" b="1">
              <a:latin typeface="Arial" panose="020B0604020202020204" pitchFamily="34" charset="0"/>
              <a:cs typeface="Arial" panose="020B0604020202020204" pitchFamily="34" charset="0"/>
            </a:endParaRPr>
          </a:p>
        </p:txBody>
      </p:sp>
      <p:sp>
        <p:nvSpPr>
          <p:cNvPr id="87" name="TextBox 86"/>
          <p:cNvSpPr txBox="1"/>
          <p:nvPr/>
        </p:nvSpPr>
        <p:spPr>
          <a:xfrm>
            <a:off x="12166072" y="2572011"/>
            <a:ext cx="1400086" cy="307777"/>
          </a:xfrm>
          <a:prstGeom prst="rect">
            <a:avLst/>
          </a:prstGeom>
          <a:noFill/>
        </p:spPr>
        <p:txBody>
          <a:bodyPr wrap="square" rtlCol="0">
            <a:spAutoFit/>
          </a:bodyPr>
          <a:lstStyle/>
          <a:p>
            <a:r>
              <a:rPr lang="en-US" altLang="ko-KR" sz="1400" b="1">
                <a:latin typeface="Arial" panose="020B0604020202020204" pitchFamily="34" charset="0"/>
                <a:cs typeface="Arial" panose="020B0604020202020204" pitchFamily="34" charset="0"/>
              </a:rPr>
              <a:t>CV = 6.7%</a:t>
            </a:r>
            <a:endParaRPr lang="ko-KR" altLang="en-US" sz="1400" b="1">
              <a:latin typeface="Arial" panose="020B0604020202020204" pitchFamily="34" charset="0"/>
              <a:cs typeface="Arial" panose="020B0604020202020204" pitchFamily="34" charset="0"/>
            </a:endParaRPr>
          </a:p>
        </p:txBody>
      </p:sp>
      <p:sp>
        <p:nvSpPr>
          <p:cNvPr id="88" name="타원 87"/>
          <p:cNvSpPr/>
          <p:nvPr/>
        </p:nvSpPr>
        <p:spPr>
          <a:xfrm>
            <a:off x="8357985" y="6047562"/>
            <a:ext cx="104775" cy="106319"/>
          </a:xfrm>
          <a:prstGeom prst="ellips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9" name="타원 88"/>
          <p:cNvSpPr/>
          <p:nvPr/>
        </p:nvSpPr>
        <p:spPr>
          <a:xfrm>
            <a:off x="8357985" y="5799263"/>
            <a:ext cx="104775" cy="106319"/>
          </a:xfrm>
          <a:prstGeom prst="ellipse">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90" name="TextBox 89"/>
          <p:cNvSpPr txBox="1"/>
          <p:nvPr/>
        </p:nvSpPr>
        <p:spPr>
          <a:xfrm>
            <a:off x="8462759" y="5664818"/>
            <a:ext cx="2756264" cy="307777"/>
          </a:xfrm>
          <a:prstGeom prst="rect">
            <a:avLst/>
          </a:prstGeom>
          <a:noFill/>
        </p:spPr>
        <p:txBody>
          <a:bodyPr wrap="square" rtlCol="0">
            <a:spAutoFit/>
          </a:bodyPr>
          <a:lstStyle/>
          <a:p>
            <a:r>
              <a:rPr lang="en-US" altLang="ko-KR" sz="1400" b="1">
                <a:latin typeface="Arial" panose="020B0604020202020204" pitchFamily="34" charset="0"/>
                <a:cs typeface="Arial" panose="020B0604020202020204" pitchFamily="34" charset="0"/>
              </a:rPr>
              <a:t>P</a:t>
            </a:r>
            <a:r>
              <a:rPr lang="en-US" altLang="ko-KR" sz="1400" b="1" smtClean="0">
                <a:latin typeface="Arial" panose="020B0604020202020204" pitchFamily="34" charset="0"/>
                <a:cs typeface="Arial" panose="020B0604020202020204" pitchFamily="34" charset="0"/>
              </a:rPr>
              <a:t>ooled sample</a:t>
            </a:r>
            <a:r>
              <a:rPr lang="en-US" altLang="ko-KR" sz="1400" b="1">
                <a:latin typeface="Arial" panose="020B0604020202020204" pitchFamily="34" charset="0"/>
                <a:cs typeface="Arial" panose="020B0604020202020204" pitchFamily="34" charset="0"/>
              </a:rPr>
              <a:t> </a:t>
            </a:r>
            <a:r>
              <a:rPr lang="en-US" altLang="ko-KR" sz="1400" b="1" smtClean="0">
                <a:latin typeface="Arial" panose="020B0604020202020204" pitchFamily="34" charset="0"/>
                <a:cs typeface="Arial" panose="020B0604020202020204" pitchFamily="34" charset="0"/>
              </a:rPr>
              <a:t>set </a:t>
            </a:r>
            <a:endParaRPr lang="ko-KR" altLang="en-US" sz="1400" b="1">
              <a:latin typeface="Arial" panose="020B0604020202020204" pitchFamily="34" charset="0"/>
              <a:cs typeface="Arial" panose="020B0604020202020204" pitchFamily="34" charset="0"/>
            </a:endParaRPr>
          </a:p>
        </p:txBody>
      </p:sp>
      <p:sp>
        <p:nvSpPr>
          <p:cNvPr id="91" name="TextBox 90"/>
          <p:cNvSpPr txBox="1"/>
          <p:nvPr/>
        </p:nvSpPr>
        <p:spPr>
          <a:xfrm>
            <a:off x="8483835" y="5941383"/>
            <a:ext cx="2598028" cy="307777"/>
          </a:xfrm>
          <a:prstGeom prst="rect">
            <a:avLst/>
          </a:prstGeom>
          <a:noFill/>
        </p:spPr>
        <p:txBody>
          <a:bodyPr wrap="square" rtlCol="0">
            <a:spAutoFit/>
          </a:bodyPr>
          <a:lstStyle/>
          <a:p>
            <a:r>
              <a:rPr lang="en-US" altLang="ko-KR" sz="1400" b="1">
                <a:latin typeface="Arial" panose="020B0604020202020204" pitchFamily="34" charset="0"/>
                <a:cs typeface="Arial" panose="020B0604020202020204" pitchFamily="34" charset="0"/>
              </a:rPr>
              <a:t>I</a:t>
            </a:r>
            <a:r>
              <a:rPr lang="en-US" altLang="ko-KR" sz="1400" b="1" smtClean="0">
                <a:latin typeface="Arial" panose="020B0604020202020204" pitchFamily="34" charset="0"/>
                <a:cs typeface="Arial" panose="020B0604020202020204" pitchFamily="34" charset="0"/>
              </a:rPr>
              <a:t>ndividual sample set </a:t>
            </a:r>
            <a:endParaRPr lang="ko-KR" altLang="en-US" sz="1400" b="1">
              <a:latin typeface="Arial" panose="020B0604020202020204" pitchFamily="34" charset="0"/>
              <a:cs typeface="Arial" panose="020B0604020202020204" pitchFamily="34" charset="0"/>
            </a:endParaRPr>
          </a:p>
        </p:txBody>
      </p:sp>
      <p:sp>
        <p:nvSpPr>
          <p:cNvPr id="39" name="직사각형 38"/>
          <p:cNvSpPr/>
          <p:nvPr/>
        </p:nvSpPr>
        <p:spPr>
          <a:xfrm>
            <a:off x="625526" y="826871"/>
            <a:ext cx="5787397" cy="369332"/>
          </a:xfrm>
          <a:prstGeom prst="rect">
            <a:avLst/>
          </a:prstGeom>
        </p:spPr>
        <p:txBody>
          <a:bodyPr wrap="square">
            <a:spAutoFit/>
          </a:bodyPr>
          <a:lstStyle/>
          <a:p>
            <a:r>
              <a:rPr lang="en-US" altLang="ko-KR" sz="1800" b="1" smtClean="0">
                <a:latin typeface="Arial" panose="020B0604020202020204" pitchFamily="34" charset="0"/>
                <a:ea typeface="굴림" panose="020B0600000101010101" pitchFamily="50" charset="-127"/>
                <a:cs typeface="Arial" panose="020B0604020202020204" pitchFamily="34" charset="0"/>
              </a:rPr>
              <a:t>The abundance and variation of ovalbumin</a:t>
            </a:r>
            <a:endParaRPr lang="ko-KR" altLang="en-US" sz="1800"/>
          </a:p>
        </p:txBody>
      </p:sp>
      <p:sp>
        <p:nvSpPr>
          <p:cNvPr id="40" name="TextBox 39"/>
          <p:cNvSpPr txBox="1"/>
          <p:nvPr/>
        </p:nvSpPr>
        <p:spPr>
          <a:xfrm>
            <a:off x="282084" y="699839"/>
            <a:ext cx="429223" cy="523220"/>
          </a:xfrm>
          <a:prstGeom prst="rect">
            <a:avLst/>
          </a:prstGeom>
          <a:noFill/>
        </p:spPr>
        <p:txBody>
          <a:bodyPr wrap="square" rtlCol="0">
            <a:spAutoFit/>
          </a:bodyPr>
          <a:lstStyle/>
          <a:p>
            <a:pPr algn="ctr"/>
            <a:r>
              <a:rPr lang="en-US" altLang="ko-KR" sz="2800" b="1" smtClean="0">
                <a:latin typeface="Arial" panose="020B0604020202020204" pitchFamily="34" charset="0"/>
                <a:cs typeface="Arial" panose="020B0604020202020204" pitchFamily="34" charset="0"/>
              </a:rPr>
              <a:t>a</a:t>
            </a:r>
            <a:endParaRPr lang="ko-KR" altLang="en-US" sz="2800" b="1">
              <a:latin typeface="Arial" panose="020B0604020202020204" pitchFamily="34" charset="0"/>
              <a:cs typeface="Arial" panose="020B0604020202020204" pitchFamily="34" charset="0"/>
            </a:endParaRPr>
          </a:p>
        </p:txBody>
      </p:sp>
      <p:pic>
        <p:nvPicPr>
          <p:cNvPr id="42" name="그림 41"/>
          <p:cNvPicPr>
            <a:picLocks noChangeAspect="1"/>
          </p:cNvPicPr>
          <p:nvPr/>
        </p:nvPicPr>
        <p:blipFill>
          <a:blip r:embed="rId5"/>
          <a:stretch>
            <a:fillRect/>
          </a:stretch>
        </p:blipFill>
        <p:spPr>
          <a:xfrm>
            <a:off x="272874" y="9012483"/>
            <a:ext cx="6042380" cy="4624697"/>
          </a:xfrm>
          <a:prstGeom prst="rect">
            <a:avLst/>
          </a:prstGeom>
        </p:spPr>
      </p:pic>
      <p:graphicFrame>
        <p:nvGraphicFramePr>
          <p:cNvPr id="43" name="개체 42"/>
          <p:cNvGraphicFramePr>
            <a:graphicFrameLocks noChangeAspect="1"/>
          </p:cNvGraphicFramePr>
          <p:nvPr>
            <p:extLst>
              <p:ext uri="{D42A27DB-BD31-4B8C-83A1-F6EECF244321}">
                <p14:modId xmlns:p14="http://schemas.microsoft.com/office/powerpoint/2010/main" val="1219055765"/>
              </p:ext>
            </p:extLst>
          </p:nvPr>
        </p:nvGraphicFramePr>
        <p:xfrm>
          <a:off x="7466114" y="9087364"/>
          <a:ext cx="5883305" cy="4519118"/>
        </p:xfrm>
        <a:graphic>
          <a:graphicData uri="http://schemas.openxmlformats.org/presentationml/2006/ole">
            <mc:AlternateContent xmlns:mc="http://schemas.openxmlformats.org/markup-compatibility/2006">
              <mc:Choice xmlns:v="urn:schemas-microsoft-com:vml" Requires="v">
                <p:oleObj spid="_x0000_s1761" name="Prism 6" r:id="rId6" imgW="7072345" imgH="5432203" progId="Prism6.Document">
                  <p:embed/>
                </p:oleObj>
              </mc:Choice>
              <mc:Fallback>
                <p:oleObj name="Prism 6" r:id="rId6" imgW="7072345" imgH="5432203" progId="Prism6.Document">
                  <p:embed/>
                  <p:pic>
                    <p:nvPicPr>
                      <p:cNvPr id="5" name="개체 4"/>
                      <p:cNvPicPr/>
                      <p:nvPr/>
                    </p:nvPicPr>
                    <p:blipFill>
                      <a:blip r:embed="rId7"/>
                      <a:stretch>
                        <a:fillRect/>
                      </a:stretch>
                    </p:blipFill>
                    <p:spPr>
                      <a:xfrm>
                        <a:off x="7466114" y="9087364"/>
                        <a:ext cx="5883305" cy="4519118"/>
                      </a:xfrm>
                      <a:prstGeom prst="rect">
                        <a:avLst/>
                      </a:prstGeom>
                    </p:spPr>
                  </p:pic>
                </p:oleObj>
              </mc:Fallback>
            </mc:AlternateContent>
          </a:graphicData>
        </a:graphic>
      </p:graphicFrame>
      <p:sp>
        <p:nvSpPr>
          <p:cNvPr id="44" name="직사각형 43"/>
          <p:cNvSpPr/>
          <p:nvPr/>
        </p:nvSpPr>
        <p:spPr>
          <a:xfrm>
            <a:off x="625526" y="7236207"/>
            <a:ext cx="10857426" cy="369332"/>
          </a:xfrm>
          <a:prstGeom prst="rect">
            <a:avLst/>
          </a:prstGeom>
        </p:spPr>
        <p:txBody>
          <a:bodyPr wrap="square">
            <a:spAutoFit/>
          </a:bodyPr>
          <a:lstStyle/>
          <a:p>
            <a:r>
              <a:rPr lang="en-US" altLang="ko-KR" sz="1800" b="1">
                <a:latin typeface="Arial" panose="020B0604020202020204" pitchFamily="34" charset="0"/>
                <a:ea typeface="굴림" panose="020B0600000101010101" pitchFamily="50" charset="-127"/>
                <a:cs typeface="Arial" panose="020B0604020202020204" pitchFamily="34" charset="0"/>
              </a:rPr>
              <a:t>Technical variability control with external standard </a:t>
            </a:r>
            <a:r>
              <a:rPr lang="en-US" altLang="ko-KR" sz="1800" b="1" smtClean="0">
                <a:latin typeface="Arial" panose="020B0604020202020204" pitchFamily="34" charset="0"/>
                <a:ea typeface="굴림" panose="020B0600000101010101" pitchFamily="50" charset="-127"/>
                <a:cs typeface="Arial" panose="020B0604020202020204" pitchFamily="34" charset="0"/>
              </a:rPr>
              <a:t>ovalbumin</a:t>
            </a:r>
            <a:endParaRPr lang="ko-KR" altLang="en-US" sz="1800"/>
          </a:p>
        </p:txBody>
      </p:sp>
      <p:sp>
        <p:nvSpPr>
          <p:cNvPr id="45" name="직사각형 44"/>
          <p:cNvSpPr/>
          <p:nvPr/>
        </p:nvSpPr>
        <p:spPr>
          <a:xfrm>
            <a:off x="913001" y="8727982"/>
            <a:ext cx="6188397" cy="307777"/>
          </a:xfrm>
          <a:prstGeom prst="rect">
            <a:avLst/>
          </a:prstGeom>
        </p:spPr>
        <p:txBody>
          <a:bodyPr wrap="square">
            <a:spAutoFit/>
          </a:bodyPr>
          <a:lstStyle/>
          <a:p>
            <a:r>
              <a:rPr lang="en-US" altLang="ko-KR" sz="1400" b="1">
                <a:latin typeface="Arial" panose="020B0604020202020204" pitchFamily="34" charset="0"/>
                <a:ea typeface="굴림" panose="020B0600000101010101" pitchFamily="50" charset="-127"/>
                <a:cs typeface="Arial" panose="020B0604020202020204" pitchFamily="34" charset="0"/>
              </a:rPr>
              <a:t>Coefficient of variation (CV) distribution before normalization</a:t>
            </a:r>
            <a:endParaRPr lang="ko-KR" altLang="en-US" sz="1400"/>
          </a:p>
        </p:txBody>
      </p:sp>
      <p:sp>
        <p:nvSpPr>
          <p:cNvPr id="46" name="직사각형 45"/>
          <p:cNvSpPr/>
          <p:nvPr/>
        </p:nvSpPr>
        <p:spPr>
          <a:xfrm>
            <a:off x="8069931" y="8727453"/>
            <a:ext cx="6222308" cy="307777"/>
          </a:xfrm>
          <a:prstGeom prst="rect">
            <a:avLst/>
          </a:prstGeom>
        </p:spPr>
        <p:txBody>
          <a:bodyPr wrap="square">
            <a:spAutoFit/>
          </a:bodyPr>
          <a:lstStyle/>
          <a:p>
            <a:r>
              <a:rPr lang="en-US" altLang="ko-KR" sz="1400" b="1">
                <a:latin typeface="Arial" panose="020B0604020202020204" pitchFamily="34" charset="0"/>
                <a:ea typeface="굴림" panose="020B0600000101010101" pitchFamily="50" charset="-127"/>
                <a:cs typeface="Arial" panose="020B0604020202020204" pitchFamily="34" charset="0"/>
              </a:rPr>
              <a:t>Coefficient of variation (CV) distribution after normalization</a:t>
            </a:r>
            <a:endParaRPr lang="ko-KR" altLang="en-US" sz="1400"/>
          </a:p>
        </p:txBody>
      </p:sp>
      <p:cxnSp>
        <p:nvCxnSpPr>
          <p:cNvPr id="48" name="직선 연결선 47"/>
          <p:cNvCxnSpPr/>
          <p:nvPr/>
        </p:nvCxnSpPr>
        <p:spPr>
          <a:xfrm>
            <a:off x="968203" y="12027199"/>
            <a:ext cx="5295959" cy="0"/>
          </a:xfrm>
          <a:prstGeom prst="line">
            <a:avLst/>
          </a:prstGeom>
          <a:ln w="38100">
            <a:solidFill>
              <a:srgbClr val="0070C0"/>
            </a:solidFill>
            <a:prstDash val="sysDot"/>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282084" y="7140632"/>
            <a:ext cx="429223" cy="523220"/>
          </a:xfrm>
          <a:prstGeom prst="rect">
            <a:avLst/>
          </a:prstGeom>
          <a:noFill/>
        </p:spPr>
        <p:txBody>
          <a:bodyPr wrap="square" rtlCol="0">
            <a:spAutoFit/>
          </a:bodyPr>
          <a:lstStyle/>
          <a:p>
            <a:pPr algn="ctr"/>
            <a:r>
              <a:rPr lang="en-US" altLang="ko-KR" sz="2800" b="1">
                <a:latin typeface="Arial" panose="020B0604020202020204" pitchFamily="34" charset="0"/>
                <a:cs typeface="Arial" panose="020B0604020202020204" pitchFamily="34" charset="0"/>
              </a:rPr>
              <a:t>b</a:t>
            </a:r>
            <a:endParaRPr lang="ko-KR" altLang="en-US" sz="2800" b="1">
              <a:latin typeface="Arial" panose="020B0604020202020204" pitchFamily="34" charset="0"/>
              <a:cs typeface="Arial" panose="020B0604020202020204" pitchFamily="34" charset="0"/>
            </a:endParaRPr>
          </a:p>
        </p:txBody>
      </p:sp>
      <p:graphicFrame>
        <p:nvGraphicFramePr>
          <p:cNvPr id="54" name="개체 53"/>
          <p:cNvGraphicFramePr>
            <a:graphicFrameLocks noChangeAspect="1"/>
          </p:cNvGraphicFramePr>
          <p:nvPr>
            <p:extLst>
              <p:ext uri="{D42A27DB-BD31-4B8C-83A1-F6EECF244321}">
                <p14:modId xmlns:p14="http://schemas.microsoft.com/office/powerpoint/2010/main" val="2058123603"/>
              </p:ext>
            </p:extLst>
          </p:nvPr>
        </p:nvGraphicFramePr>
        <p:xfrm>
          <a:off x="7614875" y="14927535"/>
          <a:ext cx="5883305" cy="4502944"/>
        </p:xfrm>
        <a:graphic>
          <a:graphicData uri="http://schemas.openxmlformats.org/presentationml/2006/ole">
            <mc:AlternateContent xmlns:mc="http://schemas.openxmlformats.org/markup-compatibility/2006">
              <mc:Choice xmlns:v="urn:schemas-microsoft-com:vml" Requires="v">
                <p:oleObj spid="_x0000_s1762" name="Prism 6" r:id="rId8" imgW="7098275" imgH="5432203" progId="Prism6.Document">
                  <p:embed/>
                </p:oleObj>
              </mc:Choice>
              <mc:Fallback>
                <p:oleObj name="Prism 6" r:id="rId8" imgW="7098275" imgH="5432203" progId="Prism6.Document">
                  <p:embed/>
                  <p:pic>
                    <p:nvPicPr>
                      <p:cNvPr id="18" name="개체 17"/>
                      <p:cNvPicPr/>
                      <p:nvPr/>
                    </p:nvPicPr>
                    <p:blipFill>
                      <a:blip r:embed="rId9"/>
                      <a:stretch>
                        <a:fillRect/>
                      </a:stretch>
                    </p:blipFill>
                    <p:spPr>
                      <a:xfrm>
                        <a:off x="7614875" y="14927535"/>
                        <a:ext cx="5883305" cy="4502944"/>
                      </a:xfrm>
                      <a:prstGeom prst="rect">
                        <a:avLst/>
                      </a:prstGeom>
                    </p:spPr>
                  </p:pic>
                </p:oleObj>
              </mc:Fallback>
            </mc:AlternateContent>
          </a:graphicData>
        </a:graphic>
      </p:graphicFrame>
      <p:graphicFrame>
        <p:nvGraphicFramePr>
          <p:cNvPr id="56" name="개체 55"/>
          <p:cNvGraphicFramePr>
            <a:graphicFrameLocks noChangeAspect="1"/>
          </p:cNvGraphicFramePr>
          <p:nvPr>
            <p:extLst>
              <p:ext uri="{D42A27DB-BD31-4B8C-83A1-F6EECF244321}">
                <p14:modId xmlns:p14="http://schemas.microsoft.com/office/powerpoint/2010/main" val="2986276177"/>
              </p:ext>
            </p:extLst>
          </p:nvPr>
        </p:nvGraphicFramePr>
        <p:xfrm>
          <a:off x="272874" y="14927535"/>
          <a:ext cx="6140049" cy="4565677"/>
        </p:xfrm>
        <a:graphic>
          <a:graphicData uri="http://schemas.openxmlformats.org/presentationml/2006/ole">
            <mc:AlternateContent xmlns:mc="http://schemas.openxmlformats.org/markup-compatibility/2006">
              <mc:Choice xmlns:v="urn:schemas-microsoft-com:vml" Requires="v">
                <p:oleObj spid="_x0000_s1763" name="Prism 6" r:id="rId10" imgW="7305713" imgH="5432203" progId="Prism6.Document">
                  <p:embed/>
                </p:oleObj>
              </mc:Choice>
              <mc:Fallback>
                <p:oleObj name="Prism 6" r:id="rId10" imgW="7305713" imgH="5432203" progId="Prism6.Document">
                  <p:embed/>
                  <p:pic>
                    <p:nvPicPr>
                      <p:cNvPr id="17" name="개체 16"/>
                      <p:cNvPicPr/>
                      <p:nvPr/>
                    </p:nvPicPr>
                    <p:blipFill>
                      <a:blip r:embed="rId11"/>
                      <a:stretch>
                        <a:fillRect/>
                      </a:stretch>
                    </p:blipFill>
                    <p:spPr>
                      <a:xfrm>
                        <a:off x="272874" y="14927535"/>
                        <a:ext cx="6140049" cy="4565677"/>
                      </a:xfrm>
                      <a:prstGeom prst="rect">
                        <a:avLst/>
                      </a:prstGeom>
                    </p:spPr>
                  </p:pic>
                </p:oleObj>
              </mc:Fallback>
            </mc:AlternateContent>
          </a:graphicData>
        </a:graphic>
      </p:graphicFrame>
      <p:sp>
        <p:nvSpPr>
          <p:cNvPr id="57" name="직사각형 56"/>
          <p:cNvSpPr/>
          <p:nvPr/>
        </p:nvSpPr>
        <p:spPr>
          <a:xfrm>
            <a:off x="1116964" y="14733107"/>
            <a:ext cx="6188397" cy="307777"/>
          </a:xfrm>
          <a:prstGeom prst="rect">
            <a:avLst/>
          </a:prstGeom>
        </p:spPr>
        <p:txBody>
          <a:bodyPr wrap="square">
            <a:spAutoFit/>
          </a:bodyPr>
          <a:lstStyle/>
          <a:p>
            <a:r>
              <a:rPr lang="en-US" altLang="ko-KR" sz="1400" b="1">
                <a:latin typeface="Arial" panose="020B0604020202020204" pitchFamily="34" charset="0"/>
                <a:ea typeface="굴림" panose="020B0600000101010101" pitchFamily="50" charset="-127"/>
                <a:cs typeface="Arial" panose="020B0604020202020204" pitchFamily="34" charset="0"/>
              </a:rPr>
              <a:t>Coefficient of variation (CV) distribution before normalization</a:t>
            </a:r>
            <a:endParaRPr lang="ko-KR" altLang="en-US" sz="1400"/>
          </a:p>
        </p:txBody>
      </p:sp>
      <p:sp>
        <p:nvSpPr>
          <p:cNvPr id="58" name="직사각형 57"/>
          <p:cNvSpPr/>
          <p:nvPr/>
        </p:nvSpPr>
        <p:spPr>
          <a:xfrm>
            <a:off x="8177905" y="14732578"/>
            <a:ext cx="6222308" cy="307777"/>
          </a:xfrm>
          <a:prstGeom prst="rect">
            <a:avLst/>
          </a:prstGeom>
        </p:spPr>
        <p:txBody>
          <a:bodyPr wrap="square">
            <a:spAutoFit/>
          </a:bodyPr>
          <a:lstStyle/>
          <a:p>
            <a:r>
              <a:rPr lang="en-US" altLang="ko-KR" sz="1400" b="1">
                <a:latin typeface="Arial" panose="020B0604020202020204" pitchFamily="34" charset="0"/>
                <a:ea typeface="굴림" panose="020B0600000101010101" pitchFamily="50" charset="-127"/>
                <a:cs typeface="Arial" panose="020B0604020202020204" pitchFamily="34" charset="0"/>
              </a:rPr>
              <a:t>Coefficient of variation (CV) distribution after normalization</a:t>
            </a:r>
            <a:endParaRPr lang="ko-KR" altLang="en-US" sz="1400"/>
          </a:p>
        </p:txBody>
      </p:sp>
      <p:cxnSp>
        <p:nvCxnSpPr>
          <p:cNvPr id="66" name="직선 연결선 65"/>
          <p:cNvCxnSpPr/>
          <p:nvPr/>
        </p:nvCxnSpPr>
        <p:spPr>
          <a:xfrm>
            <a:off x="8146779" y="12102870"/>
            <a:ext cx="5202640" cy="0"/>
          </a:xfrm>
          <a:prstGeom prst="line">
            <a:avLst/>
          </a:prstGeom>
          <a:ln w="38100">
            <a:solidFill>
              <a:srgbClr val="0070C0"/>
            </a:solidFill>
            <a:prstDash val="sysDot"/>
          </a:ln>
        </p:spPr>
        <p:style>
          <a:lnRef idx="1">
            <a:schemeClr val="accent1"/>
          </a:lnRef>
          <a:fillRef idx="0">
            <a:schemeClr val="accent1"/>
          </a:fillRef>
          <a:effectRef idx="0">
            <a:schemeClr val="accent1"/>
          </a:effectRef>
          <a:fontRef idx="minor">
            <a:schemeClr val="tx1"/>
          </a:fontRef>
        </p:style>
      </p:cxnSp>
      <p:cxnSp>
        <p:nvCxnSpPr>
          <p:cNvPr id="67" name="직선 연결선 66"/>
          <p:cNvCxnSpPr/>
          <p:nvPr/>
        </p:nvCxnSpPr>
        <p:spPr>
          <a:xfrm>
            <a:off x="1187037" y="17844378"/>
            <a:ext cx="5225886" cy="0"/>
          </a:xfrm>
          <a:prstGeom prst="line">
            <a:avLst/>
          </a:prstGeom>
          <a:ln w="38100">
            <a:solidFill>
              <a:srgbClr val="FF0000"/>
            </a:solidFill>
            <a:prstDash val="sysDot"/>
          </a:ln>
        </p:spPr>
        <p:style>
          <a:lnRef idx="1">
            <a:schemeClr val="accent1"/>
          </a:lnRef>
          <a:fillRef idx="0">
            <a:schemeClr val="accent1"/>
          </a:fillRef>
          <a:effectRef idx="0">
            <a:schemeClr val="accent1"/>
          </a:effectRef>
          <a:fontRef idx="minor">
            <a:schemeClr val="tx1"/>
          </a:fontRef>
        </p:style>
      </p:cxnSp>
      <p:cxnSp>
        <p:nvCxnSpPr>
          <p:cNvPr id="72" name="직선 연결선 71"/>
          <p:cNvCxnSpPr/>
          <p:nvPr/>
        </p:nvCxnSpPr>
        <p:spPr>
          <a:xfrm>
            <a:off x="8358983" y="17900999"/>
            <a:ext cx="5168956" cy="0"/>
          </a:xfrm>
          <a:prstGeom prst="line">
            <a:avLst/>
          </a:prstGeom>
          <a:ln w="38100">
            <a:solidFill>
              <a:srgbClr val="FF0000"/>
            </a:solidFill>
            <a:prstDash val="sysDot"/>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244051" y="8145955"/>
            <a:ext cx="3652152" cy="369332"/>
          </a:xfrm>
          <a:prstGeom prst="rect">
            <a:avLst/>
          </a:prstGeom>
          <a:noFill/>
        </p:spPr>
        <p:txBody>
          <a:bodyPr wrap="square" rtlCol="0">
            <a:spAutoFit/>
          </a:bodyPr>
          <a:lstStyle/>
          <a:p>
            <a:r>
              <a:rPr lang="en-US" altLang="ko-KR" b="1">
                <a:latin typeface="Arial" panose="020B0604020202020204" pitchFamily="34" charset="0"/>
                <a:cs typeface="Arial" panose="020B0604020202020204" pitchFamily="34" charset="0"/>
              </a:rPr>
              <a:t>P</a:t>
            </a:r>
            <a:r>
              <a:rPr lang="en-US" altLang="ko-KR" b="1" smtClean="0">
                <a:latin typeface="Arial" panose="020B0604020202020204" pitchFamily="34" charset="0"/>
                <a:cs typeface="Arial" panose="020B0604020202020204" pitchFamily="34" charset="0"/>
              </a:rPr>
              <a:t>ooled sample</a:t>
            </a:r>
            <a:r>
              <a:rPr lang="en-US" altLang="ko-KR" b="1">
                <a:latin typeface="Arial" panose="020B0604020202020204" pitchFamily="34" charset="0"/>
                <a:cs typeface="Arial" panose="020B0604020202020204" pitchFamily="34" charset="0"/>
              </a:rPr>
              <a:t> </a:t>
            </a:r>
            <a:r>
              <a:rPr lang="en-US" altLang="ko-KR" b="1" smtClean="0">
                <a:latin typeface="Arial" panose="020B0604020202020204" pitchFamily="34" charset="0"/>
                <a:cs typeface="Arial" panose="020B0604020202020204" pitchFamily="34" charset="0"/>
              </a:rPr>
              <a:t>set</a:t>
            </a:r>
            <a:endParaRPr lang="ko-KR" altLang="en-US" b="1">
              <a:latin typeface="Arial" panose="020B0604020202020204" pitchFamily="34" charset="0"/>
              <a:cs typeface="Arial" panose="020B0604020202020204" pitchFamily="34" charset="0"/>
            </a:endParaRPr>
          </a:p>
        </p:txBody>
      </p:sp>
      <p:sp>
        <p:nvSpPr>
          <p:cNvPr id="76" name="TextBox 75"/>
          <p:cNvSpPr txBox="1"/>
          <p:nvPr/>
        </p:nvSpPr>
        <p:spPr>
          <a:xfrm>
            <a:off x="244051" y="14027969"/>
            <a:ext cx="4089350" cy="369332"/>
          </a:xfrm>
          <a:prstGeom prst="rect">
            <a:avLst/>
          </a:prstGeom>
          <a:noFill/>
        </p:spPr>
        <p:txBody>
          <a:bodyPr wrap="square" rtlCol="0">
            <a:spAutoFit/>
          </a:bodyPr>
          <a:lstStyle/>
          <a:p>
            <a:r>
              <a:rPr lang="en-US" altLang="ko-KR" b="1">
                <a:latin typeface="Arial" panose="020B0604020202020204" pitchFamily="34" charset="0"/>
                <a:cs typeface="Arial" panose="020B0604020202020204" pitchFamily="34" charset="0"/>
              </a:rPr>
              <a:t>I</a:t>
            </a:r>
            <a:r>
              <a:rPr lang="en-US" altLang="ko-KR" b="1" smtClean="0">
                <a:latin typeface="Arial" panose="020B0604020202020204" pitchFamily="34" charset="0"/>
                <a:cs typeface="Arial" panose="020B0604020202020204" pitchFamily="34" charset="0"/>
              </a:rPr>
              <a:t>ndividual sample</a:t>
            </a:r>
            <a:r>
              <a:rPr lang="en-US" altLang="ko-KR" b="1">
                <a:latin typeface="Arial" panose="020B0604020202020204" pitchFamily="34" charset="0"/>
                <a:cs typeface="Arial" panose="020B0604020202020204" pitchFamily="34" charset="0"/>
              </a:rPr>
              <a:t> </a:t>
            </a:r>
            <a:r>
              <a:rPr lang="en-US" altLang="ko-KR" b="1" smtClean="0">
                <a:latin typeface="Arial" panose="020B0604020202020204" pitchFamily="34" charset="0"/>
                <a:cs typeface="Arial" panose="020B0604020202020204" pitchFamily="34" charset="0"/>
              </a:rPr>
              <a:t>set</a:t>
            </a:r>
            <a:endParaRPr lang="ko-KR" altLang="en-US" b="1">
              <a:latin typeface="Arial" panose="020B0604020202020204" pitchFamily="34" charset="0"/>
              <a:cs typeface="Arial" panose="020B0604020202020204" pitchFamily="34" charset="0"/>
            </a:endParaRPr>
          </a:p>
        </p:txBody>
      </p:sp>
      <p:pic>
        <p:nvPicPr>
          <p:cNvPr id="49" name="그림 48"/>
          <p:cNvPicPr>
            <a:picLocks noChangeAspect="1"/>
          </p:cNvPicPr>
          <p:nvPr/>
        </p:nvPicPr>
        <p:blipFill rotWithShape="1">
          <a:blip r:embed="rId12"/>
          <a:srcRect l="1561" t="4256" r="1752" b="4413"/>
          <a:stretch/>
        </p:blipFill>
        <p:spPr>
          <a:xfrm>
            <a:off x="1180216" y="1601117"/>
            <a:ext cx="5284593" cy="3420721"/>
          </a:xfrm>
          <a:prstGeom prst="rect">
            <a:avLst/>
          </a:prstGeom>
        </p:spPr>
      </p:pic>
      <p:graphicFrame>
        <p:nvGraphicFramePr>
          <p:cNvPr id="50" name="차트 49"/>
          <p:cNvGraphicFramePr>
            <a:graphicFrameLocks/>
          </p:cNvGraphicFramePr>
          <p:nvPr>
            <p:extLst>
              <p:ext uri="{D42A27DB-BD31-4B8C-83A1-F6EECF244321}">
                <p14:modId xmlns:p14="http://schemas.microsoft.com/office/powerpoint/2010/main" val="2626566824"/>
              </p:ext>
            </p:extLst>
          </p:nvPr>
        </p:nvGraphicFramePr>
        <p:xfrm>
          <a:off x="1236955" y="1121799"/>
          <a:ext cx="5152064" cy="3784817"/>
        </p:xfrm>
        <a:graphic>
          <a:graphicData uri="http://schemas.openxmlformats.org/drawingml/2006/chart">
            <c:chart xmlns:c="http://schemas.openxmlformats.org/drawingml/2006/chart" xmlns:r="http://schemas.openxmlformats.org/officeDocument/2006/relationships" r:id="rId13"/>
          </a:graphicData>
        </a:graphic>
      </p:graphicFrame>
      <p:sp>
        <p:nvSpPr>
          <p:cNvPr id="51" name="TextBox 50"/>
          <p:cNvSpPr txBox="1"/>
          <p:nvPr/>
        </p:nvSpPr>
        <p:spPr>
          <a:xfrm>
            <a:off x="2529639" y="5221529"/>
            <a:ext cx="2749550" cy="338554"/>
          </a:xfrm>
          <a:prstGeom prst="rect">
            <a:avLst/>
          </a:prstGeom>
          <a:noFill/>
        </p:spPr>
        <p:txBody>
          <a:bodyPr wrap="square" rtlCol="0">
            <a:spAutoFit/>
          </a:bodyPr>
          <a:lstStyle/>
          <a:p>
            <a:pPr algn="ctr"/>
            <a:r>
              <a:rPr lang="en-US" altLang="ko-KR" sz="1600" b="1">
                <a:latin typeface="Arial" panose="020B0604020202020204" pitchFamily="34" charset="0"/>
                <a:cs typeface="Arial" panose="020B0604020202020204" pitchFamily="34" charset="0"/>
              </a:rPr>
              <a:t>Protein rank</a:t>
            </a:r>
          </a:p>
        </p:txBody>
      </p:sp>
      <p:sp>
        <p:nvSpPr>
          <p:cNvPr id="52" name="TextBox 51"/>
          <p:cNvSpPr txBox="1"/>
          <p:nvPr/>
        </p:nvSpPr>
        <p:spPr>
          <a:xfrm>
            <a:off x="984210" y="4908995"/>
            <a:ext cx="5926096" cy="307777"/>
          </a:xfrm>
          <a:prstGeom prst="rect">
            <a:avLst/>
          </a:prstGeom>
          <a:solidFill>
            <a:schemeClr val="bg1"/>
          </a:solidFill>
        </p:spPr>
        <p:txBody>
          <a:bodyPr wrap="square" rtlCol="0">
            <a:spAutoFit/>
          </a:bodyPr>
          <a:lstStyle/>
          <a:p>
            <a:r>
              <a:rPr lang="en-US" altLang="ko-KR" sz="1400" b="1">
                <a:latin typeface="Arial" panose="020B0604020202020204" pitchFamily="34" charset="0"/>
                <a:cs typeface="Arial" panose="020B0604020202020204" pitchFamily="34" charset="0"/>
              </a:rPr>
              <a:t>   0         </a:t>
            </a:r>
            <a:r>
              <a:rPr lang="en-US" altLang="ko-KR" sz="1400" b="1" smtClean="0">
                <a:latin typeface="Arial" panose="020B0604020202020204" pitchFamily="34" charset="0"/>
                <a:cs typeface="Arial" panose="020B0604020202020204" pitchFamily="34" charset="0"/>
              </a:rPr>
              <a:t>    2000             </a:t>
            </a:r>
            <a:r>
              <a:rPr lang="en-US" altLang="ko-KR" sz="1400" b="1">
                <a:latin typeface="Arial" panose="020B0604020202020204" pitchFamily="34" charset="0"/>
                <a:cs typeface="Arial" panose="020B0604020202020204" pitchFamily="34" charset="0"/>
              </a:rPr>
              <a:t>4000     </a:t>
            </a:r>
            <a:r>
              <a:rPr lang="en-US" altLang="ko-KR" sz="1400" b="1" smtClean="0">
                <a:latin typeface="Arial" panose="020B0604020202020204" pitchFamily="34" charset="0"/>
                <a:cs typeface="Arial" panose="020B0604020202020204" pitchFamily="34" charset="0"/>
              </a:rPr>
              <a:t>        </a:t>
            </a:r>
            <a:r>
              <a:rPr lang="en-US" altLang="ko-KR" sz="1400" b="1">
                <a:latin typeface="Arial" panose="020B0604020202020204" pitchFamily="34" charset="0"/>
                <a:cs typeface="Arial" panose="020B0604020202020204" pitchFamily="34" charset="0"/>
              </a:rPr>
              <a:t>6000     </a:t>
            </a:r>
            <a:r>
              <a:rPr lang="en-US" altLang="ko-KR" sz="1400" b="1" smtClean="0">
                <a:latin typeface="Arial" panose="020B0604020202020204" pitchFamily="34" charset="0"/>
                <a:cs typeface="Arial" panose="020B0604020202020204" pitchFamily="34" charset="0"/>
              </a:rPr>
              <a:t>        </a:t>
            </a:r>
            <a:r>
              <a:rPr lang="en-US" altLang="ko-KR" sz="1400" b="1">
                <a:latin typeface="Arial" panose="020B0604020202020204" pitchFamily="34" charset="0"/>
                <a:cs typeface="Arial" panose="020B0604020202020204" pitchFamily="34" charset="0"/>
              </a:rPr>
              <a:t>8000  </a:t>
            </a:r>
            <a:r>
              <a:rPr lang="en-US" altLang="ko-KR" sz="1400" b="1" smtClean="0">
                <a:latin typeface="Arial" panose="020B0604020202020204" pitchFamily="34" charset="0"/>
                <a:cs typeface="Arial" panose="020B0604020202020204" pitchFamily="34" charset="0"/>
              </a:rPr>
              <a:t>            </a:t>
            </a:r>
            <a:r>
              <a:rPr lang="en-US" altLang="ko-KR" sz="1400" b="1">
                <a:latin typeface="Arial" panose="020B0604020202020204" pitchFamily="34" charset="0"/>
                <a:cs typeface="Arial" panose="020B0604020202020204" pitchFamily="34" charset="0"/>
              </a:rPr>
              <a:t>10000</a:t>
            </a:r>
            <a:endParaRPr lang="ko-KR" altLang="en-US" sz="1400" b="1">
              <a:latin typeface="Arial" panose="020B0604020202020204" pitchFamily="34" charset="0"/>
              <a:cs typeface="Arial" panose="020B0604020202020204" pitchFamily="34" charset="0"/>
            </a:endParaRPr>
          </a:p>
        </p:txBody>
      </p:sp>
      <p:sp>
        <p:nvSpPr>
          <p:cNvPr id="55" name="TextBox 54"/>
          <p:cNvSpPr txBox="1"/>
          <p:nvPr/>
        </p:nvSpPr>
        <p:spPr>
          <a:xfrm>
            <a:off x="739672" y="1518315"/>
            <a:ext cx="431019" cy="3503523"/>
          </a:xfrm>
          <a:prstGeom prst="rect">
            <a:avLst/>
          </a:prstGeom>
          <a:solidFill>
            <a:schemeClr val="bg1"/>
          </a:solidFill>
        </p:spPr>
        <p:txBody>
          <a:bodyPr wrap="square" rtlCol="0">
            <a:spAutoFit/>
          </a:bodyPr>
          <a:lstStyle/>
          <a:p>
            <a:pPr algn="r">
              <a:lnSpc>
                <a:spcPts val="1900"/>
              </a:lnSpc>
            </a:pPr>
            <a:endParaRPr lang="en-US" altLang="ko-KR" sz="1400" b="1" smtClean="0">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6</a:t>
            </a:r>
            <a:endParaRPr lang="en-US" altLang="ko-KR" sz="1400" b="1">
              <a:latin typeface="Arial" panose="020B0604020202020204" pitchFamily="34" charset="0"/>
              <a:cs typeface="Arial" panose="020B0604020202020204" pitchFamily="34" charset="0"/>
            </a:endParaRPr>
          </a:p>
          <a:p>
            <a:pPr algn="r">
              <a:lnSpc>
                <a:spcPts val="1900"/>
              </a:lnSpc>
            </a:pPr>
            <a:endParaRPr lang="en-US" altLang="ko-KR" sz="1400" b="1">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5</a:t>
            </a:r>
            <a:endParaRPr lang="en-US" altLang="ko-KR" sz="1400" b="1">
              <a:latin typeface="Arial" panose="020B0604020202020204" pitchFamily="34" charset="0"/>
              <a:cs typeface="Arial" panose="020B0604020202020204" pitchFamily="34" charset="0"/>
            </a:endParaRPr>
          </a:p>
          <a:p>
            <a:pPr algn="r">
              <a:lnSpc>
                <a:spcPts val="1900"/>
              </a:lnSpc>
            </a:pPr>
            <a:endParaRPr lang="en-US" altLang="ko-KR" sz="1400" b="1">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4</a:t>
            </a:r>
            <a:endParaRPr lang="en-US" altLang="ko-KR" sz="1400" b="1">
              <a:latin typeface="Arial" panose="020B0604020202020204" pitchFamily="34" charset="0"/>
              <a:cs typeface="Arial" panose="020B0604020202020204" pitchFamily="34" charset="0"/>
            </a:endParaRPr>
          </a:p>
          <a:p>
            <a:pPr algn="r">
              <a:lnSpc>
                <a:spcPts val="1900"/>
              </a:lnSpc>
            </a:pPr>
            <a:endParaRPr lang="en-US" altLang="ko-KR" sz="1400" b="1">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3</a:t>
            </a:r>
            <a:endParaRPr lang="en-US" altLang="ko-KR" sz="1400" b="1">
              <a:latin typeface="Arial" panose="020B0604020202020204" pitchFamily="34" charset="0"/>
              <a:cs typeface="Arial" panose="020B0604020202020204" pitchFamily="34" charset="0"/>
            </a:endParaRPr>
          </a:p>
          <a:p>
            <a:pPr algn="r">
              <a:lnSpc>
                <a:spcPts val="1900"/>
              </a:lnSpc>
            </a:pPr>
            <a:endParaRPr lang="en-US" altLang="ko-KR" sz="1400" b="1">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2</a:t>
            </a:r>
            <a:endParaRPr lang="en-US" altLang="ko-KR" sz="1400" b="1">
              <a:latin typeface="Arial" panose="020B0604020202020204" pitchFamily="34" charset="0"/>
              <a:cs typeface="Arial" panose="020B0604020202020204" pitchFamily="34" charset="0"/>
            </a:endParaRPr>
          </a:p>
          <a:p>
            <a:pPr algn="r">
              <a:lnSpc>
                <a:spcPts val="1900"/>
              </a:lnSpc>
            </a:pPr>
            <a:endParaRPr lang="en-US" altLang="ko-KR" sz="1400" b="1">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1</a:t>
            </a:r>
            <a:endParaRPr lang="en-US" altLang="ko-KR" sz="1400" b="1">
              <a:latin typeface="Arial" panose="020B0604020202020204" pitchFamily="34" charset="0"/>
              <a:cs typeface="Arial" panose="020B0604020202020204" pitchFamily="34" charset="0"/>
            </a:endParaRPr>
          </a:p>
          <a:p>
            <a:pPr algn="r">
              <a:lnSpc>
                <a:spcPts val="1900"/>
              </a:lnSpc>
            </a:pPr>
            <a:endParaRPr lang="en-US" altLang="ko-KR" sz="1400" b="1">
              <a:latin typeface="Arial" panose="020B0604020202020204" pitchFamily="34" charset="0"/>
              <a:cs typeface="Arial" panose="020B0604020202020204" pitchFamily="34" charset="0"/>
            </a:endParaRPr>
          </a:p>
          <a:p>
            <a:pPr algn="r">
              <a:lnSpc>
                <a:spcPts val="1900"/>
              </a:lnSpc>
            </a:pPr>
            <a:r>
              <a:rPr lang="en-US" altLang="ko-KR" sz="1400" b="1" smtClean="0">
                <a:latin typeface="Arial" panose="020B0604020202020204" pitchFamily="34" charset="0"/>
                <a:cs typeface="Arial" panose="020B0604020202020204" pitchFamily="34" charset="0"/>
              </a:rPr>
              <a:t>0</a:t>
            </a:r>
            <a:endParaRPr lang="en-US" altLang="ko-KR" sz="1400" b="1">
              <a:latin typeface="Arial" panose="020B0604020202020204" pitchFamily="34" charset="0"/>
              <a:cs typeface="Arial" panose="020B0604020202020204" pitchFamily="34" charset="0"/>
            </a:endParaRPr>
          </a:p>
        </p:txBody>
      </p:sp>
      <p:sp>
        <p:nvSpPr>
          <p:cNvPr id="59" name="TextBox 58"/>
          <p:cNvSpPr txBox="1"/>
          <p:nvPr/>
        </p:nvSpPr>
        <p:spPr>
          <a:xfrm rot="16200000">
            <a:off x="-828164" y="3178060"/>
            <a:ext cx="2795116" cy="338554"/>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og</a:t>
            </a:r>
            <a:r>
              <a:rPr lang="en-US" altLang="ko-KR" sz="1600" b="1">
                <a:latin typeface="Arial" panose="020B0604020202020204" pitchFamily="34" charset="0"/>
                <a:cs typeface="Arial" panose="020B0604020202020204" pitchFamily="34" charset="0"/>
              </a:rPr>
              <a:t>10</a:t>
            </a:r>
            <a:r>
              <a:rPr lang="en-US" altLang="ko-KR" sz="1600" b="1" smtClean="0">
                <a:latin typeface="Arial" panose="020B0604020202020204" pitchFamily="34" charset="0"/>
                <a:cs typeface="Arial" panose="020B0604020202020204" pitchFamily="34" charset="0"/>
              </a:rPr>
              <a:t> </a:t>
            </a:r>
            <a:r>
              <a:rPr lang="en-US" altLang="ko-KR" sz="1600" b="1">
                <a:latin typeface="Arial" panose="020B0604020202020204" pitchFamily="34" charset="0"/>
                <a:cs typeface="Arial" panose="020B0604020202020204" pitchFamily="34" charset="0"/>
              </a:rPr>
              <a:t>(Reporter intensity)</a:t>
            </a:r>
          </a:p>
        </p:txBody>
      </p:sp>
      <p:cxnSp>
        <p:nvCxnSpPr>
          <p:cNvPr id="60" name="직선 연결선 59"/>
          <p:cNvCxnSpPr/>
          <p:nvPr/>
        </p:nvCxnSpPr>
        <p:spPr>
          <a:xfrm>
            <a:off x="1180216" y="1781331"/>
            <a:ext cx="0" cy="3125285"/>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직선 연결선 60"/>
          <p:cNvCxnSpPr/>
          <p:nvPr/>
        </p:nvCxnSpPr>
        <p:spPr>
          <a:xfrm flipH="1" flipV="1">
            <a:off x="1170691" y="4890618"/>
            <a:ext cx="5532241" cy="27239"/>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62" name="타원 61"/>
          <p:cNvSpPr/>
          <p:nvPr/>
        </p:nvSpPr>
        <p:spPr>
          <a:xfrm>
            <a:off x="1443547" y="2506924"/>
            <a:ext cx="292642" cy="245751"/>
          </a:xfrm>
          <a:prstGeom prst="ellipse">
            <a:avLst/>
          </a:prstGeom>
          <a:noFill/>
          <a:ln w="28575">
            <a:solidFill>
              <a:schemeClr val="tx1"/>
            </a:solidFill>
          </a:ln>
          <a:effectLst>
            <a:glow>
              <a:schemeClr val="bg2">
                <a:lumMod val="50000"/>
                <a:alpha val="90000"/>
              </a:schemeClr>
            </a:glo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solidFill>
                <a:srgbClr val="C00000"/>
              </a:solidFill>
            </a:endParaRPr>
          </a:p>
        </p:txBody>
      </p:sp>
      <p:cxnSp>
        <p:nvCxnSpPr>
          <p:cNvPr id="63" name="직선 연결선 62"/>
          <p:cNvCxnSpPr>
            <a:stCxn id="62" idx="7"/>
          </p:cNvCxnSpPr>
          <p:nvPr/>
        </p:nvCxnSpPr>
        <p:spPr>
          <a:xfrm flipV="1">
            <a:off x="1693333" y="1917555"/>
            <a:ext cx="818682" cy="625358"/>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4" name="TextBox 63"/>
          <p:cNvSpPr txBox="1"/>
          <p:nvPr/>
        </p:nvSpPr>
        <p:spPr>
          <a:xfrm>
            <a:off x="2391299" y="1635556"/>
            <a:ext cx="1735120" cy="369332"/>
          </a:xfrm>
          <a:prstGeom prst="rect">
            <a:avLst/>
          </a:prstGeom>
          <a:noFill/>
        </p:spPr>
        <p:txBody>
          <a:bodyPr wrap="square" rtlCol="0">
            <a:spAutoFit/>
          </a:bodyPr>
          <a:lstStyle/>
          <a:p>
            <a:r>
              <a:rPr lang="en-US" altLang="ko-KR" b="1" smtClean="0"/>
              <a:t>Ovalbumin</a:t>
            </a:r>
            <a:endParaRPr lang="ko-KR" altLang="en-US" b="1"/>
          </a:p>
        </p:txBody>
      </p:sp>
      <p:sp>
        <p:nvSpPr>
          <p:cNvPr id="65" name="직사각형 64"/>
          <p:cNvSpPr/>
          <p:nvPr/>
        </p:nvSpPr>
        <p:spPr>
          <a:xfrm>
            <a:off x="1170691" y="6235554"/>
            <a:ext cx="609600" cy="106466"/>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8" name="직사각형 67"/>
          <p:cNvSpPr/>
          <p:nvPr/>
        </p:nvSpPr>
        <p:spPr>
          <a:xfrm>
            <a:off x="1170691" y="5868260"/>
            <a:ext cx="609600" cy="106466"/>
          </a:xfrm>
          <a:prstGeom prst="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1" name="TextBox 70"/>
          <p:cNvSpPr txBox="1"/>
          <p:nvPr/>
        </p:nvSpPr>
        <p:spPr>
          <a:xfrm>
            <a:off x="1733721" y="5745147"/>
            <a:ext cx="3214042" cy="307777"/>
          </a:xfrm>
          <a:prstGeom prst="rect">
            <a:avLst/>
          </a:prstGeom>
          <a:noFill/>
        </p:spPr>
        <p:txBody>
          <a:bodyPr wrap="square" rtlCol="0">
            <a:spAutoFit/>
          </a:bodyPr>
          <a:lstStyle/>
          <a:p>
            <a:r>
              <a:rPr lang="en-US" altLang="ko-KR" sz="1400" b="1">
                <a:latin typeface="Arial" panose="020B0604020202020204" pitchFamily="34" charset="0"/>
                <a:cs typeface="Arial" panose="020B0604020202020204" pitchFamily="34" charset="0"/>
              </a:rPr>
              <a:t>P</a:t>
            </a:r>
            <a:r>
              <a:rPr lang="en-US" altLang="ko-KR" sz="1400" b="1" smtClean="0">
                <a:latin typeface="Arial" panose="020B0604020202020204" pitchFamily="34" charset="0"/>
                <a:cs typeface="Arial" panose="020B0604020202020204" pitchFamily="34" charset="0"/>
              </a:rPr>
              <a:t>ooled sample set </a:t>
            </a:r>
            <a:endParaRPr lang="ko-KR" altLang="en-US" sz="1400" b="1">
              <a:latin typeface="Arial" panose="020B0604020202020204" pitchFamily="34" charset="0"/>
              <a:cs typeface="Arial" panose="020B0604020202020204" pitchFamily="34" charset="0"/>
            </a:endParaRPr>
          </a:p>
        </p:txBody>
      </p:sp>
      <p:sp>
        <p:nvSpPr>
          <p:cNvPr id="100" name="TextBox 99"/>
          <p:cNvSpPr txBox="1"/>
          <p:nvPr/>
        </p:nvSpPr>
        <p:spPr>
          <a:xfrm>
            <a:off x="1754797" y="6121022"/>
            <a:ext cx="2578604" cy="307777"/>
          </a:xfrm>
          <a:prstGeom prst="rect">
            <a:avLst/>
          </a:prstGeom>
          <a:noFill/>
        </p:spPr>
        <p:txBody>
          <a:bodyPr wrap="square" rtlCol="0">
            <a:spAutoFit/>
          </a:bodyPr>
          <a:lstStyle/>
          <a:p>
            <a:r>
              <a:rPr lang="en-US" altLang="ko-KR" sz="1400" b="1">
                <a:latin typeface="Arial" panose="020B0604020202020204" pitchFamily="34" charset="0"/>
                <a:cs typeface="Arial" panose="020B0604020202020204" pitchFamily="34" charset="0"/>
              </a:rPr>
              <a:t>I</a:t>
            </a:r>
            <a:r>
              <a:rPr lang="en-US" altLang="ko-KR" sz="1400" b="1" smtClean="0">
                <a:latin typeface="Arial" panose="020B0604020202020204" pitchFamily="34" charset="0"/>
                <a:cs typeface="Arial" panose="020B0604020202020204" pitchFamily="34" charset="0"/>
              </a:rPr>
              <a:t>ndividual sample set </a:t>
            </a:r>
            <a:endParaRPr lang="ko-KR" altLang="en-US" sz="1400" b="1">
              <a:latin typeface="Arial" panose="020B0604020202020204" pitchFamily="34" charset="0"/>
              <a:cs typeface="Arial" panose="020B0604020202020204" pitchFamily="34" charset="0"/>
            </a:endParaRPr>
          </a:p>
        </p:txBody>
      </p:sp>
      <p:sp>
        <p:nvSpPr>
          <p:cNvPr id="47" name="TextBox 46"/>
          <p:cNvSpPr txBox="1"/>
          <p:nvPr/>
        </p:nvSpPr>
        <p:spPr>
          <a:xfrm>
            <a:off x="6738167" y="19991959"/>
            <a:ext cx="895350" cy="461665"/>
          </a:xfrm>
          <a:prstGeom prst="rect">
            <a:avLst/>
          </a:prstGeom>
          <a:noFill/>
        </p:spPr>
        <p:txBody>
          <a:bodyPr wrap="square" rtlCol="0">
            <a:spAutoFit/>
          </a:bodyPr>
          <a:lstStyle/>
          <a:p>
            <a:r>
              <a:rPr lang="en-US" altLang="ko-KR" sz="2400" b="1" smtClean="0"/>
              <a:t>S-5</a:t>
            </a:r>
            <a:endParaRPr lang="ko-KR" altLang="en-US" sz="2400" b="1"/>
          </a:p>
        </p:txBody>
      </p:sp>
    </p:spTree>
    <p:extLst>
      <p:ext uri="{BB962C8B-B14F-4D97-AF65-F5344CB8AC3E}">
        <p14:creationId xmlns:p14="http://schemas.microsoft.com/office/powerpoint/2010/main" val="305347978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직사각형 12"/>
          <p:cNvSpPr/>
          <p:nvPr/>
        </p:nvSpPr>
        <p:spPr>
          <a:xfrm>
            <a:off x="771371" y="478915"/>
            <a:ext cx="6222308" cy="369332"/>
          </a:xfrm>
          <a:prstGeom prst="rect">
            <a:avLst/>
          </a:prstGeom>
        </p:spPr>
        <p:txBody>
          <a:bodyPr wrap="square">
            <a:spAutoFit/>
          </a:bodyPr>
          <a:lstStyle/>
          <a:p>
            <a:r>
              <a:rPr lang="en-US" altLang="ko-KR" sz="1800" b="1" dirty="0" smtClean="0">
                <a:latin typeface="Arial" panose="020B0604020202020204" pitchFamily="34" charset="0"/>
                <a:ea typeface="굴림" panose="020B0600000101010101" pitchFamily="50" charset="-127"/>
                <a:cs typeface="Arial" panose="020B0604020202020204" pitchFamily="34" charset="0"/>
              </a:rPr>
              <a:t>Median CV values in each sample</a:t>
            </a:r>
            <a:endParaRPr lang="ko-KR" altLang="en-US" sz="1800" dirty="0">
              <a:latin typeface="Arial" panose="020B0604020202020204" pitchFamily="34" charset="0"/>
              <a:cs typeface="Arial" panose="020B0604020202020204" pitchFamily="34" charset="0"/>
            </a:endParaRPr>
          </a:p>
        </p:txBody>
      </p:sp>
      <p:sp>
        <p:nvSpPr>
          <p:cNvPr id="14" name="TextBox 13"/>
          <p:cNvSpPr txBox="1"/>
          <p:nvPr/>
        </p:nvSpPr>
        <p:spPr>
          <a:xfrm>
            <a:off x="368464" y="382185"/>
            <a:ext cx="429223" cy="523220"/>
          </a:xfrm>
          <a:prstGeom prst="rect">
            <a:avLst/>
          </a:prstGeom>
          <a:noFill/>
        </p:spPr>
        <p:txBody>
          <a:bodyPr wrap="square" rtlCol="0">
            <a:spAutoFit/>
          </a:bodyPr>
          <a:lstStyle/>
          <a:p>
            <a:pPr algn="ctr"/>
            <a:r>
              <a:rPr lang="en-US" altLang="ko-KR" sz="2800" b="1">
                <a:latin typeface="Arial" panose="020B0604020202020204" pitchFamily="34" charset="0"/>
                <a:cs typeface="Arial" panose="020B0604020202020204" pitchFamily="34" charset="0"/>
              </a:rPr>
              <a:t>c</a:t>
            </a:r>
            <a:endParaRPr lang="ko-KR" altLang="en-US" sz="2800" b="1">
              <a:latin typeface="Arial" panose="020B0604020202020204" pitchFamily="34" charset="0"/>
              <a:cs typeface="Arial" panose="020B0604020202020204" pitchFamily="34" charset="0"/>
            </a:endParaRPr>
          </a:p>
        </p:txBody>
      </p:sp>
      <p:graphicFrame>
        <p:nvGraphicFramePr>
          <p:cNvPr id="16" name="표 15"/>
          <p:cNvGraphicFramePr>
            <a:graphicFrameLocks noGrp="1"/>
          </p:cNvGraphicFramePr>
          <p:nvPr>
            <p:extLst>
              <p:ext uri="{D42A27DB-BD31-4B8C-83A1-F6EECF244321}">
                <p14:modId xmlns:p14="http://schemas.microsoft.com/office/powerpoint/2010/main" val="1635073759"/>
              </p:ext>
            </p:extLst>
          </p:nvPr>
        </p:nvGraphicFramePr>
        <p:xfrm>
          <a:off x="434243" y="1818797"/>
          <a:ext cx="13639768" cy="1920240"/>
        </p:xfrm>
        <a:graphic>
          <a:graphicData uri="http://schemas.openxmlformats.org/drawingml/2006/table">
            <a:tbl>
              <a:tblPr firstRow="1" bandRow="1">
                <a:tableStyleId>{5940675A-B579-460E-94D1-54222C63F5DA}</a:tableStyleId>
              </a:tblPr>
              <a:tblGrid>
                <a:gridCol w="1704971">
                  <a:extLst>
                    <a:ext uri="{9D8B030D-6E8A-4147-A177-3AD203B41FA5}">
                      <a16:colId xmlns:a16="http://schemas.microsoft.com/office/drawing/2014/main" val="887200849"/>
                    </a:ext>
                  </a:extLst>
                </a:gridCol>
                <a:gridCol w="1704971">
                  <a:extLst>
                    <a:ext uri="{9D8B030D-6E8A-4147-A177-3AD203B41FA5}">
                      <a16:colId xmlns:a16="http://schemas.microsoft.com/office/drawing/2014/main" val="2987300468"/>
                    </a:ext>
                  </a:extLst>
                </a:gridCol>
                <a:gridCol w="1704971">
                  <a:extLst>
                    <a:ext uri="{9D8B030D-6E8A-4147-A177-3AD203B41FA5}">
                      <a16:colId xmlns:a16="http://schemas.microsoft.com/office/drawing/2014/main" val="3858516196"/>
                    </a:ext>
                  </a:extLst>
                </a:gridCol>
                <a:gridCol w="1704971">
                  <a:extLst>
                    <a:ext uri="{9D8B030D-6E8A-4147-A177-3AD203B41FA5}">
                      <a16:colId xmlns:a16="http://schemas.microsoft.com/office/drawing/2014/main" val="2006432389"/>
                    </a:ext>
                  </a:extLst>
                </a:gridCol>
                <a:gridCol w="1704971">
                  <a:extLst>
                    <a:ext uri="{9D8B030D-6E8A-4147-A177-3AD203B41FA5}">
                      <a16:colId xmlns:a16="http://schemas.microsoft.com/office/drawing/2014/main" val="318149212"/>
                    </a:ext>
                  </a:extLst>
                </a:gridCol>
                <a:gridCol w="1704971">
                  <a:extLst>
                    <a:ext uri="{9D8B030D-6E8A-4147-A177-3AD203B41FA5}">
                      <a16:colId xmlns:a16="http://schemas.microsoft.com/office/drawing/2014/main" val="2738443152"/>
                    </a:ext>
                  </a:extLst>
                </a:gridCol>
                <a:gridCol w="1704971">
                  <a:extLst>
                    <a:ext uri="{9D8B030D-6E8A-4147-A177-3AD203B41FA5}">
                      <a16:colId xmlns:a16="http://schemas.microsoft.com/office/drawing/2014/main" val="2577225833"/>
                    </a:ext>
                  </a:extLst>
                </a:gridCol>
                <a:gridCol w="1704971">
                  <a:extLst>
                    <a:ext uri="{9D8B030D-6E8A-4147-A177-3AD203B41FA5}">
                      <a16:colId xmlns:a16="http://schemas.microsoft.com/office/drawing/2014/main" val="2013354149"/>
                    </a:ext>
                  </a:extLst>
                </a:gridCol>
              </a:tblGrid>
              <a:tr h="640080">
                <a:tc>
                  <a:txBody>
                    <a:bodyPr/>
                    <a:lstStyle/>
                    <a:p>
                      <a:pPr algn="ctr" latinLnBrk="1"/>
                      <a:r>
                        <a:rPr lang="en-US" altLang="ko-KR" sz="1800" b="1" smtClean="0">
                          <a:latin typeface="Arial" panose="020B0604020202020204" pitchFamily="34" charset="0"/>
                          <a:cs typeface="Arial" panose="020B0604020202020204" pitchFamily="34" charset="0"/>
                        </a:rPr>
                        <a:t>Case</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dirty="0" smtClean="0">
                          <a:latin typeface="Arial" panose="020B0604020202020204" pitchFamily="34" charset="0"/>
                          <a:cs typeface="Arial" panose="020B0604020202020204" pitchFamily="34" charset="0"/>
                        </a:rPr>
                        <a:t>HER2</a:t>
                      </a:r>
                    </a:p>
                    <a:p>
                      <a:pPr algn="ctr" latinLnBrk="1"/>
                      <a:r>
                        <a:rPr lang="en-US" altLang="ko-KR" sz="1800" b="1" dirty="0" smtClean="0">
                          <a:latin typeface="Arial" panose="020B0604020202020204" pitchFamily="34" charset="0"/>
                          <a:cs typeface="Arial" panose="020B0604020202020204" pitchFamily="34" charset="0"/>
                        </a:rPr>
                        <a:t>Non</a:t>
                      </a:r>
                      <a:r>
                        <a:rPr lang="en-US" altLang="ko-KR" sz="1800" b="1" baseline="0" dirty="0" smtClean="0">
                          <a:latin typeface="Arial" panose="020B0604020202020204" pitchFamily="34" charset="0"/>
                          <a:cs typeface="Arial" panose="020B0604020202020204" pitchFamily="34" charset="0"/>
                        </a:rPr>
                        <a:t> dis-meta</a:t>
                      </a:r>
                      <a:endParaRPr lang="ko-KR" altLang="en-US" sz="1800" b="1" dirty="0">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TNBC</a:t>
                      </a:r>
                    </a:p>
                    <a:p>
                      <a:pPr algn="ctr" latinLnBrk="1"/>
                      <a:r>
                        <a:rPr lang="en-US" altLang="ko-KR" sz="1800" b="1" smtClean="0">
                          <a:latin typeface="Arial" panose="020B0604020202020204" pitchFamily="34" charset="0"/>
                          <a:cs typeface="Arial" panose="020B0604020202020204" pitchFamily="34" charset="0"/>
                        </a:rPr>
                        <a:t>Non dis-meta</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Luminal</a:t>
                      </a:r>
                    </a:p>
                    <a:p>
                      <a:pPr algn="ctr" latinLnBrk="1"/>
                      <a:r>
                        <a:rPr lang="en-US" altLang="ko-KR" sz="1800" b="1" smtClean="0">
                          <a:latin typeface="Arial" panose="020B0604020202020204" pitchFamily="34" charset="0"/>
                          <a:cs typeface="Arial" panose="020B0604020202020204" pitchFamily="34" charset="0"/>
                        </a:rPr>
                        <a:t>Non</a:t>
                      </a:r>
                      <a:r>
                        <a:rPr lang="en-US" altLang="ko-KR" sz="1800" b="1" baseline="0" smtClean="0">
                          <a:latin typeface="Arial" panose="020B0604020202020204" pitchFamily="34" charset="0"/>
                          <a:cs typeface="Arial" panose="020B0604020202020204" pitchFamily="34" charset="0"/>
                        </a:rPr>
                        <a:t> dis-meta</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HER2</a:t>
                      </a:r>
                    </a:p>
                    <a:p>
                      <a:pPr algn="ctr" latinLnBrk="1"/>
                      <a:r>
                        <a:rPr lang="en-US" altLang="ko-KR" sz="1800" b="1" baseline="0" smtClean="0">
                          <a:latin typeface="Arial" panose="020B0604020202020204" pitchFamily="34" charset="0"/>
                          <a:cs typeface="Arial" panose="020B0604020202020204" pitchFamily="34" charset="0"/>
                        </a:rPr>
                        <a:t>Dis-meta</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TNBC</a:t>
                      </a:r>
                    </a:p>
                    <a:p>
                      <a:pPr algn="ctr" latinLnBrk="1"/>
                      <a:r>
                        <a:rPr lang="en-US" altLang="ko-KR" sz="1800" b="1" smtClean="0">
                          <a:latin typeface="Arial" panose="020B0604020202020204" pitchFamily="34" charset="0"/>
                          <a:cs typeface="Arial" panose="020B0604020202020204" pitchFamily="34" charset="0"/>
                        </a:rPr>
                        <a:t>Dis-meta</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Luminal</a:t>
                      </a:r>
                    </a:p>
                    <a:p>
                      <a:pPr algn="ctr" latinLnBrk="1"/>
                      <a:r>
                        <a:rPr lang="en-US" altLang="ko-KR" sz="1800" b="1" baseline="0" smtClean="0">
                          <a:latin typeface="Arial" panose="020B0604020202020204" pitchFamily="34" charset="0"/>
                          <a:cs typeface="Arial" panose="020B0604020202020204" pitchFamily="34" charset="0"/>
                        </a:rPr>
                        <a:t>Dis-meta</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Median</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extLst>
                  <a:ext uri="{0D108BD9-81ED-4DB2-BD59-A6C34878D82A}">
                    <a16:rowId xmlns:a16="http://schemas.microsoft.com/office/drawing/2014/main" val="4256822782"/>
                  </a:ext>
                </a:extLst>
              </a:tr>
              <a:tr h="640080">
                <a:tc>
                  <a:txBody>
                    <a:bodyPr/>
                    <a:lstStyle/>
                    <a:p>
                      <a:pPr latinLnBrk="1"/>
                      <a:r>
                        <a:rPr lang="en-US" altLang="ko-KR" sz="1800" b="1" smtClean="0">
                          <a:latin typeface="Arial" panose="020B0604020202020204" pitchFamily="34" charset="0"/>
                          <a:cs typeface="Arial" panose="020B0604020202020204" pitchFamily="34" charset="0"/>
                        </a:rPr>
                        <a:t>No</a:t>
                      </a:r>
                    </a:p>
                    <a:p>
                      <a:pPr latinLnBrk="1"/>
                      <a:r>
                        <a:rPr lang="en-US" altLang="ko-KR" sz="1800" b="1" smtClean="0">
                          <a:latin typeface="Arial" panose="020B0604020202020204" pitchFamily="34" charset="0"/>
                          <a:cs typeface="Arial" panose="020B0604020202020204" pitchFamily="34" charset="0"/>
                        </a:rPr>
                        <a:t>normalization</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25.63</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15</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03</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40</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53</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31</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36</a:t>
                      </a:r>
                      <a:endParaRPr lang="ko-KR" altLang="en-US" sz="1800" b="1">
                        <a:latin typeface="Arial" panose="020B0604020202020204" pitchFamily="34" charset="0"/>
                        <a:cs typeface="Arial" panose="020B0604020202020204" pitchFamily="34" charset="0"/>
                      </a:endParaRPr>
                    </a:p>
                  </a:txBody>
                  <a:tcPr anchor="ctr">
                    <a:solidFill>
                      <a:schemeClr val="bg2"/>
                    </a:solidFill>
                  </a:tcPr>
                </a:tc>
                <a:extLst>
                  <a:ext uri="{0D108BD9-81ED-4DB2-BD59-A6C34878D82A}">
                    <a16:rowId xmlns:a16="http://schemas.microsoft.com/office/drawing/2014/main" val="549297302"/>
                  </a:ext>
                </a:extLst>
              </a:tr>
              <a:tr h="640080">
                <a:tc>
                  <a:txBody>
                    <a:bodyPr/>
                    <a:lstStyle/>
                    <a:p>
                      <a:pPr latinLnBrk="1"/>
                      <a:r>
                        <a:rPr lang="en-US" altLang="ko-KR" sz="1800" b="1" smtClean="0">
                          <a:latin typeface="Arial" panose="020B0604020202020204" pitchFamily="34" charset="0"/>
                          <a:cs typeface="Arial" panose="020B0604020202020204" pitchFamily="34" charset="0"/>
                        </a:rPr>
                        <a:t>Ovalbumin</a:t>
                      </a:r>
                      <a:r>
                        <a:rPr lang="en-US" altLang="ko-KR" sz="1800" b="1" baseline="0" smtClean="0">
                          <a:latin typeface="Arial" panose="020B0604020202020204" pitchFamily="34" charset="0"/>
                          <a:cs typeface="Arial" panose="020B0604020202020204" pitchFamily="34" charset="0"/>
                        </a:rPr>
                        <a:t> normalization</a:t>
                      </a:r>
                      <a:endParaRPr lang="ko-KR" altLang="en-US" sz="1800" b="1">
                        <a:latin typeface="Arial" panose="020B0604020202020204" pitchFamily="34" charset="0"/>
                        <a:cs typeface="Arial" panose="020B0604020202020204" pitchFamily="34" charset="0"/>
                      </a:endParaRPr>
                    </a:p>
                  </a:txBody>
                  <a:tcPr anchor="ctr">
                    <a:solidFill>
                      <a:schemeClr val="accent1"/>
                    </a:solidFill>
                  </a:tcPr>
                </a:tc>
                <a:tc>
                  <a:txBody>
                    <a:bodyPr/>
                    <a:lstStyle/>
                    <a:p>
                      <a:pPr algn="ctr" latinLnBrk="1"/>
                      <a:r>
                        <a:rPr lang="en-US" altLang="ko-KR" sz="1800" b="1" smtClean="0">
                          <a:latin typeface="Arial" panose="020B0604020202020204" pitchFamily="34" charset="0"/>
                          <a:cs typeface="Arial" panose="020B0604020202020204" pitchFamily="34" charset="0"/>
                        </a:rPr>
                        <a:t>25</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4.76</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06</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4.99</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4.87</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5.15</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dirty="0" smtClean="0">
                          <a:solidFill>
                            <a:srgbClr val="FF0000"/>
                          </a:solidFill>
                          <a:latin typeface="Arial" panose="020B0604020202020204" pitchFamily="34" charset="0"/>
                          <a:cs typeface="Arial" panose="020B0604020202020204" pitchFamily="34" charset="0"/>
                        </a:rPr>
                        <a:t>25.00</a:t>
                      </a:r>
                      <a:endParaRPr lang="ko-KR" altLang="en-US" sz="1800" b="1" dirty="0">
                        <a:solidFill>
                          <a:srgbClr val="FF0000"/>
                        </a:solidFill>
                        <a:latin typeface="Arial" panose="020B0604020202020204" pitchFamily="34" charset="0"/>
                        <a:cs typeface="Arial" panose="020B0604020202020204" pitchFamily="34" charset="0"/>
                      </a:endParaRPr>
                    </a:p>
                  </a:txBody>
                  <a:tcPr anchor="ctr">
                    <a:solidFill>
                      <a:schemeClr val="bg2"/>
                    </a:solidFill>
                  </a:tcPr>
                </a:tc>
                <a:extLst>
                  <a:ext uri="{0D108BD9-81ED-4DB2-BD59-A6C34878D82A}">
                    <a16:rowId xmlns:a16="http://schemas.microsoft.com/office/drawing/2014/main" val="2675557387"/>
                  </a:ext>
                </a:extLst>
              </a:tr>
            </a:tbl>
          </a:graphicData>
        </a:graphic>
      </p:graphicFrame>
      <p:graphicFrame>
        <p:nvGraphicFramePr>
          <p:cNvPr id="20" name="표 19"/>
          <p:cNvGraphicFramePr>
            <a:graphicFrameLocks noGrp="1"/>
          </p:cNvGraphicFramePr>
          <p:nvPr>
            <p:extLst>
              <p:ext uri="{D42A27DB-BD31-4B8C-83A1-F6EECF244321}">
                <p14:modId xmlns:p14="http://schemas.microsoft.com/office/powerpoint/2010/main" val="2003984628"/>
              </p:ext>
            </p:extLst>
          </p:nvPr>
        </p:nvGraphicFramePr>
        <p:xfrm>
          <a:off x="450541" y="4739582"/>
          <a:ext cx="13623472" cy="1920240"/>
        </p:xfrm>
        <a:graphic>
          <a:graphicData uri="http://schemas.openxmlformats.org/drawingml/2006/table">
            <a:tbl>
              <a:tblPr firstRow="1" bandRow="1">
                <a:tableStyleId>{5940675A-B579-460E-94D1-54222C63F5DA}</a:tableStyleId>
              </a:tblPr>
              <a:tblGrid>
                <a:gridCol w="1702934">
                  <a:extLst>
                    <a:ext uri="{9D8B030D-6E8A-4147-A177-3AD203B41FA5}">
                      <a16:colId xmlns:a16="http://schemas.microsoft.com/office/drawing/2014/main" val="887200849"/>
                    </a:ext>
                  </a:extLst>
                </a:gridCol>
                <a:gridCol w="1702934">
                  <a:extLst>
                    <a:ext uri="{9D8B030D-6E8A-4147-A177-3AD203B41FA5}">
                      <a16:colId xmlns:a16="http://schemas.microsoft.com/office/drawing/2014/main" val="2987300468"/>
                    </a:ext>
                  </a:extLst>
                </a:gridCol>
                <a:gridCol w="1702934">
                  <a:extLst>
                    <a:ext uri="{9D8B030D-6E8A-4147-A177-3AD203B41FA5}">
                      <a16:colId xmlns:a16="http://schemas.microsoft.com/office/drawing/2014/main" val="3858516196"/>
                    </a:ext>
                  </a:extLst>
                </a:gridCol>
                <a:gridCol w="1702934">
                  <a:extLst>
                    <a:ext uri="{9D8B030D-6E8A-4147-A177-3AD203B41FA5}">
                      <a16:colId xmlns:a16="http://schemas.microsoft.com/office/drawing/2014/main" val="2006432389"/>
                    </a:ext>
                  </a:extLst>
                </a:gridCol>
                <a:gridCol w="1702934">
                  <a:extLst>
                    <a:ext uri="{9D8B030D-6E8A-4147-A177-3AD203B41FA5}">
                      <a16:colId xmlns:a16="http://schemas.microsoft.com/office/drawing/2014/main" val="318149212"/>
                    </a:ext>
                  </a:extLst>
                </a:gridCol>
                <a:gridCol w="1702934">
                  <a:extLst>
                    <a:ext uri="{9D8B030D-6E8A-4147-A177-3AD203B41FA5}">
                      <a16:colId xmlns:a16="http://schemas.microsoft.com/office/drawing/2014/main" val="2738443152"/>
                    </a:ext>
                  </a:extLst>
                </a:gridCol>
                <a:gridCol w="1702934">
                  <a:extLst>
                    <a:ext uri="{9D8B030D-6E8A-4147-A177-3AD203B41FA5}">
                      <a16:colId xmlns:a16="http://schemas.microsoft.com/office/drawing/2014/main" val="2577225833"/>
                    </a:ext>
                  </a:extLst>
                </a:gridCol>
                <a:gridCol w="1702934">
                  <a:extLst>
                    <a:ext uri="{9D8B030D-6E8A-4147-A177-3AD203B41FA5}">
                      <a16:colId xmlns:a16="http://schemas.microsoft.com/office/drawing/2014/main" val="2723917060"/>
                    </a:ext>
                  </a:extLst>
                </a:gridCol>
              </a:tblGrid>
              <a:tr h="441505">
                <a:tc>
                  <a:txBody>
                    <a:bodyPr/>
                    <a:lstStyle/>
                    <a:p>
                      <a:pPr algn="ctr" latinLnBrk="1"/>
                      <a:r>
                        <a:rPr lang="en-US" altLang="ko-KR" sz="1800" b="1" smtClean="0">
                          <a:latin typeface="Arial" panose="020B0604020202020204" pitchFamily="34" charset="0"/>
                          <a:cs typeface="Arial" panose="020B0604020202020204" pitchFamily="34" charset="0"/>
                        </a:rPr>
                        <a:t>Case</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HER2</a:t>
                      </a:r>
                    </a:p>
                    <a:p>
                      <a:pPr algn="ctr" latinLnBrk="1"/>
                      <a:r>
                        <a:rPr lang="en-US" altLang="ko-KR" sz="1800" b="1" smtClean="0">
                          <a:latin typeface="Arial" panose="020B0604020202020204" pitchFamily="34" charset="0"/>
                          <a:cs typeface="Arial" panose="020B0604020202020204" pitchFamily="34" charset="0"/>
                        </a:rPr>
                        <a:t>Non</a:t>
                      </a:r>
                      <a:r>
                        <a:rPr lang="en-US" altLang="ko-KR" sz="1800" b="1" baseline="0" smtClean="0">
                          <a:latin typeface="Arial" panose="020B0604020202020204" pitchFamily="34" charset="0"/>
                          <a:cs typeface="Arial" panose="020B0604020202020204" pitchFamily="34" charset="0"/>
                        </a:rPr>
                        <a:t> dis-meta</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dirty="0" smtClean="0">
                          <a:latin typeface="Arial" panose="020B0604020202020204" pitchFamily="34" charset="0"/>
                          <a:cs typeface="Arial" panose="020B0604020202020204" pitchFamily="34" charset="0"/>
                        </a:rPr>
                        <a:t>TNBC</a:t>
                      </a:r>
                    </a:p>
                    <a:p>
                      <a:pPr algn="ctr" latinLnBrk="1"/>
                      <a:r>
                        <a:rPr lang="en-US" altLang="ko-KR" sz="1800" b="1" dirty="0" smtClean="0">
                          <a:latin typeface="Arial" panose="020B0604020202020204" pitchFamily="34" charset="0"/>
                          <a:cs typeface="Arial" panose="020B0604020202020204" pitchFamily="34" charset="0"/>
                        </a:rPr>
                        <a:t>Non dis-meta</a:t>
                      </a:r>
                      <a:endParaRPr lang="ko-KR" altLang="en-US" sz="1800" b="1" dirty="0">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Luminal</a:t>
                      </a:r>
                    </a:p>
                    <a:p>
                      <a:pPr algn="ctr" latinLnBrk="1"/>
                      <a:r>
                        <a:rPr lang="en-US" altLang="ko-KR" sz="1800" b="1" smtClean="0">
                          <a:latin typeface="Arial" panose="020B0604020202020204" pitchFamily="34" charset="0"/>
                          <a:cs typeface="Arial" panose="020B0604020202020204" pitchFamily="34" charset="0"/>
                        </a:rPr>
                        <a:t>Non</a:t>
                      </a:r>
                      <a:r>
                        <a:rPr lang="en-US" altLang="ko-KR" sz="1800" b="1" baseline="0" smtClean="0">
                          <a:latin typeface="Arial" panose="020B0604020202020204" pitchFamily="34" charset="0"/>
                          <a:cs typeface="Arial" panose="020B0604020202020204" pitchFamily="34" charset="0"/>
                        </a:rPr>
                        <a:t> dis-meta</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HER2</a:t>
                      </a:r>
                    </a:p>
                    <a:p>
                      <a:pPr algn="ctr" latinLnBrk="1"/>
                      <a:r>
                        <a:rPr lang="en-US" altLang="ko-KR" sz="1800" b="1" baseline="0" smtClean="0">
                          <a:latin typeface="Arial" panose="020B0604020202020204" pitchFamily="34" charset="0"/>
                          <a:cs typeface="Arial" panose="020B0604020202020204" pitchFamily="34" charset="0"/>
                        </a:rPr>
                        <a:t>Dis-meta</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TNBC</a:t>
                      </a:r>
                    </a:p>
                    <a:p>
                      <a:pPr algn="ctr" latinLnBrk="1"/>
                      <a:r>
                        <a:rPr lang="en-US" altLang="ko-KR" sz="1800" b="1" smtClean="0">
                          <a:latin typeface="Arial" panose="020B0604020202020204" pitchFamily="34" charset="0"/>
                          <a:cs typeface="Arial" panose="020B0604020202020204" pitchFamily="34" charset="0"/>
                        </a:rPr>
                        <a:t>Dis-meta</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Luminal</a:t>
                      </a:r>
                    </a:p>
                    <a:p>
                      <a:pPr algn="ctr" latinLnBrk="1"/>
                      <a:r>
                        <a:rPr lang="en-US" altLang="ko-KR" sz="1800" b="1" baseline="0" smtClean="0">
                          <a:latin typeface="Arial" panose="020B0604020202020204" pitchFamily="34" charset="0"/>
                          <a:cs typeface="Arial" panose="020B0604020202020204" pitchFamily="34" charset="0"/>
                        </a:rPr>
                        <a:t>Dis-meta</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Median</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extLst>
                  <a:ext uri="{0D108BD9-81ED-4DB2-BD59-A6C34878D82A}">
                    <a16:rowId xmlns:a16="http://schemas.microsoft.com/office/drawing/2014/main" val="4256822782"/>
                  </a:ext>
                </a:extLst>
              </a:tr>
              <a:tr h="461603">
                <a:tc>
                  <a:txBody>
                    <a:bodyPr/>
                    <a:lstStyle/>
                    <a:p>
                      <a:pPr latinLnBrk="1"/>
                      <a:r>
                        <a:rPr lang="en-US" altLang="ko-KR" sz="1800" b="1" smtClean="0">
                          <a:latin typeface="Arial" panose="020B0604020202020204" pitchFamily="34" charset="0"/>
                          <a:cs typeface="Arial" panose="020B0604020202020204" pitchFamily="34" charset="0"/>
                        </a:rPr>
                        <a:t>No</a:t>
                      </a:r>
                    </a:p>
                    <a:p>
                      <a:pPr latinLnBrk="1"/>
                      <a:r>
                        <a:rPr lang="en-US" altLang="ko-KR" sz="1800" b="1" smtClean="0">
                          <a:latin typeface="Arial" panose="020B0604020202020204" pitchFamily="34" charset="0"/>
                          <a:cs typeface="Arial" panose="020B0604020202020204" pitchFamily="34" charset="0"/>
                        </a:rPr>
                        <a:t>normalization</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32.55</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dirty="0" smtClean="0">
                          <a:latin typeface="Arial" panose="020B0604020202020204" pitchFamily="34" charset="0"/>
                          <a:cs typeface="Arial" panose="020B0604020202020204" pitchFamily="34" charset="0"/>
                        </a:rPr>
                        <a:t>28.89</a:t>
                      </a:r>
                      <a:endParaRPr lang="ko-KR" altLang="en-US" sz="1800" b="1" dirty="0">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9.41</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33.5</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9.58</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31.05</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30.32</a:t>
                      </a:r>
                      <a:endParaRPr lang="ko-KR" altLang="en-US" sz="1800" b="1">
                        <a:latin typeface="Arial" panose="020B0604020202020204" pitchFamily="34" charset="0"/>
                        <a:cs typeface="Arial" panose="020B0604020202020204" pitchFamily="34" charset="0"/>
                      </a:endParaRPr>
                    </a:p>
                  </a:txBody>
                  <a:tcPr anchor="ctr">
                    <a:solidFill>
                      <a:schemeClr val="bg2"/>
                    </a:solidFill>
                  </a:tcPr>
                </a:tc>
                <a:extLst>
                  <a:ext uri="{0D108BD9-81ED-4DB2-BD59-A6C34878D82A}">
                    <a16:rowId xmlns:a16="http://schemas.microsoft.com/office/drawing/2014/main" val="549297302"/>
                  </a:ext>
                </a:extLst>
              </a:tr>
              <a:tr h="461603">
                <a:tc>
                  <a:txBody>
                    <a:bodyPr/>
                    <a:lstStyle/>
                    <a:p>
                      <a:pPr latinLnBrk="1"/>
                      <a:r>
                        <a:rPr lang="en-US" altLang="ko-KR" sz="1800" b="1" smtClean="0">
                          <a:latin typeface="Arial" panose="020B0604020202020204" pitchFamily="34" charset="0"/>
                          <a:cs typeface="Arial" panose="020B0604020202020204" pitchFamily="34" charset="0"/>
                        </a:rPr>
                        <a:t>Ovalbumin</a:t>
                      </a:r>
                      <a:r>
                        <a:rPr lang="en-US" altLang="ko-KR" sz="1800" b="1" baseline="0" smtClean="0">
                          <a:latin typeface="Arial" panose="020B0604020202020204" pitchFamily="34" charset="0"/>
                          <a:cs typeface="Arial" panose="020B0604020202020204" pitchFamily="34" charset="0"/>
                        </a:rPr>
                        <a:t> normalization</a:t>
                      </a:r>
                      <a:endParaRPr lang="ko-KR" altLang="en-US" sz="1800" b="1">
                        <a:latin typeface="Arial" panose="020B0604020202020204" pitchFamily="34" charset="0"/>
                        <a:cs typeface="Arial" panose="020B0604020202020204" pitchFamily="34" charset="0"/>
                      </a:endParaRPr>
                    </a:p>
                  </a:txBody>
                  <a:tcPr anchor="ctr">
                    <a:solidFill>
                      <a:schemeClr val="accent6">
                        <a:lumMod val="60000"/>
                        <a:lumOff val="40000"/>
                      </a:schemeClr>
                    </a:solidFill>
                  </a:tcPr>
                </a:tc>
                <a:tc>
                  <a:txBody>
                    <a:bodyPr/>
                    <a:lstStyle/>
                    <a:p>
                      <a:pPr algn="ctr" latinLnBrk="1"/>
                      <a:r>
                        <a:rPr lang="en-US" altLang="ko-KR" sz="1800" b="1" smtClean="0">
                          <a:latin typeface="Arial" panose="020B0604020202020204" pitchFamily="34" charset="0"/>
                          <a:cs typeface="Arial" panose="020B0604020202020204" pitchFamily="34" charset="0"/>
                        </a:rPr>
                        <a:t>32.2</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8.58</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6.77</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9.63</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8.98</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smtClean="0">
                          <a:latin typeface="Arial" panose="020B0604020202020204" pitchFamily="34" charset="0"/>
                          <a:cs typeface="Arial" panose="020B0604020202020204" pitchFamily="34" charset="0"/>
                        </a:rPr>
                        <a:t>27.8</a:t>
                      </a:r>
                      <a:endParaRPr lang="ko-KR" altLang="en-US" sz="1800" b="1">
                        <a:latin typeface="Arial" panose="020B0604020202020204" pitchFamily="34" charset="0"/>
                        <a:cs typeface="Arial" panose="020B0604020202020204" pitchFamily="34" charset="0"/>
                      </a:endParaRPr>
                    </a:p>
                  </a:txBody>
                  <a:tcPr anchor="ctr">
                    <a:solidFill>
                      <a:schemeClr val="bg2"/>
                    </a:solidFill>
                  </a:tcPr>
                </a:tc>
                <a:tc>
                  <a:txBody>
                    <a:bodyPr/>
                    <a:lstStyle/>
                    <a:p>
                      <a:pPr algn="ctr" latinLnBrk="1"/>
                      <a:r>
                        <a:rPr lang="en-US" altLang="ko-KR" sz="1800" b="1" dirty="0" smtClean="0">
                          <a:solidFill>
                            <a:srgbClr val="FF0000"/>
                          </a:solidFill>
                          <a:latin typeface="Arial" panose="020B0604020202020204" pitchFamily="34" charset="0"/>
                          <a:cs typeface="Arial" panose="020B0604020202020204" pitchFamily="34" charset="0"/>
                        </a:rPr>
                        <a:t>28.78</a:t>
                      </a:r>
                      <a:endParaRPr lang="ko-KR" altLang="en-US" sz="1800" b="1" dirty="0">
                        <a:solidFill>
                          <a:srgbClr val="FF0000"/>
                        </a:solidFill>
                        <a:latin typeface="Arial" panose="020B0604020202020204" pitchFamily="34" charset="0"/>
                        <a:cs typeface="Arial" panose="020B0604020202020204" pitchFamily="34" charset="0"/>
                      </a:endParaRPr>
                    </a:p>
                  </a:txBody>
                  <a:tcPr anchor="ctr">
                    <a:solidFill>
                      <a:schemeClr val="bg2"/>
                    </a:solidFill>
                  </a:tcPr>
                </a:tc>
                <a:extLst>
                  <a:ext uri="{0D108BD9-81ED-4DB2-BD59-A6C34878D82A}">
                    <a16:rowId xmlns:a16="http://schemas.microsoft.com/office/drawing/2014/main" val="2675557387"/>
                  </a:ext>
                </a:extLst>
              </a:tr>
            </a:tbl>
          </a:graphicData>
        </a:graphic>
      </p:graphicFrame>
      <p:sp>
        <p:nvSpPr>
          <p:cNvPr id="2" name="TextBox 1"/>
          <p:cNvSpPr txBox="1"/>
          <p:nvPr/>
        </p:nvSpPr>
        <p:spPr>
          <a:xfrm>
            <a:off x="404583" y="1311006"/>
            <a:ext cx="3377500" cy="369332"/>
          </a:xfrm>
          <a:prstGeom prst="rect">
            <a:avLst/>
          </a:prstGeom>
          <a:noFill/>
        </p:spPr>
        <p:txBody>
          <a:bodyPr wrap="square" rtlCol="0">
            <a:spAutoFit/>
          </a:bodyPr>
          <a:lstStyle/>
          <a:p>
            <a:r>
              <a:rPr lang="en-US" altLang="ko-KR" b="1">
                <a:latin typeface="Arial" panose="020B0604020202020204" pitchFamily="34" charset="0"/>
                <a:cs typeface="Arial" panose="020B0604020202020204" pitchFamily="34" charset="0"/>
              </a:rPr>
              <a:t>P</a:t>
            </a:r>
            <a:r>
              <a:rPr lang="en-US" altLang="ko-KR" b="1" smtClean="0">
                <a:latin typeface="Arial" panose="020B0604020202020204" pitchFamily="34" charset="0"/>
                <a:cs typeface="Arial" panose="020B0604020202020204" pitchFamily="34" charset="0"/>
              </a:rPr>
              <a:t>ooled sample</a:t>
            </a:r>
            <a:r>
              <a:rPr lang="en-US" altLang="ko-KR" b="1">
                <a:latin typeface="Arial" panose="020B0604020202020204" pitchFamily="34" charset="0"/>
                <a:cs typeface="Arial" panose="020B0604020202020204" pitchFamily="34" charset="0"/>
              </a:rPr>
              <a:t> </a:t>
            </a:r>
            <a:r>
              <a:rPr lang="en-US" altLang="ko-KR" b="1" smtClean="0">
                <a:latin typeface="Arial" panose="020B0604020202020204" pitchFamily="34" charset="0"/>
                <a:cs typeface="Arial" panose="020B0604020202020204" pitchFamily="34" charset="0"/>
              </a:rPr>
              <a:t>set</a:t>
            </a:r>
            <a:endParaRPr lang="ko-KR" altLang="en-US" b="1">
              <a:latin typeface="Arial" panose="020B0604020202020204" pitchFamily="34" charset="0"/>
              <a:cs typeface="Arial" panose="020B0604020202020204" pitchFamily="34" charset="0"/>
            </a:endParaRPr>
          </a:p>
        </p:txBody>
      </p:sp>
      <p:sp>
        <p:nvSpPr>
          <p:cNvPr id="21" name="TextBox 20"/>
          <p:cNvSpPr txBox="1"/>
          <p:nvPr/>
        </p:nvSpPr>
        <p:spPr>
          <a:xfrm>
            <a:off x="431171" y="4230039"/>
            <a:ext cx="3726749" cy="369332"/>
          </a:xfrm>
          <a:prstGeom prst="rect">
            <a:avLst/>
          </a:prstGeom>
          <a:noFill/>
        </p:spPr>
        <p:txBody>
          <a:bodyPr wrap="square" rtlCol="0">
            <a:spAutoFit/>
          </a:bodyPr>
          <a:lstStyle/>
          <a:p>
            <a:r>
              <a:rPr lang="en-US" altLang="ko-KR" b="1">
                <a:latin typeface="Arial" panose="020B0604020202020204" pitchFamily="34" charset="0"/>
                <a:cs typeface="Arial" panose="020B0604020202020204" pitchFamily="34" charset="0"/>
              </a:rPr>
              <a:t>I</a:t>
            </a:r>
            <a:r>
              <a:rPr lang="en-US" altLang="ko-KR" b="1" smtClean="0">
                <a:latin typeface="Arial" panose="020B0604020202020204" pitchFamily="34" charset="0"/>
                <a:cs typeface="Arial" panose="020B0604020202020204" pitchFamily="34" charset="0"/>
              </a:rPr>
              <a:t>ndividual sample set</a:t>
            </a:r>
            <a:endParaRPr lang="ko-KR" altLang="en-US" b="1">
              <a:latin typeface="Arial" panose="020B0604020202020204" pitchFamily="34" charset="0"/>
              <a:cs typeface="Arial" panose="020B0604020202020204" pitchFamily="34" charset="0"/>
            </a:endParaRPr>
          </a:p>
        </p:txBody>
      </p:sp>
      <p:pic>
        <p:nvPicPr>
          <p:cNvPr id="7" name="그림 6"/>
          <p:cNvPicPr>
            <a:picLocks noChangeAspect="1"/>
          </p:cNvPicPr>
          <p:nvPr/>
        </p:nvPicPr>
        <p:blipFill rotWithShape="1">
          <a:blip r:embed="rId2"/>
          <a:srcRect l="3892" b="4658"/>
          <a:stretch/>
        </p:blipFill>
        <p:spPr>
          <a:xfrm>
            <a:off x="1783667" y="8755514"/>
            <a:ext cx="5396050" cy="4627016"/>
          </a:xfrm>
          <a:prstGeom prst="rect">
            <a:avLst/>
          </a:prstGeom>
        </p:spPr>
      </p:pic>
      <p:cxnSp>
        <p:nvCxnSpPr>
          <p:cNvPr id="22" name="직선 연결선 21"/>
          <p:cNvCxnSpPr/>
          <p:nvPr/>
        </p:nvCxnSpPr>
        <p:spPr>
          <a:xfrm>
            <a:off x="1809793" y="13382530"/>
            <a:ext cx="516622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직선 연결선 23"/>
          <p:cNvCxnSpPr/>
          <p:nvPr/>
        </p:nvCxnSpPr>
        <p:spPr>
          <a:xfrm flipV="1">
            <a:off x="1809793" y="8941860"/>
            <a:ext cx="0" cy="445496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1538794" y="13461868"/>
            <a:ext cx="5640923" cy="307777"/>
          </a:xfrm>
          <a:prstGeom prst="rect">
            <a:avLst/>
          </a:prstGeom>
          <a:noFill/>
        </p:spPr>
        <p:txBody>
          <a:bodyPr wrap="square" rtlCol="0">
            <a:spAutoFit/>
          </a:bodyPr>
          <a:lstStyle/>
          <a:p>
            <a:r>
              <a:rPr lang="en-US" altLang="ko-KR" sz="1400" b="1" smtClean="0">
                <a:latin typeface="Arial" panose="020B0604020202020204" pitchFamily="34" charset="0"/>
                <a:cs typeface="Arial" panose="020B0604020202020204" pitchFamily="34" charset="0"/>
              </a:rPr>
              <a:t>0.E+00      0.5.E+05      1.E+05       1.5.E+05      2.E+05      2.5E+05      </a:t>
            </a:r>
            <a:endParaRPr lang="ko-KR" altLang="en-US" sz="1400" b="1">
              <a:latin typeface="Arial" panose="020B0604020202020204" pitchFamily="34" charset="0"/>
              <a:cs typeface="Arial" panose="020B0604020202020204" pitchFamily="34" charset="0"/>
            </a:endParaRPr>
          </a:p>
        </p:txBody>
      </p:sp>
      <p:sp>
        <p:nvSpPr>
          <p:cNvPr id="35" name="직사각형 34"/>
          <p:cNvSpPr/>
          <p:nvPr/>
        </p:nvSpPr>
        <p:spPr>
          <a:xfrm>
            <a:off x="890085" y="8774518"/>
            <a:ext cx="856325" cy="4832092"/>
          </a:xfrm>
          <a:prstGeom prst="rect">
            <a:avLst/>
          </a:prstGeom>
        </p:spPr>
        <p:txBody>
          <a:bodyPr wrap="none">
            <a:spAutoFit/>
          </a:bodyPr>
          <a:lstStyle/>
          <a:p>
            <a:endParaRPr lang="en-US" altLang="ko-KR" sz="1400" b="1" smtClean="0">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2.5E+05</a:t>
            </a:r>
          </a:p>
          <a:p>
            <a:endParaRPr lang="en-US" altLang="ko-KR" sz="1400" b="1">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2.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1.5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1.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0.5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0.E+00</a:t>
            </a:r>
            <a:endParaRPr lang="en-US" altLang="ko-KR" sz="1400" b="1">
              <a:latin typeface="Arial" panose="020B0604020202020204" pitchFamily="34" charset="0"/>
              <a:cs typeface="Arial" panose="020B0604020202020204" pitchFamily="34" charset="0"/>
            </a:endParaRPr>
          </a:p>
        </p:txBody>
      </p:sp>
      <p:sp>
        <p:nvSpPr>
          <p:cNvPr id="41" name="TextBox 40"/>
          <p:cNvSpPr txBox="1"/>
          <p:nvPr/>
        </p:nvSpPr>
        <p:spPr>
          <a:xfrm rot="16200000">
            <a:off x="-1217507" y="10819744"/>
            <a:ext cx="3645487" cy="461665"/>
          </a:xfrm>
          <a:prstGeom prst="rect">
            <a:avLst/>
          </a:prstGeom>
          <a:noFill/>
        </p:spPr>
        <p:txBody>
          <a:bodyPr wrap="square" rtlCol="0">
            <a:spAutoFit/>
          </a:bodyPr>
          <a:lstStyle/>
          <a:p>
            <a:pPr algn="ctr"/>
            <a:r>
              <a:rPr lang="en-US" altLang="ko-KR" sz="2400" b="1" dirty="0" smtClean="0">
                <a:latin typeface="Arial" panose="020B0604020202020204" pitchFamily="34" charset="0"/>
                <a:cs typeface="Arial" panose="020B0604020202020204" pitchFamily="34" charset="0"/>
              </a:rPr>
              <a:t>Reporter ion Intensity</a:t>
            </a:r>
            <a:endParaRPr lang="ko-KR" altLang="en-US" sz="2400" b="1" dirty="0">
              <a:latin typeface="Arial" panose="020B0604020202020204" pitchFamily="34" charset="0"/>
              <a:cs typeface="Arial" panose="020B0604020202020204" pitchFamily="34" charset="0"/>
            </a:endParaRPr>
          </a:p>
        </p:txBody>
      </p:sp>
      <p:sp>
        <p:nvSpPr>
          <p:cNvPr id="43" name="TextBox 42"/>
          <p:cNvSpPr txBox="1"/>
          <p:nvPr/>
        </p:nvSpPr>
        <p:spPr>
          <a:xfrm>
            <a:off x="3876026" y="12154447"/>
            <a:ext cx="3158528"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Pearson correlation: 0.993</a:t>
            </a:r>
            <a:endParaRPr lang="ko-KR" altLang="en-US" b="1">
              <a:latin typeface="Arial" panose="020B0604020202020204" pitchFamily="34" charset="0"/>
              <a:cs typeface="Arial" panose="020B0604020202020204" pitchFamily="34" charset="0"/>
            </a:endParaRPr>
          </a:p>
        </p:txBody>
      </p:sp>
      <p:sp>
        <p:nvSpPr>
          <p:cNvPr id="44" name="TextBox 43"/>
          <p:cNvSpPr txBox="1"/>
          <p:nvPr/>
        </p:nvSpPr>
        <p:spPr>
          <a:xfrm>
            <a:off x="1733710" y="8469026"/>
            <a:ext cx="3532339" cy="400110"/>
          </a:xfrm>
          <a:prstGeom prst="rect">
            <a:avLst/>
          </a:prstGeom>
          <a:noFill/>
        </p:spPr>
        <p:txBody>
          <a:bodyPr wrap="square" rtlCol="0">
            <a:spAutoFit/>
          </a:bodyPr>
          <a:lstStyle/>
          <a:p>
            <a:r>
              <a:rPr lang="en-US" altLang="ko-KR" sz="2000" b="1" smtClean="0">
                <a:latin typeface="Arial" panose="020B0604020202020204" pitchFamily="34" charset="0"/>
                <a:cs typeface="Arial" panose="020B0604020202020204" pitchFamily="34" charset="0"/>
              </a:rPr>
              <a:t>Set1 vs Set2</a:t>
            </a:r>
            <a:endParaRPr lang="ko-KR" altLang="en-US" sz="2000" b="1">
              <a:latin typeface="Arial" panose="020B0604020202020204" pitchFamily="34" charset="0"/>
              <a:cs typeface="Arial" panose="020B0604020202020204" pitchFamily="34" charset="0"/>
            </a:endParaRPr>
          </a:p>
        </p:txBody>
      </p:sp>
      <p:pic>
        <p:nvPicPr>
          <p:cNvPr id="46" name="그림 45"/>
          <p:cNvPicPr>
            <a:picLocks noChangeAspect="1"/>
          </p:cNvPicPr>
          <p:nvPr/>
        </p:nvPicPr>
        <p:blipFill rotWithShape="1">
          <a:blip r:embed="rId3">
            <a:extLst>
              <a:ext uri="{28A0092B-C50C-407E-A947-70E740481C1C}">
                <a14:useLocalDpi xmlns:a14="http://schemas.microsoft.com/office/drawing/2010/main" val="0"/>
              </a:ext>
            </a:extLst>
          </a:blip>
          <a:srcRect l="4137" r="4031" b="4686"/>
          <a:stretch/>
        </p:blipFill>
        <p:spPr>
          <a:xfrm>
            <a:off x="8995313" y="8714851"/>
            <a:ext cx="5207000" cy="4671452"/>
          </a:xfrm>
          <a:prstGeom prst="rect">
            <a:avLst/>
          </a:prstGeom>
        </p:spPr>
      </p:pic>
      <p:cxnSp>
        <p:nvCxnSpPr>
          <p:cNvPr id="47" name="직선 연결선 46"/>
          <p:cNvCxnSpPr/>
          <p:nvPr/>
        </p:nvCxnSpPr>
        <p:spPr>
          <a:xfrm>
            <a:off x="8995313" y="13386303"/>
            <a:ext cx="522187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직선 연결선 47"/>
          <p:cNvCxnSpPr/>
          <p:nvPr/>
        </p:nvCxnSpPr>
        <p:spPr>
          <a:xfrm flipV="1">
            <a:off x="8995313" y="8945633"/>
            <a:ext cx="0" cy="445496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9" name="TextBox 48"/>
          <p:cNvSpPr txBox="1"/>
          <p:nvPr/>
        </p:nvSpPr>
        <p:spPr>
          <a:xfrm>
            <a:off x="8758481" y="13462801"/>
            <a:ext cx="5640923" cy="307777"/>
          </a:xfrm>
          <a:prstGeom prst="rect">
            <a:avLst/>
          </a:prstGeom>
          <a:noFill/>
        </p:spPr>
        <p:txBody>
          <a:bodyPr wrap="square" rtlCol="0">
            <a:spAutoFit/>
          </a:bodyPr>
          <a:lstStyle/>
          <a:p>
            <a:r>
              <a:rPr lang="en-US" altLang="ko-KR" sz="1400" b="1" smtClean="0">
                <a:latin typeface="Arial" panose="020B0604020202020204" pitchFamily="34" charset="0"/>
                <a:cs typeface="Arial" panose="020B0604020202020204" pitchFamily="34" charset="0"/>
              </a:rPr>
              <a:t>0.E+00      0.5.E+05      1.E+05       1.5.E+05      2.E+05      2.5E+05      </a:t>
            </a:r>
            <a:endParaRPr lang="ko-KR" altLang="en-US" sz="1400" b="1">
              <a:latin typeface="Arial" panose="020B0604020202020204" pitchFamily="34" charset="0"/>
              <a:cs typeface="Arial" panose="020B0604020202020204" pitchFamily="34" charset="0"/>
            </a:endParaRPr>
          </a:p>
        </p:txBody>
      </p:sp>
      <p:sp>
        <p:nvSpPr>
          <p:cNvPr id="50" name="직사각형 49"/>
          <p:cNvSpPr/>
          <p:nvPr/>
        </p:nvSpPr>
        <p:spPr>
          <a:xfrm>
            <a:off x="8119297" y="8775451"/>
            <a:ext cx="856325" cy="4832092"/>
          </a:xfrm>
          <a:prstGeom prst="rect">
            <a:avLst/>
          </a:prstGeom>
        </p:spPr>
        <p:txBody>
          <a:bodyPr wrap="none">
            <a:spAutoFit/>
          </a:bodyPr>
          <a:lstStyle/>
          <a:p>
            <a:endParaRPr lang="en-US" altLang="ko-KR" sz="1400" b="1" smtClean="0">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2.5E+05</a:t>
            </a:r>
          </a:p>
          <a:p>
            <a:endParaRPr lang="en-US" altLang="ko-KR" sz="1400" b="1">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2.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1.5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1.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0.5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0.E+00</a:t>
            </a:r>
            <a:endParaRPr lang="en-US" altLang="ko-KR" sz="1400" b="1">
              <a:latin typeface="Arial" panose="020B0604020202020204" pitchFamily="34" charset="0"/>
              <a:cs typeface="Arial" panose="020B0604020202020204" pitchFamily="34" charset="0"/>
            </a:endParaRPr>
          </a:p>
        </p:txBody>
      </p:sp>
      <p:sp>
        <p:nvSpPr>
          <p:cNvPr id="52" name="TextBox 51"/>
          <p:cNvSpPr txBox="1"/>
          <p:nvPr/>
        </p:nvSpPr>
        <p:spPr>
          <a:xfrm>
            <a:off x="11171830" y="12154447"/>
            <a:ext cx="3158528"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Pearson correlation: 0.994</a:t>
            </a:r>
            <a:endParaRPr lang="ko-KR" altLang="en-US" b="1">
              <a:latin typeface="Arial" panose="020B0604020202020204" pitchFamily="34" charset="0"/>
              <a:cs typeface="Arial" panose="020B0604020202020204" pitchFamily="34" charset="0"/>
            </a:endParaRPr>
          </a:p>
        </p:txBody>
      </p:sp>
      <p:sp>
        <p:nvSpPr>
          <p:cNvPr id="53" name="TextBox 52"/>
          <p:cNvSpPr txBox="1"/>
          <p:nvPr/>
        </p:nvSpPr>
        <p:spPr>
          <a:xfrm>
            <a:off x="8913707" y="8469026"/>
            <a:ext cx="3261142" cy="400110"/>
          </a:xfrm>
          <a:prstGeom prst="rect">
            <a:avLst/>
          </a:prstGeom>
          <a:noFill/>
        </p:spPr>
        <p:txBody>
          <a:bodyPr wrap="square" rtlCol="0">
            <a:spAutoFit/>
          </a:bodyPr>
          <a:lstStyle/>
          <a:p>
            <a:r>
              <a:rPr lang="en-US" altLang="ko-KR" sz="2000" b="1" smtClean="0">
                <a:latin typeface="Arial" panose="020B0604020202020204" pitchFamily="34" charset="0"/>
                <a:cs typeface="Arial" panose="020B0604020202020204" pitchFamily="34" charset="0"/>
              </a:rPr>
              <a:t>Set2 vs Set3</a:t>
            </a:r>
            <a:endParaRPr lang="ko-KR" altLang="en-US" sz="2000" b="1">
              <a:latin typeface="Arial" panose="020B0604020202020204" pitchFamily="34" charset="0"/>
              <a:cs typeface="Arial" panose="020B0604020202020204" pitchFamily="34" charset="0"/>
            </a:endParaRPr>
          </a:p>
        </p:txBody>
      </p:sp>
      <p:pic>
        <p:nvPicPr>
          <p:cNvPr id="54" name="그림 53"/>
          <p:cNvPicPr>
            <a:picLocks noChangeAspect="1"/>
          </p:cNvPicPr>
          <p:nvPr/>
        </p:nvPicPr>
        <p:blipFill rotWithShape="1">
          <a:blip r:embed="rId4">
            <a:extLst>
              <a:ext uri="{28A0092B-C50C-407E-A947-70E740481C1C}">
                <a14:useLocalDpi xmlns:a14="http://schemas.microsoft.com/office/drawing/2010/main" val="0"/>
              </a:ext>
            </a:extLst>
          </a:blip>
          <a:srcRect l="3816" b="4502"/>
          <a:stretch/>
        </p:blipFill>
        <p:spPr>
          <a:xfrm>
            <a:off x="1733710" y="14716003"/>
            <a:ext cx="5433903" cy="4663370"/>
          </a:xfrm>
          <a:prstGeom prst="rect">
            <a:avLst/>
          </a:prstGeom>
        </p:spPr>
      </p:pic>
      <p:cxnSp>
        <p:nvCxnSpPr>
          <p:cNvPr id="55" name="직선 연결선 54"/>
          <p:cNvCxnSpPr/>
          <p:nvPr/>
        </p:nvCxnSpPr>
        <p:spPr>
          <a:xfrm>
            <a:off x="1741330" y="19372678"/>
            <a:ext cx="5221878"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직선 연결선 55"/>
          <p:cNvCxnSpPr/>
          <p:nvPr/>
        </p:nvCxnSpPr>
        <p:spPr>
          <a:xfrm flipV="1">
            <a:off x="1741330" y="14932008"/>
            <a:ext cx="0" cy="445496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57" name="TextBox 56"/>
          <p:cNvSpPr txBox="1"/>
          <p:nvPr/>
        </p:nvSpPr>
        <p:spPr>
          <a:xfrm>
            <a:off x="1504498" y="19449176"/>
            <a:ext cx="5640923" cy="307777"/>
          </a:xfrm>
          <a:prstGeom prst="rect">
            <a:avLst/>
          </a:prstGeom>
          <a:noFill/>
        </p:spPr>
        <p:txBody>
          <a:bodyPr wrap="square" rtlCol="0">
            <a:spAutoFit/>
          </a:bodyPr>
          <a:lstStyle/>
          <a:p>
            <a:r>
              <a:rPr lang="en-US" altLang="ko-KR" sz="1400" b="1" smtClean="0">
                <a:latin typeface="Arial" panose="020B0604020202020204" pitchFamily="34" charset="0"/>
                <a:cs typeface="Arial" panose="020B0604020202020204" pitchFamily="34" charset="0"/>
              </a:rPr>
              <a:t>0.E+00      0.5.E+05      1.E+05       1.5.E+05      2.E+05      2.5E+05      </a:t>
            </a:r>
            <a:endParaRPr lang="ko-KR" altLang="en-US" sz="1400" b="1">
              <a:latin typeface="Arial" panose="020B0604020202020204" pitchFamily="34" charset="0"/>
              <a:cs typeface="Arial" panose="020B0604020202020204" pitchFamily="34" charset="0"/>
            </a:endParaRPr>
          </a:p>
        </p:txBody>
      </p:sp>
      <p:sp>
        <p:nvSpPr>
          <p:cNvPr id="58" name="직사각형 57"/>
          <p:cNvSpPr/>
          <p:nvPr/>
        </p:nvSpPr>
        <p:spPr>
          <a:xfrm>
            <a:off x="865314" y="14761826"/>
            <a:ext cx="856325" cy="4832092"/>
          </a:xfrm>
          <a:prstGeom prst="rect">
            <a:avLst/>
          </a:prstGeom>
        </p:spPr>
        <p:txBody>
          <a:bodyPr wrap="none">
            <a:spAutoFit/>
          </a:bodyPr>
          <a:lstStyle/>
          <a:p>
            <a:endParaRPr lang="en-US" altLang="ko-KR" sz="1400" b="1" smtClean="0">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2.5E+05</a:t>
            </a:r>
          </a:p>
          <a:p>
            <a:endParaRPr lang="en-US" altLang="ko-KR" sz="1400" b="1">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2.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1.5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1.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0.5E+05</a:t>
            </a:r>
          </a:p>
          <a:p>
            <a:endParaRPr lang="en-US" altLang="ko-KR" sz="1400" b="1" smtClean="0">
              <a:latin typeface="Arial" panose="020B0604020202020204" pitchFamily="34" charset="0"/>
              <a:cs typeface="Arial" panose="020B0604020202020204" pitchFamily="34" charset="0"/>
            </a:endParaRPr>
          </a:p>
          <a:p>
            <a:endParaRPr lang="en-US" altLang="ko-KR" sz="1400" b="1" smtClean="0">
              <a:latin typeface="Arial" panose="020B0604020202020204" pitchFamily="34" charset="0"/>
              <a:cs typeface="Arial" panose="020B0604020202020204" pitchFamily="34" charset="0"/>
            </a:endParaRPr>
          </a:p>
          <a:p>
            <a:endParaRPr lang="en-US" altLang="ko-KR" sz="1400" b="1">
              <a:latin typeface="Arial" panose="020B0604020202020204" pitchFamily="34" charset="0"/>
              <a:cs typeface="Arial" panose="020B0604020202020204" pitchFamily="34" charset="0"/>
            </a:endParaRPr>
          </a:p>
          <a:p>
            <a:r>
              <a:rPr lang="en-US" altLang="ko-KR" sz="1400" b="1" smtClean="0">
                <a:latin typeface="Arial" panose="020B0604020202020204" pitchFamily="34" charset="0"/>
                <a:cs typeface="Arial" panose="020B0604020202020204" pitchFamily="34" charset="0"/>
              </a:rPr>
              <a:t>0.E+00</a:t>
            </a:r>
            <a:endParaRPr lang="en-US" altLang="ko-KR" sz="1400" b="1">
              <a:latin typeface="Arial" panose="020B0604020202020204" pitchFamily="34" charset="0"/>
              <a:cs typeface="Arial" panose="020B0604020202020204" pitchFamily="34" charset="0"/>
            </a:endParaRPr>
          </a:p>
        </p:txBody>
      </p:sp>
      <p:sp>
        <p:nvSpPr>
          <p:cNvPr id="63" name="TextBox 62"/>
          <p:cNvSpPr txBox="1"/>
          <p:nvPr/>
        </p:nvSpPr>
        <p:spPr>
          <a:xfrm>
            <a:off x="3968760" y="18118113"/>
            <a:ext cx="3158528"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Pearson correlation: 0.993</a:t>
            </a:r>
            <a:endParaRPr lang="ko-KR" altLang="en-US" b="1">
              <a:latin typeface="Arial" panose="020B0604020202020204" pitchFamily="34" charset="0"/>
              <a:cs typeface="Arial" panose="020B0604020202020204" pitchFamily="34" charset="0"/>
            </a:endParaRPr>
          </a:p>
        </p:txBody>
      </p:sp>
      <p:sp>
        <p:nvSpPr>
          <p:cNvPr id="64" name="TextBox 63"/>
          <p:cNvSpPr txBox="1"/>
          <p:nvPr/>
        </p:nvSpPr>
        <p:spPr>
          <a:xfrm>
            <a:off x="1678959" y="14392409"/>
            <a:ext cx="3137147" cy="400110"/>
          </a:xfrm>
          <a:prstGeom prst="rect">
            <a:avLst/>
          </a:prstGeom>
          <a:noFill/>
        </p:spPr>
        <p:txBody>
          <a:bodyPr wrap="square" rtlCol="0">
            <a:spAutoFit/>
          </a:bodyPr>
          <a:lstStyle/>
          <a:p>
            <a:r>
              <a:rPr lang="en-US" altLang="ko-KR" sz="2000" b="1" smtClean="0">
                <a:latin typeface="Arial" panose="020B0604020202020204" pitchFamily="34" charset="0"/>
                <a:cs typeface="Arial" panose="020B0604020202020204" pitchFamily="34" charset="0"/>
              </a:rPr>
              <a:t>Set1 vs Set3</a:t>
            </a:r>
            <a:endParaRPr lang="ko-KR" altLang="en-US" sz="2000" b="1">
              <a:latin typeface="Arial" panose="020B0604020202020204" pitchFamily="34" charset="0"/>
              <a:cs typeface="Arial" panose="020B0604020202020204" pitchFamily="34" charset="0"/>
            </a:endParaRPr>
          </a:p>
        </p:txBody>
      </p:sp>
      <p:sp>
        <p:nvSpPr>
          <p:cNvPr id="68" name="TextBox 67"/>
          <p:cNvSpPr txBox="1"/>
          <p:nvPr/>
        </p:nvSpPr>
        <p:spPr>
          <a:xfrm>
            <a:off x="865314" y="7738908"/>
            <a:ext cx="8453849" cy="369332"/>
          </a:xfrm>
          <a:prstGeom prst="rect">
            <a:avLst/>
          </a:prstGeom>
          <a:noFill/>
        </p:spPr>
        <p:txBody>
          <a:bodyPr wrap="square" rtlCol="0">
            <a:spAutoFit/>
          </a:bodyPr>
          <a:lstStyle/>
          <a:p>
            <a:r>
              <a:rPr lang="en-US" altLang="ko-KR" sz="1800" b="1" dirty="0">
                <a:latin typeface="Arial" panose="020B0604020202020204" pitchFamily="34" charset="0"/>
                <a:cs typeface="Arial" panose="020B0604020202020204" pitchFamily="34" charset="0"/>
              </a:rPr>
              <a:t>Cross-correlation among experimental </a:t>
            </a:r>
            <a:r>
              <a:rPr lang="en-US" altLang="ko-KR" sz="1800" b="1" dirty="0" smtClean="0">
                <a:latin typeface="Arial" panose="020B0604020202020204" pitchFamily="34" charset="0"/>
                <a:cs typeface="Arial" panose="020B0604020202020204" pitchFamily="34" charset="0"/>
              </a:rPr>
              <a:t>sets of </a:t>
            </a:r>
            <a:r>
              <a:rPr lang="en-US" altLang="ko-KR" b="1" dirty="0" smtClean="0">
                <a:latin typeface="Arial" panose="020B0604020202020204" pitchFamily="34" charset="0"/>
                <a:cs typeface="Arial" panose="020B0604020202020204" pitchFamily="34" charset="0"/>
              </a:rPr>
              <a:t>pooled sample</a:t>
            </a:r>
            <a:r>
              <a:rPr lang="en-US" altLang="ko-KR" b="1" dirty="0">
                <a:latin typeface="Arial" panose="020B0604020202020204" pitchFamily="34" charset="0"/>
                <a:cs typeface="Arial" panose="020B0604020202020204" pitchFamily="34" charset="0"/>
              </a:rPr>
              <a:t> </a:t>
            </a:r>
            <a:r>
              <a:rPr lang="en-US" altLang="ko-KR" b="1" dirty="0" smtClean="0">
                <a:latin typeface="Arial" panose="020B0604020202020204" pitchFamily="34" charset="0"/>
                <a:cs typeface="Arial" panose="020B0604020202020204" pitchFamily="34" charset="0"/>
              </a:rPr>
              <a:t>set</a:t>
            </a:r>
            <a:endParaRPr lang="ko-KR" altLang="en-US" b="1" dirty="0">
              <a:latin typeface="Arial" panose="020B0604020202020204" pitchFamily="34" charset="0"/>
              <a:cs typeface="Arial" panose="020B0604020202020204" pitchFamily="34" charset="0"/>
            </a:endParaRPr>
          </a:p>
        </p:txBody>
      </p:sp>
      <p:sp>
        <p:nvSpPr>
          <p:cNvPr id="69" name="TextBox 68"/>
          <p:cNvSpPr txBox="1"/>
          <p:nvPr/>
        </p:nvSpPr>
        <p:spPr>
          <a:xfrm>
            <a:off x="460886" y="7660367"/>
            <a:ext cx="429223" cy="523220"/>
          </a:xfrm>
          <a:prstGeom prst="rect">
            <a:avLst/>
          </a:prstGeom>
          <a:noFill/>
        </p:spPr>
        <p:txBody>
          <a:bodyPr wrap="square" rtlCol="0">
            <a:spAutoFit/>
          </a:bodyPr>
          <a:lstStyle/>
          <a:p>
            <a:pPr algn="ctr"/>
            <a:r>
              <a:rPr lang="en-US" altLang="ko-KR" sz="2800" b="1">
                <a:latin typeface="Arial" panose="020B0604020202020204" pitchFamily="34" charset="0"/>
                <a:cs typeface="Arial" panose="020B0604020202020204" pitchFamily="34" charset="0"/>
              </a:rPr>
              <a:t>d</a:t>
            </a:r>
            <a:endParaRPr lang="ko-KR" altLang="en-US" sz="2800" b="1">
              <a:latin typeface="Arial" panose="020B0604020202020204" pitchFamily="34" charset="0"/>
              <a:cs typeface="Arial" panose="020B0604020202020204" pitchFamily="34" charset="0"/>
            </a:endParaRPr>
          </a:p>
        </p:txBody>
      </p:sp>
      <p:sp>
        <p:nvSpPr>
          <p:cNvPr id="34" name="TextBox 33"/>
          <p:cNvSpPr txBox="1"/>
          <p:nvPr/>
        </p:nvSpPr>
        <p:spPr>
          <a:xfrm rot="16200000">
            <a:off x="5950682" y="10819743"/>
            <a:ext cx="3645487" cy="461665"/>
          </a:xfrm>
          <a:prstGeom prst="rect">
            <a:avLst/>
          </a:prstGeom>
          <a:noFill/>
        </p:spPr>
        <p:txBody>
          <a:bodyPr wrap="square" rtlCol="0">
            <a:spAutoFit/>
          </a:bodyPr>
          <a:lstStyle/>
          <a:p>
            <a:pPr algn="ctr"/>
            <a:r>
              <a:rPr lang="en-US" altLang="ko-KR" sz="2400" b="1" smtClean="0">
                <a:latin typeface="Arial" panose="020B0604020202020204" pitchFamily="34" charset="0"/>
                <a:cs typeface="Arial" panose="020B0604020202020204" pitchFamily="34" charset="0"/>
              </a:rPr>
              <a:t>Reporter ion Intensity</a:t>
            </a:r>
            <a:endParaRPr lang="ko-KR" altLang="en-US" sz="2400" b="1">
              <a:latin typeface="Arial" panose="020B0604020202020204" pitchFamily="34" charset="0"/>
              <a:cs typeface="Arial" panose="020B0604020202020204" pitchFamily="34" charset="0"/>
            </a:endParaRPr>
          </a:p>
        </p:txBody>
      </p:sp>
      <p:sp>
        <p:nvSpPr>
          <p:cNvPr id="36" name="TextBox 35"/>
          <p:cNvSpPr txBox="1"/>
          <p:nvPr/>
        </p:nvSpPr>
        <p:spPr>
          <a:xfrm rot="16200000">
            <a:off x="-1223447" y="16676319"/>
            <a:ext cx="3645487" cy="461665"/>
          </a:xfrm>
          <a:prstGeom prst="rect">
            <a:avLst/>
          </a:prstGeom>
          <a:noFill/>
        </p:spPr>
        <p:txBody>
          <a:bodyPr wrap="square" rtlCol="0">
            <a:spAutoFit/>
          </a:bodyPr>
          <a:lstStyle/>
          <a:p>
            <a:pPr algn="ctr"/>
            <a:r>
              <a:rPr lang="en-US" altLang="ko-KR" sz="2400" b="1" smtClean="0">
                <a:latin typeface="Arial" panose="020B0604020202020204" pitchFamily="34" charset="0"/>
                <a:cs typeface="Arial" panose="020B0604020202020204" pitchFamily="34" charset="0"/>
              </a:rPr>
              <a:t>Reporter ion Intensity</a:t>
            </a:r>
            <a:endParaRPr lang="ko-KR" altLang="en-US" sz="2400" b="1">
              <a:latin typeface="Arial" panose="020B0604020202020204" pitchFamily="34" charset="0"/>
              <a:cs typeface="Arial" panose="020B0604020202020204" pitchFamily="34" charset="0"/>
            </a:endParaRPr>
          </a:p>
        </p:txBody>
      </p:sp>
      <p:sp>
        <p:nvSpPr>
          <p:cNvPr id="37" name="TextBox 36"/>
          <p:cNvSpPr txBox="1"/>
          <p:nvPr/>
        </p:nvSpPr>
        <p:spPr>
          <a:xfrm>
            <a:off x="6738167" y="19991959"/>
            <a:ext cx="895350" cy="461665"/>
          </a:xfrm>
          <a:prstGeom prst="rect">
            <a:avLst/>
          </a:prstGeom>
          <a:noFill/>
        </p:spPr>
        <p:txBody>
          <a:bodyPr wrap="square" rtlCol="0">
            <a:spAutoFit/>
          </a:bodyPr>
          <a:lstStyle/>
          <a:p>
            <a:r>
              <a:rPr lang="en-US" altLang="ko-KR" sz="2400" b="1" smtClean="0"/>
              <a:t>S-5</a:t>
            </a:r>
            <a:endParaRPr lang="ko-KR" altLang="en-US" sz="2400" b="1"/>
          </a:p>
        </p:txBody>
      </p:sp>
    </p:spTree>
    <p:extLst>
      <p:ext uri="{BB962C8B-B14F-4D97-AF65-F5344CB8AC3E}">
        <p14:creationId xmlns:p14="http://schemas.microsoft.com/office/powerpoint/2010/main" val="211021863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p:cNvPicPr>
            <a:picLocks noChangeAspect="1"/>
          </p:cNvPicPr>
          <p:nvPr/>
        </p:nvPicPr>
        <p:blipFill rotWithShape="1">
          <a:blip r:embed="rId3"/>
          <a:srcRect l="2745" t="186" b="2756"/>
          <a:stretch/>
        </p:blipFill>
        <p:spPr>
          <a:xfrm>
            <a:off x="906259" y="2569607"/>
            <a:ext cx="11672092" cy="11648441"/>
          </a:xfrm>
          <a:prstGeom prst="rect">
            <a:avLst/>
          </a:prstGeom>
        </p:spPr>
      </p:pic>
      <p:sp>
        <p:nvSpPr>
          <p:cNvPr id="7" name="직사각형 6"/>
          <p:cNvSpPr/>
          <p:nvPr/>
        </p:nvSpPr>
        <p:spPr>
          <a:xfrm>
            <a:off x="10819635" y="14542863"/>
            <a:ext cx="2195826" cy="332032"/>
          </a:xfrm>
          <a:prstGeom prst="rect">
            <a:avLst/>
          </a:prstGeom>
          <a:gradFill flip="none" rotWithShape="1">
            <a:gsLst>
              <a:gs pos="22000">
                <a:schemeClr val="accent4">
                  <a:lumMod val="60000"/>
                  <a:lumOff val="40000"/>
                </a:schemeClr>
              </a:gs>
              <a:gs pos="51000">
                <a:srgbClr val="FFB265"/>
              </a:gs>
              <a:gs pos="91000">
                <a:srgbClr val="FF0603"/>
              </a:gs>
              <a:gs pos="100000">
                <a:srgbClr val="FF0000"/>
              </a:gs>
            </a:gsLst>
            <a:lin ang="0" scaled="1"/>
            <a:tileRect/>
          </a:grad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latin typeface="Arial" panose="020B0604020202020204" pitchFamily="34" charset="0"/>
              <a:cs typeface="Arial" panose="020B0604020202020204" pitchFamily="34" charset="0"/>
            </a:endParaRPr>
          </a:p>
        </p:txBody>
      </p:sp>
      <p:sp>
        <p:nvSpPr>
          <p:cNvPr id="10" name="TextBox 9"/>
          <p:cNvSpPr txBox="1"/>
          <p:nvPr/>
        </p:nvSpPr>
        <p:spPr>
          <a:xfrm>
            <a:off x="883196" y="1948203"/>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ND-1</a:t>
            </a:r>
            <a:endParaRPr lang="ko-KR" altLang="en-US" sz="1600" b="1">
              <a:latin typeface="Arial" panose="020B0604020202020204" pitchFamily="34" charset="0"/>
              <a:cs typeface="Arial" panose="020B0604020202020204" pitchFamily="34" charset="0"/>
            </a:endParaRPr>
          </a:p>
        </p:txBody>
      </p:sp>
      <p:sp>
        <p:nvSpPr>
          <p:cNvPr id="11" name="TextBox 10"/>
          <p:cNvSpPr txBox="1"/>
          <p:nvPr/>
        </p:nvSpPr>
        <p:spPr>
          <a:xfrm>
            <a:off x="1550739" y="1959095"/>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ND-1</a:t>
            </a:r>
            <a:endParaRPr lang="ko-KR" altLang="en-US" sz="1600" b="1">
              <a:latin typeface="Arial" panose="020B0604020202020204" pitchFamily="34" charset="0"/>
              <a:cs typeface="Arial" panose="020B0604020202020204" pitchFamily="34" charset="0"/>
            </a:endParaRPr>
          </a:p>
        </p:txBody>
      </p:sp>
      <p:sp>
        <p:nvSpPr>
          <p:cNvPr id="12" name="TextBox 11"/>
          <p:cNvSpPr txBox="1"/>
          <p:nvPr/>
        </p:nvSpPr>
        <p:spPr>
          <a:xfrm>
            <a:off x="2103982" y="1959095"/>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ND-1</a:t>
            </a:r>
            <a:endParaRPr lang="ko-KR" altLang="en-US" sz="1600" b="1">
              <a:latin typeface="Arial" panose="020B0604020202020204" pitchFamily="34" charset="0"/>
              <a:cs typeface="Arial" panose="020B0604020202020204" pitchFamily="34" charset="0"/>
            </a:endParaRPr>
          </a:p>
        </p:txBody>
      </p:sp>
      <p:sp>
        <p:nvSpPr>
          <p:cNvPr id="16" name="TextBox 15"/>
          <p:cNvSpPr txBox="1"/>
          <p:nvPr/>
        </p:nvSpPr>
        <p:spPr>
          <a:xfrm>
            <a:off x="2848837" y="1959095"/>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D-1</a:t>
            </a:r>
            <a:endParaRPr lang="ko-KR" altLang="en-US" sz="1600" b="1">
              <a:latin typeface="Arial" panose="020B0604020202020204" pitchFamily="34" charset="0"/>
              <a:cs typeface="Arial" panose="020B0604020202020204" pitchFamily="34" charset="0"/>
            </a:endParaRPr>
          </a:p>
        </p:txBody>
      </p:sp>
      <p:sp>
        <p:nvSpPr>
          <p:cNvPr id="17" name="TextBox 16"/>
          <p:cNvSpPr txBox="1"/>
          <p:nvPr/>
        </p:nvSpPr>
        <p:spPr>
          <a:xfrm>
            <a:off x="3516380" y="1969987"/>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D-1</a:t>
            </a:r>
            <a:endParaRPr lang="ko-KR" altLang="en-US" sz="1600" b="1">
              <a:latin typeface="Arial" panose="020B0604020202020204" pitchFamily="34" charset="0"/>
              <a:cs typeface="Arial" panose="020B0604020202020204" pitchFamily="34" charset="0"/>
            </a:endParaRPr>
          </a:p>
        </p:txBody>
      </p:sp>
      <p:sp>
        <p:nvSpPr>
          <p:cNvPr id="18" name="TextBox 17"/>
          <p:cNvSpPr txBox="1"/>
          <p:nvPr/>
        </p:nvSpPr>
        <p:spPr>
          <a:xfrm>
            <a:off x="4069623" y="1969987"/>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D-1</a:t>
            </a:r>
            <a:endParaRPr lang="ko-KR" altLang="en-US" sz="1600" b="1">
              <a:latin typeface="Arial" panose="020B0604020202020204" pitchFamily="34" charset="0"/>
              <a:cs typeface="Arial" panose="020B0604020202020204" pitchFamily="34" charset="0"/>
            </a:endParaRPr>
          </a:p>
        </p:txBody>
      </p:sp>
      <p:sp>
        <p:nvSpPr>
          <p:cNvPr id="19" name="TextBox 18"/>
          <p:cNvSpPr txBox="1"/>
          <p:nvPr/>
        </p:nvSpPr>
        <p:spPr>
          <a:xfrm>
            <a:off x="4761796" y="1976306"/>
            <a:ext cx="752475" cy="584775"/>
          </a:xfrm>
          <a:prstGeom prst="rect">
            <a:avLst/>
          </a:prstGeom>
          <a:noFill/>
        </p:spPr>
        <p:txBody>
          <a:bodyPr wrap="square" rtlCol="0">
            <a:spAutoFit/>
          </a:bodyPr>
          <a:lstStyle/>
          <a:p>
            <a:pPr algn="ctr"/>
            <a:r>
              <a:rPr lang="en-US" altLang="ko-KR" sz="1600" b="1" smtClean="0">
                <a:solidFill>
                  <a:srgbClr val="FF0000"/>
                </a:solidFill>
                <a:latin typeface="Arial" panose="020B0604020202020204" pitchFamily="34" charset="0"/>
                <a:cs typeface="Arial" panose="020B0604020202020204" pitchFamily="34" charset="0"/>
              </a:rPr>
              <a:t>HER2</a:t>
            </a:r>
          </a:p>
          <a:p>
            <a:pPr algn="ctr"/>
            <a:r>
              <a:rPr lang="en-US" altLang="ko-KR" sz="1600" b="1" smtClean="0">
                <a:solidFill>
                  <a:srgbClr val="FF0000"/>
                </a:solidFill>
                <a:latin typeface="Arial" panose="020B0604020202020204" pitchFamily="34" charset="0"/>
                <a:cs typeface="Arial" panose="020B0604020202020204" pitchFamily="34" charset="0"/>
              </a:rPr>
              <a:t>ND-2</a:t>
            </a:r>
            <a:endParaRPr lang="ko-KR" altLang="en-US" sz="1600" b="1">
              <a:solidFill>
                <a:srgbClr val="FF0000"/>
              </a:solidFill>
              <a:latin typeface="Arial" panose="020B0604020202020204" pitchFamily="34" charset="0"/>
              <a:cs typeface="Arial" panose="020B0604020202020204" pitchFamily="34" charset="0"/>
            </a:endParaRPr>
          </a:p>
        </p:txBody>
      </p:sp>
      <p:sp>
        <p:nvSpPr>
          <p:cNvPr id="20" name="TextBox 19"/>
          <p:cNvSpPr txBox="1"/>
          <p:nvPr/>
        </p:nvSpPr>
        <p:spPr>
          <a:xfrm>
            <a:off x="5429339" y="1987198"/>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ND-2</a:t>
            </a:r>
            <a:endParaRPr lang="ko-KR" altLang="en-US" sz="1600" b="1">
              <a:latin typeface="Arial" panose="020B0604020202020204" pitchFamily="34" charset="0"/>
              <a:cs typeface="Arial" panose="020B0604020202020204" pitchFamily="34" charset="0"/>
            </a:endParaRPr>
          </a:p>
        </p:txBody>
      </p:sp>
      <p:sp>
        <p:nvSpPr>
          <p:cNvPr id="21" name="TextBox 20"/>
          <p:cNvSpPr txBox="1"/>
          <p:nvPr/>
        </p:nvSpPr>
        <p:spPr>
          <a:xfrm>
            <a:off x="5982582" y="1987198"/>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ND-2</a:t>
            </a:r>
            <a:endParaRPr lang="ko-KR" altLang="en-US" sz="1600" b="1">
              <a:latin typeface="Arial" panose="020B0604020202020204" pitchFamily="34" charset="0"/>
              <a:cs typeface="Arial" panose="020B0604020202020204" pitchFamily="34" charset="0"/>
            </a:endParaRPr>
          </a:p>
        </p:txBody>
      </p:sp>
      <p:sp>
        <p:nvSpPr>
          <p:cNvPr id="22" name="TextBox 21"/>
          <p:cNvSpPr txBox="1"/>
          <p:nvPr/>
        </p:nvSpPr>
        <p:spPr>
          <a:xfrm>
            <a:off x="6727437" y="1987198"/>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D-2</a:t>
            </a:r>
            <a:endParaRPr lang="ko-KR" altLang="en-US" sz="1600" b="1">
              <a:latin typeface="Arial" panose="020B0604020202020204" pitchFamily="34" charset="0"/>
              <a:cs typeface="Arial" panose="020B0604020202020204" pitchFamily="34" charset="0"/>
            </a:endParaRPr>
          </a:p>
        </p:txBody>
      </p:sp>
      <p:sp>
        <p:nvSpPr>
          <p:cNvPr id="23" name="TextBox 22"/>
          <p:cNvSpPr txBox="1"/>
          <p:nvPr/>
        </p:nvSpPr>
        <p:spPr>
          <a:xfrm>
            <a:off x="7394980" y="1998090"/>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D-2</a:t>
            </a:r>
            <a:endParaRPr lang="ko-KR" altLang="en-US" sz="1600" b="1">
              <a:latin typeface="Arial" panose="020B0604020202020204" pitchFamily="34" charset="0"/>
              <a:cs typeface="Arial" panose="020B0604020202020204" pitchFamily="34" charset="0"/>
            </a:endParaRPr>
          </a:p>
        </p:txBody>
      </p:sp>
      <p:sp>
        <p:nvSpPr>
          <p:cNvPr id="24" name="TextBox 23"/>
          <p:cNvSpPr txBox="1"/>
          <p:nvPr/>
        </p:nvSpPr>
        <p:spPr>
          <a:xfrm>
            <a:off x="7948223" y="1998090"/>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D-2</a:t>
            </a:r>
            <a:endParaRPr lang="ko-KR" altLang="en-US" sz="1600" b="1">
              <a:latin typeface="Arial" panose="020B0604020202020204" pitchFamily="34" charset="0"/>
              <a:cs typeface="Arial" panose="020B0604020202020204" pitchFamily="34" charset="0"/>
            </a:endParaRPr>
          </a:p>
        </p:txBody>
      </p:sp>
      <p:sp>
        <p:nvSpPr>
          <p:cNvPr id="25" name="TextBox 24"/>
          <p:cNvSpPr txBox="1"/>
          <p:nvPr/>
        </p:nvSpPr>
        <p:spPr>
          <a:xfrm>
            <a:off x="8640689" y="1993254"/>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ND-3</a:t>
            </a:r>
            <a:endParaRPr lang="ko-KR" altLang="en-US" sz="1600" b="1">
              <a:latin typeface="Arial" panose="020B0604020202020204" pitchFamily="34" charset="0"/>
              <a:cs typeface="Arial" panose="020B0604020202020204" pitchFamily="34" charset="0"/>
            </a:endParaRPr>
          </a:p>
        </p:txBody>
      </p:sp>
      <p:sp>
        <p:nvSpPr>
          <p:cNvPr id="26" name="TextBox 25"/>
          <p:cNvSpPr txBox="1"/>
          <p:nvPr/>
        </p:nvSpPr>
        <p:spPr>
          <a:xfrm>
            <a:off x="9308232" y="2004146"/>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ND-3</a:t>
            </a:r>
            <a:endParaRPr lang="ko-KR" altLang="en-US" sz="1600" b="1">
              <a:latin typeface="Arial" panose="020B0604020202020204" pitchFamily="34" charset="0"/>
              <a:cs typeface="Arial" panose="020B0604020202020204" pitchFamily="34" charset="0"/>
            </a:endParaRPr>
          </a:p>
        </p:txBody>
      </p:sp>
      <p:sp>
        <p:nvSpPr>
          <p:cNvPr id="27" name="TextBox 26"/>
          <p:cNvSpPr txBox="1"/>
          <p:nvPr/>
        </p:nvSpPr>
        <p:spPr>
          <a:xfrm>
            <a:off x="9861475" y="2004146"/>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ND-3</a:t>
            </a:r>
            <a:endParaRPr lang="ko-KR" altLang="en-US" sz="1600" b="1">
              <a:latin typeface="Arial" panose="020B0604020202020204" pitchFamily="34" charset="0"/>
              <a:cs typeface="Arial" panose="020B0604020202020204" pitchFamily="34" charset="0"/>
            </a:endParaRPr>
          </a:p>
        </p:txBody>
      </p:sp>
      <p:sp>
        <p:nvSpPr>
          <p:cNvPr id="28" name="TextBox 27"/>
          <p:cNvSpPr txBox="1"/>
          <p:nvPr/>
        </p:nvSpPr>
        <p:spPr>
          <a:xfrm>
            <a:off x="10606330" y="2004146"/>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D-3</a:t>
            </a:r>
            <a:endParaRPr lang="ko-KR" altLang="en-US" sz="1600" b="1">
              <a:latin typeface="Arial" panose="020B0604020202020204" pitchFamily="34" charset="0"/>
              <a:cs typeface="Arial" panose="020B0604020202020204" pitchFamily="34" charset="0"/>
            </a:endParaRPr>
          </a:p>
        </p:txBody>
      </p:sp>
      <p:sp>
        <p:nvSpPr>
          <p:cNvPr id="29" name="TextBox 28"/>
          <p:cNvSpPr txBox="1"/>
          <p:nvPr/>
        </p:nvSpPr>
        <p:spPr>
          <a:xfrm>
            <a:off x="11273873" y="2015038"/>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D-3</a:t>
            </a:r>
            <a:endParaRPr lang="ko-KR" altLang="en-US" sz="1600" b="1">
              <a:latin typeface="Arial" panose="020B0604020202020204" pitchFamily="34" charset="0"/>
              <a:cs typeface="Arial" panose="020B0604020202020204" pitchFamily="34" charset="0"/>
            </a:endParaRPr>
          </a:p>
        </p:txBody>
      </p:sp>
      <p:sp>
        <p:nvSpPr>
          <p:cNvPr id="30" name="TextBox 29"/>
          <p:cNvSpPr txBox="1"/>
          <p:nvPr/>
        </p:nvSpPr>
        <p:spPr>
          <a:xfrm>
            <a:off x="11827116" y="2015038"/>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D-3</a:t>
            </a:r>
            <a:endParaRPr lang="ko-KR" altLang="en-US" sz="1600" b="1">
              <a:latin typeface="Arial" panose="020B0604020202020204" pitchFamily="34" charset="0"/>
              <a:cs typeface="Arial" panose="020B0604020202020204" pitchFamily="34" charset="0"/>
            </a:endParaRPr>
          </a:p>
        </p:txBody>
      </p:sp>
      <p:sp>
        <p:nvSpPr>
          <p:cNvPr id="31" name="TextBox 30"/>
          <p:cNvSpPr txBox="1"/>
          <p:nvPr/>
        </p:nvSpPr>
        <p:spPr>
          <a:xfrm rot="5400000">
            <a:off x="12466813" y="2605304"/>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ND-1</a:t>
            </a:r>
            <a:endParaRPr lang="ko-KR" altLang="en-US" sz="1600" b="1">
              <a:latin typeface="Arial" panose="020B0604020202020204" pitchFamily="34" charset="0"/>
              <a:cs typeface="Arial" panose="020B0604020202020204" pitchFamily="34" charset="0"/>
            </a:endParaRPr>
          </a:p>
        </p:txBody>
      </p:sp>
      <p:sp>
        <p:nvSpPr>
          <p:cNvPr id="32" name="TextBox 31"/>
          <p:cNvSpPr txBox="1"/>
          <p:nvPr/>
        </p:nvSpPr>
        <p:spPr>
          <a:xfrm rot="5400000">
            <a:off x="12490627" y="3226708"/>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ND-1</a:t>
            </a:r>
            <a:endParaRPr lang="ko-KR" altLang="en-US" sz="1600" b="1">
              <a:latin typeface="Arial" panose="020B0604020202020204" pitchFamily="34" charset="0"/>
              <a:cs typeface="Arial" panose="020B0604020202020204" pitchFamily="34" charset="0"/>
            </a:endParaRPr>
          </a:p>
        </p:txBody>
      </p:sp>
      <p:sp>
        <p:nvSpPr>
          <p:cNvPr id="33" name="TextBox 32"/>
          <p:cNvSpPr txBox="1"/>
          <p:nvPr/>
        </p:nvSpPr>
        <p:spPr>
          <a:xfrm rot="5400000">
            <a:off x="12407282" y="3848112"/>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ND-1</a:t>
            </a:r>
            <a:endParaRPr lang="ko-KR" altLang="en-US" sz="1600" b="1">
              <a:latin typeface="Arial" panose="020B0604020202020204" pitchFamily="34" charset="0"/>
              <a:cs typeface="Arial" panose="020B0604020202020204" pitchFamily="34" charset="0"/>
            </a:endParaRPr>
          </a:p>
        </p:txBody>
      </p:sp>
      <p:sp>
        <p:nvSpPr>
          <p:cNvPr id="34" name="TextBox 33"/>
          <p:cNvSpPr txBox="1"/>
          <p:nvPr/>
        </p:nvSpPr>
        <p:spPr>
          <a:xfrm rot="5400000">
            <a:off x="12490901" y="4506145"/>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D-1</a:t>
            </a:r>
            <a:endParaRPr lang="ko-KR" altLang="en-US" sz="1600" b="1">
              <a:latin typeface="Arial" panose="020B0604020202020204" pitchFamily="34" charset="0"/>
              <a:cs typeface="Arial" panose="020B0604020202020204" pitchFamily="34" charset="0"/>
            </a:endParaRPr>
          </a:p>
        </p:txBody>
      </p:sp>
      <p:sp>
        <p:nvSpPr>
          <p:cNvPr id="35" name="TextBox 34"/>
          <p:cNvSpPr txBox="1"/>
          <p:nvPr/>
        </p:nvSpPr>
        <p:spPr>
          <a:xfrm rot="5400000">
            <a:off x="12490626" y="5164178"/>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D-1</a:t>
            </a:r>
            <a:endParaRPr lang="ko-KR" altLang="en-US" sz="1600" b="1">
              <a:latin typeface="Arial" panose="020B0604020202020204" pitchFamily="34" charset="0"/>
              <a:cs typeface="Arial" panose="020B0604020202020204" pitchFamily="34" charset="0"/>
            </a:endParaRPr>
          </a:p>
        </p:txBody>
      </p:sp>
      <p:sp>
        <p:nvSpPr>
          <p:cNvPr id="36" name="TextBox 35"/>
          <p:cNvSpPr txBox="1"/>
          <p:nvPr/>
        </p:nvSpPr>
        <p:spPr>
          <a:xfrm rot="5400000">
            <a:off x="12407282" y="5822211"/>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D-1</a:t>
            </a:r>
            <a:endParaRPr lang="ko-KR" altLang="en-US" sz="1600" b="1">
              <a:latin typeface="Arial" panose="020B0604020202020204" pitchFamily="34" charset="0"/>
              <a:cs typeface="Arial" panose="020B0604020202020204" pitchFamily="34" charset="0"/>
            </a:endParaRPr>
          </a:p>
        </p:txBody>
      </p:sp>
      <p:sp>
        <p:nvSpPr>
          <p:cNvPr id="37" name="TextBox 36"/>
          <p:cNvSpPr txBox="1"/>
          <p:nvPr/>
        </p:nvSpPr>
        <p:spPr>
          <a:xfrm rot="5400000">
            <a:off x="12517614" y="6481259"/>
            <a:ext cx="752475" cy="584775"/>
          </a:xfrm>
          <a:prstGeom prst="rect">
            <a:avLst/>
          </a:prstGeom>
          <a:noFill/>
        </p:spPr>
        <p:txBody>
          <a:bodyPr wrap="square" rtlCol="0">
            <a:spAutoFit/>
          </a:bodyPr>
          <a:lstStyle/>
          <a:p>
            <a:pPr algn="ctr"/>
            <a:r>
              <a:rPr lang="en-US" altLang="ko-KR" sz="1600" b="1" dirty="0" smtClean="0">
                <a:solidFill>
                  <a:srgbClr val="FF0000"/>
                </a:solidFill>
                <a:latin typeface="Arial" panose="020B0604020202020204" pitchFamily="34" charset="0"/>
                <a:cs typeface="Arial" panose="020B0604020202020204" pitchFamily="34" charset="0"/>
              </a:rPr>
              <a:t>HER2</a:t>
            </a:r>
          </a:p>
          <a:p>
            <a:pPr algn="ctr"/>
            <a:r>
              <a:rPr lang="en-US" altLang="ko-KR" sz="1600" b="1" dirty="0" smtClean="0">
                <a:solidFill>
                  <a:srgbClr val="FF0000"/>
                </a:solidFill>
                <a:latin typeface="Arial" panose="020B0604020202020204" pitchFamily="34" charset="0"/>
                <a:cs typeface="Arial" panose="020B0604020202020204" pitchFamily="34" charset="0"/>
              </a:rPr>
              <a:t>ND-2</a:t>
            </a:r>
            <a:endParaRPr lang="ko-KR" altLang="en-US" sz="1600" b="1" dirty="0">
              <a:solidFill>
                <a:srgbClr val="FF0000"/>
              </a:solidFill>
              <a:latin typeface="Arial" panose="020B0604020202020204" pitchFamily="34" charset="0"/>
              <a:cs typeface="Arial" panose="020B0604020202020204" pitchFamily="34" charset="0"/>
            </a:endParaRPr>
          </a:p>
        </p:txBody>
      </p:sp>
      <p:sp>
        <p:nvSpPr>
          <p:cNvPr id="38" name="TextBox 37"/>
          <p:cNvSpPr txBox="1"/>
          <p:nvPr/>
        </p:nvSpPr>
        <p:spPr>
          <a:xfrm rot="5400000">
            <a:off x="12514200" y="7131691"/>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ND-2</a:t>
            </a:r>
            <a:endParaRPr lang="ko-KR" altLang="en-US" sz="1600" b="1">
              <a:latin typeface="Arial" panose="020B0604020202020204" pitchFamily="34" charset="0"/>
              <a:cs typeface="Arial" panose="020B0604020202020204" pitchFamily="34" charset="0"/>
            </a:endParaRPr>
          </a:p>
        </p:txBody>
      </p:sp>
      <p:sp>
        <p:nvSpPr>
          <p:cNvPr id="39" name="TextBox 38"/>
          <p:cNvSpPr txBox="1"/>
          <p:nvPr/>
        </p:nvSpPr>
        <p:spPr>
          <a:xfrm rot="5400000">
            <a:off x="12430855" y="7753095"/>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ND-2</a:t>
            </a:r>
            <a:endParaRPr lang="ko-KR" altLang="en-US" sz="1600" b="1">
              <a:latin typeface="Arial" panose="020B0604020202020204" pitchFamily="34" charset="0"/>
              <a:cs typeface="Arial" panose="020B0604020202020204" pitchFamily="34" charset="0"/>
            </a:endParaRPr>
          </a:p>
        </p:txBody>
      </p:sp>
      <p:sp>
        <p:nvSpPr>
          <p:cNvPr id="40" name="TextBox 39"/>
          <p:cNvSpPr txBox="1"/>
          <p:nvPr/>
        </p:nvSpPr>
        <p:spPr>
          <a:xfrm rot="5400000">
            <a:off x="12514474" y="8411128"/>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D-2</a:t>
            </a:r>
            <a:endParaRPr lang="ko-KR" altLang="en-US" sz="1600" b="1">
              <a:latin typeface="Arial" panose="020B0604020202020204" pitchFamily="34" charset="0"/>
              <a:cs typeface="Arial" panose="020B0604020202020204" pitchFamily="34" charset="0"/>
            </a:endParaRPr>
          </a:p>
        </p:txBody>
      </p:sp>
      <p:sp>
        <p:nvSpPr>
          <p:cNvPr id="41" name="TextBox 40"/>
          <p:cNvSpPr txBox="1"/>
          <p:nvPr/>
        </p:nvSpPr>
        <p:spPr>
          <a:xfrm rot="5400000">
            <a:off x="12514199" y="9069161"/>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D-2</a:t>
            </a:r>
            <a:endParaRPr lang="ko-KR" altLang="en-US" sz="1600" b="1">
              <a:latin typeface="Arial" panose="020B0604020202020204" pitchFamily="34" charset="0"/>
              <a:cs typeface="Arial" panose="020B0604020202020204" pitchFamily="34" charset="0"/>
            </a:endParaRPr>
          </a:p>
        </p:txBody>
      </p:sp>
      <p:sp>
        <p:nvSpPr>
          <p:cNvPr id="42" name="TextBox 41"/>
          <p:cNvSpPr txBox="1"/>
          <p:nvPr/>
        </p:nvSpPr>
        <p:spPr>
          <a:xfrm rot="5400000">
            <a:off x="12430855" y="9727194"/>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D-2</a:t>
            </a:r>
            <a:endParaRPr lang="ko-KR" altLang="en-US" sz="1600" b="1">
              <a:latin typeface="Arial" panose="020B0604020202020204" pitchFamily="34" charset="0"/>
              <a:cs typeface="Arial" panose="020B0604020202020204" pitchFamily="34" charset="0"/>
            </a:endParaRPr>
          </a:p>
        </p:txBody>
      </p:sp>
      <p:sp>
        <p:nvSpPr>
          <p:cNvPr id="43" name="TextBox 42"/>
          <p:cNvSpPr txBox="1"/>
          <p:nvPr/>
        </p:nvSpPr>
        <p:spPr>
          <a:xfrm rot="5400000">
            <a:off x="12541184" y="10386243"/>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ND-3</a:t>
            </a:r>
            <a:endParaRPr lang="ko-KR" altLang="en-US" sz="1600" b="1">
              <a:latin typeface="Arial" panose="020B0604020202020204" pitchFamily="34" charset="0"/>
              <a:cs typeface="Arial" panose="020B0604020202020204" pitchFamily="34" charset="0"/>
            </a:endParaRPr>
          </a:p>
        </p:txBody>
      </p:sp>
      <p:sp>
        <p:nvSpPr>
          <p:cNvPr id="44" name="TextBox 43"/>
          <p:cNvSpPr txBox="1"/>
          <p:nvPr/>
        </p:nvSpPr>
        <p:spPr>
          <a:xfrm rot="5400000">
            <a:off x="12564998" y="11007647"/>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ND-3</a:t>
            </a:r>
            <a:endParaRPr lang="ko-KR" altLang="en-US" sz="1600" b="1">
              <a:latin typeface="Arial" panose="020B0604020202020204" pitchFamily="34" charset="0"/>
              <a:cs typeface="Arial" panose="020B0604020202020204" pitchFamily="34" charset="0"/>
            </a:endParaRPr>
          </a:p>
        </p:txBody>
      </p:sp>
      <p:sp>
        <p:nvSpPr>
          <p:cNvPr id="45" name="TextBox 44"/>
          <p:cNvSpPr txBox="1"/>
          <p:nvPr/>
        </p:nvSpPr>
        <p:spPr>
          <a:xfrm rot="5400000">
            <a:off x="12481653" y="11672593"/>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ND-3</a:t>
            </a:r>
            <a:endParaRPr lang="ko-KR" altLang="en-US" sz="1600" b="1">
              <a:latin typeface="Arial" panose="020B0604020202020204" pitchFamily="34" charset="0"/>
              <a:cs typeface="Arial" panose="020B0604020202020204" pitchFamily="34" charset="0"/>
            </a:endParaRPr>
          </a:p>
        </p:txBody>
      </p:sp>
      <p:sp>
        <p:nvSpPr>
          <p:cNvPr id="46" name="TextBox 45"/>
          <p:cNvSpPr txBox="1"/>
          <p:nvPr/>
        </p:nvSpPr>
        <p:spPr>
          <a:xfrm rot="5400000">
            <a:off x="12565272" y="12330626"/>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HER2</a:t>
            </a:r>
          </a:p>
          <a:p>
            <a:pPr algn="ctr"/>
            <a:r>
              <a:rPr lang="en-US" altLang="ko-KR" sz="1600" b="1" smtClean="0">
                <a:latin typeface="Arial" panose="020B0604020202020204" pitchFamily="34" charset="0"/>
                <a:cs typeface="Arial" panose="020B0604020202020204" pitchFamily="34" charset="0"/>
              </a:rPr>
              <a:t>D-3</a:t>
            </a:r>
            <a:endParaRPr lang="ko-KR" altLang="en-US" sz="1600" b="1">
              <a:latin typeface="Arial" panose="020B0604020202020204" pitchFamily="34" charset="0"/>
              <a:cs typeface="Arial" panose="020B0604020202020204" pitchFamily="34" charset="0"/>
            </a:endParaRPr>
          </a:p>
        </p:txBody>
      </p:sp>
      <p:sp>
        <p:nvSpPr>
          <p:cNvPr id="47" name="TextBox 46"/>
          <p:cNvSpPr txBox="1"/>
          <p:nvPr/>
        </p:nvSpPr>
        <p:spPr>
          <a:xfrm rot="5400000">
            <a:off x="12564997" y="12974145"/>
            <a:ext cx="752475"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TNBCD-3</a:t>
            </a:r>
            <a:endParaRPr lang="ko-KR" altLang="en-US" sz="1600" b="1">
              <a:latin typeface="Arial" panose="020B0604020202020204" pitchFamily="34" charset="0"/>
              <a:cs typeface="Arial" panose="020B0604020202020204" pitchFamily="34" charset="0"/>
            </a:endParaRPr>
          </a:p>
        </p:txBody>
      </p:sp>
      <p:sp>
        <p:nvSpPr>
          <p:cNvPr id="48" name="TextBox 47"/>
          <p:cNvSpPr txBox="1"/>
          <p:nvPr/>
        </p:nvSpPr>
        <p:spPr>
          <a:xfrm rot="5400000">
            <a:off x="12481653" y="13617664"/>
            <a:ext cx="919164" cy="584775"/>
          </a:xfrm>
          <a:prstGeom prst="rect">
            <a:avLst/>
          </a:prstGeom>
          <a:noFill/>
        </p:spPr>
        <p:txBody>
          <a:bodyPr wrap="square" rtlCol="0">
            <a:spAutoFit/>
          </a:bodyPr>
          <a:lstStyle/>
          <a:p>
            <a:pPr algn="ctr"/>
            <a:r>
              <a:rPr lang="en-US" altLang="ko-KR" sz="1600" b="1" smtClean="0">
                <a:latin typeface="Arial" panose="020B0604020202020204" pitchFamily="34" charset="0"/>
                <a:cs typeface="Arial" panose="020B0604020202020204" pitchFamily="34" charset="0"/>
              </a:rPr>
              <a:t>LU</a:t>
            </a:r>
          </a:p>
          <a:p>
            <a:pPr algn="ctr"/>
            <a:r>
              <a:rPr lang="en-US" altLang="ko-KR" sz="1600" b="1" smtClean="0">
                <a:latin typeface="Arial" panose="020B0604020202020204" pitchFamily="34" charset="0"/>
                <a:cs typeface="Arial" panose="020B0604020202020204" pitchFamily="34" charset="0"/>
              </a:rPr>
              <a:t>D-3</a:t>
            </a:r>
            <a:endParaRPr lang="ko-KR" altLang="en-US" sz="1600" b="1">
              <a:latin typeface="Arial" panose="020B0604020202020204" pitchFamily="34" charset="0"/>
              <a:cs typeface="Arial" panose="020B0604020202020204" pitchFamily="34" charset="0"/>
            </a:endParaRPr>
          </a:p>
        </p:txBody>
      </p:sp>
      <p:cxnSp>
        <p:nvCxnSpPr>
          <p:cNvPr id="76" name="직선 연결선 75"/>
          <p:cNvCxnSpPr/>
          <p:nvPr/>
        </p:nvCxnSpPr>
        <p:spPr>
          <a:xfrm>
            <a:off x="906259" y="1967504"/>
            <a:ext cx="3855537" cy="19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직선 연결선 79"/>
          <p:cNvCxnSpPr/>
          <p:nvPr/>
        </p:nvCxnSpPr>
        <p:spPr>
          <a:xfrm>
            <a:off x="906258" y="1907342"/>
            <a:ext cx="3855537" cy="19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81" name="TextBox 80"/>
          <p:cNvSpPr txBox="1"/>
          <p:nvPr/>
        </p:nvSpPr>
        <p:spPr>
          <a:xfrm>
            <a:off x="1876802" y="1475360"/>
            <a:ext cx="1914447" cy="376326"/>
          </a:xfrm>
          <a:prstGeom prst="rect">
            <a:avLst/>
          </a:prstGeom>
          <a:noFill/>
        </p:spPr>
        <p:txBody>
          <a:bodyPr wrap="square" rtlCol="0">
            <a:spAutoFit/>
          </a:bodyPr>
          <a:lstStyle/>
          <a:p>
            <a:pPr algn="ctr"/>
            <a:r>
              <a:rPr lang="en-US" altLang="ko-KR" b="1" smtClean="0">
                <a:latin typeface="Arial" panose="020B0604020202020204" pitchFamily="34" charset="0"/>
                <a:cs typeface="Arial" panose="020B0604020202020204" pitchFamily="34" charset="0"/>
              </a:rPr>
              <a:t>SET1</a:t>
            </a:r>
            <a:endParaRPr lang="ko-KR" altLang="en-US" b="1">
              <a:latin typeface="Arial" panose="020B0604020202020204" pitchFamily="34" charset="0"/>
              <a:cs typeface="Arial" panose="020B0604020202020204" pitchFamily="34" charset="0"/>
            </a:endParaRPr>
          </a:p>
        </p:txBody>
      </p:sp>
      <p:cxnSp>
        <p:nvCxnSpPr>
          <p:cNvPr id="82" name="직선 연결선 81"/>
          <p:cNvCxnSpPr/>
          <p:nvPr/>
        </p:nvCxnSpPr>
        <p:spPr>
          <a:xfrm>
            <a:off x="4823682" y="1989260"/>
            <a:ext cx="3855537" cy="19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직선 연결선 82"/>
          <p:cNvCxnSpPr/>
          <p:nvPr/>
        </p:nvCxnSpPr>
        <p:spPr>
          <a:xfrm>
            <a:off x="4823681" y="1929098"/>
            <a:ext cx="3855537" cy="19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84" name="TextBox 83"/>
          <p:cNvSpPr txBox="1"/>
          <p:nvPr/>
        </p:nvSpPr>
        <p:spPr>
          <a:xfrm>
            <a:off x="5880984" y="1478857"/>
            <a:ext cx="1728190" cy="369332"/>
          </a:xfrm>
          <a:prstGeom prst="rect">
            <a:avLst/>
          </a:prstGeom>
          <a:noFill/>
        </p:spPr>
        <p:txBody>
          <a:bodyPr wrap="square" rtlCol="0">
            <a:spAutoFit/>
          </a:bodyPr>
          <a:lstStyle/>
          <a:p>
            <a:pPr algn="ctr"/>
            <a:r>
              <a:rPr lang="en-US" altLang="ko-KR" b="1" smtClean="0">
                <a:latin typeface="Arial" panose="020B0604020202020204" pitchFamily="34" charset="0"/>
                <a:cs typeface="Arial" panose="020B0604020202020204" pitchFamily="34" charset="0"/>
              </a:rPr>
              <a:t>SET2</a:t>
            </a:r>
            <a:endParaRPr lang="ko-KR" altLang="en-US" b="1">
              <a:latin typeface="Arial" panose="020B0604020202020204" pitchFamily="34" charset="0"/>
              <a:cs typeface="Arial" panose="020B0604020202020204" pitchFamily="34" charset="0"/>
            </a:endParaRPr>
          </a:p>
        </p:txBody>
      </p:sp>
      <p:cxnSp>
        <p:nvCxnSpPr>
          <p:cNvPr id="85" name="직선 연결선 84"/>
          <p:cNvCxnSpPr/>
          <p:nvPr/>
        </p:nvCxnSpPr>
        <p:spPr>
          <a:xfrm>
            <a:off x="8745928" y="2010029"/>
            <a:ext cx="3855537" cy="19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6" name="직선 연결선 85"/>
          <p:cNvCxnSpPr/>
          <p:nvPr/>
        </p:nvCxnSpPr>
        <p:spPr>
          <a:xfrm>
            <a:off x="8745927" y="1948597"/>
            <a:ext cx="3855537" cy="1969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87" name="TextBox 86"/>
          <p:cNvSpPr txBox="1"/>
          <p:nvPr/>
        </p:nvSpPr>
        <p:spPr>
          <a:xfrm>
            <a:off x="9428844" y="1488595"/>
            <a:ext cx="2489701" cy="369332"/>
          </a:xfrm>
          <a:prstGeom prst="rect">
            <a:avLst/>
          </a:prstGeom>
          <a:noFill/>
        </p:spPr>
        <p:txBody>
          <a:bodyPr wrap="square" rtlCol="0">
            <a:spAutoFit/>
          </a:bodyPr>
          <a:lstStyle/>
          <a:p>
            <a:pPr algn="ctr"/>
            <a:r>
              <a:rPr lang="en-US" altLang="ko-KR" b="1" smtClean="0">
                <a:latin typeface="Arial" panose="020B0604020202020204" pitchFamily="34" charset="0"/>
                <a:cs typeface="Arial" panose="020B0604020202020204" pitchFamily="34" charset="0"/>
              </a:rPr>
              <a:t>SET3</a:t>
            </a:r>
            <a:endParaRPr lang="ko-KR" altLang="en-US" b="1">
              <a:latin typeface="Arial" panose="020B0604020202020204" pitchFamily="34" charset="0"/>
              <a:cs typeface="Arial" panose="020B0604020202020204" pitchFamily="34" charset="0"/>
            </a:endParaRPr>
          </a:p>
        </p:txBody>
      </p:sp>
      <p:cxnSp>
        <p:nvCxnSpPr>
          <p:cNvPr id="103" name="직선 연결선 102"/>
          <p:cNvCxnSpPr/>
          <p:nvPr/>
        </p:nvCxnSpPr>
        <p:spPr>
          <a:xfrm flipV="1">
            <a:off x="13252160" y="2620108"/>
            <a:ext cx="20988" cy="378523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직선 연결선 118"/>
          <p:cNvCxnSpPr/>
          <p:nvPr/>
        </p:nvCxnSpPr>
        <p:spPr>
          <a:xfrm flipV="1">
            <a:off x="13312043" y="2620108"/>
            <a:ext cx="20988" cy="378523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직선 연결선 119"/>
          <p:cNvCxnSpPr/>
          <p:nvPr/>
        </p:nvCxnSpPr>
        <p:spPr>
          <a:xfrm flipV="1">
            <a:off x="13235316" y="6517162"/>
            <a:ext cx="20988" cy="378523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직선 연결선 120"/>
          <p:cNvCxnSpPr/>
          <p:nvPr/>
        </p:nvCxnSpPr>
        <p:spPr>
          <a:xfrm flipV="1">
            <a:off x="13295199" y="6517162"/>
            <a:ext cx="20988" cy="378523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직선 연결선 121"/>
          <p:cNvCxnSpPr/>
          <p:nvPr/>
        </p:nvCxnSpPr>
        <p:spPr>
          <a:xfrm flipV="1">
            <a:off x="13219615" y="10412047"/>
            <a:ext cx="20988" cy="378523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직선 연결선 122"/>
          <p:cNvCxnSpPr/>
          <p:nvPr/>
        </p:nvCxnSpPr>
        <p:spPr>
          <a:xfrm flipV="1">
            <a:off x="13279498" y="10412047"/>
            <a:ext cx="20988" cy="378523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124" name="TextBox 123"/>
          <p:cNvSpPr txBox="1"/>
          <p:nvPr/>
        </p:nvSpPr>
        <p:spPr>
          <a:xfrm rot="5400000">
            <a:off x="12632081" y="4380431"/>
            <a:ext cx="2068999" cy="369332"/>
          </a:xfrm>
          <a:prstGeom prst="rect">
            <a:avLst/>
          </a:prstGeom>
          <a:noFill/>
        </p:spPr>
        <p:txBody>
          <a:bodyPr wrap="square" rtlCol="0">
            <a:spAutoFit/>
          </a:bodyPr>
          <a:lstStyle/>
          <a:p>
            <a:pPr algn="ctr"/>
            <a:r>
              <a:rPr lang="en-US" altLang="ko-KR" b="1" smtClean="0">
                <a:latin typeface="Arial" panose="020B0604020202020204" pitchFamily="34" charset="0"/>
                <a:cs typeface="Arial" panose="020B0604020202020204" pitchFamily="34" charset="0"/>
              </a:rPr>
              <a:t>SET1</a:t>
            </a:r>
            <a:endParaRPr lang="ko-KR" altLang="en-US" b="1">
              <a:latin typeface="Arial" panose="020B0604020202020204" pitchFamily="34" charset="0"/>
              <a:cs typeface="Arial" panose="020B0604020202020204" pitchFamily="34" charset="0"/>
            </a:endParaRPr>
          </a:p>
        </p:txBody>
      </p:sp>
      <p:sp>
        <p:nvSpPr>
          <p:cNvPr id="125" name="TextBox 124"/>
          <p:cNvSpPr txBox="1"/>
          <p:nvPr/>
        </p:nvSpPr>
        <p:spPr>
          <a:xfrm rot="5400000">
            <a:off x="12572383" y="8232055"/>
            <a:ext cx="2188395" cy="369332"/>
          </a:xfrm>
          <a:prstGeom prst="rect">
            <a:avLst/>
          </a:prstGeom>
          <a:noFill/>
        </p:spPr>
        <p:txBody>
          <a:bodyPr wrap="square" rtlCol="0">
            <a:spAutoFit/>
          </a:bodyPr>
          <a:lstStyle/>
          <a:p>
            <a:pPr algn="ctr"/>
            <a:r>
              <a:rPr lang="en-US" altLang="ko-KR" b="1" smtClean="0">
                <a:latin typeface="Arial" panose="020B0604020202020204" pitchFamily="34" charset="0"/>
                <a:cs typeface="Arial" panose="020B0604020202020204" pitchFamily="34" charset="0"/>
              </a:rPr>
              <a:t>SET2</a:t>
            </a:r>
            <a:endParaRPr lang="ko-KR" altLang="en-US" b="1">
              <a:latin typeface="Arial" panose="020B0604020202020204" pitchFamily="34" charset="0"/>
              <a:cs typeface="Arial" panose="020B0604020202020204" pitchFamily="34" charset="0"/>
            </a:endParaRPr>
          </a:p>
        </p:txBody>
      </p:sp>
      <p:sp>
        <p:nvSpPr>
          <p:cNvPr id="126" name="TextBox 125"/>
          <p:cNvSpPr txBox="1"/>
          <p:nvPr/>
        </p:nvSpPr>
        <p:spPr>
          <a:xfrm rot="5400000">
            <a:off x="12369258" y="11968481"/>
            <a:ext cx="2594644" cy="369332"/>
          </a:xfrm>
          <a:prstGeom prst="rect">
            <a:avLst/>
          </a:prstGeom>
          <a:noFill/>
        </p:spPr>
        <p:txBody>
          <a:bodyPr wrap="square" rtlCol="0">
            <a:spAutoFit/>
          </a:bodyPr>
          <a:lstStyle/>
          <a:p>
            <a:pPr algn="ctr"/>
            <a:r>
              <a:rPr lang="en-US" altLang="ko-KR" b="1" smtClean="0">
                <a:latin typeface="Arial" panose="020B0604020202020204" pitchFamily="34" charset="0"/>
                <a:cs typeface="Arial" panose="020B0604020202020204" pitchFamily="34" charset="0"/>
              </a:rPr>
              <a:t>SET3</a:t>
            </a:r>
            <a:endParaRPr lang="ko-KR" altLang="en-US" b="1">
              <a:latin typeface="Arial" panose="020B0604020202020204" pitchFamily="34" charset="0"/>
              <a:cs typeface="Arial" panose="020B0604020202020204" pitchFamily="34" charset="0"/>
            </a:endParaRPr>
          </a:p>
        </p:txBody>
      </p:sp>
      <p:sp>
        <p:nvSpPr>
          <p:cNvPr id="127" name="TextBox 126"/>
          <p:cNvSpPr txBox="1"/>
          <p:nvPr/>
        </p:nvSpPr>
        <p:spPr>
          <a:xfrm>
            <a:off x="10520080" y="14831564"/>
            <a:ext cx="2793845"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0.6                             0.99</a:t>
            </a:r>
            <a:endParaRPr lang="ko-KR" altLang="en-US" b="1">
              <a:latin typeface="Arial" panose="020B0604020202020204" pitchFamily="34" charset="0"/>
              <a:cs typeface="Arial" panose="020B0604020202020204" pitchFamily="34" charset="0"/>
            </a:endParaRPr>
          </a:p>
        </p:txBody>
      </p:sp>
      <p:sp>
        <p:nvSpPr>
          <p:cNvPr id="129" name="TextBox 128"/>
          <p:cNvSpPr txBox="1"/>
          <p:nvPr/>
        </p:nvSpPr>
        <p:spPr>
          <a:xfrm>
            <a:off x="10684272" y="15097371"/>
            <a:ext cx="2546341" cy="369332"/>
          </a:xfrm>
          <a:prstGeom prst="rect">
            <a:avLst/>
          </a:prstGeom>
          <a:noFill/>
        </p:spPr>
        <p:txBody>
          <a:bodyPr wrap="square" rtlCol="0">
            <a:spAutoFit/>
          </a:bodyPr>
          <a:lstStyle/>
          <a:p>
            <a:r>
              <a:rPr lang="en-US" altLang="ko-KR" b="1" smtClean="0">
                <a:latin typeface="Arial" panose="020B0604020202020204" pitchFamily="34" charset="0"/>
                <a:cs typeface="Arial" panose="020B0604020202020204" pitchFamily="34" charset="0"/>
              </a:rPr>
              <a:t>Pearson’s correlation</a:t>
            </a:r>
            <a:endParaRPr lang="ko-KR" altLang="en-US" b="1">
              <a:latin typeface="Arial" panose="020B0604020202020204" pitchFamily="34" charset="0"/>
              <a:cs typeface="Arial" panose="020B0604020202020204" pitchFamily="34" charset="0"/>
            </a:endParaRPr>
          </a:p>
        </p:txBody>
      </p:sp>
      <p:sp>
        <p:nvSpPr>
          <p:cNvPr id="130" name="TextBox 129"/>
          <p:cNvSpPr txBox="1"/>
          <p:nvPr/>
        </p:nvSpPr>
        <p:spPr>
          <a:xfrm>
            <a:off x="1027604" y="601155"/>
            <a:ext cx="11566879" cy="369332"/>
          </a:xfrm>
          <a:prstGeom prst="rect">
            <a:avLst/>
          </a:prstGeom>
          <a:noFill/>
        </p:spPr>
        <p:txBody>
          <a:bodyPr wrap="square" rtlCol="0">
            <a:spAutoFit/>
          </a:bodyPr>
          <a:lstStyle/>
          <a:p>
            <a:r>
              <a:rPr lang="en-US" altLang="ko-KR" sz="1800" b="1" dirty="0">
                <a:latin typeface="Arial" panose="020B0604020202020204" pitchFamily="34" charset="0"/>
                <a:cs typeface="Arial" panose="020B0604020202020204" pitchFamily="34" charset="0"/>
              </a:rPr>
              <a:t>Cross-correlation among </a:t>
            </a:r>
            <a:r>
              <a:rPr lang="en-US" altLang="ko-KR" sz="1800" b="1" dirty="0" smtClean="0">
                <a:latin typeface="Arial" panose="020B0604020202020204" pitchFamily="34" charset="0"/>
                <a:cs typeface="Arial" panose="020B0604020202020204" pitchFamily="34" charset="0"/>
              </a:rPr>
              <a:t>individual samples of </a:t>
            </a:r>
            <a:r>
              <a:rPr lang="en-US" altLang="ko-KR" b="1" dirty="0" smtClean="0">
                <a:latin typeface="Arial" panose="020B0604020202020204" pitchFamily="34" charset="0"/>
                <a:cs typeface="Arial" panose="020B0604020202020204" pitchFamily="34" charset="0"/>
              </a:rPr>
              <a:t>individual sample</a:t>
            </a:r>
            <a:r>
              <a:rPr lang="en-US" altLang="ko-KR" b="1" dirty="0">
                <a:latin typeface="Arial" panose="020B0604020202020204" pitchFamily="34" charset="0"/>
                <a:cs typeface="Arial" panose="020B0604020202020204" pitchFamily="34" charset="0"/>
              </a:rPr>
              <a:t> </a:t>
            </a:r>
            <a:r>
              <a:rPr lang="en-US" altLang="ko-KR" b="1" dirty="0" smtClean="0">
                <a:latin typeface="Arial" panose="020B0604020202020204" pitchFamily="34" charset="0"/>
                <a:cs typeface="Arial" panose="020B0604020202020204" pitchFamily="34" charset="0"/>
              </a:rPr>
              <a:t>set</a:t>
            </a:r>
            <a:endParaRPr lang="ko-KR" altLang="en-US" sz="1800" b="1" dirty="0">
              <a:latin typeface="Arial" panose="020B0604020202020204" pitchFamily="34" charset="0"/>
              <a:cs typeface="Arial" panose="020B0604020202020204" pitchFamily="34" charset="0"/>
            </a:endParaRPr>
          </a:p>
        </p:txBody>
      </p:sp>
      <p:sp>
        <p:nvSpPr>
          <p:cNvPr id="131" name="TextBox 130"/>
          <p:cNvSpPr txBox="1"/>
          <p:nvPr/>
        </p:nvSpPr>
        <p:spPr>
          <a:xfrm>
            <a:off x="725109" y="499341"/>
            <a:ext cx="429223" cy="523220"/>
          </a:xfrm>
          <a:prstGeom prst="rect">
            <a:avLst/>
          </a:prstGeom>
          <a:noFill/>
        </p:spPr>
        <p:txBody>
          <a:bodyPr wrap="square" rtlCol="0">
            <a:spAutoFit/>
          </a:bodyPr>
          <a:lstStyle/>
          <a:p>
            <a:pPr algn="ctr"/>
            <a:r>
              <a:rPr lang="en-US" altLang="ko-KR" sz="2800" b="1" dirty="0">
                <a:latin typeface="Arial" panose="020B0604020202020204" pitchFamily="34" charset="0"/>
                <a:cs typeface="Arial" panose="020B0604020202020204" pitchFamily="34" charset="0"/>
              </a:rPr>
              <a:t>e</a:t>
            </a:r>
            <a:endParaRPr lang="ko-KR" altLang="en-US" sz="2800" b="1" dirty="0">
              <a:latin typeface="Arial" panose="020B0604020202020204" pitchFamily="34" charset="0"/>
              <a:cs typeface="Arial" panose="020B0604020202020204" pitchFamily="34" charset="0"/>
            </a:endParaRPr>
          </a:p>
        </p:txBody>
      </p:sp>
      <p:pic>
        <p:nvPicPr>
          <p:cNvPr id="9" name="그림 8"/>
          <p:cNvPicPr>
            <a:picLocks noChangeAspect="1"/>
          </p:cNvPicPr>
          <p:nvPr/>
        </p:nvPicPr>
        <p:blipFill>
          <a:blip r:embed="rId4"/>
          <a:stretch>
            <a:fillRect/>
          </a:stretch>
        </p:blipFill>
        <p:spPr>
          <a:xfrm>
            <a:off x="881851" y="2543870"/>
            <a:ext cx="11712632" cy="11699917"/>
          </a:xfrm>
          <a:prstGeom prst="rect">
            <a:avLst/>
          </a:prstGeom>
        </p:spPr>
      </p:pic>
      <p:sp>
        <p:nvSpPr>
          <p:cNvPr id="4" name="직사각형 3"/>
          <p:cNvSpPr/>
          <p:nvPr/>
        </p:nvSpPr>
        <p:spPr>
          <a:xfrm>
            <a:off x="4808650" y="2569607"/>
            <a:ext cx="648156" cy="3882862"/>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8" name="직사각형 67"/>
          <p:cNvSpPr/>
          <p:nvPr/>
        </p:nvSpPr>
        <p:spPr>
          <a:xfrm rot="5400000">
            <a:off x="8704936" y="3208592"/>
            <a:ext cx="640795" cy="7098283"/>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9" name="TextBox 68"/>
          <p:cNvSpPr txBox="1"/>
          <p:nvPr/>
        </p:nvSpPr>
        <p:spPr>
          <a:xfrm>
            <a:off x="6738167" y="19991959"/>
            <a:ext cx="895350" cy="461665"/>
          </a:xfrm>
          <a:prstGeom prst="rect">
            <a:avLst/>
          </a:prstGeom>
          <a:noFill/>
        </p:spPr>
        <p:txBody>
          <a:bodyPr wrap="square" rtlCol="0">
            <a:spAutoFit/>
          </a:bodyPr>
          <a:lstStyle/>
          <a:p>
            <a:r>
              <a:rPr lang="en-US" altLang="ko-KR" sz="2400" b="1" dirty="0" smtClean="0"/>
              <a:t>S-5</a:t>
            </a:r>
            <a:endParaRPr lang="ko-KR" altLang="en-US" sz="2400" b="1" dirty="0"/>
          </a:p>
        </p:txBody>
      </p:sp>
      <p:sp>
        <p:nvSpPr>
          <p:cNvPr id="66" name="TextBox 65"/>
          <p:cNvSpPr txBox="1"/>
          <p:nvPr/>
        </p:nvSpPr>
        <p:spPr>
          <a:xfrm>
            <a:off x="111842" y="15576109"/>
            <a:ext cx="14148000" cy="4154984"/>
          </a:xfrm>
          <a:prstGeom prst="rect">
            <a:avLst/>
          </a:prstGeom>
          <a:noFill/>
        </p:spPr>
        <p:txBody>
          <a:bodyPr wrap="square" rtlCol="0">
            <a:spAutoFit/>
          </a:bodyPr>
          <a:lstStyle/>
          <a:p>
            <a:pPr algn="just"/>
            <a:r>
              <a:rPr lang="en-US" altLang="ko-KR" sz="2400" b="1" dirty="0">
                <a:latin typeface="Arial" panose="020B0604020202020204" pitchFamily="34" charset="0"/>
                <a:cs typeface="Arial" panose="020B0604020202020204" pitchFamily="34" charset="0"/>
              </a:rPr>
              <a:t>Additional </a:t>
            </a:r>
            <a:r>
              <a:rPr lang="en-US" altLang="ko-KR" sz="2400" b="1" dirty="0" smtClean="0">
                <a:latin typeface="Arial" panose="020B0604020202020204" pitchFamily="34" charset="0"/>
                <a:cs typeface="Arial" panose="020B0604020202020204" pitchFamily="34" charset="0"/>
              </a:rPr>
              <a:t>File </a:t>
            </a:r>
            <a:r>
              <a:rPr lang="en-US" altLang="ko-KR" sz="2400" b="1" dirty="0">
                <a:latin typeface="Arial" panose="020B0604020202020204" pitchFamily="34" charset="0"/>
                <a:cs typeface="Arial" panose="020B0604020202020204" pitchFamily="34" charset="0"/>
              </a:rPr>
              <a:t>1: Figure </a:t>
            </a:r>
            <a:r>
              <a:rPr lang="en-US" altLang="ko-KR" sz="2400" b="1" dirty="0" smtClean="0">
                <a:latin typeface="Arial" panose="020B0604020202020204" pitchFamily="34" charset="0"/>
                <a:cs typeface="Arial" panose="020B0604020202020204" pitchFamily="34" charset="0"/>
              </a:rPr>
              <a:t>S5. The </a:t>
            </a:r>
            <a:r>
              <a:rPr lang="en-US" altLang="ko-KR" sz="2400" b="1" dirty="0">
                <a:latin typeface="Arial" panose="020B0604020202020204" pitchFamily="34" charset="0"/>
                <a:cs typeface="Arial" panose="020B0604020202020204" pitchFamily="34" charset="0"/>
              </a:rPr>
              <a:t>quality assessment </a:t>
            </a:r>
            <a:r>
              <a:rPr lang="en-US" altLang="ko-KR" sz="2400" b="1" dirty="0" smtClean="0">
                <a:latin typeface="Arial" panose="020B0604020202020204" pitchFamily="34" charset="0"/>
                <a:cs typeface="Arial" panose="020B0604020202020204" pitchFamily="34" charset="0"/>
              </a:rPr>
              <a:t>of MS analysis. </a:t>
            </a:r>
            <a:endParaRPr lang="ko-KR" altLang="ko-KR" sz="2400" dirty="0">
              <a:latin typeface="Arial" panose="020B0604020202020204" pitchFamily="34" charset="0"/>
              <a:cs typeface="Arial" panose="020B0604020202020204" pitchFamily="34" charset="0"/>
            </a:endParaRPr>
          </a:p>
          <a:p>
            <a:pPr algn="just"/>
            <a:r>
              <a:rPr lang="en-US" altLang="ko-KR" sz="2400" dirty="0">
                <a:latin typeface="Arial" panose="020B0604020202020204" pitchFamily="34" charset="0"/>
                <a:cs typeface="Arial" panose="020B0604020202020204" pitchFamily="34" charset="0"/>
              </a:rPr>
              <a:t>(a) Abundance and technical variation of the external standard, ovalbumin. Ovalbumin was quantified in the middle-high abundance interval and had a CV of 4.2% and 6.7% in the pooled and individual sample sets in 18 TMT channels, respectively. (b), (c) The quantitative reproducibility of all proteins was improved slightly on normalization with the external standard, ovalbumin; the median CV value of the biological replicates of the pooled and individual sample sets decreased by 0.36% and 1.54%, respectively. (d) Cross-correlation analysis using the protein levels to confirm the repeatability of the MS analyses between experimental sets of the pooled sample set. (e) Variabilities in individual samples in our MS analysis are depicted in a </a:t>
            </a:r>
            <a:r>
              <a:rPr lang="en-US" altLang="ko-KR" sz="2400" dirty="0" err="1">
                <a:latin typeface="Arial" panose="020B0604020202020204" pitchFamily="34" charset="0"/>
                <a:cs typeface="Arial" panose="020B0604020202020204" pitchFamily="34" charset="0"/>
              </a:rPr>
              <a:t>multiscatter</a:t>
            </a:r>
            <a:r>
              <a:rPr lang="en-US" altLang="ko-KR" sz="2400" dirty="0">
                <a:latin typeface="Arial" panose="020B0604020202020204" pitchFamily="34" charset="0"/>
                <a:cs typeface="Arial" panose="020B0604020202020204" pitchFamily="34" charset="0"/>
              </a:rPr>
              <a:t> plot. Reproducibility between individual samples is represented by Pearson’s correlation value. Values of correlation with HER2 ND-2 are marked in </a:t>
            </a:r>
            <a:r>
              <a:rPr lang="en-US" altLang="ko-KR" sz="2400" dirty="0" smtClean="0">
                <a:latin typeface="Arial" panose="020B0604020202020204" pitchFamily="34" charset="0"/>
                <a:cs typeface="Arial" panose="020B0604020202020204" pitchFamily="34" charset="0"/>
              </a:rPr>
              <a:t>red. (</a:t>
            </a:r>
            <a:r>
              <a:rPr lang="en-US" altLang="ko-KR" sz="2400" dirty="0">
                <a:latin typeface="Arial" panose="020B0604020202020204" pitchFamily="34" charset="0"/>
                <a:cs typeface="Arial" panose="020B0604020202020204" pitchFamily="34" charset="0"/>
              </a:rPr>
              <a:t>ND; non dis-meta, D; dis-meta, LU; luminal, - #; number of TMT set) </a:t>
            </a:r>
            <a:endParaRPr lang="ko-KR" altLang="ko-KR" sz="2400" dirty="0">
              <a:solidFill>
                <a:srgbClr val="0000FF"/>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03164406"/>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그림 6">
            <a:extLst>
              <a:ext uri="{FF2B5EF4-FFF2-40B4-BE49-F238E27FC236}">
                <a16:creationId xmlns:a16="http://schemas.microsoft.com/office/drawing/2014/main" id="{05AB3F1D-33F1-9842-8EAF-158BBD29A636}"/>
              </a:ext>
            </a:extLst>
          </p:cNvPr>
          <p:cNvPicPr>
            <a:picLocks noChangeAspect="1"/>
          </p:cNvPicPr>
          <p:nvPr/>
        </p:nvPicPr>
        <p:blipFill>
          <a:blip r:embed="rId2"/>
          <a:stretch>
            <a:fillRect/>
          </a:stretch>
        </p:blipFill>
        <p:spPr>
          <a:xfrm>
            <a:off x="552043" y="1275170"/>
            <a:ext cx="6458515" cy="5255458"/>
          </a:xfrm>
          <a:prstGeom prst="rect">
            <a:avLst/>
          </a:prstGeom>
        </p:spPr>
      </p:pic>
      <p:sp>
        <p:nvSpPr>
          <p:cNvPr id="8" name="직사각형 7"/>
          <p:cNvSpPr/>
          <p:nvPr/>
        </p:nvSpPr>
        <p:spPr>
          <a:xfrm>
            <a:off x="7024414" y="429819"/>
            <a:ext cx="152400" cy="1079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pic>
        <p:nvPicPr>
          <p:cNvPr id="9" name="그림 8"/>
          <p:cNvPicPr>
            <a:picLocks noChangeAspect="1"/>
          </p:cNvPicPr>
          <p:nvPr/>
        </p:nvPicPr>
        <p:blipFill>
          <a:blip r:embed="rId3"/>
          <a:stretch>
            <a:fillRect/>
          </a:stretch>
        </p:blipFill>
        <p:spPr>
          <a:xfrm>
            <a:off x="7285671" y="1211209"/>
            <a:ext cx="6533969" cy="5319419"/>
          </a:xfrm>
          <a:prstGeom prst="rect">
            <a:avLst/>
          </a:prstGeom>
        </p:spPr>
      </p:pic>
      <p:sp>
        <p:nvSpPr>
          <p:cNvPr id="10" name="직사각형 9"/>
          <p:cNvSpPr/>
          <p:nvPr/>
        </p:nvSpPr>
        <p:spPr>
          <a:xfrm>
            <a:off x="1182026" y="7297297"/>
            <a:ext cx="12207289" cy="1938992"/>
          </a:xfrm>
          <a:prstGeom prst="rect">
            <a:avLst/>
          </a:prstGeom>
        </p:spPr>
        <p:txBody>
          <a:bodyPr wrap="square" anchor="ctr">
            <a:spAutoFit/>
          </a:bodyPr>
          <a:lstStyle/>
          <a:p>
            <a:pPr algn="just"/>
            <a:r>
              <a:rPr lang="en-US" altLang="ko-KR" sz="2400" b="1" dirty="0" smtClean="0">
                <a:latin typeface="Arial" panose="020B0604020202020204" pitchFamily="34" charset="0"/>
                <a:cs typeface="Arial" panose="020B0604020202020204" pitchFamily="34" charset="0"/>
              </a:rPr>
              <a:t>Additional File 1: Figure S6. Cell proliferation of MDA-MB-231 and Hs578T cell lines.  </a:t>
            </a:r>
            <a:r>
              <a:rPr lang="en-US" altLang="ko-KR" sz="2400" dirty="0" smtClean="0">
                <a:latin typeface="Arial" panose="020B0604020202020204" pitchFamily="34" charset="0"/>
                <a:cs typeface="Arial" panose="020B0604020202020204" pitchFamily="34" charset="0"/>
              </a:rPr>
              <a:t>Relative cell proliferation was observed for 3 days, when TUBB2A was knocked down compared with the control group (</a:t>
            </a:r>
            <a:r>
              <a:rPr lang="en-US" altLang="ko-KR" sz="2400" dirty="0" err="1" smtClean="0">
                <a:latin typeface="Arial" panose="020B0604020202020204" pitchFamily="34" charset="0"/>
                <a:cs typeface="Arial" panose="020B0604020202020204" pitchFamily="34" charset="0"/>
              </a:rPr>
              <a:t>siControl</a:t>
            </a:r>
            <a:r>
              <a:rPr lang="en-US" altLang="ko-KR" sz="2400" dirty="0" smtClean="0">
                <a:latin typeface="Arial" panose="020B0604020202020204" pitchFamily="34" charset="0"/>
                <a:cs typeface="Arial" panose="020B0604020202020204" pitchFamily="34" charset="0"/>
              </a:rPr>
              <a:t>) (* &lt; p-value 0.05; ** &lt; p-value 0.01). The time point at which migration and invasion assays were performed is indicated in blue circle.</a:t>
            </a:r>
            <a:endParaRPr lang="ko-KR" altLang="en-US" sz="2400" dirty="0">
              <a:latin typeface="Arial" panose="020B0604020202020204" pitchFamily="34" charset="0"/>
              <a:cs typeface="Arial" panose="020B0604020202020204" pitchFamily="34" charset="0"/>
            </a:endParaRPr>
          </a:p>
        </p:txBody>
      </p:sp>
      <p:cxnSp>
        <p:nvCxnSpPr>
          <p:cNvPr id="13" name="직선 연결선 12"/>
          <p:cNvCxnSpPr/>
          <p:nvPr/>
        </p:nvCxnSpPr>
        <p:spPr>
          <a:xfrm>
            <a:off x="3955765" y="4514603"/>
            <a:ext cx="0" cy="857250"/>
          </a:xfrm>
          <a:prstGeom prst="line">
            <a:avLst/>
          </a:prstGeom>
          <a:ln w="28575">
            <a:solidFill>
              <a:srgbClr val="0000FF"/>
            </a:solidFill>
            <a:prstDash val="dash"/>
          </a:ln>
        </p:spPr>
        <p:style>
          <a:lnRef idx="1">
            <a:schemeClr val="accent1"/>
          </a:lnRef>
          <a:fillRef idx="0">
            <a:schemeClr val="accent1"/>
          </a:fillRef>
          <a:effectRef idx="0">
            <a:schemeClr val="accent1"/>
          </a:effectRef>
          <a:fontRef idx="minor">
            <a:schemeClr val="tx1"/>
          </a:fontRef>
        </p:style>
      </p:cxnSp>
      <p:sp>
        <p:nvSpPr>
          <p:cNvPr id="15" name="타원 14"/>
          <p:cNvSpPr/>
          <p:nvPr/>
        </p:nvSpPr>
        <p:spPr>
          <a:xfrm>
            <a:off x="3815521" y="4278383"/>
            <a:ext cx="251460" cy="236220"/>
          </a:xfrm>
          <a:prstGeom prst="ellipse">
            <a:avLst/>
          </a:prstGeom>
          <a:noFill/>
          <a:ln w="285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16" name="직선 연결선 15"/>
          <p:cNvCxnSpPr/>
          <p:nvPr/>
        </p:nvCxnSpPr>
        <p:spPr>
          <a:xfrm>
            <a:off x="10718696" y="4372363"/>
            <a:ext cx="0" cy="999490"/>
          </a:xfrm>
          <a:prstGeom prst="line">
            <a:avLst/>
          </a:prstGeom>
          <a:ln w="28575">
            <a:solidFill>
              <a:srgbClr val="0000FF"/>
            </a:solidFill>
            <a:prstDash val="dash"/>
          </a:ln>
        </p:spPr>
        <p:style>
          <a:lnRef idx="1">
            <a:schemeClr val="accent1"/>
          </a:lnRef>
          <a:fillRef idx="0">
            <a:schemeClr val="accent1"/>
          </a:fillRef>
          <a:effectRef idx="0">
            <a:schemeClr val="accent1"/>
          </a:effectRef>
          <a:fontRef idx="minor">
            <a:schemeClr val="tx1"/>
          </a:fontRef>
        </p:style>
      </p:cxnSp>
      <p:sp>
        <p:nvSpPr>
          <p:cNvPr id="18" name="타원 17"/>
          <p:cNvSpPr/>
          <p:nvPr/>
        </p:nvSpPr>
        <p:spPr>
          <a:xfrm>
            <a:off x="10592966" y="4136143"/>
            <a:ext cx="251460" cy="236220"/>
          </a:xfrm>
          <a:prstGeom prst="ellipse">
            <a:avLst/>
          </a:prstGeom>
          <a:noFill/>
          <a:ln w="28575">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6" name="TextBox 25"/>
          <p:cNvSpPr txBox="1"/>
          <p:nvPr/>
        </p:nvSpPr>
        <p:spPr>
          <a:xfrm>
            <a:off x="6738167" y="19991959"/>
            <a:ext cx="895350" cy="461665"/>
          </a:xfrm>
          <a:prstGeom prst="rect">
            <a:avLst/>
          </a:prstGeom>
          <a:noFill/>
        </p:spPr>
        <p:txBody>
          <a:bodyPr wrap="square" rtlCol="0">
            <a:spAutoFit/>
          </a:bodyPr>
          <a:lstStyle/>
          <a:p>
            <a:r>
              <a:rPr lang="en-US" altLang="ko-KR" sz="2400" b="1" dirty="0" smtClean="0"/>
              <a:t>S-6</a:t>
            </a:r>
            <a:endParaRPr lang="ko-KR" altLang="en-US" sz="2400" b="1" dirty="0"/>
          </a:p>
        </p:txBody>
      </p:sp>
    </p:spTree>
    <p:extLst>
      <p:ext uri="{BB962C8B-B14F-4D97-AF65-F5344CB8AC3E}">
        <p14:creationId xmlns:p14="http://schemas.microsoft.com/office/powerpoint/2010/main" val="185496449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636</TotalTime>
  <Words>2074</Words>
  <Application>Microsoft Office PowerPoint</Application>
  <PresentationFormat>사용자 지정</PresentationFormat>
  <Paragraphs>684</Paragraphs>
  <Slides>13</Slides>
  <Notes>3</Notes>
  <HiddenSlides>0</HiddenSlides>
  <MMClips>0</MMClips>
  <ScaleCrop>false</ScaleCrop>
  <HeadingPairs>
    <vt:vector size="8" baseType="variant">
      <vt:variant>
        <vt:lpstr>사용한 글꼴</vt:lpstr>
      </vt:variant>
      <vt:variant>
        <vt:i4>7</vt:i4>
      </vt:variant>
      <vt:variant>
        <vt:lpstr>테마</vt:lpstr>
      </vt:variant>
      <vt:variant>
        <vt:i4>1</vt:i4>
      </vt:variant>
      <vt:variant>
        <vt:lpstr>포함된 OLE 서버</vt:lpstr>
      </vt:variant>
      <vt:variant>
        <vt:i4>1</vt:i4>
      </vt:variant>
      <vt:variant>
        <vt:lpstr>슬라이드 제목</vt:lpstr>
      </vt:variant>
      <vt:variant>
        <vt:i4>13</vt:i4>
      </vt:variant>
    </vt:vector>
  </HeadingPairs>
  <TitlesOfParts>
    <vt:vector size="22" baseType="lpstr">
      <vt:lpstr>Arial Unicode MS</vt:lpstr>
      <vt:lpstr>굴림</vt:lpstr>
      <vt:lpstr>맑은 고딕</vt:lpstr>
      <vt:lpstr>Arial</vt:lpstr>
      <vt:lpstr>Calibri</vt:lpstr>
      <vt:lpstr>Calibri Light</vt:lpstr>
      <vt:lpstr>Times New Roman</vt:lpstr>
      <vt:lpstr>Office 테마</vt:lpstr>
      <vt:lpstr>Prism 6</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Windows 사용자</dc:creator>
  <cp:lastModifiedBy>Windows 사용자</cp:lastModifiedBy>
  <cp:revision>287</cp:revision>
  <cp:lastPrinted>2020-01-10T02:29:40Z</cp:lastPrinted>
  <dcterms:created xsi:type="dcterms:W3CDTF">2019-08-08T11:56:38Z</dcterms:created>
  <dcterms:modified xsi:type="dcterms:W3CDTF">2020-04-06T14:21:01Z</dcterms:modified>
</cp:coreProperties>
</file>